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58" r:id="rId4"/>
    <p:sldId id="262" r:id="rId5"/>
    <p:sldId id="264" r:id="rId6"/>
    <p:sldId id="265" r:id="rId7"/>
    <p:sldId id="266" r:id="rId8"/>
    <p:sldId id="261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B83EA771-8E6E-43E1-AA3C-2D51ED08A625}">
          <p14:sldIdLst>
            <p14:sldId id="256"/>
            <p14:sldId id="257"/>
            <p14:sldId id="258"/>
            <p14:sldId id="262"/>
            <p14:sldId id="264"/>
            <p14:sldId id="265"/>
            <p14:sldId id="266"/>
            <p14:sldId id="261"/>
          </p14:sldIdLst>
        </p14:section>
        <p14:section name="无标题节" id="{25D2BB5F-32D6-445D-B54B-545B48DB0F2E}">
          <p14:sldIdLst/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87" d="100"/>
          <a:sy n="87" d="100"/>
        </p:scale>
        <p:origin x="51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ED49E4-6A4C-4DBB-BDD8-882327D05DE3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7835C0-8204-4DEB-8E94-51FAFF88DB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338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7835C0-8204-4DEB-8E94-51FAFF88DBEA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17857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6821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5569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472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122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0446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31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0417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7411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5742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6033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0015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E5FEC-9273-45E8-9936-0A2C70032A92}" type="datetimeFigureOut">
              <a:rPr lang="zh-CN" altLang="en-US" smtClean="0"/>
              <a:t>2022-08-0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2C7306-537C-458C-A574-C250654AC7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8793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7" Type="http://schemas.openxmlformats.org/officeDocument/2006/relationships/image" Target="../media/image20.pn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7" Type="http://schemas.openxmlformats.org/officeDocument/2006/relationships/image" Target="../media/image28.pn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jpeg"/><Relationship Id="rId5" Type="http://schemas.openxmlformats.org/officeDocument/2006/relationships/image" Target="../media/image26.jpeg"/><Relationship Id="rId4" Type="http://schemas.openxmlformats.org/officeDocument/2006/relationships/image" Target="../media/image25.jpe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19" descr="C:\Users\ACER\Desktop\Graph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432" y="15089"/>
            <a:ext cx="5514115" cy="3008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图片 4" descr="C:\Users\ACER\Desktop\结肠癌组织样本中每种免疫细胞中占比相关热图   仙桃\cibersort 第二次   无ABS\数值热图\tiff600 相关性热图_2021-05-03_12-29-05.tiff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40123" y="15090"/>
            <a:ext cx="5581239" cy="5235736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文本框 5"/>
          <p:cNvSpPr txBox="1"/>
          <p:nvPr/>
        </p:nvSpPr>
        <p:spPr>
          <a:xfrm>
            <a:off x="347432" y="15088"/>
            <a:ext cx="6927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246216" y="0"/>
            <a:ext cx="6927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72126" y="2871613"/>
            <a:ext cx="6927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21" name="组合 320"/>
          <p:cNvGrpSpPr/>
          <p:nvPr/>
        </p:nvGrpSpPr>
        <p:grpSpPr>
          <a:xfrm>
            <a:off x="528852" y="3467694"/>
            <a:ext cx="6007491" cy="3157503"/>
            <a:chOff x="1562229" y="1662403"/>
            <a:chExt cx="6045497" cy="3393503"/>
          </a:xfrm>
        </p:grpSpPr>
        <p:sp>
          <p:nvSpPr>
            <p:cNvPr id="322" name="pl4"/>
            <p:cNvSpPr/>
            <p:nvPr/>
          </p:nvSpPr>
          <p:spPr>
            <a:xfrm>
              <a:off x="1837528" y="1662403"/>
              <a:ext cx="0" cy="3143249"/>
            </a:xfrm>
            <a:custGeom>
              <a:avLst/>
              <a:gdLst/>
              <a:ahLst/>
              <a:cxnLst/>
              <a:rect l="0" t="0" r="0" b="0"/>
              <a:pathLst>
                <a:path h="3143249">
                  <a:moveTo>
                    <a:pt x="0" y="3143249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3" name="tx5"/>
            <p:cNvSpPr/>
            <p:nvPr/>
          </p:nvSpPr>
          <p:spPr>
            <a:xfrm>
              <a:off x="1664765" y="4648459"/>
              <a:ext cx="110132" cy="55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20</a:t>
              </a:r>
            </a:p>
          </p:txBody>
        </p:sp>
        <p:sp>
          <p:nvSpPr>
            <p:cNvPr id="324" name="tx6"/>
            <p:cNvSpPr/>
            <p:nvPr/>
          </p:nvSpPr>
          <p:spPr>
            <a:xfrm>
              <a:off x="1690177" y="3771335"/>
              <a:ext cx="84720" cy="55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 0</a:t>
              </a:r>
            </a:p>
          </p:txBody>
        </p:sp>
        <p:sp>
          <p:nvSpPr>
            <p:cNvPr id="325" name="tx7"/>
            <p:cNvSpPr/>
            <p:nvPr/>
          </p:nvSpPr>
          <p:spPr>
            <a:xfrm>
              <a:off x="1668969" y="2894210"/>
              <a:ext cx="105928" cy="55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20</a:t>
              </a:r>
            </a:p>
          </p:txBody>
        </p:sp>
        <p:sp>
          <p:nvSpPr>
            <p:cNvPr id="326" name="tx8"/>
            <p:cNvSpPr/>
            <p:nvPr/>
          </p:nvSpPr>
          <p:spPr>
            <a:xfrm>
              <a:off x="1668969" y="2017085"/>
              <a:ext cx="105928" cy="55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40</a:t>
              </a:r>
            </a:p>
          </p:txBody>
        </p:sp>
        <p:sp>
          <p:nvSpPr>
            <p:cNvPr id="327" name="pl9"/>
            <p:cNvSpPr/>
            <p:nvPr/>
          </p:nvSpPr>
          <p:spPr>
            <a:xfrm>
              <a:off x="1802733" y="467688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l10"/>
            <p:cNvSpPr/>
            <p:nvPr/>
          </p:nvSpPr>
          <p:spPr>
            <a:xfrm>
              <a:off x="1802733" y="379976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l11"/>
            <p:cNvSpPr/>
            <p:nvPr/>
          </p:nvSpPr>
          <p:spPr>
            <a:xfrm>
              <a:off x="1802733" y="292263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l12"/>
            <p:cNvSpPr/>
            <p:nvPr/>
          </p:nvSpPr>
          <p:spPr>
            <a:xfrm>
              <a:off x="1802733" y="204551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tx13"/>
            <p:cNvSpPr/>
            <p:nvPr/>
          </p:nvSpPr>
          <p:spPr>
            <a:xfrm rot="-5400000">
              <a:off x="1477627" y="3209936"/>
              <a:ext cx="217388" cy="4818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core</a:t>
              </a:r>
            </a:p>
          </p:txBody>
        </p:sp>
        <p:sp>
          <p:nvSpPr>
            <p:cNvPr id="332" name="pl14"/>
            <p:cNvSpPr/>
            <p:nvPr/>
          </p:nvSpPr>
          <p:spPr>
            <a:xfrm>
              <a:off x="1999254" y="3663669"/>
              <a:ext cx="998" cy="188881"/>
            </a:xfrm>
            <a:custGeom>
              <a:avLst/>
              <a:gdLst/>
              <a:ahLst/>
              <a:cxnLst/>
              <a:rect l="0" t="0" r="0" b="0"/>
              <a:pathLst>
                <a:path w="998" h="188881">
                  <a:moveTo>
                    <a:pt x="998" y="188881"/>
                  </a:moveTo>
                  <a:lnTo>
                    <a:pt x="988" y="188881"/>
                  </a:lnTo>
                  <a:lnTo>
                    <a:pt x="987" y="188512"/>
                  </a:lnTo>
                  <a:lnTo>
                    <a:pt x="986" y="188142"/>
                  </a:lnTo>
                  <a:lnTo>
                    <a:pt x="986" y="187772"/>
                  </a:lnTo>
                  <a:lnTo>
                    <a:pt x="985" y="187403"/>
                  </a:lnTo>
                  <a:lnTo>
                    <a:pt x="984" y="187033"/>
                  </a:lnTo>
                  <a:lnTo>
                    <a:pt x="983" y="186664"/>
                  </a:lnTo>
                  <a:lnTo>
                    <a:pt x="982" y="186294"/>
                  </a:lnTo>
                  <a:lnTo>
                    <a:pt x="981" y="185924"/>
                  </a:lnTo>
                  <a:lnTo>
                    <a:pt x="980" y="185555"/>
                  </a:lnTo>
                  <a:lnTo>
                    <a:pt x="979" y="185185"/>
                  </a:lnTo>
                  <a:lnTo>
                    <a:pt x="978" y="184815"/>
                  </a:lnTo>
                  <a:lnTo>
                    <a:pt x="976" y="184446"/>
                  </a:lnTo>
                  <a:lnTo>
                    <a:pt x="975" y="184076"/>
                  </a:lnTo>
                  <a:lnTo>
                    <a:pt x="974" y="183706"/>
                  </a:lnTo>
                  <a:lnTo>
                    <a:pt x="972" y="183337"/>
                  </a:lnTo>
                  <a:lnTo>
                    <a:pt x="971" y="182967"/>
                  </a:lnTo>
                  <a:lnTo>
                    <a:pt x="969" y="182598"/>
                  </a:lnTo>
                  <a:lnTo>
                    <a:pt x="967" y="182228"/>
                  </a:lnTo>
                  <a:lnTo>
                    <a:pt x="966" y="181858"/>
                  </a:lnTo>
                  <a:lnTo>
                    <a:pt x="964" y="181489"/>
                  </a:lnTo>
                  <a:lnTo>
                    <a:pt x="962" y="181119"/>
                  </a:lnTo>
                  <a:lnTo>
                    <a:pt x="960" y="180749"/>
                  </a:lnTo>
                  <a:lnTo>
                    <a:pt x="958" y="180380"/>
                  </a:lnTo>
                  <a:lnTo>
                    <a:pt x="956" y="180010"/>
                  </a:lnTo>
                  <a:lnTo>
                    <a:pt x="953" y="179641"/>
                  </a:lnTo>
                  <a:lnTo>
                    <a:pt x="951" y="179271"/>
                  </a:lnTo>
                  <a:lnTo>
                    <a:pt x="949" y="178901"/>
                  </a:lnTo>
                  <a:lnTo>
                    <a:pt x="946" y="178532"/>
                  </a:lnTo>
                  <a:lnTo>
                    <a:pt x="943" y="178162"/>
                  </a:lnTo>
                  <a:lnTo>
                    <a:pt x="940" y="177792"/>
                  </a:lnTo>
                  <a:lnTo>
                    <a:pt x="937" y="177423"/>
                  </a:lnTo>
                  <a:lnTo>
                    <a:pt x="934" y="177053"/>
                  </a:lnTo>
                  <a:lnTo>
                    <a:pt x="931" y="176683"/>
                  </a:lnTo>
                  <a:lnTo>
                    <a:pt x="928" y="176314"/>
                  </a:lnTo>
                  <a:lnTo>
                    <a:pt x="924" y="175944"/>
                  </a:lnTo>
                  <a:lnTo>
                    <a:pt x="921" y="175575"/>
                  </a:lnTo>
                  <a:lnTo>
                    <a:pt x="917" y="175205"/>
                  </a:lnTo>
                  <a:lnTo>
                    <a:pt x="913" y="174835"/>
                  </a:lnTo>
                  <a:lnTo>
                    <a:pt x="909" y="174466"/>
                  </a:lnTo>
                  <a:lnTo>
                    <a:pt x="905" y="174096"/>
                  </a:lnTo>
                  <a:lnTo>
                    <a:pt x="901" y="173726"/>
                  </a:lnTo>
                  <a:lnTo>
                    <a:pt x="896" y="173357"/>
                  </a:lnTo>
                  <a:lnTo>
                    <a:pt x="892" y="172987"/>
                  </a:lnTo>
                  <a:lnTo>
                    <a:pt x="887" y="172618"/>
                  </a:lnTo>
                  <a:lnTo>
                    <a:pt x="882" y="172248"/>
                  </a:lnTo>
                  <a:lnTo>
                    <a:pt x="877" y="171878"/>
                  </a:lnTo>
                  <a:lnTo>
                    <a:pt x="872" y="171509"/>
                  </a:lnTo>
                  <a:lnTo>
                    <a:pt x="866" y="171139"/>
                  </a:lnTo>
                  <a:lnTo>
                    <a:pt x="861" y="170769"/>
                  </a:lnTo>
                  <a:lnTo>
                    <a:pt x="855" y="170400"/>
                  </a:lnTo>
                  <a:lnTo>
                    <a:pt x="849" y="170030"/>
                  </a:lnTo>
                  <a:lnTo>
                    <a:pt x="843" y="169660"/>
                  </a:lnTo>
                  <a:lnTo>
                    <a:pt x="836" y="169291"/>
                  </a:lnTo>
                  <a:lnTo>
                    <a:pt x="830" y="168921"/>
                  </a:lnTo>
                  <a:lnTo>
                    <a:pt x="823" y="168552"/>
                  </a:lnTo>
                  <a:lnTo>
                    <a:pt x="816" y="168182"/>
                  </a:lnTo>
                  <a:lnTo>
                    <a:pt x="809" y="167812"/>
                  </a:lnTo>
                  <a:lnTo>
                    <a:pt x="802" y="167443"/>
                  </a:lnTo>
                  <a:lnTo>
                    <a:pt x="795" y="167073"/>
                  </a:lnTo>
                  <a:lnTo>
                    <a:pt x="787" y="166703"/>
                  </a:lnTo>
                  <a:lnTo>
                    <a:pt x="779" y="166334"/>
                  </a:lnTo>
                  <a:lnTo>
                    <a:pt x="771" y="165964"/>
                  </a:lnTo>
                  <a:lnTo>
                    <a:pt x="763" y="165595"/>
                  </a:lnTo>
                  <a:lnTo>
                    <a:pt x="755" y="165225"/>
                  </a:lnTo>
                  <a:lnTo>
                    <a:pt x="746" y="164855"/>
                  </a:lnTo>
                  <a:lnTo>
                    <a:pt x="737" y="164486"/>
                  </a:lnTo>
                  <a:lnTo>
                    <a:pt x="728" y="164116"/>
                  </a:lnTo>
                  <a:lnTo>
                    <a:pt x="719" y="163746"/>
                  </a:lnTo>
                  <a:lnTo>
                    <a:pt x="710" y="163377"/>
                  </a:lnTo>
                  <a:lnTo>
                    <a:pt x="700" y="163007"/>
                  </a:lnTo>
                  <a:lnTo>
                    <a:pt x="691" y="162637"/>
                  </a:lnTo>
                  <a:lnTo>
                    <a:pt x="681" y="162268"/>
                  </a:lnTo>
                  <a:lnTo>
                    <a:pt x="671" y="161898"/>
                  </a:lnTo>
                  <a:lnTo>
                    <a:pt x="661" y="161529"/>
                  </a:lnTo>
                  <a:lnTo>
                    <a:pt x="650" y="161159"/>
                  </a:lnTo>
                  <a:lnTo>
                    <a:pt x="640" y="160789"/>
                  </a:lnTo>
                  <a:lnTo>
                    <a:pt x="629" y="160420"/>
                  </a:lnTo>
                  <a:lnTo>
                    <a:pt x="618" y="160050"/>
                  </a:lnTo>
                  <a:lnTo>
                    <a:pt x="607" y="159680"/>
                  </a:lnTo>
                  <a:lnTo>
                    <a:pt x="596" y="159311"/>
                  </a:lnTo>
                  <a:lnTo>
                    <a:pt x="585" y="158941"/>
                  </a:lnTo>
                  <a:lnTo>
                    <a:pt x="574" y="158572"/>
                  </a:lnTo>
                  <a:lnTo>
                    <a:pt x="562" y="158202"/>
                  </a:lnTo>
                  <a:lnTo>
                    <a:pt x="550" y="157832"/>
                  </a:lnTo>
                  <a:lnTo>
                    <a:pt x="539" y="157463"/>
                  </a:lnTo>
                  <a:lnTo>
                    <a:pt x="527" y="157093"/>
                  </a:lnTo>
                  <a:lnTo>
                    <a:pt x="515" y="156723"/>
                  </a:lnTo>
                  <a:lnTo>
                    <a:pt x="503" y="156354"/>
                  </a:lnTo>
                  <a:lnTo>
                    <a:pt x="491" y="155984"/>
                  </a:lnTo>
                  <a:lnTo>
                    <a:pt x="479" y="155614"/>
                  </a:lnTo>
                  <a:lnTo>
                    <a:pt x="467" y="155245"/>
                  </a:lnTo>
                  <a:lnTo>
                    <a:pt x="454" y="154875"/>
                  </a:lnTo>
                  <a:lnTo>
                    <a:pt x="442" y="154506"/>
                  </a:lnTo>
                  <a:lnTo>
                    <a:pt x="430" y="154136"/>
                  </a:lnTo>
                  <a:lnTo>
                    <a:pt x="417" y="153766"/>
                  </a:lnTo>
                  <a:lnTo>
                    <a:pt x="405" y="153397"/>
                  </a:lnTo>
                  <a:lnTo>
                    <a:pt x="393" y="153027"/>
                  </a:lnTo>
                  <a:lnTo>
                    <a:pt x="380" y="152657"/>
                  </a:lnTo>
                  <a:lnTo>
                    <a:pt x="368" y="152288"/>
                  </a:lnTo>
                  <a:lnTo>
                    <a:pt x="356" y="151918"/>
                  </a:lnTo>
                  <a:lnTo>
                    <a:pt x="343" y="151549"/>
                  </a:lnTo>
                  <a:lnTo>
                    <a:pt x="331" y="151179"/>
                  </a:lnTo>
                  <a:lnTo>
                    <a:pt x="319" y="150809"/>
                  </a:lnTo>
                  <a:lnTo>
                    <a:pt x="307" y="150440"/>
                  </a:lnTo>
                  <a:lnTo>
                    <a:pt x="295" y="150070"/>
                  </a:lnTo>
                  <a:lnTo>
                    <a:pt x="283" y="149700"/>
                  </a:lnTo>
                  <a:lnTo>
                    <a:pt x="271" y="149331"/>
                  </a:lnTo>
                  <a:lnTo>
                    <a:pt x="259" y="148961"/>
                  </a:lnTo>
                  <a:lnTo>
                    <a:pt x="248" y="148591"/>
                  </a:lnTo>
                  <a:lnTo>
                    <a:pt x="237" y="148222"/>
                  </a:lnTo>
                  <a:lnTo>
                    <a:pt x="225" y="147852"/>
                  </a:lnTo>
                  <a:lnTo>
                    <a:pt x="214" y="147483"/>
                  </a:lnTo>
                  <a:lnTo>
                    <a:pt x="203" y="147113"/>
                  </a:lnTo>
                  <a:lnTo>
                    <a:pt x="193" y="146743"/>
                  </a:lnTo>
                  <a:lnTo>
                    <a:pt x="182" y="146374"/>
                  </a:lnTo>
                  <a:lnTo>
                    <a:pt x="172" y="146004"/>
                  </a:lnTo>
                  <a:lnTo>
                    <a:pt x="162" y="145634"/>
                  </a:lnTo>
                  <a:lnTo>
                    <a:pt x="152" y="145265"/>
                  </a:lnTo>
                  <a:lnTo>
                    <a:pt x="142" y="144895"/>
                  </a:lnTo>
                  <a:lnTo>
                    <a:pt x="133" y="144526"/>
                  </a:lnTo>
                  <a:lnTo>
                    <a:pt x="124" y="144156"/>
                  </a:lnTo>
                  <a:lnTo>
                    <a:pt x="115" y="143786"/>
                  </a:lnTo>
                  <a:lnTo>
                    <a:pt x="106" y="143417"/>
                  </a:lnTo>
                  <a:lnTo>
                    <a:pt x="98" y="143047"/>
                  </a:lnTo>
                  <a:lnTo>
                    <a:pt x="90" y="142677"/>
                  </a:lnTo>
                  <a:lnTo>
                    <a:pt x="82" y="142308"/>
                  </a:lnTo>
                  <a:lnTo>
                    <a:pt x="75" y="141938"/>
                  </a:lnTo>
                  <a:lnTo>
                    <a:pt x="68" y="141568"/>
                  </a:lnTo>
                  <a:lnTo>
                    <a:pt x="61" y="141199"/>
                  </a:lnTo>
                  <a:lnTo>
                    <a:pt x="55" y="140829"/>
                  </a:lnTo>
                  <a:lnTo>
                    <a:pt x="48" y="140460"/>
                  </a:lnTo>
                  <a:lnTo>
                    <a:pt x="43" y="140090"/>
                  </a:lnTo>
                  <a:lnTo>
                    <a:pt x="37" y="139720"/>
                  </a:lnTo>
                  <a:lnTo>
                    <a:pt x="32" y="139351"/>
                  </a:lnTo>
                  <a:lnTo>
                    <a:pt x="28" y="138981"/>
                  </a:lnTo>
                  <a:lnTo>
                    <a:pt x="23" y="138611"/>
                  </a:lnTo>
                  <a:lnTo>
                    <a:pt x="19" y="138242"/>
                  </a:lnTo>
                  <a:lnTo>
                    <a:pt x="16" y="137872"/>
                  </a:lnTo>
                  <a:lnTo>
                    <a:pt x="12" y="137502"/>
                  </a:lnTo>
                  <a:lnTo>
                    <a:pt x="10" y="137133"/>
                  </a:lnTo>
                  <a:lnTo>
                    <a:pt x="7" y="136763"/>
                  </a:lnTo>
                  <a:lnTo>
                    <a:pt x="5" y="136394"/>
                  </a:lnTo>
                  <a:lnTo>
                    <a:pt x="3" y="136024"/>
                  </a:lnTo>
                  <a:lnTo>
                    <a:pt x="2" y="135654"/>
                  </a:lnTo>
                  <a:lnTo>
                    <a:pt x="1" y="135285"/>
                  </a:lnTo>
                  <a:lnTo>
                    <a:pt x="0" y="134915"/>
                  </a:lnTo>
                  <a:lnTo>
                    <a:pt x="0" y="134545"/>
                  </a:lnTo>
                  <a:lnTo>
                    <a:pt x="0" y="134176"/>
                  </a:lnTo>
                  <a:lnTo>
                    <a:pt x="0" y="133806"/>
                  </a:lnTo>
                  <a:lnTo>
                    <a:pt x="1" y="133437"/>
                  </a:lnTo>
                  <a:lnTo>
                    <a:pt x="2" y="133067"/>
                  </a:lnTo>
                  <a:lnTo>
                    <a:pt x="3" y="132697"/>
                  </a:lnTo>
                  <a:lnTo>
                    <a:pt x="5" y="132328"/>
                  </a:lnTo>
                  <a:lnTo>
                    <a:pt x="7" y="131958"/>
                  </a:lnTo>
                  <a:lnTo>
                    <a:pt x="9" y="131588"/>
                  </a:lnTo>
                  <a:lnTo>
                    <a:pt x="12" y="131219"/>
                  </a:lnTo>
                  <a:lnTo>
                    <a:pt x="15" y="130849"/>
                  </a:lnTo>
                  <a:lnTo>
                    <a:pt x="19" y="130479"/>
                  </a:lnTo>
                  <a:lnTo>
                    <a:pt x="22" y="130110"/>
                  </a:lnTo>
                  <a:lnTo>
                    <a:pt x="26" y="129740"/>
                  </a:lnTo>
                  <a:lnTo>
                    <a:pt x="30" y="129371"/>
                  </a:lnTo>
                  <a:lnTo>
                    <a:pt x="35" y="129001"/>
                  </a:lnTo>
                  <a:lnTo>
                    <a:pt x="40" y="128631"/>
                  </a:lnTo>
                  <a:lnTo>
                    <a:pt x="44" y="128262"/>
                  </a:lnTo>
                  <a:lnTo>
                    <a:pt x="50" y="127892"/>
                  </a:lnTo>
                  <a:lnTo>
                    <a:pt x="55" y="127522"/>
                  </a:lnTo>
                  <a:lnTo>
                    <a:pt x="61" y="127153"/>
                  </a:lnTo>
                  <a:lnTo>
                    <a:pt x="67" y="126783"/>
                  </a:lnTo>
                  <a:lnTo>
                    <a:pt x="73" y="126414"/>
                  </a:lnTo>
                  <a:lnTo>
                    <a:pt x="79" y="126044"/>
                  </a:lnTo>
                  <a:lnTo>
                    <a:pt x="86" y="125674"/>
                  </a:lnTo>
                  <a:lnTo>
                    <a:pt x="92" y="125305"/>
                  </a:lnTo>
                  <a:lnTo>
                    <a:pt x="99" y="124935"/>
                  </a:lnTo>
                  <a:lnTo>
                    <a:pt x="106" y="124565"/>
                  </a:lnTo>
                  <a:lnTo>
                    <a:pt x="113" y="124196"/>
                  </a:lnTo>
                  <a:lnTo>
                    <a:pt x="121" y="123826"/>
                  </a:lnTo>
                  <a:lnTo>
                    <a:pt x="128" y="123456"/>
                  </a:lnTo>
                  <a:lnTo>
                    <a:pt x="136" y="123087"/>
                  </a:lnTo>
                  <a:lnTo>
                    <a:pt x="143" y="122717"/>
                  </a:lnTo>
                  <a:lnTo>
                    <a:pt x="151" y="122348"/>
                  </a:lnTo>
                  <a:lnTo>
                    <a:pt x="159" y="121978"/>
                  </a:lnTo>
                  <a:lnTo>
                    <a:pt x="167" y="121608"/>
                  </a:lnTo>
                  <a:lnTo>
                    <a:pt x="175" y="121239"/>
                  </a:lnTo>
                  <a:lnTo>
                    <a:pt x="183" y="120869"/>
                  </a:lnTo>
                  <a:lnTo>
                    <a:pt x="191" y="120499"/>
                  </a:lnTo>
                  <a:lnTo>
                    <a:pt x="199" y="120130"/>
                  </a:lnTo>
                  <a:lnTo>
                    <a:pt x="207" y="119760"/>
                  </a:lnTo>
                  <a:lnTo>
                    <a:pt x="215" y="119391"/>
                  </a:lnTo>
                  <a:lnTo>
                    <a:pt x="223" y="119021"/>
                  </a:lnTo>
                  <a:lnTo>
                    <a:pt x="231" y="118651"/>
                  </a:lnTo>
                  <a:lnTo>
                    <a:pt x="239" y="118282"/>
                  </a:lnTo>
                  <a:lnTo>
                    <a:pt x="247" y="117912"/>
                  </a:lnTo>
                  <a:lnTo>
                    <a:pt x="255" y="117542"/>
                  </a:lnTo>
                  <a:lnTo>
                    <a:pt x="263" y="117173"/>
                  </a:lnTo>
                  <a:lnTo>
                    <a:pt x="271" y="116803"/>
                  </a:lnTo>
                  <a:lnTo>
                    <a:pt x="279" y="116433"/>
                  </a:lnTo>
                  <a:lnTo>
                    <a:pt x="287" y="116064"/>
                  </a:lnTo>
                  <a:lnTo>
                    <a:pt x="295" y="115694"/>
                  </a:lnTo>
                  <a:lnTo>
                    <a:pt x="303" y="115325"/>
                  </a:lnTo>
                  <a:lnTo>
                    <a:pt x="311" y="114955"/>
                  </a:lnTo>
                  <a:lnTo>
                    <a:pt x="318" y="114585"/>
                  </a:lnTo>
                  <a:lnTo>
                    <a:pt x="326" y="114216"/>
                  </a:lnTo>
                  <a:lnTo>
                    <a:pt x="333" y="113846"/>
                  </a:lnTo>
                  <a:lnTo>
                    <a:pt x="341" y="113476"/>
                  </a:lnTo>
                  <a:lnTo>
                    <a:pt x="348" y="113107"/>
                  </a:lnTo>
                  <a:lnTo>
                    <a:pt x="355" y="112737"/>
                  </a:lnTo>
                  <a:lnTo>
                    <a:pt x="363" y="112368"/>
                  </a:lnTo>
                  <a:lnTo>
                    <a:pt x="370" y="111998"/>
                  </a:lnTo>
                  <a:lnTo>
                    <a:pt x="377" y="111628"/>
                  </a:lnTo>
                  <a:lnTo>
                    <a:pt x="384" y="111259"/>
                  </a:lnTo>
                  <a:lnTo>
                    <a:pt x="391" y="110889"/>
                  </a:lnTo>
                  <a:lnTo>
                    <a:pt x="397" y="110519"/>
                  </a:lnTo>
                  <a:lnTo>
                    <a:pt x="404" y="110150"/>
                  </a:lnTo>
                  <a:lnTo>
                    <a:pt x="411" y="109780"/>
                  </a:lnTo>
                  <a:lnTo>
                    <a:pt x="417" y="109410"/>
                  </a:lnTo>
                  <a:lnTo>
                    <a:pt x="423" y="109041"/>
                  </a:lnTo>
                  <a:lnTo>
                    <a:pt x="430" y="108671"/>
                  </a:lnTo>
                  <a:lnTo>
                    <a:pt x="436" y="108302"/>
                  </a:lnTo>
                  <a:lnTo>
                    <a:pt x="442" y="107932"/>
                  </a:lnTo>
                  <a:lnTo>
                    <a:pt x="448" y="107562"/>
                  </a:lnTo>
                  <a:lnTo>
                    <a:pt x="454" y="107193"/>
                  </a:lnTo>
                  <a:lnTo>
                    <a:pt x="460" y="106823"/>
                  </a:lnTo>
                  <a:lnTo>
                    <a:pt x="465" y="106453"/>
                  </a:lnTo>
                  <a:lnTo>
                    <a:pt x="471" y="106084"/>
                  </a:lnTo>
                  <a:lnTo>
                    <a:pt x="477" y="105714"/>
                  </a:lnTo>
                  <a:lnTo>
                    <a:pt x="482" y="105345"/>
                  </a:lnTo>
                  <a:lnTo>
                    <a:pt x="488" y="104975"/>
                  </a:lnTo>
                  <a:lnTo>
                    <a:pt x="493" y="104605"/>
                  </a:lnTo>
                  <a:lnTo>
                    <a:pt x="498" y="104236"/>
                  </a:lnTo>
                  <a:lnTo>
                    <a:pt x="503" y="103866"/>
                  </a:lnTo>
                  <a:lnTo>
                    <a:pt x="508" y="103496"/>
                  </a:lnTo>
                  <a:lnTo>
                    <a:pt x="513" y="103127"/>
                  </a:lnTo>
                  <a:lnTo>
                    <a:pt x="518" y="102757"/>
                  </a:lnTo>
                  <a:lnTo>
                    <a:pt x="523" y="102387"/>
                  </a:lnTo>
                  <a:lnTo>
                    <a:pt x="528" y="102018"/>
                  </a:lnTo>
                  <a:lnTo>
                    <a:pt x="533" y="101648"/>
                  </a:lnTo>
                  <a:lnTo>
                    <a:pt x="538" y="101279"/>
                  </a:lnTo>
                  <a:lnTo>
                    <a:pt x="542" y="100909"/>
                  </a:lnTo>
                  <a:lnTo>
                    <a:pt x="547" y="100539"/>
                  </a:lnTo>
                  <a:lnTo>
                    <a:pt x="552" y="100170"/>
                  </a:lnTo>
                  <a:lnTo>
                    <a:pt x="556" y="99800"/>
                  </a:lnTo>
                  <a:lnTo>
                    <a:pt x="561" y="99430"/>
                  </a:lnTo>
                  <a:lnTo>
                    <a:pt x="565" y="99061"/>
                  </a:lnTo>
                  <a:lnTo>
                    <a:pt x="569" y="98691"/>
                  </a:lnTo>
                  <a:lnTo>
                    <a:pt x="574" y="98322"/>
                  </a:lnTo>
                  <a:lnTo>
                    <a:pt x="578" y="97952"/>
                  </a:lnTo>
                  <a:lnTo>
                    <a:pt x="582" y="97582"/>
                  </a:lnTo>
                  <a:lnTo>
                    <a:pt x="586" y="97213"/>
                  </a:lnTo>
                  <a:lnTo>
                    <a:pt x="591" y="96843"/>
                  </a:lnTo>
                  <a:lnTo>
                    <a:pt x="595" y="96473"/>
                  </a:lnTo>
                  <a:lnTo>
                    <a:pt x="599" y="96104"/>
                  </a:lnTo>
                  <a:lnTo>
                    <a:pt x="603" y="95734"/>
                  </a:lnTo>
                  <a:lnTo>
                    <a:pt x="607" y="95364"/>
                  </a:lnTo>
                  <a:lnTo>
                    <a:pt x="611" y="94995"/>
                  </a:lnTo>
                  <a:lnTo>
                    <a:pt x="615" y="94625"/>
                  </a:lnTo>
                  <a:lnTo>
                    <a:pt x="619" y="94256"/>
                  </a:lnTo>
                  <a:lnTo>
                    <a:pt x="623" y="93886"/>
                  </a:lnTo>
                  <a:lnTo>
                    <a:pt x="627" y="93516"/>
                  </a:lnTo>
                  <a:lnTo>
                    <a:pt x="630" y="93147"/>
                  </a:lnTo>
                  <a:lnTo>
                    <a:pt x="634" y="92777"/>
                  </a:lnTo>
                  <a:lnTo>
                    <a:pt x="638" y="92407"/>
                  </a:lnTo>
                  <a:lnTo>
                    <a:pt x="642" y="92038"/>
                  </a:lnTo>
                  <a:lnTo>
                    <a:pt x="645" y="91668"/>
                  </a:lnTo>
                  <a:lnTo>
                    <a:pt x="649" y="91299"/>
                  </a:lnTo>
                  <a:lnTo>
                    <a:pt x="652" y="90929"/>
                  </a:lnTo>
                  <a:lnTo>
                    <a:pt x="656" y="90559"/>
                  </a:lnTo>
                  <a:lnTo>
                    <a:pt x="659" y="90190"/>
                  </a:lnTo>
                  <a:lnTo>
                    <a:pt x="663" y="89820"/>
                  </a:lnTo>
                  <a:lnTo>
                    <a:pt x="666" y="89450"/>
                  </a:lnTo>
                  <a:lnTo>
                    <a:pt x="670" y="89081"/>
                  </a:lnTo>
                  <a:lnTo>
                    <a:pt x="673" y="88711"/>
                  </a:lnTo>
                  <a:lnTo>
                    <a:pt x="676" y="88341"/>
                  </a:lnTo>
                  <a:lnTo>
                    <a:pt x="679" y="87972"/>
                  </a:lnTo>
                  <a:lnTo>
                    <a:pt x="682" y="87602"/>
                  </a:lnTo>
                  <a:lnTo>
                    <a:pt x="685" y="87233"/>
                  </a:lnTo>
                  <a:lnTo>
                    <a:pt x="688" y="86863"/>
                  </a:lnTo>
                  <a:lnTo>
                    <a:pt x="691" y="86493"/>
                  </a:lnTo>
                  <a:lnTo>
                    <a:pt x="694" y="86124"/>
                  </a:lnTo>
                  <a:lnTo>
                    <a:pt x="697" y="85754"/>
                  </a:lnTo>
                  <a:lnTo>
                    <a:pt x="699" y="85384"/>
                  </a:lnTo>
                  <a:lnTo>
                    <a:pt x="702" y="85015"/>
                  </a:lnTo>
                  <a:lnTo>
                    <a:pt x="704" y="84645"/>
                  </a:lnTo>
                  <a:lnTo>
                    <a:pt x="707" y="84276"/>
                  </a:lnTo>
                  <a:lnTo>
                    <a:pt x="709" y="83906"/>
                  </a:lnTo>
                  <a:lnTo>
                    <a:pt x="711" y="83536"/>
                  </a:lnTo>
                  <a:lnTo>
                    <a:pt x="713" y="83167"/>
                  </a:lnTo>
                  <a:lnTo>
                    <a:pt x="715" y="82797"/>
                  </a:lnTo>
                  <a:lnTo>
                    <a:pt x="717" y="82427"/>
                  </a:lnTo>
                  <a:lnTo>
                    <a:pt x="719" y="82058"/>
                  </a:lnTo>
                  <a:lnTo>
                    <a:pt x="721" y="81688"/>
                  </a:lnTo>
                  <a:lnTo>
                    <a:pt x="723" y="81318"/>
                  </a:lnTo>
                  <a:lnTo>
                    <a:pt x="724" y="80949"/>
                  </a:lnTo>
                  <a:lnTo>
                    <a:pt x="726" y="80579"/>
                  </a:lnTo>
                  <a:lnTo>
                    <a:pt x="727" y="80210"/>
                  </a:lnTo>
                  <a:lnTo>
                    <a:pt x="728" y="79840"/>
                  </a:lnTo>
                  <a:lnTo>
                    <a:pt x="730" y="79470"/>
                  </a:lnTo>
                  <a:lnTo>
                    <a:pt x="731" y="79101"/>
                  </a:lnTo>
                  <a:lnTo>
                    <a:pt x="732" y="78731"/>
                  </a:lnTo>
                  <a:lnTo>
                    <a:pt x="732" y="78361"/>
                  </a:lnTo>
                  <a:lnTo>
                    <a:pt x="733" y="77992"/>
                  </a:lnTo>
                  <a:lnTo>
                    <a:pt x="734" y="77622"/>
                  </a:lnTo>
                  <a:lnTo>
                    <a:pt x="734" y="77253"/>
                  </a:lnTo>
                  <a:lnTo>
                    <a:pt x="735" y="76883"/>
                  </a:lnTo>
                  <a:lnTo>
                    <a:pt x="735" y="76513"/>
                  </a:lnTo>
                  <a:lnTo>
                    <a:pt x="735" y="76144"/>
                  </a:lnTo>
                  <a:lnTo>
                    <a:pt x="735" y="75774"/>
                  </a:lnTo>
                  <a:lnTo>
                    <a:pt x="735" y="75404"/>
                  </a:lnTo>
                  <a:lnTo>
                    <a:pt x="735" y="75035"/>
                  </a:lnTo>
                  <a:lnTo>
                    <a:pt x="735" y="74665"/>
                  </a:lnTo>
                  <a:lnTo>
                    <a:pt x="735" y="74295"/>
                  </a:lnTo>
                  <a:lnTo>
                    <a:pt x="734" y="73926"/>
                  </a:lnTo>
                  <a:lnTo>
                    <a:pt x="734" y="73556"/>
                  </a:lnTo>
                  <a:lnTo>
                    <a:pt x="733" y="73187"/>
                  </a:lnTo>
                  <a:lnTo>
                    <a:pt x="733" y="72817"/>
                  </a:lnTo>
                  <a:lnTo>
                    <a:pt x="732" y="72447"/>
                  </a:lnTo>
                  <a:lnTo>
                    <a:pt x="731" y="72078"/>
                  </a:lnTo>
                  <a:lnTo>
                    <a:pt x="730" y="71708"/>
                  </a:lnTo>
                  <a:lnTo>
                    <a:pt x="729" y="71338"/>
                  </a:lnTo>
                  <a:lnTo>
                    <a:pt x="728" y="70969"/>
                  </a:lnTo>
                  <a:lnTo>
                    <a:pt x="727" y="70599"/>
                  </a:lnTo>
                  <a:lnTo>
                    <a:pt x="725" y="70230"/>
                  </a:lnTo>
                  <a:lnTo>
                    <a:pt x="724" y="69860"/>
                  </a:lnTo>
                  <a:lnTo>
                    <a:pt x="723" y="69490"/>
                  </a:lnTo>
                  <a:lnTo>
                    <a:pt x="721" y="69121"/>
                  </a:lnTo>
                  <a:lnTo>
                    <a:pt x="720" y="68751"/>
                  </a:lnTo>
                  <a:lnTo>
                    <a:pt x="718" y="68381"/>
                  </a:lnTo>
                  <a:lnTo>
                    <a:pt x="717" y="68012"/>
                  </a:lnTo>
                  <a:lnTo>
                    <a:pt x="715" y="67642"/>
                  </a:lnTo>
                  <a:lnTo>
                    <a:pt x="714" y="67272"/>
                  </a:lnTo>
                  <a:lnTo>
                    <a:pt x="712" y="66903"/>
                  </a:lnTo>
                  <a:lnTo>
                    <a:pt x="710" y="66533"/>
                  </a:lnTo>
                  <a:lnTo>
                    <a:pt x="708" y="66164"/>
                  </a:lnTo>
                  <a:lnTo>
                    <a:pt x="707" y="65794"/>
                  </a:lnTo>
                  <a:lnTo>
                    <a:pt x="705" y="65424"/>
                  </a:lnTo>
                  <a:lnTo>
                    <a:pt x="703" y="65055"/>
                  </a:lnTo>
                  <a:lnTo>
                    <a:pt x="701" y="64685"/>
                  </a:lnTo>
                  <a:lnTo>
                    <a:pt x="700" y="64315"/>
                  </a:lnTo>
                  <a:lnTo>
                    <a:pt x="698" y="63946"/>
                  </a:lnTo>
                  <a:lnTo>
                    <a:pt x="696" y="63576"/>
                  </a:lnTo>
                  <a:lnTo>
                    <a:pt x="694" y="63207"/>
                  </a:lnTo>
                  <a:lnTo>
                    <a:pt x="693" y="62837"/>
                  </a:lnTo>
                  <a:lnTo>
                    <a:pt x="691" y="62467"/>
                  </a:lnTo>
                  <a:lnTo>
                    <a:pt x="689" y="62098"/>
                  </a:lnTo>
                  <a:lnTo>
                    <a:pt x="688" y="61728"/>
                  </a:lnTo>
                  <a:lnTo>
                    <a:pt x="686" y="61358"/>
                  </a:lnTo>
                  <a:lnTo>
                    <a:pt x="685" y="60989"/>
                  </a:lnTo>
                  <a:lnTo>
                    <a:pt x="683" y="60619"/>
                  </a:lnTo>
                  <a:lnTo>
                    <a:pt x="682" y="60249"/>
                  </a:lnTo>
                  <a:lnTo>
                    <a:pt x="680" y="59880"/>
                  </a:lnTo>
                  <a:lnTo>
                    <a:pt x="679" y="59510"/>
                  </a:lnTo>
                  <a:lnTo>
                    <a:pt x="678" y="59141"/>
                  </a:lnTo>
                  <a:lnTo>
                    <a:pt x="677" y="58771"/>
                  </a:lnTo>
                  <a:lnTo>
                    <a:pt x="676" y="58401"/>
                  </a:lnTo>
                  <a:lnTo>
                    <a:pt x="675" y="58032"/>
                  </a:lnTo>
                  <a:lnTo>
                    <a:pt x="674" y="57662"/>
                  </a:lnTo>
                  <a:lnTo>
                    <a:pt x="673" y="57292"/>
                  </a:lnTo>
                  <a:lnTo>
                    <a:pt x="672" y="56923"/>
                  </a:lnTo>
                  <a:lnTo>
                    <a:pt x="672" y="56553"/>
                  </a:lnTo>
                  <a:lnTo>
                    <a:pt x="671" y="56184"/>
                  </a:lnTo>
                  <a:lnTo>
                    <a:pt x="671" y="55814"/>
                  </a:lnTo>
                  <a:lnTo>
                    <a:pt x="670" y="55444"/>
                  </a:lnTo>
                  <a:lnTo>
                    <a:pt x="670" y="55075"/>
                  </a:lnTo>
                  <a:lnTo>
                    <a:pt x="670" y="54705"/>
                  </a:lnTo>
                  <a:lnTo>
                    <a:pt x="670" y="54335"/>
                  </a:lnTo>
                  <a:lnTo>
                    <a:pt x="670" y="53966"/>
                  </a:lnTo>
                  <a:lnTo>
                    <a:pt x="670" y="53596"/>
                  </a:lnTo>
                  <a:lnTo>
                    <a:pt x="670" y="53226"/>
                  </a:lnTo>
                  <a:lnTo>
                    <a:pt x="671" y="52857"/>
                  </a:lnTo>
                  <a:lnTo>
                    <a:pt x="671" y="52487"/>
                  </a:lnTo>
                  <a:lnTo>
                    <a:pt x="672" y="52118"/>
                  </a:lnTo>
                  <a:lnTo>
                    <a:pt x="673" y="51748"/>
                  </a:lnTo>
                  <a:lnTo>
                    <a:pt x="674" y="51378"/>
                  </a:lnTo>
                  <a:lnTo>
                    <a:pt x="675" y="51009"/>
                  </a:lnTo>
                  <a:lnTo>
                    <a:pt x="676" y="50639"/>
                  </a:lnTo>
                  <a:lnTo>
                    <a:pt x="677" y="50269"/>
                  </a:lnTo>
                  <a:lnTo>
                    <a:pt x="678" y="49900"/>
                  </a:lnTo>
                  <a:lnTo>
                    <a:pt x="680" y="49530"/>
                  </a:lnTo>
                  <a:lnTo>
                    <a:pt x="681" y="49161"/>
                  </a:lnTo>
                  <a:lnTo>
                    <a:pt x="683" y="48791"/>
                  </a:lnTo>
                  <a:lnTo>
                    <a:pt x="685" y="48421"/>
                  </a:lnTo>
                  <a:lnTo>
                    <a:pt x="687" y="48052"/>
                  </a:lnTo>
                  <a:lnTo>
                    <a:pt x="689" y="47682"/>
                  </a:lnTo>
                  <a:lnTo>
                    <a:pt x="691" y="47312"/>
                  </a:lnTo>
                  <a:lnTo>
                    <a:pt x="693" y="46943"/>
                  </a:lnTo>
                  <a:lnTo>
                    <a:pt x="696" y="46573"/>
                  </a:lnTo>
                  <a:lnTo>
                    <a:pt x="698" y="46203"/>
                  </a:lnTo>
                  <a:lnTo>
                    <a:pt x="701" y="45834"/>
                  </a:lnTo>
                  <a:lnTo>
                    <a:pt x="703" y="45464"/>
                  </a:lnTo>
                  <a:lnTo>
                    <a:pt x="706" y="45095"/>
                  </a:lnTo>
                  <a:lnTo>
                    <a:pt x="709" y="44725"/>
                  </a:lnTo>
                  <a:lnTo>
                    <a:pt x="712" y="44355"/>
                  </a:lnTo>
                  <a:lnTo>
                    <a:pt x="715" y="43986"/>
                  </a:lnTo>
                  <a:lnTo>
                    <a:pt x="718" y="43616"/>
                  </a:lnTo>
                  <a:lnTo>
                    <a:pt x="721" y="43246"/>
                  </a:lnTo>
                  <a:lnTo>
                    <a:pt x="725" y="42877"/>
                  </a:lnTo>
                  <a:lnTo>
                    <a:pt x="728" y="42507"/>
                  </a:lnTo>
                  <a:lnTo>
                    <a:pt x="732" y="42138"/>
                  </a:lnTo>
                  <a:lnTo>
                    <a:pt x="735" y="41768"/>
                  </a:lnTo>
                  <a:lnTo>
                    <a:pt x="739" y="41398"/>
                  </a:lnTo>
                  <a:lnTo>
                    <a:pt x="742" y="41029"/>
                  </a:lnTo>
                  <a:lnTo>
                    <a:pt x="746" y="40659"/>
                  </a:lnTo>
                  <a:lnTo>
                    <a:pt x="750" y="40289"/>
                  </a:lnTo>
                  <a:lnTo>
                    <a:pt x="753" y="39920"/>
                  </a:lnTo>
                  <a:lnTo>
                    <a:pt x="757" y="39550"/>
                  </a:lnTo>
                  <a:lnTo>
                    <a:pt x="761" y="39180"/>
                  </a:lnTo>
                  <a:lnTo>
                    <a:pt x="765" y="38811"/>
                  </a:lnTo>
                  <a:lnTo>
                    <a:pt x="769" y="38441"/>
                  </a:lnTo>
                  <a:lnTo>
                    <a:pt x="773" y="38072"/>
                  </a:lnTo>
                  <a:lnTo>
                    <a:pt x="777" y="37702"/>
                  </a:lnTo>
                  <a:lnTo>
                    <a:pt x="781" y="37332"/>
                  </a:lnTo>
                  <a:lnTo>
                    <a:pt x="785" y="36963"/>
                  </a:lnTo>
                  <a:lnTo>
                    <a:pt x="789" y="36593"/>
                  </a:lnTo>
                  <a:lnTo>
                    <a:pt x="793" y="36223"/>
                  </a:lnTo>
                  <a:lnTo>
                    <a:pt x="797" y="35854"/>
                  </a:lnTo>
                  <a:lnTo>
                    <a:pt x="801" y="35484"/>
                  </a:lnTo>
                  <a:lnTo>
                    <a:pt x="805" y="35115"/>
                  </a:lnTo>
                  <a:lnTo>
                    <a:pt x="809" y="34745"/>
                  </a:lnTo>
                  <a:lnTo>
                    <a:pt x="814" y="34375"/>
                  </a:lnTo>
                  <a:lnTo>
                    <a:pt x="818" y="34006"/>
                  </a:lnTo>
                  <a:lnTo>
                    <a:pt x="822" y="33636"/>
                  </a:lnTo>
                  <a:lnTo>
                    <a:pt x="826" y="33266"/>
                  </a:lnTo>
                  <a:lnTo>
                    <a:pt x="830" y="32897"/>
                  </a:lnTo>
                  <a:lnTo>
                    <a:pt x="834" y="32527"/>
                  </a:lnTo>
                  <a:lnTo>
                    <a:pt x="838" y="32157"/>
                  </a:lnTo>
                  <a:lnTo>
                    <a:pt x="842" y="31788"/>
                  </a:lnTo>
                  <a:lnTo>
                    <a:pt x="846" y="31418"/>
                  </a:lnTo>
                  <a:lnTo>
                    <a:pt x="849" y="31049"/>
                  </a:lnTo>
                  <a:lnTo>
                    <a:pt x="853" y="30679"/>
                  </a:lnTo>
                  <a:lnTo>
                    <a:pt x="857" y="30309"/>
                  </a:lnTo>
                  <a:lnTo>
                    <a:pt x="861" y="29940"/>
                  </a:lnTo>
                  <a:lnTo>
                    <a:pt x="865" y="29570"/>
                  </a:lnTo>
                  <a:lnTo>
                    <a:pt x="868" y="29200"/>
                  </a:lnTo>
                  <a:lnTo>
                    <a:pt x="872" y="28831"/>
                  </a:lnTo>
                  <a:lnTo>
                    <a:pt x="876" y="28461"/>
                  </a:lnTo>
                  <a:lnTo>
                    <a:pt x="879" y="28092"/>
                  </a:lnTo>
                  <a:lnTo>
                    <a:pt x="883" y="27722"/>
                  </a:lnTo>
                  <a:lnTo>
                    <a:pt x="886" y="27352"/>
                  </a:lnTo>
                  <a:lnTo>
                    <a:pt x="889" y="26983"/>
                  </a:lnTo>
                  <a:lnTo>
                    <a:pt x="893" y="26613"/>
                  </a:lnTo>
                  <a:lnTo>
                    <a:pt x="896" y="26243"/>
                  </a:lnTo>
                  <a:lnTo>
                    <a:pt x="899" y="25874"/>
                  </a:lnTo>
                  <a:lnTo>
                    <a:pt x="902" y="25504"/>
                  </a:lnTo>
                  <a:lnTo>
                    <a:pt x="905" y="25134"/>
                  </a:lnTo>
                  <a:lnTo>
                    <a:pt x="908" y="24765"/>
                  </a:lnTo>
                  <a:lnTo>
                    <a:pt x="911" y="24395"/>
                  </a:lnTo>
                  <a:lnTo>
                    <a:pt x="914" y="24026"/>
                  </a:lnTo>
                  <a:lnTo>
                    <a:pt x="917" y="23656"/>
                  </a:lnTo>
                  <a:lnTo>
                    <a:pt x="920" y="23286"/>
                  </a:lnTo>
                  <a:lnTo>
                    <a:pt x="923" y="22917"/>
                  </a:lnTo>
                  <a:lnTo>
                    <a:pt x="925" y="22547"/>
                  </a:lnTo>
                  <a:lnTo>
                    <a:pt x="928" y="22177"/>
                  </a:lnTo>
                  <a:lnTo>
                    <a:pt x="931" y="21808"/>
                  </a:lnTo>
                  <a:lnTo>
                    <a:pt x="933" y="21438"/>
                  </a:lnTo>
                  <a:lnTo>
                    <a:pt x="935" y="21069"/>
                  </a:lnTo>
                  <a:lnTo>
                    <a:pt x="938" y="20699"/>
                  </a:lnTo>
                  <a:lnTo>
                    <a:pt x="940" y="20329"/>
                  </a:lnTo>
                  <a:lnTo>
                    <a:pt x="942" y="19960"/>
                  </a:lnTo>
                  <a:lnTo>
                    <a:pt x="944" y="19590"/>
                  </a:lnTo>
                  <a:lnTo>
                    <a:pt x="947" y="19220"/>
                  </a:lnTo>
                  <a:lnTo>
                    <a:pt x="949" y="18851"/>
                  </a:lnTo>
                  <a:lnTo>
                    <a:pt x="951" y="18481"/>
                  </a:lnTo>
                  <a:lnTo>
                    <a:pt x="953" y="18111"/>
                  </a:lnTo>
                  <a:lnTo>
                    <a:pt x="954" y="17742"/>
                  </a:lnTo>
                  <a:lnTo>
                    <a:pt x="956" y="17372"/>
                  </a:lnTo>
                  <a:lnTo>
                    <a:pt x="958" y="17003"/>
                  </a:lnTo>
                  <a:lnTo>
                    <a:pt x="960" y="16633"/>
                  </a:lnTo>
                  <a:lnTo>
                    <a:pt x="961" y="16263"/>
                  </a:lnTo>
                  <a:lnTo>
                    <a:pt x="963" y="15894"/>
                  </a:lnTo>
                  <a:lnTo>
                    <a:pt x="964" y="15524"/>
                  </a:lnTo>
                  <a:lnTo>
                    <a:pt x="966" y="15154"/>
                  </a:lnTo>
                  <a:lnTo>
                    <a:pt x="967" y="14785"/>
                  </a:lnTo>
                  <a:lnTo>
                    <a:pt x="969" y="14415"/>
                  </a:lnTo>
                  <a:lnTo>
                    <a:pt x="970" y="14046"/>
                  </a:lnTo>
                  <a:lnTo>
                    <a:pt x="971" y="13676"/>
                  </a:lnTo>
                  <a:lnTo>
                    <a:pt x="973" y="13306"/>
                  </a:lnTo>
                  <a:lnTo>
                    <a:pt x="974" y="12937"/>
                  </a:lnTo>
                  <a:lnTo>
                    <a:pt x="975" y="12567"/>
                  </a:lnTo>
                  <a:lnTo>
                    <a:pt x="976" y="12197"/>
                  </a:lnTo>
                  <a:lnTo>
                    <a:pt x="977" y="11828"/>
                  </a:lnTo>
                  <a:lnTo>
                    <a:pt x="978" y="11458"/>
                  </a:lnTo>
                  <a:lnTo>
                    <a:pt x="979" y="11088"/>
                  </a:lnTo>
                  <a:lnTo>
                    <a:pt x="980" y="10719"/>
                  </a:lnTo>
                  <a:lnTo>
                    <a:pt x="981" y="10349"/>
                  </a:lnTo>
                  <a:lnTo>
                    <a:pt x="982" y="9980"/>
                  </a:lnTo>
                  <a:lnTo>
                    <a:pt x="983" y="9610"/>
                  </a:lnTo>
                  <a:lnTo>
                    <a:pt x="983" y="9240"/>
                  </a:lnTo>
                  <a:lnTo>
                    <a:pt x="984" y="8871"/>
                  </a:lnTo>
                  <a:lnTo>
                    <a:pt x="985" y="8501"/>
                  </a:lnTo>
                  <a:lnTo>
                    <a:pt x="986" y="8131"/>
                  </a:lnTo>
                  <a:lnTo>
                    <a:pt x="986" y="7762"/>
                  </a:lnTo>
                  <a:lnTo>
                    <a:pt x="987" y="7392"/>
                  </a:lnTo>
                  <a:lnTo>
                    <a:pt x="988" y="7023"/>
                  </a:lnTo>
                  <a:lnTo>
                    <a:pt x="988" y="6653"/>
                  </a:lnTo>
                  <a:lnTo>
                    <a:pt x="989" y="6283"/>
                  </a:lnTo>
                  <a:lnTo>
                    <a:pt x="989" y="5914"/>
                  </a:lnTo>
                  <a:lnTo>
                    <a:pt x="990" y="5544"/>
                  </a:lnTo>
                  <a:lnTo>
                    <a:pt x="990" y="5174"/>
                  </a:lnTo>
                  <a:lnTo>
                    <a:pt x="991" y="4805"/>
                  </a:lnTo>
                  <a:lnTo>
                    <a:pt x="991" y="4435"/>
                  </a:lnTo>
                  <a:lnTo>
                    <a:pt x="992" y="4065"/>
                  </a:lnTo>
                  <a:lnTo>
                    <a:pt x="992" y="3696"/>
                  </a:lnTo>
                  <a:lnTo>
                    <a:pt x="992" y="3326"/>
                  </a:lnTo>
                  <a:lnTo>
                    <a:pt x="993" y="2957"/>
                  </a:lnTo>
                  <a:lnTo>
                    <a:pt x="993" y="2587"/>
                  </a:lnTo>
                  <a:lnTo>
                    <a:pt x="993" y="2217"/>
                  </a:lnTo>
                  <a:lnTo>
                    <a:pt x="994" y="1848"/>
                  </a:lnTo>
                  <a:lnTo>
                    <a:pt x="994" y="1478"/>
                  </a:lnTo>
                  <a:lnTo>
                    <a:pt x="994" y="1108"/>
                  </a:lnTo>
                  <a:lnTo>
                    <a:pt x="994" y="739"/>
                  </a:lnTo>
                  <a:lnTo>
                    <a:pt x="995" y="369"/>
                  </a:lnTo>
                  <a:lnTo>
                    <a:pt x="995" y="0"/>
                  </a:lnTo>
                  <a:lnTo>
                    <a:pt x="998" y="0"/>
                  </a:lnTo>
                  <a:lnTo>
                    <a:pt x="998" y="188881"/>
                  </a:lnTo>
                  <a:lnTo>
                    <a:pt x="998" y="188881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33" name="pl15"/>
            <p:cNvSpPr/>
            <p:nvPr/>
          </p:nvSpPr>
          <p:spPr>
            <a:xfrm>
              <a:off x="2000253" y="3737507"/>
              <a:ext cx="1905" cy="89931"/>
            </a:xfrm>
            <a:custGeom>
              <a:avLst/>
              <a:gdLst/>
              <a:ahLst/>
              <a:cxnLst/>
              <a:rect l="0" t="0" r="0" b="0"/>
              <a:pathLst>
                <a:path w="1905" h="89931">
                  <a:moveTo>
                    <a:pt x="0" y="0"/>
                  </a:moveTo>
                  <a:lnTo>
                    <a:pt x="6" y="0"/>
                  </a:lnTo>
                  <a:lnTo>
                    <a:pt x="7" y="175"/>
                  </a:lnTo>
                  <a:lnTo>
                    <a:pt x="7" y="351"/>
                  </a:lnTo>
                  <a:lnTo>
                    <a:pt x="8" y="527"/>
                  </a:lnTo>
                  <a:lnTo>
                    <a:pt x="8" y="703"/>
                  </a:lnTo>
                  <a:lnTo>
                    <a:pt x="9" y="879"/>
                  </a:lnTo>
                  <a:lnTo>
                    <a:pt x="9" y="1055"/>
                  </a:lnTo>
                  <a:lnTo>
                    <a:pt x="10" y="1231"/>
                  </a:lnTo>
                  <a:lnTo>
                    <a:pt x="10" y="1407"/>
                  </a:lnTo>
                  <a:lnTo>
                    <a:pt x="11" y="1583"/>
                  </a:lnTo>
                  <a:lnTo>
                    <a:pt x="11" y="1759"/>
                  </a:lnTo>
                  <a:lnTo>
                    <a:pt x="12" y="1935"/>
                  </a:lnTo>
                  <a:lnTo>
                    <a:pt x="13" y="2111"/>
                  </a:lnTo>
                  <a:lnTo>
                    <a:pt x="13" y="2287"/>
                  </a:lnTo>
                  <a:lnTo>
                    <a:pt x="14" y="2463"/>
                  </a:lnTo>
                  <a:lnTo>
                    <a:pt x="15" y="2639"/>
                  </a:lnTo>
                  <a:lnTo>
                    <a:pt x="16" y="2815"/>
                  </a:lnTo>
                  <a:lnTo>
                    <a:pt x="17" y="2991"/>
                  </a:lnTo>
                  <a:lnTo>
                    <a:pt x="18" y="3167"/>
                  </a:lnTo>
                  <a:lnTo>
                    <a:pt x="18" y="3343"/>
                  </a:lnTo>
                  <a:lnTo>
                    <a:pt x="19" y="3519"/>
                  </a:lnTo>
                  <a:lnTo>
                    <a:pt x="20" y="3695"/>
                  </a:lnTo>
                  <a:lnTo>
                    <a:pt x="22" y="3871"/>
                  </a:lnTo>
                  <a:lnTo>
                    <a:pt x="23" y="4047"/>
                  </a:lnTo>
                  <a:lnTo>
                    <a:pt x="24" y="4223"/>
                  </a:lnTo>
                  <a:lnTo>
                    <a:pt x="25" y="4399"/>
                  </a:lnTo>
                  <a:lnTo>
                    <a:pt x="26" y="4575"/>
                  </a:lnTo>
                  <a:lnTo>
                    <a:pt x="28" y="4751"/>
                  </a:lnTo>
                  <a:lnTo>
                    <a:pt x="29" y="4927"/>
                  </a:lnTo>
                  <a:lnTo>
                    <a:pt x="30" y="5103"/>
                  </a:lnTo>
                  <a:lnTo>
                    <a:pt x="32" y="5279"/>
                  </a:lnTo>
                  <a:lnTo>
                    <a:pt x="33" y="5455"/>
                  </a:lnTo>
                  <a:lnTo>
                    <a:pt x="35" y="5631"/>
                  </a:lnTo>
                  <a:lnTo>
                    <a:pt x="37" y="5807"/>
                  </a:lnTo>
                  <a:lnTo>
                    <a:pt x="38" y="5983"/>
                  </a:lnTo>
                  <a:lnTo>
                    <a:pt x="40" y="6159"/>
                  </a:lnTo>
                  <a:lnTo>
                    <a:pt x="42" y="6335"/>
                  </a:lnTo>
                  <a:lnTo>
                    <a:pt x="44" y="6511"/>
                  </a:lnTo>
                  <a:lnTo>
                    <a:pt x="46" y="6687"/>
                  </a:lnTo>
                  <a:lnTo>
                    <a:pt x="48" y="6863"/>
                  </a:lnTo>
                  <a:lnTo>
                    <a:pt x="50" y="7039"/>
                  </a:lnTo>
                  <a:lnTo>
                    <a:pt x="52" y="7215"/>
                  </a:lnTo>
                  <a:lnTo>
                    <a:pt x="54" y="7391"/>
                  </a:lnTo>
                  <a:lnTo>
                    <a:pt x="57" y="7567"/>
                  </a:lnTo>
                  <a:lnTo>
                    <a:pt x="59" y="7743"/>
                  </a:lnTo>
                  <a:lnTo>
                    <a:pt x="62" y="7919"/>
                  </a:lnTo>
                  <a:lnTo>
                    <a:pt x="64" y="8095"/>
                  </a:lnTo>
                  <a:lnTo>
                    <a:pt x="67" y="8271"/>
                  </a:lnTo>
                  <a:lnTo>
                    <a:pt x="70" y="8447"/>
                  </a:lnTo>
                  <a:lnTo>
                    <a:pt x="72" y="8623"/>
                  </a:lnTo>
                  <a:lnTo>
                    <a:pt x="75" y="8799"/>
                  </a:lnTo>
                  <a:lnTo>
                    <a:pt x="78" y="8975"/>
                  </a:lnTo>
                  <a:lnTo>
                    <a:pt x="82" y="9151"/>
                  </a:lnTo>
                  <a:lnTo>
                    <a:pt x="85" y="9327"/>
                  </a:lnTo>
                  <a:lnTo>
                    <a:pt x="88" y="9503"/>
                  </a:lnTo>
                  <a:lnTo>
                    <a:pt x="91" y="9679"/>
                  </a:lnTo>
                  <a:lnTo>
                    <a:pt x="95" y="9855"/>
                  </a:lnTo>
                  <a:lnTo>
                    <a:pt x="98" y="10031"/>
                  </a:lnTo>
                  <a:lnTo>
                    <a:pt x="102" y="10207"/>
                  </a:lnTo>
                  <a:lnTo>
                    <a:pt x="106" y="10383"/>
                  </a:lnTo>
                  <a:lnTo>
                    <a:pt x="110" y="10559"/>
                  </a:lnTo>
                  <a:lnTo>
                    <a:pt x="114" y="10735"/>
                  </a:lnTo>
                  <a:lnTo>
                    <a:pt x="118" y="10911"/>
                  </a:lnTo>
                  <a:lnTo>
                    <a:pt x="122" y="11087"/>
                  </a:lnTo>
                  <a:lnTo>
                    <a:pt x="126" y="11263"/>
                  </a:lnTo>
                  <a:lnTo>
                    <a:pt x="131" y="11439"/>
                  </a:lnTo>
                  <a:lnTo>
                    <a:pt x="135" y="11615"/>
                  </a:lnTo>
                  <a:lnTo>
                    <a:pt x="140" y="11791"/>
                  </a:lnTo>
                  <a:lnTo>
                    <a:pt x="145" y="11967"/>
                  </a:lnTo>
                  <a:lnTo>
                    <a:pt x="149" y="12143"/>
                  </a:lnTo>
                  <a:lnTo>
                    <a:pt x="154" y="12319"/>
                  </a:lnTo>
                  <a:lnTo>
                    <a:pt x="159" y="12495"/>
                  </a:lnTo>
                  <a:lnTo>
                    <a:pt x="164" y="12671"/>
                  </a:lnTo>
                  <a:lnTo>
                    <a:pt x="170" y="12847"/>
                  </a:lnTo>
                  <a:lnTo>
                    <a:pt x="175" y="13023"/>
                  </a:lnTo>
                  <a:lnTo>
                    <a:pt x="180" y="13199"/>
                  </a:lnTo>
                  <a:lnTo>
                    <a:pt x="186" y="13375"/>
                  </a:lnTo>
                  <a:lnTo>
                    <a:pt x="192" y="13551"/>
                  </a:lnTo>
                  <a:lnTo>
                    <a:pt x="197" y="13727"/>
                  </a:lnTo>
                  <a:lnTo>
                    <a:pt x="203" y="13903"/>
                  </a:lnTo>
                  <a:lnTo>
                    <a:pt x="209" y="14079"/>
                  </a:lnTo>
                  <a:lnTo>
                    <a:pt x="215" y="14255"/>
                  </a:lnTo>
                  <a:lnTo>
                    <a:pt x="222" y="14431"/>
                  </a:lnTo>
                  <a:lnTo>
                    <a:pt x="228" y="14607"/>
                  </a:lnTo>
                  <a:lnTo>
                    <a:pt x="234" y="14783"/>
                  </a:lnTo>
                  <a:lnTo>
                    <a:pt x="241" y="14959"/>
                  </a:lnTo>
                  <a:lnTo>
                    <a:pt x="247" y="15135"/>
                  </a:lnTo>
                  <a:lnTo>
                    <a:pt x="254" y="15311"/>
                  </a:lnTo>
                  <a:lnTo>
                    <a:pt x="261" y="15487"/>
                  </a:lnTo>
                  <a:lnTo>
                    <a:pt x="267" y="15663"/>
                  </a:lnTo>
                  <a:lnTo>
                    <a:pt x="274" y="15839"/>
                  </a:lnTo>
                  <a:lnTo>
                    <a:pt x="281" y="16015"/>
                  </a:lnTo>
                  <a:lnTo>
                    <a:pt x="288" y="16191"/>
                  </a:lnTo>
                  <a:lnTo>
                    <a:pt x="295" y="16367"/>
                  </a:lnTo>
                  <a:lnTo>
                    <a:pt x="303" y="16543"/>
                  </a:lnTo>
                  <a:lnTo>
                    <a:pt x="310" y="16719"/>
                  </a:lnTo>
                  <a:lnTo>
                    <a:pt x="317" y="16895"/>
                  </a:lnTo>
                  <a:lnTo>
                    <a:pt x="325" y="17071"/>
                  </a:lnTo>
                  <a:lnTo>
                    <a:pt x="332" y="17247"/>
                  </a:lnTo>
                  <a:lnTo>
                    <a:pt x="340" y="17423"/>
                  </a:lnTo>
                  <a:lnTo>
                    <a:pt x="347" y="17599"/>
                  </a:lnTo>
                  <a:lnTo>
                    <a:pt x="355" y="17775"/>
                  </a:lnTo>
                  <a:lnTo>
                    <a:pt x="363" y="17951"/>
                  </a:lnTo>
                  <a:lnTo>
                    <a:pt x="371" y="18127"/>
                  </a:lnTo>
                  <a:lnTo>
                    <a:pt x="378" y="18303"/>
                  </a:lnTo>
                  <a:lnTo>
                    <a:pt x="386" y="18479"/>
                  </a:lnTo>
                  <a:lnTo>
                    <a:pt x="394" y="18655"/>
                  </a:lnTo>
                  <a:lnTo>
                    <a:pt x="402" y="18831"/>
                  </a:lnTo>
                  <a:lnTo>
                    <a:pt x="410" y="19007"/>
                  </a:lnTo>
                  <a:lnTo>
                    <a:pt x="418" y="19183"/>
                  </a:lnTo>
                  <a:lnTo>
                    <a:pt x="426" y="19359"/>
                  </a:lnTo>
                  <a:lnTo>
                    <a:pt x="434" y="19535"/>
                  </a:lnTo>
                  <a:lnTo>
                    <a:pt x="442" y="19711"/>
                  </a:lnTo>
                  <a:lnTo>
                    <a:pt x="450" y="19887"/>
                  </a:lnTo>
                  <a:lnTo>
                    <a:pt x="458" y="20063"/>
                  </a:lnTo>
                  <a:lnTo>
                    <a:pt x="466" y="20239"/>
                  </a:lnTo>
                  <a:lnTo>
                    <a:pt x="474" y="20415"/>
                  </a:lnTo>
                  <a:lnTo>
                    <a:pt x="482" y="20590"/>
                  </a:lnTo>
                  <a:lnTo>
                    <a:pt x="490" y="20766"/>
                  </a:lnTo>
                  <a:lnTo>
                    <a:pt x="498" y="20942"/>
                  </a:lnTo>
                  <a:lnTo>
                    <a:pt x="506" y="21118"/>
                  </a:lnTo>
                  <a:lnTo>
                    <a:pt x="514" y="21294"/>
                  </a:lnTo>
                  <a:lnTo>
                    <a:pt x="522" y="21470"/>
                  </a:lnTo>
                  <a:lnTo>
                    <a:pt x="530" y="21646"/>
                  </a:lnTo>
                  <a:lnTo>
                    <a:pt x="538" y="21822"/>
                  </a:lnTo>
                  <a:lnTo>
                    <a:pt x="545" y="21998"/>
                  </a:lnTo>
                  <a:lnTo>
                    <a:pt x="553" y="22174"/>
                  </a:lnTo>
                  <a:lnTo>
                    <a:pt x="561" y="22350"/>
                  </a:lnTo>
                  <a:lnTo>
                    <a:pt x="569" y="22526"/>
                  </a:lnTo>
                  <a:lnTo>
                    <a:pt x="576" y="22702"/>
                  </a:lnTo>
                  <a:lnTo>
                    <a:pt x="584" y="22878"/>
                  </a:lnTo>
                  <a:lnTo>
                    <a:pt x="591" y="23054"/>
                  </a:lnTo>
                  <a:lnTo>
                    <a:pt x="599" y="23230"/>
                  </a:lnTo>
                  <a:lnTo>
                    <a:pt x="606" y="23406"/>
                  </a:lnTo>
                  <a:lnTo>
                    <a:pt x="613" y="23582"/>
                  </a:lnTo>
                  <a:lnTo>
                    <a:pt x="620" y="23758"/>
                  </a:lnTo>
                  <a:lnTo>
                    <a:pt x="627" y="23934"/>
                  </a:lnTo>
                  <a:lnTo>
                    <a:pt x="634" y="24110"/>
                  </a:lnTo>
                  <a:lnTo>
                    <a:pt x="641" y="24286"/>
                  </a:lnTo>
                  <a:lnTo>
                    <a:pt x="648" y="24462"/>
                  </a:lnTo>
                  <a:lnTo>
                    <a:pt x="655" y="24638"/>
                  </a:lnTo>
                  <a:lnTo>
                    <a:pt x="661" y="24814"/>
                  </a:lnTo>
                  <a:lnTo>
                    <a:pt x="668" y="24990"/>
                  </a:lnTo>
                  <a:lnTo>
                    <a:pt x="674" y="25166"/>
                  </a:lnTo>
                  <a:lnTo>
                    <a:pt x="681" y="25342"/>
                  </a:lnTo>
                  <a:lnTo>
                    <a:pt x="687" y="25518"/>
                  </a:lnTo>
                  <a:lnTo>
                    <a:pt x="693" y="25694"/>
                  </a:lnTo>
                  <a:lnTo>
                    <a:pt x="699" y="25870"/>
                  </a:lnTo>
                  <a:lnTo>
                    <a:pt x="705" y="26046"/>
                  </a:lnTo>
                  <a:lnTo>
                    <a:pt x="711" y="26222"/>
                  </a:lnTo>
                  <a:lnTo>
                    <a:pt x="717" y="26398"/>
                  </a:lnTo>
                  <a:lnTo>
                    <a:pt x="722" y="26574"/>
                  </a:lnTo>
                  <a:lnTo>
                    <a:pt x="728" y="26750"/>
                  </a:lnTo>
                  <a:lnTo>
                    <a:pt x="733" y="26926"/>
                  </a:lnTo>
                  <a:lnTo>
                    <a:pt x="738" y="27102"/>
                  </a:lnTo>
                  <a:lnTo>
                    <a:pt x="743" y="27278"/>
                  </a:lnTo>
                  <a:lnTo>
                    <a:pt x="748" y="27454"/>
                  </a:lnTo>
                  <a:lnTo>
                    <a:pt x="753" y="27630"/>
                  </a:lnTo>
                  <a:lnTo>
                    <a:pt x="758" y="27806"/>
                  </a:lnTo>
                  <a:lnTo>
                    <a:pt x="763" y="27982"/>
                  </a:lnTo>
                  <a:lnTo>
                    <a:pt x="767" y="28158"/>
                  </a:lnTo>
                  <a:lnTo>
                    <a:pt x="772" y="28334"/>
                  </a:lnTo>
                  <a:lnTo>
                    <a:pt x="776" y="28510"/>
                  </a:lnTo>
                  <a:lnTo>
                    <a:pt x="780" y="28686"/>
                  </a:lnTo>
                  <a:lnTo>
                    <a:pt x="784" y="28862"/>
                  </a:lnTo>
                  <a:lnTo>
                    <a:pt x="788" y="29038"/>
                  </a:lnTo>
                  <a:lnTo>
                    <a:pt x="792" y="29214"/>
                  </a:lnTo>
                  <a:lnTo>
                    <a:pt x="796" y="29390"/>
                  </a:lnTo>
                  <a:lnTo>
                    <a:pt x="800" y="29566"/>
                  </a:lnTo>
                  <a:lnTo>
                    <a:pt x="803" y="29742"/>
                  </a:lnTo>
                  <a:lnTo>
                    <a:pt x="807" y="29918"/>
                  </a:lnTo>
                  <a:lnTo>
                    <a:pt x="810" y="30094"/>
                  </a:lnTo>
                  <a:lnTo>
                    <a:pt x="813" y="30270"/>
                  </a:lnTo>
                  <a:lnTo>
                    <a:pt x="816" y="30446"/>
                  </a:lnTo>
                  <a:lnTo>
                    <a:pt x="820" y="30622"/>
                  </a:lnTo>
                  <a:lnTo>
                    <a:pt x="823" y="30798"/>
                  </a:lnTo>
                  <a:lnTo>
                    <a:pt x="825" y="30974"/>
                  </a:lnTo>
                  <a:lnTo>
                    <a:pt x="828" y="31150"/>
                  </a:lnTo>
                  <a:lnTo>
                    <a:pt x="831" y="31326"/>
                  </a:lnTo>
                  <a:lnTo>
                    <a:pt x="834" y="31502"/>
                  </a:lnTo>
                  <a:lnTo>
                    <a:pt x="836" y="31678"/>
                  </a:lnTo>
                  <a:lnTo>
                    <a:pt x="839" y="31854"/>
                  </a:lnTo>
                  <a:lnTo>
                    <a:pt x="841" y="32030"/>
                  </a:lnTo>
                  <a:lnTo>
                    <a:pt x="843" y="32206"/>
                  </a:lnTo>
                  <a:lnTo>
                    <a:pt x="846" y="32382"/>
                  </a:lnTo>
                  <a:lnTo>
                    <a:pt x="848" y="32558"/>
                  </a:lnTo>
                  <a:lnTo>
                    <a:pt x="850" y="32734"/>
                  </a:lnTo>
                  <a:lnTo>
                    <a:pt x="852" y="32910"/>
                  </a:lnTo>
                  <a:lnTo>
                    <a:pt x="854" y="33086"/>
                  </a:lnTo>
                  <a:lnTo>
                    <a:pt x="856" y="33262"/>
                  </a:lnTo>
                  <a:lnTo>
                    <a:pt x="858" y="33438"/>
                  </a:lnTo>
                  <a:lnTo>
                    <a:pt x="860" y="33614"/>
                  </a:lnTo>
                  <a:lnTo>
                    <a:pt x="862" y="33790"/>
                  </a:lnTo>
                  <a:lnTo>
                    <a:pt x="863" y="33966"/>
                  </a:lnTo>
                  <a:lnTo>
                    <a:pt x="865" y="34142"/>
                  </a:lnTo>
                  <a:lnTo>
                    <a:pt x="867" y="34318"/>
                  </a:lnTo>
                  <a:lnTo>
                    <a:pt x="868" y="34494"/>
                  </a:lnTo>
                  <a:lnTo>
                    <a:pt x="870" y="34670"/>
                  </a:lnTo>
                  <a:lnTo>
                    <a:pt x="872" y="34846"/>
                  </a:lnTo>
                  <a:lnTo>
                    <a:pt x="873" y="35022"/>
                  </a:lnTo>
                  <a:lnTo>
                    <a:pt x="875" y="35198"/>
                  </a:lnTo>
                  <a:lnTo>
                    <a:pt x="876" y="35374"/>
                  </a:lnTo>
                  <a:lnTo>
                    <a:pt x="878" y="35550"/>
                  </a:lnTo>
                  <a:lnTo>
                    <a:pt x="879" y="35726"/>
                  </a:lnTo>
                  <a:lnTo>
                    <a:pt x="881" y="35902"/>
                  </a:lnTo>
                  <a:lnTo>
                    <a:pt x="882" y="36078"/>
                  </a:lnTo>
                  <a:lnTo>
                    <a:pt x="884" y="36254"/>
                  </a:lnTo>
                  <a:lnTo>
                    <a:pt x="885" y="36430"/>
                  </a:lnTo>
                  <a:lnTo>
                    <a:pt x="887" y="36606"/>
                  </a:lnTo>
                  <a:lnTo>
                    <a:pt x="888" y="36782"/>
                  </a:lnTo>
                  <a:lnTo>
                    <a:pt x="890" y="36958"/>
                  </a:lnTo>
                  <a:lnTo>
                    <a:pt x="891" y="37134"/>
                  </a:lnTo>
                  <a:lnTo>
                    <a:pt x="893" y="37310"/>
                  </a:lnTo>
                  <a:lnTo>
                    <a:pt x="894" y="37486"/>
                  </a:lnTo>
                  <a:lnTo>
                    <a:pt x="896" y="37662"/>
                  </a:lnTo>
                  <a:lnTo>
                    <a:pt x="897" y="37838"/>
                  </a:lnTo>
                  <a:lnTo>
                    <a:pt x="899" y="38014"/>
                  </a:lnTo>
                  <a:lnTo>
                    <a:pt x="901" y="38190"/>
                  </a:lnTo>
                  <a:lnTo>
                    <a:pt x="902" y="38366"/>
                  </a:lnTo>
                  <a:lnTo>
                    <a:pt x="904" y="38542"/>
                  </a:lnTo>
                  <a:lnTo>
                    <a:pt x="906" y="38718"/>
                  </a:lnTo>
                  <a:lnTo>
                    <a:pt x="907" y="38894"/>
                  </a:lnTo>
                  <a:lnTo>
                    <a:pt x="909" y="39070"/>
                  </a:lnTo>
                  <a:lnTo>
                    <a:pt x="911" y="39246"/>
                  </a:lnTo>
                  <a:lnTo>
                    <a:pt x="913" y="39422"/>
                  </a:lnTo>
                  <a:lnTo>
                    <a:pt x="915" y="39598"/>
                  </a:lnTo>
                  <a:lnTo>
                    <a:pt x="917" y="39774"/>
                  </a:lnTo>
                  <a:lnTo>
                    <a:pt x="919" y="39950"/>
                  </a:lnTo>
                  <a:lnTo>
                    <a:pt x="921" y="40126"/>
                  </a:lnTo>
                  <a:lnTo>
                    <a:pt x="924" y="40302"/>
                  </a:lnTo>
                  <a:lnTo>
                    <a:pt x="926" y="40478"/>
                  </a:lnTo>
                  <a:lnTo>
                    <a:pt x="928" y="40654"/>
                  </a:lnTo>
                  <a:lnTo>
                    <a:pt x="931" y="40830"/>
                  </a:lnTo>
                  <a:lnTo>
                    <a:pt x="933" y="41005"/>
                  </a:lnTo>
                  <a:lnTo>
                    <a:pt x="936" y="41181"/>
                  </a:lnTo>
                  <a:lnTo>
                    <a:pt x="938" y="41357"/>
                  </a:lnTo>
                  <a:lnTo>
                    <a:pt x="941" y="41533"/>
                  </a:lnTo>
                  <a:lnTo>
                    <a:pt x="944" y="41709"/>
                  </a:lnTo>
                  <a:lnTo>
                    <a:pt x="947" y="41885"/>
                  </a:lnTo>
                  <a:lnTo>
                    <a:pt x="950" y="42061"/>
                  </a:lnTo>
                  <a:lnTo>
                    <a:pt x="953" y="42237"/>
                  </a:lnTo>
                  <a:lnTo>
                    <a:pt x="957" y="42413"/>
                  </a:lnTo>
                  <a:lnTo>
                    <a:pt x="960" y="42589"/>
                  </a:lnTo>
                  <a:lnTo>
                    <a:pt x="964" y="42765"/>
                  </a:lnTo>
                  <a:lnTo>
                    <a:pt x="967" y="42941"/>
                  </a:lnTo>
                  <a:lnTo>
                    <a:pt x="971" y="43117"/>
                  </a:lnTo>
                  <a:lnTo>
                    <a:pt x="975" y="43293"/>
                  </a:lnTo>
                  <a:lnTo>
                    <a:pt x="979" y="43469"/>
                  </a:lnTo>
                  <a:lnTo>
                    <a:pt x="983" y="43645"/>
                  </a:lnTo>
                  <a:lnTo>
                    <a:pt x="988" y="43821"/>
                  </a:lnTo>
                  <a:lnTo>
                    <a:pt x="992" y="43997"/>
                  </a:lnTo>
                  <a:lnTo>
                    <a:pt x="997" y="44173"/>
                  </a:lnTo>
                  <a:lnTo>
                    <a:pt x="1002" y="44349"/>
                  </a:lnTo>
                  <a:lnTo>
                    <a:pt x="1007" y="44525"/>
                  </a:lnTo>
                  <a:lnTo>
                    <a:pt x="1012" y="44701"/>
                  </a:lnTo>
                  <a:lnTo>
                    <a:pt x="1017" y="44877"/>
                  </a:lnTo>
                  <a:lnTo>
                    <a:pt x="1022" y="45053"/>
                  </a:lnTo>
                  <a:lnTo>
                    <a:pt x="1028" y="45229"/>
                  </a:lnTo>
                  <a:lnTo>
                    <a:pt x="1034" y="45405"/>
                  </a:lnTo>
                  <a:lnTo>
                    <a:pt x="1040" y="45581"/>
                  </a:lnTo>
                  <a:lnTo>
                    <a:pt x="1046" y="45757"/>
                  </a:lnTo>
                  <a:lnTo>
                    <a:pt x="1053" y="45933"/>
                  </a:lnTo>
                  <a:lnTo>
                    <a:pt x="1059" y="46109"/>
                  </a:lnTo>
                  <a:lnTo>
                    <a:pt x="1066" y="46285"/>
                  </a:lnTo>
                  <a:lnTo>
                    <a:pt x="1073" y="46461"/>
                  </a:lnTo>
                  <a:lnTo>
                    <a:pt x="1080" y="46637"/>
                  </a:lnTo>
                  <a:lnTo>
                    <a:pt x="1087" y="46813"/>
                  </a:lnTo>
                  <a:lnTo>
                    <a:pt x="1095" y="46989"/>
                  </a:lnTo>
                  <a:lnTo>
                    <a:pt x="1103" y="47165"/>
                  </a:lnTo>
                  <a:lnTo>
                    <a:pt x="1111" y="47341"/>
                  </a:lnTo>
                  <a:lnTo>
                    <a:pt x="1119" y="47517"/>
                  </a:lnTo>
                  <a:lnTo>
                    <a:pt x="1127" y="47693"/>
                  </a:lnTo>
                  <a:lnTo>
                    <a:pt x="1136" y="47869"/>
                  </a:lnTo>
                  <a:lnTo>
                    <a:pt x="1145" y="48045"/>
                  </a:lnTo>
                  <a:lnTo>
                    <a:pt x="1154" y="48221"/>
                  </a:lnTo>
                  <a:lnTo>
                    <a:pt x="1163" y="48397"/>
                  </a:lnTo>
                  <a:lnTo>
                    <a:pt x="1172" y="48573"/>
                  </a:lnTo>
                  <a:lnTo>
                    <a:pt x="1182" y="48749"/>
                  </a:lnTo>
                  <a:lnTo>
                    <a:pt x="1192" y="48925"/>
                  </a:lnTo>
                  <a:lnTo>
                    <a:pt x="1202" y="49101"/>
                  </a:lnTo>
                  <a:lnTo>
                    <a:pt x="1212" y="49277"/>
                  </a:lnTo>
                  <a:lnTo>
                    <a:pt x="1223" y="49453"/>
                  </a:lnTo>
                  <a:lnTo>
                    <a:pt x="1233" y="49629"/>
                  </a:lnTo>
                  <a:lnTo>
                    <a:pt x="1244" y="49805"/>
                  </a:lnTo>
                  <a:lnTo>
                    <a:pt x="1255" y="49981"/>
                  </a:lnTo>
                  <a:lnTo>
                    <a:pt x="1266" y="50157"/>
                  </a:lnTo>
                  <a:lnTo>
                    <a:pt x="1278" y="50333"/>
                  </a:lnTo>
                  <a:lnTo>
                    <a:pt x="1289" y="50509"/>
                  </a:lnTo>
                  <a:lnTo>
                    <a:pt x="1301" y="50685"/>
                  </a:lnTo>
                  <a:lnTo>
                    <a:pt x="1313" y="50861"/>
                  </a:lnTo>
                  <a:lnTo>
                    <a:pt x="1325" y="51037"/>
                  </a:lnTo>
                  <a:lnTo>
                    <a:pt x="1337" y="51213"/>
                  </a:lnTo>
                  <a:lnTo>
                    <a:pt x="1350" y="51389"/>
                  </a:lnTo>
                  <a:lnTo>
                    <a:pt x="1362" y="51565"/>
                  </a:lnTo>
                  <a:lnTo>
                    <a:pt x="1375" y="51741"/>
                  </a:lnTo>
                  <a:lnTo>
                    <a:pt x="1388" y="51917"/>
                  </a:lnTo>
                  <a:lnTo>
                    <a:pt x="1401" y="52093"/>
                  </a:lnTo>
                  <a:lnTo>
                    <a:pt x="1413" y="52269"/>
                  </a:lnTo>
                  <a:lnTo>
                    <a:pt x="1427" y="52445"/>
                  </a:lnTo>
                  <a:lnTo>
                    <a:pt x="1440" y="52621"/>
                  </a:lnTo>
                  <a:lnTo>
                    <a:pt x="1453" y="52797"/>
                  </a:lnTo>
                  <a:lnTo>
                    <a:pt x="1466" y="52973"/>
                  </a:lnTo>
                  <a:lnTo>
                    <a:pt x="1480" y="53149"/>
                  </a:lnTo>
                  <a:lnTo>
                    <a:pt x="1493" y="53325"/>
                  </a:lnTo>
                  <a:lnTo>
                    <a:pt x="1506" y="53501"/>
                  </a:lnTo>
                  <a:lnTo>
                    <a:pt x="1520" y="53677"/>
                  </a:lnTo>
                  <a:lnTo>
                    <a:pt x="1533" y="53853"/>
                  </a:lnTo>
                  <a:lnTo>
                    <a:pt x="1547" y="54029"/>
                  </a:lnTo>
                  <a:lnTo>
                    <a:pt x="1560" y="54205"/>
                  </a:lnTo>
                  <a:lnTo>
                    <a:pt x="1573" y="54381"/>
                  </a:lnTo>
                  <a:lnTo>
                    <a:pt x="1587" y="54557"/>
                  </a:lnTo>
                  <a:lnTo>
                    <a:pt x="1600" y="54733"/>
                  </a:lnTo>
                  <a:lnTo>
                    <a:pt x="1613" y="54909"/>
                  </a:lnTo>
                  <a:lnTo>
                    <a:pt x="1626" y="55085"/>
                  </a:lnTo>
                  <a:lnTo>
                    <a:pt x="1639" y="55261"/>
                  </a:lnTo>
                  <a:lnTo>
                    <a:pt x="1652" y="55437"/>
                  </a:lnTo>
                  <a:lnTo>
                    <a:pt x="1664" y="55613"/>
                  </a:lnTo>
                  <a:lnTo>
                    <a:pt x="1677" y="55789"/>
                  </a:lnTo>
                  <a:lnTo>
                    <a:pt x="1689" y="55965"/>
                  </a:lnTo>
                  <a:lnTo>
                    <a:pt x="1701" y="56141"/>
                  </a:lnTo>
                  <a:lnTo>
                    <a:pt x="1713" y="56317"/>
                  </a:lnTo>
                  <a:lnTo>
                    <a:pt x="1725" y="56493"/>
                  </a:lnTo>
                  <a:lnTo>
                    <a:pt x="1737" y="56669"/>
                  </a:lnTo>
                  <a:lnTo>
                    <a:pt x="1748" y="56845"/>
                  </a:lnTo>
                  <a:lnTo>
                    <a:pt x="1759" y="57021"/>
                  </a:lnTo>
                  <a:lnTo>
                    <a:pt x="1769" y="57197"/>
                  </a:lnTo>
                  <a:lnTo>
                    <a:pt x="1780" y="57373"/>
                  </a:lnTo>
                  <a:lnTo>
                    <a:pt x="1790" y="57549"/>
                  </a:lnTo>
                  <a:lnTo>
                    <a:pt x="1799" y="57725"/>
                  </a:lnTo>
                  <a:lnTo>
                    <a:pt x="1809" y="57901"/>
                  </a:lnTo>
                  <a:lnTo>
                    <a:pt x="1818" y="58077"/>
                  </a:lnTo>
                  <a:lnTo>
                    <a:pt x="1827" y="58253"/>
                  </a:lnTo>
                  <a:lnTo>
                    <a:pt x="1835" y="58429"/>
                  </a:lnTo>
                  <a:lnTo>
                    <a:pt x="1843" y="58605"/>
                  </a:lnTo>
                  <a:lnTo>
                    <a:pt x="1850" y="58781"/>
                  </a:lnTo>
                  <a:lnTo>
                    <a:pt x="1857" y="58957"/>
                  </a:lnTo>
                  <a:lnTo>
                    <a:pt x="1864" y="59133"/>
                  </a:lnTo>
                  <a:lnTo>
                    <a:pt x="1870" y="59309"/>
                  </a:lnTo>
                  <a:lnTo>
                    <a:pt x="1876" y="59485"/>
                  </a:lnTo>
                  <a:lnTo>
                    <a:pt x="1881" y="59661"/>
                  </a:lnTo>
                  <a:lnTo>
                    <a:pt x="1886" y="59837"/>
                  </a:lnTo>
                  <a:lnTo>
                    <a:pt x="1890" y="60013"/>
                  </a:lnTo>
                  <a:lnTo>
                    <a:pt x="1894" y="60189"/>
                  </a:lnTo>
                  <a:lnTo>
                    <a:pt x="1897" y="60365"/>
                  </a:lnTo>
                  <a:lnTo>
                    <a:pt x="1900" y="60541"/>
                  </a:lnTo>
                  <a:lnTo>
                    <a:pt x="1902" y="60717"/>
                  </a:lnTo>
                  <a:lnTo>
                    <a:pt x="1904" y="60893"/>
                  </a:lnTo>
                  <a:lnTo>
                    <a:pt x="1905" y="61069"/>
                  </a:lnTo>
                  <a:lnTo>
                    <a:pt x="1905" y="61245"/>
                  </a:lnTo>
                  <a:lnTo>
                    <a:pt x="1905" y="61421"/>
                  </a:lnTo>
                  <a:lnTo>
                    <a:pt x="1905" y="61596"/>
                  </a:lnTo>
                  <a:lnTo>
                    <a:pt x="1904" y="61772"/>
                  </a:lnTo>
                  <a:lnTo>
                    <a:pt x="1902" y="61948"/>
                  </a:lnTo>
                  <a:lnTo>
                    <a:pt x="1900" y="62124"/>
                  </a:lnTo>
                  <a:lnTo>
                    <a:pt x="1897" y="62300"/>
                  </a:lnTo>
                  <a:lnTo>
                    <a:pt x="1894" y="62476"/>
                  </a:lnTo>
                  <a:lnTo>
                    <a:pt x="1890" y="62652"/>
                  </a:lnTo>
                  <a:lnTo>
                    <a:pt x="1885" y="62828"/>
                  </a:lnTo>
                  <a:lnTo>
                    <a:pt x="1880" y="63004"/>
                  </a:lnTo>
                  <a:lnTo>
                    <a:pt x="1874" y="63180"/>
                  </a:lnTo>
                  <a:lnTo>
                    <a:pt x="1868" y="63356"/>
                  </a:lnTo>
                  <a:lnTo>
                    <a:pt x="1861" y="63532"/>
                  </a:lnTo>
                  <a:lnTo>
                    <a:pt x="1854" y="63708"/>
                  </a:lnTo>
                  <a:lnTo>
                    <a:pt x="1846" y="63884"/>
                  </a:lnTo>
                  <a:lnTo>
                    <a:pt x="1838" y="64060"/>
                  </a:lnTo>
                  <a:lnTo>
                    <a:pt x="1829" y="64236"/>
                  </a:lnTo>
                  <a:lnTo>
                    <a:pt x="1819" y="64412"/>
                  </a:lnTo>
                  <a:lnTo>
                    <a:pt x="1809" y="64588"/>
                  </a:lnTo>
                  <a:lnTo>
                    <a:pt x="1798" y="64764"/>
                  </a:lnTo>
                  <a:lnTo>
                    <a:pt x="1787" y="64940"/>
                  </a:lnTo>
                  <a:lnTo>
                    <a:pt x="1775" y="65116"/>
                  </a:lnTo>
                  <a:lnTo>
                    <a:pt x="1763" y="65292"/>
                  </a:lnTo>
                  <a:lnTo>
                    <a:pt x="1750" y="65468"/>
                  </a:lnTo>
                  <a:lnTo>
                    <a:pt x="1737" y="65644"/>
                  </a:lnTo>
                  <a:lnTo>
                    <a:pt x="1723" y="65820"/>
                  </a:lnTo>
                  <a:lnTo>
                    <a:pt x="1709" y="65996"/>
                  </a:lnTo>
                  <a:lnTo>
                    <a:pt x="1695" y="66172"/>
                  </a:lnTo>
                  <a:lnTo>
                    <a:pt x="1680" y="66348"/>
                  </a:lnTo>
                  <a:lnTo>
                    <a:pt x="1664" y="66524"/>
                  </a:lnTo>
                  <a:lnTo>
                    <a:pt x="1648" y="66700"/>
                  </a:lnTo>
                  <a:lnTo>
                    <a:pt x="1632" y="66876"/>
                  </a:lnTo>
                  <a:lnTo>
                    <a:pt x="1615" y="67052"/>
                  </a:lnTo>
                  <a:lnTo>
                    <a:pt x="1598" y="67228"/>
                  </a:lnTo>
                  <a:lnTo>
                    <a:pt x="1581" y="67404"/>
                  </a:lnTo>
                  <a:lnTo>
                    <a:pt x="1563" y="67580"/>
                  </a:lnTo>
                  <a:lnTo>
                    <a:pt x="1545" y="67756"/>
                  </a:lnTo>
                  <a:lnTo>
                    <a:pt x="1527" y="67932"/>
                  </a:lnTo>
                  <a:lnTo>
                    <a:pt x="1508" y="68108"/>
                  </a:lnTo>
                  <a:lnTo>
                    <a:pt x="1489" y="68284"/>
                  </a:lnTo>
                  <a:lnTo>
                    <a:pt x="1470" y="68460"/>
                  </a:lnTo>
                  <a:lnTo>
                    <a:pt x="1450" y="68636"/>
                  </a:lnTo>
                  <a:lnTo>
                    <a:pt x="1430" y="68812"/>
                  </a:lnTo>
                  <a:lnTo>
                    <a:pt x="1410" y="68988"/>
                  </a:lnTo>
                  <a:lnTo>
                    <a:pt x="1390" y="69164"/>
                  </a:lnTo>
                  <a:lnTo>
                    <a:pt x="1370" y="69340"/>
                  </a:lnTo>
                  <a:lnTo>
                    <a:pt x="1349" y="69516"/>
                  </a:lnTo>
                  <a:lnTo>
                    <a:pt x="1328" y="69692"/>
                  </a:lnTo>
                  <a:lnTo>
                    <a:pt x="1308" y="69868"/>
                  </a:lnTo>
                  <a:lnTo>
                    <a:pt x="1287" y="70044"/>
                  </a:lnTo>
                  <a:lnTo>
                    <a:pt x="1266" y="70220"/>
                  </a:lnTo>
                  <a:lnTo>
                    <a:pt x="1244" y="70396"/>
                  </a:lnTo>
                  <a:lnTo>
                    <a:pt x="1223" y="70572"/>
                  </a:lnTo>
                  <a:lnTo>
                    <a:pt x="1202" y="70748"/>
                  </a:lnTo>
                  <a:lnTo>
                    <a:pt x="1180" y="70924"/>
                  </a:lnTo>
                  <a:lnTo>
                    <a:pt x="1159" y="71100"/>
                  </a:lnTo>
                  <a:lnTo>
                    <a:pt x="1138" y="71276"/>
                  </a:lnTo>
                  <a:lnTo>
                    <a:pt x="1116" y="71452"/>
                  </a:lnTo>
                  <a:lnTo>
                    <a:pt x="1095" y="71628"/>
                  </a:lnTo>
                  <a:lnTo>
                    <a:pt x="1073" y="71804"/>
                  </a:lnTo>
                  <a:lnTo>
                    <a:pt x="1052" y="71980"/>
                  </a:lnTo>
                  <a:lnTo>
                    <a:pt x="1031" y="72156"/>
                  </a:lnTo>
                  <a:lnTo>
                    <a:pt x="1010" y="72332"/>
                  </a:lnTo>
                  <a:lnTo>
                    <a:pt x="988" y="72508"/>
                  </a:lnTo>
                  <a:lnTo>
                    <a:pt x="967" y="72684"/>
                  </a:lnTo>
                  <a:lnTo>
                    <a:pt x="946" y="72860"/>
                  </a:lnTo>
                  <a:lnTo>
                    <a:pt x="926" y="73036"/>
                  </a:lnTo>
                  <a:lnTo>
                    <a:pt x="905" y="73212"/>
                  </a:lnTo>
                  <a:lnTo>
                    <a:pt x="884" y="73388"/>
                  </a:lnTo>
                  <a:lnTo>
                    <a:pt x="864" y="73564"/>
                  </a:lnTo>
                  <a:lnTo>
                    <a:pt x="844" y="73740"/>
                  </a:lnTo>
                  <a:lnTo>
                    <a:pt x="824" y="73916"/>
                  </a:lnTo>
                  <a:lnTo>
                    <a:pt x="804" y="74092"/>
                  </a:lnTo>
                  <a:lnTo>
                    <a:pt x="784" y="74268"/>
                  </a:lnTo>
                  <a:lnTo>
                    <a:pt x="765" y="74444"/>
                  </a:lnTo>
                  <a:lnTo>
                    <a:pt x="746" y="74620"/>
                  </a:lnTo>
                  <a:lnTo>
                    <a:pt x="727" y="74796"/>
                  </a:lnTo>
                  <a:lnTo>
                    <a:pt x="708" y="74972"/>
                  </a:lnTo>
                  <a:lnTo>
                    <a:pt x="689" y="75148"/>
                  </a:lnTo>
                  <a:lnTo>
                    <a:pt x="671" y="75324"/>
                  </a:lnTo>
                  <a:lnTo>
                    <a:pt x="653" y="75500"/>
                  </a:lnTo>
                  <a:lnTo>
                    <a:pt x="635" y="75676"/>
                  </a:lnTo>
                  <a:lnTo>
                    <a:pt x="618" y="75852"/>
                  </a:lnTo>
                  <a:lnTo>
                    <a:pt x="601" y="76028"/>
                  </a:lnTo>
                  <a:lnTo>
                    <a:pt x="584" y="76204"/>
                  </a:lnTo>
                  <a:lnTo>
                    <a:pt x="567" y="76380"/>
                  </a:lnTo>
                  <a:lnTo>
                    <a:pt x="550" y="76556"/>
                  </a:lnTo>
                  <a:lnTo>
                    <a:pt x="534" y="76732"/>
                  </a:lnTo>
                  <a:lnTo>
                    <a:pt x="518" y="76908"/>
                  </a:lnTo>
                  <a:lnTo>
                    <a:pt x="503" y="77084"/>
                  </a:lnTo>
                  <a:lnTo>
                    <a:pt x="488" y="77260"/>
                  </a:lnTo>
                  <a:lnTo>
                    <a:pt x="473" y="77436"/>
                  </a:lnTo>
                  <a:lnTo>
                    <a:pt x="458" y="77612"/>
                  </a:lnTo>
                  <a:lnTo>
                    <a:pt x="443" y="77788"/>
                  </a:lnTo>
                  <a:lnTo>
                    <a:pt x="429" y="77964"/>
                  </a:lnTo>
                  <a:lnTo>
                    <a:pt x="416" y="78140"/>
                  </a:lnTo>
                  <a:lnTo>
                    <a:pt x="402" y="78316"/>
                  </a:lnTo>
                  <a:lnTo>
                    <a:pt x="389" y="78492"/>
                  </a:lnTo>
                  <a:lnTo>
                    <a:pt x="376" y="78668"/>
                  </a:lnTo>
                  <a:lnTo>
                    <a:pt x="363" y="78844"/>
                  </a:lnTo>
                  <a:lnTo>
                    <a:pt x="351" y="79020"/>
                  </a:lnTo>
                  <a:lnTo>
                    <a:pt x="339" y="79196"/>
                  </a:lnTo>
                  <a:lnTo>
                    <a:pt x="327" y="79372"/>
                  </a:lnTo>
                  <a:lnTo>
                    <a:pt x="316" y="79548"/>
                  </a:lnTo>
                  <a:lnTo>
                    <a:pt x="305" y="79724"/>
                  </a:lnTo>
                  <a:lnTo>
                    <a:pt x="294" y="79900"/>
                  </a:lnTo>
                  <a:lnTo>
                    <a:pt x="283" y="80076"/>
                  </a:lnTo>
                  <a:lnTo>
                    <a:pt x="273" y="80252"/>
                  </a:lnTo>
                  <a:lnTo>
                    <a:pt x="263" y="80428"/>
                  </a:lnTo>
                  <a:lnTo>
                    <a:pt x="253" y="80604"/>
                  </a:lnTo>
                  <a:lnTo>
                    <a:pt x="244" y="80780"/>
                  </a:lnTo>
                  <a:lnTo>
                    <a:pt x="235" y="80956"/>
                  </a:lnTo>
                  <a:lnTo>
                    <a:pt x="226" y="81132"/>
                  </a:lnTo>
                  <a:lnTo>
                    <a:pt x="217" y="81308"/>
                  </a:lnTo>
                  <a:lnTo>
                    <a:pt x="209" y="81484"/>
                  </a:lnTo>
                  <a:lnTo>
                    <a:pt x="200" y="81660"/>
                  </a:lnTo>
                  <a:lnTo>
                    <a:pt x="192" y="81836"/>
                  </a:lnTo>
                  <a:lnTo>
                    <a:pt x="185" y="82011"/>
                  </a:lnTo>
                  <a:lnTo>
                    <a:pt x="177" y="82187"/>
                  </a:lnTo>
                  <a:lnTo>
                    <a:pt x="170" y="82363"/>
                  </a:lnTo>
                  <a:lnTo>
                    <a:pt x="163" y="82539"/>
                  </a:lnTo>
                  <a:lnTo>
                    <a:pt x="156" y="82715"/>
                  </a:lnTo>
                  <a:lnTo>
                    <a:pt x="150" y="82891"/>
                  </a:lnTo>
                  <a:lnTo>
                    <a:pt x="144" y="83067"/>
                  </a:lnTo>
                  <a:lnTo>
                    <a:pt x="137" y="83243"/>
                  </a:lnTo>
                  <a:lnTo>
                    <a:pt x="132" y="83419"/>
                  </a:lnTo>
                  <a:lnTo>
                    <a:pt x="126" y="83595"/>
                  </a:lnTo>
                  <a:lnTo>
                    <a:pt x="121" y="83771"/>
                  </a:lnTo>
                  <a:lnTo>
                    <a:pt x="115" y="83947"/>
                  </a:lnTo>
                  <a:lnTo>
                    <a:pt x="110" y="84123"/>
                  </a:lnTo>
                  <a:lnTo>
                    <a:pt x="105" y="84299"/>
                  </a:lnTo>
                  <a:lnTo>
                    <a:pt x="101" y="84475"/>
                  </a:lnTo>
                  <a:lnTo>
                    <a:pt x="96" y="84651"/>
                  </a:lnTo>
                  <a:lnTo>
                    <a:pt x="92" y="84827"/>
                  </a:lnTo>
                  <a:lnTo>
                    <a:pt x="87" y="85003"/>
                  </a:lnTo>
                  <a:lnTo>
                    <a:pt x="83" y="85179"/>
                  </a:lnTo>
                  <a:lnTo>
                    <a:pt x="79" y="85355"/>
                  </a:lnTo>
                  <a:lnTo>
                    <a:pt x="76" y="85531"/>
                  </a:lnTo>
                  <a:lnTo>
                    <a:pt x="72" y="85707"/>
                  </a:lnTo>
                  <a:lnTo>
                    <a:pt x="69" y="85883"/>
                  </a:lnTo>
                  <a:lnTo>
                    <a:pt x="65" y="86059"/>
                  </a:lnTo>
                  <a:lnTo>
                    <a:pt x="62" y="86235"/>
                  </a:lnTo>
                  <a:lnTo>
                    <a:pt x="59" y="86411"/>
                  </a:lnTo>
                  <a:lnTo>
                    <a:pt x="56" y="86587"/>
                  </a:lnTo>
                  <a:lnTo>
                    <a:pt x="53" y="86763"/>
                  </a:lnTo>
                  <a:lnTo>
                    <a:pt x="51" y="86939"/>
                  </a:lnTo>
                  <a:lnTo>
                    <a:pt x="48" y="87115"/>
                  </a:lnTo>
                  <a:lnTo>
                    <a:pt x="46" y="87291"/>
                  </a:lnTo>
                  <a:lnTo>
                    <a:pt x="43" y="87467"/>
                  </a:lnTo>
                  <a:lnTo>
                    <a:pt x="41" y="87643"/>
                  </a:lnTo>
                  <a:lnTo>
                    <a:pt x="39" y="87819"/>
                  </a:lnTo>
                  <a:lnTo>
                    <a:pt x="37" y="87995"/>
                  </a:lnTo>
                  <a:lnTo>
                    <a:pt x="35" y="88171"/>
                  </a:lnTo>
                  <a:lnTo>
                    <a:pt x="33" y="88347"/>
                  </a:lnTo>
                  <a:lnTo>
                    <a:pt x="31" y="88523"/>
                  </a:lnTo>
                  <a:lnTo>
                    <a:pt x="30" y="88699"/>
                  </a:lnTo>
                  <a:lnTo>
                    <a:pt x="28" y="88875"/>
                  </a:lnTo>
                  <a:lnTo>
                    <a:pt x="27" y="89051"/>
                  </a:lnTo>
                  <a:lnTo>
                    <a:pt x="25" y="89227"/>
                  </a:lnTo>
                  <a:lnTo>
                    <a:pt x="24" y="89403"/>
                  </a:lnTo>
                  <a:lnTo>
                    <a:pt x="22" y="89579"/>
                  </a:lnTo>
                  <a:lnTo>
                    <a:pt x="21" y="89755"/>
                  </a:lnTo>
                  <a:lnTo>
                    <a:pt x="20" y="89931"/>
                  </a:lnTo>
                  <a:lnTo>
                    <a:pt x="0" y="89931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34" name="pl16"/>
            <p:cNvSpPr/>
            <p:nvPr/>
          </p:nvSpPr>
          <p:spPr>
            <a:xfrm>
              <a:off x="2271228" y="3183857"/>
              <a:ext cx="234" cy="903353"/>
            </a:xfrm>
            <a:custGeom>
              <a:avLst/>
              <a:gdLst/>
              <a:ahLst/>
              <a:cxnLst/>
              <a:rect l="0" t="0" r="0" b="0"/>
              <a:pathLst>
                <a:path w="234" h="903353">
                  <a:moveTo>
                    <a:pt x="234" y="903353"/>
                  </a:moveTo>
                  <a:lnTo>
                    <a:pt x="231" y="903353"/>
                  </a:lnTo>
                  <a:lnTo>
                    <a:pt x="231" y="901585"/>
                  </a:lnTo>
                  <a:lnTo>
                    <a:pt x="231" y="899817"/>
                  </a:lnTo>
                  <a:lnTo>
                    <a:pt x="231" y="898049"/>
                  </a:lnTo>
                  <a:lnTo>
                    <a:pt x="231" y="896281"/>
                  </a:lnTo>
                  <a:lnTo>
                    <a:pt x="230" y="894513"/>
                  </a:lnTo>
                  <a:lnTo>
                    <a:pt x="230" y="892746"/>
                  </a:lnTo>
                  <a:lnTo>
                    <a:pt x="230" y="890978"/>
                  </a:lnTo>
                  <a:lnTo>
                    <a:pt x="230" y="889210"/>
                  </a:lnTo>
                  <a:lnTo>
                    <a:pt x="230" y="887442"/>
                  </a:lnTo>
                  <a:lnTo>
                    <a:pt x="229" y="885674"/>
                  </a:lnTo>
                  <a:lnTo>
                    <a:pt x="229" y="883907"/>
                  </a:lnTo>
                  <a:lnTo>
                    <a:pt x="229" y="882139"/>
                  </a:lnTo>
                  <a:lnTo>
                    <a:pt x="229" y="880371"/>
                  </a:lnTo>
                  <a:lnTo>
                    <a:pt x="228" y="878603"/>
                  </a:lnTo>
                  <a:lnTo>
                    <a:pt x="228" y="876835"/>
                  </a:lnTo>
                  <a:lnTo>
                    <a:pt x="228" y="875067"/>
                  </a:lnTo>
                  <a:lnTo>
                    <a:pt x="227" y="873300"/>
                  </a:lnTo>
                  <a:lnTo>
                    <a:pt x="227" y="871532"/>
                  </a:lnTo>
                  <a:lnTo>
                    <a:pt x="227" y="869764"/>
                  </a:lnTo>
                  <a:lnTo>
                    <a:pt x="226" y="867996"/>
                  </a:lnTo>
                  <a:lnTo>
                    <a:pt x="226" y="866228"/>
                  </a:lnTo>
                  <a:lnTo>
                    <a:pt x="226" y="864461"/>
                  </a:lnTo>
                  <a:lnTo>
                    <a:pt x="225" y="862693"/>
                  </a:lnTo>
                  <a:lnTo>
                    <a:pt x="225" y="860925"/>
                  </a:lnTo>
                  <a:lnTo>
                    <a:pt x="224" y="859157"/>
                  </a:lnTo>
                  <a:lnTo>
                    <a:pt x="224" y="857389"/>
                  </a:lnTo>
                  <a:lnTo>
                    <a:pt x="224" y="855622"/>
                  </a:lnTo>
                  <a:lnTo>
                    <a:pt x="223" y="853854"/>
                  </a:lnTo>
                  <a:lnTo>
                    <a:pt x="223" y="852086"/>
                  </a:lnTo>
                  <a:lnTo>
                    <a:pt x="222" y="850318"/>
                  </a:lnTo>
                  <a:lnTo>
                    <a:pt x="221" y="848550"/>
                  </a:lnTo>
                  <a:lnTo>
                    <a:pt x="221" y="846782"/>
                  </a:lnTo>
                  <a:lnTo>
                    <a:pt x="220" y="845015"/>
                  </a:lnTo>
                  <a:lnTo>
                    <a:pt x="220" y="843247"/>
                  </a:lnTo>
                  <a:lnTo>
                    <a:pt x="219" y="841479"/>
                  </a:lnTo>
                  <a:lnTo>
                    <a:pt x="218" y="839711"/>
                  </a:lnTo>
                  <a:lnTo>
                    <a:pt x="218" y="837943"/>
                  </a:lnTo>
                  <a:lnTo>
                    <a:pt x="217" y="836176"/>
                  </a:lnTo>
                  <a:lnTo>
                    <a:pt x="216" y="834408"/>
                  </a:lnTo>
                  <a:lnTo>
                    <a:pt x="216" y="832640"/>
                  </a:lnTo>
                  <a:lnTo>
                    <a:pt x="215" y="830872"/>
                  </a:lnTo>
                  <a:lnTo>
                    <a:pt x="214" y="829104"/>
                  </a:lnTo>
                  <a:lnTo>
                    <a:pt x="213" y="827337"/>
                  </a:lnTo>
                  <a:lnTo>
                    <a:pt x="212" y="825569"/>
                  </a:lnTo>
                  <a:lnTo>
                    <a:pt x="211" y="823801"/>
                  </a:lnTo>
                  <a:lnTo>
                    <a:pt x="211" y="822033"/>
                  </a:lnTo>
                  <a:lnTo>
                    <a:pt x="210" y="820265"/>
                  </a:lnTo>
                  <a:lnTo>
                    <a:pt x="209" y="818497"/>
                  </a:lnTo>
                  <a:lnTo>
                    <a:pt x="208" y="816730"/>
                  </a:lnTo>
                  <a:lnTo>
                    <a:pt x="207" y="814962"/>
                  </a:lnTo>
                  <a:lnTo>
                    <a:pt x="206" y="813194"/>
                  </a:lnTo>
                  <a:lnTo>
                    <a:pt x="204" y="811426"/>
                  </a:lnTo>
                  <a:lnTo>
                    <a:pt x="203" y="809658"/>
                  </a:lnTo>
                  <a:lnTo>
                    <a:pt x="202" y="807891"/>
                  </a:lnTo>
                  <a:lnTo>
                    <a:pt x="201" y="806123"/>
                  </a:lnTo>
                  <a:lnTo>
                    <a:pt x="200" y="804355"/>
                  </a:lnTo>
                  <a:lnTo>
                    <a:pt x="199" y="802587"/>
                  </a:lnTo>
                  <a:lnTo>
                    <a:pt x="197" y="800819"/>
                  </a:lnTo>
                  <a:lnTo>
                    <a:pt x="196" y="799051"/>
                  </a:lnTo>
                  <a:lnTo>
                    <a:pt x="195" y="797284"/>
                  </a:lnTo>
                  <a:lnTo>
                    <a:pt x="193" y="795516"/>
                  </a:lnTo>
                  <a:lnTo>
                    <a:pt x="192" y="793748"/>
                  </a:lnTo>
                  <a:lnTo>
                    <a:pt x="190" y="791980"/>
                  </a:lnTo>
                  <a:lnTo>
                    <a:pt x="189" y="790212"/>
                  </a:lnTo>
                  <a:lnTo>
                    <a:pt x="187" y="788445"/>
                  </a:lnTo>
                  <a:lnTo>
                    <a:pt x="186" y="786677"/>
                  </a:lnTo>
                  <a:lnTo>
                    <a:pt x="184" y="784909"/>
                  </a:lnTo>
                  <a:lnTo>
                    <a:pt x="183" y="783141"/>
                  </a:lnTo>
                  <a:lnTo>
                    <a:pt x="181" y="781373"/>
                  </a:lnTo>
                  <a:lnTo>
                    <a:pt x="179" y="779606"/>
                  </a:lnTo>
                  <a:lnTo>
                    <a:pt x="177" y="777838"/>
                  </a:lnTo>
                  <a:lnTo>
                    <a:pt x="176" y="776070"/>
                  </a:lnTo>
                  <a:lnTo>
                    <a:pt x="174" y="774302"/>
                  </a:lnTo>
                  <a:lnTo>
                    <a:pt x="172" y="772534"/>
                  </a:lnTo>
                  <a:lnTo>
                    <a:pt x="170" y="770766"/>
                  </a:lnTo>
                  <a:lnTo>
                    <a:pt x="168" y="768999"/>
                  </a:lnTo>
                  <a:lnTo>
                    <a:pt x="166" y="767231"/>
                  </a:lnTo>
                  <a:lnTo>
                    <a:pt x="164" y="765463"/>
                  </a:lnTo>
                  <a:lnTo>
                    <a:pt x="162" y="763695"/>
                  </a:lnTo>
                  <a:lnTo>
                    <a:pt x="160" y="761927"/>
                  </a:lnTo>
                  <a:lnTo>
                    <a:pt x="158" y="760160"/>
                  </a:lnTo>
                  <a:lnTo>
                    <a:pt x="156" y="758392"/>
                  </a:lnTo>
                  <a:lnTo>
                    <a:pt x="154" y="756624"/>
                  </a:lnTo>
                  <a:lnTo>
                    <a:pt x="152" y="754856"/>
                  </a:lnTo>
                  <a:lnTo>
                    <a:pt x="150" y="753088"/>
                  </a:lnTo>
                  <a:lnTo>
                    <a:pt x="147" y="751320"/>
                  </a:lnTo>
                  <a:lnTo>
                    <a:pt x="145" y="749553"/>
                  </a:lnTo>
                  <a:lnTo>
                    <a:pt x="143" y="747785"/>
                  </a:lnTo>
                  <a:lnTo>
                    <a:pt x="140" y="746017"/>
                  </a:lnTo>
                  <a:lnTo>
                    <a:pt x="138" y="744249"/>
                  </a:lnTo>
                  <a:lnTo>
                    <a:pt x="136" y="742481"/>
                  </a:lnTo>
                  <a:lnTo>
                    <a:pt x="133" y="740714"/>
                  </a:lnTo>
                  <a:lnTo>
                    <a:pt x="131" y="738946"/>
                  </a:lnTo>
                  <a:lnTo>
                    <a:pt x="129" y="737178"/>
                  </a:lnTo>
                  <a:lnTo>
                    <a:pt x="126" y="735410"/>
                  </a:lnTo>
                  <a:lnTo>
                    <a:pt x="124" y="733642"/>
                  </a:lnTo>
                  <a:lnTo>
                    <a:pt x="121" y="731875"/>
                  </a:lnTo>
                  <a:lnTo>
                    <a:pt x="119" y="730107"/>
                  </a:lnTo>
                  <a:lnTo>
                    <a:pt x="116" y="728339"/>
                  </a:lnTo>
                  <a:lnTo>
                    <a:pt x="113" y="726571"/>
                  </a:lnTo>
                  <a:lnTo>
                    <a:pt x="111" y="724803"/>
                  </a:lnTo>
                  <a:lnTo>
                    <a:pt x="108" y="723035"/>
                  </a:lnTo>
                  <a:lnTo>
                    <a:pt x="106" y="721268"/>
                  </a:lnTo>
                  <a:lnTo>
                    <a:pt x="103" y="719500"/>
                  </a:lnTo>
                  <a:lnTo>
                    <a:pt x="101" y="717732"/>
                  </a:lnTo>
                  <a:lnTo>
                    <a:pt x="98" y="715964"/>
                  </a:lnTo>
                  <a:lnTo>
                    <a:pt x="95" y="714196"/>
                  </a:lnTo>
                  <a:lnTo>
                    <a:pt x="93" y="712429"/>
                  </a:lnTo>
                  <a:lnTo>
                    <a:pt x="90" y="710661"/>
                  </a:lnTo>
                  <a:lnTo>
                    <a:pt x="87" y="708893"/>
                  </a:lnTo>
                  <a:lnTo>
                    <a:pt x="85" y="707125"/>
                  </a:lnTo>
                  <a:lnTo>
                    <a:pt x="82" y="705357"/>
                  </a:lnTo>
                  <a:lnTo>
                    <a:pt x="80" y="703590"/>
                  </a:lnTo>
                  <a:lnTo>
                    <a:pt x="77" y="701822"/>
                  </a:lnTo>
                  <a:lnTo>
                    <a:pt x="74" y="700054"/>
                  </a:lnTo>
                  <a:lnTo>
                    <a:pt x="72" y="698286"/>
                  </a:lnTo>
                  <a:lnTo>
                    <a:pt x="69" y="696518"/>
                  </a:lnTo>
                  <a:lnTo>
                    <a:pt x="67" y="694750"/>
                  </a:lnTo>
                  <a:lnTo>
                    <a:pt x="64" y="692983"/>
                  </a:lnTo>
                  <a:lnTo>
                    <a:pt x="62" y="691215"/>
                  </a:lnTo>
                  <a:lnTo>
                    <a:pt x="59" y="689447"/>
                  </a:lnTo>
                  <a:lnTo>
                    <a:pt x="57" y="687679"/>
                  </a:lnTo>
                  <a:lnTo>
                    <a:pt x="54" y="685911"/>
                  </a:lnTo>
                  <a:lnTo>
                    <a:pt x="52" y="684144"/>
                  </a:lnTo>
                  <a:lnTo>
                    <a:pt x="50" y="682376"/>
                  </a:lnTo>
                  <a:lnTo>
                    <a:pt x="47" y="680608"/>
                  </a:lnTo>
                  <a:lnTo>
                    <a:pt x="45" y="678840"/>
                  </a:lnTo>
                  <a:lnTo>
                    <a:pt x="43" y="677072"/>
                  </a:lnTo>
                  <a:lnTo>
                    <a:pt x="40" y="675304"/>
                  </a:lnTo>
                  <a:lnTo>
                    <a:pt x="38" y="673537"/>
                  </a:lnTo>
                  <a:lnTo>
                    <a:pt x="36" y="671769"/>
                  </a:lnTo>
                  <a:lnTo>
                    <a:pt x="34" y="670001"/>
                  </a:lnTo>
                  <a:lnTo>
                    <a:pt x="32" y="668233"/>
                  </a:lnTo>
                  <a:lnTo>
                    <a:pt x="30" y="666465"/>
                  </a:lnTo>
                  <a:lnTo>
                    <a:pt x="28" y="664698"/>
                  </a:lnTo>
                  <a:lnTo>
                    <a:pt x="26" y="662930"/>
                  </a:lnTo>
                  <a:lnTo>
                    <a:pt x="24" y="661162"/>
                  </a:lnTo>
                  <a:lnTo>
                    <a:pt x="22" y="659394"/>
                  </a:lnTo>
                  <a:lnTo>
                    <a:pt x="21" y="657626"/>
                  </a:lnTo>
                  <a:lnTo>
                    <a:pt x="19" y="655859"/>
                  </a:lnTo>
                  <a:lnTo>
                    <a:pt x="17" y="654091"/>
                  </a:lnTo>
                  <a:lnTo>
                    <a:pt x="16" y="652323"/>
                  </a:lnTo>
                  <a:lnTo>
                    <a:pt x="14" y="650555"/>
                  </a:lnTo>
                  <a:lnTo>
                    <a:pt x="13" y="648787"/>
                  </a:lnTo>
                  <a:lnTo>
                    <a:pt x="12" y="647019"/>
                  </a:lnTo>
                  <a:lnTo>
                    <a:pt x="10" y="645252"/>
                  </a:lnTo>
                  <a:lnTo>
                    <a:pt x="9" y="643484"/>
                  </a:lnTo>
                  <a:lnTo>
                    <a:pt x="8" y="641716"/>
                  </a:lnTo>
                  <a:lnTo>
                    <a:pt x="7" y="639948"/>
                  </a:lnTo>
                  <a:lnTo>
                    <a:pt x="6" y="638180"/>
                  </a:lnTo>
                  <a:lnTo>
                    <a:pt x="5" y="636413"/>
                  </a:lnTo>
                  <a:lnTo>
                    <a:pt x="4" y="634645"/>
                  </a:lnTo>
                  <a:lnTo>
                    <a:pt x="3" y="632877"/>
                  </a:lnTo>
                  <a:lnTo>
                    <a:pt x="2" y="631109"/>
                  </a:lnTo>
                  <a:lnTo>
                    <a:pt x="2" y="629341"/>
                  </a:lnTo>
                  <a:lnTo>
                    <a:pt x="1" y="627574"/>
                  </a:lnTo>
                  <a:lnTo>
                    <a:pt x="1" y="625806"/>
                  </a:lnTo>
                  <a:lnTo>
                    <a:pt x="0" y="624038"/>
                  </a:lnTo>
                  <a:lnTo>
                    <a:pt x="0" y="622270"/>
                  </a:lnTo>
                  <a:lnTo>
                    <a:pt x="0" y="620502"/>
                  </a:lnTo>
                  <a:lnTo>
                    <a:pt x="0" y="618734"/>
                  </a:lnTo>
                  <a:lnTo>
                    <a:pt x="0" y="616967"/>
                  </a:lnTo>
                  <a:lnTo>
                    <a:pt x="0" y="615199"/>
                  </a:lnTo>
                  <a:lnTo>
                    <a:pt x="0" y="613431"/>
                  </a:lnTo>
                  <a:lnTo>
                    <a:pt x="0" y="611663"/>
                  </a:lnTo>
                  <a:lnTo>
                    <a:pt x="0" y="609895"/>
                  </a:lnTo>
                  <a:lnTo>
                    <a:pt x="0" y="608128"/>
                  </a:lnTo>
                  <a:lnTo>
                    <a:pt x="1" y="606360"/>
                  </a:lnTo>
                  <a:lnTo>
                    <a:pt x="1" y="604592"/>
                  </a:lnTo>
                  <a:lnTo>
                    <a:pt x="2" y="602824"/>
                  </a:lnTo>
                  <a:lnTo>
                    <a:pt x="2" y="601056"/>
                  </a:lnTo>
                  <a:lnTo>
                    <a:pt x="3" y="599288"/>
                  </a:lnTo>
                  <a:lnTo>
                    <a:pt x="4" y="597521"/>
                  </a:lnTo>
                  <a:lnTo>
                    <a:pt x="4" y="595753"/>
                  </a:lnTo>
                  <a:lnTo>
                    <a:pt x="5" y="593985"/>
                  </a:lnTo>
                  <a:lnTo>
                    <a:pt x="6" y="592217"/>
                  </a:lnTo>
                  <a:lnTo>
                    <a:pt x="7" y="590449"/>
                  </a:lnTo>
                  <a:lnTo>
                    <a:pt x="8" y="588682"/>
                  </a:lnTo>
                  <a:lnTo>
                    <a:pt x="10" y="586914"/>
                  </a:lnTo>
                  <a:lnTo>
                    <a:pt x="11" y="585146"/>
                  </a:lnTo>
                  <a:lnTo>
                    <a:pt x="12" y="583378"/>
                  </a:lnTo>
                  <a:lnTo>
                    <a:pt x="14" y="581610"/>
                  </a:lnTo>
                  <a:lnTo>
                    <a:pt x="15" y="579843"/>
                  </a:lnTo>
                  <a:lnTo>
                    <a:pt x="17" y="578075"/>
                  </a:lnTo>
                  <a:lnTo>
                    <a:pt x="18" y="576307"/>
                  </a:lnTo>
                  <a:lnTo>
                    <a:pt x="20" y="574539"/>
                  </a:lnTo>
                  <a:lnTo>
                    <a:pt x="21" y="572771"/>
                  </a:lnTo>
                  <a:lnTo>
                    <a:pt x="23" y="571003"/>
                  </a:lnTo>
                  <a:lnTo>
                    <a:pt x="25" y="569236"/>
                  </a:lnTo>
                  <a:lnTo>
                    <a:pt x="27" y="567468"/>
                  </a:lnTo>
                  <a:lnTo>
                    <a:pt x="29" y="565700"/>
                  </a:lnTo>
                  <a:lnTo>
                    <a:pt x="31" y="563932"/>
                  </a:lnTo>
                  <a:lnTo>
                    <a:pt x="33" y="562164"/>
                  </a:lnTo>
                  <a:lnTo>
                    <a:pt x="35" y="560397"/>
                  </a:lnTo>
                  <a:lnTo>
                    <a:pt x="37" y="558629"/>
                  </a:lnTo>
                  <a:lnTo>
                    <a:pt x="39" y="556861"/>
                  </a:lnTo>
                  <a:lnTo>
                    <a:pt x="41" y="555093"/>
                  </a:lnTo>
                  <a:lnTo>
                    <a:pt x="43" y="553325"/>
                  </a:lnTo>
                  <a:lnTo>
                    <a:pt x="46" y="551558"/>
                  </a:lnTo>
                  <a:lnTo>
                    <a:pt x="48" y="549790"/>
                  </a:lnTo>
                  <a:lnTo>
                    <a:pt x="50" y="548022"/>
                  </a:lnTo>
                  <a:lnTo>
                    <a:pt x="52" y="546254"/>
                  </a:lnTo>
                  <a:lnTo>
                    <a:pt x="55" y="544486"/>
                  </a:lnTo>
                  <a:lnTo>
                    <a:pt x="57" y="542718"/>
                  </a:lnTo>
                  <a:lnTo>
                    <a:pt x="59" y="540951"/>
                  </a:lnTo>
                  <a:lnTo>
                    <a:pt x="62" y="539183"/>
                  </a:lnTo>
                  <a:lnTo>
                    <a:pt x="64" y="537415"/>
                  </a:lnTo>
                  <a:lnTo>
                    <a:pt x="67" y="535647"/>
                  </a:lnTo>
                  <a:lnTo>
                    <a:pt x="69" y="533879"/>
                  </a:lnTo>
                  <a:lnTo>
                    <a:pt x="72" y="532112"/>
                  </a:lnTo>
                  <a:lnTo>
                    <a:pt x="74" y="530344"/>
                  </a:lnTo>
                  <a:lnTo>
                    <a:pt x="77" y="528576"/>
                  </a:lnTo>
                  <a:lnTo>
                    <a:pt x="79" y="526808"/>
                  </a:lnTo>
                  <a:lnTo>
                    <a:pt x="82" y="525040"/>
                  </a:lnTo>
                  <a:lnTo>
                    <a:pt x="84" y="523272"/>
                  </a:lnTo>
                  <a:lnTo>
                    <a:pt x="87" y="521505"/>
                  </a:lnTo>
                  <a:lnTo>
                    <a:pt x="89" y="519737"/>
                  </a:lnTo>
                  <a:lnTo>
                    <a:pt x="91" y="517969"/>
                  </a:lnTo>
                  <a:lnTo>
                    <a:pt x="94" y="516201"/>
                  </a:lnTo>
                  <a:lnTo>
                    <a:pt x="96" y="514433"/>
                  </a:lnTo>
                  <a:lnTo>
                    <a:pt x="99" y="512666"/>
                  </a:lnTo>
                  <a:lnTo>
                    <a:pt x="101" y="510898"/>
                  </a:lnTo>
                  <a:lnTo>
                    <a:pt x="104" y="509130"/>
                  </a:lnTo>
                  <a:lnTo>
                    <a:pt x="106" y="507362"/>
                  </a:lnTo>
                  <a:lnTo>
                    <a:pt x="109" y="505594"/>
                  </a:lnTo>
                  <a:lnTo>
                    <a:pt x="111" y="503827"/>
                  </a:lnTo>
                  <a:lnTo>
                    <a:pt x="113" y="502059"/>
                  </a:lnTo>
                  <a:lnTo>
                    <a:pt x="116" y="500291"/>
                  </a:lnTo>
                  <a:lnTo>
                    <a:pt x="118" y="498523"/>
                  </a:lnTo>
                  <a:lnTo>
                    <a:pt x="120" y="496755"/>
                  </a:lnTo>
                  <a:lnTo>
                    <a:pt x="122" y="494987"/>
                  </a:lnTo>
                  <a:lnTo>
                    <a:pt x="125" y="493220"/>
                  </a:lnTo>
                  <a:lnTo>
                    <a:pt x="127" y="491452"/>
                  </a:lnTo>
                  <a:lnTo>
                    <a:pt x="129" y="489684"/>
                  </a:lnTo>
                  <a:lnTo>
                    <a:pt x="131" y="487916"/>
                  </a:lnTo>
                  <a:lnTo>
                    <a:pt x="133" y="486148"/>
                  </a:lnTo>
                  <a:lnTo>
                    <a:pt x="135" y="484381"/>
                  </a:lnTo>
                  <a:lnTo>
                    <a:pt x="137" y="482613"/>
                  </a:lnTo>
                  <a:lnTo>
                    <a:pt x="139" y="480845"/>
                  </a:lnTo>
                  <a:lnTo>
                    <a:pt x="141" y="479077"/>
                  </a:lnTo>
                  <a:lnTo>
                    <a:pt x="143" y="477309"/>
                  </a:lnTo>
                  <a:lnTo>
                    <a:pt x="145" y="475541"/>
                  </a:lnTo>
                  <a:lnTo>
                    <a:pt x="147" y="473774"/>
                  </a:lnTo>
                  <a:lnTo>
                    <a:pt x="149" y="472006"/>
                  </a:lnTo>
                  <a:lnTo>
                    <a:pt x="150" y="470238"/>
                  </a:lnTo>
                  <a:lnTo>
                    <a:pt x="152" y="468470"/>
                  </a:lnTo>
                  <a:lnTo>
                    <a:pt x="154" y="466702"/>
                  </a:lnTo>
                  <a:lnTo>
                    <a:pt x="155" y="464935"/>
                  </a:lnTo>
                  <a:lnTo>
                    <a:pt x="157" y="463167"/>
                  </a:lnTo>
                  <a:lnTo>
                    <a:pt x="158" y="461399"/>
                  </a:lnTo>
                  <a:lnTo>
                    <a:pt x="160" y="459631"/>
                  </a:lnTo>
                  <a:lnTo>
                    <a:pt x="161" y="457863"/>
                  </a:lnTo>
                  <a:lnTo>
                    <a:pt x="163" y="456096"/>
                  </a:lnTo>
                  <a:lnTo>
                    <a:pt x="164" y="454328"/>
                  </a:lnTo>
                  <a:lnTo>
                    <a:pt x="166" y="452560"/>
                  </a:lnTo>
                  <a:lnTo>
                    <a:pt x="167" y="450792"/>
                  </a:lnTo>
                  <a:lnTo>
                    <a:pt x="168" y="449024"/>
                  </a:lnTo>
                  <a:lnTo>
                    <a:pt x="169" y="447256"/>
                  </a:lnTo>
                  <a:lnTo>
                    <a:pt x="170" y="445489"/>
                  </a:lnTo>
                  <a:lnTo>
                    <a:pt x="172" y="443721"/>
                  </a:lnTo>
                  <a:lnTo>
                    <a:pt x="173" y="441953"/>
                  </a:lnTo>
                  <a:lnTo>
                    <a:pt x="174" y="440185"/>
                  </a:lnTo>
                  <a:lnTo>
                    <a:pt x="175" y="438417"/>
                  </a:lnTo>
                  <a:lnTo>
                    <a:pt x="175" y="436650"/>
                  </a:lnTo>
                  <a:lnTo>
                    <a:pt x="176" y="434882"/>
                  </a:lnTo>
                  <a:lnTo>
                    <a:pt x="177" y="433114"/>
                  </a:lnTo>
                  <a:lnTo>
                    <a:pt x="178" y="431346"/>
                  </a:lnTo>
                  <a:lnTo>
                    <a:pt x="179" y="429578"/>
                  </a:lnTo>
                  <a:lnTo>
                    <a:pt x="179" y="427811"/>
                  </a:lnTo>
                  <a:lnTo>
                    <a:pt x="180" y="426043"/>
                  </a:lnTo>
                  <a:lnTo>
                    <a:pt x="181" y="424275"/>
                  </a:lnTo>
                  <a:lnTo>
                    <a:pt x="181" y="422507"/>
                  </a:lnTo>
                  <a:lnTo>
                    <a:pt x="182" y="420739"/>
                  </a:lnTo>
                  <a:lnTo>
                    <a:pt x="182" y="418971"/>
                  </a:lnTo>
                  <a:lnTo>
                    <a:pt x="183" y="417204"/>
                  </a:lnTo>
                  <a:lnTo>
                    <a:pt x="183" y="415436"/>
                  </a:lnTo>
                  <a:lnTo>
                    <a:pt x="184" y="413668"/>
                  </a:lnTo>
                  <a:lnTo>
                    <a:pt x="184" y="411900"/>
                  </a:lnTo>
                  <a:lnTo>
                    <a:pt x="185" y="410132"/>
                  </a:lnTo>
                  <a:lnTo>
                    <a:pt x="185" y="408365"/>
                  </a:lnTo>
                  <a:lnTo>
                    <a:pt x="185" y="406597"/>
                  </a:lnTo>
                  <a:lnTo>
                    <a:pt x="185" y="404829"/>
                  </a:lnTo>
                  <a:lnTo>
                    <a:pt x="186" y="403061"/>
                  </a:lnTo>
                  <a:lnTo>
                    <a:pt x="186" y="401293"/>
                  </a:lnTo>
                  <a:lnTo>
                    <a:pt x="186" y="399525"/>
                  </a:lnTo>
                  <a:lnTo>
                    <a:pt x="186" y="397758"/>
                  </a:lnTo>
                  <a:lnTo>
                    <a:pt x="186" y="395990"/>
                  </a:lnTo>
                  <a:lnTo>
                    <a:pt x="186" y="394222"/>
                  </a:lnTo>
                  <a:lnTo>
                    <a:pt x="186" y="392454"/>
                  </a:lnTo>
                  <a:lnTo>
                    <a:pt x="186" y="390686"/>
                  </a:lnTo>
                  <a:lnTo>
                    <a:pt x="186" y="388919"/>
                  </a:lnTo>
                  <a:lnTo>
                    <a:pt x="186" y="387151"/>
                  </a:lnTo>
                  <a:lnTo>
                    <a:pt x="186" y="385383"/>
                  </a:lnTo>
                  <a:lnTo>
                    <a:pt x="186" y="383615"/>
                  </a:lnTo>
                  <a:lnTo>
                    <a:pt x="186" y="381847"/>
                  </a:lnTo>
                  <a:lnTo>
                    <a:pt x="186" y="380080"/>
                  </a:lnTo>
                  <a:lnTo>
                    <a:pt x="186" y="378312"/>
                  </a:lnTo>
                  <a:lnTo>
                    <a:pt x="185" y="376544"/>
                  </a:lnTo>
                  <a:lnTo>
                    <a:pt x="185" y="374776"/>
                  </a:lnTo>
                  <a:lnTo>
                    <a:pt x="185" y="373008"/>
                  </a:lnTo>
                  <a:lnTo>
                    <a:pt x="185" y="371240"/>
                  </a:lnTo>
                  <a:lnTo>
                    <a:pt x="185" y="369473"/>
                  </a:lnTo>
                  <a:lnTo>
                    <a:pt x="184" y="367705"/>
                  </a:lnTo>
                  <a:lnTo>
                    <a:pt x="184" y="365937"/>
                  </a:lnTo>
                  <a:lnTo>
                    <a:pt x="184" y="364169"/>
                  </a:lnTo>
                  <a:lnTo>
                    <a:pt x="184" y="362401"/>
                  </a:lnTo>
                  <a:lnTo>
                    <a:pt x="183" y="360634"/>
                  </a:lnTo>
                  <a:lnTo>
                    <a:pt x="183" y="358866"/>
                  </a:lnTo>
                  <a:lnTo>
                    <a:pt x="183" y="357098"/>
                  </a:lnTo>
                  <a:lnTo>
                    <a:pt x="182" y="355330"/>
                  </a:lnTo>
                  <a:lnTo>
                    <a:pt x="182" y="353562"/>
                  </a:lnTo>
                  <a:lnTo>
                    <a:pt x="182" y="351795"/>
                  </a:lnTo>
                  <a:lnTo>
                    <a:pt x="181" y="350027"/>
                  </a:lnTo>
                  <a:lnTo>
                    <a:pt x="181" y="348259"/>
                  </a:lnTo>
                  <a:lnTo>
                    <a:pt x="181" y="346491"/>
                  </a:lnTo>
                  <a:lnTo>
                    <a:pt x="181" y="344723"/>
                  </a:lnTo>
                  <a:lnTo>
                    <a:pt x="180" y="342955"/>
                  </a:lnTo>
                  <a:lnTo>
                    <a:pt x="180" y="341188"/>
                  </a:lnTo>
                  <a:lnTo>
                    <a:pt x="180" y="339420"/>
                  </a:lnTo>
                  <a:lnTo>
                    <a:pt x="179" y="337652"/>
                  </a:lnTo>
                  <a:lnTo>
                    <a:pt x="179" y="335884"/>
                  </a:lnTo>
                  <a:lnTo>
                    <a:pt x="179" y="334116"/>
                  </a:lnTo>
                  <a:lnTo>
                    <a:pt x="178" y="332349"/>
                  </a:lnTo>
                  <a:lnTo>
                    <a:pt x="178" y="330581"/>
                  </a:lnTo>
                  <a:lnTo>
                    <a:pt x="178" y="328813"/>
                  </a:lnTo>
                  <a:lnTo>
                    <a:pt x="178" y="327045"/>
                  </a:lnTo>
                  <a:lnTo>
                    <a:pt x="177" y="325277"/>
                  </a:lnTo>
                  <a:lnTo>
                    <a:pt x="177" y="323509"/>
                  </a:lnTo>
                  <a:lnTo>
                    <a:pt x="177" y="321742"/>
                  </a:lnTo>
                  <a:lnTo>
                    <a:pt x="177" y="319974"/>
                  </a:lnTo>
                  <a:lnTo>
                    <a:pt x="176" y="318206"/>
                  </a:lnTo>
                  <a:lnTo>
                    <a:pt x="176" y="316438"/>
                  </a:lnTo>
                  <a:lnTo>
                    <a:pt x="176" y="314670"/>
                  </a:lnTo>
                  <a:lnTo>
                    <a:pt x="176" y="312903"/>
                  </a:lnTo>
                  <a:lnTo>
                    <a:pt x="176" y="311135"/>
                  </a:lnTo>
                  <a:lnTo>
                    <a:pt x="175" y="309367"/>
                  </a:lnTo>
                  <a:lnTo>
                    <a:pt x="175" y="307599"/>
                  </a:lnTo>
                  <a:lnTo>
                    <a:pt x="175" y="305831"/>
                  </a:lnTo>
                  <a:lnTo>
                    <a:pt x="175" y="304064"/>
                  </a:lnTo>
                  <a:lnTo>
                    <a:pt x="175" y="302296"/>
                  </a:lnTo>
                  <a:lnTo>
                    <a:pt x="175" y="300528"/>
                  </a:lnTo>
                  <a:lnTo>
                    <a:pt x="175" y="298760"/>
                  </a:lnTo>
                  <a:lnTo>
                    <a:pt x="175" y="296992"/>
                  </a:lnTo>
                  <a:lnTo>
                    <a:pt x="175" y="295224"/>
                  </a:lnTo>
                  <a:lnTo>
                    <a:pt x="175" y="293457"/>
                  </a:lnTo>
                  <a:lnTo>
                    <a:pt x="175" y="291689"/>
                  </a:lnTo>
                  <a:lnTo>
                    <a:pt x="175" y="289921"/>
                  </a:lnTo>
                  <a:lnTo>
                    <a:pt x="175" y="288153"/>
                  </a:lnTo>
                  <a:lnTo>
                    <a:pt x="175" y="286385"/>
                  </a:lnTo>
                  <a:lnTo>
                    <a:pt x="175" y="284618"/>
                  </a:lnTo>
                  <a:lnTo>
                    <a:pt x="175" y="282850"/>
                  </a:lnTo>
                  <a:lnTo>
                    <a:pt x="175" y="281082"/>
                  </a:lnTo>
                  <a:lnTo>
                    <a:pt x="175" y="279314"/>
                  </a:lnTo>
                  <a:lnTo>
                    <a:pt x="175" y="277546"/>
                  </a:lnTo>
                  <a:lnTo>
                    <a:pt x="175" y="275779"/>
                  </a:lnTo>
                  <a:lnTo>
                    <a:pt x="175" y="274011"/>
                  </a:lnTo>
                  <a:lnTo>
                    <a:pt x="176" y="272243"/>
                  </a:lnTo>
                  <a:lnTo>
                    <a:pt x="176" y="270475"/>
                  </a:lnTo>
                  <a:lnTo>
                    <a:pt x="176" y="268707"/>
                  </a:lnTo>
                  <a:lnTo>
                    <a:pt x="176" y="266939"/>
                  </a:lnTo>
                  <a:lnTo>
                    <a:pt x="177" y="265172"/>
                  </a:lnTo>
                  <a:lnTo>
                    <a:pt x="177" y="263404"/>
                  </a:lnTo>
                  <a:lnTo>
                    <a:pt x="177" y="261636"/>
                  </a:lnTo>
                  <a:lnTo>
                    <a:pt x="177" y="259868"/>
                  </a:lnTo>
                  <a:lnTo>
                    <a:pt x="178" y="258100"/>
                  </a:lnTo>
                  <a:lnTo>
                    <a:pt x="178" y="256333"/>
                  </a:lnTo>
                  <a:lnTo>
                    <a:pt x="178" y="254565"/>
                  </a:lnTo>
                  <a:lnTo>
                    <a:pt x="179" y="252797"/>
                  </a:lnTo>
                  <a:lnTo>
                    <a:pt x="179" y="251029"/>
                  </a:lnTo>
                  <a:lnTo>
                    <a:pt x="180" y="249261"/>
                  </a:lnTo>
                  <a:lnTo>
                    <a:pt x="180" y="247493"/>
                  </a:lnTo>
                  <a:lnTo>
                    <a:pt x="180" y="245726"/>
                  </a:lnTo>
                  <a:lnTo>
                    <a:pt x="181" y="243958"/>
                  </a:lnTo>
                  <a:lnTo>
                    <a:pt x="181" y="242190"/>
                  </a:lnTo>
                  <a:lnTo>
                    <a:pt x="182" y="240422"/>
                  </a:lnTo>
                  <a:lnTo>
                    <a:pt x="182" y="238654"/>
                  </a:lnTo>
                  <a:lnTo>
                    <a:pt x="183" y="236887"/>
                  </a:lnTo>
                  <a:lnTo>
                    <a:pt x="183" y="235119"/>
                  </a:lnTo>
                  <a:lnTo>
                    <a:pt x="184" y="233351"/>
                  </a:lnTo>
                  <a:lnTo>
                    <a:pt x="184" y="231583"/>
                  </a:lnTo>
                  <a:lnTo>
                    <a:pt x="185" y="229815"/>
                  </a:lnTo>
                  <a:lnTo>
                    <a:pt x="185" y="228048"/>
                  </a:lnTo>
                  <a:lnTo>
                    <a:pt x="186" y="226280"/>
                  </a:lnTo>
                  <a:lnTo>
                    <a:pt x="187" y="224512"/>
                  </a:lnTo>
                  <a:lnTo>
                    <a:pt x="187" y="222744"/>
                  </a:lnTo>
                  <a:lnTo>
                    <a:pt x="188" y="220976"/>
                  </a:lnTo>
                  <a:lnTo>
                    <a:pt x="188" y="219208"/>
                  </a:lnTo>
                  <a:lnTo>
                    <a:pt x="189" y="217441"/>
                  </a:lnTo>
                  <a:lnTo>
                    <a:pt x="190" y="215673"/>
                  </a:lnTo>
                  <a:lnTo>
                    <a:pt x="190" y="213905"/>
                  </a:lnTo>
                  <a:lnTo>
                    <a:pt x="191" y="212137"/>
                  </a:lnTo>
                  <a:lnTo>
                    <a:pt x="191" y="210369"/>
                  </a:lnTo>
                  <a:lnTo>
                    <a:pt x="192" y="208602"/>
                  </a:lnTo>
                  <a:lnTo>
                    <a:pt x="193" y="206834"/>
                  </a:lnTo>
                  <a:lnTo>
                    <a:pt x="193" y="205066"/>
                  </a:lnTo>
                  <a:lnTo>
                    <a:pt x="194" y="203298"/>
                  </a:lnTo>
                  <a:lnTo>
                    <a:pt x="195" y="201530"/>
                  </a:lnTo>
                  <a:lnTo>
                    <a:pt x="195" y="199762"/>
                  </a:lnTo>
                  <a:lnTo>
                    <a:pt x="196" y="197995"/>
                  </a:lnTo>
                  <a:lnTo>
                    <a:pt x="197" y="196227"/>
                  </a:lnTo>
                  <a:lnTo>
                    <a:pt x="197" y="194459"/>
                  </a:lnTo>
                  <a:lnTo>
                    <a:pt x="198" y="192691"/>
                  </a:lnTo>
                  <a:lnTo>
                    <a:pt x="199" y="190923"/>
                  </a:lnTo>
                  <a:lnTo>
                    <a:pt x="199" y="189156"/>
                  </a:lnTo>
                  <a:lnTo>
                    <a:pt x="200" y="187388"/>
                  </a:lnTo>
                  <a:lnTo>
                    <a:pt x="200" y="185620"/>
                  </a:lnTo>
                  <a:lnTo>
                    <a:pt x="201" y="183852"/>
                  </a:lnTo>
                  <a:lnTo>
                    <a:pt x="202" y="182084"/>
                  </a:lnTo>
                  <a:lnTo>
                    <a:pt x="202" y="180317"/>
                  </a:lnTo>
                  <a:lnTo>
                    <a:pt x="203" y="178549"/>
                  </a:lnTo>
                  <a:lnTo>
                    <a:pt x="204" y="176781"/>
                  </a:lnTo>
                  <a:lnTo>
                    <a:pt x="204" y="175013"/>
                  </a:lnTo>
                  <a:lnTo>
                    <a:pt x="205" y="173245"/>
                  </a:lnTo>
                  <a:lnTo>
                    <a:pt x="206" y="171477"/>
                  </a:lnTo>
                  <a:lnTo>
                    <a:pt x="206" y="169710"/>
                  </a:lnTo>
                  <a:lnTo>
                    <a:pt x="207" y="167942"/>
                  </a:lnTo>
                  <a:lnTo>
                    <a:pt x="207" y="166174"/>
                  </a:lnTo>
                  <a:lnTo>
                    <a:pt x="208" y="164406"/>
                  </a:lnTo>
                  <a:lnTo>
                    <a:pt x="209" y="162638"/>
                  </a:lnTo>
                  <a:lnTo>
                    <a:pt x="209" y="160871"/>
                  </a:lnTo>
                  <a:lnTo>
                    <a:pt x="210" y="159103"/>
                  </a:lnTo>
                  <a:lnTo>
                    <a:pt x="210" y="157335"/>
                  </a:lnTo>
                  <a:lnTo>
                    <a:pt x="211" y="155567"/>
                  </a:lnTo>
                  <a:lnTo>
                    <a:pt x="212" y="153799"/>
                  </a:lnTo>
                  <a:lnTo>
                    <a:pt x="212" y="152032"/>
                  </a:lnTo>
                  <a:lnTo>
                    <a:pt x="213" y="150264"/>
                  </a:lnTo>
                  <a:lnTo>
                    <a:pt x="213" y="148496"/>
                  </a:lnTo>
                  <a:lnTo>
                    <a:pt x="214" y="146728"/>
                  </a:lnTo>
                  <a:lnTo>
                    <a:pt x="214" y="144960"/>
                  </a:lnTo>
                  <a:lnTo>
                    <a:pt x="215" y="143192"/>
                  </a:lnTo>
                  <a:lnTo>
                    <a:pt x="215" y="141425"/>
                  </a:lnTo>
                  <a:lnTo>
                    <a:pt x="216" y="139657"/>
                  </a:lnTo>
                  <a:lnTo>
                    <a:pt x="216" y="137889"/>
                  </a:lnTo>
                  <a:lnTo>
                    <a:pt x="217" y="136121"/>
                  </a:lnTo>
                  <a:lnTo>
                    <a:pt x="217" y="134353"/>
                  </a:lnTo>
                  <a:lnTo>
                    <a:pt x="218" y="132586"/>
                  </a:lnTo>
                  <a:lnTo>
                    <a:pt x="218" y="130818"/>
                  </a:lnTo>
                  <a:lnTo>
                    <a:pt x="219" y="129050"/>
                  </a:lnTo>
                  <a:lnTo>
                    <a:pt x="219" y="127282"/>
                  </a:lnTo>
                  <a:lnTo>
                    <a:pt x="220" y="125514"/>
                  </a:lnTo>
                  <a:lnTo>
                    <a:pt x="220" y="123746"/>
                  </a:lnTo>
                  <a:lnTo>
                    <a:pt x="221" y="121979"/>
                  </a:lnTo>
                  <a:lnTo>
                    <a:pt x="221" y="120211"/>
                  </a:lnTo>
                  <a:lnTo>
                    <a:pt x="221" y="118443"/>
                  </a:lnTo>
                  <a:lnTo>
                    <a:pt x="222" y="116675"/>
                  </a:lnTo>
                  <a:lnTo>
                    <a:pt x="222" y="114907"/>
                  </a:lnTo>
                  <a:lnTo>
                    <a:pt x="223" y="113140"/>
                  </a:lnTo>
                  <a:lnTo>
                    <a:pt x="223" y="111372"/>
                  </a:lnTo>
                  <a:lnTo>
                    <a:pt x="223" y="109604"/>
                  </a:lnTo>
                  <a:lnTo>
                    <a:pt x="224" y="107836"/>
                  </a:lnTo>
                  <a:lnTo>
                    <a:pt x="224" y="106068"/>
                  </a:lnTo>
                  <a:lnTo>
                    <a:pt x="224" y="104301"/>
                  </a:lnTo>
                  <a:lnTo>
                    <a:pt x="225" y="102533"/>
                  </a:lnTo>
                  <a:lnTo>
                    <a:pt x="225" y="100765"/>
                  </a:lnTo>
                  <a:lnTo>
                    <a:pt x="225" y="98997"/>
                  </a:lnTo>
                  <a:lnTo>
                    <a:pt x="226" y="97229"/>
                  </a:lnTo>
                  <a:lnTo>
                    <a:pt x="226" y="95461"/>
                  </a:lnTo>
                  <a:lnTo>
                    <a:pt x="226" y="93694"/>
                  </a:lnTo>
                  <a:lnTo>
                    <a:pt x="226" y="91926"/>
                  </a:lnTo>
                  <a:lnTo>
                    <a:pt x="227" y="90158"/>
                  </a:lnTo>
                  <a:lnTo>
                    <a:pt x="227" y="88390"/>
                  </a:lnTo>
                  <a:lnTo>
                    <a:pt x="227" y="86622"/>
                  </a:lnTo>
                  <a:lnTo>
                    <a:pt x="228" y="84855"/>
                  </a:lnTo>
                  <a:lnTo>
                    <a:pt x="228" y="83087"/>
                  </a:lnTo>
                  <a:lnTo>
                    <a:pt x="228" y="81319"/>
                  </a:lnTo>
                  <a:lnTo>
                    <a:pt x="228" y="79551"/>
                  </a:lnTo>
                  <a:lnTo>
                    <a:pt x="228" y="77783"/>
                  </a:lnTo>
                  <a:lnTo>
                    <a:pt x="229" y="76016"/>
                  </a:lnTo>
                  <a:lnTo>
                    <a:pt x="229" y="74248"/>
                  </a:lnTo>
                  <a:lnTo>
                    <a:pt x="229" y="72480"/>
                  </a:lnTo>
                  <a:lnTo>
                    <a:pt x="229" y="70712"/>
                  </a:lnTo>
                  <a:lnTo>
                    <a:pt x="229" y="68944"/>
                  </a:lnTo>
                  <a:lnTo>
                    <a:pt x="230" y="67176"/>
                  </a:lnTo>
                  <a:lnTo>
                    <a:pt x="230" y="65409"/>
                  </a:lnTo>
                  <a:lnTo>
                    <a:pt x="230" y="63641"/>
                  </a:lnTo>
                  <a:lnTo>
                    <a:pt x="230" y="61873"/>
                  </a:lnTo>
                  <a:lnTo>
                    <a:pt x="230" y="60105"/>
                  </a:lnTo>
                  <a:lnTo>
                    <a:pt x="230" y="58337"/>
                  </a:lnTo>
                  <a:lnTo>
                    <a:pt x="231" y="56570"/>
                  </a:lnTo>
                  <a:lnTo>
                    <a:pt x="231" y="54802"/>
                  </a:lnTo>
                  <a:lnTo>
                    <a:pt x="231" y="53034"/>
                  </a:lnTo>
                  <a:lnTo>
                    <a:pt x="231" y="51266"/>
                  </a:lnTo>
                  <a:lnTo>
                    <a:pt x="231" y="49498"/>
                  </a:lnTo>
                  <a:lnTo>
                    <a:pt x="231" y="47730"/>
                  </a:lnTo>
                  <a:lnTo>
                    <a:pt x="231" y="45963"/>
                  </a:lnTo>
                  <a:lnTo>
                    <a:pt x="231" y="44195"/>
                  </a:lnTo>
                  <a:lnTo>
                    <a:pt x="232" y="42427"/>
                  </a:lnTo>
                  <a:lnTo>
                    <a:pt x="232" y="40659"/>
                  </a:lnTo>
                  <a:lnTo>
                    <a:pt x="232" y="38891"/>
                  </a:lnTo>
                  <a:lnTo>
                    <a:pt x="232" y="37124"/>
                  </a:lnTo>
                  <a:lnTo>
                    <a:pt x="232" y="35356"/>
                  </a:lnTo>
                  <a:lnTo>
                    <a:pt x="232" y="33588"/>
                  </a:lnTo>
                  <a:lnTo>
                    <a:pt x="232" y="31820"/>
                  </a:lnTo>
                  <a:lnTo>
                    <a:pt x="232" y="30052"/>
                  </a:lnTo>
                  <a:lnTo>
                    <a:pt x="232" y="28285"/>
                  </a:lnTo>
                  <a:lnTo>
                    <a:pt x="232" y="26517"/>
                  </a:lnTo>
                  <a:lnTo>
                    <a:pt x="232" y="24749"/>
                  </a:lnTo>
                  <a:lnTo>
                    <a:pt x="233" y="22981"/>
                  </a:lnTo>
                  <a:lnTo>
                    <a:pt x="233" y="21213"/>
                  </a:lnTo>
                  <a:lnTo>
                    <a:pt x="233" y="19445"/>
                  </a:lnTo>
                  <a:lnTo>
                    <a:pt x="233" y="17678"/>
                  </a:lnTo>
                  <a:lnTo>
                    <a:pt x="233" y="15910"/>
                  </a:lnTo>
                  <a:lnTo>
                    <a:pt x="233" y="14142"/>
                  </a:lnTo>
                  <a:lnTo>
                    <a:pt x="233" y="12374"/>
                  </a:lnTo>
                  <a:lnTo>
                    <a:pt x="233" y="10606"/>
                  </a:lnTo>
                  <a:lnTo>
                    <a:pt x="233" y="8839"/>
                  </a:lnTo>
                  <a:lnTo>
                    <a:pt x="233" y="7071"/>
                  </a:lnTo>
                  <a:lnTo>
                    <a:pt x="233" y="5303"/>
                  </a:lnTo>
                  <a:lnTo>
                    <a:pt x="233" y="3535"/>
                  </a:lnTo>
                  <a:lnTo>
                    <a:pt x="233" y="1767"/>
                  </a:lnTo>
                  <a:lnTo>
                    <a:pt x="233" y="0"/>
                  </a:lnTo>
                  <a:lnTo>
                    <a:pt x="234" y="0"/>
                  </a:lnTo>
                  <a:lnTo>
                    <a:pt x="234" y="903353"/>
                  </a:lnTo>
                  <a:lnTo>
                    <a:pt x="234" y="903353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35" name="pl17"/>
            <p:cNvSpPr/>
            <p:nvPr/>
          </p:nvSpPr>
          <p:spPr>
            <a:xfrm>
              <a:off x="2271462" y="3562551"/>
              <a:ext cx="608" cy="347917"/>
            </a:xfrm>
            <a:custGeom>
              <a:avLst/>
              <a:gdLst/>
              <a:ahLst/>
              <a:cxnLst/>
              <a:rect l="0" t="0" r="0" b="0"/>
              <a:pathLst>
                <a:path w="608" h="347917">
                  <a:moveTo>
                    <a:pt x="0" y="0"/>
                  </a:moveTo>
                  <a:lnTo>
                    <a:pt x="1" y="0"/>
                  </a:lnTo>
                  <a:lnTo>
                    <a:pt x="1" y="680"/>
                  </a:lnTo>
                  <a:lnTo>
                    <a:pt x="1" y="1361"/>
                  </a:lnTo>
                  <a:lnTo>
                    <a:pt x="2" y="2042"/>
                  </a:lnTo>
                  <a:lnTo>
                    <a:pt x="2" y="2723"/>
                  </a:lnTo>
                  <a:lnTo>
                    <a:pt x="2" y="3404"/>
                  </a:lnTo>
                  <a:lnTo>
                    <a:pt x="2" y="4085"/>
                  </a:lnTo>
                  <a:lnTo>
                    <a:pt x="2" y="4765"/>
                  </a:lnTo>
                  <a:lnTo>
                    <a:pt x="2" y="5446"/>
                  </a:lnTo>
                  <a:lnTo>
                    <a:pt x="2" y="6127"/>
                  </a:lnTo>
                  <a:lnTo>
                    <a:pt x="2" y="6808"/>
                  </a:lnTo>
                  <a:lnTo>
                    <a:pt x="3" y="7489"/>
                  </a:lnTo>
                  <a:lnTo>
                    <a:pt x="3" y="8170"/>
                  </a:lnTo>
                  <a:lnTo>
                    <a:pt x="3" y="8851"/>
                  </a:lnTo>
                  <a:lnTo>
                    <a:pt x="3" y="9531"/>
                  </a:lnTo>
                  <a:lnTo>
                    <a:pt x="3" y="10212"/>
                  </a:lnTo>
                  <a:lnTo>
                    <a:pt x="3" y="10893"/>
                  </a:lnTo>
                  <a:lnTo>
                    <a:pt x="4" y="11574"/>
                  </a:lnTo>
                  <a:lnTo>
                    <a:pt x="4" y="12255"/>
                  </a:lnTo>
                  <a:lnTo>
                    <a:pt x="4" y="12936"/>
                  </a:lnTo>
                  <a:lnTo>
                    <a:pt x="4" y="13617"/>
                  </a:lnTo>
                  <a:lnTo>
                    <a:pt x="5" y="14297"/>
                  </a:lnTo>
                  <a:lnTo>
                    <a:pt x="5" y="14978"/>
                  </a:lnTo>
                  <a:lnTo>
                    <a:pt x="5" y="15659"/>
                  </a:lnTo>
                  <a:lnTo>
                    <a:pt x="5" y="16340"/>
                  </a:lnTo>
                  <a:lnTo>
                    <a:pt x="6" y="17021"/>
                  </a:lnTo>
                  <a:lnTo>
                    <a:pt x="6" y="17702"/>
                  </a:lnTo>
                  <a:lnTo>
                    <a:pt x="6" y="18383"/>
                  </a:lnTo>
                  <a:lnTo>
                    <a:pt x="7" y="19063"/>
                  </a:lnTo>
                  <a:lnTo>
                    <a:pt x="7" y="19744"/>
                  </a:lnTo>
                  <a:lnTo>
                    <a:pt x="7" y="20425"/>
                  </a:lnTo>
                  <a:lnTo>
                    <a:pt x="8" y="21106"/>
                  </a:lnTo>
                  <a:lnTo>
                    <a:pt x="8" y="21787"/>
                  </a:lnTo>
                  <a:lnTo>
                    <a:pt x="8" y="22468"/>
                  </a:lnTo>
                  <a:lnTo>
                    <a:pt x="9" y="23149"/>
                  </a:lnTo>
                  <a:lnTo>
                    <a:pt x="9" y="23829"/>
                  </a:lnTo>
                  <a:lnTo>
                    <a:pt x="9" y="24510"/>
                  </a:lnTo>
                  <a:lnTo>
                    <a:pt x="10" y="25191"/>
                  </a:lnTo>
                  <a:lnTo>
                    <a:pt x="10" y="25872"/>
                  </a:lnTo>
                  <a:lnTo>
                    <a:pt x="11" y="26553"/>
                  </a:lnTo>
                  <a:lnTo>
                    <a:pt x="11" y="27234"/>
                  </a:lnTo>
                  <a:lnTo>
                    <a:pt x="12" y="27915"/>
                  </a:lnTo>
                  <a:lnTo>
                    <a:pt x="12" y="28595"/>
                  </a:lnTo>
                  <a:lnTo>
                    <a:pt x="13" y="29276"/>
                  </a:lnTo>
                  <a:lnTo>
                    <a:pt x="13" y="29957"/>
                  </a:lnTo>
                  <a:lnTo>
                    <a:pt x="14" y="30638"/>
                  </a:lnTo>
                  <a:lnTo>
                    <a:pt x="15" y="31319"/>
                  </a:lnTo>
                  <a:lnTo>
                    <a:pt x="15" y="32000"/>
                  </a:lnTo>
                  <a:lnTo>
                    <a:pt x="16" y="32681"/>
                  </a:lnTo>
                  <a:lnTo>
                    <a:pt x="16" y="33361"/>
                  </a:lnTo>
                  <a:lnTo>
                    <a:pt x="17" y="34042"/>
                  </a:lnTo>
                  <a:lnTo>
                    <a:pt x="18" y="34723"/>
                  </a:lnTo>
                  <a:lnTo>
                    <a:pt x="19" y="35404"/>
                  </a:lnTo>
                  <a:lnTo>
                    <a:pt x="19" y="36085"/>
                  </a:lnTo>
                  <a:lnTo>
                    <a:pt x="20" y="36766"/>
                  </a:lnTo>
                  <a:lnTo>
                    <a:pt x="21" y="37447"/>
                  </a:lnTo>
                  <a:lnTo>
                    <a:pt x="22" y="38127"/>
                  </a:lnTo>
                  <a:lnTo>
                    <a:pt x="22" y="38808"/>
                  </a:lnTo>
                  <a:lnTo>
                    <a:pt x="23" y="39489"/>
                  </a:lnTo>
                  <a:lnTo>
                    <a:pt x="24" y="40170"/>
                  </a:lnTo>
                  <a:lnTo>
                    <a:pt x="25" y="40851"/>
                  </a:lnTo>
                  <a:lnTo>
                    <a:pt x="26" y="41532"/>
                  </a:lnTo>
                  <a:lnTo>
                    <a:pt x="27" y="42213"/>
                  </a:lnTo>
                  <a:lnTo>
                    <a:pt x="28" y="42893"/>
                  </a:lnTo>
                  <a:lnTo>
                    <a:pt x="29" y="43574"/>
                  </a:lnTo>
                  <a:lnTo>
                    <a:pt x="30" y="44255"/>
                  </a:lnTo>
                  <a:lnTo>
                    <a:pt x="31" y="44936"/>
                  </a:lnTo>
                  <a:lnTo>
                    <a:pt x="32" y="45617"/>
                  </a:lnTo>
                  <a:lnTo>
                    <a:pt x="33" y="46298"/>
                  </a:lnTo>
                  <a:lnTo>
                    <a:pt x="34" y="46979"/>
                  </a:lnTo>
                  <a:lnTo>
                    <a:pt x="35" y="47659"/>
                  </a:lnTo>
                  <a:lnTo>
                    <a:pt x="36" y="48340"/>
                  </a:lnTo>
                  <a:lnTo>
                    <a:pt x="37" y="49021"/>
                  </a:lnTo>
                  <a:lnTo>
                    <a:pt x="38" y="49702"/>
                  </a:lnTo>
                  <a:lnTo>
                    <a:pt x="40" y="50383"/>
                  </a:lnTo>
                  <a:lnTo>
                    <a:pt x="41" y="51064"/>
                  </a:lnTo>
                  <a:lnTo>
                    <a:pt x="42" y="51745"/>
                  </a:lnTo>
                  <a:lnTo>
                    <a:pt x="43" y="52425"/>
                  </a:lnTo>
                  <a:lnTo>
                    <a:pt x="45" y="53106"/>
                  </a:lnTo>
                  <a:lnTo>
                    <a:pt x="46" y="53787"/>
                  </a:lnTo>
                  <a:lnTo>
                    <a:pt x="47" y="54468"/>
                  </a:lnTo>
                  <a:lnTo>
                    <a:pt x="49" y="55149"/>
                  </a:lnTo>
                  <a:lnTo>
                    <a:pt x="50" y="55830"/>
                  </a:lnTo>
                  <a:lnTo>
                    <a:pt x="51" y="56511"/>
                  </a:lnTo>
                  <a:lnTo>
                    <a:pt x="53" y="57191"/>
                  </a:lnTo>
                  <a:lnTo>
                    <a:pt x="54" y="57872"/>
                  </a:lnTo>
                  <a:lnTo>
                    <a:pt x="56" y="58553"/>
                  </a:lnTo>
                  <a:lnTo>
                    <a:pt x="57" y="59234"/>
                  </a:lnTo>
                  <a:lnTo>
                    <a:pt x="59" y="59915"/>
                  </a:lnTo>
                  <a:lnTo>
                    <a:pt x="60" y="60596"/>
                  </a:lnTo>
                  <a:lnTo>
                    <a:pt x="62" y="61277"/>
                  </a:lnTo>
                  <a:lnTo>
                    <a:pt x="63" y="61957"/>
                  </a:lnTo>
                  <a:lnTo>
                    <a:pt x="65" y="62638"/>
                  </a:lnTo>
                  <a:lnTo>
                    <a:pt x="66" y="63319"/>
                  </a:lnTo>
                  <a:lnTo>
                    <a:pt x="68" y="64000"/>
                  </a:lnTo>
                  <a:lnTo>
                    <a:pt x="69" y="64681"/>
                  </a:lnTo>
                  <a:lnTo>
                    <a:pt x="71" y="65362"/>
                  </a:lnTo>
                  <a:lnTo>
                    <a:pt x="73" y="66043"/>
                  </a:lnTo>
                  <a:lnTo>
                    <a:pt x="74" y="66723"/>
                  </a:lnTo>
                  <a:lnTo>
                    <a:pt x="76" y="67404"/>
                  </a:lnTo>
                  <a:lnTo>
                    <a:pt x="78" y="68085"/>
                  </a:lnTo>
                  <a:lnTo>
                    <a:pt x="79" y="68766"/>
                  </a:lnTo>
                  <a:lnTo>
                    <a:pt x="81" y="69447"/>
                  </a:lnTo>
                  <a:lnTo>
                    <a:pt x="83" y="70128"/>
                  </a:lnTo>
                  <a:lnTo>
                    <a:pt x="84" y="70809"/>
                  </a:lnTo>
                  <a:lnTo>
                    <a:pt x="86" y="71489"/>
                  </a:lnTo>
                  <a:lnTo>
                    <a:pt x="88" y="72170"/>
                  </a:lnTo>
                  <a:lnTo>
                    <a:pt x="89" y="72851"/>
                  </a:lnTo>
                  <a:lnTo>
                    <a:pt x="91" y="73532"/>
                  </a:lnTo>
                  <a:lnTo>
                    <a:pt x="93" y="74213"/>
                  </a:lnTo>
                  <a:lnTo>
                    <a:pt x="95" y="74894"/>
                  </a:lnTo>
                  <a:lnTo>
                    <a:pt x="96" y="75575"/>
                  </a:lnTo>
                  <a:lnTo>
                    <a:pt x="98" y="76255"/>
                  </a:lnTo>
                  <a:lnTo>
                    <a:pt x="100" y="76936"/>
                  </a:lnTo>
                  <a:lnTo>
                    <a:pt x="101" y="77617"/>
                  </a:lnTo>
                  <a:lnTo>
                    <a:pt x="103" y="78298"/>
                  </a:lnTo>
                  <a:lnTo>
                    <a:pt x="105" y="78979"/>
                  </a:lnTo>
                  <a:lnTo>
                    <a:pt x="106" y="79660"/>
                  </a:lnTo>
                  <a:lnTo>
                    <a:pt x="108" y="80341"/>
                  </a:lnTo>
                  <a:lnTo>
                    <a:pt x="110" y="81021"/>
                  </a:lnTo>
                  <a:lnTo>
                    <a:pt x="111" y="81702"/>
                  </a:lnTo>
                  <a:lnTo>
                    <a:pt x="113" y="82383"/>
                  </a:lnTo>
                  <a:lnTo>
                    <a:pt x="114" y="83064"/>
                  </a:lnTo>
                  <a:lnTo>
                    <a:pt x="116" y="83745"/>
                  </a:lnTo>
                  <a:lnTo>
                    <a:pt x="118" y="84426"/>
                  </a:lnTo>
                  <a:lnTo>
                    <a:pt x="119" y="85107"/>
                  </a:lnTo>
                  <a:lnTo>
                    <a:pt x="121" y="85787"/>
                  </a:lnTo>
                  <a:lnTo>
                    <a:pt x="122" y="86468"/>
                  </a:lnTo>
                  <a:lnTo>
                    <a:pt x="124" y="87149"/>
                  </a:lnTo>
                  <a:lnTo>
                    <a:pt x="125" y="87830"/>
                  </a:lnTo>
                  <a:lnTo>
                    <a:pt x="127" y="88511"/>
                  </a:lnTo>
                  <a:lnTo>
                    <a:pt x="128" y="89192"/>
                  </a:lnTo>
                  <a:lnTo>
                    <a:pt x="129" y="89873"/>
                  </a:lnTo>
                  <a:lnTo>
                    <a:pt x="131" y="90553"/>
                  </a:lnTo>
                  <a:lnTo>
                    <a:pt x="132" y="91234"/>
                  </a:lnTo>
                  <a:lnTo>
                    <a:pt x="133" y="91915"/>
                  </a:lnTo>
                  <a:lnTo>
                    <a:pt x="135" y="92596"/>
                  </a:lnTo>
                  <a:lnTo>
                    <a:pt x="136" y="93277"/>
                  </a:lnTo>
                  <a:lnTo>
                    <a:pt x="137" y="93958"/>
                  </a:lnTo>
                  <a:lnTo>
                    <a:pt x="138" y="94639"/>
                  </a:lnTo>
                  <a:lnTo>
                    <a:pt x="139" y="95319"/>
                  </a:lnTo>
                  <a:lnTo>
                    <a:pt x="140" y="96000"/>
                  </a:lnTo>
                  <a:lnTo>
                    <a:pt x="141" y="96681"/>
                  </a:lnTo>
                  <a:lnTo>
                    <a:pt x="142" y="97362"/>
                  </a:lnTo>
                  <a:lnTo>
                    <a:pt x="143" y="98043"/>
                  </a:lnTo>
                  <a:lnTo>
                    <a:pt x="144" y="98724"/>
                  </a:lnTo>
                  <a:lnTo>
                    <a:pt x="145" y="99405"/>
                  </a:lnTo>
                  <a:lnTo>
                    <a:pt x="146" y="100085"/>
                  </a:lnTo>
                  <a:lnTo>
                    <a:pt x="147" y="100766"/>
                  </a:lnTo>
                  <a:lnTo>
                    <a:pt x="148" y="101447"/>
                  </a:lnTo>
                  <a:lnTo>
                    <a:pt x="148" y="102128"/>
                  </a:lnTo>
                  <a:lnTo>
                    <a:pt x="149" y="102809"/>
                  </a:lnTo>
                  <a:lnTo>
                    <a:pt x="149" y="103490"/>
                  </a:lnTo>
                  <a:lnTo>
                    <a:pt x="150" y="104171"/>
                  </a:lnTo>
                  <a:lnTo>
                    <a:pt x="151" y="104851"/>
                  </a:lnTo>
                  <a:lnTo>
                    <a:pt x="151" y="105532"/>
                  </a:lnTo>
                  <a:lnTo>
                    <a:pt x="152" y="106213"/>
                  </a:lnTo>
                  <a:lnTo>
                    <a:pt x="152" y="106894"/>
                  </a:lnTo>
                  <a:lnTo>
                    <a:pt x="152" y="107575"/>
                  </a:lnTo>
                  <a:lnTo>
                    <a:pt x="153" y="108256"/>
                  </a:lnTo>
                  <a:lnTo>
                    <a:pt x="153" y="108937"/>
                  </a:lnTo>
                  <a:lnTo>
                    <a:pt x="153" y="109617"/>
                  </a:lnTo>
                  <a:lnTo>
                    <a:pt x="153" y="110298"/>
                  </a:lnTo>
                  <a:lnTo>
                    <a:pt x="153" y="110979"/>
                  </a:lnTo>
                  <a:lnTo>
                    <a:pt x="153" y="111660"/>
                  </a:lnTo>
                  <a:lnTo>
                    <a:pt x="153" y="112341"/>
                  </a:lnTo>
                  <a:lnTo>
                    <a:pt x="153" y="113022"/>
                  </a:lnTo>
                  <a:lnTo>
                    <a:pt x="153" y="113703"/>
                  </a:lnTo>
                  <a:lnTo>
                    <a:pt x="153" y="114383"/>
                  </a:lnTo>
                  <a:lnTo>
                    <a:pt x="153" y="115064"/>
                  </a:lnTo>
                  <a:lnTo>
                    <a:pt x="153" y="115745"/>
                  </a:lnTo>
                  <a:lnTo>
                    <a:pt x="153" y="116426"/>
                  </a:lnTo>
                  <a:lnTo>
                    <a:pt x="152" y="117107"/>
                  </a:lnTo>
                  <a:lnTo>
                    <a:pt x="152" y="117788"/>
                  </a:lnTo>
                  <a:lnTo>
                    <a:pt x="152" y="118469"/>
                  </a:lnTo>
                  <a:lnTo>
                    <a:pt x="151" y="119149"/>
                  </a:lnTo>
                  <a:lnTo>
                    <a:pt x="151" y="119830"/>
                  </a:lnTo>
                  <a:lnTo>
                    <a:pt x="150" y="120511"/>
                  </a:lnTo>
                  <a:lnTo>
                    <a:pt x="150" y="121192"/>
                  </a:lnTo>
                  <a:lnTo>
                    <a:pt x="149" y="121873"/>
                  </a:lnTo>
                  <a:lnTo>
                    <a:pt x="149" y="122554"/>
                  </a:lnTo>
                  <a:lnTo>
                    <a:pt x="148" y="123235"/>
                  </a:lnTo>
                  <a:lnTo>
                    <a:pt x="148" y="123915"/>
                  </a:lnTo>
                  <a:lnTo>
                    <a:pt x="147" y="124596"/>
                  </a:lnTo>
                  <a:lnTo>
                    <a:pt x="146" y="125277"/>
                  </a:lnTo>
                  <a:lnTo>
                    <a:pt x="146" y="125958"/>
                  </a:lnTo>
                  <a:lnTo>
                    <a:pt x="145" y="126639"/>
                  </a:lnTo>
                  <a:lnTo>
                    <a:pt x="144" y="127320"/>
                  </a:lnTo>
                  <a:lnTo>
                    <a:pt x="143" y="128001"/>
                  </a:lnTo>
                  <a:lnTo>
                    <a:pt x="143" y="128681"/>
                  </a:lnTo>
                  <a:lnTo>
                    <a:pt x="142" y="129362"/>
                  </a:lnTo>
                  <a:lnTo>
                    <a:pt x="141" y="130043"/>
                  </a:lnTo>
                  <a:lnTo>
                    <a:pt x="140" y="130724"/>
                  </a:lnTo>
                  <a:lnTo>
                    <a:pt x="139" y="131405"/>
                  </a:lnTo>
                  <a:lnTo>
                    <a:pt x="139" y="132086"/>
                  </a:lnTo>
                  <a:lnTo>
                    <a:pt x="138" y="132767"/>
                  </a:lnTo>
                  <a:lnTo>
                    <a:pt x="137" y="133447"/>
                  </a:lnTo>
                  <a:lnTo>
                    <a:pt x="136" y="134128"/>
                  </a:lnTo>
                  <a:lnTo>
                    <a:pt x="135" y="134809"/>
                  </a:lnTo>
                  <a:lnTo>
                    <a:pt x="135" y="135490"/>
                  </a:lnTo>
                  <a:lnTo>
                    <a:pt x="134" y="136171"/>
                  </a:lnTo>
                  <a:lnTo>
                    <a:pt x="133" y="136852"/>
                  </a:lnTo>
                  <a:lnTo>
                    <a:pt x="132" y="137533"/>
                  </a:lnTo>
                  <a:lnTo>
                    <a:pt x="131" y="138213"/>
                  </a:lnTo>
                  <a:lnTo>
                    <a:pt x="131" y="138894"/>
                  </a:lnTo>
                  <a:lnTo>
                    <a:pt x="130" y="139575"/>
                  </a:lnTo>
                  <a:lnTo>
                    <a:pt x="129" y="140256"/>
                  </a:lnTo>
                  <a:lnTo>
                    <a:pt x="129" y="140937"/>
                  </a:lnTo>
                  <a:lnTo>
                    <a:pt x="128" y="141618"/>
                  </a:lnTo>
                  <a:lnTo>
                    <a:pt x="127" y="142299"/>
                  </a:lnTo>
                  <a:lnTo>
                    <a:pt x="127" y="142979"/>
                  </a:lnTo>
                  <a:lnTo>
                    <a:pt x="126" y="143660"/>
                  </a:lnTo>
                  <a:lnTo>
                    <a:pt x="126" y="144341"/>
                  </a:lnTo>
                  <a:lnTo>
                    <a:pt x="125" y="145022"/>
                  </a:lnTo>
                  <a:lnTo>
                    <a:pt x="125" y="145703"/>
                  </a:lnTo>
                  <a:lnTo>
                    <a:pt x="124" y="146384"/>
                  </a:lnTo>
                  <a:lnTo>
                    <a:pt x="124" y="147065"/>
                  </a:lnTo>
                  <a:lnTo>
                    <a:pt x="124" y="147745"/>
                  </a:lnTo>
                  <a:lnTo>
                    <a:pt x="124" y="148426"/>
                  </a:lnTo>
                  <a:lnTo>
                    <a:pt x="123" y="149107"/>
                  </a:lnTo>
                  <a:lnTo>
                    <a:pt x="123" y="149788"/>
                  </a:lnTo>
                  <a:lnTo>
                    <a:pt x="123" y="150469"/>
                  </a:lnTo>
                  <a:lnTo>
                    <a:pt x="123" y="151150"/>
                  </a:lnTo>
                  <a:lnTo>
                    <a:pt x="123" y="151831"/>
                  </a:lnTo>
                  <a:lnTo>
                    <a:pt x="124" y="152511"/>
                  </a:lnTo>
                  <a:lnTo>
                    <a:pt x="124" y="153192"/>
                  </a:lnTo>
                  <a:lnTo>
                    <a:pt x="124" y="153873"/>
                  </a:lnTo>
                  <a:lnTo>
                    <a:pt x="124" y="154554"/>
                  </a:lnTo>
                  <a:lnTo>
                    <a:pt x="125" y="155235"/>
                  </a:lnTo>
                  <a:lnTo>
                    <a:pt x="125" y="155916"/>
                  </a:lnTo>
                  <a:lnTo>
                    <a:pt x="126" y="156597"/>
                  </a:lnTo>
                  <a:lnTo>
                    <a:pt x="127" y="157277"/>
                  </a:lnTo>
                  <a:lnTo>
                    <a:pt x="128" y="157958"/>
                  </a:lnTo>
                  <a:lnTo>
                    <a:pt x="128" y="158639"/>
                  </a:lnTo>
                  <a:lnTo>
                    <a:pt x="129" y="159320"/>
                  </a:lnTo>
                  <a:lnTo>
                    <a:pt x="130" y="160001"/>
                  </a:lnTo>
                  <a:lnTo>
                    <a:pt x="132" y="160682"/>
                  </a:lnTo>
                  <a:lnTo>
                    <a:pt x="133" y="161363"/>
                  </a:lnTo>
                  <a:lnTo>
                    <a:pt x="134" y="162043"/>
                  </a:lnTo>
                  <a:lnTo>
                    <a:pt x="136" y="162724"/>
                  </a:lnTo>
                  <a:lnTo>
                    <a:pt x="137" y="163405"/>
                  </a:lnTo>
                  <a:lnTo>
                    <a:pt x="139" y="164086"/>
                  </a:lnTo>
                  <a:lnTo>
                    <a:pt x="141" y="164767"/>
                  </a:lnTo>
                  <a:lnTo>
                    <a:pt x="142" y="165448"/>
                  </a:lnTo>
                  <a:lnTo>
                    <a:pt x="144" y="166129"/>
                  </a:lnTo>
                  <a:lnTo>
                    <a:pt x="146" y="166809"/>
                  </a:lnTo>
                  <a:lnTo>
                    <a:pt x="149" y="167490"/>
                  </a:lnTo>
                  <a:lnTo>
                    <a:pt x="151" y="168171"/>
                  </a:lnTo>
                  <a:lnTo>
                    <a:pt x="153" y="168852"/>
                  </a:lnTo>
                  <a:lnTo>
                    <a:pt x="156" y="169533"/>
                  </a:lnTo>
                  <a:lnTo>
                    <a:pt x="159" y="170214"/>
                  </a:lnTo>
                  <a:lnTo>
                    <a:pt x="161" y="170895"/>
                  </a:lnTo>
                  <a:lnTo>
                    <a:pt x="164" y="171575"/>
                  </a:lnTo>
                  <a:lnTo>
                    <a:pt x="167" y="172256"/>
                  </a:lnTo>
                  <a:lnTo>
                    <a:pt x="170" y="172937"/>
                  </a:lnTo>
                  <a:lnTo>
                    <a:pt x="173" y="173618"/>
                  </a:lnTo>
                  <a:lnTo>
                    <a:pt x="177" y="174299"/>
                  </a:lnTo>
                  <a:lnTo>
                    <a:pt x="180" y="174980"/>
                  </a:lnTo>
                  <a:lnTo>
                    <a:pt x="184" y="175661"/>
                  </a:lnTo>
                  <a:lnTo>
                    <a:pt x="187" y="176341"/>
                  </a:lnTo>
                  <a:lnTo>
                    <a:pt x="191" y="177022"/>
                  </a:lnTo>
                  <a:lnTo>
                    <a:pt x="195" y="177703"/>
                  </a:lnTo>
                  <a:lnTo>
                    <a:pt x="199" y="178384"/>
                  </a:lnTo>
                  <a:lnTo>
                    <a:pt x="203" y="179065"/>
                  </a:lnTo>
                  <a:lnTo>
                    <a:pt x="207" y="179746"/>
                  </a:lnTo>
                  <a:lnTo>
                    <a:pt x="212" y="180427"/>
                  </a:lnTo>
                  <a:lnTo>
                    <a:pt x="216" y="181107"/>
                  </a:lnTo>
                  <a:lnTo>
                    <a:pt x="221" y="181788"/>
                  </a:lnTo>
                  <a:lnTo>
                    <a:pt x="225" y="182469"/>
                  </a:lnTo>
                  <a:lnTo>
                    <a:pt x="230" y="183150"/>
                  </a:lnTo>
                  <a:lnTo>
                    <a:pt x="235" y="183831"/>
                  </a:lnTo>
                  <a:lnTo>
                    <a:pt x="240" y="184512"/>
                  </a:lnTo>
                  <a:lnTo>
                    <a:pt x="245" y="185193"/>
                  </a:lnTo>
                  <a:lnTo>
                    <a:pt x="250" y="185873"/>
                  </a:lnTo>
                  <a:lnTo>
                    <a:pt x="256" y="186554"/>
                  </a:lnTo>
                  <a:lnTo>
                    <a:pt x="261" y="187235"/>
                  </a:lnTo>
                  <a:lnTo>
                    <a:pt x="266" y="187916"/>
                  </a:lnTo>
                  <a:lnTo>
                    <a:pt x="272" y="188597"/>
                  </a:lnTo>
                  <a:lnTo>
                    <a:pt x="277" y="189278"/>
                  </a:lnTo>
                  <a:lnTo>
                    <a:pt x="283" y="189959"/>
                  </a:lnTo>
                  <a:lnTo>
                    <a:pt x="289" y="190639"/>
                  </a:lnTo>
                  <a:lnTo>
                    <a:pt x="295" y="191320"/>
                  </a:lnTo>
                  <a:lnTo>
                    <a:pt x="301" y="192001"/>
                  </a:lnTo>
                  <a:lnTo>
                    <a:pt x="307" y="192682"/>
                  </a:lnTo>
                  <a:lnTo>
                    <a:pt x="313" y="193363"/>
                  </a:lnTo>
                  <a:lnTo>
                    <a:pt x="319" y="194044"/>
                  </a:lnTo>
                  <a:lnTo>
                    <a:pt x="325" y="194725"/>
                  </a:lnTo>
                  <a:lnTo>
                    <a:pt x="331" y="195405"/>
                  </a:lnTo>
                  <a:lnTo>
                    <a:pt x="337" y="196086"/>
                  </a:lnTo>
                  <a:lnTo>
                    <a:pt x="344" y="196767"/>
                  </a:lnTo>
                  <a:lnTo>
                    <a:pt x="350" y="197448"/>
                  </a:lnTo>
                  <a:lnTo>
                    <a:pt x="356" y="198129"/>
                  </a:lnTo>
                  <a:lnTo>
                    <a:pt x="363" y="198810"/>
                  </a:lnTo>
                  <a:lnTo>
                    <a:pt x="369" y="199490"/>
                  </a:lnTo>
                  <a:lnTo>
                    <a:pt x="375" y="200171"/>
                  </a:lnTo>
                  <a:lnTo>
                    <a:pt x="382" y="200852"/>
                  </a:lnTo>
                  <a:lnTo>
                    <a:pt x="388" y="201533"/>
                  </a:lnTo>
                  <a:lnTo>
                    <a:pt x="395" y="202214"/>
                  </a:lnTo>
                  <a:lnTo>
                    <a:pt x="401" y="202895"/>
                  </a:lnTo>
                  <a:lnTo>
                    <a:pt x="408" y="203576"/>
                  </a:lnTo>
                  <a:lnTo>
                    <a:pt x="414" y="204256"/>
                  </a:lnTo>
                  <a:lnTo>
                    <a:pt x="421" y="204937"/>
                  </a:lnTo>
                  <a:lnTo>
                    <a:pt x="427" y="205618"/>
                  </a:lnTo>
                  <a:lnTo>
                    <a:pt x="433" y="206299"/>
                  </a:lnTo>
                  <a:lnTo>
                    <a:pt x="440" y="206980"/>
                  </a:lnTo>
                  <a:lnTo>
                    <a:pt x="446" y="207661"/>
                  </a:lnTo>
                  <a:lnTo>
                    <a:pt x="452" y="208342"/>
                  </a:lnTo>
                  <a:lnTo>
                    <a:pt x="458" y="209022"/>
                  </a:lnTo>
                  <a:lnTo>
                    <a:pt x="465" y="209703"/>
                  </a:lnTo>
                  <a:lnTo>
                    <a:pt x="471" y="210384"/>
                  </a:lnTo>
                  <a:lnTo>
                    <a:pt x="477" y="211065"/>
                  </a:lnTo>
                  <a:lnTo>
                    <a:pt x="483" y="211746"/>
                  </a:lnTo>
                  <a:lnTo>
                    <a:pt x="488" y="212427"/>
                  </a:lnTo>
                  <a:lnTo>
                    <a:pt x="494" y="213108"/>
                  </a:lnTo>
                  <a:lnTo>
                    <a:pt x="500" y="213788"/>
                  </a:lnTo>
                  <a:lnTo>
                    <a:pt x="506" y="214469"/>
                  </a:lnTo>
                  <a:lnTo>
                    <a:pt x="511" y="215150"/>
                  </a:lnTo>
                  <a:lnTo>
                    <a:pt x="516" y="215831"/>
                  </a:lnTo>
                  <a:lnTo>
                    <a:pt x="522" y="216512"/>
                  </a:lnTo>
                  <a:lnTo>
                    <a:pt x="527" y="217193"/>
                  </a:lnTo>
                  <a:lnTo>
                    <a:pt x="532" y="217874"/>
                  </a:lnTo>
                  <a:lnTo>
                    <a:pt x="537" y="218554"/>
                  </a:lnTo>
                  <a:lnTo>
                    <a:pt x="542" y="219235"/>
                  </a:lnTo>
                  <a:lnTo>
                    <a:pt x="546" y="219916"/>
                  </a:lnTo>
                  <a:lnTo>
                    <a:pt x="551" y="220597"/>
                  </a:lnTo>
                  <a:lnTo>
                    <a:pt x="555" y="221278"/>
                  </a:lnTo>
                  <a:lnTo>
                    <a:pt x="559" y="221959"/>
                  </a:lnTo>
                  <a:lnTo>
                    <a:pt x="564" y="222640"/>
                  </a:lnTo>
                  <a:lnTo>
                    <a:pt x="567" y="223320"/>
                  </a:lnTo>
                  <a:lnTo>
                    <a:pt x="571" y="224001"/>
                  </a:lnTo>
                  <a:lnTo>
                    <a:pt x="575" y="224682"/>
                  </a:lnTo>
                  <a:lnTo>
                    <a:pt x="578" y="225363"/>
                  </a:lnTo>
                  <a:lnTo>
                    <a:pt x="582" y="226044"/>
                  </a:lnTo>
                  <a:lnTo>
                    <a:pt x="585" y="226725"/>
                  </a:lnTo>
                  <a:lnTo>
                    <a:pt x="588" y="227406"/>
                  </a:lnTo>
                  <a:lnTo>
                    <a:pt x="590" y="228086"/>
                  </a:lnTo>
                  <a:lnTo>
                    <a:pt x="593" y="228767"/>
                  </a:lnTo>
                  <a:lnTo>
                    <a:pt x="595" y="229448"/>
                  </a:lnTo>
                  <a:lnTo>
                    <a:pt x="597" y="230129"/>
                  </a:lnTo>
                  <a:lnTo>
                    <a:pt x="599" y="230810"/>
                  </a:lnTo>
                  <a:lnTo>
                    <a:pt x="601" y="231491"/>
                  </a:lnTo>
                  <a:lnTo>
                    <a:pt x="603" y="232172"/>
                  </a:lnTo>
                  <a:lnTo>
                    <a:pt x="604" y="232852"/>
                  </a:lnTo>
                  <a:lnTo>
                    <a:pt x="605" y="233533"/>
                  </a:lnTo>
                  <a:lnTo>
                    <a:pt x="606" y="234214"/>
                  </a:lnTo>
                  <a:lnTo>
                    <a:pt x="607" y="234895"/>
                  </a:lnTo>
                  <a:lnTo>
                    <a:pt x="607" y="235576"/>
                  </a:lnTo>
                  <a:lnTo>
                    <a:pt x="608" y="236257"/>
                  </a:lnTo>
                  <a:lnTo>
                    <a:pt x="608" y="236938"/>
                  </a:lnTo>
                  <a:lnTo>
                    <a:pt x="608" y="237618"/>
                  </a:lnTo>
                  <a:lnTo>
                    <a:pt x="608" y="238299"/>
                  </a:lnTo>
                  <a:lnTo>
                    <a:pt x="607" y="238980"/>
                  </a:lnTo>
                  <a:lnTo>
                    <a:pt x="606" y="239661"/>
                  </a:lnTo>
                  <a:lnTo>
                    <a:pt x="606" y="240342"/>
                  </a:lnTo>
                  <a:lnTo>
                    <a:pt x="605" y="241023"/>
                  </a:lnTo>
                  <a:lnTo>
                    <a:pt x="603" y="241704"/>
                  </a:lnTo>
                  <a:lnTo>
                    <a:pt x="602" y="242384"/>
                  </a:lnTo>
                  <a:lnTo>
                    <a:pt x="600" y="243065"/>
                  </a:lnTo>
                  <a:lnTo>
                    <a:pt x="598" y="243746"/>
                  </a:lnTo>
                  <a:lnTo>
                    <a:pt x="596" y="244427"/>
                  </a:lnTo>
                  <a:lnTo>
                    <a:pt x="594" y="245108"/>
                  </a:lnTo>
                  <a:lnTo>
                    <a:pt x="591" y="245789"/>
                  </a:lnTo>
                  <a:lnTo>
                    <a:pt x="589" y="246470"/>
                  </a:lnTo>
                  <a:lnTo>
                    <a:pt x="586" y="247150"/>
                  </a:lnTo>
                  <a:lnTo>
                    <a:pt x="583" y="247831"/>
                  </a:lnTo>
                  <a:lnTo>
                    <a:pt x="580" y="248512"/>
                  </a:lnTo>
                  <a:lnTo>
                    <a:pt x="576" y="249193"/>
                  </a:lnTo>
                  <a:lnTo>
                    <a:pt x="573" y="249874"/>
                  </a:lnTo>
                  <a:lnTo>
                    <a:pt x="569" y="250555"/>
                  </a:lnTo>
                  <a:lnTo>
                    <a:pt x="565" y="251236"/>
                  </a:lnTo>
                  <a:lnTo>
                    <a:pt x="561" y="251916"/>
                  </a:lnTo>
                  <a:lnTo>
                    <a:pt x="557" y="252597"/>
                  </a:lnTo>
                  <a:lnTo>
                    <a:pt x="553" y="253278"/>
                  </a:lnTo>
                  <a:lnTo>
                    <a:pt x="548" y="253959"/>
                  </a:lnTo>
                  <a:lnTo>
                    <a:pt x="544" y="254640"/>
                  </a:lnTo>
                  <a:lnTo>
                    <a:pt x="539" y="255321"/>
                  </a:lnTo>
                  <a:lnTo>
                    <a:pt x="534" y="256002"/>
                  </a:lnTo>
                  <a:lnTo>
                    <a:pt x="529" y="256682"/>
                  </a:lnTo>
                  <a:lnTo>
                    <a:pt x="523" y="257363"/>
                  </a:lnTo>
                  <a:lnTo>
                    <a:pt x="518" y="258044"/>
                  </a:lnTo>
                  <a:lnTo>
                    <a:pt x="513" y="258725"/>
                  </a:lnTo>
                  <a:lnTo>
                    <a:pt x="507" y="259406"/>
                  </a:lnTo>
                  <a:lnTo>
                    <a:pt x="501" y="260087"/>
                  </a:lnTo>
                  <a:lnTo>
                    <a:pt x="496" y="260768"/>
                  </a:lnTo>
                  <a:lnTo>
                    <a:pt x="490" y="261448"/>
                  </a:lnTo>
                  <a:lnTo>
                    <a:pt x="484" y="262129"/>
                  </a:lnTo>
                  <a:lnTo>
                    <a:pt x="478" y="262810"/>
                  </a:lnTo>
                  <a:lnTo>
                    <a:pt x="472" y="263491"/>
                  </a:lnTo>
                  <a:lnTo>
                    <a:pt x="465" y="264172"/>
                  </a:lnTo>
                  <a:lnTo>
                    <a:pt x="459" y="264853"/>
                  </a:lnTo>
                  <a:lnTo>
                    <a:pt x="453" y="265534"/>
                  </a:lnTo>
                  <a:lnTo>
                    <a:pt x="446" y="266214"/>
                  </a:lnTo>
                  <a:lnTo>
                    <a:pt x="440" y="266895"/>
                  </a:lnTo>
                  <a:lnTo>
                    <a:pt x="433" y="267576"/>
                  </a:lnTo>
                  <a:lnTo>
                    <a:pt x="427" y="268257"/>
                  </a:lnTo>
                  <a:lnTo>
                    <a:pt x="420" y="268938"/>
                  </a:lnTo>
                  <a:lnTo>
                    <a:pt x="413" y="269619"/>
                  </a:lnTo>
                  <a:lnTo>
                    <a:pt x="407" y="270300"/>
                  </a:lnTo>
                  <a:lnTo>
                    <a:pt x="400" y="270980"/>
                  </a:lnTo>
                  <a:lnTo>
                    <a:pt x="393" y="271661"/>
                  </a:lnTo>
                  <a:lnTo>
                    <a:pt x="386" y="272342"/>
                  </a:lnTo>
                  <a:lnTo>
                    <a:pt x="380" y="273023"/>
                  </a:lnTo>
                  <a:lnTo>
                    <a:pt x="373" y="273704"/>
                  </a:lnTo>
                  <a:lnTo>
                    <a:pt x="366" y="274385"/>
                  </a:lnTo>
                  <a:lnTo>
                    <a:pt x="359" y="275066"/>
                  </a:lnTo>
                  <a:lnTo>
                    <a:pt x="352" y="275746"/>
                  </a:lnTo>
                  <a:lnTo>
                    <a:pt x="346" y="276427"/>
                  </a:lnTo>
                  <a:lnTo>
                    <a:pt x="339" y="277108"/>
                  </a:lnTo>
                  <a:lnTo>
                    <a:pt x="332" y="277789"/>
                  </a:lnTo>
                  <a:lnTo>
                    <a:pt x="325" y="278470"/>
                  </a:lnTo>
                  <a:lnTo>
                    <a:pt x="319" y="279151"/>
                  </a:lnTo>
                  <a:lnTo>
                    <a:pt x="312" y="279832"/>
                  </a:lnTo>
                  <a:lnTo>
                    <a:pt x="305" y="280512"/>
                  </a:lnTo>
                  <a:lnTo>
                    <a:pt x="299" y="281193"/>
                  </a:lnTo>
                  <a:lnTo>
                    <a:pt x="292" y="281874"/>
                  </a:lnTo>
                  <a:lnTo>
                    <a:pt x="286" y="282555"/>
                  </a:lnTo>
                  <a:lnTo>
                    <a:pt x="279" y="283236"/>
                  </a:lnTo>
                  <a:lnTo>
                    <a:pt x="273" y="283917"/>
                  </a:lnTo>
                  <a:lnTo>
                    <a:pt x="267" y="284598"/>
                  </a:lnTo>
                  <a:lnTo>
                    <a:pt x="260" y="285278"/>
                  </a:lnTo>
                  <a:lnTo>
                    <a:pt x="254" y="285959"/>
                  </a:lnTo>
                  <a:lnTo>
                    <a:pt x="248" y="286640"/>
                  </a:lnTo>
                  <a:lnTo>
                    <a:pt x="242" y="287321"/>
                  </a:lnTo>
                  <a:lnTo>
                    <a:pt x="236" y="288002"/>
                  </a:lnTo>
                  <a:lnTo>
                    <a:pt x="230" y="288683"/>
                  </a:lnTo>
                  <a:lnTo>
                    <a:pt x="224" y="289364"/>
                  </a:lnTo>
                  <a:lnTo>
                    <a:pt x="218" y="290044"/>
                  </a:lnTo>
                  <a:lnTo>
                    <a:pt x="212" y="290725"/>
                  </a:lnTo>
                  <a:lnTo>
                    <a:pt x="207" y="291406"/>
                  </a:lnTo>
                  <a:lnTo>
                    <a:pt x="201" y="292087"/>
                  </a:lnTo>
                  <a:lnTo>
                    <a:pt x="196" y="292768"/>
                  </a:lnTo>
                  <a:lnTo>
                    <a:pt x="190" y="293449"/>
                  </a:lnTo>
                  <a:lnTo>
                    <a:pt x="185" y="294130"/>
                  </a:lnTo>
                  <a:lnTo>
                    <a:pt x="180" y="294810"/>
                  </a:lnTo>
                  <a:lnTo>
                    <a:pt x="175" y="295491"/>
                  </a:lnTo>
                  <a:lnTo>
                    <a:pt x="170" y="296172"/>
                  </a:lnTo>
                  <a:lnTo>
                    <a:pt x="165" y="296853"/>
                  </a:lnTo>
                  <a:lnTo>
                    <a:pt x="160" y="297534"/>
                  </a:lnTo>
                  <a:lnTo>
                    <a:pt x="155" y="298215"/>
                  </a:lnTo>
                  <a:lnTo>
                    <a:pt x="150" y="298896"/>
                  </a:lnTo>
                  <a:lnTo>
                    <a:pt x="146" y="299576"/>
                  </a:lnTo>
                  <a:lnTo>
                    <a:pt x="141" y="300257"/>
                  </a:lnTo>
                  <a:lnTo>
                    <a:pt x="137" y="300938"/>
                  </a:lnTo>
                  <a:lnTo>
                    <a:pt x="133" y="301619"/>
                  </a:lnTo>
                  <a:lnTo>
                    <a:pt x="128" y="302300"/>
                  </a:lnTo>
                  <a:lnTo>
                    <a:pt x="124" y="302981"/>
                  </a:lnTo>
                  <a:lnTo>
                    <a:pt x="120" y="303662"/>
                  </a:lnTo>
                  <a:lnTo>
                    <a:pt x="116" y="304342"/>
                  </a:lnTo>
                  <a:lnTo>
                    <a:pt x="112" y="305023"/>
                  </a:lnTo>
                  <a:lnTo>
                    <a:pt x="109" y="305704"/>
                  </a:lnTo>
                  <a:lnTo>
                    <a:pt x="105" y="306385"/>
                  </a:lnTo>
                  <a:lnTo>
                    <a:pt x="101" y="307066"/>
                  </a:lnTo>
                  <a:lnTo>
                    <a:pt x="98" y="307747"/>
                  </a:lnTo>
                  <a:lnTo>
                    <a:pt x="94" y="308428"/>
                  </a:lnTo>
                  <a:lnTo>
                    <a:pt x="91" y="309108"/>
                  </a:lnTo>
                  <a:lnTo>
                    <a:pt x="88" y="309789"/>
                  </a:lnTo>
                  <a:lnTo>
                    <a:pt x="85" y="310470"/>
                  </a:lnTo>
                  <a:lnTo>
                    <a:pt x="82" y="311151"/>
                  </a:lnTo>
                  <a:lnTo>
                    <a:pt x="79" y="311832"/>
                  </a:lnTo>
                  <a:lnTo>
                    <a:pt x="76" y="312513"/>
                  </a:lnTo>
                  <a:lnTo>
                    <a:pt x="73" y="313194"/>
                  </a:lnTo>
                  <a:lnTo>
                    <a:pt x="70" y="313874"/>
                  </a:lnTo>
                  <a:lnTo>
                    <a:pt x="67" y="314555"/>
                  </a:lnTo>
                  <a:lnTo>
                    <a:pt x="65" y="315236"/>
                  </a:lnTo>
                  <a:lnTo>
                    <a:pt x="62" y="315917"/>
                  </a:lnTo>
                  <a:lnTo>
                    <a:pt x="60" y="316598"/>
                  </a:lnTo>
                  <a:lnTo>
                    <a:pt x="58" y="317279"/>
                  </a:lnTo>
                  <a:lnTo>
                    <a:pt x="55" y="317960"/>
                  </a:lnTo>
                  <a:lnTo>
                    <a:pt x="53" y="318640"/>
                  </a:lnTo>
                  <a:lnTo>
                    <a:pt x="51" y="319321"/>
                  </a:lnTo>
                  <a:lnTo>
                    <a:pt x="49" y="320002"/>
                  </a:lnTo>
                  <a:lnTo>
                    <a:pt x="47" y="320683"/>
                  </a:lnTo>
                  <a:lnTo>
                    <a:pt x="45" y="321364"/>
                  </a:lnTo>
                  <a:lnTo>
                    <a:pt x="43" y="322045"/>
                  </a:lnTo>
                  <a:lnTo>
                    <a:pt x="41" y="322726"/>
                  </a:lnTo>
                  <a:lnTo>
                    <a:pt x="39" y="323406"/>
                  </a:lnTo>
                  <a:lnTo>
                    <a:pt x="38" y="324087"/>
                  </a:lnTo>
                  <a:lnTo>
                    <a:pt x="36" y="324768"/>
                  </a:lnTo>
                  <a:lnTo>
                    <a:pt x="35" y="325449"/>
                  </a:lnTo>
                  <a:lnTo>
                    <a:pt x="33" y="326130"/>
                  </a:lnTo>
                  <a:lnTo>
                    <a:pt x="32" y="326811"/>
                  </a:lnTo>
                  <a:lnTo>
                    <a:pt x="30" y="327492"/>
                  </a:lnTo>
                  <a:lnTo>
                    <a:pt x="29" y="328172"/>
                  </a:lnTo>
                  <a:lnTo>
                    <a:pt x="28" y="328853"/>
                  </a:lnTo>
                  <a:lnTo>
                    <a:pt x="26" y="329534"/>
                  </a:lnTo>
                  <a:lnTo>
                    <a:pt x="25" y="330215"/>
                  </a:lnTo>
                  <a:lnTo>
                    <a:pt x="24" y="330896"/>
                  </a:lnTo>
                  <a:lnTo>
                    <a:pt x="23" y="331577"/>
                  </a:lnTo>
                  <a:lnTo>
                    <a:pt x="22" y="332258"/>
                  </a:lnTo>
                  <a:lnTo>
                    <a:pt x="21" y="332938"/>
                  </a:lnTo>
                  <a:lnTo>
                    <a:pt x="20" y="333619"/>
                  </a:lnTo>
                  <a:lnTo>
                    <a:pt x="19" y="334300"/>
                  </a:lnTo>
                  <a:lnTo>
                    <a:pt x="18" y="334981"/>
                  </a:lnTo>
                  <a:lnTo>
                    <a:pt x="17" y="335662"/>
                  </a:lnTo>
                  <a:lnTo>
                    <a:pt x="16" y="336343"/>
                  </a:lnTo>
                  <a:lnTo>
                    <a:pt x="15" y="337024"/>
                  </a:lnTo>
                  <a:lnTo>
                    <a:pt x="15" y="337704"/>
                  </a:lnTo>
                  <a:lnTo>
                    <a:pt x="14" y="338385"/>
                  </a:lnTo>
                  <a:lnTo>
                    <a:pt x="13" y="339066"/>
                  </a:lnTo>
                  <a:lnTo>
                    <a:pt x="12" y="339747"/>
                  </a:lnTo>
                  <a:lnTo>
                    <a:pt x="12" y="340428"/>
                  </a:lnTo>
                  <a:lnTo>
                    <a:pt x="11" y="341109"/>
                  </a:lnTo>
                  <a:lnTo>
                    <a:pt x="11" y="341790"/>
                  </a:lnTo>
                  <a:lnTo>
                    <a:pt x="10" y="342470"/>
                  </a:lnTo>
                  <a:lnTo>
                    <a:pt x="9" y="343151"/>
                  </a:lnTo>
                  <a:lnTo>
                    <a:pt x="9" y="343832"/>
                  </a:lnTo>
                  <a:lnTo>
                    <a:pt x="8" y="344513"/>
                  </a:lnTo>
                  <a:lnTo>
                    <a:pt x="8" y="345194"/>
                  </a:lnTo>
                  <a:lnTo>
                    <a:pt x="8" y="345875"/>
                  </a:lnTo>
                  <a:lnTo>
                    <a:pt x="7" y="346556"/>
                  </a:lnTo>
                  <a:lnTo>
                    <a:pt x="7" y="347236"/>
                  </a:lnTo>
                  <a:lnTo>
                    <a:pt x="6" y="347917"/>
                  </a:lnTo>
                  <a:lnTo>
                    <a:pt x="0" y="347917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36" name="pl18"/>
            <p:cNvSpPr/>
            <p:nvPr/>
          </p:nvSpPr>
          <p:spPr>
            <a:xfrm>
              <a:off x="2542462" y="3132227"/>
              <a:ext cx="209" cy="852596"/>
            </a:xfrm>
            <a:custGeom>
              <a:avLst/>
              <a:gdLst/>
              <a:ahLst/>
              <a:cxnLst/>
              <a:rect l="0" t="0" r="0" b="0"/>
              <a:pathLst>
                <a:path w="209" h="852596">
                  <a:moveTo>
                    <a:pt x="209" y="852596"/>
                  </a:moveTo>
                  <a:lnTo>
                    <a:pt x="208" y="852596"/>
                  </a:lnTo>
                  <a:lnTo>
                    <a:pt x="208" y="850928"/>
                  </a:lnTo>
                  <a:lnTo>
                    <a:pt x="208" y="849259"/>
                  </a:lnTo>
                  <a:lnTo>
                    <a:pt x="208" y="847591"/>
                  </a:lnTo>
                  <a:lnTo>
                    <a:pt x="208" y="845922"/>
                  </a:lnTo>
                  <a:lnTo>
                    <a:pt x="207" y="844254"/>
                  </a:lnTo>
                  <a:lnTo>
                    <a:pt x="207" y="842585"/>
                  </a:lnTo>
                  <a:lnTo>
                    <a:pt x="207" y="840917"/>
                  </a:lnTo>
                  <a:lnTo>
                    <a:pt x="207" y="839248"/>
                  </a:lnTo>
                  <a:lnTo>
                    <a:pt x="207" y="837580"/>
                  </a:lnTo>
                  <a:lnTo>
                    <a:pt x="207" y="835911"/>
                  </a:lnTo>
                  <a:lnTo>
                    <a:pt x="207" y="834243"/>
                  </a:lnTo>
                  <a:lnTo>
                    <a:pt x="206" y="832574"/>
                  </a:lnTo>
                  <a:lnTo>
                    <a:pt x="206" y="830906"/>
                  </a:lnTo>
                  <a:lnTo>
                    <a:pt x="206" y="829237"/>
                  </a:lnTo>
                  <a:lnTo>
                    <a:pt x="206" y="827569"/>
                  </a:lnTo>
                  <a:lnTo>
                    <a:pt x="205" y="825900"/>
                  </a:lnTo>
                  <a:lnTo>
                    <a:pt x="205" y="824232"/>
                  </a:lnTo>
                  <a:lnTo>
                    <a:pt x="205" y="822564"/>
                  </a:lnTo>
                  <a:lnTo>
                    <a:pt x="205" y="820895"/>
                  </a:lnTo>
                  <a:lnTo>
                    <a:pt x="204" y="819227"/>
                  </a:lnTo>
                  <a:lnTo>
                    <a:pt x="204" y="817558"/>
                  </a:lnTo>
                  <a:lnTo>
                    <a:pt x="204" y="815890"/>
                  </a:lnTo>
                  <a:lnTo>
                    <a:pt x="203" y="814221"/>
                  </a:lnTo>
                  <a:lnTo>
                    <a:pt x="203" y="812553"/>
                  </a:lnTo>
                  <a:lnTo>
                    <a:pt x="203" y="810884"/>
                  </a:lnTo>
                  <a:lnTo>
                    <a:pt x="202" y="809216"/>
                  </a:lnTo>
                  <a:lnTo>
                    <a:pt x="202" y="807547"/>
                  </a:lnTo>
                  <a:lnTo>
                    <a:pt x="201" y="805879"/>
                  </a:lnTo>
                  <a:lnTo>
                    <a:pt x="201" y="804210"/>
                  </a:lnTo>
                  <a:lnTo>
                    <a:pt x="200" y="802542"/>
                  </a:lnTo>
                  <a:lnTo>
                    <a:pt x="200" y="800873"/>
                  </a:lnTo>
                  <a:lnTo>
                    <a:pt x="199" y="799205"/>
                  </a:lnTo>
                  <a:lnTo>
                    <a:pt x="199" y="797536"/>
                  </a:lnTo>
                  <a:lnTo>
                    <a:pt x="198" y="795868"/>
                  </a:lnTo>
                  <a:lnTo>
                    <a:pt x="197" y="794199"/>
                  </a:lnTo>
                  <a:lnTo>
                    <a:pt x="197" y="792531"/>
                  </a:lnTo>
                  <a:lnTo>
                    <a:pt x="196" y="790862"/>
                  </a:lnTo>
                  <a:lnTo>
                    <a:pt x="196" y="789194"/>
                  </a:lnTo>
                  <a:lnTo>
                    <a:pt x="195" y="787525"/>
                  </a:lnTo>
                  <a:lnTo>
                    <a:pt x="194" y="785857"/>
                  </a:lnTo>
                  <a:lnTo>
                    <a:pt x="193" y="784188"/>
                  </a:lnTo>
                  <a:lnTo>
                    <a:pt x="192" y="782520"/>
                  </a:lnTo>
                  <a:lnTo>
                    <a:pt x="192" y="780851"/>
                  </a:lnTo>
                  <a:lnTo>
                    <a:pt x="191" y="779183"/>
                  </a:lnTo>
                  <a:lnTo>
                    <a:pt x="190" y="777514"/>
                  </a:lnTo>
                  <a:lnTo>
                    <a:pt x="189" y="775846"/>
                  </a:lnTo>
                  <a:lnTo>
                    <a:pt x="188" y="774177"/>
                  </a:lnTo>
                  <a:lnTo>
                    <a:pt x="187" y="772509"/>
                  </a:lnTo>
                  <a:lnTo>
                    <a:pt x="186" y="770840"/>
                  </a:lnTo>
                  <a:lnTo>
                    <a:pt x="185" y="769172"/>
                  </a:lnTo>
                  <a:lnTo>
                    <a:pt x="184" y="767503"/>
                  </a:lnTo>
                  <a:lnTo>
                    <a:pt x="183" y="765835"/>
                  </a:lnTo>
                  <a:lnTo>
                    <a:pt x="181" y="764166"/>
                  </a:lnTo>
                  <a:lnTo>
                    <a:pt x="180" y="762498"/>
                  </a:lnTo>
                  <a:lnTo>
                    <a:pt x="179" y="760830"/>
                  </a:lnTo>
                  <a:lnTo>
                    <a:pt x="178" y="759161"/>
                  </a:lnTo>
                  <a:lnTo>
                    <a:pt x="176" y="757493"/>
                  </a:lnTo>
                  <a:lnTo>
                    <a:pt x="175" y="755824"/>
                  </a:lnTo>
                  <a:lnTo>
                    <a:pt x="173" y="754156"/>
                  </a:lnTo>
                  <a:lnTo>
                    <a:pt x="172" y="752487"/>
                  </a:lnTo>
                  <a:lnTo>
                    <a:pt x="170" y="750819"/>
                  </a:lnTo>
                  <a:lnTo>
                    <a:pt x="169" y="749150"/>
                  </a:lnTo>
                  <a:lnTo>
                    <a:pt x="167" y="747482"/>
                  </a:lnTo>
                  <a:lnTo>
                    <a:pt x="166" y="745813"/>
                  </a:lnTo>
                  <a:lnTo>
                    <a:pt x="164" y="744145"/>
                  </a:lnTo>
                  <a:lnTo>
                    <a:pt x="162" y="742476"/>
                  </a:lnTo>
                  <a:lnTo>
                    <a:pt x="161" y="740808"/>
                  </a:lnTo>
                  <a:lnTo>
                    <a:pt x="159" y="739139"/>
                  </a:lnTo>
                  <a:lnTo>
                    <a:pt x="157" y="737471"/>
                  </a:lnTo>
                  <a:lnTo>
                    <a:pt x="155" y="735802"/>
                  </a:lnTo>
                  <a:lnTo>
                    <a:pt x="153" y="734134"/>
                  </a:lnTo>
                  <a:lnTo>
                    <a:pt x="151" y="732465"/>
                  </a:lnTo>
                  <a:lnTo>
                    <a:pt x="149" y="730797"/>
                  </a:lnTo>
                  <a:lnTo>
                    <a:pt x="147" y="729128"/>
                  </a:lnTo>
                  <a:lnTo>
                    <a:pt x="145" y="727460"/>
                  </a:lnTo>
                  <a:lnTo>
                    <a:pt x="143" y="725791"/>
                  </a:lnTo>
                  <a:lnTo>
                    <a:pt x="141" y="724123"/>
                  </a:lnTo>
                  <a:lnTo>
                    <a:pt x="139" y="722454"/>
                  </a:lnTo>
                  <a:lnTo>
                    <a:pt x="137" y="720786"/>
                  </a:lnTo>
                  <a:lnTo>
                    <a:pt x="135" y="719117"/>
                  </a:lnTo>
                  <a:lnTo>
                    <a:pt x="133" y="717449"/>
                  </a:lnTo>
                  <a:lnTo>
                    <a:pt x="130" y="715780"/>
                  </a:lnTo>
                  <a:lnTo>
                    <a:pt x="128" y="714112"/>
                  </a:lnTo>
                  <a:lnTo>
                    <a:pt x="126" y="712443"/>
                  </a:lnTo>
                  <a:lnTo>
                    <a:pt x="123" y="710775"/>
                  </a:lnTo>
                  <a:lnTo>
                    <a:pt x="121" y="709106"/>
                  </a:lnTo>
                  <a:lnTo>
                    <a:pt x="119" y="707438"/>
                  </a:lnTo>
                  <a:lnTo>
                    <a:pt x="116" y="705769"/>
                  </a:lnTo>
                  <a:lnTo>
                    <a:pt x="114" y="704101"/>
                  </a:lnTo>
                  <a:lnTo>
                    <a:pt x="112" y="702432"/>
                  </a:lnTo>
                  <a:lnTo>
                    <a:pt x="109" y="700764"/>
                  </a:lnTo>
                  <a:lnTo>
                    <a:pt x="107" y="699095"/>
                  </a:lnTo>
                  <a:lnTo>
                    <a:pt x="104" y="697427"/>
                  </a:lnTo>
                  <a:lnTo>
                    <a:pt x="102" y="695759"/>
                  </a:lnTo>
                  <a:lnTo>
                    <a:pt x="99" y="694090"/>
                  </a:lnTo>
                  <a:lnTo>
                    <a:pt x="97" y="692422"/>
                  </a:lnTo>
                  <a:lnTo>
                    <a:pt x="94" y="690753"/>
                  </a:lnTo>
                  <a:lnTo>
                    <a:pt x="92" y="689085"/>
                  </a:lnTo>
                  <a:lnTo>
                    <a:pt x="89" y="687416"/>
                  </a:lnTo>
                  <a:lnTo>
                    <a:pt x="87" y="685748"/>
                  </a:lnTo>
                  <a:lnTo>
                    <a:pt x="84" y="684079"/>
                  </a:lnTo>
                  <a:lnTo>
                    <a:pt x="82" y="682411"/>
                  </a:lnTo>
                  <a:lnTo>
                    <a:pt x="79" y="680742"/>
                  </a:lnTo>
                  <a:lnTo>
                    <a:pt x="77" y="679074"/>
                  </a:lnTo>
                  <a:lnTo>
                    <a:pt x="75" y="677405"/>
                  </a:lnTo>
                  <a:lnTo>
                    <a:pt x="72" y="675737"/>
                  </a:lnTo>
                  <a:lnTo>
                    <a:pt x="70" y="674068"/>
                  </a:lnTo>
                  <a:lnTo>
                    <a:pt x="67" y="672400"/>
                  </a:lnTo>
                  <a:lnTo>
                    <a:pt x="65" y="670731"/>
                  </a:lnTo>
                  <a:lnTo>
                    <a:pt x="63" y="669063"/>
                  </a:lnTo>
                  <a:lnTo>
                    <a:pt x="60" y="667394"/>
                  </a:lnTo>
                  <a:lnTo>
                    <a:pt x="58" y="665726"/>
                  </a:lnTo>
                  <a:lnTo>
                    <a:pt x="56" y="664057"/>
                  </a:lnTo>
                  <a:lnTo>
                    <a:pt x="54" y="662389"/>
                  </a:lnTo>
                  <a:lnTo>
                    <a:pt x="51" y="660720"/>
                  </a:lnTo>
                  <a:lnTo>
                    <a:pt x="49" y="659052"/>
                  </a:lnTo>
                  <a:lnTo>
                    <a:pt x="47" y="657383"/>
                  </a:lnTo>
                  <a:lnTo>
                    <a:pt x="45" y="655715"/>
                  </a:lnTo>
                  <a:lnTo>
                    <a:pt x="43" y="654046"/>
                  </a:lnTo>
                  <a:lnTo>
                    <a:pt x="41" y="652378"/>
                  </a:lnTo>
                  <a:lnTo>
                    <a:pt x="39" y="650709"/>
                  </a:lnTo>
                  <a:lnTo>
                    <a:pt x="37" y="649041"/>
                  </a:lnTo>
                  <a:lnTo>
                    <a:pt x="35" y="647372"/>
                  </a:lnTo>
                  <a:lnTo>
                    <a:pt x="33" y="645704"/>
                  </a:lnTo>
                  <a:lnTo>
                    <a:pt x="32" y="644035"/>
                  </a:lnTo>
                  <a:lnTo>
                    <a:pt x="30" y="642367"/>
                  </a:lnTo>
                  <a:lnTo>
                    <a:pt x="28" y="640698"/>
                  </a:lnTo>
                  <a:lnTo>
                    <a:pt x="26" y="639030"/>
                  </a:lnTo>
                  <a:lnTo>
                    <a:pt x="25" y="637361"/>
                  </a:lnTo>
                  <a:lnTo>
                    <a:pt x="23" y="635693"/>
                  </a:lnTo>
                  <a:lnTo>
                    <a:pt x="22" y="634025"/>
                  </a:lnTo>
                  <a:lnTo>
                    <a:pt x="20" y="632356"/>
                  </a:lnTo>
                  <a:lnTo>
                    <a:pt x="19" y="630688"/>
                  </a:lnTo>
                  <a:lnTo>
                    <a:pt x="17" y="629019"/>
                  </a:lnTo>
                  <a:lnTo>
                    <a:pt x="16" y="627351"/>
                  </a:lnTo>
                  <a:lnTo>
                    <a:pt x="15" y="625682"/>
                  </a:lnTo>
                  <a:lnTo>
                    <a:pt x="14" y="624014"/>
                  </a:lnTo>
                  <a:lnTo>
                    <a:pt x="13" y="622345"/>
                  </a:lnTo>
                  <a:lnTo>
                    <a:pt x="11" y="620677"/>
                  </a:lnTo>
                  <a:lnTo>
                    <a:pt x="10" y="619008"/>
                  </a:lnTo>
                  <a:lnTo>
                    <a:pt x="9" y="617340"/>
                  </a:lnTo>
                  <a:lnTo>
                    <a:pt x="8" y="615671"/>
                  </a:lnTo>
                  <a:lnTo>
                    <a:pt x="8" y="614003"/>
                  </a:lnTo>
                  <a:lnTo>
                    <a:pt x="7" y="612334"/>
                  </a:lnTo>
                  <a:lnTo>
                    <a:pt x="6" y="610666"/>
                  </a:lnTo>
                  <a:lnTo>
                    <a:pt x="5" y="608997"/>
                  </a:lnTo>
                  <a:lnTo>
                    <a:pt x="4" y="607329"/>
                  </a:lnTo>
                  <a:lnTo>
                    <a:pt x="4" y="605660"/>
                  </a:lnTo>
                  <a:lnTo>
                    <a:pt x="3" y="603992"/>
                  </a:lnTo>
                  <a:lnTo>
                    <a:pt x="3" y="602323"/>
                  </a:lnTo>
                  <a:lnTo>
                    <a:pt x="2" y="600655"/>
                  </a:lnTo>
                  <a:lnTo>
                    <a:pt x="2" y="598986"/>
                  </a:lnTo>
                  <a:lnTo>
                    <a:pt x="1" y="597318"/>
                  </a:lnTo>
                  <a:lnTo>
                    <a:pt x="1" y="595649"/>
                  </a:lnTo>
                  <a:lnTo>
                    <a:pt x="1" y="593981"/>
                  </a:lnTo>
                  <a:lnTo>
                    <a:pt x="0" y="592312"/>
                  </a:lnTo>
                  <a:lnTo>
                    <a:pt x="0" y="590644"/>
                  </a:lnTo>
                  <a:lnTo>
                    <a:pt x="0" y="588975"/>
                  </a:lnTo>
                  <a:lnTo>
                    <a:pt x="0" y="587307"/>
                  </a:lnTo>
                  <a:lnTo>
                    <a:pt x="0" y="585638"/>
                  </a:lnTo>
                  <a:lnTo>
                    <a:pt x="0" y="583970"/>
                  </a:lnTo>
                  <a:lnTo>
                    <a:pt x="0" y="582301"/>
                  </a:lnTo>
                  <a:lnTo>
                    <a:pt x="0" y="580633"/>
                  </a:lnTo>
                  <a:lnTo>
                    <a:pt x="0" y="578964"/>
                  </a:lnTo>
                  <a:lnTo>
                    <a:pt x="0" y="577296"/>
                  </a:lnTo>
                  <a:lnTo>
                    <a:pt x="0" y="575627"/>
                  </a:lnTo>
                  <a:lnTo>
                    <a:pt x="0" y="573959"/>
                  </a:lnTo>
                  <a:lnTo>
                    <a:pt x="0" y="572290"/>
                  </a:lnTo>
                  <a:lnTo>
                    <a:pt x="0" y="570622"/>
                  </a:lnTo>
                  <a:lnTo>
                    <a:pt x="0" y="568954"/>
                  </a:lnTo>
                  <a:lnTo>
                    <a:pt x="1" y="567285"/>
                  </a:lnTo>
                  <a:lnTo>
                    <a:pt x="1" y="565617"/>
                  </a:lnTo>
                  <a:lnTo>
                    <a:pt x="1" y="563948"/>
                  </a:lnTo>
                  <a:lnTo>
                    <a:pt x="2" y="562280"/>
                  </a:lnTo>
                  <a:lnTo>
                    <a:pt x="2" y="560611"/>
                  </a:lnTo>
                  <a:lnTo>
                    <a:pt x="2" y="558943"/>
                  </a:lnTo>
                  <a:lnTo>
                    <a:pt x="3" y="557274"/>
                  </a:lnTo>
                  <a:lnTo>
                    <a:pt x="3" y="555606"/>
                  </a:lnTo>
                  <a:lnTo>
                    <a:pt x="4" y="553937"/>
                  </a:lnTo>
                  <a:lnTo>
                    <a:pt x="4" y="552269"/>
                  </a:lnTo>
                  <a:lnTo>
                    <a:pt x="5" y="550600"/>
                  </a:lnTo>
                  <a:lnTo>
                    <a:pt x="5" y="548932"/>
                  </a:lnTo>
                  <a:lnTo>
                    <a:pt x="6" y="547263"/>
                  </a:lnTo>
                  <a:lnTo>
                    <a:pt x="7" y="545595"/>
                  </a:lnTo>
                  <a:lnTo>
                    <a:pt x="7" y="543926"/>
                  </a:lnTo>
                  <a:lnTo>
                    <a:pt x="8" y="542258"/>
                  </a:lnTo>
                  <a:lnTo>
                    <a:pt x="9" y="540589"/>
                  </a:lnTo>
                  <a:lnTo>
                    <a:pt x="9" y="538921"/>
                  </a:lnTo>
                  <a:lnTo>
                    <a:pt x="10" y="537252"/>
                  </a:lnTo>
                  <a:lnTo>
                    <a:pt x="11" y="535584"/>
                  </a:lnTo>
                  <a:lnTo>
                    <a:pt x="12" y="533915"/>
                  </a:lnTo>
                  <a:lnTo>
                    <a:pt x="12" y="532247"/>
                  </a:lnTo>
                  <a:lnTo>
                    <a:pt x="13" y="530578"/>
                  </a:lnTo>
                  <a:lnTo>
                    <a:pt x="14" y="528910"/>
                  </a:lnTo>
                  <a:lnTo>
                    <a:pt x="15" y="527241"/>
                  </a:lnTo>
                  <a:lnTo>
                    <a:pt x="16" y="525573"/>
                  </a:lnTo>
                  <a:lnTo>
                    <a:pt x="17" y="523904"/>
                  </a:lnTo>
                  <a:lnTo>
                    <a:pt x="18" y="522236"/>
                  </a:lnTo>
                  <a:lnTo>
                    <a:pt x="19" y="520567"/>
                  </a:lnTo>
                  <a:lnTo>
                    <a:pt x="20" y="518899"/>
                  </a:lnTo>
                  <a:lnTo>
                    <a:pt x="21" y="517230"/>
                  </a:lnTo>
                  <a:lnTo>
                    <a:pt x="22" y="515562"/>
                  </a:lnTo>
                  <a:lnTo>
                    <a:pt x="23" y="513893"/>
                  </a:lnTo>
                  <a:lnTo>
                    <a:pt x="24" y="512225"/>
                  </a:lnTo>
                  <a:lnTo>
                    <a:pt x="25" y="510556"/>
                  </a:lnTo>
                  <a:lnTo>
                    <a:pt x="27" y="508888"/>
                  </a:lnTo>
                  <a:lnTo>
                    <a:pt x="28" y="507220"/>
                  </a:lnTo>
                  <a:lnTo>
                    <a:pt x="29" y="505551"/>
                  </a:lnTo>
                  <a:lnTo>
                    <a:pt x="30" y="503883"/>
                  </a:lnTo>
                  <a:lnTo>
                    <a:pt x="32" y="502214"/>
                  </a:lnTo>
                  <a:lnTo>
                    <a:pt x="33" y="500546"/>
                  </a:lnTo>
                  <a:lnTo>
                    <a:pt x="34" y="498877"/>
                  </a:lnTo>
                  <a:lnTo>
                    <a:pt x="36" y="497209"/>
                  </a:lnTo>
                  <a:lnTo>
                    <a:pt x="37" y="495540"/>
                  </a:lnTo>
                  <a:lnTo>
                    <a:pt x="39" y="493872"/>
                  </a:lnTo>
                  <a:lnTo>
                    <a:pt x="40" y="492203"/>
                  </a:lnTo>
                  <a:lnTo>
                    <a:pt x="42" y="490535"/>
                  </a:lnTo>
                  <a:lnTo>
                    <a:pt x="43" y="488866"/>
                  </a:lnTo>
                  <a:lnTo>
                    <a:pt x="45" y="487198"/>
                  </a:lnTo>
                  <a:lnTo>
                    <a:pt x="46" y="485529"/>
                  </a:lnTo>
                  <a:lnTo>
                    <a:pt x="48" y="483861"/>
                  </a:lnTo>
                  <a:lnTo>
                    <a:pt x="50" y="482192"/>
                  </a:lnTo>
                  <a:lnTo>
                    <a:pt x="51" y="480524"/>
                  </a:lnTo>
                  <a:lnTo>
                    <a:pt x="53" y="478855"/>
                  </a:lnTo>
                  <a:lnTo>
                    <a:pt x="55" y="477187"/>
                  </a:lnTo>
                  <a:lnTo>
                    <a:pt x="56" y="475518"/>
                  </a:lnTo>
                  <a:lnTo>
                    <a:pt x="58" y="473850"/>
                  </a:lnTo>
                  <a:lnTo>
                    <a:pt x="60" y="472181"/>
                  </a:lnTo>
                  <a:lnTo>
                    <a:pt x="62" y="470513"/>
                  </a:lnTo>
                  <a:lnTo>
                    <a:pt x="64" y="468844"/>
                  </a:lnTo>
                  <a:lnTo>
                    <a:pt x="65" y="467176"/>
                  </a:lnTo>
                  <a:lnTo>
                    <a:pt x="67" y="465507"/>
                  </a:lnTo>
                  <a:lnTo>
                    <a:pt x="69" y="463839"/>
                  </a:lnTo>
                  <a:lnTo>
                    <a:pt x="71" y="462170"/>
                  </a:lnTo>
                  <a:lnTo>
                    <a:pt x="73" y="460502"/>
                  </a:lnTo>
                  <a:lnTo>
                    <a:pt x="75" y="458833"/>
                  </a:lnTo>
                  <a:lnTo>
                    <a:pt x="77" y="457165"/>
                  </a:lnTo>
                  <a:lnTo>
                    <a:pt x="79" y="455496"/>
                  </a:lnTo>
                  <a:lnTo>
                    <a:pt x="81" y="453828"/>
                  </a:lnTo>
                  <a:lnTo>
                    <a:pt x="83" y="452159"/>
                  </a:lnTo>
                  <a:lnTo>
                    <a:pt x="85" y="450491"/>
                  </a:lnTo>
                  <a:lnTo>
                    <a:pt x="87" y="448822"/>
                  </a:lnTo>
                  <a:lnTo>
                    <a:pt x="89" y="447154"/>
                  </a:lnTo>
                  <a:lnTo>
                    <a:pt x="91" y="445485"/>
                  </a:lnTo>
                  <a:lnTo>
                    <a:pt x="93" y="443817"/>
                  </a:lnTo>
                  <a:lnTo>
                    <a:pt x="95" y="442149"/>
                  </a:lnTo>
                  <a:lnTo>
                    <a:pt x="97" y="440480"/>
                  </a:lnTo>
                  <a:lnTo>
                    <a:pt x="99" y="438812"/>
                  </a:lnTo>
                  <a:lnTo>
                    <a:pt x="101" y="437143"/>
                  </a:lnTo>
                  <a:lnTo>
                    <a:pt x="103" y="435475"/>
                  </a:lnTo>
                  <a:lnTo>
                    <a:pt x="105" y="433806"/>
                  </a:lnTo>
                  <a:lnTo>
                    <a:pt x="107" y="432138"/>
                  </a:lnTo>
                  <a:lnTo>
                    <a:pt x="109" y="430469"/>
                  </a:lnTo>
                  <a:lnTo>
                    <a:pt x="111" y="428801"/>
                  </a:lnTo>
                  <a:lnTo>
                    <a:pt x="113" y="427132"/>
                  </a:lnTo>
                  <a:lnTo>
                    <a:pt x="115" y="425464"/>
                  </a:lnTo>
                  <a:lnTo>
                    <a:pt x="117" y="423795"/>
                  </a:lnTo>
                  <a:lnTo>
                    <a:pt x="119" y="422127"/>
                  </a:lnTo>
                  <a:lnTo>
                    <a:pt x="121" y="420458"/>
                  </a:lnTo>
                  <a:lnTo>
                    <a:pt x="123" y="418790"/>
                  </a:lnTo>
                  <a:lnTo>
                    <a:pt x="125" y="417121"/>
                  </a:lnTo>
                  <a:lnTo>
                    <a:pt x="127" y="415453"/>
                  </a:lnTo>
                  <a:lnTo>
                    <a:pt x="129" y="413784"/>
                  </a:lnTo>
                  <a:lnTo>
                    <a:pt x="131" y="412116"/>
                  </a:lnTo>
                  <a:lnTo>
                    <a:pt x="133" y="410447"/>
                  </a:lnTo>
                  <a:lnTo>
                    <a:pt x="134" y="408779"/>
                  </a:lnTo>
                  <a:lnTo>
                    <a:pt x="136" y="407110"/>
                  </a:lnTo>
                  <a:lnTo>
                    <a:pt x="138" y="405442"/>
                  </a:lnTo>
                  <a:lnTo>
                    <a:pt x="139" y="403773"/>
                  </a:lnTo>
                  <a:lnTo>
                    <a:pt x="141" y="402105"/>
                  </a:lnTo>
                  <a:lnTo>
                    <a:pt x="143" y="400436"/>
                  </a:lnTo>
                  <a:lnTo>
                    <a:pt x="144" y="398768"/>
                  </a:lnTo>
                  <a:lnTo>
                    <a:pt x="146" y="397099"/>
                  </a:lnTo>
                  <a:lnTo>
                    <a:pt x="148" y="395431"/>
                  </a:lnTo>
                  <a:lnTo>
                    <a:pt x="149" y="393762"/>
                  </a:lnTo>
                  <a:lnTo>
                    <a:pt x="150" y="392094"/>
                  </a:lnTo>
                  <a:lnTo>
                    <a:pt x="152" y="390425"/>
                  </a:lnTo>
                  <a:lnTo>
                    <a:pt x="153" y="388757"/>
                  </a:lnTo>
                  <a:lnTo>
                    <a:pt x="155" y="387088"/>
                  </a:lnTo>
                  <a:lnTo>
                    <a:pt x="156" y="385420"/>
                  </a:lnTo>
                  <a:lnTo>
                    <a:pt x="157" y="383751"/>
                  </a:lnTo>
                  <a:lnTo>
                    <a:pt x="158" y="382083"/>
                  </a:lnTo>
                  <a:lnTo>
                    <a:pt x="160" y="380415"/>
                  </a:lnTo>
                  <a:lnTo>
                    <a:pt x="161" y="378746"/>
                  </a:lnTo>
                  <a:lnTo>
                    <a:pt x="162" y="377078"/>
                  </a:lnTo>
                  <a:lnTo>
                    <a:pt x="163" y="375409"/>
                  </a:lnTo>
                  <a:lnTo>
                    <a:pt x="164" y="373741"/>
                  </a:lnTo>
                  <a:lnTo>
                    <a:pt x="165" y="372072"/>
                  </a:lnTo>
                  <a:lnTo>
                    <a:pt x="166" y="370404"/>
                  </a:lnTo>
                  <a:lnTo>
                    <a:pt x="167" y="368735"/>
                  </a:lnTo>
                  <a:lnTo>
                    <a:pt x="167" y="367067"/>
                  </a:lnTo>
                  <a:lnTo>
                    <a:pt x="168" y="365398"/>
                  </a:lnTo>
                  <a:lnTo>
                    <a:pt x="169" y="363730"/>
                  </a:lnTo>
                  <a:lnTo>
                    <a:pt x="170" y="362061"/>
                  </a:lnTo>
                  <a:lnTo>
                    <a:pt x="170" y="360393"/>
                  </a:lnTo>
                  <a:lnTo>
                    <a:pt x="171" y="358724"/>
                  </a:lnTo>
                  <a:lnTo>
                    <a:pt x="171" y="357056"/>
                  </a:lnTo>
                  <a:lnTo>
                    <a:pt x="172" y="355387"/>
                  </a:lnTo>
                  <a:lnTo>
                    <a:pt x="172" y="353719"/>
                  </a:lnTo>
                  <a:lnTo>
                    <a:pt x="173" y="352050"/>
                  </a:lnTo>
                  <a:lnTo>
                    <a:pt x="173" y="350382"/>
                  </a:lnTo>
                  <a:lnTo>
                    <a:pt x="173" y="348713"/>
                  </a:lnTo>
                  <a:lnTo>
                    <a:pt x="173" y="347045"/>
                  </a:lnTo>
                  <a:lnTo>
                    <a:pt x="174" y="345376"/>
                  </a:lnTo>
                  <a:lnTo>
                    <a:pt x="174" y="343708"/>
                  </a:lnTo>
                  <a:lnTo>
                    <a:pt x="174" y="342039"/>
                  </a:lnTo>
                  <a:lnTo>
                    <a:pt x="174" y="340371"/>
                  </a:lnTo>
                  <a:lnTo>
                    <a:pt x="174" y="338702"/>
                  </a:lnTo>
                  <a:lnTo>
                    <a:pt x="174" y="337034"/>
                  </a:lnTo>
                  <a:lnTo>
                    <a:pt x="174" y="335365"/>
                  </a:lnTo>
                  <a:lnTo>
                    <a:pt x="174" y="333697"/>
                  </a:lnTo>
                  <a:lnTo>
                    <a:pt x="174" y="332028"/>
                  </a:lnTo>
                  <a:lnTo>
                    <a:pt x="173" y="330360"/>
                  </a:lnTo>
                  <a:lnTo>
                    <a:pt x="173" y="328691"/>
                  </a:lnTo>
                  <a:lnTo>
                    <a:pt x="173" y="327023"/>
                  </a:lnTo>
                  <a:lnTo>
                    <a:pt x="173" y="325354"/>
                  </a:lnTo>
                  <a:lnTo>
                    <a:pt x="172" y="323686"/>
                  </a:lnTo>
                  <a:lnTo>
                    <a:pt x="172" y="322017"/>
                  </a:lnTo>
                  <a:lnTo>
                    <a:pt x="171" y="320349"/>
                  </a:lnTo>
                  <a:lnTo>
                    <a:pt x="171" y="318680"/>
                  </a:lnTo>
                  <a:lnTo>
                    <a:pt x="170" y="317012"/>
                  </a:lnTo>
                  <a:lnTo>
                    <a:pt x="170" y="315344"/>
                  </a:lnTo>
                  <a:lnTo>
                    <a:pt x="169" y="313675"/>
                  </a:lnTo>
                  <a:lnTo>
                    <a:pt x="169" y="312007"/>
                  </a:lnTo>
                  <a:lnTo>
                    <a:pt x="168" y="310338"/>
                  </a:lnTo>
                  <a:lnTo>
                    <a:pt x="168" y="308670"/>
                  </a:lnTo>
                  <a:lnTo>
                    <a:pt x="167" y="307001"/>
                  </a:lnTo>
                  <a:lnTo>
                    <a:pt x="166" y="305333"/>
                  </a:lnTo>
                  <a:lnTo>
                    <a:pt x="165" y="303664"/>
                  </a:lnTo>
                  <a:lnTo>
                    <a:pt x="165" y="301996"/>
                  </a:lnTo>
                  <a:lnTo>
                    <a:pt x="164" y="300327"/>
                  </a:lnTo>
                  <a:lnTo>
                    <a:pt x="163" y="298659"/>
                  </a:lnTo>
                  <a:lnTo>
                    <a:pt x="162" y="296990"/>
                  </a:lnTo>
                  <a:lnTo>
                    <a:pt x="162" y="295322"/>
                  </a:lnTo>
                  <a:lnTo>
                    <a:pt x="161" y="293653"/>
                  </a:lnTo>
                  <a:lnTo>
                    <a:pt x="160" y="291985"/>
                  </a:lnTo>
                  <a:lnTo>
                    <a:pt x="159" y="290316"/>
                  </a:lnTo>
                  <a:lnTo>
                    <a:pt x="158" y="288648"/>
                  </a:lnTo>
                  <a:lnTo>
                    <a:pt x="157" y="286979"/>
                  </a:lnTo>
                  <a:lnTo>
                    <a:pt x="156" y="285311"/>
                  </a:lnTo>
                  <a:lnTo>
                    <a:pt x="155" y="283642"/>
                  </a:lnTo>
                  <a:lnTo>
                    <a:pt x="155" y="281974"/>
                  </a:lnTo>
                  <a:lnTo>
                    <a:pt x="154" y="280305"/>
                  </a:lnTo>
                  <a:lnTo>
                    <a:pt x="153" y="278637"/>
                  </a:lnTo>
                  <a:lnTo>
                    <a:pt x="152" y="276968"/>
                  </a:lnTo>
                  <a:lnTo>
                    <a:pt x="151" y="275300"/>
                  </a:lnTo>
                  <a:lnTo>
                    <a:pt x="150" y="273631"/>
                  </a:lnTo>
                  <a:lnTo>
                    <a:pt x="149" y="271963"/>
                  </a:lnTo>
                  <a:lnTo>
                    <a:pt x="148" y="270294"/>
                  </a:lnTo>
                  <a:lnTo>
                    <a:pt x="147" y="268626"/>
                  </a:lnTo>
                  <a:lnTo>
                    <a:pt x="147" y="266957"/>
                  </a:lnTo>
                  <a:lnTo>
                    <a:pt x="146" y="265289"/>
                  </a:lnTo>
                  <a:lnTo>
                    <a:pt x="145" y="263620"/>
                  </a:lnTo>
                  <a:lnTo>
                    <a:pt x="144" y="261952"/>
                  </a:lnTo>
                  <a:lnTo>
                    <a:pt x="143" y="260283"/>
                  </a:lnTo>
                  <a:lnTo>
                    <a:pt x="142" y="258615"/>
                  </a:lnTo>
                  <a:lnTo>
                    <a:pt x="142" y="256946"/>
                  </a:lnTo>
                  <a:lnTo>
                    <a:pt x="141" y="255278"/>
                  </a:lnTo>
                  <a:lnTo>
                    <a:pt x="140" y="253610"/>
                  </a:lnTo>
                  <a:lnTo>
                    <a:pt x="140" y="251941"/>
                  </a:lnTo>
                  <a:lnTo>
                    <a:pt x="139" y="250273"/>
                  </a:lnTo>
                  <a:lnTo>
                    <a:pt x="138" y="248604"/>
                  </a:lnTo>
                  <a:lnTo>
                    <a:pt x="138" y="246936"/>
                  </a:lnTo>
                  <a:lnTo>
                    <a:pt x="137" y="245267"/>
                  </a:lnTo>
                  <a:lnTo>
                    <a:pt x="136" y="243599"/>
                  </a:lnTo>
                  <a:lnTo>
                    <a:pt x="136" y="241930"/>
                  </a:lnTo>
                  <a:lnTo>
                    <a:pt x="135" y="240262"/>
                  </a:lnTo>
                  <a:lnTo>
                    <a:pt x="135" y="238593"/>
                  </a:lnTo>
                  <a:lnTo>
                    <a:pt x="134" y="236925"/>
                  </a:lnTo>
                  <a:lnTo>
                    <a:pt x="134" y="235256"/>
                  </a:lnTo>
                  <a:lnTo>
                    <a:pt x="134" y="233588"/>
                  </a:lnTo>
                  <a:lnTo>
                    <a:pt x="133" y="231919"/>
                  </a:lnTo>
                  <a:lnTo>
                    <a:pt x="133" y="230251"/>
                  </a:lnTo>
                  <a:lnTo>
                    <a:pt x="133" y="228582"/>
                  </a:lnTo>
                  <a:lnTo>
                    <a:pt x="133" y="226914"/>
                  </a:lnTo>
                  <a:lnTo>
                    <a:pt x="132" y="225245"/>
                  </a:lnTo>
                  <a:lnTo>
                    <a:pt x="132" y="223577"/>
                  </a:lnTo>
                  <a:lnTo>
                    <a:pt x="132" y="221908"/>
                  </a:lnTo>
                  <a:lnTo>
                    <a:pt x="132" y="220240"/>
                  </a:lnTo>
                  <a:lnTo>
                    <a:pt x="132" y="218571"/>
                  </a:lnTo>
                  <a:lnTo>
                    <a:pt x="132" y="216903"/>
                  </a:lnTo>
                  <a:lnTo>
                    <a:pt x="132" y="215234"/>
                  </a:lnTo>
                  <a:lnTo>
                    <a:pt x="132" y="213566"/>
                  </a:lnTo>
                  <a:lnTo>
                    <a:pt x="132" y="211897"/>
                  </a:lnTo>
                  <a:lnTo>
                    <a:pt x="133" y="210229"/>
                  </a:lnTo>
                  <a:lnTo>
                    <a:pt x="133" y="208560"/>
                  </a:lnTo>
                  <a:lnTo>
                    <a:pt x="133" y="206892"/>
                  </a:lnTo>
                  <a:lnTo>
                    <a:pt x="133" y="205223"/>
                  </a:lnTo>
                  <a:lnTo>
                    <a:pt x="134" y="203555"/>
                  </a:lnTo>
                  <a:lnTo>
                    <a:pt x="134" y="201886"/>
                  </a:lnTo>
                  <a:lnTo>
                    <a:pt x="134" y="200218"/>
                  </a:lnTo>
                  <a:lnTo>
                    <a:pt x="135" y="198549"/>
                  </a:lnTo>
                  <a:lnTo>
                    <a:pt x="135" y="196881"/>
                  </a:lnTo>
                  <a:lnTo>
                    <a:pt x="136" y="195212"/>
                  </a:lnTo>
                  <a:lnTo>
                    <a:pt x="136" y="193544"/>
                  </a:lnTo>
                  <a:lnTo>
                    <a:pt x="137" y="191875"/>
                  </a:lnTo>
                  <a:lnTo>
                    <a:pt x="138" y="190207"/>
                  </a:lnTo>
                  <a:lnTo>
                    <a:pt x="138" y="188539"/>
                  </a:lnTo>
                  <a:lnTo>
                    <a:pt x="139" y="186870"/>
                  </a:lnTo>
                  <a:lnTo>
                    <a:pt x="140" y="185202"/>
                  </a:lnTo>
                  <a:lnTo>
                    <a:pt x="140" y="183533"/>
                  </a:lnTo>
                  <a:lnTo>
                    <a:pt x="141" y="181865"/>
                  </a:lnTo>
                  <a:lnTo>
                    <a:pt x="142" y="180196"/>
                  </a:lnTo>
                  <a:lnTo>
                    <a:pt x="143" y="178528"/>
                  </a:lnTo>
                  <a:lnTo>
                    <a:pt x="144" y="176859"/>
                  </a:lnTo>
                  <a:lnTo>
                    <a:pt x="144" y="175191"/>
                  </a:lnTo>
                  <a:lnTo>
                    <a:pt x="145" y="173522"/>
                  </a:lnTo>
                  <a:lnTo>
                    <a:pt x="146" y="171854"/>
                  </a:lnTo>
                  <a:lnTo>
                    <a:pt x="147" y="170185"/>
                  </a:lnTo>
                  <a:lnTo>
                    <a:pt x="148" y="168517"/>
                  </a:lnTo>
                  <a:lnTo>
                    <a:pt x="149" y="166848"/>
                  </a:lnTo>
                  <a:lnTo>
                    <a:pt x="150" y="165180"/>
                  </a:lnTo>
                  <a:lnTo>
                    <a:pt x="151" y="163511"/>
                  </a:lnTo>
                  <a:lnTo>
                    <a:pt x="152" y="161843"/>
                  </a:lnTo>
                  <a:lnTo>
                    <a:pt x="153" y="160174"/>
                  </a:lnTo>
                  <a:lnTo>
                    <a:pt x="154" y="158506"/>
                  </a:lnTo>
                  <a:lnTo>
                    <a:pt x="155" y="156837"/>
                  </a:lnTo>
                  <a:lnTo>
                    <a:pt x="156" y="155169"/>
                  </a:lnTo>
                  <a:lnTo>
                    <a:pt x="157" y="153500"/>
                  </a:lnTo>
                  <a:lnTo>
                    <a:pt x="158" y="151832"/>
                  </a:lnTo>
                  <a:lnTo>
                    <a:pt x="159" y="150163"/>
                  </a:lnTo>
                  <a:lnTo>
                    <a:pt x="160" y="148495"/>
                  </a:lnTo>
                  <a:lnTo>
                    <a:pt x="162" y="146826"/>
                  </a:lnTo>
                  <a:lnTo>
                    <a:pt x="163" y="145158"/>
                  </a:lnTo>
                  <a:lnTo>
                    <a:pt x="164" y="143489"/>
                  </a:lnTo>
                  <a:lnTo>
                    <a:pt x="165" y="141821"/>
                  </a:lnTo>
                  <a:lnTo>
                    <a:pt x="166" y="140152"/>
                  </a:lnTo>
                  <a:lnTo>
                    <a:pt x="167" y="138484"/>
                  </a:lnTo>
                  <a:lnTo>
                    <a:pt x="168" y="136815"/>
                  </a:lnTo>
                  <a:lnTo>
                    <a:pt x="169" y="135147"/>
                  </a:lnTo>
                  <a:lnTo>
                    <a:pt x="170" y="133478"/>
                  </a:lnTo>
                  <a:lnTo>
                    <a:pt x="171" y="131810"/>
                  </a:lnTo>
                  <a:lnTo>
                    <a:pt x="172" y="130141"/>
                  </a:lnTo>
                  <a:lnTo>
                    <a:pt x="173" y="128473"/>
                  </a:lnTo>
                  <a:lnTo>
                    <a:pt x="174" y="126805"/>
                  </a:lnTo>
                  <a:lnTo>
                    <a:pt x="175" y="125136"/>
                  </a:lnTo>
                  <a:lnTo>
                    <a:pt x="176" y="123468"/>
                  </a:lnTo>
                  <a:lnTo>
                    <a:pt x="177" y="121799"/>
                  </a:lnTo>
                  <a:lnTo>
                    <a:pt x="178" y="120131"/>
                  </a:lnTo>
                  <a:lnTo>
                    <a:pt x="179" y="118462"/>
                  </a:lnTo>
                  <a:lnTo>
                    <a:pt x="180" y="116794"/>
                  </a:lnTo>
                  <a:lnTo>
                    <a:pt x="181" y="115125"/>
                  </a:lnTo>
                  <a:lnTo>
                    <a:pt x="182" y="113457"/>
                  </a:lnTo>
                  <a:lnTo>
                    <a:pt x="183" y="111788"/>
                  </a:lnTo>
                  <a:lnTo>
                    <a:pt x="184" y="110120"/>
                  </a:lnTo>
                  <a:lnTo>
                    <a:pt x="185" y="108451"/>
                  </a:lnTo>
                  <a:lnTo>
                    <a:pt x="185" y="106783"/>
                  </a:lnTo>
                  <a:lnTo>
                    <a:pt x="186" y="105114"/>
                  </a:lnTo>
                  <a:lnTo>
                    <a:pt x="187" y="103446"/>
                  </a:lnTo>
                  <a:lnTo>
                    <a:pt x="188" y="101777"/>
                  </a:lnTo>
                  <a:lnTo>
                    <a:pt x="189" y="100109"/>
                  </a:lnTo>
                  <a:lnTo>
                    <a:pt x="189" y="98440"/>
                  </a:lnTo>
                  <a:lnTo>
                    <a:pt x="190" y="96772"/>
                  </a:lnTo>
                  <a:lnTo>
                    <a:pt x="191" y="95103"/>
                  </a:lnTo>
                  <a:lnTo>
                    <a:pt x="192" y="93435"/>
                  </a:lnTo>
                  <a:lnTo>
                    <a:pt x="192" y="91766"/>
                  </a:lnTo>
                  <a:lnTo>
                    <a:pt x="193" y="90098"/>
                  </a:lnTo>
                  <a:lnTo>
                    <a:pt x="194" y="88429"/>
                  </a:lnTo>
                  <a:lnTo>
                    <a:pt x="194" y="86761"/>
                  </a:lnTo>
                  <a:lnTo>
                    <a:pt x="195" y="85092"/>
                  </a:lnTo>
                  <a:lnTo>
                    <a:pt x="196" y="83424"/>
                  </a:lnTo>
                  <a:lnTo>
                    <a:pt x="196" y="81755"/>
                  </a:lnTo>
                  <a:lnTo>
                    <a:pt x="197" y="80087"/>
                  </a:lnTo>
                  <a:lnTo>
                    <a:pt x="197" y="78418"/>
                  </a:lnTo>
                  <a:lnTo>
                    <a:pt x="198" y="76750"/>
                  </a:lnTo>
                  <a:lnTo>
                    <a:pt x="198" y="75081"/>
                  </a:lnTo>
                  <a:lnTo>
                    <a:pt x="199" y="73413"/>
                  </a:lnTo>
                  <a:lnTo>
                    <a:pt x="199" y="71744"/>
                  </a:lnTo>
                  <a:lnTo>
                    <a:pt x="200" y="70076"/>
                  </a:lnTo>
                  <a:lnTo>
                    <a:pt x="200" y="68407"/>
                  </a:lnTo>
                  <a:lnTo>
                    <a:pt x="201" y="66739"/>
                  </a:lnTo>
                  <a:lnTo>
                    <a:pt x="201" y="65070"/>
                  </a:lnTo>
                  <a:lnTo>
                    <a:pt x="201" y="63402"/>
                  </a:lnTo>
                  <a:lnTo>
                    <a:pt x="202" y="61734"/>
                  </a:lnTo>
                  <a:lnTo>
                    <a:pt x="202" y="60065"/>
                  </a:lnTo>
                  <a:lnTo>
                    <a:pt x="203" y="58397"/>
                  </a:lnTo>
                  <a:lnTo>
                    <a:pt x="203" y="56728"/>
                  </a:lnTo>
                  <a:lnTo>
                    <a:pt x="203" y="55060"/>
                  </a:lnTo>
                  <a:lnTo>
                    <a:pt x="204" y="53391"/>
                  </a:lnTo>
                  <a:lnTo>
                    <a:pt x="204" y="51723"/>
                  </a:lnTo>
                  <a:lnTo>
                    <a:pt x="204" y="50054"/>
                  </a:lnTo>
                  <a:lnTo>
                    <a:pt x="204" y="48386"/>
                  </a:lnTo>
                  <a:lnTo>
                    <a:pt x="205" y="46717"/>
                  </a:lnTo>
                  <a:lnTo>
                    <a:pt x="205" y="45049"/>
                  </a:lnTo>
                  <a:lnTo>
                    <a:pt x="205" y="43380"/>
                  </a:lnTo>
                  <a:lnTo>
                    <a:pt x="205" y="41712"/>
                  </a:lnTo>
                  <a:lnTo>
                    <a:pt x="206" y="40043"/>
                  </a:lnTo>
                  <a:lnTo>
                    <a:pt x="206" y="38375"/>
                  </a:lnTo>
                  <a:lnTo>
                    <a:pt x="206" y="36706"/>
                  </a:lnTo>
                  <a:lnTo>
                    <a:pt x="206" y="35038"/>
                  </a:lnTo>
                  <a:lnTo>
                    <a:pt x="206" y="33369"/>
                  </a:lnTo>
                  <a:lnTo>
                    <a:pt x="207" y="31701"/>
                  </a:lnTo>
                  <a:lnTo>
                    <a:pt x="207" y="30032"/>
                  </a:lnTo>
                  <a:lnTo>
                    <a:pt x="207" y="28364"/>
                  </a:lnTo>
                  <a:lnTo>
                    <a:pt x="207" y="26695"/>
                  </a:lnTo>
                  <a:lnTo>
                    <a:pt x="207" y="25027"/>
                  </a:lnTo>
                  <a:lnTo>
                    <a:pt x="207" y="23358"/>
                  </a:lnTo>
                  <a:lnTo>
                    <a:pt x="207" y="21690"/>
                  </a:lnTo>
                  <a:lnTo>
                    <a:pt x="208" y="20021"/>
                  </a:lnTo>
                  <a:lnTo>
                    <a:pt x="208" y="18353"/>
                  </a:lnTo>
                  <a:lnTo>
                    <a:pt x="208" y="16684"/>
                  </a:lnTo>
                  <a:lnTo>
                    <a:pt x="208" y="15016"/>
                  </a:lnTo>
                  <a:lnTo>
                    <a:pt x="208" y="13347"/>
                  </a:lnTo>
                  <a:lnTo>
                    <a:pt x="208" y="11679"/>
                  </a:lnTo>
                  <a:lnTo>
                    <a:pt x="208" y="10010"/>
                  </a:lnTo>
                  <a:lnTo>
                    <a:pt x="208" y="8342"/>
                  </a:lnTo>
                  <a:lnTo>
                    <a:pt x="208" y="6673"/>
                  </a:lnTo>
                  <a:lnTo>
                    <a:pt x="208" y="5005"/>
                  </a:lnTo>
                  <a:lnTo>
                    <a:pt x="208" y="3336"/>
                  </a:lnTo>
                  <a:lnTo>
                    <a:pt x="209" y="1668"/>
                  </a:lnTo>
                  <a:lnTo>
                    <a:pt x="209" y="0"/>
                  </a:lnTo>
                  <a:lnTo>
                    <a:pt x="209" y="0"/>
                  </a:lnTo>
                  <a:lnTo>
                    <a:pt x="209" y="852596"/>
                  </a:lnTo>
                  <a:lnTo>
                    <a:pt x="209" y="852596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37" name="pl19"/>
            <p:cNvSpPr/>
            <p:nvPr/>
          </p:nvSpPr>
          <p:spPr>
            <a:xfrm>
              <a:off x="2542672" y="3503037"/>
              <a:ext cx="643" cy="347578"/>
            </a:xfrm>
            <a:custGeom>
              <a:avLst/>
              <a:gdLst/>
              <a:ahLst/>
              <a:cxnLst/>
              <a:rect l="0" t="0" r="0" b="0"/>
              <a:pathLst>
                <a:path w="643" h="347578">
                  <a:moveTo>
                    <a:pt x="0" y="0"/>
                  </a:moveTo>
                  <a:lnTo>
                    <a:pt x="3" y="0"/>
                  </a:lnTo>
                  <a:lnTo>
                    <a:pt x="3" y="680"/>
                  </a:lnTo>
                  <a:lnTo>
                    <a:pt x="3" y="1360"/>
                  </a:lnTo>
                  <a:lnTo>
                    <a:pt x="4" y="2040"/>
                  </a:lnTo>
                  <a:lnTo>
                    <a:pt x="4" y="2720"/>
                  </a:lnTo>
                  <a:lnTo>
                    <a:pt x="5" y="3400"/>
                  </a:lnTo>
                  <a:lnTo>
                    <a:pt x="5" y="4081"/>
                  </a:lnTo>
                  <a:lnTo>
                    <a:pt x="6" y="4761"/>
                  </a:lnTo>
                  <a:lnTo>
                    <a:pt x="6" y="5441"/>
                  </a:lnTo>
                  <a:lnTo>
                    <a:pt x="7" y="6121"/>
                  </a:lnTo>
                  <a:lnTo>
                    <a:pt x="8" y="6801"/>
                  </a:lnTo>
                  <a:lnTo>
                    <a:pt x="8" y="7482"/>
                  </a:lnTo>
                  <a:lnTo>
                    <a:pt x="9" y="8162"/>
                  </a:lnTo>
                  <a:lnTo>
                    <a:pt x="10" y="8842"/>
                  </a:lnTo>
                  <a:lnTo>
                    <a:pt x="11" y="9522"/>
                  </a:lnTo>
                  <a:lnTo>
                    <a:pt x="12" y="10202"/>
                  </a:lnTo>
                  <a:lnTo>
                    <a:pt x="13" y="10883"/>
                  </a:lnTo>
                  <a:lnTo>
                    <a:pt x="14" y="11563"/>
                  </a:lnTo>
                  <a:lnTo>
                    <a:pt x="15" y="12243"/>
                  </a:lnTo>
                  <a:lnTo>
                    <a:pt x="17" y="12923"/>
                  </a:lnTo>
                  <a:lnTo>
                    <a:pt x="18" y="13603"/>
                  </a:lnTo>
                  <a:lnTo>
                    <a:pt x="19" y="14284"/>
                  </a:lnTo>
                  <a:lnTo>
                    <a:pt x="21" y="14964"/>
                  </a:lnTo>
                  <a:lnTo>
                    <a:pt x="23" y="15644"/>
                  </a:lnTo>
                  <a:lnTo>
                    <a:pt x="24" y="16324"/>
                  </a:lnTo>
                  <a:lnTo>
                    <a:pt x="26" y="17004"/>
                  </a:lnTo>
                  <a:lnTo>
                    <a:pt x="28" y="17685"/>
                  </a:lnTo>
                  <a:lnTo>
                    <a:pt x="30" y="18365"/>
                  </a:lnTo>
                  <a:lnTo>
                    <a:pt x="33" y="19045"/>
                  </a:lnTo>
                  <a:lnTo>
                    <a:pt x="35" y="19725"/>
                  </a:lnTo>
                  <a:lnTo>
                    <a:pt x="37" y="20405"/>
                  </a:lnTo>
                  <a:lnTo>
                    <a:pt x="40" y="21085"/>
                  </a:lnTo>
                  <a:lnTo>
                    <a:pt x="43" y="21766"/>
                  </a:lnTo>
                  <a:lnTo>
                    <a:pt x="46" y="22446"/>
                  </a:lnTo>
                  <a:lnTo>
                    <a:pt x="49" y="23126"/>
                  </a:lnTo>
                  <a:lnTo>
                    <a:pt x="52" y="23806"/>
                  </a:lnTo>
                  <a:lnTo>
                    <a:pt x="55" y="24486"/>
                  </a:lnTo>
                  <a:lnTo>
                    <a:pt x="58" y="25167"/>
                  </a:lnTo>
                  <a:lnTo>
                    <a:pt x="62" y="25847"/>
                  </a:lnTo>
                  <a:lnTo>
                    <a:pt x="65" y="26527"/>
                  </a:lnTo>
                  <a:lnTo>
                    <a:pt x="69" y="27207"/>
                  </a:lnTo>
                  <a:lnTo>
                    <a:pt x="73" y="27887"/>
                  </a:lnTo>
                  <a:lnTo>
                    <a:pt x="77" y="28568"/>
                  </a:lnTo>
                  <a:lnTo>
                    <a:pt x="82" y="29248"/>
                  </a:lnTo>
                  <a:lnTo>
                    <a:pt x="86" y="29928"/>
                  </a:lnTo>
                  <a:lnTo>
                    <a:pt x="90" y="30608"/>
                  </a:lnTo>
                  <a:lnTo>
                    <a:pt x="95" y="31288"/>
                  </a:lnTo>
                  <a:lnTo>
                    <a:pt x="100" y="31969"/>
                  </a:lnTo>
                  <a:lnTo>
                    <a:pt x="104" y="32649"/>
                  </a:lnTo>
                  <a:lnTo>
                    <a:pt x="109" y="33329"/>
                  </a:lnTo>
                  <a:lnTo>
                    <a:pt x="114" y="34009"/>
                  </a:lnTo>
                  <a:lnTo>
                    <a:pt x="120" y="34689"/>
                  </a:lnTo>
                  <a:lnTo>
                    <a:pt x="125" y="35370"/>
                  </a:lnTo>
                  <a:lnTo>
                    <a:pt x="130" y="36050"/>
                  </a:lnTo>
                  <a:lnTo>
                    <a:pt x="135" y="36730"/>
                  </a:lnTo>
                  <a:lnTo>
                    <a:pt x="141" y="37410"/>
                  </a:lnTo>
                  <a:lnTo>
                    <a:pt x="146" y="38090"/>
                  </a:lnTo>
                  <a:lnTo>
                    <a:pt x="152" y="38771"/>
                  </a:lnTo>
                  <a:lnTo>
                    <a:pt x="157" y="39451"/>
                  </a:lnTo>
                  <a:lnTo>
                    <a:pt x="163" y="40131"/>
                  </a:lnTo>
                  <a:lnTo>
                    <a:pt x="169" y="40811"/>
                  </a:lnTo>
                  <a:lnTo>
                    <a:pt x="174" y="41491"/>
                  </a:lnTo>
                  <a:lnTo>
                    <a:pt x="180" y="42171"/>
                  </a:lnTo>
                  <a:lnTo>
                    <a:pt x="185" y="42852"/>
                  </a:lnTo>
                  <a:lnTo>
                    <a:pt x="191" y="43532"/>
                  </a:lnTo>
                  <a:lnTo>
                    <a:pt x="196" y="44212"/>
                  </a:lnTo>
                  <a:lnTo>
                    <a:pt x="202" y="44892"/>
                  </a:lnTo>
                  <a:lnTo>
                    <a:pt x="207" y="45572"/>
                  </a:lnTo>
                  <a:lnTo>
                    <a:pt x="212" y="46253"/>
                  </a:lnTo>
                  <a:lnTo>
                    <a:pt x="217" y="46933"/>
                  </a:lnTo>
                  <a:lnTo>
                    <a:pt x="222" y="47613"/>
                  </a:lnTo>
                  <a:lnTo>
                    <a:pt x="227" y="48293"/>
                  </a:lnTo>
                  <a:lnTo>
                    <a:pt x="232" y="48973"/>
                  </a:lnTo>
                  <a:lnTo>
                    <a:pt x="236" y="49654"/>
                  </a:lnTo>
                  <a:lnTo>
                    <a:pt x="240" y="50334"/>
                  </a:lnTo>
                  <a:lnTo>
                    <a:pt x="245" y="51014"/>
                  </a:lnTo>
                  <a:lnTo>
                    <a:pt x="248" y="51694"/>
                  </a:lnTo>
                  <a:lnTo>
                    <a:pt x="252" y="52374"/>
                  </a:lnTo>
                  <a:lnTo>
                    <a:pt x="256" y="53055"/>
                  </a:lnTo>
                  <a:lnTo>
                    <a:pt x="259" y="53735"/>
                  </a:lnTo>
                  <a:lnTo>
                    <a:pt x="262" y="54415"/>
                  </a:lnTo>
                  <a:lnTo>
                    <a:pt x="264" y="55095"/>
                  </a:lnTo>
                  <a:lnTo>
                    <a:pt x="267" y="55775"/>
                  </a:lnTo>
                  <a:lnTo>
                    <a:pt x="269" y="56456"/>
                  </a:lnTo>
                  <a:lnTo>
                    <a:pt x="271" y="57136"/>
                  </a:lnTo>
                  <a:lnTo>
                    <a:pt x="272" y="57816"/>
                  </a:lnTo>
                  <a:lnTo>
                    <a:pt x="274" y="58496"/>
                  </a:lnTo>
                  <a:lnTo>
                    <a:pt x="274" y="59176"/>
                  </a:lnTo>
                  <a:lnTo>
                    <a:pt x="275" y="59857"/>
                  </a:lnTo>
                  <a:lnTo>
                    <a:pt x="276" y="60537"/>
                  </a:lnTo>
                  <a:lnTo>
                    <a:pt x="275" y="61217"/>
                  </a:lnTo>
                  <a:lnTo>
                    <a:pt x="275" y="61897"/>
                  </a:lnTo>
                  <a:lnTo>
                    <a:pt x="275" y="62577"/>
                  </a:lnTo>
                  <a:lnTo>
                    <a:pt x="274" y="63257"/>
                  </a:lnTo>
                  <a:lnTo>
                    <a:pt x="273" y="63938"/>
                  </a:lnTo>
                  <a:lnTo>
                    <a:pt x="271" y="64618"/>
                  </a:lnTo>
                  <a:lnTo>
                    <a:pt x="269" y="65298"/>
                  </a:lnTo>
                  <a:lnTo>
                    <a:pt x="267" y="65978"/>
                  </a:lnTo>
                  <a:lnTo>
                    <a:pt x="265" y="66658"/>
                  </a:lnTo>
                  <a:lnTo>
                    <a:pt x="262" y="67339"/>
                  </a:lnTo>
                  <a:lnTo>
                    <a:pt x="259" y="68019"/>
                  </a:lnTo>
                  <a:lnTo>
                    <a:pt x="256" y="68699"/>
                  </a:lnTo>
                  <a:lnTo>
                    <a:pt x="253" y="69379"/>
                  </a:lnTo>
                  <a:lnTo>
                    <a:pt x="249" y="70059"/>
                  </a:lnTo>
                  <a:lnTo>
                    <a:pt x="245" y="70740"/>
                  </a:lnTo>
                  <a:lnTo>
                    <a:pt x="241" y="71420"/>
                  </a:lnTo>
                  <a:lnTo>
                    <a:pt x="237" y="72100"/>
                  </a:lnTo>
                  <a:lnTo>
                    <a:pt x="233" y="72780"/>
                  </a:lnTo>
                  <a:lnTo>
                    <a:pt x="228" y="73460"/>
                  </a:lnTo>
                  <a:lnTo>
                    <a:pt x="223" y="74141"/>
                  </a:lnTo>
                  <a:lnTo>
                    <a:pt x="218" y="74821"/>
                  </a:lnTo>
                  <a:lnTo>
                    <a:pt x="213" y="75501"/>
                  </a:lnTo>
                  <a:lnTo>
                    <a:pt x="208" y="76181"/>
                  </a:lnTo>
                  <a:lnTo>
                    <a:pt x="203" y="76861"/>
                  </a:lnTo>
                  <a:lnTo>
                    <a:pt x="197" y="77542"/>
                  </a:lnTo>
                  <a:lnTo>
                    <a:pt x="192" y="78222"/>
                  </a:lnTo>
                  <a:lnTo>
                    <a:pt x="186" y="78902"/>
                  </a:lnTo>
                  <a:lnTo>
                    <a:pt x="181" y="79582"/>
                  </a:lnTo>
                  <a:lnTo>
                    <a:pt x="175" y="80262"/>
                  </a:lnTo>
                  <a:lnTo>
                    <a:pt x="170" y="80943"/>
                  </a:lnTo>
                  <a:lnTo>
                    <a:pt x="164" y="81623"/>
                  </a:lnTo>
                  <a:lnTo>
                    <a:pt x="159" y="82303"/>
                  </a:lnTo>
                  <a:lnTo>
                    <a:pt x="153" y="82983"/>
                  </a:lnTo>
                  <a:lnTo>
                    <a:pt x="147" y="83663"/>
                  </a:lnTo>
                  <a:lnTo>
                    <a:pt x="142" y="84343"/>
                  </a:lnTo>
                  <a:lnTo>
                    <a:pt x="137" y="85024"/>
                  </a:lnTo>
                  <a:lnTo>
                    <a:pt x="131" y="85704"/>
                  </a:lnTo>
                  <a:lnTo>
                    <a:pt x="126" y="86384"/>
                  </a:lnTo>
                  <a:lnTo>
                    <a:pt x="121" y="87064"/>
                  </a:lnTo>
                  <a:lnTo>
                    <a:pt x="115" y="87744"/>
                  </a:lnTo>
                  <a:lnTo>
                    <a:pt x="110" y="88425"/>
                  </a:lnTo>
                  <a:lnTo>
                    <a:pt x="105" y="89105"/>
                  </a:lnTo>
                  <a:lnTo>
                    <a:pt x="101" y="89785"/>
                  </a:lnTo>
                  <a:lnTo>
                    <a:pt x="96" y="90465"/>
                  </a:lnTo>
                  <a:lnTo>
                    <a:pt x="91" y="91145"/>
                  </a:lnTo>
                  <a:lnTo>
                    <a:pt x="87" y="91826"/>
                  </a:lnTo>
                  <a:lnTo>
                    <a:pt x="82" y="92506"/>
                  </a:lnTo>
                  <a:lnTo>
                    <a:pt x="78" y="93186"/>
                  </a:lnTo>
                  <a:lnTo>
                    <a:pt x="74" y="93866"/>
                  </a:lnTo>
                  <a:lnTo>
                    <a:pt x="70" y="94546"/>
                  </a:lnTo>
                  <a:lnTo>
                    <a:pt x="66" y="95227"/>
                  </a:lnTo>
                  <a:lnTo>
                    <a:pt x="63" y="95907"/>
                  </a:lnTo>
                  <a:lnTo>
                    <a:pt x="59" y="96587"/>
                  </a:lnTo>
                  <a:lnTo>
                    <a:pt x="56" y="97267"/>
                  </a:lnTo>
                  <a:lnTo>
                    <a:pt x="52" y="97947"/>
                  </a:lnTo>
                  <a:lnTo>
                    <a:pt x="49" y="98628"/>
                  </a:lnTo>
                  <a:lnTo>
                    <a:pt x="46" y="99308"/>
                  </a:lnTo>
                  <a:lnTo>
                    <a:pt x="43" y="99988"/>
                  </a:lnTo>
                  <a:lnTo>
                    <a:pt x="41" y="100668"/>
                  </a:lnTo>
                  <a:lnTo>
                    <a:pt x="38" y="101348"/>
                  </a:lnTo>
                  <a:lnTo>
                    <a:pt x="35" y="102029"/>
                  </a:lnTo>
                  <a:lnTo>
                    <a:pt x="33" y="102709"/>
                  </a:lnTo>
                  <a:lnTo>
                    <a:pt x="31" y="103389"/>
                  </a:lnTo>
                  <a:lnTo>
                    <a:pt x="29" y="104069"/>
                  </a:lnTo>
                  <a:lnTo>
                    <a:pt x="27" y="104749"/>
                  </a:lnTo>
                  <a:lnTo>
                    <a:pt x="25" y="105429"/>
                  </a:lnTo>
                  <a:lnTo>
                    <a:pt x="23" y="106110"/>
                  </a:lnTo>
                  <a:lnTo>
                    <a:pt x="21" y="106790"/>
                  </a:lnTo>
                  <a:lnTo>
                    <a:pt x="20" y="107470"/>
                  </a:lnTo>
                  <a:lnTo>
                    <a:pt x="18" y="108150"/>
                  </a:lnTo>
                  <a:lnTo>
                    <a:pt x="17" y="108830"/>
                  </a:lnTo>
                  <a:lnTo>
                    <a:pt x="15" y="109511"/>
                  </a:lnTo>
                  <a:lnTo>
                    <a:pt x="14" y="110191"/>
                  </a:lnTo>
                  <a:lnTo>
                    <a:pt x="13" y="110871"/>
                  </a:lnTo>
                  <a:lnTo>
                    <a:pt x="12" y="111551"/>
                  </a:lnTo>
                  <a:lnTo>
                    <a:pt x="11" y="112231"/>
                  </a:lnTo>
                  <a:lnTo>
                    <a:pt x="10" y="112912"/>
                  </a:lnTo>
                  <a:lnTo>
                    <a:pt x="9" y="113592"/>
                  </a:lnTo>
                  <a:lnTo>
                    <a:pt x="8" y="114272"/>
                  </a:lnTo>
                  <a:lnTo>
                    <a:pt x="8" y="114952"/>
                  </a:lnTo>
                  <a:lnTo>
                    <a:pt x="7" y="115632"/>
                  </a:lnTo>
                  <a:lnTo>
                    <a:pt x="6" y="116313"/>
                  </a:lnTo>
                  <a:lnTo>
                    <a:pt x="6" y="116993"/>
                  </a:lnTo>
                  <a:lnTo>
                    <a:pt x="5" y="117673"/>
                  </a:lnTo>
                  <a:lnTo>
                    <a:pt x="5" y="118353"/>
                  </a:lnTo>
                  <a:lnTo>
                    <a:pt x="4" y="119033"/>
                  </a:lnTo>
                  <a:lnTo>
                    <a:pt x="4" y="119714"/>
                  </a:lnTo>
                  <a:lnTo>
                    <a:pt x="3" y="120394"/>
                  </a:lnTo>
                  <a:lnTo>
                    <a:pt x="3" y="121074"/>
                  </a:lnTo>
                  <a:lnTo>
                    <a:pt x="3" y="121754"/>
                  </a:lnTo>
                  <a:lnTo>
                    <a:pt x="2" y="122434"/>
                  </a:lnTo>
                  <a:lnTo>
                    <a:pt x="2" y="123115"/>
                  </a:lnTo>
                  <a:lnTo>
                    <a:pt x="2" y="123795"/>
                  </a:lnTo>
                  <a:lnTo>
                    <a:pt x="2" y="124475"/>
                  </a:lnTo>
                  <a:lnTo>
                    <a:pt x="1" y="125155"/>
                  </a:lnTo>
                  <a:lnTo>
                    <a:pt x="1" y="125835"/>
                  </a:lnTo>
                  <a:lnTo>
                    <a:pt x="1" y="126515"/>
                  </a:lnTo>
                  <a:lnTo>
                    <a:pt x="1" y="127196"/>
                  </a:lnTo>
                  <a:lnTo>
                    <a:pt x="1" y="127876"/>
                  </a:lnTo>
                  <a:lnTo>
                    <a:pt x="1" y="128556"/>
                  </a:lnTo>
                  <a:lnTo>
                    <a:pt x="0" y="129236"/>
                  </a:lnTo>
                  <a:lnTo>
                    <a:pt x="0" y="129916"/>
                  </a:lnTo>
                  <a:lnTo>
                    <a:pt x="0" y="130597"/>
                  </a:lnTo>
                  <a:lnTo>
                    <a:pt x="0" y="131277"/>
                  </a:lnTo>
                  <a:lnTo>
                    <a:pt x="0" y="131957"/>
                  </a:lnTo>
                  <a:lnTo>
                    <a:pt x="0" y="132637"/>
                  </a:lnTo>
                  <a:lnTo>
                    <a:pt x="0" y="133317"/>
                  </a:lnTo>
                  <a:lnTo>
                    <a:pt x="0" y="133998"/>
                  </a:lnTo>
                  <a:lnTo>
                    <a:pt x="0" y="134678"/>
                  </a:lnTo>
                  <a:lnTo>
                    <a:pt x="0" y="135358"/>
                  </a:lnTo>
                  <a:lnTo>
                    <a:pt x="0" y="136038"/>
                  </a:lnTo>
                  <a:lnTo>
                    <a:pt x="0" y="136718"/>
                  </a:lnTo>
                  <a:lnTo>
                    <a:pt x="0" y="137399"/>
                  </a:lnTo>
                  <a:lnTo>
                    <a:pt x="0" y="138079"/>
                  </a:lnTo>
                  <a:lnTo>
                    <a:pt x="0" y="138759"/>
                  </a:lnTo>
                  <a:lnTo>
                    <a:pt x="0" y="139439"/>
                  </a:lnTo>
                  <a:lnTo>
                    <a:pt x="0" y="140119"/>
                  </a:lnTo>
                  <a:lnTo>
                    <a:pt x="0" y="140800"/>
                  </a:lnTo>
                  <a:lnTo>
                    <a:pt x="0" y="141480"/>
                  </a:lnTo>
                  <a:lnTo>
                    <a:pt x="0" y="142160"/>
                  </a:lnTo>
                  <a:lnTo>
                    <a:pt x="0" y="142840"/>
                  </a:lnTo>
                  <a:lnTo>
                    <a:pt x="0" y="143520"/>
                  </a:lnTo>
                  <a:lnTo>
                    <a:pt x="0" y="144201"/>
                  </a:lnTo>
                  <a:lnTo>
                    <a:pt x="0" y="144881"/>
                  </a:lnTo>
                  <a:lnTo>
                    <a:pt x="0" y="145561"/>
                  </a:lnTo>
                  <a:lnTo>
                    <a:pt x="0" y="146241"/>
                  </a:lnTo>
                  <a:lnTo>
                    <a:pt x="0" y="146921"/>
                  </a:lnTo>
                  <a:lnTo>
                    <a:pt x="0" y="147601"/>
                  </a:lnTo>
                  <a:lnTo>
                    <a:pt x="0" y="148282"/>
                  </a:lnTo>
                  <a:lnTo>
                    <a:pt x="0" y="148962"/>
                  </a:lnTo>
                  <a:lnTo>
                    <a:pt x="0" y="149642"/>
                  </a:lnTo>
                  <a:lnTo>
                    <a:pt x="0" y="150322"/>
                  </a:lnTo>
                  <a:lnTo>
                    <a:pt x="0" y="151002"/>
                  </a:lnTo>
                  <a:lnTo>
                    <a:pt x="0" y="151683"/>
                  </a:lnTo>
                  <a:lnTo>
                    <a:pt x="0" y="152363"/>
                  </a:lnTo>
                  <a:lnTo>
                    <a:pt x="0" y="153043"/>
                  </a:lnTo>
                  <a:lnTo>
                    <a:pt x="0" y="153723"/>
                  </a:lnTo>
                  <a:lnTo>
                    <a:pt x="0" y="154403"/>
                  </a:lnTo>
                  <a:lnTo>
                    <a:pt x="0" y="155084"/>
                  </a:lnTo>
                  <a:lnTo>
                    <a:pt x="0" y="155764"/>
                  </a:lnTo>
                  <a:lnTo>
                    <a:pt x="0" y="156444"/>
                  </a:lnTo>
                  <a:lnTo>
                    <a:pt x="0" y="157124"/>
                  </a:lnTo>
                  <a:lnTo>
                    <a:pt x="0" y="157804"/>
                  </a:lnTo>
                  <a:lnTo>
                    <a:pt x="0" y="158485"/>
                  </a:lnTo>
                  <a:lnTo>
                    <a:pt x="0" y="159165"/>
                  </a:lnTo>
                  <a:lnTo>
                    <a:pt x="0" y="159845"/>
                  </a:lnTo>
                  <a:lnTo>
                    <a:pt x="0" y="160525"/>
                  </a:lnTo>
                  <a:lnTo>
                    <a:pt x="0" y="161205"/>
                  </a:lnTo>
                  <a:lnTo>
                    <a:pt x="0" y="161886"/>
                  </a:lnTo>
                  <a:lnTo>
                    <a:pt x="0" y="162566"/>
                  </a:lnTo>
                  <a:lnTo>
                    <a:pt x="0" y="163246"/>
                  </a:lnTo>
                  <a:lnTo>
                    <a:pt x="0" y="163926"/>
                  </a:lnTo>
                  <a:lnTo>
                    <a:pt x="0" y="164606"/>
                  </a:lnTo>
                  <a:lnTo>
                    <a:pt x="0" y="165287"/>
                  </a:lnTo>
                  <a:lnTo>
                    <a:pt x="0" y="165967"/>
                  </a:lnTo>
                  <a:lnTo>
                    <a:pt x="0" y="166647"/>
                  </a:lnTo>
                  <a:lnTo>
                    <a:pt x="1" y="167327"/>
                  </a:lnTo>
                  <a:lnTo>
                    <a:pt x="1" y="168007"/>
                  </a:lnTo>
                  <a:lnTo>
                    <a:pt x="1" y="168687"/>
                  </a:lnTo>
                  <a:lnTo>
                    <a:pt x="1" y="169368"/>
                  </a:lnTo>
                  <a:lnTo>
                    <a:pt x="1" y="170048"/>
                  </a:lnTo>
                  <a:lnTo>
                    <a:pt x="1" y="170728"/>
                  </a:lnTo>
                  <a:lnTo>
                    <a:pt x="2" y="171408"/>
                  </a:lnTo>
                  <a:lnTo>
                    <a:pt x="2" y="172088"/>
                  </a:lnTo>
                  <a:lnTo>
                    <a:pt x="2" y="172769"/>
                  </a:lnTo>
                  <a:lnTo>
                    <a:pt x="2" y="173449"/>
                  </a:lnTo>
                  <a:lnTo>
                    <a:pt x="3" y="174129"/>
                  </a:lnTo>
                  <a:lnTo>
                    <a:pt x="3" y="174809"/>
                  </a:lnTo>
                  <a:lnTo>
                    <a:pt x="4" y="175489"/>
                  </a:lnTo>
                  <a:lnTo>
                    <a:pt x="4" y="176170"/>
                  </a:lnTo>
                  <a:lnTo>
                    <a:pt x="4" y="176850"/>
                  </a:lnTo>
                  <a:lnTo>
                    <a:pt x="5" y="177530"/>
                  </a:lnTo>
                  <a:lnTo>
                    <a:pt x="6" y="178210"/>
                  </a:lnTo>
                  <a:lnTo>
                    <a:pt x="6" y="178890"/>
                  </a:lnTo>
                  <a:lnTo>
                    <a:pt x="7" y="179571"/>
                  </a:lnTo>
                  <a:lnTo>
                    <a:pt x="8" y="180251"/>
                  </a:lnTo>
                  <a:lnTo>
                    <a:pt x="8" y="180931"/>
                  </a:lnTo>
                  <a:lnTo>
                    <a:pt x="9" y="181611"/>
                  </a:lnTo>
                  <a:lnTo>
                    <a:pt x="10" y="182291"/>
                  </a:lnTo>
                  <a:lnTo>
                    <a:pt x="11" y="182972"/>
                  </a:lnTo>
                  <a:lnTo>
                    <a:pt x="12" y="183652"/>
                  </a:lnTo>
                  <a:lnTo>
                    <a:pt x="14" y="184332"/>
                  </a:lnTo>
                  <a:lnTo>
                    <a:pt x="15" y="185012"/>
                  </a:lnTo>
                  <a:lnTo>
                    <a:pt x="16" y="185692"/>
                  </a:lnTo>
                  <a:lnTo>
                    <a:pt x="18" y="186373"/>
                  </a:lnTo>
                  <a:lnTo>
                    <a:pt x="20" y="187053"/>
                  </a:lnTo>
                  <a:lnTo>
                    <a:pt x="21" y="187733"/>
                  </a:lnTo>
                  <a:lnTo>
                    <a:pt x="23" y="188413"/>
                  </a:lnTo>
                  <a:lnTo>
                    <a:pt x="25" y="189093"/>
                  </a:lnTo>
                  <a:lnTo>
                    <a:pt x="27" y="189773"/>
                  </a:lnTo>
                  <a:lnTo>
                    <a:pt x="30" y="190454"/>
                  </a:lnTo>
                  <a:lnTo>
                    <a:pt x="32" y="191134"/>
                  </a:lnTo>
                  <a:lnTo>
                    <a:pt x="35" y="191814"/>
                  </a:lnTo>
                  <a:lnTo>
                    <a:pt x="38" y="192494"/>
                  </a:lnTo>
                  <a:lnTo>
                    <a:pt x="41" y="193174"/>
                  </a:lnTo>
                  <a:lnTo>
                    <a:pt x="44" y="193855"/>
                  </a:lnTo>
                  <a:lnTo>
                    <a:pt x="47" y="194535"/>
                  </a:lnTo>
                  <a:lnTo>
                    <a:pt x="51" y="195215"/>
                  </a:lnTo>
                  <a:lnTo>
                    <a:pt x="55" y="195895"/>
                  </a:lnTo>
                  <a:lnTo>
                    <a:pt x="59" y="196575"/>
                  </a:lnTo>
                  <a:lnTo>
                    <a:pt x="63" y="197256"/>
                  </a:lnTo>
                  <a:lnTo>
                    <a:pt x="67" y="197936"/>
                  </a:lnTo>
                  <a:lnTo>
                    <a:pt x="72" y="198616"/>
                  </a:lnTo>
                  <a:lnTo>
                    <a:pt x="77" y="199296"/>
                  </a:lnTo>
                  <a:lnTo>
                    <a:pt x="82" y="199976"/>
                  </a:lnTo>
                  <a:lnTo>
                    <a:pt x="88" y="200657"/>
                  </a:lnTo>
                  <a:lnTo>
                    <a:pt x="93" y="201337"/>
                  </a:lnTo>
                  <a:lnTo>
                    <a:pt x="99" y="202017"/>
                  </a:lnTo>
                  <a:lnTo>
                    <a:pt x="105" y="202697"/>
                  </a:lnTo>
                  <a:lnTo>
                    <a:pt x="112" y="203377"/>
                  </a:lnTo>
                  <a:lnTo>
                    <a:pt x="119" y="204058"/>
                  </a:lnTo>
                  <a:lnTo>
                    <a:pt x="126" y="204738"/>
                  </a:lnTo>
                  <a:lnTo>
                    <a:pt x="133" y="205418"/>
                  </a:lnTo>
                  <a:lnTo>
                    <a:pt x="141" y="206098"/>
                  </a:lnTo>
                  <a:lnTo>
                    <a:pt x="148" y="206778"/>
                  </a:lnTo>
                  <a:lnTo>
                    <a:pt x="157" y="207459"/>
                  </a:lnTo>
                  <a:lnTo>
                    <a:pt x="165" y="208139"/>
                  </a:lnTo>
                  <a:lnTo>
                    <a:pt x="174" y="208819"/>
                  </a:lnTo>
                  <a:lnTo>
                    <a:pt x="182" y="209499"/>
                  </a:lnTo>
                  <a:lnTo>
                    <a:pt x="192" y="210179"/>
                  </a:lnTo>
                  <a:lnTo>
                    <a:pt x="201" y="210859"/>
                  </a:lnTo>
                  <a:lnTo>
                    <a:pt x="211" y="211540"/>
                  </a:lnTo>
                  <a:lnTo>
                    <a:pt x="220" y="212220"/>
                  </a:lnTo>
                  <a:lnTo>
                    <a:pt x="231" y="212900"/>
                  </a:lnTo>
                  <a:lnTo>
                    <a:pt x="241" y="213580"/>
                  </a:lnTo>
                  <a:lnTo>
                    <a:pt x="251" y="214260"/>
                  </a:lnTo>
                  <a:lnTo>
                    <a:pt x="262" y="214941"/>
                  </a:lnTo>
                  <a:lnTo>
                    <a:pt x="273" y="215621"/>
                  </a:lnTo>
                  <a:lnTo>
                    <a:pt x="284" y="216301"/>
                  </a:lnTo>
                  <a:lnTo>
                    <a:pt x="295" y="216981"/>
                  </a:lnTo>
                  <a:lnTo>
                    <a:pt x="306" y="217661"/>
                  </a:lnTo>
                  <a:lnTo>
                    <a:pt x="317" y="218342"/>
                  </a:lnTo>
                  <a:lnTo>
                    <a:pt x="329" y="219022"/>
                  </a:lnTo>
                  <a:lnTo>
                    <a:pt x="340" y="219702"/>
                  </a:lnTo>
                  <a:lnTo>
                    <a:pt x="351" y="220382"/>
                  </a:lnTo>
                  <a:lnTo>
                    <a:pt x="363" y="221062"/>
                  </a:lnTo>
                  <a:lnTo>
                    <a:pt x="374" y="221743"/>
                  </a:lnTo>
                  <a:lnTo>
                    <a:pt x="386" y="222423"/>
                  </a:lnTo>
                  <a:lnTo>
                    <a:pt x="397" y="223103"/>
                  </a:lnTo>
                  <a:lnTo>
                    <a:pt x="409" y="223783"/>
                  </a:lnTo>
                  <a:lnTo>
                    <a:pt x="420" y="224463"/>
                  </a:lnTo>
                  <a:lnTo>
                    <a:pt x="431" y="225144"/>
                  </a:lnTo>
                  <a:lnTo>
                    <a:pt x="442" y="225824"/>
                  </a:lnTo>
                  <a:lnTo>
                    <a:pt x="453" y="226504"/>
                  </a:lnTo>
                  <a:lnTo>
                    <a:pt x="464" y="227184"/>
                  </a:lnTo>
                  <a:lnTo>
                    <a:pt x="474" y="227864"/>
                  </a:lnTo>
                  <a:lnTo>
                    <a:pt x="484" y="228545"/>
                  </a:lnTo>
                  <a:lnTo>
                    <a:pt x="494" y="229225"/>
                  </a:lnTo>
                  <a:lnTo>
                    <a:pt x="504" y="229905"/>
                  </a:lnTo>
                  <a:lnTo>
                    <a:pt x="513" y="230585"/>
                  </a:lnTo>
                  <a:lnTo>
                    <a:pt x="523" y="231265"/>
                  </a:lnTo>
                  <a:lnTo>
                    <a:pt x="532" y="231945"/>
                  </a:lnTo>
                  <a:lnTo>
                    <a:pt x="540" y="232626"/>
                  </a:lnTo>
                  <a:lnTo>
                    <a:pt x="548" y="233306"/>
                  </a:lnTo>
                  <a:lnTo>
                    <a:pt x="556" y="233986"/>
                  </a:lnTo>
                  <a:lnTo>
                    <a:pt x="564" y="234666"/>
                  </a:lnTo>
                  <a:lnTo>
                    <a:pt x="571" y="235346"/>
                  </a:lnTo>
                  <a:lnTo>
                    <a:pt x="578" y="236027"/>
                  </a:lnTo>
                  <a:lnTo>
                    <a:pt x="584" y="236707"/>
                  </a:lnTo>
                  <a:lnTo>
                    <a:pt x="591" y="237387"/>
                  </a:lnTo>
                  <a:lnTo>
                    <a:pt x="596" y="238067"/>
                  </a:lnTo>
                  <a:lnTo>
                    <a:pt x="602" y="238747"/>
                  </a:lnTo>
                  <a:lnTo>
                    <a:pt x="607" y="239428"/>
                  </a:lnTo>
                  <a:lnTo>
                    <a:pt x="611" y="240108"/>
                  </a:lnTo>
                  <a:lnTo>
                    <a:pt x="615" y="240788"/>
                  </a:lnTo>
                  <a:lnTo>
                    <a:pt x="619" y="241468"/>
                  </a:lnTo>
                  <a:lnTo>
                    <a:pt x="623" y="242148"/>
                  </a:lnTo>
                  <a:lnTo>
                    <a:pt x="626" y="242829"/>
                  </a:lnTo>
                  <a:lnTo>
                    <a:pt x="629" y="243509"/>
                  </a:lnTo>
                  <a:lnTo>
                    <a:pt x="632" y="244189"/>
                  </a:lnTo>
                  <a:lnTo>
                    <a:pt x="634" y="244869"/>
                  </a:lnTo>
                  <a:lnTo>
                    <a:pt x="636" y="245549"/>
                  </a:lnTo>
                  <a:lnTo>
                    <a:pt x="637" y="246230"/>
                  </a:lnTo>
                  <a:lnTo>
                    <a:pt x="639" y="246910"/>
                  </a:lnTo>
                  <a:lnTo>
                    <a:pt x="640" y="247590"/>
                  </a:lnTo>
                  <a:lnTo>
                    <a:pt x="641" y="248270"/>
                  </a:lnTo>
                  <a:lnTo>
                    <a:pt x="642" y="248950"/>
                  </a:lnTo>
                  <a:lnTo>
                    <a:pt x="642" y="249631"/>
                  </a:lnTo>
                  <a:lnTo>
                    <a:pt x="643" y="250311"/>
                  </a:lnTo>
                  <a:lnTo>
                    <a:pt x="643" y="250991"/>
                  </a:lnTo>
                  <a:lnTo>
                    <a:pt x="643" y="251671"/>
                  </a:lnTo>
                  <a:lnTo>
                    <a:pt x="643" y="252351"/>
                  </a:lnTo>
                  <a:lnTo>
                    <a:pt x="643" y="253031"/>
                  </a:lnTo>
                  <a:lnTo>
                    <a:pt x="643" y="253712"/>
                  </a:lnTo>
                  <a:lnTo>
                    <a:pt x="643" y="254392"/>
                  </a:lnTo>
                  <a:lnTo>
                    <a:pt x="643" y="255072"/>
                  </a:lnTo>
                  <a:lnTo>
                    <a:pt x="642" y="255752"/>
                  </a:lnTo>
                  <a:lnTo>
                    <a:pt x="642" y="256432"/>
                  </a:lnTo>
                  <a:lnTo>
                    <a:pt x="642" y="257113"/>
                  </a:lnTo>
                  <a:lnTo>
                    <a:pt x="641" y="257793"/>
                  </a:lnTo>
                  <a:lnTo>
                    <a:pt x="641" y="258473"/>
                  </a:lnTo>
                  <a:lnTo>
                    <a:pt x="641" y="259153"/>
                  </a:lnTo>
                  <a:lnTo>
                    <a:pt x="641" y="259833"/>
                  </a:lnTo>
                  <a:lnTo>
                    <a:pt x="640" y="260514"/>
                  </a:lnTo>
                  <a:lnTo>
                    <a:pt x="640" y="261194"/>
                  </a:lnTo>
                  <a:lnTo>
                    <a:pt x="640" y="261874"/>
                  </a:lnTo>
                  <a:lnTo>
                    <a:pt x="640" y="262554"/>
                  </a:lnTo>
                  <a:lnTo>
                    <a:pt x="640" y="263234"/>
                  </a:lnTo>
                  <a:lnTo>
                    <a:pt x="640" y="263915"/>
                  </a:lnTo>
                  <a:lnTo>
                    <a:pt x="640" y="264595"/>
                  </a:lnTo>
                  <a:lnTo>
                    <a:pt x="640" y="265275"/>
                  </a:lnTo>
                  <a:lnTo>
                    <a:pt x="640" y="265955"/>
                  </a:lnTo>
                  <a:lnTo>
                    <a:pt x="640" y="266635"/>
                  </a:lnTo>
                  <a:lnTo>
                    <a:pt x="640" y="267316"/>
                  </a:lnTo>
                  <a:lnTo>
                    <a:pt x="640" y="267996"/>
                  </a:lnTo>
                  <a:lnTo>
                    <a:pt x="640" y="268676"/>
                  </a:lnTo>
                  <a:lnTo>
                    <a:pt x="640" y="269356"/>
                  </a:lnTo>
                  <a:lnTo>
                    <a:pt x="640" y="270036"/>
                  </a:lnTo>
                  <a:lnTo>
                    <a:pt x="640" y="270717"/>
                  </a:lnTo>
                  <a:lnTo>
                    <a:pt x="639" y="271397"/>
                  </a:lnTo>
                  <a:lnTo>
                    <a:pt x="639" y="272077"/>
                  </a:lnTo>
                  <a:lnTo>
                    <a:pt x="638" y="272757"/>
                  </a:lnTo>
                  <a:lnTo>
                    <a:pt x="638" y="273437"/>
                  </a:lnTo>
                  <a:lnTo>
                    <a:pt x="637" y="274117"/>
                  </a:lnTo>
                  <a:lnTo>
                    <a:pt x="636" y="274798"/>
                  </a:lnTo>
                  <a:lnTo>
                    <a:pt x="634" y="275478"/>
                  </a:lnTo>
                  <a:lnTo>
                    <a:pt x="633" y="276158"/>
                  </a:lnTo>
                  <a:lnTo>
                    <a:pt x="631" y="276838"/>
                  </a:lnTo>
                  <a:lnTo>
                    <a:pt x="629" y="277518"/>
                  </a:lnTo>
                  <a:lnTo>
                    <a:pt x="627" y="278199"/>
                  </a:lnTo>
                  <a:lnTo>
                    <a:pt x="624" y="278879"/>
                  </a:lnTo>
                  <a:lnTo>
                    <a:pt x="622" y="279559"/>
                  </a:lnTo>
                  <a:lnTo>
                    <a:pt x="619" y="280239"/>
                  </a:lnTo>
                  <a:lnTo>
                    <a:pt x="615" y="280919"/>
                  </a:lnTo>
                  <a:lnTo>
                    <a:pt x="611" y="281600"/>
                  </a:lnTo>
                  <a:lnTo>
                    <a:pt x="607" y="282280"/>
                  </a:lnTo>
                  <a:lnTo>
                    <a:pt x="603" y="282960"/>
                  </a:lnTo>
                  <a:lnTo>
                    <a:pt x="598" y="283640"/>
                  </a:lnTo>
                  <a:lnTo>
                    <a:pt x="593" y="284320"/>
                  </a:lnTo>
                  <a:lnTo>
                    <a:pt x="587" y="285001"/>
                  </a:lnTo>
                  <a:lnTo>
                    <a:pt x="581" y="285681"/>
                  </a:lnTo>
                  <a:lnTo>
                    <a:pt x="575" y="286361"/>
                  </a:lnTo>
                  <a:lnTo>
                    <a:pt x="568" y="287041"/>
                  </a:lnTo>
                  <a:lnTo>
                    <a:pt x="561" y="287721"/>
                  </a:lnTo>
                  <a:lnTo>
                    <a:pt x="554" y="288402"/>
                  </a:lnTo>
                  <a:lnTo>
                    <a:pt x="547" y="289082"/>
                  </a:lnTo>
                  <a:lnTo>
                    <a:pt x="538" y="289762"/>
                  </a:lnTo>
                  <a:lnTo>
                    <a:pt x="530" y="290442"/>
                  </a:lnTo>
                  <a:lnTo>
                    <a:pt x="522" y="291122"/>
                  </a:lnTo>
                  <a:lnTo>
                    <a:pt x="513" y="291803"/>
                  </a:lnTo>
                  <a:lnTo>
                    <a:pt x="503" y="292483"/>
                  </a:lnTo>
                  <a:lnTo>
                    <a:pt x="494" y="293163"/>
                  </a:lnTo>
                  <a:lnTo>
                    <a:pt x="484" y="293843"/>
                  </a:lnTo>
                  <a:lnTo>
                    <a:pt x="474" y="294523"/>
                  </a:lnTo>
                  <a:lnTo>
                    <a:pt x="464" y="295203"/>
                  </a:lnTo>
                  <a:lnTo>
                    <a:pt x="454" y="295884"/>
                  </a:lnTo>
                  <a:lnTo>
                    <a:pt x="443" y="296564"/>
                  </a:lnTo>
                  <a:lnTo>
                    <a:pt x="432" y="297244"/>
                  </a:lnTo>
                  <a:lnTo>
                    <a:pt x="421" y="297924"/>
                  </a:lnTo>
                  <a:lnTo>
                    <a:pt x="410" y="298604"/>
                  </a:lnTo>
                  <a:lnTo>
                    <a:pt x="399" y="299285"/>
                  </a:lnTo>
                  <a:lnTo>
                    <a:pt x="388" y="299965"/>
                  </a:lnTo>
                  <a:lnTo>
                    <a:pt x="377" y="300645"/>
                  </a:lnTo>
                  <a:lnTo>
                    <a:pt x="365" y="301325"/>
                  </a:lnTo>
                  <a:lnTo>
                    <a:pt x="354" y="302005"/>
                  </a:lnTo>
                  <a:lnTo>
                    <a:pt x="343" y="302686"/>
                  </a:lnTo>
                  <a:lnTo>
                    <a:pt x="332" y="303366"/>
                  </a:lnTo>
                  <a:lnTo>
                    <a:pt x="320" y="304046"/>
                  </a:lnTo>
                  <a:lnTo>
                    <a:pt x="309" y="304726"/>
                  </a:lnTo>
                  <a:lnTo>
                    <a:pt x="298" y="305406"/>
                  </a:lnTo>
                  <a:lnTo>
                    <a:pt x="287" y="306087"/>
                  </a:lnTo>
                  <a:lnTo>
                    <a:pt x="276" y="306767"/>
                  </a:lnTo>
                  <a:lnTo>
                    <a:pt x="266" y="307447"/>
                  </a:lnTo>
                  <a:lnTo>
                    <a:pt x="255" y="308127"/>
                  </a:lnTo>
                  <a:lnTo>
                    <a:pt x="245" y="308807"/>
                  </a:lnTo>
                  <a:lnTo>
                    <a:pt x="234" y="309488"/>
                  </a:lnTo>
                  <a:lnTo>
                    <a:pt x="224" y="310168"/>
                  </a:lnTo>
                  <a:lnTo>
                    <a:pt x="215" y="310848"/>
                  </a:lnTo>
                  <a:lnTo>
                    <a:pt x="205" y="311528"/>
                  </a:lnTo>
                  <a:lnTo>
                    <a:pt x="196" y="312208"/>
                  </a:lnTo>
                  <a:lnTo>
                    <a:pt x="186" y="312889"/>
                  </a:lnTo>
                  <a:lnTo>
                    <a:pt x="178" y="313569"/>
                  </a:lnTo>
                  <a:lnTo>
                    <a:pt x="169" y="314249"/>
                  </a:lnTo>
                  <a:lnTo>
                    <a:pt x="160" y="314929"/>
                  </a:lnTo>
                  <a:lnTo>
                    <a:pt x="152" y="315609"/>
                  </a:lnTo>
                  <a:lnTo>
                    <a:pt x="144" y="316289"/>
                  </a:lnTo>
                  <a:lnTo>
                    <a:pt x="137" y="316970"/>
                  </a:lnTo>
                  <a:lnTo>
                    <a:pt x="129" y="317650"/>
                  </a:lnTo>
                  <a:lnTo>
                    <a:pt x="122" y="318330"/>
                  </a:lnTo>
                  <a:lnTo>
                    <a:pt x="115" y="319010"/>
                  </a:lnTo>
                  <a:lnTo>
                    <a:pt x="109" y="319690"/>
                  </a:lnTo>
                  <a:lnTo>
                    <a:pt x="103" y="320371"/>
                  </a:lnTo>
                  <a:lnTo>
                    <a:pt x="97" y="321051"/>
                  </a:lnTo>
                  <a:lnTo>
                    <a:pt x="91" y="321731"/>
                  </a:lnTo>
                  <a:lnTo>
                    <a:pt x="85" y="322411"/>
                  </a:lnTo>
                  <a:lnTo>
                    <a:pt x="80" y="323091"/>
                  </a:lnTo>
                  <a:lnTo>
                    <a:pt x="75" y="323772"/>
                  </a:lnTo>
                  <a:lnTo>
                    <a:pt x="70" y="324452"/>
                  </a:lnTo>
                  <a:lnTo>
                    <a:pt x="66" y="325132"/>
                  </a:lnTo>
                  <a:lnTo>
                    <a:pt x="61" y="325812"/>
                  </a:lnTo>
                  <a:lnTo>
                    <a:pt x="57" y="326492"/>
                  </a:lnTo>
                  <a:lnTo>
                    <a:pt x="53" y="327173"/>
                  </a:lnTo>
                  <a:lnTo>
                    <a:pt x="49" y="327853"/>
                  </a:lnTo>
                  <a:lnTo>
                    <a:pt x="46" y="328533"/>
                  </a:lnTo>
                  <a:lnTo>
                    <a:pt x="43" y="329213"/>
                  </a:lnTo>
                  <a:lnTo>
                    <a:pt x="40" y="329893"/>
                  </a:lnTo>
                  <a:lnTo>
                    <a:pt x="37" y="330574"/>
                  </a:lnTo>
                  <a:lnTo>
                    <a:pt x="34" y="331254"/>
                  </a:lnTo>
                  <a:lnTo>
                    <a:pt x="31" y="331934"/>
                  </a:lnTo>
                  <a:lnTo>
                    <a:pt x="29" y="332614"/>
                  </a:lnTo>
                  <a:lnTo>
                    <a:pt x="27" y="333294"/>
                  </a:lnTo>
                  <a:lnTo>
                    <a:pt x="25" y="333975"/>
                  </a:lnTo>
                  <a:lnTo>
                    <a:pt x="23" y="334655"/>
                  </a:lnTo>
                  <a:lnTo>
                    <a:pt x="21" y="335335"/>
                  </a:lnTo>
                  <a:lnTo>
                    <a:pt x="19" y="336015"/>
                  </a:lnTo>
                  <a:lnTo>
                    <a:pt x="17" y="336695"/>
                  </a:lnTo>
                  <a:lnTo>
                    <a:pt x="16" y="337375"/>
                  </a:lnTo>
                  <a:lnTo>
                    <a:pt x="15" y="338056"/>
                  </a:lnTo>
                  <a:lnTo>
                    <a:pt x="13" y="338736"/>
                  </a:lnTo>
                  <a:lnTo>
                    <a:pt x="12" y="339416"/>
                  </a:lnTo>
                  <a:lnTo>
                    <a:pt x="11" y="340096"/>
                  </a:lnTo>
                  <a:lnTo>
                    <a:pt x="10" y="340776"/>
                  </a:lnTo>
                  <a:lnTo>
                    <a:pt x="9" y="341457"/>
                  </a:lnTo>
                  <a:lnTo>
                    <a:pt x="8" y="342137"/>
                  </a:lnTo>
                  <a:lnTo>
                    <a:pt x="7" y="342817"/>
                  </a:lnTo>
                  <a:lnTo>
                    <a:pt x="7" y="343497"/>
                  </a:lnTo>
                  <a:lnTo>
                    <a:pt x="6" y="344177"/>
                  </a:lnTo>
                  <a:lnTo>
                    <a:pt x="5" y="344858"/>
                  </a:lnTo>
                  <a:lnTo>
                    <a:pt x="5" y="345538"/>
                  </a:lnTo>
                  <a:lnTo>
                    <a:pt x="4" y="346218"/>
                  </a:lnTo>
                  <a:lnTo>
                    <a:pt x="4" y="346898"/>
                  </a:lnTo>
                  <a:lnTo>
                    <a:pt x="3" y="347578"/>
                  </a:lnTo>
                  <a:lnTo>
                    <a:pt x="0" y="347578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38" name="pl20"/>
            <p:cNvSpPr/>
            <p:nvPr/>
          </p:nvSpPr>
          <p:spPr>
            <a:xfrm>
              <a:off x="2813679" y="3116814"/>
              <a:ext cx="201" cy="932786"/>
            </a:xfrm>
            <a:custGeom>
              <a:avLst/>
              <a:gdLst/>
              <a:ahLst/>
              <a:cxnLst/>
              <a:rect l="0" t="0" r="0" b="0"/>
              <a:pathLst>
                <a:path w="201" h="932786">
                  <a:moveTo>
                    <a:pt x="201" y="932786"/>
                  </a:moveTo>
                  <a:lnTo>
                    <a:pt x="200" y="932786"/>
                  </a:lnTo>
                  <a:lnTo>
                    <a:pt x="200" y="930961"/>
                  </a:lnTo>
                  <a:lnTo>
                    <a:pt x="200" y="929135"/>
                  </a:lnTo>
                  <a:lnTo>
                    <a:pt x="200" y="927310"/>
                  </a:lnTo>
                  <a:lnTo>
                    <a:pt x="200" y="925485"/>
                  </a:lnTo>
                  <a:lnTo>
                    <a:pt x="200" y="923659"/>
                  </a:lnTo>
                  <a:lnTo>
                    <a:pt x="200" y="921834"/>
                  </a:lnTo>
                  <a:lnTo>
                    <a:pt x="200" y="920008"/>
                  </a:lnTo>
                  <a:lnTo>
                    <a:pt x="200" y="918183"/>
                  </a:lnTo>
                  <a:lnTo>
                    <a:pt x="199" y="916357"/>
                  </a:lnTo>
                  <a:lnTo>
                    <a:pt x="199" y="914532"/>
                  </a:lnTo>
                  <a:lnTo>
                    <a:pt x="199" y="912707"/>
                  </a:lnTo>
                  <a:lnTo>
                    <a:pt x="199" y="910881"/>
                  </a:lnTo>
                  <a:lnTo>
                    <a:pt x="199" y="909056"/>
                  </a:lnTo>
                  <a:lnTo>
                    <a:pt x="199" y="907230"/>
                  </a:lnTo>
                  <a:lnTo>
                    <a:pt x="199" y="905405"/>
                  </a:lnTo>
                  <a:lnTo>
                    <a:pt x="198" y="903580"/>
                  </a:lnTo>
                  <a:lnTo>
                    <a:pt x="198" y="901754"/>
                  </a:lnTo>
                  <a:lnTo>
                    <a:pt x="198" y="899929"/>
                  </a:lnTo>
                  <a:lnTo>
                    <a:pt x="198" y="898103"/>
                  </a:lnTo>
                  <a:lnTo>
                    <a:pt x="198" y="896278"/>
                  </a:lnTo>
                  <a:lnTo>
                    <a:pt x="197" y="894452"/>
                  </a:lnTo>
                  <a:lnTo>
                    <a:pt x="197" y="892627"/>
                  </a:lnTo>
                  <a:lnTo>
                    <a:pt x="197" y="890802"/>
                  </a:lnTo>
                  <a:lnTo>
                    <a:pt x="197" y="888976"/>
                  </a:lnTo>
                  <a:lnTo>
                    <a:pt x="196" y="887151"/>
                  </a:lnTo>
                  <a:lnTo>
                    <a:pt x="196" y="885325"/>
                  </a:lnTo>
                  <a:lnTo>
                    <a:pt x="196" y="883500"/>
                  </a:lnTo>
                  <a:lnTo>
                    <a:pt x="196" y="881675"/>
                  </a:lnTo>
                  <a:lnTo>
                    <a:pt x="195" y="879849"/>
                  </a:lnTo>
                  <a:lnTo>
                    <a:pt x="195" y="878024"/>
                  </a:lnTo>
                  <a:lnTo>
                    <a:pt x="195" y="876198"/>
                  </a:lnTo>
                  <a:lnTo>
                    <a:pt x="194" y="874373"/>
                  </a:lnTo>
                  <a:lnTo>
                    <a:pt x="194" y="872547"/>
                  </a:lnTo>
                  <a:lnTo>
                    <a:pt x="193" y="870722"/>
                  </a:lnTo>
                  <a:lnTo>
                    <a:pt x="193" y="868897"/>
                  </a:lnTo>
                  <a:lnTo>
                    <a:pt x="193" y="867071"/>
                  </a:lnTo>
                  <a:lnTo>
                    <a:pt x="192" y="865246"/>
                  </a:lnTo>
                  <a:lnTo>
                    <a:pt x="192" y="863420"/>
                  </a:lnTo>
                  <a:lnTo>
                    <a:pt x="191" y="861595"/>
                  </a:lnTo>
                  <a:lnTo>
                    <a:pt x="190" y="859770"/>
                  </a:lnTo>
                  <a:lnTo>
                    <a:pt x="190" y="857944"/>
                  </a:lnTo>
                  <a:lnTo>
                    <a:pt x="189" y="856119"/>
                  </a:lnTo>
                  <a:lnTo>
                    <a:pt x="189" y="854293"/>
                  </a:lnTo>
                  <a:lnTo>
                    <a:pt x="188" y="852468"/>
                  </a:lnTo>
                  <a:lnTo>
                    <a:pt x="187" y="850643"/>
                  </a:lnTo>
                  <a:lnTo>
                    <a:pt x="187" y="848817"/>
                  </a:lnTo>
                  <a:lnTo>
                    <a:pt x="186" y="846992"/>
                  </a:lnTo>
                  <a:lnTo>
                    <a:pt x="185" y="845166"/>
                  </a:lnTo>
                  <a:lnTo>
                    <a:pt x="185" y="843341"/>
                  </a:lnTo>
                  <a:lnTo>
                    <a:pt x="184" y="841515"/>
                  </a:lnTo>
                  <a:lnTo>
                    <a:pt x="183" y="839690"/>
                  </a:lnTo>
                  <a:lnTo>
                    <a:pt x="182" y="837865"/>
                  </a:lnTo>
                  <a:lnTo>
                    <a:pt x="181" y="836039"/>
                  </a:lnTo>
                  <a:lnTo>
                    <a:pt x="180" y="834214"/>
                  </a:lnTo>
                  <a:lnTo>
                    <a:pt x="179" y="832388"/>
                  </a:lnTo>
                  <a:lnTo>
                    <a:pt x="178" y="830563"/>
                  </a:lnTo>
                  <a:lnTo>
                    <a:pt x="177" y="828738"/>
                  </a:lnTo>
                  <a:lnTo>
                    <a:pt x="176" y="826912"/>
                  </a:lnTo>
                  <a:lnTo>
                    <a:pt x="175" y="825087"/>
                  </a:lnTo>
                  <a:lnTo>
                    <a:pt x="174" y="823261"/>
                  </a:lnTo>
                  <a:lnTo>
                    <a:pt x="173" y="821436"/>
                  </a:lnTo>
                  <a:lnTo>
                    <a:pt x="172" y="819610"/>
                  </a:lnTo>
                  <a:lnTo>
                    <a:pt x="171" y="817785"/>
                  </a:lnTo>
                  <a:lnTo>
                    <a:pt x="169" y="815960"/>
                  </a:lnTo>
                  <a:lnTo>
                    <a:pt x="168" y="814134"/>
                  </a:lnTo>
                  <a:lnTo>
                    <a:pt x="167" y="812309"/>
                  </a:lnTo>
                  <a:lnTo>
                    <a:pt x="165" y="810483"/>
                  </a:lnTo>
                  <a:lnTo>
                    <a:pt x="164" y="808658"/>
                  </a:lnTo>
                  <a:lnTo>
                    <a:pt x="162" y="806833"/>
                  </a:lnTo>
                  <a:lnTo>
                    <a:pt x="161" y="805007"/>
                  </a:lnTo>
                  <a:lnTo>
                    <a:pt x="159" y="803182"/>
                  </a:lnTo>
                  <a:lnTo>
                    <a:pt x="158" y="801356"/>
                  </a:lnTo>
                  <a:lnTo>
                    <a:pt x="156" y="799531"/>
                  </a:lnTo>
                  <a:lnTo>
                    <a:pt x="155" y="797706"/>
                  </a:lnTo>
                  <a:lnTo>
                    <a:pt x="153" y="795880"/>
                  </a:lnTo>
                  <a:lnTo>
                    <a:pt x="151" y="794055"/>
                  </a:lnTo>
                  <a:lnTo>
                    <a:pt x="150" y="792229"/>
                  </a:lnTo>
                  <a:lnTo>
                    <a:pt x="148" y="790404"/>
                  </a:lnTo>
                  <a:lnTo>
                    <a:pt x="146" y="788578"/>
                  </a:lnTo>
                  <a:lnTo>
                    <a:pt x="144" y="786753"/>
                  </a:lnTo>
                  <a:lnTo>
                    <a:pt x="142" y="784928"/>
                  </a:lnTo>
                  <a:lnTo>
                    <a:pt x="140" y="783102"/>
                  </a:lnTo>
                  <a:lnTo>
                    <a:pt x="138" y="781277"/>
                  </a:lnTo>
                  <a:lnTo>
                    <a:pt x="136" y="779451"/>
                  </a:lnTo>
                  <a:lnTo>
                    <a:pt x="134" y="777626"/>
                  </a:lnTo>
                  <a:lnTo>
                    <a:pt x="132" y="775801"/>
                  </a:lnTo>
                  <a:lnTo>
                    <a:pt x="130" y="773975"/>
                  </a:lnTo>
                  <a:lnTo>
                    <a:pt x="128" y="772150"/>
                  </a:lnTo>
                  <a:lnTo>
                    <a:pt x="126" y="770324"/>
                  </a:lnTo>
                  <a:lnTo>
                    <a:pt x="123" y="768499"/>
                  </a:lnTo>
                  <a:lnTo>
                    <a:pt x="121" y="766673"/>
                  </a:lnTo>
                  <a:lnTo>
                    <a:pt x="119" y="764848"/>
                  </a:lnTo>
                  <a:lnTo>
                    <a:pt x="117" y="763023"/>
                  </a:lnTo>
                  <a:lnTo>
                    <a:pt x="114" y="761197"/>
                  </a:lnTo>
                  <a:lnTo>
                    <a:pt x="112" y="759372"/>
                  </a:lnTo>
                  <a:lnTo>
                    <a:pt x="110" y="757546"/>
                  </a:lnTo>
                  <a:lnTo>
                    <a:pt x="107" y="755721"/>
                  </a:lnTo>
                  <a:lnTo>
                    <a:pt x="105" y="753896"/>
                  </a:lnTo>
                  <a:lnTo>
                    <a:pt x="102" y="752070"/>
                  </a:lnTo>
                  <a:lnTo>
                    <a:pt x="100" y="750245"/>
                  </a:lnTo>
                  <a:lnTo>
                    <a:pt x="98" y="748419"/>
                  </a:lnTo>
                  <a:lnTo>
                    <a:pt x="95" y="746594"/>
                  </a:lnTo>
                  <a:lnTo>
                    <a:pt x="93" y="744769"/>
                  </a:lnTo>
                  <a:lnTo>
                    <a:pt x="90" y="742943"/>
                  </a:lnTo>
                  <a:lnTo>
                    <a:pt x="88" y="741118"/>
                  </a:lnTo>
                  <a:lnTo>
                    <a:pt x="85" y="739292"/>
                  </a:lnTo>
                  <a:lnTo>
                    <a:pt x="83" y="737467"/>
                  </a:lnTo>
                  <a:lnTo>
                    <a:pt x="80" y="735641"/>
                  </a:lnTo>
                  <a:lnTo>
                    <a:pt x="78" y="733816"/>
                  </a:lnTo>
                  <a:lnTo>
                    <a:pt x="75" y="731991"/>
                  </a:lnTo>
                  <a:lnTo>
                    <a:pt x="73" y="730165"/>
                  </a:lnTo>
                  <a:lnTo>
                    <a:pt x="70" y="728340"/>
                  </a:lnTo>
                  <a:lnTo>
                    <a:pt x="68" y="726514"/>
                  </a:lnTo>
                  <a:lnTo>
                    <a:pt x="65" y="724689"/>
                  </a:lnTo>
                  <a:lnTo>
                    <a:pt x="63" y="722864"/>
                  </a:lnTo>
                  <a:lnTo>
                    <a:pt x="60" y="721038"/>
                  </a:lnTo>
                  <a:lnTo>
                    <a:pt x="58" y="719213"/>
                  </a:lnTo>
                  <a:lnTo>
                    <a:pt x="55" y="717387"/>
                  </a:lnTo>
                  <a:lnTo>
                    <a:pt x="53" y="715562"/>
                  </a:lnTo>
                  <a:lnTo>
                    <a:pt x="51" y="713736"/>
                  </a:lnTo>
                  <a:lnTo>
                    <a:pt x="48" y="711911"/>
                  </a:lnTo>
                  <a:lnTo>
                    <a:pt x="46" y="710086"/>
                  </a:lnTo>
                  <a:lnTo>
                    <a:pt x="44" y="708260"/>
                  </a:lnTo>
                  <a:lnTo>
                    <a:pt x="42" y="706435"/>
                  </a:lnTo>
                  <a:lnTo>
                    <a:pt x="39" y="704609"/>
                  </a:lnTo>
                  <a:lnTo>
                    <a:pt x="37" y="702784"/>
                  </a:lnTo>
                  <a:lnTo>
                    <a:pt x="35" y="700959"/>
                  </a:lnTo>
                  <a:lnTo>
                    <a:pt x="33" y="699133"/>
                  </a:lnTo>
                  <a:lnTo>
                    <a:pt x="31" y="697308"/>
                  </a:lnTo>
                  <a:lnTo>
                    <a:pt x="29" y="695482"/>
                  </a:lnTo>
                  <a:lnTo>
                    <a:pt x="27" y="693657"/>
                  </a:lnTo>
                  <a:lnTo>
                    <a:pt x="25" y="691831"/>
                  </a:lnTo>
                  <a:lnTo>
                    <a:pt x="23" y="690006"/>
                  </a:lnTo>
                  <a:lnTo>
                    <a:pt x="22" y="688181"/>
                  </a:lnTo>
                  <a:lnTo>
                    <a:pt x="20" y="686355"/>
                  </a:lnTo>
                  <a:lnTo>
                    <a:pt x="18" y="684530"/>
                  </a:lnTo>
                  <a:lnTo>
                    <a:pt x="17" y="682704"/>
                  </a:lnTo>
                  <a:lnTo>
                    <a:pt x="15" y="680879"/>
                  </a:lnTo>
                  <a:lnTo>
                    <a:pt x="14" y="679054"/>
                  </a:lnTo>
                  <a:lnTo>
                    <a:pt x="12" y="677228"/>
                  </a:lnTo>
                  <a:lnTo>
                    <a:pt x="11" y="675403"/>
                  </a:lnTo>
                  <a:lnTo>
                    <a:pt x="10" y="673577"/>
                  </a:lnTo>
                  <a:lnTo>
                    <a:pt x="9" y="671752"/>
                  </a:lnTo>
                  <a:lnTo>
                    <a:pt x="8" y="669927"/>
                  </a:lnTo>
                  <a:lnTo>
                    <a:pt x="6" y="668101"/>
                  </a:lnTo>
                  <a:lnTo>
                    <a:pt x="5" y="666276"/>
                  </a:lnTo>
                  <a:lnTo>
                    <a:pt x="5" y="664450"/>
                  </a:lnTo>
                  <a:lnTo>
                    <a:pt x="4" y="662625"/>
                  </a:lnTo>
                  <a:lnTo>
                    <a:pt x="3" y="660799"/>
                  </a:lnTo>
                  <a:lnTo>
                    <a:pt x="2" y="658974"/>
                  </a:lnTo>
                  <a:lnTo>
                    <a:pt x="2" y="657149"/>
                  </a:lnTo>
                  <a:lnTo>
                    <a:pt x="1" y="655323"/>
                  </a:lnTo>
                  <a:lnTo>
                    <a:pt x="1" y="653498"/>
                  </a:lnTo>
                  <a:lnTo>
                    <a:pt x="0" y="651672"/>
                  </a:lnTo>
                  <a:lnTo>
                    <a:pt x="0" y="649847"/>
                  </a:lnTo>
                  <a:lnTo>
                    <a:pt x="0" y="648022"/>
                  </a:lnTo>
                  <a:lnTo>
                    <a:pt x="0" y="646196"/>
                  </a:lnTo>
                  <a:lnTo>
                    <a:pt x="0" y="644371"/>
                  </a:lnTo>
                  <a:lnTo>
                    <a:pt x="0" y="642545"/>
                  </a:lnTo>
                  <a:lnTo>
                    <a:pt x="0" y="640720"/>
                  </a:lnTo>
                  <a:lnTo>
                    <a:pt x="0" y="638894"/>
                  </a:lnTo>
                  <a:lnTo>
                    <a:pt x="0" y="637069"/>
                  </a:lnTo>
                  <a:lnTo>
                    <a:pt x="0" y="635244"/>
                  </a:lnTo>
                  <a:lnTo>
                    <a:pt x="0" y="633418"/>
                  </a:lnTo>
                  <a:lnTo>
                    <a:pt x="1" y="631593"/>
                  </a:lnTo>
                  <a:lnTo>
                    <a:pt x="1" y="629767"/>
                  </a:lnTo>
                  <a:lnTo>
                    <a:pt x="2" y="627942"/>
                  </a:lnTo>
                  <a:lnTo>
                    <a:pt x="3" y="626117"/>
                  </a:lnTo>
                  <a:lnTo>
                    <a:pt x="3" y="624291"/>
                  </a:lnTo>
                  <a:lnTo>
                    <a:pt x="4" y="622466"/>
                  </a:lnTo>
                  <a:lnTo>
                    <a:pt x="5" y="620640"/>
                  </a:lnTo>
                  <a:lnTo>
                    <a:pt x="6" y="618815"/>
                  </a:lnTo>
                  <a:lnTo>
                    <a:pt x="6" y="616990"/>
                  </a:lnTo>
                  <a:lnTo>
                    <a:pt x="7" y="615164"/>
                  </a:lnTo>
                  <a:lnTo>
                    <a:pt x="8" y="613339"/>
                  </a:lnTo>
                  <a:lnTo>
                    <a:pt x="9" y="611513"/>
                  </a:lnTo>
                  <a:lnTo>
                    <a:pt x="11" y="609688"/>
                  </a:lnTo>
                  <a:lnTo>
                    <a:pt x="12" y="607862"/>
                  </a:lnTo>
                  <a:lnTo>
                    <a:pt x="13" y="606037"/>
                  </a:lnTo>
                  <a:lnTo>
                    <a:pt x="14" y="604212"/>
                  </a:lnTo>
                  <a:lnTo>
                    <a:pt x="15" y="602386"/>
                  </a:lnTo>
                  <a:lnTo>
                    <a:pt x="17" y="600561"/>
                  </a:lnTo>
                  <a:lnTo>
                    <a:pt x="18" y="598735"/>
                  </a:lnTo>
                  <a:lnTo>
                    <a:pt x="19" y="596910"/>
                  </a:lnTo>
                  <a:lnTo>
                    <a:pt x="21" y="595085"/>
                  </a:lnTo>
                  <a:lnTo>
                    <a:pt x="22" y="593259"/>
                  </a:lnTo>
                  <a:lnTo>
                    <a:pt x="24" y="591434"/>
                  </a:lnTo>
                  <a:lnTo>
                    <a:pt x="25" y="589608"/>
                  </a:lnTo>
                  <a:lnTo>
                    <a:pt x="27" y="587783"/>
                  </a:lnTo>
                  <a:lnTo>
                    <a:pt x="28" y="585957"/>
                  </a:lnTo>
                  <a:lnTo>
                    <a:pt x="30" y="584132"/>
                  </a:lnTo>
                  <a:lnTo>
                    <a:pt x="31" y="582307"/>
                  </a:lnTo>
                  <a:lnTo>
                    <a:pt x="33" y="580481"/>
                  </a:lnTo>
                  <a:lnTo>
                    <a:pt x="35" y="578656"/>
                  </a:lnTo>
                  <a:lnTo>
                    <a:pt x="36" y="576830"/>
                  </a:lnTo>
                  <a:lnTo>
                    <a:pt x="38" y="575005"/>
                  </a:lnTo>
                  <a:lnTo>
                    <a:pt x="39" y="573180"/>
                  </a:lnTo>
                  <a:lnTo>
                    <a:pt x="41" y="571354"/>
                  </a:lnTo>
                  <a:lnTo>
                    <a:pt x="43" y="569529"/>
                  </a:lnTo>
                  <a:lnTo>
                    <a:pt x="44" y="567703"/>
                  </a:lnTo>
                  <a:lnTo>
                    <a:pt x="46" y="565878"/>
                  </a:lnTo>
                  <a:lnTo>
                    <a:pt x="47" y="564052"/>
                  </a:lnTo>
                  <a:lnTo>
                    <a:pt x="49" y="562227"/>
                  </a:lnTo>
                  <a:lnTo>
                    <a:pt x="51" y="560402"/>
                  </a:lnTo>
                  <a:lnTo>
                    <a:pt x="52" y="558576"/>
                  </a:lnTo>
                  <a:lnTo>
                    <a:pt x="54" y="556751"/>
                  </a:lnTo>
                  <a:lnTo>
                    <a:pt x="55" y="554925"/>
                  </a:lnTo>
                  <a:lnTo>
                    <a:pt x="57" y="553100"/>
                  </a:lnTo>
                  <a:lnTo>
                    <a:pt x="59" y="551275"/>
                  </a:lnTo>
                  <a:lnTo>
                    <a:pt x="60" y="549449"/>
                  </a:lnTo>
                  <a:lnTo>
                    <a:pt x="62" y="547624"/>
                  </a:lnTo>
                  <a:lnTo>
                    <a:pt x="63" y="545798"/>
                  </a:lnTo>
                  <a:lnTo>
                    <a:pt x="65" y="543973"/>
                  </a:lnTo>
                  <a:lnTo>
                    <a:pt x="66" y="542148"/>
                  </a:lnTo>
                  <a:lnTo>
                    <a:pt x="68" y="540322"/>
                  </a:lnTo>
                  <a:lnTo>
                    <a:pt x="69" y="538497"/>
                  </a:lnTo>
                  <a:lnTo>
                    <a:pt x="70" y="536671"/>
                  </a:lnTo>
                  <a:lnTo>
                    <a:pt x="72" y="534846"/>
                  </a:lnTo>
                  <a:lnTo>
                    <a:pt x="73" y="533020"/>
                  </a:lnTo>
                  <a:lnTo>
                    <a:pt x="75" y="531195"/>
                  </a:lnTo>
                  <a:lnTo>
                    <a:pt x="76" y="529370"/>
                  </a:lnTo>
                  <a:lnTo>
                    <a:pt x="77" y="527544"/>
                  </a:lnTo>
                  <a:lnTo>
                    <a:pt x="79" y="525719"/>
                  </a:lnTo>
                  <a:lnTo>
                    <a:pt x="80" y="523893"/>
                  </a:lnTo>
                  <a:lnTo>
                    <a:pt x="81" y="522068"/>
                  </a:lnTo>
                  <a:lnTo>
                    <a:pt x="82" y="520243"/>
                  </a:lnTo>
                  <a:lnTo>
                    <a:pt x="84" y="518417"/>
                  </a:lnTo>
                  <a:lnTo>
                    <a:pt x="85" y="516592"/>
                  </a:lnTo>
                  <a:lnTo>
                    <a:pt x="86" y="514766"/>
                  </a:lnTo>
                  <a:lnTo>
                    <a:pt x="87" y="512941"/>
                  </a:lnTo>
                  <a:lnTo>
                    <a:pt x="88" y="511115"/>
                  </a:lnTo>
                  <a:lnTo>
                    <a:pt x="89" y="509290"/>
                  </a:lnTo>
                  <a:lnTo>
                    <a:pt x="90" y="507465"/>
                  </a:lnTo>
                  <a:lnTo>
                    <a:pt x="92" y="505639"/>
                  </a:lnTo>
                  <a:lnTo>
                    <a:pt x="93" y="503814"/>
                  </a:lnTo>
                  <a:lnTo>
                    <a:pt x="94" y="501988"/>
                  </a:lnTo>
                  <a:lnTo>
                    <a:pt x="95" y="500163"/>
                  </a:lnTo>
                  <a:lnTo>
                    <a:pt x="96" y="498338"/>
                  </a:lnTo>
                  <a:lnTo>
                    <a:pt x="97" y="496512"/>
                  </a:lnTo>
                  <a:lnTo>
                    <a:pt x="98" y="494687"/>
                  </a:lnTo>
                  <a:lnTo>
                    <a:pt x="99" y="492861"/>
                  </a:lnTo>
                  <a:lnTo>
                    <a:pt x="100" y="491036"/>
                  </a:lnTo>
                  <a:lnTo>
                    <a:pt x="101" y="489211"/>
                  </a:lnTo>
                  <a:lnTo>
                    <a:pt x="102" y="487385"/>
                  </a:lnTo>
                  <a:lnTo>
                    <a:pt x="103" y="485560"/>
                  </a:lnTo>
                  <a:lnTo>
                    <a:pt x="104" y="483734"/>
                  </a:lnTo>
                  <a:lnTo>
                    <a:pt x="105" y="481909"/>
                  </a:lnTo>
                  <a:lnTo>
                    <a:pt x="105" y="480083"/>
                  </a:lnTo>
                  <a:lnTo>
                    <a:pt x="106" y="478258"/>
                  </a:lnTo>
                  <a:lnTo>
                    <a:pt x="107" y="476433"/>
                  </a:lnTo>
                  <a:lnTo>
                    <a:pt x="108" y="474607"/>
                  </a:lnTo>
                  <a:lnTo>
                    <a:pt x="109" y="472782"/>
                  </a:lnTo>
                  <a:lnTo>
                    <a:pt x="110" y="470956"/>
                  </a:lnTo>
                  <a:lnTo>
                    <a:pt x="111" y="469131"/>
                  </a:lnTo>
                  <a:lnTo>
                    <a:pt x="112" y="467306"/>
                  </a:lnTo>
                  <a:lnTo>
                    <a:pt x="112" y="465480"/>
                  </a:lnTo>
                  <a:lnTo>
                    <a:pt x="113" y="463655"/>
                  </a:lnTo>
                  <a:lnTo>
                    <a:pt x="114" y="461829"/>
                  </a:lnTo>
                  <a:lnTo>
                    <a:pt x="115" y="460004"/>
                  </a:lnTo>
                  <a:lnTo>
                    <a:pt x="116" y="458178"/>
                  </a:lnTo>
                  <a:lnTo>
                    <a:pt x="117" y="456353"/>
                  </a:lnTo>
                  <a:lnTo>
                    <a:pt x="117" y="454528"/>
                  </a:lnTo>
                  <a:lnTo>
                    <a:pt x="118" y="452702"/>
                  </a:lnTo>
                  <a:lnTo>
                    <a:pt x="119" y="450877"/>
                  </a:lnTo>
                  <a:lnTo>
                    <a:pt x="120" y="449051"/>
                  </a:lnTo>
                  <a:lnTo>
                    <a:pt x="121" y="447226"/>
                  </a:lnTo>
                  <a:lnTo>
                    <a:pt x="121" y="445401"/>
                  </a:lnTo>
                  <a:lnTo>
                    <a:pt x="122" y="443575"/>
                  </a:lnTo>
                  <a:lnTo>
                    <a:pt x="123" y="441750"/>
                  </a:lnTo>
                  <a:lnTo>
                    <a:pt x="124" y="439924"/>
                  </a:lnTo>
                  <a:lnTo>
                    <a:pt x="125" y="438099"/>
                  </a:lnTo>
                  <a:lnTo>
                    <a:pt x="125" y="436273"/>
                  </a:lnTo>
                  <a:lnTo>
                    <a:pt x="126" y="434448"/>
                  </a:lnTo>
                  <a:lnTo>
                    <a:pt x="127" y="432623"/>
                  </a:lnTo>
                  <a:lnTo>
                    <a:pt x="128" y="430797"/>
                  </a:lnTo>
                  <a:lnTo>
                    <a:pt x="128" y="428972"/>
                  </a:lnTo>
                  <a:lnTo>
                    <a:pt x="129" y="427146"/>
                  </a:lnTo>
                  <a:lnTo>
                    <a:pt x="130" y="425321"/>
                  </a:lnTo>
                  <a:lnTo>
                    <a:pt x="130" y="423496"/>
                  </a:lnTo>
                  <a:lnTo>
                    <a:pt x="131" y="421670"/>
                  </a:lnTo>
                  <a:lnTo>
                    <a:pt x="132" y="419845"/>
                  </a:lnTo>
                  <a:lnTo>
                    <a:pt x="132" y="418019"/>
                  </a:lnTo>
                  <a:lnTo>
                    <a:pt x="133" y="416194"/>
                  </a:lnTo>
                  <a:lnTo>
                    <a:pt x="134" y="414369"/>
                  </a:lnTo>
                  <a:lnTo>
                    <a:pt x="134" y="412543"/>
                  </a:lnTo>
                  <a:lnTo>
                    <a:pt x="135" y="410718"/>
                  </a:lnTo>
                  <a:lnTo>
                    <a:pt x="136" y="408892"/>
                  </a:lnTo>
                  <a:lnTo>
                    <a:pt x="136" y="407067"/>
                  </a:lnTo>
                  <a:lnTo>
                    <a:pt x="137" y="405241"/>
                  </a:lnTo>
                  <a:lnTo>
                    <a:pt x="137" y="403416"/>
                  </a:lnTo>
                  <a:lnTo>
                    <a:pt x="138" y="401591"/>
                  </a:lnTo>
                  <a:lnTo>
                    <a:pt x="138" y="399765"/>
                  </a:lnTo>
                  <a:lnTo>
                    <a:pt x="139" y="397940"/>
                  </a:lnTo>
                  <a:lnTo>
                    <a:pt x="139" y="396114"/>
                  </a:lnTo>
                  <a:lnTo>
                    <a:pt x="140" y="394289"/>
                  </a:lnTo>
                  <a:lnTo>
                    <a:pt x="140" y="392464"/>
                  </a:lnTo>
                  <a:lnTo>
                    <a:pt x="141" y="390638"/>
                  </a:lnTo>
                  <a:lnTo>
                    <a:pt x="141" y="388813"/>
                  </a:lnTo>
                  <a:lnTo>
                    <a:pt x="142" y="386987"/>
                  </a:lnTo>
                  <a:lnTo>
                    <a:pt x="142" y="385162"/>
                  </a:lnTo>
                  <a:lnTo>
                    <a:pt x="142" y="383336"/>
                  </a:lnTo>
                  <a:lnTo>
                    <a:pt x="143" y="381511"/>
                  </a:lnTo>
                  <a:lnTo>
                    <a:pt x="143" y="379686"/>
                  </a:lnTo>
                  <a:lnTo>
                    <a:pt x="143" y="377860"/>
                  </a:lnTo>
                  <a:lnTo>
                    <a:pt x="143" y="376035"/>
                  </a:lnTo>
                  <a:lnTo>
                    <a:pt x="144" y="374209"/>
                  </a:lnTo>
                  <a:lnTo>
                    <a:pt x="144" y="372384"/>
                  </a:lnTo>
                  <a:lnTo>
                    <a:pt x="144" y="370559"/>
                  </a:lnTo>
                  <a:lnTo>
                    <a:pt x="144" y="368733"/>
                  </a:lnTo>
                  <a:lnTo>
                    <a:pt x="144" y="366908"/>
                  </a:lnTo>
                  <a:lnTo>
                    <a:pt x="145" y="365082"/>
                  </a:lnTo>
                  <a:lnTo>
                    <a:pt x="145" y="363257"/>
                  </a:lnTo>
                  <a:lnTo>
                    <a:pt x="145" y="361432"/>
                  </a:lnTo>
                  <a:lnTo>
                    <a:pt x="145" y="359606"/>
                  </a:lnTo>
                  <a:lnTo>
                    <a:pt x="145" y="357781"/>
                  </a:lnTo>
                  <a:lnTo>
                    <a:pt x="145" y="355955"/>
                  </a:lnTo>
                  <a:lnTo>
                    <a:pt x="145" y="354130"/>
                  </a:lnTo>
                  <a:lnTo>
                    <a:pt x="145" y="352304"/>
                  </a:lnTo>
                  <a:lnTo>
                    <a:pt x="145" y="350479"/>
                  </a:lnTo>
                  <a:lnTo>
                    <a:pt x="145" y="348654"/>
                  </a:lnTo>
                  <a:lnTo>
                    <a:pt x="144" y="346828"/>
                  </a:lnTo>
                  <a:lnTo>
                    <a:pt x="144" y="345003"/>
                  </a:lnTo>
                  <a:lnTo>
                    <a:pt x="144" y="343177"/>
                  </a:lnTo>
                  <a:lnTo>
                    <a:pt x="144" y="341352"/>
                  </a:lnTo>
                  <a:lnTo>
                    <a:pt x="144" y="339527"/>
                  </a:lnTo>
                  <a:lnTo>
                    <a:pt x="144" y="337701"/>
                  </a:lnTo>
                  <a:lnTo>
                    <a:pt x="143" y="335876"/>
                  </a:lnTo>
                  <a:lnTo>
                    <a:pt x="143" y="334050"/>
                  </a:lnTo>
                  <a:lnTo>
                    <a:pt x="143" y="332225"/>
                  </a:lnTo>
                  <a:lnTo>
                    <a:pt x="143" y="330399"/>
                  </a:lnTo>
                  <a:lnTo>
                    <a:pt x="142" y="328574"/>
                  </a:lnTo>
                  <a:lnTo>
                    <a:pt x="142" y="326749"/>
                  </a:lnTo>
                  <a:lnTo>
                    <a:pt x="142" y="324923"/>
                  </a:lnTo>
                  <a:lnTo>
                    <a:pt x="141" y="323098"/>
                  </a:lnTo>
                  <a:lnTo>
                    <a:pt x="141" y="321272"/>
                  </a:lnTo>
                  <a:lnTo>
                    <a:pt x="141" y="319447"/>
                  </a:lnTo>
                  <a:lnTo>
                    <a:pt x="140" y="317622"/>
                  </a:lnTo>
                  <a:lnTo>
                    <a:pt x="140" y="315796"/>
                  </a:lnTo>
                  <a:lnTo>
                    <a:pt x="140" y="313971"/>
                  </a:lnTo>
                  <a:lnTo>
                    <a:pt x="139" y="312145"/>
                  </a:lnTo>
                  <a:lnTo>
                    <a:pt x="139" y="310320"/>
                  </a:lnTo>
                  <a:lnTo>
                    <a:pt x="139" y="308495"/>
                  </a:lnTo>
                  <a:lnTo>
                    <a:pt x="138" y="306669"/>
                  </a:lnTo>
                  <a:lnTo>
                    <a:pt x="138" y="304844"/>
                  </a:lnTo>
                  <a:lnTo>
                    <a:pt x="137" y="303018"/>
                  </a:lnTo>
                  <a:lnTo>
                    <a:pt x="137" y="301193"/>
                  </a:lnTo>
                  <a:lnTo>
                    <a:pt x="137" y="299367"/>
                  </a:lnTo>
                  <a:lnTo>
                    <a:pt x="136" y="297542"/>
                  </a:lnTo>
                  <a:lnTo>
                    <a:pt x="136" y="295717"/>
                  </a:lnTo>
                  <a:lnTo>
                    <a:pt x="136" y="293891"/>
                  </a:lnTo>
                  <a:lnTo>
                    <a:pt x="135" y="292066"/>
                  </a:lnTo>
                  <a:lnTo>
                    <a:pt x="135" y="290240"/>
                  </a:lnTo>
                  <a:lnTo>
                    <a:pt x="135" y="288415"/>
                  </a:lnTo>
                  <a:lnTo>
                    <a:pt x="134" y="286590"/>
                  </a:lnTo>
                  <a:lnTo>
                    <a:pt x="134" y="284764"/>
                  </a:lnTo>
                  <a:lnTo>
                    <a:pt x="134" y="282939"/>
                  </a:lnTo>
                  <a:lnTo>
                    <a:pt x="133" y="281113"/>
                  </a:lnTo>
                  <a:lnTo>
                    <a:pt x="133" y="279288"/>
                  </a:lnTo>
                  <a:lnTo>
                    <a:pt x="133" y="277462"/>
                  </a:lnTo>
                  <a:lnTo>
                    <a:pt x="133" y="275637"/>
                  </a:lnTo>
                  <a:lnTo>
                    <a:pt x="133" y="273812"/>
                  </a:lnTo>
                  <a:lnTo>
                    <a:pt x="132" y="271986"/>
                  </a:lnTo>
                  <a:lnTo>
                    <a:pt x="132" y="270161"/>
                  </a:lnTo>
                  <a:lnTo>
                    <a:pt x="132" y="268335"/>
                  </a:lnTo>
                  <a:lnTo>
                    <a:pt x="132" y="266510"/>
                  </a:lnTo>
                  <a:lnTo>
                    <a:pt x="132" y="264685"/>
                  </a:lnTo>
                  <a:lnTo>
                    <a:pt x="132" y="262859"/>
                  </a:lnTo>
                  <a:lnTo>
                    <a:pt x="132" y="261034"/>
                  </a:lnTo>
                  <a:lnTo>
                    <a:pt x="132" y="259208"/>
                  </a:lnTo>
                  <a:lnTo>
                    <a:pt x="132" y="257383"/>
                  </a:lnTo>
                  <a:lnTo>
                    <a:pt x="132" y="255557"/>
                  </a:lnTo>
                  <a:lnTo>
                    <a:pt x="132" y="253732"/>
                  </a:lnTo>
                  <a:lnTo>
                    <a:pt x="132" y="251907"/>
                  </a:lnTo>
                  <a:lnTo>
                    <a:pt x="132" y="250081"/>
                  </a:lnTo>
                  <a:lnTo>
                    <a:pt x="132" y="248256"/>
                  </a:lnTo>
                  <a:lnTo>
                    <a:pt x="132" y="246430"/>
                  </a:lnTo>
                  <a:lnTo>
                    <a:pt x="132" y="244605"/>
                  </a:lnTo>
                  <a:lnTo>
                    <a:pt x="133" y="242780"/>
                  </a:lnTo>
                  <a:lnTo>
                    <a:pt x="133" y="240954"/>
                  </a:lnTo>
                  <a:lnTo>
                    <a:pt x="133" y="239129"/>
                  </a:lnTo>
                  <a:lnTo>
                    <a:pt x="133" y="237303"/>
                  </a:lnTo>
                  <a:lnTo>
                    <a:pt x="134" y="235478"/>
                  </a:lnTo>
                  <a:lnTo>
                    <a:pt x="134" y="233653"/>
                  </a:lnTo>
                  <a:lnTo>
                    <a:pt x="134" y="231827"/>
                  </a:lnTo>
                  <a:lnTo>
                    <a:pt x="135" y="230002"/>
                  </a:lnTo>
                  <a:lnTo>
                    <a:pt x="135" y="228176"/>
                  </a:lnTo>
                  <a:lnTo>
                    <a:pt x="136" y="226351"/>
                  </a:lnTo>
                  <a:lnTo>
                    <a:pt x="136" y="224525"/>
                  </a:lnTo>
                  <a:lnTo>
                    <a:pt x="137" y="222700"/>
                  </a:lnTo>
                  <a:lnTo>
                    <a:pt x="137" y="220875"/>
                  </a:lnTo>
                  <a:lnTo>
                    <a:pt x="138" y="219049"/>
                  </a:lnTo>
                  <a:lnTo>
                    <a:pt x="138" y="217224"/>
                  </a:lnTo>
                  <a:lnTo>
                    <a:pt x="139" y="215398"/>
                  </a:lnTo>
                  <a:lnTo>
                    <a:pt x="139" y="213573"/>
                  </a:lnTo>
                  <a:lnTo>
                    <a:pt x="140" y="211748"/>
                  </a:lnTo>
                  <a:lnTo>
                    <a:pt x="141" y="209922"/>
                  </a:lnTo>
                  <a:lnTo>
                    <a:pt x="141" y="208097"/>
                  </a:lnTo>
                  <a:lnTo>
                    <a:pt x="142" y="206271"/>
                  </a:lnTo>
                  <a:lnTo>
                    <a:pt x="143" y="204446"/>
                  </a:lnTo>
                  <a:lnTo>
                    <a:pt x="144" y="202620"/>
                  </a:lnTo>
                  <a:lnTo>
                    <a:pt x="144" y="200795"/>
                  </a:lnTo>
                  <a:lnTo>
                    <a:pt x="145" y="198970"/>
                  </a:lnTo>
                  <a:lnTo>
                    <a:pt x="146" y="197144"/>
                  </a:lnTo>
                  <a:lnTo>
                    <a:pt x="147" y="195319"/>
                  </a:lnTo>
                  <a:lnTo>
                    <a:pt x="147" y="193493"/>
                  </a:lnTo>
                  <a:lnTo>
                    <a:pt x="148" y="191668"/>
                  </a:lnTo>
                  <a:lnTo>
                    <a:pt x="149" y="189843"/>
                  </a:lnTo>
                  <a:lnTo>
                    <a:pt x="150" y="188017"/>
                  </a:lnTo>
                  <a:lnTo>
                    <a:pt x="151" y="186192"/>
                  </a:lnTo>
                  <a:lnTo>
                    <a:pt x="152" y="184366"/>
                  </a:lnTo>
                  <a:lnTo>
                    <a:pt x="152" y="182541"/>
                  </a:lnTo>
                  <a:lnTo>
                    <a:pt x="153" y="180716"/>
                  </a:lnTo>
                  <a:lnTo>
                    <a:pt x="154" y="178890"/>
                  </a:lnTo>
                  <a:lnTo>
                    <a:pt x="155" y="177065"/>
                  </a:lnTo>
                  <a:lnTo>
                    <a:pt x="156" y="175239"/>
                  </a:lnTo>
                  <a:lnTo>
                    <a:pt x="157" y="173414"/>
                  </a:lnTo>
                  <a:lnTo>
                    <a:pt x="158" y="171588"/>
                  </a:lnTo>
                  <a:lnTo>
                    <a:pt x="159" y="169763"/>
                  </a:lnTo>
                  <a:lnTo>
                    <a:pt x="160" y="167938"/>
                  </a:lnTo>
                  <a:lnTo>
                    <a:pt x="161" y="166112"/>
                  </a:lnTo>
                  <a:lnTo>
                    <a:pt x="161" y="164287"/>
                  </a:lnTo>
                  <a:lnTo>
                    <a:pt x="162" y="162461"/>
                  </a:lnTo>
                  <a:lnTo>
                    <a:pt x="163" y="160636"/>
                  </a:lnTo>
                  <a:lnTo>
                    <a:pt x="164" y="158811"/>
                  </a:lnTo>
                  <a:lnTo>
                    <a:pt x="165" y="156985"/>
                  </a:lnTo>
                  <a:lnTo>
                    <a:pt x="166" y="155160"/>
                  </a:lnTo>
                  <a:lnTo>
                    <a:pt x="167" y="153334"/>
                  </a:lnTo>
                  <a:lnTo>
                    <a:pt x="168" y="151509"/>
                  </a:lnTo>
                  <a:lnTo>
                    <a:pt x="169" y="149683"/>
                  </a:lnTo>
                  <a:lnTo>
                    <a:pt x="169" y="147858"/>
                  </a:lnTo>
                  <a:lnTo>
                    <a:pt x="170" y="146033"/>
                  </a:lnTo>
                  <a:lnTo>
                    <a:pt x="171" y="144207"/>
                  </a:lnTo>
                  <a:lnTo>
                    <a:pt x="172" y="142382"/>
                  </a:lnTo>
                  <a:lnTo>
                    <a:pt x="173" y="140556"/>
                  </a:lnTo>
                  <a:lnTo>
                    <a:pt x="174" y="138731"/>
                  </a:lnTo>
                  <a:lnTo>
                    <a:pt x="174" y="136906"/>
                  </a:lnTo>
                  <a:lnTo>
                    <a:pt x="175" y="135080"/>
                  </a:lnTo>
                  <a:lnTo>
                    <a:pt x="176" y="133255"/>
                  </a:lnTo>
                  <a:lnTo>
                    <a:pt x="177" y="131429"/>
                  </a:lnTo>
                  <a:lnTo>
                    <a:pt x="177" y="129604"/>
                  </a:lnTo>
                  <a:lnTo>
                    <a:pt x="178" y="127778"/>
                  </a:lnTo>
                  <a:lnTo>
                    <a:pt x="179" y="125953"/>
                  </a:lnTo>
                  <a:lnTo>
                    <a:pt x="180" y="124128"/>
                  </a:lnTo>
                  <a:lnTo>
                    <a:pt x="180" y="122302"/>
                  </a:lnTo>
                  <a:lnTo>
                    <a:pt x="181" y="120477"/>
                  </a:lnTo>
                  <a:lnTo>
                    <a:pt x="182" y="118651"/>
                  </a:lnTo>
                  <a:lnTo>
                    <a:pt x="182" y="116826"/>
                  </a:lnTo>
                  <a:lnTo>
                    <a:pt x="183" y="115001"/>
                  </a:lnTo>
                  <a:lnTo>
                    <a:pt x="184" y="113175"/>
                  </a:lnTo>
                  <a:lnTo>
                    <a:pt x="184" y="111350"/>
                  </a:lnTo>
                  <a:lnTo>
                    <a:pt x="185" y="109524"/>
                  </a:lnTo>
                  <a:lnTo>
                    <a:pt x="186" y="107699"/>
                  </a:lnTo>
                  <a:lnTo>
                    <a:pt x="186" y="105874"/>
                  </a:lnTo>
                  <a:lnTo>
                    <a:pt x="187" y="104048"/>
                  </a:lnTo>
                  <a:lnTo>
                    <a:pt x="187" y="102223"/>
                  </a:lnTo>
                  <a:lnTo>
                    <a:pt x="188" y="100397"/>
                  </a:lnTo>
                  <a:lnTo>
                    <a:pt x="188" y="98572"/>
                  </a:lnTo>
                  <a:lnTo>
                    <a:pt x="189" y="96746"/>
                  </a:lnTo>
                  <a:lnTo>
                    <a:pt x="189" y="94921"/>
                  </a:lnTo>
                  <a:lnTo>
                    <a:pt x="190" y="93096"/>
                  </a:lnTo>
                  <a:lnTo>
                    <a:pt x="190" y="91270"/>
                  </a:lnTo>
                  <a:lnTo>
                    <a:pt x="191" y="89445"/>
                  </a:lnTo>
                  <a:lnTo>
                    <a:pt x="191" y="87619"/>
                  </a:lnTo>
                  <a:lnTo>
                    <a:pt x="192" y="85794"/>
                  </a:lnTo>
                  <a:lnTo>
                    <a:pt x="192" y="83969"/>
                  </a:lnTo>
                  <a:lnTo>
                    <a:pt x="192" y="82143"/>
                  </a:lnTo>
                  <a:lnTo>
                    <a:pt x="193" y="80318"/>
                  </a:lnTo>
                  <a:lnTo>
                    <a:pt x="193" y="78492"/>
                  </a:lnTo>
                  <a:lnTo>
                    <a:pt x="193" y="76667"/>
                  </a:lnTo>
                  <a:lnTo>
                    <a:pt x="194" y="74841"/>
                  </a:lnTo>
                  <a:lnTo>
                    <a:pt x="194" y="73016"/>
                  </a:lnTo>
                  <a:lnTo>
                    <a:pt x="195" y="71191"/>
                  </a:lnTo>
                  <a:lnTo>
                    <a:pt x="195" y="69365"/>
                  </a:lnTo>
                  <a:lnTo>
                    <a:pt x="195" y="67540"/>
                  </a:lnTo>
                  <a:lnTo>
                    <a:pt x="195" y="65714"/>
                  </a:lnTo>
                  <a:lnTo>
                    <a:pt x="196" y="63889"/>
                  </a:lnTo>
                  <a:lnTo>
                    <a:pt x="196" y="62064"/>
                  </a:lnTo>
                  <a:lnTo>
                    <a:pt x="196" y="60238"/>
                  </a:lnTo>
                  <a:lnTo>
                    <a:pt x="196" y="58413"/>
                  </a:lnTo>
                  <a:lnTo>
                    <a:pt x="197" y="56587"/>
                  </a:lnTo>
                  <a:lnTo>
                    <a:pt x="197" y="54762"/>
                  </a:lnTo>
                  <a:lnTo>
                    <a:pt x="197" y="52937"/>
                  </a:lnTo>
                  <a:lnTo>
                    <a:pt x="197" y="51111"/>
                  </a:lnTo>
                  <a:lnTo>
                    <a:pt x="198" y="49286"/>
                  </a:lnTo>
                  <a:lnTo>
                    <a:pt x="198" y="47460"/>
                  </a:lnTo>
                  <a:lnTo>
                    <a:pt x="198" y="45635"/>
                  </a:lnTo>
                  <a:lnTo>
                    <a:pt x="198" y="43809"/>
                  </a:lnTo>
                  <a:lnTo>
                    <a:pt x="198" y="41984"/>
                  </a:lnTo>
                  <a:lnTo>
                    <a:pt x="198" y="40159"/>
                  </a:lnTo>
                  <a:lnTo>
                    <a:pt x="199" y="38333"/>
                  </a:lnTo>
                  <a:lnTo>
                    <a:pt x="199" y="36508"/>
                  </a:lnTo>
                  <a:lnTo>
                    <a:pt x="199" y="34682"/>
                  </a:lnTo>
                  <a:lnTo>
                    <a:pt x="199" y="32857"/>
                  </a:lnTo>
                  <a:lnTo>
                    <a:pt x="199" y="31032"/>
                  </a:lnTo>
                  <a:lnTo>
                    <a:pt x="199" y="29206"/>
                  </a:lnTo>
                  <a:lnTo>
                    <a:pt x="199" y="27381"/>
                  </a:lnTo>
                  <a:lnTo>
                    <a:pt x="199" y="25555"/>
                  </a:lnTo>
                  <a:lnTo>
                    <a:pt x="200" y="23730"/>
                  </a:lnTo>
                  <a:lnTo>
                    <a:pt x="200" y="21904"/>
                  </a:lnTo>
                  <a:lnTo>
                    <a:pt x="200" y="20079"/>
                  </a:lnTo>
                  <a:lnTo>
                    <a:pt x="200" y="18254"/>
                  </a:lnTo>
                  <a:lnTo>
                    <a:pt x="200" y="16428"/>
                  </a:lnTo>
                  <a:lnTo>
                    <a:pt x="200" y="14603"/>
                  </a:lnTo>
                  <a:lnTo>
                    <a:pt x="200" y="12777"/>
                  </a:lnTo>
                  <a:lnTo>
                    <a:pt x="200" y="10952"/>
                  </a:lnTo>
                  <a:lnTo>
                    <a:pt x="200" y="9127"/>
                  </a:lnTo>
                  <a:lnTo>
                    <a:pt x="200" y="7301"/>
                  </a:lnTo>
                  <a:lnTo>
                    <a:pt x="200" y="5476"/>
                  </a:lnTo>
                  <a:lnTo>
                    <a:pt x="200" y="3650"/>
                  </a:lnTo>
                  <a:lnTo>
                    <a:pt x="200" y="1825"/>
                  </a:lnTo>
                  <a:lnTo>
                    <a:pt x="201" y="0"/>
                  </a:lnTo>
                  <a:lnTo>
                    <a:pt x="201" y="0"/>
                  </a:lnTo>
                  <a:lnTo>
                    <a:pt x="201" y="932786"/>
                  </a:lnTo>
                  <a:lnTo>
                    <a:pt x="201" y="932786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39" name="pl21"/>
            <p:cNvSpPr/>
            <p:nvPr/>
          </p:nvSpPr>
          <p:spPr>
            <a:xfrm>
              <a:off x="2813881" y="3554319"/>
              <a:ext cx="714" cy="311119"/>
            </a:xfrm>
            <a:custGeom>
              <a:avLst/>
              <a:gdLst/>
              <a:ahLst/>
              <a:cxnLst/>
              <a:rect l="0" t="0" r="0" b="0"/>
              <a:pathLst>
                <a:path w="714" h="311119">
                  <a:moveTo>
                    <a:pt x="0" y="0"/>
                  </a:moveTo>
                  <a:lnTo>
                    <a:pt x="2" y="0"/>
                  </a:lnTo>
                  <a:lnTo>
                    <a:pt x="3" y="608"/>
                  </a:lnTo>
                  <a:lnTo>
                    <a:pt x="3" y="1217"/>
                  </a:lnTo>
                  <a:lnTo>
                    <a:pt x="3" y="1826"/>
                  </a:lnTo>
                  <a:lnTo>
                    <a:pt x="3" y="2435"/>
                  </a:lnTo>
                  <a:lnTo>
                    <a:pt x="4" y="3044"/>
                  </a:lnTo>
                  <a:lnTo>
                    <a:pt x="4" y="3653"/>
                  </a:lnTo>
                  <a:lnTo>
                    <a:pt x="5" y="4261"/>
                  </a:lnTo>
                  <a:lnTo>
                    <a:pt x="5" y="4870"/>
                  </a:lnTo>
                  <a:lnTo>
                    <a:pt x="5" y="5479"/>
                  </a:lnTo>
                  <a:lnTo>
                    <a:pt x="6" y="6088"/>
                  </a:lnTo>
                  <a:lnTo>
                    <a:pt x="6" y="6697"/>
                  </a:lnTo>
                  <a:lnTo>
                    <a:pt x="7" y="7306"/>
                  </a:lnTo>
                  <a:lnTo>
                    <a:pt x="7" y="7914"/>
                  </a:lnTo>
                  <a:lnTo>
                    <a:pt x="8" y="8523"/>
                  </a:lnTo>
                  <a:lnTo>
                    <a:pt x="9" y="9132"/>
                  </a:lnTo>
                  <a:lnTo>
                    <a:pt x="9" y="9741"/>
                  </a:lnTo>
                  <a:lnTo>
                    <a:pt x="10" y="10350"/>
                  </a:lnTo>
                  <a:lnTo>
                    <a:pt x="11" y="10959"/>
                  </a:lnTo>
                  <a:lnTo>
                    <a:pt x="12" y="11568"/>
                  </a:lnTo>
                  <a:lnTo>
                    <a:pt x="13" y="12176"/>
                  </a:lnTo>
                  <a:lnTo>
                    <a:pt x="13" y="12785"/>
                  </a:lnTo>
                  <a:lnTo>
                    <a:pt x="14" y="13394"/>
                  </a:lnTo>
                  <a:lnTo>
                    <a:pt x="15" y="14003"/>
                  </a:lnTo>
                  <a:lnTo>
                    <a:pt x="16" y="14612"/>
                  </a:lnTo>
                  <a:lnTo>
                    <a:pt x="18" y="15221"/>
                  </a:lnTo>
                  <a:lnTo>
                    <a:pt x="19" y="15829"/>
                  </a:lnTo>
                  <a:lnTo>
                    <a:pt x="20" y="16438"/>
                  </a:lnTo>
                  <a:lnTo>
                    <a:pt x="21" y="17047"/>
                  </a:lnTo>
                  <a:lnTo>
                    <a:pt x="23" y="17656"/>
                  </a:lnTo>
                  <a:lnTo>
                    <a:pt x="24" y="18265"/>
                  </a:lnTo>
                  <a:lnTo>
                    <a:pt x="26" y="18874"/>
                  </a:lnTo>
                  <a:lnTo>
                    <a:pt x="27" y="19483"/>
                  </a:lnTo>
                  <a:lnTo>
                    <a:pt x="29" y="20091"/>
                  </a:lnTo>
                  <a:lnTo>
                    <a:pt x="31" y="20700"/>
                  </a:lnTo>
                  <a:lnTo>
                    <a:pt x="33" y="21309"/>
                  </a:lnTo>
                  <a:lnTo>
                    <a:pt x="34" y="21918"/>
                  </a:lnTo>
                  <a:lnTo>
                    <a:pt x="36" y="22527"/>
                  </a:lnTo>
                  <a:lnTo>
                    <a:pt x="38" y="23136"/>
                  </a:lnTo>
                  <a:lnTo>
                    <a:pt x="41" y="23744"/>
                  </a:lnTo>
                  <a:lnTo>
                    <a:pt x="43" y="24353"/>
                  </a:lnTo>
                  <a:lnTo>
                    <a:pt x="45" y="24962"/>
                  </a:lnTo>
                  <a:lnTo>
                    <a:pt x="48" y="25571"/>
                  </a:lnTo>
                  <a:lnTo>
                    <a:pt x="50" y="26180"/>
                  </a:lnTo>
                  <a:lnTo>
                    <a:pt x="53" y="26789"/>
                  </a:lnTo>
                  <a:lnTo>
                    <a:pt x="55" y="27397"/>
                  </a:lnTo>
                  <a:lnTo>
                    <a:pt x="58" y="28006"/>
                  </a:lnTo>
                  <a:lnTo>
                    <a:pt x="61" y="28615"/>
                  </a:lnTo>
                  <a:lnTo>
                    <a:pt x="64" y="29224"/>
                  </a:lnTo>
                  <a:lnTo>
                    <a:pt x="67" y="29833"/>
                  </a:lnTo>
                  <a:lnTo>
                    <a:pt x="70" y="30442"/>
                  </a:lnTo>
                  <a:lnTo>
                    <a:pt x="73" y="31051"/>
                  </a:lnTo>
                  <a:lnTo>
                    <a:pt x="76" y="31659"/>
                  </a:lnTo>
                  <a:lnTo>
                    <a:pt x="80" y="32268"/>
                  </a:lnTo>
                  <a:lnTo>
                    <a:pt x="83" y="32877"/>
                  </a:lnTo>
                  <a:lnTo>
                    <a:pt x="87" y="33486"/>
                  </a:lnTo>
                  <a:lnTo>
                    <a:pt x="90" y="34095"/>
                  </a:lnTo>
                  <a:lnTo>
                    <a:pt x="94" y="34704"/>
                  </a:lnTo>
                  <a:lnTo>
                    <a:pt x="98" y="35312"/>
                  </a:lnTo>
                  <a:lnTo>
                    <a:pt x="101" y="35921"/>
                  </a:lnTo>
                  <a:lnTo>
                    <a:pt x="105" y="36530"/>
                  </a:lnTo>
                  <a:lnTo>
                    <a:pt x="109" y="37139"/>
                  </a:lnTo>
                  <a:lnTo>
                    <a:pt x="113" y="37748"/>
                  </a:lnTo>
                  <a:lnTo>
                    <a:pt x="117" y="38357"/>
                  </a:lnTo>
                  <a:lnTo>
                    <a:pt x="121" y="38966"/>
                  </a:lnTo>
                  <a:lnTo>
                    <a:pt x="126" y="39574"/>
                  </a:lnTo>
                  <a:lnTo>
                    <a:pt x="130" y="40183"/>
                  </a:lnTo>
                  <a:lnTo>
                    <a:pt x="134" y="40792"/>
                  </a:lnTo>
                  <a:lnTo>
                    <a:pt x="138" y="41401"/>
                  </a:lnTo>
                  <a:lnTo>
                    <a:pt x="143" y="42010"/>
                  </a:lnTo>
                  <a:lnTo>
                    <a:pt x="147" y="42619"/>
                  </a:lnTo>
                  <a:lnTo>
                    <a:pt x="151" y="43227"/>
                  </a:lnTo>
                  <a:lnTo>
                    <a:pt x="155" y="43836"/>
                  </a:lnTo>
                  <a:lnTo>
                    <a:pt x="160" y="44445"/>
                  </a:lnTo>
                  <a:lnTo>
                    <a:pt x="164" y="45054"/>
                  </a:lnTo>
                  <a:lnTo>
                    <a:pt x="168" y="45663"/>
                  </a:lnTo>
                  <a:lnTo>
                    <a:pt x="173" y="46272"/>
                  </a:lnTo>
                  <a:lnTo>
                    <a:pt x="177" y="46881"/>
                  </a:lnTo>
                  <a:lnTo>
                    <a:pt x="181" y="47489"/>
                  </a:lnTo>
                  <a:lnTo>
                    <a:pt x="185" y="48098"/>
                  </a:lnTo>
                  <a:lnTo>
                    <a:pt x="189" y="48707"/>
                  </a:lnTo>
                  <a:lnTo>
                    <a:pt x="193" y="49316"/>
                  </a:lnTo>
                  <a:lnTo>
                    <a:pt x="197" y="49925"/>
                  </a:lnTo>
                  <a:lnTo>
                    <a:pt x="201" y="50534"/>
                  </a:lnTo>
                  <a:lnTo>
                    <a:pt x="205" y="51142"/>
                  </a:lnTo>
                  <a:lnTo>
                    <a:pt x="209" y="51751"/>
                  </a:lnTo>
                  <a:lnTo>
                    <a:pt x="213" y="52360"/>
                  </a:lnTo>
                  <a:lnTo>
                    <a:pt x="216" y="52969"/>
                  </a:lnTo>
                  <a:lnTo>
                    <a:pt x="219" y="53578"/>
                  </a:lnTo>
                  <a:lnTo>
                    <a:pt x="223" y="54187"/>
                  </a:lnTo>
                  <a:lnTo>
                    <a:pt x="226" y="54795"/>
                  </a:lnTo>
                  <a:lnTo>
                    <a:pt x="229" y="55404"/>
                  </a:lnTo>
                  <a:lnTo>
                    <a:pt x="232" y="56013"/>
                  </a:lnTo>
                  <a:lnTo>
                    <a:pt x="235" y="56622"/>
                  </a:lnTo>
                  <a:lnTo>
                    <a:pt x="237" y="57231"/>
                  </a:lnTo>
                  <a:lnTo>
                    <a:pt x="240" y="57840"/>
                  </a:lnTo>
                  <a:lnTo>
                    <a:pt x="242" y="58449"/>
                  </a:lnTo>
                  <a:lnTo>
                    <a:pt x="244" y="59057"/>
                  </a:lnTo>
                  <a:lnTo>
                    <a:pt x="246" y="59666"/>
                  </a:lnTo>
                  <a:lnTo>
                    <a:pt x="248" y="60275"/>
                  </a:lnTo>
                  <a:lnTo>
                    <a:pt x="250" y="60884"/>
                  </a:lnTo>
                  <a:lnTo>
                    <a:pt x="251" y="61493"/>
                  </a:lnTo>
                  <a:lnTo>
                    <a:pt x="252" y="62102"/>
                  </a:lnTo>
                  <a:lnTo>
                    <a:pt x="253" y="62710"/>
                  </a:lnTo>
                  <a:lnTo>
                    <a:pt x="254" y="63319"/>
                  </a:lnTo>
                  <a:lnTo>
                    <a:pt x="255" y="63928"/>
                  </a:lnTo>
                  <a:lnTo>
                    <a:pt x="255" y="64537"/>
                  </a:lnTo>
                  <a:lnTo>
                    <a:pt x="256" y="65146"/>
                  </a:lnTo>
                  <a:lnTo>
                    <a:pt x="256" y="65755"/>
                  </a:lnTo>
                  <a:lnTo>
                    <a:pt x="256" y="66364"/>
                  </a:lnTo>
                  <a:lnTo>
                    <a:pt x="255" y="66972"/>
                  </a:lnTo>
                  <a:lnTo>
                    <a:pt x="255" y="67581"/>
                  </a:lnTo>
                  <a:lnTo>
                    <a:pt x="254" y="68190"/>
                  </a:lnTo>
                  <a:lnTo>
                    <a:pt x="253" y="68799"/>
                  </a:lnTo>
                  <a:lnTo>
                    <a:pt x="252" y="69408"/>
                  </a:lnTo>
                  <a:lnTo>
                    <a:pt x="251" y="70017"/>
                  </a:lnTo>
                  <a:lnTo>
                    <a:pt x="249" y="70625"/>
                  </a:lnTo>
                  <a:lnTo>
                    <a:pt x="248" y="71234"/>
                  </a:lnTo>
                  <a:lnTo>
                    <a:pt x="246" y="71843"/>
                  </a:lnTo>
                  <a:lnTo>
                    <a:pt x="244" y="72452"/>
                  </a:lnTo>
                  <a:lnTo>
                    <a:pt x="242" y="73061"/>
                  </a:lnTo>
                  <a:lnTo>
                    <a:pt x="239" y="73670"/>
                  </a:lnTo>
                  <a:lnTo>
                    <a:pt x="237" y="74279"/>
                  </a:lnTo>
                  <a:lnTo>
                    <a:pt x="234" y="74887"/>
                  </a:lnTo>
                  <a:lnTo>
                    <a:pt x="231" y="75496"/>
                  </a:lnTo>
                  <a:lnTo>
                    <a:pt x="228" y="76105"/>
                  </a:lnTo>
                  <a:lnTo>
                    <a:pt x="225" y="76714"/>
                  </a:lnTo>
                  <a:lnTo>
                    <a:pt x="222" y="77323"/>
                  </a:lnTo>
                  <a:lnTo>
                    <a:pt x="219" y="77932"/>
                  </a:lnTo>
                  <a:lnTo>
                    <a:pt x="215" y="78540"/>
                  </a:lnTo>
                  <a:lnTo>
                    <a:pt x="212" y="79149"/>
                  </a:lnTo>
                  <a:lnTo>
                    <a:pt x="208" y="79758"/>
                  </a:lnTo>
                  <a:lnTo>
                    <a:pt x="204" y="80367"/>
                  </a:lnTo>
                  <a:lnTo>
                    <a:pt x="200" y="80976"/>
                  </a:lnTo>
                  <a:lnTo>
                    <a:pt x="196" y="81585"/>
                  </a:lnTo>
                  <a:lnTo>
                    <a:pt x="192" y="82193"/>
                  </a:lnTo>
                  <a:lnTo>
                    <a:pt x="188" y="82802"/>
                  </a:lnTo>
                  <a:lnTo>
                    <a:pt x="184" y="83411"/>
                  </a:lnTo>
                  <a:lnTo>
                    <a:pt x="180" y="84020"/>
                  </a:lnTo>
                  <a:lnTo>
                    <a:pt x="176" y="84629"/>
                  </a:lnTo>
                  <a:lnTo>
                    <a:pt x="172" y="85238"/>
                  </a:lnTo>
                  <a:lnTo>
                    <a:pt x="167" y="85847"/>
                  </a:lnTo>
                  <a:lnTo>
                    <a:pt x="163" y="86455"/>
                  </a:lnTo>
                  <a:lnTo>
                    <a:pt x="159" y="87064"/>
                  </a:lnTo>
                  <a:lnTo>
                    <a:pt x="154" y="87673"/>
                  </a:lnTo>
                  <a:lnTo>
                    <a:pt x="150" y="88282"/>
                  </a:lnTo>
                  <a:lnTo>
                    <a:pt x="146" y="88891"/>
                  </a:lnTo>
                  <a:lnTo>
                    <a:pt x="141" y="89500"/>
                  </a:lnTo>
                  <a:lnTo>
                    <a:pt x="137" y="90108"/>
                  </a:lnTo>
                  <a:lnTo>
                    <a:pt x="133" y="90717"/>
                  </a:lnTo>
                  <a:lnTo>
                    <a:pt x="129" y="91326"/>
                  </a:lnTo>
                  <a:lnTo>
                    <a:pt x="125" y="91935"/>
                  </a:lnTo>
                  <a:lnTo>
                    <a:pt x="120" y="92544"/>
                  </a:lnTo>
                  <a:lnTo>
                    <a:pt x="116" y="93153"/>
                  </a:lnTo>
                  <a:lnTo>
                    <a:pt x="112" y="93762"/>
                  </a:lnTo>
                  <a:lnTo>
                    <a:pt x="108" y="94370"/>
                  </a:lnTo>
                  <a:lnTo>
                    <a:pt x="104" y="94979"/>
                  </a:lnTo>
                  <a:lnTo>
                    <a:pt x="101" y="95588"/>
                  </a:lnTo>
                  <a:lnTo>
                    <a:pt x="97" y="96197"/>
                  </a:lnTo>
                  <a:lnTo>
                    <a:pt x="93" y="96806"/>
                  </a:lnTo>
                  <a:lnTo>
                    <a:pt x="90" y="97415"/>
                  </a:lnTo>
                  <a:lnTo>
                    <a:pt x="86" y="98023"/>
                  </a:lnTo>
                  <a:lnTo>
                    <a:pt x="83" y="98632"/>
                  </a:lnTo>
                  <a:lnTo>
                    <a:pt x="79" y="99241"/>
                  </a:lnTo>
                  <a:lnTo>
                    <a:pt x="76" y="99850"/>
                  </a:lnTo>
                  <a:lnTo>
                    <a:pt x="73" y="100459"/>
                  </a:lnTo>
                  <a:lnTo>
                    <a:pt x="69" y="101068"/>
                  </a:lnTo>
                  <a:lnTo>
                    <a:pt x="66" y="101676"/>
                  </a:lnTo>
                  <a:lnTo>
                    <a:pt x="64" y="102285"/>
                  </a:lnTo>
                  <a:lnTo>
                    <a:pt x="61" y="102894"/>
                  </a:lnTo>
                  <a:lnTo>
                    <a:pt x="58" y="103503"/>
                  </a:lnTo>
                  <a:lnTo>
                    <a:pt x="55" y="104112"/>
                  </a:lnTo>
                  <a:lnTo>
                    <a:pt x="53" y="104721"/>
                  </a:lnTo>
                  <a:lnTo>
                    <a:pt x="50" y="105330"/>
                  </a:lnTo>
                  <a:lnTo>
                    <a:pt x="48" y="105938"/>
                  </a:lnTo>
                  <a:lnTo>
                    <a:pt x="46" y="106547"/>
                  </a:lnTo>
                  <a:lnTo>
                    <a:pt x="43" y="107156"/>
                  </a:lnTo>
                  <a:lnTo>
                    <a:pt x="41" y="107765"/>
                  </a:lnTo>
                  <a:lnTo>
                    <a:pt x="39" y="108374"/>
                  </a:lnTo>
                  <a:lnTo>
                    <a:pt x="37" y="108983"/>
                  </a:lnTo>
                  <a:lnTo>
                    <a:pt x="35" y="109591"/>
                  </a:lnTo>
                  <a:lnTo>
                    <a:pt x="34" y="110200"/>
                  </a:lnTo>
                  <a:lnTo>
                    <a:pt x="32" y="110809"/>
                  </a:lnTo>
                  <a:lnTo>
                    <a:pt x="31" y="111418"/>
                  </a:lnTo>
                  <a:lnTo>
                    <a:pt x="29" y="112027"/>
                  </a:lnTo>
                  <a:lnTo>
                    <a:pt x="28" y="112636"/>
                  </a:lnTo>
                  <a:lnTo>
                    <a:pt x="26" y="113245"/>
                  </a:lnTo>
                  <a:lnTo>
                    <a:pt x="25" y="113853"/>
                  </a:lnTo>
                  <a:lnTo>
                    <a:pt x="24" y="114462"/>
                  </a:lnTo>
                  <a:lnTo>
                    <a:pt x="23" y="115071"/>
                  </a:lnTo>
                  <a:lnTo>
                    <a:pt x="22" y="115680"/>
                  </a:lnTo>
                  <a:lnTo>
                    <a:pt x="21" y="116289"/>
                  </a:lnTo>
                  <a:lnTo>
                    <a:pt x="20" y="116898"/>
                  </a:lnTo>
                  <a:lnTo>
                    <a:pt x="20" y="117506"/>
                  </a:lnTo>
                  <a:lnTo>
                    <a:pt x="19" y="118115"/>
                  </a:lnTo>
                  <a:lnTo>
                    <a:pt x="19" y="118724"/>
                  </a:lnTo>
                  <a:lnTo>
                    <a:pt x="18" y="119333"/>
                  </a:lnTo>
                  <a:lnTo>
                    <a:pt x="18" y="119942"/>
                  </a:lnTo>
                  <a:lnTo>
                    <a:pt x="17" y="120551"/>
                  </a:lnTo>
                  <a:lnTo>
                    <a:pt x="17" y="121160"/>
                  </a:lnTo>
                  <a:lnTo>
                    <a:pt x="17" y="121768"/>
                  </a:lnTo>
                  <a:lnTo>
                    <a:pt x="17" y="122377"/>
                  </a:lnTo>
                  <a:lnTo>
                    <a:pt x="17" y="122986"/>
                  </a:lnTo>
                  <a:lnTo>
                    <a:pt x="17" y="123595"/>
                  </a:lnTo>
                  <a:lnTo>
                    <a:pt x="17" y="124204"/>
                  </a:lnTo>
                  <a:lnTo>
                    <a:pt x="17" y="124813"/>
                  </a:lnTo>
                  <a:lnTo>
                    <a:pt x="18" y="125421"/>
                  </a:lnTo>
                  <a:lnTo>
                    <a:pt x="18" y="126030"/>
                  </a:lnTo>
                  <a:lnTo>
                    <a:pt x="19" y="126639"/>
                  </a:lnTo>
                  <a:lnTo>
                    <a:pt x="19" y="127248"/>
                  </a:lnTo>
                  <a:lnTo>
                    <a:pt x="20" y="127857"/>
                  </a:lnTo>
                  <a:lnTo>
                    <a:pt x="21" y="128466"/>
                  </a:lnTo>
                  <a:lnTo>
                    <a:pt x="21" y="129074"/>
                  </a:lnTo>
                  <a:lnTo>
                    <a:pt x="22" y="129683"/>
                  </a:lnTo>
                  <a:lnTo>
                    <a:pt x="23" y="130292"/>
                  </a:lnTo>
                  <a:lnTo>
                    <a:pt x="24" y="130901"/>
                  </a:lnTo>
                  <a:lnTo>
                    <a:pt x="25" y="131510"/>
                  </a:lnTo>
                  <a:lnTo>
                    <a:pt x="27" y="132119"/>
                  </a:lnTo>
                  <a:lnTo>
                    <a:pt x="28" y="132728"/>
                  </a:lnTo>
                  <a:lnTo>
                    <a:pt x="29" y="133336"/>
                  </a:lnTo>
                  <a:lnTo>
                    <a:pt x="31" y="133945"/>
                  </a:lnTo>
                  <a:lnTo>
                    <a:pt x="32" y="134554"/>
                  </a:lnTo>
                  <a:lnTo>
                    <a:pt x="34" y="135163"/>
                  </a:lnTo>
                  <a:lnTo>
                    <a:pt x="36" y="135772"/>
                  </a:lnTo>
                  <a:lnTo>
                    <a:pt x="38" y="136381"/>
                  </a:lnTo>
                  <a:lnTo>
                    <a:pt x="40" y="136989"/>
                  </a:lnTo>
                  <a:lnTo>
                    <a:pt x="42" y="137598"/>
                  </a:lnTo>
                  <a:lnTo>
                    <a:pt x="44" y="138207"/>
                  </a:lnTo>
                  <a:lnTo>
                    <a:pt x="46" y="138816"/>
                  </a:lnTo>
                  <a:lnTo>
                    <a:pt x="48" y="139425"/>
                  </a:lnTo>
                  <a:lnTo>
                    <a:pt x="51" y="140034"/>
                  </a:lnTo>
                  <a:lnTo>
                    <a:pt x="53" y="140643"/>
                  </a:lnTo>
                  <a:lnTo>
                    <a:pt x="56" y="141251"/>
                  </a:lnTo>
                  <a:lnTo>
                    <a:pt x="59" y="141860"/>
                  </a:lnTo>
                  <a:lnTo>
                    <a:pt x="61" y="142469"/>
                  </a:lnTo>
                  <a:lnTo>
                    <a:pt x="64" y="143078"/>
                  </a:lnTo>
                  <a:lnTo>
                    <a:pt x="67" y="143687"/>
                  </a:lnTo>
                  <a:lnTo>
                    <a:pt x="71" y="144296"/>
                  </a:lnTo>
                  <a:lnTo>
                    <a:pt x="74" y="144904"/>
                  </a:lnTo>
                  <a:lnTo>
                    <a:pt x="77" y="145513"/>
                  </a:lnTo>
                  <a:lnTo>
                    <a:pt x="80" y="146122"/>
                  </a:lnTo>
                  <a:lnTo>
                    <a:pt x="84" y="146731"/>
                  </a:lnTo>
                  <a:lnTo>
                    <a:pt x="87" y="147340"/>
                  </a:lnTo>
                  <a:lnTo>
                    <a:pt x="91" y="147949"/>
                  </a:lnTo>
                  <a:lnTo>
                    <a:pt x="95" y="148558"/>
                  </a:lnTo>
                  <a:lnTo>
                    <a:pt x="99" y="149166"/>
                  </a:lnTo>
                  <a:lnTo>
                    <a:pt x="103" y="149775"/>
                  </a:lnTo>
                  <a:lnTo>
                    <a:pt x="107" y="150384"/>
                  </a:lnTo>
                  <a:lnTo>
                    <a:pt x="111" y="150993"/>
                  </a:lnTo>
                  <a:lnTo>
                    <a:pt x="115" y="151602"/>
                  </a:lnTo>
                  <a:lnTo>
                    <a:pt x="119" y="152211"/>
                  </a:lnTo>
                  <a:lnTo>
                    <a:pt x="123" y="152819"/>
                  </a:lnTo>
                  <a:lnTo>
                    <a:pt x="128" y="153428"/>
                  </a:lnTo>
                  <a:lnTo>
                    <a:pt x="132" y="154037"/>
                  </a:lnTo>
                  <a:lnTo>
                    <a:pt x="137" y="154646"/>
                  </a:lnTo>
                  <a:lnTo>
                    <a:pt x="141" y="155255"/>
                  </a:lnTo>
                  <a:lnTo>
                    <a:pt x="146" y="155864"/>
                  </a:lnTo>
                  <a:lnTo>
                    <a:pt x="151" y="156472"/>
                  </a:lnTo>
                  <a:lnTo>
                    <a:pt x="155" y="157081"/>
                  </a:lnTo>
                  <a:lnTo>
                    <a:pt x="160" y="157690"/>
                  </a:lnTo>
                  <a:lnTo>
                    <a:pt x="165" y="158299"/>
                  </a:lnTo>
                  <a:lnTo>
                    <a:pt x="170" y="158908"/>
                  </a:lnTo>
                  <a:lnTo>
                    <a:pt x="174" y="159517"/>
                  </a:lnTo>
                  <a:lnTo>
                    <a:pt x="179" y="160126"/>
                  </a:lnTo>
                  <a:lnTo>
                    <a:pt x="184" y="160734"/>
                  </a:lnTo>
                  <a:lnTo>
                    <a:pt x="189" y="161343"/>
                  </a:lnTo>
                  <a:lnTo>
                    <a:pt x="194" y="161952"/>
                  </a:lnTo>
                  <a:lnTo>
                    <a:pt x="199" y="162561"/>
                  </a:lnTo>
                  <a:lnTo>
                    <a:pt x="204" y="163170"/>
                  </a:lnTo>
                  <a:lnTo>
                    <a:pt x="208" y="163779"/>
                  </a:lnTo>
                  <a:lnTo>
                    <a:pt x="213" y="164387"/>
                  </a:lnTo>
                  <a:lnTo>
                    <a:pt x="218" y="164996"/>
                  </a:lnTo>
                  <a:lnTo>
                    <a:pt x="223" y="165605"/>
                  </a:lnTo>
                  <a:lnTo>
                    <a:pt x="228" y="166214"/>
                  </a:lnTo>
                  <a:lnTo>
                    <a:pt x="232" y="166823"/>
                  </a:lnTo>
                  <a:lnTo>
                    <a:pt x="237" y="167432"/>
                  </a:lnTo>
                  <a:lnTo>
                    <a:pt x="242" y="168041"/>
                  </a:lnTo>
                  <a:lnTo>
                    <a:pt x="246" y="168649"/>
                  </a:lnTo>
                  <a:lnTo>
                    <a:pt x="251" y="169258"/>
                  </a:lnTo>
                  <a:lnTo>
                    <a:pt x="256" y="169867"/>
                  </a:lnTo>
                  <a:lnTo>
                    <a:pt x="260" y="170476"/>
                  </a:lnTo>
                  <a:lnTo>
                    <a:pt x="265" y="171085"/>
                  </a:lnTo>
                  <a:lnTo>
                    <a:pt x="269" y="171694"/>
                  </a:lnTo>
                  <a:lnTo>
                    <a:pt x="273" y="172302"/>
                  </a:lnTo>
                  <a:lnTo>
                    <a:pt x="278" y="172911"/>
                  </a:lnTo>
                  <a:lnTo>
                    <a:pt x="282" y="173520"/>
                  </a:lnTo>
                  <a:lnTo>
                    <a:pt x="286" y="174129"/>
                  </a:lnTo>
                  <a:lnTo>
                    <a:pt x="291" y="174738"/>
                  </a:lnTo>
                  <a:lnTo>
                    <a:pt x="295" y="175347"/>
                  </a:lnTo>
                  <a:lnTo>
                    <a:pt x="299" y="175955"/>
                  </a:lnTo>
                  <a:lnTo>
                    <a:pt x="303" y="176564"/>
                  </a:lnTo>
                  <a:lnTo>
                    <a:pt x="307" y="177173"/>
                  </a:lnTo>
                  <a:lnTo>
                    <a:pt x="311" y="177782"/>
                  </a:lnTo>
                  <a:lnTo>
                    <a:pt x="315" y="178391"/>
                  </a:lnTo>
                  <a:lnTo>
                    <a:pt x="319" y="179000"/>
                  </a:lnTo>
                  <a:lnTo>
                    <a:pt x="323" y="179609"/>
                  </a:lnTo>
                  <a:lnTo>
                    <a:pt x="326" y="180217"/>
                  </a:lnTo>
                  <a:lnTo>
                    <a:pt x="330" y="180826"/>
                  </a:lnTo>
                  <a:lnTo>
                    <a:pt x="334" y="181435"/>
                  </a:lnTo>
                  <a:lnTo>
                    <a:pt x="338" y="182044"/>
                  </a:lnTo>
                  <a:lnTo>
                    <a:pt x="342" y="182653"/>
                  </a:lnTo>
                  <a:lnTo>
                    <a:pt x="345" y="183262"/>
                  </a:lnTo>
                  <a:lnTo>
                    <a:pt x="349" y="183870"/>
                  </a:lnTo>
                  <a:lnTo>
                    <a:pt x="353" y="184479"/>
                  </a:lnTo>
                  <a:lnTo>
                    <a:pt x="357" y="185088"/>
                  </a:lnTo>
                  <a:lnTo>
                    <a:pt x="361" y="185697"/>
                  </a:lnTo>
                  <a:lnTo>
                    <a:pt x="365" y="186306"/>
                  </a:lnTo>
                  <a:lnTo>
                    <a:pt x="369" y="186915"/>
                  </a:lnTo>
                  <a:lnTo>
                    <a:pt x="373" y="187524"/>
                  </a:lnTo>
                  <a:lnTo>
                    <a:pt x="377" y="188132"/>
                  </a:lnTo>
                  <a:lnTo>
                    <a:pt x="381" y="188741"/>
                  </a:lnTo>
                  <a:lnTo>
                    <a:pt x="385" y="189350"/>
                  </a:lnTo>
                  <a:lnTo>
                    <a:pt x="389" y="189959"/>
                  </a:lnTo>
                  <a:lnTo>
                    <a:pt x="394" y="190568"/>
                  </a:lnTo>
                  <a:lnTo>
                    <a:pt x="398" y="191177"/>
                  </a:lnTo>
                  <a:lnTo>
                    <a:pt x="402" y="191785"/>
                  </a:lnTo>
                  <a:lnTo>
                    <a:pt x="407" y="192394"/>
                  </a:lnTo>
                  <a:lnTo>
                    <a:pt x="412" y="193003"/>
                  </a:lnTo>
                  <a:lnTo>
                    <a:pt x="416" y="193612"/>
                  </a:lnTo>
                  <a:lnTo>
                    <a:pt x="421" y="194221"/>
                  </a:lnTo>
                  <a:lnTo>
                    <a:pt x="426" y="194830"/>
                  </a:lnTo>
                  <a:lnTo>
                    <a:pt x="431" y="195439"/>
                  </a:lnTo>
                  <a:lnTo>
                    <a:pt x="436" y="196047"/>
                  </a:lnTo>
                  <a:lnTo>
                    <a:pt x="442" y="196656"/>
                  </a:lnTo>
                  <a:lnTo>
                    <a:pt x="447" y="197265"/>
                  </a:lnTo>
                  <a:lnTo>
                    <a:pt x="453" y="197874"/>
                  </a:lnTo>
                  <a:lnTo>
                    <a:pt x="458" y="198483"/>
                  </a:lnTo>
                  <a:lnTo>
                    <a:pt x="464" y="199092"/>
                  </a:lnTo>
                  <a:lnTo>
                    <a:pt x="470" y="199700"/>
                  </a:lnTo>
                  <a:lnTo>
                    <a:pt x="476" y="200309"/>
                  </a:lnTo>
                  <a:lnTo>
                    <a:pt x="482" y="200918"/>
                  </a:lnTo>
                  <a:lnTo>
                    <a:pt x="488" y="201527"/>
                  </a:lnTo>
                  <a:lnTo>
                    <a:pt x="494" y="202136"/>
                  </a:lnTo>
                  <a:lnTo>
                    <a:pt x="501" y="202745"/>
                  </a:lnTo>
                  <a:lnTo>
                    <a:pt x="507" y="203353"/>
                  </a:lnTo>
                  <a:lnTo>
                    <a:pt x="514" y="203962"/>
                  </a:lnTo>
                  <a:lnTo>
                    <a:pt x="520" y="204571"/>
                  </a:lnTo>
                  <a:lnTo>
                    <a:pt x="527" y="205180"/>
                  </a:lnTo>
                  <a:lnTo>
                    <a:pt x="534" y="205789"/>
                  </a:lnTo>
                  <a:lnTo>
                    <a:pt x="540" y="206398"/>
                  </a:lnTo>
                  <a:lnTo>
                    <a:pt x="547" y="207007"/>
                  </a:lnTo>
                  <a:lnTo>
                    <a:pt x="554" y="207615"/>
                  </a:lnTo>
                  <a:lnTo>
                    <a:pt x="561" y="208224"/>
                  </a:lnTo>
                  <a:lnTo>
                    <a:pt x="568" y="208833"/>
                  </a:lnTo>
                  <a:lnTo>
                    <a:pt x="575" y="209442"/>
                  </a:lnTo>
                  <a:lnTo>
                    <a:pt x="581" y="210051"/>
                  </a:lnTo>
                  <a:lnTo>
                    <a:pt x="588" y="210660"/>
                  </a:lnTo>
                  <a:lnTo>
                    <a:pt x="595" y="211268"/>
                  </a:lnTo>
                  <a:lnTo>
                    <a:pt x="602" y="211877"/>
                  </a:lnTo>
                  <a:lnTo>
                    <a:pt x="608" y="212486"/>
                  </a:lnTo>
                  <a:lnTo>
                    <a:pt x="615" y="213095"/>
                  </a:lnTo>
                  <a:lnTo>
                    <a:pt x="622" y="213704"/>
                  </a:lnTo>
                  <a:lnTo>
                    <a:pt x="628" y="214313"/>
                  </a:lnTo>
                  <a:lnTo>
                    <a:pt x="634" y="214922"/>
                  </a:lnTo>
                  <a:lnTo>
                    <a:pt x="640" y="215530"/>
                  </a:lnTo>
                  <a:lnTo>
                    <a:pt x="646" y="216139"/>
                  </a:lnTo>
                  <a:lnTo>
                    <a:pt x="652" y="216748"/>
                  </a:lnTo>
                  <a:lnTo>
                    <a:pt x="658" y="217357"/>
                  </a:lnTo>
                  <a:lnTo>
                    <a:pt x="663" y="217966"/>
                  </a:lnTo>
                  <a:lnTo>
                    <a:pt x="668" y="218575"/>
                  </a:lnTo>
                  <a:lnTo>
                    <a:pt x="673" y="219183"/>
                  </a:lnTo>
                  <a:lnTo>
                    <a:pt x="678" y="219792"/>
                  </a:lnTo>
                  <a:lnTo>
                    <a:pt x="683" y="220401"/>
                  </a:lnTo>
                  <a:lnTo>
                    <a:pt x="687" y="221010"/>
                  </a:lnTo>
                  <a:lnTo>
                    <a:pt x="691" y="221619"/>
                  </a:lnTo>
                  <a:lnTo>
                    <a:pt x="694" y="222228"/>
                  </a:lnTo>
                  <a:lnTo>
                    <a:pt x="698" y="222837"/>
                  </a:lnTo>
                  <a:lnTo>
                    <a:pt x="701" y="223445"/>
                  </a:lnTo>
                  <a:lnTo>
                    <a:pt x="704" y="224054"/>
                  </a:lnTo>
                  <a:lnTo>
                    <a:pt x="706" y="224663"/>
                  </a:lnTo>
                  <a:lnTo>
                    <a:pt x="708" y="225272"/>
                  </a:lnTo>
                  <a:lnTo>
                    <a:pt x="710" y="225881"/>
                  </a:lnTo>
                  <a:lnTo>
                    <a:pt x="712" y="226490"/>
                  </a:lnTo>
                  <a:lnTo>
                    <a:pt x="713" y="227098"/>
                  </a:lnTo>
                  <a:lnTo>
                    <a:pt x="713" y="227707"/>
                  </a:lnTo>
                  <a:lnTo>
                    <a:pt x="714" y="228316"/>
                  </a:lnTo>
                  <a:lnTo>
                    <a:pt x="714" y="228925"/>
                  </a:lnTo>
                  <a:lnTo>
                    <a:pt x="714" y="229534"/>
                  </a:lnTo>
                  <a:lnTo>
                    <a:pt x="713" y="230143"/>
                  </a:lnTo>
                  <a:lnTo>
                    <a:pt x="712" y="230751"/>
                  </a:lnTo>
                  <a:lnTo>
                    <a:pt x="710" y="231360"/>
                  </a:lnTo>
                  <a:lnTo>
                    <a:pt x="708" y="231969"/>
                  </a:lnTo>
                  <a:lnTo>
                    <a:pt x="706" y="232578"/>
                  </a:lnTo>
                  <a:lnTo>
                    <a:pt x="704" y="233187"/>
                  </a:lnTo>
                  <a:lnTo>
                    <a:pt x="701" y="233796"/>
                  </a:lnTo>
                  <a:lnTo>
                    <a:pt x="697" y="234405"/>
                  </a:lnTo>
                  <a:lnTo>
                    <a:pt x="694" y="235013"/>
                  </a:lnTo>
                  <a:lnTo>
                    <a:pt x="690" y="235622"/>
                  </a:lnTo>
                  <a:lnTo>
                    <a:pt x="685" y="236231"/>
                  </a:lnTo>
                  <a:lnTo>
                    <a:pt x="680" y="236840"/>
                  </a:lnTo>
                  <a:lnTo>
                    <a:pt x="675" y="237449"/>
                  </a:lnTo>
                  <a:lnTo>
                    <a:pt x="670" y="238058"/>
                  </a:lnTo>
                  <a:lnTo>
                    <a:pt x="664" y="238666"/>
                  </a:lnTo>
                  <a:lnTo>
                    <a:pt x="658" y="239275"/>
                  </a:lnTo>
                  <a:lnTo>
                    <a:pt x="652" y="239884"/>
                  </a:lnTo>
                  <a:lnTo>
                    <a:pt x="645" y="240493"/>
                  </a:lnTo>
                  <a:lnTo>
                    <a:pt x="638" y="241102"/>
                  </a:lnTo>
                  <a:lnTo>
                    <a:pt x="631" y="241711"/>
                  </a:lnTo>
                  <a:lnTo>
                    <a:pt x="623" y="242320"/>
                  </a:lnTo>
                  <a:lnTo>
                    <a:pt x="615" y="242928"/>
                  </a:lnTo>
                  <a:lnTo>
                    <a:pt x="607" y="243537"/>
                  </a:lnTo>
                  <a:lnTo>
                    <a:pt x="599" y="244146"/>
                  </a:lnTo>
                  <a:lnTo>
                    <a:pt x="590" y="244755"/>
                  </a:lnTo>
                  <a:lnTo>
                    <a:pt x="582" y="245364"/>
                  </a:lnTo>
                  <a:lnTo>
                    <a:pt x="573" y="245973"/>
                  </a:lnTo>
                  <a:lnTo>
                    <a:pt x="564" y="246581"/>
                  </a:lnTo>
                  <a:lnTo>
                    <a:pt x="554" y="247190"/>
                  </a:lnTo>
                  <a:lnTo>
                    <a:pt x="545" y="247799"/>
                  </a:lnTo>
                  <a:lnTo>
                    <a:pt x="535" y="248408"/>
                  </a:lnTo>
                  <a:lnTo>
                    <a:pt x="526" y="249017"/>
                  </a:lnTo>
                  <a:lnTo>
                    <a:pt x="516" y="249626"/>
                  </a:lnTo>
                  <a:lnTo>
                    <a:pt x="506" y="250235"/>
                  </a:lnTo>
                  <a:lnTo>
                    <a:pt x="496" y="250843"/>
                  </a:lnTo>
                  <a:lnTo>
                    <a:pt x="486" y="251452"/>
                  </a:lnTo>
                  <a:lnTo>
                    <a:pt x="475" y="252061"/>
                  </a:lnTo>
                  <a:lnTo>
                    <a:pt x="465" y="252670"/>
                  </a:lnTo>
                  <a:lnTo>
                    <a:pt x="455" y="253279"/>
                  </a:lnTo>
                  <a:lnTo>
                    <a:pt x="444" y="253888"/>
                  </a:lnTo>
                  <a:lnTo>
                    <a:pt x="434" y="254496"/>
                  </a:lnTo>
                  <a:lnTo>
                    <a:pt x="424" y="255105"/>
                  </a:lnTo>
                  <a:lnTo>
                    <a:pt x="413" y="255714"/>
                  </a:lnTo>
                  <a:lnTo>
                    <a:pt x="403" y="256323"/>
                  </a:lnTo>
                  <a:lnTo>
                    <a:pt x="393" y="256932"/>
                  </a:lnTo>
                  <a:lnTo>
                    <a:pt x="382" y="257541"/>
                  </a:lnTo>
                  <a:lnTo>
                    <a:pt x="372" y="258149"/>
                  </a:lnTo>
                  <a:lnTo>
                    <a:pt x="362" y="258758"/>
                  </a:lnTo>
                  <a:lnTo>
                    <a:pt x="352" y="259367"/>
                  </a:lnTo>
                  <a:lnTo>
                    <a:pt x="342" y="259976"/>
                  </a:lnTo>
                  <a:lnTo>
                    <a:pt x="332" y="260585"/>
                  </a:lnTo>
                  <a:lnTo>
                    <a:pt x="322" y="261194"/>
                  </a:lnTo>
                  <a:lnTo>
                    <a:pt x="312" y="261803"/>
                  </a:lnTo>
                  <a:lnTo>
                    <a:pt x="303" y="262411"/>
                  </a:lnTo>
                  <a:lnTo>
                    <a:pt x="293" y="263020"/>
                  </a:lnTo>
                  <a:lnTo>
                    <a:pt x="284" y="263629"/>
                  </a:lnTo>
                  <a:lnTo>
                    <a:pt x="275" y="264238"/>
                  </a:lnTo>
                  <a:lnTo>
                    <a:pt x="265" y="264847"/>
                  </a:lnTo>
                  <a:lnTo>
                    <a:pt x="256" y="265456"/>
                  </a:lnTo>
                  <a:lnTo>
                    <a:pt x="248" y="266064"/>
                  </a:lnTo>
                  <a:lnTo>
                    <a:pt x="239" y="266673"/>
                  </a:lnTo>
                  <a:lnTo>
                    <a:pt x="231" y="267282"/>
                  </a:lnTo>
                  <a:lnTo>
                    <a:pt x="222" y="267891"/>
                  </a:lnTo>
                  <a:lnTo>
                    <a:pt x="214" y="268500"/>
                  </a:lnTo>
                  <a:lnTo>
                    <a:pt x="206" y="269109"/>
                  </a:lnTo>
                  <a:lnTo>
                    <a:pt x="198" y="269718"/>
                  </a:lnTo>
                  <a:lnTo>
                    <a:pt x="191" y="270326"/>
                  </a:lnTo>
                  <a:lnTo>
                    <a:pt x="183" y="270935"/>
                  </a:lnTo>
                  <a:lnTo>
                    <a:pt x="176" y="271544"/>
                  </a:lnTo>
                  <a:lnTo>
                    <a:pt x="169" y="272153"/>
                  </a:lnTo>
                  <a:lnTo>
                    <a:pt x="162" y="272762"/>
                  </a:lnTo>
                  <a:lnTo>
                    <a:pt x="155" y="273371"/>
                  </a:lnTo>
                  <a:lnTo>
                    <a:pt x="149" y="273979"/>
                  </a:lnTo>
                  <a:lnTo>
                    <a:pt x="142" y="274588"/>
                  </a:lnTo>
                  <a:lnTo>
                    <a:pt x="136" y="275197"/>
                  </a:lnTo>
                  <a:lnTo>
                    <a:pt x="130" y="275806"/>
                  </a:lnTo>
                  <a:lnTo>
                    <a:pt x="124" y="276415"/>
                  </a:lnTo>
                  <a:lnTo>
                    <a:pt x="119" y="277024"/>
                  </a:lnTo>
                  <a:lnTo>
                    <a:pt x="113" y="277632"/>
                  </a:lnTo>
                  <a:lnTo>
                    <a:pt x="108" y="278241"/>
                  </a:lnTo>
                  <a:lnTo>
                    <a:pt x="103" y="278850"/>
                  </a:lnTo>
                  <a:lnTo>
                    <a:pt x="98" y="279459"/>
                  </a:lnTo>
                  <a:lnTo>
                    <a:pt x="93" y="280068"/>
                  </a:lnTo>
                  <a:lnTo>
                    <a:pt x="89" y="280677"/>
                  </a:lnTo>
                  <a:lnTo>
                    <a:pt x="84" y="281286"/>
                  </a:lnTo>
                  <a:lnTo>
                    <a:pt x="80" y="281894"/>
                  </a:lnTo>
                  <a:lnTo>
                    <a:pt x="76" y="282503"/>
                  </a:lnTo>
                  <a:lnTo>
                    <a:pt x="72" y="283112"/>
                  </a:lnTo>
                  <a:lnTo>
                    <a:pt x="68" y="283721"/>
                  </a:lnTo>
                  <a:lnTo>
                    <a:pt x="65" y="284330"/>
                  </a:lnTo>
                  <a:lnTo>
                    <a:pt x="61" y="284939"/>
                  </a:lnTo>
                  <a:lnTo>
                    <a:pt x="58" y="285547"/>
                  </a:lnTo>
                  <a:lnTo>
                    <a:pt x="55" y="286156"/>
                  </a:lnTo>
                  <a:lnTo>
                    <a:pt x="52" y="286765"/>
                  </a:lnTo>
                  <a:lnTo>
                    <a:pt x="49" y="287374"/>
                  </a:lnTo>
                  <a:lnTo>
                    <a:pt x="46" y="287983"/>
                  </a:lnTo>
                  <a:lnTo>
                    <a:pt x="43" y="288592"/>
                  </a:lnTo>
                  <a:lnTo>
                    <a:pt x="41" y="289201"/>
                  </a:lnTo>
                  <a:lnTo>
                    <a:pt x="38" y="289809"/>
                  </a:lnTo>
                  <a:lnTo>
                    <a:pt x="36" y="290418"/>
                  </a:lnTo>
                  <a:lnTo>
                    <a:pt x="34" y="291027"/>
                  </a:lnTo>
                  <a:lnTo>
                    <a:pt x="32" y="291636"/>
                  </a:lnTo>
                  <a:lnTo>
                    <a:pt x="30" y="292245"/>
                  </a:lnTo>
                  <a:lnTo>
                    <a:pt x="28" y="292854"/>
                  </a:lnTo>
                  <a:lnTo>
                    <a:pt x="26" y="293462"/>
                  </a:lnTo>
                  <a:lnTo>
                    <a:pt x="25" y="294071"/>
                  </a:lnTo>
                  <a:lnTo>
                    <a:pt x="23" y="294680"/>
                  </a:lnTo>
                  <a:lnTo>
                    <a:pt x="22" y="295289"/>
                  </a:lnTo>
                  <a:lnTo>
                    <a:pt x="20" y="295898"/>
                  </a:lnTo>
                  <a:lnTo>
                    <a:pt x="19" y="296507"/>
                  </a:lnTo>
                  <a:lnTo>
                    <a:pt x="17" y="297116"/>
                  </a:lnTo>
                  <a:lnTo>
                    <a:pt x="16" y="297724"/>
                  </a:lnTo>
                  <a:lnTo>
                    <a:pt x="15" y="298333"/>
                  </a:lnTo>
                  <a:lnTo>
                    <a:pt x="14" y="298942"/>
                  </a:lnTo>
                  <a:lnTo>
                    <a:pt x="13" y="299551"/>
                  </a:lnTo>
                  <a:lnTo>
                    <a:pt x="12" y="300160"/>
                  </a:lnTo>
                  <a:lnTo>
                    <a:pt x="11" y="300769"/>
                  </a:lnTo>
                  <a:lnTo>
                    <a:pt x="10" y="301377"/>
                  </a:lnTo>
                  <a:lnTo>
                    <a:pt x="10" y="301986"/>
                  </a:lnTo>
                  <a:lnTo>
                    <a:pt x="9" y="302595"/>
                  </a:lnTo>
                  <a:lnTo>
                    <a:pt x="8" y="303204"/>
                  </a:lnTo>
                  <a:lnTo>
                    <a:pt x="8" y="303813"/>
                  </a:lnTo>
                  <a:lnTo>
                    <a:pt x="7" y="304422"/>
                  </a:lnTo>
                  <a:lnTo>
                    <a:pt x="6" y="305030"/>
                  </a:lnTo>
                  <a:lnTo>
                    <a:pt x="6" y="305639"/>
                  </a:lnTo>
                  <a:lnTo>
                    <a:pt x="5" y="306248"/>
                  </a:lnTo>
                  <a:lnTo>
                    <a:pt x="5" y="306857"/>
                  </a:lnTo>
                  <a:lnTo>
                    <a:pt x="5" y="307466"/>
                  </a:lnTo>
                  <a:lnTo>
                    <a:pt x="4" y="308075"/>
                  </a:lnTo>
                  <a:lnTo>
                    <a:pt x="4" y="308684"/>
                  </a:lnTo>
                  <a:lnTo>
                    <a:pt x="3" y="309292"/>
                  </a:lnTo>
                  <a:lnTo>
                    <a:pt x="3" y="309901"/>
                  </a:lnTo>
                  <a:lnTo>
                    <a:pt x="3" y="310510"/>
                  </a:lnTo>
                  <a:lnTo>
                    <a:pt x="3" y="311119"/>
                  </a:lnTo>
                  <a:lnTo>
                    <a:pt x="0" y="311119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40" name="pl22"/>
            <p:cNvSpPr/>
            <p:nvPr/>
          </p:nvSpPr>
          <p:spPr>
            <a:xfrm>
              <a:off x="3084958" y="2756055"/>
              <a:ext cx="132" cy="966370"/>
            </a:xfrm>
            <a:custGeom>
              <a:avLst/>
              <a:gdLst/>
              <a:ahLst/>
              <a:cxnLst/>
              <a:rect l="0" t="0" r="0" b="0"/>
              <a:pathLst>
                <a:path w="132" h="966370">
                  <a:moveTo>
                    <a:pt x="132" y="966370"/>
                  </a:moveTo>
                  <a:lnTo>
                    <a:pt x="131" y="966370"/>
                  </a:lnTo>
                  <a:lnTo>
                    <a:pt x="131" y="964479"/>
                  </a:lnTo>
                  <a:lnTo>
                    <a:pt x="131" y="962587"/>
                  </a:lnTo>
                  <a:lnTo>
                    <a:pt x="131" y="960696"/>
                  </a:lnTo>
                  <a:lnTo>
                    <a:pt x="131" y="958805"/>
                  </a:lnTo>
                  <a:lnTo>
                    <a:pt x="130" y="956914"/>
                  </a:lnTo>
                  <a:lnTo>
                    <a:pt x="130" y="955023"/>
                  </a:lnTo>
                  <a:lnTo>
                    <a:pt x="130" y="953132"/>
                  </a:lnTo>
                  <a:lnTo>
                    <a:pt x="130" y="951241"/>
                  </a:lnTo>
                  <a:lnTo>
                    <a:pt x="130" y="949349"/>
                  </a:lnTo>
                  <a:lnTo>
                    <a:pt x="130" y="947458"/>
                  </a:lnTo>
                  <a:lnTo>
                    <a:pt x="130" y="945567"/>
                  </a:lnTo>
                  <a:lnTo>
                    <a:pt x="130" y="943676"/>
                  </a:lnTo>
                  <a:lnTo>
                    <a:pt x="130" y="941785"/>
                  </a:lnTo>
                  <a:lnTo>
                    <a:pt x="130" y="939894"/>
                  </a:lnTo>
                  <a:lnTo>
                    <a:pt x="130" y="938003"/>
                  </a:lnTo>
                  <a:lnTo>
                    <a:pt x="129" y="936111"/>
                  </a:lnTo>
                  <a:lnTo>
                    <a:pt x="129" y="934220"/>
                  </a:lnTo>
                  <a:lnTo>
                    <a:pt x="129" y="932329"/>
                  </a:lnTo>
                  <a:lnTo>
                    <a:pt x="129" y="930438"/>
                  </a:lnTo>
                  <a:lnTo>
                    <a:pt x="129" y="928547"/>
                  </a:lnTo>
                  <a:lnTo>
                    <a:pt x="129" y="926656"/>
                  </a:lnTo>
                  <a:lnTo>
                    <a:pt x="129" y="924765"/>
                  </a:lnTo>
                  <a:lnTo>
                    <a:pt x="128" y="922874"/>
                  </a:lnTo>
                  <a:lnTo>
                    <a:pt x="128" y="920982"/>
                  </a:lnTo>
                  <a:lnTo>
                    <a:pt x="128" y="919091"/>
                  </a:lnTo>
                  <a:lnTo>
                    <a:pt x="128" y="917200"/>
                  </a:lnTo>
                  <a:lnTo>
                    <a:pt x="128" y="915309"/>
                  </a:lnTo>
                  <a:lnTo>
                    <a:pt x="128" y="913418"/>
                  </a:lnTo>
                  <a:lnTo>
                    <a:pt x="127" y="911527"/>
                  </a:lnTo>
                  <a:lnTo>
                    <a:pt x="127" y="909636"/>
                  </a:lnTo>
                  <a:lnTo>
                    <a:pt x="127" y="907744"/>
                  </a:lnTo>
                  <a:lnTo>
                    <a:pt x="127" y="905853"/>
                  </a:lnTo>
                  <a:lnTo>
                    <a:pt x="126" y="903962"/>
                  </a:lnTo>
                  <a:lnTo>
                    <a:pt x="126" y="902071"/>
                  </a:lnTo>
                  <a:lnTo>
                    <a:pt x="126" y="900180"/>
                  </a:lnTo>
                  <a:lnTo>
                    <a:pt x="126" y="898289"/>
                  </a:lnTo>
                  <a:lnTo>
                    <a:pt x="125" y="896398"/>
                  </a:lnTo>
                  <a:lnTo>
                    <a:pt x="125" y="894507"/>
                  </a:lnTo>
                  <a:lnTo>
                    <a:pt x="125" y="892615"/>
                  </a:lnTo>
                  <a:lnTo>
                    <a:pt x="125" y="890724"/>
                  </a:lnTo>
                  <a:lnTo>
                    <a:pt x="124" y="888833"/>
                  </a:lnTo>
                  <a:lnTo>
                    <a:pt x="124" y="886942"/>
                  </a:lnTo>
                  <a:lnTo>
                    <a:pt x="124" y="885051"/>
                  </a:lnTo>
                  <a:lnTo>
                    <a:pt x="123" y="883160"/>
                  </a:lnTo>
                  <a:lnTo>
                    <a:pt x="123" y="881269"/>
                  </a:lnTo>
                  <a:lnTo>
                    <a:pt x="123" y="879377"/>
                  </a:lnTo>
                  <a:lnTo>
                    <a:pt x="122" y="877486"/>
                  </a:lnTo>
                  <a:lnTo>
                    <a:pt x="122" y="875595"/>
                  </a:lnTo>
                  <a:lnTo>
                    <a:pt x="121" y="873704"/>
                  </a:lnTo>
                  <a:lnTo>
                    <a:pt x="121" y="871813"/>
                  </a:lnTo>
                  <a:lnTo>
                    <a:pt x="121" y="869922"/>
                  </a:lnTo>
                  <a:lnTo>
                    <a:pt x="120" y="868031"/>
                  </a:lnTo>
                  <a:lnTo>
                    <a:pt x="120" y="866139"/>
                  </a:lnTo>
                  <a:lnTo>
                    <a:pt x="119" y="864248"/>
                  </a:lnTo>
                  <a:lnTo>
                    <a:pt x="119" y="862357"/>
                  </a:lnTo>
                  <a:lnTo>
                    <a:pt x="118" y="860466"/>
                  </a:lnTo>
                  <a:lnTo>
                    <a:pt x="118" y="858575"/>
                  </a:lnTo>
                  <a:lnTo>
                    <a:pt x="117" y="856684"/>
                  </a:lnTo>
                  <a:lnTo>
                    <a:pt x="117" y="854793"/>
                  </a:lnTo>
                  <a:lnTo>
                    <a:pt x="116" y="852902"/>
                  </a:lnTo>
                  <a:lnTo>
                    <a:pt x="115" y="851010"/>
                  </a:lnTo>
                  <a:lnTo>
                    <a:pt x="115" y="849119"/>
                  </a:lnTo>
                  <a:lnTo>
                    <a:pt x="114" y="847228"/>
                  </a:lnTo>
                  <a:lnTo>
                    <a:pt x="114" y="845337"/>
                  </a:lnTo>
                  <a:lnTo>
                    <a:pt x="113" y="843446"/>
                  </a:lnTo>
                  <a:lnTo>
                    <a:pt x="112" y="841555"/>
                  </a:lnTo>
                  <a:lnTo>
                    <a:pt x="112" y="839664"/>
                  </a:lnTo>
                  <a:lnTo>
                    <a:pt x="111" y="837772"/>
                  </a:lnTo>
                  <a:lnTo>
                    <a:pt x="110" y="835881"/>
                  </a:lnTo>
                  <a:lnTo>
                    <a:pt x="110" y="833990"/>
                  </a:lnTo>
                  <a:lnTo>
                    <a:pt x="109" y="832099"/>
                  </a:lnTo>
                  <a:lnTo>
                    <a:pt x="108" y="830208"/>
                  </a:lnTo>
                  <a:lnTo>
                    <a:pt x="107" y="828317"/>
                  </a:lnTo>
                  <a:lnTo>
                    <a:pt x="107" y="826426"/>
                  </a:lnTo>
                  <a:lnTo>
                    <a:pt x="106" y="824534"/>
                  </a:lnTo>
                  <a:lnTo>
                    <a:pt x="105" y="822643"/>
                  </a:lnTo>
                  <a:lnTo>
                    <a:pt x="104" y="820752"/>
                  </a:lnTo>
                  <a:lnTo>
                    <a:pt x="103" y="818861"/>
                  </a:lnTo>
                  <a:lnTo>
                    <a:pt x="102" y="816970"/>
                  </a:lnTo>
                  <a:lnTo>
                    <a:pt x="102" y="815079"/>
                  </a:lnTo>
                  <a:lnTo>
                    <a:pt x="101" y="813188"/>
                  </a:lnTo>
                  <a:lnTo>
                    <a:pt x="100" y="811297"/>
                  </a:lnTo>
                  <a:lnTo>
                    <a:pt x="99" y="809405"/>
                  </a:lnTo>
                  <a:lnTo>
                    <a:pt x="98" y="807514"/>
                  </a:lnTo>
                  <a:lnTo>
                    <a:pt x="97" y="805623"/>
                  </a:lnTo>
                  <a:lnTo>
                    <a:pt x="96" y="803732"/>
                  </a:lnTo>
                  <a:lnTo>
                    <a:pt x="95" y="801841"/>
                  </a:lnTo>
                  <a:lnTo>
                    <a:pt x="94" y="799950"/>
                  </a:lnTo>
                  <a:lnTo>
                    <a:pt x="93" y="798059"/>
                  </a:lnTo>
                  <a:lnTo>
                    <a:pt x="92" y="796167"/>
                  </a:lnTo>
                  <a:lnTo>
                    <a:pt x="91" y="794276"/>
                  </a:lnTo>
                  <a:lnTo>
                    <a:pt x="90" y="792385"/>
                  </a:lnTo>
                  <a:lnTo>
                    <a:pt x="89" y="790494"/>
                  </a:lnTo>
                  <a:lnTo>
                    <a:pt x="87" y="788603"/>
                  </a:lnTo>
                  <a:lnTo>
                    <a:pt x="86" y="786712"/>
                  </a:lnTo>
                  <a:lnTo>
                    <a:pt x="85" y="784821"/>
                  </a:lnTo>
                  <a:lnTo>
                    <a:pt x="84" y="782930"/>
                  </a:lnTo>
                  <a:lnTo>
                    <a:pt x="83" y="781038"/>
                  </a:lnTo>
                  <a:lnTo>
                    <a:pt x="82" y="779147"/>
                  </a:lnTo>
                  <a:lnTo>
                    <a:pt x="81" y="777256"/>
                  </a:lnTo>
                  <a:lnTo>
                    <a:pt x="79" y="775365"/>
                  </a:lnTo>
                  <a:lnTo>
                    <a:pt x="78" y="773474"/>
                  </a:lnTo>
                  <a:lnTo>
                    <a:pt x="77" y="771583"/>
                  </a:lnTo>
                  <a:lnTo>
                    <a:pt x="76" y="769692"/>
                  </a:lnTo>
                  <a:lnTo>
                    <a:pt x="74" y="767800"/>
                  </a:lnTo>
                  <a:lnTo>
                    <a:pt x="73" y="765909"/>
                  </a:lnTo>
                  <a:lnTo>
                    <a:pt x="72" y="764018"/>
                  </a:lnTo>
                  <a:lnTo>
                    <a:pt x="71" y="762127"/>
                  </a:lnTo>
                  <a:lnTo>
                    <a:pt x="69" y="760236"/>
                  </a:lnTo>
                  <a:lnTo>
                    <a:pt x="68" y="758345"/>
                  </a:lnTo>
                  <a:lnTo>
                    <a:pt x="67" y="756454"/>
                  </a:lnTo>
                  <a:lnTo>
                    <a:pt x="66" y="754562"/>
                  </a:lnTo>
                  <a:lnTo>
                    <a:pt x="64" y="752671"/>
                  </a:lnTo>
                  <a:lnTo>
                    <a:pt x="63" y="750780"/>
                  </a:lnTo>
                  <a:lnTo>
                    <a:pt x="62" y="748889"/>
                  </a:lnTo>
                  <a:lnTo>
                    <a:pt x="60" y="746998"/>
                  </a:lnTo>
                  <a:lnTo>
                    <a:pt x="59" y="745107"/>
                  </a:lnTo>
                  <a:lnTo>
                    <a:pt x="58" y="743216"/>
                  </a:lnTo>
                  <a:lnTo>
                    <a:pt x="57" y="741325"/>
                  </a:lnTo>
                  <a:lnTo>
                    <a:pt x="55" y="739433"/>
                  </a:lnTo>
                  <a:lnTo>
                    <a:pt x="54" y="737542"/>
                  </a:lnTo>
                  <a:lnTo>
                    <a:pt x="53" y="735651"/>
                  </a:lnTo>
                  <a:lnTo>
                    <a:pt x="51" y="733760"/>
                  </a:lnTo>
                  <a:lnTo>
                    <a:pt x="50" y="731869"/>
                  </a:lnTo>
                  <a:lnTo>
                    <a:pt x="49" y="729978"/>
                  </a:lnTo>
                  <a:lnTo>
                    <a:pt x="47" y="728087"/>
                  </a:lnTo>
                  <a:lnTo>
                    <a:pt x="46" y="726195"/>
                  </a:lnTo>
                  <a:lnTo>
                    <a:pt x="45" y="724304"/>
                  </a:lnTo>
                  <a:lnTo>
                    <a:pt x="44" y="722413"/>
                  </a:lnTo>
                  <a:lnTo>
                    <a:pt x="42" y="720522"/>
                  </a:lnTo>
                  <a:lnTo>
                    <a:pt x="41" y="718631"/>
                  </a:lnTo>
                  <a:lnTo>
                    <a:pt x="40" y="716740"/>
                  </a:lnTo>
                  <a:lnTo>
                    <a:pt x="39" y="714849"/>
                  </a:lnTo>
                  <a:lnTo>
                    <a:pt x="37" y="712958"/>
                  </a:lnTo>
                  <a:lnTo>
                    <a:pt x="36" y="711066"/>
                  </a:lnTo>
                  <a:lnTo>
                    <a:pt x="35" y="709175"/>
                  </a:lnTo>
                  <a:lnTo>
                    <a:pt x="34" y="707284"/>
                  </a:lnTo>
                  <a:lnTo>
                    <a:pt x="32" y="705393"/>
                  </a:lnTo>
                  <a:lnTo>
                    <a:pt x="31" y="703502"/>
                  </a:lnTo>
                  <a:lnTo>
                    <a:pt x="30" y="701611"/>
                  </a:lnTo>
                  <a:lnTo>
                    <a:pt x="29" y="699720"/>
                  </a:lnTo>
                  <a:lnTo>
                    <a:pt x="28" y="697828"/>
                  </a:lnTo>
                  <a:lnTo>
                    <a:pt x="27" y="695937"/>
                  </a:lnTo>
                  <a:lnTo>
                    <a:pt x="26" y="694046"/>
                  </a:lnTo>
                  <a:lnTo>
                    <a:pt x="25" y="692155"/>
                  </a:lnTo>
                  <a:lnTo>
                    <a:pt x="24" y="690264"/>
                  </a:lnTo>
                  <a:lnTo>
                    <a:pt x="22" y="688373"/>
                  </a:lnTo>
                  <a:lnTo>
                    <a:pt x="21" y="686482"/>
                  </a:lnTo>
                  <a:lnTo>
                    <a:pt x="20" y="684590"/>
                  </a:lnTo>
                  <a:lnTo>
                    <a:pt x="19" y="682699"/>
                  </a:lnTo>
                  <a:lnTo>
                    <a:pt x="19" y="680808"/>
                  </a:lnTo>
                  <a:lnTo>
                    <a:pt x="18" y="678917"/>
                  </a:lnTo>
                  <a:lnTo>
                    <a:pt x="17" y="677026"/>
                  </a:lnTo>
                  <a:lnTo>
                    <a:pt x="16" y="675135"/>
                  </a:lnTo>
                  <a:lnTo>
                    <a:pt x="15" y="673244"/>
                  </a:lnTo>
                  <a:lnTo>
                    <a:pt x="14" y="671353"/>
                  </a:lnTo>
                  <a:lnTo>
                    <a:pt x="13" y="669461"/>
                  </a:lnTo>
                  <a:lnTo>
                    <a:pt x="12" y="667570"/>
                  </a:lnTo>
                  <a:lnTo>
                    <a:pt x="12" y="665679"/>
                  </a:lnTo>
                  <a:lnTo>
                    <a:pt x="11" y="663788"/>
                  </a:lnTo>
                  <a:lnTo>
                    <a:pt x="10" y="661897"/>
                  </a:lnTo>
                  <a:lnTo>
                    <a:pt x="9" y="660006"/>
                  </a:lnTo>
                  <a:lnTo>
                    <a:pt x="9" y="658115"/>
                  </a:lnTo>
                  <a:lnTo>
                    <a:pt x="8" y="656223"/>
                  </a:lnTo>
                  <a:lnTo>
                    <a:pt x="7" y="654332"/>
                  </a:lnTo>
                  <a:lnTo>
                    <a:pt x="7" y="652441"/>
                  </a:lnTo>
                  <a:lnTo>
                    <a:pt x="6" y="650550"/>
                  </a:lnTo>
                  <a:lnTo>
                    <a:pt x="6" y="648659"/>
                  </a:lnTo>
                  <a:lnTo>
                    <a:pt x="5" y="646768"/>
                  </a:lnTo>
                  <a:lnTo>
                    <a:pt x="5" y="644877"/>
                  </a:lnTo>
                  <a:lnTo>
                    <a:pt x="4" y="642986"/>
                  </a:lnTo>
                  <a:lnTo>
                    <a:pt x="4" y="641094"/>
                  </a:lnTo>
                  <a:lnTo>
                    <a:pt x="3" y="639203"/>
                  </a:lnTo>
                  <a:lnTo>
                    <a:pt x="3" y="637312"/>
                  </a:lnTo>
                  <a:lnTo>
                    <a:pt x="3" y="635421"/>
                  </a:lnTo>
                  <a:lnTo>
                    <a:pt x="2" y="633530"/>
                  </a:lnTo>
                  <a:lnTo>
                    <a:pt x="2" y="631639"/>
                  </a:lnTo>
                  <a:lnTo>
                    <a:pt x="2" y="629748"/>
                  </a:lnTo>
                  <a:lnTo>
                    <a:pt x="1" y="627856"/>
                  </a:lnTo>
                  <a:lnTo>
                    <a:pt x="1" y="625965"/>
                  </a:lnTo>
                  <a:lnTo>
                    <a:pt x="1" y="624074"/>
                  </a:lnTo>
                  <a:lnTo>
                    <a:pt x="0" y="622183"/>
                  </a:lnTo>
                  <a:lnTo>
                    <a:pt x="0" y="620292"/>
                  </a:lnTo>
                  <a:lnTo>
                    <a:pt x="0" y="618401"/>
                  </a:lnTo>
                  <a:lnTo>
                    <a:pt x="0" y="616510"/>
                  </a:lnTo>
                  <a:lnTo>
                    <a:pt x="0" y="614618"/>
                  </a:lnTo>
                  <a:lnTo>
                    <a:pt x="0" y="612727"/>
                  </a:lnTo>
                  <a:lnTo>
                    <a:pt x="0" y="610836"/>
                  </a:lnTo>
                  <a:lnTo>
                    <a:pt x="0" y="608945"/>
                  </a:lnTo>
                  <a:lnTo>
                    <a:pt x="0" y="607054"/>
                  </a:lnTo>
                  <a:lnTo>
                    <a:pt x="0" y="605163"/>
                  </a:lnTo>
                  <a:lnTo>
                    <a:pt x="0" y="603272"/>
                  </a:lnTo>
                  <a:lnTo>
                    <a:pt x="0" y="601381"/>
                  </a:lnTo>
                  <a:lnTo>
                    <a:pt x="0" y="599489"/>
                  </a:lnTo>
                  <a:lnTo>
                    <a:pt x="0" y="597598"/>
                  </a:lnTo>
                  <a:lnTo>
                    <a:pt x="0" y="595707"/>
                  </a:lnTo>
                  <a:lnTo>
                    <a:pt x="0" y="593816"/>
                  </a:lnTo>
                  <a:lnTo>
                    <a:pt x="0" y="591925"/>
                  </a:lnTo>
                  <a:lnTo>
                    <a:pt x="0" y="590034"/>
                  </a:lnTo>
                  <a:lnTo>
                    <a:pt x="0" y="588143"/>
                  </a:lnTo>
                  <a:lnTo>
                    <a:pt x="0" y="586251"/>
                  </a:lnTo>
                  <a:lnTo>
                    <a:pt x="0" y="584360"/>
                  </a:lnTo>
                  <a:lnTo>
                    <a:pt x="0" y="582469"/>
                  </a:lnTo>
                  <a:lnTo>
                    <a:pt x="1" y="580578"/>
                  </a:lnTo>
                  <a:lnTo>
                    <a:pt x="1" y="578687"/>
                  </a:lnTo>
                  <a:lnTo>
                    <a:pt x="1" y="576796"/>
                  </a:lnTo>
                  <a:lnTo>
                    <a:pt x="1" y="574905"/>
                  </a:lnTo>
                  <a:lnTo>
                    <a:pt x="1" y="573013"/>
                  </a:lnTo>
                  <a:lnTo>
                    <a:pt x="2" y="571122"/>
                  </a:lnTo>
                  <a:lnTo>
                    <a:pt x="2" y="569231"/>
                  </a:lnTo>
                  <a:lnTo>
                    <a:pt x="2" y="567340"/>
                  </a:lnTo>
                  <a:lnTo>
                    <a:pt x="2" y="565449"/>
                  </a:lnTo>
                  <a:lnTo>
                    <a:pt x="2" y="563558"/>
                  </a:lnTo>
                  <a:lnTo>
                    <a:pt x="3" y="561667"/>
                  </a:lnTo>
                  <a:lnTo>
                    <a:pt x="3" y="559776"/>
                  </a:lnTo>
                  <a:lnTo>
                    <a:pt x="3" y="557884"/>
                  </a:lnTo>
                  <a:lnTo>
                    <a:pt x="3" y="555993"/>
                  </a:lnTo>
                  <a:lnTo>
                    <a:pt x="4" y="554102"/>
                  </a:lnTo>
                  <a:lnTo>
                    <a:pt x="4" y="552211"/>
                  </a:lnTo>
                  <a:lnTo>
                    <a:pt x="4" y="550320"/>
                  </a:lnTo>
                  <a:lnTo>
                    <a:pt x="4" y="548429"/>
                  </a:lnTo>
                  <a:lnTo>
                    <a:pt x="5" y="546538"/>
                  </a:lnTo>
                  <a:lnTo>
                    <a:pt x="5" y="544646"/>
                  </a:lnTo>
                  <a:lnTo>
                    <a:pt x="5" y="542755"/>
                  </a:lnTo>
                  <a:lnTo>
                    <a:pt x="5" y="540864"/>
                  </a:lnTo>
                  <a:lnTo>
                    <a:pt x="6" y="538973"/>
                  </a:lnTo>
                  <a:lnTo>
                    <a:pt x="6" y="537082"/>
                  </a:lnTo>
                  <a:lnTo>
                    <a:pt x="6" y="535191"/>
                  </a:lnTo>
                  <a:lnTo>
                    <a:pt x="6" y="533300"/>
                  </a:lnTo>
                  <a:lnTo>
                    <a:pt x="7" y="531409"/>
                  </a:lnTo>
                  <a:lnTo>
                    <a:pt x="7" y="529517"/>
                  </a:lnTo>
                  <a:lnTo>
                    <a:pt x="7" y="527626"/>
                  </a:lnTo>
                  <a:lnTo>
                    <a:pt x="7" y="525735"/>
                  </a:lnTo>
                  <a:lnTo>
                    <a:pt x="7" y="523844"/>
                  </a:lnTo>
                  <a:lnTo>
                    <a:pt x="8" y="521953"/>
                  </a:lnTo>
                  <a:lnTo>
                    <a:pt x="8" y="520062"/>
                  </a:lnTo>
                  <a:lnTo>
                    <a:pt x="8" y="518171"/>
                  </a:lnTo>
                  <a:lnTo>
                    <a:pt x="8" y="516279"/>
                  </a:lnTo>
                  <a:lnTo>
                    <a:pt x="8" y="514388"/>
                  </a:lnTo>
                  <a:lnTo>
                    <a:pt x="8" y="512497"/>
                  </a:lnTo>
                  <a:lnTo>
                    <a:pt x="9" y="510606"/>
                  </a:lnTo>
                  <a:lnTo>
                    <a:pt x="9" y="508715"/>
                  </a:lnTo>
                  <a:lnTo>
                    <a:pt x="9" y="506824"/>
                  </a:lnTo>
                  <a:lnTo>
                    <a:pt x="9" y="504933"/>
                  </a:lnTo>
                  <a:lnTo>
                    <a:pt x="9" y="503041"/>
                  </a:lnTo>
                  <a:lnTo>
                    <a:pt x="9" y="501150"/>
                  </a:lnTo>
                  <a:lnTo>
                    <a:pt x="9" y="499259"/>
                  </a:lnTo>
                  <a:lnTo>
                    <a:pt x="9" y="497368"/>
                  </a:lnTo>
                  <a:lnTo>
                    <a:pt x="9" y="495477"/>
                  </a:lnTo>
                  <a:lnTo>
                    <a:pt x="9" y="493586"/>
                  </a:lnTo>
                  <a:lnTo>
                    <a:pt x="9" y="491695"/>
                  </a:lnTo>
                  <a:lnTo>
                    <a:pt x="9" y="489804"/>
                  </a:lnTo>
                  <a:lnTo>
                    <a:pt x="9" y="487912"/>
                  </a:lnTo>
                  <a:lnTo>
                    <a:pt x="9" y="486021"/>
                  </a:lnTo>
                  <a:lnTo>
                    <a:pt x="9" y="484130"/>
                  </a:lnTo>
                  <a:lnTo>
                    <a:pt x="9" y="482239"/>
                  </a:lnTo>
                  <a:lnTo>
                    <a:pt x="9" y="480348"/>
                  </a:lnTo>
                  <a:lnTo>
                    <a:pt x="9" y="478457"/>
                  </a:lnTo>
                  <a:lnTo>
                    <a:pt x="9" y="476566"/>
                  </a:lnTo>
                  <a:lnTo>
                    <a:pt x="9" y="474674"/>
                  </a:lnTo>
                  <a:lnTo>
                    <a:pt x="9" y="472783"/>
                  </a:lnTo>
                  <a:lnTo>
                    <a:pt x="9" y="470892"/>
                  </a:lnTo>
                  <a:lnTo>
                    <a:pt x="9" y="469001"/>
                  </a:lnTo>
                  <a:lnTo>
                    <a:pt x="9" y="467110"/>
                  </a:lnTo>
                  <a:lnTo>
                    <a:pt x="9" y="465219"/>
                  </a:lnTo>
                  <a:lnTo>
                    <a:pt x="9" y="463328"/>
                  </a:lnTo>
                  <a:lnTo>
                    <a:pt x="9" y="461437"/>
                  </a:lnTo>
                  <a:lnTo>
                    <a:pt x="9" y="459545"/>
                  </a:lnTo>
                  <a:lnTo>
                    <a:pt x="8" y="457654"/>
                  </a:lnTo>
                  <a:lnTo>
                    <a:pt x="8" y="455763"/>
                  </a:lnTo>
                  <a:lnTo>
                    <a:pt x="8" y="453872"/>
                  </a:lnTo>
                  <a:lnTo>
                    <a:pt x="8" y="451981"/>
                  </a:lnTo>
                  <a:lnTo>
                    <a:pt x="8" y="450090"/>
                  </a:lnTo>
                  <a:lnTo>
                    <a:pt x="8" y="448199"/>
                  </a:lnTo>
                  <a:lnTo>
                    <a:pt x="8" y="446307"/>
                  </a:lnTo>
                  <a:lnTo>
                    <a:pt x="7" y="444416"/>
                  </a:lnTo>
                  <a:lnTo>
                    <a:pt x="7" y="442525"/>
                  </a:lnTo>
                  <a:lnTo>
                    <a:pt x="7" y="440634"/>
                  </a:lnTo>
                  <a:lnTo>
                    <a:pt x="7" y="438743"/>
                  </a:lnTo>
                  <a:lnTo>
                    <a:pt x="7" y="436852"/>
                  </a:lnTo>
                  <a:lnTo>
                    <a:pt x="6" y="434961"/>
                  </a:lnTo>
                  <a:lnTo>
                    <a:pt x="6" y="433069"/>
                  </a:lnTo>
                  <a:lnTo>
                    <a:pt x="6" y="431178"/>
                  </a:lnTo>
                  <a:lnTo>
                    <a:pt x="6" y="429287"/>
                  </a:lnTo>
                  <a:lnTo>
                    <a:pt x="6" y="427396"/>
                  </a:lnTo>
                  <a:lnTo>
                    <a:pt x="5" y="425505"/>
                  </a:lnTo>
                  <a:lnTo>
                    <a:pt x="5" y="423614"/>
                  </a:lnTo>
                  <a:lnTo>
                    <a:pt x="5" y="421723"/>
                  </a:lnTo>
                  <a:lnTo>
                    <a:pt x="5" y="419832"/>
                  </a:lnTo>
                  <a:lnTo>
                    <a:pt x="5" y="417940"/>
                  </a:lnTo>
                  <a:lnTo>
                    <a:pt x="4" y="416049"/>
                  </a:lnTo>
                  <a:lnTo>
                    <a:pt x="4" y="414158"/>
                  </a:lnTo>
                  <a:lnTo>
                    <a:pt x="4" y="412267"/>
                  </a:lnTo>
                  <a:lnTo>
                    <a:pt x="4" y="410376"/>
                  </a:lnTo>
                  <a:lnTo>
                    <a:pt x="4" y="408485"/>
                  </a:lnTo>
                  <a:lnTo>
                    <a:pt x="3" y="406594"/>
                  </a:lnTo>
                  <a:lnTo>
                    <a:pt x="3" y="404702"/>
                  </a:lnTo>
                  <a:lnTo>
                    <a:pt x="3" y="402811"/>
                  </a:lnTo>
                  <a:lnTo>
                    <a:pt x="3" y="400920"/>
                  </a:lnTo>
                  <a:lnTo>
                    <a:pt x="3" y="399029"/>
                  </a:lnTo>
                  <a:lnTo>
                    <a:pt x="3" y="397138"/>
                  </a:lnTo>
                  <a:lnTo>
                    <a:pt x="3" y="395247"/>
                  </a:lnTo>
                  <a:lnTo>
                    <a:pt x="3" y="393356"/>
                  </a:lnTo>
                  <a:lnTo>
                    <a:pt x="2" y="391465"/>
                  </a:lnTo>
                  <a:lnTo>
                    <a:pt x="2" y="389573"/>
                  </a:lnTo>
                  <a:lnTo>
                    <a:pt x="2" y="387682"/>
                  </a:lnTo>
                  <a:lnTo>
                    <a:pt x="2" y="385791"/>
                  </a:lnTo>
                  <a:lnTo>
                    <a:pt x="2" y="383900"/>
                  </a:lnTo>
                  <a:lnTo>
                    <a:pt x="2" y="382009"/>
                  </a:lnTo>
                  <a:lnTo>
                    <a:pt x="2" y="380118"/>
                  </a:lnTo>
                  <a:lnTo>
                    <a:pt x="2" y="378227"/>
                  </a:lnTo>
                  <a:lnTo>
                    <a:pt x="2" y="376335"/>
                  </a:lnTo>
                  <a:lnTo>
                    <a:pt x="2" y="374444"/>
                  </a:lnTo>
                  <a:lnTo>
                    <a:pt x="2" y="372553"/>
                  </a:lnTo>
                  <a:lnTo>
                    <a:pt x="2" y="370662"/>
                  </a:lnTo>
                  <a:lnTo>
                    <a:pt x="2" y="368771"/>
                  </a:lnTo>
                  <a:lnTo>
                    <a:pt x="2" y="366880"/>
                  </a:lnTo>
                  <a:lnTo>
                    <a:pt x="2" y="364989"/>
                  </a:lnTo>
                  <a:lnTo>
                    <a:pt x="3" y="363097"/>
                  </a:lnTo>
                  <a:lnTo>
                    <a:pt x="3" y="361206"/>
                  </a:lnTo>
                  <a:lnTo>
                    <a:pt x="3" y="359315"/>
                  </a:lnTo>
                  <a:lnTo>
                    <a:pt x="3" y="357424"/>
                  </a:lnTo>
                  <a:lnTo>
                    <a:pt x="3" y="355533"/>
                  </a:lnTo>
                  <a:lnTo>
                    <a:pt x="4" y="353642"/>
                  </a:lnTo>
                  <a:lnTo>
                    <a:pt x="4" y="351751"/>
                  </a:lnTo>
                  <a:lnTo>
                    <a:pt x="4" y="349860"/>
                  </a:lnTo>
                  <a:lnTo>
                    <a:pt x="4" y="347968"/>
                  </a:lnTo>
                  <a:lnTo>
                    <a:pt x="5" y="346077"/>
                  </a:lnTo>
                  <a:lnTo>
                    <a:pt x="5" y="344186"/>
                  </a:lnTo>
                  <a:lnTo>
                    <a:pt x="5" y="342295"/>
                  </a:lnTo>
                  <a:lnTo>
                    <a:pt x="6" y="340404"/>
                  </a:lnTo>
                  <a:lnTo>
                    <a:pt x="6" y="338513"/>
                  </a:lnTo>
                  <a:lnTo>
                    <a:pt x="7" y="336622"/>
                  </a:lnTo>
                  <a:lnTo>
                    <a:pt x="7" y="334730"/>
                  </a:lnTo>
                  <a:lnTo>
                    <a:pt x="8" y="332839"/>
                  </a:lnTo>
                  <a:lnTo>
                    <a:pt x="8" y="330948"/>
                  </a:lnTo>
                  <a:lnTo>
                    <a:pt x="9" y="329057"/>
                  </a:lnTo>
                  <a:lnTo>
                    <a:pt x="9" y="327166"/>
                  </a:lnTo>
                  <a:lnTo>
                    <a:pt x="10" y="325275"/>
                  </a:lnTo>
                  <a:lnTo>
                    <a:pt x="10" y="323384"/>
                  </a:lnTo>
                  <a:lnTo>
                    <a:pt x="11" y="321493"/>
                  </a:lnTo>
                  <a:lnTo>
                    <a:pt x="12" y="319601"/>
                  </a:lnTo>
                  <a:lnTo>
                    <a:pt x="12" y="317710"/>
                  </a:lnTo>
                  <a:lnTo>
                    <a:pt x="13" y="315819"/>
                  </a:lnTo>
                  <a:lnTo>
                    <a:pt x="14" y="313928"/>
                  </a:lnTo>
                  <a:lnTo>
                    <a:pt x="14" y="312037"/>
                  </a:lnTo>
                  <a:lnTo>
                    <a:pt x="15" y="310146"/>
                  </a:lnTo>
                  <a:lnTo>
                    <a:pt x="16" y="308255"/>
                  </a:lnTo>
                  <a:lnTo>
                    <a:pt x="17" y="306363"/>
                  </a:lnTo>
                  <a:lnTo>
                    <a:pt x="18" y="304472"/>
                  </a:lnTo>
                  <a:lnTo>
                    <a:pt x="19" y="302581"/>
                  </a:lnTo>
                  <a:lnTo>
                    <a:pt x="19" y="300690"/>
                  </a:lnTo>
                  <a:lnTo>
                    <a:pt x="20" y="298799"/>
                  </a:lnTo>
                  <a:lnTo>
                    <a:pt x="21" y="296908"/>
                  </a:lnTo>
                  <a:lnTo>
                    <a:pt x="22" y="295017"/>
                  </a:lnTo>
                  <a:lnTo>
                    <a:pt x="23" y="293125"/>
                  </a:lnTo>
                  <a:lnTo>
                    <a:pt x="24" y="291234"/>
                  </a:lnTo>
                  <a:lnTo>
                    <a:pt x="25" y="289343"/>
                  </a:lnTo>
                  <a:lnTo>
                    <a:pt x="26" y="287452"/>
                  </a:lnTo>
                  <a:lnTo>
                    <a:pt x="27" y="285561"/>
                  </a:lnTo>
                  <a:lnTo>
                    <a:pt x="28" y="283670"/>
                  </a:lnTo>
                  <a:lnTo>
                    <a:pt x="29" y="281779"/>
                  </a:lnTo>
                  <a:lnTo>
                    <a:pt x="30" y="279888"/>
                  </a:lnTo>
                  <a:lnTo>
                    <a:pt x="31" y="277996"/>
                  </a:lnTo>
                  <a:lnTo>
                    <a:pt x="32" y="276105"/>
                  </a:lnTo>
                  <a:lnTo>
                    <a:pt x="34" y="274214"/>
                  </a:lnTo>
                  <a:lnTo>
                    <a:pt x="35" y="272323"/>
                  </a:lnTo>
                  <a:lnTo>
                    <a:pt x="36" y="270432"/>
                  </a:lnTo>
                  <a:lnTo>
                    <a:pt x="37" y="268541"/>
                  </a:lnTo>
                  <a:lnTo>
                    <a:pt x="38" y="266650"/>
                  </a:lnTo>
                  <a:lnTo>
                    <a:pt x="39" y="264758"/>
                  </a:lnTo>
                  <a:lnTo>
                    <a:pt x="40" y="262867"/>
                  </a:lnTo>
                  <a:lnTo>
                    <a:pt x="42" y="260976"/>
                  </a:lnTo>
                  <a:lnTo>
                    <a:pt x="43" y="259085"/>
                  </a:lnTo>
                  <a:lnTo>
                    <a:pt x="44" y="257194"/>
                  </a:lnTo>
                  <a:lnTo>
                    <a:pt x="45" y="255303"/>
                  </a:lnTo>
                  <a:lnTo>
                    <a:pt x="47" y="253412"/>
                  </a:lnTo>
                  <a:lnTo>
                    <a:pt x="48" y="251520"/>
                  </a:lnTo>
                  <a:lnTo>
                    <a:pt x="49" y="249629"/>
                  </a:lnTo>
                  <a:lnTo>
                    <a:pt x="50" y="247738"/>
                  </a:lnTo>
                  <a:lnTo>
                    <a:pt x="52" y="245847"/>
                  </a:lnTo>
                  <a:lnTo>
                    <a:pt x="53" y="243956"/>
                  </a:lnTo>
                  <a:lnTo>
                    <a:pt x="54" y="242065"/>
                  </a:lnTo>
                  <a:lnTo>
                    <a:pt x="55" y="240174"/>
                  </a:lnTo>
                  <a:lnTo>
                    <a:pt x="57" y="238283"/>
                  </a:lnTo>
                  <a:lnTo>
                    <a:pt x="58" y="236391"/>
                  </a:lnTo>
                  <a:lnTo>
                    <a:pt x="59" y="234500"/>
                  </a:lnTo>
                  <a:lnTo>
                    <a:pt x="60" y="232609"/>
                  </a:lnTo>
                  <a:lnTo>
                    <a:pt x="62" y="230718"/>
                  </a:lnTo>
                  <a:lnTo>
                    <a:pt x="63" y="228827"/>
                  </a:lnTo>
                  <a:lnTo>
                    <a:pt x="64" y="226936"/>
                  </a:lnTo>
                  <a:lnTo>
                    <a:pt x="65" y="225045"/>
                  </a:lnTo>
                  <a:lnTo>
                    <a:pt x="67" y="223153"/>
                  </a:lnTo>
                  <a:lnTo>
                    <a:pt x="68" y="221262"/>
                  </a:lnTo>
                  <a:lnTo>
                    <a:pt x="69" y="219371"/>
                  </a:lnTo>
                  <a:lnTo>
                    <a:pt x="70" y="217480"/>
                  </a:lnTo>
                  <a:lnTo>
                    <a:pt x="72" y="215589"/>
                  </a:lnTo>
                  <a:lnTo>
                    <a:pt x="73" y="213698"/>
                  </a:lnTo>
                  <a:lnTo>
                    <a:pt x="74" y="211807"/>
                  </a:lnTo>
                  <a:lnTo>
                    <a:pt x="75" y="209916"/>
                  </a:lnTo>
                  <a:lnTo>
                    <a:pt x="76" y="208024"/>
                  </a:lnTo>
                  <a:lnTo>
                    <a:pt x="78" y="206133"/>
                  </a:lnTo>
                  <a:lnTo>
                    <a:pt x="79" y="204242"/>
                  </a:lnTo>
                  <a:lnTo>
                    <a:pt x="80" y="202351"/>
                  </a:lnTo>
                  <a:lnTo>
                    <a:pt x="81" y="200460"/>
                  </a:lnTo>
                  <a:lnTo>
                    <a:pt x="82" y="198569"/>
                  </a:lnTo>
                  <a:lnTo>
                    <a:pt x="83" y="196678"/>
                  </a:lnTo>
                  <a:lnTo>
                    <a:pt x="84" y="194786"/>
                  </a:lnTo>
                  <a:lnTo>
                    <a:pt x="86" y="192895"/>
                  </a:lnTo>
                  <a:lnTo>
                    <a:pt x="87" y="191004"/>
                  </a:lnTo>
                  <a:lnTo>
                    <a:pt x="88" y="189113"/>
                  </a:lnTo>
                  <a:lnTo>
                    <a:pt x="89" y="187222"/>
                  </a:lnTo>
                  <a:lnTo>
                    <a:pt x="90" y="185331"/>
                  </a:lnTo>
                  <a:lnTo>
                    <a:pt x="91" y="183440"/>
                  </a:lnTo>
                  <a:lnTo>
                    <a:pt x="92" y="181548"/>
                  </a:lnTo>
                  <a:lnTo>
                    <a:pt x="93" y="179657"/>
                  </a:lnTo>
                  <a:lnTo>
                    <a:pt x="94" y="177766"/>
                  </a:lnTo>
                  <a:lnTo>
                    <a:pt x="95" y="175875"/>
                  </a:lnTo>
                  <a:lnTo>
                    <a:pt x="96" y="173984"/>
                  </a:lnTo>
                  <a:lnTo>
                    <a:pt x="97" y="172093"/>
                  </a:lnTo>
                  <a:lnTo>
                    <a:pt x="98" y="170202"/>
                  </a:lnTo>
                  <a:lnTo>
                    <a:pt x="99" y="168311"/>
                  </a:lnTo>
                  <a:lnTo>
                    <a:pt x="100" y="166419"/>
                  </a:lnTo>
                  <a:lnTo>
                    <a:pt x="101" y="164528"/>
                  </a:lnTo>
                  <a:lnTo>
                    <a:pt x="101" y="162637"/>
                  </a:lnTo>
                  <a:lnTo>
                    <a:pt x="102" y="160746"/>
                  </a:lnTo>
                  <a:lnTo>
                    <a:pt x="103" y="158855"/>
                  </a:lnTo>
                  <a:lnTo>
                    <a:pt x="104" y="156964"/>
                  </a:lnTo>
                  <a:lnTo>
                    <a:pt x="105" y="155073"/>
                  </a:lnTo>
                  <a:lnTo>
                    <a:pt x="106" y="153181"/>
                  </a:lnTo>
                  <a:lnTo>
                    <a:pt x="106" y="151290"/>
                  </a:lnTo>
                  <a:lnTo>
                    <a:pt x="107" y="149399"/>
                  </a:lnTo>
                  <a:lnTo>
                    <a:pt x="108" y="147508"/>
                  </a:lnTo>
                  <a:lnTo>
                    <a:pt x="109" y="145617"/>
                  </a:lnTo>
                  <a:lnTo>
                    <a:pt x="109" y="143726"/>
                  </a:lnTo>
                  <a:lnTo>
                    <a:pt x="110" y="141835"/>
                  </a:lnTo>
                  <a:lnTo>
                    <a:pt x="111" y="139944"/>
                  </a:lnTo>
                  <a:lnTo>
                    <a:pt x="111" y="138052"/>
                  </a:lnTo>
                  <a:lnTo>
                    <a:pt x="112" y="136161"/>
                  </a:lnTo>
                  <a:lnTo>
                    <a:pt x="113" y="134270"/>
                  </a:lnTo>
                  <a:lnTo>
                    <a:pt x="113" y="132379"/>
                  </a:lnTo>
                  <a:lnTo>
                    <a:pt x="114" y="130488"/>
                  </a:lnTo>
                  <a:lnTo>
                    <a:pt x="115" y="128597"/>
                  </a:lnTo>
                  <a:lnTo>
                    <a:pt x="115" y="126706"/>
                  </a:lnTo>
                  <a:lnTo>
                    <a:pt x="116" y="124814"/>
                  </a:lnTo>
                  <a:lnTo>
                    <a:pt x="116" y="122923"/>
                  </a:lnTo>
                  <a:lnTo>
                    <a:pt x="117" y="121032"/>
                  </a:lnTo>
                  <a:lnTo>
                    <a:pt x="117" y="119141"/>
                  </a:lnTo>
                  <a:lnTo>
                    <a:pt x="118" y="117250"/>
                  </a:lnTo>
                  <a:lnTo>
                    <a:pt x="118" y="115359"/>
                  </a:lnTo>
                  <a:lnTo>
                    <a:pt x="119" y="113468"/>
                  </a:lnTo>
                  <a:lnTo>
                    <a:pt x="119" y="111576"/>
                  </a:lnTo>
                  <a:lnTo>
                    <a:pt x="120" y="109685"/>
                  </a:lnTo>
                  <a:lnTo>
                    <a:pt x="120" y="107794"/>
                  </a:lnTo>
                  <a:lnTo>
                    <a:pt x="121" y="105903"/>
                  </a:lnTo>
                  <a:lnTo>
                    <a:pt x="121" y="104012"/>
                  </a:lnTo>
                  <a:lnTo>
                    <a:pt x="122" y="102121"/>
                  </a:lnTo>
                  <a:lnTo>
                    <a:pt x="122" y="100230"/>
                  </a:lnTo>
                  <a:lnTo>
                    <a:pt x="122" y="98339"/>
                  </a:lnTo>
                  <a:lnTo>
                    <a:pt x="123" y="96447"/>
                  </a:lnTo>
                  <a:lnTo>
                    <a:pt x="123" y="94556"/>
                  </a:lnTo>
                  <a:lnTo>
                    <a:pt x="123" y="92665"/>
                  </a:lnTo>
                  <a:lnTo>
                    <a:pt x="124" y="90774"/>
                  </a:lnTo>
                  <a:lnTo>
                    <a:pt x="124" y="88883"/>
                  </a:lnTo>
                  <a:lnTo>
                    <a:pt x="124" y="86992"/>
                  </a:lnTo>
                  <a:lnTo>
                    <a:pt x="125" y="85101"/>
                  </a:lnTo>
                  <a:lnTo>
                    <a:pt x="125" y="83209"/>
                  </a:lnTo>
                  <a:lnTo>
                    <a:pt x="125" y="81318"/>
                  </a:lnTo>
                  <a:lnTo>
                    <a:pt x="125" y="79427"/>
                  </a:lnTo>
                  <a:lnTo>
                    <a:pt x="126" y="77536"/>
                  </a:lnTo>
                  <a:lnTo>
                    <a:pt x="126" y="75645"/>
                  </a:lnTo>
                  <a:lnTo>
                    <a:pt x="126" y="73754"/>
                  </a:lnTo>
                  <a:lnTo>
                    <a:pt x="126" y="71863"/>
                  </a:lnTo>
                  <a:lnTo>
                    <a:pt x="127" y="69972"/>
                  </a:lnTo>
                  <a:lnTo>
                    <a:pt x="127" y="68080"/>
                  </a:lnTo>
                  <a:lnTo>
                    <a:pt x="127" y="66189"/>
                  </a:lnTo>
                  <a:lnTo>
                    <a:pt x="127" y="64298"/>
                  </a:lnTo>
                  <a:lnTo>
                    <a:pt x="128" y="62407"/>
                  </a:lnTo>
                  <a:lnTo>
                    <a:pt x="128" y="60516"/>
                  </a:lnTo>
                  <a:lnTo>
                    <a:pt x="128" y="58625"/>
                  </a:lnTo>
                  <a:lnTo>
                    <a:pt x="128" y="56734"/>
                  </a:lnTo>
                  <a:lnTo>
                    <a:pt x="128" y="54842"/>
                  </a:lnTo>
                  <a:lnTo>
                    <a:pt x="128" y="52951"/>
                  </a:lnTo>
                  <a:lnTo>
                    <a:pt x="129" y="51060"/>
                  </a:lnTo>
                  <a:lnTo>
                    <a:pt x="129" y="49169"/>
                  </a:lnTo>
                  <a:lnTo>
                    <a:pt x="129" y="47278"/>
                  </a:lnTo>
                  <a:lnTo>
                    <a:pt x="129" y="45387"/>
                  </a:lnTo>
                  <a:lnTo>
                    <a:pt x="129" y="43496"/>
                  </a:lnTo>
                  <a:lnTo>
                    <a:pt x="129" y="41604"/>
                  </a:lnTo>
                  <a:lnTo>
                    <a:pt x="129" y="39713"/>
                  </a:lnTo>
                  <a:lnTo>
                    <a:pt x="130" y="37822"/>
                  </a:lnTo>
                  <a:lnTo>
                    <a:pt x="130" y="35931"/>
                  </a:lnTo>
                  <a:lnTo>
                    <a:pt x="130" y="34040"/>
                  </a:lnTo>
                  <a:lnTo>
                    <a:pt x="130" y="32149"/>
                  </a:lnTo>
                  <a:lnTo>
                    <a:pt x="130" y="30258"/>
                  </a:lnTo>
                  <a:lnTo>
                    <a:pt x="130" y="28367"/>
                  </a:lnTo>
                  <a:lnTo>
                    <a:pt x="130" y="26475"/>
                  </a:lnTo>
                  <a:lnTo>
                    <a:pt x="130" y="24584"/>
                  </a:lnTo>
                  <a:lnTo>
                    <a:pt x="130" y="22693"/>
                  </a:lnTo>
                  <a:lnTo>
                    <a:pt x="130" y="20802"/>
                  </a:lnTo>
                  <a:lnTo>
                    <a:pt x="130" y="18911"/>
                  </a:lnTo>
                  <a:lnTo>
                    <a:pt x="131" y="17020"/>
                  </a:lnTo>
                  <a:lnTo>
                    <a:pt x="131" y="15129"/>
                  </a:lnTo>
                  <a:lnTo>
                    <a:pt x="131" y="13237"/>
                  </a:lnTo>
                  <a:lnTo>
                    <a:pt x="131" y="11346"/>
                  </a:lnTo>
                  <a:lnTo>
                    <a:pt x="131" y="9455"/>
                  </a:lnTo>
                  <a:lnTo>
                    <a:pt x="131" y="7564"/>
                  </a:lnTo>
                  <a:lnTo>
                    <a:pt x="131" y="5673"/>
                  </a:lnTo>
                  <a:lnTo>
                    <a:pt x="131" y="3782"/>
                  </a:lnTo>
                  <a:lnTo>
                    <a:pt x="131" y="1891"/>
                  </a:lnTo>
                  <a:lnTo>
                    <a:pt x="131" y="0"/>
                  </a:lnTo>
                  <a:lnTo>
                    <a:pt x="132" y="0"/>
                  </a:lnTo>
                  <a:lnTo>
                    <a:pt x="132" y="966370"/>
                  </a:lnTo>
                  <a:lnTo>
                    <a:pt x="132" y="96637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41" name="pl23"/>
            <p:cNvSpPr/>
            <p:nvPr/>
          </p:nvSpPr>
          <p:spPr>
            <a:xfrm>
              <a:off x="3085090" y="3434678"/>
              <a:ext cx="618" cy="271431"/>
            </a:xfrm>
            <a:custGeom>
              <a:avLst/>
              <a:gdLst/>
              <a:ahLst/>
              <a:cxnLst/>
              <a:rect l="0" t="0" r="0" b="0"/>
              <a:pathLst>
                <a:path w="618" h="271431">
                  <a:moveTo>
                    <a:pt x="0" y="0"/>
                  </a:moveTo>
                  <a:lnTo>
                    <a:pt x="3" y="0"/>
                  </a:lnTo>
                  <a:lnTo>
                    <a:pt x="3" y="531"/>
                  </a:lnTo>
                  <a:lnTo>
                    <a:pt x="3" y="1062"/>
                  </a:lnTo>
                  <a:lnTo>
                    <a:pt x="3" y="1593"/>
                  </a:lnTo>
                  <a:lnTo>
                    <a:pt x="4" y="2124"/>
                  </a:lnTo>
                  <a:lnTo>
                    <a:pt x="4" y="2655"/>
                  </a:lnTo>
                  <a:lnTo>
                    <a:pt x="4" y="3187"/>
                  </a:lnTo>
                  <a:lnTo>
                    <a:pt x="5" y="3718"/>
                  </a:lnTo>
                  <a:lnTo>
                    <a:pt x="5" y="4249"/>
                  </a:lnTo>
                  <a:lnTo>
                    <a:pt x="6" y="4780"/>
                  </a:lnTo>
                  <a:lnTo>
                    <a:pt x="6" y="5311"/>
                  </a:lnTo>
                  <a:lnTo>
                    <a:pt x="6" y="5842"/>
                  </a:lnTo>
                  <a:lnTo>
                    <a:pt x="7" y="6374"/>
                  </a:lnTo>
                  <a:lnTo>
                    <a:pt x="8" y="6905"/>
                  </a:lnTo>
                  <a:lnTo>
                    <a:pt x="8" y="7436"/>
                  </a:lnTo>
                  <a:lnTo>
                    <a:pt x="9" y="7967"/>
                  </a:lnTo>
                  <a:lnTo>
                    <a:pt x="9" y="8498"/>
                  </a:lnTo>
                  <a:lnTo>
                    <a:pt x="10" y="9030"/>
                  </a:lnTo>
                  <a:lnTo>
                    <a:pt x="11" y="9561"/>
                  </a:lnTo>
                  <a:lnTo>
                    <a:pt x="11" y="10092"/>
                  </a:lnTo>
                  <a:lnTo>
                    <a:pt x="12" y="10623"/>
                  </a:lnTo>
                  <a:lnTo>
                    <a:pt x="13" y="11154"/>
                  </a:lnTo>
                  <a:lnTo>
                    <a:pt x="14" y="11685"/>
                  </a:lnTo>
                  <a:lnTo>
                    <a:pt x="15" y="12217"/>
                  </a:lnTo>
                  <a:lnTo>
                    <a:pt x="16" y="12748"/>
                  </a:lnTo>
                  <a:lnTo>
                    <a:pt x="17" y="13279"/>
                  </a:lnTo>
                  <a:lnTo>
                    <a:pt x="18" y="13810"/>
                  </a:lnTo>
                  <a:lnTo>
                    <a:pt x="19" y="14341"/>
                  </a:lnTo>
                  <a:lnTo>
                    <a:pt x="20" y="14872"/>
                  </a:lnTo>
                  <a:lnTo>
                    <a:pt x="22" y="15404"/>
                  </a:lnTo>
                  <a:lnTo>
                    <a:pt x="23" y="15935"/>
                  </a:lnTo>
                  <a:lnTo>
                    <a:pt x="24" y="16466"/>
                  </a:lnTo>
                  <a:lnTo>
                    <a:pt x="26" y="16997"/>
                  </a:lnTo>
                  <a:lnTo>
                    <a:pt x="27" y="17528"/>
                  </a:lnTo>
                  <a:lnTo>
                    <a:pt x="29" y="18060"/>
                  </a:lnTo>
                  <a:lnTo>
                    <a:pt x="31" y="18591"/>
                  </a:lnTo>
                  <a:lnTo>
                    <a:pt x="32" y="19122"/>
                  </a:lnTo>
                  <a:lnTo>
                    <a:pt x="34" y="19653"/>
                  </a:lnTo>
                  <a:lnTo>
                    <a:pt x="36" y="20184"/>
                  </a:lnTo>
                  <a:lnTo>
                    <a:pt x="38" y="20715"/>
                  </a:lnTo>
                  <a:lnTo>
                    <a:pt x="40" y="21247"/>
                  </a:lnTo>
                  <a:lnTo>
                    <a:pt x="42" y="21778"/>
                  </a:lnTo>
                  <a:lnTo>
                    <a:pt x="44" y="22309"/>
                  </a:lnTo>
                  <a:lnTo>
                    <a:pt x="47" y="22840"/>
                  </a:lnTo>
                  <a:lnTo>
                    <a:pt x="49" y="23371"/>
                  </a:lnTo>
                  <a:lnTo>
                    <a:pt x="51" y="23902"/>
                  </a:lnTo>
                  <a:lnTo>
                    <a:pt x="54" y="24434"/>
                  </a:lnTo>
                  <a:lnTo>
                    <a:pt x="56" y="24965"/>
                  </a:lnTo>
                  <a:lnTo>
                    <a:pt x="59" y="25496"/>
                  </a:lnTo>
                  <a:lnTo>
                    <a:pt x="62" y="26027"/>
                  </a:lnTo>
                  <a:lnTo>
                    <a:pt x="65" y="26558"/>
                  </a:lnTo>
                  <a:lnTo>
                    <a:pt x="67" y="27090"/>
                  </a:lnTo>
                  <a:lnTo>
                    <a:pt x="71" y="27621"/>
                  </a:lnTo>
                  <a:lnTo>
                    <a:pt x="74" y="28152"/>
                  </a:lnTo>
                  <a:lnTo>
                    <a:pt x="77" y="28683"/>
                  </a:lnTo>
                  <a:lnTo>
                    <a:pt x="80" y="29214"/>
                  </a:lnTo>
                  <a:lnTo>
                    <a:pt x="83" y="29745"/>
                  </a:lnTo>
                  <a:lnTo>
                    <a:pt x="87" y="30277"/>
                  </a:lnTo>
                  <a:lnTo>
                    <a:pt x="90" y="30808"/>
                  </a:lnTo>
                  <a:lnTo>
                    <a:pt x="94" y="31339"/>
                  </a:lnTo>
                  <a:lnTo>
                    <a:pt x="97" y="31870"/>
                  </a:lnTo>
                  <a:lnTo>
                    <a:pt x="101" y="32401"/>
                  </a:lnTo>
                  <a:lnTo>
                    <a:pt x="105" y="32932"/>
                  </a:lnTo>
                  <a:lnTo>
                    <a:pt x="109" y="33464"/>
                  </a:lnTo>
                  <a:lnTo>
                    <a:pt x="112" y="33995"/>
                  </a:lnTo>
                  <a:lnTo>
                    <a:pt x="116" y="34526"/>
                  </a:lnTo>
                  <a:lnTo>
                    <a:pt x="120" y="35057"/>
                  </a:lnTo>
                  <a:lnTo>
                    <a:pt x="124" y="35588"/>
                  </a:lnTo>
                  <a:lnTo>
                    <a:pt x="129" y="36120"/>
                  </a:lnTo>
                  <a:lnTo>
                    <a:pt x="133" y="36651"/>
                  </a:lnTo>
                  <a:lnTo>
                    <a:pt x="137" y="37182"/>
                  </a:lnTo>
                  <a:lnTo>
                    <a:pt x="141" y="37713"/>
                  </a:lnTo>
                  <a:lnTo>
                    <a:pt x="145" y="38244"/>
                  </a:lnTo>
                  <a:lnTo>
                    <a:pt x="150" y="38775"/>
                  </a:lnTo>
                  <a:lnTo>
                    <a:pt x="154" y="39307"/>
                  </a:lnTo>
                  <a:lnTo>
                    <a:pt x="158" y="39838"/>
                  </a:lnTo>
                  <a:lnTo>
                    <a:pt x="163" y="40369"/>
                  </a:lnTo>
                  <a:lnTo>
                    <a:pt x="167" y="40900"/>
                  </a:lnTo>
                  <a:lnTo>
                    <a:pt x="171" y="41431"/>
                  </a:lnTo>
                  <a:lnTo>
                    <a:pt x="176" y="41962"/>
                  </a:lnTo>
                  <a:lnTo>
                    <a:pt x="180" y="42494"/>
                  </a:lnTo>
                  <a:lnTo>
                    <a:pt x="184" y="43025"/>
                  </a:lnTo>
                  <a:lnTo>
                    <a:pt x="188" y="43556"/>
                  </a:lnTo>
                  <a:lnTo>
                    <a:pt x="193" y="44087"/>
                  </a:lnTo>
                  <a:lnTo>
                    <a:pt x="197" y="44618"/>
                  </a:lnTo>
                  <a:lnTo>
                    <a:pt x="201" y="45150"/>
                  </a:lnTo>
                  <a:lnTo>
                    <a:pt x="205" y="45681"/>
                  </a:lnTo>
                  <a:lnTo>
                    <a:pt x="209" y="46212"/>
                  </a:lnTo>
                  <a:lnTo>
                    <a:pt x="213" y="46743"/>
                  </a:lnTo>
                  <a:lnTo>
                    <a:pt x="217" y="47274"/>
                  </a:lnTo>
                  <a:lnTo>
                    <a:pt x="221" y="47805"/>
                  </a:lnTo>
                  <a:lnTo>
                    <a:pt x="225" y="48337"/>
                  </a:lnTo>
                  <a:lnTo>
                    <a:pt x="228" y="48868"/>
                  </a:lnTo>
                  <a:lnTo>
                    <a:pt x="232" y="49399"/>
                  </a:lnTo>
                  <a:lnTo>
                    <a:pt x="235" y="49930"/>
                  </a:lnTo>
                  <a:lnTo>
                    <a:pt x="239" y="50461"/>
                  </a:lnTo>
                  <a:lnTo>
                    <a:pt x="242" y="50992"/>
                  </a:lnTo>
                  <a:lnTo>
                    <a:pt x="245" y="51524"/>
                  </a:lnTo>
                  <a:lnTo>
                    <a:pt x="248" y="52055"/>
                  </a:lnTo>
                  <a:lnTo>
                    <a:pt x="251" y="52586"/>
                  </a:lnTo>
                  <a:lnTo>
                    <a:pt x="253" y="53117"/>
                  </a:lnTo>
                  <a:lnTo>
                    <a:pt x="256" y="53648"/>
                  </a:lnTo>
                  <a:lnTo>
                    <a:pt x="258" y="54180"/>
                  </a:lnTo>
                  <a:lnTo>
                    <a:pt x="261" y="54711"/>
                  </a:lnTo>
                  <a:lnTo>
                    <a:pt x="263" y="55242"/>
                  </a:lnTo>
                  <a:lnTo>
                    <a:pt x="265" y="55773"/>
                  </a:lnTo>
                  <a:lnTo>
                    <a:pt x="266" y="56304"/>
                  </a:lnTo>
                  <a:lnTo>
                    <a:pt x="268" y="56835"/>
                  </a:lnTo>
                  <a:lnTo>
                    <a:pt x="269" y="57367"/>
                  </a:lnTo>
                  <a:lnTo>
                    <a:pt x="271" y="57898"/>
                  </a:lnTo>
                  <a:lnTo>
                    <a:pt x="272" y="58429"/>
                  </a:lnTo>
                  <a:lnTo>
                    <a:pt x="273" y="58960"/>
                  </a:lnTo>
                  <a:lnTo>
                    <a:pt x="273" y="59491"/>
                  </a:lnTo>
                  <a:lnTo>
                    <a:pt x="274" y="60022"/>
                  </a:lnTo>
                  <a:lnTo>
                    <a:pt x="274" y="60554"/>
                  </a:lnTo>
                  <a:lnTo>
                    <a:pt x="274" y="61085"/>
                  </a:lnTo>
                  <a:lnTo>
                    <a:pt x="274" y="61616"/>
                  </a:lnTo>
                  <a:lnTo>
                    <a:pt x="274" y="62147"/>
                  </a:lnTo>
                  <a:lnTo>
                    <a:pt x="274" y="62678"/>
                  </a:lnTo>
                  <a:lnTo>
                    <a:pt x="273" y="63210"/>
                  </a:lnTo>
                  <a:lnTo>
                    <a:pt x="272" y="63741"/>
                  </a:lnTo>
                  <a:lnTo>
                    <a:pt x="271" y="64272"/>
                  </a:lnTo>
                  <a:lnTo>
                    <a:pt x="270" y="64803"/>
                  </a:lnTo>
                  <a:lnTo>
                    <a:pt x="269" y="65334"/>
                  </a:lnTo>
                  <a:lnTo>
                    <a:pt x="267" y="65865"/>
                  </a:lnTo>
                  <a:lnTo>
                    <a:pt x="266" y="66397"/>
                  </a:lnTo>
                  <a:lnTo>
                    <a:pt x="264" y="66928"/>
                  </a:lnTo>
                  <a:lnTo>
                    <a:pt x="262" y="67459"/>
                  </a:lnTo>
                  <a:lnTo>
                    <a:pt x="260" y="67990"/>
                  </a:lnTo>
                  <a:lnTo>
                    <a:pt x="257" y="68521"/>
                  </a:lnTo>
                  <a:lnTo>
                    <a:pt x="255" y="69052"/>
                  </a:lnTo>
                  <a:lnTo>
                    <a:pt x="252" y="69584"/>
                  </a:lnTo>
                  <a:lnTo>
                    <a:pt x="250" y="70115"/>
                  </a:lnTo>
                  <a:lnTo>
                    <a:pt x="247" y="70646"/>
                  </a:lnTo>
                  <a:lnTo>
                    <a:pt x="244" y="71177"/>
                  </a:lnTo>
                  <a:lnTo>
                    <a:pt x="241" y="71708"/>
                  </a:lnTo>
                  <a:lnTo>
                    <a:pt x="237" y="72240"/>
                  </a:lnTo>
                  <a:lnTo>
                    <a:pt x="234" y="72771"/>
                  </a:lnTo>
                  <a:lnTo>
                    <a:pt x="231" y="73302"/>
                  </a:lnTo>
                  <a:lnTo>
                    <a:pt x="227" y="73833"/>
                  </a:lnTo>
                  <a:lnTo>
                    <a:pt x="223" y="74364"/>
                  </a:lnTo>
                  <a:lnTo>
                    <a:pt x="220" y="74895"/>
                  </a:lnTo>
                  <a:lnTo>
                    <a:pt x="216" y="75427"/>
                  </a:lnTo>
                  <a:lnTo>
                    <a:pt x="212" y="75958"/>
                  </a:lnTo>
                  <a:lnTo>
                    <a:pt x="208" y="76489"/>
                  </a:lnTo>
                  <a:lnTo>
                    <a:pt x="204" y="77020"/>
                  </a:lnTo>
                  <a:lnTo>
                    <a:pt x="200" y="77551"/>
                  </a:lnTo>
                  <a:lnTo>
                    <a:pt x="196" y="78082"/>
                  </a:lnTo>
                  <a:lnTo>
                    <a:pt x="192" y="78614"/>
                  </a:lnTo>
                  <a:lnTo>
                    <a:pt x="187" y="79145"/>
                  </a:lnTo>
                  <a:lnTo>
                    <a:pt x="183" y="79676"/>
                  </a:lnTo>
                  <a:lnTo>
                    <a:pt x="179" y="80207"/>
                  </a:lnTo>
                  <a:lnTo>
                    <a:pt x="175" y="80738"/>
                  </a:lnTo>
                  <a:lnTo>
                    <a:pt x="170" y="81270"/>
                  </a:lnTo>
                  <a:lnTo>
                    <a:pt x="166" y="81801"/>
                  </a:lnTo>
                  <a:lnTo>
                    <a:pt x="162" y="82332"/>
                  </a:lnTo>
                  <a:lnTo>
                    <a:pt x="158" y="82863"/>
                  </a:lnTo>
                  <a:lnTo>
                    <a:pt x="153" y="83394"/>
                  </a:lnTo>
                  <a:lnTo>
                    <a:pt x="149" y="83925"/>
                  </a:lnTo>
                  <a:lnTo>
                    <a:pt x="145" y="84457"/>
                  </a:lnTo>
                  <a:lnTo>
                    <a:pt x="141" y="84988"/>
                  </a:lnTo>
                  <a:lnTo>
                    <a:pt x="137" y="85519"/>
                  </a:lnTo>
                  <a:lnTo>
                    <a:pt x="133" y="86050"/>
                  </a:lnTo>
                  <a:lnTo>
                    <a:pt x="129" y="86581"/>
                  </a:lnTo>
                  <a:lnTo>
                    <a:pt x="125" y="87112"/>
                  </a:lnTo>
                  <a:lnTo>
                    <a:pt x="121" y="87644"/>
                  </a:lnTo>
                  <a:lnTo>
                    <a:pt x="118" y="88175"/>
                  </a:lnTo>
                  <a:lnTo>
                    <a:pt x="114" y="88706"/>
                  </a:lnTo>
                  <a:lnTo>
                    <a:pt x="110" y="89237"/>
                  </a:lnTo>
                  <a:lnTo>
                    <a:pt x="107" y="89768"/>
                  </a:lnTo>
                  <a:lnTo>
                    <a:pt x="103" y="90300"/>
                  </a:lnTo>
                  <a:lnTo>
                    <a:pt x="100" y="90831"/>
                  </a:lnTo>
                  <a:lnTo>
                    <a:pt x="97" y="91362"/>
                  </a:lnTo>
                  <a:lnTo>
                    <a:pt x="94" y="91893"/>
                  </a:lnTo>
                  <a:lnTo>
                    <a:pt x="91" y="92424"/>
                  </a:lnTo>
                  <a:lnTo>
                    <a:pt x="88" y="92955"/>
                  </a:lnTo>
                  <a:lnTo>
                    <a:pt x="85" y="93487"/>
                  </a:lnTo>
                  <a:lnTo>
                    <a:pt x="82" y="94018"/>
                  </a:lnTo>
                  <a:lnTo>
                    <a:pt x="79" y="94549"/>
                  </a:lnTo>
                  <a:lnTo>
                    <a:pt x="77" y="95080"/>
                  </a:lnTo>
                  <a:lnTo>
                    <a:pt x="74" y="95611"/>
                  </a:lnTo>
                  <a:lnTo>
                    <a:pt x="72" y="96142"/>
                  </a:lnTo>
                  <a:lnTo>
                    <a:pt x="70" y="96674"/>
                  </a:lnTo>
                  <a:lnTo>
                    <a:pt x="68" y="97205"/>
                  </a:lnTo>
                  <a:lnTo>
                    <a:pt x="66" y="97736"/>
                  </a:lnTo>
                  <a:lnTo>
                    <a:pt x="64" y="98267"/>
                  </a:lnTo>
                  <a:lnTo>
                    <a:pt x="63" y="98798"/>
                  </a:lnTo>
                  <a:lnTo>
                    <a:pt x="61" y="99330"/>
                  </a:lnTo>
                  <a:lnTo>
                    <a:pt x="60" y="99861"/>
                  </a:lnTo>
                  <a:lnTo>
                    <a:pt x="59" y="100392"/>
                  </a:lnTo>
                  <a:lnTo>
                    <a:pt x="58" y="100923"/>
                  </a:lnTo>
                  <a:lnTo>
                    <a:pt x="57" y="101454"/>
                  </a:lnTo>
                  <a:lnTo>
                    <a:pt x="56" y="101985"/>
                  </a:lnTo>
                  <a:lnTo>
                    <a:pt x="55" y="102517"/>
                  </a:lnTo>
                  <a:lnTo>
                    <a:pt x="55" y="103048"/>
                  </a:lnTo>
                  <a:lnTo>
                    <a:pt x="54" y="103579"/>
                  </a:lnTo>
                  <a:lnTo>
                    <a:pt x="54" y="104110"/>
                  </a:lnTo>
                  <a:lnTo>
                    <a:pt x="54" y="104641"/>
                  </a:lnTo>
                  <a:lnTo>
                    <a:pt x="54" y="105172"/>
                  </a:lnTo>
                  <a:lnTo>
                    <a:pt x="55" y="105704"/>
                  </a:lnTo>
                  <a:lnTo>
                    <a:pt x="55" y="106235"/>
                  </a:lnTo>
                  <a:lnTo>
                    <a:pt x="56" y="106766"/>
                  </a:lnTo>
                  <a:lnTo>
                    <a:pt x="56" y="107297"/>
                  </a:lnTo>
                  <a:lnTo>
                    <a:pt x="57" y="107828"/>
                  </a:lnTo>
                  <a:lnTo>
                    <a:pt x="58" y="108360"/>
                  </a:lnTo>
                  <a:lnTo>
                    <a:pt x="59" y="108891"/>
                  </a:lnTo>
                  <a:lnTo>
                    <a:pt x="61" y="109422"/>
                  </a:lnTo>
                  <a:lnTo>
                    <a:pt x="62" y="109953"/>
                  </a:lnTo>
                  <a:lnTo>
                    <a:pt x="64" y="110484"/>
                  </a:lnTo>
                  <a:lnTo>
                    <a:pt x="66" y="111015"/>
                  </a:lnTo>
                  <a:lnTo>
                    <a:pt x="68" y="111547"/>
                  </a:lnTo>
                  <a:lnTo>
                    <a:pt x="70" y="112078"/>
                  </a:lnTo>
                  <a:lnTo>
                    <a:pt x="73" y="112609"/>
                  </a:lnTo>
                  <a:lnTo>
                    <a:pt x="75" y="113140"/>
                  </a:lnTo>
                  <a:lnTo>
                    <a:pt x="78" y="113671"/>
                  </a:lnTo>
                  <a:lnTo>
                    <a:pt x="81" y="114202"/>
                  </a:lnTo>
                  <a:lnTo>
                    <a:pt x="84" y="114734"/>
                  </a:lnTo>
                  <a:lnTo>
                    <a:pt x="87" y="115265"/>
                  </a:lnTo>
                  <a:lnTo>
                    <a:pt x="91" y="115796"/>
                  </a:lnTo>
                  <a:lnTo>
                    <a:pt x="94" y="116327"/>
                  </a:lnTo>
                  <a:lnTo>
                    <a:pt x="98" y="116858"/>
                  </a:lnTo>
                  <a:lnTo>
                    <a:pt x="102" y="117390"/>
                  </a:lnTo>
                  <a:lnTo>
                    <a:pt x="106" y="117921"/>
                  </a:lnTo>
                  <a:lnTo>
                    <a:pt x="111" y="118452"/>
                  </a:lnTo>
                  <a:lnTo>
                    <a:pt x="115" y="118983"/>
                  </a:lnTo>
                  <a:lnTo>
                    <a:pt x="120" y="119514"/>
                  </a:lnTo>
                  <a:lnTo>
                    <a:pt x="125" y="120045"/>
                  </a:lnTo>
                  <a:lnTo>
                    <a:pt x="130" y="120577"/>
                  </a:lnTo>
                  <a:lnTo>
                    <a:pt x="135" y="121108"/>
                  </a:lnTo>
                  <a:lnTo>
                    <a:pt x="140" y="121639"/>
                  </a:lnTo>
                  <a:lnTo>
                    <a:pt x="146" y="122170"/>
                  </a:lnTo>
                  <a:lnTo>
                    <a:pt x="152" y="122701"/>
                  </a:lnTo>
                  <a:lnTo>
                    <a:pt x="158" y="123232"/>
                  </a:lnTo>
                  <a:lnTo>
                    <a:pt x="164" y="123764"/>
                  </a:lnTo>
                  <a:lnTo>
                    <a:pt x="170" y="124295"/>
                  </a:lnTo>
                  <a:lnTo>
                    <a:pt x="176" y="124826"/>
                  </a:lnTo>
                  <a:lnTo>
                    <a:pt x="183" y="125357"/>
                  </a:lnTo>
                  <a:lnTo>
                    <a:pt x="190" y="125888"/>
                  </a:lnTo>
                  <a:lnTo>
                    <a:pt x="197" y="126420"/>
                  </a:lnTo>
                  <a:lnTo>
                    <a:pt x="204" y="126951"/>
                  </a:lnTo>
                  <a:lnTo>
                    <a:pt x="211" y="127482"/>
                  </a:lnTo>
                  <a:lnTo>
                    <a:pt x="218" y="128013"/>
                  </a:lnTo>
                  <a:lnTo>
                    <a:pt x="226" y="128544"/>
                  </a:lnTo>
                  <a:lnTo>
                    <a:pt x="233" y="129075"/>
                  </a:lnTo>
                  <a:lnTo>
                    <a:pt x="241" y="129607"/>
                  </a:lnTo>
                  <a:lnTo>
                    <a:pt x="249" y="130138"/>
                  </a:lnTo>
                  <a:lnTo>
                    <a:pt x="257" y="130669"/>
                  </a:lnTo>
                  <a:lnTo>
                    <a:pt x="265" y="131200"/>
                  </a:lnTo>
                  <a:lnTo>
                    <a:pt x="273" y="131731"/>
                  </a:lnTo>
                  <a:lnTo>
                    <a:pt x="281" y="132262"/>
                  </a:lnTo>
                  <a:lnTo>
                    <a:pt x="289" y="132794"/>
                  </a:lnTo>
                  <a:lnTo>
                    <a:pt x="298" y="133325"/>
                  </a:lnTo>
                  <a:lnTo>
                    <a:pt x="306" y="133856"/>
                  </a:lnTo>
                  <a:lnTo>
                    <a:pt x="314" y="134387"/>
                  </a:lnTo>
                  <a:lnTo>
                    <a:pt x="323" y="134918"/>
                  </a:lnTo>
                  <a:lnTo>
                    <a:pt x="332" y="135450"/>
                  </a:lnTo>
                  <a:lnTo>
                    <a:pt x="340" y="135981"/>
                  </a:lnTo>
                  <a:lnTo>
                    <a:pt x="349" y="136512"/>
                  </a:lnTo>
                  <a:lnTo>
                    <a:pt x="357" y="137043"/>
                  </a:lnTo>
                  <a:lnTo>
                    <a:pt x="366" y="137574"/>
                  </a:lnTo>
                  <a:lnTo>
                    <a:pt x="374" y="138105"/>
                  </a:lnTo>
                  <a:lnTo>
                    <a:pt x="383" y="138637"/>
                  </a:lnTo>
                  <a:lnTo>
                    <a:pt x="391" y="139168"/>
                  </a:lnTo>
                  <a:lnTo>
                    <a:pt x="400" y="139699"/>
                  </a:lnTo>
                  <a:lnTo>
                    <a:pt x="408" y="140230"/>
                  </a:lnTo>
                  <a:lnTo>
                    <a:pt x="417" y="140761"/>
                  </a:lnTo>
                  <a:lnTo>
                    <a:pt x="425" y="141292"/>
                  </a:lnTo>
                  <a:lnTo>
                    <a:pt x="433" y="141824"/>
                  </a:lnTo>
                  <a:lnTo>
                    <a:pt x="441" y="142355"/>
                  </a:lnTo>
                  <a:lnTo>
                    <a:pt x="449" y="142886"/>
                  </a:lnTo>
                  <a:lnTo>
                    <a:pt x="457" y="143417"/>
                  </a:lnTo>
                  <a:lnTo>
                    <a:pt x="465" y="143948"/>
                  </a:lnTo>
                  <a:lnTo>
                    <a:pt x="473" y="144480"/>
                  </a:lnTo>
                  <a:lnTo>
                    <a:pt x="480" y="145011"/>
                  </a:lnTo>
                  <a:lnTo>
                    <a:pt x="488" y="145542"/>
                  </a:lnTo>
                  <a:lnTo>
                    <a:pt x="495" y="146073"/>
                  </a:lnTo>
                  <a:lnTo>
                    <a:pt x="502" y="146604"/>
                  </a:lnTo>
                  <a:lnTo>
                    <a:pt x="509" y="147135"/>
                  </a:lnTo>
                  <a:lnTo>
                    <a:pt x="515" y="147667"/>
                  </a:lnTo>
                  <a:lnTo>
                    <a:pt x="522" y="148198"/>
                  </a:lnTo>
                  <a:lnTo>
                    <a:pt x="528" y="148729"/>
                  </a:lnTo>
                  <a:lnTo>
                    <a:pt x="534" y="149260"/>
                  </a:lnTo>
                  <a:lnTo>
                    <a:pt x="540" y="149791"/>
                  </a:lnTo>
                  <a:lnTo>
                    <a:pt x="546" y="150322"/>
                  </a:lnTo>
                  <a:lnTo>
                    <a:pt x="552" y="150854"/>
                  </a:lnTo>
                  <a:lnTo>
                    <a:pt x="557" y="151385"/>
                  </a:lnTo>
                  <a:lnTo>
                    <a:pt x="562" y="151916"/>
                  </a:lnTo>
                  <a:lnTo>
                    <a:pt x="567" y="152447"/>
                  </a:lnTo>
                  <a:lnTo>
                    <a:pt x="571" y="152978"/>
                  </a:lnTo>
                  <a:lnTo>
                    <a:pt x="576" y="153510"/>
                  </a:lnTo>
                  <a:lnTo>
                    <a:pt x="580" y="154041"/>
                  </a:lnTo>
                  <a:lnTo>
                    <a:pt x="584" y="154572"/>
                  </a:lnTo>
                  <a:lnTo>
                    <a:pt x="588" y="155103"/>
                  </a:lnTo>
                  <a:lnTo>
                    <a:pt x="591" y="155634"/>
                  </a:lnTo>
                  <a:lnTo>
                    <a:pt x="594" y="156165"/>
                  </a:lnTo>
                  <a:lnTo>
                    <a:pt x="597" y="156697"/>
                  </a:lnTo>
                  <a:lnTo>
                    <a:pt x="600" y="157228"/>
                  </a:lnTo>
                  <a:lnTo>
                    <a:pt x="603" y="157759"/>
                  </a:lnTo>
                  <a:lnTo>
                    <a:pt x="605" y="158290"/>
                  </a:lnTo>
                  <a:lnTo>
                    <a:pt x="607" y="158821"/>
                  </a:lnTo>
                  <a:lnTo>
                    <a:pt x="609" y="159352"/>
                  </a:lnTo>
                  <a:lnTo>
                    <a:pt x="611" y="159884"/>
                  </a:lnTo>
                  <a:lnTo>
                    <a:pt x="612" y="160415"/>
                  </a:lnTo>
                  <a:lnTo>
                    <a:pt x="614" y="160946"/>
                  </a:lnTo>
                  <a:lnTo>
                    <a:pt x="615" y="161477"/>
                  </a:lnTo>
                  <a:lnTo>
                    <a:pt x="616" y="162008"/>
                  </a:lnTo>
                  <a:lnTo>
                    <a:pt x="617" y="162540"/>
                  </a:lnTo>
                  <a:lnTo>
                    <a:pt x="617" y="163071"/>
                  </a:lnTo>
                  <a:lnTo>
                    <a:pt x="618" y="163602"/>
                  </a:lnTo>
                  <a:lnTo>
                    <a:pt x="618" y="164133"/>
                  </a:lnTo>
                  <a:lnTo>
                    <a:pt x="618" y="164664"/>
                  </a:lnTo>
                  <a:lnTo>
                    <a:pt x="618" y="165195"/>
                  </a:lnTo>
                  <a:lnTo>
                    <a:pt x="618" y="165727"/>
                  </a:lnTo>
                  <a:lnTo>
                    <a:pt x="618" y="166258"/>
                  </a:lnTo>
                  <a:lnTo>
                    <a:pt x="618" y="166789"/>
                  </a:lnTo>
                  <a:lnTo>
                    <a:pt x="617" y="167320"/>
                  </a:lnTo>
                  <a:lnTo>
                    <a:pt x="617" y="167851"/>
                  </a:lnTo>
                  <a:lnTo>
                    <a:pt x="616" y="168382"/>
                  </a:lnTo>
                  <a:lnTo>
                    <a:pt x="616" y="168914"/>
                  </a:lnTo>
                  <a:lnTo>
                    <a:pt x="615" y="169445"/>
                  </a:lnTo>
                  <a:lnTo>
                    <a:pt x="614" y="169976"/>
                  </a:lnTo>
                  <a:lnTo>
                    <a:pt x="613" y="170507"/>
                  </a:lnTo>
                  <a:lnTo>
                    <a:pt x="612" y="171038"/>
                  </a:lnTo>
                  <a:lnTo>
                    <a:pt x="611" y="171570"/>
                  </a:lnTo>
                  <a:lnTo>
                    <a:pt x="610" y="172101"/>
                  </a:lnTo>
                  <a:lnTo>
                    <a:pt x="609" y="172632"/>
                  </a:lnTo>
                  <a:lnTo>
                    <a:pt x="608" y="173163"/>
                  </a:lnTo>
                  <a:lnTo>
                    <a:pt x="607" y="173694"/>
                  </a:lnTo>
                  <a:lnTo>
                    <a:pt x="606" y="174225"/>
                  </a:lnTo>
                  <a:lnTo>
                    <a:pt x="605" y="174757"/>
                  </a:lnTo>
                  <a:lnTo>
                    <a:pt x="604" y="175288"/>
                  </a:lnTo>
                  <a:lnTo>
                    <a:pt x="603" y="175819"/>
                  </a:lnTo>
                  <a:lnTo>
                    <a:pt x="602" y="176350"/>
                  </a:lnTo>
                  <a:lnTo>
                    <a:pt x="601" y="176881"/>
                  </a:lnTo>
                  <a:lnTo>
                    <a:pt x="600" y="177412"/>
                  </a:lnTo>
                  <a:lnTo>
                    <a:pt x="600" y="177944"/>
                  </a:lnTo>
                  <a:lnTo>
                    <a:pt x="599" y="178475"/>
                  </a:lnTo>
                  <a:lnTo>
                    <a:pt x="598" y="179006"/>
                  </a:lnTo>
                  <a:lnTo>
                    <a:pt x="597" y="179537"/>
                  </a:lnTo>
                  <a:lnTo>
                    <a:pt x="596" y="180068"/>
                  </a:lnTo>
                  <a:lnTo>
                    <a:pt x="596" y="180600"/>
                  </a:lnTo>
                  <a:lnTo>
                    <a:pt x="595" y="181131"/>
                  </a:lnTo>
                  <a:lnTo>
                    <a:pt x="594" y="181662"/>
                  </a:lnTo>
                  <a:lnTo>
                    <a:pt x="594" y="182193"/>
                  </a:lnTo>
                  <a:lnTo>
                    <a:pt x="593" y="182724"/>
                  </a:lnTo>
                  <a:lnTo>
                    <a:pt x="593" y="183255"/>
                  </a:lnTo>
                  <a:lnTo>
                    <a:pt x="592" y="183787"/>
                  </a:lnTo>
                  <a:lnTo>
                    <a:pt x="592" y="184318"/>
                  </a:lnTo>
                  <a:lnTo>
                    <a:pt x="591" y="184849"/>
                  </a:lnTo>
                  <a:lnTo>
                    <a:pt x="591" y="185380"/>
                  </a:lnTo>
                  <a:lnTo>
                    <a:pt x="590" y="185911"/>
                  </a:lnTo>
                  <a:lnTo>
                    <a:pt x="590" y="186442"/>
                  </a:lnTo>
                  <a:lnTo>
                    <a:pt x="589" y="186974"/>
                  </a:lnTo>
                  <a:lnTo>
                    <a:pt x="589" y="187505"/>
                  </a:lnTo>
                  <a:lnTo>
                    <a:pt x="589" y="188036"/>
                  </a:lnTo>
                  <a:lnTo>
                    <a:pt x="588" y="188567"/>
                  </a:lnTo>
                  <a:lnTo>
                    <a:pt x="588" y="189098"/>
                  </a:lnTo>
                  <a:lnTo>
                    <a:pt x="587" y="189630"/>
                  </a:lnTo>
                  <a:lnTo>
                    <a:pt x="587" y="190161"/>
                  </a:lnTo>
                  <a:lnTo>
                    <a:pt x="586" y="190692"/>
                  </a:lnTo>
                  <a:lnTo>
                    <a:pt x="586" y="191223"/>
                  </a:lnTo>
                  <a:lnTo>
                    <a:pt x="585" y="191754"/>
                  </a:lnTo>
                  <a:lnTo>
                    <a:pt x="585" y="192285"/>
                  </a:lnTo>
                  <a:lnTo>
                    <a:pt x="584" y="192817"/>
                  </a:lnTo>
                  <a:lnTo>
                    <a:pt x="583" y="193348"/>
                  </a:lnTo>
                  <a:lnTo>
                    <a:pt x="582" y="193879"/>
                  </a:lnTo>
                  <a:lnTo>
                    <a:pt x="581" y="194410"/>
                  </a:lnTo>
                  <a:lnTo>
                    <a:pt x="580" y="194941"/>
                  </a:lnTo>
                  <a:lnTo>
                    <a:pt x="579" y="195472"/>
                  </a:lnTo>
                  <a:lnTo>
                    <a:pt x="578" y="196004"/>
                  </a:lnTo>
                  <a:lnTo>
                    <a:pt x="577" y="196535"/>
                  </a:lnTo>
                  <a:lnTo>
                    <a:pt x="575" y="197066"/>
                  </a:lnTo>
                  <a:lnTo>
                    <a:pt x="574" y="197597"/>
                  </a:lnTo>
                  <a:lnTo>
                    <a:pt x="572" y="198128"/>
                  </a:lnTo>
                  <a:lnTo>
                    <a:pt x="570" y="198660"/>
                  </a:lnTo>
                  <a:lnTo>
                    <a:pt x="568" y="199191"/>
                  </a:lnTo>
                  <a:lnTo>
                    <a:pt x="566" y="199722"/>
                  </a:lnTo>
                  <a:lnTo>
                    <a:pt x="564" y="200253"/>
                  </a:lnTo>
                  <a:lnTo>
                    <a:pt x="561" y="200784"/>
                  </a:lnTo>
                  <a:lnTo>
                    <a:pt x="559" y="201315"/>
                  </a:lnTo>
                  <a:lnTo>
                    <a:pt x="556" y="201847"/>
                  </a:lnTo>
                  <a:lnTo>
                    <a:pt x="553" y="202378"/>
                  </a:lnTo>
                  <a:lnTo>
                    <a:pt x="550" y="202909"/>
                  </a:lnTo>
                  <a:lnTo>
                    <a:pt x="547" y="203440"/>
                  </a:lnTo>
                  <a:lnTo>
                    <a:pt x="543" y="203971"/>
                  </a:lnTo>
                  <a:lnTo>
                    <a:pt x="540" y="204502"/>
                  </a:lnTo>
                  <a:lnTo>
                    <a:pt x="536" y="205034"/>
                  </a:lnTo>
                  <a:lnTo>
                    <a:pt x="532" y="205565"/>
                  </a:lnTo>
                  <a:lnTo>
                    <a:pt x="528" y="206096"/>
                  </a:lnTo>
                  <a:lnTo>
                    <a:pt x="524" y="206627"/>
                  </a:lnTo>
                  <a:lnTo>
                    <a:pt x="519" y="207158"/>
                  </a:lnTo>
                  <a:lnTo>
                    <a:pt x="515" y="207690"/>
                  </a:lnTo>
                  <a:lnTo>
                    <a:pt x="510" y="208221"/>
                  </a:lnTo>
                  <a:lnTo>
                    <a:pt x="505" y="208752"/>
                  </a:lnTo>
                  <a:lnTo>
                    <a:pt x="500" y="209283"/>
                  </a:lnTo>
                  <a:lnTo>
                    <a:pt x="495" y="209814"/>
                  </a:lnTo>
                  <a:lnTo>
                    <a:pt x="489" y="210345"/>
                  </a:lnTo>
                  <a:lnTo>
                    <a:pt x="484" y="210877"/>
                  </a:lnTo>
                  <a:lnTo>
                    <a:pt x="478" y="211408"/>
                  </a:lnTo>
                  <a:lnTo>
                    <a:pt x="472" y="211939"/>
                  </a:lnTo>
                  <a:lnTo>
                    <a:pt x="466" y="212470"/>
                  </a:lnTo>
                  <a:lnTo>
                    <a:pt x="460" y="213001"/>
                  </a:lnTo>
                  <a:lnTo>
                    <a:pt x="453" y="213532"/>
                  </a:lnTo>
                  <a:lnTo>
                    <a:pt x="447" y="214064"/>
                  </a:lnTo>
                  <a:lnTo>
                    <a:pt x="440" y="214595"/>
                  </a:lnTo>
                  <a:lnTo>
                    <a:pt x="434" y="215126"/>
                  </a:lnTo>
                  <a:lnTo>
                    <a:pt x="427" y="215657"/>
                  </a:lnTo>
                  <a:lnTo>
                    <a:pt x="420" y="216188"/>
                  </a:lnTo>
                  <a:lnTo>
                    <a:pt x="413" y="216720"/>
                  </a:lnTo>
                  <a:lnTo>
                    <a:pt x="406" y="217251"/>
                  </a:lnTo>
                  <a:lnTo>
                    <a:pt x="399" y="217782"/>
                  </a:lnTo>
                  <a:lnTo>
                    <a:pt x="392" y="218313"/>
                  </a:lnTo>
                  <a:lnTo>
                    <a:pt x="384" y="218844"/>
                  </a:lnTo>
                  <a:lnTo>
                    <a:pt x="377" y="219375"/>
                  </a:lnTo>
                  <a:lnTo>
                    <a:pt x="369" y="219907"/>
                  </a:lnTo>
                  <a:lnTo>
                    <a:pt x="362" y="220438"/>
                  </a:lnTo>
                  <a:lnTo>
                    <a:pt x="354" y="220969"/>
                  </a:lnTo>
                  <a:lnTo>
                    <a:pt x="347" y="221500"/>
                  </a:lnTo>
                  <a:lnTo>
                    <a:pt x="339" y="222031"/>
                  </a:lnTo>
                  <a:lnTo>
                    <a:pt x="332" y="222562"/>
                  </a:lnTo>
                  <a:lnTo>
                    <a:pt x="324" y="223094"/>
                  </a:lnTo>
                  <a:lnTo>
                    <a:pt x="317" y="223625"/>
                  </a:lnTo>
                  <a:lnTo>
                    <a:pt x="309" y="224156"/>
                  </a:lnTo>
                  <a:lnTo>
                    <a:pt x="301" y="224687"/>
                  </a:lnTo>
                  <a:lnTo>
                    <a:pt x="294" y="225218"/>
                  </a:lnTo>
                  <a:lnTo>
                    <a:pt x="286" y="225750"/>
                  </a:lnTo>
                  <a:lnTo>
                    <a:pt x="279" y="226281"/>
                  </a:lnTo>
                  <a:lnTo>
                    <a:pt x="271" y="226812"/>
                  </a:lnTo>
                  <a:lnTo>
                    <a:pt x="264" y="227343"/>
                  </a:lnTo>
                  <a:lnTo>
                    <a:pt x="257" y="227874"/>
                  </a:lnTo>
                  <a:lnTo>
                    <a:pt x="249" y="228405"/>
                  </a:lnTo>
                  <a:lnTo>
                    <a:pt x="242" y="228937"/>
                  </a:lnTo>
                  <a:lnTo>
                    <a:pt x="235" y="229468"/>
                  </a:lnTo>
                  <a:lnTo>
                    <a:pt x="228" y="229999"/>
                  </a:lnTo>
                  <a:lnTo>
                    <a:pt x="221" y="230530"/>
                  </a:lnTo>
                  <a:lnTo>
                    <a:pt x="214" y="231061"/>
                  </a:lnTo>
                  <a:lnTo>
                    <a:pt x="207" y="231592"/>
                  </a:lnTo>
                  <a:lnTo>
                    <a:pt x="201" y="232124"/>
                  </a:lnTo>
                  <a:lnTo>
                    <a:pt x="194" y="232655"/>
                  </a:lnTo>
                  <a:lnTo>
                    <a:pt x="188" y="233186"/>
                  </a:lnTo>
                  <a:lnTo>
                    <a:pt x="181" y="233717"/>
                  </a:lnTo>
                  <a:lnTo>
                    <a:pt x="175" y="234248"/>
                  </a:lnTo>
                  <a:lnTo>
                    <a:pt x="169" y="234780"/>
                  </a:lnTo>
                  <a:lnTo>
                    <a:pt x="163" y="235311"/>
                  </a:lnTo>
                  <a:lnTo>
                    <a:pt x="157" y="235842"/>
                  </a:lnTo>
                  <a:lnTo>
                    <a:pt x="151" y="236373"/>
                  </a:lnTo>
                  <a:lnTo>
                    <a:pt x="146" y="236904"/>
                  </a:lnTo>
                  <a:lnTo>
                    <a:pt x="140" y="237435"/>
                  </a:lnTo>
                  <a:lnTo>
                    <a:pt x="135" y="237967"/>
                  </a:lnTo>
                  <a:lnTo>
                    <a:pt x="129" y="238498"/>
                  </a:lnTo>
                  <a:lnTo>
                    <a:pt x="124" y="239029"/>
                  </a:lnTo>
                  <a:lnTo>
                    <a:pt x="119" y="239560"/>
                  </a:lnTo>
                  <a:lnTo>
                    <a:pt x="114" y="240091"/>
                  </a:lnTo>
                  <a:lnTo>
                    <a:pt x="110" y="240622"/>
                  </a:lnTo>
                  <a:lnTo>
                    <a:pt x="105" y="241154"/>
                  </a:lnTo>
                  <a:lnTo>
                    <a:pt x="100" y="241685"/>
                  </a:lnTo>
                  <a:lnTo>
                    <a:pt x="96" y="242216"/>
                  </a:lnTo>
                  <a:lnTo>
                    <a:pt x="92" y="242747"/>
                  </a:lnTo>
                  <a:lnTo>
                    <a:pt x="88" y="243278"/>
                  </a:lnTo>
                  <a:lnTo>
                    <a:pt x="84" y="243810"/>
                  </a:lnTo>
                  <a:lnTo>
                    <a:pt x="80" y="244341"/>
                  </a:lnTo>
                  <a:lnTo>
                    <a:pt x="76" y="244872"/>
                  </a:lnTo>
                  <a:lnTo>
                    <a:pt x="73" y="245403"/>
                  </a:lnTo>
                  <a:lnTo>
                    <a:pt x="69" y="245934"/>
                  </a:lnTo>
                  <a:lnTo>
                    <a:pt x="66" y="246465"/>
                  </a:lnTo>
                  <a:lnTo>
                    <a:pt x="63" y="246997"/>
                  </a:lnTo>
                  <a:lnTo>
                    <a:pt x="60" y="247528"/>
                  </a:lnTo>
                  <a:lnTo>
                    <a:pt x="57" y="248059"/>
                  </a:lnTo>
                  <a:lnTo>
                    <a:pt x="54" y="248590"/>
                  </a:lnTo>
                  <a:lnTo>
                    <a:pt x="51" y="249121"/>
                  </a:lnTo>
                  <a:lnTo>
                    <a:pt x="48" y="249652"/>
                  </a:lnTo>
                  <a:lnTo>
                    <a:pt x="46" y="250184"/>
                  </a:lnTo>
                  <a:lnTo>
                    <a:pt x="43" y="250715"/>
                  </a:lnTo>
                  <a:lnTo>
                    <a:pt x="41" y="251246"/>
                  </a:lnTo>
                  <a:lnTo>
                    <a:pt x="39" y="251777"/>
                  </a:lnTo>
                  <a:lnTo>
                    <a:pt x="37" y="252308"/>
                  </a:lnTo>
                  <a:lnTo>
                    <a:pt x="35" y="252840"/>
                  </a:lnTo>
                  <a:lnTo>
                    <a:pt x="33" y="253371"/>
                  </a:lnTo>
                  <a:lnTo>
                    <a:pt x="31" y="253902"/>
                  </a:lnTo>
                  <a:lnTo>
                    <a:pt x="29" y="254433"/>
                  </a:lnTo>
                  <a:lnTo>
                    <a:pt x="27" y="254964"/>
                  </a:lnTo>
                  <a:lnTo>
                    <a:pt x="26" y="255495"/>
                  </a:lnTo>
                  <a:lnTo>
                    <a:pt x="24" y="256027"/>
                  </a:lnTo>
                  <a:lnTo>
                    <a:pt x="23" y="256558"/>
                  </a:lnTo>
                  <a:lnTo>
                    <a:pt x="21" y="257089"/>
                  </a:lnTo>
                  <a:lnTo>
                    <a:pt x="20" y="257620"/>
                  </a:lnTo>
                  <a:lnTo>
                    <a:pt x="19" y="258151"/>
                  </a:lnTo>
                  <a:lnTo>
                    <a:pt x="18" y="258682"/>
                  </a:lnTo>
                  <a:lnTo>
                    <a:pt x="17" y="259214"/>
                  </a:lnTo>
                  <a:lnTo>
                    <a:pt x="15" y="259745"/>
                  </a:lnTo>
                  <a:lnTo>
                    <a:pt x="14" y="260276"/>
                  </a:lnTo>
                  <a:lnTo>
                    <a:pt x="14" y="260807"/>
                  </a:lnTo>
                  <a:lnTo>
                    <a:pt x="13" y="261338"/>
                  </a:lnTo>
                  <a:lnTo>
                    <a:pt x="12" y="261870"/>
                  </a:lnTo>
                  <a:lnTo>
                    <a:pt x="11" y="262401"/>
                  </a:lnTo>
                  <a:lnTo>
                    <a:pt x="10" y="262932"/>
                  </a:lnTo>
                  <a:lnTo>
                    <a:pt x="9" y="263463"/>
                  </a:lnTo>
                  <a:lnTo>
                    <a:pt x="9" y="263994"/>
                  </a:lnTo>
                  <a:lnTo>
                    <a:pt x="8" y="264525"/>
                  </a:lnTo>
                  <a:lnTo>
                    <a:pt x="8" y="265057"/>
                  </a:lnTo>
                  <a:lnTo>
                    <a:pt x="7" y="265588"/>
                  </a:lnTo>
                  <a:lnTo>
                    <a:pt x="6" y="266119"/>
                  </a:lnTo>
                  <a:lnTo>
                    <a:pt x="6" y="266650"/>
                  </a:lnTo>
                  <a:lnTo>
                    <a:pt x="6" y="267181"/>
                  </a:lnTo>
                  <a:lnTo>
                    <a:pt x="5" y="267712"/>
                  </a:lnTo>
                  <a:lnTo>
                    <a:pt x="5" y="268244"/>
                  </a:lnTo>
                  <a:lnTo>
                    <a:pt x="4" y="268775"/>
                  </a:lnTo>
                  <a:lnTo>
                    <a:pt x="4" y="269306"/>
                  </a:lnTo>
                  <a:lnTo>
                    <a:pt x="4" y="269837"/>
                  </a:lnTo>
                  <a:lnTo>
                    <a:pt x="3" y="270368"/>
                  </a:lnTo>
                  <a:lnTo>
                    <a:pt x="3" y="270900"/>
                  </a:lnTo>
                  <a:lnTo>
                    <a:pt x="3" y="271431"/>
                  </a:lnTo>
                  <a:lnTo>
                    <a:pt x="0" y="271431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42" name="pl24"/>
            <p:cNvSpPr/>
            <p:nvPr/>
          </p:nvSpPr>
          <p:spPr>
            <a:xfrm>
              <a:off x="3356004" y="3316124"/>
              <a:ext cx="294" cy="647550"/>
            </a:xfrm>
            <a:custGeom>
              <a:avLst/>
              <a:gdLst/>
              <a:ahLst/>
              <a:cxnLst/>
              <a:rect l="0" t="0" r="0" b="0"/>
              <a:pathLst>
                <a:path w="294" h="647550">
                  <a:moveTo>
                    <a:pt x="294" y="647550"/>
                  </a:moveTo>
                  <a:lnTo>
                    <a:pt x="293" y="647550"/>
                  </a:lnTo>
                  <a:lnTo>
                    <a:pt x="293" y="646283"/>
                  </a:lnTo>
                  <a:lnTo>
                    <a:pt x="292" y="645016"/>
                  </a:lnTo>
                  <a:lnTo>
                    <a:pt x="292" y="643749"/>
                  </a:lnTo>
                  <a:lnTo>
                    <a:pt x="292" y="642481"/>
                  </a:lnTo>
                  <a:lnTo>
                    <a:pt x="292" y="641214"/>
                  </a:lnTo>
                  <a:lnTo>
                    <a:pt x="292" y="639947"/>
                  </a:lnTo>
                  <a:lnTo>
                    <a:pt x="292" y="638680"/>
                  </a:lnTo>
                  <a:lnTo>
                    <a:pt x="292" y="637412"/>
                  </a:lnTo>
                  <a:lnTo>
                    <a:pt x="291" y="636145"/>
                  </a:lnTo>
                  <a:lnTo>
                    <a:pt x="291" y="634878"/>
                  </a:lnTo>
                  <a:lnTo>
                    <a:pt x="291" y="633611"/>
                  </a:lnTo>
                  <a:lnTo>
                    <a:pt x="291" y="632344"/>
                  </a:lnTo>
                  <a:lnTo>
                    <a:pt x="290" y="631076"/>
                  </a:lnTo>
                  <a:lnTo>
                    <a:pt x="290" y="629809"/>
                  </a:lnTo>
                  <a:lnTo>
                    <a:pt x="290" y="628542"/>
                  </a:lnTo>
                  <a:lnTo>
                    <a:pt x="290" y="627275"/>
                  </a:lnTo>
                  <a:lnTo>
                    <a:pt x="289" y="626007"/>
                  </a:lnTo>
                  <a:lnTo>
                    <a:pt x="289" y="624740"/>
                  </a:lnTo>
                  <a:lnTo>
                    <a:pt x="289" y="623473"/>
                  </a:lnTo>
                  <a:lnTo>
                    <a:pt x="288" y="622206"/>
                  </a:lnTo>
                  <a:lnTo>
                    <a:pt x="288" y="620939"/>
                  </a:lnTo>
                  <a:lnTo>
                    <a:pt x="287" y="619671"/>
                  </a:lnTo>
                  <a:lnTo>
                    <a:pt x="287" y="618404"/>
                  </a:lnTo>
                  <a:lnTo>
                    <a:pt x="287" y="617137"/>
                  </a:lnTo>
                  <a:lnTo>
                    <a:pt x="286" y="615870"/>
                  </a:lnTo>
                  <a:lnTo>
                    <a:pt x="286" y="614602"/>
                  </a:lnTo>
                  <a:lnTo>
                    <a:pt x="285" y="613335"/>
                  </a:lnTo>
                  <a:lnTo>
                    <a:pt x="285" y="612068"/>
                  </a:lnTo>
                  <a:lnTo>
                    <a:pt x="284" y="610801"/>
                  </a:lnTo>
                  <a:lnTo>
                    <a:pt x="283" y="609534"/>
                  </a:lnTo>
                  <a:lnTo>
                    <a:pt x="283" y="608266"/>
                  </a:lnTo>
                  <a:lnTo>
                    <a:pt x="282" y="606999"/>
                  </a:lnTo>
                  <a:lnTo>
                    <a:pt x="281" y="605732"/>
                  </a:lnTo>
                  <a:lnTo>
                    <a:pt x="281" y="604465"/>
                  </a:lnTo>
                  <a:lnTo>
                    <a:pt x="280" y="603197"/>
                  </a:lnTo>
                  <a:lnTo>
                    <a:pt x="279" y="601930"/>
                  </a:lnTo>
                  <a:lnTo>
                    <a:pt x="278" y="600663"/>
                  </a:lnTo>
                  <a:lnTo>
                    <a:pt x="278" y="599396"/>
                  </a:lnTo>
                  <a:lnTo>
                    <a:pt x="277" y="598129"/>
                  </a:lnTo>
                  <a:lnTo>
                    <a:pt x="276" y="596861"/>
                  </a:lnTo>
                  <a:lnTo>
                    <a:pt x="275" y="595594"/>
                  </a:lnTo>
                  <a:lnTo>
                    <a:pt x="274" y="594327"/>
                  </a:lnTo>
                  <a:lnTo>
                    <a:pt x="273" y="593060"/>
                  </a:lnTo>
                  <a:lnTo>
                    <a:pt x="272" y="591792"/>
                  </a:lnTo>
                  <a:lnTo>
                    <a:pt x="271" y="590525"/>
                  </a:lnTo>
                  <a:lnTo>
                    <a:pt x="269" y="589258"/>
                  </a:lnTo>
                  <a:lnTo>
                    <a:pt x="268" y="587991"/>
                  </a:lnTo>
                  <a:lnTo>
                    <a:pt x="267" y="586724"/>
                  </a:lnTo>
                  <a:lnTo>
                    <a:pt x="266" y="585456"/>
                  </a:lnTo>
                  <a:lnTo>
                    <a:pt x="264" y="584189"/>
                  </a:lnTo>
                  <a:lnTo>
                    <a:pt x="263" y="582922"/>
                  </a:lnTo>
                  <a:lnTo>
                    <a:pt x="261" y="581655"/>
                  </a:lnTo>
                  <a:lnTo>
                    <a:pt x="260" y="580387"/>
                  </a:lnTo>
                  <a:lnTo>
                    <a:pt x="258" y="579120"/>
                  </a:lnTo>
                  <a:lnTo>
                    <a:pt x="257" y="577853"/>
                  </a:lnTo>
                  <a:lnTo>
                    <a:pt x="255" y="576586"/>
                  </a:lnTo>
                  <a:lnTo>
                    <a:pt x="253" y="575319"/>
                  </a:lnTo>
                  <a:lnTo>
                    <a:pt x="251" y="574051"/>
                  </a:lnTo>
                  <a:lnTo>
                    <a:pt x="250" y="572784"/>
                  </a:lnTo>
                  <a:lnTo>
                    <a:pt x="248" y="571517"/>
                  </a:lnTo>
                  <a:lnTo>
                    <a:pt x="246" y="570250"/>
                  </a:lnTo>
                  <a:lnTo>
                    <a:pt x="244" y="568982"/>
                  </a:lnTo>
                  <a:lnTo>
                    <a:pt x="242" y="567715"/>
                  </a:lnTo>
                  <a:lnTo>
                    <a:pt x="240" y="566448"/>
                  </a:lnTo>
                  <a:lnTo>
                    <a:pt x="237" y="565181"/>
                  </a:lnTo>
                  <a:lnTo>
                    <a:pt x="235" y="563914"/>
                  </a:lnTo>
                  <a:lnTo>
                    <a:pt x="233" y="562646"/>
                  </a:lnTo>
                  <a:lnTo>
                    <a:pt x="231" y="561379"/>
                  </a:lnTo>
                  <a:lnTo>
                    <a:pt x="228" y="560112"/>
                  </a:lnTo>
                  <a:lnTo>
                    <a:pt x="226" y="558845"/>
                  </a:lnTo>
                  <a:lnTo>
                    <a:pt x="223" y="557577"/>
                  </a:lnTo>
                  <a:lnTo>
                    <a:pt x="221" y="556310"/>
                  </a:lnTo>
                  <a:lnTo>
                    <a:pt x="218" y="555043"/>
                  </a:lnTo>
                  <a:lnTo>
                    <a:pt x="215" y="553776"/>
                  </a:lnTo>
                  <a:lnTo>
                    <a:pt x="213" y="552509"/>
                  </a:lnTo>
                  <a:lnTo>
                    <a:pt x="210" y="551241"/>
                  </a:lnTo>
                  <a:lnTo>
                    <a:pt x="207" y="549974"/>
                  </a:lnTo>
                  <a:lnTo>
                    <a:pt x="204" y="548707"/>
                  </a:lnTo>
                  <a:lnTo>
                    <a:pt x="201" y="547440"/>
                  </a:lnTo>
                  <a:lnTo>
                    <a:pt x="198" y="546172"/>
                  </a:lnTo>
                  <a:lnTo>
                    <a:pt x="195" y="544905"/>
                  </a:lnTo>
                  <a:lnTo>
                    <a:pt x="192" y="543638"/>
                  </a:lnTo>
                  <a:lnTo>
                    <a:pt x="189" y="542371"/>
                  </a:lnTo>
                  <a:lnTo>
                    <a:pt x="186" y="541104"/>
                  </a:lnTo>
                  <a:lnTo>
                    <a:pt x="182" y="539836"/>
                  </a:lnTo>
                  <a:lnTo>
                    <a:pt x="179" y="538569"/>
                  </a:lnTo>
                  <a:lnTo>
                    <a:pt x="176" y="537302"/>
                  </a:lnTo>
                  <a:lnTo>
                    <a:pt x="172" y="536035"/>
                  </a:lnTo>
                  <a:lnTo>
                    <a:pt x="169" y="534767"/>
                  </a:lnTo>
                  <a:lnTo>
                    <a:pt x="166" y="533500"/>
                  </a:lnTo>
                  <a:lnTo>
                    <a:pt x="162" y="532233"/>
                  </a:lnTo>
                  <a:lnTo>
                    <a:pt x="159" y="530966"/>
                  </a:lnTo>
                  <a:lnTo>
                    <a:pt x="155" y="529699"/>
                  </a:lnTo>
                  <a:lnTo>
                    <a:pt x="152" y="528431"/>
                  </a:lnTo>
                  <a:lnTo>
                    <a:pt x="148" y="527164"/>
                  </a:lnTo>
                  <a:lnTo>
                    <a:pt x="145" y="525897"/>
                  </a:lnTo>
                  <a:lnTo>
                    <a:pt x="141" y="524630"/>
                  </a:lnTo>
                  <a:lnTo>
                    <a:pt x="137" y="523362"/>
                  </a:lnTo>
                  <a:lnTo>
                    <a:pt x="134" y="522095"/>
                  </a:lnTo>
                  <a:lnTo>
                    <a:pt x="130" y="520828"/>
                  </a:lnTo>
                  <a:lnTo>
                    <a:pt x="127" y="519561"/>
                  </a:lnTo>
                  <a:lnTo>
                    <a:pt x="123" y="518294"/>
                  </a:lnTo>
                  <a:lnTo>
                    <a:pt x="119" y="517026"/>
                  </a:lnTo>
                  <a:lnTo>
                    <a:pt x="116" y="515759"/>
                  </a:lnTo>
                  <a:lnTo>
                    <a:pt x="112" y="514492"/>
                  </a:lnTo>
                  <a:lnTo>
                    <a:pt x="108" y="513225"/>
                  </a:lnTo>
                  <a:lnTo>
                    <a:pt x="105" y="511957"/>
                  </a:lnTo>
                  <a:lnTo>
                    <a:pt x="101" y="510690"/>
                  </a:lnTo>
                  <a:lnTo>
                    <a:pt x="98" y="509423"/>
                  </a:lnTo>
                  <a:lnTo>
                    <a:pt x="94" y="508156"/>
                  </a:lnTo>
                  <a:lnTo>
                    <a:pt x="91" y="506889"/>
                  </a:lnTo>
                  <a:lnTo>
                    <a:pt x="87" y="505621"/>
                  </a:lnTo>
                  <a:lnTo>
                    <a:pt x="84" y="504354"/>
                  </a:lnTo>
                  <a:lnTo>
                    <a:pt x="80" y="503087"/>
                  </a:lnTo>
                  <a:lnTo>
                    <a:pt x="77" y="501820"/>
                  </a:lnTo>
                  <a:lnTo>
                    <a:pt x="74" y="500552"/>
                  </a:lnTo>
                  <a:lnTo>
                    <a:pt x="70" y="499285"/>
                  </a:lnTo>
                  <a:lnTo>
                    <a:pt x="67" y="498018"/>
                  </a:lnTo>
                  <a:lnTo>
                    <a:pt x="64" y="496751"/>
                  </a:lnTo>
                  <a:lnTo>
                    <a:pt x="61" y="495484"/>
                  </a:lnTo>
                  <a:lnTo>
                    <a:pt x="58" y="494216"/>
                  </a:lnTo>
                  <a:lnTo>
                    <a:pt x="55" y="492949"/>
                  </a:lnTo>
                  <a:lnTo>
                    <a:pt x="52" y="491682"/>
                  </a:lnTo>
                  <a:lnTo>
                    <a:pt x="49" y="490415"/>
                  </a:lnTo>
                  <a:lnTo>
                    <a:pt x="46" y="489147"/>
                  </a:lnTo>
                  <a:lnTo>
                    <a:pt x="43" y="487880"/>
                  </a:lnTo>
                  <a:lnTo>
                    <a:pt x="40" y="486613"/>
                  </a:lnTo>
                  <a:lnTo>
                    <a:pt x="38" y="485346"/>
                  </a:lnTo>
                  <a:lnTo>
                    <a:pt x="35" y="484079"/>
                  </a:lnTo>
                  <a:lnTo>
                    <a:pt x="33" y="482811"/>
                  </a:lnTo>
                  <a:lnTo>
                    <a:pt x="30" y="481544"/>
                  </a:lnTo>
                  <a:lnTo>
                    <a:pt x="28" y="480277"/>
                  </a:lnTo>
                  <a:lnTo>
                    <a:pt x="26" y="479010"/>
                  </a:lnTo>
                  <a:lnTo>
                    <a:pt x="24" y="477742"/>
                  </a:lnTo>
                  <a:lnTo>
                    <a:pt x="22" y="476475"/>
                  </a:lnTo>
                  <a:lnTo>
                    <a:pt x="20" y="475208"/>
                  </a:lnTo>
                  <a:lnTo>
                    <a:pt x="18" y="473941"/>
                  </a:lnTo>
                  <a:lnTo>
                    <a:pt x="16" y="472674"/>
                  </a:lnTo>
                  <a:lnTo>
                    <a:pt x="14" y="471406"/>
                  </a:lnTo>
                  <a:lnTo>
                    <a:pt x="13" y="470139"/>
                  </a:lnTo>
                  <a:lnTo>
                    <a:pt x="11" y="468872"/>
                  </a:lnTo>
                  <a:lnTo>
                    <a:pt x="10" y="467605"/>
                  </a:lnTo>
                  <a:lnTo>
                    <a:pt x="8" y="466337"/>
                  </a:lnTo>
                  <a:lnTo>
                    <a:pt x="7" y="465070"/>
                  </a:lnTo>
                  <a:lnTo>
                    <a:pt x="6" y="463803"/>
                  </a:lnTo>
                  <a:lnTo>
                    <a:pt x="5" y="462536"/>
                  </a:lnTo>
                  <a:lnTo>
                    <a:pt x="4" y="461269"/>
                  </a:lnTo>
                  <a:lnTo>
                    <a:pt x="3" y="460001"/>
                  </a:lnTo>
                  <a:lnTo>
                    <a:pt x="2" y="458734"/>
                  </a:lnTo>
                  <a:lnTo>
                    <a:pt x="2" y="457467"/>
                  </a:lnTo>
                  <a:lnTo>
                    <a:pt x="1" y="456200"/>
                  </a:lnTo>
                  <a:lnTo>
                    <a:pt x="1" y="454932"/>
                  </a:lnTo>
                  <a:lnTo>
                    <a:pt x="0" y="453665"/>
                  </a:lnTo>
                  <a:lnTo>
                    <a:pt x="0" y="452398"/>
                  </a:lnTo>
                  <a:lnTo>
                    <a:pt x="0" y="451131"/>
                  </a:lnTo>
                  <a:lnTo>
                    <a:pt x="0" y="449864"/>
                  </a:lnTo>
                  <a:lnTo>
                    <a:pt x="0" y="448596"/>
                  </a:lnTo>
                  <a:lnTo>
                    <a:pt x="0" y="447329"/>
                  </a:lnTo>
                  <a:lnTo>
                    <a:pt x="0" y="446062"/>
                  </a:lnTo>
                  <a:lnTo>
                    <a:pt x="0" y="444795"/>
                  </a:lnTo>
                  <a:lnTo>
                    <a:pt x="0" y="443527"/>
                  </a:lnTo>
                  <a:lnTo>
                    <a:pt x="1" y="442260"/>
                  </a:lnTo>
                  <a:lnTo>
                    <a:pt x="1" y="440993"/>
                  </a:lnTo>
                  <a:lnTo>
                    <a:pt x="1" y="439726"/>
                  </a:lnTo>
                  <a:lnTo>
                    <a:pt x="2" y="438459"/>
                  </a:lnTo>
                  <a:lnTo>
                    <a:pt x="3" y="437191"/>
                  </a:lnTo>
                  <a:lnTo>
                    <a:pt x="4" y="435924"/>
                  </a:lnTo>
                  <a:lnTo>
                    <a:pt x="4" y="434657"/>
                  </a:lnTo>
                  <a:lnTo>
                    <a:pt x="5" y="433390"/>
                  </a:lnTo>
                  <a:lnTo>
                    <a:pt x="6" y="432122"/>
                  </a:lnTo>
                  <a:lnTo>
                    <a:pt x="7" y="430855"/>
                  </a:lnTo>
                  <a:lnTo>
                    <a:pt x="8" y="429588"/>
                  </a:lnTo>
                  <a:lnTo>
                    <a:pt x="9" y="428321"/>
                  </a:lnTo>
                  <a:lnTo>
                    <a:pt x="11" y="427054"/>
                  </a:lnTo>
                  <a:lnTo>
                    <a:pt x="12" y="425786"/>
                  </a:lnTo>
                  <a:lnTo>
                    <a:pt x="13" y="424519"/>
                  </a:lnTo>
                  <a:lnTo>
                    <a:pt x="14" y="423252"/>
                  </a:lnTo>
                  <a:lnTo>
                    <a:pt x="16" y="421985"/>
                  </a:lnTo>
                  <a:lnTo>
                    <a:pt x="17" y="420717"/>
                  </a:lnTo>
                  <a:lnTo>
                    <a:pt x="19" y="419450"/>
                  </a:lnTo>
                  <a:lnTo>
                    <a:pt x="20" y="418183"/>
                  </a:lnTo>
                  <a:lnTo>
                    <a:pt x="22" y="416916"/>
                  </a:lnTo>
                  <a:lnTo>
                    <a:pt x="23" y="415649"/>
                  </a:lnTo>
                  <a:lnTo>
                    <a:pt x="25" y="414381"/>
                  </a:lnTo>
                  <a:lnTo>
                    <a:pt x="27" y="413114"/>
                  </a:lnTo>
                  <a:lnTo>
                    <a:pt x="28" y="411847"/>
                  </a:lnTo>
                  <a:lnTo>
                    <a:pt x="30" y="410580"/>
                  </a:lnTo>
                  <a:lnTo>
                    <a:pt x="32" y="409312"/>
                  </a:lnTo>
                  <a:lnTo>
                    <a:pt x="34" y="408045"/>
                  </a:lnTo>
                  <a:lnTo>
                    <a:pt x="36" y="406778"/>
                  </a:lnTo>
                  <a:lnTo>
                    <a:pt x="38" y="405511"/>
                  </a:lnTo>
                  <a:lnTo>
                    <a:pt x="39" y="404244"/>
                  </a:lnTo>
                  <a:lnTo>
                    <a:pt x="41" y="402976"/>
                  </a:lnTo>
                  <a:lnTo>
                    <a:pt x="43" y="401709"/>
                  </a:lnTo>
                  <a:lnTo>
                    <a:pt x="45" y="400442"/>
                  </a:lnTo>
                  <a:lnTo>
                    <a:pt x="47" y="399175"/>
                  </a:lnTo>
                  <a:lnTo>
                    <a:pt x="49" y="397907"/>
                  </a:lnTo>
                  <a:lnTo>
                    <a:pt x="51" y="396640"/>
                  </a:lnTo>
                  <a:lnTo>
                    <a:pt x="53" y="395373"/>
                  </a:lnTo>
                  <a:lnTo>
                    <a:pt x="55" y="394106"/>
                  </a:lnTo>
                  <a:lnTo>
                    <a:pt x="57" y="392839"/>
                  </a:lnTo>
                  <a:lnTo>
                    <a:pt x="59" y="391571"/>
                  </a:lnTo>
                  <a:lnTo>
                    <a:pt x="61" y="390304"/>
                  </a:lnTo>
                  <a:lnTo>
                    <a:pt x="64" y="389037"/>
                  </a:lnTo>
                  <a:lnTo>
                    <a:pt x="66" y="387770"/>
                  </a:lnTo>
                  <a:lnTo>
                    <a:pt x="68" y="386502"/>
                  </a:lnTo>
                  <a:lnTo>
                    <a:pt x="70" y="385235"/>
                  </a:lnTo>
                  <a:lnTo>
                    <a:pt x="72" y="383968"/>
                  </a:lnTo>
                  <a:lnTo>
                    <a:pt x="74" y="382701"/>
                  </a:lnTo>
                  <a:lnTo>
                    <a:pt x="76" y="381434"/>
                  </a:lnTo>
                  <a:lnTo>
                    <a:pt x="79" y="380166"/>
                  </a:lnTo>
                  <a:lnTo>
                    <a:pt x="81" y="378899"/>
                  </a:lnTo>
                  <a:lnTo>
                    <a:pt x="83" y="377632"/>
                  </a:lnTo>
                  <a:lnTo>
                    <a:pt x="85" y="376365"/>
                  </a:lnTo>
                  <a:lnTo>
                    <a:pt x="87" y="375097"/>
                  </a:lnTo>
                  <a:lnTo>
                    <a:pt x="89" y="373830"/>
                  </a:lnTo>
                  <a:lnTo>
                    <a:pt x="92" y="372563"/>
                  </a:lnTo>
                  <a:lnTo>
                    <a:pt x="94" y="371296"/>
                  </a:lnTo>
                  <a:lnTo>
                    <a:pt x="96" y="370029"/>
                  </a:lnTo>
                  <a:lnTo>
                    <a:pt x="98" y="368761"/>
                  </a:lnTo>
                  <a:lnTo>
                    <a:pt x="100" y="367494"/>
                  </a:lnTo>
                  <a:lnTo>
                    <a:pt x="103" y="366227"/>
                  </a:lnTo>
                  <a:lnTo>
                    <a:pt x="105" y="364960"/>
                  </a:lnTo>
                  <a:lnTo>
                    <a:pt x="107" y="363692"/>
                  </a:lnTo>
                  <a:lnTo>
                    <a:pt x="109" y="362425"/>
                  </a:lnTo>
                  <a:lnTo>
                    <a:pt x="112" y="361158"/>
                  </a:lnTo>
                  <a:lnTo>
                    <a:pt x="114" y="359891"/>
                  </a:lnTo>
                  <a:lnTo>
                    <a:pt x="116" y="358624"/>
                  </a:lnTo>
                  <a:lnTo>
                    <a:pt x="118" y="357356"/>
                  </a:lnTo>
                  <a:lnTo>
                    <a:pt x="121" y="356089"/>
                  </a:lnTo>
                  <a:lnTo>
                    <a:pt x="123" y="354822"/>
                  </a:lnTo>
                  <a:lnTo>
                    <a:pt x="125" y="353555"/>
                  </a:lnTo>
                  <a:lnTo>
                    <a:pt x="128" y="352287"/>
                  </a:lnTo>
                  <a:lnTo>
                    <a:pt x="130" y="351020"/>
                  </a:lnTo>
                  <a:lnTo>
                    <a:pt x="132" y="349753"/>
                  </a:lnTo>
                  <a:lnTo>
                    <a:pt x="134" y="348486"/>
                  </a:lnTo>
                  <a:lnTo>
                    <a:pt x="137" y="347218"/>
                  </a:lnTo>
                  <a:lnTo>
                    <a:pt x="139" y="345951"/>
                  </a:lnTo>
                  <a:lnTo>
                    <a:pt x="141" y="344684"/>
                  </a:lnTo>
                  <a:lnTo>
                    <a:pt x="144" y="343417"/>
                  </a:lnTo>
                  <a:lnTo>
                    <a:pt x="146" y="342150"/>
                  </a:lnTo>
                  <a:lnTo>
                    <a:pt x="148" y="340882"/>
                  </a:lnTo>
                  <a:lnTo>
                    <a:pt x="150" y="339615"/>
                  </a:lnTo>
                  <a:lnTo>
                    <a:pt x="153" y="338348"/>
                  </a:lnTo>
                  <a:lnTo>
                    <a:pt x="155" y="337081"/>
                  </a:lnTo>
                  <a:lnTo>
                    <a:pt x="157" y="335813"/>
                  </a:lnTo>
                  <a:lnTo>
                    <a:pt x="160" y="334546"/>
                  </a:lnTo>
                  <a:lnTo>
                    <a:pt x="162" y="333279"/>
                  </a:lnTo>
                  <a:lnTo>
                    <a:pt x="164" y="332012"/>
                  </a:lnTo>
                  <a:lnTo>
                    <a:pt x="166" y="330745"/>
                  </a:lnTo>
                  <a:lnTo>
                    <a:pt x="169" y="329477"/>
                  </a:lnTo>
                  <a:lnTo>
                    <a:pt x="171" y="328210"/>
                  </a:lnTo>
                  <a:lnTo>
                    <a:pt x="173" y="326943"/>
                  </a:lnTo>
                  <a:lnTo>
                    <a:pt x="175" y="325676"/>
                  </a:lnTo>
                  <a:lnTo>
                    <a:pt x="178" y="324408"/>
                  </a:lnTo>
                  <a:lnTo>
                    <a:pt x="180" y="323141"/>
                  </a:lnTo>
                  <a:lnTo>
                    <a:pt x="182" y="321874"/>
                  </a:lnTo>
                  <a:lnTo>
                    <a:pt x="184" y="320607"/>
                  </a:lnTo>
                  <a:lnTo>
                    <a:pt x="186" y="319340"/>
                  </a:lnTo>
                  <a:lnTo>
                    <a:pt x="188" y="318072"/>
                  </a:lnTo>
                  <a:lnTo>
                    <a:pt x="190" y="316805"/>
                  </a:lnTo>
                  <a:lnTo>
                    <a:pt x="193" y="315538"/>
                  </a:lnTo>
                  <a:lnTo>
                    <a:pt x="195" y="314271"/>
                  </a:lnTo>
                  <a:lnTo>
                    <a:pt x="197" y="313003"/>
                  </a:lnTo>
                  <a:lnTo>
                    <a:pt x="199" y="311736"/>
                  </a:lnTo>
                  <a:lnTo>
                    <a:pt x="201" y="310469"/>
                  </a:lnTo>
                  <a:lnTo>
                    <a:pt x="203" y="309202"/>
                  </a:lnTo>
                  <a:lnTo>
                    <a:pt x="205" y="307935"/>
                  </a:lnTo>
                  <a:lnTo>
                    <a:pt x="206" y="306667"/>
                  </a:lnTo>
                  <a:lnTo>
                    <a:pt x="208" y="305400"/>
                  </a:lnTo>
                  <a:lnTo>
                    <a:pt x="210" y="304133"/>
                  </a:lnTo>
                  <a:lnTo>
                    <a:pt x="212" y="302866"/>
                  </a:lnTo>
                  <a:lnTo>
                    <a:pt x="214" y="301598"/>
                  </a:lnTo>
                  <a:lnTo>
                    <a:pt x="216" y="300331"/>
                  </a:lnTo>
                  <a:lnTo>
                    <a:pt x="217" y="299064"/>
                  </a:lnTo>
                  <a:lnTo>
                    <a:pt x="219" y="297797"/>
                  </a:lnTo>
                  <a:lnTo>
                    <a:pt x="221" y="296530"/>
                  </a:lnTo>
                  <a:lnTo>
                    <a:pt x="222" y="295262"/>
                  </a:lnTo>
                  <a:lnTo>
                    <a:pt x="224" y="293995"/>
                  </a:lnTo>
                  <a:lnTo>
                    <a:pt x="225" y="292728"/>
                  </a:lnTo>
                  <a:lnTo>
                    <a:pt x="227" y="291461"/>
                  </a:lnTo>
                  <a:lnTo>
                    <a:pt x="228" y="290193"/>
                  </a:lnTo>
                  <a:lnTo>
                    <a:pt x="230" y="288926"/>
                  </a:lnTo>
                  <a:lnTo>
                    <a:pt x="231" y="287659"/>
                  </a:lnTo>
                  <a:lnTo>
                    <a:pt x="232" y="286392"/>
                  </a:lnTo>
                  <a:lnTo>
                    <a:pt x="233" y="285125"/>
                  </a:lnTo>
                  <a:lnTo>
                    <a:pt x="235" y="283857"/>
                  </a:lnTo>
                  <a:lnTo>
                    <a:pt x="236" y="282590"/>
                  </a:lnTo>
                  <a:lnTo>
                    <a:pt x="237" y="281323"/>
                  </a:lnTo>
                  <a:lnTo>
                    <a:pt x="238" y="280056"/>
                  </a:lnTo>
                  <a:lnTo>
                    <a:pt x="239" y="278788"/>
                  </a:lnTo>
                  <a:lnTo>
                    <a:pt x="240" y="277521"/>
                  </a:lnTo>
                  <a:lnTo>
                    <a:pt x="241" y="276254"/>
                  </a:lnTo>
                  <a:lnTo>
                    <a:pt x="242" y="274987"/>
                  </a:lnTo>
                  <a:lnTo>
                    <a:pt x="242" y="273720"/>
                  </a:lnTo>
                  <a:lnTo>
                    <a:pt x="243" y="272452"/>
                  </a:lnTo>
                  <a:lnTo>
                    <a:pt x="244" y="271185"/>
                  </a:lnTo>
                  <a:lnTo>
                    <a:pt x="244" y="269918"/>
                  </a:lnTo>
                  <a:lnTo>
                    <a:pt x="245" y="268651"/>
                  </a:lnTo>
                  <a:lnTo>
                    <a:pt x="245" y="267383"/>
                  </a:lnTo>
                  <a:lnTo>
                    <a:pt x="246" y="266116"/>
                  </a:lnTo>
                  <a:lnTo>
                    <a:pt x="246" y="264849"/>
                  </a:lnTo>
                  <a:lnTo>
                    <a:pt x="247" y="263582"/>
                  </a:lnTo>
                  <a:lnTo>
                    <a:pt x="247" y="262315"/>
                  </a:lnTo>
                  <a:lnTo>
                    <a:pt x="247" y="261047"/>
                  </a:lnTo>
                  <a:lnTo>
                    <a:pt x="247" y="259780"/>
                  </a:lnTo>
                  <a:lnTo>
                    <a:pt x="247" y="258513"/>
                  </a:lnTo>
                  <a:lnTo>
                    <a:pt x="247" y="257246"/>
                  </a:lnTo>
                  <a:lnTo>
                    <a:pt x="247" y="255978"/>
                  </a:lnTo>
                  <a:lnTo>
                    <a:pt x="247" y="254711"/>
                  </a:lnTo>
                  <a:lnTo>
                    <a:pt x="247" y="253444"/>
                  </a:lnTo>
                  <a:lnTo>
                    <a:pt x="247" y="252177"/>
                  </a:lnTo>
                  <a:lnTo>
                    <a:pt x="247" y="250910"/>
                  </a:lnTo>
                  <a:lnTo>
                    <a:pt x="247" y="249642"/>
                  </a:lnTo>
                  <a:lnTo>
                    <a:pt x="246" y="248375"/>
                  </a:lnTo>
                  <a:lnTo>
                    <a:pt x="246" y="247108"/>
                  </a:lnTo>
                  <a:lnTo>
                    <a:pt x="245" y="245841"/>
                  </a:lnTo>
                  <a:lnTo>
                    <a:pt x="245" y="244573"/>
                  </a:lnTo>
                  <a:lnTo>
                    <a:pt x="244" y="243306"/>
                  </a:lnTo>
                  <a:lnTo>
                    <a:pt x="244" y="242039"/>
                  </a:lnTo>
                  <a:lnTo>
                    <a:pt x="243" y="240772"/>
                  </a:lnTo>
                  <a:lnTo>
                    <a:pt x="243" y="239505"/>
                  </a:lnTo>
                  <a:lnTo>
                    <a:pt x="242" y="238237"/>
                  </a:lnTo>
                  <a:lnTo>
                    <a:pt x="241" y="236970"/>
                  </a:lnTo>
                  <a:lnTo>
                    <a:pt x="241" y="235703"/>
                  </a:lnTo>
                  <a:lnTo>
                    <a:pt x="240" y="234436"/>
                  </a:lnTo>
                  <a:lnTo>
                    <a:pt x="239" y="233168"/>
                  </a:lnTo>
                  <a:lnTo>
                    <a:pt x="238" y="231901"/>
                  </a:lnTo>
                  <a:lnTo>
                    <a:pt x="237" y="230634"/>
                  </a:lnTo>
                  <a:lnTo>
                    <a:pt x="236" y="229367"/>
                  </a:lnTo>
                  <a:lnTo>
                    <a:pt x="235" y="228100"/>
                  </a:lnTo>
                  <a:lnTo>
                    <a:pt x="234" y="226832"/>
                  </a:lnTo>
                  <a:lnTo>
                    <a:pt x="233" y="225565"/>
                  </a:lnTo>
                  <a:lnTo>
                    <a:pt x="232" y="224298"/>
                  </a:lnTo>
                  <a:lnTo>
                    <a:pt x="231" y="223031"/>
                  </a:lnTo>
                  <a:lnTo>
                    <a:pt x="230" y="221763"/>
                  </a:lnTo>
                  <a:lnTo>
                    <a:pt x="229" y="220496"/>
                  </a:lnTo>
                  <a:lnTo>
                    <a:pt x="228" y="219229"/>
                  </a:lnTo>
                  <a:lnTo>
                    <a:pt x="226" y="217962"/>
                  </a:lnTo>
                  <a:lnTo>
                    <a:pt x="225" y="216695"/>
                  </a:lnTo>
                  <a:lnTo>
                    <a:pt x="224" y="215427"/>
                  </a:lnTo>
                  <a:lnTo>
                    <a:pt x="223" y="214160"/>
                  </a:lnTo>
                  <a:lnTo>
                    <a:pt x="222" y="212893"/>
                  </a:lnTo>
                  <a:lnTo>
                    <a:pt x="221" y="211626"/>
                  </a:lnTo>
                  <a:lnTo>
                    <a:pt x="219" y="210358"/>
                  </a:lnTo>
                  <a:lnTo>
                    <a:pt x="218" y="209091"/>
                  </a:lnTo>
                  <a:lnTo>
                    <a:pt x="217" y="207824"/>
                  </a:lnTo>
                  <a:lnTo>
                    <a:pt x="216" y="206557"/>
                  </a:lnTo>
                  <a:lnTo>
                    <a:pt x="215" y="205290"/>
                  </a:lnTo>
                  <a:lnTo>
                    <a:pt x="213" y="204022"/>
                  </a:lnTo>
                  <a:lnTo>
                    <a:pt x="212" y="202755"/>
                  </a:lnTo>
                  <a:lnTo>
                    <a:pt x="211" y="201488"/>
                  </a:lnTo>
                  <a:lnTo>
                    <a:pt x="210" y="200221"/>
                  </a:lnTo>
                  <a:lnTo>
                    <a:pt x="209" y="198953"/>
                  </a:lnTo>
                  <a:lnTo>
                    <a:pt x="208" y="197686"/>
                  </a:lnTo>
                  <a:lnTo>
                    <a:pt x="207" y="196419"/>
                  </a:lnTo>
                  <a:lnTo>
                    <a:pt x="205" y="195152"/>
                  </a:lnTo>
                  <a:lnTo>
                    <a:pt x="204" y="193885"/>
                  </a:lnTo>
                  <a:lnTo>
                    <a:pt x="203" y="192617"/>
                  </a:lnTo>
                  <a:lnTo>
                    <a:pt x="202" y="191350"/>
                  </a:lnTo>
                  <a:lnTo>
                    <a:pt x="202" y="190083"/>
                  </a:lnTo>
                  <a:lnTo>
                    <a:pt x="201" y="188816"/>
                  </a:lnTo>
                  <a:lnTo>
                    <a:pt x="200" y="187548"/>
                  </a:lnTo>
                  <a:lnTo>
                    <a:pt x="199" y="186281"/>
                  </a:lnTo>
                  <a:lnTo>
                    <a:pt x="198" y="185014"/>
                  </a:lnTo>
                  <a:lnTo>
                    <a:pt x="197" y="183747"/>
                  </a:lnTo>
                  <a:lnTo>
                    <a:pt x="197" y="182480"/>
                  </a:lnTo>
                  <a:lnTo>
                    <a:pt x="196" y="181212"/>
                  </a:lnTo>
                  <a:lnTo>
                    <a:pt x="195" y="179945"/>
                  </a:lnTo>
                  <a:lnTo>
                    <a:pt x="195" y="178678"/>
                  </a:lnTo>
                  <a:lnTo>
                    <a:pt x="194" y="177411"/>
                  </a:lnTo>
                  <a:lnTo>
                    <a:pt x="194" y="176143"/>
                  </a:lnTo>
                  <a:lnTo>
                    <a:pt x="193" y="174876"/>
                  </a:lnTo>
                  <a:lnTo>
                    <a:pt x="193" y="173609"/>
                  </a:lnTo>
                  <a:lnTo>
                    <a:pt x="192" y="172342"/>
                  </a:lnTo>
                  <a:lnTo>
                    <a:pt x="192" y="171075"/>
                  </a:lnTo>
                  <a:lnTo>
                    <a:pt x="192" y="169807"/>
                  </a:lnTo>
                  <a:lnTo>
                    <a:pt x="192" y="168540"/>
                  </a:lnTo>
                  <a:lnTo>
                    <a:pt x="192" y="167273"/>
                  </a:lnTo>
                  <a:lnTo>
                    <a:pt x="191" y="166006"/>
                  </a:lnTo>
                  <a:lnTo>
                    <a:pt x="191" y="164738"/>
                  </a:lnTo>
                  <a:lnTo>
                    <a:pt x="191" y="163471"/>
                  </a:lnTo>
                  <a:lnTo>
                    <a:pt x="191" y="162204"/>
                  </a:lnTo>
                  <a:lnTo>
                    <a:pt x="192" y="160937"/>
                  </a:lnTo>
                  <a:lnTo>
                    <a:pt x="192" y="159670"/>
                  </a:lnTo>
                  <a:lnTo>
                    <a:pt x="192" y="158402"/>
                  </a:lnTo>
                  <a:lnTo>
                    <a:pt x="192" y="157135"/>
                  </a:lnTo>
                  <a:lnTo>
                    <a:pt x="193" y="155868"/>
                  </a:lnTo>
                  <a:lnTo>
                    <a:pt x="193" y="154601"/>
                  </a:lnTo>
                  <a:lnTo>
                    <a:pt x="193" y="153333"/>
                  </a:lnTo>
                  <a:lnTo>
                    <a:pt x="194" y="152066"/>
                  </a:lnTo>
                  <a:lnTo>
                    <a:pt x="194" y="150799"/>
                  </a:lnTo>
                  <a:lnTo>
                    <a:pt x="195" y="149532"/>
                  </a:lnTo>
                  <a:lnTo>
                    <a:pt x="196" y="148265"/>
                  </a:lnTo>
                  <a:lnTo>
                    <a:pt x="196" y="146997"/>
                  </a:lnTo>
                  <a:lnTo>
                    <a:pt x="197" y="145730"/>
                  </a:lnTo>
                  <a:lnTo>
                    <a:pt x="198" y="144463"/>
                  </a:lnTo>
                  <a:lnTo>
                    <a:pt x="199" y="143196"/>
                  </a:lnTo>
                  <a:lnTo>
                    <a:pt x="200" y="141928"/>
                  </a:lnTo>
                  <a:lnTo>
                    <a:pt x="200" y="140661"/>
                  </a:lnTo>
                  <a:lnTo>
                    <a:pt x="201" y="139394"/>
                  </a:lnTo>
                  <a:lnTo>
                    <a:pt x="202" y="138127"/>
                  </a:lnTo>
                  <a:lnTo>
                    <a:pt x="203" y="136860"/>
                  </a:lnTo>
                  <a:lnTo>
                    <a:pt x="204" y="135592"/>
                  </a:lnTo>
                  <a:lnTo>
                    <a:pt x="206" y="134325"/>
                  </a:lnTo>
                  <a:lnTo>
                    <a:pt x="207" y="133058"/>
                  </a:lnTo>
                  <a:lnTo>
                    <a:pt x="208" y="131791"/>
                  </a:lnTo>
                  <a:lnTo>
                    <a:pt x="209" y="130523"/>
                  </a:lnTo>
                  <a:lnTo>
                    <a:pt x="210" y="129256"/>
                  </a:lnTo>
                  <a:lnTo>
                    <a:pt x="212" y="127989"/>
                  </a:lnTo>
                  <a:lnTo>
                    <a:pt x="213" y="126722"/>
                  </a:lnTo>
                  <a:lnTo>
                    <a:pt x="214" y="125455"/>
                  </a:lnTo>
                  <a:lnTo>
                    <a:pt x="215" y="124187"/>
                  </a:lnTo>
                  <a:lnTo>
                    <a:pt x="217" y="122920"/>
                  </a:lnTo>
                  <a:lnTo>
                    <a:pt x="218" y="121653"/>
                  </a:lnTo>
                  <a:lnTo>
                    <a:pt x="219" y="120386"/>
                  </a:lnTo>
                  <a:lnTo>
                    <a:pt x="221" y="119118"/>
                  </a:lnTo>
                  <a:lnTo>
                    <a:pt x="222" y="117851"/>
                  </a:lnTo>
                  <a:lnTo>
                    <a:pt x="224" y="116584"/>
                  </a:lnTo>
                  <a:lnTo>
                    <a:pt x="225" y="115317"/>
                  </a:lnTo>
                  <a:lnTo>
                    <a:pt x="227" y="114050"/>
                  </a:lnTo>
                  <a:lnTo>
                    <a:pt x="228" y="112782"/>
                  </a:lnTo>
                  <a:lnTo>
                    <a:pt x="229" y="111515"/>
                  </a:lnTo>
                  <a:lnTo>
                    <a:pt x="231" y="110248"/>
                  </a:lnTo>
                  <a:lnTo>
                    <a:pt x="232" y="108981"/>
                  </a:lnTo>
                  <a:lnTo>
                    <a:pt x="234" y="107713"/>
                  </a:lnTo>
                  <a:lnTo>
                    <a:pt x="235" y="106446"/>
                  </a:lnTo>
                  <a:lnTo>
                    <a:pt x="237" y="105179"/>
                  </a:lnTo>
                  <a:lnTo>
                    <a:pt x="238" y="103912"/>
                  </a:lnTo>
                  <a:lnTo>
                    <a:pt x="239" y="102645"/>
                  </a:lnTo>
                  <a:lnTo>
                    <a:pt x="241" y="101377"/>
                  </a:lnTo>
                  <a:lnTo>
                    <a:pt x="242" y="100110"/>
                  </a:lnTo>
                  <a:lnTo>
                    <a:pt x="244" y="98843"/>
                  </a:lnTo>
                  <a:lnTo>
                    <a:pt x="245" y="97576"/>
                  </a:lnTo>
                  <a:lnTo>
                    <a:pt x="246" y="96308"/>
                  </a:lnTo>
                  <a:lnTo>
                    <a:pt x="248" y="95041"/>
                  </a:lnTo>
                  <a:lnTo>
                    <a:pt x="249" y="93774"/>
                  </a:lnTo>
                  <a:lnTo>
                    <a:pt x="250" y="92507"/>
                  </a:lnTo>
                  <a:lnTo>
                    <a:pt x="252" y="91240"/>
                  </a:lnTo>
                  <a:lnTo>
                    <a:pt x="253" y="89972"/>
                  </a:lnTo>
                  <a:lnTo>
                    <a:pt x="254" y="88705"/>
                  </a:lnTo>
                  <a:lnTo>
                    <a:pt x="256" y="87438"/>
                  </a:lnTo>
                  <a:lnTo>
                    <a:pt x="257" y="86171"/>
                  </a:lnTo>
                  <a:lnTo>
                    <a:pt x="258" y="84903"/>
                  </a:lnTo>
                  <a:lnTo>
                    <a:pt x="259" y="83636"/>
                  </a:lnTo>
                  <a:lnTo>
                    <a:pt x="260" y="82369"/>
                  </a:lnTo>
                  <a:lnTo>
                    <a:pt x="262" y="81102"/>
                  </a:lnTo>
                  <a:lnTo>
                    <a:pt x="263" y="79835"/>
                  </a:lnTo>
                  <a:lnTo>
                    <a:pt x="264" y="78567"/>
                  </a:lnTo>
                  <a:lnTo>
                    <a:pt x="265" y="77300"/>
                  </a:lnTo>
                  <a:lnTo>
                    <a:pt x="266" y="76033"/>
                  </a:lnTo>
                  <a:lnTo>
                    <a:pt x="267" y="74766"/>
                  </a:lnTo>
                  <a:lnTo>
                    <a:pt x="268" y="73498"/>
                  </a:lnTo>
                  <a:lnTo>
                    <a:pt x="269" y="72231"/>
                  </a:lnTo>
                  <a:lnTo>
                    <a:pt x="270" y="70964"/>
                  </a:lnTo>
                  <a:lnTo>
                    <a:pt x="271" y="69697"/>
                  </a:lnTo>
                  <a:lnTo>
                    <a:pt x="272" y="68430"/>
                  </a:lnTo>
                  <a:lnTo>
                    <a:pt x="273" y="67162"/>
                  </a:lnTo>
                  <a:lnTo>
                    <a:pt x="274" y="65895"/>
                  </a:lnTo>
                  <a:lnTo>
                    <a:pt x="274" y="64628"/>
                  </a:lnTo>
                  <a:lnTo>
                    <a:pt x="275" y="63361"/>
                  </a:lnTo>
                  <a:lnTo>
                    <a:pt x="276" y="62093"/>
                  </a:lnTo>
                  <a:lnTo>
                    <a:pt x="277" y="60826"/>
                  </a:lnTo>
                  <a:lnTo>
                    <a:pt x="278" y="59559"/>
                  </a:lnTo>
                  <a:lnTo>
                    <a:pt x="278" y="58292"/>
                  </a:lnTo>
                  <a:lnTo>
                    <a:pt x="279" y="57025"/>
                  </a:lnTo>
                  <a:lnTo>
                    <a:pt x="280" y="55757"/>
                  </a:lnTo>
                  <a:lnTo>
                    <a:pt x="280" y="54490"/>
                  </a:lnTo>
                  <a:lnTo>
                    <a:pt x="281" y="53223"/>
                  </a:lnTo>
                  <a:lnTo>
                    <a:pt x="282" y="51956"/>
                  </a:lnTo>
                  <a:lnTo>
                    <a:pt x="282" y="50688"/>
                  </a:lnTo>
                  <a:lnTo>
                    <a:pt x="283" y="49421"/>
                  </a:lnTo>
                  <a:lnTo>
                    <a:pt x="283" y="48154"/>
                  </a:lnTo>
                  <a:lnTo>
                    <a:pt x="284" y="46887"/>
                  </a:lnTo>
                  <a:lnTo>
                    <a:pt x="284" y="45620"/>
                  </a:lnTo>
                  <a:lnTo>
                    <a:pt x="285" y="44352"/>
                  </a:lnTo>
                  <a:lnTo>
                    <a:pt x="285" y="43085"/>
                  </a:lnTo>
                  <a:lnTo>
                    <a:pt x="286" y="41818"/>
                  </a:lnTo>
                  <a:lnTo>
                    <a:pt x="286" y="40551"/>
                  </a:lnTo>
                  <a:lnTo>
                    <a:pt x="287" y="39283"/>
                  </a:lnTo>
                  <a:lnTo>
                    <a:pt x="287" y="38016"/>
                  </a:lnTo>
                  <a:lnTo>
                    <a:pt x="287" y="36749"/>
                  </a:lnTo>
                  <a:lnTo>
                    <a:pt x="288" y="35482"/>
                  </a:lnTo>
                  <a:lnTo>
                    <a:pt x="288" y="34215"/>
                  </a:lnTo>
                  <a:lnTo>
                    <a:pt x="288" y="32947"/>
                  </a:lnTo>
                  <a:lnTo>
                    <a:pt x="289" y="31680"/>
                  </a:lnTo>
                  <a:lnTo>
                    <a:pt x="289" y="30413"/>
                  </a:lnTo>
                  <a:lnTo>
                    <a:pt x="289" y="29146"/>
                  </a:lnTo>
                  <a:lnTo>
                    <a:pt x="290" y="27878"/>
                  </a:lnTo>
                  <a:lnTo>
                    <a:pt x="290" y="26611"/>
                  </a:lnTo>
                  <a:lnTo>
                    <a:pt x="290" y="25344"/>
                  </a:lnTo>
                  <a:lnTo>
                    <a:pt x="290" y="24077"/>
                  </a:lnTo>
                  <a:lnTo>
                    <a:pt x="291" y="22810"/>
                  </a:lnTo>
                  <a:lnTo>
                    <a:pt x="291" y="21542"/>
                  </a:lnTo>
                  <a:lnTo>
                    <a:pt x="291" y="20275"/>
                  </a:lnTo>
                  <a:lnTo>
                    <a:pt x="291" y="19008"/>
                  </a:lnTo>
                  <a:lnTo>
                    <a:pt x="291" y="17741"/>
                  </a:lnTo>
                  <a:lnTo>
                    <a:pt x="292" y="16473"/>
                  </a:lnTo>
                  <a:lnTo>
                    <a:pt x="292" y="15206"/>
                  </a:lnTo>
                  <a:lnTo>
                    <a:pt x="292" y="13939"/>
                  </a:lnTo>
                  <a:lnTo>
                    <a:pt x="292" y="12672"/>
                  </a:lnTo>
                  <a:lnTo>
                    <a:pt x="292" y="11405"/>
                  </a:lnTo>
                  <a:lnTo>
                    <a:pt x="292" y="10137"/>
                  </a:lnTo>
                  <a:lnTo>
                    <a:pt x="292" y="8870"/>
                  </a:lnTo>
                  <a:lnTo>
                    <a:pt x="293" y="7603"/>
                  </a:lnTo>
                  <a:lnTo>
                    <a:pt x="293" y="6336"/>
                  </a:lnTo>
                  <a:lnTo>
                    <a:pt x="293" y="5068"/>
                  </a:lnTo>
                  <a:lnTo>
                    <a:pt x="293" y="3801"/>
                  </a:lnTo>
                  <a:lnTo>
                    <a:pt x="293" y="2534"/>
                  </a:lnTo>
                  <a:lnTo>
                    <a:pt x="293" y="1267"/>
                  </a:lnTo>
                  <a:lnTo>
                    <a:pt x="293" y="0"/>
                  </a:lnTo>
                  <a:lnTo>
                    <a:pt x="294" y="0"/>
                  </a:lnTo>
                  <a:lnTo>
                    <a:pt x="294" y="647550"/>
                  </a:lnTo>
                  <a:lnTo>
                    <a:pt x="294" y="64755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43" name="pl25"/>
            <p:cNvSpPr/>
            <p:nvPr/>
          </p:nvSpPr>
          <p:spPr>
            <a:xfrm>
              <a:off x="3356299" y="3575507"/>
              <a:ext cx="562" cy="315804"/>
            </a:xfrm>
            <a:custGeom>
              <a:avLst/>
              <a:gdLst/>
              <a:ahLst/>
              <a:cxnLst/>
              <a:rect l="0" t="0" r="0" b="0"/>
              <a:pathLst>
                <a:path w="562" h="315804">
                  <a:moveTo>
                    <a:pt x="0" y="0"/>
                  </a:moveTo>
                  <a:lnTo>
                    <a:pt x="2" y="0"/>
                  </a:lnTo>
                  <a:lnTo>
                    <a:pt x="2" y="618"/>
                  </a:lnTo>
                  <a:lnTo>
                    <a:pt x="2" y="1236"/>
                  </a:lnTo>
                  <a:lnTo>
                    <a:pt x="2" y="1854"/>
                  </a:lnTo>
                  <a:lnTo>
                    <a:pt x="2" y="2472"/>
                  </a:lnTo>
                  <a:lnTo>
                    <a:pt x="2" y="3090"/>
                  </a:lnTo>
                  <a:lnTo>
                    <a:pt x="2" y="3708"/>
                  </a:lnTo>
                  <a:lnTo>
                    <a:pt x="3" y="4326"/>
                  </a:lnTo>
                  <a:lnTo>
                    <a:pt x="3" y="4944"/>
                  </a:lnTo>
                  <a:lnTo>
                    <a:pt x="3" y="5562"/>
                  </a:lnTo>
                  <a:lnTo>
                    <a:pt x="3" y="6180"/>
                  </a:lnTo>
                  <a:lnTo>
                    <a:pt x="3" y="6798"/>
                  </a:lnTo>
                  <a:lnTo>
                    <a:pt x="4" y="7416"/>
                  </a:lnTo>
                  <a:lnTo>
                    <a:pt x="4" y="8034"/>
                  </a:lnTo>
                  <a:lnTo>
                    <a:pt x="4" y="8652"/>
                  </a:lnTo>
                  <a:lnTo>
                    <a:pt x="4" y="9270"/>
                  </a:lnTo>
                  <a:lnTo>
                    <a:pt x="5" y="9888"/>
                  </a:lnTo>
                  <a:lnTo>
                    <a:pt x="5" y="10506"/>
                  </a:lnTo>
                  <a:lnTo>
                    <a:pt x="5" y="11124"/>
                  </a:lnTo>
                  <a:lnTo>
                    <a:pt x="6" y="11742"/>
                  </a:lnTo>
                  <a:lnTo>
                    <a:pt x="6" y="12360"/>
                  </a:lnTo>
                  <a:lnTo>
                    <a:pt x="6" y="12978"/>
                  </a:lnTo>
                  <a:lnTo>
                    <a:pt x="7" y="13596"/>
                  </a:lnTo>
                  <a:lnTo>
                    <a:pt x="7" y="14214"/>
                  </a:lnTo>
                  <a:lnTo>
                    <a:pt x="7" y="14832"/>
                  </a:lnTo>
                  <a:lnTo>
                    <a:pt x="8" y="15450"/>
                  </a:lnTo>
                  <a:lnTo>
                    <a:pt x="8" y="16068"/>
                  </a:lnTo>
                  <a:lnTo>
                    <a:pt x="9" y="16686"/>
                  </a:lnTo>
                  <a:lnTo>
                    <a:pt x="9" y="17304"/>
                  </a:lnTo>
                  <a:lnTo>
                    <a:pt x="10" y="17922"/>
                  </a:lnTo>
                  <a:lnTo>
                    <a:pt x="10" y="18540"/>
                  </a:lnTo>
                  <a:lnTo>
                    <a:pt x="11" y="19158"/>
                  </a:lnTo>
                  <a:lnTo>
                    <a:pt x="11" y="19776"/>
                  </a:lnTo>
                  <a:lnTo>
                    <a:pt x="12" y="20394"/>
                  </a:lnTo>
                  <a:lnTo>
                    <a:pt x="12" y="21012"/>
                  </a:lnTo>
                  <a:lnTo>
                    <a:pt x="13" y="21630"/>
                  </a:lnTo>
                  <a:lnTo>
                    <a:pt x="14" y="22248"/>
                  </a:lnTo>
                  <a:lnTo>
                    <a:pt x="14" y="22866"/>
                  </a:lnTo>
                  <a:lnTo>
                    <a:pt x="15" y="23484"/>
                  </a:lnTo>
                  <a:lnTo>
                    <a:pt x="16" y="24102"/>
                  </a:lnTo>
                  <a:lnTo>
                    <a:pt x="16" y="24720"/>
                  </a:lnTo>
                  <a:lnTo>
                    <a:pt x="17" y="25338"/>
                  </a:lnTo>
                  <a:lnTo>
                    <a:pt x="18" y="25956"/>
                  </a:lnTo>
                  <a:lnTo>
                    <a:pt x="19" y="26574"/>
                  </a:lnTo>
                  <a:lnTo>
                    <a:pt x="20" y="27192"/>
                  </a:lnTo>
                  <a:lnTo>
                    <a:pt x="20" y="27810"/>
                  </a:lnTo>
                  <a:lnTo>
                    <a:pt x="21" y="28428"/>
                  </a:lnTo>
                  <a:lnTo>
                    <a:pt x="22" y="29046"/>
                  </a:lnTo>
                  <a:lnTo>
                    <a:pt x="23" y="29664"/>
                  </a:lnTo>
                  <a:lnTo>
                    <a:pt x="24" y="30282"/>
                  </a:lnTo>
                  <a:lnTo>
                    <a:pt x="25" y="30900"/>
                  </a:lnTo>
                  <a:lnTo>
                    <a:pt x="26" y="31518"/>
                  </a:lnTo>
                  <a:lnTo>
                    <a:pt x="27" y="32136"/>
                  </a:lnTo>
                  <a:lnTo>
                    <a:pt x="28" y="32754"/>
                  </a:lnTo>
                  <a:lnTo>
                    <a:pt x="30" y="33372"/>
                  </a:lnTo>
                  <a:lnTo>
                    <a:pt x="31" y="33990"/>
                  </a:lnTo>
                  <a:lnTo>
                    <a:pt x="32" y="34608"/>
                  </a:lnTo>
                  <a:lnTo>
                    <a:pt x="33" y="35226"/>
                  </a:lnTo>
                  <a:lnTo>
                    <a:pt x="34" y="35844"/>
                  </a:lnTo>
                  <a:lnTo>
                    <a:pt x="36" y="36462"/>
                  </a:lnTo>
                  <a:lnTo>
                    <a:pt x="37" y="37080"/>
                  </a:lnTo>
                  <a:lnTo>
                    <a:pt x="38" y="37698"/>
                  </a:lnTo>
                  <a:lnTo>
                    <a:pt x="40" y="38316"/>
                  </a:lnTo>
                  <a:lnTo>
                    <a:pt x="41" y="38934"/>
                  </a:lnTo>
                  <a:lnTo>
                    <a:pt x="43" y="39552"/>
                  </a:lnTo>
                  <a:lnTo>
                    <a:pt x="44" y="40170"/>
                  </a:lnTo>
                  <a:lnTo>
                    <a:pt x="46" y="40788"/>
                  </a:lnTo>
                  <a:lnTo>
                    <a:pt x="47" y="41406"/>
                  </a:lnTo>
                  <a:lnTo>
                    <a:pt x="49" y="42024"/>
                  </a:lnTo>
                  <a:lnTo>
                    <a:pt x="51" y="42642"/>
                  </a:lnTo>
                  <a:lnTo>
                    <a:pt x="52" y="43260"/>
                  </a:lnTo>
                  <a:lnTo>
                    <a:pt x="54" y="43878"/>
                  </a:lnTo>
                  <a:lnTo>
                    <a:pt x="56" y="44496"/>
                  </a:lnTo>
                  <a:lnTo>
                    <a:pt x="58" y="45114"/>
                  </a:lnTo>
                  <a:lnTo>
                    <a:pt x="59" y="45732"/>
                  </a:lnTo>
                  <a:lnTo>
                    <a:pt x="61" y="46350"/>
                  </a:lnTo>
                  <a:lnTo>
                    <a:pt x="63" y="46968"/>
                  </a:lnTo>
                  <a:lnTo>
                    <a:pt x="65" y="47586"/>
                  </a:lnTo>
                  <a:lnTo>
                    <a:pt x="67" y="48204"/>
                  </a:lnTo>
                  <a:lnTo>
                    <a:pt x="69" y="48822"/>
                  </a:lnTo>
                  <a:lnTo>
                    <a:pt x="71" y="49440"/>
                  </a:lnTo>
                  <a:lnTo>
                    <a:pt x="73" y="50058"/>
                  </a:lnTo>
                  <a:lnTo>
                    <a:pt x="75" y="50676"/>
                  </a:lnTo>
                  <a:lnTo>
                    <a:pt x="77" y="51295"/>
                  </a:lnTo>
                  <a:lnTo>
                    <a:pt x="79" y="51913"/>
                  </a:lnTo>
                  <a:lnTo>
                    <a:pt x="81" y="52531"/>
                  </a:lnTo>
                  <a:lnTo>
                    <a:pt x="84" y="53149"/>
                  </a:lnTo>
                  <a:lnTo>
                    <a:pt x="86" y="53767"/>
                  </a:lnTo>
                  <a:lnTo>
                    <a:pt x="88" y="54385"/>
                  </a:lnTo>
                  <a:lnTo>
                    <a:pt x="90" y="55003"/>
                  </a:lnTo>
                  <a:lnTo>
                    <a:pt x="92" y="55621"/>
                  </a:lnTo>
                  <a:lnTo>
                    <a:pt x="95" y="56239"/>
                  </a:lnTo>
                  <a:lnTo>
                    <a:pt x="97" y="56857"/>
                  </a:lnTo>
                  <a:lnTo>
                    <a:pt x="99" y="57475"/>
                  </a:lnTo>
                  <a:lnTo>
                    <a:pt x="101" y="58093"/>
                  </a:lnTo>
                  <a:lnTo>
                    <a:pt x="104" y="58711"/>
                  </a:lnTo>
                  <a:lnTo>
                    <a:pt x="106" y="59329"/>
                  </a:lnTo>
                  <a:lnTo>
                    <a:pt x="108" y="59947"/>
                  </a:lnTo>
                  <a:lnTo>
                    <a:pt x="111" y="60565"/>
                  </a:lnTo>
                  <a:lnTo>
                    <a:pt x="113" y="61183"/>
                  </a:lnTo>
                  <a:lnTo>
                    <a:pt x="115" y="61801"/>
                  </a:lnTo>
                  <a:lnTo>
                    <a:pt x="118" y="62419"/>
                  </a:lnTo>
                  <a:lnTo>
                    <a:pt x="120" y="63037"/>
                  </a:lnTo>
                  <a:lnTo>
                    <a:pt x="123" y="63655"/>
                  </a:lnTo>
                  <a:lnTo>
                    <a:pt x="125" y="64273"/>
                  </a:lnTo>
                  <a:lnTo>
                    <a:pt x="127" y="64891"/>
                  </a:lnTo>
                  <a:lnTo>
                    <a:pt x="130" y="65509"/>
                  </a:lnTo>
                  <a:lnTo>
                    <a:pt x="132" y="66127"/>
                  </a:lnTo>
                  <a:lnTo>
                    <a:pt x="134" y="66745"/>
                  </a:lnTo>
                  <a:lnTo>
                    <a:pt x="137" y="67363"/>
                  </a:lnTo>
                  <a:lnTo>
                    <a:pt x="139" y="67981"/>
                  </a:lnTo>
                  <a:lnTo>
                    <a:pt x="141" y="68599"/>
                  </a:lnTo>
                  <a:lnTo>
                    <a:pt x="143" y="69217"/>
                  </a:lnTo>
                  <a:lnTo>
                    <a:pt x="146" y="69835"/>
                  </a:lnTo>
                  <a:lnTo>
                    <a:pt x="148" y="70453"/>
                  </a:lnTo>
                  <a:lnTo>
                    <a:pt x="150" y="71071"/>
                  </a:lnTo>
                  <a:lnTo>
                    <a:pt x="152" y="71689"/>
                  </a:lnTo>
                  <a:lnTo>
                    <a:pt x="155" y="72307"/>
                  </a:lnTo>
                  <a:lnTo>
                    <a:pt x="157" y="72925"/>
                  </a:lnTo>
                  <a:lnTo>
                    <a:pt x="159" y="73543"/>
                  </a:lnTo>
                  <a:lnTo>
                    <a:pt x="161" y="74161"/>
                  </a:lnTo>
                  <a:lnTo>
                    <a:pt x="163" y="74779"/>
                  </a:lnTo>
                  <a:lnTo>
                    <a:pt x="165" y="75397"/>
                  </a:lnTo>
                  <a:lnTo>
                    <a:pt x="167" y="76015"/>
                  </a:lnTo>
                  <a:lnTo>
                    <a:pt x="169" y="76633"/>
                  </a:lnTo>
                  <a:lnTo>
                    <a:pt x="171" y="77251"/>
                  </a:lnTo>
                  <a:lnTo>
                    <a:pt x="173" y="77869"/>
                  </a:lnTo>
                  <a:lnTo>
                    <a:pt x="175" y="78487"/>
                  </a:lnTo>
                  <a:lnTo>
                    <a:pt x="176" y="79105"/>
                  </a:lnTo>
                  <a:lnTo>
                    <a:pt x="178" y="79723"/>
                  </a:lnTo>
                  <a:lnTo>
                    <a:pt x="180" y="80341"/>
                  </a:lnTo>
                  <a:lnTo>
                    <a:pt x="182" y="80959"/>
                  </a:lnTo>
                  <a:lnTo>
                    <a:pt x="183" y="81577"/>
                  </a:lnTo>
                  <a:lnTo>
                    <a:pt x="185" y="82195"/>
                  </a:lnTo>
                  <a:lnTo>
                    <a:pt x="186" y="82813"/>
                  </a:lnTo>
                  <a:lnTo>
                    <a:pt x="188" y="83431"/>
                  </a:lnTo>
                  <a:lnTo>
                    <a:pt x="189" y="84049"/>
                  </a:lnTo>
                  <a:lnTo>
                    <a:pt x="191" y="84667"/>
                  </a:lnTo>
                  <a:lnTo>
                    <a:pt x="192" y="85285"/>
                  </a:lnTo>
                  <a:lnTo>
                    <a:pt x="193" y="85903"/>
                  </a:lnTo>
                  <a:lnTo>
                    <a:pt x="195" y="86521"/>
                  </a:lnTo>
                  <a:lnTo>
                    <a:pt x="196" y="87139"/>
                  </a:lnTo>
                  <a:lnTo>
                    <a:pt x="197" y="87757"/>
                  </a:lnTo>
                  <a:lnTo>
                    <a:pt x="198" y="88375"/>
                  </a:lnTo>
                  <a:lnTo>
                    <a:pt x="199" y="88993"/>
                  </a:lnTo>
                  <a:lnTo>
                    <a:pt x="200" y="89611"/>
                  </a:lnTo>
                  <a:lnTo>
                    <a:pt x="201" y="90229"/>
                  </a:lnTo>
                  <a:lnTo>
                    <a:pt x="202" y="90847"/>
                  </a:lnTo>
                  <a:lnTo>
                    <a:pt x="203" y="91465"/>
                  </a:lnTo>
                  <a:lnTo>
                    <a:pt x="204" y="92083"/>
                  </a:lnTo>
                  <a:lnTo>
                    <a:pt x="205" y="92701"/>
                  </a:lnTo>
                  <a:lnTo>
                    <a:pt x="206" y="93319"/>
                  </a:lnTo>
                  <a:lnTo>
                    <a:pt x="206" y="93937"/>
                  </a:lnTo>
                  <a:lnTo>
                    <a:pt x="207" y="94555"/>
                  </a:lnTo>
                  <a:lnTo>
                    <a:pt x="208" y="95173"/>
                  </a:lnTo>
                  <a:lnTo>
                    <a:pt x="208" y="95791"/>
                  </a:lnTo>
                  <a:lnTo>
                    <a:pt x="209" y="96409"/>
                  </a:lnTo>
                  <a:lnTo>
                    <a:pt x="209" y="97027"/>
                  </a:lnTo>
                  <a:lnTo>
                    <a:pt x="210" y="97645"/>
                  </a:lnTo>
                  <a:lnTo>
                    <a:pt x="210" y="98263"/>
                  </a:lnTo>
                  <a:lnTo>
                    <a:pt x="210" y="98881"/>
                  </a:lnTo>
                  <a:lnTo>
                    <a:pt x="211" y="99499"/>
                  </a:lnTo>
                  <a:lnTo>
                    <a:pt x="211" y="100117"/>
                  </a:lnTo>
                  <a:lnTo>
                    <a:pt x="211" y="100735"/>
                  </a:lnTo>
                  <a:lnTo>
                    <a:pt x="212" y="101353"/>
                  </a:lnTo>
                  <a:lnTo>
                    <a:pt x="212" y="101971"/>
                  </a:lnTo>
                  <a:lnTo>
                    <a:pt x="212" y="102590"/>
                  </a:lnTo>
                  <a:lnTo>
                    <a:pt x="212" y="103208"/>
                  </a:lnTo>
                  <a:lnTo>
                    <a:pt x="213" y="103826"/>
                  </a:lnTo>
                  <a:lnTo>
                    <a:pt x="213" y="104444"/>
                  </a:lnTo>
                  <a:lnTo>
                    <a:pt x="213" y="105062"/>
                  </a:lnTo>
                  <a:lnTo>
                    <a:pt x="213" y="105680"/>
                  </a:lnTo>
                  <a:lnTo>
                    <a:pt x="213" y="106298"/>
                  </a:lnTo>
                  <a:lnTo>
                    <a:pt x="213" y="106916"/>
                  </a:lnTo>
                  <a:lnTo>
                    <a:pt x="213" y="107534"/>
                  </a:lnTo>
                  <a:lnTo>
                    <a:pt x="213" y="108152"/>
                  </a:lnTo>
                  <a:lnTo>
                    <a:pt x="213" y="108770"/>
                  </a:lnTo>
                  <a:lnTo>
                    <a:pt x="213" y="109388"/>
                  </a:lnTo>
                  <a:lnTo>
                    <a:pt x="214" y="110006"/>
                  </a:lnTo>
                  <a:lnTo>
                    <a:pt x="214" y="110624"/>
                  </a:lnTo>
                  <a:lnTo>
                    <a:pt x="214" y="111242"/>
                  </a:lnTo>
                  <a:lnTo>
                    <a:pt x="214" y="111860"/>
                  </a:lnTo>
                  <a:lnTo>
                    <a:pt x="214" y="112478"/>
                  </a:lnTo>
                  <a:lnTo>
                    <a:pt x="214" y="113096"/>
                  </a:lnTo>
                  <a:lnTo>
                    <a:pt x="214" y="113714"/>
                  </a:lnTo>
                  <a:lnTo>
                    <a:pt x="214" y="114332"/>
                  </a:lnTo>
                  <a:lnTo>
                    <a:pt x="214" y="114950"/>
                  </a:lnTo>
                  <a:lnTo>
                    <a:pt x="214" y="115568"/>
                  </a:lnTo>
                  <a:lnTo>
                    <a:pt x="214" y="116186"/>
                  </a:lnTo>
                  <a:lnTo>
                    <a:pt x="214" y="116804"/>
                  </a:lnTo>
                  <a:lnTo>
                    <a:pt x="215" y="117422"/>
                  </a:lnTo>
                  <a:lnTo>
                    <a:pt x="215" y="118040"/>
                  </a:lnTo>
                  <a:lnTo>
                    <a:pt x="215" y="118658"/>
                  </a:lnTo>
                  <a:lnTo>
                    <a:pt x="215" y="119276"/>
                  </a:lnTo>
                  <a:lnTo>
                    <a:pt x="215" y="119894"/>
                  </a:lnTo>
                  <a:lnTo>
                    <a:pt x="216" y="120512"/>
                  </a:lnTo>
                  <a:lnTo>
                    <a:pt x="216" y="121130"/>
                  </a:lnTo>
                  <a:lnTo>
                    <a:pt x="216" y="121748"/>
                  </a:lnTo>
                  <a:lnTo>
                    <a:pt x="217" y="122366"/>
                  </a:lnTo>
                  <a:lnTo>
                    <a:pt x="217" y="122984"/>
                  </a:lnTo>
                  <a:lnTo>
                    <a:pt x="217" y="123602"/>
                  </a:lnTo>
                  <a:lnTo>
                    <a:pt x="218" y="124220"/>
                  </a:lnTo>
                  <a:lnTo>
                    <a:pt x="218" y="124838"/>
                  </a:lnTo>
                  <a:lnTo>
                    <a:pt x="219" y="125456"/>
                  </a:lnTo>
                  <a:lnTo>
                    <a:pt x="219" y="126074"/>
                  </a:lnTo>
                  <a:lnTo>
                    <a:pt x="220" y="126692"/>
                  </a:lnTo>
                  <a:lnTo>
                    <a:pt x="221" y="127310"/>
                  </a:lnTo>
                  <a:lnTo>
                    <a:pt x="221" y="127928"/>
                  </a:lnTo>
                  <a:lnTo>
                    <a:pt x="222" y="128546"/>
                  </a:lnTo>
                  <a:lnTo>
                    <a:pt x="223" y="129164"/>
                  </a:lnTo>
                  <a:lnTo>
                    <a:pt x="223" y="129782"/>
                  </a:lnTo>
                  <a:lnTo>
                    <a:pt x="224" y="130400"/>
                  </a:lnTo>
                  <a:lnTo>
                    <a:pt x="225" y="131018"/>
                  </a:lnTo>
                  <a:lnTo>
                    <a:pt x="226" y="131636"/>
                  </a:lnTo>
                  <a:lnTo>
                    <a:pt x="227" y="132254"/>
                  </a:lnTo>
                  <a:lnTo>
                    <a:pt x="228" y="132872"/>
                  </a:lnTo>
                  <a:lnTo>
                    <a:pt x="229" y="133490"/>
                  </a:lnTo>
                  <a:lnTo>
                    <a:pt x="230" y="134108"/>
                  </a:lnTo>
                  <a:lnTo>
                    <a:pt x="231" y="134726"/>
                  </a:lnTo>
                  <a:lnTo>
                    <a:pt x="232" y="135344"/>
                  </a:lnTo>
                  <a:lnTo>
                    <a:pt x="233" y="135962"/>
                  </a:lnTo>
                  <a:lnTo>
                    <a:pt x="234" y="136580"/>
                  </a:lnTo>
                  <a:lnTo>
                    <a:pt x="236" y="137198"/>
                  </a:lnTo>
                  <a:lnTo>
                    <a:pt x="237" y="137816"/>
                  </a:lnTo>
                  <a:lnTo>
                    <a:pt x="238" y="138434"/>
                  </a:lnTo>
                  <a:lnTo>
                    <a:pt x="240" y="139052"/>
                  </a:lnTo>
                  <a:lnTo>
                    <a:pt x="241" y="139670"/>
                  </a:lnTo>
                  <a:lnTo>
                    <a:pt x="242" y="140288"/>
                  </a:lnTo>
                  <a:lnTo>
                    <a:pt x="244" y="140906"/>
                  </a:lnTo>
                  <a:lnTo>
                    <a:pt x="245" y="141524"/>
                  </a:lnTo>
                  <a:lnTo>
                    <a:pt x="247" y="142142"/>
                  </a:lnTo>
                  <a:lnTo>
                    <a:pt x="248" y="142760"/>
                  </a:lnTo>
                  <a:lnTo>
                    <a:pt x="250" y="143378"/>
                  </a:lnTo>
                  <a:lnTo>
                    <a:pt x="252" y="143996"/>
                  </a:lnTo>
                  <a:lnTo>
                    <a:pt x="253" y="144614"/>
                  </a:lnTo>
                  <a:lnTo>
                    <a:pt x="255" y="145232"/>
                  </a:lnTo>
                  <a:lnTo>
                    <a:pt x="257" y="145850"/>
                  </a:lnTo>
                  <a:lnTo>
                    <a:pt x="259" y="146468"/>
                  </a:lnTo>
                  <a:lnTo>
                    <a:pt x="261" y="147086"/>
                  </a:lnTo>
                  <a:lnTo>
                    <a:pt x="262" y="147704"/>
                  </a:lnTo>
                  <a:lnTo>
                    <a:pt x="264" y="148322"/>
                  </a:lnTo>
                  <a:lnTo>
                    <a:pt x="266" y="148940"/>
                  </a:lnTo>
                  <a:lnTo>
                    <a:pt x="268" y="149558"/>
                  </a:lnTo>
                  <a:lnTo>
                    <a:pt x="270" y="150176"/>
                  </a:lnTo>
                  <a:lnTo>
                    <a:pt x="272" y="150794"/>
                  </a:lnTo>
                  <a:lnTo>
                    <a:pt x="275" y="151412"/>
                  </a:lnTo>
                  <a:lnTo>
                    <a:pt x="277" y="152030"/>
                  </a:lnTo>
                  <a:lnTo>
                    <a:pt x="279" y="152648"/>
                  </a:lnTo>
                  <a:lnTo>
                    <a:pt x="281" y="153266"/>
                  </a:lnTo>
                  <a:lnTo>
                    <a:pt x="283" y="153885"/>
                  </a:lnTo>
                  <a:lnTo>
                    <a:pt x="286" y="154503"/>
                  </a:lnTo>
                  <a:lnTo>
                    <a:pt x="288" y="155121"/>
                  </a:lnTo>
                  <a:lnTo>
                    <a:pt x="291" y="155739"/>
                  </a:lnTo>
                  <a:lnTo>
                    <a:pt x="293" y="156357"/>
                  </a:lnTo>
                  <a:lnTo>
                    <a:pt x="295" y="156975"/>
                  </a:lnTo>
                  <a:lnTo>
                    <a:pt x="298" y="157593"/>
                  </a:lnTo>
                  <a:lnTo>
                    <a:pt x="300" y="158211"/>
                  </a:lnTo>
                  <a:lnTo>
                    <a:pt x="303" y="158829"/>
                  </a:lnTo>
                  <a:lnTo>
                    <a:pt x="306" y="159447"/>
                  </a:lnTo>
                  <a:lnTo>
                    <a:pt x="308" y="160065"/>
                  </a:lnTo>
                  <a:lnTo>
                    <a:pt x="311" y="160683"/>
                  </a:lnTo>
                  <a:lnTo>
                    <a:pt x="314" y="161301"/>
                  </a:lnTo>
                  <a:lnTo>
                    <a:pt x="317" y="161919"/>
                  </a:lnTo>
                  <a:lnTo>
                    <a:pt x="319" y="162537"/>
                  </a:lnTo>
                  <a:lnTo>
                    <a:pt x="322" y="163155"/>
                  </a:lnTo>
                  <a:lnTo>
                    <a:pt x="325" y="163773"/>
                  </a:lnTo>
                  <a:lnTo>
                    <a:pt x="328" y="164391"/>
                  </a:lnTo>
                  <a:lnTo>
                    <a:pt x="331" y="165009"/>
                  </a:lnTo>
                  <a:lnTo>
                    <a:pt x="334" y="165627"/>
                  </a:lnTo>
                  <a:lnTo>
                    <a:pt x="337" y="166245"/>
                  </a:lnTo>
                  <a:lnTo>
                    <a:pt x="340" y="166863"/>
                  </a:lnTo>
                  <a:lnTo>
                    <a:pt x="344" y="167481"/>
                  </a:lnTo>
                  <a:lnTo>
                    <a:pt x="347" y="168099"/>
                  </a:lnTo>
                  <a:lnTo>
                    <a:pt x="350" y="168717"/>
                  </a:lnTo>
                  <a:lnTo>
                    <a:pt x="353" y="169335"/>
                  </a:lnTo>
                  <a:lnTo>
                    <a:pt x="357" y="169953"/>
                  </a:lnTo>
                  <a:lnTo>
                    <a:pt x="360" y="170571"/>
                  </a:lnTo>
                  <a:lnTo>
                    <a:pt x="363" y="171189"/>
                  </a:lnTo>
                  <a:lnTo>
                    <a:pt x="367" y="171807"/>
                  </a:lnTo>
                  <a:lnTo>
                    <a:pt x="370" y="172425"/>
                  </a:lnTo>
                  <a:lnTo>
                    <a:pt x="374" y="173043"/>
                  </a:lnTo>
                  <a:lnTo>
                    <a:pt x="378" y="173661"/>
                  </a:lnTo>
                  <a:lnTo>
                    <a:pt x="381" y="174279"/>
                  </a:lnTo>
                  <a:lnTo>
                    <a:pt x="385" y="174897"/>
                  </a:lnTo>
                  <a:lnTo>
                    <a:pt x="388" y="175515"/>
                  </a:lnTo>
                  <a:lnTo>
                    <a:pt x="392" y="176133"/>
                  </a:lnTo>
                  <a:lnTo>
                    <a:pt x="396" y="176751"/>
                  </a:lnTo>
                  <a:lnTo>
                    <a:pt x="400" y="177369"/>
                  </a:lnTo>
                  <a:lnTo>
                    <a:pt x="403" y="177987"/>
                  </a:lnTo>
                  <a:lnTo>
                    <a:pt x="407" y="178605"/>
                  </a:lnTo>
                  <a:lnTo>
                    <a:pt x="411" y="179223"/>
                  </a:lnTo>
                  <a:lnTo>
                    <a:pt x="415" y="179841"/>
                  </a:lnTo>
                  <a:lnTo>
                    <a:pt x="419" y="180459"/>
                  </a:lnTo>
                  <a:lnTo>
                    <a:pt x="423" y="181077"/>
                  </a:lnTo>
                  <a:lnTo>
                    <a:pt x="427" y="181695"/>
                  </a:lnTo>
                  <a:lnTo>
                    <a:pt x="430" y="182313"/>
                  </a:lnTo>
                  <a:lnTo>
                    <a:pt x="434" y="182931"/>
                  </a:lnTo>
                  <a:lnTo>
                    <a:pt x="438" y="183549"/>
                  </a:lnTo>
                  <a:lnTo>
                    <a:pt x="442" y="184167"/>
                  </a:lnTo>
                  <a:lnTo>
                    <a:pt x="446" y="184785"/>
                  </a:lnTo>
                  <a:lnTo>
                    <a:pt x="450" y="185403"/>
                  </a:lnTo>
                  <a:lnTo>
                    <a:pt x="454" y="186021"/>
                  </a:lnTo>
                  <a:lnTo>
                    <a:pt x="458" y="186639"/>
                  </a:lnTo>
                  <a:lnTo>
                    <a:pt x="462" y="187257"/>
                  </a:lnTo>
                  <a:lnTo>
                    <a:pt x="466" y="187875"/>
                  </a:lnTo>
                  <a:lnTo>
                    <a:pt x="470" y="188493"/>
                  </a:lnTo>
                  <a:lnTo>
                    <a:pt x="473" y="189111"/>
                  </a:lnTo>
                  <a:lnTo>
                    <a:pt x="477" y="189729"/>
                  </a:lnTo>
                  <a:lnTo>
                    <a:pt x="481" y="190347"/>
                  </a:lnTo>
                  <a:lnTo>
                    <a:pt x="485" y="190965"/>
                  </a:lnTo>
                  <a:lnTo>
                    <a:pt x="488" y="191583"/>
                  </a:lnTo>
                  <a:lnTo>
                    <a:pt x="492" y="192201"/>
                  </a:lnTo>
                  <a:lnTo>
                    <a:pt x="496" y="192819"/>
                  </a:lnTo>
                  <a:lnTo>
                    <a:pt x="499" y="193437"/>
                  </a:lnTo>
                  <a:lnTo>
                    <a:pt x="503" y="194055"/>
                  </a:lnTo>
                  <a:lnTo>
                    <a:pt x="506" y="194673"/>
                  </a:lnTo>
                  <a:lnTo>
                    <a:pt x="510" y="195291"/>
                  </a:lnTo>
                  <a:lnTo>
                    <a:pt x="513" y="195909"/>
                  </a:lnTo>
                  <a:lnTo>
                    <a:pt x="516" y="196527"/>
                  </a:lnTo>
                  <a:lnTo>
                    <a:pt x="519" y="197145"/>
                  </a:lnTo>
                  <a:lnTo>
                    <a:pt x="523" y="197763"/>
                  </a:lnTo>
                  <a:lnTo>
                    <a:pt x="526" y="198381"/>
                  </a:lnTo>
                  <a:lnTo>
                    <a:pt x="528" y="198999"/>
                  </a:lnTo>
                  <a:lnTo>
                    <a:pt x="531" y="199617"/>
                  </a:lnTo>
                  <a:lnTo>
                    <a:pt x="534" y="200235"/>
                  </a:lnTo>
                  <a:lnTo>
                    <a:pt x="537" y="200853"/>
                  </a:lnTo>
                  <a:lnTo>
                    <a:pt x="539" y="201471"/>
                  </a:lnTo>
                  <a:lnTo>
                    <a:pt x="542" y="202089"/>
                  </a:lnTo>
                  <a:lnTo>
                    <a:pt x="544" y="202707"/>
                  </a:lnTo>
                  <a:lnTo>
                    <a:pt x="546" y="203325"/>
                  </a:lnTo>
                  <a:lnTo>
                    <a:pt x="548" y="203943"/>
                  </a:lnTo>
                  <a:lnTo>
                    <a:pt x="550" y="204561"/>
                  </a:lnTo>
                  <a:lnTo>
                    <a:pt x="552" y="205180"/>
                  </a:lnTo>
                  <a:lnTo>
                    <a:pt x="553" y="205798"/>
                  </a:lnTo>
                  <a:lnTo>
                    <a:pt x="555" y="206416"/>
                  </a:lnTo>
                  <a:lnTo>
                    <a:pt x="556" y="207034"/>
                  </a:lnTo>
                  <a:lnTo>
                    <a:pt x="558" y="207652"/>
                  </a:lnTo>
                  <a:lnTo>
                    <a:pt x="559" y="208270"/>
                  </a:lnTo>
                  <a:lnTo>
                    <a:pt x="560" y="208888"/>
                  </a:lnTo>
                  <a:lnTo>
                    <a:pt x="560" y="209506"/>
                  </a:lnTo>
                  <a:lnTo>
                    <a:pt x="561" y="210124"/>
                  </a:lnTo>
                  <a:lnTo>
                    <a:pt x="561" y="210742"/>
                  </a:lnTo>
                  <a:lnTo>
                    <a:pt x="562" y="211360"/>
                  </a:lnTo>
                  <a:lnTo>
                    <a:pt x="562" y="211978"/>
                  </a:lnTo>
                  <a:lnTo>
                    <a:pt x="562" y="212596"/>
                  </a:lnTo>
                  <a:lnTo>
                    <a:pt x="562" y="213214"/>
                  </a:lnTo>
                  <a:lnTo>
                    <a:pt x="561" y="213832"/>
                  </a:lnTo>
                  <a:lnTo>
                    <a:pt x="561" y="214450"/>
                  </a:lnTo>
                  <a:lnTo>
                    <a:pt x="560" y="215068"/>
                  </a:lnTo>
                  <a:lnTo>
                    <a:pt x="559" y="215686"/>
                  </a:lnTo>
                  <a:lnTo>
                    <a:pt x="558" y="216304"/>
                  </a:lnTo>
                  <a:lnTo>
                    <a:pt x="557" y="216922"/>
                  </a:lnTo>
                  <a:lnTo>
                    <a:pt x="556" y="217540"/>
                  </a:lnTo>
                  <a:lnTo>
                    <a:pt x="554" y="218158"/>
                  </a:lnTo>
                  <a:lnTo>
                    <a:pt x="553" y="218776"/>
                  </a:lnTo>
                  <a:lnTo>
                    <a:pt x="551" y="219394"/>
                  </a:lnTo>
                  <a:lnTo>
                    <a:pt x="549" y="220012"/>
                  </a:lnTo>
                  <a:lnTo>
                    <a:pt x="546" y="220630"/>
                  </a:lnTo>
                  <a:lnTo>
                    <a:pt x="544" y="221248"/>
                  </a:lnTo>
                  <a:lnTo>
                    <a:pt x="541" y="221866"/>
                  </a:lnTo>
                  <a:lnTo>
                    <a:pt x="539" y="222484"/>
                  </a:lnTo>
                  <a:lnTo>
                    <a:pt x="536" y="223102"/>
                  </a:lnTo>
                  <a:lnTo>
                    <a:pt x="533" y="223720"/>
                  </a:lnTo>
                  <a:lnTo>
                    <a:pt x="530" y="224338"/>
                  </a:lnTo>
                  <a:lnTo>
                    <a:pt x="526" y="224956"/>
                  </a:lnTo>
                  <a:lnTo>
                    <a:pt x="523" y="225574"/>
                  </a:lnTo>
                  <a:lnTo>
                    <a:pt x="519" y="226192"/>
                  </a:lnTo>
                  <a:lnTo>
                    <a:pt x="515" y="226810"/>
                  </a:lnTo>
                  <a:lnTo>
                    <a:pt x="511" y="227428"/>
                  </a:lnTo>
                  <a:lnTo>
                    <a:pt x="507" y="228046"/>
                  </a:lnTo>
                  <a:lnTo>
                    <a:pt x="503" y="228664"/>
                  </a:lnTo>
                  <a:lnTo>
                    <a:pt x="498" y="229282"/>
                  </a:lnTo>
                  <a:lnTo>
                    <a:pt x="494" y="229900"/>
                  </a:lnTo>
                  <a:lnTo>
                    <a:pt x="489" y="230518"/>
                  </a:lnTo>
                  <a:lnTo>
                    <a:pt x="484" y="231136"/>
                  </a:lnTo>
                  <a:lnTo>
                    <a:pt x="479" y="231754"/>
                  </a:lnTo>
                  <a:lnTo>
                    <a:pt x="474" y="232372"/>
                  </a:lnTo>
                  <a:lnTo>
                    <a:pt x="469" y="232990"/>
                  </a:lnTo>
                  <a:lnTo>
                    <a:pt x="464" y="233608"/>
                  </a:lnTo>
                  <a:lnTo>
                    <a:pt x="459" y="234226"/>
                  </a:lnTo>
                  <a:lnTo>
                    <a:pt x="453" y="234844"/>
                  </a:lnTo>
                  <a:lnTo>
                    <a:pt x="448" y="235462"/>
                  </a:lnTo>
                  <a:lnTo>
                    <a:pt x="442" y="236080"/>
                  </a:lnTo>
                  <a:lnTo>
                    <a:pt x="436" y="236698"/>
                  </a:lnTo>
                  <a:lnTo>
                    <a:pt x="430" y="237316"/>
                  </a:lnTo>
                  <a:lnTo>
                    <a:pt x="424" y="237934"/>
                  </a:lnTo>
                  <a:lnTo>
                    <a:pt x="419" y="238552"/>
                  </a:lnTo>
                  <a:lnTo>
                    <a:pt x="412" y="239170"/>
                  </a:lnTo>
                  <a:lnTo>
                    <a:pt x="406" y="239788"/>
                  </a:lnTo>
                  <a:lnTo>
                    <a:pt x="400" y="240406"/>
                  </a:lnTo>
                  <a:lnTo>
                    <a:pt x="394" y="241024"/>
                  </a:lnTo>
                  <a:lnTo>
                    <a:pt x="388" y="241642"/>
                  </a:lnTo>
                  <a:lnTo>
                    <a:pt x="381" y="242260"/>
                  </a:lnTo>
                  <a:lnTo>
                    <a:pt x="375" y="242878"/>
                  </a:lnTo>
                  <a:lnTo>
                    <a:pt x="369" y="243496"/>
                  </a:lnTo>
                  <a:lnTo>
                    <a:pt x="362" y="244114"/>
                  </a:lnTo>
                  <a:lnTo>
                    <a:pt x="356" y="244732"/>
                  </a:lnTo>
                  <a:lnTo>
                    <a:pt x="350" y="245350"/>
                  </a:lnTo>
                  <a:lnTo>
                    <a:pt x="343" y="245968"/>
                  </a:lnTo>
                  <a:lnTo>
                    <a:pt x="337" y="246586"/>
                  </a:lnTo>
                  <a:lnTo>
                    <a:pt x="330" y="247204"/>
                  </a:lnTo>
                  <a:lnTo>
                    <a:pt x="324" y="247822"/>
                  </a:lnTo>
                  <a:lnTo>
                    <a:pt x="317" y="248440"/>
                  </a:lnTo>
                  <a:lnTo>
                    <a:pt x="311" y="249058"/>
                  </a:lnTo>
                  <a:lnTo>
                    <a:pt x="304" y="249676"/>
                  </a:lnTo>
                  <a:lnTo>
                    <a:pt x="298" y="250294"/>
                  </a:lnTo>
                  <a:lnTo>
                    <a:pt x="292" y="250912"/>
                  </a:lnTo>
                  <a:lnTo>
                    <a:pt x="285" y="251530"/>
                  </a:lnTo>
                  <a:lnTo>
                    <a:pt x="279" y="252148"/>
                  </a:lnTo>
                  <a:lnTo>
                    <a:pt x="273" y="252766"/>
                  </a:lnTo>
                  <a:lnTo>
                    <a:pt x="266" y="253384"/>
                  </a:lnTo>
                  <a:lnTo>
                    <a:pt x="260" y="254002"/>
                  </a:lnTo>
                  <a:lnTo>
                    <a:pt x="254" y="254620"/>
                  </a:lnTo>
                  <a:lnTo>
                    <a:pt x="248" y="255238"/>
                  </a:lnTo>
                  <a:lnTo>
                    <a:pt x="242" y="255856"/>
                  </a:lnTo>
                  <a:lnTo>
                    <a:pt x="236" y="256475"/>
                  </a:lnTo>
                  <a:lnTo>
                    <a:pt x="230" y="257093"/>
                  </a:lnTo>
                  <a:lnTo>
                    <a:pt x="224" y="257711"/>
                  </a:lnTo>
                  <a:lnTo>
                    <a:pt x="218" y="258329"/>
                  </a:lnTo>
                  <a:lnTo>
                    <a:pt x="213" y="258947"/>
                  </a:lnTo>
                  <a:lnTo>
                    <a:pt x="207" y="259565"/>
                  </a:lnTo>
                  <a:lnTo>
                    <a:pt x="201" y="260183"/>
                  </a:lnTo>
                  <a:lnTo>
                    <a:pt x="196" y="260801"/>
                  </a:lnTo>
                  <a:lnTo>
                    <a:pt x="190" y="261419"/>
                  </a:lnTo>
                  <a:lnTo>
                    <a:pt x="185" y="262037"/>
                  </a:lnTo>
                  <a:lnTo>
                    <a:pt x="180" y="262655"/>
                  </a:lnTo>
                  <a:lnTo>
                    <a:pt x="175" y="263273"/>
                  </a:lnTo>
                  <a:lnTo>
                    <a:pt x="169" y="263891"/>
                  </a:lnTo>
                  <a:lnTo>
                    <a:pt x="164" y="264509"/>
                  </a:lnTo>
                  <a:lnTo>
                    <a:pt x="160" y="265127"/>
                  </a:lnTo>
                  <a:lnTo>
                    <a:pt x="155" y="265745"/>
                  </a:lnTo>
                  <a:lnTo>
                    <a:pt x="150" y="266363"/>
                  </a:lnTo>
                  <a:lnTo>
                    <a:pt x="145" y="266981"/>
                  </a:lnTo>
                  <a:lnTo>
                    <a:pt x="141" y="267599"/>
                  </a:lnTo>
                  <a:lnTo>
                    <a:pt x="136" y="268217"/>
                  </a:lnTo>
                  <a:lnTo>
                    <a:pt x="132" y="268835"/>
                  </a:lnTo>
                  <a:lnTo>
                    <a:pt x="127" y="269453"/>
                  </a:lnTo>
                  <a:lnTo>
                    <a:pt x="123" y="270071"/>
                  </a:lnTo>
                  <a:lnTo>
                    <a:pt x="119" y="270689"/>
                  </a:lnTo>
                  <a:lnTo>
                    <a:pt x="115" y="271307"/>
                  </a:lnTo>
                  <a:lnTo>
                    <a:pt x="111" y="271925"/>
                  </a:lnTo>
                  <a:lnTo>
                    <a:pt x="107" y="272543"/>
                  </a:lnTo>
                  <a:lnTo>
                    <a:pt x="104" y="273161"/>
                  </a:lnTo>
                  <a:lnTo>
                    <a:pt x="100" y="273779"/>
                  </a:lnTo>
                  <a:lnTo>
                    <a:pt x="96" y="274397"/>
                  </a:lnTo>
                  <a:lnTo>
                    <a:pt x="93" y="275015"/>
                  </a:lnTo>
                  <a:lnTo>
                    <a:pt x="89" y="275633"/>
                  </a:lnTo>
                  <a:lnTo>
                    <a:pt x="86" y="276251"/>
                  </a:lnTo>
                  <a:lnTo>
                    <a:pt x="83" y="276869"/>
                  </a:lnTo>
                  <a:lnTo>
                    <a:pt x="80" y="277487"/>
                  </a:lnTo>
                  <a:lnTo>
                    <a:pt x="77" y="278105"/>
                  </a:lnTo>
                  <a:lnTo>
                    <a:pt x="74" y="278723"/>
                  </a:lnTo>
                  <a:lnTo>
                    <a:pt x="71" y="279341"/>
                  </a:lnTo>
                  <a:lnTo>
                    <a:pt x="68" y="279959"/>
                  </a:lnTo>
                  <a:lnTo>
                    <a:pt x="66" y="280577"/>
                  </a:lnTo>
                  <a:lnTo>
                    <a:pt x="63" y="281195"/>
                  </a:lnTo>
                  <a:lnTo>
                    <a:pt x="60" y="281813"/>
                  </a:lnTo>
                  <a:lnTo>
                    <a:pt x="58" y="282431"/>
                  </a:lnTo>
                  <a:lnTo>
                    <a:pt x="56" y="283049"/>
                  </a:lnTo>
                  <a:lnTo>
                    <a:pt x="53" y="283667"/>
                  </a:lnTo>
                  <a:lnTo>
                    <a:pt x="51" y="284285"/>
                  </a:lnTo>
                  <a:lnTo>
                    <a:pt x="49" y="284903"/>
                  </a:lnTo>
                  <a:lnTo>
                    <a:pt x="47" y="285521"/>
                  </a:lnTo>
                  <a:lnTo>
                    <a:pt x="45" y="286139"/>
                  </a:lnTo>
                  <a:lnTo>
                    <a:pt x="43" y="286757"/>
                  </a:lnTo>
                  <a:lnTo>
                    <a:pt x="41" y="287375"/>
                  </a:lnTo>
                  <a:lnTo>
                    <a:pt x="39" y="287993"/>
                  </a:lnTo>
                  <a:lnTo>
                    <a:pt x="37" y="288611"/>
                  </a:lnTo>
                  <a:lnTo>
                    <a:pt x="36" y="289229"/>
                  </a:lnTo>
                  <a:lnTo>
                    <a:pt x="34" y="289847"/>
                  </a:lnTo>
                  <a:lnTo>
                    <a:pt x="32" y="290465"/>
                  </a:lnTo>
                  <a:lnTo>
                    <a:pt x="31" y="291083"/>
                  </a:lnTo>
                  <a:lnTo>
                    <a:pt x="30" y="291701"/>
                  </a:lnTo>
                  <a:lnTo>
                    <a:pt x="28" y="292319"/>
                  </a:lnTo>
                  <a:lnTo>
                    <a:pt x="27" y="292937"/>
                  </a:lnTo>
                  <a:lnTo>
                    <a:pt x="25" y="293555"/>
                  </a:lnTo>
                  <a:lnTo>
                    <a:pt x="24" y="294173"/>
                  </a:lnTo>
                  <a:lnTo>
                    <a:pt x="23" y="294791"/>
                  </a:lnTo>
                  <a:lnTo>
                    <a:pt x="22" y="295409"/>
                  </a:lnTo>
                  <a:lnTo>
                    <a:pt x="21" y="296027"/>
                  </a:lnTo>
                  <a:lnTo>
                    <a:pt x="20" y="296645"/>
                  </a:lnTo>
                  <a:lnTo>
                    <a:pt x="19" y="297263"/>
                  </a:lnTo>
                  <a:lnTo>
                    <a:pt x="18" y="297881"/>
                  </a:lnTo>
                  <a:lnTo>
                    <a:pt x="17" y="298499"/>
                  </a:lnTo>
                  <a:lnTo>
                    <a:pt x="16" y="299117"/>
                  </a:lnTo>
                  <a:lnTo>
                    <a:pt x="15" y="299735"/>
                  </a:lnTo>
                  <a:lnTo>
                    <a:pt x="14" y="300353"/>
                  </a:lnTo>
                  <a:lnTo>
                    <a:pt x="14" y="300971"/>
                  </a:lnTo>
                  <a:lnTo>
                    <a:pt x="13" y="301589"/>
                  </a:lnTo>
                  <a:lnTo>
                    <a:pt x="12" y="302207"/>
                  </a:lnTo>
                  <a:lnTo>
                    <a:pt x="12" y="302825"/>
                  </a:lnTo>
                  <a:lnTo>
                    <a:pt x="11" y="303443"/>
                  </a:lnTo>
                  <a:lnTo>
                    <a:pt x="10" y="304061"/>
                  </a:lnTo>
                  <a:lnTo>
                    <a:pt x="10" y="304679"/>
                  </a:lnTo>
                  <a:lnTo>
                    <a:pt x="9" y="305297"/>
                  </a:lnTo>
                  <a:lnTo>
                    <a:pt x="9" y="305915"/>
                  </a:lnTo>
                  <a:lnTo>
                    <a:pt x="8" y="306533"/>
                  </a:lnTo>
                  <a:lnTo>
                    <a:pt x="8" y="307151"/>
                  </a:lnTo>
                  <a:lnTo>
                    <a:pt x="7" y="307770"/>
                  </a:lnTo>
                  <a:lnTo>
                    <a:pt x="7" y="308388"/>
                  </a:lnTo>
                  <a:lnTo>
                    <a:pt x="6" y="309006"/>
                  </a:lnTo>
                  <a:lnTo>
                    <a:pt x="6" y="309624"/>
                  </a:lnTo>
                  <a:lnTo>
                    <a:pt x="6" y="310242"/>
                  </a:lnTo>
                  <a:lnTo>
                    <a:pt x="5" y="310860"/>
                  </a:lnTo>
                  <a:lnTo>
                    <a:pt x="5" y="311478"/>
                  </a:lnTo>
                  <a:lnTo>
                    <a:pt x="5" y="312096"/>
                  </a:lnTo>
                  <a:lnTo>
                    <a:pt x="4" y="312714"/>
                  </a:lnTo>
                  <a:lnTo>
                    <a:pt x="4" y="313332"/>
                  </a:lnTo>
                  <a:lnTo>
                    <a:pt x="4" y="313950"/>
                  </a:lnTo>
                  <a:lnTo>
                    <a:pt x="3" y="314568"/>
                  </a:lnTo>
                  <a:lnTo>
                    <a:pt x="3" y="315186"/>
                  </a:lnTo>
                  <a:lnTo>
                    <a:pt x="3" y="315804"/>
                  </a:lnTo>
                  <a:lnTo>
                    <a:pt x="0" y="315804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44" name="pl26"/>
            <p:cNvSpPr/>
            <p:nvPr/>
          </p:nvSpPr>
          <p:spPr>
            <a:xfrm>
              <a:off x="3627169" y="3295135"/>
              <a:ext cx="338" cy="455758"/>
            </a:xfrm>
            <a:custGeom>
              <a:avLst/>
              <a:gdLst/>
              <a:ahLst/>
              <a:cxnLst/>
              <a:rect l="0" t="0" r="0" b="0"/>
              <a:pathLst>
                <a:path w="338" h="455758">
                  <a:moveTo>
                    <a:pt x="338" y="455758"/>
                  </a:moveTo>
                  <a:lnTo>
                    <a:pt x="337" y="455758"/>
                  </a:lnTo>
                  <a:lnTo>
                    <a:pt x="337" y="454866"/>
                  </a:lnTo>
                  <a:lnTo>
                    <a:pt x="337" y="453975"/>
                  </a:lnTo>
                  <a:lnTo>
                    <a:pt x="337" y="453083"/>
                  </a:lnTo>
                  <a:lnTo>
                    <a:pt x="337" y="452191"/>
                  </a:lnTo>
                  <a:lnTo>
                    <a:pt x="337" y="451299"/>
                  </a:lnTo>
                  <a:lnTo>
                    <a:pt x="336" y="450407"/>
                  </a:lnTo>
                  <a:lnTo>
                    <a:pt x="336" y="449515"/>
                  </a:lnTo>
                  <a:lnTo>
                    <a:pt x="336" y="448623"/>
                  </a:lnTo>
                  <a:lnTo>
                    <a:pt x="336" y="447731"/>
                  </a:lnTo>
                  <a:lnTo>
                    <a:pt x="336" y="446839"/>
                  </a:lnTo>
                  <a:lnTo>
                    <a:pt x="336" y="445948"/>
                  </a:lnTo>
                  <a:lnTo>
                    <a:pt x="336" y="445056"/>
                  </a:lnTo>
                  <a:lnTo>
                    <a:pt x="335" y="444164"/>
                  </a:lnTo>
                  <a:lnTo>
                    <a:pt x="335" y="443272"/>
                  </a:lnTo>
                  <a:lnTo>
                    <a:pt x="335" y="442380"/>
                  </a:lnTo>
                  <a:lnTo>
                    <a:pt x="335" y="441488"/>
                  </a:lnTo>
                  <a:lnTo>
                    <a:pt x="335" y="440596"/>
                  </a:lnTo>
                  <a:lnTo>
                    <a:pt x="334" y="439704"/>
                  </a:lnTo>
                  <a:lnTo>
                    <a:pt x="334" y="438812"/>
                  </a:lnTo>
                  <a:lnTo>
                    <a:pt x="334" y="437920"/>
                  </a:lnTo>
                  <a:lnTo>
                    <a:pt x="334" y="437029"/>
                  </a:lnTo>
                  <a:lnTo>
                    <a:pt x="333" y="436137"/>
                  </a:lnTo>
                  <a:lnTo>
                    <a:pt x="333" y="435245"/>
                  </a:lnTo>
                  <a:lnTo>
                    <a:pt x="333" y="434353"/>
                  </a:lnTo>
                  <a:lnTo>
                    <a:pt x="333" y="433461"/>
                  </a:lnTo>
                  <a:lnTo>
                    <a:pt x="332" y="432569"/>
                  </a:lnTo>
                  <a:lnTo>
                    <a:pt x="332" y="431677"/>
                  </a:lnTo>
                  <a:lnTo>
                    <a:pt x="332" y="430785"/>
                  </a:lnTo>
                  <a:lnTo>
                    <a:pt x="331" y="429893"/>
                  </a:lnTo>
                  <a:lnTo>
                    <a:pt x="331" y="429001"/>
                  </a:lnTo>
                  <a:lnTo>
                    <a:pt x="330" y="428110"/>
                  </a:lnTo>
                  <a:lnTo>
                    <a:pt x="330" y="427218"/>
                  </a:lnTo>
                  <a:lnTo>
                    <a:pt x="330" y="426326"/>
                  </a:lnTo>
                  <a:lnTo>
                    <a:pt x="329" y="425434"/>
                  </a:lnTo>
                  <a:lnTo>
                    <a:pt x="329" y="424542"/>
                  </a:lnTo>
                  <a:lnTo>
                    <a:pt x="328" y="423650"/>
                  </a:lnTo>
                  <a:lnTo>
                    <a:pt x="328" y="422758"/>
                  </a:lnTo>
                  <a:lnTo>
                    <a:pt x="327" y="421866"/>
                  </a:lnTo>
                  <a:lnTo>
                    <a:pt x="327" y="420974"/>
                  </a:lnTo>
                  <a:lnTo>
                    <a:pt x="326" y="420083"/>
                  </a:lnTo>
                  <a:lnTo>
                    <a:pt x="326" y="419191"/>
                  </a:lnTo>
                  <a:lnTo>
                    <a:pt x="325" y="418299"/>
                  </a:lnTo>
                  <a:lnTo>
                    <a:pt x="324" y="417407"/>
                  </a:lnTo>
                  <a:lnTo>
                    <a:pt x="324" y="416515"/>
                  </a:lnTo>
                  <a:lnTo>
                    <a:pt x="323" y="415623"/>
                  </a:lnTo>
                  <a:lnTo>
                    <a:pt x="322" y="414731"/>
                  </a:lnTo>
                  <a:lnTo>
                    <a:pt x="322" y="413839"/>
                  </a:lnTo>
                  <a:lnTo>
                    <a:pt x="321" y="412947"/>
                  </a:lnTo>
                  <a:lnTo>
                    <a:pt x="320" y="412055"/>
                  </a:lnTo>
                  <a:lnTo>
                    <a:pt x="319" y="411164"/>
                  </a:lnTo>
                  <a:lnTo>
                    <a:pt x="318" y="410272"/>
                  </a:lnTo>
                  <a:lnTo>
                    <a:pt x="318" y="409380"/>
                  </a:lnTo>
                  <a:lnTo>
                    <a:pt x="317" y="408488"/>
                  </a:lnTo>
                  <a:lnTo>
                    <a:pt x="316" y="407596"/>
                  </a:lnTo>
                  <a:lnTo>
                    <a:pt x="315" y="406704"/>
                  </a:lnTo>
                  <a:lnTo>
                    <a:pt x="314" y="405812"/>
                  </a:lnTo>
                  <a:lnTo>
                    <a:pt x="313" y="404920"/>
                  </a:lnTo>
                  <a:lnTo>
                    <a:pt x="312" y="404028"/>
                  </a:lnTo>
                  <a:lnTo>
                    <a:pt x="311" y="403136"/>
                  </a:lnTo>
                  <a:lnTo>
                    <a:pt x="310" y="402245"/>
                  </a:lnTo>
                  <a:lnTo>
                    <a:pt x="309" y="401353"/>
                  </a:lnTo>
                  <a:lnTo>
                    <a:pt x="307" y="400461"/>
                  </a:lnTo>
                  <a:lnTo>
                    <a:pt x="306" y="399569"/>
                  </a:lnTo>
                  <a:lnTo>
                    <a:pt x="305" y="398677"/>
                  </a:lnTo>
                  <a:lnTo>
                    <a:pt x="304" y="397785"/>
                  </a:lnTo>
                  <a:lnTo>
                    <a:pt x="302" y="396893"/>
                  </a:lnTo>
                  <a:lnTo>
                    <a:pt x="301" y="396001"/>
                  </a:lnTo>
                  <a:lnTo>
                    <a:pt x="300" y="395109"/>
                  </a:lnTo>
                  <a:lnTo>
                    <a:pt x="298" y="394218"/>
                  </a:lnTo>
                  <a:lnTo>
                    <a:pt x="297" y="393326"/>
                  </a:lnTo>
                  <a:lnTo>
                    <a:pt x="295" y="392434"/>
                  </a:lnTo>
                  <a:lnTo>
                    <a:pt x="294" y="391542"/>
                  </a:lnTo>
                  <a:lnTo>
                    <a:pt x="292" y="390650"/>
                  </a:lnTo>
                  <a:lnTo>
                    <a:pt x="291" y="389758"/>
                  </a:lnTo>
                  <a:lnTo>
                    <a:pt x="289" y="388866"/>
                  </a:lnTo>
                  <a:lnTo>
                    <a:pt x="287" y="387974"/>
                  </a:lnTo>
                  <a:lnTo>
                    <a:pt x="286" y="387082"/>
                  </a:lnTo>
                  <a:lnTo>
                    <a:pt x="284" y="386190"/>
                  </a:lnTo>
                  <a:lnTo>
                    <a:pt x="282" y="385299"/>
                  </a:lnTo>
                  <a:lnTo>
                    <a:pt x="280" y="384407"/>
                  </a:lnTo>
                  <a:lnTo>
                    <a:pt x="278" y="383515"/>
                  </a:lnTo>
                  <a:lnTo>
                    <a:pt x="277" y="382623"/>
                  </a:lnTo>
                  <a:lnTo>
                    <a:pt x="275" y="381731"/>
                  </a:lnTo>
                  <a:lnTo>
                    <a:pt x="273" y="380839"/>
                  </a:lnTo>
                  <a:lnTo>
                    <a:pt x="271" y="379947"/>
                  </a:lnTo>
                  <a:lnTo>
                    <a:pt x="269" y="379055"/>
                  </a:lnTo>
                  <a:lnTo>
                    <a:pt x="266" y="378163"/>
                  </a:lnTo>
                  <a:lnTo>
                    <a:pt x="264" y="377272"/>
                  </a:lnTo>
                  <a:lnTo>
                    <a:pt x="262" y="376380"/>
                  </a:lnTo>
                  <a:lnTo>
                    <a:pt x="260" y="375488"/>
                  </a:lnTo>
                  <a:lnTo>
                    <a:pt x="258" y="374596"/>
                  </a:lnTo>
                  <a:lnTo>
                    <a:pt x="255" y="373704"/>
                  </a:lnTo>
                  <a:lnTo>
                    <a:pt x="253" y="372812"/>
                  </a:lnTo>
                  <a:lnTo>
                    <a:pt x="251" y="371920"/>
                  </a:lnTo>
                  <a:lnTo>
                    <a:pt x="248" y="371028"/>
                  </a:lnTo>
                  <a:lnTo>
                    <a:pt x="246" y="370136"/>
                  </a:lnTo>
                  <a:lnTo>
                    <a:pt x="243" y="369244"/>
                  </a:lnTo>
                  <a:lnTo>
                    <a:pt x="241" y="368353"/>
                  </a:lnTo>
                  <a:lnTo>
                    <a:pt x="238" y="367461"/>
                  </a:lnTo>
                  <a:lnTo>
                    <a:pt x="235" y="366569"/>
                  </a:lnTo>
                  <a:lnTo>
                    <a:pt x="233" y="365677"/>
                  </a:lnTo>
                  <a:lnTo>
                    <a:pt x="230" y="364785"/>
                  </a:lnTo>
                  <a:lnTo>
                    <a:pt x="227" y="363893"/>
                  </a:lnTo>
                  <a:lnTo>
                    <a:pt x="225" y="363001"/>
                  </a:lnTo>
                  <a:lnTo>
                    <a:pt x="222" y="362109"/>
                  </a:lnTo>
                  <a:lnTo>
                    <a:pt x="219" y="361217"/>
                  </a:lnTo>
                  <a:lnTo>
                    <a:pt x="216" y="360325"/>
                  </a:lnTo>
                  <a:lnTo>
                    <a:pt x="213" y="359434"/>
                  </a:lnTo>
                  <a:lnTo>
                    <a:pt x="210" y="358542"/>
                  </a:lnTo>
                  <a:lnTo>
                    <a:pt x="207" y="357650"/>
                  </a:lnTo>
                  <a:lnTo>
                    <a:pt x="204" y="356758"/>
                  </a:lnTo>
                  <a:lnTo>
                    <a:pt x="201" y="355866"/>
                  </a:lnTo>
                  <a:lnTo>
                    <a:pt x="198" y="354974"/>
                  </a:lnTo>
                  <a:lnTo>
                    <a:pt x="195" y="354082"/>
                  </a:lnTo>
                  <a:lnTo>
                    <a:pt x="192" y="353190"/>
                  </a:lnTo>
                  <a:lnTo>
                    <a:pt x="189" y="352298"/>
                  </a:lnTo>
                  <a:lnTo>
                    <a:pt x="186" y="351407"/>
                  </a:lnTo>
                  <a:lnTo>
                    <a:pt x="183" y="350515"/>
                  </a:lnTo>
                  <a:lnTo>
                    <a:pt x="180" y="349623"/>
                  </a:lnTo>
                  <a:lnTo>
                    <a:pt x="177" y="348731"/>
                  </a:lnTo>
                  <a:lnTo>
                    <a:pt x="173" y="347839"/>
                  </a:lnTo>
                  <a:lnTo>
                    <a:pt x="170" y="346947"/>
                  </a:lnTo>
                  <a:lnTo>
                    <a:pt x="167" y="346055"/>
                  </a:lnTo>
                  <a:lnTo>
                    <a:pt x="164" y="345163"/>
                  </a:lnTo>
                  <a:lnTo>
                    <a:pt x="160" y="344271"/>
                  </a:lnTo>
                  <a:lnTo>
                    <a:pt x="157" y="343379"/>
                  </a:lnTo>
                  <a:lnTo>
                    <a:pt x="154" y="342488"/>
                  </a:lnTo>
                  <a:lnTo>
                    <a:pt x="151" y="341596"/>
                  </a:lnTo>
                  <a:lnTo>
                    <a:pt x="147" y="340704"/>
                  </a:lnTo>
                  <a:lnTo>
                    <a:pt x="144" y="339812"/>
                  </a:lnTo>
                  <a:lnTo>
                    <a:pt x="141" y="338920"/>
                  </a:lnTo>
                  <a:lnTo>
                    <a:pt x="137" y="338028"/>
                  </a:lnTo>
                  <a:lnTo>
                    <a:pt x="134" y="337136"/>
                  </a:lnTo>
                  <a:lnTo>
                    <a:pt x="131" y="336244"/>
                  </a:lnTo>
                  <a:lnTo>
                    <a:pt x="127" y="335352"/>
                  </a:lnTo>
                  <a:lnTo>
                    <a:pt x="124" y="334461"/>
                  </a:lnTo>
                  <a:lnTo>
                    <a:pt x="121" y="333569"/>
                  </a:lnTo>
                  <a:lnTo>
                    <a:pt x="118" y="332677"/>
                  </a:lnTo>
                  <a:lnTo>
                    <a:pt x="114" y="331785"/>
                  </a:lnTo>
                  <a:lnTo>
                    <a:pt x="111" y="330893"/>
                  </a:lnTo>
                  <a:lnTo>
                    <a:pt x="108" y="330001"/>
                  </a:lnTo>
                  <a:lnTo>
                    <a:pt x="105" y="329109"/>
                  </a:lnTo>
                  <a:lnTo>
                    <a:pt x="101" y="328217"/>
                  </a:lnTo>
                  <a:lnTo>
                    <a:pt x="98" y="327325"/>
                  </a:lnTo>
                  <a:lnTo>
                    <a:pt x="95" y="326433"/>
                  </a:lnTo>
                  <a:lnTo>
                    <a:pt x="92" y="325542"/>
                  </a:lnTo>
                  <a:lnTo>
                    <a:pt x="89" y="324650"/>
                  </a:lnTo>
                  <a:lnTo>
                    <a:pt x="86" y="323758"/>
                  </a:lnTo>
                  <a:lnTo>
                    <a:pt x="82" y="322866"/>
                  </a:lnTo>
                  <a:lnTo>
                    <a:pt x="79" y="321974"/>
                  </a:lnTo>
                  <a:lnTo>
                    <a:pt x="76" y="321082"/>
                  </a:lnTo>
                  <a:lnTo>
                    <a:pt x="73" y="320190"/>
                  </a:lnTo>
                  <a:lnTo>
                    <a:pt x="71" y="319298"/>
                  </a:lnTo>
                  <a:lnTo>
                    <a:pt x="68" y="318406"/>
                  </a:lnTo>
                  <a:lnTo>
                    <a:pt x="65" y="317514"/>
                  </a:lnTo>
                  <a:lnTo>
                    <a:pt x="62" y="316623"/>
                  </a:lnTo>
                  <a:lnTo>
                    <a:pt x="59" y="315731"/>
                  </a:lnTo>
                  <a:lnTo>
                    <a:pt x="56" y="314839"/>
                  </a:lnTo>
                  <a:lnTo>
                    <a:pt x="54" y="313947"/>
                  </a:lnTo>
                  <a:lnTo>
                    <a:pt x="51" y="313055"/>
                  </a:lnTo>
                  <a:lnTo>
                    <a:pt x="48" y="312163"/>
                  </a:lnTo>
                  <a:lnTo>
                    <a:pt x="46" y="311271"/>
                  </a:lnTo>
                  <a:lnTo>
                    <a:pt x="43" y="310379"/>
                  </a:lnTo>
                  <a:lnTo>
                    <a:pt x="41" y="309487"/>
                  </a:lnTo>
                  <a:lnTo>
                    <a:pt x="39" y="308596"/>
                  </a:lnTo>
                  <a:lnTo>
                    <a:pt x="36" y="307704"/>
                  </a:lnTo>
                  <a:lnTo>
                    <a:pt x="34" y="306812"/>
                  </a:lnTo>
                  <a:lnTo>
                    <a:pt x="32" y="305920"/>
                  </a:lnTo>
                  <a:lnTo>
                    <a:pt x="30" y="305028"/>
                  </a:lnTo>
                  <a:lnTo>
                    <a:pt x="28" y="304136"/>
                  </a:lnTo>
                  <a:lnTo>
                    <a:pt x="26" y="303244"/>
                  </a:lnTo>
                  <a:lnTo>
                    <a:pt x="24" y="302352"/>
                  </a:lnTo>
                  <a:lnTo>
                    <a:pt x="22" y="301460"/>
                  </a:lnTo>
                  <a:lnTo>
                    <a:pt x="20" y="300568"/>
                  </a:lnTo>
                  <a:lnTo>
                    <a:pt x="18" y="299677"/>
                  </a:lnTo>
                  <a:lnTo>
                    <a:pt x="17" y="298785"/>
                  </a:lnTo>
                  <a:lnTo>
                    <a:pt x="15" y="297893"/>
                  </a:lnTo>
                  <a:lnTo>
                    <a:pt x="13" y="297001"/>
                  </a:lnTo>
                  <a:lnTo>
                    <a:pt x="12" y="296109"/>
                  </a:lnTo>
                  <a:lnTo>
                    <a:pt x="11" y="295217"/>
                  </a:lnTo>
                  <a:lnTo>
                    <a:pt x="9" y="294325"/>
                  </a:lnTo>
                  <a:lnTo>
                    <a:pt x="8" y="293433"/>
                  </a:lnTo>
                  <a:lnTo>
                    <a:pt x="7" y="292541"/>
                  </a:lnTo>
                  <a:lnTo>
                    <a:pt x="6" y="291649"/>
                  </a:lnTo>
                  <a:lnTo>
                    <a:pt x="5" y="290758"/>
                  </a:lnTo>
                  <a:lnTo>
                    <a:pt x="4" y="289866"/>
                  </a:lnTo>
                  <a:lnTo>
                    <a:pt x="3" y="288974"/>
                  </a:lnTo>
                  <a:lnTo>
                    <a:pt x="3" y="288082"/>
                  </a:lnTo>
                  <a:lnTo>
                    <a:pt x="2" y="287190"/>
                  </a:lnTo>
                  <a:lnTo>
                    <a:pt x="1" y="286298"/>
                  </a:lnTo>
                  <a:lnTo>
                    <a:pt x="1" y="285406"/>
                  </a:lnTo>
                  <a:lnTo>
                    <a:pt x="0" y="284514"/>
                  </a:lnTo>
                  <a:lnTo>
                    <a:pt x="0" y="283622"/>
                  </a:lnTo>
                  <a:lnTo>
                    <a:pt x="0" y="282731"/>
                  </a:lnTo>
                  <a:lnTo>
                    <a:pt x="0" y="281839"/>
                  </a:lnTo>
                  <a:lnTo>
                    <a:pt x="0" y="280947"/>
                  </a:lnTo>
                  <a:lnTo>
                    <a:pt x="0" y="280055"/>
                  </a:lnTo>
                  <a:lnTo>
                    <a:pt x="0" y="279163"/>
                  </a:lnTo>
                  <a:lnTo>
                    <a:pt x="0" y="278271"/>
                  </a:lnTo>
                  <a:lnTo>
                    <a:pt x="0" y="277379"/>
                  </a:lnTo>
                  <a:lnTo>
                    <a:pt x="0" y="276487"/>
                  </a:lnTo>
                  <a:lnTo>
                    <a:pt x="1" y="275595"/>
                  </a:lnTo>
                  <a:lnTo>
                    <a:pt x="1" y="274703"/>
                  </a:lnTo>
                  <a:lnTo>
                    <a:pt x="2" y="273812"/>
                  </a:lnTo>
                  <a:lnTo>
                    <a:pt x="2" y="272920"/>
                  </a:lnTo>
                  <a:lnTo>
                    <a:pt x="3" y="272028"/>
                  </a:lnTo>
                  <a:lnTo>
                    <a:pt x="4" y="271136"/>
                  </a:lnTo>
                  <a:lnTo>
                    <a:pt x="4" y="270244"/>
                  </a:lnTo>
                  <a:lnTo>
                    <a:pt x="5" y="269352"/>
                  </a:lnTo>
                  <a:lnTo>
                    <a:pt x="6" y="268460"/>
                  </a:lnTo>
                  <a:lnTo>
                    <a:pt x="7" y="267568"/>
                  </a:lnTo>
                  <a:lnTo>
                    <a:pt x="8" y="266676"/>
                  </a:lnTo>
                  <a:lnTo>
                    <a:pt x="9" y="265785"/>
                  </a:lnTo>
                  <a:lnTo>
                    <a:pt x="11" y="264893"/>
                  </a:lnTo>
                  <a:lnTo>
                    <a:pt x="12" y="264001"/>
                  </a:lnTo>
                  <a:lnTo>
                    <a:pt x="13" y="263109"/>
                  </a:lnTo>
                  <a:lnTo>
                    <a:pt x="15" y="262217"/>
                  </a:lnTo>
                  <a:lnTo>
                    <a:pt x="16" y="261325"/>
                  </a:lnTo>
                  <a:lnTo>
                    <a:pt x="17" y="260433"/>
                  </a:lnTo>
                  <a:lnTo>
                    <a:pt x="19" y="259541"/>
                  </a:lnTo>
                  <a:lnTo>
                    <a:pt x="20" y="258649"/>
                  </a:lnTo>
                  <a:lnTo>
                    <a:pt x="22" y="257757"/>
                  </a:lnTo>
                  <a:lnTo>
                    <a:pt x="24" y="256866"/>
                  </a:lnTo>
                  <a:lnTo>
                    <a:pt x="25" y="255974"/>
                  </a:lnTo>
                  <a:lnTo>
                    <a:pt x="27" y="255082"/>
                  </a:lnTo>
                  <a:lnTo>
                    <a:pt x="29" y="254190"/>
                  </a:lnTo>
                  <a:lnTo>
                    <a:pt x="30" y="253298"/>
                  </a:lnTo>
                  <a:lnTo>
                    <a:pt x="32" y="252406"/>
                  </a:lnTo>
                  <a:lnTo>
                    <a:pt x="34" y="251514"/>
                  </a:lnTo>
                  <a:lnTo>
                    <a:pt x="36" y="250622"/>
                  </a:lnTo>
                  <a:lnTo>
                    <a:pt x="38" y="249730"/>
                  </a:lnTo>
                  <a:lnTo>
                    <a:pt x="40" y="248838"/>
                  </a:lnTo>
                  <a:lnTo>
                    <a:pt x="41" y="247947"/>
                  </a:lnTo>
                  <a:lnTo>
                    <a:pt x="43" y="247055"/>
                  </a:lnTo>
                  <a:lnTo>
                    <a:pt x="45" y="246163"/>
                  </a:lnTo>
                  <a:lnTo>
                    <a:pt x="47" y="245271"/>
                  </a:lnTo>
                  <a:lnTo>
                    <a:pt x="49" y="244379"/>
                  </a:lnTo>
                  <a:lnTo>
                    <a:pt x="51" y="243487"/>
                  </a:lnTo>
                  <a:lnTo>
                    <a:pt x="53" y="242595"/>
                  </a:lnTo>
                  <a:lnTo>
                    <a:pt x="55" y="241703"/>
                  </a:lnTo>
                  <a:lnTo>
                    <a:pt x="57" y="240811"/>
                  </a:lnTo>
                  <a:lnTo>
                    <a:pt x="59" y="239920"/>
                  </a:lnTo>
                  <a:lnTo>
                    <a:pt x="60" y="239028"/>
                  </a:lnTo>
                  <a:lnTo>
                    <a:pt x="62" y="238136"/>
                  </a:lnTo>
                  <a:lnTo>
                    <a:pt x="64" y="237244"/>
                  </a:lnTo>
                  <a:lnTo>
                    <a:pt x="66" y="236352"/>
                  </a:lnTo>
                  <a:lnTo>
                    <a:pt x="68" y="235460"/>
                  </a:lnTo>
                  <a:lnTo>
                    <a:pt x="70" y="234568"/>
                  </a:lnTo>
                  <a:lnTo>
                    <a:pt x="71" y="233676"/>
                  </a:lnTo>
                  <a:lnTo>
                    <a:pt x="73" y="232784"/>
                  </a:lnTo>
                  <a:lnTo>
                    <a:pt x="75" y="231892"/>
                  </a:lnTo>
                  <a:lnTo>
                    <a:pt x="76" y="231001"/>
                  </a:lnTo>
                  <a:lnTo>
                    <a:pt x="78" y="230109"/>
                  </a:lnTo>
                  <a:lnTo>
                    <a:pt x="80" y="229217"/>
                  </a:lnTo>
                  <a:lnTo>
                    <a:pt x="81" y="228325"/>
                  </a:lnTo>
                  <a:lnTo>
                    <a:pt x="83" y="227433"/>
                  </a:lnTo>
                  <a:lnTo>
                    <a:pt x="84" y="226541"/>
                  </a:lnTo>
                  <a:lnTo>
                    <a:pt x="86" y="225649"/>
                  </a:lnTo>
                  <a:lnTo>
                    <a:pt x="87" y="224757"/>
                  </a:lnTo>
                  <a:lnTo>
                    <a:pt x="89" y="223865"/>
                  </a:lnTo>
                  <a:lnTo>
                    <a:pt x="90" y="222974"/>
                  </a:lnTo>
                  <a:lnTo>
                    <a:pt x="91" y="222082"/>
                  </a:lnTo>
                  <a:lnTo>
                    <a:pt x="92" y="221190"/>
                  </a:lnTo>
                  <a:lnTo>
                    <a:pt x="94" y="220298"/>
                  </a:lnTo>
                  <a:lnTo>
                    <a:pt x="95" y="219406"/>
                  </a:lnTo>
                  <a:lnTo>
                    <a:pt x="96" y="218514"/>
                  </a:lnTo>
                  <a:lnTo>
                    <a:pt x="97" y="217622"/>
                  </a:lnTo>
                  <a:lnTo>
                    <a:pt x="98" y="216730"/>
                  </a:lnTo>
                  <a:lnTo>
                    <a:pt x="99" y="215838"/>
                  </a:lnTo>
                  <a:lnTo>
                    <a:pt x="100" y="214946"/>
                  </a:lnTo>
                  <a:lnTo>
                    <a:pt x="101" y="214055"/>
                  </a:lnTo>
                  <a:lnTo>
                    <a:pt x="102" y="213163"/>
                  </a:lnTo>
                  <a:lnTo>
                    <a:pt x="103" y="212271"/>
                  </a:lnTo>
                  <a:lnTo>
                    <a:pt x="103" y="211379"/>
                  </a:lnTo>
                  <a:lnTo>
                    <a:pt x="104" y="210487"/>
                  </a:lnTo>
                  <a:lnTo>
                    <a:pt x="105" y="209595"/>
                  </a:lnTo>
                  <a:lnTo>
                    <a:pt x="105" y="208703"/>
                  </a:lnTo>
                  <a:lnTo>
                    <a:pt x="106" y="207811"/>
                  </a:lnTo>
                  <a:lnTo>
                    <a:pt x="106" y="206919"/>
                  </a:lnTo>
                  <a:lnTo>
                    <a:pt x="107" y="206027"/>
                  </a:lnTo>
                  <a:lnTo>
                    <a:pt x="107" y="205136"/>
                  </a:lnTo>
                  <a:lnTo>
                    <a:pt x="108" y="204244"/>
                  </a:lnTo>
                  <a:lnTo>
                    <a:pt x="108" y="203352"/>
                  </a:lnTo>
                  <a:lnTo>
                    <a:pt x="108" y="202460"/>
                  </a:lnTo>
                  <a:lnTo>
                    <a:pt x="109" y="201568"/>
                  </a:lnTo>
                  <a:lnTo>
                    <a:pt x="109" y="200676"/>
                  </a:lnTo>
                  <a:lnTo>
                    <a:pt x="109" y="199784"/>
                  </a:lnTo>
                  <a:lnTo>
                    <a:pt x="109" y="198892"/>
                  </a:lnTo>
                  <a:lnTo>
                    <a:pt x="110" y="198000"/>
                  </a:lnTo>
                  <a:lnTo>
                    <a:pt x="110" y="197109"/>
                  </a:lnTo>
                  <a:lnTo>
                    <a:pt x="110" y="196217"/>
                  </a:lnTo>
                  <a:lnTo>
                    <a:pt x="110" y="195325"/>
                  </a:lnTo>
                  <a:lnTo>
                    <a:pt x="110" y="194433"/>
                  </a:lnTo>
                  <a:lnTo>
                    <a:pt x="110" y="193541"/>
                  </a:lnTo>
                  <a:lnTo>
                    <a:pt x="110" y="192649"/>
                  </a:lnTo>
                  <a:lnTo>
                    <a:pt x="110" y="191757"/>
                  </a:lnTo>
                  <a:lnTo>
                    <a:pt x="110" y="190865"/>
                  </a:lnTo>
                  <a:lnTo>
                    <a:pt x="110" y="189973"/>
                  </a:lnTo>
                  <a:lnTo>
                    <a:pt x="110" y="189081"/>
                  </a:lnTo>
                  <a:lnTo>
                    <a:pt x="110" y="188190"/>
                  </a:lnTo>
                  <a:lnTo>
                    <a:pt x="110" y="187298"/>
                  </a:lnTo>
                  <a:lnTo>
                    <a:pt x="110" y="186406"/>
                  </a:lnTo>
                  <a:lnTo>
                    <a:pt x="109" y="185514"/>
                  </a:lnTo>
                  <a:lnTo>
                    <a:pt x="109" y="184622"/>
                  </a:lnTo>
                  <a:lnTo>
                    <a:pt x="109" y="183730"/>
                  </a:lnTo>
                  <a:lnTo>
                    <a:pt x="109" y="182838"/>
                  </a:lnTo>
                  <a:lnTo>
                    <a:pt x="109" y="181946"/>
                  </a:lnTo>
                  <a:lnTo>
                    <a:pt x="109" y="181054"/>
                  </a:lnTo>
                  <a:lnTo>
                    <a:pt x="109" y="180162"/>
                  </a:lnTo>
                  <a:lnTo>
                    <a:pt x="109" y="179271"/>
                  </a:lnTo>
                  <a:lnTo>
                    <a:pt x="108" y="178379"/>
                  </a:lnTo>
                  <a:lnTo>
                    <a:pt x="108" y="177487"/>
                  </a:lnTo>
                  <a:lnTo>
                    <a:pt x="108" y="176595"/>
                  </a:lnTo>
                  <a:lnTo>
                    <a:pt x="108" y="175703"/>
                  </a:lnTo>
                  <a:lnTo>
                    <a:pt x="108" y="174811"/>
                  </a:lnTo>
                  <a:lnTo>
                    <a:pt x="108" y="173919"/>
                  </a:lnTo>
                  <a:lnTo>
                    <a:pt x="108" y="173027"/>
                  </a:lnTo>
                  <a:lnTo>
                    <a:pt x="108" y="172135"/>
                  </a:lnTo>
                  <a:lnTo>
                    <a:pt x="108" y="171244"/>
                  </a:lnTo>
                  <a:lnTo>
                    <a:pt x="108" y="170352"/>
                  </a:lnTo>
                  <a:lnTo>
                    <a:pt x="108" y="169460"/>
                  </a:lnTo>
                  <a:lnTo>
                    <a:pt x="108" y="168568"/>
                  </a:lnTo>
                  <a:lnTo>
                    <a:pt x="108" y="167676"/>
                  </a:lnTo>
                  <a:lnTo>
                    <a:pt x="108" y="166784"/>
                  </a:lnTo>
                  <a:lnTo>
                    <a:pt x="108" y="165892"/>
                  </a:lnTo>
                  <a:lnTo>
                    <a:pt x="109" y="165000"/>
                  </a:lnTo>
                  <a:lnTo>
                    <a:pt x="109" y="164108"/>
                  </a:lnTo>
                  <a:lnTo>
                    <a:pt x="109" y="163216"/>
                  </a:lnTo>
                  <a:lnTo>
                    <a:pt x="109" y="162325"/>
                  </a:lnTo>
                  <a:lnTo>
                    <a:pt x="110" y="161433"/>
                  </a:lnTo>
                  <a:lnTo>
                    <a:pt x="110" y="160541"/>
                  </a:lnTo>
                  <a:lnTo>
                    <a:pt x="110" y="159649"/>
                  </a:lnTo>
                  <a:lnTo>
                    <a:pt x="111" y="158757"/>
                  </a:lnTo>
                  <a:lnTo>
                    <a:pt x="111" y="157865"/>
                  </a:lnTo>
                  <a:lnTo>
                    <a:pt x="112" y="156973"/>
                  </a:lnTo>
                  <a:lnTo>
                    <a:pt x="112" y="156081"/>
                  </a:lnTo>
                  <a:lnTo>
                    <a:pt x="113" y="155189"/>
                  </a:lnTo>
                  <a:lnTo>
                    <a:pt x="113" y="154298"/>
                  </a:lnTo>
                  <a:lnTo>
                    <a:pt x="114" y="153406"/>
                  </a:lnTo>
                  <a:lnTo>
                    <a:pt x="115" y="152514"/>
                  </a:lnTo>
                  <a:lnTo>
                    <a:pt x="115" y="151622"/>
                  </a:lnTo>
                  <a:lnTo>
                    <a:pt x="116" y="150730"/>
                  </a:lnTo>
                  <a:lnTo>
                    <a:pt x="117" y="149838"/>
                  </a:lnTo>
                  <a:lnTo>
                    <a:pt x="118" y="148946"/>
                  </a:lnTo>
                  <a:lnTo>
                    <a:pt x="119" y="148054"/>
                  </a:lnTo>
                  <a:lnTo>
                    <a:pt x="120" y="147162"/>
                  </a:lnTo>
                  <a:lnTo>
                    <a:pt x="121" y="146270"/>
                  </a:lnTo>
                  <a:lnTo>
                    <a:pt x="122" y="145379"/>
                  </a:lnTo>
                  <a:lnTo>
                    <a:pt x="123" y="144487"/>
                  </a:lnTo>
                  <a:lnTo>
                    <a:pt x="124" y="143595"/>
                  </a:lnTo>
                  <a:lnTo>
                    <a:pt x="125" y="142703"/>
                  </a:lnTo>
                  <a:lnTo>
                    <a:pt x="126" y="141811"/>
                  </a:lnTo>
                  <a:lnTo>
                    <a:pt x="128" y="140919"/>
                  </a:lnTo>
                  <a:lnTo>
                    <a:pt x="129" y="140027"/>
                  </a:lnTo>
                  <a:lnTo>
                    <a:pt x="130" y="139135"/>
                  </a:lnTo>
                  <a:lnTo>
                    <a:pt x="132" y="138243"/>
                  </a:lnTo>
                  <a:lnTo>
                    <a:pt x="133" y="137351"/>
                  </a:lnTo>
                  <a:lnTo>
                    <a:pt x="135" y="136460"/>
                  </a:lnTo>
                  <a:lnTo>
                    <a:pt x="136" y="135568"/>
                  </a:lnTo>
                  <a:lnTo>
                    <a:pt x="138" y="134676"/>
                  </a:lnTo>
                  <a:lnTo>
                    <a:pt x="139" y="133784"/>
                  </a:lnTo>
                  <a:lnTo>
                    <a:pt x="141" y="132892"/>
                  </a:lnTo>
                  <a:lnTo>
                    <a:pt x="143" y="132000"/>
                  </a:lnTo>
                  <a:lnTo>
                    <a:pt x="144" y="131108"/>
                  </a:lnTo>
                  <a:lnTo>
                    <a:pt x="146" y="130216"/>
                  </a:lnTo>
                  <a:lnTo>
                    <a:pt x="148" y="129324"/>
                  </a:lnTo>
                  <a:lnTo>
                    <a:pt x="150" y="128433"/>
                  </a:lnTo>
                  <a:lnTo>
                    <a:pt x="152" y="127541"/>
                  </a:lnTo>
                  <a:lnTo>
                    <a:pt x="153" y="126649"/>
                  </a:lnTo>
                  <a:lnTo>
                    <a:pt x="155" y="125757"/>
                  </a:lnTo>
                  <a:lnTo>
                    <a:pt x="157" y="124865"/>
                  </a:lnTo>
                  <a:lnTo>
                    <a:pt x="159" y="123973"/>
                  </a:lnTo>
                  <a:lnTo>
                    <a:pt x="161" y="123081"/>
                  </a:lnTo>
                  <a:lnTo>
                    <a:pt x="163" y="122189"/>
                  </a:lnTo>
                  <a:lnTo>
                    <a:pt x="165" y="121297"/>
                  </a:lnTo>
                  <a:lnTo>
                    <a:pt x="167" y="120405"/>
                  </a:lnTo>
                  <a:lnTo>
                    <a:pt x="170" y="119514"/>
                  </a:lnTo>
                  <a:lnTo>
                    <a:pt x="172" y="118622"/>
                  </a:lnTo>
                  <a:lnTo>
                    <a:pt x="174" y="117730"/>
                  </a:lnTo>
                  <a:lnTo>
                    <a:pt x="176" y="116838"/>
                  </a:lnTo>
                  <a:lnTo>
                    <a:pt x="178" y="115946"/>
                  </a:lnTo>
                  <a:lnTo>
                    <a:pt x="180" y="115054"/>
                  </a:lnTo>
                  <a:lnTo>
                    <a:pt x="183" y="114162"/>
                  </a:lnTo>
                  <a:lnTo>
                    <a:pt x="185" y="113270"/>
                  </a:lnTo>
                  <a:lnTo>
                    <a:pt x="187" y="112378"/>
                  </a:lnTo>
                  <a:lnTo>
                    <a:pt x="189" y="111487"/>
                  </a:lnTo>
                  <a:lnTo>
                    <a:pt x="192" y="110595"/>
                  </a:lnTo>
                  <a:lnTo>
                    <a:pt x="194" y="109703"/>
                  </a:lnTo>
                  <a:lnTo>
                    <a:pt x="196" y="108811"/>
                  </a:lnTo>
                  <a:lnTo>
                    <a:pt x="199" y="107919"/>
                  </a:lnTo>
                  <a:lnTo>
                    <a:pt x="201" y="107027"/>
                  </a:lnTo>
                  <a:lnTo>
                    <a:pt x="203" y="106135"/>
                  </a:lnTo>
                  <a:lnTo>
                    <a:pt x="205" y="105243"/>
                  </a:lnTo>
                  <a:lnTo>
                    <a:pt x="208" y="104351"/>
                  </a:lnTo>
                  <a:lnTo>
                    <a:pt x="210" y="103459"/>
                  </a:lnTo>
                  <a:lnTo>
                    <a:pt x="212" y="102568"/>
                  </a:lnTo>
                  <a:lnTo>
                    <a:pt x="215" y="101676"/>
                  </a:lnTo>
                  <a:lnTo>
                    <a:pt x="217" y="100784"/>
                  </a:lnTo>
                  <a:lnTo>
                    <a:pt x="219" y="99892"/>
                  </a:lnTo>
                  <a:lnTo>
                    <a:pt x="222" y="99000"/>
                  </a:lnTo>
                  <a:lnTo>
                    <a:pt x="224" y="98108"/>
                  </a:lnTo>
                  <a:lnTo>
                    <a:pt x="226" y="97216"/>
                  </a:lnTo>
                  <a:lnTo>
                    <a:pt x="228" y="96324"/>
                  </a:lnTo>
                  <a:lnTo>
                    <a:pt x="231" y="95432"/>
                  </a:lnTo>
                  <a:lnTo>
                    <a:pt x="233" y="94540"/>
                  </a:lnTo>
                  <a:lnTo>
                    <a:pt x="235" y="93649"/>
                  </a:lnTo>
                  <a:lnTo>
                    <a:pt x="237" y="92757"/>
                  </a:lnTo>
                  <a:lnTo>
                    <a:pt x="240" y="91865"/>
                  </a:lnTo>
                  <a:lnTo>
                    <a:pt x="242" y="90973"/>
                  </a:lnTo>
                  <a:lnTo>
                    <a:pt x="244" y="90081"/>
                  </a:lnTo>
                  <a:lnTo>
                    <a:pt x="246" y="89189"/>
                  </a:lnTo>
                  <a:lnTo>
                    <a:pt x="248" y="88297"/>
                  </a:lnTo>
                  <a:lnTo>
                    <a:pt x="250" y="87405"/>
                  </a:lnTo>
                  <a:lnTo>
                    <a:pt x="253" y="86513"/>
                  </a:lnTo>
                  <a:lnTo>
                    <a:pt x="255" y="85622"/>
                  </a:lnTo>
                  <a:lnTo>
                    <a:pt x="257" y="84730"/>
                  </a:lnTo>
                  <a:lnTo>
                    <a:pt x="259" y="83838"/>
                  </a:lnTo>
                  <a:lnTo>
                    <a:pt x="261" y="82946"/>
                  </a:lnTo>
                  <a:lnTo>
                    <a:pt x="263" y="82054"/>
                  </a:lnTo>
                  <a:lnTo>
                    <a:pt x="265" y="81162"/>
                  </a:lnTo>
                  <a:lnTo>
                    <a:pt x="267" y="80270"/>
                  </a:lnTo>
                  <a:lnTo>
                    <a:pt x="269" y="79378"/>
                  </a:lnTo>
                  <a:lnTo>
                    <a:pt x="270" y="78486"/>
                  </a:lnTo>
                  <a:lnTo>
                    <a:pt x="272" y="77594"/>
                  </a:lnTo>
                  <a:lnTo>
                    <a:pt x="274" y="76703"/>
                  </a:lnTo>
                  <a:lnTo>
                    <a:pt x="276" y="75811"/>
                  </a:lnTo>
                  <a:lnTo>
                    <a:pt x="278" y="74919"/>
                  </a:lnTo>
                  <a:lnTo>
                    <a:pt x="279" y="74027"/>
                  </a:lnTo>
                  <a:lnTo>
                    <a:pt x="281" y="73135"/>
                  </a:lnTo>
                  <a:lnTo>
                    <a:pt x="283" y="72243"/>
                  </a:lnTo>
                  <a:lnTo>
                    <a:pt x="284" y="71351"/>
                  </a:lnTo>
                  <a:lnTo>
                    <a:pt x="286" y="70459"/>
                  </a:lnTo>
                  <a:lnTo>
                    <a:pt x="288" y="69567"/>
                  </a:lnTo>
                  <a:lnTo>
                    <a:pt x="289" y="68675"/>
                  </a:lnTo>
                  <a:lnTo>
                    <a:pt x="291" y="67784"/>
                  </a:lnTo>
                  <a:lnTo>
                    <a:pt x="292" y="66892"/>
                  </a:lnTo>
                  <a:lnTo>
                    <a:pt x="294" y="66000"/>
                  </a:lnTo>
                  <a:lnTo>
                    <a:pt x="295" y="65108"/>
                  </a:lnTo>
                  <a:lnTo>
                    <a:pt x="297" y="64216"/>
                  </a:lnTo>
                  <a:lnTo>
                    <a:pt x="298" y="63324"/>
                  </a:lnTo>
                  <a:lnTo>
                    <a:pt x="299" y="62432"/>
                  </a:lnTo>
                  <a:lnTo>
                    <a:pt x="301" y="61540"/>
                  </a:lnTo>
                  <a:lnTo>
                    <a:pt x="302" y="60648"/>
                  </a:lnTo>
                  <a:lnTo>
                    <a:pt x="303" y="59757"/>
                  </a:lnTo>
                  <a:lnTo>
                    <a:pt x="304" y="58865"/>
                  </a:lnTo>
                  <a:lnTo>
                    <a:pt x="306" y="57973"/>
                  </a:lnTo>
                  <a:lnTo>
                    <a:pt x="307" y="57081"/>
                  </a:lnTo>
                  <a:lnTo>
                    <a:pt x="308" y="56189"/>
                  </a:lnTo>
                  <a:lnTo>
                    <a:pt x="309" y="55297"/>
                  </a:lnTo>
                  <a:lnTo>
                    <a:pt x="310" y="54405"/>
                  </a:lnTo>
                  <a:lnTo>
                    <a:pt x="311" y="53513"/>
                  </a:lnTo>
                  <a:lnTo>
                    <a:pt x="312" y="52621"/>
                  </a:lnTo>
                  <a:lnTo>
                    <a:pt x="313" y="51729"/>
                  </a:lnTo>
                  <a:lnTo>
                    <a:pt x="314" y="50838"/>
                  </a:lnTo>
                  <a:lnTo>
                    <a:pt x="315" y="49946"/>
                  </a:lnTo>
                  <a:lnTo>
                    <a:pt x="316" y="49054"/>
                  </a:lnTo>
                  <a:lnTo>
                    <a:pt x="317" y="48162"/>
                  </a:lnTo>
                  <a:lnTo>
                    <a:pt x="318" y="47270"/>
                  </a:lnTo>
                  <a:lnTo>
                    <a:pt x="318" y="46378"/>
                  </a:lnTo>
                  <a:lnTo>
                    <a:pt x="319" y="45486"/>
                  </a:lnTo>
                  <a:lnTo>
                    <a:pt x="320" y="44594"/>
                  </a:lnTo>
                  <a:lnTo>
                    <a:pt x="321" y="43702"/>
                  </a:lnTo>
                  <a:lnTo>
                    <a:pt x="321" y="42811"/>
                  </a:lnTo>
                  <a:lnTo>
                    <a:pt x="322" y="41919"/>
                  </a:lnTo>
                  <a:lnTo>
                    <a:pt x="323" y="41027"/>
                  </a:lnTo>
                  <a:lnTo>
                    <a:pt x="324" y="40135"/>
                  </a:lnTo>
                  <a:lnTo>
                    <a:pt x="324" y="39243"/>
                  </a:lnTo>
                  <a:lnTo>
                    <a:pt x="325" y="38351"/>
                  </a:lnTo>
                  <a:lnTo>
                    <a:pt x="325" y="37459"/>
                  </a:lnTo>
                  <a:lnTo>
                    <a:pt x="326" y="36567"/>
                  </a:lnTo>
                  <a:lnTo>
                    <a:pt x="326" y="35675"/>
                  </a:lnTo>
                  <a:lnTo>
                    <a:pt x="327" y="34783"/>
                  </a:lnTo>
                  <a:lnTo>
                    <a:pt x="328" y="33892"/>
                  </a:lnTo>
                  <a:lnTo>
                    <a:pt x="328" y="33000"/>
                  </a:lnTo>
                  <a:lnTo>
                    <a:pt x="328" y="32108"/>
                  </a:lnTo>
                  <a:lnTo>
                    <a:pt x="329" y="31216"/>
                  </a:lnTo>
                  <a:lnTo>
                    <a:pt x="329" y="30324"/>
                  </a:lnTo>
                  <a:lnTo>
                    <a:pt x="330" y="29432"/>
                  </a:lnTo>
                  <a:lnTo>
                    <a:pt x="330" y="28540"/>
                  </a:lnTo>
                  <a:lnTo>
                    <a:pt x="331" y="27648"/>
                  </a:lnTo>
                  <a:lnTo>
                    <a:pt x="331" y="26756"/>
                  </a:lnTo>
                  <a:lnTo>
                    <a:pt x="331" y="25864"/>
                  </a:lnTo>
                  <a:lnTo>
                    <a:pt x="332" y="24973"/>
                  </a:lnTo>
                  <a:lnTo>
                    <a:pt x="332" y="24081"/>
                  </a:lnTo>
                  <a:lnTo>
                    <a:pt x="332" y="23189"/>
                  </a:lnTo>
                  <a:lnTo>
                    <a:pt x="333" y="22297"/>
                  </a:lnTo>
                  <a:lnTo>
                    <a:pt x="333" y="21405"/>
                  </a:lnTo>
                  <a:lnTo>
                    <a:pt x="333" y="20513"/>
                  </a:lnTo>
                  <a:lnTo>
                    <a:pt x="333" y="19621"/>
                  </a:lnTo>
                  <a:lnTo>
                    <a:pt x="334" y="18729"/>
                  </a:lnTo>
                  <a:lnTo>
                    <a:pt x="334" y="17837"/>
                  </a:lnTo>
                  <a:lnTo>
                    <a:pt x="334" y="16946"/>
                  </a:lnTo>
                  <a:lnTo>
                    <a:pt x="334" y="16054"/>
                  </a:lnTo>
                  <a:lnTo>
                    <a:pt x="335" y="15162"/>
                  </a:lnTo>
                  <a:lnTo>
                    <a:pt x="335" y="14270"/>
                  </a:lnTo>
                  <a:lnTo>
                    <a:pt x="335" y="13378"/>
                  </a:lnTo>
                  <a:lnTo>
                    <a:pt x="335" y="12486"/>
                  </a:lnTo>
                  <a:lnTo>
                    <a:pt x="335" y="11594"/>
                  </a:lnTo>
                  <a:lnTo>
                    <a:pt x="336" y="10702"/>
                  </a:lnTo>
                  <a:lnTo>
                    <a:pt x="336" y="9810"/>
                  </a:lnTo>
                  <a:lnTo>
                    <a:pt x="336" y="8918"/>
                  </a:lnTo>
                  <a:lnTo>
                    <a:pt x="336" y="8027"/>
                  </a:lnTo>
                  <a:lnTo>
                    <a:pt x="336" y="7135"/>
                  </a:lnTo>
                  <a:lnTo>
                    <a:pt x="336" y="6243"/>
                  </a:lnTo>
                  <a:lnTo>
                    <a:pt x="336" y="5351"/>
                  </a:lnTo>
                  <a:lnTo>
                    <a:pt x="337" y="4459"/>
                  </a:lnTo>
                  <a:lnTo>
                    <a:pt x="337" y="3567"/>
                  </a:lnTo>
                  <a:lnTo>
                    <a:pt x="337" y="2675"/>
                  </a:lnTo>
                  <a:lnTo>
                    <a:pt x="337" y="1783"/>
                  </a:lnTo>
                  <a:lnTo>
                    <a:pt x="337" y="891"/>
                  </a:lnTo>
                  <a:lnTo>
                    <a:pt x="337" y="0"/>
                  </a:lnTo>
                  <a:lnTo>
                    <a:pt x="338" y="0"/>
                  </a:lnTo>
                  <a:lnTo>
                    <a:pt x="338" y="455758"/>
                  </a:lnTo>
                  <a:lnTo>
                    <a:pt x="338" y="455758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45" name="pl27"/>
            <p:cNvSpPr/>
            <p:nvPr/>
          </p:nvSpPr>
          <p:spPr>
            <a:xfrm>
              <a:off x="3627508" y="3630822"/>
              <a:ext cx="1128" cy="131887"/>
            </a:xfrm>
            <a:custGeom>
              <a:avLst/>
              <a:gdLst/>
              <a:ahLst/>
              <a:cxnLst/>
              <a:rect l="0" t="0" r="0" b="0"/>
              <a:pathLst>
                <a:path w="1128" h="131887">
                  <a:moveTo>
                    <a:pt x="0" y="0"/>
                  </a:moveTo>
                  <a:lnTo>
                    <a:pt x="5" y="0"/>
                  </a:lnTo>
                  <a:lnTo>
                    <a:pt x="5" y="258"/>
                  </a:lnTo>
                  <a:lnTo>
                    <a:pt x="6" y="516"/>
                  </a:lnTo>
                  <a:lnTo>
                    <a:pt x="6" y="774"/>
                  </a:lnTo>
                  <a:lnTo>
                    <a:pt x="7" y="1032"/>
                  </a:lnTo>
                  <a:lnTo>
                    <a:pt x="7" y="1290"/>
                  </a:lnTo>
                  <a:lnTo>
                    <a:pt x="7" y="1548"/>
                  </a:lnTo>
                  <a:lnTo>
                    <a:pt x="8" y="1806"/>
                  </a:lnTo>
                  <a:lnTo>
                    <a:pt x="9" y="2064"/>
                  </a:lnTo>
                  <a:lnTo>
                    <a:pt x="9" y="2322"/>
                  </a:lnTo>
                  <a:lnTo>
                    <a:pt x="10" y="2580"/>
                  </a:lnTo>
                  <a:lnTo>
                    <a:pt x="10" y="2839"/>
                  </a:lnTo>
                  <a:lnTo>
                    <a:pt x="11" y="3097"/>
                  </a:lnTo>
                  <a:lnTo>
                    <a:pt x="12" y="3355"/>
                  </a:lnTo>
                  <a:lnTo>
                    <a:pt x="13" y="3613"/>
                  </a:lnTo>
                  <a:lnTo>
                    <a:pt x="13" y="3871"/>
                  </a:lnTo>
                  <a:lnTo>
                    <a:pt x="14" y="4129"/>
                  </a:lnTo>
                  <a:lnTo>
                    <a:pt x="15" y="4387"/>
                  </a:lnTo>
                  <a:lnTo>
                    <a:pt x="16" y="4645"/>
                  </a:lnTo>
                  <a:lnTo>
                    <a:pt x="17" y="4903"/>
                  </a:lnTo>
                  <a:lnTo>
                    <a:pt x="18" y="5161"/>
                  </a:lnTo>
                  <a:lnTo>
                    <a:pt x="19" y="5420"/>
                  </a:lnTo>
                  <a:lnTo>
                    <a:pt x="20" y="5678"/>
                  </a:lnTo>
                  <a:lnTo>
                    <a:pt x="21" y="5936"/>
                  </a:lnTo>
                  <a:lnTo>
                    <a:pt x="23" y="6194"/>
                  </a:lnTo>
                  <a:lnTo>
                    <a:pt x="24" y="6452"/>
                  </a:lnTo>
                  <a:lnTo>
                    <a:pt x="25" y="6710"/>
                  </a:lnTo>
                  <a:lnTo>
                    <a:pt x="27" y="6968"/>
                  </a:lnTo>
                  <a:lnTo>
                    <a:pt x="28" y="7226"/>
                  </a:lnTo>
                  <a:lnTo>
                    <a:pt x="30" y="7484"/>
                  </a:lnTo>
                  <a:lnTo>
                    <a:pt x="31" y="7742"/>
                  </a:lnTo>
                  <a:lnTo>
                    <a:pt x="33" y="8000"/>
                  </a:lnTo>
                  <a:lnTo>
                    <a:pt x="35" y="8259"/>
                  </a:lnTo>
                  <a:lnTo>
                    <a:pt x="37" y="8517"/>
                  </a:lnTo>
                  <a:lnTo>
                    <a:pt x="39" y="8775"/>
                  </a:lnTo>
                  <a:lnTo>
                    <a:pt x="41" y="9033"/>
                  </a:lnTo>
                  <a:lnTo>
                    <a:pt x="43" y="9291"/>
                  </a:lnTo>
                  <a:lnTo>
                    <a:pt x="45" y="9549"/>
                  </a:lnTo>
                  <a:lnTo>
                    <a:pt x="47" y="9807"/>
                  </a:lnTo>
                  <a:lnTo>
                    <a:pt x="49" y="10065"/>
                  </a:lnTo>
                  <a:lnTo>
                    <a:pt x="52" y="10323"/>
                  </a:lnTo>
                  <a:lnTo>
                    <a:pt x="54" y="10581"/>
                  </a:lnTo>
                  <a:lnTo>
                    <a:pt x="57" y="10840"/>
                  </a:lnTo>
                  <a:lnTo>
                    <a:pt x="59" y="11098"/>
                  </a:lnTo>
                  <a:lnTo>
                    <a:pt x="62" y="11356"/>
                  </a:lnTo>
                  <a:lnTo>
                    <a:pt x="65" y="11614"/>
                  </a:lnTo>
                  <a:lnTo>
                    <a:pt x="68" y="11872"/>
                  </a:lnTo>
                  <a:lnTo>
                    <a:pt x="71" y="12130"/>
                  </a:lnTo>
                  <a:lnTo>
                    <a:pt x="74" y="12388"/>
                  </a:lnTo>
                  <a:lnTo>
                    <a:pt x="78" y="12646"/>
                  </a:lnTo>
                  <a:lnTo>
                    <a:pt x="81" y="12904"/>
                  </a:lnTo>
                  <a:lnTo>
                    <a:pt x="85" y="13162"/>
                  </a:lnTo>
                  <a:lnTo>
                    <a:pt x="88" y="13420"/>
                  </a:lnTo>
                  <a:lnTo>
                    <a:pt x="92" y="13679"/>
                  </a:lnTo>
                  <a:lnTo>
                    <a:pt x="96" y="13937"/>
                  </a:lnTo>
                  <a:lnTo>
                    <a:pt x="100" y="14195"/>
                  </a:lnTo>
                  <a:lnTo>
                    <a:pt x="104" y="14453"/>
                  </a:lnTo>
                  <a:lnTo>
                    <a:pt x="108" y="14711"/>
                  </a:lnTo>
                  <a:lnTo>
                    <a:pt x="112" y="14969"/>
                  </a:lnTo>
                  <a:lnTo>
                    <a:pt x="116" y="15227"/>
                  </a:lnTo>
                  <a:lnTo>
                    <a:pt x="121" y="15485"/>
                  </a:lnTo>
                  <a:lnTo>
                    <a:pt x="126" y="15743"/>
                  </a:lnTo>
                  <a:lnTo>
                    <a:pt x="130" y="16001"/>
                  </a:lnTo>
                  <a:lnTo>
                    <a:pt x="135" y="16260"/>
                  </a:lnTo>
                  <a:lnTo>
                    <a:pt x="140" y="16518"/>
                  </a:lnTo>
                  <a:lnTo>
                    <a:pt x="145" y="16776"/>
                  </a:lnTo>
                  <a:lnTo>
                    <a:pt x="150" y="17034"/>
                  </a:lnTo>
                  <a:lnTo>
                    <a:pt x="156" y="17292"/>
                  </a:lnTo>
                  <a:lnTo>
                    <a:pt x="161" y="17550"/>
                  </a:lnTo>
                  <a:lnTo>
                    <a:pt x="166" y="17808"/>
                  </a:lnTo>
                  <a:lnTo>
                    <a:pt x="172" y="18066"/>
                  </a:lnTo>
                  <a:lnTo>
                    <a:pt x="178" y="18324"/>
                  </a:lnTo>
                  <a:lnTo>
                    <a:pt x="184" y="18582"/>
                  </a:lnTo>
                  <a:lnTo>
                    <a:pt x="190" y="18841"/>
                  </a:lnTo>
                  <a:lnTo>
                    <a:pt x="196" y="19099"/>
                  </a:lnTo>
                  <a:lnTo>
                    <a:pt x="202" y="19357"/>
                  </a:lnTo>
                  <a:lnTo>
                    <a:pt x="208" y="19615"/>
                  </a:lnTo>
                  <a:lnTo>
                    <a:pt x="214" y="19873"/>
                  </a:lnTo>
                  <a:lnTo>
                    <a:pt x="221" y="20131"/>
                  </a:lnTo>
                  <a:lnTo>
                    <a:pt x="227" y="20389"/>
                  </a:lnTo>
                  <a:lnTo>
                    <a:pt x="234" y="20647"/>
                  </a:lnTo>
                  <a:lnTo>
                    <a:pt x="240" y="20905"/>
                  </a:lnTo>
                  <a:lnTo>
                    <a:pt x="247" y="21163"/>
                  </a:lnTo>
                  <a:lnTo>
                    <a:pt x="254" y="21421"/>
                  </a:lnTo>
                  <a:lnTo>
                    <a:pt x="261" y="21680"/>
                  </a:lnTo>
                  <a:lnTo>
                    <a:pt x="268" y="21938"/>
                  </a:lnTo>
                  <a:lnTo>
                    <a:pt x="275" y="22196"/>
                  </a:lnTo>
                  <a:lnTo>
                    <a:pt x="282" y="22454"/>
                  </a:lnTo>
                  <a:lnTo>
                    <a:pt x="289" y="22712"/>
                  </a:lnTo>
                  <a:lnTo>
                    <a:pt x="296" y="22970"/>
                  </a:lnTo>
                  <a:lnTo>
                    <a:pt x="303" y="23228"/>
                  </a:lnTo>
                  <a:lnTo>
                    <a:pt x="311" y="23486"/>
                  </a:lnTo>
                  <a:lnTo>
                    <a:pt x="318" y="23744"/>
                  </a:lnTo>
                  <a:lnTo>
                    <a:pt x="325" y="24002"/>
                  </a:lnTo>
                  <a:lnTo>
                    <a:pt x="333" y="24261"/>
                  </a:lnTo>
                  <a:lnTo>
                    <a:pt x="340" y="24519"/>
                  </a:lnTo>
                  <a:lnTo>
                    <a:pt x="347" y="24777"/>
                  </a:lnTo>
                  <a:lnTo>
                    <a:pt x="355" y="25035"/>
                  </a:lnTo>
                  <a:lnTo>
                    <a:pt x="362" y="25293"/>
                  </a:lnTo>
                  <a:lnTo>
                    <a:pt x="370" y="25551"/>
                  </a:lnTo>
                  <a:lnTo>
                    <a:pt x="377" y="25809"/>
                  </a:lnTo>
                  <a:lnTo>
                    <a:pt x="385" y="26067"/>
                  </a:lnTo>
                  <a:lnTo>
                    <a:pt x="392" y="26325"/>
                  </a:lnTo>
                  <a:lnTo>
                    <a:pt x="399" y="26583"/>
                  </a:lnTo>
                  <a:lnTo>
                    <a:pt x="407" y="26841"/>
                  </a:lnTo>
                  <a:lnTo>
                    <a:pt x="414" y="27100"/>
                  </a:lnTo>
                  <a:lnTo>
                    <a:pt x="421" y="27358"/>
                  </a:lnTo>
                  <a:lnTo>
                    <a:pt x="429" y="27616"/>
                  </a:lnTo>
                  <a:lnTo>
                    <a:pt x="436" y="27874"/>
                  </a:lnTo>
                  <a:lnTo>
                    <a:pt x="443" y="28132"/>
                  </a:lnTo>
                  <a:lnTo>
                    <a:pt x="450" y="28390"/>
                  </a:lnTo>
                  <a:lnTo>
                    <a:pt x="457" y="28648"/>
                  </a:lnTo>
                  <a:lnTo>
                    <a:pt x="464" y="28906"/>
                  </a:lnTo>
                  <a:lnTo>
                    <a:pt x="471" y="29164"/>
                  </a:lnTo>
                  <a:lnTo>
                    <a:pt x="478" y="29422"/>
                  </a:lnTo>
                  <a:lnTo>
                    <a:pt x="485" y="29681"/>
                  </a:lnTo>
                  <a:lnTo>
                    <a:pt x="492" y="29939"/>
                  </a:lnTo>
                  <a:lnTo>
                    <a:pt x="498" y="30197"/>
                  </a:lnTo>
                  <a:lnTo>
                    <a:pt x="505" y="30455"/>
                  </a:lnTo>
                  <a:lnTo>
                    <a:pt x="511" y="30713"/>
                  </a:lnTo>
                  <a:lnTo>
                    <a:pt x="517" y="30971"/>
                  </a:lnTo>
                  <a:lnTo>
                    <a:pt x="524" y="31229"/>
                  </a:lnTo>
                  <a:lnTo>
                    <a:pt x="530" y="31487"/>
                  </a:lnTo>
                  <a:lnTo>
                    <a:pt x="536" y="31745"/>
                  </a:lnTo>
                  <a:lnTo>
                    <a:pt x="542" y="32003"/>
                  </a:lnTo>
                  <a:lnTo>
                    <a:pt x="548" y="32261"/>
                  </a:lnTo>
                  <a:lnTo>
                    <a:pt x="553" y="32520"/>
                  </a:lnTo>
                  <a:lnTo>
                    <a:pt x="559" y="32778"/>
                  </a:lnTo>
                  <a:lnTo>
                    <a:pt x="565" y="33036"/>
                  </a:lnTo>
                  <a:lnTo>
                    <a:pt x="570" y="33294"/>
                  </a:lnTo>
                  <a:lnTo>
                    <a:pt x="575" y="33552"/>
                  </a:lnTo>
                  <a:lnTo>
                    <a:pt x="580" y="33810"/>
                  </a:lnTo>
                  <a:lnTo>
                    <a:pt x="585" y="34068"/>
                  </a:lnTo>
                  <a:lnTo>
                    <a:pt x="590" y="34326"/>
                  </a:lnTo>
                  <a:lnTo>
                    <a:pt x="595" y="34584"/>
                  </a:lnTo>
                  <a:lnTo>
                    <a:pt x="600" y="34842"/>
                  </a:lnTo>
                  <a:lnTo>
                    <a:pt x="604" y="35101"/>
                  </a:lnTo>
                  <a:lnTo>
                    <a:pt x="609" y="35359"/>
                  </a:lnTo>
                  <a:lnTo>
                    <a:pt x="613" y="35617"/>
                  </a:lnTo>
                  <a:lnTo>
                    <a:pt x="617" y="35875"/>
                  </a:lnTo>
                  <a:lnTo>
                    <a:pt x="621" y="36133"/>
                  </a:lnTo>
                  <a:lnTo>
                    <a:pt x="625" y="36391"/>
                  </a:lnTo>
                  <a:lnTo>
                    <a:pt x="629" y="36649"/>
                  </a:lnTo>
                  <a:lnTo>
                    <a:pt x="633" y="36907"/>
                  </a:lnTo>
                  <a:lnTo>
                    <a:pt x="637" y="37165"/>
                  </a:lnTo>
                  <a:lnTo>
                    <a:pt x="640" y="37423"/>
                  </a:lnTo>
                  <a:lnTo>
                    <a:pt x="644" y="37682"/>
                  </a:lnTo>
                  <a:lnTo>
                    <a:pt x="647" y="37940"/>
                  </a:lnTo>
                  <a:lnTo>
                    <a:pt x="650" y="38198"/>
                  </a:lnTo>
                  <a:lnTo>
                    <a:pt x="653" y="38456"/>
                  </a:lnTo>
                  <a:lnTo>
                    <a:pt x="656" y="38714"/>
                  </a:lnTo>
                  <a:lnTo>
                    <a:pt x="659" y="38972"/>
                  </a:lnTo>
                  <a:lnTo>
                    <a:pt x="662" y="39230"/>
                  </a:lnTo>
                  <a:lnTo>
                    <a:pt x="665" y="39488"/>
                  </a:lnTo>
                  <a:lnTo>
                    <a:pt x="667" y="39746"/>
                  </a:lnTo>
                  <a:lnTo>
                    <a:pt x="670" y="40004"/>
                  </a:lnTo>
                  <a:lnTo>
                    <a:pt x="673" y="40262"/>
                  </a:lnTo>
                  <a:lnTo>
                    <a:pt x="675" y="40521"/>
                  </a:lnTo>
                  <a:lnTo>
                    <a:pt x="677" y="40779"/>
                  </a:lnTo>
                  <a:lnTo>
                    <a:pt x="680" y="41037"/>
                  </a:lnTo>
                  <a:lnTo>
                    <a:pt x="682" y="41295"/>
                  </a:lnTo>
                  <a:lnTo>
                    <a:pt x="684" y="41553"/>
                  </a:lnTo>
                  <a:lnTo>
                    <a:pt x="686" y="41811"/>
                  </a:lnTo>
                  <a:lnTo>
                    <a:pt x="688" y="42069"/>
                  </a:lnTo>
                  <a:lnTo>
                    <a:pt x="690" y="42327"/>
                  </a:lnTo>
                  <a:lnTo>
                    <a:pt x="692" y="42585"/>
                  </a:lnTo>
                  <a:lnTo>
                    <a:pt x="694" y="42843"/>
                  </a:lnTo>
                  <a:lnTo>
                    <a:pt x="696" y="43102"/>
                  </a:lnTo>
                  <a:lnTo>
                    <a:pt x="698" y="43360"/>
                  </a:lnTo>
                  <a:lnTo>
                    <a:pt x="700" y="43618"/>
                  </a:lnTo>
                  <a:lnTo>
                    <a:pt x="701" y="43876"/>
                  </a:lnTo>
                  <a:lnTo>
                    <a:pt x="703" y="44134"/>
                  </a:lnTo>
                  <a:lnTo>
                    <a:pt x="705" y="44392"/>
                  </a:lnTo>
                  <a:lnTo>
                    <a:pt x="707" y="44650"/>
                  </a:lnTo>
                  <a:lnTo>
                    <a:pt x="708" y="44908"/>
                  </a:lnTo>
                  <a:lnTo>
                    <a:pt x="710" y="45166"/>
                  </a:lnTo>
                  <a:lnTo>
                    <a:pt x="712" y="45424"/>
                  </a:lnTo>
                  <a:lnTo>
                    <a:pt x="713" y="45682"/>
                  </a:lnTo>
                  <a:lnTo>
                    <a:pt x="715" y="45941"/>
                  </a:lnTo>
                  <a:lnTo>
                    <a:pt x="717" y="46199"/>
                  </a:lnTo>
                  <a:lnTo>
                    <a:pt x="718" y="46457"/>
                  </a:lnTo>
                  <a:lnTo>
                    <a:pt x="720" y="46715"/>
                  </a:lnTo>
                  <a:lnTo>
                    <a:pt x="722" y="46973"/>
                  </a:lnTo>
                  <a:lnTo>
                    <a:pt x="723" y="47231"/>
                  </a:lnTo>
                  <a:lnTo>
                    <a:pt x="725" y="47489"/>
                  </a:lnTo>
                  <a:lnTo>
                    <a:pt x="727" y="47747"/>
                  </a:lnTo>
                  <a:lnTo>
                    <a:pt x="728" y="48005"/>
                  </a:lnTo>
                  <a:lnTo>
                    <a:pt x="730" y="48263"/>
                  </a:lnTo>
                  <a:lnTo>
                    <a:pt x="732" y="48522"/>
                  </a:lnTo>
                  <a:lnTo>
                    <a:pt x="734" y="48780"/>
                  </a:lnTo>
                  <a:lnTo>
                    <a:pt x="735" y="49038"/>
                  </a:lnTo>
                  <a:lnTo>
                    <a:pt x="737" y="49296"/>
                  </a:lnTo>
                  <a:lnTo>
                    <a:pt x="739" y="49554"/>
                  </a:lnTo>
                  <a:lnTo>
                    <a:pt x="741" y="49812"/>
                  </a:lnTo>
                  <a:lnTo>
                    <a:pt x="743" y="50070"/>
                  </a:lnTo>
                  <a:lnTo>
                    <a:pt x="745" y="50328"/>
                  </a:lnTo>
                  <a:lnTo>
                    <a:pt x="747" y="50586"/>
                  </a:lnTo>
                  <a:lnTo>
                    <a:pt x="749" y="50844"/>
                  </a:lnTo>
                  <a:lnTo>
                    <a:pt x="751" y="51102"/>
                  </a:lnTo>
                  <a:lnTo>
                    <a:pt x="753" y="51361"/>
                  </a:lnTo>
                  <a:lnTo>
                    <a:pt x="755" y="51619"/>
                  </a:lnTo>
                  <a:lnTo>
                    <a:pt x="758" y="51877"/>
                  </a:lnTo>
                  <a:lnTo>
                    <a:pt x="760" y="52135"/>
                  </a:lnTo>
                  <a:lnTo>
                    <a:pt x="762" y="52393"/>
                  </a:lnTo>
                  <a:lnTo>
                    <a:pt x="765" y="52651"/>
                  </a:lnTo>
                  <a:lnTo>
                    <a:pt x="767" y="52909"/>
                  </a:lnTo>
                  <a:lnTo>
                    <a:pt x="770" y="53167"/>
                  </a:lnTo>
                  <a:lnTo>
                    <a:pt x="772" y="53425"/>
                  </a:lnTo>
                  <a:lnTo>
                    <a:pt x="775" y="53683"/>
                  </a:lnTo>
                  <a:lnTo>
                    <a:pt x="778" y="53942"/>
                  </a:lnTo>
                  <a:lnTo>
                    <a:pt x="780" y="54200"/>
                  </a:lnTo>
                  <a:lnTo>
                    <a:pt x="783" y="54458"/>
                  </a:lnTo>
                  <a:lnTo>
                    <a:pt x="786" y="54716"/>
                  </a:lnTo>
                  <a:lnTo>
                    <a:pt x="789" y="54974"/>
                  </a:lnTo>
                  <a:lnTo>
                    <a:pt x="792" y="55232"/>
                  </a:lnTo>
                  <a:lnTo>
                    <a:pt x="795" y="55490"/>
                  </a:lnTo>
                  <a:lnTo>
                    <a:pt x="798" y="55748"/>
                  </a:lnTo>
                  <a:lnTo>
                    <a:pt x="802" y="56006"/>
                  </a:lnTo>
                  <a:lnTo>
                    <a:pt x="805" y="56264"/>
                  </a:lnTo>
                  <a:lnTo>
                    <a:pt x="808" y="56523"/>
                  </a:lnTo>
                  <a:lnTo>
                    <a:pt x="812" y="56781"/>
                  </a:lnTo>
                  <a:lnTo>
                    <a:pt x="816" y="57039"/>
                  </a:lnTo>
                  <a:lnTo>
                    <a:pt x="819" y="57297"/>
                  </a:lnTo>
                  <a:lnTo>
                    <a:pt x="823" y="57555"/>
                  </a:lnTo>
                  <a:lnTo>
                    <a:pt x="827" y="57813"/>
                  </a:lnTo>
                  <a:lnTo>
                    <a:pt x="831" y="58071"/>
                  </a:lnTo>
                  <a:lnTo>
                    <a:pt x="835" y="58329"/>
                  </a:lnTo>
                  <a:lnTo>
                    <a:pt x="839" y="58587"/>
                  </a:lnTo>
                  <a:lnTo>
                    <a:pt x="843" y="58845"/>
                  </a:lnTo>
                  <a:lnTo>
                    <a:pt x="847" y="59103"/>
                  </a:lnTo>
                  <a:lnTo>
                    <a:pt x="851" y="59362"/>
                  </a:lnTo>
                  <a:lnTo>
                    <a:pt x="856" y="59620"/>
                  </a:lnTo>
                  <a:lnTo>
                    <a:pt x="860" y="59878"/>
                  </a:lnTo>
                  <a:lnTo>
                    <a:pt x="865" y="60136"/>
                  </a:lnTo>
                  <a:lnTo>
                    <a:pt x="870" y="60394"/>
                  </a:lnTo>
                  <a:lnTo>
                    <a:pt x="874" y="60652"/>
                  </a:lnTo>
                  <a:lnTo>
                    <a:pt x="879" y="60910"/>
                  </a:lnTo>
                  <a:lnTo>
                    <a:pt x="884" y="61168"/>
                  </a:lnTo>
                  <a:lnTo>
                    <a:pt x="889" y="61426"/>
                  </a:lnTo>
                  <a:lnTo>
                    <a:pt x="894" y="61684"/>
                  </a:lnTo>
                  <a:lnTo>
                    <a:pt x="899" y="61943"/>
                  </a:lnTo>
                  <a:lnTo>
                    <a:pt x="904" y="62201"/>
                  </a:lnTo>
                  <a:lnTo>
                    <a:pt x="909" y="62459"/>
                  </a:lnTo>
                  <a:lnTo>
                    <a:pt x="915" y="62717"/>
                  </a:lnTo>
                  <a:lnTo>
                    <a:pt x="920" y="62975"/>
                  </a:lnTo>
                  <a:lnTo>
                    <a:pt x="925" y="63233"/>
                  </a:lnTo>
                  <a:lnTo>
                    <a:pt x="931" y="63491"/>
                  </a:lnTo>
                  <a:lnTo>
                    <a:pt x="936" y="63749"/>
                  </a:lnTo>
                  <a:lnTo>
                    <a:pt x="942" y="64007"/>
                  </a:lnTo>
                  <a:lnTo>
                    <a:pt x="947" y="64265"/>
                  </a:lnTo>
                  <a:lnTo>
                    <a:pt x="953" y="64523"/>
                  </a:lnTo>
                  <a:lnTo>
                    <a:pt x="958" y="64782"/>
                  </a:lnTo>
                  <a:lnTo>
                    <a:pt x="964" y="65040"/>
                  </a:lnTo>
                  <a:lnTo>
                    <a:pt x="970" y="65298"/>
                  </a:lnTo>
                  <a:lnTo>
                    <a:pt x="975" y="65556"/>
                  </a:lnTo>
                  <a:lnTo>
                    <a:pt x="981" y="65814"/>
                  </a:lnTo>
                  <a:lnTo>
                    <a:pt x="987" y="66072"/>
                  </a:lnTo>
                  <a:lnTo>
                    <a:pt x="992" y="66330"/>
                  </a:lnTo>
                  <a:lnTo>
                    <a:pt x="998" y="66588"/>
                  </a:lnTo>
                  <a:lnTo>
                    <a:pt x="1003" y="66846"/>
                  </a:lnTo>
                  <a:lnTo>
                    <a:pt x="1009" y="67104"/>
                  </a:lnTo>
                  <a:lnTo>
                    <a:pt x="1014" y="67363"/>
                  </a:lnTo>
                  <a:lnTo>
                    <a:pt x="1020" y="67621"/>
                  </a:lnTo>
                  <a:lnTo>
                    <a:pt x="1025" y="67879"/>
                  </a:lnTo>
                  <a:lnTo>
                    <a:pt x="1031" y="68137"/>
                  </a:lnTo>
                  <a:lnTo>
                    <a:pt x="1036" y="68395"/>
                  </a:lnTo>
                  <a:lnTo>
                    <a:pt x="1041" y="68653"/>
                  </a:lnTo>
                  <a:lnTo>
                    <a:pt x="1046" y="68911"/>
                  </a:lnTo>
                  <a:lnTo>
                    <a:pt x="1051" y="69169"/>
                  </a:lnTo>
                  <a:lnTo>
                    <a:pt x="1056" y="69427"/>
                  </a:lnTo>
                  <a:lnTo>
                    <a:pt x="1061" y="69685"/>
                  </a:lnTo>
                  <a:lnTo>
                    <a:pt x="1066" y="69943"/>
                  </a:lnTo>
                  <a:lnTo>
                    <a:pt x="1070" y="70202"/>
                  </a:lnTo>
                  <a:lnTo>
                    <a:pt x="1075" y="70460"/>
                  </a:lnTo>
                  <a:lnTo>
                    <a:pt x="1079" y="70718"/>
                  </a:lnTo>
                  <a:lnTo>
                    <a:pt x="1083" y="70976"/>
                  </a:lnTo>
                  <a:lnTo>
                    <a:pt x="1087" y="71234"/>
                  </a:lnTo>
                  <a:lnTo>
                    <a:pt x="1091" y="71492"/>
                  </a:lnTo>
                  <a:lnTo>
                    <a:pt x="1095" y="71750"/>
                  </a:lnTo>
                  <a:lnTo>
                    <a:pt x="1098" y="72008"/>
                  </a:lnTo>
                  <a:lnTo>
                    <a:pt x="1102" y="72266"/>
                  </a:lnTo>
                  <a:lnTo>
                    <a:pt x="1105" y="72524"/>
                  </a:lnTo>
                  <a:lnTo>
                    <a:pt x="1108" y="72783"/>
                  </a:lnTo>
                  <a:lnTo>
                    <a:pt x="1110" y="73041"/>
                  </a:lnTo>
                  <a:lnTo>
                    <a:pt x="1113" y="73299"/>
                  </a:lnTo>
                  <a:lnTo>
                    <a:pt x="1115" y="73557"/>
                  </a:lnTo>
                  <a:lnTo>
                    <a:pt x="1118" y="73815"/>
                  </a:lnTo>
                  <a:lnTo>
                    <a:pt x="1120" y="74073"/>
                  </a:lnTo>
                  <a:lnTo>
                    <a:pt x="1121" y="74331"/>
                  </a:lnTo>
                  <a:lnTo>
                    <a:pt x="1123" y="74589"/>
                  </a:lnTo>
                  <a:lnTo>
                    <a:pt x="1124" y="74847"/>
                  </a:lnTo>
                  <a:lnTo>
                    <a:pt x="1125" y="75105"/>
                  </a:lnTo>
                  <a:lnTo>
                    <a:pt x="1126" y="75364"/>
                  </a:lnTo>
                  <a:lnTo>
                    <a:pt x="1127" y="75622"/>
                  </a:lnTo>
                  <a:lnTo>
                    <a:pt x="1127" y="75880"/>
                  </a:lnTo>
                  <a:lnTo>
                    <a:pt x="1128" y="76138"/>
                  </a:lnTo>
                  <a:lnTo>
                    <a:pt x="1128" y="76396"/>
                  </a:lnTo>
                  <a:lnTo>
                    <a:pt x="1127" y="76654"/>
                  </a:lnTo>
                  <a:lnTo>
                    <a:pt x="1127" y="76912"/>
                  </a:lnTo>
                  <a:lnTo>
                    <a:pt x="1126" y="77170"/>
                  </a:lnTo>
                  <a:lnTo>
                    <a:pt x="1125" y="77428"/>
                  </a:lnTo>
                  <a:lnTo>
                    <a:pt x="1124" y="77686"/>
                  </a:lnTo>
                  <a:lnTo>
                    <a:pt x="1123" y="77944"/>
                  </a:lnTo>
                  <a:lnTo>
                    <a:pt x="1121" y="78203"/>
                  </a:lnTo>
                  <a:lnTo>
                    <a:pt x="1119" y="78461"/>
                  </a:lnTo>
                  <a:lnTo>
                    <a:pt x="1117" y="78719"/>
                  </a:lnTo>
                  <a:lnTo>
                    <a:pt x="1115" y="78977"/>
                  </a:lnTo>
                  <a:lnTo>
                    <a:pt x="1112" y="79235"/>
                  </a:lnTo>
                  <a:lnTo>
                    <a:pt x="1110" y="79493"/>
                  </a:lnTo>
                  <a:lnTo>
                    <a:pt x="1107" y="79751"/>
                  </a:lnTo>
                  <a:lnTo>
                    <a:pt x="1104" y="80009"/>
                  </a:lnTo>
                  <a:lnTo>
                    <a:pt x="1100" y="80267"/>
                  </a:lnTo>
                  <a:lnTo>
                    <a:pt x="1097" y="80525"/>
                  </a:lnTo>
                  <a:lnTo>
                    <a:pt x="1093" y="80784"/>
                  </a:lnTo>
                  <a:lnTo>
                    <a:pt x="1089" y="81042"/>
                  </a:lnTo>
                  <a:lnTo>
                    <a:pt x="1085" y="81300"/>
                  </a:lnTo>
                  <a:lnTo>
                    <a:pt x="1081" y="81558"/>
                  </a:lnTo>
                  <a:lnTo>
                    <a:pt x="1077" y="81816"/>
                  </a:lnTo>
                  <a:lnTo>
                    <a:pt x="1072" y="82074"/>
                  </a:lnTo>
                  <a:lnTo>
                    <a:pt x="1067" y="82332"/>
                  </a:lnTo>
                  <a:lnTo>
                    <a:pt x="1063" y="82590"/>
                  </a:lnTo>
                  <a:lnTo>
                    <a:pt x="1058" y="82848"/>
                  </a:lnTo>
                  <a:lnTo>
                    <a:pt x="1052" y="83106"/>
                  </a:lnTo>
                  <a:lnTo>
                    <a:pt x="1047" y="83364"/>
                  </a:lnTo>
                  <a:lnTo>
                    <a:pt x="1042" y="83623"/>
                  </a:lnTo>
                  <a:lnTo>
                    <a:pt x="1036" y="83881"/>
                  </a:lnTo>
                  <a:lnTo>
                    <a:pt x="1031" y="84139"/>
                  </a:lnTo>
                  <a:lnTo>
                    <a:pt x="1025" y="84397"/>
                  </a:lnTo>
                  <a:lnTo>
                    <a:pt x="1019" y="84655"/>
                  </a:lnTo>
                  <a:lnTo>
                    <a:pt x="1013" y="84913"/>
                  </a:lnTo>
                  <a:lnTo>
                    <a:pt x="1007" y="85171"/>
                  </a:lnTo>
                  <a:lnTo>
                    <a:pt x="1001" y="85429"/>
                  </a:lnTo>
                  <a:lnTo>
                    <a:pt x="995" y="85687"/>
                  </a:lnTo>
                  <a:lnTo>
                    <a:pt x="988" y="85945"/>
                  </a:lnTo>
                  <a:lnTo>
                    <a:pt x="982" y="86204"/>
                  </a:lnTo>
                  <a:lnTo>
                    <a:pt x="976" y="86462"/>
                  </a:lnTo>
                  <a:lnTo>
                    <a:pt x="969" y="86720"/>
                  </a:lnTo>
                  <a:lnTo>
                    <a:pt x="962" y="86978"/>
                  </a:lnTo>
                  <a:lnTo>
                    <a:pt x="956" y="87236"/>
                  </a:lnTo>
                  <a:lnTo>
                    <a:pt x="949" y="87494"/>
                  </a:lnTo>
                  <a:lnTo>
                    <a:pt x="942" y="87752"/>
                  </a:lnTo>
                  <a:lnTo>
                    <a:pt x="936" y="88010"/>
                  </a:lnTo>
                  <a:lnTo>
                    <a:pt x="929" y="88268"/>
                  </a:lnTo>
                  <a:lnTo>
                    <a:pt x="922" y="88526"/>
                  </a:lnTo>
                  <a:lnTo>
                    <a:pt x="915" y="88785"/>
                  </a:lnTo>
                  <a:lnTo>
                    <a:pt x="908" y="89043"/>
                  </a:lnTo>
                  <a:lnTo>
                    <a:pt x="901" y="89301"/>
                  </a:lnTo>
                  <a:lnTo>
                    <a:pt x="894" y="89559"/>
                  </a:lnTo>
                  <a:lnTo>
                    <a:pt x="887" y="89817"/>
                  </a:lnTo>
                  <a:lnTo>
                    <a:pt x="880" y="90075"/>
                  </a:lnTo>
                  <a:lnTo>
                    <a:pt x="873" y="90333"/>
                  </a:lnTo>
                  <a:lnTo>
                    <a:pt x="866" y="90591"/>
                  </a:lnTo>
                  <a:lnTo>
                    <a:pt x="859" y="90849"/>
                  </a:lnTo>
                  <a:lnTo>
                    <a:pt x="852" y="91107"/>
                  </a:lnTo>
                  <a:lnTo>
                    <a:pt x="844" y="91365"/>
                  </a:lnTo>
                  <a:lnTo>
                    <a:pt x="837" y="91624"/>
                  </a:lnTo>
                  <a:lnTo>
                    <a:pt x="830" y="91882"/>
                  </a:lnTo>
                  <a:lnTo>
                    <a:pt x="823" y="92140"/>
                  </a:lnTo>
                  <a:lnTo>
                    <a:pt x="816" y="92398"/>
                  </a:lnTo>
                  <a:lnTo>
                    <a:pt x="808" y="92656"/>
                  </a:lnTo>
                  <a:lnTo>
                    <a:pt x="801" y="92914"/>
                  </a:lnTo>
                  <a:lnTo>
                    <a:pt x="794" y="93172"/>
                  </a:lnTo>
                  <a:lnTo>
                    <a:pt x="786" y="93430"/>
                  </a:lnTo>
                  <a:lnTo>
                    <a:pt x="779" y="93688"/>
                  </a:lnTo>
                  <a:lnTo>
                    <a:pt x="772" y="93946"/>
                  </a:lnTo>
                  <a:lnTo>
                    <a:pt x="764" y="94205"/>
                  </a:lnTo>
                  <a:lnTo>
                    <a:pt x="757" y="94463"/>
                  </a:lnTo>
                  <a:lnTo>
                    <a:pt x="749" y="94721"/>
                  </a:lnTo>
                  <a:lnTo>
                    <a:pt x="742" y="94979"/>
                  </a:lnTo>
                  <a:lnTo>
                    <a:pt x="734" y="95237"/>
                  </a:lnTo>
                  <a:lnTo>
                    <a:pt x="727" y="95495"/>
                  </a:lnTo>
                  <a:lnTo>
                    <a:pt x="719" y="95753"/>
                  </a:lnTo>
                  <a:lnTo>
                    <a:pt x="711" y="96011"/>
                  </a:lnTo>
                  <a:lnTo>
                    <a:pt x="704" y="96269"/>
                  </a:lnTo>
                  <a:lnTo>
                    <a:pt x="696" y="96527"/>
                  </a:lnTo>
                  <a:lnTo>
                    <a:pt x="688" y="96785"/>
                  </a:lnTo>
                  <a:lnTo>
                    <a:pt x="681" y="97044"/>
                  </a:lnTo>
                  <a:lnTo>
                    <a:pt x="673" y="97302"/>
                  </a:lnTo>
                  <a:lnTo>
                    <a:pt x="665" y="97560"/>
                  </a:lnTo>
                  <a:lnTo>
                    <a:pt x="657" y="97818"/>
                  </a:lnTo>
                  <a:lnTo>
                    <a:pt x="649" y="98076"/>
                  </a:lnTo>
                  <a:lnTo>
                    <a:pt x="641" y="98334"/>
                  </a:lnTo>
                  <a:lnTo>
                    <a:pt x="633" y="98592"/>
                  </a:lnTo>
                  <a:lnTo>
                    <a:pt x="625" y="98850"/>
                  </a:lnTo>
                  <a:lnTo>
                    <a:pt x="617" y="99108"/>
                  </a:lnTo>
                  <a:lnTo>
                    <a:pt x="609" y="99366"/>
                  </a:lnTo>
                  <a:lnTo>
                    <a:pt x="601" y="99625"/>
                  </a:lnTo>
                  <a:lnTo>
                    <a:pt x="593" y="99883"/>
                  </a:lnTo>
                  <a:lnTo>
                    <a:pt x="585" y="100141"/>
                  </a:lnTo>
                  <a:lnTo>
                    <a:pt x="577" y="100399"/>
                  </a:lnTo>
                  <a:lnTo>
                    <a:pt x="569" y="100657"/>
                  </a:lnTo>
                  <a:lnTo>
                    <a:pt x="560" y="100915"/>
                  </a:lnTo>
                  <a:lnTo>
                    <a:pt x="552" y="101173"/>
                  </a:lnTo>
                  <a:lnTo>
                    <a:pt x="544" y="101431"/>
                  </a:lnTo>
                  <a:lnTo>
                    <a:pt x="535" y="101689"/>
                  </a:lnTo>
                  <a:lnTo>
                    <a:pt x="527" y="101947"/>
                  </a:lnTo>
                  <a:lnTo>
                    <a:pt x="519" y="102205"/>
                  </a:lnTo>
                  <a:lnTo>
                    <a:pt x="510" y="102464"/>
                  </a:lnTo>
                  <a:lnTo>
                    <a:pt x="502" y="102722"/>
                  </a:lnTo>
                  <a:lnTo>
                    <a:pt x="493" y="102980"/>
                  </a:lnTo>
                  <a:lnTo>
                    <a:pt x="485" y="103238"/>
                  </a:lnTo>
                  <a:lnTo>
                    <a:pt x="477" y="103496"/>
                  </a:lnTo>
                  <a:lnTo>
                    <a:pt x="468" y="103754"/>
                  </a:lnTo>
                  <a:lnTo>
                    <a:pt x="460" y="104012"/>
                  </a:lnTo>
                  <a:lnTo>
                    <a:pt x="451" y="104270"/>
                  </a:lnTo>
                  <a:lnTo>
                    <a:pt x="443" y="104528"/>
                  </a:lnTo>
                  <a:lnTo>
                    <a:pt x="434" y="104786"/>
                  </a:lnTo>
                  <a:lnTo>
                    <a:pt x="426" y="105045"/>
                  </a:lnTo>
                  <a:lnTo>
                    <a:pt x="418" y="105303"/>
                  </a:lnTo>
                  <a:lnTo>
                    <a:pt x="409" y="105561"/>
                  </a:lnTo>
                  <a:lnTo>
                    <a:pt x="401" y="105819"/>
                  </a:lnTo>
                  <a:lnTo>
                    <a:pt x="393" y="106077"/>
                  </a:lnTo>
                  <a:lnTo>
                    <a:pt x="384" y="106335"/>
                  </a:lnTo>
                  <a:lnTo>
                    <a:pt x="376" y="106593"/>
                  </a:lnTo>
                  <a:lnTo>
                    <a:pt x="368" y="106851"/>
                  </a:lnTo>
                  <a:lnTo>
                    <a:pt x="360" y="107109"/>
                  </a:lnTo>
                  <a:lnTo>
                    <a:pt x="352" y="107367"/>
                  </a:lnTo>
                  <a:lnTo>
                    <a:pt x="344" y="107626"/>
                  </a:lnTo>
                  <a:lnTo>
                    <a:pt x="336" y="107884"/>
                  </a:lnTo>
                  <a:lnTo>
                    <a:pt x="328" y="108142"/>
                  </a:lnTo>
                  <a:lnTo>
                    <a:pt x="320" y="108400"/>
                  </a:lnTo>
                  <a:lnTo>
                    <a:pt x="312" y="108658"/>
                  </a:lnTo>
                  <a:lnTo>
                    <a:pt x="304" y="108916"/>
                  </a:lnTo>
                  <a:lnTo>
                    <a:pt x="297" y="109174"/>
                  </a:lnTo>
                  <a:lnTo>
                    <a:pt x="289" y="109432"/>
                  </a:lnTo>
                  <a:lnTo>
                    <a:pt x="282" y="109690"/>
                  </a:lnTo>
                  <a:lnTo>
                    <a:pt x="274" y="109948"/>
                  </a:lnTo>
                  <a:lnTo>
                    <a:pt x="267" y="110206"/>
                  </a:lnTo>
                  <a:lnTo>
                    <a:pt x="260" y="110465"/>
                  </a:lnTo>
                  <a:lnTo>
                    <a:pt x="252" y="110723"/>
                  </a:lnTo>
                  <a:lnTo>
                    <a:pt x="245" y="110981"/>
                  </a:lnTo>
                  <a:lnTo>
                    <a:pt x="238" y="111239"/>
                  </a:lnTo>
                  <a:lnTo>
                    <a:pt x="231" y="111497"/>
                  </a:lnTo>
                  <a:lnTo>
                    <a:pt x="225" y="111755"/>
                  </a:lnTo>
                  <a:lnTo>
                    <a:pt x="218" y="112013"/>
                  </a:lnTo>
                  <a:lnTo>
                    <a:pt x="212" y="112271"/>
                  </a:lnTo>
                  <a:lnTo>
                    <a:pt x="205" y="112529"/>
                  </a:lnTo>
                  <a:lnTo>
                    <a:pt x="199" y="112787"/>
                  </a:lnTo>
                  <a:lnTo>
                    <a:pt x="192" y="113046"/>
                  </a:lnTo>
                  <a:lnTo>
                    <a:pt x="186" y="113304"/>
                  </a:lnTo>
                  <a:lnTo>
                    <a:pt x="180" y="113562"/>
                  </a:lnTo>
                  <a:lnTo>
                    <a:pt x="174" y="113820"/>
                  </a:lnTo>
                  <a:lnTo>
                    <a:pt x="169" y="114078"/>
                  </a:lnTo>
                  <a:lnTo>
                    <a:pt x="163" y="114336"/>
                  </a:lnTo>
                  <a:lnTo>
                    <a:pt x="157" y="114594"/>
                  </a:lnTo>
                  <a:lnTo>
                    <a:pt x="152" y="114852"/>
                  </a:lnTo>
                  <a:lnTo>
                    <a:pt x="147" y="115110"/>
                  </a:lnTo>
                  <a:lnTo>
                    <a:pt x="142" y="115368"/>
                  </a:lnTo>
                  <a:lnTo>
                    <a:pt x="137" y="115626"/>
                  </a:lnTo>
                  <a:lnTo>
                    <a:pt x="132" y="115885"/>
                  </a:lnTo>
                  <a:lnTo>
                    <a:pt x="127" y="116143"/>
                  </a:lnTo>
                  <a:lnTo>
                    <a:pt x="122" y="116401"/>
                  </a:lnTo>
                  <a:lnTo>
                    <a:pt x="118" y="116659"/>
                  </a:lnTo>
                  <a:lnTo>
                    <a:pt x="113" y="116917"/>
                  </a:lnTo>
                  <a:lnTo>
                    <a:pt x="109" y="117175"/>
                  </a:lnTo>
                  <a:lnTo>
                    <a:pt x="105" y="117433"/>
                  </a:lnTo>
                  <a:lnTo>
                    <a:pt x="100" y="117691"/>
                  </a:lnTo>
                  <a:lnTo>
                    <a:pt x="96" y="117949"/>
                  </a:lnTo>
                  <a:lnTo>
                    <a:pt x="93" y="118207"/>
                  </a:lnTo>
                  <a:lnTo>
                    <a:pt x="89" y="118466"/>
                  </a:lnTo>
                  <a:lnTo>
                    <a:pt x="85" y="118724"/>
                  </a:lnTo>
                  <a:lnTo>
                    <a:pt x="82" y="118982"/>
                  </a:lnTo>
                  <a:lnTo>
                    <a:pt x="78" y="119240"/>
                  </a:lnTo>
                  <a:lnTo>
                    <a:pt x="75" y="119498"/>
                  </a:lnTo>
                  <a:lnTo>
                    <a:pt x="72" y="119756"/>
                  </a:lnTo>
                  <a:lnTo>
                    <a:pt x="69" y="120014"/>
                  </a:lnTo>
                  <a:lnTo>
                    <a:pt x="65" y="120272"/>
                  </a:lnTo>
                  <a:lnTo>
                    <a:pt x="63" y="120530"/>
                  </a:lnTo>
                  <a:lnTo>
                    <a:pt x="60" y="120788"/>
                  </a:lnTo>
                  <a:lnTo>
                    <a:pt x="57" y="121046"/>
                  </a:lnTo>
                  <a:lnTo>
                    <a:pt x="54" y="121305"/>
                  </a:lnTo>
                  <a:lnTo>
                    <a:pt x="52" y="121563"/>
                  </a:lnTo>
                  <a:lnTo>
                    <a:pt x="50" y="121821"/>
                  </a:lnTo>
                  <a:lnTo>
                    <a:pt x="47" y="122079"/>
                  </a:lnTo>
                  <a:lnTo>
                    <a:pt x="45" y="122337"/>
                  </a:lnTo>
                  <a:lnTo>
                    <a:pt x="43" y="122595"/>
                  </a:lnTo>
                  <a:lnTo>
                    <a:pt x="41" y="122853"/>
                  </a:lnTo>
                  <a:lnTo>
                    <a:pt x="39" y="123111"/>
                  </a:lnTo>
                  <a:lnTo>
                    <a:pt x="37" y="123369"/>
                  </a:lnTo>
                  <a:lnTo>
                    <a:pt x="35" y="123627"/>
                  </a:lnTo>
                  <a:lnTo>
                    <a:pt x="33" y="123886"/>
                  </a:lnTo>
                  <a:lnTo>
                    <a:pt x="31" y="124144"/>
                  </a:lnTo>
                  <a:lnTo>
                    <a:pt x="30" y="124402"/>
                  </a:lnTo>
                  <a:lnTo>
                    <a:pt x="28" y="124660"/>
                  </a:lnTo>
                  <a:lnTo>
                    <a:pt x="27" y="124918"/>
                  </a:lnTo>
                  <a:lnTo>
                    <a:pt x="25" y="125176"/>
                  </a:lnTo>
                  <a:lnTo>
                    <a:pt x="24" y="125434"/>
                  </a:lnTo>
                  <a:lnTo>
                    <a:pt x="23" y="125692"/>
                  </a:lnTo>
                  <a:lnTo>
                    <a:pt x="21" y="125950"/>
                  </a:lnTo>
                  <a:lnTo>
                    <a:pt x="20" y="126208"/>
                  </a:lnTo>
                  <a:lnTo>
                    <a:pt x="19" y="126467"/>
                  </a:lnTo>
                  <a:lnTo>
                    <a:pt x="18" y="126725"/>
                  </a:lnTo>
                  <a:lnTo>
                    <a:pt x="17" y="126983"/>
                  </a:lnTo>
                  <a:lnTo>
                    <a:pt x="16" y="127241"/>
                  </a:lnTo>
                  <a:lnTo>
                    <a:pt x="15" y="127499"/>
                  </a:lnTo>
                  <a:lnTo>
                    <a:pt x="14" y="127757"/>
                  </a:lnTo>
                  <a:lnTo>
                    <a:pt x="13" y="128015"/>
                  </a:lnTo>
                  <a:lnTo>
                    <a:pt x="13" y="128273"/>
                  </a:lnTo>
                  <a:lnTo>
                    <a:pt x="12" y="128531"/>
                  </a:lnTo>
                  <a:lnTo>
                    <a:pt x="11" y="128789"/>
                  </a:lnTo>
                  <a:lnTo>
                    <a:pt x="10" y="129047"/>
                  </a:lnTo>
                  <a:lnTo>
                    <a:pt x="10" y="129306"/>
                  </a:lnTo>
                  <a:lnTo>
                    <a:pt x="9" y="129564"/>
                  </a:lnTo>
                  <a:lnTo>
                    <a:pt x="9" y="129822"/>
                  </a:lnTo>
                  <a:lnTo>
                    <a:pt x="8" y="130080"/>
                  </a:lnTo>
                  <a:lnTo>
                    <a:pt x="8" y="130338"/>
                  </a:lnTo>
                  <a:lnTo>
                    <a:pt x="7" y="130596"/>
                  </a:lnTo>
                  <a:lnTo>
                    <a:pt x="7" y="130854"/>
                  </a:lnTo>
                  <a:lnTo>
                    <a:pt x="6" y="131112"/>
                  </a:lnTo>
                  <a:lnTo>
                    <a:pt x="6" y="131370"/>
                  </a:lnTo>
                  <a:lnTo>
                    <a:pt x="5" y="131628"/>
                  </a:lnTo>
                  <a:lnTo>
                    <a:pt x="5" y="131887"/>
                  </a:lnTo>
                  <a:lnTo>
                    <a:pt x="0" y="131887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46" name="pl28"/>
            <p:cNvSpPr/>
            <p:nvPr/>
          </p:nvSpPr>
          <p:spPr>
            <a:xfrm>
              <a:off x="3898301" y="3560095"/>
              <a:ext cx="416" cy="300161"/>
            </a:xfrm>
            <a:custGeom>
              <a:avLst/>
              <a:gdLst/>
              <a:ahLst/>
              <a:cxnLst/>
              <a:rect l="0" t="0" r="0" b="0"/>
              <a:pathLst>
                <a:path w="416" h="300161">
                  <a:moveTo>
                    <a:pt x="416" y="300161"/>
                  </a:moveTo>
                  <a:lnTo>
                    <a:pt x="412" y="300161"/>
                  </a:lnTo>
                  <a:lnTo>
                    <a:pt x="412" y="299574"/>
                  </a:lnTo>
                  <a:lnTo>
                    <a:pt x="412" y="298987"/>
                  </a:lnTo>
                  <a:lnTo>
                    <a:pt x="412" y="298399"/>
                  </a:lnTo>
                  <a:lnTo>
                    <a:pt x="411" y="297812"/>
                  </a:lnTo>
                  <a:lnTo>
                    <a:pt x="411" y="297224"/>
                  </a:lnTo>
                  <a:lnTo>
                    <a:pt x="411" y="296637"/>
                  </a:lnTo>
                  <a:lnTo>
                    <a:pt x="411" y="296050"/>
                  </a:lnTo>
                  <a:lnTo>
                    <a:pt x="410" y="295462"/>
                  </a:lnTo>
                  <a:lnTo>
                    <a:pt x="410" y="294875"/>
                  </a:lnTo>
                  <a:lnTo>
                    <a:pt x="410" y="294287"/>
                  </a:lnTo>
                  <a:lnTo>
                    <a:pt x="410" y="293700"/>
                  </a:lnTo>
                  <a:lnTo>
                    <a:pt x="409" y="293113"/>
                  </a:lnTo>
                  <a:lnTo>
                    <a:pt x="409" y="292525"/>
                  </a:lnTo>
                  <a:lnTo>
                    <a:pt x="409" y="291938"/>
                  </a:lnTo>
                  <a:lnTo>
                    <a:pt x="408" y="291350"/>
                  </a:lnTo>
                  <a:lnTo>
                    <a:pt x="408" y="290763"/>
                  </a:lnTo>
                  <a:lnTo>
                    <a:pt x="407" y="290176"/>
                  </a:lnTo>
                  <a:lnTo>
                    <a:pt x="407" y="289588"/>
                  </a:lnTo>
                  <a:lnTo>
                    <a:pt x="407" y="289001"/>
                  </a:lnTo>
                  <a:lnTo>
                    <a:pt x="406" y="288413"/>
                  </a:lnTo>
                  <a:lnTo>
                    <a:pt x="406" y="287826"/>
                  </a:lnTo>
                  <a:lnTo>
                    <a:pt x="405" y="287239"/>
                  </a:lnTo>
                  <a:lnTo>
                    <a:pt x="405" y="286651"/>
                  </a:lnTo>
                  <a:lnTo>
                    <a:pt x="404" y="286064"/>
                  </a:lnTo>
                  <a:lnTo>
                    <a:pt x="404" y="285476"/>
                  </a:lnTo>
                  <a:lnTo>
                    <a:pt x="403" y="284889"/>
                  </a:lnTo>
                  <a:lnTo>
                    <a:pt x="402" y="284302"/>
                  </a:lnTo>
                  <a:lnTo>
                    <a:pt x="402" y="283714"/>
                  </a:lnTo>
                  <a:lnTo>
                    <a:pt x="401" y="283127"/>
                  </a:lnTo>
                  <a:lnTo>
                    <a:pt x="401" y="282539"/>
                  </a:lnTo>
                  <a:lnTo>
                    <a:pt x="400" y="281952"/>
                  </a:lnTo>
                  <a:lnTo>
                    <a:pt x="399" y="281365"/>
                  </a:lnTo>
                  <a:lnTo>
                    <a:pt x="398" y="280777"/>
                  </a:lnTo>
                  <a:lnTo>
                    <a:pt x="398" y="280190"/>
                  </a:lnTo>
                  <a:lnTo>
                    <a:pt x="397" y="279602"/>
                  </a:lnTo>
                  <a:lnTo>
                    <a:pt x="396" y="279015"/>
                  </a:lnTo>
                  <a:lnTo>
                    <a:pt x="395" y="278428"/>
                  </a:lnTo>
                  <a:lnTo>
                    <a:pt x="394" y="277840"/>
                  </a:lnTo>
                  <a:lnTo>
                    <a:pt x="393" y="277253"/>
                  </a:lnTo>
                  <a:lnTo>
                    <a:pt x="392" y="276665"/>
                  </a:lnTo>
                  <a:lnTo>
                    <a:pt x="391" y="276078"/>
                  </a:lnTo>
                  <a:lnTo>
                    <a:pt x="390" y="275491"/>
                  </a:lnTo>
                  <a:lnTo>
                    <a:pt x="389" y="274903"/>
                  </a:lnTo>
                  <a:lnTo>
                    <a:pt x="388" y="274316"/>
                  </a:lnTo>
                  <a:lnTo>
                    <a:pt x="387" y="273728"/>
                  </a:lnTo>
                  <a:lnTo>
                    <a:pt x="386" y="273141"/>
                  </a:lnTo>
                  <a:lnTo>
                    <a:pt x="385" y="272554"/>
                  </a:lnTo>
                  <a:lnTo>
                    <a:pt x="384" y="271966"/>
                  </a:lnTo>
                  <a:lnTo>
                    <a:pt x="382" y="271379"/>
                  </a:lnTo>
                  <a:lnTo>
                    <a:pt x="381" y="270791"/>
                  </a:lnTo>
                  <a:lnTo>
                    <a:pt x="380" y="270204"/>
                  </a:lnTo>
                  <a:lnTo>
                    <a:pt x="378" y="269616"/>
                  </a:lnTo>
                  <a:lnTo>
                    <a:pt x="377" y="269029"/>
                  </a:lnTo>
                  <a:lnTo>
                    <a:pt x="375" y="268442"/>
                  </a:lnTo>
                  <a:lnTo>
                    <a:pt x="374" y="267854"/>
                  </a:lnTo>
                  <a:lnTo>
                    <a:pt x="372" y="267267"/>
                  </a:lnTo>
                  <a:lnTo>
                    <a:pt x="371" y="266679"/>
                  </a:lnTo>
                  <a:lnTo>
                    <a:pt x="369" y="266092"/>
                  </a:lnTo>
                  <a:lnTo>
                    <a:pt x="367" y="265505"/>
                  </a:lnTo>
                  <a:lnTo>
                    <a:pt x="366" y="264917"/>
                  </a:lnTo>
                  <a:lnTo>
                    <a:pt x="364" y="264330"/>
                  </a:lnTo>
                  <a:lnTo>
                    <a:pt x="362" y="263742"/>
                  </a:lnTo>
                  <a:lnTo>
                    <a:pt x="360" y="263155"/>
                  </a:lnTo>
                  <a:lnTo>
                    <a:pt x="358" y="262568"/>
                  </a:lnTo>
                  <a:lnTo>
                    <a:pt x="356" y="261980"/>
                  </a:lnTo>
                  <a:lnTo>
                    <a:pt x="354" y="261393"/>
                  </a:lnTo>
                  <a:lnTo>
                    <a:pt x="352" y="260805"/>
                  </a:lnTo>
                  <a:lnTo>
                    <a:pt x="350" y="260218"/>
                  </a:lnTo>
                  <a:lnTo>
                    <a:pt x="348" y="259631"/>
                  </a:lnTo>
                  <a:lnTo>
                    <a:pt x="346" y="259043"/>
                  </a:lnTo>
                  <a:lnTo>
                    <a:pt x="343" y="258456"/>
                  </a:lnTo>
                  <a:lnTo>
                    <a:pt x="341" y="257868"/>
                  </a:lnTo>
                  <a:lnTo>
                    <a:pt x="339" y="257281"/>
                  </a:lnTo>
                  <a:lnTo>
                    <a:pt x="336" y="256694"/>
                  </a:lnTo>
                  <a:lnTo>
                    <a:pt x="334" y="256106"/>
                  </a:lnTo>
                  <a:lnTo>
                    <a:pt x="331" y="255519"/>
                  </a:lnTo>
                  <a:lnTo>
                    <a:pt x="329" y="254931"/>
                  </a:lnTo>
                  <a:lnTo>
                    <a:pt x="326" y="254344"/>
                  </a:lnTo>
                  <a:lnTo>
                    <a:pt x="323" y="253757"/>
                  </a:lnTo>
                  <a:lnTo>
                    <a:pt x="320" y="253169"/>
                  </a:lnTo>
                  <a:lnTo>
                    <a:pt x="318" y="252582"/>
                  </a:lnTo>
                  <a:lnTo>
                    <a:pt x="315" y="251994"/>
                  </a:lnTo>
                  <a:lnTo>
                    <a:pt x="312" y="251407"/>
                  </a:lnTo>
                  <a:lnTo>
                    <a:pt x="309" y="250820"/>
                  </a:lnTo>
                  <a:lnTo>
                    <a:pt x="306" y="250232"/>
                  </a:lnTo>
                  <a:lnTo>
                    <a:pt x="303" y="249645"/>
                  </a:lnTo>
                  <a:lnTo>
                    <a:pt x="300" y="249057"/>
                  </a:lnTo>
                  <a:lnTo>
                    <a:pt x="297" y="248470"/>
                  </a:lnTo>
                  <a:lnTo>
                    <a:pt x="294" y="247883"/>
                  </a:lnTo>
                  <a:lnTo>
                    <a:pt x="290" y="247295"/>
                  </a:lnTo>
                  <a:lnTo>
                    <a:pt x="287" y="246708"/>
                  </a:lnTo>
                  <a:lnTo>
                    <a:pt x="284" y="246120"/>
                  </a:lnTo>
                  <a:lnTo>
                    <a:pt x="281" y="245533"/>
                  </a:lnTo>
                  <a:lnTo>
                    <a:pt x="277" y="244946"/>
                  </a:lnTo>
                  <a:lnTo>
                    <a:pt x="274" y="244358"/>
                  </a:lnTo>
                  <a:lnTo>
                    <a:pt x="270" y="243771"/>
                  </a:lnTo>
                  <a:lnTo>
                    <a:pt x="267" y="243183"/>
                  </a:lnTo>
                  <a:lnTo>
                    <a:pt x="263" y="242596"/>
                  </a:lnTo>
                  <a:lnTo>
                    <a:pt x="260" y="242009"/>
                  </a:lnTo>
                  <a:lnTo>
                    <a:pt x="256" y="241421"/>
                  </a:lnTo>
                  <a:lnTo>
                    <a:pt x="252" y="240834"/>
                  </a:lnTo>
                  <a:lnTo>
                    <a:pt x="249" y="240246"/>
                  </a:lnTo>
                  <a:lnTo>
                    <a:pt x="245" y="239659"/>
                  </a:lnTo>
                  <a:lnTo>
                    <a:pt x="241" y="239072"/>
                  </a:lnTo>
                  <a:lnTo>
                    <a:pt x="237" y="238484"/>
                  </a:lnTo>
                  <a:lnTo>
                    <a:pt x="233" y="237897"/>
                  </a:lnTo>
                  <a:lnTo>
                    <a:pt x="230" y="237309"/>
                  </a:lnTo>
                  <a:lnTo>
                    <a:pt x="226" y="236722"/>
                  </a:lnTo>
                  <a:lnTo>
                    <a:pt x="222" y="236135"/>
                  </a:lnTo>
                  <a:lnTo>
                    <a:pt x="218" y="235547"/>
                  </a:lnTo>
                  <a:lnTo>
                    <a:pt x="214" y="234960"/>
                  </a:lnTo>
                  <a:lnTo>
                    <a:pt x="210" y="234372"/>
                  </a:lnTo>
                  <a:lnTo>
                    <a:pt x="206" y="233785"/>
                  </a:lnTo>
                  <a:lnTo>
                    <a:pt x="202" y="233198"/>
                  </a:lnTo>
                  <a:lnTo>
                    <a:pt x="198" y="232610"/>
                  </a:lnTo>
                  <a:lnTo>
                    <a:pt x="194" y="232023"/>
                  </a:lnTo>
                  <a:lnTo>
                    <a:pt x="190" y="231435"/>
                  </a:lnTo>
                  <a:lnTo>
                    <a:pt x="186" y="230848"/>
                  </a:lnTo>
                  <a:lnTo>
                    <a:pt x="182" y="230261"/>
                  </a:lnTo>
                  <a:lnTo>
                    <a:pt x="178" y="229673"/>
                  </a:lnTo>
                  <a:lnTo>
                    <a:pt x="174" y="229086"/>
                  </a:lnTo>
                  <a:lnTo>
                    <a:pt x="170" y="228498"/>
                  </a:lnTo>
                  <a:lnTo>
                    <a:pt x="166" y="227911"/>
                  </a:lnTo>
                  <a:lnTo>
                    <a:pt x="162" y="227324"/>
                  </a:lnTo>
                  <a:lnTo>
                    <a:pt x="158" y="226736"/>
                  </a:lnTo>
                  <a:lnTo>
                    <a:pt x="154" y="226149"/>
                  </a:lnTo>
                  <a:lnTo>
                    <a:pt x="150" y="225561"/>
                  </a:lnTo>
                  <a:lnTo>
                    <a:pt x="146" y="224974"/>
                  </a:lnTo>
                  <a:lnTo>
                    <a:pt x="142" y="224387"/>
                  </a:lnTo>
                  <a:lnTo>
                    <a:pt x="138" y="223799"/>
                  </a:lnTo>
                  <a:lnTo>
                    <a:pt x="134" y="223212"/>
                  </a:lnTo>
                  <a:lnTo>
                    <a:pt x="130" y="222624"/>
                  </a:lnTo>
                  <a:lnTo>
                    <a:pt x="126" y="222037"/>
                  </a:lnTo>
                  <a:lnTo>
                    <a:pt x="122" y="221450"/>
                  </a:lnTo>
                  <a:lnTo>
                    <a:pt x="118" y="220862"/>
                  </a:lnTo>
                  <a:lnTo>
                    <a:pt x="114" y="220275"/>
                  </a:lnTo>
                  <a:lnTo>
                    <a:pt x="111" y="219687"/>
                  </a:lnTo>
                  <a:lnTo>
                    <a:pt x="107" y="219100"/>
                  </a:lnTo>
                  <a:lnTo>
                    <a:pt x="103" y="218513"/>
                  </a:lnTo>
                  <a:lnTo>
                    <a:pt x="100" y="217925"/>
                  </a:lnTo>
                  <a:lnTo>
                    <a:pt x="96" y="217338"/>
                  </a:lnTo>
                  <a:lnTo>
                    <a:pt x="93" y="216750"/>
                  </a:lnTo>
                  <a:lnTo>
                    <a:pt x="89" y="216163"/>
                  </a:lnTo>
                  <a:lnTo>
                    <a:pt x="86" y="215576"/>
                  </a:lnTo>
                  <a:lnTo>
                    <a:pt x="82" y="214988"/>
                  </a:lnTo>
                  <a:lnTo>
                    <a:pt x="79" y="214401"/>
                  </a:lnTo>
                  <a:lnTo>
                    <a:pt x="76" y="213813"/>
                  </a:lnTo>
                  <a:lnTo>
                    <a:pt x="72" y="213226"/>
                  </a:lnTo>
                  <a:lnTo>
                    <a:pt x="69" y="212639"/>
                  </a:lnTo>
                  <a:lnTo>
                    <a:pt x="66" y="212051"/>
                  </a:lnTo>
                  <a:lnTo>
                    <a:pt x="63" y="211464"/>
                  </a:lnTo>
                  <a:lnTo>
                    <a:pt x="60" y="210876"/>
                  </a:lnTo>
                  <a:lnTo>
                    <a:pt x="57" y="210289"/>
                  </a:lnTo>
                  <a:lnTo>
                    <a:pt x="54" y="209702"/>
                  </a:lnTo>
                  <a:lnTo>
                    <a:pt x="51" y="209114"/>
                  </a:lnTo>
                  <a:lnTo>
                    <a:pt x="49" y="208527"/>
                  </a:lnTo>
                  <a:lnTo>
                    <a:pt x="46" y="207939"/>
                  </a:lnTo>
                  <a:lnTo>
                    <a:pt x="43" y="207352"/>
                  </a:lnTo>
                  <a:lnTo>
                    <a:pt x="41" y="206765"/>
                  </a:lnTo>
                  <a:lnTo>
                    <a:pt x="38" y="206177"/>
                  </a:lnTo>
                  <a:lnTo>
                    <a:pt x="36" y="205590"/>
                  </a:lnTo>
                  <a:lnTo>
                    <a:pt x="34" y="205002"/>
                  </a:lnTo>
                  <a:lnTo>
                    <a:pt x="31" y="204415"/>
                  </a:lnTo>
                  <a:lnTo>
                    <a:pt x="29" y="203828"/>
                  </a:lnTo>
                  <a:lnTo>
                    <a:pt x="27" y="203240"/>
                  </a:lnTo>
                  <a:lnTo>
                    <a:pt x="25" y="202653"/>
                  </a:lnTo>
                  <a:lnTo>
                    <a:pt x="23" y="202065"/>
                  </a:lnTo>
                  <a:lnTo>
                    <a:pt x="21" y="201478"/>
                  </a:lnTo>
                  <a:lnTo>
                    <a:pt x="20" y="200891"/>
                  </a:lnTo>
                  <a:lnTo>
                    <a:pt x="18" y="200303"/>
                  </a:lnTo>
                  <a:lnTo>
                    <a:pt x="16" y="199716"/>
                  </a:lnTo>
                  <a:lnTo>
                    <a:pt x="15" y="199128"/>
                  </a:lnTo>
                  <a:lnTo>
                    <a:pt x="13" y="198541"/>
                  </a:lnTo>
                  <a:lnTo>
                    <a:pt x="12" y="197954"/>
                  </a:lnTo>
                  <a:lnTo>
                    <a:pt x="11" y="197366"/>
                  </a:lnTo>
                  <a:lnTo>
                    <a:pt x="9" y="196779"/>
                  </a:lnTo>
                  <a:lnTo>
                    <a:pt x="8" y="196191"/>
                  </a:lnTo>
                  <a:lnTo>
                    <a:pt x="7" y="195604"/>
                  </a:lnTo>
                  <a:lnTo>
                    <a:pt x="6" y="195017"/>
                  </a:lnTo>
                  <a:lnTo>
                    <a:pt x="5" y="194429"/>
                  </a:lnTo>
                  <a:lnTo>
                    <a:pt x="4" y="193842"/>
                  </a:lnTo>
                  <a:lnTo>
                    <a:pt x="4" y="193254"/>
                  </a:lnTo>
                  <a:lnTo>
                    <a:pt x="3" y="192667"/>
                  </a:lnTo>
                  <a:lnTo>
                    <a:pt x="2" y="192080"/>
                  </a:lnTo>
                  <a:lnTo>
                    <a:pt x="2" y="191492"/>
                  </a:lnTo>
                  <a:lnTo>
                    <a:pt x="1" y="190905"/>
                  </a:lnTo>
                  <a:lnTo>
                    <a:pt x="1" y="190317"/>
                  </a:lnTo>
                  <a:lnTo>
                    <a:pt x="0" y="189730"/>
                  </a:lnTo>
                  <a:lnTo>
                    <a:pt x="0" y="189143"/>
                  </a:lnTo>
                  <a:lnTo>
                    <a:pt x="0" y="188555"/>
                  </a:lnTo>
                  <a:lnTo>
                    <a:pt x="0" y="187968"/>
                  </a:lnTo>
                  <a:lnTo>
                    <a:pt x="0" y="187380"/>
                  </a:lnTo>
                  <a:lnTo>
                    <a:pt x="0" y="186793"/>
                  </a:lnTo>
                  <a:lnTo>
                    <a:pt x="0" y="186206"/>
                  </a:lnTo>
                  <a:lnTo>
                    <a:pt x="0" y="185618"/>
                  </a:lnTo>
                  <a:lnTo>
                    <a:pt x="0" y="185031"/>
                  </a:lnTo>
                  <a:lnTo>
                    <a:pt x="0" y="184443"/>
                  </a:lnTo>
                  <a:lnTo>
                    <a:pt x="0" y="183856"/>
                  </a:lnTo>
                  <a:lnTo>
                    <a:pt x="0" y="183269"/>
                  </a:lnTo>
                  <a:lnTo>
                    <a:pt x="1" y="182681"/>
                  </a:lnTo>
                  <a:lnTo>
                    <a:pt x="1" y="182094"/>
                  </a:lnTo>
                  <a:lnTo>
                    <a:pt x="1" y="181506"/>
                  </a:lnTo>
                  <a:lnTo>
                    <a:pt x="2" y="180919"/>
                  </a:lnTo>
                  <a:lnTo>
                    <a:pt x="2" y="180332"/>
                  </a:lnTo>
                  <a:lnTo>
                    <a:pt x="3" y="179744"/>
                  </a:lnTo>
                  <a:lnTo>
                    <a:pt x="3" y="179157"/>
                  </a:lnTo>
                  <a:lnTo>
                    <a:pt x="4" y="178569"/>
                  </a:lnTo>
                  <a:lnTo>
                    <a:pt x="5" y="177982"/>
                  </a:lnTo>
                  <a:lnTo>
                    <a:pt x="5" y="177395"/>
                  </a:lnTo>
                  <a:lnTo>
                    <a:pt x="6" y="176807"/>
                  </a:lnTo>
                  <a:lnTo>
                    <a:pt x="7" y="176220"/>
                  </a:lnTo>
                  <a:lnTo>
                    <a:pt x="7" y="175632"/>
                  </a:lnTo>
                  <a:lnTo>
                    <a:pt x="8" y="175045"/>
                  </a:lnTo>
                  <a:lnTo>
                    <a:pt x="9" y="174458"/>
                  </a:lnTo>
                  <a:lnTo>
                    <a:pt x="10" y="173870"/>
                  </a:lnTo>
                  <a:lnTo>
                    <a:pt x="10" y="173283"/>
                  </a:lnTo>
                  <a:lnTo>
                    <a:pt x="11" y="172695"/>
                  </a:lnTo>
                  <a:lnTo>
                    <a:pt x="12" y="172108"/>
                  </a:lnTo>
                  <a:lnTo>
                    <a:pt x="13" y="171521"/>
                  </a:lnTo>
                  <a:lnTo>
                    <a:pt x="14" y="170933"/>
                  </a:lnTo>
                  <a:lnTo>
                    <a:pt x="14" y="170346"/>
                  </a:lnTo>
                  <a:lnTo>
                    <a:pt x="15" y="169758"/>
                  </a:lnTo>
                  <a:lnTo>
                    <a:pt x="16" y="169171"/>
                  </a:lnTo>
                  <a:lnTo>
                    <a:pt x="17" y="168584"/>
                  </a:lnTo>
                  <a:lnTo>
                    <a:pt x="18" y="167996"/>
                  </a:lnTo>
                  <a:lnTo>
                    <a:pt x="19" y="167409"/>
                  </a:lnTo>
                  <a:lnTo>
                    <a:pt x="20" y="166821"/>
                  </a:lnTo>
                  <a:lnTo>
                    <a:pt x="20" y="166234"/>
                  </a:lnTo>
                  <a:lnTo>
                    <a:pt x="21" y="165647"/>
                  </a:lnTo>
                  <a:lnTo>
                    <a:pt x="22" y="165059"/>
                  </a:lnTo>
                  <a:lnTo>
                    <a:pt x="23" y="164472"/>
                  </a:lnTo>
                  <a:lnTo>
                    <a:pt x="24" y="163884"/>
                  </a:lnTo>
                  <a:lnTo>
                    <a:pt x="24" y="163297"/>
                  </a:lnTo>
                  <a:lnTo>
                    <a:pt x="25" y="162710"/>
                  </a:lnTo>
                  <a:lnTo>
                    <a:pt x="26" y="162122"/>
                  </a:lnTo>
                  <a:lnTo>
                    <a:pt x="27" y="161535"/>
                  </a:lnTo>
                  <a:lnTo>
                    <a:pt x="27" y="160947"/>
                  </a:lnTo>
                  <a:lnTo>
                    <a:pt x="28" y="160360"/>
                  </a:lnTo>
                  <a:lnTo>
                    <a:pt x="29" y="159773"/>
                  </a:lnTo>
                  <a:lnTo>
                    <a:pt x="29" y="159185"/>
                  </a:lnTo>
                  <a:lnTo>
                    <a:pt x="30" y="158598"/>
                  </a:lnTo>
                  <a:lnTo>
                    <a:pt x="30" y="158010"/>
                  </a:lnTo>
                  <a:lnTo>
                    <a:pt x="31" y="157423"/>
                  </a:lnTo>
                  <a:lnTo>
                    <a:pt x="31" y="156836"/>
                  </a:lnTo>
                  <a:lnTo>
                    <a:pt x="32" y="156248"/>
                  </a:lnTo>
                  <a:lnTo>
                    <a:pt x="32" y="155661"/>
                  </a:lnTo>
                  <a:lnTo>
                    <a:pt x="33" y="155073"/>
                  </a:lnTo>
                  <a:lnTo>
                    <a:pt x="33" y="154486"/>
                  </a:lnTo>
                  <a:lnTo>
                    <a:pt x="33" y="153899"/>
                  </a:lnTo>
                  <a:lnTo>
                    <a:pt x="34" y="153311"/>
                  </a:lnTo>
                  <a:lnTo>
                    <a:pt x="34" y="152724"/>
                  </a:lnTo>
                  <a:lnTo>
                    <a:pt x="34" y="152136"/>
                  </a:lnTo>
                  <a:lnTo>
                    <a:pt x="34" y="151549"/>
                  </a:lnTo>
                  <a:lnTo>
                    <a:pt x="35" y="150962"/>
                  </a:lnTo>
                  <a:lnTo>
                    <a:pt x="35" y="150374"/>
                  </a:lnTo>
                  <a:lnTo>
                    <a:pt x="35" y="149787"/>
                  </a:lnTo>
                  <a:lnTo>
                    <a:pt x="35" y="149199"/>
                  </a:lnTo>
                  <a:lnTo>
                    <a:pt x="35" y="148612"/>
                  </a:lnTo>
                  <a:lnTo>
                    <a:pt x="35" y="148025"/>
                  </a:lnTo>
                  <a:lnTo>
                    <a:pt x="35" y="147437"/>
                  </a:lnTo>
                  <a:lnTo>
                    <a:pt x="35" y="146850"/>
                  </a:lnTo>
                  <a:lnTo>
                    <a:pt x="35" y="146262"/>
                  </a:lnTo>
                  <a:lnTo>
                    <a:pt x="35" y="145675"/>
                  </a:lnTo>
                  <a:lnTo>
                    <a:pt x="35" y="145088"/>
                  </a:lnTo>
                  <a:lnTo>
                    <a:pt x="34" y="144500"/>
                  </a:lnTo>
                  <a:lnTo>
                    <a:pt x="34" y="143913"/>
                  </a:lnTo>
                  <a:lnTo>
                    <a:pt x="34" y="143325"/>
                  </a:lnTo>
                  <a:lnTo>
                    <a:pt x="33" y="142738"/>
                  </a:lnTo>
                  <a:lnTo>
                    <a:pt x="33" y="142151"/>
                  </a:lnTo>
                  <a:lnTo>
                    <a:pt x="33" y="141563"/>
                  </a:lnTo>
                  <a:lnTo>
                    <a:pt x="32" y="140976"/>
                  </a:lnTo>
                  <a:lnTo>
                    <a:pt x="32" y="140388"/>
                  </a:lnTo>
                  <a:lnTo>
                    <a:pt x="31" y="139801"/>
                  </a:lnTo>
                  <a:lnTo>
                    <a:pt x="31" y="139214"/>
                  </a:lnTo>
                  <a:lnTo>
                    <a:pt x="30" y="138626"/>
                  </a:lnTo>
                  <a:lnTo>
                    <a:pt x="30" y="138039"/>
                  </a:lnTo>
                  <a:lnTo>
                    <a:pt x="29" y="137451"/>
                  </a:lnTo>
                  <a:lnTo>
                    <a:pt x="29" y="136864"/>
                  </a:lnTo>
                  <a:lnTo>
                    <a:pt x="28" y="136277"/>
                  </a:lnTo>
                  <a:lnTo>
                    <a:pt x="28" y="135689"/>
                  </a:lnTo>
                  <a:lnTo>
                    <a:pt x="27" y="135102"/>
                  </a:lnTo>
                  <a:lnTo>
                    <a:pt x="26" y="134514"/>
                  </a:lnTo>
                  <a:lnTo>
                    <a:pt x="25" y="133927"/>
                  </a:lnTo>
                  <a:lnTo>
                    <a:pt x="25" y="133339"/>
                  </a:lnTo>
                  <a:lnTo>
                    <a:pt x="24" y="132752"/>
                  </a:lnTo>
                  <a:lnTo>
                    <a:pt x="23" y="132165"/>
                  </a:lnTo>
                  <a:lnTo>
                    <a:pt x="23" y="131577"/>
                  </a:lnTo>
                  <a:lnTo>
                    <a:pt x="22" y="130990"/>
                  </a:lnTo>
                  <a:lnTo>
                    <a:pt x="21" y="130402"/>
                  </a:lnTo>
                  <a:lnTo>
                    <a:pt x="20" y="129815"/>
                  </a:lnTo>
                  <a:lnTo>
                    <a:pt x="20" y="129228"/>
                  </a:lnTo>
                  <a:lnTo>
                    <a:pt x="19" y="128640"/>
                  </a:lnTo>
                  <a:lnTo>
                    <a:pt x="18" y="128053"/>
                  </a:lnTo>
                  <a:lnTo>
                    <a:pt x="17" y="127465"/>
                  </a:lnTo>
                  <a:lnTo>
                    <a:pt x="17" y="126878"/>
                  </a:lnTo>
                  <a:lnTo>
                    <a:pt x="16" y="126291"/>
                  </a:lnTo>
                  <a:lnTo>
                    <a:pt x="15" y="125703"/>
                  </a:lnTo>
                  <a:lnTo>
                    <a:pt x="14" y="125116"/>
                  </a:lnTo>
                  <a:lnTo>
                    <a:pt x="14" y="124528"/>
                  </a:lnTo>
                  <a:lnTo>
                    <a:pt x="13" y="123941"/>
                  </a:lnTo>
                  <a:lnTo>
                    <a:pt x="12" y="123354"/>
                  </a:lnTo>
                  <a:lnTo>
                    <a:pt x="12" y="122766"/>
                  </a:lnTo>
                  <a:lnTo>
                    <a:pt x="11" y="122179"/>
                  </a:lnTo>
                  <a:lnTo>
                    <a:pt x="10" y="121591"/>
                  </a:lnTo>
                  <a:lnTo>
                    <a:pt x="10" y="121004"/>
                  </a:lnTo>
                  <a:lnTo>
                    <a:pt x="9" y="120417"/>
                  </a:lnTo>
                  <a:lnTo>
                    <a:pt x="9" y="119829"/>
                  </a:lnTo>
                  <a:lnTo>
                    <a:pt x="8" y="119242"/>
                  </a:lnTo>
                  <a:lnTo>
                    <a:pt x="8" y="118654"/>
                  </a:lnTo>
                  <a:lnTo>
                    <a:pt x="7" y="118067"/>
                  </a:lnTo>
                  <a:lnTo>
                    <a:pt x="7" y="117480"/>
                  </a:lnTo>
                  <a:lnTo>
                    <a:pt x="6" y="116892"/>
                  </a:lnTo>
                  <a:lnTo>
                    <a:pt x="6" y="116305"/>
                  </a:lnTo>
                  <a:lnTo>
                    <a:pt x="6" y="115717"/>
                  </a:lnTo>
                  <a:lnTo>
                    <a:pt x="5" y="115130"/>
                  </a:lnTo>
                  <a:lnTo>
                    <a:pt x="5" y="114543"/>
                  </a:lnTo>
                  <a:lnTo>
                    <a:pt x="5" y="113955"/>
                  </a:lnTo>
                  <a:lnTo>
                    <a:pt x="5" y="113368"/>
                  </a:lnTo>
                  <a:lnTo>
                    <a:pt x="5" y="112780"/>
                  </a:lnTo>
                  <a:lnTo>
                    <a:pt x="5" y="112193"/>
                  </a:lnTo>
                  <a:lnTo>
                    <a:pt x="5" y="111606"/>
                  </a:lnTo>
                  <a:lnTo>
                    <a:pt x="5" y="111018"/>
                  </a:lnTo>
                  <a:lnTo>
                    <a:pt x="5" y="110431"/>
                  </a:lnTo>
                  <a:lnTo>
                    <a:pt x="6" y="109843"/>
                  </a:lnTo>
                  <a:lnTo>
                    <a:pt x="6" y="109256"/>
                  </a:lnTo>
                  <a:lnTo>
                    <a:pt x="6" y="108669"/>
                  </a:lnTo>
                  <a:lnTo>
                    <a:pt x="7" y="108081"/>
                  </a:lnTo>
                  <a:lnTo>
                    <a:pt x="7" y="107494"/>
                  </a:lnTo>
                  <a:lnTo>
                    <a:pt x="8" y="106906"/>
                  </a:lnTo>
                  <a:lnTo>
                    <a:pt x="8" y="106319"/>
                  </a:lnTo>
                  <a:lnTo>
                    <a:pt x="9" y="105732"/>
                  </a:lnTo>
                  <a:lnTo>
                    <a:pt x="10" y="105144"/>
                  </a:lnTo>
                  <a:lnTo>
                    <a:pt x="11" y="104557"/>
                  </a:lnTo>
                  <a:lnTo>
                    <a:pt x="12" y="103969"/>
                  </a:lnTo>
                  <a:lnTo>
                    <a:pt x="13" y="103382"/>
                  </a:lnTo>
                  <a:lnTo>
                    <a:pt x="14" y="102795"/>
                  </a:lnTo>
                  <a:lnTo>
                    <a:pt x="15" y="102207"/>
                  </a:lnTo>
                  <a:lnTo>
                    <a:pt x="16" y="101620"/>
                  </a:lnTo>
                  <a:lnTo>
                    <a:pt x="17" y="101032"/>
                  </a:lnTo>
                  <a:lnTo>
                    <a:pt x="19" y="100445"/>
                  </a:lnTo>
                  <a:lnTo>
                    <a:pt x="20" y="99858"/>
                  </a:lnTo>
                  <a:lnTo>
                    <a:pt x="22" y="99270"/>
                  </a:lnTo>
                  <a:lnTo>
                    <a:pt x="23" y="98683"/>
                  </a:lnTo>
                  <a:lnTo>
                    <a:pt x="25" y="98095"/>
                  </a:lnTo>
                  <a:lnTo>
                    <a:pt x="27" y="97508"/>
                  </a:lnTo>
                  <a:lnTo>
                    <a:pt x="28" y="96921"/>
                  </a:lnTo>
                  <a:lnTo>
                    <a:pt x="30" y="96333"/>
                  </a:lnTo>
                  <a:lnTo>
                    <a:pt x="32" y="95746"/>
                  </a:lnTo>
                  <a:lnTo>
                    <a:pt x="34" y="95158"/>
                  </a:lnTo>
                  <a:lnTo>
                    <a:pt x="36" y="94571"/>
                  </a:lnTo>
                  <a:lnTo>
                    <a:pt x="39" y="93984"/>
                  </a:lnTo>
                  <a:lnTo>
                    <a:pt x="41" y="93396"/>
                  </a:lnTo>
                  <a:lnTo>
                    <a:pt x="43" y="92809"/>
                  </a:lnTo>
                  <a:lnTo>
                    <a:pt x="46" y="92221"/>
                  </a:lnTo>
                  <a:lnTo>
                    <a:pt x="48" y="91634"/>
                  </a:lnTo>
                  <a:lnTo>
                    <a:pt x="51" y="91047"/>
                  </a:lnTo>
                  <a:lnTo>
                    <a:pt x="53" y="90459"/>
                  </a:lnTo>
                  <a:lnTo>
                    <a:pt x="56" y="89872"/>
                  </a:lnTo>
                  <a:lnTo>
                    <a:pt x="59" y="89284"/>
                  </a:lnTo>
                  <a:lnTo>
                    <a:pt x="62" y="88697"/>
                  </a:lnTo>
                  <a:lnTo>
                    <a:pt x="64" y="88110"/>
                  </a:lnTo>
                  <a:lnTo>
                    <a:pt x="67" y="87522"/>
                  </a:lnTo>
                  <a:lnTo>
                    <a:pt x="70" y="86935"/>
                  </a:lnTo>
                  <a:lnTo>
                    <a:pt x="74" y="86347"/>
                  </a:lnTo>
                  <a:lnTo>
                    <a:pt x="77" y="85760"/>
                  </a:lnTo>
                  <a:lnTo>
                    <a:pt x="80" y="85173"/>
                  </a:lnTo>
                  <a:lnTo>
                    <a:pt x="83" y="84585"/>
                  </a:lnTo>
                  <a:lnTo>
                    <a:pt x="86" y="83998"/>
                  </a:lnTo>
                  <a:lnTo>
                    <a:pt x="90" y="83410"/>
                  </a:lnTo>
                  <a:lnTo>
                    <a:pt x="93" y="82823"/>
                  </a:lnTo>
                  <a:lnTo>
                    <a:pt x="97" y="82236"/>
                  </a:lnTo>
                  <a:lnTo>
                    <a:pt x="100" y="81648"/>
                  </a:lnTo>
                  <a:lnTo>
                    <a:pt x="104" y="81061"/>
                  </a:lnTo>
                  <a:lnTo>
                    <a:pt x="107" y="80473"/>
                  </a:lnTo>
                  <a:lnTo>
                    <a:pt x="111" y="79886"/>
                  </a:lnTo>
                  <a:lnTo>
                    <a:pt x="115" y="79299"/>
                  </a:lnTo>
                  <a:lnTo>
                    <a:pt x="118" y="78711"/>
                  </a:lnTo>
                  <a:lnTo>
                    <a:pt x="122" y="78124"/>
                  </a:lnTo>
                  <a:lnTo>
                    <a:pt x="126" y="77536"/>
                  </a:lnTo>
                  <a:lnTo>
                    <a:pt x="130" y="76949"/>
                  </a:lnTo>
                  <a:lnTo>
                    <a:pt x="134" y="76362"/>
                  </a:lnTo>
                  <a:lnTo>
                    <a:pt x="137" y="75774"/>
                  </a:lnTo>
                  <a:lnTo>
                    <a:pt x="141" y="75187"/>
                  </a:lnTo>
                  <a:lnTo>
                    <a:pt x="145" y="74599"/>
                  </a:lnTo>
                  <a:lnTo>
                    <a:pt x="149" y="74012"/>
                  </a:lnTo>
                  <a:lnTo>
                    <a:pt x="153" y="73425"/>
                  </a:lnTo>
                  <a:lnTo>
                    <a:pt x="157" y="72837"/>
                  </a:lnTo>
                  <a:lnTo>
                    <a:pt x="161" y="72250"/>
                  </a:lnTo>
                  <a:lnTo>
                    <a:pt x="165" y="71662"/>
                  </a:lnTo>
                  <a:lnTo>
                    <a:pt x="169" y="71075"/>
                  </a:lnTo>
                  <a:lnTo>
                    <a:pt x="173" y="70488"/>
                  </a:lnTo>
                  <a:lnTo>
                    <a:pt x="177" y="69900"/>
                  </a:lnTo>
                  <a:lnTo>
                    <a:pt x="181" y="69313"/>
                  </a:lnTo>
                  <a:lnTo>
                    <a:pt x="185" y="68725"/>
                  </a:lnTo>
                  <a:lnTo>
                    <a:pt x="189" y="68138"/>
                  </a:lnTo>
                  <a:lnTo>
                    <a:pt x="193" y="67551"/>
                  </a:lnTo>
                  <a:lnTo>
                    <a:pt x="197" y="66963"/>
                  </a:lnTo>
                  <a:lnTo>
                    <a:pt x="201" y="66376"/>
                  </a:lnTo>
                  <a:lnTo>
                    <a:pt x="205" y="65788"/>
                  </a:lnTo>
                  <a:lnTo>
                    <a:pt x="209" y="65201"/>
                  </a:lnTo>
                  <a:lnTo>
                    <a:pt x="213" y="64614"/>
                  </a:lnTo>
                  <a:lnTo>
                    <a:pt x="217" y="64026"/>
                  </a:lnTo>
                  <a:lnTo>
                    <a:pt x="221" y="63439"/>
                  </a:lnTo>
                  <a:lnTo>
                    <a:pt x="225" y="62851"/>
                  </a:lnTo>
                  <a:lnTo>
                    <a:pt x="228" y="62264"/>
                  </a:lnTo>
                  <a:lnTo>
                    <a:pt x="232" y="61677"/>
                  </a:lnTo>
                  <a:lnTo>
                    <a:pt x="236" y="61089"/>
                  </a:lnTo>
                  <a:lnTo>
                    <a:pt x="240" y="60502"/>
                  </a:lnTo>
                  <a:lnTo>
                    <a:pt x="244" y="59914"/>
                  </a:lnTo>
                  <a:lnTo>
                    <a:pt x="247" y="59327"/>
                  </a:lnTo>
                  <a:lnTo>
                    <a:pt x="251" y="58740"/>
                  </a:lnTo>
                  <a:lnTo>
                    <a:pt x="255" y="58152"/>
                  </a:lnTo>
                  <a:lnTo>
                    <a:pt x="258" y="57565"/>
                  </a:lnTo>
                  <a:lnTo>
                    <a:pt x="262" y="56977"/>
                  </a:lnTo>
                  <a:lnTo>
                    <a:pt x="266" y="56390"/>
                  </a:lnTo>
                  <a:lnTo>
                    <a:pt x="269" y="55803"/>
                  </a:lnTo>
                  <a:lnTo>
                    <a:pt x="273" y="55215"/>
                  </a:lnTo>
                  <a:lnTo>
                    <a:pt x="276" y="54628"/>
                  </a:lnTo>
                  <a:lnTo>
                    <a:pt x="279" y="54040"/>
                  </a:lnTo>
                  <a:lnTo>
                    <a:pt x="283" y="53453"/>
                  </a:lnTo>
                  <a:lnTo>
                    <a:pt x="286" y="52866"/>
                  </a:lnTo>
                  <a:lnTo>
                    <a:pt x="289" y="52278"/>
                  </a:lnTo>
                  <a:lnTo>
                    <a:pt x="293" y="51691"/>
                  </a:lnTo>
                  <a:lnTo>
                    <a:pt x="296" y="51103"/>
                  </a:lnTo>
                  <a:lnTo>
                    <a:pt x="299" y="50516"/>
                  </a:lnTo>
                  <a:lnTo>
                    <a:pt x="302" y="49929"/>
                  </a:lnTo>
                  <a:lnTo>
                    <a:pt x="305" y="49341"/>
                  </a:lnTo>
                  <a:lnTo>
                    <a:pt x="308" y="48754"/>
                  </a:lnTo>
                  <a:lnTo>
                    <a:pt x="311" y="48166"/>
                  </a:lnTo>
                  <a:lnTo>
                    <a:pt x="314" y="47579"/>
                  </a:lnTo>
                  <a:lnTo>
                    <a:pt x="317" y="46992"/>
                  </a:lnTo>
                  <a:lnTo>
                    <a:pt x="319" y="46404"/>
                  </a:lnTo>
                  <a:lnTo>
                    <a:pt x="322" y="45817"/>
                  </a:lnTo>
                  <a:lnTo>
                    <a:pt x="325" y="45229"/>
                  </a:lnTo>
                  <a:lnTo>
                    <a:pt x="328" y="44642"/>
                  </a:lnTo>
                  <a:lnTo>
                    <a:pt x="330" y="44055"/>
                  </a:lnTo>
                  <a:lnTo>
                    <a:pt x="333" y="43467"/>
                  </a:lnTo>
                  <a:lnTo>
                    <a:pt x="335" y="42880"/>
                  </a:lnTo>
                  <a:lnTo>
                    <a:pt x="338" y="42292"/>
                  </a:lnTo>
                  <a:lnTo>
                    <a:pt x="340" y="41705"/>
                  </a:lnTo>
                  <a:lnTo>
                    <a:pt x="342" y="41118"/>
                  </a:lnTo>
                  <a:lnTo>
                    <a:pt x="345" y="40530"/>
                  </a:lnTo>
                  <a:lnTo>
                    <a:pt x="347" y="39943"/>
                  </a:lnTo>
                  <a:lnTo>
                    <a:pt x="349" y="39355"/>
                  </a:lnTo>
                  <a:lnTo>
                    <a:pt x="351" y="38768"/>
                  </a:lnTo>
                  <a:lnTo>
                    <a:pt x="353" y="38181"/>
                  </a:lnTo>
                  <a:lnTo>
                    <a:pt x="355" y="37593"/>
                  </a:lnTo>
                  <a:lnTo>
                    <a:pt x="357" y="37006"/>
                  </a:lnTo>
                  <a:lnTo>
                    <a:pt x="359" y="36418"/>
                  </a:lnTo>
                  <a:lnTo>
                    <a:pt x="361" y="35831"/>
                  </a:lnTo>
                  <a:lnTo>
                    <a:pt x="363" y="35244"/>
                  </a:lnTo>
                  <a:lnTo>
                    <a:pt x="365" y="34656"/>
                  </a:lnTo>
                  <a:lnTo>
                    <a:pt x="367" y="34069"/>
                  </a:lnTo>
                  <a:lnTo>
                    <a:pt x="368" y="33481"/>
                  </a:lnTo>
                  <a:lnTo>
                    <a:pt x="370" y="32894"/>
                  </a:lnTo>
                  <a:lnTo>
                    <a:pt x="372" y="32307"/>
                  </a:lnTo>
                  <a:lnTo>
                    <a:pt x="373" y="31719"/>
                  </a:lnTo>
                  <a:lnTo>
                    <a:pt x="375" y="31132"/>
                  </a:lnTo>
                  <a:lnTo>
                    <a:pt x="376" y="30544"/>
                  </a:lnTo>
                  <a:lnTo>
                    <a:pt x="378" y="29957"/>
                  </a:lnTo>
                  <a:lnTo>
                    <a:pt x="379" y="29370"/>
                  </a:lnTo>
                  <a:lnTo>
                    <a:pt x="380" y="28782"/>
                  </a:lnTo>
                  <a:lnTo>
                    <a:pt x="382" y="28195"/>
                  </a:lnTo>
                  <a:lnTo>
                    <a:pt x="383" y="27607"/>
                  </a:lnTo>
                  <a:lnTo>
                    <a:pt x="384" y="27020"/>
                  </a:lnTo>
                  <a:lnTo>
                    <a:pt x="385" y="26433"/>
                  </a:lnTo>
                  <a:lnTo>
                    <a:pt x="387" y="25845"/>
                  </a:lnTo>
                  <a:lnTo>
                    <a:pt x="388" y="25258"/>
                  </a:lnTo>
                  <a:lnTo>
                    <a:pt x="389" y="24670"/>
                  </a:lnTo>
                  <a:lnTo>
                    <a:pt x="390" y="24083"/>
                  </a:lnTo>
                  <a:lnTo>
                    <a:pt x="391" y="23496"/>
                  </a:lnTo>
                  <a:lnTo>
                    <a:pt x="392" y="22908"/>
                  </a:lnTo>
                  <a:lnTo>
                    <a:pt x="393" y="22321"/>
                  </a:lnTo>
                  <a:lnTo>
                    <a:pt x="394" y="21733"/>
                  </a:lnTo>
                  <a:lnTo>
                    <a:pt x="395" y="21146"/>
                  </a:lnTo>
                  <a:lnTo>
                    <a:pt x="396" y="20559"/>
                  </a:lnTo>
                  <a:lnTo>
                    <a:pt x="396" y="19971"/>
                  </a:lnTo>
                  <a:lnTo>
                    <a:pt x="397" y="19384"/>
                  </a:lnTo>
                  <a:lnTo>
                    <a:pt x="398" y="18796"/>
                  </a:lnTo>
                  <a:lnTo>
                    <a:pt x="399" y="18209"/>
                  </a:lnTo>
                  <a:lnTo>
                    <a:pt x="400" y="17622"/>
                  </a:lnTo>
                  <a:lnTo>
                    <a:pt x="400" y="17034"/>
                  </a:lnTo>
                  <a:lnTo>
                    <a:pt x="401" y="16447"/>
                  </a:lnTo>
                  <a:lnTo>
                    <a:pt x="402" y="15859"/>
                  </a:lnTo>
                  <a:lnTo>
                    <a:pt x="402" y="15272"/>
                  </a:lnTo>
                  <a:lnTo>
                    <a:pt x="403" y="14685"/>
                  </a:lnTo>
                  <a:lnTo>
                    <a:pt x="403" y="14097"/>
                  </a:lnTo>
                  <a:lnTo>
                    <a:pt x="404" y="13510"/>
                  </a:lnTo>
                  <a:lnTo>
                    <a:pt x="404" y="12922"/>
                  </a:lnTo>
                  <a:lnTo>
                    <a:pt x="405" y="12335"/>
                  </a:lnTo>
                  <a:lnTo>
                    <a:pt x="406" y="11748"/>
                  </a:lnTo>
                  <a:lnTo>
                    <a:pt x="406" y="11160"/>
                  </a:lnTo>
                  <a:lnTo>
                    <a:pt x="406" y="10573"/>
                  </a:lnTo>
                  <a:lnTo>
                    <a:pt x="407" y="9985"/>
                  </a:lnTo>
                  <a:lnTo>
                    <a:pt x="407" y="9398"/>
                  </a:lnTo>
                  <a:lnTo>
                    <a:pt x="408" y="8811"/>
                  </a:lnTo>
                  <a:lnTo>
                    <a:pt x="408" y="8223"/>
                  </a:lnTo>
                  <a:lnTo>
                    <a:pt x="408" y="7636"/>
                  </a:lnTo>
                  <a:lnTo>
                    <a:pt x="409" y="7048"/>
                  </a:lnTo>
                  <a:lnTo>
                    <a:pt x="409" y="6461"/>
                  </a:lnTo>
                  <a:lnTo>
                    <a:pt x="409" y="5874"/>
                  </a:lnTo>
                  <a:lnTo>
                    <a:pt x="410" y="5286"/>
                  </a:lnTo>
                  <a:lnTo>
                    <a:pt x="410" y="4699"/>
                  </a:lnTo>
                  <a:lnTo>
                    <a:pt x="410" y="4111"/>
                  </a:lnTo>
                  <a:lnTo>
                    <a:pt x="411" y="3524"/>
                  </a:lnTo>
                  <a:lnTo>
                    <a:pt x="411" y="2937"/>
                  </a:lnTo>
                  <a:lnTo>
                    <a:pt x="411" y="2349"/>
                  </a:lnTo>
                  <a:lnTo>
                    <a:pt x="411" y="1762"/>
                  </a:lnTo>
                  <a:lnTo>
                    <a:pt x="412" y="1174"/>
                  </a:lnTo>
                  <a:lnTo>
                    <a:pt x="412" y="587"/>
                  </a:lnTo>
                  <a:lnTo>
                    <a:pt x="412" y="0"/>
                  </a:lnTo>
                  <a:lnTo>
                    <a:pt x="416" y="0"/>
                  </a:lnTo>
                  <a:lnTo>
                    <a:pt x="416" y="300161"/>
                  </a:lnTo>
                  <a:lnTo>
                    <a:pt x="416" y="300161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47" name="pl29"/>
            <p:cNvSpPr/>
            <p:nvPr/>
          </p:nvSpPr>
          <p:spPr>
            <a:xfrm>
              <a:off x="3898717" y="3716942"/>
              <a:ext cx="1766" cy="99602"/>
            </a:xfrm>
            <a:custGeom>
              <a:avLst/>
              <a:gdLst/>
              <a:ahLst/>
              <a:cxnLst/>
              <a:rect l="0" t="0" r="0" b="0"/>
              <a:pathLst>
                <a:path w="1766" h="99602">
                  <a:moveTo>
                    <a:pt x="0" y="0"/>
                  </a:moveTo>
                  <a:lnTo>
                    <a:pt x="8" y="0"/>
                  </a:lnTo>
                  <a:lnTo>
                    <a:pt x="8" y="194"/>
                  </a:lnTo>
                  <a:lnTo>
                    <a:pt x="9" y="389"/>
                  </a:lnTo>
                  <a:lnTo>
                    <a:pt x="9" y="584"/>
                  </a:lnTo>
                  <a:lnTo>
                    <a:pt x="10" y="779"/>
                  </a:lnTo>
                  <a:lnTo>
                    <a:pt x="11" y="974"/>
                  </a:lnTo>
                  <a:lnTo>
                    <a:pt x="11" y="1169"/>
                  </a:lnTo>
                  <a:lnTo>
                    <a:pt x="12" y="1364"/>
                  </a:lnTo>
                  <a:lnTo>
                    <a:pt x="13" y="1559"/>
                  </a:lnTo>
                  <a:lnTo>
                    <a:pt x="14" y="1754"/>
                  </a:lnTo>
                  <a:lnTo>
                    <a:pt x="14" y="1949"/>
                  </a:lnTo>
                  <a:lnTo>
                    <a:pt x="15" y="2144"/>
                  </a:lnTo>
                  <a:lnTo>
                    <a:pt x="16" y="2339"/>
                  </a:lnTo>
                  <a:lnTo>
                    <a:pt x="17" y="2533"/>
                  </a:lnTo>
                  <a:lnTo>
                    <a:pt x="18" y="2728"/>
                  </a:lnTo>
                  <a:lnTo>
                    <a:pt x="19" y="2923"/>
                  </a:lnTo>
                  <a:lnTo>
                    <a:pt x="20" y="3118"/>
                  </a:lnTo>
                  <a:lnTo>
                    <a:pt x="21" y="3313"/>
                  </a:lnTo>
                  <a:lnTo>
                    <a:pt x="23" y="3508"/>
                  </a:lnTo>
                  <a:lnTo>
                    <a:pt x="24" y="3703"/>
                  </a:lnTo>
                  <a:lnTo>
                    <a:pt x="25" y="3898"/>
                  </a:lnTo>
                  <a:lnTo>
                    <a:pt x="27" y="4093"/>
                  </a:lnTo>
                  <a:lnTo>
                    <a:pt x="28" y="4288"/>
                  </a:lnTo>
                  <a:lnTo>
                    <a:pt x="30" y="4483"/>
                  </a:lnTo>
                  <a:lnTo>
                    <a:pt x="31" y="4678"/>
                  </a:lnTo>
                  <a:lnTo>
                    <a:pt x="33" y="4872"/>
                  </a:lnTo>
                  <a:lnTo>
                    <a:pt x="35" y="5067"/>
                  </a:lnTo>
                  <a:lnTo>
                    <a:pt x="36" y="5262"/>
                  </a:lnTo>
                  <a:lnTo>
                    <a:pt x="38" y="5457"/>
                  </a:lnTo>
                  <a:lnTo>
                    <a:pt x="40" y="5652"/>
                  </a:lnTo>
                  <a:lnTo>
                    <a:pt x="42" y="5847"/>
                  </a:lnTo>
                  <a:lnTo>
                    <a:pt x="44" y="6042"/>
                  </a:lnTo>
                  <a:lnTo>
                    <a:pt x="47" y="6237"/>
                  </a:lnTo>
                  <a:lnTo>
                    <a:pt x="49" y="6432"/>
                  </a:lnTo>
                  <a:lnTo>
                    <a:pt x="51" y="6627"/>
                  </a:lnTo>
                  <a:lnTo>
                    <a:pt x="54" y="6822"/>
                  </a:lnTo>
                  <a:lnTo>
                    <a:pt x="56" y="7017"/>
                  </a:lnTo>
                  <a:lnTo>
                    <a:pt x="59" y="7211"/>
                  </a:lnTo>
                  <a:lnTo>
                    <a:pt x="62" y="7406"/>
                  </a:lnTo>
                  <a:lnTo>
                    <a:pt x="65" y="7601"/>
                  </a:lnTo>
                  <a:lnTo>
                    <a:pt x="68" y="7796"/>
                  </a:lnTo>
                  <a:lnTo>
                    <a:pt x="71" y="7991"/>
                  </a:lnTo>
                  <a:lnTo>
                    <a:pt x="74" y="8186"/>
                  </a:lnTo>
                  <a:lnTo>
                    <a:pt x="77" y="8381"/>
                  </a:lnTo>
                  <a:lnTo>
                    <a:pt x="81" y="8576"/>
                  </a:lnTo>
                  <a:lnTo>
                    <a:pt x="84" y="8771"/>
                  </a:lnTo>
                  <a:lnTo>
                    <a:pt x="88" y="8966"/>
                  </a:lnTo>
                  <a:lnTo>
                    <a:pt x="92" y="9161"/>
                  </a:lnTo>
                  <a:lnTo>
                    <a:pt x="96" y="9356"/>
                  </a:lnTo>
                  <a:lnTo>
                    <a:pt x="100" y="9550"/>
                  </a:lnTo>
                  <a:lnTo>
                    <a:pt x="104" y="9745"/>
                  </a:lnTo>
                  <a:lnTo>
                    <a:pt x="108" y="9940"/>
                  </a:lnTo>
                  <a:lnTo>
                    <a:pt x="113" y="10135"/>
                  </a:lnTo>
                  <a:lnTo>
                    <a:pt x="117" y="10330"/>
                  </a:lnTo>
                  <a:lnTo>
                    <a:pt x="122" y="10525"/>
                  </a:lnTo>
                  <a:lnTo>
                    <a:pt x="126" y="10720"/>
                  </a:lnTo>
                  <a:lnTo>
                    <a:pt x="131" y="10915"/>
                  </a:lnTo>
                  <a:lnTo>
                    <a:pt x="136" y="11110"/>
                  </a:lnTo>
                  <a:lnTo>
                    <a:pt x="142" y="11305"/>
                  </a:lnTo>
                  <a:lnTo>
                    <a:pt x="147" y="11500"/>
                  </a:lnTo>
                  <a:lnTo>
                    <a:pt x="152" y="11695"/>
                  </a:lnTo>
                  <a:lnTo>
                    <a:pt x="158" y="11889"/>
                  </a:lnTo>
                  <a:lnTo>
                    <a:pt x="164" y="12084"/>
                  </a:lnTo>
                  <a:lnTo>
                    <a:pt x="170" y="12279"/>
                  </a:lnTo>
                  <a:lnTo>
                    <a:pt x="176" y="12474"/>
                  </a:lnTo>
                  <a:lnTo>
                    <a:pt x="182" y="12669"/>
                  </a:lnTo>
                  <a:lnTo>
                    <a:pt x="188" y="12864"/>
                  </a:lnTo>
                  <a:lnTo>
                    <a:pt x="195" y="13059"/>
                  </a:lnTo>
                  <a:lnTo>
                    <a:pt x="201" y="13254"/>
                  </a:lnTo>
                  <a:lnTo>
                    <a:pt x="208" y="13449"/>
                  </a:lnTo>
                  <a:lnTo>
                    <a:pt x="215" y="13644"/>
                  </a:lnTo>
                  <a:lnTo>
                    <a:pt x="222" y="13839"/>
                  </a:lnTo>
                  <a:lnTo>
                    <a:pt x="229" y="14034"/>
                  </a:lnTo>
                  <a:lnTo>
                    <a:pt x="236" y="14228"/>
                  </a:lnTo>
                  <a:lnTo>
                    <a:pt x="243" y="14423"/>
                  </a:lnTo>
                  <a:lnTo>
                    <a:pt x="251" y="14618"/>
                  </a:lnTo>
                  <a:lnTo>
                    <a:pt x="258" y="14813"/>
                  </a:lnTo>
                  <a:lnTo>
                    <a:pt x="266" y="15008"/>
                  </a:lnTo>
                  <a:lnTo>
                    <a:pt x="274" y="15203"/>
                  </a:lnTo>
                  <a:lnTo>
                    <a:pt x="282" y="15398"/>
                  </a:lnTo>
                  <a:lnTo>
                    <a:pt x="290" y="15593"/>
                  </a:lnTo>
                  <a:lnTo>
                    <a:pt x="298" y="15788"/>
                  </a:lnTo>
                  <a:lnTo>
                    <a:pt x="306" y="15983"/>
                  </a:lnTo>
                  <a:lnTo>
                    <a:pt x="314" y="16178"/>
                  </a:lnTo>
                  <a:lnTo>
                    <a:pt x="323" y="16373"/>
                  </a:lnTo>
                  <a:lnTo>
                    <a:pt x="331" y="16567"/>
                  </a:lnTo>
                  <a:lnTo>
                    <a:pt x="340" y="16762"/>
                  </a:lnTo>
                  <a:lnTo>
                    <a:pt x="349" y="16957"/>
                  </a:lnTo>
                  <a:lnTo>
                    <a:pt x="357" y="17152"/>
                  </a:lnTo>
                  <a:lnTo>
                    <a:pt x="366" y="17347"/>
                  </a:lnTo>
                  <a:lnTo>
                    <a:pt x="375" y="17542"/>
                  </a:lnTo>
                  <a:lnTo>
                    <a:pt x="384" y="17737"/>
                  </a:lnTo>
                  <a:lnTo>
                    <a:pt x="393" y="17932"/>
                  </a:lnTo>
                  <a:lnTo>
                    <a:pt x="402" y="18127"/>
                  </a:lnTo>
                  <a:lnTo>
                    <a:pt x="411" y="18322"/>
                  </a:lnTo>
                  <a:lnTo>
                    <a:pt x="420" y="18517"/>
                  </a:lnTo>
                  <a:lnTo>
                    <a:pt x="429" y="18712"/>
                  </a:lnTo>
                  <a:lnTo>
                    <a:pt x="438" y="18906"/>
                  </a:lnTo>
                  <a:lnTo>
                    <a:pt x="448" y="19101"/>
                  </a:lnTo>
                  <a:lnTo>
                    <a:pt x="457" y="19296"/>
                  </a:lnTo>
                  <a:lnTo>
                    <a:pt x="466" y="19491"/>
                  </a:lnTo>
                  <a:lnTo>
                    <a:pt x="475" y="19686"/>
                  </a:lnTo>
                  <a:lnTo>
                    <a:pt x="484" y="19881"/>
                  </a:lnTo>
                  <a:lnTo>
                    <a:pt x="493" y="20076"/>
                  </a:lnTo>
                  <a:lnTo>
                    <a:pt x="502" y="20271"/>
                  </a:lnTo>
                  <a:lnTo>
                    <a:pt x="511" y="20466"/>
                  </a:lnTo>
                  <a:lnTo>
                    <a:pt x="520" y="20661"/>
                  </a:lnTo>
                  <a:lnTo>
                    <a:pt x="529" y="20856"/>
                  </a:lnTo>
                  <a:lnTo>
                    <a:pt x="538" y="21051"/>
                  </a:lnTo>
                  <a:lnTo>
                    <a:pt x="547" y="21245"/>
                  </a:lnTo>
                  <a:lnTo>
                    <a:pt x="555" y="21440"/>
                  </a:lnTo>
                  <a:lnTo>
                    <a:pt x="564" y="21635"/>
                  </a:lnTo>
                  <a:lnTo>
                    <a:pt x="572" y="21830"/>
                  </a:lnTo>
                  <a:lnTo>
                    <a:pt x="581" y="22025"/>
                  </a:lnTo>
                  <a:lnTo>
                    <a:pt x="589" y="22220"/>
                  </a:lnTo>
                  <a:lnTo>
                    <a:pt x="597" y="22415"/>
                  </a:lnTo>
                  <a:lnTo>
                    <a:pt x="605" y="22610"/>
                  </a:lnTo>
                  <a:lnTo>
                    <a:pt x="613" y="22805"/>
                  </a:lnTo>
                  <a:lnTo>
                    <a:pt x="620" y="23000"/>
                  </a:lnTo>
                  <a:lnTo>
                    <a:pt x="628" y="23195"/>
                  </a:lnTo>
                  <a:lnTo>
                    <a:pt x="635" y="23390"/>
                  </a:lnTo>
                  <a:lnTo>
                    <a:pt x="643" y="23585"/>
                  </a:lnTo>
                  <a:lnTo>
                    <a:pt x="650" y="23779"/>
                  </a:lnTo>
                  <a:lnTo>
                    <a:pt x="656" y="23974"/>
                  </a:lnTo>
                  <a:lnTo>
                    <a:pt x="663" y="24169"/>
                  </a:lnTo>
                  <a:lnTo>
                    <a:pt x="669" y="24364"/>
                  </a:lnTo>
                  <a:lnTo>
                    <a:pt x="676" y="24559"/>
                  </a:lnTo>
                  <a:lnTo>
                    <a:pt x="682" y="24754"/>
                  </a:lnTo>
                  <a:lnTo>
                    <a:pt x="687" y="24949"/>
                  </a:lnTo>
                  <a:lnTo>
                    <a:pt x="693" y="25144"/>
                  </a:lnTo>
                  <a:lnTo>
                    <a:pt x="698" y="25339"/>
                  </a:lnTo>
                  <a:lnTo>
                    <a:pt x="703" y="25534"/>
                  </a:lnTo>
                  <a:lnTo>
                    <a:pt x="708" y="25729"/>
                  </a:lnTo>
                  <a:lnTo>
                    <a:pt x="713" y="25924"/>
                  </a:lnTo>
                  <a:lnTo>
                    <a:pt x="717" y="26118"/>
                  </a:lnTo>
                  <a:lnTo>
                    <a:pt x="721" y="26313"/>
                  </a:lnTo>
                  <a:lnTo>
                    <a:pt x="725" y="26508"/>
                  </a:lnTo>
                  <a:lnTo>
                    <a:pt x="729" y="26703"/>
                  </a:lnTo>
                  <a:lnTo>
                    <a:pt x="732" y="26898"/>
                  </a:lnTo>
                  <a:lnTo>
                    <a:pt x="735" y="27093"/>
                  </a:lnTo>
                  <a:lnTo>
                    <a:pt x="738" y="27288"/>
                  </a:lnTo>
                  <a:lnTo>
                    <a:pt x="741" y="27483"/>
                  </a:lnTo>
                  <a:lnTo>
                    <a:pt x="743" y="27678"/>
                  </a:lnTo>
                  <a:lnTo>
                    <a:pt x="745" y="27873"/>
                  </a:lnTo>
                  <a:lnTo>
                    <a:pt x="747" y="28068"/>
                  </a:lnTo>
                  <a:lnTo>
                    <a:pt x="748" y="28263"/>
                  </a:lnTo>
                  <a:lnTo>
                    <a:pt x="750" y="28457"/>
                  </a:lnTo>
                  <a:lnTo>
                    <a:pt x="751" y="28652"/>
                  </a:lnTo>
                  <a:lnTo>
                    <a:pt x="751" y="28847"/>
                  </a:lnTo>
                  <a:lnTo>
                    <a:pt x="752" y="29042"/>
                  </a:lnTo>
                  <a:lnTo>
                    <a:pt x="752" y="29237"/>
                  </a:lnTo>
                  <a:lnTo>
                    <a:pt x="752" y="29432"/>
                  </a:lnTo>
                  <a:lnTo>
                    <a:pt x="752" y="29627"/>
                  </a:lnTo>
                  <a:lnTo>
                    <a:pt x="751" y="29822"/>
                  </a:lnTo>
                  <a:lnTo>
                    <a:pt x="751" y="30017"/>
                  </a:lnTo>
                  <a:lnTo>
                    <a:pt x="749" y="30212"/>
                  </a:lnTo>
                  <a:lnTo>
                    <a:pt x="748" y="30407"/>
                  </a:lnTo>
                  <a:lnTo>
                    <a:pt x="747" y="30602"/>
                  </a:lnTo>
                  <a:lnTo>
                    <a:pt x="745" y="30796"/>
                  </a:lnTo>
                  <a:lnTo>
                    <a:pt x="743" y="30991"/>
                  </a:lnTo>
                  <a:lnTo>
                    <a:pt x="741" y="31186"/>
                  </a:lnTo>
                  <a:lnTo>
                    <a:pt x="739" y="31381"/>
                  </a:lnTo>
                  <a:lnTo>
                    <a:pt x="736" y="31576"/>
                  </a:lnTo>
                  <a:lnTo>
                    <a:pt x="734" y="31771"/>
                  </a:lnTo>
                  <a:lnTo>
                    <a:pt x="731" y="31966"/>
                  </a:lnTo>
                  <a:lnTo>
                    <a:pt x="728" y="32161"/>
                  </a:lnTo>
                  <a:lnTo>
                    <a:pt x="725" y="32356"/>
                  </a:lnTo>
                  <a:lnTo>
                    <a:pt x="721" y="32551"/>
                  </a:lnTo>
                  <a:lnTo>
                    <a:pt x="718" y="32746"/>
                  </a:lnTo>
                  <a:lnTo>
                    <a:pt x="714" y="32941"/>
                  </a:lnTo>
                  <a:lnTo>
                    <a:pt x="711" y="33135"/>
                  </a:lnTo>
                  <a:lnTo>
                    <a:pt x="707" y="33330"/>
                  </a:lnTo>
                  <a:lnTo>
                    <a:pt x="703" y="33525"/>
                  </a:lnTo>
                  <a:lnTo>
                    <a:pt x="699" y="33720"/>
                  </a:lnTo>
                  <a:lnTo>
                    <a:pt x="695" y="33915"/>
                  </a:lnTo>
                  <a:lnTo>
                    <a:pt x="691" y="34110"/>
                  </a:lnTo>
                  <a:lnTo>
                    <a:pt x="686" y="34305"/>
                  </a:lnTo>
                  <a:lnTo>
                    <a:pt x="682" y="34500"/>
                  </a:lnTo>
                  <a:lnTo>
                    <a:pt x="678" y="34695"/>
                  </a:lnTo>
                  <a:lnTo>
                    <a:pt x="674" y="34890"/>
                  </a:lnTo>
                  <a:lnTo>
                    <a:pt x="669" y="35085"/>
                  </a:lnTo>
                  <a:lnTo>
                    <a:pt x="665" y="35280"/>
                  </a:lnTo>
                  <a:lnTo>
                    <a:pt x="661" y="35474"/>
                  </a:lnTo>
                  <a:lnTo>
                    <a:pt x="657" y="35669"/>
                  </a:lnTo>
                  <a:lnTo>
                    <a:pt x="652" y="35864"/>
                  </a:lnTo>
                  <a:lnTo>
                    <a:pt x="648" y="36059"/>
                  </a:lnTo>
                  <a:lnTo>
                    <a:pt x="644" y="36254"/>
                  </a:lnTo>
                  <a:lnTo>
                    <a:pt x="640" y="36449"/>
                  </a:lnTo>
                  <a:lnTo>
                    <a:pt x="636" y="36644"/>
                  </a:lnTo>
                  <a:lnTo>
                    <a:pt x="632" y="36839"/>
                  </a:lnTo>
                  <a:lnTo>
                    <a:pt x="628" y="37034"/>
                  </a:lnTo>
                  <a:lnTo>
                    <a:pt x="625" y="37229"/>
                  </a:lnTo>
                  <a:lnTo>
                    <a:pt x="621" y="37424"/>
                  </a:lnTo>
                  <a:lnTo>
                    <a:pt x="618" y="37619"/>
                  </a:lnTo>
                  <a:lnTo>
                    <a:pt x="615" y="37813"/>
                  </a:lnTo>
                  <a:lnTo>
                    <a:pt x="612" y="38008"/>
                  </a:lnTo>
                  <a:lnTo>
                    <a:pt x="609" y="38203"/>
                  </a:lnTo>
                  <a:lnTo>
                    <a:pt x="606" y="38398"/>
                  </a:lnTo>
                  <a:lnTo>
                    <a:pt x="603" y="38593"/>
                  </a:lnTo>
                  <a:lnTo>
                    <a:pt x="601" y="38788"/>
                  </a:lnTo>
                  <a:lnTo>
                    <a:pt x="599" y="38983"/>
                  </a:lnTo>
                  <a:lnTo>
                    <a:pt x="597" y="39178"/>
                  </a:lnTo>
                  <a:lnTo>
                    <a:pt x="595" y="39373"/>
                  </a:lnTo>
                  <a:lnTo>
                    <a:pt x="594" y="39568"/>
                  </a:lnTo>
                  <a:lnTo>
                    <a:pt x="593" y="39763"/>
                  </a:lnTo>
                  <a:lnTo>
                    <a:pt x="592" y="39958"/>
                  </a:lnTo>
                  <a:lnTo>
                    <a:pt x="591" y="40152"/>
                  </a:lnTo>
                  <a:lnTo>
                    <a:pt x="591" y="40347"/>
                  </a:lnTo>
                  <a:lnTo>
                    <a:pt x="591" y="40542"/>
                  </a:lnTo>
                  <a:lnTo>
                    <a:pt x="591" y="40737"/>
                  </a:lnTo>
                  <a:lnTo>
                    <a:pt x="591" y="40932"/>
                  </a:lnTo>
                  <a:lnTo>
                    <a:pt x="592" y="41127"/>
                  </a:lnTo>
                  <a:lnTo>
                    <a:pt x="593" y="41322"/>
                  </a:lnTo>
                  <a:lnTo>
                    <a:pt x="594" y="41517"/>
                  </a:lnTo>
                  <a:lnTo>
                    <a:pt x="596" y="41712"/>
                  </a:lnTo>
                  <a:lnTo>
                    <a:pt x="598" y="41907"/>
                  </a:lnTo>
                  <a:lnTo>
                    <a:pt x="600" y="42102"/>
                  </a:lnTo>
                  <a:lnTo>
                    <a:pt x="602" y="42297"/>
                  </a:lnTo>
                  <a:lnTo>
                    <a:pt x="605" y="42491"/>
                  </a:lnTo>
                  <a:lnTo>
                    <a:pt x="608" y="42686"/>
                  </a:lnTo>
                  <a:lnTo>
                    <a:pt x="612" y="42881"/>
                  </a:lnTo>
                  <a:lnTo>
                    <a:pt x="615" y="43076"/>
                  </a:lnTo>
                  <a:lnTo>
                    <a:pt x="620" y="43271"/>
                  </a:lnTo>
                  <a:lnTo>
                    <a:pt x="624" y="43466"/>
                  </a:lnTo>
                  <a:lnTo>
                    <a:pt x="629" y="43661"/>
                  </a:lnTo>
                  <a:lnTo>
                    <a:pt x="634" y="43856"/>
                  </a:lnTo>
                  <a:lnTo>
                    <a:pt x="639" y="44051"/>
                  </a:lnTo>
                  <a:lnTo>
                    <a:pt x="645" y="44246"/>
                  </a:lnTo>
                  <a:lnTo>
                    <a:pt x="651" y="44441"/>
                  </a:lnTo>
                  <a:lnTo>
                    <a:pt x="657" y="44636"/>
                  </a:lnTo>
                  <a:lnTo>
                    <a:pt x="664" y="44831"/>
                  </a:lnTo>
                  <a:lnTo>
                    <a:pt x="671" y="45025"/>
                  </a:lnTo>
                  <a:lnTo>
                    <a:pt x="678" y="45220"/>
                  </a:lnTo>
                  <a:lnTo>
                    <a:pt x="686" y="45415"/>
                  </a:lnTo>
                  <a:lnTo>
                    <a:pt x="694" y="45610"/>
                  </a:lnTo>
                  <a:lnTo>
                    <a:pt x="702" y="45805"/>
                  </a:lnTo>
                  <a:lnTo>
                    <a:pt x="711" y="46000"/>
                  </a:lnTo>
                  <a:lnTo>
                    <a:pt x="719" y="46195"/>
                  </a:lnTo>
                  <a:lnTo>
                    <a:pt x="728" y="46390"/>
                  </a:lnTo>
                  <a:lnTo>
                    <a:pt x="738" y="46585"/>
                  </a:lnTo>
                  <a:lnTo>
                    <a:pt x="747" y="46780"/>
                  </a:lnTo>
                  <a:lnTo>
                    <a:pt x="757" y="46975"/>
                  </a:lnTo>
                  <a:lnTo>
                    <a:pt x="768" y="47170"/>
                  </a:lnTo>
                  <a:lnTo>
                    <a:pt x="778" y="47364"/>
                  </a:lnTo>
                  <a:lnTo>
                    <a:pt x="789" y="47559"/>
                  </a:lnTo>
                  <a:lnTo>
                    <a:pt x="800" y="47754"/>
                  </a:lnTo>
                  <a:lnTo>
                    <a:pt x="811" y="47949"/>
                  </a:lnTo>
                  <a:lnTo>
                    <a:pt x="822" y="48144"/>
                  </a:lnTo>
                  <a:lnTo>
                    <a:pt x="834" y="48339"/>
                  </a:lnTo>
                  <a:lnTo>
                    <a:pt x="846" y="48534"/>
                  </a:lnTo>
                  <a:lnTo>
                    <a:pt x="858" y="48729"/>
                  </a:lnTo>
                  <a:lnTo>
                    <a:pt x="870" y="48924"/>
                  </a:lnTo>
                  <a:lnTo>
                    <a:pt x="883" y="49119"/>
                  </a:lnTo>
                  <a:lnTo>
                    <a:pt x="895" y="49314"/>
                  </a:lnTo>
                  <a:lnTo>
                    <a:pt x="908" y="49509"/>
                  </a:lnTo>
                  <a:lnTo>
                    <a:pt x="921" y="49703"/>
                  </a:lnTo>
                  <a:lnTo>
                    <a:pt x="935" y="49898"/>
                  </a:lnTo>
                  <a:lnTo>
                    <a:pt x="948" y="50093"/>
                  </a:lnTo>
                  <a:lnTo>
                    <a:pt x="961" y="50288"/>
                  </a:lnTo>
                  <a:lnTo>
                    <a:pt x="975" y="50483"/>
                  </a:lnTo>
                  <a:lnTo>
                    <a:pt x="989" y="50678"/>
                  </a:lnTo>
                  <a:lnTo>
                    <a:pt x="1003" y="50873"/>
                  </a:lnTo>
                  <a:lnTo>
                    <a:pt x="1017" y="51068"/>
                  </a:lnTo>
                  <a:lnTo>
                    <a:pt x="1031" y="51263"/>
                  </a:lnTo>
                  <a:lnTo>
                    <a:pt x="1045" y="51458"/>
                  </a:lnTo>
                  <a:lnTo>
                    <a:pt x="1060" y="51653"/>
                  </a:lnTo>
                  <a:lnTo>
                    <a:pt x="1074" y="51848"/>
                  </a:lnTo>
                  <a:lnTo>
                    <a:pt x="1088" y="52042"/>
                  </a:lnTo>
                  <a:lnTo>
                    <a:pt x="1103" y="52237"/>
                  </a:lnTo>
                  <a:lnTo>
                    <a:pt x="1118" y="52432"/>
                  </a:lnTo>
                  <a:lnTo>
                    <a:pt x="1132" y="52627"/>
                  </a:lnTo>
                  <a:lnTo>
                    <a:pt x="1147" y="52822"/>
                  </a:lnTo>
                  <a:lnTo>
                    <a:pt x="1161" y="53017"/>
                  </a:lnTo>
                  <a:lnTo>
                    <a:pt x="1176" y="53212"/>
                  </a:lnTo>
                  <a:lnTo>
                    <a:pt x="1191" y="53407"/>
                  </a:lnTo>
                  <a:lnTo>
                    <a:pt x="1206" y="53602"/>
                  </a:lnTo>
                  <a:lnTo>
                    <a:pt x="1220" y="53797"/>
                  </a:lnTo>
                  <a:lnTo>
                    <a:pt x="1235" y="53992"/>
                  </a:lnTo>
                  <a:lnTo>
                    <a:pt x="1250" y="54187"/>
                  </a:lnTo>
                  <a:lnTo>
                    <a:pt x="1264" y="54381"/>
                  </a:lnTo>
                  <a:lnTo>
                    <a:pt x="1279" y="54576"/>
                  </a:lnTo>
                  <a:lnTo>
                    <a:pt x="1293" y="54771"/>
                  </a:lnTo>
                  <a:lnTo>
                    <a:pt x="1308" y="54966"/>
                  </a:lnTo>
                  <a:lnTo>
                    <a:pt x="1322" y="55161"/>
                  </a:lnTo>
                  <a:lnTo>
                    <a:pt x="1336" y="55356"/>
                  </a:lnTo>
                  <a:lnTo>
                    <a:pt x="1351" y="55551"/>
                  </a:lnTo>
                  <a:lnTo>
                    <a:pt x="1365" y="55746"/>
                  </a:lnTo>
                  <a:lnTo>
                    <a:pt x="1379" y="55941"/>
                  </a:lnTo>
                  <a:lnTo>
                    <a:pt x="1393" y="56136"/>
                  </a:lnTo>
                  <a:lnTo>
                    <a:pt x="1406" y="56331"/>
                  </a:lnTo>
                  <a:lnTo>
                    <a:pt x="1420" y="56526"/>
                  </a:lnTo>
                  <a:lnTo>
                    <a:pt x="1433" y="56720"/>
                  </a:lnTo>
                  <a:lnTo>
                    <a:pt x="1447" y="56915"/>
                  </a:lnTo>
                  <a:lnTo>
                    <a:pt x="1460" y="57110"/>
                  </a:lnTo>
                  <a:lnTo>
                    <a:pt x="1473" y="57305"/>
                  </a:lnTo>
                  <a:lnTo>
                    <a:pt x="1486" y="57500"/>
                  </a:lnTo>
                  <a:lnTo>
                    <a:pt x="1498" y="57695"/>
                  </a:lnTo>
                  <a:lnTo>
                    <a:pt x="1511" y="57890"/>
                  </a:lnTo>
                  <a:lnTo>
                    <a:pt x="1523" y="58085"/>
                  </a:lnTo>
                  <a:lnTo>
                    <a:pt x="1535" y="58280"/>
                  </a:lnTo>
                  <a:lnTo>
                    <a:pt x="1547" y="58475"/>
                  </a:lnTo>
                  <a:lnTo>
                    <a:pt x="1559" y="58670"/>
                  </a:lnTo>
                  <a:lnTo>
                    <a:pt x="1570" y="58865"/>
                  </a:lnTo>
                  <a:lnTo>
                    <a:pt x="1581" y="59059"/>
                  </a:lnTo>
                  <a:lnTo>
                    <a:pt x="1592" y="59254"/>
                  </a:lnTo>
                  <a:lnTo>
                    <a:pt x="1603" y="59449"/>
                  </a:lnTo>
                  <a:lnTo>
                    <a:pt x="1613" y="59644"/>
                  </a:lnTo>
                  <a:lnTo>
                    <a:pt x="1623" y="59839"/>
                  </a:lnTo>
                  <a:lnTo>
                    <a:pt x="1633" y="60034"/>
                  </a:lnTo>
                  <a:lnTo>
                    <a:pt x="1642" y="60229"/>
                  </a:lnTo>
                  <a:lnTo>
                    <a:pt x="1652" y="60424"/>
                  </a:lnTo>
                  <a:lnTo>
                    <a:pt x="1661" y="60619"/>
                  </a:lnTo>
                  <a:lnTo>
                    <a:pt x="1669" y="60814"/>
                  </a:lnTo>
                  <a:lnTo>
                    <a:pt x="1677" y="61009"/>
                  </a:lnTo>
                  <a:lnTo>
                    <a:pt x="1685" y="61204"/>
                  </a:lnTo>
                  <a:lnTo>
                    <a:pt x="1693" y="61398"/>
                  </a:lnTo>
                  <a:lnTo>
                    <a:pt x="1700" y="61593"/>
                  </a:lnTo>
                  <a:lnTo>
                    <a:pt x="1707" y="61788"/>
                  </a:lnTo>
                  <a:lnTo>
                    <a:pt x="1714" y="61983"/>
                  </a:lnTo>
                  <a:lnTo>
                    <a:pt x="1720" y="62178"/>
                  </a:lnTo>
                  <a:lnTo>
                    <a:pt x="1726" y="62373"/>
                  </a:lnTo>
                  <a:lnTo>
                    <a:pt x="1731" y="62568"/>
                  </a:lnTo>
                  <a:lnTo>
                    <a:pt x="1737" y="62763"/>
                  </a:lnTo>
                  <a:lnTo>
                    <a:pt x="1741" y="62958"/>
                  </a:lnTo>
                  <a:lnTo>
                    <a:pt x="1746" y="63153"/>
                  </a:lnTo>
                  <a:lnTo>
                    <a:pt x="1750" y="63348"/>
                  </a:lnTo>
                  <a:lnTo>
                    <a:pt x="1753" y="63543"/>
                  </a:lnTo>
                  <a:lnTo>
                    <a:pt x="1756" y="63737"/>
                  </a:lnTo>
                  <a:lnTo>
                    <a:pt x="1759" y="63932"/>
                  </a:lnTo>
                  <a:lnTo>
                    <a:pt x="1761" y="64127"/>
                  </a:lnTo>
                  <a:lnTo>
                    <a:pt x="1763" y="64322"/>
                  </a:lnTo>
                  <a:lnTo>
                    <a:pt x="1765" y="64517"/>
                  </a:lnTo>
                  <a:lnTo>
                    <a:pt x="1766" y="64712"/>
                  </a:lnTo>
                  <a:lnTo>
                    <a:pt x="1766" y="64907"/>
                  </a:lnTo>
                  <a:lnTo>
                    <a:pt x="1766" y="65102"/>
                  </a:lnTo>
                  <a:lnTo>
                    <a:pt x="1766" y="65297"/>
                  </a:lnTo>
                  <a:lnTo>
                    <a:pt x="1765" y="65492"/>
                  </a:lnTo>
                  <a:lnTo>
                    <a:pt x="1764" y="65687"/>
                  </a:lnTo>
                  <a:lnTo>
                    <a:pt x="1763" y="65882"/>
                  </a:lnTo>
                  <a:lnTo>
                    <a:pt x="1760" y="66077"/>
                  </a:lnTo>
                  <a:lnTo>
                    <a:pt x="1758" y="66271"/>
                  </a:lnTo>
                  <a:lnTo>
                    <a:pt x="1755" y="66466"/>
                  </a:lnTo>
                  <a:lnTo>
                    <a:pt x="1751" y="66661"/>
                  </a:lnTo>
                  <a:lnTo>
                    <a:pt x="1748" y="66856"/>
                  </a:lnTo>
                  <a:lnTo>
                    <a:pt x="1743" y="67051"/>
                  </a:lnTo>
                  <a:lnTo>
                    <a:pt x="1738" y="67246"/>
                  </a:lnTo>
                  <a:lnTo>
                    <a:pt x="1733" y="67441"/>
                  </a:lnTo>
                  <a:lnTo>
                    <a:pt x="1727" y="67636"/>
                  </a:lnTo>
                  <a:lnTo>
                    <a:pt x="1721" y="67831"/>
                  </a:lnTo>
                  <a:lnTo>
                    <a:pt x="1715" y="68026"/>
                  </a:lnTo>
                  <a:lnTo>
                    <a:pt x="1708" y="68221"/>
                  </a:lnTo>
                  <a:lnTo>
                    <a:pt x="1700" y="68416"/>
                  </a:lnTo>
                  <a:lnTo>
                    <a:pt x="1692" y="68610"/>
                  </a:lnTo>
                  <a:lnTo>
                    <a:pt x="1684" y="68805"/>
                  </a:lnTo>
                  <a:lnTo>
                    <a:pt x="1675" y="69000"/>
                  </a:lnTo>
                  <a:lnTo>
                    <a:pt x="1666" y="69195"/>
                  </a:lnTo>
                  <a:lnTo>
                    <a:pt x="1656" y="69390"/>
                  </a:lnTo>
                  <a:lnTo>
                    <a:pt x="1646" y="69585"/>
                  </a:lnTo>
                  <a:lnTo>
                    <a:pt x="1635" y="69780"/>
                  </a:lnTo>
                  <a:lnTo>
                    <a:pt x="1625" y="69975"/>
                  </a:lnTo>
                  <a:lnTo>
                    <a:pt x="1613" y="70170"/>
                  </a:lnTo>
                  <a:lnTo>
                    <a:pt x="1602" y="70365"/>
                  </a:lnTo>
                  <a:lnTo>
                    <a:pt x="1589" y="70560"/>
                  </a:lnTo>
                  <a:lnTo>
                    <a:pt x="1577" y="70755"/>
                  </a:lnTo>
                  <a:lnTo>
                    <a:pt x="1564" y="70949"/>
                  </a:lnTo>
                  <a:lnTo>
                    <a:pt x="1551" y="71144"/>
                  </a:lnTo>
                  <a:lnTo>
                    <a:pt x="1537" y="71339"/>
                  </a:lnTo>
                  <a:lnTo>
                    <a:pt x="1523" y="71534"/>
                  </a:lnTo>
                  <a:lnTo>
                    <a:pt x="1509" y="71729"/>
                  </a:lnTo>
                  <a:lnTo>
                    <a:pt x="1494" y="71924"/>
                  </a:lnTo>
                  <a:lnTo>
                    <a:pt x="1480" y="72119"/>
                  </a:lnTo>
                  <a:lnTo>
                    <a:pt x="1464" y="72314"/>
                  </a:lnTo>
                  <a:lnTo>
                    <a:pt x="1449" y="72509"/>
                  </a:lnTo>
                  <a:lnTo>
                    <a:pt x="1433" y="72704"/>
                  </a:lnTo>
                  <a:lnTo>
                    <a:pt x="1417" y="72899"/>
                  </a:lnTo>
                  <a:lnTo>
                    <a:pt x="1400" y="73094"/>
                  </a:lnTo>
                  <a:lnTo>
                    <a:pt x="1384" y="73288"/>
                  </a:lnTo>
                  <a:lnTo>
                    <a:pt x="1367" y="73483"/>
                  </a:lnTo>
                  <a:lnTo>
                    <a:pt x="1350" y="73678"/>
                  </a:lnTo>
                  <a:lnTo>
                    <a:pt x="1332" y="73873"/>
                  </a:lnTo>
                  <a:lnTo>
                    <a:pt x="1315" y="74068"/>
                  </a:lnTo>
                  <a:lnTo>
                    <a:pt x="1297" y="74263"/>
                  </a:lnTo>
                  <a:lnTo>
                    <a:pt x="1279" y="74458"/>
                  </a:lnTo>
                  <a:lnTo>
                    <a:pt x="1261" y="74653"/>
                  </a:lnTo>
                  <a:lnTo>
                    <a:pt x="1243" y="74848"/>
                  </a:lnTo>
                  <a:lnTo>
                    <a:pt x="1225" y="75043"/>
                  </a:lnTo>
                  <a:lnTo>
                    <a:pt x="1206" y="75238"/>
                  </a:lnTo>
                  <a:lnTo>
                    <a:pt x="1187" y="75433"/>
                  </a:lnTo>
                  <a:lnTo>
                    <a:pt x="1169" y="75627"/>
                  </a:lnTo>
                  <a:lnTo>
                    <a:pt x="1150" y="75822"/>
                  </a:lnTo>
                  <a:lnTo>
                    <a:pt x="1131" y="76017"/>
                  </a:lnTo>
                  <a:lnTo>
                    <a:pt x="1112" y="76212"/>
                  </a:lnTo>
                  <a:lnTo>
                    <a:pt x="1093" y="76407"/>
                  </a:lnTo>
                  <a:lnTo>
                    <a:pt x="1074" y="76602"/>
                  </a:lnTo>
                  <a:lnTo>
                    <a:pt x="1055" y="76797"/>
                  </a:lnTo>
                  <a:lnTo>
                    <a:pt x="1035" y="76992"/>
                  </a:lnTo>
                  <a:lnTo>
                    <a:pt x="1016" y="77187"/>
                  </a:lnTo>
                  <a:lnTo>
                    <a:pt x="997" y="77382"/>
                  </a:lnTo>
                  <a:lnTo>
                    <a:pt x="978" y="77577"/>
                  </a:lnTo>
                  <a:lnTo>
                    <a:pt x="959" y="77772"/>
                  </a:lnTo>
                  <a:lnTo>
                    <a:pt x="940" y="77966"/>
                  </a:lnTo>
                  <a:lnTo>
                    <a:pt x="921" y="78161"/>
                  </a:lnTo>
                  <a:lnTo>
                    <a:pt x="902" y="78356"/>
                  </a:lnTo>
                  <a:lnTo>
                    <a:pt x="883" y="78551"/>
                  </a:lnTo>
                  <a:lnTo>
                    <a:pt x="864" y="78746"/>
                  </a:lnTo>
                  <a:lnTo>
                    <a:pt x="846" y="78941"/>
                  </a:lnTo>
                  <a:lnTo>
                    <a:pt x="827" y="79136"/>
                  </a:lnTo>
                  <a:lnTo>
                    <a:pt x="809" y="79331"/>
                  </a:lnTo>
                  <a:lnTo>
                    <a:pt x="790" y="79526"/>
                  </a:lnTo>
                  <a:lnTo>
                    <a:pt x="772" y="79721"/>
                  </a:lnTo>
                  <a:lnTo>
                    <a:pt x="754" y="79916"/>
                  </a:lnTo>
                  <a:lnTo>
                    <a:pt x="736" y="80111"/>
                  </a:lnTo>
                  <a:lnTo>
                    <a:pt x="718" y="80305"/>
                  </a:lnTo>
                  <a:lnTo>
                    <a:pt x="701" y="80500"/>
                  </a:lnTo>
                  <a:lnTo>
                    <a:pt x="683" y="80695"/>
                  </a:lnTo>
                  <a:lnTo>
                    <a:pt x="666" y="80890"/>
                  </a:lnTo>
                  <a:lnTo>
                    <a:pt x="649" y="81085"/>
                  </a:lnTo>
                  <a:lnTo>
                    <a:pt x="632" y="81280"/>
                  </a:lnTo>
                  <a:lnTo>
                    <a:pt x="616" y="81475"/>
                  </a:lnTo>
                  <a:lnTo>
                    <a:pt x="600" y="81670"/>
                  </a:lnTo>
                  <a:lnTo>
                    <a:pt x="583" y="81865"/>
                  </a:lnTo>
                  <a:lnTo>
                    <a:pt x="567" y="82060"/>
                  </a:lnTo>
                  <a:lnTo>
                    <a:pt x="552" y="82255"/>
                  </a:lnTo>
                  <a:lnTo>
                    <a:pt x="536" y="82450"/>
                  </a:lnTo>
                  <a:lnTo>
                    <a:pt x="521" y="82644"/>
                  </a:lnTo>
                  <a:lnTo>
                    <a:pt x="506" y="82839"/>
                  </a:lnTo>
                  <a:lnTo>
                    <a:pt x="491" y="83034"/>
                  </a:lnTo>
                  <a:lnTo>
                    <a:pt x="477" y="83229"/>
                  </a:lnTo>
                  <a:lnTo>
                    <a:pt x="463" y="83424"/>
                  </a:lnTo>
                  <a:lnTo>
                    <a:pt x="449" y="83619"/>
                  </a:lnTo>
                  <a:lnTo>
                    <a:pt x="435" y="83814"/>
                  </a:lnTo>
                  <a:lnTo>
                    <a:pt x="421" y="84009"/>
                  </a:lnTo>
                  <a:lnTo>
                    <a:pt x="408" y="84204"/>
                  </a:lnTo>
                  <a:lnTo>
                    <a:pt x="395" y="84399"/>
                  </a:lnTo>
                  <a:lnTo>
                    <a:pt x="383" y="84594"/>
                  </a:lnTo>
                  <a:lnTo>
                    <a:pt x="370" y="84789"/>
                  </a:lnTo>
                  <a:lnTo>
                    <a:pt x="358" y="84983"/>
                  </a:lnTo>
                  <a:lnTo>
                    <a:pt x="346" y="85178"/>
                  </a:lnTo>
                  <a:lnTo>
                    <a:pt x="335" y="85373"/>
                  </a:lnTo>
                  <a:lnTo>
                    <a:pt x="323" y="85568"/>
                  </a:lnTo>
                  <a:lnTo>
                    <a:pt x="312" y="85763"/>
                  </a:lnTo>
                  <a:lnTo>
                    <a:pt x="301" y="85958"/>
                  </a:lnTo>
                  <a:lnTo>
                    <a:pt x="291" y="86153"/>
                  </a:lnTo>
                  <a:lnTo>
                    <a:pt x="281" y="86348"/>
                  </a:lnTo>
                  <a:lnTo>
                    <a:pt x="271" y="86543"/>
                  </a:lnTo>
                  <a:lnTo>
                    <a:pt x="261" y="86738"/>
                  </a:lnTo>
                  <a:lnTo>
                    <a:pt x="251" y="86933"/>
                  </a:lnTo>
                  <a:lnTo>
                    <a:pt x="242" y="87128"/>
                  </a:lnTo>
                  <a:lnTo>
                    <a:pt x="233" y="87323"/>
                  </a:lnTo>
                  <a:lnTo>
                    <a:pt x="224" y="87517"/>
                  </a:lnTo>
                  <a:lnTo>
                    <a:pt x="216" y="87712"/>
                  </a:lnTo>
                  <a:lnTo>
                    <a:pt x="207" y="87907"/>
                  </a:lnTo>
                  <a:lnTo>
                    <a:pt x="199" y="88102"/>
                  </a:lnTo>
                  <a:lnTo>
                    <a:pt x="192" y="88297"/>
                  </a:lnTo>
                  <a:lnTo>
                    <a:pt x="184" y="88492"/>
                  </a:lnTo>
                  <a:lnTo>
                    <a:pt x="177" y="88687"/>
                  </a:lnTo>
                  <a:lnTo>
                    <a:pt x="170" y="88882"/>
                  </a:lnTo>
                  <a:lnTo>
                    <a:pt x="163" y="89077"/>
                  </a:lnTo>
                  <a:lnTo>
                    <a:pt x="156" y="89272"/>
                  </a:lnTo>
                  <a:lnTo>
                    <a:pt x="150" y="89467"/>
                  </a:lnTo>
                  <a:lnTo>
                    <a:pt x="143" y="89662"/>
                  </a:lnTo>
                  <a:lnTo>
                    <a:pt x="137" y="89856"/>
                  </a:lnTo>
                  <a:lnTo>
                    <a:pt x="131" y="90051"/>
                  </a:lnTo>
                  <a:lnTo>
                    <a:pt x="126" y="90246"/>
                  </a:lnTo>
                  <a:lnTo>
                    <a:pt x="120" y="90441"/>
                  </a:lnTo>
                  <a:lnTo>
                    <a:pt x="115" y="90636"/>
                  </a:lnTo>
                  <a:lnTo>
                    <a:pt x="110" y="90831"/>
                  </a:lnTo>
                  <a:lnTo>
                    <a:pt x="105" y="91026"/>
                  </a:lnTo>
                  <a:lnTo>
                    <a:pt x="100" y="91221"/>
                  </a:lnTo>
                  <a:lnTo>
                    <a:pt x="96" y="91416"/>
                  </a:lnTo>
                  <a:lnTo>
                    <a:pt x="92" y="91611"/>
                  </a:lnTo>
                  <a:lnTo>
                    <a:pt x="87" y="91806"/>
                  </a:lnTo>
                  <a:lnTo>
                    <a:pt x="83" y="92001"/>
                  </a:lnTo>
                  <a:lnTo>
                    <a:pt x="79" y="92195"/>
                  </a:lnTo>
                  <a:lnTo>
                    <a:pt x="76" y="92390"/>
                  </a:lnTo>
                  <a:lnTo>
                    <a:pt x="72" y="92585"/>
                  </a:lnTo>
                  <a:lnTo>
                    <a:pt x="69" y="92780"/>
                  </a:lnTo>
                  <a:lnTo>
                    <a:pt x="65" y="92975"/>
                  </a:lnTo>
                  <a:lnTo>
                    <a:pt x="62" y="93170"/>
                  </a:lnTo>
                  <a:lnTo>
                    <a:pt x="59" y="93365"/>
                  </a:lnTo>
                  <a:lnTo>
                    <a:pt x="56" y="93560"/>
                  </a:lnTo>
                  <a:lnTo>
                    <a:pt x="53" y="93755"/>
                  </a:lnTo>
                  <a:lnTo>
                    <a:pt x="51" y="93950"/>
                  </a:lnTo>
                  <a:lnTo>
                    <a:pt x="48" y="94145"/>
                  </a:lnTo>
                  <a:lnTo>
                    <a:pt x="46" y="94340"/>
                  </a:lnTo>
                  <a:lnTo>
                    <a:pt x="43" y="94534"/>
                  </a:lnTo>
                  <a:lnTo>
                    <a:pt x="41" y="94729"/>
                  </a:lnTo>
                  <a:lnTo>
                    <a:pt x="39" y="94924"/>
                  </a:lnTo>
                  <a:lnTo>
                    <a:pt x="37" y="95119"/>
                  </a:lnTo>
                  <a:lnTo>
                    <a:pt x="35" y="95314"/>
                  </a:lnTo>
                  <a:lnTo>
                    <a:pt x="33" y="95509"/>
                  </a:lnTo>
                  <a:lnTo>
                    <a:pt x="31" y="95704"/>
                  </a:lnTo>
                  <a:lnTo>
                    <a:pt x="30" y="95899"/>
                  </a:lnTo>
                  <a:lnTo>
                    <a:pt x="28" y="96094"/>
                  </a:lnTo>
                  <a:lnTo>
                    <a:pt x="26" y="96289"/>
                  </a:lnTo>
                  <a:lnTo>
                    <a:pt x="25" y="96484"/>
                  </a:lnTo>
                  <a:lnTo>
                    <a:pt x="23" y="96679"/>
                  </a:lnTo>
                  <a:lnTo>
                    <a:pt x="22" y="96873"/>
                  </a:lnTo>
                  <a:lnTo>
                    <a:pt x="21" y="97068"/>
                  </a:lnTo>
                  <a:lnTo>
                    <a:pt x="20" y="97263"/>
                  </a:lnTo>
                  <a:lnTo>
                    <a:pt x="19" y="97458"/>
                  </a:lnTo>
                  <a:lnTo>
                    <a:pt x="17" y="97653"/>
                  </a:lnTo>
                  <a:lnTo>
                    <a:pt x="16" y="97848"/>
                  </a:lnTo>
                  <a:lnTo>
                    <a:pt x="15" y="98043"/>
                  </a:lnTo>
                  <a:lnTo>
                    <a:pt x="15" y="98238"/>
                  </a:lnTo>
                  <a:lnTo>
                    <a:pt x="14" y="98433"/>
                  </a:lnTo>
                  <a:lnTo>
                    <a:pt x="13" y="98628"/>
                  </a:lnTo>
                  <a:lnTo>
                    <a:pt x="12" y="98823"/>
                  </a:lnTo>
                  <a:lnTo>
                    <a:pt x="11" y="99018"/>
                  </a:lnTo>
                  <a:lnTo>
                    <a:pt x="11" y="99212"/>
                  </a:lnTo>
                  <a:lnTo>
                    <a:pt x="10" y="99407"/>
                  </a:lnTo>
                  <a:lnTo>
                    <a:pt x="9" y="99602"/>
                  </a:lnTo>
                  <a:lnTo>
                    <a:pt x="0" y="99602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48" name="pl30"/>
            <p:cNvSpPr/>
            <p:nvPr/>
          </p:nvSpPr>
          <p:spPr>
            <a:xfrm>
              <a:off x="4168469" y="3438239"/>
              <a:ext cx="1458" cy="386495"/>
            </a:xfrm>
            <a:custGeom>
              <a:avLst/>
              <a:gdLst/>
              <a:ahLst/>
              <a:cxnLst/>
              <a:rect l="0" t="0" r="0" b="0"/>
              <a:pathLst>
                <a:path w="1458" h="386495">
                  <a:moveTo>
                    <a:pt x="1458" y="386495"/>
                  </a:moveTo>
                  <a:lnTo>
                    <a:pt x="1450" y="386495"/>
                  </a:lnTo>
                  <a:lnTo>
                    <a:pt x="1447" y="385739"/>
                  </a:lnTo>
                  <a:lnTo>
                    <a:pt x="1445" y="384982"/>
                  </a:lnTo>
                  <a:lnTo>
                    <a:pt x="1441" y="384226"/>
                  </a:lnTo>
                  <a:lnTo>
                    <a:pt x="1436" y="383470"/>
                  </a:lnTo>
                  <a:lnTo>
                    <a:pt x="1431" y="382713"/>
                  </a:lnTo>
                  <a:lnTo>
                    <a:pt x="1424" y="381957"/>
                  </a:lnTo>
                  <a:lnTo>
                    <a:pt x="1416" y="381201"/>
                  </a:lnTo>
                  <a:lnTo>
                    <a:pt x="1406" y="380444"/>
                  </a:lnTo>
                  <a:lnTo>
                    <a:pt x="1394" y="379688"/>
                  </a:lnTo>
                  <a:lnTo>
                    <a:pt x="1381" y="378931"/>
                  </a:lnTo>
                  <a:lnTo>
                    <a:pt x="1366" y="378175"/>
                  </a:lnTo>
                  <a:lnTo>
                    <a:pt x="1348" y="377419"/>
                  </a:lnTo>
                  <a:lnTo>
                    <a:pt x="1327" y="376662"/>
                  </a:lnTo>
                  <a:lnTo>
                    <a:pt x="1305" y="375906"/>
                  </a:lnTo>
                  <a:lnTo>
                    <a:pt x="1280" y="375150"/>
                  </a:lnTo>
                  <a:lnTo>
                    <a:pt x="1253" y="374393"/>
                  </a:lnTo>
                  <a:lnTo>
                    <a:pt x="1223" y="373637"/>
                  </a:lnTo>
                  <a:lnTo>
                    <a:pt x="1191" y="372881"/>
                  </a:lnTo>
                  <a:lnTo>
                    <a:pt x="1157" y="372124"/>
                  </a:lnTo>
                  <a:lnTo>
                    <a:pt x="1122" y="371368"/>
                  </a:lnTo>
                  <a:lnTo>
                    <a:pt x="1086" y="370612"/>
                  </a:lnTo>
                  <a:lnTo>
                    <a:pt x="1049" y="369855"/>
                  </a:lnTo>
                  <a:lnTo>
                    <a:pt x="1012" y="369099"/>
                  </a:lnTo>
                  <a:lnTo>
                    <a:pt x="976" y="368343"/>
                  </a:lnTo>
                  <a:lnTo>
                    <a:pt x="941" y="367586"/>
                  </a:lnTo>
                  <a:lnTo>
                    <a:pt x="908" y="366830"/>
                  </a:lnTo>
                  <a:lnTo>
                    <a:pt x="878" y="366074"/>
                  </a:lnTo>
                  <a:lnTo>
                    <a:pt x="851" y="365317"/>
                  </a:lnTo>
                  <a:lnTo>
                    <a:pt x="828" y="364561"/>
                  </a:lnTo>
                  <a:lnTo>
                    <a:pt x="810" y="363804"/>
                  </a:lnTo>
                  <a:lnTo>
                    <a:pt x="796" y="363048"/>
                  </a:lnTo>
                  <a:lnTo>
                    <a:pt x="788" y="362292"/>
                  </a:lnTo>
                  <a:lnTo>
                    <a:pt x="785" y="361535"/>
                  </a:lnTo>
                  <a:lnTo>
                    <a:pt x="788" y="360779"/>
                  </a:lnTo>
                  <a:lnTo>
                    <a:pt x="796" y="360023"/>
                  </a:lnTo>
                  <a:lnTo>
                    <a:pt x="809" y="359266"/>
                  </a:lnTo>
                  <a:lnTo>
                    <a:pt x="827" y="358510"/>
                  </a:lnTo>
                  <a:lnTo>
                    <a:pt x="850" y="357754"/>
                  </a:lnTo>
                  <a:lnTo>
                    <a:pt x="877" y="356997"/>
                  </a:lnTo>
                  <a:lnTo>
                    <a:pt x="907" y="356241"/>
                  </a:lnTo>
                  <a:lnTo>
                    <a:pt x="940" y="355485"/>
                  </a:lnTo>
                  <a:lnTo>
                    <a:pt x="975" y="354728"/>
                  </a:lnTo>
                  <a:lnTo>
                    <a:pt x="1011" y="353972"/>
                  </a:lnTo>
                  <a:lnTo>
                    <a:pt x="1047" y="353216"/>
                  </a:lnTo>
                  <a:lnTo>
                    <a:pt x="1084" y="352459"/>
                  </a:lnTo>
                  <a:lnTo>
                    <a:pt x="1121" y="351703"/>
                  </a:lnTo>
                  <a:lnTo>
                    <a:pt x="1156" y="350946"/>
                  </a:lnTo>
                  <a:lnTo>
                    <a:pt x="1190" y="350190"/>
                  </a:lnTo>
                  <a:lnTo>
                    <a:pt x="1222" y="349434"/>
                  </a:lnTo>
                  <a:lnTo>
                    <a:pt x="1251" y="348677"/>
                  </a:lnTo>
                  <a:lnTo>
                    <a:pt x="1279" y="347921"/>
                  </a:lnTo>
                  <a:lnTo>
                    <a:pt x="1304" y="347165"/>
                  </a:lnTo>
                  <a:lnTo>
                    <a:pt x="1327" y="346408"/>
                  </a:lnTo>
                  <a:lnTo>
                    <a:pt x="1347" y="345652"/>
                  </a:lnTo>
                  <a:lnTo>
                    <a:pt x="1365" y="344896"/>
                  </a:lnTo>
                  <a:lnTo>
                    <a:pt x="1380" y="344139"/>
                  </a:lnTo>
                  <a:lnTo>
                    <a:pt x="1394" y="343383"/>
                  </a:lnTo>
                  <a:lnTo>
                    <a:pt x="1406" y="342627"/>
                  </a:lnTo>
                  <a:lnTo>
                    <a:pt x="1415" y="341870"/>
                  </a:lnTo>
                  <a:lnTo>
                    <a:pt x="1424" y="341114"/>
                  </a:lnTo>
                  <a:lnTo>
                    <a:pt x="1430" y="340358"/>
                  </a:lnTo>
                  <a:lnTo>
                    <a:pt x="1436" y="339601"/>
                  </a:lnTo>
                  <a:lnTo>
                    <a:pt x="1441" y="338845"/>
                  </a:lnTo>
                  <a:lnTo>
                    <a:pt x="1444" y="338089"/>
                  </a:lnTo>
                  <a:lnTo>
                    <a:pt x="1447" y="337332"/>
                  </a:lnTo>
                  <a:lnTo>
                    <a:pt x="1450" y="336576"/>
                  </a:lnTo>
                  <a:lnTo>
                    <a:pt x="1452" y="335819"/>
                  </a:lnTo>
                  <a:lnTo>
                    <a:pt x="1453" y="335063"/>
                  </a:lnTo>
                  <a:lnTo>
                    <a:pt x="1454" y="334307"/>
                  </a:lnTo>
                  <a:lnTo>
                    <a:pt x="1455" y="333550"/>
                  </a:lnTo>
                  <a:lnTo>
                    <a:pt x="1456" y="332794"/>
                  </a:lnTo>
                  <a:lnTo>
                    <a:pt x="1456" y="332038"/>
                  </a:lnTo>
                  <a:lnTo>
                    <a:pt x="1457" y="331281"/>
                  </a:lnTo>
                  <a:lnTo>
                    <a:pt x="1457" y="330525"/>
                  </a:lnTo>
                  <a:lnTo>
                    <a:pt x="1457" y="329769"/>
                  </a:lnTo>
                  <a:lnTo>
                    <a:pt x="1457" y="329012"/>
                  </a:lnTo>
                  <a:lnTo>
                    <a:pt x="1457" y="328256"/>
                  </a:lnTo>
                  <a:lnTo>
                    <a:pt x="1457" y="327500"/>
                  </a:lnTo>
                  <a:lnTo>
                    <a:pt x="1457" y="326743"/>
                  </a:lnTo>
                  <a:lnTo>
                    <a:pt x="1457" y="325987"/>
                  </a:lnTo>
                  <a:lnTo>
                    <a:pt x="1457" y="325231"/>
                  </a:lnTo>
                  <a:lnTo>
                    <a:pt x="1458" y="324474"/>
                  </a:lnTo>
                  <a:lnTo>
                    <a:pt x="1458" y="323718"/>
                  </a:lnTo>
                  <a:lnTo>
                    <a:pt x="1458" y="322961"/>
                  </a:lnTo>
                  <a:lnTo>
                    <a:pt x="1458" y="322205"/>
                  </a:lnTo>
                  <a:lnTo>
                    <a:pt x="1458" y="321449"/>
                  </a:lnTo>
                  <a:lnTo>
                    <a:pt x="1458" y="320692"/>
                  </a:lnTo>
                  <a:lnTo>
                    <a:pt x="1458" y="319936"/>
                  </a:lnTo>
                  <a:lnTo>
                    <a:pt x="1458" y="319180"/>
                  </a:lnTo>
                  <a:lnTo>
                    <a:pt x="1458" y="318423"/>
                  </a:lnTo>
                  <a:lnTo>
                    <a:pt x="1458" y="317667"/>
                  </a:lnTo>
                  <a:lnTo>
                    <a:pt x="1458" y="316911"/>
                  </a:lnTo>
                  <a:lnTo>
                    <a:pt x="1458" y="316154"/>
                  </a:lnTo>
                  <a:lnTo>
                    <a:pt x="1458" y="315398"/>
                  </a:lnTo>
                  <a:lnTo>
                    <a:pt x="1458" y="314642"/>
                  </a:lnTo>
                  <a:lnTo>
                    <a:pt x="1458" y="313885"/>
                  </a:lnTo>
                  <a:lnTo>
                    <a:pt x="1458" y="313129"/>
                  </a:lnTo>
                  <a:lnTo>
                    <a:pt x="1458" y="312373"/>
                  </a:lnTo>
                  <a:lnTo>
                    <a:pt x="1458" y="311616"/>
                  </a:lnTo>
                  <a:lnTo>
                    <a:pt x="1458" y="310860"/>
                  </a:lnTo>
                  <a:lnTo>
                    <a:pt x="1458" y="310104"/>
                  </a:lnTo>
                  <a:lnTo>
                    <a:pt x="1458" y="309347"/>
                  </a:lnTo>
                  <a:lnTo>
                    <a:pt x="1458" y="308591"/>
                  </a:lnTo>
                  <a:lnTo>
                    <a:pt x="1458" y="307834"/>
                  </a:lnTo>
                  <a:lnTo>
                    <a:pt x="1458" y="307078"/>
                  </a:lnTo>
                  <a:lnTo>
                    <a:pt x="1458" y="306322"/>
                  </a:lnTo>
                  <a:lnTo>
                    <a:pt x="1458" y="305565"/>
                  </a:lnTo>
                  <a:lnTo>
                    <a:pt x="1458" y="304809"/>
                  </a:lnTo>
                  <a:lnTo>
                    <a:pt x="1458" y="304053"/>
                  </a:lnTo>
                  <a:lnTo>
                    <a:pt x="1458" y="303296"/>
                  </a:lnTo>
                  <a:lnTo>
                    <a:pt x="1458" y="302540"/>
                  </a:lnTo>
                  <a:lnTo>
                    <a:pt x="1458" y="301784"/>
                  </a:lnTo>
                  <a:lnTo>
                    <a:pt x="1458" y="301027"/>
                  </a:lnTo>
                  <a:lnTo>
                    <a:pt x="1458" y="300271"/>
                  </a:lnTo>
                  <a:lnTo>
                    <a:pt x="1458" y="299515"/>
                  </a:lnTo>
                  <a:lnTo>
                    <a:pt x="1458" y="298758"/>
                  </a:lnTo>
                  <a:lnTo>
                    <a:pt x="1458" y="298002"/>
                  </a:lnTo>
                  <a:lnTo>
                    <a:pt x="1458" y="297246"/>
                  </a:lnTo>
                  <a:lnTo>
                    <a:pt x="1458" y="296489"/>
                  </a:lnTo>
                  <a:lnTo>
                    <a:pt x="1458" y="295733"/>
                  </a:lnTo>
                  <a:lnTo>
                    <a:pt x="1458" y="294976"/>
                  </a:lnTo>
                  <a:lnTo>
                    <a:pt x="1458" y="294220"/>
                  </a:lnTo>
                  <a:lnTo>
                    <a:pt x="1458" y="293464"/>
                  </a:lnTo>
                  <a:lnTo>
                    <a:pt x="1458" y="292707"/>
                  </a:lnTo>
                  <a:lnTo>
                    <a:pt x="1458" y="291951"/>
                  </a:lnTo>
                  <a:lnTo>
                    <a:pt x="1458" y="291195"/>
                  </a:lnTo>
                  <a:lnTo>
                    <a:pt x="1458" y="290438"/>
                  </a:lnTo>
                  <a:lnTo>
                    <a:pt x="1458" y="289682"/>
                  </a:lnTo>
                  <a:lnTo>
                    <a:pt x="1458" y="288926"/>
                  </a:lnTo>
                  <a:lnTo>
                    <a:pt x="1458" y="288169"/>
                  </a:lnTo>
                  <a:lnTo>
                    <a:pt x="1458" y="287413"/>
                  </a:lnTo>
                  <a:lnTo>
                    <a:pt x="1458" y="286657"/>
                  </a:lnTo>
                  <a:lnTo>
                    <a:pt x="1458" y="285900"/>
                  </a:lnTo>
                  <a:lnTo>
                    <a:pt x="1458" y="285144"/>
                  </a:lnTo>
                  <a:lnTo>
                    <a:pt x="1458" y="284388"/>
                  </a:lnTo>
                  <a:lnTo>
                    <a:pt x="1458" y="283631"/>
                  </a:lnTo>
                  <a:lnTo>
                    <a:pt x="1458" y="282875"/>
                  </a:lnTo>
                  <a:lnTo>
                    <a:pt x="1458" y="282119"/>
                  </a:lnTo>
                  <a:lnTo>
                    <a:pt x="1458" y="281362"/>
                  </a:lnTo>
                  <a:lnTo>
                    <a:pt x="1458" y="280606"/>
                  </a:lnTo>
                  <a:lnTo>
                    <a:pt x="1458" y="279849"/>
                  </a:lnTo>
                  <a:lnTo>
                    <a:pt x="1458" y="279093"/>
                  </a:lnTo>
                  <a:lnTo>
                    <a:pt x="1458" y="278337"/>
                  </a:lnTo>
                  <a:lnTo>
                    <a:pt x="1458" y="277580"/>
                  </a:lnTo>
                  <a:lnTo>
                    <a:pt x="1458" y="276824"/>
                  </a:lnTo>
                  <a:lnTo>
                    <a:pt x="1458" y="276068"/>
                  </a:lnTo>
                  <a:lnTo>
                    <a:pt x="1458" y="275311"/>
                  </a:lnTo>
                  <a:lnTo>
                    <a:pt x="1458" y="274555"/>
                  </a:lnTo>
                  <a:lnTo>
                    <a:pt x="1458" y="273799"/>
                  </a:lnTo>
                  <a:lnTo>
                    <a:pt x="1458" y="273042"/>
                  </a:lnTo>
                  <a:lnTo>
                    <a:pt x="1458" y="272286"/>
                  </a:lnTo>
                  <a:lnTo>
                    <a:pt x="1458" y="271530"/>
                  </a:lnTo>
                  <a:lnTo>
                    <a:pt x="1458" y="270773"/>
                  </a:lnTo>
                  <a:lnTo>
                    <a:pt x="1458" y="270017"/>
                  </a:lnTo>
                  <a:lnTo>
                    <a:pt x="1458" y="269261"/>
                  </a:lnTo>
                  <a:lnTo>
                    <a:pt x="1458" y="268504"/>
                  </a:lnTo>
                  <a:lnTo>
                    <a:pt x="1458" y="267748"/>
                  </a:lnTo>
                  <a:lnTo>
                    <a:pt x="1458" y="266991"/>
                  </a:lnTo>
                  <a:lnTo>
                    <a:pt x="1458" y="266235"/>
                  </a:lnTo>
                  <a:lnTo>
                    <a:pt x="1458" y="265479"/>
                  </a:lnTo>
                  <a:lnTo>
                    <a:pt x="1458" y="264722"/>
                  </a:lnTo>
                  <a:lnTo>
                    <a:pt x="1458" y="263966"/>
                  </a:lnTo>
                  <a:lnTo>
                    <a:pt x="1458" y="263210"/>
                  </a:lnTo>
                  <a:lnTo>
                    <a:pt x="1458" y="262453"/>
                  </a:lnTo>
                  <a:lnTo>
                    <a:pt x="1458" y="261697"/>
                  </a:lnTo>
                  <a:lnTo>
                    <a:pt x="1458" y="260941"/>
                  </a:lnTo>
                  <a:lnTo>
                    <a:pt x="1458" y="260184"/>
                  </a:lnTo>
                  <a:lnTo>
                    <a:pt x="1458" y="259428"/>
                  </a:lnTo>
                  <a:lnTo>
                    <a:pt x="1458" y="258672"/>
                  </a:lnTo>
                  <a:lnTo>
                    <a:pt x="1458" y="257915"/>
                  </a:lnTo>
                  <a:lnTo>
                    <a:pt x="1458" y="257159"/>
                  </a:lnTo>
                  <a:lnTo>
                    <a:pt x="1458" y="256403"/>
                  </a:lnTo>
                  <a:lnTo>
                    <a:pt x="1458" y="255646"/>
                  </a:lnTo>
                  <a:lnTo>
                    <a:pt x="1458" y="254890"/>
                  </a:lnTo>
                  <a:lnTo>
                    <a:pt x="1458" y="254134"/>
                  </a:lnTo>
                  <a:lnTo>
                    <a:pt x="1457" y="253377"/>
                  </a:lnTo>
                  <a:lnTo>
                    <a:pt x="1457" y="252621"/>
                  </a:lnTo>
                  <a:lnTo>
                    <a:pt x="1457" y="251864"/>
                  </a:lnTo>
                  <a:lnTo>
                    <a:pt x="1457" y="251108"/>
                  </a:lnTo>
                  <a:lnTo>
                    <a:pt x="1457" y="250352"/>
                  </a:lnTo>
                  <a:lnTo>
                    <a:pt x="1457" y="249595"/>
                  </a:lnTo>
                  <a:lnTo>
                    <a:pt x="1457" y="248839"/>
                  </a:lnTo>
                  <a:lnTo>
                    <a:pt x="1457" y="248083"/>
                  </a:lnTo>
                  <a:lnTo>
                    <a:pt x="1457" y="247326"/>
                  </a:lnTo>
                  <a:lnTo>
                    <a:pt x="1456" y="246570"/>
                  </a:lnTo>
                  <a:lnTo>
                    <a:pt x="1456" y="245814"/>
                  </a:lnTo>
                  <a:lnTo>
                    <a:pt x="1456" y="245057"/>
                  </a:lnTo>
                  <a:lnTo>
                    <a:pt x="1455" y="244301"/>
                  </a:lnTo>
                  <a:lnTo>
                    <a:pt x="1454" y="243545"/>
                  </a:lnTo>
                  <a:lnTo>
                    <a:pt x="1453" y="242788"/>
                  </a:lnTo>
                  <a:lnTo>
                    <a:pt x="1451" y="242032"/>
                  </a:lnTo>
                  <a:lnTo>
                    <a:pt x="1449" y="241276"/>
                  </a:lnTo>
                  <a:lnTo>
                    <a:pt x="1446" y="240519"/>
                  </a:lnTo>
                  <a:lnTo>
                    <a:pt x="1443" y="239763"/>
                  </a:lnTo>
                  <a:lnTo>
                    <a:pt x="1439" y="239007"/>
                  </a:lnTo>
                  <a:lnTo>
                    <a:pt x="1434" y="238250"/>
                  </a:lnTo>
                  <a:lnTo>
                    <a:pt x="1428" y="237494"/>
                  </a:lnTo>
                  <a:lnTo>
                    <a:pt x="1421" y="236737"/>
                  </a:lnTo>
                  <a:lnTo>
                    <a:pt x="1412" y="235981"/>
                  </a:lnTo>
                  <a:lnTo>
                    <a:pt x="1402" y="235225"/>
                  </a:lnTo>
                  <a:lnTo>
                    <a:pt x="1390" y="234468"/>
                  </a:lnTo>
                  <a:lnTo>
                    <a:pt x="1375" y="233712"/>
                  </a:lnTo>
                  <a:lnTo>
                    <a:pt x="1358" y="232956"/>
                  </a:lnTo>
                  <a:lnTo>
                    <a:pt x="1339" y="232199"/>
                  </a:lnTo>
                  <a:lnTo>
                    <a:pt x="1318" y="231443"/>
                  </a:lnTo>
                  <a:lnTo>
                    <a:pt x="1294" y="230687"/>
                  </a:lnTo>
                  <a:lnTo>
                    <a:pt x="1267" y="229930"/>
                  </a:lnTo>
                  <a:lnTo>
                    <a:pt x="1238" y="229174"/>
                  </a:lnTo>
                  <a:lnTo>
                    <a:pt x="1206" y="228418"/>
                  </a:lnTo>
                  <a:lnTo>
                    <a:pt x="1172" y="227661"/>
                  </a:lnTo>
                  <a:lnTo>
                    <a:pt x="1135" y="226905"/>
                  </a:lnTo>
                  <a:lnTo>
                    <a:pt x="1096" y="226149"/>
                  </a:lnTo>
                  <a:lnTo>
                    <a:pt x="1056" y="225392"/>
                  </a:lnTo>
                  <a:lnTo>
                    <a:pt x="1014" y="224636"/>
                  </a:lnTo>
                  <a:lnTo>
                    <a:pt x="972" y="223879"/>
                  </a:lnTo>
                  <a:lnTo>
                    <a:pt x="928" y="223123"/>
                  </a:lnTo>
                  <a:lnTo>
                    <a:pt x="885" y="222367"/>
                  </a:lnTo>
                  <a:lnTo>
                    <a:pt x="842" y="221610"/>
                  </a:lnTo>
                  <a:lnTo>
                    <a:pt x="799" y="220854"/>
                  </a:lnTo>
                  <a:lnTo>
                    <a:pt x="757" y="220098"/>
                  </a:lnTo>
                  <a:lnTo>
                    <a:pt x="716" y="219341"/>
                  </a:lnTo>
                  <a:lnTo>
                    <a:pt x="676" y="218585"/>
                  </a:lnTo>
                  <a:lnTo>
                    <a:pt x="638" y="217829"/>
                  </a:lnTo>
                  <a:lnTo>
                    <a:pt x="601" y="217072"/>
                  </a:lnTo>
                  <a:lnTo>
                    <a:pt x="565" y="216316"/>
                  </a:lnTo>
                  <a:lnTo>
                    <a:pt x="530" y="215560"/>
                  </a:lnTo>
                  <a:lnTo>
                    <a:pt x="495" y="214803"/>
                  </a:lnTo>
                  <a:lnTo>
                    <a:pt x="460" y="214047"/>
                  </a:lnTo>
                  <a:lnTo>
                    <a:pt x="426" y="213291"/>
                  </a:lnTo>
                  <a:lnTo>
                    <a:pt x="391" y="212534"/>
                  </a:lnTo>
                  <a:lnTo>
                    <a:pt x="356" y="211778"/>
                  </a:lnTo>
                  <a:lnTo>
                    <a:pt x="321" y="211022"/>
                  </a:lnTo>
                  <a:lnTo>
                    <a:pt x="285" y="210265"/>
                  </a:lnTo>
                  <a:lnTo>
                    <a:pt x="249" y="209509"/>
                  </a:lnTo>
                  <a:lnTo>
                    <a:pt x="212" y="208752"/>
                  </a:lnTo>
                  <a:lnTo>
                    <a:pt x="176" y="207996"/>
                  </a:lnTo>
                  <a:lnTo>
                    <a:pt x="141" y="207240"/>
                  </a:lnTo>
                  <a:lnTo>
                    <a:pt x="109" y="206483"/>
                  </a:lnTo>
                  <a:lnTo>
                    <a:pt x="78" y="205727"/>
                  </a:lnTo>
                  <a:lnTo>
                    <a:pt x="52" y="204971"/>
                  </a:lnTo>
                  <a:lnTo>
                    <a:pt x="29" y="204214"/>
                  </a:lnTo>
                  <a:lnTo>
                    <a:pt x="12" y="203458"/>
                  </a:lnTo>
                  <a:lnTo>
                    <a:pt x="2" y="202702"/>
                  </a:lnTo>
                  <a:lnTo>
                    <a:pt x="0" y="201945"/>
                  </a:lnTo>
                  <a:lnTo>
                    <a:pt x="4" y="201189"/>
                  </a:lnTo>
                  <a:lnTo>
                    <a:pt x="17" y="200433"/>
                  </a:lnTo>
                  <a:lnTo>
                    <a:pt x="38" y="199676"/>
                  </a:lnTo>
                  <a:lnTo>
                    <a:pt x="68" y="198920"/>
                  </a:lnTo>
                  <a:lnTo>
                    <a:pt x="106" y="198164"/>
                  </a:lnTo>
                  <a:lnTo>
                    <a:pt x="153" y="197407"/>
                  </a:lnTo>
                  <a:lnTo>
                    <a:pt x="206" y="196651"/>
                  </a:lnTo>
                  <a:lnTo>
                    <a:pt x="266" y="195894"/>
                  </a:lnTo>
                  <a:lnTo>
                    <a:pt x="331" y="195138"/>
                  </a:lnTo>
                  <a:lnTo>
                    <a:pt x="401" y="194382"/>
                  </a:lnTo>
                  <a:lnTo>
                    <a:pt x="473" y="193625"/>
                  </a:lnTo>
                  <a:lnTo>
                    <a:pt x="548" y="192869"/>
                  </a:lnTo>
                  <a:lnTo>
                    <a:pt x="623" y="192113"/>
                  </a:lnTo>
                  <a:lnTo>
                    <a:pt x="698" y="191356"/>
                  </a:lnTo>
                  <a:lnTo>
                    <a:pt x="772" y="190600"/>
                  </a:lnTo>
                  <a:lnTo>
                    <a:pt x="843" y="189844"/>
                  </a:lnTo>
                  <a:lnTo>
                    <a:pt x="912" y="189087"/>
                  </a:lnTo>
                  <a:lnTo>
                    <a:pt x="977" y="188331"/>
                  </a:lnTo>
                  <a:lnTo>
                    <a:pt x="1037" y="187575"/>
                  </a:lnTo>
                  <a:lnTo>
                    <a:pt x="1092" y="186818"/>
                  </a:lnTo>
                  <a:lnTo>
                    <a:pt x="1143" y="186062"/>
                  </a:lnTo>
                  <a:lnTo>
                    <a:pt x="1189" y="185306"/>
                  </a:lnTo>
                  <a:lnTo>
                    <a:pt x="1230" y="184549"/>
                  </a:lnTo>
                  <a:lnTo>
                    <a:pt x="1267" y="183793"/>
                  </a:lnTo>
                  <a:lnTo>
                    <a:pt x="1299" y="183037"/>
                  </a:lnTo>
                  <a:lnTo>
                    <a:pt x="1326" y="182280"/>
                  </a:lnTo>
                  <a:lnTo>
                    <a:pt x="1349" y="181524"/>
                  </a:lnTo>
                  <a:lnTo>
                    <a:pt x="1369" y="180767"/>
                  </a:lnTo>
                  <a:lnTo>
                    <a:pt x="1386" y="180011"/>
                  </a:lnTo>
                  <a:lnTo>
                    <a:pt x="1401" y="179255"/>
                  </a:lnTo>
                  <a:lnTo>
                    <a:pt x="1413" y="178498"/>
                  </a:lnTo>
                  <a:lnTo>
                    <a:pt x="1422" y="177742"/>
                  </a:lnTo>
                  <a:lnTo>
                    <a:pt x="1430" y="176986"/>
                  </a:lnTo>
                  <a:lnTo>
                    <a:pt x="1436" y="176229"/>
                  </a:lnTo>
                  <a:lnTo>
                    <a:pt x="1441" y="175473"/>
                  </a:lnTo>
                  <a:lnTo>
                    <a:pt x="1445" y="174717"/>
                  </a:lnTo>
                  <a:lnTo>
                    <a:pt x="1448" y="173960"/>
                  </a:lnTo>
                  <a:lnTo>
                    <a:pt x="1450" y="173204"/>
                  </a:lnTo>
                  <a:lnTo>
                    <a:pt x="1452" y="172448"/>
                  </a:lnTo>
                  <a:lnTo>
                    <a:pt x="1454" y="171691"/>
                  </a:lnTo>
                  <a:lnTo>
                    <a:pt x="1455" y="170935"/>
                  </a:lnTo>
                  <a:lnTo>
                    <a:pt x="1455" y="170179"/>
                  </a:lnTo>
                  <a:lnTo>
                    <a:pt x="1456" y="169422"/>
                  </a:lnTo>
                  <a:lnTo>
                    <a:pt x="1456" y="168666"/>
                  </a:lnTo>
                  <a:lnTo>
                    <a:pt x="1457" y="167909"/>
                  </a:lnTo>
                  <a:lnTo>
                    <a:pt x="1457" y="167153"/>
                  </a:lnTo>
                  <a:lnTo>
                    <a:pt x="1457" y="166397"/>
                  </a:lnTo>
                  <a:lnTo>
                    <a:pt x="1457" y="165640"/>
                  </a:lnTo>
                  <a:lnTo>
                    <a:pt x="1457" y="164884"/>
                  </a:lnTo>
                  <a:lnTo>
                    <a:pt x="1457" y="164128"/>
                  </a:lnTo>
                  <a:lnTo>
                    <a:pt x="1457" y="163371"/>
                  </a:lnTo>
                  <a:lnTo>
                    <a:pt x="1457" y="162615"/>
                  </a:lnTo>
                  <a:lnTo>
                    <a:pt x="1458" y="161859"/>
                  </a:lnTo>
                  <a:lnTo>
                    <a:pt x="1458" y="161102"/>
                  </a:lnTo>
                  <a:lnTo>
                    <a:pt x="1458" y="160346"/>
                  </a:lnTo>
                  <a:lnTo>
                    <a:pt x="1458" y="159590"/>
                  </a:lnTo>
                  <a:lnTo>
                    <a:pt x="1458" y="158833"/>
                  </a:lnTo>
                  <a:lnTo>
                    <a:pt x="1458" y="158077"/>
                  </a:lnTo>
                  <a:lnTo>
                    <a:pt x="1458" y="157321"/>
                  </a:lnTo>
                  <a:lnTo>
                    <a:pt x="1458" y="156564"/>
                  </a:lnTo>
                  <a:lnTo>
                    <a:pt x="1458" y="155808"/>
                  </a:lnTo>
                  <a:lnTo>
                    <a:pt x="1458" y="155052"/>
                  </a:lnTo>
                  <a:lnTo>
                    <a:pt x="1458" y="154295"/>
                  </a:lnTo>
                  <a:lnTo>
                    <a:pt x="1458" y="153539"/>
                  </a:lnTo>
                  <a:lnTo>
                    <a:pt x="1458" y="152782"/>
                  </a:lnTo>
                  <a:lnTo>
                    <a:pt x="1458" y="152026"/>
                  </a:lnTo>
                  <a:lnTo>
                    <a:pt x="1458" y="151270"/>
                  </a:lnTo>
                  <a:lnTo>
                    <a:pt x="1458" y="150513"/>
                  </a:lnTo>
                  <a:lnTo>
                    <a:pt x="1458" y="149757"/>
                  </a:lnTo>
                  <a:lnTo>
                    <a:pt x="1458" y="149001"/>
                  </a:lnTo>
                  <a:lnTo>
                    <a:pt x="1458" y="148244"/>
                  </a:lnTo>
                  <a:lnTo>
                    <a:pt x="1458" y="147488"/>
                  </a:lnTo>
                  <a:lnTo>
                    <a:pt x="1458" y="146732"/>
                  </a:lnTo>
                  <a:lnTo>
                    <a:pt x="1458" y="145975"/>
                  </a:lnTo>
                  <a:lnTo>
                    <a:pt x="1458" y="145219"/>
                  </a:lnTo>
                  <a:lnTo>
                    <a:pt x="1458" y="144463"/>
                  </a:lnTo>
                  <a:lnTo>
                    <a:pt x="1458" y="143706"/>
                  </a:lnTo>
                  <a:lnTo>
                    <a:pt x="1458" y="142950"/>
                  </a:lnTo>
                  <a:lnTo>
                    <a:pt x="1458" y="142194"/>
                  </a:lnTo>
                  <a:lnTo>
                    <a:pt x="1458" y="141437"/>
                  </a:lnTo>
                  <a:lnTo>
                    <a:pt x="1458" y="140681"/>
                  </a:lnTo>
                  <a:lnTo>
                    <a:pt x="1458" y="139924"/>
                  </a:lnTo>
                  <a:lnTo>
                    <a:pt x="1458" y="139168"/>
                  </a:lnTo>
                  <a:lnTo>
                    <a:pt x="1458" y="138412"/>
                  </a:lnTo>
                  <a:lnTo>
                    <a:pt x="1458" y="137655"/>
                  </a:lnTo>
                  <a:lnTo>
                    <a:pt x="1458" y="136899"/>
                  </a:lnTo>
                  <a:lnTo>
                    <a:pt x="1458" y="136143"/>
                  </a:lnTo>
                  <a:lnTo>
                    <a:pt x="1458" y="135386"/>
                  </a:lnTo>
                  <a:lnTo>
                    <a:pt x="1458" y="134630"/>
                  </a:lnTo>
                  <a:lnTo>
                    <a:pt x="1458" y="133874"/>
                  </a:lnTo>
                  <a:lnTo>
                    <a:pt x="1458" y="133117"/>
                  </a:lnTo>
                  <a:lnTo>
                    <a:pt x="1458" y="132361"/>
                  </a:lnTo>
                  <a:lnTo>
                    <a:pt x="1458" y="131605"/>
                  </a:lnTo>
                  <a:lnTo>
                    <a:pt x="1458" y="130848"/>
                  </a:lnTo>
                  <a:lnTo>
                    <a:pt x="1458" y="130092"/>
                  </a:lnTo>
                  <a:lnTo>
                    <a:pt x="1458" y="129336"/>
                  </a:lnTo>
                  <a:lnTo>
                    <a:pt x="1458" y="128579"/>
                  </a:lnTo>
                  <a:lnTo>
                    <a:pt x="1458" y="127823"/>
                  </a:lnTo>
                  <a:lnTo>
                    <a:pt x="1458" y="127067"/>
                  </a:lnTo>
                  <a:lnTo>
                    <a:pt x="1458" y="126310"/>
                  </a:lnTo>
                  <a:lnTo>
                    <a:pt x="1458" y="125554"/>
                  </a:lnTo>
                  <a:lnTo>
                    <a:pt x="1458" y="124797"/>
                  </a:lnTo>
                  <a:lnTo>
                    <a:pt x="1458" y="124041"/>
                  </a:lnTo>
                  <a:lnTo>
                    <a:pt x="1458" y="123285"/>
                  </a:lnTo>
                  <a:lnTo>
                    <a:pt x="1458" y="122528"/>
                  </a:lnTo>
                  <a:lnTo>
                    <a:pt x="1458" y="121772"/>
                  </a:lnTo>
                  <a:lnTo>
                    <a:pt x="1458" y="121016"/>
                  </a:lnTo>
                  <a:lnTo>
                    <a:pt x="1458" y="120259"/>
                  </a:lnTo>
                  <a:lnTo>
                    <a:pt x="1458" y="119503"/>
                  </a:lnTo>
                  <a:lnTo>
                    <a:pt x="1458" y="118747"/>
                  </a:lnTo>
                  <a:lnTo>
                    <a:pt x="1458" y="117990"/>
                  </a:lnTo>
                  <a:lnTo>
                    <a:pt x="1458" y="117234"/>
                  </a:lnTo>
                  <a:lnTo>
                    <a:pt x="1458" y="116478"/>
                  </a:lnTo>
                  <a:lnTo>
                    <a:pt x="1458" y="115721"/>
                  </a:lnTo>
                  <a:lnTo>
                    <a:pt x="1458" y="114965"/>
                  </a:lnTo>
                  <a:lnTo>
                    <a:pt x="1458" y="114209"/>
                  </a:lnTo>
                  <a:lnTo>
                    <a:pt x="1458" y="113452"/>
                  </a:lnTo>
                  <a:lnTo>
                    <a:pt x="1458" y="112696"/>
                  </a:lnTo>
                  <a:lnTo>
                    <a:pt x="1458" y="111939"/>
                  </a:lnTo>
                  <a:lnTo>
                    <a:pt x="1458" y="111183"/>
                  </a:lnTo>
                  <a:lnTo>
                    <a:pt x="1458" y="110427"/>
                  </a:lnTo>
                  <a:lnTo>
                    <a:pt x="1458" y="109670"/>
                  </a:lnTo>
                  <a:lnTo>
                    <a:pt x="1458" y="108914"/>
                  </a:lnTo>
                  <a:lnTo>
                    <a:pt x="1458" y="108158"/>
                  </a:lnTo>
                  <a:lnTo>
                    <a:pt x="1458" y="107401"/>
                  </a:lnTo>
                  <a:lnTo>
                    <a:pt x="1458" y="106645"/>
                  </a:lnTo>
                  <a:lnTo>
                    <a:pt x="1458" y="105889"/>
                  </a:lnTo>
                  <a:lnTo>
                    <a:pt x="1458" y="105132"/>
                  </a:lnTo>
                  <a:lnTo>
                    <a:pt x="1458" y="104376"/>
                  </a:lnTo>
                  <a:lnTo>
                    <a:pt x="1458" y="103620"/>
                  </a:lnTo>
                  <a:lnTo>
                    <a:pt x="1458" y="102863"/>
                  </a:lnTo>
                  <a:lnTo>
                    <a:pt x="1458" y="102107"/>
                  </a:lnTo>
                  <a:lnTo>
                    <a:pt x="1458" y="101351"/>
                  </a:lnTo>
                  <a:lnTo>
                    <a:pt x="1458" y="100594"/>
                  </a:lnTo>
                  <a:lnTo>
                    <a:pt x="1458" y="99838"/>
                  </a:lnTo>
                  <a:lnTo>
                    <a:pt x="1458" y="99082"/>
                  </a:lnTo>
                  <a:lnTo>
                    <a:pt x="1458" y="98325"/>
                  </a:lnTo>
                  <a:lnTo>
                    <a:pt x="1458" y="97569"/>
                  </a:lnTo>
                  <a:lnTo>
                    <a:pt x="1458" y="96812"/>
                  </a:lnTo>
                  <a:lnTo>
                    <a:pt x="1458" y="96056"/>
                  </a:lnTo>
                  <a:lnTo>
                    <a:pt x="1458" y="95300"/>
                  </a:lnTo>
                  <a:lnTo>
                    <a:pt x="1458" y="94543"/>
                  </a:lnTo>
                  <a:lnTo>
                    <a:pt x="1458" y="93787"/>
                  </a:lnTo>
                  <a:lnTo>
                    <a:pt x="1458" y="93031"/>
                  </a:lnTo>
                  <a:lnTo>
                    <a:pt x="1458" y="92274"/>
                  </a:lnTo>
                  <a:lnTo>
                    <a:pt x="1458" y="91518"/>
                  </a:lnTo>
                  <a:lnTo>
                    <a:pt x="1458" y="90762"/>
                  </a:lnTo>
                  <a:lnTo>
                    <a:pt x="1458" y="90005"/>
                  </a:lnTo>
                  <a:lnTo>
                    <a:pt x="1458" y="89249"/>
                  </a:lnTo>
                  <a:lnTo>
                    <a:pt x="1458" y="88493"/>
                  </a:lnTo>
                  <a:lnTo>
                    <a:pt x="1458" y="87736"/>
                  </a:lnTo>
                  <a:lnTo>
                    <a:pt x="1458" y="86980"/>
                  </a:lnTo>
                  <a:lnTo>
                    <a:pt x="1458" y="86224"/>
                  </a:lnTo>
                  <a:lnTo>
                    <a:pt x="1458" y="85467"/>
                  </a:lnTo>
                  <a:lnTo>
                    <a:pt x="1458" y="84711"/>
                  </a:lnTo>
                  <a:lnTo>
                    <a:pt x="1458" y="83954"/>
                  </a:lnTo>
                  <a:lnTo>
                    <a:pt x="1458" y="83198"/>
                  </a:lnTo>
                  <a:lnTo>
                    <a:pt x="1458" y="82442"/>
                  </a:lnTo>
                  <a:lnTo>
                    <a:pt x="1458" y="81685"/>
                  </a:lnTo>
                  <a:lnTo>
                    <a:pt x="1458" y="80929"/>
                  </a:lnTo>
                  <a:lnTo>
                    <a:pt x="1458" y="80173"/>
                  </a:lnTo>
                  <a:lnTo>
                    <a:pt x="1458" y="79416"/>
                  </a:lnTo>
                  <a:lnTo>
                    <a:pt x="1458" y="78660"/>
                  </a:lnTo>
                  <a:lnTo>
                    <a:pt x="1458" y="77904"/>
                  </a:lnTo>
                  <a:lnTo>
                    <a:pt x="1458" y="77147"/>
                  </a:lnTo>
                  <a:lnTo>
                    <a:pt x="1458" y="76391"/>
                  </a:lnTo>
                  <a:lnTo>
                    <a:pt x="1458" y="75635"/>
                  </a:lnTo>
                  <a:lnTo>
                    <a:pt x="1458" y="74878"/>
                  </a:lnTo>
                  <a:lnTo>
                    <a:pt x="1458" y="74122"/>
                  </a:lnTo>
                  <a:lnTo>
                    <a:pt x="1458" y="73366"/>
                  </a:lnTo>
                  <a:lnTo>
                    <a:pt x="1458" y="72609"/>
                  </a:lnTo>
                  <a:lnTo>
                    <a:pt x="1458" y="71853"/>
                  </a:lnTo>
                  <a:lnTo>
                    <a:pt x="1458" y="71097"/>
                  </a:lnTo>
                  <a:lnTo>
                    <a:pt x="1458" y="70340"/>
                  </a:lnTo>
                  <a:lnTo>
                    <a:pt x="1458" y="69584"/>
                  </a:lnTo>
                  <a:lnTo>
                    <a:pt x="1458" y="68827"/>
                  </a:lnTo>
                  <a:lnTo>
                    <a:pt x="1458" y="68071"/>
                  </a:lnTo>
                  <a:lnTo>
                    <a:pt x="1458" y="67315"/>
                  </a:lnTo>
                  <a:lnTo>
                    <a:pt x="1458" y="66558"/>
                  </a:lnTo>
                  <a:lnTo>
                    <a:pt x="1458" y="65802"/>
                  </a:lnTo>
                  <a:lnTo>
                    <a:pt x="1458" y="65046"/>
                  </a:lnTo>
                  <a:lnTo>
                    <a:pt x="1458" y="64289"/>
                  </a:lnTo>
                  <a:lnTo>
                    <a:pt x="1458" y="63533"/>
                  </a:lnTo>
                  <a:lnTo>
                    <a:pt x="1458" y="62777"/>
                  </a:lnTo>
                  <a:lnTo>
                    <a:pt x="1458" y="62020"/>
                  </a:lnTo>
                  <a:lnTo>
                    <a:pt x="1457" y="61264"/>
                  </a:lnTo>
                  <a:lnTo>
                    <a:pt x="1457" y="60508"/>
                  </a:lnTo>
                  <a:lnTo>
                    <a:pt x="1457" y="59751"/>
                  </a:lnTo>
                  <a:lnTo>
                    <a:pt x="1457" y="58995"/>
                  </a:lnTo>
                  <a:lnTo>
                    <a:pt x="1457" y="58239"/>
                  </a:lnTo>
                  <a:lnTo>
                    <a:pt x="1457" y="57482"/>
                  </a:lnTo>
                  <a:lnTo>
                    <a:pt x="1457" y="56726"/>
                  </a:lnTo>
                  <a:lnTo>
                    <a:pt x="1457" y="55969"/>
                  </a:lnTo>
                  <a:lnTo>
                    <a:pt x="1457" y="55213"/>
                  </a:lnTo>
                  <a:lnTo>
                    <a:pt x="1456" y="54457"/>
                  </a:lnTo>
                  <a:lnTo>
                    <a:pt x="1456" y="53700"/>
                  </a:lnTo>
                  <a:lnTo>
                    <a:pt x="1455" y="52944"/>
                  </a:lnTo>
                  <a:lnTo>
                    <a:pt x="1454" y="52188"/>
                  </a:lnTo>
                  <a:lnTo>
                    <a:pt x="1453" y="51431"/>
                  </a:lnTo>
                  <a:lnTo>
                    <a:pt x="1452" y="50675"/>
                  </a:lnTo>
                  <a:lnTo>
                    <a:pt x="1450" y="49919"/>
                  </a:lnTo>
                  <a:lnTo>
                    <a:pt x="1447" y="49162"/>
                  </a:lnTo>
                  <a:lnTo>
                    <a:pt x="1444" y="48406"/>
                  </a:lnTo>
                  <a:lnTo>
                    <a:pt x="1441" y="47650"/>
                  </a:lnTo>
                  <a:lnTo>
                    <a:pt x="1436" y="46893"/>
                  </a:lnTo>
                  <a:lnTo>
                    <a:pt x="1430" y="46137"/>
                  </a:lnTo>
                  <a:lnTo>
                    <a:pt x="1424" y="45381"/>
                  </a:lnTo>
                  <a:lnTo>
                    <a:pt x="1415" y="44624"/>
                  </a:lnTo>
                  <a:lnTo>
                    <a:pt x="1406" y="43868"/>
                  </a:lnTo>
                  <a:lnTo>
                    <a:pt x="1394" y="43112"/>
                  </a:lnTo>
                  <a:lnTo>
                    <a:pt x="1380" y="42355"/>
                  </a:lnTo>
                  <a:lnTo>
                    <a:pt x="1365" y="41599"/>
                  </a:lnTo>
                  <a:lnTo>
                    <a:pt x="1347" y="40842"/>
                  </a:lnTo>
                  <a:lnTo>
                    <a:pt x="1327" y="40086"/>
                  </a:lnTo>
                  <a:lnTo>
                    <a:pt x="1304" y="39330"/>
                  </a:lnTo>
                  <a:lnTo>
                    <a:pt x="1279" y="38573"/>
                  </a:lnTo>
                  <a:lnTo>
                    <a:pt x="1251" y="37817"/>
                  </a:lnTo>
                  <a:lnTo>
                    <a:pt x="1222" y="37061"/>
                  </a:lnTo>
                  <a:lnTo>
                    <a:pt x="1190" y="36304"/>
                  </a:lnTo>
                  <a:lnTo>
                    <a:pt x="1156" y="35548"/>
                  </a:lnTo>
                  <a:lnTo>
                    <a:pt x="1121" y="34792"/>
                  </a:lnTo>
                  <a:lnTo>
                    <a:pt x="1084" y="34035"/>
                  </a:lnTo>
                  <a:lnTo>
                    <a:pt x="1047" y="33279"/>
                  </a:lnTo>
                  <a:lnTo>
                    <a:pt x="1011" y="32523"/>
                  </a:lnTo>
                  <a:lnTo>
                    <a:pt x="975" y="31766"/>
                  </a:lnTo>
                  <a:lnTo>
                    <a:pt x="940" y="31010"/>
                  </a:lnTo>
                  <a:lnTo>
                    <a:pt x="907" y="30254"/>
                  </a:lnTo>
                  <a:lnTo>
                    <a:pt x="877" y="29497"/>
                  </a:lnTo>
                  <a:lnTo>
                    <a:pt x="850" y="28741"/>
                  </a:lnTo>
                  <a:lnTo>
                    <a:pt x="827" y="27984"/>
                  </a:lnTo>
                  <a:lnTo>
                    <a:pt x="809" y="27228"/>
                  </a:lnTo>
                  <a:lnTo>
                    <a:pt x="796" y="26472"/>
                  </a:lnTo>
                  <a:lnTo>
                    <a:pt x="788" y="25715"/>
                  </a:lnTo>
                  <a:lnTo>
                    <a:pt x="785" y="24959"/>
                  </a:lnTo>
                  <a:lnTo>
                    <a:pt x="788" y="24203"/>
                  </a:lnTo>
                  <a:lnTo>
                    <a:pt x="796" y="23446"/>
                  </a:lnTo>
                  <a:lnTo>
                    <a:pt x="810" y="22690"/>
                  </a:lnTo>
                  <a:lnTo>
                    <a:pt x="828" y="21934"/>
                  </a:lnTo>
                  <a:lnTo>
                    <a:pt x="851" y="21177"/>
                  </a:lnTo>
                  <a:lnTo>
                    <a:pt x="878" y="20421"/>
                  </a:lnTo>
                  <a:lnTo>
                    <a:pt x="908" y="19665"/>
                  </a:lnTo>
                  <a:lnTo>
                    <a:pt x="941" y="18908"/>
                  </a:lnTo>
                  <a:lnTo>
                    <a:pt x="976" y="18152"/>
                  </a:lnTo>
                  <a:lnTo>
                    <a:pt x="1012" y="17396"/>
                  </a:lnTo>
                  <a:lnTo>
                    <a:pt x="1049" y="16639"/>
                  </a:lnTo>
                  <a:lnTo>
                    <a:pt x="1086" y="15883"/>
                  </a:lnTo>
                  <a:lnTo>
                    <a:pt x="1122" y="15127"/>
                  </a:lnTo>
                  <a:lnTo>
                    <a:pt x="1157" y="14370"/>
                  </a:lnTo>
                  <a:lnTo>
                    <a:pt x="1191" y="13614"/>
                  </a:lnTo>
                  <a:lnTo>
                    <a:pt x="1223" y="12857"/>
                  </a:lnTo>
                  <a:lnTo>
                    <a:pt x="1253" y="12101"/>
                  </a:lnTo>
                  <a:lnTo>
                    <a:pt x="1280" y="11345"/>
                  </a:lnTo>
                  <a:lnTo>
                    <a:pt x="1305" y="10588"/>
                  </a:lnTo>
                  <a:lnTo>
                    <a:pt x="1327" y="9832"/>
                  </a:lnTo>
                  <a:lnTo>
                    <a:pt x="1348" y="9076"/>
                  </a:lnTo>
                  <a:lnTo>
                    <a:pt x="1366" y="8319"/>
                  </a:lnTo>
                  <a:lnTo>
                    <a:pt x="1381" y="7563"/>
                  </a:lnTo>
                  <a:lnTo>
                    <a:pt x="1394" y="6807"/>
                  </a:lnTo>
                  <a:lnTo>
                    <a:pt x="1406" y="6050"/>
                  </a:lnTo>
                  <a:lnTo>
                    <a:pt x="1416" y="5294"/>
                  </a:lnTo>
                  <a:lnTo>
                    <a:pt x="1424" y="4538"/>
                  </a:lnTo>
                  <a:lnTo>
                    <a:pt x="1431" y="3781"/>
                  </a:lnTo>
                  <a:lnTo>
                    <a:pt x="1436" y="3025"/>
                  </a:lnTo>
                  <a:lnTo>
                    <a:pt x="1441" y="2269"/>
                  </a:lnTo>
                  <a:lnTo>
                    <a:pt x="1445" y="1512"/>
                  </a:lnTo>
                  <a:lnTo>
                    <a:pt x="1447" y="756"/>
                  </a:lnTo>
                  <a:lnTo>
                    <a:pt x="1450" y="0"/>
                  </a:lnTo>
                  <a:lnTo>
                    <a:pt x="1458" y="0"/>
                  </a:lnTo>
                  <a:lnTo>
                    <a:pt x="1458" y="386495"/>
                  </a:lnTo>
                  <a:lnTo>
                    <a:pt x="1458" y="386495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49" name="pl31"/>
            <p:cNvSpPr/>
            <p:nvPr/>
          </p:nvSpPr>
          <p:spPr>
            <a:xfrm>
              <a:off x="4169927" y="3643219"/>
              <a:ext cx="721" cy="208550"/>
            </a:xfrm>
            <a:custGeom>
              <a:avLst/>
              <a:gdLst/>
              <a:ahLst/>
              <a:cxnLst/>
              <a:rect l="0" t="0" r="0" b="0"/>
              <a:pathLst>
                <a:path w="721" h="208550">
                  <a:moveTo>
                    <a:pt x="0" y="0"/>
                  </a:moveTo>
                  <a:lnTo>
                    <a:pt x="3" y="0"/>
                  </a:lnTo>
                  <a:lnTo>
                    <a:pt x="3" y="408"/>
                  </a:lnTo>
                  <a:lnTo>
                    <a:pt x="4" y="816"/>
                  </a:lnTo>
                  <a:lnTo>
                    <a:pt x="4" y="1224"/>
                  </a:lnTo>
                  <a:lnTo>
                    <a:pt x="4" y="1632"/>
                  </a:lnTo>
                  <a:lnTo>
                    <a:pt x="5" y="2040"/>
                  </a:lnTo>
                  <a:lnTo>
                    <a:pt x="5" y="2448"/>
                  </a:lnTo>
                  <a:lnTo>
                    <a:pt x="6" y="2856"/>
                  </a:lnTo>
                  <a:lnTo>
                    <a:pt x="6" y="3264"/>
                  </a:lnTo>
                  <a:lnTo>
                    <a:pt x="6" y="3673"/>
                  </a:lnTo>
                  <a:lnTo>
                    <a:pt x="7" y="4081"/>
                  </a:lnTo>
                  <a:lnTo>
                    <a:pt x="7" y="4489"/>
                  </a:lnTo>
                  <a:lnTo>
                    <a:pt x="8" y="4897"/>
                  </a:lnTo>
                  <a:lnTo>
                    <a:pt x="8" y="5305"/>
                  </a:lnTo>
                  <a:lnTo>
                    <a:pt x="9" y="5713"/>
                  </a:lnTo>
                  <a:lnTo>
                    <a:pt x="10" y="6121"/>
                  </a:lnTo>
                  <a:lnTo>
                    <a:pt x="10" y="6529"/>
                  </a:lnTo>
                  <a:lnTo>
                    <a:pt x="11" y="6938"/>
                  </a:lnTo>
                  <a:lnTo>
                    <a:pt x="12" y="7346"/>
                  </a:lnTo>
                  <a:lnTo>
                    <a:pt x="12" y="7754"/>
                  </a:lnTo>
                  <a:lnTo>
                    <a:pt x="13" y="8162"/>
                  </a:lnTo>
                  <a:lnTo>
                    <a:pt x="14" y="8570"/>
                  </a:lnTo>
                  <a:lnTo>
                    <a:pt x="15" y="8978"/>
                  </a:lnTo>
                  <a:lnTo>
                    <a:pt x="16" y="9386"/>
                  </a:lnTo>
                  <a:lnTo>
                    <a:pt x="17" y="9794"/>
                  </a:lnTo>
                  <a:lnTo>
                    <a:pt x="18" y="10203"/>
                  </a:lnTo>
                  <a:lnTo>
                    <a:pt x="19" y="10611"/>
                  </a:lnTo>
                  <a:lnTo>
                    <a:pt x="20" y="11019"/>
                  </a:lnTo>
                  <a:lnTo>
                    <a:pt x="21" y="11427"/>
                  </a:lnTo>
                  <a:lnTo>
                    <a:pt x="23" y="11835"/>
                  </a:lnTo>
                  <a:lnTo>
                    <a:pt x="24" y="12243"/>
                  </a:lnTo>
                  <a:lnTo>
                    <a:pt x="25" y="12651"/>
                  </a:lnTo>
                  <a:lnTo>
                    <a:pt x="27" y="13059"/>
                  </a:lnTo>
                  <a:lnTo>
                    <a:pt x="28" y="13468"/>
                  </a:lnTo>
                  <a:lnTo>
                    <a:pt x="30" y="13876"/>
                  </a:lnTo>
                  <a:lnTo>
                    <a:pt x="31" y="14284"/>
                  </a:lnTo>
                  <a:lnTo>
                    <a:pt x="33" y="14692"/>
                  </a:lnTo>
                  <a:lnTo>
                    <a:pt x="35" y="15100"/>
                  </a:lnTo>
                  <a:lnTo>
                    <a:pt x="37" y="15508"/>
                  </a:lnTo>
                  <a:lnTo>
                    <a:pt x="39" y="15916"/>
                  </a:lnTo>
                  <a:lnTo>
                    <a:pt x="41" y="16324"/>
                  </a:lnTo>
                  <a:lnTo>
                    <a:pt x="43" y="16733"/>
                  </a:lnTo>
                  <a:lnTo>
                    <a:pt x="45" y="17141"/>
                  </a:lnTo>
                  <a:lnTo>
                    <a:pt x="47" y="17549"/>
                  </a:lnTo>
                  <a:lnTo>
                    <a:pt x="49" y="17957"/>
                  </a:lnTo>
                  <a:lnTo>
                    <a:pt x="52" y="18365"/>
                  </a:lnTo>
                  <a:lnTo>
                    <a:pt x="54" y="18773"/>
                  </a:lnTo>
                  <a:lnTo>
                    <a:pt x="57" y="19181"/>
                  </a:lnTo>
                  <a:lnTo>
                    <a:pt x="60" y="19589"/>
                  </a:lnTo>
                  <a:lnTo>
                    <a:pt x="63" y="19998"/>
                  </a:lnTo>
                  <a:lnTo>
                    <a:pt x="65" y="20406"/>
                  </a:lnTo>
                  <a:lnTo>
                    <a:pt x="68" y="20814"/>
                  </a:lnTo>
                  <a:lnTo>
                    <a:pt x="71" y="21222"/>
                  </a:lnTo>
                  <a:lnTo>
                    <a:pt x="75" y="21630"/>
                  </a:lnTo>
                  <a:lnTo>
                    <a:pt x="78" y="22038"/>
                  </a:lnTo>
                  <a:lnTo>
                    <a:pt x="81" y="22446"/>
                  </a:lnTo>
                  <a:lnTo>
                    <a:pt x="85" y="22854"/>
                  </a:lnTo>
                  <a:lnTo>
                    <a:pt x="88" y="23263"/>
                  </a:lnTo>
                  <a:lnTo>
                    <a:pt x="92" y="23671"/>
                  </a:lnTo>
                  <a:lnTo>
                    <a:pt x="96" y="24079"/>
                  </a:lnTo>
                  <a:lnTo>
                    <a:pt x="100" y="24487"/>
                  </a:lnTo>
                  <a:lnTo>
                    <a:pt x="104" y="24895"/>
                  </a:lnTo>
                  <a:lnTo>
                    <a:pt x="108" y="25303"/>
                  </a:lnTo>
                  <a:lnTo>
                    <a:pt x="112" y="25711"/>
                  </a:lnTo>
                  <a:lnTo>
                    <a:pt x="116" y="26119"/>
                  </a:lnTo>
                  <a:lnTo>
                    <a:pt x="121" y="26527"/>
                  </a:lnTo>
                  <a:lnTo>
                    <a:pt x="125" y="26936"/>
                  </a:lnTo>
                  <a:lnTo>
                    <a:pt x="130" y="27344"/>
                  </a:lnTo>
                  <a:lnTo>
                    <a:pt x="135" y="27752"/>
                  </a:lnTo>
                  <a:lnTo>
                    <a:pt x="140" y="28160"/>
                  </a:lnTo>
                  <a:lnTo>
                    <a:pt x="145" y="28568"/>
                  </a:lnTo>
                  <a:lnTo>
                    <a:pt x="150" y="28976"/>
                  </a:lnTo>
                  <a:lnTo>
                    <a:pt x="155" y="29384"/>
                  </a:lnTo>
                  <a:lnTo>
                    <a:pt x="160" y="29792"/>
                  </a:lnTo>
                  <a:lnTo>
                    <a:pt x="166" y="30201"/>
                  </a:lnTo>
                  <a:lnTo>
                    <a:pt x="171" y="30609"/>
                  </a:lnTo>
                  <a:lnTo>
                    <a:pt x="177" y="31017"/>
                  </a:lnTo>
                  <a:lnTo>
                    <a:pt x="182" y="31425"/>
                  </a:lnTo>
                  <a:lnTo>
                    <a:pt x="188" y="31833"/>
                  </a:lnTo>
                  <a:lnTo>
                    <a:pt x="194" y="32241"/>
                  </a:lnTo>
                  <a:lnTo>
                    <a:pt x="200" y="32649"/>
                  </a:lnTo>
                  <a:lnTo>
                    <a:pt x="206" y="33057"/>
                  </a:lnTo>
                  <a:lnTo>
                    <a:pt x="212" y="33466"/>
                  </a:lnTo>
                  <a:lnTo>
                    <a:pt x="218" y="33874"/>
                  </a:lnTo>
                  <a:lnTo>
                    <a:pt x="224" y="34282"/>
                  </a:lnTo>
                  <a:lnTo>
                    <a:pt x="231" y="34690"/>
                  </a:lnTo>
                  <a:lnTo>
                    <a:pt x="237" y="35098"/>
                  </a:lnTo>
                  <a:lnTo>
                    <a:pt x="243" y="35506"/>
                  </a:lnTo>
                  <a:lnTo>
                    <a:pt x="250" y="35914"/>
                  </a:lnTo>
                  <a:lnTo>
                    <a:pt x="257" y="36322"/>
                  </a:lnTo>
                  <a:lnTo>
                    <a:pt x="263" y="36731"/>
                  </a:lnTo>
                  <a:lnTo>
                    <a:pt x="270" y="37139"/>
                  </a:lnTo>
                  <a:lnTo>
                    <a:pt x="277" y="37547"/>
                  </a:lnTo>
                  <a:lnTo>
                    <a:pt x="283" y="37955"/>
                  </a:lnTo>
                  <a:lnTo>
                    <a:pt x="290" y="38363"/>
                  </a:lnTo>
                  <a:lnTo>
                    <a:pt x="297" y="38771"/>
                  </a:lnTo>
                  <a:lnTo>
                    <a:pt x="304" y="39179"/>
                  </a:lnTo>
                  <a:lnTo>
                    <a:pt x="311" y="39587"/>
                  </a:lnTo>
                  <a:lnTo>
                    <a:pt x="318" y="39996"/>
                  </a:lnTo>
                  <a:lnTo>
                    <a:pt x="325" y="40404"/>
                  </a:lnTo>
                  <a:lnTo>
                    <a:pt x="332" y="40812"/>
                  </a:lnTo>
                  <a:lnTo>
                    <a:pt x="339" y="41220"/>
                  </a:lnTo>
                  <a:lnTo>
                    <a:pt x="345" y="41628"/>
                  </a:lnTo>
                  <a:lnTo>
                    <a:pt x="352" y="42036"/>
                  </a:lnTo>
                  <a:lnTo>
                    <a:pt x="359" y="42444"/>
                  </a:lnTo>
                  <a:lnTo>
                    <a:pt x="366" y="42852"/>
                  </a:lnTo>
                  <a:lnTo>
                    <a:pt x="373" y="43261"/>
                  </a:lnTo>
                  <a:lnTo>
                    <a:pt x="380" y="43669"/>
                  </a:lnTo>
                  <a:lnTo>
                    <a:pt x="387" y="44077"/>
                  </a:lnTo>
                  <a:lnTo>
                    <a:pt x="394" y="44485"/>
                  </a:lnTo>
                  <a:lnTo>
                    <a:pt x="401" y="44893"/>
                  </a:lnTo>
                  <a:lnTo>
                    <a:pt x="407" y="45301"/>
                  </a:lnTo>
                  <a:lnTo>
                    <a:pt x="414" y="45709"/>
                  </a:lnTo>
                  <a:lnTo>
                    <a:pt x="421" y="46117"/>
                  </a:lnTo>
                  <a:lnTo>
                    <a:pt x="427" y="46526"/>
                  </a:lnTo>
                  <a:lnTo>
                    <a:pt x="434" y="46934"/>
                  </a:lnTo>
                  <a:lnTo>
                    <a:pt x="440" y="47342"/>
                  </a:lnTo>
                  <a:lnTo>
                    <a:pt x="447" y="47750"/>
                  </a:lnTo>
                  <a:lnTo>
                    <a:pt x="453" y="48158"/>
                  </a:lnTo>
                  <a:lnTo>
                    <a:pt x="459" y="48566"/>
                  </a:lnTo>
                  <a:lnTo>
                    <a:pt x="466" y="48974"/>
                  </a:lnTo>
                  <a:lnTo>
                    <a:pt x="472" y="49382"/>
                  </a:lnTo>
                  <a:lnTo>
                    <a:pt x="478" y="49790"/>
                  </a:lnTo>
                  <a:lnTo>
                    <a:pt x="484" y="50199"/>
                  </a:lnTo>
                  <a:lnTo>
                    <a:pt x="489" y="50607"/>
                  </a:lnTo>
                  <a:lnTo>
                    <a:pt x="495" y="51015"/>
                  </a:lnTo>
                  <a:lnTo>
                    <a:pt x="501" y="51423"/>
                  </a:lnTo>
                  <a:lnTo>
                    <a:pt x="506" y="51831"/>
                  </a:lnTo>
                  <a:lnTo>
                    <a:pt x="512" y="52239"/>
                  </a:lnTo>
                  <a:lnTo>
                    <a:pt x="517" y="52647"/>
                  </a:lnTo>
                  <a:lnTo>
                    <a:pt x="522" y="53055"/>
                  </a:lnTo>
                  <a:lnTo>
                    <a:pt x="527" y="53464"/>
                  </a:lnTo>
                  <a:lnTo>
                    <a:pt x="532" y="53872"/>
                  </a:lnTo>
                  <a:lnTo>
                    <a:pt x="537" y="54280"/>
                  </a:lnTo>
                  <a:lnTo>
                    <a:pt x="542" y="54688"/>
                  </a:lnTo>
                  <a:lnTo>
                    <a:pt x="547" y="55096"/>
                  </a:lnTo>
                  <a:lnTo>
                    <a:pt x="551" y="55504"/>
                  </a:lnTo>
                  <a:lnTo>
                    <a:pt x="556" y="55912"/>
                  </a:lnTo>
                  <a:lnTo>
                    <a:pt x="560" y="56320"/>
                  </a:lnTo>
                  <a:lnTo>
                    <a:pt x="564" y="56729"/>
                  </a:lnTo>
                  <a:lnTo>
                    <a:pt x="568" y="57137"/>
                  </a:lnTo>
                  <a:lnTo>
                    <a:pt x="572" y="57545"/>
                  </a:lnTo>
                  <a:lnTo>
                    <a:pt x="576" y="57953"/>
                  </a:lnTo>
                  <a:lnTo>
                    <a:pt x="580" y="58361"/>
                  </a:lnTo>
                  <a:lnTo>
                    <a:pt x="583" y="58769"/>
                  </a:lnTo>
                  <a:lnTo>
                    <a:pt x="587" y="59177"/>
                  </a:lnTo>
                  <a:lnTo>
                    <a:pt x="590" y="59585"/>
                  </a:lnTo>
                  <a:lnTo>
                    <a:pt x="593" y="59994"/>
                  </a:lnTo>
                  <a:lnTo>
                    <a:pt x="596" y="60402"/>
                  </a:lnTo>
                  <a:lnTo>
                    <a:pt x="599" y="60810"/>
                  </a:lnTo>
                  <a:lnTo>
                    <a:pt x="602" y="61218"/>
                  </a:lnTo>
                  <a:lnTo>
                    <a:pt x="605" y="61626"/>
                  </a:lnTo>
                  <a:lnTo>
                    <a:pt x="608" y="62034"/>
                  </a:lnTo>
                  <a:lnTo>
                    <a:pt x="611" y="62442"/>
                  </a:lnTo>
                  <a:lnTo>
                    <a:pt x="613" y="62850"/>
                  </a:lnTo>
                  <a:lnTo>
                    <a:pt x="616" y="63259"/>
                  </a:lnTo>
                  <a:lnTo>
                    <a:pt x="618" y="63667"/>
                  </a:lnTo>
                  <a:lnTo>
                    <a:pt x="620" y="64075"/>
                  </a:lnTo>
                  <a:lnTo>
                    <a:pt x="622" y="64483"/>
                  </a:lnTo>
                  <a:lnTo>
                    <a:pt x="624" y="64891"/>
                  </a:lnTo>
                  <a:lnTo>
                    <a:pt x="626" y="65299"/>
                  </a:lnTo>
                  <a:lnTo>
                    <a:pt x="628" y="65707"/>
                  </a:lnTo>
                  <a:lnTo>
                    <a:pt x="630" y="66115"/>
                  </a:lnTo>
                  <a:lnTo>
                    <a:pt x="632" y="66524"/>
                  </a:lnTo>
                  <a:lnTo>
                    <a:pt x="634" y="66932"/>
                  </a:lnTo>
                  <a:lnTo>
                    <a:pt x="635" y="67340"/>
                  </a:lnTo>
                  <a:lnTo>
                    <a:pt x="637" y="67748"/>
                  </a:lnTo>
                  <a:lnTo>
                    <a:pt x="639" y="68156"/>
                  </a:lnTo>
                  <a:lnTo>
                    <a:pt x="640" y="68564"/>
                  </a:lnTo>
                  <a:lnTo>
                    <a:pt x="642" y="68972"/>
                  </a:lnTo>
                  <a:lnTo>
                    <a:pt x="643" y="69380"/>
                  </a:lnTo>
                  <a:lnTo>
                    <a:pt x="644" y="69789"/>
                  </a:lnTo>
                  <a:lnTo>
                    <a:pt x="646" y="70197"/>
                  </a:lnTo>
                  <a:lnTo>
                    <a:pt x="647" y="70605"/>
                  </a:lnTo>
                  <a:lnTo>
                    <a:pt x="648" y="71013"/>
                  </a:lnTo>
                  <a:lnTo>
                    <a:pt x="650" y="71421"/>
                  </a:lnTo>
                  <a:lnTo>
                    <a:pt x="651" y="71829"/>
                  </a:lnTo>
                  <a:lnTo>
                    <a:pt x="652" y="72237"/>
                  </a:lnTo>
                  <a:lnTo>
                    <a:pt x="654" y="72645"/>
                  </a:lnTo>
                  <a:lnTo>
                    <a:pt x="655" y="73054"/>
                  </a:lnTo>
                  <a:lnTo>
                    <a:pt x="656" y="73462"/>
                  </a:lnTo>
                  <a:lnTo>
                    <a:pt x="657" y="73870"/>
                  </a:lnTo>
                  <a:lnTo>
                    <a:pt x="659" y="74278"/>
                  </a:lnTo>
                  <a:lnTo>
                    <a:pt x="660" y="74686"/>
                  </a:lnTo>
                  <a:lnTo>
                    <a:pt x="661" y="75094"/>
                  </a:lnTo>
                  <a:lnTo>
                    <a:pt x="662" y="75502"/>
                  </a:lnTo>
                  <a:lnTo>
                    <a:pt x="664" y="75910"/>
                  </a:lnTo>
                  <a:lnTo>
                    <a:pt x="665" y="76318"/>
                  </a:lnTo>
                  <a:lnTo>
                    <a:pt x="666" y="76727"/>
                  </a:lnTo>
                  <a:lnTo>
                    <a:pt x="667" y="77135"/>
                  </a:lnTo>
                  <a:lnTo>
                    <a:pt x="669" y="77543"/>
                  </a:lnTo>
                  <a:lnTo>
                    <a:pt x="670" y="77951"/>
                  </a:lnTo>
                  <a:lnTo>
                    <a:pt x="672" y="78359"/>
                  </a:lnTo>
                  <a:lnTo>
                    <a:pt x="673" y="78767"/>
                  </a:lnTo>
                  <a:lnTo>
                    <a:pt x="674" y="79175"/>
                  </a:lnTo>
                  <a:lnTo>
                    <a:pt x="676" y="79583"/>
                  </a:lnTo>
                  <a:lnTo>
                    <a:pt x="677" y="79992"/>
                  </a:lnTo>
                  <a:lnTo>
                    <a:pt x="679" y="80400"/>
                  </a:lnTo>
                  <a:lnTo>
                    <a:pt x="680" y="80808"/>
                  </a:lnTo>
                  <a:lnTo>
                    <a:pt x="682" y="81216"/>
                  </a:lnTo>
                  <a:lnTo>
                    <a:pt x="683" y="81624"/>
                  </a:lnTo>
                  <a:lnTo>
                    <a:pt x="685" y="82032"/>
                  </a:lnTo>
                  <a:lnTo>
                    <a:pt x="686" y="82440"/>
                  </a:lnTo>
                  <a:lnTo>
                    <a:pt x="688" y="82848"/>
                  </a:lnTo>
                  <a:lnTo>
                    <a:pt x="690" y="83257"/>
                  </a:lnTo>
                  <a:lnTo>
                    <a:pt x="691" y="83665"/>
                  </a:lnTo>
                  <a:lnTo>
                    <a:pt x="693" y="84073"/>
                  </a:lnTo>
                  <a:lnTo>
                    <a:pt x="694" y="84481"/>
                  </a:lnTo>
                  <a:lnTo>
                    <a:pt x="696" y="84889"/>
                  </a:lnTo>
                  <a:lnTo>
                    <a:pt x="698" y="85297"/>
                  </a:lnTo>
                  <a:lnTo>
                    <a:pt x="699" y="85705"/>
                  </a:lnTo>
                  <a:lnTo>
                    <a:pt x="701" y="86113"/>
                  </a:lnTo>
                  <a:lnTo>
                    <a:pt x="702" y="86522"/>
                  </a:lnTo>
                  <a:lnTo>
                    <a:pt x="704" y="86930"/>
                  </a:lnTo>
                  <a:lnTo>
                    <a:pt x="705" y="87338"/>
                  </a:lnTo>
                  <a:lnTo>
                    <a:pt x="707" y="87746"/>
                  </a:lnTo>
                  <a:lnTo>
                    <a:pt x="708" y="88154"/>
                  </a:lnTo>
                  <a:lnTo>
                    <a:pt x="710" y="88562"/>
                  </a:lnTo>
                  <a:lnTo>
                    <a:pt x="711" y="88970"/>
                  </a:lnTo>
                  <a:lnTo>
                    <a:pt x="712" y="89378"/>
                  </a:lnTo>
                  <a:lnTo>
                    <a:pt x="713" y="89787"/>
                  </a:lnTo>
                  <a:lnTo>
                    <a:pt x="714" y="90195"/>
                  </a:lnTo>
                  <a:lnTo>
                    <a:pt x="715" y="90603"/>
                  </a:lnTo>
                  <a:lnTo>
                    <a:pt x="716" y="91011"/>
                  </a:lnTo>
                  <a:lnTo>
                    <a:pt x="717" y="91419"/>
                  </a:lnTo>
                  <a:lnTo>
                    <a:pt x="718" y="91827"/>
                  </a:lnTo>
                  <a:lnTo>
                    <a:pt x="719" y="92235"/>
                  </a:lnTo>
                  <a:lnTo>
                    <a:pt x="719" y="92643"/>
                  </a:lnTo>
                  <a:lnTo>
                    <a:pt x="720" y="93052"/>
                  </a:lnTo>
                  <a:lnTo>
                    <a:pt x="720" y="93460"/>
                  </a:lnTo>
                  <a:lnTo>
                    <a:pt x="721" y="93868"/>
                  </a:lnTo>
                  <a:lnTo>
                    <a:pt x="721" y="94276"/>
                  </a:lnTo>
                  <a:lnTo>
                    <a:pt x="721" y="94684"/>
                  </a:lnTo>
                  <a:lnTo>
                    <a:pt x="721" y="95092"/>
                  </a:lnTo>
                  <a:lnTo>
                    <a:pt x="720" y="95500"/>
                  </a:lnTo>
                  <a:lnTo>
                    <a:pt x="720" y="95908"/>
                  </a:lnTo>
                  <a:lnTo>
                    <a:pt x="719" y="96317"/>
                  </a:lnTo>
                  <a:lnTo>
                    <a:pt x="719" y="96725"/>
                  </a:lnTo>
                  <a:lnTo>
                    <a:pt x="718" y="97133"/>
                  </a:lnTo>
                  <a:lnTo>
                    <a:pt x="717" y="97541"/>
                  </a:lnTo>
                  <a:lnTo>
                    <a:pt x="715" y="97949"/>
                  </a:lnTo>
                  <a:lnTo>
                    <a:pt x="714" y="98357"/>
                  </a:lnTo>
                  <a:lnTo>
                    <a:pt x="712" y="98765"/>
                  </a:lnTo>
                  <a:lnTo>
                    <a:pt x="711" y="99173"/>
                  </a:lnTo>
                  <a:lnTo>
                    <a:pt x="709" y="99581"/>
                  </a:lnTo>
                  <a:lnTo>
                    <a:pt x="706" y="99990"/>
                  </a:lnTo>
                  <a:lnTo>
                    <a:pt x="704" y="100398"/>
                  </a:lnTo>
                  <a:lnTo>
                    <a:pt x="702" y="100806"/>
                  </a:lnTo>
                  <a:lnTo>
                    <a:pt x="699" y="101214"/>
                  </a:lnTo>
                  <a:lnTo>
                    <a:pt x="696" y="101622"/>
                  </a:lnTo>
                  <a:lnTo>
                    <a:pt x="693" y="102030"/>
                  </a:lnTo>
                  <a:lnTo>
                    <a:pt x="689" y="102438"/>
                  </a:lnTo>
                  <a:lnTo>
                    <a:pt x="686" y="102846"/>
                  </a:lnTo>
                  <a:lnTo>
                    <a:pt x="682" y="103255"/>
                  </a:lnTo>
                  <a:lnTo>
                    <a:pt x="678" y="103663"/>
                  </a:lnTo>
                  <a:lnTo>
                    <a:pt x="674" y="104071"/>
                  </a:lnTo>
                  <a:lnTo>
                    <a:pt x="670" y="104479"/>
                  </a:lnTo>
                  <a:lnTo>
                    <a:pt x="665" y="104887"/>
                  </a:lnTo>
                  <a:lnTo>
                    <a:pt x="661" y="105295"/>
                  </a:lnTo>
                  <a:lnTo>
                    <a:pt x="656" y="105703"/>
                  </a:lnTo>
                  <a:lnTo>
                    <a:pt x="651" y="106111"/>
                  </a:lnTo>
                  <a:lnTo>
                    <a:pt x="646" y="106520"/>
                  </a:lnTo>
                  <a:lnTo>
                    <a:pt x="640" y="106928"/>
                  </a:lnTo>
                  <a:lnTo>
                    <a:pt x="635" y="107336"/>
                  </a:lnTo>
                  <a:lnTo>
                    <a:pt x="629" y="107744"/>
                  </a:lnTo>
                  <a:lnTo>
                    <a:pt x="623" y="108152"/>
                  </a:lnTo>
                  <a:lnTo>
                    <a:pt x="617" y="108560"/>
                  </a:lnTo>
                  <a:lnTo>
                    <a:pt x="611" y="108968"/>
                  </a:lnTo>
                  <a:lnTo>
                    <a:pt x="605" y="109376"/>
                  </a:lnTo>
                  <a:lnTo>
                    <a:pt x="598" y="109785"/>
                  </a:lnTo>
                  <a:lnTo>
                    <a:pt x="592" y="110193"/>
                  </a:lnTo>
                  <a:lnTo>
                    <a:pt x="585" y="110601"/>
                  </a:lnTo>
                  <a:lnTo>
                    <a:pt x="578" y="111009"/>
                  </a:lnTo>
                  <a:lnTo>
                    <a:pt x="571" y="111417"/>
                  </a:lnTo>
                  <a:lnTo>
                    <a:pt x="564" y="111825"/>
                  </a:lnTo>
                  <a:lnTo>
                    <a:pt x="557" y="112233"/>
                  </a:lnTo>
                  <a:lnTo>
                    <a:pt x="550" y="112641"/>
                  </a:lnTo>
                  <a:lnTo>
                    <a:pt x="543" y="113050"/>
                  </a:lnTo>
                  <a:lnTo>
                    <a:pt x="535" y="113458"/>
                  </a:lnTo>
                  <a:lnTo>
                    <a:pt x="528" y="113866"/>
                  </a:lnTo>
                  <a:lnTo>
                    <a:pt x="520" y="114274"/>
                  </a:lnTo>
                  <a:lnTo>
                    <a:pt x="513" y="114682"/>
                  </a:lnTo>
                  <a:lnTo>
                    <a:pt x="505" y="115090"/>
                  </a:lnTo>
                  <a:lnTo>
                    <a:pt x="498" y="115498"/>
                  </a:lnTo>
                  <a:lnTo>
                    <a:pt x="490" y="115906"/>
                  </a:lnTo>
                  <a:lnTo>
                    <a:pt x="483" y="116315"/>
                  </a:lnTo>
                  <a:lnTo>
                    <a:pt x="475" y="116723"/>
                  </a:lnTo>
                  <a:lnTo>
                    <a:pt x="468" y="117131"/>
                  </a:lnTo>
                  <a:lnTo>
                    <a:pt x="460" y="117539"/>
                  </a:lnTo>
                  <a:lnTo>
                    <a:pt x="453" y="117947"/>
                  </a:lnTo>
                  <a:lnTo>
                    <a:pt x="445" y="118355"/>
                  </a:lnTo>
                  <a:lnTo>
                    <a:pt x="438" y="118763"/>
                  </a:lnTo>
                  <a:lnTo>
                    <a:pt x="431" y="119171"/>
                  </a:lnTo>
                  <a:lnTo>
                    <a:pt x="424" y="119580"/>
                  </a:lnTo>
                  <a:lnTo>
                    <a:pt x="417" y="119988"/>
                  </a:lnTo>
                  <a:lnTo>
                    <a:pt x="409" y="120396"/>
                  </a:lnTo>
                  <a:lnTo>
                    <a:pt x="403" y="120804"/>
                  </a:lnTo>
                  <a:lnTo>
                    <a:pt x="396" y="121212"/>
                  </a:lnTo>
                  <a:lnTo>
                    <a:pt x="389" y="121620"/>
                  </a:lnTo>
                  <a:lnTo>
                    <a:pt x="382" y="122028"/>
                  </a:lnTo>
                  <a:lnTo>
                    <a:pt x="376" y="122436"/>
                  </a:lnTo>
                  <a:lnTo>
                    <a:pt x="370" y="122844"/>
                  </a:lnTo>
                  <a:lnTo>
                    <a:pt x="363" y="123253"/>
                  </a:lnTo>
                  <a:lnTo>
                    <a:pt x="357" y="123661"/>
                  </a:lnTo>
                  <a:lnTo>
                    <a:pt x="352" y="124069"/>
                  </a:lnTo>
                  <a:lnTo>
                    <a:pt x="346" y="124477"/>
                  </a:lnTo>
                  <a:lnTo>
                    <a:pt x="340" y="124885"/>
                  </a:lnTo>
                  <a:lnTo>
                    <a:pt x="335" y="125293"/>
                  </a:lnTo>
                  <a:lnTo>
                    <a:pt x="330" y="125701"/>
                  </a:lnTo>
                  <a:lnTo>
                    <a:pt x="325" y="126109"/>
                  </a:lnTo>
                  <a:lnTo>
                    <a:pt x="320" y="126518"/>
                  </a:lnTo>
                  <a:lnTo>
                    <a:pt x="315" y="126926"/>
                  </a:lnTo>
                  <a:lnTo>
                    <a:pt x="311" y="127334"/>
                  </a:lnTo>
                  <a:lnTo>
                    <a:pt x="307" y="127742"/>
                  </a:lnTo>
                  <a:lnTo>
                    <a:pt x="303" y="128150"/>
                  </a:lnTo>
                  <a:lnTo>
                    <a:pt x="299" y="128558"/>
                  </a:lnTo>
                  <a:lnTo>
                    <a:pt x="295" y="128966"/>
                  </a:lnTo>
                  <a:lnTo>
                    <a:pt x="292" y="129374"/>
                  </a:lnTo>
                  <a:lnTo>
                    <a:pt x="289" y="129783"/>
                  </a:lnTo>
                  <a:lnTo>
                    <a:pt x="286" y="130191"/>
                  </a:lnTo>
                  <a:lnTo>
                    <a:pt x="283" y="130599"/>
                  </a:lnTo>
                  <a:lnTo>
                    <a:pt x="281" y="131007"/>
                  </a:lnTo>
                  <a:lnTo>
                    <a:pt x="278" y="131415"/>
                  </a:lnTo>
                  <a:lnTo>
                    <a:pt x="276" y="131823"/>
                  </a:lnTo>
                  <a:lnTo>
                    <a:pt x="274" y="132231"/>
                  </a:lnTo>
                  <a:lnTo>
                    <a:pt x="273" y="132639"/>
                  </a:lnTo>
                  <a:lnTo>
                    <a:pt x="271" y="133048"/>
                  </a:lnTo>
                  <a:lnTo>
                    <a:pt x="270" y="133456"/>
                  </a:lnTo>
                  <a:lnTo>
                    <a:pt x="269" y="133864"/>
                  </a:lnTo>
                  <a:lnTo>
                    <a:pt x="268" y="134272"/>
                  </a:lnTo>
                  <a:lnTo>
                    <a:pt x="267" y="134680"/>
                  </a:lnTo>
                  <a:lnTo>
                    <a:pt x="267" y="135088"/>
                  </a:lnTo>
                  <a:lnTo>
                    <a:pt x="266" y="135496"/>
                  </a:lnTo>
                  <a:lnTo>
                    <a:pt x="266" y="135904"/>
                  </a:lnTo>
                  <a:lnTo>
                    <a:pt x="266" y="136313"/>
                  </a:lnTo>
                  <a:lnTo>
                    <a:pt x="266" y="136721"/>
                  </a:lnTo>
                  <a:lnTo>
                    <a:pt x="267" y="137129"/>
                  </a:lnTo>
                  <a:lnTo>
                    <a:pt x="267" y="137537"/>
                  </a:lnTo>
                  <a:lnTo>
                    <a:pt x="268" y="137945"/>
                  </a:lnTo>
                  <a:lnTo>
                    <a:pt x="269" y="138353"/>
                  </a:lnTo>
                  <a:lnTo>
                    <a:pt x="270" y="138761"/>
                  </a:lnTo>
                  <a:lnTo>
                    <a:pt x="271" y="139169"/>
                  </a:lnTo>
                  <a:lnTo>
                    <a:pt x="272" y="139578"/>
                  </a:lnTo>
                  <a:lnTo>
                    <a:pt x="273" y="139986"/>
                  </a:lnTo>
                  <a:lnTo>
                    <a:pt x="274" y="140394"/>
                  </a:lnTo>
                  <a:lnTo>
                    <a:pt x="276" y="140802"/>
                  </a:lnTo>
                  <a:lnTo>
                    <a:pt x="278" y="141210"/>
                  </a:lnTo>
                  <a:lnTo>
                    <a:pt x="279" y="141618"/>
                  </a:lnTo>
                  <a:lnTo>
                    <a:pt x="281" y="142026"/>
                  </a:lnTo>
                  <a:lnTo>
                    <a:pt x="283" y="142434"/>
                  </a:lnTo>
                  <a:lnTo>
                    <a:pt x="285" y="142843"/>
                  </a:lnTo>
                  <a:lnTo>
                    <a:pt x="287" y="143251"/>
                  </a:lnTo>
                  <a:lnTo>
                    <a:pt x="289" y="143659"/>
                  </a:lnTo>
                  <a:lnTo>
                    <a:pt x="291" y="144067"/>
                  </a:lnTo>
                  <a:lnTo>
                    <a:pt x="293" y="144475"/>
                  </a:lnTo>
                  <a:lnTo>
                    <a:pt x="295" y="144883"/>
                  </a:lnTo>
                  <a:lnTo>
                    <a:pt x="297" y="145291"/>
                  </a:lnTo>
                  <a:lnTo>
                    <a:pt x="299" y="145699"/>
                  </a:lnTo>
                  <a:lnTo>
                    <a:pt x="301" y="146108"/>
                  </a:lnTo>
                  <a:lnTo>
                    <a:pt x="303" y="146516"/>
                  </a:lnTo>
                  <a:lnTo>
                    <a:pt x="305" y="146924"/>
                  </a:lnTo>
                  <a:lnTo>
                    <a:pt x="307" y="147332"/>
                  </a:lnTo>
                  <a:lnTo>
                    <a:pt x="309" y="147740"/>
                  </a:lnTo>
                  <a:lnTo>
                    <a:pt x="311" y="148148"/>
                  </a:lnTo>
                  <a:lnTo>
                    <a:pt x="313" y="148556"/>
                  </a:lnTo>
                  <a:lnTo>
                    <a:pt x="315" y="148964"/>
                  </a:lnTo>
                  <a:lnTo>
                    <a:pt x="317" y="149372"/>
                  </a:lnTo>
                  <a:lnTo>
                    <a:pt x="318" y="149781"/>
                  </a:lnTo>
                  <a:lnTo>
                    <a:pt x="320" y="150189"/>
                  </a:lnTo>
                  <a:lnTo>
                    <a:pt x="321" y="150597"/>
                  </a:lnTo>
                  <a:lnTo>
                    <a:pt x="323" y="151005"/>
                  </a:lnTo>
                  <a:lnTo>
                    <a:pt x="324" y="151413"/>
                  </a:lnTo>
                  <a:lnTo>
                    <a:pt x="325" y="151821"/>
                  </a:lnTo>
                  <a:lnTo>
                    <a:pt x="326" y="152229"/>
                  </a:lnTo>
                  <a:lnTo>
                    <a:pt x="327" y="152637"/>
                  </a:lnTo>
                  <a:lnTo>
                    <a:pt x="328" y="153046"/>
                  </a:lnTo>
                  <a:lnTo>
                    <a:pt x="329" y="153454"/>
                  </a:lnTo>
                  <a:lnTo>
                    <a:pt x="329" y="153862"/>
                  </a:lnTo>
                  <a:lnTo>
                    <a:pt x="330" y="154270"/>
                  </a:lnTo>
                  <a:lnTo>
                    <a:pt x="330" y="154678"/>
                  </a:lnTo>
                  <a:lnTo>
                    <a:pt x="330" y="155086"/>
                  </a:lnTo>
                  <a:lnTo>
                    <a:pt x="330" y="155494"/>
                  </a:lnTo>
                  <a:lnTo>
                    <a:pt x="330" y="155902"/>
                  </a:lnTo>
                  <a:lnTo>
                    <a:pt x="330" y="156311"/>
                  </a:lnTo>
                  <a:lnTo>
                    <a:pt x="329" y="156719"/>
                  </a:lnTo>
                  <a:lnTo>
                    <a:pt x="329" y="157127"/>
                  </a:lnTo>
                  <a:lnTo>
                    <a:pt x="328" y="157535"/>
                  </a:lnTo>
                  <a:lnTo>
                    <a:pt x="327" y="157943"/>
                  </a:lnTo>
                  <a:lnTo>
                    <a:pt x="326" y="158351"/>
                  </a:lnTo>
                  <a:lnTo>
                    <a:pt x="325" y="158759"/>
                  </a:lnTo>
                  <a:lnTo>
                    <a:pt x="323" y="159167"/>
                  </a:lnTo>
                  <a:lnTo>
                    <a:pt x="322" y="159576"/>
                  </a:lnTo>
                  <a:lnTo>
                    <a:pt x="320" y="159984"/>
                  </a:lnTo>
                  <a:lnTo>
                    <a:pt x="318" y="160392"/>
                  </a:lnTo>
                  <a:lnTo>
                    <a:pt x="316" y="160800"/>
                  </a:lnTo>
                  <a:lnTo>
                    <a:pt x="314" y="161208"/>
                  </a:lnTo>
                  <a:lnTo>
                    <a:pt x="312" y="161616"/>
                  </a:lnTo>
                  <a:lnTo>
                    <a:pt x="310" y="162024"/>
                  </a:lnTo>
                  <a:lnTo>
                    <a:pt x="307" y="162432"/>
                  </a:lnTo>
                  <a:lnTo>
                    <a:pt x="304" y="162841"/>
                  </a:lnTo>
                  <a:lnTo>
                    <a:pt x="302" y="163249"/>
                  </a:lnTo>
                  <a:lnTo>
                    <a:pt x="299" y="163657"/>
                  </a:lnTo>
                  <a:lnTo>
                    <a:pt x="296" y="164065"/>
                  </a:lnTo>
                  <a:lnTo>
                    <a:pt x="292" y="164473"/>
                  </a:lnTo>
                  <a:lnTo>
                    <a:pt x="289" y="164881"/>
                  </a:lnTo>
                  <a:lnTo>
                    <a:pt x="286" y="165289"/>
                  </a:lnTo>
                  <a:lnTo>
                    <a:pt x="282" y="165697"/>
                  </a:lnTo>
                  <a:lnTo>
                    <a:pt x="279" y="166106"/>
                  </a:lnTo>
                  <a:lnTo>
                    <a:pt x="275" y="166514"/>
                  </a:lnTo>
                  <a:lnTo>
                    <a:pt x="271" y="166922"/>
                  </a:lnTo>
                  <a:lnTo>
                    <a:pt x="267" y="167330"/>
                  </a:lnTo>
                  <a:lnTo>
                    <a:pt x="263" y="167738"/>
                  </a:lnTo>
                  <a:lnTo>
                    <a:pt x="259" y="168146"/>
                  </a:lnTo>
                  <a:lnTo>
                    <a:pt x="255" y="168554"/>
                  </a:lnTo>
                  <a:lnTo>
                    <a:pt x="251" y="168962"/>
                  </a:lnTo>
                  <a:lnTo>
                    <a:pt x="246" y="169371"/>
                  </a:lnTo>
                  <a:lnTo>
                    <a:pt x="242" y="169779"/>
                  </a:lnTo>
                  <a:lnTo>
                    <a:pt x="237" y="170187"/>
                  </a:lnTo>
                  <a:lnTo>
                    <a:pt x="233" y="170595"/>
                  </a:lnTo>
                  <a:lnTo>
                    <a:pt x="229" y="171003"/>
                  </a:lnTo>
                  <a:lnTo>
                    <a:pt x="224" y="171411"/>
                  </a:lnTo>
                  <a:lnTo>
                    <a:pt x="219" y="171819"/>
                  </a:lnTo>
                  <a:lnTo>
                    <a:pt x="215" y="172227"/>
                  </a:lnTo>
                  <a:lnTo>
                    <a:pt x="210" y="172635"/>
                  </a:lnTo>
                  <a:lnTo>
                    <a:pt x="206" y="173044"/>
                  </a:lnTo>
                  <a:lnTo>
                    <a:pt x="201" y="173452"/>
                  </a:lnTo>
                  <a:lnTo>
                    <a:pt x="196" y="173860"/>
                  </a:lnTo>
                  <a:lnTo>
                    <a:pt x="192" y="174268"/>
                  </a:lnTo>
                  <a:lnTo>
                    <a:pt x="187" y="174676"/>
                  </a:lnTo>
                  <a:lnTo>
                    <a:pt x="183" y="175084"/>
                  </a:lnTo>
                  <a:lnTo>
                    <a:pt x="178" y="175492"/>
                  </a:lnTo>
                  <a:lnTo>
                    <a:pt x="173" y="175900"/>
                  </a:lnTo>
                  <a:lnTo>
                    <a:pt x="169" y="176309"/>
                  </a:lnTo>
                  <a:lnTo>
                    <a:pt x="164" y="176717"/>
                  </a:lnTo>
                  <a:lnTo>
                    <a:pt x="160" y="177125"/>
                  </a:lnTo>
                  <a:lnTo>
                    <a:pt x="155" y="177533"/>
                  </a:lnTo>
                  <a:lnTo>
                    <a:pt x="151" y="177941"/>
                  </a:lnTo>
                  <a:lnTo>
                    <a:pt x="147" y="178349"/>
                  </a:lnTo>
                  <a:lnTo>
                    <a:pt x="142" y="178757"/>
                  </a:lnTo>
                  <a:lnTo>
                    <a:pt x="138" y="179165"/>
                  </a:lnTo>
                  <a:lnTo>
                    <a:pt x="134" y="179574"/>
                  </a:lnTo>
                  <a:lnTo>
                    <a:pt x="130" y="179982"/>
                  </a:lnTo>
                  <a:lnTo>
                    <a:pt x="125" y="180390"/>
                  </a:lnTo>
                  <a:lnTo>
                    <a:pt x="121" y="180798"/>
                  </a:lnTo>
                  <a:lnTo>
                    <a:pt x="117" y="181206"/>
                  </a:lnTo>
                  <a:lnTo>
                    <a:pt x="114" y="181614"/>
                  </a:lnTo>
                  <a:lnTo>
                    <a:pt x="110" y="182022"/>
                  </a:lnTo>
                  <a:lnTo>
                    <a:pt x="106" y="182430"/>
                  </a:lnTo>
                  <a:lnTo>
                    <a:pt x="102" y="182839"/>
                  </a:lnTo>
                  <a:lnTo>
                    <a:pt x="99" y="183247"/>
                  </a:lnTo>
                  <a:lnTo>
                    <a:pt x="95" y="183655"/>
                  </a:lnTo>
                  <a:lnTo>
                    <a:pt x="92" y="184063"/>
                  </a:lnTo>
                  <a:lnTo>
                    <a:pt x="88" y="184471"/>
                  </a:lnTo>
                  <a:lnTo>
                    <a:pt x="85" y="184879"/>
                  </a:lnTo>
                  <a:lnTo>
                    <a:pt x="82" y="185287"/>
                  </a:lnTo>
                  <a:lnTo>
                    <a:pt x="78" y="185695"/>
                  </a:lnTo>
                  <a:lnTo>
                    <a:pt x="75" y="186104"/>
                  </a:lnTo>
                  <a:lnTo>
                    <a:pt x="72" y="186512"/>
                  </a:lnTo>
                  <a:lnTo>
                    <a:pt x="69" y="186920"/>
                  </a:lnTo>
                  <a:lnTo>
                    <a:pt x="67" y="187328"/>
                  </a:lnTo>
                  <a:lnTo>
                    <a:pt x="64" y="187736"/>
                  </a:lnTo>
                  <a:lnTo>
                    <a:pt x="61" y="188144"/>
                  </a:lnTo>
                  <a:lnTo>
                    <a:pt x="59" y="188552"/>
                  </a:lnTo>
                  <a:lnTo>
                    <a:pt x="56" y="188960"/>
                  </a:lnTo>
                  <a:lnTo>
                    <a:pt x="54" y="189369"/>
                  </a:lnTo>
                  <a:lnTo>
                    <a:pt x="51" y="189777"/>
                  </a:lnTo>
                  <a:lnTo>
                    <a:pt x="49" y="190185"/>
                  </a:lnTo>
                  <a:lnTo>
                    <a:pt x="47" y="190593"/>
                  </a:lnTo>
                  <a:lnTo>
                    <a:pt x="45" y="191001"/>
                  </a:lnTo>
                  <a:lnTo>
                    <a:pt x="43" y="191409"/>
                  </a:lnTo>
                  <a:lnTo>
                    <a:pt x="41" y="191817"/>
                  </a:lnTo>
                  <a:lnTo>
                    <a:pt x="39" y="192225"/>
                  </a:lnTo>
                  <a:lnTo>
                    <a:pt x="37" y="192634"/>
                  </a:lnTo>
                  <a:lnTo>
                    <a:pt x="35" y="193042"/>
                  </a:lnTo>
                  <a:lnTo>
                    <a:pt x="33" y="193450"/>
                  </a:lnTo>
                  <a:lnTo>
                    <a:pt x="32" y="193858"/>
                  </a:lnTo>
                  <a:lnTo>
                    <a:pt x="30" y="194266"/>
                  </a:lnTo>
                  <a:lnTo>
                    <a:pt x="28" y="194674"/>
                  </a:lnTo>
                  <a:lnTo>
                    <a:pt x="27" y="195082"/>
                  </a:lnTo>
                  <a:lnTo>
                    <a:pt x="26" y="195490"/>
                  </a:lnTo>
                  <a:lnTo>
                    <a:pt x="24" y="195899"/>
                  </a:lnTo>
                  <a:lnTo>
                    <a:pt x="23" y="196307"/>
                  </a:lnTo>
                  <a:lnTo>
                    <a:pt x="22" y="196715"/>
                  </a:lnTo>
                  <a:lnTo>
                    <a:pt x="21" y="197123"/>
                  </a:lnTo>
                  <a:lnTo>
                    <a:pt x="19" y="197531"/>
                  </a:lnTo>
                  <a:lnTo>
                    <a:pt x="18" y="197939"/>
                  </a:lnTo>
                  <a:lnTo>
                    <a:pt x="17" y="198347"/>
                  </a:lnTo>
                  <a:lnTo>
                    <a:pt x="16" y="198755"/>
                  </a:lnTo>
                  <a:lnTo>
                    <a:pt x="15" y="199163"/>
                  </a:lnTo>
                  <a:lnTo>
                    <a:pt x="14" y="199572"/>
                  </a:lnTo>
                  <a:lnTo>
                    <a:pt x="14" y="199980"/>
                  </a:lnTo>
                  <a:lnTo>
                    <a:pt x="13" y="200388"/>
                  </a:lnTo>
                  <a:lnTo>
                    <a:pt x="12" y="200796"/>
                  </a:lnTo>
                  <a:lnTo>
                    <a:pt x="11" y="201204"/>
                  </a:lnTo>
                  <a:lnTo>
                    <a:pt x="11" y="201612"/>
                  </a:lnTo>
                  <a:lnTo>
                    <a:pt x="10" y="202020"/>
                  </a:lnTo>
                  <a:lnTo>
                    <a:pt x="9" y="202428"/>
                  </a:lnTo>
                  <a:lnTo>
                    <a:pt x="9" y="202837"/>
                  </a:lnTo>
                  <a:lnTo>
                    <a:pt x="8" y="203245"/>
                  </a:lnTo>
                  <a:lnTo>
                    <a:pt x="8" y="203653"/>
                  </a:lnTo>
                  <a:lnTo>
                    <a:pt x="7" y="204061"/>
                  </a:lnTo>
                  <a:lnTo>
                    <a:pt x="7" y="204469"/>
                  </a:lnTo>
                  <a:lnTo>
                    <a:pt x="6" y="204877"/>
                  </a:lnTo>
                  <a:lnTo>
                    <a:pt x="6" y="205285"/>
                  </a:lnTo>
                  <a:lnTo>
                    <a:pt x="5" y="205693"/>
                  </a:lnTo>
                  <a:lnTo>
                    <a:pt x="5" y="206102"/>
                  </a:lnTo>
                  <a:lnTo>
                    <a:pt x="5" y="206510"/>
                  </a:lnTo>
                  <a:lnTo>
                    <a:pt x="4" y="206918"/>
                  </a:lnTo>
                  <a:lnTo>
                    <a:pt x="4" y="207326"/>
                  </a:lnTo>
                  <a:lnTo>
                    <a:pt x="4" y="207734"/>
                  </a:lnTo>
                  <a:lnTo>
                    <a:pt x="3" y="208142"/>
                  </a:lnTo>
                  <a:lnTo>
                    <a:pt x="3" y="208550"/>
                  </a:lnTo>
                  <a:lnTo>
                    <a:pt x="0" y="208550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50" name="pl32"/>
            <p:cNvSpPr/>
            <p:nvPr/>
          </p:nvSpPr>
          <p:spPr>
            <a:xfrm>
              <a:off x="4440369" y="3671008"/>
              <a:ext cx="767" cy="182067"/>
            </a:xfrm>
            <a:custGeom>
              <a:avLst/>
              <a:gdLst/>
              <a:ahLst/>
              <a:cxnLst/>
              <a:rect l="0" t="0" r="0" b="0"/>
              <a:pathLst>
                <a:path w="767" h="182067">
                  <a:moveTo>
                    <a:pt x="767" y="182067"/>
                  </a:moveTo>
                  <a:lnTo>
                    <a:pt x="760" y="182067"/>
                  </a:lnTo>
                  <a:lnTo>
                    <a:pt x="759" y="181711"/>
                  </a:lnTo>
                  <a:lnTo>
                    <a:pt x="759" y="181354"/>
                  </a:lnTo>
                  <a:lnTo>
                    <a:pt x="758" y="180998"/>
                  </a:lnTo>
                  <a:lnTo>
                    <a:pt x="758" y="180642"/>
                  </a:lnTo>
                  <a:lnTo>
                    <a:pt x="757" y="180286"/>
                  </a:lnTo>
                  <a:lnTo>
                    <a:pt x="757" y="179929"/>
                  </a:lnTo>
                  <a:lnTo>
                    <a:pt x="756" y="179573"/>
                  </a:lnTo>
                  <a:lnTo>
                    <a:pt x="755" y="179217"/>
                  </a:lnTo>
                  <a:lnTo>
                    <a:pt x="755" y="178860"/>
                  </a:lnTo>
                  <a:lnTo>
                    <a:pt x="754" y="178504"/>
                  </a:lnTo>
                  <a:lnTo>
                    <a:pt x="753" y="178148"/>
                  </a:lnTo>
                  <a:lnTo>
                    <a:pt x="753" y="177791"/>
                  </a:lnTo>
                  <a:lnTo>
                    <a:pt x="752" y="177435"/>
                  </a:lnTo>
                  <a:lnTo>
                    <a:pt x="751" y="177079"/>
                  </a:lnTo>
                  <a:lnTo>
                    <a:pt x="750" y="176723"/>
                  </a:lnTo>
                  <a:lnTo>
                    <a:pt x="749" y="176366"/>
                  </a:lnTo>
                  <a:lnTo>
                    <a:pt x="748" y="176010"/>
                  </a:lnTo>
                  <a:lnTo>
                    <a:pt x="747" y="175654"/>
                  </a:lnTo>
                  <a:lnTo>
                    <a:pt x="746" y="175297"/>
                  </a:lnTo>
                  <a:lnTo>
                    <a:pt x="745" y="174941"/>
                  </a:lnTo>
                  <a:lnTo>
                    <a:pt x="744" y="174585"/>
                  </a:lnTo>
                  <a:lnTo>
                    <a:pt x="743" y="174228"/>
                  </a:lnTo>
                  <a:lnTo>
                    <a:pt x="741" y="173872"/>
                  </a:lnTo>
                  <a:lnTo>
                    <a:pt x="740" y="173516"/>
                  </a:lnTo>
                  <a:lnTo>
                    <a:pt x="739" y="173160"/>
                  </a:lnTo>
                  <a:lnTo>
                    <a:pt x="737" y="172803"/>
                  </a:lnTo>
                  <a:lnTo>
                    <a:pt x="736" y="172447"/>
                  </a:lnTo>
                  <a:lnTo>
                    <a:pt x="734" y="172091"/>
                  </a:lnTo>
                  <a:lnTo>
                    <a:pt x="733" y="171734"/>
                  </a:lnTo>
                  <a:lnTo>
                    <a:pt x="731" y="171378"/>
                  </a:lnTo>
                  <a:lnTo>
                    <a:pt x="729" y="171022"/>
                  </a:lnTo>
                  <a:lnTo>
                    <a:pt x="727" y="170666"/>
                  </a:lnTo>
                  <a:lnTo>
                    <a:pt x="725" y="170309"/>
                  </a:lnTo>
                  <a:lnTo>
                    <a:pt x="724" y="169953"/>
                  </a:lnTo>
                  <a:lnTo>
                    <a:pt x="721" y="169597"/>
                  </a:lnTo>
                  <a:lnTo>
                    <a:pt x="719" y="169240"/>
                  </a:lnTo>
                  <a:lnTo>
                    <a:pt x="717" y="168884"/>
                  </a:lnTo>
                  <a:lnTo>
                    <a:pt x="715" y="168528"/>
                  </a:lnTo>
                  <a:lnTo>
                    <a:pt x="712" y="168171"/>
                  </a:lnTo>
                  <a:lnTo>
                    <a:pt x="710" y="167815"/>
                  </a:lnTo>
                  <a:lnTo>
                    <a:pt x="707" y="167459"/>
                  </a:lnTo>
                  <a:lnTo>
                    <a:pt x="705" y="167103"/>
                  </a:lnTo>
                  <a:lnTo>
                    <a:pt x="702" y="166746"/>
                  </a:lnTo>
                  <a:lnTo>
                    <a:pt x="699" y="166390"/>
                  </a:lnTo>
                  <a:lnTo>
                    <a:pt x="696" y="166034"/>
                  </a:lnTo>
                  <a:lnTo>
                    <a:pt x="693" y="165677"/>
                  </a:lnTo>
                  <a:lnTo>
                    <a:pt x="690" y="165321"/>
                  </a:lnTo>
                  <a:lnTo>
                    <a:pt x="687" y="164965"/>
                  </a:lnTo>
                  <a:lnTo>
                    <a:pt x="684" y="164608"/>
                  </a:lnTo>
                  <a:lnTo>
                    <a:pt x="680" y="164252"/>
                  </a:lnTo>
                  <a:lnTo>
                    <a:pt x="677" y="163896"/>
                  </a:lnTo>
                  <a:lnTo>
                    <a:pt x="673" y="163540"/>
                  </a:lnTo>
                  <a:lnTo>
                    <a:pt x="669" y="163183"/>
                  </a:lnTo>
                  <a:lnTo>
                    <a:pt x="666" y="162827"/>
                  </a:lnTo>
                  <a:lnTo>
                    <a:pt x="662" y="162471"/>
                  </a:lnTo>
                  <a:lnTo>
                    <a:pt x="658" y="162114"/>
                  </a:lnTo>
                  <a:lnTo>
                    <a:pt x="653" y="161758"/>
                  </a:lnTo>
                  <a:lnTo>
                    <a:pt x="649" y="161402"/>
                  </a:lnTo>
                  <a:lnTo>
                    <a:pt x="645" y="161046"/>
                  </a:lnTo>
                  <a:lnTo>
                    <a:pt x="640" y="160689"/>
                  </a:lnTo>
                  <a:lnTo>
                    <a:pt x="636" y="160333"/>
                  </a:lnTo>
                  <a:lnTo>
                    <a:pt x="631" y="159977"/>
                  </a:lnTo>
                  <a:lnTo>
                    <a:pt x="626" y="159620"/>
                  </a:lnTo>
                  <a:lnTo>
                    <a:pt x="621" y="159264"/>
                  </a:lnTo>
                  <a:lnTo>
                    <a:pt x="616" y="158908"/>
                  </a:lnTo>
                  <a:lnTo>
                    <a:pt x="611" y="158551"/>
                  </a:lnTo>
                  <a:lnTo>
                    <a:pt x="605" y="158195"/>
                  </a:lnTo>
                  <a:lnTo>
                    <a:pt x="600" y="157839"/>
                  </a:lnTo>
                  <a:lnTo>
                    <a:pt x="594" y="157483"/>
                  </a:lnTo>
                  <a:lnTo>
                    <a:pt x="589" y="157126"/>
                  </a:lnTo>
                  <a:lnTo>
                    <a:pt x="583" y="156770"/>
                  </a:lnTo>
                  <a:lnTo>
                    <a:pt x="577" y="156414"/>
                  </a:lnTo>
                  <a:lnTo>
                    <a:pt x="571" y="156057"/>
                  </a:lnTo>
                  <a:lnTo>
                    <a:pt x="565" y="155701"/>
                  </a:lnTo>
                  <a:lnTo>
                    <a:pt x="559" y="155345"/>
                  </a:lnTo>
                  <a:lnTo>
                    <a:pt x="552" y="154988"/>
                  </a:lnTo>
                  <a:lnTo>
                    <a:pt x="546" y="154632"/>
                  </a:lnTo>
                  <a:lnTo>
                    <a:pt x="539" y="154276"/>
                  </a:lnTo>
                  <a:lnTo>
                    <a:pt x="533" y="153920"/>
                  </a:lnTo>
                  <a:lnTo>
                    <a:pt x="526" y="153563"/>
                  </a:lnTo>
                  <a:lnTo>
                    <a:pt x="519" y="153207"/>
                  </a:lnTo>
                  <a:lnTo>
                    <a:pt x="512" y="152851"/>
                  </a:lnTo>
                  <a:lnTo>
                    <a:pt x="505" y="152494"/>
                  </a:lnTo>
                  <a:lnTo>
                    <a:pt x="498" y="152138"/>
                  </a:lnTo>
                  <a:lnTo>
                    <a:pt x="491" y="151782"/>
                  </a:lnTo>
                  <a:lnTo>
                    <a:pt x="484" y="151426"/>
                  </a:lnTo>
                  <a:lnTo>
                    <a:pt x="476" y="151069"/>
                  </a:lnTo>
                  <a:lnTo>
                    <a:pt x="469" y="150713"/>
                  </a:lnTo>
                  <a:lnTo>
                    <a:pt x="461" y="150357"/>
                  </a:lnTo>
                  <a:lnTo>
                    <a:pt x="454" y="150000"/>
                  </a:lnTo>
                  <a:lnTo>
                    <a:pt x="446" y="149644"/>
                  </a:lnTo>
                  <a:lnTo>
                    <a:pt x="438" y="149288"/>
                  </a:lnTo>
                  <a:lnTo>
                    <a:pt x="430" y="148931"/>
                  </a:lnTo>
                  <a:lnTo>
                    <a:pt x="423" y="148575"/>
                  </a:lnTo>
                  <a:lnTo>
                    <a:pt x="415" y="148219"/>
                  </a:lnTo>
                  <a:lnTo>
                    <a:pt x="407" y="147863"/>
                  </a:lnTo>
                  <a:lnTo>
                    <a:pt x="399" y="147506"/>
                  </a:lnTo>
                  <a:lnTo>
                    <a:pt x="391" y="147150"/>
                  </a:lnTo>
                  <a:lnTo>
                    <a:pt x="383" y="146794"/>
                  </a:lnTo>
                  <a:lnTo>
                    <a:pt x="375" y="146437"/>
                  </a:lnTo>
                  <a:lnTo>
                    <a:pt x="366" y="146081"/>
                  </a:lnTo>
                  <a:lnTo>
                    <a:pt x="358" y="145725"/>
                  </a:lnTo>
                  <a:lnTo>
                    <a:pt x="350" y="145368"/>
                  </a:lnTo>
                  <a:lnTo>
                    <a:pt x="342" y="145012"/>
                  </a:lnTo>
                  <a:lnTo>
                    <a:pt x="334" y="144656"/>
                  </a:lnTo>
                  <a:lnTo>
                    <a:pt x="326" y="144300"/>
                  </a:lnTo>
                  <a:lnTo>
                    <a:pt x="318" y="143943"/>
                  </a:lnTo>
                  <a:lnTo>
                    <a:pt x="310" y="143587"/>
                  </a:lnTo>
                  <a:lnTo>
                    <a:pt x="302" y="143231"/>
                  </a:lnTo>
                  <a:lnTo>
                    <a:pt x="294" y="142874"/>
                  </a:lnTo>
                  <a:lnTo>
                    <a:pt x="285" y="142518"/>
                  </a:lnTo>
                  <a:lnTo>
                    <a:pt x="278" y="142162"/>
                  </a:lnTo>
                  <a:lnTo>
                    <a:pt x="270" y="141806"/>
                  </a:lnTo>
                  <a:lnTo>
                    <a:pt x="262" y="141449"/>
                  </a:lnTo>
                  <a:lnTo>
                    <a:pt x="254" y="141093"/>
                  </a:lnTo>
                  <a:lnTo>
                    <a:pt x="246" y="140737"/>
                  </a:lnTo>
                  <a:lnTo>
                    <a:pt x="238" y="140380"/>
                  </a:lnTo>
                  <a:lnTo>
                    <a:pt x="231" y="140024"/>
                  </a:lnTo>
                  <a:lnTo>
                    <a:pt x="223" y="139668"/>
                  </a:lnTo>
                  <a:lnTo>
                    <a:pt x="216" y="139311"/>
                  </a:lnTo>
                  <a:lnTo>
                    <a:pt x="208" y="138955"/>
                  </a:lnTo>
                  <a:lnTo>
                    <a:pt x="201" y="138599"/>
                  </a:lnTo>
                  <a:lnTo>
                    <a:pt x="194" y="138243"/>
                  </a:lnTo>
                  <a:lnTo>
                    <a:pt x="187" y="137886"/>
                  </a:lnTo>
                  <a:lnTo>
                    <a:pt x="180" y="137530"/>
                  </a:lnTo>
                  <a:lnTo>
                    <a:pt x="173" y="137174"/>
                  </a:lnTo>
                  <a:lnTo>
                    <a:pt x="166" y="136817"/>
                  </a:lnTo>
                  <a:lnTo>
                    <a:pt x="160" y="136461"/>
                  </a:lnTo>
                  <a:lnTo>
                    <a:pt x="153" y="136105"/>
                  </a:lnTo>
                  <a:lnTo>
                    <a:pt x="147" y="135748"/>
                  </a:lnTo>
                  <a:lnTo>
                    <a:pt x="141" y="135392"/>
                  </a:lnTo>
                  <a:lnTo>
                    <a:pt x="135" y="135036"/>
                  </a:lnTo>
                  <a:lnTo>
                    <a:pt x="129" y="134680"/>
                  </a:lnTo>
                  <a:lnTo>
                    <a:pt x="123" y="134323"/>
                  </a:lnTo>
                  <a:lnTo>
                    <a:pt x="117" y="133967"/>
                  </a:lnTo>
                  <a:lnTo>
                    <a:pt x="111" y="133611"/>
                  </a:lnTo>
                  <a:lnTo>
                    <a:pt x="106" y="133254"/>
                  </a:lnTo>
                  <a:lnTo>
                    <a:pt x="101" y="132898"/>
                  </a:lnTo>
                  <a:lnTo>
                    <a:pt x="96" y="132542"/>
                  </a:lnTo>
                  <a:lnTo>
                    <a:pt x="91" y="132186"/>
                  </a:lnTo>
                  <a:lnTo>
                    <a:pt x="86" y="131829"/>
                  </a:lnTo>
                  <a:lnTo>
                    <a:pt x="81" y="131473"/>
                  </a:lnTo>
                  <a:lnTo>
                    <a:pt x="77" y="131117"/>
                  </a:lnTo>
                  <a:lnTo>
                    <a:pt x="72" y="130760"/>
                  </a:lnTo>
                  <a:lnTo>
                    <a:pt x="68" y="130404"/>
                  </a:lnTo>
                  <a:lnTo>
                    <a:pt x="64" y="130048"/>
                  </a:lnTo>
                  <a:lnTo>
                    <a:pt x="60" y="129691"/>
                  </a:lnTo>
                  <a:lnTo>
                    <a:pt x="57" y="129335"/>
                  </a:lnTo>
                  <a:lnTo>
                    <a:pt x="53" y="128979"/>
                  </a:lnTo>
                  <a:lnTo>
                    <a:pt x="50" y="128623"/>
                  </a:lnTo>
                  <a:lnTo>
                    <a:pt x="46" y="128266"/>
                  </a:lnTo>
                  <a:lnTo>
                    <a:pt x="43" y="127910"/>
                  </a:lnTo>
                  <a:lnTo>
                    <a:pt x="40" y="127554"/>
                  </a:lnTo>
                  <a:lnTo>
                    <a:pt x="38" y="127197"/>
                  </a:lnTo>
                  <a:lnTo>
                    <a:pt x="35" y="126841"/>
                  </a:lnTo>
                  <a:lnTo>
                    <a:pt x="32" y="126485"/>
                  </a:lnTo>
                  <a:lnTo>
                    <a:pt x="30" y="126128"/>
                  </a:lnTo>
                  <a:lnTo>
                    <a:pt x="28" y="125772"/>
                  </a:lnTo>
                  <a:lnTo>
                    <a:pt x="26" y="125416"/>
                  </a:lnTo>
                  <a:lnTo>
                    <a:pt x="23" y="125060"/>
                  </a:lnTo>
                  <a:lnTo>
                    <a:pt x="22" y="124703"/>
                  </a:lnTo>
                  <a:lnTo>
                    <a:pt x="20" y="124347"/>
                  </a:lnTo>
                  <a:lnTo>
                    <a:pt x="18" y="123991"/>
                  </a:lnTo>
                  <a:lnTo>
                    <a:pt x="17" y="123634"/>
                  </a:lnTo>
                  <a:lnTo>
                    <a:pt x="15" y="123278"/>
                  </a:lnTo>
                  <a:lnTo>
                    <a:pt x="14" y="122922"/>
                  </a:lnTo>
                  <a:lnTo>
                    <a:pt x="13" y="122566"/>
                  </a:lnTo>
                  <a:lnTo>
                    <a:pt x="12" y="122209"/>
                  </a:lnTo>
                  <a:lnTo>
                    <a:pt x="11" y="121853"/>
                  </a:lnTo>
                  <a:lnTo>
                    <a:pt x="10" y="121497"/>
                  </a:lnTo>
                  <a:lnTo>
                    <a:pt x="9" y="121140"/>
                  </a:lnTo>
                  <a:lnTo>
                    <a:pt x="8" y="120784"/>
                  </a:lnTo>
                  <a:lnTo>
                    <a:pt x="7" y="120428"/>
                  </a:lnTo>
                  <a:lnTo>
                    <a:pt x="7" y="120071"/>
                  </a:lnTo>
                  <a:lnTo>
                    <a:pt x="6" y="119715"/>
                  </a:lnTo>
                  <a:lnTo>
                    <a:pt x="6" y="119359"/>
                  </a:lnTo>
                  <a:lnTo>
                    <a:pt x="5" y="119003"/>
                  </a:lnTo>
                  <a:lnTo>
                    <a:pt x="5" y="118646"/>
                  </a:lnTo>
                  <a:lnTo>
                    <a:pt x="4" y="118290"/>
                  </a:lnTo>
                  <a:lnTo>
                    <a:pt x="4" y="117934"/>
                  </a:lnTo>
                  <a:lnTo>
                    <a:pt x="4" y="117577"/>
                  </a:lnTo>
                  <a:lnTo>
                    <a:pt x="4" y="117221"/>
                  </a:lnTo>
                  <a:lnTo>
                    <a:pt x="3" y="116865"/>
                  </a:lnTo>
                  <a:lnTo>
                    <a:pt x="3" y="116508"/>
                  </a:lnTo>
                  <a:lnTo>
                    <a:pt x="3" y="116152"/>
                  </a:lnTo>
                  <a:lnTo>
                    <a:pt x="3" y="115796"/>
                  </a:lnTo>
                  <a:lnTo>
                    <a:pt x="3" y="115440"/>
                  </a:lnTo>
                  <a:lnTo>
                    <a:pt x="3" y="115083"/>
                  </a:lnTo>
                  <a:lnTo>
                    <a:pt x="3" y="114727"/>
                  </a:lnTo>
                  <a:lnTo>
                    <a:pt x="3" y="114371"/>
                  </a:lnTo>
                  <a:lnTo>
                    <a:pt x="3" y="114014"/>
                  </a:lnTo>
                  <a:lnTo>
                    <a:pt x="3" y="113658"/>
                  </a:lnTo>
                  <a:lnTo>
                    <a:pt x="2" y="113302"/>
                  </a:lnTo>
                  <a:lnTo>
                    <a:pt x="2" y="112945"/>
                  </a:lnTo>
                  <a:lnTo>
                    <a:pt x="2" y="112589"/>
                  </a:lnTo>
                  <a:lnTo>
                    <a:pt x="2" y="112233"/>
                  </a:lnTo>
                  <a:lnTo>
                    <a:pt x="2" y="111877"/>
                  </a:lnTo>
                  <a:lnTo>
                    <a:pt x="2" y="111520"/>
                  </a:lnTo>
                  <a:lnTo>
                    <a:pt x="2" y="111164"/>
                  </a:lnTo>
                  <a:lnTo>
                    <a:pt x="2" y="110808"/>
                  </a:lnTo>
                  <a:lnTo>
                    <a:pt x="2" y="110451"/>
                  </a:lnTo>
                  <a:lnTo>
                    <a:pt x="2" y="110095"/>
                  </a:lnTo>
                  <a:lnTo>
                    <a:pt x="2" y="109739"/>
                  </a:lnTo>
                  <a:lnTo>
                    <a:pt x="2" y="109383"/>
                  </a:lnTo>
                  <a:lnTo>
                    <a:pt x="1" y="109026"/>
                  </a:lnTo>
                  <a:lnTo>
                    <a:pt x="1" y="108670"/>
                  </a:lnTo>
                  <a:lnTo>
                    <a:pt x="1" y="108314"/>
                  </a:lnTo>
                  <a:lnTo>
                    <a:pt x="1" y="107957"/>
                  </a:lnTo>
                  <a:lnTo>
                    <a:pt x="1" y="107601"/>
                  </a:lnTo>
                  <a:lnTo>
                    <a:pt x="1" y="107245"/>
                  </a:lnTo>
                  <a:lnTo>
                    <a:pt x="0" y="106888"/>
                  </a:lnTo>
                  <a:lnTo>
                    <a:pt x="0" y="106532"/>
                  </a:lnTo>
                  <a:lnTo>
                    <a:pt x="0" y="106176"/>
                  </a:lnTo>
                  <a:lnTo>
                    <a:pt x="0" y="105820"/>
                  </a:lnTo>
                  <a:lnTo>
                    <a:pt x="0" y="105463"/>
                  </a:lnTo>
                  <a:lnTo>
                    <a:pt x="0" y="105107"/>
                  </a:lnTo>
                  <a:lnTo>
                    <a:pt x="0" y="104751"/>
                  </a:lnTo>
                  <a:lnTo>
                    <a:pt x="0" y="104394"/>
                  </a:lnTo>
                  <a:lnTo>
                    <a:pt x="0" y="104038"/>
                  </a:lnTo>
                  <a:lnTo>
                    <a:pt x="0" y="103682"/>
                  </a:lnTo>
                  <a:lnTo>
                    <a:pt x="0" y="103325"/>
                  </a:lnTo>
                  <a:lnTo>
                    <a:pt x="0" y="102969"/>
                  </a:lnTo>
                  <a:lnTo>
                    <a:pt x="0" y="102613"/>
                  </a:lnTo>
                  <a:lnTo>
                    <a:pt x="0" y="102257"/>
                  </a:lnTo>
                  <a:lnTo>
                    <a:pt x="0" y="101900"/>
                  </a:lnTo>
                  <a:lnTo>
                    <a:pt x="0" y="101544"/>
                  </a:lnTo>
                  <a:lnTo>
                    <a:pt x="0" y="101188"/>
                  </a:lnTo>
                  <a:lnTo>
                    <a:pt x="0" y="100831"/>
                  </a:lnTo>
                  <a:lnTo>
                    <a:pt x="1" y="100475"/>
                  </a:lnTo>
                  <a:lnTo>
                    <a:pt x="1" y="100119"/>
                  </a:lnTo>
                  <a:lnTo>
                    <a:pt x="2" y="99763"/>
                  </a:lnTo>
                  <a:lnTo>
                    <a:pt x="2" y="99406"/>
                  </a:lnTo>
                  <a:lnTo>
                    <a:pt x="3" y="99050"/>
                  </a:lnTo>
                  <a:lnTo>
                    <a:pt x="3" y="98694"/>
                  </a:lnTo>
                  <a:lnTo>
                    <a:pt x="4" y="98337"/>
                  </a:lnTo>
                  <a:lnTo>
                    <a:pt x="5" y="97981"/>
                  </a:lnTo>
                  <a:lnTo>
                    <a:pt x="6" y="97625"/>
                  </a:lnTo>
                  <a:lnTo>
                    <a:pt x="7" y="97268"/>
                  </a:lnTo>
                  <a:lnTo>
                    <a:pt x="8" y="96912"/>
                  </a:lnTo>
                  <a:lnTo>
                    <a:pt x="9" y="96556"/>
                  </a:lnTo>
                  <a:lnTo>
                    <a:pt x="10" y="96200"/>
                  </a:lnTo>
                  <a:lnTo>
                    <a:pt x="12" y="95843"/>
                  </a:lnTo>
                  <a:lnTo>
                    <a:pt x="13" y="95487"/>
                  </a:lnTo>
                  <a:lnTo>
                    <a:pt x="15" y="95131"/>
                  </a:lnTo>
                  <a:lnTo>
                    <a:pt x="16" y="94774"/>
                  </a:lnTo>
                  <a:lnTo>
                    <a:pt x="18" y="94418"/>
                  </a:lnTo>
                  <a:lnTo>
                    <a:pt x="20" y="94062"/>
                  </a:lnTo>
                  <a:lnTo>
                    <a:pt x="22" y="93705"/>
                  </a:lnTo>
                  <a:lnTo>
                    <a:pt x="24" y="93349"/>
                  </a:lnTo>
                  <a:lnTo>
                    <a:pt x="26" y="92993"/>
                  </a:lnTo>
                  <a:lnTo>
                    <a:pt x="28" y="92637"/>
                  </a:lnTo>
                  <a:lnTo>
                    <a:pt x="31" y="92280"/>
                  </a:lnTo>
                  <a:lnTo>
                    <a:pt x="33" y="91924"/>
                  </a:lnTo>
                  <a:lnTo>
                    <a:pt x="36" y="91568"/>
                  </a:lnTo>
                  <a:lnTo>
                    <a:pt x="39" y="91211"/>
                  </a:lnTo>
                  <a:lnTo>
                    <a:pt x="42" y="90855"/>
                  </a:lnTo>
                  <a:lnTo>
                    <a:pt x="44" y="90499"/>
                  </a:lnTo>
                  <a:lnTo>
                    <a:pt x="48" y="90143"/>
                  </a:lnTo>
                  <a:lnTo>
                    <a:pt x="51" y="89786"/>
                  </a:lnTo>
                  <a:lnTo>
                    <a:pt x="54" y="89430"/>
                  </a:lnTo>
                  <a:lnTo>
                    <a:pt x="57" y="89074"/>
                  </a:lnTo>
                  <a:lnTo>
                    <a:pt x="61" y="88717"/>
                  </a:lnTo>
                  <a:lnTo>
                    <a:pt x="64" y="88361"/>
                  </a:lnTo>
                  <a:lnTo>
                    <a:pt x="68" y="88005"/>
                  </a:lnTo>
                  <a:lnTo>
                    <a:pt x="72" y="87648"/>
                  </a:lnTo>
                  <a:lnTo>
                    <a:pt x="76" y="87292"/>
                  </a:lnTo>
                  <a:lnTo>
                    <a:pt x="79" y="86936"/>
                  </a:lnTo>
                  <a:lnTo>
                    <a:pt x="83" y="86580"/>
                  </a:lnTo>
                  <a:lnTo>
                    <a:pt x="87" y="86223"/>
                  </a:lnTo>
                  <a:lnTo>
                    <a:pt x="92" y="85867"/>
                  </a:lnTo>
                  <a:lnTo>
                    <a:pt x="96" y="85511"/>
                  </a:lnTo>
                  <a:lnTo>
                    <a:pt x="100" y="85154"/>
                  </a:lnTo>
                  <a:lnTo>
                    <a:pt x="105" y="84798"/>
                  </a:lnTo>
                  <a:lnTo>
                    <a:pt x="109" y="84442"/>
                  </a:lnTo>
                  <a:lnTo>
                    <a:pt x="113" y="84085"/>
                  </a:lnTo>
                  <a:lnTo>
                    <a:pt x="118" y="83729"/>
                  </a:lnTo>
                  <a:lnTo>
                    <a:pt x="122" y="83373"/>
                  </a:lnTo>
                  <a:lnTo>
                    <a:pt x="127" y="83017"/>
                  </a:lnTo>
                  <a:lnTo>
                    <a:pt x="132" y="82660"/>
                  </a:lnTo>
                  <a:lnTo>
                    <a:pt x="136" y="82304"/>
                  </a:lnTo>
                  <a:lnTo>
                    <a:pt x="141" y="81948"/>
                  </a:lnTo>
                  <a:lnTo>
                    <a:pt x="146" y="81591"/>
                  </a:lnTo>
                  <a:lnTo>
                    <a:pt x="151" y="81235"/>
                  </a:lnTo>
                  <a:lnTo>
                    <a:pt x="155" y="80879"/>
                  </a:lnTo>
                  <a:lnTo>
                    <a:pt x="160" y="80523"/>
                  </a:lnTo>
                  <a:lnTo>
                    <a:pt x="165" y="80166"/>
                  </a:lnTo>
                  <a:lnTo>
                    <a:pt x="170" y="79810"/>
                  </a:lnTo>
                  <a:lnTo>
                    <a:pt x="175" y="79454"/>
                  </a:lnTo>
                  <a:lnTo>
                    <a:pt x="179" y="79097"/>
                  </a:lnTo>
                  <a:lnTo>
                    <a:pt x="184" y="78741"/>
                  </a:lnTo>
                  <a:lnTo>
                    <a:pt x="189" y="78385"/>
                  </a:lnTo>
                  <a:lnTo>
                    <a:pt x="194" y="78028"/>
                  </a:lnTo>
                  <a:lnTo>
                    <a:pt x="198" y="77672"/>
                  </a:lnTo>
                  <a:lnTo>
                    <a:pt x="203" y="77316"/>
                  </a:lnTo>
                  <a:lnTo>
                    <a:pt x="208" y="76960"/>
                  </a:lnTo>
                  <a:lnTo>
                    <a:pt x="212" y="76603"/>
                  </a:lnTo>
                  <a:lnTo>
                    <a:pt x="217" y="76247"/>
                  </a:lnTo>
                  <a:lnTo>
                    <a:pt x="221" y="75891"/>
                  </a:lnTo>
                  <a:lnTo>
                    <a:pt x="226" y="75534"/>
                  </a:lnTo>
                  <a:lnTo>
                    <a:pt x="230" y="75178"/>
                  </a:lnTo>
                  <a:lnTo>
                    <a:pt x="235" y="74822"/>
                  </a:lnTo>
                  <a:lnTo>
                    <a:pt x="239" y="74465"/>
                  </a:lnTo>
                  <a:lnTo>
                    <a:pt x="243" y="74109"/>
                  </a:lnTo>
                  <a:lnTo>
                    <a:pt x="248" y="73753"/>
                  </a:lnTo>
                  <a:lnTo>
                    <a:pt x="252" y="73397"/>
                  </a:lnTo>
                  <a:lnTo>
                    <a:pt x="256" y="73040"/>
                  </a:lnTo>
                  <a:lnTo>
                    <a:pt x="260" y="72684"/>
                  </a:lnTo>
                  <a:lnTo>
                    <a:pt x="264" y="72328"/>
                  </a:lnTo>
                  <a:lnTo>
                    <a:pt x="268" y="71971"/>
                  </a:lnTo>
                  <a:lnTo>
                    <a:pt x="271" y="71615"/>
                  </a:lnTo>
                  <a:lnTo>
                    <a:pt x="275" y="71259"/>
                  </a:lnTo>
                  <a:lnTo>
                    <a:pt x="279" y="70903"/>
                  </a:lnTo>
                  <a:lnTo>
                    <a:pt x="282" y="70546"/>
                  </a:lnTo>
                  <a:lnTo>
                    <a:pt x="286" y="70190"/>
                  </a:lnTo>
                  <a:lnTo>
                    <a:pt x="289" y="69834"/>
                  </a:lnTo>
                  <a:lnTo>
                    <a:pt x="293" y="69477"/>
                  </a:lnTo>
                  <a:lnTo>
                    <a:pt x="296" y="69121"/>
                  </a:lnTo>
                  <a:lnTo>
                    <a:pt x="299" y="68765"/>
                  </a:lnTo>
                  <a:lnTo>
                    <a:pt x="302" y="68408"/>
                  </a:lnTo>
                  <a:lnTo>
                    <a:pt x="305" y="68052"/>
                  </a:lnTo>
                  <a:lnTo>
                    <a:pt x="308" y="67696"/>
                  </a:lnTo>
                  <a:lnTo>
                    <a:pt x="311" y="67340"/>
                  </a:lnTo>
                  <a:lnTo>
                    <a:pt x="314" y="66983"/>
                  </a:lnTo>
                  <a:lnTo>
                    <a:pt x="317" y="66627"/>
                  </a:lnTo>
                  <a:lnTo>
                    <a:pt x="320" y="66271"/>
                  </a:lnTo>
                  <a:lnTo>
                    <a:pt x="322" y="65914"/>
                  </a:lnTo>
                  <a:lnTo>
                    <a:pt x="325" y="65558"/>
                  </a:lnTo>
                  <a:lnTo>
                    <a:pt x="327" y="65202"/>
                  </a:lnTo>
                  <a:lnTo>
                    <a:pt x="330" y="64845"/>
                  </a:lnTo>
                  <a:lnTo>
                    <a:pt x="332" y="64489"/>
                  </a:lnTo>
                  <a:lnTo>
                    <a:pt x="335" y="64133"/>
                  </a:lnTo>
                  <a:lnTo>
                    <a:pt x="337" y="63777"/>
                  </a:lnTo>
                  <a:lnTo>
                    <a:pt x="339" y="63420"/>
                  </a:lnTo>
                  <a:lnTo>
                    <a:pt x="342" y="63064"/>
                  </a:lnTo>
                  <a:lnTo>
                    <a:pt x="344" y="62708"/>
                  </a:lnTo>
                  <a:lnTo>
                    <a:pt x="346" y="62351"/>
                  </a:lnTo>
                  <a:lnTo>
                    <a:pt x="348" y="61995"/>
                  </a:lnTo>
                  <a:lnTo>
                    <a:pt x="350" y="61639"/>
                  </a:lnTo>
                  <a:lnTo>
                    <a:pt x="352" y="61283"/>
                  </a:lnTo>
                  <a:lnTo>
                    <a:pt x="354" y="60926"/>
                  </a:lnTo>
                  <a:lnTo>
                    <a:pt x="356" y="60570"/>
                  </a:lnTo>
                  <a:lnTo>
                    <a:pt x="358" y="60214"/>
                  </a:lnTo>
                  <a:lnTo>
                    <a:pt x="360" y="59857"/>
                  </a:lnTo>
                  <a:lnTo>
                    <a:pt x="362" y="59501"/>
                  </a:lnTo>
                  <a:lnTo>
                    <a:pt x="364" y="59145"/>
                  </a:lnTo>
                  <a:lnTo>
                    <a:pt x="366" y="58788"/>
                  </a:lnTo>
                  <a:lnTo>
                    <a:pt x="368" y="58432"/>
                  </a:lnTo>
                  <a:lnTo>
                    <a:pt x="370" y="58076"/>
                  </a:lnTo>
                  <a:lnTo>
                    <a:pt x="372" y="57720"/>
                  </a:lnTo>
                  <a:lnTo>
                    <a:pt x="374" y="57363"/>
                  </a:lnTo>
                  <a:lnTo>
                    <a:pt x="376" y="57007"/>
                  </a:lnTo>
                  <a:lnTo>
                    <a:pt x="378" y="56651"/>
                  </a:lnTo>
                  <a:lnTo>
                    <a:pt x="380" y="56294"/>
                  </a:lnTo>
                  <a:lnTo>
                    <a:pt x="382" y="55938"/>
                  </a:lnTo>
                  <a:lnTo>
                    <a:pt x="385" y="55582"/>
                  </a:lnTo>
                  <a:lnTo>
                    <a:pt x="387" y="55225"/>
                  </a:lnTo>
                  <a:lnTo>
                    <a:pt x="389" y="54869"/>
                  </a:lnTo>
                  <a:lnTo>
                    <a:pt x="391" y="54513"/>
                  </a:lnTo>
                  <a:lnTo>
                    <a:pt x="393" y="54157"/>
                  </a:lnTo>
                  <a:lnTo>
                    <a:pt x="396" y="53800"/>
                  </a:lnTo>
                  <a:lnTo>
                    <a:pt x="398" y="53444"/>
                  </a:lnTo>
                  <a:lnTo>
                    <a:pt x="400" y="53088"/>
                  </a:lnTo>
                  <a:lnTo>
                    <a:pt x="403" y="52731"/>
                  </a:lnTo>
                  <a:lnTo>
                    <a:pt x="405" y="52375"/>
                  </a:lnTo>
                  <a:lnTo>
                    <a:pt x="407" y="52019"/>
                  </a:lnTo>
                  <a:lnTo>
                    <a:pt x="410" y="51662"/>
                  </a:lnTo>
                  <a:lnTo>
                    <a:pt x="413" y="51306"/>
                  </a:lnTo>
                  <a:lnTo>
                    <a:pt x="415" y="50950"/>
                  </a:lnTo>
                  <a:lnTo>
                    <a:pt x="418" y="50594"/>
                  </a:lnTo>
                  <a:lnTo>
                    <a:pt x="421" y="50237"/>
                  </a:lnTo>
                  <a:lnTo>
                    <a:pt x="423" y="49881"/>
                  </a:lnTo>
                  <a:lnTo>
                    <a:pt x="426" y="49525"/>
                  </a:lnTo>
                  <a:lnTo>
                    <a:pt x="429" y="49168"/>
                  </a:lnTo>
                  <a:lnTo>
                    <a:pt x="432" y="48812"/>
                  </a:lnTo>
                  <a:lnTo>
                    <a:pt x="435" y="48456"/>
                  </a:lnTo>
                  <a:lnTo>
                    <a:pt x="438" y="48100"/>
                  </a:lnTo>
                  <a:lnTo>
                    <a:pt x="441" y="47743"/>
                  </a:lnTo>
                  <a:lnTo>
                    <a:pt x="445" y="47387"/>
                  </a:lnTo>
                  <a:lnTo>
                    <a:pt x="448" y="47031"/>
                  </a:lnTo>
                  <a:lnTo>
                    <a:pt x="451" y="46674"/>
                  </a:lnTo>
                  <a:lnTo>
                    <a:pt x="454" y="46318"/>
                  </a:lnTo>
                  <a:lnTo>
                    <a:pt x="458" y="45962"/>
                  </a:lnTo>
                  <a:lnTo>
                    <a:pt x="461" y="45605"/>
                  </a:lnTo>
                  <a:lnTo>
                    <a:pt x="465" y="45249"/>
                  </a:lnTo>
                  <a:lnTo>
                    <a:pt x="468" y="44893"/>
                  </a:lnTo>
                  <a:lnTo>
                    <a:pt x="472" y="44537"/>
                  </a:lnTo>
                  <a:lnTo>
                    <a:pt x="475" y="44180"/>
                  </a:lnTo>
                  <a:lnTo>
                    <a:pt x="479" y="43824"/>
                  </a:lnTo>
                  <a:lnTo>
                    <a:pt x="483" y="43468"/>
                  </a:lnTo>
                  <a:lnTo>
                    <a:pt x="487" y="43111"/>
                  </a:lnTo>
                  <a:lnTo>
                    <a:pt x="490" y="42755"/>
                  </a:lnTo>
                  <a:lnTo>
                    <a:pt x="494" y="42399"/>
                  </a:lnTo>
                  <a:lnTo>
                    <a:pt x="498" y="42042"/>
                  </a:lnTo>
                  <a:lnTo>
                    <a:pt x="502" y="41686"/>
                  </a:lnTo>
                  <a:lnTo>
                    <a:pt x="506" y="41330"/>
                  </a:lnTo>
                  <a:lnTo>
                    <a:pt x="510" y="40974"/>
                  </a:lnTo>
                  <a:lnTo>
                    <a:pt x="514" y="40617"/>
                  </a:lnTo>
                  <a:lnTo>
                    <a:pt x="518" y="40261"/>
                  </a:lnTo>
                  <a:lnTo>
                    <a:pt x="522" y="39905"/>
                  </a:lnTo>
                  <a:lnTo>
                    <a:pt x="526" y="39548"/>
                  </a:lnTo>
                  <a:lnTo>
                    <a:pt x="530" y="39192"/>
                  </a:lnTo>
                  <a:lnTo>
                    <a:pt x="534" y="38836"/>
                  </a:lnTo>
                  <a:lnTo>
                    <a:pt x="538" y="38480"/>
                  </a:lnTo>
                  <a:lnTo>
                    <a:pt x="542" y="38123"/>
                  </a:lnTo>
                  <a:lnTo>
                    <a:pt x="546" y="37767"/>
                  </a:lnTo>
                  <a:lnTo>
                    <a:pt x="550" y="37411"/>
                  </a:lnTo>
                  <a:lnTo>
                    <a:pt x="554" y="37054"/>
                  </a:lnTo>
                  <a:lnTo>
                    <a:pt x="558" y="36698"/>
                  </a:lnTo>
                  <a:lnTo>
                    <a:pt x="563" y="36342"/>
                  </a:lnTo>
                  <a:lnTo>
                    <a:pt x="567" y="35985"/>
                  </a:lnTo>
                  <a:lnTo>
                    <a:pt x="571" y="35629"/>
                  </a:lnTo>
                  <a:lnTo>
                    <a:pt x="575" y="35273"/>
                  </a:lnTo>
                  <a:lnTo>
                    <a:pt x="579" y="34917"/>
                  </a:lnTo>
                  <a:lnTo>
                    <a:pt x="583" y="34560"/>
                  </a:lnTo>
                  <a:lnTo>
                    <a:pt x="587" y="34204"/>
                  </a:lnTo>
                  <a:lnTo>
                    <a:pt x="591" y="33848"/>
                  </a:lnTo>
                  <a:lnTo>
                    <a:pt x="595" y="33491"/>
                  </a:lnTo>
                  <a:lnTo>
                    <a:pt x="599" y="33135"/>
                  </a:lnTo>
                  <a:lnTo>
                    <a:pt x="603" y="32779"/>
                  </a:lnTo>
                  <a:lnTo>
                    <a:pt x="606" y="32422"/>
                  </a:lnTo>
                  <a:lnTo>
                    <a:pt x="610" y="32066"/>
                  </a:lnTo>
                  <a:lnTo>
                    <a:pt x="614" y="31710"/>
                  </a:lnTo>
                  <a:lnTo>
                    <a:pt x="618" y="31354"/>
                  </a:lnTo>
                  <a:lnTo>
                    <a:pt x="622" y="30997"/>
                  </a:lnTo>
                  <a:lnTo>
                    <a:pt x="625" y="30641"/>
                  </a:lnTo>
                  <a:lnTo>
                    <a:pt x="629" y="30285"/>
                  </a:lnTo>
                  <a:lnTo>
                    <a:pt x="633" y="29928"/>
                  </a:lnTo>
                  <a:lnTo>
                    <a:pt x="636" y="29572"/>
                  </a:lnTo>
                  <a:lnTo>
                    <a:pt x="640" y="29216"/>
                  </a:lnTo>
                  <a:lnTo>
                    <a:pt x="643" y="28860"/>
                  </a:lnTo>
                  <a:lnTo>
                    <a:pt x="647" y="28503"/>
                  </a:lnTo>
                  <a:lnTo>
                    <a:pt x="650" y="28147"/>
                  </a:lnTo>
                  <a:lnTo>
                    <a:pt x="653" y="27791"/>
                  </a:lnTo>
                  <a:lnTo>
                    <a:pt x="656" y="27434"/>
                  </a:lnTo>
                  <a:lnTo>
                    <a:pt x="660" y="27078"/>
                  </a:lnTo>
                  <a:lnTo>
                    <a:pt x="663" y="26722"/>
                  </a:lnTo>
                  <a:lnTo>
                    <a:pt x="666" y="26365"/>
                  </a:lnTo>
                  <a:lnTo>
                    <a:pt x="669" y="26009"/>
                  </a:lnTo>
                  <a:lnTo>
                    <a:pt x="672" y="25653"/>
                  </a:lnTo>
                  <a:lnTo>
                    <a:pt x="675" y="25297"/>
                  </a:lnTo>
                  <a:lnTo>
                    <a:pt x="678" y="24940"/>
                  </a:lnTo>
                  <a:lnTo>
                    <a:pt x="681" y="24584"/>
                  </a:lnTo>
                  <a:lnTo>
                    <a:pt x="683" y="24228"/>
                  </a:lnTo>
                  <a:lnTo>
                    <a:pt x="686" y="23871"/>
                  </a:lnTo>
                  <a:lnTo>
                    <a:pt x="689" y="23515"/>
                  </a:lnTo>
                  <a:lnTo>
                    <a:pt x="691" y="23159"/>
                  </a:lnTo>
                  <a:lnTo>
                    <a:pt x="694" y="22802"/>
                  </a:lnTo>
                  <a:lnTo>
                    <a:pt x="696" y="22446"/>
                  </a:lnTo>
                  <a:lnTo>
                    <a:pt x="699" y="22090"/>
                  </a:lnTo>
                  <a:lnTo>
                    <a:pt x="701" y="21734"/>
                  </a:lnTo>
                  <a:lnTo>
                    <a:pt x="704" y="21377"/>
                  </a:lnTo>
                  <a:lnTo>
                    <a:pt x="706" y="21021"/>
                  </a:lnTo>
                  <a:lnTo>
                    <a:pt x="708" y="20665"/>
                  </a:lnTo>
                  <a:lnTo>
                    <a:pt x="710" y="20308"/>
                  </a:lnTo>
                  <a:lnTo>
                    <a:pt x="712" y="19952"/>
                  </a:lnTo>
                  <a:lnTo>
                    <a:pt x="714" y="19596"/>
                  </a:lnTo>
                  <a:lnTo>
                    <a:pt x="716" y="19240"/>
                  </a:lnTo>
                  <a:lnTo>
                    <a:pt x="718" y="18883"/>
                  </a:lnTo>
                  <a:lnTo>
                    <a:pt x="720" y="18527"/>
                  </a:lnTo>
                  <a:lnTo>
                    <a:pt x="722" y="18171"/>
                  </a:lnTo>
                  <a:lnTo>
                    <a:pt x="724" y="17814"/>
                  </a:lnTo>
                  <a:lnTo>
                    <a:pt x="725" y="17458"/>
                  </a:lnTo>
                  <a:lnTo>
                    <a:pt x="727" y="17102"/>
                  </a:lnTo>
                  <a:lnTo>
                    <a:pt x="729" y="16745"/>
                  </a:lnTo>
                  <a:lnTo>
                    <a:pt x="730" y="16389"/>
                  </a:lnTo>
                  <a:lnTo>
                    <a:pt x="732" y="16033"/>
                  </a:lnTo>
                  <a:lnTo>
                    <a:pt x="733" y="15677"/>
                  </a:lnTo>
                  <a:lnTo>
                    <a:pt x="734" y="15320"/>
                  </a:lnTo>
                  <a:lnTo>
                    <a:pt x="736" y="14964"/>
                  </a:lnTo>
                  <a:lnTo>
                    <a:pt x="737" y="14608"/>
                  </a:lnTo>
                  <a:lnTo>
                    <a:pt x="738" y="14251"/>
                  </a:lnTo>
                  <a:lnTo>
                    <a:pt x="740" y="13895"/>
                  </a:lnTo>
                  <a:lnTo>
                    <a:pt x="741" y="13539"/>
                  </a:lnTo>
                  <a:lnTo>
                    <a:pt x="742" y="13182"/>
                  </a:lnTo>
                  <a:lnTo>
                    <a:pt x="743" y="12826"/>
                  </a:lnTo>
                  <a:lnTo>
                    <a:pt x="744" y="12470"/>
                  </a:lnTo>
                  <a:lnTo>
                    <a:pt x="745" y="12114"/>
                  </a:lnTo>
                  <a:lnTo>
                    <a:pt x="746" y="11757"/>
                  </a:lnTo>
                  <a:lnTo>
                    <a:pt x="747" y="11401"/>
                  </a:lnTo>
                  <a:lnTo>
                    <a:pt x="748" y="11045"/>
                  </a:lnTo>
                  <a:lnTo>
                    <a:pt x="749" y="10688"/>
                  </a:lnTo>
                  <a:lnTo>
                    <a:pt x="750" y="10332"/>
                  </a:lnTo>
                  <a:lnTo>
                    <a:pt x="751" y="9976"/>
                  </a:lnTo>
                  <a:lnTo>
                    <a:pt x="751" y="9620"/>
                  </a:lnTo>
                  <a:lnTo>
                    <a:pt x="752" y="9263"/>
                  </a:lnTo>
                  <a:lnTo>
                    <a:pt x="753" y="8907"/>
                  </a:lnTo>
                  <a:lnTo>
                    <a:pt x="753" y="8551"/>
                  </a:lnTo>
                  <a:lnTo>
                    <a:pt x="754" y="8194"/>
                  </a:lnTo>
                  <a:lnTo>
                    <a:pt x="755" y="7838"/>
                  </a:lnTo>
                  <a:lnTo>
                    <a:pt x="755" y="7482"/>
                  </a:lnTo>
                  <a:lnTo>
                    <a:pt x="756" y="7125"/>
                  </a:lnTo>
                  <a:lnTo>
                    <a:pt x="756" y="6769"/>
                  </a:lnTo>
                  <a:lnTo>
                    <a:pt x="757" y="6413"/>
                  </a:lnTo>
                  <a:lnTo>
                    <a:pt x="757" y="6057"/>
                  </a:lnTo>
                  <a:lnTo>
                    <a:pt x="758" y="5700"/>
                  </a:lnTo>
                  <a:lnTo>
                    <a:pt x="758" y="5344"/>
                  </a:lnTo>
                  <a:lnTo>
                    <a:pt x="759" y="4988"/>
                  </a:lnTo>
                  <a:lnTo>
                    <a:pt x="759" y="4631"/>
                  </a:lnTo>
                  <a:lnTo>
                    <a:pt x="760" y="4275"/>
                  </a:lnTo>
                  <a:lnTo>
                    <a:pt x="760" y="3919"/>
                  </a:lnTo>
                  <a:lnTo>
                    <a:pt x="760" y="3562"/>
                  </a:lnTo>
                  <a:lnTo>
                    <a:pt x="761" y="3206"/>
                  </a:lnTo>
                  <a:lnTo>
                    <a:pt x="761" y="2850"/>
                  </a:lnTo>
                  <a:lnTo>
                    <a:pt x="761" y="2494"/>
                  </a:lnTo>
                  <a:lnTo>
                    <a:pt x="762" y="2137"/>
                  </a:lnTo>
                  <a:lnTo>
                    <a:pt x="762" y="1781"/>
                  </a:lnTo>
                  <a:lnTo>
                    <a:pt x="762" y="1425"/>
                  </a:lnTo>
                  <a:lnTo>
                    <a:pt x="763" y="1068"/>
                  </a:lnTo>
                  <a:lnTo>
                    <a:pt x="763" y="712"/>
                  </a:lnTo>
                  <a:lnTo>
                    <a:pt x="763" y="356"/>
                  </a:lnTo>
                  <a:lnTo>
                    <a:pt x="763" y="0"/>
                  </a:lnTo>
                  <a:lnTo>
                    <a:pt x="767" y="0"/>
                  </a:lnTo>
                  <a:lnTo>
                    <a:pt x="767" y="182067"/>
                  </a:lnTo>
                  <a:lnTo>
                    <a:pt x="767" y="182067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51" name="pl33"/>
            <p:cNvSpPr/>
            <p:nvPr/>
          </p:nvSpPr>
          <p:spPr>
            <a:xfrm>
              <a:off x="4441136" y="3756704"/>
              <a:ext cx="2208" cy="62890"/>
            </a:xfrm>
            <a:custGeom>
              <a:avLst/>
              <a:gdLst/>
              <a:ahLst/>
              <a:cxnLst/>
              <a:rect l="0" t="0" r="0" b="0"/>
              <a:pathLst>
                <a:path w="2208" h="62890">
                  <a:moveTo>
                    <a:pt x="0" y="0"/>
                  </a:moveTo>
                  <a:lnTo>
                    <a:pt x="9" y="0"/>
                  </a:lnTo>
                  <a:lnTo>
                    <a:pt x="10" y="123"/>
                  </a:lnTo>
                  <a:lnTo>
                    <a:pt x="10" y="246"/>
                  </a:lnTo>
                  <a:lnTo>
                    <a:pt x="11" y="369"/>
                  </a:lnTo>
                  <a:lnTo>
                    <a:pt x="12" y="492"/>
                  </a:lnTo>
                  <a:lnTo>
                    <a:pt x="12" y="615"/>
                  </a:lnTo>
                  <a:lnTo>
                    <a:pt x="13" y="738"/>
                  </a:lnTo>
                  <a:lnTo>
                    <a:pt x="14" y="861"/>
                  </a:lnTo>
                  <a:lnTo>
                    <a:pt x="14" y="984"/>
                  </a:lnTo>
                  <a:lnTo>
                    <a:pt x="15" y="1107"/>
                  </a:lnTo>
                  <a:lnTo>
                    <a:pt x="16" y="1230"/>
                  </a:lnTo>
                  <a:lnTo>
                    <a:pt x="17" y="1353"/>
                  </a:lnTo>
                  <a:lnTo>
                    <a:pt x="18" y="1476"/>
                  </a:lnTo>
                  <a:lnTo>
                    <a:pt x="19" y="1599"/>
                  </a:lnTo>
                  <a:lnTo>
                    <a:pt x="20" y="1723"/>
                  </a:lnTo>
                  <a:lnTo>
                    <a:pt x="21" y="1846"/>
                  </a:lnTo>
                  <a:lnTo>
                    <a:pt x="22" y="1969"/>
                  </a:lnTo>
                  <a:lnTo>
                    <a:pt x="23" y="2092"/>
                  </a:lnTo>
                  <a:lnTo>
                    <a:pt x="25" y="2215"/>
                  </a:lnTo>
                  <a:lnTo>
                    <a:pt x="26" y="2338"/>
                  </a:lnTo>
                  <a:lnTo>
                    <a:pt x="27" y="2461"/>
                  </a:lnTo>
                  <a:lnTo>
                    <a:pt x="29" y="2584"/>
                  </a:lnTo>
                  <a:lnTo>
                    <a:pt x="30" y="2707"/>
                  </a:lnTo>
                  <a:lnTo>
                    <a:pt x="32" y="2830"/>
                  </a:lnTo>
                  <a:lnTo>
                    <a:pt x="33" y="2953"/>
                  </a:lnTo>
                  <a:lnTo>
                    <a:pt x="35" y="3076"/>
                  </a:lnTo>
                  <a:lnTo>
                    <a:pt x="37" y="3199"/>
                  </a:lnTo>
                  <a:lnTo>
                    <a:pt x="38" y="3322"/>
                  </a:lnTo>
                  <a:lnTo>
                    <a:pt x="40" y="3446"/>
                  </a:lnTo>
                  <a:lnTo>
                    <a:pt x="42" y="3569"/>
                  </a:lnTo>
                  <a:lnTo>
                    <a:pt x="44" y="3692"/>
                  </a:lnTo>
                  <a:lnTo>
                    <a:pt x="46" y="3815"/>
                  </a:lnTo>
                  <a:lnTo>
                    <a:pt x="48" y="3938"/>
                  </a:lnTo>
                  <a:lnTo>
                    <a:pt x="51" y="4061"/>
                  </a:lnTo>
                  <a:lnTo>
                    <a:pt x="53" y="4184"/>
                  </a:lnTo>
                  <a:lnTo>
                    <a:pt x="56" y="4307"/>
                  </a:lnTo>
                  <a:lnTo>
                    <a:pt x="58" y="4430"/>
                  </a:lnTo>
                  <a:lnTo>
                    <a:pt x="61" y="4553"/>
                  </a:lnTo>
                  <a:lnTo>
                    <a:pt x="63" y="4676"/>
                  </a:lnTo>
                  <a:lnTo>
                    <a:pt x="66" y="4799"/>
                  </a:lnTo>
                  <a:lnTo>
                    <a:pt x="69" y="4922"/>
                  </a:lnTo>
                  <a:lnTo>
                    <a:pt x="72" y="5046"/>
                  </a:lnTo>
                  <a:lnTo>
                    <a:pt x="75" y="5169"/>
                  </a:lnTo>
                  <a:lnTo>
                    <a:pt x="79" y="5292"/>
                  </a:lnTo>
                  <a:lnTo>
                    <a:pt x="82" y="5415"/>
                  </a:lnTo>
                  <a:lnTo>
                    <a:pt x="85" y="5538"/>
                  </a:lnTo>
                  <a:lnTo>
                    <a:pt x="89" y="5661"/>
                  </a:lnTo>
                  <a:lnTo>
                    <a:pt x="93" y="5784"/>
                  </a:lnTo>
                  <a:lnTo>
                    <a:pt x="97" y="5907"/>
                  </a:lnTo>
                  <a:lnTo>
                    <a:pt x="101" y="6030"/>
                  </a:lnTo>
                  <a:lnTo>
                    <a:pt x="105" y="6153"/>
                  </a:lnTo>
                  <a:lnTo>
                    <a:pt x="109" y="6276"/>
                  </a:lnTo>
                  <a:lnTo>
                    <a:pt x="113" y="6399"/>
                  </a:lnTo>
                  <a:lnTo>
                    <a:pt x="118" y="6522"/>
                  </a:lnTo>
                  <a:lnTo>
                    <a:pt x="122" y="6645"/>
                  </a:lnTo>
                  <a:lnTo>
                    <a:pt x="127" y="6769"/>
                  </a:lnTo>
                  <a:lnTo>
                    <a:pt x="132" y="6892"/>
                  </a:lnTo>
                  <a:lnTo>
                    <a:pt x="137" y="7015"/>
                  </a:lnTo>
                  <a:lnTo>
                    <a:pt x="142" y="7138"/>
                  </a:lnTo>
                  <a:lnTo>
                    <a:pt x="148" y="7261"/>
                  </a:lnTo>
                  <a:lnTo>
                    <a:pt x="153" y="7384"/>
                  </a:lnTo>
                  <a:lnTo>
                    <a:pt x="159" y="7507"/>
                  </a:lnTo>
                  <a:lnTo>
                    <a:pt x="165" y="7630"/>
                  </a:lnTo>
                  <a:lnTo>
                    <a:pt x="171" y="7753"/>
                  </a:lnTo>
                  <a:lnTo>
                    <a:pt x="177" y="7876"/>
                  </a:lnTo>
                  <a:lnTo>
                    <a:pt x="183" y="7999"/>
                  </a:lnTo>
                  <a:lnTo>
                    <a:pt x="190" y="8122"/>
                  </a:lnTo>
                  <a:lnTo>
                    <a:pt x="197" y="8245"/>
                  </a:lnTo>
                  <a:lnTo>
                    <a:pt x="203" y="8368"/>
                  </a:lnTo>
                  <a:lnTo>
                    <a:pt x="210" y="8492"/>
                  </a:lnTo>
                  <a:lnTo>
                    <a:pt x="218" y="8615"/>
                  </a:lnTo>
                  <a:lnTo>
                    <a:pt x="225" y="8738"/>
                  </a:lnTo>
                  <a:lnTo>
                    <a:pt x="233" y="8861"/>
                  </a:lnTo>
                  <a:lnTo>
                    <a:pt x="240" y="8984"/>
                  </a:lnTo>
                  <a:lnTo>
                    <a:pt x="248" y="9107"/>
                  </a:lnTo>
                  <a:lnTo>
                    <a:pt x="256" y="9230"/>
                  </a:lnTo>
                  <a:lnTo>
                    <a:pt x="265" y="9353"/>
                  </a:lnTo>
                  <a:lnTo>
                    <a:pt x="273" y="9476"/>
                  </a:lnTo>
                  <a:lnTo>
                    <a:pt x="282" y="9599"/>
                  </a:lnTo>
                  <a:lnTo>
                    <a:pt x="291" y="9722"/>
                  </a:lnTo>
                  <a:lnTo>
                    <a:pt x="300" y="9845"/>
                  </a:lnTo>
                  <a:lnTo>
                    <a:pt x="309" y="9968"/>
                  </a:lnTo>
                  <a:lnTo>
                    <a:pt x="318" y="10092"/>
                  </a:lnTo>
                  <a:lnTo>
                    <a:pt x="328" y="10215"/>
                  </a:lnTo>
                  <a:lnTo>
                    <a:pt x="338" y="10338"/>
                  </a:lnTo>
                  <a:lnTo>
                    <a:pt x="348" y="10461"/>
                  </a:lnTo>
                  <a:lnTo>
                    <a:pt x="358" y="10584"/>
                  </a:lnTo>
                  <a:lnTo>
                    <a:pt x="368" y="10707"/>
                  </a:lnTo>
                  <a:lnTo>
                    <a:pt x="379" y="10830"/>
                  </a:lnTo>
                  <a:lnTo>
                    <a:pt x="390" y="10953"/>
                  </a:lnTo>
                  <a:lnTo>
                    <a:pt x="401" y="11076"/>
                  </a:lnTo>
                  <a:lnTo>
                    <a:pt x="412" y="11199"/>
                  </a:lnTo>
                  <a:lnTo>
                    <a:pt x="423" y="11322"/>
                  </a:lnTo>
                  <a:lnTo>
                    <a:pt x="435" y="11445"/>
                  </a:lnTo>
                  <a:lnTo>
                    <a:pt x="446" y="11568"/>
                  </a:lnTo>
                  <a:lnTo>
                    <a:pt x="458" y="11691"/>
                  </a:lnTo>
                  <a:lnTo>
                    <a:pt x="470" y="11815"/>
                  </a:lnTo>
                  <a:lnTo>
                    <a:pt x="483" y="11938"/>
                  </a:lnTo>
                  <a:lnTo>
                    <a:pt x="495" y="12061"/>
                  </a:lnTo>
                  <a:lnTo>
                    <a:pt x="508" y="12184"/>
                  </a:lnTo>
                  <a:lnTo>
                    <a:pt x="521" y="12307"/>
                  </a:lnTo>
                  <a:lnTo>
                    <a:pt x="534" y="12430"/>
                  </a:lnTo>
                  <a:lnTo>
                    <a:pt x="547" y="12553"/>
                  </a:lnTo>
                  <a:lnTo>
                    <a:pt x="561" y="12676"/>
                  </a:lnTo>
                  <a:lnTo>
                    <a:pt x="574" y="12799"/>
                  </a:lnTo>
                  <a:lnTo>
                    <a:pt x="588" y="12922"/>
                  </a:lnTo>
                  <a:lnTo>
                    <a:pt x="602" y="13045"/>
                  </a:lnTo>
                  <a:lnTo>
                    <a:pt x="616" y="13168"/>
                  </a:lnTo>
                  <a:lnTo>
                    <a:pt x="630" y="13291"/>
                  </a:lnTo>
                  <a:lnTo>
                    <a:pt x="645" y="13414"/>
                  </a:lnTo>
                  <a:lnTo>
                    <a:pt x="659" y="13538"/>
                  </a:lnTo>
                  <a:lnTo>
                    <a:pt x="674" y="13661"/>
                  </a:lnTo>
                  <a:lnTo>
                    <a:pt x="689" y="13784"/>
                  </a:lnTo>
                  <a:lnTo>
                    <a:pt x="704" y="13907"/>
                  </a:lnTo>
                  <a:lnTo>
                    <a:pt x="719" y="14030"/>
                  </a:lnTo>
                  <a:lnTo>
                    <a:pt x="735" y="14153"/>
                  </a:lnTo>
                  <a:lnTo>
                    <a:pt x="750" y="14276"/>
                  </a:lnTo>
                  <a:lnTo>
                    <a:pt x="766" y="14399"/>
                  </a:lnTo>
                  <a:lnTo>
                    <a:pt x="782" y="14522"/>
                  </a:lnTo>
                  <a:lnTo>
                    <a:pt x="797" y="14645"/>
                  </a:lnTo>
                  <a:lnTo>
                    <a:pt x="813" y="14768"/>
                  </a:lnTo>
                  <a:lnTo>
                    <a:pt x="830" y="14891"/>
                  </a:lnTo>
                  <a:lnTo>
                    <a:pt x="846" y="15014"/>
                  </a:lnTo>
                  <a:lnTo>
                    <a:pt x="862" y="15138"/>
                  </a:lnTo>
                  <a:lnTo>
                    <a:pt x="879" y="15261"/>
                  </a:lnTo>
                  <a:lnTo>
                    <a:pt x="896" y="15384"/>
                  </a:lnTo>
                  <a:lnTo>
                    <a:pt x="912" y="15507"/>
                  </a:lnTo>
                  <a:lnTo>
                    <a:pt x="929" y="15630"/>
                  </a:lnTo>
                  <a:lnTo>
                    <a:pt x="946" y="15753"/>
                  </a:lnTo>
                  <a:lnTo>
                    <a:pt x="963" y="15876"/>
                  </a:lnTo>
                  <a:lnTo>
                    <a:pt x="981" y="15999"/>
                  </a:lnTo>
                  <a:lnTo>
                    <a:pt x="998" y="16122"/>
                  </a:lnTo>
                  <a:lnTo>
                    <a:pt x="1015" y="16245"/>
                  </a:lnTo>
                  <a:lnTo>
                    <a:pt x="1032" y="16368"/>
                  </a:lnTo>
                  <a:lnTo>
                    <a:pt x="1050" y="16491"/>
                  </a:lnTo>
                  <a:lnTo>
                    <a:pt x="1067" y="16614"/>
                  </a:lnTo>
                  <a:lnTo>
                    <a:pt x="1085" y="16737"/>
                  </a:lnTo>
                  <a:lnTo>
                    <a:pt x="1103" y="16861"/>
                  </a:lnTo>
                  <a:lnTo>
                    <a:pt x="1120" y="16984"/>
                  </a:lnTo>
                  <a:lnTo>
                    <a:pt x="1138" y="17107"/>
                  </a:lnTo>
                  <a:lnTo>
                    <a:pt x="1156" y="17230"/>
                  </a:lnTo>
                  <a:lnTo>
                    <a:pt x="1174" y="17353"/>
                  </a:lnTo>
                  <a:lnTo>
                    <a:pt x="1192" y="17476"/>
                  </a:lnTo>
                  <a:lnTo>
                    <a:pt x="1210" y="17599"/>
                  </a:lnTo>
                  <a:lnTo>
                    <a:pt x="1227" y="17722"/>
                  </a:lnTo>
                  <a:lnTo>
                    <a:pt x="1245" y="17845"/>
                  </a:lnTo>
                  <a:lnTo>
                    <a:pt x="1263" y="17968"/>
                  </a:lnTo>
                  <a:lnTo>
                    <a:pt x="1281" y="18091"/>
                  </a:lnTo>
                  <a:lnTo>
                    <a:pt x="1299" y="18214"/>
                  </a:lnTo>
                  <a:lnTo>
                    <a:pt x="1317" y="18337"/>
                  </a:lnTo>
                  <a:lnTo>
                    <a:pt x="1335" y="18460"/>
                  </a:lnTo>
                  <a:lnTo>
                    <a:pt x="1353" y="18584"/>
                  </a:lnTo>
                  <a:lnTo>
                    <a:pt x="1371" y="18707"/>
                  </a:lnTo>
                  <a:lnTo>
                    <a:pt x="1389" y="18830"/>
                  </a:lnTo>
                  <a:lnTo>
                    <a:pt x="1406" y="18953"/>
                  </a:lnTo>
                  <a:lnTo>
                    <a:pt x="1424" y="19076"/>
                  </a:lnTo>
                  <a:lnTo>
                    <a:pt x="1442" y="19199"/>
                  </a:lnTo>
                  <a:lnTo>
                    <a:pt x="1459" y="19322"/>
                  </a:lnTo>
                  <a:lnTo>
                    <a:pt x="1477" y="19445"/>
                  </a:lnTo>
                  <a:lnTo>
                    <a:pt x="1495" y="19568"/>
                  </a:lnTo>
                  <a:lnTo>
                    <a:pt x="1512" y="19691"/>
                  </a:lnTo>
                  <a:lnTo>
                    <a:pt x="1529" y="19814"/>
                  </a:lnTo>
                  <a:lnTo>
                    <a:pt x="1547" y="19937"/>
                  </a:lnTo>
                  <a:lnTo>
                    <a:pt x="1564" y="20060"/>
                  </a:lnTo>
                  <a:lnTo>
                    <a:pt x="1581" y="20184"/>
                  </a:lnTo>
                  <a:lnTo>
                    <a:pt x="1598" y="20307"/>
                  </a:lnTo>
                  <a:lnTo>
                    <a:pt x="1615" y="20430"/>
                  </a:lnTo>
                  <a:lnTo>
                    <a:pt x="1632" y="20553"/>
                  </a:lnTo>
                  <a:lnTo>
                    <a:pt x="1648" y="20676"/>
                  </a:lnTo>
                  <a:lnTo>
                    <a:pt x="1665" y="20799"/>
                  </a:lnTo>
                  <a:lnTo>
                    <a:pt x="1681" y="20922"/>
                  </a:lnTo>
                  <a:lnTo>
                    <a:pt x="1698" y="21045"/>
                  </a:lnTo>
                  <a:lnTo>
                    <a:pt x="1714" y="21168"/>
                  </a:lnTo>
                  <a:lnTo>
                    <a:pt x="1730" y="21291"/>
                  </a:lnTo>
                  <a:lnTo>
                    <a:pt x="1745" y="21414"/>
                  </a:lnTo>
                  <a:lnTo>
                    <a:pt x="1761" y="21537"/>
                  </a:lnTo>
                  <a:lnTo>
                    <a:pt x="1776" y="21660"/>
                  </a:lnTo>
                  <a:lnTo>
                    <a:pt x="1792" y="21783"/>
                  </a:lnTo>
                  <a:lnTo>
                    <a:pt x="1807" y="21907"/>
                  </a:lnTo>
                  <a:lnTo>
                    <a:pt x="1822" y="22030"/>
                  </a:lnTo>
                  <a:lnTo>
                    <a:pt x="1836" y="22153"/>
                  </a:lnTo>
                  <a:lnTo>
                    <a:pt x="1851" y="22276"/>
                  </a:lnTo>
                  <a:lnTo>
                    <a:pt x="1865" y="22399"/>
                  </a:lnTo>
                  <a:lnTo>
                    <a:pt x="1879" y="22522"/>
                  </a:lnTo>
                  <a:lnTo>
                    <a:pt x="1893" y="22645"/>
                  </a:lnTo>
                  <a:lnTo>
                    <a:pt x="1907" y="22768"/>
                  </a:lnTo>
                  <a:lnTo>
                    <a:pt x="1920" y="22891"/>
                  </a:lnTo>
                  <a:lnTo>
                    <a:pt x="1933" y="23014"/>
                  </a:lnTo>
                  <a:lnTo>
                    <a:pt x="1946" y="23137"/>
                  </a:lnTo>
                  <a:lnTo>
                    <a:pt x="1959" y="23260"/>
                  </a:lnTo>
                  <a:lnTo>
                    <a:pt x="1971" y="23383"/>
                  </a:lnTo>
                  <a:lnTo>
                    <a:pt x="1983" y="23506"/>
                  </a:lnTo>
                  <a:lnTo>
                    <a:pt x="1995" y="23630"/>
                  </a:lnTo>
                  <a:lnTo>
                    <a:pt x="2007" y="23753"/>
                  </a:lnTo>
                  <a:lnTo>
                    <a:pt x="2018" y="23876"/>
                  </a:lnTo>
                  <a:lnTo>
                    <a:pt x="2029" y="23999"/>
                  </a:lnTo>
                  <a:lnTo>
                    <a:pt x="2040" y="24122"/>
                  </a:lnTo>
                  <a:lnTo>
                    <a:pt x="2050" y="24245"/>
                  </a:lnTo>
                  <a:lnTo>
                    <a:pt x="2060" y="24368"/>
                  </a:lnTo>
                  <a:lnTo>
                    <a:pt x="2070" y="24491"/>
                  </a:lnTo>
                  <a:lnTo>
                    <a:pt x="2079" y="24614"/>
                  </a:lnTo>
                  <a:lnTo>
                    <a:pt x="2088" y="24737"/>
                  </a:lnTo>
                  <a:lnTo>
                    <a:pt x="2097" y="24860"/>
                  </a:lnTo>
                  <a:lnTo>
                    <a:pt x="2106" y="24983"/>
                  </a:lnTo>
                  <a:lnTo>
                    <a:pt x="2114" y="25106"/>
                  </a:lnTo>
                  <a:lnTo>
                    <a:pt x="2122" y="25230"/>
                  </a:lnTo>
                  <a:lnTo>
                    <a:pt x="2129" y="25353"/>
                  </a:lnTo>
                  <a:lnTo>
                    <a:pt x="2136" y="25476"/>
                  </a:lnTo>
                  <a:lnTo>
                    <a:pt x="2143" y="25599"/>
                  </a:lnTo>
                  <a:lnTo>
                    <a:pt x="2150" y="25722"/>
                  </a:lnTo>
                  <a:lnTo>
                    <a:pt x="2156" y="25845"/>
                  </a:lnTo>
                  <a:lnTo>
                    <a:pt x="2162" y="25968"/>
                  </a:lnTo>
                  <a:lnTo>
                    <a:pt x="2167" y="26091"/>
                  </a:lnTo>
                  <a:lnTo>
                    <a:pt x="2172" y="26214"/>
                  </a:lnTo>
                  <a:lnTo>
                    <a:pt x="2177" y="26337"/>
                  </a:lnTo>
                  <a:lnTo>
                    <a:pt x="2181" y="26460"/>
                  </a:lnTo>
                  <a:lnTo>
                    <a:pt x="2186" y="26583"/>
                  </a:lnTo>
                  <a:lnTo>
                    <a:pt x="2189" y="26706"/>
                  </a:lnTo>
                  <a:lnTo>
                    <a:pt x="2193" y="26829"/>
                  </a:lnTo>
                  <a:lnTo>
                    <a:pt x="2196" y="26953"/>
                  </a:lnTo>
                  <a:lnTo>
                    <a:pt x="2198" y="27076"/>
                  </a:lnTo>
                  <a:lnTo>
                    <a:pt x="2201" y="27199"/>
                  </a:lnTo>
                  <a:lnTo>
                    <a:pt x="2203" y="27322"/>
                  </a:lnTo>
                  <a:lnTo>
                    <a:pt x="2204" y="27445"/>
                  </a:lnTo>
                  <a:lnTo>
                    <a:pt x="2206" y="27568"/>
                  </a:lnTo>
                  <a:lnTo>
                    <a:pt x="2207" y="27691"/>
                  </a:lnTo>
                  <a:lnTo>
                    <a:pt x="2207" y="27814"/>
                  </a:lnTo>
                  <a:lnTo>
                    <a:pt x="2208" y="27937"/>
                  </a:lnTo>
                  <a:lnTo>
                    <a:pt x="2208" y="28060"/>
                  </a:lnTo>
                  <a:lnTo>
                    <a:pt x="2207" y="28183"/>
                  </a:lnTo>
                  <a:lnTo>
                    <a:pt x="2207" y="28306"/>
                  </a:lnTo>
                  <a:lnTo>
                    <a:pt x="2206" y="28429"/>
                  </a:lnTo>
                  <a:lnTo>
                    <a:pt x="2204" y="28553"/>
                  </a:lnTo>
                  <a:lnTo>
                    <a:pt x="2203" y="28676"/>
                  </a:lnTo>
                  <a:lnTo>
                    <a:pt x="2201" y="28799"/>
                  </a:lnTo>
                  <a:lnTo>
                    <a:pt x="2199" y="28922"/>
                  </a:lnTo>
                  <a:lnTo>
                    <a:pt x="2197" y="29045"/>
                  </a:lnTo>
                  <a:lnTo>
                    <a:pt x="2194" y="29168"/>
                  </a:lnTo>
                  <a:lnTo>
                    <a:pt x="2191" y="29291"/>
                  </a:lnTo>
                  <a:lnTo>
                    <a:pt x="2188" y="29414"/>
                  </a:lnTo>
                  <a:lnTo>
                    <a:pt x="2185" y="29537"/>
                  </a:lnTo>
                  <a:lnTo>
                    <a:pt x="2181" y="29660"/>
                  </a:lnTo>
                  <a:lnTo>
                    <a:pt x="2177" y="29783"/>
                  </a:lnTo>
                  <a:lnTo>
                    <a:pt x="2173" y="29906"/>
                  </a:lnTo>
                  <a:lnTo>
                    <a:pt x="2169" y="30029"/>
                  </a:lnTo>
                  <a:lnTo>
                    <a:pt x="2165" y="30152"/>
                  </a:lnTo>
                  <a:lnTo>
                    <a:pt x="2160" y="30276"/>
                  </a:lnTo>
                  <a:lnTo>
                    <a:pt x="2156" y="30399"/>
                  </a:lnTo>
                  <a:lnTo>
                    <a:pt x="2151" y="30522"/>
                  </a:lnTo>
                  <a:lnTo>
                    <a:pt x="2146" y="30645"/>
                  </a:lnTo>
                  <a:lnTo>
                    <a:pt x="2140" y="30768"/>
                  </a:lnTo>
                  <a:lnTo>
                    <a:pt x="2135" y="30891"/>
                  </a:lnTo>
                  <a:lnTo>
                    <a:pt x="2130" y="31014"/>
                  </a:lnTo>
                  <a:lnTo>
                    <a:pt x="2124" y="31137"/>
                  </a:lnTo>
                  <a:lnTo>
                    <a:pt x="2119" y="31260"/>
                  </a:lnTo>
                  <a:lnTo>
                    <a:pt x="2113" y="31383"/>
                  </a:lnTo>
                  <a:lnTo>
                    <a:pt x="2107" y="31506"/>
                  </a:lnTo>
                  <a:lnTo>
                    <a:pt x="2101" y="31629"/>
                  </a:lnTo>
                  <a:lnTo>
                    <a:pt x="2096" y="31752"/>
                  </a:lnTo>
                  <a:lnTo>
                    <a:pt x="2090" y="31875"/>
                  </a:lnTo>
                  <a:lnTo>
                    <a:pt x="2084" y="31999"/>
                  </a:lnTo>
                  <a:lnTo>
                    <a:pt x="2078" y="32122"/>
                  </a:lnTo>
                  <a:lnTo>
                    <a:pt x="2072" y="32245"/>
                  </a:lnTo>
                  <a:lnTo>
                    <a:pt x="2066" y="32368"/>
                  </a:lnTo>
                  <a:lnTo>
                    <a:pt x="2060" y="32491"/>
                  </a:lnTo>
                  <a:lnTo>
                    <a:pt x="2054" y="32614"/>
                  </a:lnTo>
                  <a:lnTo>
                    <a:pt x="2049" y="32737"/>
                  </a:lnTo>
                  <a:lnTo>
                    <a:pt x="2043" y="32860"/>
                  </a:lnTo>
                  <a:lnTo>
                    <a:pt x="2037" y="32983"/>
                  </a:lnTo>
                  <a:lnTo>
                    <a:pt x="2032" y="33106"/>
                  </a:lnTo>
                  <a:lnTo>
                    <a:pt x="2026" y="33229"/>
                  </a:lnTo>
                  <a:lnTo>
                    <a:pt x="2021" y="33352"/>
                  </a:lnTo>
                  <a:lnTo>
                    <a:pt x="2015" y="33475"/>
                  </a:lnTo>
                  <a:lnTo>
                    <a:pt x="2010" y="33599"/>
                  </a:lnTo>
                  <a:lnTo>
                    <a:pt x="2005" y="33722"/>
                  </a:lnTo>
                  <a:lnTo>
                    <a:pt x="2000" y="33845"/>
                  </a:lnTo>
                  <a:lnTo>
                    <a:pt x="1995" y="33968"/>
                  </a:lnTo>
                  <a:lnTo>
                    <a:pt x="1991" y="34091"/>
                  </a:lnTo>
                  <a:lnTo>
                    <a:pt x="1986" y="34214"/>
                  </a:lnTo>
                  <a:lnTo>
                    <a:pt x="1982" y="34337"/>
                  </a:lnTo>
                  <a:lnTo>
                    <a:pt x="1978" y="34460"/>
                  </a:lnTo>
                  <a:lnTo>
                    <a:pt x="1974" y="34583"/>
                  </a:lnTo>
                  <a:lnTo>
                    <a:pt x="1970" y="34706"/>
                  </a:lnTo>
                  <a:lnTo>
                    <a:pt x="1966" y="34829"/>
                  </a:lnTo>
                  <a:lnTo>
                    <a:pt x="1963" y="34952"/>
                  </a:lnTo>
                  <a:lnTo>
                    <a:pt x="1959" y="35075"/>
                  </a:lnTo>
                  <a:lnTo>
                    <a:pt x="1956" y="35198"/>
                  </a:lnTo>
                  <a:lnTo>
                    <a:pt x="1953" y="35322"/>
                  </a:lnTo>
                  <a:lnTo>
                    <a:pt x="1950" y="35445"/>
                  </a:lnTo>
                  <a:lnTo>
                    <a:pt x="1948" y="35568"/>
                  </a:lnTo>
                  <a:lnTo>
                    <a:pt x="1945" y="35691"/>
                  </a:lnTo>
                  <a:lnTo>
                    <a:pt x="1943" y="35814"/>
                  </a:lnTo>
                  <a:lnTo>
                    <a:pt x="1941" y="35937"/>
                  </a:lnTo>
                  <a:lnTo>
                    <a:pt x="1939" y="36060"/>
                  </a:lnTo>
                  <a:lnTo>
                    <a:pt x="1938" y="36183"/>
                  </a:lnTo>
                  <a:lnTo>
                    <a:pt x="1936" y="36306"/>
                  </a:lnTo>
                  <a:lnTo>
                    <a:pt x="1935" y="36429"/>
                  </a:lnTo>
                  <a:lnTo>
                    <a:pt x="1934" y="36552"/>
                  </a:lnTo>
                  <a:lnTo>
                    <a:pt x="1933" y="36675"/>
                  </a:lnTo>
                  <a:lnTo>
                    <a:pt x="1932" y="36798"/>
                  </a:lnTo>
                  <a:lnTo>
                    <a:pt x="1931" y="36921"/>
                  </a:lnTo>
                  <a:lnTo>
                    <a:pt x="1930" y="37045"/>
                  </a:lnTo>
                  <a:lnTo>
                    <a:pt x="1930" y="37168"/>
                  </a:lnTo>
                  <a:lnTo>
                    <a:pt x="1930" y="37291"/>
                  </a:lnTo>
                  <a:lnTo>
                    <a:pt x="1930" y="37414"/>
                  </a:lnTo>
                  <a:lnTo>
                    <a:pt x="1930" y="37537"/>
                  </a:lnTo>
                  <a:lnTo>
                    <a:pt x="1930" y="37660"/>
                  </a:lnTo>
                  <a:lnTo>
                    <a:pt x="1930" y="37783"/>
                  </a:lnTo>
                  <a:lnTo>
                    <a:pt x="1930" y="37906"/>
                  </a:lnTo>
                  <a:lnTo>
                    <a:pt x="1930" y="38029"/>
                  </a:lnTo>
                  <a:lnTo>
                    <a:pt x="1931" y="38152"/>
                  </a:lnTo>
                  <a:lnTo>
                    <a:pt x="1931" y="38275"/>
                  </a:lnTo>
                  <a:lnTo>
                    <a:pt x="1932" y="38398"/>
                  </a:lnTo>
                  <a:lnTo>
                    <a:pt x="1932" y="38521"/>
                  </a:lnTo>
                  <a:lnTo>
                    <a:pt x="1933" y="38645"/>
                  </a:lnTo>
                  <a:lnTo>
                    <a:pt x="1933" y="38768"/>
                  </a:lnTo>
                  <a:lnTo>
                    <a:pt x="1934" y="38891"/>
                  </a:lnTo>
                  <a:lnTo>
                    <a:pt x="1935" y="39014"/>
                  </a:lnTo>
                  <a:lnTo>
                    <a:pt x="1935" y="39137"/>
                  </a:lnTo>
                  <a:lnTo>
                    <a:pt x="1936" y="39260"/>
                  </a:lnTo>
                  <a:lnTo>
                    <a:pt x="1936" y="39383"/>
                  </a:lnTo>
                  <a:lnTo>
                    <a:pt x="1936" y="39506"/>
                  </a:lnTo>
                  <a:lnTo>
                    <a:pt x="1937" y="39629"/>
                  </a:lnTo>
                  <a:lnTo>
                    <a:pt x="1937" y="39752"/>
                  </a:lnTo>
                  <a:lnTo>
                    <a:pt x="1937" y="39875"/>
                  </a:lnTo>
                  <a:lnTo>
                    <a:pt x="1937" y="39998"/>
                  </a:lnTo>
                  <a:lnTo>
                    <a:pt x="1937" y="40121"/>
                  </a:lnTo>
                  <a:lnTo>
                    <a:pt x="1936" y="40244"/>
                  </a:lnTo>
                  <a:lnTo>
                    <a:pt x="1936" y="40368"/>
                  </a:lnTo>
                  <a:lnTo>
                    <a:pt x="1935" y="40491"/>
                  </a:lnTo>
                  <a:lnTo>
                    <a:pt x="1935" y="40614"/>
                  </a:lnTo>
                  <a:lnTo>
                    <a:pt x="1934" y="40737"/>
                  </a:lnTo>
                  <a:lnTo>
                    <a:pt x="1932" y="40860"/>
                  </a:lnTo>
                  <a:lnTo>
                    <a:pt x="1931" y="40983"/>
                  </a:lnTo>
                  <a:lnTo>
                    <a:pt x="1929" y="41106"/>
                  </a:lnTo>
                  <a:lnTo>
                    <a:pt x="1927" y="41229"/>
                  </a:lnTo>
                  <a:lnTo>
                    <a:pt x="1925" y="41352"/>
                  </a:lnTo>
                  <a:lnTo>
                    <a:pt x="1923" y="41475"/>
                  </a:lnTo>
                  <a:lnTo>
                    <a:pt x="1920" y="41598"/>
                  </a:lnTo>
                  <a:lnTo>
                    <a:pt x="1917" y="41721"/>
                  </a:lnTo>
                  <a:lnTo>
                    <a:pt x="1914" y="41844"/>
                  </a:lnTo>
                  <a:lnTo>
                    <a:pt x="1910" y="41967"/>
                  </a:lnTo>
                  <a:lnTo>
                    <a:pt x="1906" y="42091"/>
                  </a:lnTo>
                  <a:lnTo>
                    <a:pt x="1902" y="42214"/>
                  </a:lnTo>
                  <a:lnTo>
                    <a:pt x="1898" y="42337"/>
                  </a:lnTo>
                  <a:lnTo>
                    <a:pt x="1893" y="42460"/>
                  </a:lnTo>
                  <a:lnTo>
                    <a:pt x="1888" y="42583"/>
                  </a:lnTo>
                  <a:lnTo>
                    <a:pt x="1882" y="42706"/>
                  </a:lnTo>
                  <a:lnTo>
                    <a:pt x="1876" y="42829"/>
                  </a:lnTo>
                  <a:lnTo>
                    <a:pt x="1870" y="42952"/>
                  </a:lnTo>
                  <a:lnTo>
                    <a:pt x="1863" y="43075"/>
                  </a:lnTo>
                  <a:lnTo>
                    <a:pt x="1856" y="43198"/>
                  </a:lnTo>
                  <a:lnTo>
                    <a:pt x="1849" y="43321"/>
                  </a:lnTo>
                  <a:lnTo>
                    <a:pt x="1841" y="43444"/>
                  </a:lnTo>
                  <a:lnTo>
                    <a:pt x="1833" y="43567"/>
                  </a:lnTo>
                  <a:lnTo>
                    <a:pt x="1824" y="43691"/>
                  </a:lnTo>
                  <a:lnTo>
                    <a:pt x="1816" y="43814"/>
                  </a:lnTo>
                  <a:lnTo>
                    <a:pt x="1806" y="43937"/>
                  </a:lnTo>
                  <a:lnTo>
                    <a:pt x="1797" y="44060"/>
                  </a:lnTo>
                  <a:lnTo>
                    <a:pt x="1786" y="44183"/>
                  </a:lnTo>
                  <a:lnTo>
                    <a:pt x="1776" y="44306"/>
                  </a:lnTo>
                  <a:lnTo>
                    <a:pt x="1765" y="44429"/>
                  </a:lnTo>
                  <a:lnTo>
                    <a:pt x="1754" y="44552"/>
                  </a:lnTo>
                  <a:lnTo>
                    <a:pt x="1742" y="44675"/>
                  </a:lnTo>
                  <a:lnTo>
                    <a:pt x="1730" y="44798"/>
                  </a:lnTo>
                  <a:lnTo>
                    <a:pt x="1718" y="44921"/>
                  </a:lnTo>
                  <a:lnTo>
                    <a:pt x="1705" y="45044"/>
                  </a:lnTo>
                  <a:lnTo>
                    <a:pt x="1692" y="45167"/>
                  </a:lnTo>
                  <a:lnTo>
                    <a:pt x="1679" y="45290"/>
                  </a:lnTo>
                  <a:lnTo>
                    <a:pt x="1665" y="45414"/>
                  </a:lnTo>
                  <a:lnTo>
                    <a:pt x="1651" y="45537"/>
                  </a:lnTo>
                  <a:lnTo>
                    <a:pt x="1636" y="45660"/>
                  </a:lnTo>
                  <a:lnTo>
                    <a:pt x="1622" y="45783"/>
                  </a:lnTo>
                  <a:lnTo>
                    <a:pt x="1606" y="45906"/>
                  </a:lnTo>
                  <a:lnTo>
                    <a:pt x="1591" y="46029"/>
                  </a:lnTo>
                  <a:lnTo>
                    <a:pt x="1575" y="46152"/>
                  </a:lnTo>
                  <a:lnTo>
                    <a:pt x="1559" y="46275"/>
                  </a:lnTo>
                  <a:lnTo>
                    <a:pt x="1543" y="46398"/>
                  </a:lnTo>
                  <a:lnTo>
                    <a:pt x="1526" y="46521"/>
                  </a:lnTo>
                  <a:lnTo>
                    <a:pt x="1509" y="46644"/>
                  </a:lnTo>
                  <a:lnTo>
                    <a:pt x="1492" y="46767"/>
                  </a:lnTo>
                  <a:lnTo>
                    <a:pt x="1475" y="46890"/>
                  </a:lnTo>
                  <a:lnTo>
                    <a:pt x="1457" y="47013"/>
                  </a:lnTo>
                  <a:lnTo>
                    <a:pt x="1439" y="47137"/>
                  </a:lnTo>
                  <a:lnTo>
                    <a:pt x="1421" y="47260"/>
                  </a:lnTo>
                  <a:lnTo>
                    <a:pt x="1403" y="47383"/>
                  </a:lnTo>
                  <a:lnTo>
                    <a:pt x="1385" y="47506"/>
                  </a:lnTo>
                  <a:lnTo>
                    <a:pt x="1366" y="47629"/>
                  </a:lnTo>
                  <a:lnTo>
                    <a:pt x="1347" y="47752"/>
                  </a:lnTo>
                  <a:lnTo>
                    <a:pt x="1328" y="47875"/>
                  </a:lnTo>
                  <a:lnTo>
                    <a:pt x="1309" y="47998"/>
                  </a:lnTo>
                  <a:lnTo>
                    <a:pt x="1290" y="48121"/>
                  </a:lnTo>
                  <a:lnTo>
                    <a:pt x="1270" y="48244"/>
                  </a:lnTo>
                  <a:lnTo>
                    <a:pt x="1251" y="48367"/>
                  </a:lnTo>
                  <a:lnTo>
                    <a:pt x="1231" y="48490"/>
                  </a:lnTo>
                  <a:lnTo>
                    <a:pt x="1212" y="48613"/>
                  </a:lnTo>
                  <a:lnTo>
                    <a:pt x="1192" y="48737"/>
                  </a:lnTo>
                  <a:lnTo>
                    <a:pt x="1172" y="48860"/>
                  </a:lnTo>
                  <a:lnTo>
                    <a:pt x="1152" y="48983"/>
                  </a:lnTo>
                  <a:lnTo>
                    <a:pt x="1132" y="49106"/>
                  </a:lnTo>
                  <a:lnTo>
                    <a:pt x="1113" y="49229"/>
                  </a:lnTo>
                  <a:lnTo>
                    <a:pt x="1093" y="49352"/>
                  </a:lnTo>
                  <a:lnTo>
                    <a:pt x="1073" y="49475"/>
                  </a:lnTo>
                  <a:lnTo>
                    <a:pt x="1053" y="49598"/>
                  </a:lnTo>
                  <a:lnTo>
                    <a:pt x="1033" y="49721"/>
                  </a:lnTo>
                  <a:lnTo>
                    <a:pt x="1013" y="49844"/>
                  </a:lnTo>
                  <a:lnTo>
                    <a:pt x="994" y="49967"/>
                  </a:lnTo>
                  <a:lnTo>
                    <a:pt x="974" y="50090"/>
                  </a:lnTo>
                  <a:lnTo>
                    <a:pt x="954" y="50213"/>
                  </a:lnTo>
                  <a:lnTo>
                    <a:pt x="935" y="50336"/>
                  </a:lnTo>
                  <a:lnTo>
                    <a:pt x="915" y="50460"/>
                  </a:lnTo>
                  <a:lnTo>
                    <a:pt x="896" y="50583"/>
                  </a:lnTo>
                  <a:lnTo>
                    <a:pt x="877" y="50706"/>
                  </a:lnTo>
                  <a:lnTo>
                    <a:pt x="858" y="50829"/>
                  </a:lnTo>
                  <a:lnTo>
                    <a:pt x="839" y="50952"/>
                  </a:lnTo>
                  <a:lnTo>
                    <a:pt x="820" y="51075"/>
                  </a:lnTo>
                  <a:lnTo>
                    <a:pt x="801" y="51198"/>
                  </a:lnTo>
                  <a:lnTo>
                    <a:pt x="783" y="51321"/>
                  </a:lnTo>
                  <a:lnTo>
                    <a:pt x="765" y="51444"/>
                  </a:lnTo>
                  <a:lnTo>
                    <a:pt x="747" y="51567"/>
                  </a:lnTo>
                  <a:lnTo>
                    <a:pt x="729" y="51690"/>
                  </a:lnTo>
                  <a:lnTo>
                    <a:pt x="711" y="51813"/>
                  </a:lnTo>
                  <a:lnTo>
                    <a:pt x="693" y="51936"/>
                  </a:lnTo>
                  <a:lnTo>
                    <a:pt x="676" y="52059"/>
                  </a:lnTo>
                  <a:lnTo>
                    <a:pt x="659" y="52183"/>
                  </a:lnTo>
                  <a:lnTo>
                    <a:pt x="642" y="52306"/>
                  </a:lnTo>
                  <a:lnTo>
                    <a:pt x="625" y="52429"/>
                  </a:lnTo>
                  <a:lnTo>
                    <a:pt x="609" y="52552"/>
                  </a:lnTo>
                  <a:lnTo>
                    <a:pt x="592" y="52675"/>
                  </a:lnTo>
                  <a:lnTo>
                    <a:pt x="576" y="52798"/>
                  </a:lnTo>
                  <a:lnTo>
                    <a:pt x="561" y="52921"/>
                  </a:lnTo>
                  <a:lnTo>
                    <a:pt x="545" y="53044"/>
                  </a:lnTo>
                  <a:lnTo>
                    <a:pt x="530" y="53167"/>
                  </a:lnTo>
                  <a:lnTo>
                    <a:pt x="515" y="53290"/>
                  </a:lnTo>
                  <a:lnTo>
                    <a:pt x="500" y="53413"/>
                  </a:lnTo>
                  <a:lnTo>
                    <a:pt x="486" y="53536"/>
                  </a:lnTo>
                  <a:lnTo>
                    <a:pt x="471" y="53659"/>
                  </a:lnTo>
                  <a:lnTo>
                    <a:pt x="457" y="53783"/>
                  </a:lnTo>
                  <a:lnTo>
                    <a:pt x="444" y="53906"/>
                  </a:lnTo>
                  <a:lnTo>
                    <a:pt x="430" y="54029"/>
                  </a:lnTo>
                  <a:lnTo>
                    <a:pt x="417" y="54152"/>
                  </a:lnTo>
                  <a:lnTo>
                    <a:pt x="404" y="54275"/>
                  </a:lnTo>
                  <a:lnTo>
                    <a:pt x="391" y="54398"/>
                  </a:lnTo>
                  <a:lnTo>
                    <a:pt x="379" y="54521"/>
                  </a:lnTo>
                  <a:lnTo>
                    <a:pt x="367" y="54644"/>
                  </a:lnTo>
                  <a:lnTo>
                    <a:pt x="355" y="54767"/>
                  </a:lnTo>
                  <a:lnTo>
                    <a:pt x="343" y="54890"/>
                  </a:lnTo>
                  <a:lnTo>
                    <a:pt x="332" y="55013"/>
                  </a:lnTo>
                  <a:lnTo>
                    <a:pt x="321" y="55136"/>
                  </a:lnTo>
                  <a:lnTo>
                    <a:pt x="310" y="55259"/>
                  </a:lnTo>
                  <a:lnTo>
                    <a:pt x="300" y="55382"/>
                  </a:lnTo>
                  <a:lnTo>
                    <a:pt x="289" y="55506"/>
                  </a:lnTo>
                  <a:lnTo>
                    <a:pt x="279" y="55629"/>
                  </a:lnTo>
                  <a:lnTo>
                    <a:pt x="270" y="55752"/>
                  </a:lnTo>
                  <a:lnTo>
                    <a:pt x="260" y="55875"/>
                  </a:lnTo>
                  <a:lnTo>
                    <a:pt x="251" y="55998"/>
                  </a:lnTo>
                  <a:lnTo>
                    <a:pt x="242" y="56121"/>
                  </a:lnTo>
                  <a:lnTo>
                    <a:pt x="233" y="56244"/>
                  </a:lnTo>
                  <a:lnTo>
                    <a:pt x="224" y="56367"/>
                  </a:lnTo>
                  <a:lnTo>
                    <a:pt x="216" y="56490"/>
                  </a:lnTo>
                  <a:lnTo>
                    <a:pt x="208" y="56613"/>
                  </a:lnTo>
                  <a:lnTo>
                    <a:pt x="200" y="56736"/>
                  </a:lnTo>
                  <a:lnTo>
                    <a:pt x="193" y="56859"/>
                  </a:lnTo>
                  <a:lnTo>
                    <a:pt x="185" y="56982"/>
                  </a:lnTo>
                  <a:lnTo>
                    <a:pt x="178" y="57106"/>
                  </a:lnTo>
                  <a:lnTo>
                    <a:pt x="171" y="57229"/>
                  </a:lnTo>
                  <a:lnTo>
                    <a:pt x="164" y="57352"/>
                  </a:lnTo>
                  <a:lnTo>
                    <a:pt x="158" y="57475"/>
                  </a:lnTo>
                  <a:lnTo>
                    <a:pt x="152" y="57598"/>
                  </a:lnTo>
                  <a:lnTo>
                    <a:pt x="145" y="57721"/>
                  </a:lnTo>
                  <a:lnTo>
                    <a:pt x="139" y="57844"/>
                  </a:lnTo>
                  <a:lnTo>
                    <a:pt x="134" y="57967"/>
                  </a:lnTo>
                  <a:lnTo>
                    <a:pt x="128" y="58090"/>
                  </a:lnTo>
                  <a:lnTo>
                    <a:pt x="123" y="58213"/>
                  </a:lnTo>
                  <a:lnTo>
                    <a:pt x="118" y="58336"/>
                  </a:lnTo>
                  <a:lnTo>
                    <a:pt x="113" y="58459"/>
                  </a:lnTo>
                  <a:lnTo>
                    <a:pt x="108" y="58582"/>
                  </a:lnTo>
                  <a:lnTo>
                    <a:pt x="103" y="58705"/>
                  </a:lnTo>
                  <a:lnTo>
                    <a:pt x="99" y="58829"/>
                  </a:lnTo>
                  <a:lnTo>
                    <a:pt x="94" y="58952"/>
                  </a:lnTo>
                  <a:lnTo>
                    <a:pt x="90" y="59075"/>
                  </a:lnTo>
                  <a:lnTo>
                    <a:pt x="86" y="59198"/>
                  </a:lnTo>
                  <a:lnTo>
                    <a:pt x="82" y="59321"/>
                  </a:lnTo>
                  <a:lnTo>
                    <a:pt x="79" y="59444"/>
                  </a:lnTo>
                  <a:lnTo>
                    <a:pt x="75" y="59567"/>
                  </a:lnTo>
                  <a:lnTo>
                    <a:pt x="72" y="59690"/>
                  </a:lnTo>
                  <a:lnTo>
                    <a:pt x="68" y="59813"/>
                  </a:lnTo>
                  <a:lnTo>
                    <a:pt x="65" y="59936"/>
                  </a:lnTo>
                  <a:lnTo>
                    <a:pt x="62" y="60059"/>
                  </a:lnTo>
                  <a:lnTo>
                    <a:pt x="59" y="60182"/>
                  </a:lnTo>
                  <a:lnTo>
                    <a:pt x="56" y="60305"/>
                  </a:lnTo>
                  <a:lnTo>
                    <a:pt x="54" y="60428"/>
                  </a:lnTo>
                  <a:lnTo>
                    <a:pt x="51" y="60552"/>
                  </a:lnTo>
                  <a:lnTo>
                    <a:pt x="49" y="60675"/>
                  </a:lnTo>
                  <a:lnTo>
                    <a:pt x="46" y="60798"/>
                  </a:lnTo>
                  <a:lnTo>
                    <a:pt x="44" y="60921"/>
                  </a:lnTo>
                  <a:lnTo>
                    <a:pt x="42" y="61044"/>
                  </a:lnTo>
                  <a:lnTo>
                    <a:pt x="40" y="61167"/>
                  </a:lnTo>
                  <a:lnTo>
                    <a:pt x="38" y="61290"/>
                  </a:lnTo>
                  <a:lnTo>
                    <a:pt x="36" y="61413"/>
                  </a:lnTo>
                  <a:lnTo>
                    <a:pt x="34" y="61536"/>
                  </a:lnTo>
                  <a:lnTo>
                    <a:pt x="32" y="61659"/>
                  </a:lnTo>
                  <a:lnTo>
                    <a:pt x="31" y="61782"/>
                  </a:lnTo>
                  <a:lnTo>
                    <a:pt x="29" y="61905"/>
                  </a:lnTo>
                  <a:lnTo>
                    <a:pt x="27" y="62028"/>
                  </a:lnTo>
                  <a:lnTo>
                    <a:pt x="26" y="62152"/>
                  </a:lnTo>
                  <a:lnTo>
                    <a:pt x="25" y="62275"/>
                  </a:lnTo>
                  <a:lnTo>
                    <a:pt x="23" y="62398"/>
                  </a:lnTo>
                  <a:lnTo>
                    <a:pt x="22" y="62521"/>
                  </a:lnTo>
                  <a:lnTo>
                    <a:pt x="21" y="62644"/>
                  </a:lnTo>
                  <a:lnTo>
                    <a:pt x="20" y="62767"/>
                  </a:lnTo>
                  <a:lnTo>
                    <a:pt x="19" y="62890"/>
                  </a:lnTo>
                  <a:lnTo>
                    <a:pt x="0" y="62890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52" name="pl34"/>
            <p:cNvSpPr/>
            <p:nvPr/>
          </p:nvSpPr>
          <p:spPr>
            <a:xfrm>
              <a:off x="4712100" y="3383594"/>
              <a:ext cx="244" cy="572967"/>
            </a:xfrm>
            <a:custGeom>
              <a:avLst/>
              <a:gdLst/>
              <a:ahLst/>
              <a:cxnLst/>
              <a:rect l="0" t="0" r="0" b="0"/>
              <a:pathLst>
                <a:path w="244" h="572967">
                  <a:moveTo>
                    <a:pt x="244" y="572967"/>
                  </a:moveTo>
                  <a:lnTo>
                    <a:pt x="243" y="572967"/>
                  </a:lnTo>
                  <a:lnTo>
                    <a:pt x="243" y="571845"/>
                  </a:lnTo>
                  <a:lnTo>
                    <a:pt x="243" y="570724"/>
                  </a:lnTo>
                  <a:lnTo>
                    <a:pt x="243" y="569603"/>
                  </a:lnTo>
                  <a:lnTo>
                    <a:pt x="242" y="568481"/>
                  </a:lnTo>
                  <a:lnTo>
                    <a:pt x="242" y="567360"/>
                  </a:lnTo>
                  <a:lnTo>
                    <a:pt x="242" y="566239"/>
                  </a:lnTo>
                  <a:lnTo>
                    <a:pt x="242" y="565118"/>
                  </a:lnTo>
                  <a:lnTo>
                    <a:pt x="242" y="563996"/>
                  </a:lnTo>
                  <a:lnTo>
                    <a:pt x="242" y="562875"/>
                  </a:lnTo>
                  <a:lnTo>
                    <a:pt x="242" y="561754"/>
                  </a:lnTo>
                  <a:lnTo>
                    <a:pt x="241" y="560633"/>
                  </a:lnTo>
                  <a:lnTo>
                    <a:pt x="241" y="559511"/>
                  </a:lnTo>
                  <a:lnTo>
                    <a:pt x="241" y="558390"/>
                  </a:lnTo>
                  <a:lnTo>
                    <a:pt x="241" y="557269"/>
                  </a:lnTo>
                  <a:lnTo>
                    <a:pt x="241" y="556148"/>
                  </a:lnTo>
                  <a:lnTo>
                    <a:pt x="240" y="555026"/>
                  </a:lnTo>
                  <a:lnTo>
                    <a:pt x="240" y="553905"/>
                  </a:lnTo>
                  <a:lnTo>
                    <a:pt x="240" y="552784"/>
                  </a:lnTo>
                  <a:lnTo>
                    <a:pt x="240" y="551662"/>
                  </a:lnTo>
                  <a:lnTo>
                    <a:pt x="239" y="550541"/>
                  </a:lnTo>
                  <a:lnTo>
                    <a:pt x="239" y="549420"/>
                  </a:lnTo>
                  <a:lnTo>
                    <a:pt x="239" y="548299"/>
                  </a:lnTo>
                  <a:lnTo>
                    <a:pt x="239" y="547177"/>
                  </a:lnTo>
                  <a:lnTo>
                    <a:pt x="238" y="546056"/>
                  </a:lnTo>
                  <a:lnTo>
                    <a:pt x="238" y="544935"/>
                  </a:lnTo>
                  <a:lnTo>
                    <a:pt x="238" y="543814"/>
                  </a:lnTo>
                  <a:lnTo>
                    <a:pt x="237" y="542692"/>
                  </a:lnTo>
                  <a:lnTo>
                    <a:pt x="237" y="541571"/>
                  </a:lnTo>
                  <a:lnTo>
                    <a:pt x="236" y="540450"/>
                  </a:lnTo>
                  <a:lnTo>
                    <a:pt x="236" y="539329"/>
                  </a:lnTo>
                  <a:lnTo>
                    <a:pt x="235" y="538207"/>
                  </a:lnTo>
                  <a:lnTo>
                    <a:pt x="235" y="537086"/>
                  </a:lnTo>
                  <a:lnTo>
                    <a:pt x="235" y="535965"/>
                  </a:lnTo>
                  <a:lnTo>
                    <a:pt x="234" y="534843"/>
                  </a:lnTo>
                  <a:lnTo>
                    <a:pt x="234" y="533722"/>
                  </a:lnTo>
                  <a:lnTo>
                    <a:pt x="233" y="532601"/>
                  </a:lnTo>
                  <a:lnTo>
                    <a:pt x="232" y="531480"/>
                  </a:lnTo>
                  <a:lnTo>
                    <a:pt x="232" y="530358"/>
                  </a:lnTo>
                  <a:lnTo>
                    <a:pt x="231" y="529237"/>
                  </a:lnTo>
                  <a:lnTo>
                    <a:pt x="231" y="528116"/>
                  </a:lnTo>
                  <a:lnTo>
                    <a:pt x="230" y="526995"/>
                  </a:lnTo>
                  <a:lnTo>
                    <a:pt x="229" y="525873"/>
                  </a:lnTo>
                  <a:lnTo>
                    <a:pt x="228" y="524752"/>
                  </a:lnTo>
                  <a:lnTo>
                    <a:pt x="228" y="523631"/>
                  </a:lnTo>
                  <a:lnTo>
                    <a:pt x="227" y="522510"/>
                  </a:lnTo>
                  <a:lnTo>
                    <a:pt x="226" y="521388"/>
                  </a:lnTo>
                  <a:lnTo>
                    <a:pt x="225" y="520267"/>
                  </a:lnTo>
                  <a:lnTo>
                    <a:pt x="224" y="519146"/>
                  </a:lnTo>
                  <a:lnTo>
                    <a:pt x="223" y="518024"/>
                  </a:lnTo>
                  <a:lnTo>
                    <a:pt x="222" y="516903"/>
                  </a:lnTo>
                  <a:lnTo>
                    <a:pt x="221" y="515782"/>
                  </a:lnTo>
                  <a:lnTo>
                    <a:pt x="220" y="514661"/>
                  </a:lnTo>
                  <a:lnTo>
                    <a:pt x="219" y="513539"/>
                  </a:lnTo>
                  <a:lnTo>
                    <a:pt x="218" y="512418"/>
                  </a:lnTo>
                  <a:lnTo>
                    <a:pt x="217" y="511297"/>
                  </a:lnTo>
                  <a:lnTo>
                    <a:pt x="216" y="510176"/>
                  </a:lnTo>
                  <a:lnTo>
                    <a:pt x="215" y="509054"/>
                  </a:lnTo>
                  <a:lnTo>
                    <a:pt x="214" y="507933"/>
                  </a:lnTo>
                  <a:lnTo>
                    <a:pt x="212" y="506812"/>
                  </a:lnTo>
                  <a:lnTo>
                    <a:pt x="211" y="505691"/>
                  </a:lnTo>
                  <a:lnTo>
                    <a:pt x="210" y="504569"/>
                  </a:lnTo>
                  <a:lnTo>
                    <a:pt x="208" y="503448"/>
                  </a:lnTo>
                  <a:lnTo>
                    <a:pt x="207" y="502327"/>
                  </a:lnTo>
                  <a:lnTo>
                    <a:pt x="206" y="501205"/>
                  </a:lnTo>
                  <a:lnTo>
                    <a:pt x="204" y="500084"/>
                  </a:lnTo>
                  <a:lnTo>
                    <a:pt x="203" y="498963"/>
                  </a:lnTo>
                  <a:lnTo>
                    <a:pt x="201" y="497842"/>
                  </a:lnTo>
                  <a:lnTo>
                    <a:pt x="199" y="496720"/>
                  </a:lnTo>
                  <a:lnTo>
                    <a:pt x="198" y="495599"/>
                  </a:lnTo>
                  <a:lnTo>
                    <a:pt x="196" y="494478"/>
                  </a:lnTo>
                  <a:lnTo>
                    <a:pt x="194" y="493357"/>
                  </a:lnTo>
                  <a:lnTo>
                    <a:pt x="193" y="492235"/>
                  </a:lnTo>
                  <a:lnTo>
                    <a:pt x="191" y="491114"/>
                  </a:lnTo>
                  <a:lnTo>
                    <a:pt x="189" y="489993"/>
                  </a:lnTo>
                  <a:lnTo>
                    <a:pt x="187" y="488872"/>
                  </a:lnTo>
                  <a:lnTo>
                    <a:pt x="185" y="487750"/>
                  </a:lnTo>
                  <a:lnTo>
                    <a:pt x="183" y="486629"/>
                  </a:lnTo>
                  <a:lnTo>
                    <a:pt x="181" y="485508"/>
                  </a:lnTo>
                  <a:lnTo>
                    <a:pt x="179" y="484386"/>
                  </a:lnTo>
                  <a:lnTo>
                    <a:pt x="177" y="483265"/>
                  </a:lnTo>
                  <a:lnTo>
                    <a:pt x="175" y="482144"/>
                  </a:lnTo>
                  <a:lnTo>
                    <a:pt x="173" y="481023"/>
                  </a:lnTo>
                  <a:lnTo>
                    <a:pt x="171" y="479901"/>
                  </a:lnTo>
                  <a:lnTo>
                    <a:pt x="168" y="478780"/>
                  </a:lnTo>
                  <a:lnTo>
                    <a:pt x="166" y="477659"/>
                  </a:lnTo>
                  <a:lnTo>
                    <a:pt x="164" y="476538"/>
                  </a:lnTo>
                  <a:lnTo>
                    <a:pt x="162" y="475416"/>
                  </a:lnTo>
                  <a:lnTo>
                    <a:pt x="159" y="474295"/>
                  </a:lnTo>
                  <a:lnTo>
                    <a:pt x="157" y="473174"/>
                  </a:lnTo>
                  <a:lnTo>
                    <a:pt x="154" y="472053"/>
                  </a:lnTo>
                  <a:lnTo>
                    <a:pt x="152" y="470931"/>
                  </a:lnTo>
                  <a:lnTo>
                    <a:pt x="150" y="469810"/>
                  </a:lnTo>
                  <a:lnTo>
                    <a:pt x="147" y="468689"/>
                  </a:lnTo>
                  <a:lnTo>
                    <a:pt x="145" y="467567"/>
                  </a:lnTo>
                  <a:lnTo>
                    <a:pt x="142" y="466446"/>
                  </a:lnTo>
                  <a:lnTo>
                    <a:pt x="139" y="465325"/>
                  </a:lnTo>
                  <a:lnTo>
                    <a:pt x="137" y="464204"/>
                  </a:lnTo>
                  <a:lnTo>
                    <a:pt x="134" y="463082"/>
                  </a:lnTo>
                  <a:lnTo>
                    <a:pt x="132" y="461961"/>
                  </a:lnTo>
                  <a:lnTo>
                    <a:pt x="129" y="460840"/>
                  </a:lnTo>
                  <a:lnTo>
                    <a:pt x="126" y="459719"/>
                  </a:lnTo>
                  <a:lnTo>
                    <a:pt x="124" y="458597"/>
                  </a:lnTo>
                  <a:lnTo>
                    <a:pt x="121" y="457476"/>
                  </a:lnTo>
                  <a:lnTo>
                    <a:pt x="118" y="456355"/>
                  </a:lnTo>
                  <a:lnTo>
                    <a:pt x="116" y="455234"/>
                  </a:lnTo>
                  <a:lnTo>
                    <a:pt x="113" y="454112"/>
                  </a:lnTo>
                  <a:lnTo>
                    <a:pt x="110" y="452991"/>
                  </a:lnTo>
                  <a:lnTo>
                    <a:pt x="108" y="451870"/>
                  </a:lnTo>
                  <a:lnTo>
                    <a:pt x="105" y="450748"/>
                  </a:lnTo>
                  <a:lnTo>
                    <a:pt x="102" y="449627"/>
                  </a:lnTo>
                  <a:lnTo>
                    <a:pt x="100" y="448506"/>
                  </a:lnTo>
                  <a:lnTo>
                    <a:pt x="97" y="447385"/>
                  </a:lnTo>
                  <a:lnTo>
                    <a:pt x="94" y="446263"/>
                  </a:lnTo>
                  <a:lnTo>
                    <a:pt x="92" y="445142"/>
                  </a:lnTo>
                  <a:lnTo>
                    <a:pt x="89" y="444021"/>
                  </a:lnTo>
                  <a:lnTo>
                    <a:pt x="87" y="442900"/>
                  </a:lnTo>
                  <a:lnTo>
                    <a:pt x="84" y="441778"/>
                  </a:lnTo>
                  <a:lnTo>
                    <a:pt x="82" y="440657"/>
                  </a:lnTo>
                  <a:lnTo>
                    <a:pt x="79" y="439536"/>
                  </a:lnTo>
                  <a:lnTo>
                    <a:pt x="76" y="438415"/>
                  </a:lnTo>
                  <a:lnTo>
                    <a:pt x="74" y="437293"/>
                  </a:lnTo>
                  <a:lnTo>
                    <a:pt x="72" y="436172"/>
                  </a:lnTo>
                  <a:lnTo>
                    <a:pt x="69" y="435051"/>
                  </a:lnTo>
                  <a:lnTo>
                    <a:pt x="67" y="433930"/>
                  </a:lnTo>
                  <a:lnTo>
                    <a:pt x="64" y="432808"/>
                  </a:lnTo>
                  <a:lnTo>
                    <a:pt x="62" y="431687"/>
                  </a:lnTo>
                  <a:lnTo>
                    <a:pt x="60" y="430566"/>
                  </a:lnTo>
                  <a:lnTo>
                    <a:pt x="58" y="429444"/>
                  </a:lnTo>
                  <a:lnTo>
                    <a:pt x="55" y="428323"/>
                  </a:lnTo>
                  <a:lnTo>
                    <a:pt x="53" y="427202"/>
                  </a:lnTo>
                  <a:lnTo>
                    <a:pt x="51" y="426081"/>
                  </a:lnTo>
                  <a:lnTo>
                    <a:pt x="49" y="424959"/>
                  </a:lnTo>
                  <a:lnTo>
                    <a:pt x="47" y="423838"/>
                  </a:lnTo>
                  <a:lnTo>
                    <a:pt x="45" y="422717"/>
                  </a:lnTo>
                  <a:lnTo>
                    <a:pt x="43" y="421596"/>
                  </a:lnTo>
                  <a:lnTo>
                    <a:pt x="41" y="420474"/>
                  </a:lnTo>
                  <a:lnTo>
                    <a:pt x="39" y="419353"/>
                  </a:lnTo>
                  <a:lnTo>
                    <a:pt x="38" y="418232"/>
                  </a:lnTo>
                  <a:lnTo>
                    <a:pt x="36" y="417111"/>
                  </a:lnTo>
                  <a:lnTo>
                    <a:pt x="34" y="415989"/>
                  </a:lnTo>
                  <a:lnTo>
                    <a:pt x="33" y="414868"/>
                  </a:lnTo>
                  <a:lnTo>
                    <a:pt x="31" y="413747"/>
                  </a:lnTo>
                  <a:lnTo>
                    <a:pt x="30" y="412625"/>
                  </a:lnTo>
                  <a:lnTo>
                    <a:pt x="28" y="411504"/>
                  </a:lnTo>
                  <a:lnTo>
                    <a:pt x="27" y="410383"/>
                  </a:lnTo>
                  <a:lnTo>
                    <a:pt x="26" y="409262"/>
                  </a:lnTo>
                  <a:lnTo>
                    <a:pt x="24" y="408140"/>
                  </a:lnTo>
                  <a:lnTo>
                    <a:pt x="23" y="407019"/>
                  </a:lnTo>
                  <a:lnTo>
                    <a:pt x="22" y="405898"/>
                  </a:lnTo>
                  <a:lnTo>
                    <a:pt x="21" y="404777"/>
                  </a:lnTo>
                  <a:lnTo>
                    <a:pt x="20" y="403655"/>
                  </a:lnTo>
                  <a:lnTo>
                    <a:pt x="19" y="402534"/>
                  </a:lnTo>
                  <a:lnTo>
                    <a:pt x="18" y="401413"/>
                  </a:lnTo>
                  <a:lnTo>
                    <a:pt x="17" y="400292"/>
                  </a:lnTo>
                  <a:lnTo>
                    <a:pt x="16" y="399170"/>
                  </a:lnTo>
                  <a:lnTo>
                    <a:pt x="15" y="398049"/>
                  </a:lnTo>
                  <a:lnTo>
                    <a:pt x="15" y="396928"/>
                  </a:lnTo>
                  <a:lnTo>
                    <a:pt x="14" y="395806"/>
                  </a:lnTo>
                  <a:lnTo>
                    <a:pt x="13" y="394685"/>
                  </a:lnTo>
                  <a:lnTo>
                    <a:pt x="13" y="393564"/>
                  </a:lnTo>
                  <a:lnTo>
                    <a:pt x="12" y="392443"/>
                  </a:lnTo>
                  <a:lnTo>
                    <a:pt x="12" y="391321"/>
                  </a:lnTo>
                  <a:lnTo>
                    <a:pt x="11" y="390200"/>
                  </a:lnTo>
                  <a:lnTo>
                    <a:pt x="11" y="389079"/>
                  </a:lnTo>
                  <a:lnTo>
                    <a:pt x="11" y="387958"/>
                  </a:lnTo>
                  <a:lnTo>
                    <a:pt x="10" y="386836"/>
                  </a:lnTo>
                  <a:lnTo>
                    <a:pt x="10" y="385715"/>
                  </a:lnTo>
                  <a:lnTo>
                    <a:pt x="10" y="384594"/>
                  </a:lnTo>
                  <a:lnTo>
                    <a:pt x="10" y="383473"/>
                  </a:lnTo>
                  <a:lnTo>
                    <a:pt x="9" y="382351"/>
                  </a:lnTo>
                  <a:lnTo>
                    <a:pt x="9" y="381230"/>
                  </a:lnTo>
                  <a:lnTo>
                    <a:pt x="9" y="380109"/>
                  </a:lnTo>
                  <a:lnTo>
                    <a:pt x="9" y="378987"/>
                  </a:lnTo>
                  <a:lnTo>
                    <a:pt x="9" y="377866"/>
                  </a:lnTo>
                  <a:lnTo>
                    <a:pt x="9" y="376745"/>
                  </a:lnTo>
                  <a:lnTo>
                    <a:pt x="9" y="375624"/>
                  </a:lnTo>
                  <a:lnTo>
                    <a:pt x="9" y="374502"/>
                  </a:lnTo>
                  <a:lnTo>
                    <a:pt x="9" y="373381"/>
                  </a:lnTo>
                  <a:lnTo>
                    <a:pt x="9" y="372260"/>
                  </a:lnTo>
                  <a:lnTo>
                    <a:pt x="9" y="371139"/>
                  </a:lnTo>
                  <a:lnTo>
                    <a:pt x="9" y="370017"/>
                  </a:lnTo>
                  <a:lnTo>
                    <a:pt x="9" y="368896"/>
                  </a:lnTo>
                  <a:lnTo>
                    <a:pt x="9" y="367775"/>
                  </a:lnTo>
                  <a:lnTo>
                    <a:pt x="9" y="366654"/>
                  </a:lnTo>
                  <a:lnTo>
                    <a:pt x="9" y="365532"/>
                  </a:lnTo>
                  <a:lnTo>
                    <a:pt x="9" y="364411"/>
                  </a:lnTo>
                  <a:lnTo>
                    <a:pt x="9" y="363290"/>
                  </a:lnTo>
                  <a:lnTo>
                    <a:pt x="9" y="362168"/>
                  </a:lnTo>
                  <a:lnTo>
                    <a:pt x="9" y="361047"/>
                  </a:lnTo>
                  <a:lnTo>
                    <a:pt x="9" y="359926"/>
                  </a:lnTo>
                  <a:lnTo>
                    <a:pt x="9" y="358805"/>
                  </a:lnTo>
                  <a:lnTo>
                    <a:pt x="9" y="357683"/>
                  </a:lnTo>
                  <a:lnTo>
                    <a:pt x="9" y="356562"/>
                  </a:lnTo>
                  <a:lnTo>
                    <a:pt x="9" y="355441"/>
                  </a:lnTo>
                  <a:lnTo>
                    <a:pt x="9" y="354320"/>
                  </a:lnTo>
                  <a:lnTo>
                    <a:pt x="9" y="353198"/>
                  </a:lnTo>
                  <a:lnTo>
                    <a:pt x="9" y="352077"/>
                  </a:lnTo>
                  <a:lnTo>
                    <a:pt x="9" y="350956"/>
                  </a:lnTo>
                  <a:lnTo>
                    <a:pt x="9" y="349835"/>
                  </a:lnTo>
                  <a:lnTo>
                    <a:pt x="9" y="348713"/>
                  </a:lnTo>
                  <a:lnTo>
                    <a:pt x="9" y="347592"/>
                  </a:lnTo>
                  <a:lnTo>
                    <a:pt x="9" y="346471"/>
                  </a:lnTo>
                  <a:lnTo>
                    <a:pt x="9" y="345349"/>
                  </a:lnTo>
                  <a:lnTo>
                    <a:pt x="9" y="344228"/>
                  </a:lnTo>
                  <a:lnTo>
                    <a:pt x="8" y="343107"/>
                  </a:lnTo>
                  <a:lnTo>
                    <a:pt x="8" y="341986"/>
                  </a:lnTo>
                  <a:lnTo>
                    <a:pt x="8" y="340864"/>
                  </a:lnTo>
                  <a:lnTo>
                    <a:pt x="8" y="339743"/>
                  </a:lnTo>
                  <a:lnTo>
                    <a:pt x="8" y="338622"/>
                  </a:lnTo>
                  <a:lnTo>
                    <a:pt x="7" y="337501"/>
                  </a:lnTo>
                  <a:lnTo>
                    <a:pt x="7" y="336379"/>
                  </a:lnTo>
                  <a:lnTo>
                    <a:pt x="7" y="335258"/>
                  </a:lnTo>
                  <a:lnTo>
                    <a:pt x="7" y="334137"/>
                  </a:lnTo>
                  <a:lnTo>
                    <a:pt x="6" y="333016"/>
                  </a:lnTo>
                  <a:lnTo>
                    <a:pt x="6" y="331894"/>
                  </a:lnTo>
                  <a:lnTo>
                    <a:pt x="6" y="330773"/>
                  </a:lnTo>
                  <a:lnTo>
                    <a:pt x="5" y="329652"/>
                  </a:lnTo>
                  <a:lnTo>
                    <a:pt x="5" y="328530"/>
                  </a:lnTo>
                  <a:lnTo>
                    <a:pt x="5" y="327409"/>
                  </a:lnTo>
                  <a:lnTo>
                    <a:pt x="4" y="326288"/>
                  </a:lnTo>
                  <a:lnTo>
                    <a:pt x="4" y="325167"/>
                  </a:lnTo>
                  <a:lnTo>
                    <a:pt x="4" y="324045"/>
                  </a:lnTo>
                  <a:lnTo>
                    <a:pt x="3" y="322924"/>
                  </a:lnTo>
                  <a:lnTo>
                    <a:pt x="3" y="321803"/>
                  </a:lnTo>
                  <a:lnTo>
                    <a:pt x="3" y="320682"/>
                  </a:lnTo>
                  <a:lnTo>
                    <a:pt x="2" y="319560"/>
                  </a:lnTo>
                  <a:lnTo>
                    <a:pt x="2" y="318439"/>
                  </a:lnTo>
                  <a:lnTo>
                    <a:pt x="2" y="317318"/>
                  </a:lnTo>
                  <a:lnTo>
                    <a:pt x="1" y="316197"/>
                  </a:lnTo>
                  <a:lnTo>
                    <a:pt x="1" y="315075"/>
                  </a:lnTo>
                  <a:lnTo>
                    <a:pt x="1" y="313954"/>
                  </a:lnTo>
                  <a:lnTo>
                    <a:pt x="1" y="312833"/>
                  </a:lnTo>
                  <a:lnTo>
                    <a:pt x="0" y="311711"/>
                  </a:lnTo>
                  <a:lnTo>
                    <a:pt x="0" y="310590"/>
                  </a:lnTo>
                  <a:lnTo>
                    <a:pt x="0" y="309469"/>
                  </a:lnTo>
                  <a:lnTo>
                    <a:pt x="0" y="308348"/>
                  </a:lnTo>
                  <a:lnTo>
                    <a:pt x="0" y="307226"/>
                  </a:lnTo>
                  <a:lnTo>
                    <a:pt x="0" y="306105"/>
                  </a:lnTo>
                  <a:lnTo>
                    <a:pt x="0" y="304984"/>
                  </a:lnTo>
                  <a:lnTo>
                    <a:pt x="0" y="303863"/>
                  </a:lnTo>
                  <a:lnTo>
                    <a:pt x="0" y="302741"/>
                  </a:lnTo>
                  <a:lnTo>
                    <a:pt x="0" y="301620"/>
                  </a:lnTo>
                  <a:lnTo>
                    <a:pt x="0" y="300499"/>
                  </a:lnTo>
                  <a:lnTo>
                    <a:pt x="0" y="299378"/>
                  </a:lnTo>
                  <a:lnTo>
                    <a:pt x="0" y="298256"/>
                  </a:lnTo>
                  <a:lnTo>
                    <a:pt x="0" y="297135"/>
                  </a:lnTo>
                  <a:lnTo>
                    <a:pt x="0" y="296014"/>
                  </a:lnTo>
                  <a:lnTo>
                    <a:pt x="1" y="294892"/>
                  </a:lnTo>
                  <a:lnTo>
                    <a:pt x="1" y="293771"/>
                  </a:lnTo>
                  <a:lnTo>
                    <a:pt x="1" y="292650"/>
                  </a:lnTo>
                  <a:lnTo>
                    <a:pt x="2" y="291529"/>
                  </a:lnTo>
                  <a:lnTo>
                    <a:pt x="2" y="290407"/>
                  </a:lnTo>
                  <a:lnTo>
                    <a:pt x="3" y="289286"/>
                  </a:lnTo>
                  <a:lnTo>
                    <a:pt x="4" y="288165"/>
                  </a:lnTo>
                  <a:lnTo>
                    <a:pt x="4" y="287044"/>
                  </a:lnTo>
                  <a:lnTo>
                    <a:pt x="5" y="285922"/>
                  </a:lnTo>
                  <a:lnTo>
                    <a:pt x="6" y="284801"/>
                  </a:lnTo>
                  <a:lnTo>
                    <a:pt x="6" y="283680"/>
                  </a:lnTo>
                  <a:lnTo>
                    <a:pt x="7" y="282559"/>
                  </a:lnTo>
                  <a:lnTo>
                    <a:pt x="8" y="281437"/>
                  </a:lnTo>
                  <a:lnTo>
                    <a:pt x="9" y="280316"/>
                  </a:lnTo>
                  <a:lnTo>
                    <a:pt x="10" y="279195"/>
                  </a:lnTo>
                  <a:lnTo>
                    <a:pt x="11" y="278074"/>
                  </a:lnTo>
                  <a:lnTo>
                    <a:pt x="12" y="276952"/>
                  </a:lnTo>
                  <a:lnTo>
                    <a:pt x="13" y="275831"/>
                  </a:lnTo>
                  <a:lnTo>
                    <a:pt x="15" y="274710"/>
                  </a:lnTo>
                  <a:lnTo>
                    <a:pt x="16" y="273588"/>
                  </a:lnTo>
                  <a:lnTo>
                    <a:pt x="17" y="272467"/>
                  </a:lnTo>
                  <a:lnTo>
                    <a:pt x="19" y="271346"/>
                  </a:lnTo>
                  <a:lnTo>
                    <a:pt x="20" y="270225"/>
                  </a:lnTo>
                  <a:lnTo>
                    <a:pt x="21" y="269103"/>
                  </a:lnTo>
                  <a:lnTo>
                    <a:pt x="23" y="267982"/>
                  </a:lnTo>
                  <a:lnTo>
                    <a:pt x="24" y="266861"/>
                  </a:lnTo>
                  <a:lnTo>
                    <a:pt x="26" y="265740"/>
                  </a:lnTo>
                  <a:lnTo>
                    <a:pt x="28" y="264618"/>
                  </a:lnTo>
                  <a:lnTo>
                    <a:pt x="29" y="263497"/>
                  </a:lnTo>
                  <a:lnTo>
                    <a:pt x="31" y="262376"/>
                  </a:lnTo>
                  <a:lnTo>
                    <a:pt x="32" y="261255"/>
                  </a:lnTo>
                  <a:lnTo>
                    <a:pt x="34" y="260133"/>
                  </a:lnTo>
                  <a:lnTo>
                    <a:pt x="36" y="259012"/>
                  </a:lnTo>
                  <a:lnTo>
                    <a:pt x="38" y="257891"/>
                  </a:lnTo>
                  <a:lnTo>
                    <a:pt x="39" y="256769"/>
                  </a:lnTo>
                  <a:lnTo>
                    <a:pt x="41" y="255648"/>
                  </a:lnTo>
                  <a:lnTo>
                    <a:pt x="43" y="254527"/>
                  </a:lnTo>
                  <a:lnTo>
                    <a:pt x="45" y="253406"/>
                  </a:lnTo>
                  <a:lnTo>
                    <a:pt x="47" y="252284"/>
                  </a:lnTo>
                  <a:lnTo>
                    <a:pt x="49" y="251163"/>
                  </a:lnTo>
                  <a:lnTo>
                    <a:pt x="50" y="250042"/>
                  </a:lnTo>
                  <a:lnTo>
                    <a:pt x="52" y="248921"/>
                  </a:lnTo>
                  <a:lnTo>
                    <a:pt x="54" y="247799"/>
                  </a:lnTo>
                  <a:lnTo>
                    <a:pt x="56" y="246678"/>
                  </a:lnTo>
                  <a:lnTo>
                    <a:pt x="58" y="245557"/>
                  </a:lnTo>
                  <a:lnTo>
                    <a:pt x="60" y="244436"/>
                  </a:lnTo>
                  <a:lnTo>
                    <a:pt x="62" y="243314"/>
                  </a:lnTo>
                  <a:lnTo>
                    <a:pt x="64" y="242193"/>
                  </a:lnTo>
                  <a:lnTo>
                    <a:pt x="65" y="241072"/>
                  </a:lnTo>
                  <a:lnTo>
                    <a:pt x="67" y="239950"/>
                  </a:lnTo>
                  <a:lnTo>
                    <a:pt x="69" y="238829"/>
                  </a:lnTo>
                  <a:lnTo>
                    <a:pt x="71" y="237708"/>
                  </a:lnTo>
                  <a:lnTo>
                    <a:pt x="73" y="236587"/>
                  </a:lnTo>
                  <a:lnTo>
                    <a:pt x="74" y="235465"/>
                  </a:lnTo>
                  <a:lnTo>
                    <a:pt x="76" y="234344"/>
                  </a:lnTo>
                  <a:lnTo>
                    <a:pt x="78" y="233223"/>
                  </a:lnTo>
                  <a:lnTo>
                    <a:pt x="79" y="232102"/>
                  </a:lnTo>
                  <a:lnTo>
                    <a:pt x="81" y="230980"/>
                  </a:lnTo>
                  <a:lnTo>
                    <a:pt x="83" y="229859"/>
                  </a:lnTo>
                  <a:lnTo>
                    <a:pt x="84" y="228738"/>
                  </a:lnTo>
                  <a:lnTo>
                    <a:pt x="86" y="227617"/>
                  </a:lnTo>
                  <a:lnTo>
                    <a:pt x="87" y="226495"/>
                  </a:lnTo>
                  <a:lnTo>
                    <a:pt x="89" y="225374"/>
                  </a:lnTo>
                  <a:lnTo>
                    <a:pt x="90" y="224253"/>
                  </a:lnTo>
                  <a:lnTo>
                    <a:pt x="92" y="223131"/>
                  </a:lnTo>
                  <a:lnTo>
                    <a:pt x="93" y="222010"/>
                  </a:lnTo>
                  <a:lnTo>
                    <a:pt x="94" y="220889"/>
                  </a:lnTo>
                  <a:lnTo>
                    <a:pt x="96" y="219768"/>
                  </a:lnTo>
                  <a:lnTo>
                    <a:pt x="97" y="218646"/>
                  </a:lnTo>
                  <a:lnTo>
                    <a:pt x="98" y="217525"/>
                  </a:lnTo>
                  <a:lnTo>
                    <a:pt x="99" y="216404"/>
                  </a:lnTo>
                  <a:lnTo>
                    <a:pt x="101" y="215283"/>
                  </a:lnTo>
                  <a:lnTo>
                    <a:pt x="102" y="214161"/>
                  </a:lnTo>
                  <a:lnTo>
                    <a:pt x="103" y="213040"/>
                  </a:lnTo>
                  <a:lnTo>
                    <a:pt x="104" y="211919"/>
                  </a:lnTo>
                  <a:lnTo>
                    <a:pt x="105" y="210798"/>
                  </a:lnTo>
                  <a:lnTo>
                    <a:pt x="106" y="209676"/>
                  </a:lnTo>
                  <a:lnTo>
                    <a:pt x="107" y="208555"/>
                  </a:lnTo>
                  <a:lnTo>
                    <a:pt x="107" y="207434"/>
                  </a:lnTo>
                  <a:lnTo>
                    <a:pt x="108" y="206312"/>
                  </a:lnTo>
                  <a:lnTo>
                    <a:pt x="109" y="205191"/>
                  </a:lnTo>
                  <a:lnTo>
                    <a:pt x="110" y="204070"/>
                  </a:lnTo>
                  <a:lnTo>
                    <a:pt x="110" y="202949"/>
                  </a:lnTo>
                  <a:lnTo>
                    <a:pt x="111" y="201827"/>
                  </a:lnTo>
                  <a:lnTo>
                    <a:pt x="112" y="200706"/>
                  </a:lnTo>
                  <a:lnTo>
                    <a:pt x="112" y="199585"/>
                  </a:lnTo>
                  <a:lnTo>
                    <a:pt x="113" y="198464"/>
                  </a:lnTo>
                  <a:lnTo>
                    <a:pt x="114" y="197342"/>
                  </a:lnTo>
                  <a:lnTo>
                    <a:pt x="114" y="196221"/>
                  </a:lnTo>
                  <a:lnTo>
                    <a:pt x="115" y="195100"/>
                  </a:lnTo>
                  <a:lnTo>
                    <a:pt x="115" y="193979"/>
                  </a:lnTo>
                  <a:lnTo>
                    <a:pt x="115" y="192857"/>
                  </a:lnTo>
                  <a:lnTo>
                    <a:pt x="116" y="191736"/>
                  </a:lnTo>
                  <a:lnTo>
                    <a:pt x="116" y="190615"/>
                  </a:lnTo>
                  <a:lnTo>
                    <a:pt x="117" y="189493"/>
                  </a:lnTo>
                  <a:lnTo>
                    <a:pt x="117" y="188372"/>
                  </a:lnTo>
                  <a:lnTo>
                    <a:pt x="117" y="187251"/>
                  </a:lnTo>
                  <a:lnTo>
                    <a:pt x="118" y="186130"/>
                  </a:lnTo>
                  <a:lnTo>
                    <a:pt x="118" y="185008"/>
                  </a:lnTo>
                  <a:lnTo>
                    <a:pt x="118" y="183887"/>
                  </a:lnTo>
                  <a:lnTo>
                    <a:pt x="118" y="182766"/>
                  </a:lnTo>
                  <a:lnTo>
                    <a:pt x="119" y="181645"/>
                  </a:lnTo>
                  <a:lnTo>
                    <a:pt x="119" y="180523"/>
                  </a:lnTo>
                  <a:lnTo>
                    <a:pt x="119" y="179402"/>
                  </a:lnTo>
                  <a:lnTo>
                    <a:pt x="120" y="178281"/>
                  </a:lnTo>
                  <a:lnTo>
                    <a:pt x="120" y="177160"/>
                  </a:lnTo>
                  <a:lnTo>
                    <a:pt x="120" y="176038"/>
                  </a:lnTo>
                  <a:lnTo>
                    <a:pt x="120" y="174917"/>
                  </a:lnTo>
                  <a:lnTo>
                    <a:pt x="121" y="173796"/>
                  </a:lnTo>
                  <a:lnTo>
                    <a:pt x="121" y="172674"/>
                  </a:lnTo>
                  <a:lnTo>
                    <a:pt x="121" y="171553"/>
                  </a:lnTo>
                  <a:lnTo>
                    <a:pt x="122" y="170432"/>
                  </a:lnTo>
                  <a:lnTo>
                    <a:pt x="122" y="169311"/>
                  </a:lnTo>
                  <a:lnTo>
                    <a:pt x="122" y="168189"/>
                  </a:lnTo>
                  <a:lnTo>
                    <a:pt x="123" y="167068"/>
                  </a:lnTo>
                  <a:lnTo>
                    <a:pt x="123" y="165947"/>
                  </a:lnTo>
                  <a:lnTo>
                    <a:pt x="123" y="164826"/>
                  </a:lnTo>
                  <a:lnTo>
                    <a:pt x="124" y="163704"/>
                  </a:lnTo>
                  <a:lnTo>
                    <a:pt x="124" y="162583"/>
                  </a:lnTo>
                  <a:lnTo>
                    <a:pt x="124" y="161462"/>
                  </a:lnTo>
                  <a:lnTo>
                    <a:pt x="125" y="160341"/>
                  </a:lnTo>
                  <a:lnTo>
                    <a:pt x="125" y="159219"/>
                  </a:lnTo>
                  <a:lnTo>
                    <a:pt x="126" y="158098"/>
                  </a:lnTo>
                  <a:lnTo>
                    <a:pt x="126" y="156977"/>
                  </a:lnTo>
                  <a:lnTo>
                    <a:pt x="127" y="155855"/>
                  </a:lnTo>
                  <a:lnTo>
                    <a:pt x="128" y="154734"/>
                  </a:lnTo>
                  <a:lnTo>
                    <a:pt x="128" y="153613"/>
                  </a:lnTo>
                  <a:lnTo>
                    <a:pt x="129" y="152492"/>
                  </a:lnTo>
                  <a:lnTo>
                    <a:pt x="129" y="151370"/>
                  </a:lnTo>
                  <a:lnTo>
                    <a:pt x="130" y="150249"/>
                  </a:lnTo>
                  <a:lnTo>
                    <a:pt x="131" y="149128"/>
                  </a:lnTo>
                  <a:lnTo>
                    <a:pt x="132" y="148007"/>
                  </a:lnTo>
                  <a:lnTo>
                    <a:pt x="132" y="146885"/>
                  </a:lnTo>
                  <a:lnTo>
                    <a:pt x="133" y="145764"/>
                  </a:lnTo>
                  <a:lnTo>
                    <a:pt x="134" y="144643"/>
                  </a:lnTo>
                  <a:lnTo>
                    <a:pt x="135" y="143522"/>
                  </a:lnTo>
                  <a:lnTo>
                    <a:pt x="136" y="142400"/>
                  </a:lnTo>
                  <a:lnTo>
                    <a:pt x="137" y="141279"/>
                  </a:lnTo>
                  <a:lnTo>
                    <a:pt x="138" y="140158"/>
                  </a:lnTo>
                  <a:lnTo>
                    <a:pt x="139" y="139037"/>
                  </a:lnTo>
                  <a:lnTo>
                    <a:pt x="140" y="137915"/>
                  </a:lnTo>
                  <a:lnTo>
                    <a:pt x="141" y="136794"/>
                  </a:lnTo>
                  <a:lnTo>
                    <a:pt x="142" y="135673"/>
                  </a:lnTo>
                  <a:lnTo>
                    <a:pt x="143" y="134551"/>
                  </a:lnTo>
                  <a:lnTo>
                    <a:pt x="144" y="133430"/>
                  </a:lnTo>
                  <a:lnTo>
                    <a:pt x="145" y="132309"/>
                  </a:lnTo>
                  <a:lnTo>
                    <a:pt x="146" y="131188"/>
                  </a:lnTo>
                  <a:lnTo>
                    <a:pt x="147" y="130066"/>
                  </a:lnTo>
                  <a:lnTo>
                    <a:pt x="149" y="128945"/>
                  </a:lnTo>
                  <a:lnTo>
                    <a:pt x="150" y="127824"/>
                  </a:lnTo>
                  <a:lnTo>
                    <a:pt x="151" y="126703"/>
                  </a:lnTo>
                  <a:lnTo>
                    <a:pt x="152" y="125581"/>
                  </a:lnTo>
                  <a:lnTo>
                    <a:pt x="154" y="124460"/>
                  </a:lnTo>
                  <a:lnTo>
                    <a:pt x="155" y="123339"/>
                  </a:lnTo>
                  <a:lnTo>
                    <a:pt x="156" y="122218"/>
                  </a:lnTo>
                  <a:lnTo>
                    <a:pt x="158" y="121096"/>
                  </a:lnTo>
                  <a:lnTo>
                    <a:pt x="159" y="119975"/>
                  </a:lnTo>
                  <a:lnTo>
                    <a:pt x="160" y="118854"/>
                  </a:lnTo>
                  <a:lnTo>
                    <a:pt x="162" y="117732"/>
                  </a:lnTo>
                  <a:lnTo>
                    <a:pt x="163" y="116611"/>
                  </a:lnTo>
                  <a:lnTo>
                    <a:pt x="165" y="115490"/>
                  </a:lnTo>
                  <a:lnTo>
                    <a:pt x="166" y="114369"/>
                  </a:lnTo>
                  <a:lnTo>
                    <a:pt x="167" y="113247"/>
                  </a:lnTo>
                  <a:lnTo>
                    <a:pt x="169" y="112126"/>
                  </a:lnTo>
                  <a:lnTo>
                    <a:pt x="170" y="111005"/>
                  </a:lnTo>
                  <a:lnTo>
                    <a:pt x="172" y="109884"/>
                  </a:lnTo>
                  <a:lnTo>
                    <a:pt x="173" y="108762"/>
                  </a:lnTo>
                  <a:lnTo>
                    <a:pt x="175" y="107641"/>
                  </a:lnTo>
                  <a:lnTo>
                    <a:pt x="176" y="106520"/>
                  </a:lnTo>
                  <a:lnTo>
                    <a:pt x="177" y="105399"/>
                  </a:lnTo>
                  <a:lnTo>
                    <a:pt x="179" y="104277"/>
                  </a:lnTo>
                  <a:lnTo>
                    <a:pt x="180" y="103156"/>
                  </a:lnTo>
                  <a:lnTo>
                    <a:pt x="182" y="102035"/>
                  </a:lnTo>
                  <a:lnTo>
                    <a:pt x="183" y="100913"/>
                  </a:lnTo>
                  <a:lnTo>
                    <a:pt x="185" y="99792"/>
                  </a:lnTo>
                  <a:lnTo>
                    <a:pt x="186" y="98671"/>
                  </a:lnTo>
                  <a:lnTo>
                    <a:pt x="187" y="97550"/>
                  </a:lnTo>
                  <a:lnTo>
                    <a:pt x="189" y="96428"/>
                  </a:lnTo>
                  <a:lnTo>
                    <a:pt x="190" y="95307"/>
                  </a:lnTo>
                  <a:lnTo>
                    <a:pt x="192" y="94186"/>
                  </a:lnTo>
                  <a:lnTo>
                    <a:pt x="193" y="93065"/>
                  </a:lnTo>
                  <a:lnTo>
                    <a:pt x="194" y="91943"/>
                  </a:lnTo>
                  <a:lnTo>
                    <a:pt x="196" y="90822"/>
                  </a:lnTo>
                  <a:lnTo>
                    <a:pt x="197" y="89701"/>
                  </a:lnTo>
                  <a:lnTo>
                    <a:pt x="198" y="88580"/>
                  </a:lnTo>
                  <a:lnTo>
                    <a:pt x="199" y="87458"/>
                  </a:lnTo>
                  <a:lnTo>
                    <a:pt x="201" y="86337"/>
                  </a:lnTo>
                  <a:lnTo>
                    <a:pt x="202" y="85216"/>
                  </a:lnTo>
                  <a:lnTo>
                    <a:pt x="203" y="84094"/>
                  </a:lnTo>
                  <a:lnTo>
                    <a:pt x="204" y="82973"/>
                  </a:lnTo>
                  <a:lnTo>
                    <a:pt x="206" y="81852"/>
                  </a:lnTo>
                  <a:lnTo>
                    <a:pt x="207" y="80731"/>
                  </a:lnTo>
                  <a:lnTo>
                    <a:pt x="208" y="79609"/>
                  </a:lnTo>
                  <a:lnTo>
                    <a:pt x="209" y="78488"/>
                  </a:lnTo>
                  <a:lnTo>
                    <a:pt x="210" y="77367"/>
                  </a:lnTo>
                  <a:lnTo>
                    <a:pt x="211" y="76246"/>
                  </a:lnTo>
                  <a:lnTo>
                    <a:pt x="212" y="75124"/>
                  </a:lnTo>
                  <a:lnTo>
                    <a:pt x="213" y="74003"/>
                  </a:lnTo>
                  <a:lnTo>
                    <a:pt x="215" y="72882"/>
                  </a:lnTo>
                  <a:lnTo>
                    <a:pt x="216" y="71761"/>
                  </a:lnTo>
                  <a:lnTo>
                    <a:pt x="217" y="70639"/>
                  </a:lnTo>
                  <a:lnTo>
                    <a:pt x="217" y="69518"/>
                  </a:lnTo>
                  <a:lnTo>
                    <a:pt x="218" y="68397"/>
                  </a:lnTo>
                  <a:lnTo>
                    <a:pt x="219" y="67275"/>
                  </a:lnTo>
                  <a:lnTo>
                    <a:pt x="220" y="66154"/>
                  </a:lnTo>
                  <a:lnTo>
                    <a:pt x="221" y="65033"/>
                  </a:lnTo>
                  <a:lnTo>
                    <a:pt x="222" y="63912"/>
                  </a:lnTo>
                  <a:lnTo>
                    <a:pt x="223" y="62790"/>
                  </a:lnTo>
                  <a:lnTo>
                    <a:pt x="224" y="61669"/>
                  </a:lnTo>
                  <a:lnTo>
                    <a:pt x="224" y="60548"/>
                  </a:lnTo>
                  <a:lnTo>
                    <a:pt x="225" y="59427"/>
                  </a:lnTo>
                  <a:lnTo>
                    <a:pt x="226" y="58305"/>
                  </a:lnTo>
                  <a:lnTo>
                    <a:pt x="227" y="57184"/>
                  </a:lnTo>
                  <a:lnTo>
                    <a:pt x="227" y="56063"/>
                  </a:lnTo>
                  <a:lnTo>
                    <a:pt x="228" y="54942"/>
                  </a:lnTo>
                  <a:lnTo>
                    <a:pt x="229" y="53820"/>
                  </a:lnTo>
                  <a:lnTo>
                    <a:pt x="229" y="52699"/>
                  </a:lnTo>
                  <a:lnTo>
                    <a:pt x="230" y="51578"/>
                  </a:lnTo>
                  <a:lnTo>
                    <a:pt x="231" y="50456"/>
                  </a:lnTo>
                  <a:lnTo>
                    <a:pt x="231" y="49335"/>
                  </a:lnTo>
                  <a:lnTo>
                    <a:pt x="232" y="48214"/>
                  </a:lnTo>
                  <a:lnTo>
                    <a:pt x="232" y="47093"/>
                  </a:lnTo>
                  <a:lnTo>
                    <a:pt x="233" y="45971"/>
                  </a:lnTo>
                  <a:lnTo>
                    <a:pt x="233" y="44850"/>
                  </a:lnTo>
                  <a:lnTo>
                    <a:pt x="234" y="43729"/>
                  </a:lnTo>
                  <a:lnTo>
                    <a:pt x="234" y="42608"/>
                  </a:lnTo>
                  <a:lnTo>
                    <a:pt x="235" y="41486"/>
                  </a:lnTo>
                  <a:lnTo>
                    <a:pt x="235" y="40365"/>
                  </a:lnTo>
                  <a:lnTo>
                    <a:pt x="236" y="39244"/>
                  </a:lnTo>
                  <a:lnTo>
                    <a:pt x="236" y="38123"/>
                  </a:lnTo>
                  <a:lnTo>
                    <a:pt x="236" y="37001"/>
                  </a:lnTo>
                  <a:lnTo>
                    <a:pt x="237" y="35880"/>
                  </a:lnTo>
                  <a:lnTo>
                    <a:pt x="237" y="34759"/>
                  </a:lnTo>
                  <a:lnTo>
                    <a:pt x="238" y="33637"/>
                  </a:lnTo>
                  <a:lnTo>
                    <a:pt x="238" y="32516"/>
                  </a:lnTo>
                  <a:lnTo>
                    <a:pt x="238" y="31395"/>
                  </a:lnTo>
                  <a:lnTo>
                    <a:pt x="238" y="30274"/>
                  </a:lnTo>
                  <a:lnTo>
                    <a:pt x="239" y="29152"/>
                  </a:lnTo>
                  <a:lnTo>
                    <a:pt x="239" y="28031"/>
                  </a:lnTo>
                  <a:lnTo>
                    <a:pt x="239" y="26910"/>
                  </a:lnTo>
                  <a:lnTo>
                    <a:pt x="240" y="25789"/>
                  </a:lnTo>
                  <a:lnTo>
                    <a:pt x="240" y="24667"/>
                  </a:lnTo>
                  <a:lnTo>
                    <a:pt x="240" y="23546"/>
                  </a:lnTo>
                  <a:lnTo>
                    <a:pt x="240" y="22425"/>
                  </a:lnTo>
                  <a:lnTo>
                    <a:pt x="240" y="21304"/>
                  </a:lnTo>
                  <a:lnTo>
                    <a:pt x="241" y="20182"/>
                  </a:lnTo>
                  <a:lnTo>
                    <a:pt x="241" y="19061"/>
                  </a:lnTo>
                  <a:lnTo>
                    <a:pt x="241" y="17940"/>
                  </a:lnTo>
                  <a:lnTo>
                    <a:pt x="241" y="16818"/>
                  </a:lnTo>
                  <a:lnTo>
                    <a:pt x="241" y="15697"/>
                  </a:lnTo>
                  <a:lnTo>
                    <a:pt x="242" y="14576"/>
                  </a:lnTo>
                  <a:lnTo>
                    <a:pt x="242" y="13455"/>
                  </a:lnTo>
                  <a:lnTo>
                    <a:pt x="242" y="12333"/>
                  </a:lnTo>
                  <a:lnTo>
                    <a:pt x="242" y="11212"/>
                  </a:lnTo>
                  <a:lnTo>
                    <a:pt x="242" y="10091"/>
                  </a:lnTo>
                  <a:lnTo>
                    <a:pt x="242" y="8970"/>
                  </a:lnTo>
                  <a:lnTo>
                    <a:pt x="242" y="7848"/>
                  </a:lnTo>
                  <a:lnTo>
                    <a:pt x="242" y="6727"/>
                  </a:lnTo>
                  <a:lnTo>
                    <a:pt x="243" y="5606"/>
                  </a:lnTo>
                  <a:lnTo>
                    <a:pt x="243" y="4485"/>
                  </a:lnTo>
                  <a:lnTo>
                    <a:pt x="243" y="3363"/>
                  </a:lnTo>
                  <a:lnTo>
                    <a:pt x="243" y="2242"/>
                  </a:lnTo>
                  <a:lnTo>
                    <a:pt x="243" y="1121"/>
                  </a:lnTo>
                  <a:lnTo>
                    <a:pt x="243" y="0"/>
                  </a:lnTo>
                  <a:lnTo>
                    <a:pt x="244" y="0"/>
                  </a:lnTo>
                  <a:lnTo>
                    <a:pt x="244" y="572967"/>
                  </a:lnTo>
                  <a:lnTo>
                    <a:pt x="244" y="572967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53" name="pl35"/>
            <p:cNvSpPr/>
            <p:nvPr/>
          </p:nvSpPr>
          <p:spPr>
            <a:xfrm>
              <a:off x="4712345" y="3660793"/>
              <a:ext cx="699" cy="198086"/>
            </a:xfrm>
            <a:custGeom>
              <a:avLst/>
              <a:gdLst/>
              <a:ahLst/>
              <a:cxnLst/>
              <a:rect l="0" t="0" r="0" b="0"/>
              <a:pathLst>
                <a:path w="699" h="198086">
                  <a:moveTo>
                    <a:pt x="0" y="0"/>
                  </a:moveTo>
                  <a:lnTo>
                    <a:pt x="3" y="0"/>
                  </a:lnTo>
                  <a:lnTo>
                    <a:pt x="3" y="387"/>
                  </a:lnTo>
                  <a:lnTo>
                    <a:pt x="3" y="775"/>
                  </a:lnTo>
                  <a:lnTo>
                    <a:pt x="3" y="1162"/>
                  </a:lnTo>
                  <a:lnTo>
                    <a:pt x="4" y="1550"/>
                  </a:lnTo>
                  <a:lnTo>
                    <a:pt x="4" y="1938"/>
                  </a:lnTo>
                  <a:lnTo>
                    <a:pt x="4" y="2325"/>
                  </a:lnTo>
                  <a:lnTo>
                    <a:pt x="4" y="2713"/>
                  </a:lnTo>
                  <a:lnTo>
                    <a:pt x="5" y="3101"/>
                  </a:lnTo>
                  <a:lnTo>
                    <a:pt x="5" y="3488"/>
                  </a:lnTo>
                  <a:lnTo>
                    <a:pt x="5" y="3876"/>
                  </a:lnTo>
                  <a:lnTo>
                    <a:pt x="6" y="4264"/>
                  </a:lnTo>
                  <a:lnTo>
                    <a:pt x="6" y="4651"/>
                  </a:lnTo>
                  <a:lnTo>
                    <a:pt x="6" y="5039"/>
                  </a:lnTo>
                  <a:lnTo>
                    <a:pt x="7" y="5427"/>
                  </a:lnTo>
                  <a:lnTo>
                    <a:pt x="7" y="5814"/>
                  </a:lnTo>
                  <a:lnTo>
                    <a:pt x="7" y="6202"/>
                  </a:lnTo>
                  <a:lnTo>
                    <a:pt x="8" y="6589"/>
                  </a:lnTo>
                  <a:lnTo>
                    <a:pt x="8" y="6977"/>
                  </a:lnTo>
                  <a:lnTo>
                    <a:pt x="9" y="7365"/>
                  </a:lnTo>
                  <a:lnTo>
                    <a:pt x="9" y="7752"/>
                  </a:lnTo>
                  <a:lnTo>
                    <a:pt x="10" y="8140"/>
                  </a:lnTo>
                  <a:lnTo>
                    <a:pt x="10" y="8528"/>
                  </a:lnTo>
                  <a:lnTo>
                    <a:pt x="11" y="8915"/>
                  </a:lnTo>
                  <a:lnTo>
                    <a:pt x="11" y="9303"/>
                  </a:lnTo>
                  <a:lnTo>
                    <a:pt x="12" y="9691"/>
                  </a:lnTo>
                  <a:lnTo>
                    <a:pt x="13" y="10078"/>
                  </a:lnTo>
                  <a:lnTo>
                    <a:pt x="13" y="10466"/>
                  </a:lnTo>
                  <a:lnTo>
                    <a:pt x="14" y="10854"/>
                  </a:lnTo>
                  <a:lnTo>
                    <a:pt x="15" y="11241"/>
                  </a:lnTo>
                  <a:lnTo>
                    <a:pt x="15" y="11629"/>
                  </a:lnTo>
                  <a:lnTo>
                    <a:pt x="16" y="12017"/>
                  </a:lnTo>
                  <a:lnTo>
                    <a:pt x="17" y="12404"/>
                  </a:lnTo>
                  <a:lnTo>
                    <a:pt x="18" y="12792"/>
                  </a:lnTo>
                  <a:lnTo>
                    <a:pt x="19" y="13179"/>
                  </a:lnTo>
                  <a:lnTo>
                    <a:pt x="20" y="13567"/>
                  </a:lnTo>
                  <a:lnTo>
                    <a:pt x="21" y="13955"/>
                  </a:lnTo>
                  <a:lnTo>
                    <a:pt x="22" y="14342"/>
                  </a:lnTo>
                  <a:lnTo>
                    <a:pt x="23" y="14730"/>
                  </a:lnTo>
                  <a:lnTo>
                    <a:pt x="24" y="15118"/>
                  </a:lnTo>
                  <a:lnTo>
                    <a:pt x="25" y="15505"/>
                  </a:lnTo>
                  <a:lnTo>
                    <a:pt x="26" y="15893"/>
                  </a:lnTo>
                  <a:lnTo>
                    <a:pt x="27" y="16281"/>
                  </a:lnTo>
                  <a:lnTo>
                    <a:pt x="28" y="16668"/>
                  </a:lnTo>
                  <a:lnTo>
                    <a:pt x="29" y="17056"/>
                  </a:lnTo>
                  <a:lnTo>
                    <a:pt x="31" y="17444"/>
                  </a:lnTo>
                  <a:lnTo>
                    <a:pt x="32" y="17831"/>
                  </a:lnTo>
                  <a:lnTo>
                    <a:pt x="33" y="18219"/>
                  </a:lnTo>
                  <a:lnTo>
                    <a:pt x="35" y="18606"/>
                  </a:lnTo>
                  <a:lnTo>
                    <a:pt x="36" y="18994"/>
                  </a:lnTo>
                  <a:lnTo>
                    <a:pt x="38" y="19382"/>
                  </a:lnTo>
                  <a:lnTo>
                    <a:pt x="39" y="19769"/>
                  </a:lnTo>
                  <a:lnTo>
                    <a:pt x="41" y="20157"/>
                  </a:lnTo>
                  <a:lnTo>
                    <a:pt x="43" y="20545"/>
                  </a:lnTo>
                  <a:lnTo>
                    <a:pt x="44" y="20932"/>
                  </a:lnTo>
                  <a:lnTo>
                    <a:pt x="46" y="21320"/>
                  </a:lnTo>
                  <a:lnTo>
                    <a:pt x="48" y="21708"/>
                  </a:lnTo>
                  <a:lnTo>
                    <a:pt x="50" y="22095"/>
                  </a:lnTo>
                  <a:lnTo>
                    <a:pt x="52" y="22483"/>
                  </a:lnTo>
                  <a:lnTo>
                    <a:pt x="54" y="22871"/>
                  </a:lnTo>
                  <a:lnTo>
                    <a:pt x="56" y="23258"/>
                  </a:lnTo>
                  <a:lnTo>
                    <a:pt x="58" y="23646"/>
                  </a:lnTo>
                  <a:lnTo>
                    <a:pt x="60" y="24034"/>
                  </a:lnTo>
                  <a:lnTo>
                    <a:pt x="62" y="24421"/>
                  </a:lnTo>
                  <a:lnTo>
                    <a:pt x="65" y="24809"/>
                  </a:lnTo>
                  <a:lnTo>
                    <a:pt x="67" y="25196"/>
                  </a:lnTo>
                  <a:lnTo>
                    <a:pt x="69" y="25584"/>
                  </a:lnTo>
                  <a:lnTo>
                    <a:pt x="72" y="25972"/>
                  </a:lnTo>
                  <a:lnTo>
                    <a:pt x="74" y="26359"/>
                  </a:lnTo>
                  <a:lnTo>
                    <a:pt x="77" y="26747"/>
                  </a:lnTo>
                  <a:lnTo>
                    <a:pt x="79" y="27135"/>
                  </a:lnTo>
                  <a:lnTo>
                    <a:pt x="82" y="27522"/>
                  </a:lnTo>
                  <a:lnTo>
                    <a:pt x="85" y="27910"/>
                  </a:lnTo>
                  <a:lnTo>
                    <a:pt x="88" y="28298"/>
                  </a:lnTo>
                  <a:lnTo>
                    <a:pt x="90" y="28685"/>
                  </a:lnTo>
                  <a:lnTo>
                    <a:pt x="93" y="29073"/>
                  </a:lnTo>
                  <a:lnTo>
                    <a:pt x="96" y="29461"/>
                  </a:lnTo>
                  <a:lnTo>
                    <a:pt x="99" y="29848"/>
                  </a:lnTo>
                  <a:lnTo>
                    <a:pt x="102" y="30236"/>
                  </a:lnTo>
                  <a:lnTo>
                    <a:pt x="106" y="30623"/>
                  </a:lnTo>
                  <a:lnTo>
                    <a:pt x="109" y="31011"/>
                  </a:lnTo>
                  <a:lnTo>
                    <a:pt x="112" y="31399"/>
                  </a:lnTo>
                  <a:lnTo>
                    <a:pt x="115" y="31786"/>
                  </a:lnTo>
                  <a:lnTo>
                    <a:pt x="119" y="32174"/>
                  </a:lnTo>
                  <a:lnTo>
                    <a:pt x="122" y="32562"/>
                  </a:lnTo>
                  <a:lnTo>
                    <a:pt x="126" y="32949"/>
                  </a:lnTo>
                  <a:lnTo>
                    <a:pt x="129" y="33337"/>
                  </a:lnTo>
                  <a:lnTo>
                    <a:pt x="133" y="33725"/>
                  </a:lnTo>
                  <a:lnTo>
                    <a:pt x="136" y="34112"/>
                  </a:lnTo>
                  <a:lnTo>
                    <a:pt x="140" y="34500"/>
                  </a:lnTo>
                  <a:lnTo>
                    <a:pt x="144" y="34888"/>
                  </a:lnTo>
                  <a:lnTo>
                    <a:pt x="148" y="35275"/>
                  </a:lnTo>
                  <a:lnTo>
                    <a:pt x="152" y="35663"/>
                  </a:lnTo>
                  <a:lnTo>
                    <a:pt x="155" y="36051"/>
                  </a:lnTo>
                  <a:lnTo>
                    <a:pt x="159" y="36438"/>
                  </a:lnTo>
                  <a:lnTo>
                    <a:pt x="163" y="36826"/>
                  </a:lnTo>
                  <a:lnTo>
                    <a:pt x="167" y="37213"/>
                  </a:lnTo>
                  <a:lnTo>
                    <a:pt x="172" y="37601"/>
                  </a:lnTo>
                  <a:lnTo>
                    <a:pt x="176" y="37989"/>
                  </a:lnTo>
                  <a:lnTo>
                    <a:pt x="180" y="38376"/>
                  </a:lnTo>
                  <a:lnTo>
                    <a:pt x="184" y="38764"/>
                  </a:lnTo>
                  <a:lnTo>
                    <a:pt x="188" y="39152"/>
                  </a:lnTo>
                  <a:lnTo>
                    <a:pt x="193" y="39539"/>
                  </a:lnTo>
                  <a:lnTo>
                    <a:pt x="197" y="39927"/>
                  </a:lnTo>
                  <a:lnTo>
                    <a:pt x="201" y="40315"/>
                  </a:lnTo>
                  <a:lnTo>
                    <a:pt x="206" y="40702"/>
                  </a:lnTo>
                  <a:lnTo>
                    <a:pt x="210" y="41090"/>
                  </a:lnTo>
                  <a:lnTo>
                    <a:pt x="215" y="41478"/>
                  </a:lnTo>
                  <a:lnTo>
                    <a:pt x="219" y="41865"/>
                  </a:lnTo>
                  <a:lnTo>
                    <a:pt x="224" y="42253"/>
                  </a:lnTo>
                  <a:lnTo>
                    <a:pt x="228" y="42641"/>
                  </a:lnTo>
                  <a:lnTo>
                    <a:pt x="233" y="43028"/>
                  </a:lnTo>
                  <a:lnTo>
                    <a:pt x="238" y="43416"/>
                  </a:lnTo>
                  <a:lnTo>
                    <a:pt x="242" y="43803"/>
                  </a:lnTo>
                  <a:lnTo>
                    <a:pt x="247" y="44191"/>
                  </a:lnTo>
                  <a:lnTo>
                    <a:pt x="251" y="44579"/>
                  </a:lnTo>
                  <a:lnTo>
                    <a:pt x="256" y="44966"/>
                  </a:lnTo>
                  <a:lnTo>
                    <a:pt x="261" y="45354"/>
                  </a:lnTo>
                  <a:lnTo>
                    <a:pt x="266" y="45742"/>
                  </a:lnTo>
                  <a:lnTo>
                    <a:pt x="270" y="46129"/>
                  </a:lnTo>
                  <a:lnTo>
                    <a:pt x="275" y="46517"/>
                  </a:lnTo>
                  <a:lnTo>
                    <a:pt x="280" y="46905"/>
                  </a:lnTo>
                  <a:lnTo>
                    <a:pt x="284" y="47292"/>
                  </a:lnTo>
                  <a:lnTo>
                    <a:pt x="289" y="47680"/>
                  </a:lnTo>
                  <a:lnTo>
                    <a:pt x="294" y="48068"/>
                  </a:lnTo>
                  <a:lnTo>
                    <a:pt x="299" y="48455"/>
                  </a:lnTo>
                  <a:lnTo>
                    <a:pt x="303" y="48843"/>
                  </a:lnTo>
                  <a:lnTo>
                    <a:pt x="308" y="49230"/>
                  </a:lnTo>
                  <a:lnTo>
                    <a:pt x="313" y="49618"/>
                  </a:lnTo>
                  <a:lnTo>
                    <a:pt x="318" y="50006"/>
                  </a:lnTo>
                  <a:lnTo>
                    <a:pt x="322" y="50393"/>
                  </a:lnTo>
                  <a:lnTo>
                    <a:pt x="327" y="50781"/>
                  </a:lnTo>
                  <a:lnTo>
                    <a:pt x="332" y="51169"/>
                  </a:lnTo>
                  <a:lnTo>
                    <a:pt x="337" y="51556"/>
                  </a:lnTo>
                  <a:lnTo>
                    <a:pt x="341" y="51944"/>
                  </a:lnTo>
                  <a:lnTo>
                    <a:pt x="346" y="52332"/>
                  </a:lnTo>
                  <a:lnTo>
                    <a:pt x="351" y="52719"/>
                  </a:lnTo>
                  <a:lnTo>
                    <a:pt x="355" y="53107"/>
                  </a:lnTo>
                  <a:lnTo>
                    <a:pt x="360" y="53495"/>
                  </a:lnTo>
                  <a:lnTo>
                    <a:pt x="365" y="53882"/>
                  </a:lnTo>
                  <a:lnTo>
                    <a:pt x="369" y="54270"/>
                  </a:lnTo>
                  <a:lnTo>
                    <a:pt x="374" y="54658"/>
                  </a:lnTo>
                  <a:lnTo>
                    <a:pt x="378" y="55045"/>
                  </a:lnTo>
                  <a:lnTo>
                    <a:pt x="383" y="55433"/>
                  </a:lnTo>
                  <a:lnTo>
                    <a:pt x="387" y="55820"/>
                  </a:lnTo>
                  <a:lnTo>
                    <a:pt x="392" y="56208"/>
                  </a:lnTo>
                  <a:lnTo>
                    <a:pt x="396" y="56596"/>
                  </a:lnTo>
                  <a:lnTo>
                    <a:pt x="401" y="56983"/>
                  </a:lnTo>
                  <a:lnTo>
                    <a:pt x="405" y="57371"/>
                  </a:lnTo>
                  <a:lnTo>
                    <a:pt x="410" y="57759"/>
                  </a:lnTo>
                  <a:lnTo>
                    <a:pt x="414" y="58146"/>
                  </a:lnTo>
                  <a:lnTo>
                    <a:pt x="418" y="58534"/>
                  </a:lnTo>
                  <a:lnTo>
                    <a:pt x="423" y="58922"/>
                  </a:lnTo>
                  <a:lnTo>
                    <a:pt x="427" y="59309"/>
                  </a:lnTo>
                  <a:lnTo>
                    <a:pt x="431" y="59697"/>
                  </a:lnTo>
                  <a:lnTo>
                    <a:pt x="435" y="60085"/>
                  </a:lnTo>
                  <a:lnTo>
                    <a:pt x="440" y="60472"/>
                  </a:lnTo>
                  <a:lnTo>
                    <a:pt x="444" y="60860"/>
                  </a:lnTo>
                  <a:lnTo>
                    <a:pt x="448" y="61247"/>
                  </a:lnTo>
                  <a:lnTo>
                    <a:pt x="452" y="61635"/>
                  </a:lnTo>
                  <a:lnTo>
                    <a:pt x="456" y="62023"/>
                  </a:lnTo>
                  <a:lnTo>
                    <a:pt x="460" y="62410"/>
                  </a:lnTo>
                  <a:lnTo>
                    <a:pt x="464" y="62798"/>
                  </a:lnTo>
                  <a:lnTo>
                    <a:pt x="468" y="63186"/>
                  </a:lnTo>
                  <a:lnTo>
                    <a:pt x="472" y="63573"/>
                  </a:lnTo>
                  <a:lnTo>
                    <a:pt x="476" y="63961"/>
                  </a:lnTo>
                  <a:lnTo>
                    <a:pt x="480" y="64349"/>
                  </a:lnTo>
                  <a:lnTo>
                    <a:pt x="484" y="64736"/>
                  </a:lnTo>
                  <a:lnTo>
                    <a:pt x="488" y="65124"/>
                  </a:lnTo>
                  <a:lnTo>
                    <a:pt x="492" y="65512"/>
                  </a:lnTo>
                  <a:lnTo>
                    <a:pt x="496" y="65899"/>
                  </a:lnTo>
                  <a:lnTo>
                    <a:pt x="500" y="66287"/>
                  </a:lnTo>
                  <a:lnTo>
                    <a:pt x="503" y="66675"/>
                  </a:lnTo>
                  <a:lnTo>
                    <a:pt x="507" y="67062"/>
                  </a:lnTo>
                  <a:lnTo>
                    <a:pt x="511" y="67450"/>
                  </a:lnTo>
                  <a:lnTo>
                    <a:pt x="514" y="67837"/>
                  </a:lnTo>
                  <a:lnTo>
                    <a:pt x="518" y="68225"/>
                  </a:lnTo>
                  <a:lnTo>
                    <a:pt x="522" y="68613"/>
                  </a:lnTo>
                  <a:lnTo>
                    <a:pt x="525" y="69000"/>
                  </a:lnTo>
                  <a:lnTo>
                    <a:pt x="529" y="69388"/>
                  </a:lnTo>
                  <a:lnTo>
                    <a:pt x="533" y="69776"/>
                  </a:lnTo>
                  <a:lnTo>
                    <a:pt x="536" y="70163"/>
                  </a:lnTo>
                  <a:lnTo>
                    <a:pt x="540" y="70551"/>
                  </a:lnTo>
                  <a:lnTo>
                    <a:pt x="543" y="70939"/>
                  </a:lnTo>
                  <a:lnTo>
                    <a:pt x="546" y="71326"/>
                  </a:lnTo>
                  <a:lnTo>
                    <a:pt x="550" y="71714"/>
                  </a:lnTo>
                  <a:lnTo>
                    <a:pt x="553" y="72102"/>
                  </a:lnTo>
                  <a:lnTo>
                    <a:pt x="557" y="72489"/>
                  </a:lnTo>
                  <a:lnTo>
                    <a:pt x="560" y="72877"/>
                  </a:lnTo>
                  <a:lnTo>
                    <a:pt x="563" y="73265"/>
                  </a:lnTo>
                  <a:lnTo>
                    <a:pt x="566" y="73652"/>
                  </a:lnTo>
                  <a:lnTo>
                    <a:pt x="570" y="74040"/>
                  </a:lnTo>
                  <a:lnTo>
                    <a:pt x="573" y="74427"/>
                  </a:lnTo>
                  <a:lnTo>
                    <a:pt x="576" y="74815"/>
                  </a:lnTo>
                  <a:lnTo>
                    <a:pt x="579" y="75203"/>
                  </a:lnTo>
                  <a:lnTo>
                    <a:pt x="582" y="75590"/>
                  </a:lnTo>
                  <a:lnTo>
                    <a:pt x="585" y="75978"/>
                  </a:lnTo>
                  <a:lnTo>
                    <a:pt x="589" y="76366"/>
                  </a:lnTo>
                  <a:lnTo>
                    <a:pt x="592" y="76753"/>
                  </a:lnTo>
                  <a:lnTo>
                    <a:pt x="595" y="77141"/>
                  </a:lnTo>
                  <a:lnTo>
                    <a:pt x="597" y="77529"/>
                  </a:lnTo>
                  <a:lnTo>
                    <a:pt x="600" y="77916"/>
                  </a:lnTo>
                  <a:lnTo>
                    <a:pt x="603" y="78304"/>
                  </a:lnTo>
                  <a:lnTo>
                    <a:pt x="606" y="78692"/>
                  </a:lnTo>
                  <a:lnTo>
                    <a:pt x="609" y="79079"/>
                  </a:lnTo>
                  <a:lnTo>
                    <a:pt x="612" y="79467"/>
                  </a:lnTo>
                  <a:lnTo>
                    <a:pt x="614" y="79854"/>
                  </a:lnTo>
                  <a:lnTo>
                    <a:pt x="617" y="80242"/>
                  </a:lnTo>
                  <a:lnTo>
                    <a:pt x="620" y="80630"/>
                  </a:lnTo>
                  <a:lnTo>
                    <a:pt x="622" y="81017"/>
                  </a:lnTo>
                  <a:lnTo>
                    <a:pt x="625" y="81405"/>
                  </a:lnTo>
                  <a:lnTo>
                    <a:pt x="628" y="81793"/>
                  </a:lnTo>
                  <a:lnTo>
                    <a:pt x="630" y="82180"/>
                  </a:lnTo>
                  <a:lnTo>
                    <a:pt x="633" y="82568"/>
                  </a:lnTo>
                  <a:lnTo>
                    <a:pt x="635" y="82956"/>
                  </a:lnTo>
                  <a:lnTo>
                    <a:pt x="637" y="83343"/>
                  </a:lnTo>
                  <a:lnTo>
                    <a:pt x="640" y="83731"/>
                  </a:lnTo>
                  <a:lnTo>
                    <a:pt x="642" y="84119"/>
                  </a:lnTo>
                  <a:lnTo>
                    <a:pt x="644" y="84506"/>
                  </a:lnTo>
                  <a:lnTo>
                    <a:pt x="646" y="84894"/>
                  </a:lnTo>
                  <a:lnTo>
                    <a:pt x="648" y="85282"/>
                  </a:lnTo>
                  <a:lnTo>
                    <a:pt x="651" y="85669"/>
                  </a:lnTo>
                  <a:lnTo>
                    <a:pt x="653" y="86057"/>
                  </a:lnTo>
                  <a:lnTo>
                    <a:pt x="655" y="86444"/>
                  </a:lnTo>
                  <a:lnTo>
                    <a:pt x="657" y="86832"/>
                  </a:lnTo>
                  <a:lnTo>
                    <a:pt x="659" y="87220"/>
                  </a:lnTo>
                  <a:lnTo>
                    <a:pt x="660" y="87607"/>
                  </a:lnTo>
                  <a:lnTo>
                    <a:pt x="662" y="87995"/>
                  </a:lnTo>
                  <a:lnTo>
                    <a:pt x="664" y="88383"/>
                  </a:lnTo>
                  <a:lnTo>
                    <a:pt x="666" y="88770"/>
                  </a:lnTo>
                  <a:lnTo>
                    <a:pt x="667" y="89158"/>
                  </a:lnTo>
                  <a:lnTo>
                    <a:pt x="669" y="89546"/>
                  </a:lnTo>
                  <a:lnTo>
                    <a:pt x="670" y="89933"/>
                  </a:lnTo>
                  <a:lnTo>
                    <a:pt x="672" y="90321"/>
                  </a:lnTo>
                  <a:lnTo>
                    <a:pt x="673" y="90709"/>
                  </a:lnTo>
                  <a:lnTo>
                    <a:pt x="675" y="91096"/>
                  </a:lnTo>
                  <a:lnTo>
                    <a:pt x="676" y="91484"/>
                  </a:lnTo>
                  <a:lnTo>
                    <a:pt x="677" y="91871"/>
                  </a:lnTo>
                  <a:lnTo>
                    <a:pt x="679" y="92259"/>
                  </a:lnTo>
                  <a:lnTo>
                    <a:pt x="680" y="92647"/>
                  </a:lnTo>
                  <a:lnTo>
                    <a:pt x="681" y="93034"/>
                  </a:lnTo>
                  <a:lnTo>
                    <a:pt x="682" y="93422"/>
                  </a:lnTo>
                  <a:lnTo>
                    <a:pt x="683" y="93810"/>
                  </a:lnTo>
                  <a:lnTo>
                    <a:pt x="684" y="94197"/>
                  </a:lnTo>
                  <a:lnTo>
                    <a:pt x="685" y="94585"/>
                  </a:lnTo>
                  <a:lnTo>
                    <a:pt x="686" y="94973"/>
                  </a:lnTo>
                  <a:lnTo>
                    <a:pt x="687" y="95360"/>
                  </a:lnTo>
                  <a:lnTo>
                    <a:pt x="688" y="95748"/>
                  </a:lnTo>
                  <a:lnTo>
                    <a:pt x="689" y="96136"/>
                  </a:lnTo>
                  <a:lnTo>
                    <a:pt x="690" y="96523"/>
                  </a:lnTo>
                  <a:lnTo>
                    <a:pt x="690" y="96911"/>
                  </a:lnTo>
                  <a:lnTo>
                    <a:pt x="691" y="97299"/>
                  </a:lnTo>
                  <a:lnTo>
                    <a:pt x="692" y="97686"/>
                  </a:lnTo>
                  <a:lnTo>
                    <a:pt x="692" y="98074"/>
                  </a:lnTo>
                  <a:lnTo>
                    <a:pt x="693" y="98461"/>
                  </a:lnTo>
                  <a:lnTo>
                    <a:pt x="693" y="98849"/>
                  </a:lnTo>
                  <a:lnTo>
                    <a:pt x="694" y="99237"/>
                  </a:lnTo>
                  <a:lnTo>
                    <a:pt x="694" y="99624"/>
                  </a:lnTo>
                  <a:lnTo>
                    <a:pt x="695" y="100012"/>
                  </a:lnTo>
                  <a:lnTo>
                    <a:pt x="695" y="100400"/>
                  </a:lnTo>
                  <a:lnTo>
                    <a:pt x="695" y="100787"/>
                  </a:lnTo>
                  <a:lnTo>
                    <a:pt x="696" y="101175"/>
                  </a:lnTo>
                  <a:lnTo>
                    <a:pt x="696" y="101563"/>
                  </a:lnTo>
                  <a:lnTo>
                    <a:pt x="696" y="101950"/>
                  </a:lnTo>
                  <a:lnTo>
                    <a:pt x="697" y="102338"/>
                  </a:lnTo>
                  <a:lnTo>
                    <a:pt x="697" y="102726"/>
                  </a:lnTo>
                  <a:lnTo>
                    <a:pt x="697" y="103113"/>
                  </a:lnTo>
                  <a:lnTo>
                    <a:pt x="697" y="103501"/>
                  </a:lnTo>
                  <a:lnTo>
                    <a:pt x="697" y="103889"/>
                  </a:lnTo>
                  <a:lnTo>
                    <a:pt x="698" y="104276"/>
                  </a:lnTo>
                  <a:lnTo>
                    <a:pt x="698" y="104664"/>
                  </a:lnTo>
                  <a:lnTo>
                    <a:pt x="698" y="105051"/>
                  </a:lnTo>
                  <a:lnTo>
                    <a:pt x="698" y="105439"/>
                  </a:lnTo>
                  <a:lnTo>
                    <a:pt x="698" y="105827"/>
                  </a:lnTo>
                  <a:lnTo>
                    <a:pt x="698" y="106214"/>
                  </a:lnTo>
                  <a:lnTo>
                    <a:pt x="698" y="106602"/>
                  </a:lnTo>
                  <a:lnTo>
                    <a:pt x="698" y="106990"/>
                  </a:lnTo>
                  <a:lnTo>
                    <a:pt x="698" y="107377"/>
                  </a:lnTo>
                  <a:lnTo>
                    <a:pt x="698" y="107765"/>
                  </a:lnTo>
                  <a:lnTo>
                    <a:pt x="698" y="108153"/>
                  </a:lnTo>
                  <a:lnTo>
                    <a:pt x="698" y="108540"/>
                  </a:lnTo>
                  <a:lnTo>
                    <a:pt x="699" y="108928"/>
                  </a:lnTo>
                  <a:lnTo>
                    <a:pt x="699" y="109316"/>
                  </a:lnTo>
                  <a:lnTo>
                    <a:pt x="698" y="109703"/>
                  </a:lnTo>
                  <a:lnTo>
                    <a:pt x="698" y="110091"/>
                  </a:lnTo>
                  <a:lnTo>
                    <a:pt x="698" y="110478"/>
                  </a:lnTo>
                  <a:lnTo>
                    <a:pt x="698" y="110866"/>
                  </a:lnTo>
                  <a:lnTo>
                    <a:pt x="698" y="111254"/>
                  </a:lnTo>
                  <a:lnTo>
                    <a:pt x="698" y="111641"/>
                  </a:lnTo>
                  <a:lnTo>
                    <a:pt x="698" y="112029"/>
                  </a:lnTo>
                  <a:lnTo>
                    <a:pt x="698" y="112417"/>
                  </a:lnTo>
                  <a:lnTo>
                    <a:pt x="698" y="112804"/>
                  </a:lnTo>
                  <a:lnTo>
                    <a:pt x="698" y="113192"/>
                  </a:lnTo>
                  <a:lnTo>
                    <a:pt x="698" y="113580"/>
                  </a:lnTo>
                  <a:lnTo>
                    <a:pt x="698" y="113967"/>
                  </a:lnTo>
                  <a:lnTo>
                    <a:pt x="698" y="114355"/>
                  </a:lnTo>
                  <a:lnTo>
                    <a:pt x="698" y="114743"/>
                  </a:lnTo>
                  <a:lnTo>
                    <a:pt x="697" y="115130"/>
                  </a:lnTo>
                  <a:lnTo>
                    <a:pt x="697" y="115518"/>
                  </a:lnTo>
                  <a:lnTo>
                    <a:pt x="697" y="115906"/>
                  </a:lnTo>
                  <a:lnTo>
                    <a:pt x="697" y="116293"/>
                  </a:lnTo>
                  <a:lnTo>
                    <a:pt x="696" y="116681"/>
                  </a:lnTo>
                  <a:lnTo>
                    <a:pt x="696" y="117068"/>
                  </a:lnTo>
                  <a:lnTo>
                    <a:pt x="696" y="117456"/>
                  </a:lnTo>
                  <a:lnTo>
                    <a:pt x="696" y="117844"/>
                  </a:lnTo>
                  <a:lnTo>
                    <a:pt x="695" y="118231"/>
                  </a:lnTo>
                  <a:lnTo>
                    <a:pt x="695" y="118619"/>
                  </a:lnTo>
                  <a:lnTo>
                    <a:pt x="694" y="119007"/>
                  </a:lnTo>
                  <a:lnTo>
                    <a:pt x="694" y="119394"/>
                  </a:lnTo>
                  <a:lnTo>
                    <a:pt x="693" y="119782"/>
                  </a:lnTo>
                  <a:lnTo>
                    <a:pt x="693" y="120170"/>
                  </a:lnTo>
                  <a:lnTo>
                    <a:pt x="692" y="120557"/>
                  </a:lnTo>
                  <a:lnTo>
                    <a:pt x="692" y="120945"/>
                  </a:lnTo>
                  <a:lnTo>
                    <a:pt x="691" y="121333"/>
                  </a:lnTo>
                  <a:lnTo>
                    <a:pt x="690" y="121720"/>
                  </a:lnTo>
                  <a:lnTo>
                    <a:pt x="689" y="122108"/>
                  </a:lnTo>
                  <a:lnTo>
                    <a:pt x="689" y="122495"/>
                  </a:lnTo>
                  <a:lnTo>
                    <a:pt x="688" y="122883"/>
                  </a:lnTo>
                  <a:lnTo>
                    <a:pt x="687" y="123271"/>
                  </a:lnTo>
                  <a:lnTo>
                    <a:pt x="686" y="123658"/>
                  </a:lnTo>
                  <a:lnTo>
                    <a:pt x="685" y="124046"/>
                  </a:lnTo>
                  <a:lnTo>
                    <a:pt x="683" y="124434"/>
                  </a:lnTo>
                  <a:lnTo>
                    <a:pt x="682" y="124821"/>
                  </a:lnTo>
                  <a:lnTo>
                    <a:pt x="681" y="125209"/>
                  </a:lnTo>
                  <a:lnTo>
                    <a:pt x="680" y="125597"/>
                  </a:lnTo>
                  <a:lnTo>
                    <a:pt x="678" y="125984"/>
                  </a:lnTo>
                  <a:lnTo>
                    <a:pt x="677" y="126372"/>
                  </a:lnTo>
                  <a:lnTo>
                    <a:pt x="675" y="126760"/>
                  </a:lnTo>
                  <a:lnTo>
                    <a:pt x="673" y="127147"/>
                  </a:lnTo>
                  <a:lnTo>
                    <a:pt x="671" y="127535"/>
                  </a:lnTo>
                  <a:lnTo>
                    <a:pt x="670" y="127923"/>
                  </a:lnTo>
                  <a:lnTo>
                    <a:pt x="668" y="128310"/>
                  </a:lnTo>
                  <a:lnTo>
                    <a:pt x="665" y="128698"/>
                  </a:lnTo>
                  <a:lnTo>
                    <a:pt x="663" y="129085"/>
                  </a:lnTo>
                  <a:lnTo>
                    <a:pt x="661" y="129473"/>
                  </a:lnTo>
                  <a:lnTo>
                    <a:pt x="659" y="129861"/>
                  </a:lnTo>
                  <a:lnTo>
                    <a:pt x="656" y="130248"/>
                  </a:lnTo>
                  <a:lnTo>
                    <a:pt x="654" y="130636"/>
                  </a:lnTo>
                  <a:lnTo>
                    <a:pt x="651" y="131024"/>
                  </a:lnTo>
                  <a:lnTo>
                    <a:pt x="648" y="131411"/>
                  </a:lnTo>
                  <a:lnTo>
                    <a:pt x="645" y="131799"/>
                  </a:lnTo>
                  <a:lnTo>
                    <a:pt x="642" y="132187"/>
                  </a:lnTo>
                  <a:lnTo>
                    <a:pt x="639" y="132574"/>
                  </a:lnTo>
                  <a:lnTo>
                    <a:pt x="636" y="132962"/>
                  </a:lnTo>
                  <a:lnTo>
                    <a:pt x="633" y="133350"/>
                  </a:lnTo>
                  <a:lnTo>
                    <a:pt x="629" y="133737"/>
                  </a:lnTo>
                  <a:lnTo>
                    <a:pt x="626" y="134125"/>
                  </a:lnTo>
                  <a:lnTo>
                    <a:pt x="622" y="134513"/>
                  </a:lnTo>
                  <a:lnTo>
                    <a:pt x="618" y="134900"/>
                  </a:lnTo>
                  <a:lnTo>
                    <a:pt x="614" y="135288"/>
                  </a:lnTo>
                  <a:lnTo>
                    <a:pt x="610" y="135675"/>
                  </a:lnTo>
                  <a:lnTo>
                    <a:pt x="606" y="136063"/>
                  </a:lnTo>
                  <a:lnTo>
                    <a:pt x="602" y="136451"/>
                  </a:lnTo>
                  <a:lnTo>
                    <a:pt x="598" y="136838"/>
                  </a:lnTo>
                  <a:lnTo>
                    <a:pt x="593" y="137226"/>
                  </a:lnTo>
                  <a:lnTo>
                    <a:pt x="589" y="137614"/>
                  </a:lnTo>
                  <a:lnTo>
                    <a:pt x="584" y="138001"/>
                  </a:lnTo>
                  <a:lnTo>
                    <a:pt x="580" y="138389"/>
                  </a:lnTo>
                  <a:lnTo>
                    <a:pt x="575" y="138777"/>
                  </a:lnTo>
                  <a:lnTo>
                    <a:pt x="570" y="139164"/>
                  </a:lnTo>
                  <a:lnTo>
                    <a:pt x="565" y="139552"/>
                  </a:lnTo>
                  <a:lnTo>
                    <a:pt x="560" y="139940"/>
                  </a:lnTo>
                  <a:lnTo>
                    <a:pt x="554" y="140327"/>
                  </a:lnTo>
                  <a:lnTo>
                    <a:pt x="549" y="140715"/>
                  </a:lnTo>
                  <a:lnTo>
                    <a:pt x="544" y="141102"/>
                  </a:lnTo>
                  <a:lnTo>
                    <a:pt x="538" y="141490"/>
                  </a:lnTo>
                  <a:lnTo>
                    <a:pt x="533" y="141878"/>
                  </a:lnTo>
                  <a:lnTo>
                    <a:pt x="527" y="142265"/>
                  </a:lnTo>
                  <a:lnTo>
                    <a:pt x="521" y="142653"/>
                  </a:lnTo>
                  <a:lnTo>
                    <a:pt x="515" y="143041"/>
                  </a:lnTo>
                  <a:lnTo>
                    <a:pt x="509" y="143428"/>
                  </a:lnTo>
                  <a:lnTo>
                    <a:pt x="503" y="143816"/>
                  </a:lnTo>
                  <a:lnTo>
                    <a:pt x="497" y="144204"/>
                  </a:lnTo>
                  <a:lnTo>
                    <a:pt x="491" y="144591"/>
                  </a:lnTo>
                  <a:lnTo>
                    <a:pt x="485" y="144979"/>
                  </a:lnTo>
                  <a:lnTo>
                    <a:pt x="479" y="145367"/>
                  </a:lnTo>
                  <a:lnTo>
                    <a:pt x="472" y="145754"/>
                  </a:lnTo>
                  <a:lnTo>
                    <a:pt x="466" y="146142"/>
                  </a:lnTo>
                  <a:lnTo>
                    <a:pt x="460" y="146530"/>
                  </a:lnTo>
                  <a:lnTo>
                    <a:pt x="453" y="146917"/>
                  </a:lnTo>
                  <a:lnTo>
                    <a:pt x="447" y="147305"/>
                  </a:lnTo>
                  <a:lnTo>
                    <a:pt x="440" y="147692"/>
                  </a:lnTo>
                  <a:lnTo>
                    <a:pt x="434" y="148080"/>
                  </a:lnTo>
                  <a:lnTo>
                    <a:pt x="427" y="148468"/>
                  </a:lnTo>
                  <a:lnTo>
                    <a:pt x="420" y="148855"/>
                  </a:lnTo>
                  <a:lnTo>
                    <a:pt x="414" y="149243"/>
                  </a:lnTo>
                  <a:lnTo>
                    <a:pt x="407" y="149631"/>
                  </a:lnTo>
                  <a:lnTo>
                    <a:pt x="400" y="150018"/>
                  </a:lnTo>
                  <a:lnTo>
                    <a:pt x="394" y="150406"/>
                  </a:lnTo>
                  <a:lnTo>
                    <a:pt x="387" y="150794"/>
                  </a:lnTo>
                  <a:lnTo>
                    <a:pt x="380" y="151181"/>
                  </a:lnTo>
                  <a:lnTo>
                    <a:pt x="373" y="151569"/>
                  </a:lnTo>
                  <a:lnTo>
                    <a:pt x="367" y="151957"/>
                  </a:lnTo>
                  <a:lnTo>
                    <a:pt x="360" y="152344"/>
                  </a:lnTo>
                  <a:lnTo>
                    <a:pt x="353" y="152732"/>
                  </a:lnTo>
                  <a:lnTo>
                    <a:pt x="347" y="153119"/>
                  </a:lnTo>
                  <a:lnTo>
                    <a:pt x="340" y="153507"/>
                  </a:lnTo>
                  <a:lnTo>
                    <a:pt x="333" y="153895"/>
                  </a:lnTo>
                  <a:lnTo>
                    <a:pt x="327" y="154282"/>
                  </a:lnTo>
                  <a:lnTo>
                    <a:pt x="320" y="154670"/>
                  </a:lnTo>
                  <a:lnTo>
                    <a:pt x="314" y="155058"/>
                  </a:lnTo>
                  <a:lnTo>
                    <a:pt x="307" y="155445"/>
                  </a:lnTo>
                  <a:lnTo>
                    <a:pt x="301" y="155833"/>
                  </a:lnTo>
                  <a:lnTo>
                    <a:pt x="294" y="156221"/>
                  </a:lnTo>
                  <a:lnTo>
                    <a:pt x="288" y="156608"/>
                  </a:lnTo>
                  <a:lnTo>
                    <a:pt x="281" y="156996"/>
                  </a:lnTo>
                  <a:lnTo>
                    <a:pt x="275" y="157384"/>
                  </a:lnTo>
                  <a:lnTo>
                    <a:pt x="269" y="157771"/>
                  </a:lnTo>
                  <a:lnTo>
                    <a:pt x="263" y="158159"/>
                  </a:lnTo>
                  <a:lnTo>
                    <a:pt x="256" y="158547"/>
                  </a:lnTo>
                  <a:lnTo>
                    <a:pt x="250" y="158934"/>
                  </a:lnTo>
                  <a:lnTo>
                    <a:pt x="244" y="159322"/>
                  </a:lnTo>
                  <a:lnTo>
                    <a:pt x="238" y="159709"/>
                  </a:lnTo>
                  <a:lnTo>
                    <a:pt x="232" y="160097"/>
                  </a:lnTo>
                  <a:lnTo>
                    <a:pt x="227" y="160485"/>
                  </a:lnTo>
                  <a:lnTo>
                    <a:pt x="221" y="160872"/>
                  </a:lnTo>
                  <a:lnTo>
                    <a:pt x="215" y="161260"/>
                  </a:lnTo>
                  <a:lnTo>
                    <a:pt x="210" y="161648"/>
                  </a:lnTo>
                  <a:lnTo>
                    <a:pt x="204" y="162035"/>
                  </a:lnTo>
                  <a:lnTo>
                    <a:pt x="199" y="162423"/>
                  </a:lnTo>
                  <a:lnTo>
                    <a:pt x="193" y="162811"/>
                  </a:lnTo>
                  <a:lnTo>
                    <a:pt x="188" y="163198"/>
                  </a:lnTo>
                  <a:lnTo>
                    <a:pt x="183" y="163586"/>
                  </a:lnTo>
                  <a:lnTo>
                    <a:pt x="177" y="163974"/>
                  </a:lnTo>
                  <a:lnTo>
                    <a:pt x="172" y="164361"/>
                  </a:lnTo>
                  <a:lnTo>
                    <a:pt x="167" y="164749"/>
                  </a:lnTo>
                  <a:lnTo>
                    <a:pt x="163" y="165137"/>
                  </a:lnTo>
                  <a:lnTo>
                    <a:pt x="158" y="165524"/>
                  </a:lnTo>
                  <a:lnTo>
                    <a:pt x="153" y="165912"/>
                  </a:lnTo>
                  <a:lnTo>
                    <a:pt x="148" y="166299"/>
                  </a:lnTo>
                  <a:lnTo>
                    <a:pt x="144" y="166687"/>
                  </a:lnTo>
                  <a:lnTo>
                    <a:pt x="140" y="167075"/>
                  </a:lnTo>
                  <a:lnTo>
                    <a:pt x="135" y="167462"/>
                  </a:lnTo>
                  <a:lnTo>
                    <a:pt x="131" y="167850"/>
                  </a:lnTo>
                  <a:lnTo>
                    <a:pt x="127" y="168238"/>
                  </a:lnTo>
                  <a:lnTo>
                    <a:pt x="123" y="168625"/>
                  </a:lnTo>
                  <a:lnTo>
                    <a:pt x="119" y="169013"/>
                  </a:lnTo>
                  <a:lnTo>
                    <a:pt x="115" y="169401"/>
                  </a:lnTo>
                  <a:lnTo>
                    <a:pt x="111" y="169788"/>
                  </a:lnTo>
                  <a:lnTo>
                    <a:pt x="107" y="170176"/>
                  </a:lnTo>
                  <a:lnTo>
                    <a:pt x="104" y="170564"/>
                  </a:lnTo>
                  <a:lnTo>
                    <a:pt x="100" y="170951"/>
                  </a:lnTo>
                  <a:lnTo>
                    <a:pt x="97" y="171339"/>
                  </a:lnTo>
                  <a:lnTo>
                    <a:pt x="93" y="171726"/>
                  </a:lnTo>
                  <a:lnTo>
                    <a:pt x="90" y="172114"/>
                  </a:lnTo>
                  <a:lnTo>
                    <a:pt x="87" y="172502"/>
                  </a:lnTo>
                  <a:lnTo>
                    <a:pt x="84" y="172889"/>
                  </a:lnTo>
                  <a:lnTo>
                    <a:pt x="81" y="173277"/>
                  </a:lnTo>
                  <a:lnTo>
                    <a:pt x="78" y="173665"/>
                  </a:lnTo>
                  <a:lnTo>
                    <a:pt x="75" y="174052"/>
                  </a:lnTo>
                  <a:lnTo>
                    <a:pt x="72" y="174440"/>
                  </a:lnTo>
                  <a:lnTo>
                    <a:pt x="69" y="174828"/>
                  </a:lnTo>
                  <a:lnTo>
                    <a:pt x="67" y="175215"/>
                  </a:lnTo>
                  <a:lnTo>
                    <a:pt x="64" y="175603"/>
                  </a:lnTo>
                  <a:lnTo>
                    <a:pt x="62" y="175991"/>
                  </a:lnTo>
                  <a:lnTo>
                    <a:pt x="59" y="176378"/>
                  </a:lnTo>
                  <a:lnTo>
                    <a:pt x="57" y="176766"/>
                  </a:lnTo>
                  <a:lnTo>
                    <a:pt x="55" y="177154"/>
                  </a:lnTo>
                  <a:lnTo>
                    <a:pt x="52" y="177541"/>
                  </a:lnTo>
                  <a:lnTo>
                    <a:pt x="50" y="177929"/>
                  </a:lnTo>
                  <a:lnTo>
                    <a:pt x="48" y="178316"/>
                  </a:lnTo>
                  <a:lnTo>
                    <a:pt x="46" y="178704"/>
                  </a:lnTo>
                  <a:lnTo>
                    <a:pt x="44" y="179092"/>
                  </a:lnTo>
                  <a:lnTo>
                    <a:pt x="42" y="179479"/>
                  </a:lnTo>
                  <a:lnTo>
                    <a:pt x="41" y="179867"/>
                  </a:lnTo>
                  <a:lnTo>
                    <a:pt x="39" y="180255"/>
                  </a:lnTo>
                  <a:lnTo>
                    <a:pt x="37" y="180642"/>
                  </a:lnTo>
                  <a:lnTo>
                    <a:pt x="36" y="181030"/>
                  </a:lnTo>
                  <a:lnTo>
                    <a:pt x="34" y="181418"/>
                  </a:lnTo>
                  <a:lnTo>
                    <a:pt x="32" y="181805"/>
                  </a:lnTo>
                  <a:lnTo>
                    <a:pt x="31" y="182193"/>
                  </a:lnTo>
                  <a:lnTo>
                    <a:pt x="30" y="182581"/>
                  </a:lnTo>
                  <a:lnTo>
                    <a:pt x="28" y="182968"/>
                  </a:lnTo>
                  <a:lnTo>
                    <a:pt x="27" y="183356"/>
                  </a:lnTo>
                  <a:lnTo>
                    <a:pt x="26" y="183743"/>
                  </a:lnTo>
                  <a:lnTo>
                    <a:pt x="24" y="184131"/>
                  </a:lnTo>
                  <a:lnTo>
                    <a:pt x="23" y="184519"/>
                  </a:lnTo>
                  <a:lnTo>
                    <a:pt x="22" y="184906"/>
                  </a:lnTo>
                  <a:lnTo>
                    <a:pt x="21" y="185294"/>
                  </a:lnTo>
                  <a:lnTo>
                    <a:pt x="20" y="185682"/>
                  </a:lnTo>
                  <a:lnTo>
                    <a:pt x="19" y="186069"/>
                  </a:lnTo>
                  <a:lnTo>
                    <a:pt x="18" y="186457"/>
                  </a:lnTo>
                  <a:lnTo>
                    <a:pt x="17" y="186845"/>
                  </a:lnTo>
                  <a:lnTo>
                    <a:pt x="16" y="187232"/>
                  </a:lnTo>
                  <a:lnTo>
                    <a:pt x="16" y="187620"/>
                  </a:lnTo>
                  <a:lnTo>
                    <a:pt x="15" y="188008"/>
                  </a:lnTo>
                  <a:lnTo>
                    <a:pt x="14" y="188395"/>
                  </a:lnTo>
                  <a:lnTo>
                    <a:pt x="13" y="188783"/>
                  </a:lnTo>
                  <a:lnTo>
                    <a:pt x="13" y="189171"/>
                  </a:lnTo>
                  <a:lnTo>
                    <a:pt x="12" y="189558"/>
                  </a:lnTo>
                  <a:lnTo>
                    <a:pt x="11" y="189946"/>
                  </a:lnTo>
                  <a:lnTo>
                    <a:pt x="11" y="190333"/>
                  </a:lnTo>
                  <a:lnTo>
                    <a:pt x="10" y="190721"/>
                  </a:lnTo>
                  <a:lnTo>
                    <a:pt x="10" y="191109"/>
                  </a:lnTo>
                  <a:lnTo>
                    <a:pt x="9" y="191496"/>
                  </a:lnTo>
                  <a:lnTo>
                    <a:pt x="9" y="191884"/>
                  </a:lnTo>
                  <a:lnTo>
                    <a:pt x="8" y="192272"/>
                  </a:lnTo>
                  <a:lnTo>
                    <a:pt x="8" y="192659"/>
                  </a:lnTo>
                  <a:lnTo>
                    <a:pt x="7" y="193047"/>
                  </a:lnTo>
                  <a:lnTo>
                    <a:pt x="7" y="193435"/>
                  </a:lnTo>
                  <a:lnTo>
                    <a:pt x="6" y="193822"/>
                  </a:lnTo>
                  <a:lnTo>
                    <a:pt x="6" y="194210"/>
                  </a:lnTo>
                  <a:lnTo>
                    <a:pt x="6" y="194598"/>
                  </a:lnTo>
                  <a:lnTo>
                    <a:pt x="5" y="194985"/>
                  </a:lnTo>
                  <a:lnTo>
                    <a:pt x="5" y="195373"/>
                  </a:lnTo>
                  <a:lnTo>
                    <a:pt x="5" y="195761"/>
                  </a:lnTo>
                  <a:lnTo>
                    <a:pt x="4" y="196148"/>
                  </a:lnTo>
                  <a:lnTo>
                    <a:pt x="4" y="196536"/>
                  </a:lnTo>
                  <a:lnTo>
                    <a:pt x="4" y="196923"/>
                  </a:lnTo>
                  <a:lnTo>
                    <a:pt x="4" y="197311"/>
                  </a:lnTo>
                  <a:lnTo>
                    <a:pt x="3" y="197699"/>
                  </a:lnTo>
                  <a:lnTo>
                    <a:pt x="3" y="198086"/>
                  </a:lnTo>
                  <a:lnTo>
                    <a:pt x="0" y="198086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54" name="pl36"/>
            <p:cNvSpPr/>
            <p:nvPr/>
          </p:nvSpPr>
          <p:spPr>
            <a:xfrm>
              <a:off x="4983500" y="1957518"/>
              <a:ext cx="54" cy="2705258"/>
            </a:xfrm>
            <a:custGeom>
              <a:avLst/>
              <a:gdLst/>
              <a:ahLst/>
              <a:cxnLst/>
              <a:rect l="0" t="0" r="0" b="0"/>
              <a:pathLst>
                <a:path w="54" h="2705258">
                  <a:moveTo>
                    <a:pt x="54" y="2705258"/>
                  </a:moveTo>
                  <a:lnTo>
                    <a:pt x="53" y="2705258"/>
                  </a:lnTo>
                  <a:lnTo>
                    <a:pt x="53" y="2699964"/>
                  </a:lnTo>
                  <a:lnTo>
                    <a:pt x="53" y="2694670"/>
                  </a:lnTo>
                  <a:lnTo>
                    <a:pt x="53" y="2689376"/>
                  </a:lnTo>
                  <a:lnTo>
                    <a:pt x="53" y="2684082"/>
                  </a:lnTo>
                  <a:lnTo>
                    <a:pt x="53" y="2678788"/>
                  </a:lnTo>
                  <a:lnTo>
                    <a:pt x="53" y="2673494"/>
                  </a:lnTo>
                  <a:lnTo>
                    <a:pt x="53" y="2668200"/>
                  </a:lnTo>
                  <a:lnTo>
                    <a:pt x="53" y="2662906"/>
                  </a:lnTo>
                  <a:lnTo>
                    <a:pt x="53" y="2657612"/>
                  </a:lnTo>
                  <a:lnTo>
                    <a:pt x="53" y="2652318"/>
                  </a:lnTo>
                  <a:lnTo>
                    <a:pt x="53" y="2647024"/>
                  </a:lnTo>
                  <a:lnTo>
                    <a:pt x="53" y="2641730"/>
                  </a:lnTo>
                  <a:lnTo>
                    <a:pt x="53" y="2636436"/>
                  </a:lnTo>
                  <a:lnTo>
                    <a:pt x="53" y="2631142"/>
                  </a:lnTo>
                  <a:lnTo>
                    <a:pt x="53" y="2625848"/>
                  </a:lnTo>
                  <a:lnTo>
                    <a:pt x="53" y="2620554"/>
                  </a:lnTo>
                  <a:lnTo>
                    <a:pt x="53" y="2615260"/>
                  </a:lnTo>
                  <a:lnTo>
                    <a:pt x="53" y="2609966"/>
                  </a:lnTo>
                  <a:lnTo>
                    <a:pt x="53" y="2604672"/>
                  </a:lnTo>
                  <a:lnTo>
                    <a:pt x="53" y="2599378"/>
                  </a:lnTo>
                  <a:lnTo>
                    <a:pt x="53" y="2594083"/>
                  </a:lnTo>
                  <a:lnTo>
                    <a:pt x="53" y="2588789"/>
                  </a:lnTo>
                  <a:lnTo>
                    <a:pt x="53" y="2583495"/>
                  </a:lnTo>
                  <a:lnTo>
                    <a:pt x="53" y="2578201"/>
                  </a:lnTo>
                  <a:lnTo>
                    <a:pt x="53" y="2572907"/>
                  </a:lnTo>
                  <a:lnTo>
                    <a:pt x="53" y="2567613"/>
                  </a:lnTo>
                  <a:lnTo>
                    <a:pt x="52" y="2562319"/>
                  </a:lnTo>
                  <a:lnTo>
                    <a:pt x="52" y="2557025"/>
                  </a:lnTo>
                  <a:lnTo>
                    <a:pt x="52" y="2551731"/>
                  </a:lnTo>
                  <a:lnTo>
                    <a:pt x="52" y="2546437"/>
                  </a:lnTo>
                  <a:lnTo>
                    <a:pt x="52" y="2541143"/>
                  </a:lnTo>
                  <a:lnTo>
                    <a:pt x="52" y="2535849"/>
                  </a:lnTo>
                  <a:lnTo>
                    <a:pt x="52" y="2530555"/>
                  </a:lnTo>
                  <a:lnTo>
                    <a:pt x="52" y="2525261"/>
                  </a:lnTo>
                  <a:lnTo>
                    <a:pt x="52" y="2519967"/>
                  </a:lnTo>
                  <a:lnTo>
                    <a:pt x="52" y="2514673"/>
                  </a:lnTo>
                  <a:lnTo>
                    <a:pt x="52" y="2509379"/>
                  </a:lnTo>
                  <a:lnTo>
                    <a:pt x="52" y="2504085"/>
                  </a:lnTo>
                  <a:lnTo>
                    <a:pt x="51" y="2498791"/>
                  </a:lnTo>
                  <a:lnTo>
                    <a:pt x="51" y="2493497"/>
                  </a:lnTo>
                  <a:lnTo>
                    <a:pt x="51" y="2488202"/>
                  </a:lnTo>
                  <a:lnTo>
                    <a:pt x="51" y="2482908"/>
                  </a:lnTo>
                  <a:lnTo>
                    <a:pt x="51" y="2477614"/>
                  </a:lnTo>
                  <a:lnTo>
                    <a:pt x="51" y="2472320"/>
                  </a:lnTo>
                  <a:lnTo>
                    <a:pt x="51" y="2467026"/>
                  </a:lnTo>
                  <a:lnTo>
                    <a:pt x="51" y="2461732"/>
                  </a:lnTo>
                  <a:lnTo>
                    <a:pt x="51" y="2456438"/>
                  </a:lnTo>
                  <a:lnTo>
                    <a:pt x="50" y="2451144"/>
                  </a:lnTo>
                  <a:lnTo>
                    <a:pt x="50" y="2445850"/>
                  </a:lnTo>
                  <a:lnTo>
                    <a:pt x="50" y="2440556"/>
                  </a:lnTo>
                  <a:lnTo>
                    <a:pt x="50" y="2435262"/>
                  </a:lnTo>
                  <a:lnTo>
                    <a:pt x="50" y="2429968"/>
                  </a:lnTo>
                  <a:lnTo>
                    <a:pt x="50" y="2424674"/>
                  </a:lnTo>
                  <a:lnTo>
                    <a:pt x="49" y="2419380"/>
                  </a:lnTo>
                  <a:lnTo>
                    <a:pt x="49" y="2414086"/>
                  </a:lnTo>
                  <a:lnTo>
                    <a:pt x="49" y="2408792"/>
                  </a:lnTo>
                  <a:lnTo>
                    <a:pt x="49" y="2403498"/>
                  </a:lnTo>
                  <a:lnTo>
                    <a:pt x="49" y="2398204"/>
                  </a:lnTo>
                  <a:lnTo>
                    <a:pt x="49" y="2392910"/>
                  </a:lnTo>
                  <a:lnTo>
                    <a:pt x="48" y="2387616"/>
                  </a:lnTo>
                  <a:lnTo>
                    <a:pt x="48" y="2382322"/>
                  </a:lnTo>
                  <a:lnTo>
                    <a:pt x="48" y="2377027"/>
                  </a:lnTo>
                  <a:lnTo>
                    <a:pt x="48" y="2371733"/>
                  </a:lnTo>
                  <a:lnTo>
                    <a:pt x="48" y="2366439"/>
                  </a:lnTo>
                  <a:lnTo>
                    <a:pt x="47" y="2361145"/>
                  </a:lnTo>
                  <a:lnTo>
                    <a:pt x="47" y="2355851"/>
                  </a:lnTo>
                  <a:lnTo>
                    <a:pt x="47" y="2350557"/>
                  </a:lnTo>
                  <a:lnTo>
                    <a:pt x="47" y="2345263"/>
                  </a:lnTo>
                  <a:lnTo>
                    <a:pt x="46" y="2339969"/>
                  </a:lnTo>
                  <a:lnTo>
                    <a:pt x="46" y="2334675"/>
                  </a:lnTo>
                  <a:lnTo>
                    <a:pt x="46" y="2329381"/>
                  </a:lnTo>
                  <a:lnTo>
                    <a:pt x="46" y="2324087"/>
                  </a:lnTo>
                  <a:lnTo>
                    <a:pt x="45" y="2318793"/>
                  </a:lnTo>
                  <a:lnTo>
                    <a:pt x="45" y="2313499"/>
                  </a:lnTo>
                  <a:lnTo>
                    <a:pt x="45" y="2308205"/>
                  </a:lnTo>
                  <a:lnTo>
                    <a:pt x="44" y="2302911"/>
                  </a:lnTo>
                  <a:lnTo>
                    <a:pt x="44" y="2297617"/>
                  </a:lnTo>
                  <a:lnTo>
                    <a:pt x="44" y="2292323"/>
                  </a:lnTo>
                  <a:lnTo>
                    <a:pt x="44" y="2287029"/>
                  </a:lnTo>
                  <a:lnTo>
                    <a:pt x="43" y="2281735"/>
                  </a:lnTo>
                  <a:lnTo>
                    <a:pt x="43" y="2276441"/>
                  </a:lnTo>
                  <a:lnTo>
                    <a:pt x="43" y="2271146"/>
                  </a:lnTo>
                  <a:lnTo>
                    <a:pt x="42" y="2265852"/>
                  </a:lnTo>
                  <a:lnTo>
                    <a:pt x="42" y="2260558"/>
                  </a:lnTo>
                  <a:lnTo>
                    <a:pt x="42" y="2255264"/>
                  </a:lnTo>
                  <a:lnTo>
                    <a:pt x="41" y="2249970"/>
                  </a:lnTo>
                  <a:lnTo>
                    <a:pt x="41" y="2244676"/>
                  </a:lnTo>
                  <a:lnTo>
                    <a:pt x="41" y="2239382"/>
                  </a:lnTo>
                  <a:lnTo>
                    <a:pt x="40" y="2234088"/>
                  </a:lnTo>
                  <a:lnTo>
                    <a:pt x="40" y="2228794"/>
                  </a:lnTo>
                  <a:lnTo>
                    <a:pt x="39" y="2223500"/>
                  </a:lnTo>
                  <a:lnTo>
                    <a:pt x="39" y="2218206"/>
                  </a:lnTo>
                  <a:lnTo>
                    <a:pt x="39" y="2212912"/>
                  </a:lnTo>
                  <a:lnTo>
                    <a:pt x="38" y="2207618"/>
                  </a:lnTo>
                  <a:lnTo>
                    <a:pt x="38" y="2202324"/>
                  </a:lnTo>
                  <a:lnTo>
                    <a:pt x="38" y="2197030"/>
                  </a:lnTo>
                  <a:lnTo>
                    <a:pt x="37" y="2191736"/>
                  </a:lnTo>
                  <a:lnTo>
                    <a:pt x="37" y="2186442"/>
                  </a:lnTo>
                  <a:lnTo>
                    <a:pt x="36" y="2181148"/>
                  </a:lnTo>
                  <a:lnTo>
                    <a:pt x="36" y="2175854"/>
                  </a:lnTo>
                  <a:lnTo>
                    <a:pt x="36" y="2170560"/>
                  </a:lnTo>
                  <a:lnTo>
                    <a:pt x="35" y="2165265"/>
                  </a:lnTo>
                  <a:lnTo>
                    <a:pt x="35" y="2159971"/>
                  </a:lnTo>
                  <a:lnTo>
                    <a:pt x="34" y="2154677"/>
                  </a:lnTo>
                  <a:lnTo>
                    <a:pt x="34" y="2149383"/>
                  </a:lnTo>
                  <a:lnTo>
                    <a:pt x="33" y="2144089"/>
                  </a:lnTo>
                  <a:lnTo>
                    <a:pt x="33" y="2138795"/>
                  </a:lnTo>
                  <a:lnTo>
                    <a:pt x="33" y="2133501"/>
                  </a:lnTo>
                  <a:lnTo>
                    <a:pt x="32" y="2128207"/>
                  </a:lnTo>
                  <a:lnTo>
                    <a:pt x="32" y="2122913"/>
                  </a:lnTo>
                  <a:lnTo>
                    <a:pt x="31" y="2117619"/>
                  </a:lnTo>
                  <a:lnTo>
                    <a:pt x="31" y="2112325"/>
                  </a:lnTo>
                  <a:lnTo>
                    <a:pt x="30" y="2107031"/>
                  </a:lnTo>
                  <a:lnTo>
                    <a:pt x="30" y="2101737"/>
                  </a:lnTo>
                  <a:lnTo>
                    <a:pt x="29" y="2096443"/>
                  </a:lnTo>
                  <a:lnTo>
                    <a:pt x="29" y="2091149"/>
                  </a:lnTo>
                  <a:lnTo>
                    <a:pt x="29" y="2085855"/>
                  </a:lnTo>
                  <a:lnTo>
                    <a:pt x="28" y="2080561"/>
                  </a:lnTo>
                  <a:lnTo>
                    <a:pt x="28" y="2075267"/>
                  </a:lnTo>
                  <a:lnTo>
                    <a:pt x="27" y="2069973"/>
                  </a:lnTo>
                  <a:lnTo>
                    <a:pt x="27" y="2064679"/>
                  </a:lnTo>
                  <a:lnTo>
                    <a:pt x="26" y="2059385"/>
                  </a:lnTo>
                  <a:lnTo>
                    <a:pt x="26" y="2054090"/>
                  </a:lnTo>
                  <a:lnTo>
                    <a:pt x="26" y="2048796"/>
                  </a:lnTo>
                  <a:lnTo>
                    <a:pt x="25" y="2043502"/>
                  </a:lnTo>
                  <a:lnTo>
                    <a:pt x="25" y="2038208"/>
                  </a:lnTo>
                  <a:lnTo>
                    <a:pt x="24" y="2032914"/>
                  </a:lnTo>
                  <a:lnTo>
                    <a:pt x="24" y="2027620"/>
                  </a:lnTo>
                  <a:lnTo>
                    <a:pt x="23" y="2022326"/>
                  </a:lnTo>
                  <a:lnTo>
                    <a:pt x="23" y="2017032"/>
                  </a:lnTo>
                  <a:lnTo>
                    <a:pt x="23" y="2011738"/>
                  </a:lnTo>
                  <a:lnTo>
                    <a:pt x="22" y="2006444"/>
                  </a:lnTo>
                  <a:lnTo>
                    <a:pt x="22" y="2001150"/>
                  </a:lnTo>
                  <a:lnTo>
                    <a:pt x="21" y="1995856"/>
                  </a:lnTo>
                  <a:lnTo>
                    <a:pt x="21" y="1990562"/>
                  </a:lnTo>
                  <a:lnTo>
                    <a:pt x="21" y="1985268"/>
                  </a:lnTo>
                  <a:lnTo>
                    <a:pt x="20" y="1979974"/>
                  </a:lnTo>
                  <a:lnTo>
                    <a:pt x="20" y="1974680"/>
                  </a:lnTo>
                  <a:lnTo>
                    <a:pt x="20" y="1969386"/>
                  </a:lnTo>
                  <a:lnTo>
                    <a:pt x="19" y="1964092"/>
                  </a:lnTo>
                  <a:lnTo>
                    <a:pt x="19" y="1958798"/>
                  </a:lnTo>
                  <a:lnTo>
                    <a:pt x="19" y="1953504"/>
                  </a:lnTo>
                  <a:lnTo>
                    <a:pt x="18" y="1948209"/>
                  </a:lnTo>
                  <a:lnTo>
                    <a:pt x="18" y="1942915"/>
                  </a:lnTo>
                  <a:lnTo>
                    <a:pt x="18" y="1937621"/>
                  </a:lnTo>
                  <a:lnTo>
                    <a:pt x="17" y="1932327"/>
                  </a:lnTo>
                  <a:lnTo>
                    <a:pt x="17" y="1927033"/>
                  </a:lnTo>
                  <a:lnTo>
                    <a:pt x="17" y="1921739"/>
                  </a:lnTo>
                  <a:lnTo>
                    <a:pt x="16" y="1916445"/>
                  </a:lnTo>
                  <a:lnTo>
                    <a:pt x="16" y="1911151"/>
                  </a:lnTo>
                  <a:lnTo>
                    <a:pt x="16" y="1905857"/>
                  </a:lnTo>
                  <a:lnTo>
                    <a:pt x="16" y="1900563"/>
                  </a:lnTo>
                  <a:lnTo>
                    <a:pt x="15" y="1895269"/>
                  </a:lnTo>
                  <a:lnTo>
                    <a:pt x="15" y="1889975"/>
                  </a:lnTo>
                  <a:lnTo>
                    <a:pt x="15" y="1884681"/>
                  </a:lnTo>
                  <a:lnTo>
                    <a:pt x="15" y="1879387"/>
                  </a:lnTo>
                  <a:lnTo>
                    <a:pt x="14" y="1874093"/>
                  </a:lnTo>
                  <a:lnTo>
                    <a:pt x="14" y="1868799"/>
                  </a:lnTo>
                  <a:lnTo>
                    <a:pt x="14" y="1863505"/>
                  </a:lnTo>
                  <a:lnTo>
                    <a:pt x="14" y="1858211"/>
                  </a:lnTo>
                  <a:lnTo>
                    <a:pt x="14" y="1852917"/>
                  </a:lnTo>
                  <a:lnTo>
                    <a:pt x="13" y="1847623"/>
                  </a:lnTo>
                  <a:lnTo>
                    <a:pt x="13" y="1842329"/>
                  </a:lnTo>
                  <a:lnTo>
                    <a:pt x="13" y="1837034"/>
                  </a:lnTo>
                  <a:lnTo>
                    <a:pt x="13" y="1831740"/>
                  </a:lnTo>
                  <a:lnTo>
                    <a:pt x="13" y="1826446"/>
                  </a:lnTo>
                  <a:lnTo>
                    <a:pt x="13" y="1821152"/>
                  </a:lnTo>
                  <a:lnTo>
                    <a:pt x="13" y="1815858"/>
                  </a:lnTo>
                  <a:lnTo>
                    <a:pt x="13" y="1810564"/>
                  </a:lnTo>
                  <a:lnTo>
                    <a:pt x="12" y="1805270"/>
                  </a:lnTo>
                  <a:lnTo>
                    <a:pt x="12" y="1799976"/>
                  </a:lnTo>
                  <a:lnTo>
                    <a:pt x="12" y="1794682"/>
                  </a:lnTo>
                  <a:lnTo>
                    <a:pt x="12" y="1789388"/>
                  </a:lnTo>
                  <a:lnTo>
                    <a:pt x="12" y="1784094"/>
                  </a:lnTo>
                  <a:lnTo>
                    <a:pt x="12" y="1778800"/>
                  </a:lnTo>
                  <a:lnTo>
                    <a:pt x="12" y="1773506"/>
                  </a:lnTo>
                  <a:lnTo>
                    <a:pt x="12" y="1768212"/>
                  </a:lnTo>
                  <a:lnTo>
                    <a:pt x="12" y="1762918"/>
                  </a:lnTo>
                  <a:lnTo>
                    <a:pt x="12" y="1757624"/>
                  </a:lnTo>
                  <a:lnTo>
                    <a:pt x="12" y="1752330"/>
                  </a:lnTo>
                  <a:lnTo>
                    <a:pt x="12" y="1747036"/>
                  </a:lnTo>
                  <a:lnTo>
                    <a:pt x="12" y="1741742"/>
                  </a:lnTo>
                  <a:lnTo>
                    <a:pt x="12" y="1736448"/>
                  </a:lnTo>
                  <a:lnTo>
                    <a:pt x="12" y="1731153"/>
                  </a:lnTo>
                  <a:lnTo>
                    <a:pt x="12" y="1725859"/>
                  </a:lnTo>
                  <a:lnTo>
                    <a:pt x="12" y="1720565"/>
                  </a:lnTo>
                  <a:lnTo>
                    <a:pt x="12" y="1715271"/>
                  </a:lnTo>
                  <a:lnTo>
                    <a:pt x="12" y="1709977"/>
                  </a:lnTo>
                  <a:lnTo>
                    <a:pt x="12" y="1704683"/>
                  </a:lnTo>
                  <a:lnTo>
                    <a:pt x="12" y="1699389"/>
                  </a:lnTo>
                  <a:lnTo>
                    <a:pt x="12" y="1694095"/>
                  </a:lnTo>
                  <a:lnTo>
                    <a:pt x="12" y="1688801"/>
                  </a:lnTo>
                  <a:lnTo>
                    <a:pt x="12" y="1683507"/>
                  </a:lnTo>
                  <a:lnTo>
                    <a:pt x="12" y="1678213"/>
                  </a:lnTo>
                  <a:lnTo>
                    <a:pt x="13" y="1672919"/>
                  </a:lnTo>
                  <a:lnTo>
                    <a:pt x="13" y="1667625"/>
                  </a:lnTo>
                  <a:lnTo>
                    <a:pt x="13" y="1662331"/>
                  </a:lnTo>
                  <a:lnTo>
                    <a:pt x="13" y="1657037"/>
                  </a:lnTo>
                  <a:lnTo>
                    <a:pt x="13" y="1651743"/>
                  </a:lnTo>
                  <a:lnTo>
                    <a:pt x="13" y="1646449"/>
                  </a:lnTo>
                  <a:lnTo>
                    <a:pt x="13" y="1641155"/>
                  </a:lnTo>
                  <a:lnTo>
                    <a:pt x="13" y="1635861"/>
                  </a:lnTo>
                  <a:lnTo>
                    <a:pt x="13" y="1630567"/>
                  </a:lnTo>
                  <a:lnTo>
                    <a:pt x="13" y="1625273"/>
                  </a:lnTo>
                  <a:lnTo>
                    <a:pt x="13" y="1619978"/>
                  </a:lnTo>
                  <a:lnTo>
                    <a:pt x="13" y="1614684"/>
                  </a:lnTo>
                  <a:lnTo>
                    <a:pt x="13" y="1609390"/>
                  </a:lnTo>
                  <a:lnTo>
                    <a:pt x="13" y="1604096"/>
                  </a:lnTo>
                  <a:lnTo>
                    <a:pt x="14" y="1598802"/>
                  </a:lnTo>
                  <a:lnTo>
                    <a:pt x="14" y="1593508"/>
                  </a:lnTo>
                  <a:lnTo>
                    <a:pt x="14" y="1588214"/>
                  </a:lnTo>
                  <a:lnTo>
                    <a:pt x="14" y="1582920"/>
                  </a:lnTo>
                  <a:lnTo>
                    <a:pt x="14" y="1577626"/>
                  </a:lnTo>
                  <a:lnTo>
                    <a:pt x="14" y="1572332"/>
                  </a:lnTo>
                  <a:lnTo>
                    <a:pt x="14" y="1567038"/>
                  </a:lnTo>
                  <a:lnTo>
                    <a:pt x="14" y="1561744"/>
                  </a:lnTo>
                  <a:lnTo>
                    <a:pt x="14" y="1556450"/>
                  </a:lnTo>
                  <a:lnTo>
                    <a:pt x="14" y="1551156"/>
                  </a:lnTo>
                  <a:lnTo>
                    <a:pt x="14" y="1545862"/>
                  </a:lnTo>
                  <a:lnTo>
                    <a:pt x="14" y="1540568"/>
                  </a:lnTo>
                  <a:lnTo>
                    <a:pt x="14" y="1535274"/>
                  </a:lnTo>
                  <a:lnTo>
                    <a:pt x="14" y="1529980"/>
                  </a:lnTo>
                  <a:lnTo>
                    <a:pt x="14" y="1524686"/>
                  </a:lnTo>
                  <a:lnTo>
                    <a:pt x="14" y="1519392"/>
                  </a:lnTo>
                  <a:lnTo>
                    <a:pt x="14" y="1514097"/>
                  </a:lnTo>
                  <a:lnTo>
                    <a:pt x="14" y="1508803"/>
                  </a:lnTo>
                  <a:lnTo>
                    <a:pt x="14" y="1503509"/>
                  </a:lnTo>
                  <a:lnTo>
                    <a:pt x="14" y="1498215"/>
                  </a:lnTo>
                  <a:lnTo>
                    <a:pt x="14" y="1492921"/>
                  </a:lnTo>
                  <a:lnTo>
                    <a:pt x="14" y="1487627"/>
                  </a:lnTo>
                  <a:lnTo>
                    <a:pt x="14" y="1482333"/>
                  </a:lnTo>
                  <a:lnTo>
                    <a:pt x="14" y="1477039"/>
                  </a:lnTo>
                  <a:lnTo>
                    <a:pt x="14" y="1471745"/>
                  </a:lnTo>
                  <a:lnTo>
                    <a:pt x="14" y="1466451"/>
                  </a:lnTo>
                  <a:lnTo>
                    <a:pt x="13" y="1461157"/>
                  </a:lnTo>
                  <a:lnTo>
                    <a:pt x="13" y="1455863"/>
                  </a:lnTo>
                  <a:lnTo>
                    <a:pt x="13" y="1450569"/>
                  </a:lnTo>
                  <a:lnTo>
                    <a:pt x="13" y="1445275"/>
                  </a:lnTo>
                  <a:lnTo>
                    <a:pt x="13" y="1439981"/>
                  </a:lnTo>
                  <a:lnTo>
                    <a:pt x="13" y="1434687"/>
                  </a:lnTo>
                  <a:lnTo>
                    <a:pt x="13" y="1429393"/>
                  </a:lnTo>
                  <a:lnTo>
                    <a:pt x="13" y="1424099"/>
                  </a:lnTo>
                  <a:lnTo>
                    <a:pt x="13" y="1418805"/>
                  </a:lnTo>
                  <a:lnTo>
                    <a:pt x="12" y="1413511"/>
                  </a:lnTo>
                  <a:lnTo>
                    <a:pt x="12" y="1408217"/>
                  </a:lnTo>
                  <a:lnTo>
                    <a:pt x="12" y="1402922"/>
                  </a:lnTo>
                  <a:lnTo>
                    <a:pt x="12" y="1397628"/>
                  </a:lnTo>
                  <a:lnTo>
                    <a:pt x="12" y="1392334"/>
                  </a:lnTo>
                  <a:lnTo>
                    <a:pt x="12" y="1387040"/>
                  </a:lnTo>
                  <a:lnTo>
                    <a:pt x="11" y="1381746"/>
                  </a:lnTo>
                  <a:lnTo>
                    <a:pt x="11" y="1376452"/>
                  </a:lnTo>
                  <a:lnTo>
                    <a:pt x="11" y="1371158"/>
                  </a:lnTo>
                  <a:lnTo>
                    <a:pt x="11" y="1365864"/>
                  </a:lnTo>
                  <a:lnTo>
                    <a:pt x="10" y="1360570"/>
                  </a:lnTo>
                  <a:lnTo>
                    <a:pt x="10" y="1355276"/>
                  </a:lnTo>
                  <a:lnTo>
                    <a:pt x="10" y="1349982"/>
                  </a:lnTo>
                  <a:lnTo>
                    <a:pt x="10" y="1344688"/>
                  </a:lnTo>
                  <a:lnTo>
                    <a:pt x="10" y="1339394"/>
                  </a:lnTo>
                  <a:lnTo>
                    <a:pt x="9" y="1334100"/>
                  </a:lnTo>
                  <a:lnTo>
                    <a:pt x="9" y="1328806"/>
                  </a:lnTo>
                  <a:lnTo>
                    <a:pt x="9" y="1323512"/>
                  </a:lnTo>
                  <a:lnTo>
                    <a:pt x="9" y="1318218"/>
                  </a:lnTo>
                  <a:lnTo>
                    <a:pt x="8" y="1312924"/>
                  </a:lnTo>
                  <a:lnTo>
                    <a:pt x="8" y="1307630"/>
                  </a:lnTo>
                  <a:lnTo>
                    <a:pt x="8" y="1302336"/>
                  </a:lnTo>
                  <a:lnTo>
                    <a:pt x="7" y="1297041"/>
                  </a:lnTo>
                  <a:lnTo>
                    <a:pt x="7" y="1291747"/>
                  </a:lnTo>
                  <a:lnTo>
                    <a:pt x="7" y="1286453"/>
                  </a:lnTo>
                  <a:lnTo>
                    <a:pt x="7" y="1281159"/>
                  </a:lnTo>
                  <a:lnTo>
                    <a:pt x="6" y="1275865"/>
                  </a:lnTo>
                  <a:lnTo>
                    <a:pt x="6" y="1270571"/>
                  </a:lnTo>
                  <a:lnTo>
                    <a:pt x="6" y="1265277"/>
                  </a:lnTo>
                  <a:lnTo>
                    <a:pt x="6" y="1259983"/>
                  </a:lnTo>
                  <a:lnTo>
                    <a:pt x="5" y="1254689"/>
                  </a:lnTo>
                  <a:lnTo>
                    <a:pt x="5" y="1249395"/>
                  </a:lnTo>
                  <a:lnTo>
                    <a:pt x="5" y="1244101"/>
                  </a:lnTo>
                  <a:lnTo>
                    <a:pt x="5" y="1238807"/>
                  </a:lnTo>
                  <a:lnTo>
                    <a:pt x="4" y="1233513"/>
                  </a:lnTo>
                  <a:lnTo>
                    <a:pt x="4" y="1228219"/>
                  </a:lnTo>
                  <a:lnTo>
                    <a:pt x="4" y="1222925"/>
                  </a:lnTo>
                  <a:lnTo>
                    <a:pt x="4" y="1217631"/>
                  </a:lnTo>
                  <a:lnTo>
                    <a:pt x="3" y="1212337"/>
                  </a:lnTo>
                  <a:lnTo>
                    <a:pt x="3" y="1207043"/>
                  </a:lnTo>
                  <a:lnTo>
                    <a:pt x="3" y="1201749"/>
                  </a:lnTo>
                  <a:lnTo>
                    <a:pt x="3" y="1196455"/>
                  </a:lnTo>
                  <a:lnTo>
                    <a:pt x="2" y="1191161"/>
                  </a:lnTo>
                  <a:lnTo>
                    <a:pt x="2" y="1185866"/>
                  </a:lnTo>
                  <a:lnTo>
                    <a:pt x="2" y="1180572"/>
                  </a:lnTo>
                  <a:lnTo>
                    <a:pt x="2" y="1175278"/>
                  </a:lnTo>
                  <a:lnTo>
                    <a:pt x="2" y="1169984"/>
                  </a:lnTo>
                  <a:lnTo>
                    <a:pt x="1" y="1164690"/>
                  </a:lnTo>
                  <a:lnTo>
                    <a:pt x="1" y="1159396"/>
                  </a:lnTo>
                  <a:lnTo>
                    <a:pt x="1" y="1154102"/>
                  </a:lnTo>
                  <a:lnTo>
                    <a:pt x="1" y="1148808"/>
                  </a:lnTo>
                  <a:lnTo>
                    <a:pt x="1" y="1143514"/>
                  </a:lnTo>
                  <a:lnTo>
                    <a:pt x="1" y="1138220"/>
                  </a:lnTo>
                  <a:lnTo>
                    <a:pt x="0" y="1132926"/>
                  </a:lnTo>
                  <a:lnTo>
                    <a:pt x="0" y="1127632"/>
                  </a:lnTo>
                  <a:lnTo>
                    <a:pt x="0" y="1122338"/>
                  </a:lnTo>
                  <a:lnTo>
                    <a:pt x="0" y="1117044"/>
                  </a:lnTo>
                  <a:lnTo>
                    <a:pt x="0" y="1111750"/>
                  </a:lnTo>
                  <a:lnTo>
                    <a:pt x="0" y="1106456"/>
                  </a:lnTo>
                  <a:lnTo>
                    <a:pt x="0" y="1101162"/>
                  </a:lnTo>
                  <a:lnTo>
                    <a:pt x="0" y="1095868"/>
                  </a:lnTo>
                  <a:lnTo>
                    <a:pt x="0" y="1090574"/>
                  </a:lnTo>
                  <a:lnTo>
                    <a:pt x="0" y="1085280"/>
                  </a:lnTo>
                  <a:lnTo>
                    <a:pt x="0" y="1079985"/>
                  </a:lnTo>
                  <a:lnTo>
                    <a:pt x="0" y="1074691"/>
                  </a:lnTo>
                  <a:lnTo>
                    <a:pt x="0" y="1069397"/>
                  </a:lnTo>
                  <a:lnTo>
                    <a:pt x="0" y="1064103"/>
                  </a:lnTo>
                  <a:lnTo>
                    <a:pt x="0" y="1058809"/>
                  </a:lnTo>
                  <a:lnTo>
                    <a:pt x="0" y="1053515"/>
                  </a:lnTo>
                  <a:lnTo>
                    <a:pt x="0" y="1048221"/>
                  </a:lnTo>
                  <a:lnTo>
                    <a:pt x="0" y="1042927"/>
                  </a:lnTo>
                  <a:lnTo>
                    <a:pt x="0" y="1037633"/>
                  </a:lnTo>
                  <a:lnTo>
                    <a:pt x="0" y="1032339"/>
                  </a:lnTo>
                  <a:lnTo>
                    <a:pt x="0" y="1027045"/>
                  </a:lnTo>
                  <a:lnTo>
                    <a:pt x="0" y="1021751"/>
                  </a:lnTo>
                  <a:lnTo>
                    <a:pt x="0" y="1016457"/>
                  </a:lnTo>
                  <a:lnTo>
                    <a:pt x="0" y="1011163"/>
                  </a:lnTo>
                  <a:lnTo>
                    <a:pt x="0" y="1005869"/>
                  </a:lnTo>
                  <a:lnTo>
                    <a:pt x="0" y="1000575"/>
                  </a:lnTo>
                  <a:lnTo>
                    <a:pt x="1" y="995281"/>
                  </a:lnTo>
                  <a:lnTo>
                    <a:pt x="1" y="989987"/>
                  </a:lnTo>
                  <a:lnTo>
                    <a:pt x="1" y="984693"/>
                  </a:lnTo>
                  <a:lnTo>
                    <a:pt x="1" y="979399"/>
                  </a:lnTo>
                  <a:lnTo>
                    <a:pt x="1" y="974104"/>
                  </a:lnTo>
                  <a:lnTo>
                    <a:pt x="2" y="968810"/>
                  </a:lnTo>
                  <a:lnTo>
                    <a:pt x="2" y="963516"/>
                  </a:lnTo>
                  <a:lnTo>
                    <a:pt x="2" y="958222"/>
                  </a:lnTo>
                  <a:lnTo>
                    <a:pt x="2" y="952928"/>
                  </a:lnTo>
                  <a:lnTo>
                    <a:pt x="3" y="947634"/>
                  </a:lnTo>
                  <a:lnTo>
                    <a:pt x="3" y="942340"/>
                  </a:lnTo>
                  <a:lnTo>
                    <a:pt x="3" y="937046"/>
                  </a:lnTo>
                  <a:lnTo>
                    <a:pt x="3" y="931752"/>
                  </a:lnTo>
                  <a:lnTo>
                    <a:pt x="4" y="926458"/>
                  </a:lnTo>
                  <a:lnTo>
                    <a:pt x="4" y="921164"/>
                  </a:lnTo>
                  <a:lnTo>
                    <a:pt x="4" y="915870"/>
                  </a:lnTo>
                  <a:lnTo>
                    <a:pt x="5" y="910576"/>
                  </a:lnTo>
                  <a:lnTo>
                    <a:pt x="5" y="905282"/>
                  </a:lnTo>
                  <a:lnTo>
                    <a:pt x="6" y="899988"/>
                  </a:lnTo>
                  <a:lnTo>
                    <a:pt x="6" y="894694"/>
                  </a:lnTo>
                  <a:lnTo>
                    <a:pt x="6" y="889400"/>
                  </a:lnTo>
                  <a:lnTo>
                    <a:pt x="7" y="884106"/>
                  </a:lnTo>
                  <a:lnTo>
                    <a:pt x="7" y="878812"/>
                  </a:lnTo>
                  <a:lnTo>
                    <a:pt x="7" y="873518"/>
                  </a:lnTo>
                  <a:lnTo>
                    <a:pt x="8" y="868224"/>
                  </a:lnTo>
                  <a:lnTo>
                    <a:pt x="8" y="862929"/>
                  </a:lnTo>
                  <a:lnTo>
                    <a:pt x="9" y="857635"/>
                  </a:lnTo>
                  <a:lnTo>
                    <a:pt x="9" y="852341"/>
                  </a:lnTo>
                  <a:lnTo>
                    <a:pt x="10" y="847047"/>
                  </a:lnTo>
                  <a:lnTo>
                    <a:pt x="10" y="841753"/>
                  </a:lnTo>
                  <a:lnTo>
                    <a:pt x="11" y="836459"/>
                  </a:lnTo>
                  <a:lnTo>
                    <a:pt x="11" y="831165"/>
                  </a:lnTo>
                  <a:lnTo>
                    <a:pt x="12" y="825871"/>
                  </a:lnTo>
                  <a:lnTo>
                    <a:pt x="12" y="820577"/>
                  </a:lnTo>
                  <a:lnTo>
                    <a:pt x="12" y="815283"/>
                  </a:lnTo>
                  <a:lnTo>
                    <a:pt x="13" y="809989"/>
                  </a:lnTo>
                  <a:lnTo>
                    <a:pt x="13" y="804695"/>
                  </a:lnTo>
                  <a:lnTo>
                    <a:pt x="14" y="799401"/>
                  </a:lnTo>
                  <a:lnTo>
                    <a:pt x="14" y="794107"/>
                  </a:lnTo>
                  <a:lnTo>
                    <a:pt x="15" y="788813"/>
                  </a:lnTo>
                  <a:lnTo>
                    <a:pt x="15" y="783519"/>
                  </a:lnTo>
                  <a:lnTo>
                    <a:pt x="16" y="778225"/>
                  </a:lnTo>
                  <a:lnTo>
                    <a:pt x="17" y="772931"/>
                  </a:lnTo>
                  <a:lnTo>
                    <a:pt x="17" y="767637"/>
                  </a:lnTo>
                  <a:lnTo>
                    <a:pt x="18" y="762343"/>
                  </a:lnTo>
                  <a:lnTo>
                    <a:pt x="18" y="757048"/>
                  </a:lnTo>
                  <a:lnTo>
                    <a:pt x="19" y="751754"/>
                  </a:lnTo>
                  <a:lnTo>
                    <a:pt x="19" y="746460"/>
                  </a:lnTo>
                  <a:lnTo>
                    <a:pt x="20" y="741166"/>
                  </a:lnTo>
                  <a:lnTo>
                    <a:pt x="20" y="735872"/>
                  </a:lnTo>
                  <a:lnTo>
                    <a:pt x="21" y="730578"/>
                  </a:lnTo>
                  <a:lnTo>
                    <a:pt x="21" y="725284"/>
                  </a:lnTo>
                  <a:lnTo>
                    <a:pt x="22" y="719990"/>
                  </a:lnTo>
                  <a:lnTo>
                    <a:pt x="22" y="714696"/>
                  </a:lnTo>
                  <a:lnTo>
                    <a:pt x="23" y="709402"/>
                  </a:lnTo>
                  <a:lnTo>
                    <a:pt x="23" y="704108"/>
                  </a:lnTo>
                  <a:lnTo>
                    <a:pt x="24" y="698814"/>
                  </a:lnTo>
                  <a:lnTo>
                    <a:pt x="24" y="693520"/>
                  </a:lnTo>
                  <a:lnTo>
                    <a:pt x="25" y="688226"/>
                  </a:lnTo>
                  <a:lnTo>
                    <a:pt x="25" y="682932"/>
                  </a:lnTo>
                  <a:lnTo>
                    <a:pt x="26" y="677638"/>
                  </a:lnTo>
                  <a:lnTo>
                    <a:pt x="27" y="672344"/>
                  </a:lnTo>
                  <a:lnTo>
                    <a:pt x="27" y="667050"/>
                  </a:lnTo>
                  <a:lnTo>
                    <a:pt x="28" y="661756"/>
                  </a:lnTo>
                  <a:lnTo>
                    <a:pt x="28" y="656462"/>
                  </a:lnTo>
                  <a:lnTo>
                    <a:pt x="29" y="651168"/>
                  </a:lnTo>
                  <a:lnTo>
                    <a:pt x="29" y="645873"/>
                  </a:lnTo>
                  <a:lnTo>
                    <a:pt x="30" y="640579"/>
                  </a:lnTo>
                  <a:lnTo>
                    <a:pt x="30" y="635285"/>
                  </a:lnTo>
                  <a:lnTo>
                    <a:pt x="31" y="629991"/>
                  </a:lnTo>
                  <a:lnTo>
                    <a:pt x="31" y="624697"/>
                  </a:lnTo>
                  <a:lnTo>
                    <a:pt x="32" y="619403"/>
                  </a:lnTo>
                  <a:lnTo>
                    <a:pt x="32" y="614109"/>
                  </a:lnTo>
                  <a:lnTo>
                    <a:pt x="32" y="608815"/>
                  </a:lnTo>
                  <a:lnTo>
                    <a:pt x="33" y="603521"/>
                  </a:lnTo>
                  <a:lnTo>
                    <a:pt x="33" y="598227"/>
                  </a:lnTo>
                  <a:lnTo>
                    <a:pt x="34" y="592933"/>
                  </a:lnTo>
                  <a:lnTo>
                    <a:pt x="34" y="587639"/>
                  </a:lnTo>
                  <a:lnTo>
                    <a:pt x="35" y="582345"/>
                  </a:lnTo>
                  <a:lnTo>
                    <a:pt x="35" y="577051"/>
                  </a:lnTo>
                  <a:lnTo>
                    <a:pt x="36" y="571757"/>
                  </a:lnTo>
                  <a:lnTo>
                    <a:pt x="36" y="566463"/>
                  </a:lnTo>
                  <a:lnTo>
                    <a:pt x="37" y="561169"/>
                  </a:lnTo>
                  <a:lnTo>
                    <a:pt x="37" y="555875"/>
                  </a:lnTo>
                  <a:lnTo>
                    <a:pt x="37" y="550581"/>
                  </a:lnTo>
                  <a:lnTo>
                    <a:pt x="38" y="545287"/>
                  </a:lnTo>
                  <a:lnTo>
                    <a:pt x="38" y="539992"/>
                  </a:lnTo>
                  <a:lnTo>
                    <a:pt x="39" y="534698"/>
                  </a:lnTo>
                  <a:lnTo>
                    <a:pt x="39" y="529404"/>
                  </a:lnTo>
                  <a:lnTo>
                    <a:pt x="39" y="524110"/>
                  </a:lnTo>
                  <a:lnTo>
                    <a:pt x="40" y="518816"/>
                  </a:lnTo>
                  <a:lnTo>
                    <a:pt x="40" y="513522"/>
                  </a:lnTo>
                  <a:lnTo>
                    <a:pt x="41" y="508228"/>
                  </a:lnTo>
                  <a:lnTo>
                    <a:pt x="41" y="502934"/>
                  </a:lnTo>
                  <a:lnTo>
                    <a:pt x="41" y="497640"/>
                  </a:lnTo>
                  <a:lnTo>
                    <a:pt x="42" y="492346"/>
                  </a:lnTo>
                  <a:lnTo>
                    <a:pt x="42" y="487052"/>
                  </a:lnTo>
                  <a:lnTo>
                    <a:pt x="42" y="481758"/>
                  </a:lnTo>
                  <a:lnTo>
                    <a:pt x="43" y="476464"/>
                  </a:lnTo>
                  <a:lnTo>
                    <a:pt x="43" y="471170"/>
                  </a:lnTo>
                  <a:lnTo>
                    <a:pt x="43" y="465876"/>
                  </a:lnTo>
                  <a:lnTo>
                    <a:pt x="44" y="460582"/>
                  </a:lnTo>
                  <a:lnTo>
                    <a:pt x="44" y="455288"/>
                  </a:lnTo>
                  <a:lnTo>
                    <a:pt x="44" y="449994"/>
                  </a:lnTo>
                  <a:lnTo>
                    <a:pt x="44" y="444700"/>
                  </a:lnTo>
                  <a:lnTo>
                    <a:pt x="45" y="439406"/>
                  </a:lnTo>
                  <a:lnTo>
                    <a:pt x="45" y="434112"/>
                  </a:lnTo>
                  <a:lnTo>
                    <a:pt x="45" y="428817"/>
                  </a:lnTo>
                  <a:lnTo>
                    <a:pt x="46" y="423523"/>
                  </a:lnTo>
                  <a:lnTo>
                    <a:pt x="46" y="418229"/>
                  </a:lnTo>
                  <a:lnTo>
                    <a:pt x="46" y="412935"/>
                  </a:lnTo>
                  <a:lnTo>
                    <a:pt x="46" y="407641"/>
                  </a:lnTo>
                  <a:lnTo>
                    <a:pt x="47" y="402347"/>
                  </a:lnTo>
                  <a:lnTo>
                    <a:pt x="47" y="397053"/>
                  </a:lnTo>
                  <a:lnTo>
                    <a:pt x="47" y="391759"/>
                  </a:lnTo>
                  <a:lnTo>
                    <a:pt x="47" y="386465"/>
                  </a:lnTo>
                  <a:lnTo>
                    <a:pt x="48" y="381171"/>
                  </a:lnTo>
                  <a:lnTo>
                    <a:pt x="48" y="375877"/>
                  </a:lnTo>
                  <a:lnTo>
                    <a:pt x="48" y="370583"/>
                  </a:lnTo>
                  <a:lnTo>
                    <a:pt x="48" y="365289"/>
                  </a:lnTo>
                  <a:lnTo>
                    <a:pt x="48" y="359995"/>
                  </a:lnTo>
                  <a:lnTo>
                    <a:pt x="49" y="354701"/>
                  </a:lnTo>
                  <a:lnTo>
                    <a:pt x="49" y="349407"/>
                  </a:lnTo>
                  <a:lnTo>
                    <a:pt x="49" y="344113"/>
                  </a:lnTo>
                  <a:lnTo>
                    <a:pt x="49" y="338819"/>
                  </a:lnTo>
                  <a:lnTo>
                    <a:pt x="49" y="333525"/>
                  </a:lnTo>
                  <a:lnTo>
                    <a:pt x="49" y="328231"/>
                  </a:lnTo>
                  <a:lnTo>
                    <a:pt x="50" y="322936"/>
                  </a:lnTo>
                  <a:lnTo>
                    <a:pt x="50" y="317642"/>
                  </a:lnTo>
                  <a:lnTo>
                    <a:pt x="50" y="312348"/>
                  </a:lnTo>
                  <a:lnTo>
                    <a:pt x="50" y="307054"/>
                  </a:lnTo>
                  <a:lnTo>
                    <a:pt x="50" y="301760"/>
                  </a:lnTo>
                  <a:lnTo>
                    <a:pt x="50" y="296466"/>
                  </a:lnTo>
                  <a:lnTo>
                    <a:pt x="50" y="291172"/>
                  </a:lnTo>
                  <a:lnTo>
                    <a:pt x="51" y="285878"/>
                  </a:lnTo>
                  <a:lnTo>
                    <a:pt x="51" y="280584"/>
                  </a:lnTo>
                  <a:lnTo>
                    <a:pt x="51" y="275290"/>
                  </a:lnTo>
                  <a:lnTo>
                    <a:pt x="51" y="269996"/>
                  </a:lnTo>
                  <a:lnTo>
                    <a:pt x="51" y="264702"/>
                  </a:lnTo>
                  <a:lnTo>
                    <a:pt x="51" y="259408"/>
                  </a:lnTo>
                  <a:lnTo>
                    <a:pt x="51" y="254114"/>
                  </a:lnTo>
                  <a:lnTo>
                    <a:pt x="51" y="248820"/>
                  </a:lnTo>
                  <a:lnTo>
                    <a:pt x="51" y="243526"/>
                  </a:lnTo>
                  <a:lnTo>
                    <a:pt x="52" y="238232"/>
                  </a:lnTo>
                  <a:lnTo>
                    <a:pt x="52" y="232938"/>
                  </a:lnTo>
                  <a:lnTo>
                    <a:pt x="52" y="227644"/>
                  </a:lnTo>
                  <a:lnTo>
                    <a:pt x="52" y="222350"/>
                  </a:lnTo>
                  <a:lnTo>
                    <a:pt x="52" y="217056"/>
                  </a:lnTo>
                  <a:lnTo>
                    <a:pt x="52" y="211761"/>
                  </a:lnTo>
                  <a:lnTo>
                    <a:pt x="52" y="206467"/>
                  </a:lnTo>
                  <a:lnTo>
                    <a:pt x="52" y="201173"/>
                  </a:lnTo>
                  <a:lnTo>
                    <a:pt x="52" y="195879"/>
                  </a:lnTo>
                  <a:lnTo>
                    <a:pt x="52" y="190585"/>
                  </a:lnTo>
                  <a:lnTo>
                    <a:pt x="52" y="185291"/>
                  </a:lnTo>
                  <a:lnTo>
                    <a:pt x="52" y="179997"/>
                  </a:lnTo>
                  <a:lnTo>
                    <a:pt x="53" y="174703"/>
                  </a:lnTo>
                  <a:lnTo>
                    <a:pt x="53" y="169409"/>
                  </a:lnTo>
                  <a:lnTo>
                    <a:pt x="53" y="164115"/>
                  </a:lnTo>
                  <a:lnTo>
                    <a:pt x="53" y="158821"/>
                  </a:lnTo>
                  <a:lnTo>
                    <a:pt x="53" y="153527"/>
                  </a:lnTo>
                  <a:lnTo>
                    <a:pt x="53" y="148233"/>
                  </a:lnTo>
                  <a:lnTo>
                    <a:pt x="53" y="142939"/>
                  </a:lnTo>
                  <a:lnTo>
                    <a:pt x="53" y="137645"/>
                  </a:lnTo>
                  <a:lnTo>
                    <a:pt x="53" y="132351"/>
                  </a:lnTo>
                  <a:lnTo>
                    <a:pt x="53" y="127057"/>
                  </a:lnTo>
                  <a:lnTo>
                    <a:pt x="53" y="121763"/>
                  </a:lnTo>
                  <a:lnTo>
                    <a:pt x="53" y="116469"/>
                  </a:lnTo>
                  <a:lnTo>
                    <a:pt x="53" y="111175"/>
                  </a:lnTo>
                  <a:lnTo>
                    <a:pt x="53" y="105880"/>
                  </a:lnTo>
                  <a:lnTo>
                    <a:pt x="53" y="100586"/>
                  </a:lnTo>
                  <a:lnTo>
                    <a:pt x="53" y="95292"/>
                  </a:lnTo>
                  <a:lnTo>
                    <a:pt x="53" y="89998"/>
                  </a:lnTo>
                  <a:lnTo>
                    <a:pt x="53" y="84704"/>
                  </a:lnTo>
                  <a:lnTo>
                    <a:pt x="53" y="79410"/>
                  </a:lnTo>
                  <a:lnTo>
                    <a:pt x="53" y="74116"/>
                  </a:lnTo>
                  <a:lnTo>
                    <a:pt x="53" y="68822"/>
                  </a:lnTo>
                  <a:lnTo>
                    <a:pt x="53" y="63528"/>
                  </a:lnTo>
                  <a:lnTo>
                    <a:pt x="53" y="58234"/>
                  </a:lnTo>
                  <a:lnTo>
                    <a:pt x="53" y="52940"/>
                  </a:lnTo>
                  <a:lnTo>
                    <a:pt x="53" y="47646"/>
                  </a:lnTo>
                  <a:lnTo>
                    <a:pt x="53" y="42352"/>
                  </a:lnTo>
                  <a:lnTo>
                    <a:pt x="53" y="37058"/>
                  </a:lnTo>
                  <a:lnTo>
                    <a:pt x="53" y="31764"/>
                  </a:lnTo>
                  <a:lnTo>
                    <a:pt x="54" y="26470"/>
                  </a:lnTo>
                  <a:lnTo>
                    <a:pt x="54" y="21176"/>
                  </a:lnTo>
                  <a:lnTo>
                    <a:pt x="54" y="15882"/>
                  </a:lnTo>
                  <a:lnTo>
                    <a:pt x="54" y="10588"/>
                  </a:lnTo>
                  <a:lnTo>
                    <a:pt x="54" y="5294"/>
                  </a:lnTo>
                  <a:lnTo>
                    <a:pt x="54" y="0"/>
                  </a:lnTo>
                  <a:lnTo>
                    <a:pt x="54" y="0"/>
                  </a:lnTo>
                  <a:lnTo>
                    <a:pt x="54" y="2705258"/>
                  </a:lnTo>
                  <a:lnTo>
                    <a:pt x="54" y="2705258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55" name="pl37"/>
            <p:cNvSpPr/>
            <p:nvPr/>
          </p:nvSpPr>
          <p:spPr>
            <a:xfrm>
              <a:off x="4983554" y="2975496"/>
              <a:ext cx="129" cy="1135114"/>
            </a:xfrm>
            <a:custGeom>
              <a:avLst/>
              <a:gdLst/>
              <a:ahLst/>
              <a:cxnLst/>
              <a:rect l="0" t="0" r="0" b="0"/>
              <a:pathLst>
                <a:path w="129" h="1135114">
                  <a:moveTo>
                    <a:pt x="0" y="0"/>
                  </a:moveTo>
                  <a:lnTo>
                    <a:pt x="0" y="0"/>
                  </a:lnTo>
                  <a:lnTo>
                    <a:pt x="0" y="2221"/>
                  </a:lnTo>
                  <a:lnTo>
                    <a:pt x="0" y="4442"/>
                  </a:lnTo>
                  <a:lnTo>
                    <a:pt x="0" y="6664"/>
                  </a:lnTo>
                  <a:lnTo>
                    <a:pt x="0" y="8885"/>
                  </a:lnTo>
                  <a:lnTo>
                    <a:pt x="0" y="11106"/>
                  </a:lnTo>
                  <a:lnTo>
                    <a:pt x="0" y="13328"/>
                  </a:lnTo>
                  <a:lnTo>
                    <a:pt x="0" y="15549"/>
                  </a:lnTo>
                  <a:lnTo>
                    <a:pt x="1" y="17770"/>
                  </a:lnTo>
                  <a:lnTo>
                    <a:pt x="1" y="19992"/>
                  </a:lnTo>
                  <a:lnTo>
                    <a:pt x="1" y="22213"/>
                  </a:lnTo>
                  <a:lnTo>
                    <a:pt x="1" y="24434"/>
                  </a:lnTo>
                  <a:lnTo>
                    <a:pt x="1" y="26656"/>
                  </a:lnTo>
                  <a:lnTo>
                    <a:pt x="1" y="28877"/>
                  </a:lnTo>
                  <a:lnTo>
                    <a:pt x="1" y="31099"/>
                  </a:lnTo>
                  <a:lnTo>
                    <a:pt x="1" y="33320"/>
                  </a:lnTo>
                  <a:lnTo>
                    <a:pt x="1" y="35541"/>
                  </a:lnTo>
                  <a:lnTo>
                    <a:pt x="1" y="37763"/>
                  </a:lnTo>
                  <a:lnTo>
                    <a:pt x="1" y="39984"/>
                  </a:lnTo>
                  <a:lnTo>
                    <a:pt x="1" y="42205"/>
                  </a:lnTo>
                  <a:lnTo>
                    <a:pt x="2" y="44427"/>
                  </a:lnTo>
                  <a:lnTo>
                    <a:pt x="2" y="46648"/>
                  </a:lnTo>
                  <a:lnTo>
                    <a:pt x="2" y="48869"/>
                  </a:lnTo>
                  <a:lnTo>
                    <a:pt x="2" y="51091"/>
                  </a:lnTo>
                  <a:lnTo>
                    <a:pt x="2" y="53312"/>
                  </a:lnTo>
                  <a:lnTo>
                    <a:pt x="2" y="55533"/>
                  </a:lnTo>
                  <a:lnTo>
                    <a:pt x="2" y="57755"/>
                  </a:lnTo>
                  <a:lnTo>
                    <a:pt x="2" y="59976"/>
                  </a:lnTo>
                  <a:lnTo>
                    <a:pt x="3" y="62198"/>
                  </a:lnTo>
                  <a:lnTo>
                    <a:pt x="3" y="64419"/>
                  </a:lnTo>
                  <a:lnTo>
                    <a:pt x="3" y="66640"/>
                  </a:lnTo>
                  <a:lnTo>
                    <a:pt x="3" y="68862"/>
                  </a:lnTo>
                  <a:lnTo>
                    <a:pt x="3" y="71083"/>
                  </a:lnTo>
                  <a:lnTo>
                    <a:pt x="3" y="73304"/>
                  </a:lnTo>
                  <a:lnTo>
                    <a:pt x="4" y="75526"/>
                  </a:lnTo>
                  <a:lnTo>
                    <a:pt x="4" y="77747"/>
                  </a:lnTo>
                  <a:lnTo>
                    <a:pt x="4" y="79968"/>
                  </a:lnTo>
                  <a:lnTo>
                    <a:pt x="4" y="82190"/>
                  </a:lnTo>
                  <a:lnTo>
                    <a:pt x="5" y="84411"/>
                  </a:lnTo>
                  <a:lnTo>
                    <a:pt x="5" y="86632"/>
                  </a:lnTo>
                  <a:lnTo>
                    <a:pt x="5" y="88854"/>
                  </a:lnTo>
                  <a:lnTo>
                    <a:pt x="5" y="91075"/>
                  </a:lnTo>
                  <a:lnTo>
                    <a:pt x="6" y="93297"/>
                  </a:lnTo>
                  <a:lnTo>
                    <a:pt x="6" y="95518"/>
                  </a:lnTo>
                  <a:lnTo>
                    <a:pt x="6" y="97739"/>
                  </a:lnTo>
                  <a:lnTo>
                    <a:pt x="6" y="99961"/>
                  </a:lnTo>
                  <a:lnTo>
                    <a:pt x="7" y="102182"/>
                  </a:lnTo>
                  <a:lnTo>
                    <a:pt x="7" y="104403"/>
                  </a:lnTo>
                  <a:lnTo>
                    <a:pt x="7" y="106625"/>
                  </a:lnTo>
                  <a:lnTo>
                    <a:pt x="8" y="108846"/>
                  </a:lnTo>
                  <a:lnTo>
                    <a:pt x="8" y="111067"/>
                  </a:lnTo>
                  <a:lnTo>
                    <a:pt x="8" y="113289"/>
                  </a:lnTo>
                  <a:lnTo>
                    <a:pt x="9" y="115510"/>
                  </a:lnTo>
                  <a:lnTo>
                    <a:pt x="9" y="117731"/>
                  </a:lnTo>
                  <a:lnTo>
                    <a:pt x="9" y="119953"/>
                  </a:lnTo>
                  <a:lnTo>
                    <a:pt x="10" y="122174"/>
                  </a:lnTo>
                  <a:lnTo>
                    <a:pt x="10" y="124396"/>
                  </a:lnTo>
                  <a:lnTo>
                    <a:pt x="11" y="126617"/>
                  </a:lnTo>
                  <a:lnTo>
                    <a:pt x="11" y="128838"/>
                  </a:lnTo>
                  <a:lnTo>
                    <a:pt x="12" y="131060"/>
                  </a:lnTo>
                  <a:lnTo>
                    <a:pt x="12" y="133281"/>
                  </a:lnTo>
                  <a:lnTo>
                    <a:pt x="12" y="135502"/>
                  </a:lnTo>
                  <a:lnTo>
                    <a:pt x="13" y="137724"/>
                  </a:lnTo>
                  <a:lnTo>
                    <a:pt x="13" y="139945"/>
                  </a:lnTo>
                  <a:lnTo>
                    <a:pt x="14" y="142166"/>
                  </a:lnTo>
                  <a:lnTo>
                    <a:pt x="14" y="144388"/>
                  </a:lnTo>
                  <a:lnTo>
                    <a:pt x="15" y="146609"/>
                  </a:lnTo>
                  <a:lnTo>
                    <a:pt x="15" y="148830"/>
                  </a:lnTo>
                  <a:lnTo>
                    <a:pt x="16" y="151052"/>
                  </a:lnTo>
                  <a:lnTo>
                    <a:pt x="17" y="153273"/>
                  </a:lnTo>
                  <a:lnTo>
                    <a:pt x="17" y="155495"/>
                  </a:lnTo>
                  <a:lnTo>
                    <a:pt x="18" y="157716"/>
                  </a:lnTo>
                  <a:lnTo>
                    <a:pt x="18" y="159937"/>
                  </a:lnTo>
                  <a:lnTo>
                    <a:pt x="19" y="162159"/>
                  </a:lnTo>
                  <a:lnTo>
                    <a:pt x="19" y="164380"/>
                  </a:lnTo>
                  <a:lnTo>
                    <a:pt x="20" y="166601"/>
                  </a:lnTo>
                  <a:lnTo>
                    <a:pt x="21" y="168823"/>
                  </a:lnTo>
                  <a:lnTo>
                    <a:pt x="21" y="171044"/>
                  </a:lnTo>
                  <a:lnTo>
                    <a:pt x="22" y="173265"/>
                  </a:lnTo>
                  <a:lnTo>
                    <a:pt x="23" y="175487"/>
                  </a:lnTo>
                  <a:lnTo>
                    <a:pt x="23" y="177708"/>
                  </a:lnTo>
                  <a:lnTo>
                    <a:pt x="24" y="179930"/>
                  </a:lnTo>
                  <a:lnTo>
                    <a:pt x="25" y="182151"/>
                  </a:lnTo>
                  <a:lnTo>
                    <a:pt x="25" y="184372"/>
                  </a:lnTo>
                  <a:lnTo>
                    <a:pt x="26" y="186594"/>
                  </a:lnTo>
                  <a:lnTo>
                    <a:pt x="27" y="188815"/>
                  </a:lnTo>
                  <a:lnTo>
                    <a:pt x="27" y="191036"/>
                  </a:lnTo>
                  <a:lnTo>
                    <a:pt x="28" y="193258"/>
                  </a:lnTo>
                  <a:lnTo>
                    <a:pt x="29" y="195479"/>
                  </a:lnTo>
                  <a:lnTo>
                    <a:pt x="29" y="197700"/>
                  </a:lnTo>
                  <a:lnTo>
                    <a:pt x="30" y="199922"/>
                  </a:lnTo>
                  <a:lnTo>
                    <a:pt x="31" y="202143"/>
                  </a:lnTo>
                  <a:lnTo>
                    <a:pt x="32" y="204364"/>
                  </a:lnTo>
                  <a:lnTo>
                    <a:pt x="32" y="206586"/>
                  </a:lnTo>
                  <a:lnTo>
                    <a:pt x="33" y="208807"/>
                  </a:lnTo>
                  <a:lnTo>
                    <a:pt x="34" y="211029"/>
                  </a:lnTo>
                  <a:lnTo>
                    <a:pt x="34" y="213250"/>
                  </a:lnTo>
                  <a:lnTo>
                    <a:pt x="35" y="215471"/>
                  </a:lnTo>
                  <a:lnTo>
                    <a:pt x="36" y="217693"/>
                  </a:lnTo>
                  <a:lnTo>
                    <a:pt x="36" y="219914"/>
                  </a:lnTo>
                  <a:lnTo>
                    <a:pt x="37" y="222135"/>
                  </a:lnTo>
                  <a:lnTo>
                    <a:pt x="38" y="224357"/>
                  </a:lnTo>
                  <a:lnTo>
                    <a:pt x="39" y="226578"/>
                  </a:lnTo>
                  <a:lnTo>
                    <a:pt x="39" y="228799"/>
                  </a:lnTo>
                  <a:lnTo>
                    <a:pt x="40" y="231021"/>
                  </a:lnTo>
                  <a:lnTo>
                    <a:pt x="41" y="233242"/>
                  </a:lnTo>
                  <a:lnTo>
                    <a:pt x="41" y="235463"/>
                  </a:lnTo>
                  <a:lnTo>
                    <a:pt x="42" y="237685"/>
                  </a:lnTo>
                  <a:lnTo>
                    <a:pt x="43" y="239906"/>
                  </a:lnTo>
                  <a:lnTo>
                    <a:pt x="43" y="242128"/>
                  </a:lnTo>
                  <a:lnTo>
                    <a:pt x="44" y="244349"/>
                  </a:lnTo>
                  <a:lnTo>
                    <a:pt x="45" y="246570"/>
                  </a:lnTo>
                  <a:lnTo>
                    <a:pt x="45" y="248792"/>
                  </a:lnTo>
                  <a:lnTo>
                    <a:pt x="46" y="251013"/>
                  </a:lnTo>
                  <a:lnTo>
                    <a:pt x="46" y="253234"/>
                  </a:lnTo>
                  <a:lnTo>
                    <a:pt x="47" y="255456"/>
                  </a:lnTo>
                  <a:lnTo>
                    <a:pt x="47" y="257677"/>
                  </a:lnTo>
                  <a:lnTo>
                    <a:pt x="48" y="259898"/>
                  </a:lnTo>
                  <a:lnTo>
                    <a:pt x="49" y="262120"/>
                  </a:lnTo>
                  <a:lnTo>
                    <a:pt x="49" y="264341"/>
                  </a:lnTo>
                  <a:lnTo>
                    <a:pt x="50" y="266562"/>
                  </a:lnTo>
                  <a:lnTo>
                    <a:pt x="50" y="268784"/>
                  </a:lnTo>
                  <a:lnTo>
                    <a:pt x="50" y="271005"/>
                  </a:lnTo>
                  <a:lnTo>
                    <a:pt x="51" y="273227"/>
                  </a:lnTo>
                  <a:lnTo>
                    <a:pt x="51" y="275448"/>
                  </a:lnTo>
                  <a:lnTo>
                    <a:pt x="52" y="277669"/>
                  </a:lnTo>
                  <a:lnTo>
                    <a:pt x="52" y="279891"/>
                  </a:lnTo>
                  <a:lnTo>
                    <a:pt x="53" y="282112"/>
                  </a:lnTo>
                  <a:lnTo>
                    <a:pt x="53" y="284333"/>
                  </a:lnTo>
                  <a:lnTo>
                    <a:pt x="53" y="286555"/>
                  </a:lnTo>
                  <a:lnTo>
                    <a:pt x="54" y="288776"/>
                  </a:lnTo>
                  <a:lnTo>
                    <a:pt x="54" y="290997"/>
                  </a:lnTo>
                  <a:lnTo>
                    <a:pt x="54" y="293219"/>
                  </a:lnTo>
                  <a:lnTo>
                    <a:pt x="54" y="295440"/>
                  </a:lnTo>
                  <a:lnTo>
                    <a:pt x="55" y="297661"/>
                  </a:lnTo>
                  <a:lnTo>
                    <a:pt x="55" y="299883"/>
                  </a:lnTo>
                  <a:lnTo>
                    <a:pt x="55" y="302104"/>
                  </a:lnTo>
                  <a:lnTo>
                    <a:pt x="55" y="304326"/>
                  </a:lnTo>
                  <a:lnTo>
                    <a:pt x="56" y="306547"/>
                  </a:lnTo>
                  <a:lnTo>
                    <a:pt x="56" y="308768"/>
                  </a:lnTo>
                  <a:lnTo>
                    <a:pt x="56" y="310990"/>
                  </a:lnTo>
                  <a:lnTo>
                    <a:pt x="56" y="313211"/>
                  </a:lnTo>
                  <a:lnTo>
                    <a:pt x="56" y="315432"/>
                  </a:lnTo>
                  <a:lnTo>
                    <a:pt x="56" y="317654"/>
                  </a:lnTo>
                  <a:lnTo>
                    <a:pt x="56" y="319875"/>
                  </a:lnTo>
                  <a:lnTo>
                    <a:pt x="56" y="322096"/>
                  </a:lnTo>
                  <a:lnTo>
                    <a:pt x="56" y="324318"/>
                  </a:lnTo>
                  <a:lnTo>
                    <a:pt x="56" y="326539"/>
                  </a:lnTo>
                  <a:lnTo>
                    <a:pt x="56" y="328761"/>
                  </a:lnTo>
                  <a:lnTo>
                    <a:pt x="56" y="330982"/>
                  </a:lnTo>
                  <a:lnTo>
                    <a:pt x="56" y="333203"/>
                  </a:lnTo>
                  <a:lnTo>
                    <a:pt x="56" y="335425"/>
                  </a:lnTo>
                  <a:lnTo>
                    <a:pt x="56" y="337646"/>
                  </a:lnTo>
                  <a:lnTo>
                    <a:pt x="56" y="339867"/>
                  </a:lnTo>
                  <a:lnTo>
                    <a:pt x="56" y="342089"/>
                  </a:lnTo>
                  <a:lnTo>
                    <a:pt x="56" y="344310"/>
                  </a:lnTo>
                  <a:lnTo>
                    <a:pt x="56" y="346531"/>
                  </a:lnTo>
                  <a:lnTo>
                    <a:pt x="56" y="348753"/>
                  </a:lnTo>
                  <a:lnTo>
                    <a:pt x="56" y="350974"/>
                  </a:lnTo>
                  <a:lnTo>
                    <a:pt x="56" y="353195"/>
                  </a:lnTo>
                  <a:lnTo>
                    <a:pt x="56" y="355417"/>
                  </a:lnTo>
                  <a:lnTo>
                    <a:pt x="55" y="357638"/>
                  </a:lnTo>
                  <a:lnTo>
                    <a:pt x="55" y="359860"/>
                  </a:lnTo>
                  <a:lnTo>
                    <a:pt x="55" y="362081"/>
                  </a:lnTo>
                  <a:lnTo>
                    <a:pt x="55" y="364302"/>
                  </a:lnTo>
                  <a:lnTo>
                    <a:pt x="55" y="366524"/>
                  </a:lnTo>
                  <a:lnTo>
                    <a:pt x="55" y="368745"/>
                  </a:lnTo>
                  <a:lnTo>
                    <a:pt x="55" y="370966"/>
                  </a:lnTo>
                  <a:lnTo>
                    <a:pt x="54" y="373188"/>
                  </a:lnTo>
                  <a:lnTo>
                    <a:pt x="54" y="375409"/>
                  </a:lnTo>
                  <a:lnTo>
                    <a:pt x="54" y="377630"/>
                  </a:lnTo>
                  <a:lnTo>
                    <a:pt x="54" y="379852"/>
                  </a:lnTo>
                  <a:lnTo>
                    <a:pt x="54" y="382073"/>
                  </a:lnTo>
                  <a:lnTo>
                    <a:pt x="54" y="384294"/>
                  </a:lnTo>
                  <a:lnTo>
                    <a:pt x="54" y="386516"/>
                  </a:lnTo>
                  <a:lnTo>
                    <a:pt x="54" y="388737"/>
                  </a:lnTo>
                  <a:lnTo>
                    <a:pt x="54" y="390959"/>
                  </a:lnTo>
                  <a:lnTo>
                    <a:pt x="54" y="393180"/>
                  </a:lnTo>
                  <a:lnTo>
                    <a:pt x="54" y="395401"/>
                  </a:lnTo>
                  <a:lnTo>
                    <a:pt x="54" y="397623"/>
                  </a:lnTo>
                  <a:lnTo>
                    <a:pt x="54" y="399844"/>
                  </a:lnTo>
                  <a:lnTo>
                    <a:pt x="54" y="402065"/>
                  </a:lnTo>
                  <a:lnTo>
                    <a:pt x="54" y="404287"/>
                  </a:lnTo>
                  <a:lnTo>
                    <a:pt x="54" y="406508"/>
                  </a:lnTo>
                  <a:lnTo>
                    <a:pt x="54" y="408729"/>
                  </a:lnTo>
                  <a:lnTo>
                    <a:pt x="54" y="410951"/>
                  </a:lnTo>
                  <a:lnTo>
                    <a:pt x="54" y="413172"/>
                  </a:lnTo>
                  <a:lnTo>
                    <a:pt x="54" y="415393"/>
                  </a:lnTo>
                  <a:lnTo>
                    <a:pt x="54" y="417615"/>
                  </a:lnTo>
                  <a:lnTo>
                    <a:pt x="54" y="419836"/>
                  </a:lnTo>
                  <a:lnTo>
                    <a:pt x="54" y="422058"/>
                  </a:lnTo>
                  <a:lnTo>
                    <a:pt x="55" y="424279"/>
                  </a:lnTo>
                  <a:lnTo>
                    <a:pt x="55" y="426500"/>
                  </a:lnTo>
                  <a:lnTo>
                    <a:pt x="55" y="428722"/>
                  </a:lnTo>
                  <a:lnTo>
                    <a:pt x="55" y="430943"/>
                  </a:lnTo>
                  <a:lnTo>
                    <a:pt x="56" y="433164"/>
                  </a:lnTo>
                  <a:lnTo>
                    <a:pt x="56" y="435386"/>
                  </a:lnTo>
                  <a:lnTo>
                    <a:pt x="57" y="437607"/>
                  </a:lnTo>
                  <a:lnTo>
                    <a:pt x="57" y="439828"/>
                  </a:lnTo>
                  <a:lnTo>
                    <a:pt x="57" y="442050"/>
                  </a:lnTo>
                  <a:lnTo>
                    <a:pt x="58" y="444271"/>
                  </a:lnTo>
                  <a:lnTo>
                    <a:pt x="58" y="446492"/>
                  </a:lnTo>
                  <a:lnTo>
                    <a:pt x="59" y="448714"/>
                  </a:lnTo>
                  <a:lnTo>
                    <a:pt x="59" y="450935"/>
                  </a:lnTo>
                  <a:lnTo>
                    <a:pt x="60" y="453157"/>
                  </a:lnTo>
                  <a:lnTo>
                    <a:pt x="60" y="455378"/>
                  </a:lnTo>
                  <a:lnTo>
                    <a:pt x="61" y="457599"/>
                  </a:lnTo>
                  <a:lnTo>
                    <a:pt x="62" y="459821"/>
                  </a:lnTo>
                  <a:lnTo>
                    <a:pt x="62" y="462042"/>
                  </a:lnTo>
                  <a:lnTo>
                    <a:pt x="63" y="464263"/>
                  </a:lnTo>
                  <a:lnTo>
                    <a:pt x="64" y="466485"/>
                  </a:lnTo>
                  <a:lnTo>
                    <a:pt x="65" y="468706"/>
                  </a:lnTo>
                  <a:lnTo>
                    <a:pt x="65" y="470927"/>
                  </a:lnTo>
                  <a:lnTo>
                    <a:pt x="66" y="473149"/>
                  </a:lnTo>
                  <a:lnTo>
                    <a:pt x="67" y="475370"/>
                  </a:lnTo>
                  <a:lnTo>
                    <a:pt x="68" y="477592"/>
                  </a:lnTo>
                  <a:lnTo>
                    <a:pt x="69" y="479813"/>
                  </a:lnTo>
                  <a:lnTo>
                    <a:pt x="70" y="482034"/>
                  </a:lnTo>
                  <a:lnTo>
                    <a:pt x="71" y="484256"/>
                  </a:lnTo>
                  <a:lnTo>
                    <a:pt x="72" y="486477"/>
                  </a:lnTo>
                  <a:lnTo>
                    <a:pt x="72" y="488698"/>
                  </a:lnTo>
                  <a:lnTo>
                    <a:pt x="73" y="490920"/>
                  </a:lnTo>
                  <a:lnTo>
                    <a:pt x="74" y="493141"/>
                  </a:lnTo>
                  <a:lnTo>
                    <a:pt x="75" y="495362"/>
                  </a:lnTo>
                  <a:lnTo>
                    <a:pt x="77" y="497584"/>
                  </a:lnTo>
                  <a:lnTo>
                    <a:pt x="78" y="499805"/>
                  </a:lnTo>
                  <a:lnTo>
                    <a:pt x="79" y="502026"/>
                  </a:lnTo>
                  <a:lnTo>
                    <a:pt x="80" y="504248"/>
                  </a:lnTo>
                  <a:lnTo>
                    <a:pt x="81" y="506469"/>
                  </a:lnTo>
                  <a:lnTo>
                    <a:pt x="82" y="508691"/>
                  </a:lnTo>
                  <a:lnTo>
                    <a:pt x="83" y="510912"/>
                  </a:lnTo>
                  <a:lnTo>
                    <a:pt x="84" y="513133"/>
                  </a:lnTo>
                  <a:lnTo>
                    <a:pt x="85" y="515355"/>
                  </a:lnTo>
                  <a:lnTo>
                    <a:pt x="86" y="517576"/>
                  </a:lnTo>
                  <a:lnTo>
                    <a:pt x="87" y="519797"/>
                  </a:lnTo>
                  <a:lnTo>
                    <a:pt x="89" y="522019"/>
                  </a:lnTo>
                  <a:lnTo>
                    <a:pt x="90" y="524240"/>
                  </a:lnTo>
                  <a:lnTo>
                    <a:pt x="91" y="526461"/>
                  </a:lnTo>
                  <a:lnTo>
                    <a:pt x="92" y="528683"/>
                  </a:lnTo>
                  <a:lnTo>
                    <a:pt x="93" y="530904"/>
                  </a:lnTo>
                  <a:lnTo>
                    <a:pt x="94" y="533125"/>
                  </a:lnTo>
                  <a:lnTo>
                    <a:pt x="95" y="535347"/>
                  </a:lnTo>
                  <a:lnTo>
                    <a:pt x="97" y="537568"/>
                  </a:lnTo>
                  <a:lnTo>
                    <a:pt x="98" y="539790"/>
                  </a:lnTo>
                  <a:lnTo>
                    <a:pt x="99" y="542011"/>
                  </a:lnTo>
                  <a:lnTo>
                    <a:pt x="100" y="544232"/>
                  </a:lnTo>
                  <a:lnTo>
                    <a:pt x="101" y="546454"/>
                  </a:lnTo>
                  <a:lnTo>
                    <a:pt x="102" y="548675"/>
                  </a:lnTo>
                  <a:lnTo>
                    <a:pt x="103" y="550896"/>
                  </a:lnTo>
                  <a:lnTo>
                    <a:pt x="104" y="553118"/>
                  </a:lnTo>
                  <a:lnTo>
                    <a:pt x="105" y="555339"/>
                  </a:lnTo>
                  <a:lnTo>
                    <a:pt x="106" y="557560"/>
                  </a:lnTo>
                  <a:lnTo>
                    <a:pt x="107" y="559782"/>
                  </a:lnTo>
                  <a:lnTo>
                    <a:pt x="108" y="562003"/>
                  </a:lnTo>
                  <a:lnTo>
                    <a:pt x="109" y="564224"/>
                  </a:lnTo>
                  <a:lnTo>
                    <a:pt x="110" y="566446"/>
                  </a:lnTo>
                  <a:lnTo>
                    <a:pt x="111" y="568667"/>
                  </a:lnTo>
                  <a:lnTo>
                    <a:pt x="112" y="570889"/>
                  </a:lnTo>
                  <a:lnTo>
                    <a:pt x="113" y="573110"/>
                  </a:lnTo>
                  <a:lnTo>
                    <a:pt x="114" y="575331"/>
                  </a:lnTo>
                  <a:lnTo>
                    <a:pt x="114" y="577553"/>
                  </a:lnTo>
                  <a:lnTo>
                    <a:pt x="115" y="579774"/>
                  </a:lnTo>
                  <a:lnTo>
                    <a:pt x="116" y="581995"/>
                  </a:lnTo>
                  <a:lnTo>
                    <a:pt x="117" y="584217"/>
                  </a:lnTo>
                  <a:lnTo>
                    <a:pt x="117" y="586438"/>
                  </a:lnTo>
                  <a:lnTo>
                    <a:pt x="118" y="588659"/>
                  </a:lnTo>
                  <a:lnTo>
                    <a:pt x="119" y="590881"/>
                  </a:lnTo>
                  <a:lnTo>
                    <a:pt x="120" y="593102"/>
                  </a:lnTo>
                  <a:lnTo>
                    <a:pt x="120" y="595323"/>
                  </a:lnTo>
                  <a:lnTo>
                    <a:pt x="121" y="597545"/>
                  </a:lnTo>
                  <a:lnTo>
                    <a:pt x="121" y="599766"/>
                  </a:lnTo>
                  <a:lnTo>
                    <a:pt x="122" y="601988"/>
                  </a:lnTo>
                  <a:lnTo>
                    <a:pt x="122" y="604209"/>
                  </a:lnTo>
                  <a:lnTo>
                    <a:pt x="123" y="606430"/>
                  </a:lnTo>
                  <a:lnTo>
                    <a:pt x="123" y="608652"/>
                  </a:lnTo>
                  <a:lnTo>
                    <a:pt x="124" y="610873"/>
                  </a:lnTo>
                  <a:lnTo>
                    <a:pt x="124" y="613094"/>
                  </a:lnTo>
                  <a:lnTo>
                    <a:pt x="125" y="615316"/>
                  </a:lnTo>
                  <a:lnTo>
                    <a:pt x="125" y="617537"/>
                  </a:lnTo>
                  <a:lnTo>
                    <a:pt x="125" y="619758"/>
                  </a:lnTo>
                  <a:lnTo>
                    <a:pt x="126" y="621980"/>
                  </a:lnTo>
                  <a:lnTo>
                    <a:pt x="126" y="624201"/>
                  </a:lnTo>
                  <a:lnTo>
                    <a:pt x="126" y="626422"/>
                  </a:lnTo>
                  <a:lnTo>
                    <a:pt x="127" y="628644"/>
                  </a:lnTo>
                  <a:lnTo>
                    <a:pt x="127" y="630865"/>
                  </a:lnTo>
                  <a:lnTo>
                    <a:pt x="127" y="633087"/>
                  </a:lnTo>
                  <a:lnTo>
                    <a:pt x="127" y="635308"/>
                  </a:lnTo>
                  <a:lnTo>
                    <a:pt x="127" y="637529"/>
                  </a:lnTo>
                  <a:lnTo>
                    <a:pt x="128" y="639751"/>
                  </a:lnTo>
                  <a:lnTo>
                    <a:pt x="128" y="641972"/>
                  </a:lnTo>
                  <a:lnTo>
                    <a:pt x="128" y="644193"/>
                  </a:lnTo>
                  <a:lnTo>
                    <a:pt x="128" y="646415"/>
                  </a:lnTo>
                  <a:lnTo>
                    <a:pt x="128" y="648636"/>
                  </a:lnTo>
                  <a:lnTo>
                    <a:pt x="128" y="650857"/>
                  </a:lnTo>
                  <a:lnTo>
                    <a:pt x="128" y="653079"/>
                  </a:lnTo>
                  <a:lnTo>
                    <a:pt x="128" y="655300"/>
                  </a:lnTo>
                  <a:lnTo>
                    <a:pt x="129" y="657522"/>
                  </a:lnTo>
                  <a:lnTo>
                    <a:pt x="129" y="659743"/>
                  </a:lnTo>
                  <a:lnTo>
                    <a:pt x="129" y="661964"/>
                  </a:lnTo>
                  <a:lnTo>
                    <a:pt x="129" y="664186"/>
                  </a:lnTo>
                  <a:lnTo>
                    <a:pt x="129" y="666407"/>
                  </a:lnTo>
                  <a:lnTo>
                    <a:pt x="129" y="668628"/>
                  </a:lnTo>
                  <a:lnTo>
                    <a:pt x="129" y="670850"/>
                  </a:lnTo>
                  <a:lnTo>
                    <a:pt x="129" y="673071"/>
                  </a:lnTo>
                  <a:lnTo>
                    <a:pt x="129" y="675292"/>
                  </a:lnTo>
                  <a:lnTo>
                    <a:pt x="129" y="677514"/>
                  </a:lnTo>
                  <a:lnTo>
                    <a:pt x="129" y="679735"/>
                  </a:lnTo>
                  <a:lnTo>
                    <a:pt x="129" y="681956"/>
                  </a:lnTo>
                  <a:lnTo>
                    <a:pt x="129" y="684178"/>
                  </a:lnTo>
                  <a:lnTo>
                    <a:pt x="129" y="686399"/>
                  </a:lnTo>
                  <a:lnTo>
                    <a:pt x="129" y="688621"/>
                  </a:lnTo>
                  <a:lnTo>
                    <a:pt x="129" y="690842"/>
                  </a:lnTo>
                  <a:lnTo>
                    <a:pt x="129" y="693063"/>
                  </a:lnTo>
                  <a:lnTo>
                    <a:pt x="129" y="695285"/>
                  </a:lnTo>
                  <a:lnTo>
                    <a:pt x="129" y="697506"/>
                  </a:lnTo>
                  <a:lnTo>
                    <a:pt x="129" y="699727"/>
                  </a:lnTo>
                  <a:lnTo>
                    <a:pt x="129" y="701949"/>
                  </a:lnTo>
                  <a:lnTo>
                    <a:pt x="129" y="704170"/>
                  </a:lnTo>
                  <a:lnTo>
                    <a:pt x="129" y="706391"/>
                  </a:lnTo>
                  <a:lnTo>
                    <a:pt x="129" y="708613"/>
                  </a:lnTo>
                  <a:lnTo>
                    <a:pt x="129" y="710834"/>
                  </a:lnTo>
                  <a:lnTo>
                    <a:pt x="129" y="713055"/>
                  </a:lnTo>
                  <a:lnTo>
                    <a:pt x="129" y="715277"/>
                  </a:lnTo>
                  <a:lnTo>
                    <a:pt x="129" y="717498"/>
                  </a:lnTo>
                  <a:lnTo>
                    <a:pt x="129" y="719720"/>
                  </a:lnTo>
                  <a:lnTo>
                    <a:pt x="129" y="721941"/>
                  </a:lnTo>
                  <a:lnTo>
                    <a:pt x="129" y="724162"/>
                  </a:lnTo>
                  <a:lnTo>
                    <a:pt x="129" y="726384"/>
                  </a:lnTo>
                  <a:lnTo>
                    <a:pt x="129" y="728605"/>
                  </a:lnTo>
                  <a:lnTo>
                    <a:pt x="129" y="730826"/>
                  </a:lnTo>
                  <a:lnTo>
                    <a:pt x="129" y="733048"/>
                  </a:lnTo>
                  <a:lnTo>
                    <a:pt x="129" y="735269"/>
                  </a:lnTo>
                  <a:lnTo>
                    <a:pt x="129" y="737490"/>
                  </a:lnTo>
                  <a:lnTo>
                    <a:pt x="129" y="739712"/>
                  </a:lnTo>
                  <a:lnTo>
                    <a:pt x="129" y="741933"/>
                  </a:lnTo>
                  <a:lnTo>
                    <a:pt x="129" y="744154"/>
                  </a:lnTo>
                  <a:lnTo>
                    <a:pt x="129" y="746376"/>
                  </a:lnTo>
                  <a:lnTo>
                    <a:pt x="129" y="748597"/>
                  </a:lnTo>
                  <a:lnTo>
                    <a:pt x="129" y="750819"/>
                  </a:lnTo>
                  <a:lnTo>
                    <a:pt x="129" y="753040"/>
                  </a:lnTo>
                  <a:lnTo>
                    <a:pt x="129" y="755261"/>
                  </a:lnTo>
                  <a:lnTo>
                    <a:pt x="129" y="757483"/>
                  </a:lnTo>
                  <a:lnTo>
                    <a:pt x="128" y="759704"/>
                  </a:lnTo>
                  <a:lnTo>
                    <a:pt x="128" y="761925"/>
                  </a:lnTo>
                  <a:lnTo>
                    <a:pt x="128" y="764147"/>
                  </a:lnTo>
                  <a:lnTo>
                    <a:pt x="128" y="766368"/>
                  </a:lnTo>
                  <a:lnTo>
                    <a:pt x="128" y="768589"/>
                  </a:lnTo>
                  <a:lnTo>
                    <a:pt x="128" y="770811"/>
                  </a:lnTo>
                  <a:lnTo>
                    <a:pt x="128" y="773032"/>
                  </a:lnTo>
                  <a:lnTo>
                    <a:pt x="128" y="775253"/>
                  </a:lnTo>
                  <a:lnTo>
                    <a:pt x="127" y="777475"/>
                  </a:lnTo>
                  <a:lnTo>
                    <a:pt x="127" y="779696"/>
                  </a:lnTo>
                  <a:lnTo>
                    <a:pt x="127" y="781918"/>
                  </a:lnTo>
                  <a:lnTo>
                    <a:pt x="127" y="784139"/>
                  </a:lnTo>
                  <a:lnTo>
                    <a:pt x="126" y="786360"/>
                  </a:lnTo>
                  <a:lnTo>
                    <a:pt x="126" y="788582"/>
                  </a:lnTo>
                  <a:lnTo>
                    <a:pt x="126" y="790803"/>
                  </a:lnTo>
                  <a:lnTo>
                    <a:pt x="125" y="793024"/>
                  </a:lnTo>
                  <a:lnTo>
                    <a:pt x="125" y="795246"/>
                  </a:lnTo>
                  <a:lnTo>
                    <a:pt x="125" y="797467"/>
                  </a:lnTo>
                  <a:lnTo>
                    <a:pt x="124" y="799688"/>
                  </a:lnTo>
                  <a:lnTo>
                    <a:pt x="124" y="801910"/>
                  </a:lnTo>
                  <a:lnTo>
                    <a:pt x="123" y="804131"/>
                  </a:lnTo>
                  <a:lnTo>
                    <a:pt x="123" y="806353"/>
                  </a:lnTo>
                  <a:lnTo>
                    <a:pt x="122" y="808574"/>
                  </a:lnTo>
                  <a:lnTo>
                    <a:pt x="122" y="810795"/>
                  </a:lnTo>
                  <a:lnTo>
                    <a:pt x="121" y="813017"/>
                  </a:lnTo>
                  <a:lnTo>
                    <a:pt x="121" y="815238"/>
                  </a:lnTo>
                  <a:lnTo>
                    <a:pt x="120" y="817459"/>
                  </a:lnTo>
                  <a:lnTo>
                    <a:pt x="119" y="819681"/>
                  </a:lnTo>
                  <a:lnTo>
                    <a:pt x="119" y="821902"/>
                  </a:lnTo>
                  <a:lnTo>
                    <a:pt x="118" y="824123"/>
                  </a:lnTo>
                  <a:lnTo>
                    <a:pt x="117" y="826345"/>
                  </a:lnTo>
                  <a:lnTo>
                    <a:pt x="116" y="828566"/>
                  </a:lnTo>
                  <a:lnTo>
                    <a:pt x="115" y="830787"/>
                  </a:lnTo>
                  <a:lnTo>
                    <a:pt x="115" y="833009"/>
                  </a:lnTo>
                  <a:lnTo>
                    <a:pt x="114" y="835230"/>
                  </a:lnTo>
                  <a:lnTo>
                    <a:pt x="113" y="837452"/>
                  </a:lnTo>
                  <a:lnTo>
                    <a:pt x="112" y="839673"/>
                  </a:lnTo>
                  <a:lnTo>
                    <a:pt x="111" y="841894"/>
                  </a:lnTo>
                  <a:lnTo>
                    <a:pt x="110" y="844116"/>
                  </a:lnTo>
                  <a:lnTo>
                    <a:pt x="109" y="846337"/>
                  </a:lnTo>
                  <a:lnTo>
                    <a:pt x="108" y="848558"/>
                  </a:lnTo>
                  <a:lnTo>
                    <a:pt x="107" y="850780"/>
                  </a:lnTo>
                  <a:lnTo>
                    <a:pt x="106" y="853001"/>
                  </a:lnTo>
                  <a:lnTo>
                    <a:pt x="104" y="855222"/>
                  </a:lnTo>
                  <a:lnTo>
                    <a:pt x="103" y="857444"/>
                  </a:lnTo>
                  <a:lnTo>
                    <a:pt x="102" y="859665"/>
                  </a:lnTo>
                  <a:lnTo>
                    <a:pt x="101" y="861886"/>
                  </a:lnTo>
                  <a:lnTo>
                    <a:pt x="100" y="864108"/>
                  </a:lnTo>
                  <a:lnTo>
                    <a:pt x="98" y="866329"/>
                  </a:lnTo>
                  <a:lnTo>
                    <a:pt x="97" y="868551"/>
                  </a:lnTo>
                  <a:lnTo>
                    <a:pt x="96" y="870772"/>
                  </a:lnTo>
                  <a:lnTo>
                    <a:pt x="94" y="872993"/>
                  </a:lnTo>
                  <a:lnTo>
                    <a:pt x="93" y="875215"/>
                  </a:lnTo>
                  <a:lnTo>
                    <a:pt x="92" y="877436"/>
                  </a:lnTo>
                  <a:lnTo>
                    <a:pt x="90" y="879657"/>
                  </a:lnTo>
                  <a:lnTo>
                    <a:pt x="89" y="881879"/>
                  </a:lnTo>
                  <a:lnTo>
                    <a:pt x="88" y="884100"/>
                  </a:lnTo>
                  <a:lnTo>
                    <a:pt x="86" y="886321"/>
                  </a:lnTo>
                  <a:lnTo>
                    <a:pt x="85" y="888543"/>
                  </a:lnTo>
                  <a:lnTo>
                    <a:pt x="83" y="890764"/>
                  </a:lnTo>
                  <a:lnTo>
                    <a:pt x="82" y="892985"/>
                  </a:lnTo>
                  <a:lnTo>
                    <a:pt x="81" y="895207"/>
                  </a:lnTo>
                  <a:lnTo>
                    <a:pt x="79" y="897428"/>
                  </a:lnTo>
                  <a:lnTo>
                    <a:pt x="78" y="899650"/>
                  </a:lnTo>
                  <a:lnTo>
                    <a:pt x="76" y="901871"/>
                  </a:lnTo>
                  <a:lnTo>
                    <a:pt x="75" y="904092"/>
                  </a:lnTo>
                  <a:lnTo>
                    <a:pt x="73" y="906314"/>
                  </a:lnTo>
                  <a:lnTo>
                    <a:pt x="72" y="908535"/>
                  </a:lnTo>
                  <a:lnTo>
                    <a:pt x="70" y="910756"/>
                  </a:lnTo>
                  <a:lnTo>
                    <a:pt x="69" y="912978"/>
                  </a:lnTo>
                  <a:lnTo>
                    <a:pt x="67" y="915199"/>
                  </a:lnTo>
                  <a:lnTo>
                    <a:pt x="66" y="917420"/>
                  </a:lnTo>
                  <a:lnTo>
                    <a:pt x="64" y="919642"/>
                  </a:lnTo>
                  <a:lnTo>
                    <a:pt x="63" y="921863"/>
                  </a:lnTo>
                  <a:lnTo>
                    <a:pt x="62" y="924084"/>
                  </a:lnTo>
                  <a:lnTo>
                    <a:pt x="60" y="926306"/>
                  </a:lnTo>
                  <a:lnTo>
                    <a:pt x="59" y="928527"/>
                  </a:lnTo>
                  <a:lnTo>
                    <a:pt x="57" y="930749"/>
                  </a:lnTo>
                  <a:lnTo>
                    <a:pt x="56" y="932970"/>
                  </a:lnTo>
                  <a:lnTo>
                    <a:pt x="54" y="935191"/>
                  </a:lnTo>
                  <a:lnTo>
                    <a:pt x="53" y="937413"/>
                  </a:lnTo>
                  <a:lnTo>
                    <a:pt x="52" y="939634"/>
                  </a:lnTo>
                  <a:lnTo>
                    <a:pt x="50" y="941855"/>
                  </a:lnTo>
                  <a:lnTo>
                    <a:pt x="49" y="944077"/>
                  </a:lnTo>
                  <a:lnTo>
                    <a:pt x="48" y="946298"/>
                  </a:lnTo>
                  <a:lnTo>
                    <a:pt x="46" y="948519"/>
                  </a:lnTo>
                  <a:lnTo>
                    <a:pt x="45" y="950741"/>
                  </a:lnTo>
                  <a:lnTo>
                    <a:pt x="44" y="952962"/>
                  </a:lnTo>
                  <a:lnTo>
                    <a:pt x="42" y="955184"/>
                  </a:lnTo>
                  <a:lnTo>
                    <a:pt x="41" y="957405"/>
                  </a:lnTo>
                  <a:lnTo>
                    <a:pt x="40" y="959626"/>
                  </a:lnTo>
                  <a:lnTo>
                    <a:pt x="39" y="961848"/>
                  </a:lnTo>
                  <a:lnTo>
                    <a:pt x="38" y="964069"/>
                  </a:lnTo>
                  <a:lnTo>
                    <a:pt x="36" y="966290"/>
                  </a:lnTo>
                  <a:lnTo>
                    <a:pt x="35" y="968512"/>
                  </a:lnTo>
                  <a:lnTo>
                    <a:pt x="34" y="970733"/>
                  </a:lnTo>
                  <a:lnTo>
                    <a:pt x="33" y="972954"/>
                  </a:lnTo>
                  <a:lnTo>
                    <a:pt x="32" y="975176"/>
                  </a:lnTo>
                  <a:lnTo>
                    <a:pt x="31" y="977397"/>
                  </a:lnTo>
                  <a:lnTo>
                    <a:pt x="30" y="979618"/>
                  </a:lnTo>
                  <a:lnTo>
                    <a:pt x="29" y="981840"/>
                  </a:lnTo>
                  <a:lnTo>
                    <a:pt x="28" y="984061"/>
                  </a:lnTo>
                  <a:lnTo>
                    <a:pt x="27" y="986283"/>
                  </a:lnTo>
                  <a:lnTo>
                    <a:pt x="26" y="988504"/>
                  </a:lnTo>
                  <a:lnTo>
                    <a:pt x="25" y="990725"/>
                  </a:lnTo>
                  <a:lnTo>
                    <a:pt x="24" y="992947"/>
                  </a:lnTo>
                  <a:lnTo>
                    <a:pt x="23" y="995168"/>
                  </a:lnTo>
                  <a:lnTo>
                    <a:pt x="22" y="997389"/>
                  </a:lnTo>
                  <a:lnTo>
                    <a:pt x="21" y="999611"/>
                  </a:lnTo>
                  <a:lnTo>
                    <a:pt x="21" y="1001832"/>
                  </a:lnTo>
                  <a:lnTo>
                    <a:pt x="20" y="1004053"/>
                  </a:lnTo>
                  <a:lnTo>
                    <a:pt x="19" y="1006275"/>
                  </a:lnTo>
                  <a:lnTo>
                    <a:pt x="18" y="1008496"/>
                  </a:lnTo>
                  <a:lnTo>
                    <a:pt x="17" y="1010717"/>
                  </a:lnTo>
                  <a:lnTo>
                    <a:pt x="17" y="1012939"/>
                  </a:lnTo>
                  <a:lnTo>
                    <a:pt x="16" y="1015160"/>
                  </a:lnTo>
                  <a:lnTo>
                    <a:pt x="15" y="1017382"/>
                  </a:lnTo>
                  <a:lnTo>
                    <a:pt x="15" y="1019603"/>
                  </a:lnTo>
                  <a:lnTo>
                    <a:pt x="14" y="1021824"/>
                  </a:lnTo>
                  <a:lnTo>
                    <a:pt x="13" y="1024046"/>
                  </a:lnTo>
                  <a:lnTo>
                    <a:pt x="13" y="1026267"/>
                  </a:lnTo>
                  <a:lnTo>
                    <a:pt x="12" y="1028488"/>
                  </a:lnTo>
                  <a:lnTo>
                    <a:pt x="12" y="1030710"/>
                  </a:lnTo>
                  <a:lnTo>
                    <a:pt x="11" y="1032931"/>
                  </a:lnTo>
                  <a:lnTo>
                    <a:pt x="11" y="1035152"/>
                  </a:lnTo>
                  <a:lnTo>
                    <a:pt x="10" y="1037374"/>
                  </a:lnTo>
                  <a:lnTo>
                    <a:pt x="10" y="1039595"/>
                  </a:lnTo>
                  <a:lnTo>
                    <a:pt x="9" y="1041816"/>
                  </a:lnTo>
                  <a:lnTo>
                    <a:pt x="9" y="1044038"/>
                  </a:lnTo>
                  <a:lnTo>
                    <a:pt x="8" y="1046259"/>
                  </a:lnTo>
                  <a:lnTo>
                    <a:pt x="8" y="1048481"/>
                  </a:lnTo>
                  <a:lnTo>
                    <a:pt x="8" y="1050702"/>
                  </a:lnTo>
                  <a:lnTo>
                    <a:pt x="7" y="1052923"/>
                  </a:lnTo>
                  <a:lnTo>
                    <a:pt x="7" y="1055145"/>
                  </a:lnTo>
                  <a:lnTo>
                    <a:pt x="6" y="1057366"/>
                  </a:lnTo>
                  <a:lnTo>
                    <a:pt x="6" y="1059587"/>
                  </a:lnTo>
                  <a:lnTo>
                    <a:pt x="6" y="1061809"/>
                  </a:lnTo>
                  <a:lnTo>
                    <a:pt x="5" y="1064030"/>
                  </a:lnTo>
                  <a:lnTo>
                    <a:pt x="5" y="1066251"/>
                  </a:lnTo>
                  <a:lnTo>
                    <a:pt x="5" y="1068473"/>
                  </a:lnTo>
                  <a:lnTo>
                    <a:pt x="5" y="1070694"/>
                  </a:lnTo>
                  <a:lnTo>
                    <a:pt x="4" y="1072915"/>
                  </a:lnTo>
                  <a:lnTo>
                    <a:pt x="4" y="1075137"/>
                  </a:lnTo>
                  <a:lnTo>
                    <a:pt x="4" y="1077358"/>
                  </a:lnTo>
                  <a:lnTo>
                    <a:pt x="4" y="1079580"/>
                  </a:lnTo>
                  <a:lnTo>
                    <a:pt x="3" y="1081801"/>
                  </a:lnTo>
                  <a:lnTo>
                    <a:pt x="3" y="1084022"/>
                  </a:lnTo>
                  <a:lnTo>
                    <a:pt x="3" y="1086244"/>
                  </a:lnTo>
                  <a:lnTo>
                    <a:pt x="3" y="1088465"/>
                  </a:lnTo>
                  <a:lnTo>
                    <a:pt x="3" y="1090686"/>
                  </a:lnTo>
                  <a:lnTo>
                    <a:pt x="2" y="1092908"/>
                  </a:lnTo>
                  <a:lnTo>
                    <a:pt x="2" y="1095129"/>
                  </a:lnTo>
                  <a:lnTo>
                    <a:pt x="2" y="1097350"/>
                  </a:lnTo>
                  <a:lnTo>
                    <a:pt x="2" y="1099572"/>
                  </a:lnTo>
                  <a:lnTo>
                    <a:pt x="2" y="1101793"/>
                  </a:lnTo>
                  <a:lnTo>
                    <a:pt x="2" y="1104015"/>
                  </a:lnTo>
                  <a:lnTo>
                    <a:pt x="2" y="1106236"/>
                  </a:lnTo>
                  <a:lnTo>
                    <a:pt x="1" y="1108457"/>
                  </a:lnTo>
                  <a:lnTo>
                    <a:pt x="1" y="1110679"/>
                  </a:lnTo>
                  <a:lnTo>
                    <a:pt x="1" y="1112900"/>
                  </a:lnTo>
                  <a:lnTo>
                    <a:pt x="1" y="1115121"/>
                  </a:lnTo>
                  <a:lnTo>
                    <a:pt x="1" y="1117343"/>
                  </a:lnTo>
                  <a:lnTo>
                    <a:pt x="1" y="1119564"/>
                  </a:lnTo>
                  <a:lnTo>
                    <a:pt x="1" y="1121785"/>
                  </a:lnTo>
                  <a:lnTo>
                    <a:pt x="1" y="1124007"/>
                  </a:lnTo>
                  <a:lnTo>
                    <a:pt x="1" y="1126228"/>
                  </a:lnTo>
                  <a:lnTo>
                    <a:pt x="1" y="1128449"/>
                  </a:lnTo>
                  <a:lnTo>
                    <a:pt x="1" y="1130671"/>
                  </a:lnTo>
                  <a:lnTo>
                    <a:pt x="0" y="1132892"/>
                  </a:lnTo>
                  <a:lnTo>
                    <a:pt x="0" y="1135114"/>
                  </a:lnTo>
                  <a:lnTo>
                    <a:pt x="0" y="1135114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56" name="pl38"/>
            <p:cNvSpPr/>
            <p:nvPr/>
          </p:nvSpPr>
          <p:spPr>
            <a:xfrm>
              <a:off x="5254580" y="3275676"/>
              <a:ext cx="183" cy="740689"/>
            </a:xfrm>
            <a:custGeom>
              <a:avLst/>
              <a:gdLst/>
              <a:ahLst/>
              <a:cxnLst/>
              <a:rect l="0" t="0" r="0" b="0"/>
              <a:pathLst>
                <a:path w="183" h="740689">
                  <a:moveTo>
                    <a:pt x="183" y="740689"/>
                  </a:moveTo>
                  <a:lnTo>
                    <a:pt x="181" y="740689"/>
                  </a:lnTo>
                  <a:lnTo>
                    <a:pt x="181" y="739240"/>
                  </a:lnTo>
                  <a:lnTo>
                    <a:pt x="181" y="737790"/>
                  </a:lnTo>
                  <a:lnTo>
                    <a:pt x="181" y="736341"/>
                  </a:lnTo>
                  <a:lnTo>
                    <a:pt x="181" y="734891"/>
                  </a:lnTo>
                  <a:lnTo>
                    <a:pt x="181" y="733442"/>
                  </a:lnTo>
                  <a:lnTo>
                    <a:pt x="181" y="731992"/>
                  </a:lnTo>
                  <a:lnTo>
                    <a:pt x="181" y="730543"/>
                  </a:lnTo>
                  <a:lnTo>
                    <a:pt x="181" y="729093"/>
                  </a:lnTo>
                  <a:lnTo>
                    <a:pt x="181" y="727644"/>
                  </a:lnTo>
                  <a:lnTo>
                    <a:pt x="181" y="726194"/>
                  </a:lnTo>
                  <a:lnTo>
                    <a:pt x="180" y="724745"/>
                  </a:lnTo>
                  <a:lnTo>
                    <a:pt x="180" y="723295"/>
                  </a:lnTo>
                  <a:lnTo>
                    <a:pt x="180" y="721846"/>
                  </a:lnTo>
                  <a:lnTo>
                    <a:pt x="180" y="720396"/>
                  </a:lnTo>
                  <a:lnTo>
                    <a:pt x="180" y="718947"/>
                  </a:lnTo>
                  <a:lnTo>
                    <a:pt x="180" y="717498"/>
                  </a:lnTo>
                  <a:lnTo>
                    <a:pt x="180" y="716048"/>
                  </a:lnTo>
                  <a:lnTo>
                    <a:pt x="179" y="714599"/>
                  </a:lnTo>
                  <a:lnTo>
                    <a:pt x="179" y="713149"/>
                  </a:lnTo>
                  <a:lnTo>
                    <a:pt x="179" y="711700"/>
                  </a:lnTo>
                  <a:lnTo>
                    <a:pt x="179" y="710250"/>
                  </a:lnTo>
                  <a:lnTo>
                    <a:pt x="179" y="708801"/>
                  </a:lnTo>
                  <a:lnTo>
                    <a:pt x="179" y="707351"/>
                  </a:lnTo>
                  <a:lnTo>
                    <a:pt x="178" y="705902"/>
                  </a:lnTo>
                  <a:lnTo>
                    <a:pt x="178" y="704452"/>
                  </a:lnTo>
                  <a:lnTo>
                    <a:pt x="178" y="703003"/>
                  </a:lnTo>
                  <a:lnTo>
                    <a:pt x="178" y="701553"/>
                  </a:lnTo>
                  <a:lnTo>
                    <a:pt x="178" y="700104"/>
                  </a:lnTo>
                  <a:lnTo>
                    <a:pt x="177" y="698654"/>
                  </a:lnTo>
                  <a:lnTo>
                    <a:pt x="177" y="697205"/>
                  </a:lnTo>
                  <a:lnTo>
                    <a:pt x="177" y="695755"/>
                  </a:lnTo>
                  <a:lnTo>
                    <a:pt x="176" y="694306"/>
                  </a:lnTo>
                  <a:lnTo>
                    <a:pt x="176" y="692856"/>
                  </a:lnTo>
                  <a:lnTo>
                    <a:pt x="176" y="691407"/>
                  </a:lnTo>
                  <a:lnTo>
                    <a:pt x="176" y="689957"/>
                  </a:lnTo>
                  <a:lnTo>
                    <a:pt x="175" y="688508"/>
                  </a:lnTo>
                  <a:lnTo>
                    <a:pt x="175" y="687058"/>
                  </a:lnTo>
                  <a:lnTo>
                    <a:pt x="175" y="685609"/>
                  </a:lnTo>
                  <a:lnTo>
                    <a:pt x="174" y="684159"/>
                  </a:lnTo>
                  <a:lnTo>
                    <a:pt x="174" y="682710"/>
                  </a:lnTo>
                  <a:lnTo>
                    <a:pt x="173" y="681260"/>
                  </a:lnTo>
                  <a:lnTo>
                    <a:pt x="173" y="679811"/>
                  </a:lnTo>
                  <a:lnTo>
                    <a:pt x="173" y="678361"/>
                  </a:lnTo>
                  <a:lnTo>
                    <a:pt x="172" y="676912"/>
                  </a:lnTo>
                  <a:lnTo>
                    <a:pt x="172" y="675462"/>
                  </a:lnTo>
                  <a:lnTo>
                    <a:pt x="171" y="674013"/>
                  </a:lnTo>
                  <a:lnTo>
                    <a:pt x="171" y="672563"/>
                  </a:lnTo>
                  <a:lnTo>
                    <a:pt x="170" y="671114"/>
                  </a:lnTo>
                  <a:lnTo>
                    <a:pt x="170" y="669664"/>
                  </a:lnTo>
                  <a:lnTo>
                    <a:pt x="169" y="668215"/>
                  </a:lnTo>
                  <a:lnTo>
                    <a:pt x="169" y="666765"/>
                  </a:lnTo>
                  <a:lnTo>
                    <a:pt x="168" y="665316"/>
                  </a:lnTo>
                  <a:lnTo>
                    <a:pt x="168" y="663866"/>
                  </a:lnTo>
                  <a:lnTo>
                    <a:pt x="167" y="662417"/>
                  </a:lnTo>
                  <a:lnTo>
                    <a:pt x="167" y="660967"/>
                  </a:lnTo>
                  <a:lnTo>
                    <a:pt x="166" y="659518"/>
                  </a:lnTo>
                  <a:lnTo>
                    <a:pt x="165" y="658068"/>
                  </a:lnTo>
                  <a:lnTo>
                    <a:pt x="165" y="656619"/>
                  </a:lnTo>
                  <a:lnTo>
                    <a:pt x="164" y="655169"/>
                  </a:lnTo>
                  <a:lnTo>
                    <a:pt x="163" y="653720"/>
                  </a:lnTo>
                  <a:lnTo>
                    <a:pt x="163" y="652270"/>
                  </a:lnTo>
                  <a:lnTo>
                    <a:pt x="162" y="650821"/>
                  </a:lnTo>
                  <a:lnTo>
                    <a:pt x="161" y="649371"/>
                  </a:lnTo>
                  <a:lnTo>
                    <a:pt x="160" y="647922"/>
                  </a:lnTo>
                  <a:lnTo>
                    <a:pt x="160" y="646472"/>
                  </a:lnTo>
                  <a:lnTo>
                    <a:pt x="159" y="645023"/>
                  </a:lnTo>
                  <a:lnTo>
                    <a:pt x="158" y="643573"/>
                  </a:lnTo>
                  <a:lnTo>
                    <a:pt x="157" y="642124"/>
                  </a:lnTo>
                  <a:lnTo>
                    <a:pt x="156" y="640674"/>
                  </a:lnTo>
                  <a:lnTo>
                    <a:pt x="155" y="639225"/>
                  </a:lnTo>
                  <a:lnTo>
                    <a:pt x="154" y="637776"/>
                  </a:lnTo>
                  <a:lnTo>
                    <a:pt x="153" y="636326"/>
                  </a:lnTo>
                  <a:lnTo>
                    <a:pt x="152" y="634877"/>
                  </a:lnTo>
                  <a:lnTo>
                    <a:pt x="151" y="633427"/>
                  </a:lnTo>
                  <a:lnTo>
                    <a:pt x="150" y="631978"/>
                  </a:lnTo>
                  <a:lnTo>
                    <a:pt x="149" y="630528"/>
                  </a:lnTo>
                  <a:lnTo>
                    <a:pt x="148" y="629079"/>
                  </a:lnTo>
                  <a:lnTo>
                    <a:pt x="147" y="627629"/>
                  </a:lnTo>
                  <a:lnTo>
                    <a:pt x="146" y="626180"/>
                  </a:lnTo>
                  <a:lnTo>
                    <a:pt x="145" y="624730"/>
                  </a:lnTo>
                  <a:lnTo>
                    <a:pt x="144" y="623281"/>
                  </a:lnTo>
                  <a:lnTo>
                    <a:pt x="143" y="621831"/>
                  </a:lnTo>
                  <a:lnTo>
                    <a:pt x="142" y="620382"/>
                  </a:lnTo>
                  <a:lnTo>
                    <a:pt x="141" y="618932"/>
                  </a:lnTo>
                  <a:lnTo>
                    <a:pt x="139" y="617483"/>
                  </a:lnTo>
                  <a:lnTo>
                    <a:pt x="138" y="616033"/>
                  </a:lnTo>
                  <a:lnTo>
                    <a:pt x="137" y="614584"/>
                  </a:lnTo>
                  <a:lnTo>
                    <a:pt x="136" y="613134"/>
                  </a:lnTo>
                  <a:lnTo>
                    <a:pt x="134" y="611685"/>
                  </a:lnTo>
                  <a:lnTo>
                    <a:pt x="133" y="610235"/>
                  </a:lnTo>
                  <a:lnTo>
                    <a:pt x="132" y="608786"/>
                  </a:lnTo>
                  <a:lnTo>
                    <a:pt x="130" y="607336"/>
                  </a:lnTo>
                  <a:lnTo>
                    <a:pt x="129" y="605887"/>
                  </a:lnTo>
                  <a:lnTo>
                    <a:pt x="128" y="604437"/>
                  </a:lnTo>
                  <a:lnTo>
                    <a:pt x="126" y="602988"/>
                  </a:lnTo>
                  <a:lnTo>
                    <a:pt x="125" y="601538"/>
                  </a:lnTo>
                  <a:lnTo>
                    <a:pt x="124" y="600089"/>
                  </a:lnTo>
                  <a:lnTo>
                    <a:pt x="122" y="598639"/>
                  </a:lnTo>
                  <a:lnTo>
                    <a:pt x="121" y="597190"/>
                  </a:lnTo>
                  <a:lnTo>
                    <a:pt x="119" y="595740"/>
                  </a:lnTo>
                  <a:lnTo>
                    <a:pt x="118" y="594291"/>
                  </a:lnTo>
                  <a:lnTo>
                    <a:pt x="116" y="592841"/>
                  </a:lnTo>
                  <a:lnTo>
                    <a:pt x="115" y="591392"/>
                  </a:lnTo>
                  <a:lnTo>
                    <a:pt x="113" y="589942"/>
                  </a:lnTo>
                  <a:lnTo>
                    <a:pt x="112" y="588493"/>
                  </a:lnTo>
                  <a:lnTo>
                    <a:pt x="110" y="587043"/>
                  </a:lnTo>
                  <a:lnTo>
                    <a:pt x="109" y="585594"/>
                  </a:lnTo>
                  <a:lnTo>
                    <a:pt x="107" y="584144"/>
                  </a:lnTo>
                  <a:lnTo>
                    <a:pt x="105" y="582695"/>
                  </a:lnTo>
                  <a:lnTo>
                    <a:pt x="104" y="581245"/>
                  </a:lnTo>
                  <a:lnTo>
                    <a:pt x="102" y="579796"/>
                  </a:lnTo>
                  <a:lnTo>
                    <a:pt x="101" y="578346"/>
                  </a:lnTo>
                  <a:lnTo>
                    <a:pt x="99" y="576897"/>
                  </a:lnTo>
                  <a:lnTo>
                    <a:pt x="98" y="575447"/>
                  </a:lnTo>
                  <a:lnTo>
                    <a:pt x="96" y="573998"/>
                  </a:lnTo>
                  <a:lnTo>
                    <a:pt x="94" y="572548"/>
                  </a:lnTo>
                  <a:lnTo>
                    <a:pt x="93" y="571099"/>
                  </a:lnTo>
                  <a:lnTo>
                    <a:pt x="91" y="569649"/>
                  </a:lnTo>
                  <a:lnTo>
                    <a:pt x="89" y="568200"/>
                  </a:lnTo>
                  <a:lnTo>
                    <a:pt x="88" y="566750"/>
                  </a:lnTo>
                  <a:lnTo>
                    <a:pt x="86" y="565301"/>
                  </a:lnTo>
                  <a:lnTo>
                    <a:pt x="85" y="563851"/>
                  </a:lnTo>
                  <a:lnTo>
                    <a:pt x="83" y="562402"/>
                  </a:lnTo>
                  <a:lnTo>
                    <a:pt x="81" y="560952"/>
                  </a:lnTo>
                  <a:lnTo>
                    <a:pt x="80" y="559503"/>
                  </a:lnTo>
                  <a:lnTo>
                    <a:pt x="78" y="558054"/>
                  </a:lnTo>
                  <a:lnTo>
                    <a:pt x="77" y="556604"/>
                  </a:lnTo>
                  <a:lnTo>
                    <a:pt x="75" y="555155"/>
                  </a:lnTo>
                  <a:lnTo>
                    <a:pt x="74" y="553705"/>
                  </a:lnTo>
                  <a:lnTo>
                    <a:pt x="72" y="552256"/>
                  </a:lnTo>
                  <a:lnTo>
                    <a:pt x="70" y="550806"/>
                  </a:lnTo>
                  <a:lnTo>
                    <a:pt x="69" y="549357"/>
                  </a:lnTo>
                  <a:lnTo>
                    <a:pt x="67" y="547907"/>
                  </a:lnTo>
                  <a:lnTo>
                    <a:pt x="66" y="546458"/>
                  </a:lnTo>
                  <a:lnTo>
                    <a:pt x="64" y="545008"/>
                  </a:lnTo>
                  <a:lnTo>
                    <a:pt x="63" y="543559"/>
                  </a:lnTo>
                  <a:lnTo>
                    <a:pt x="62" y="542109"/>
                  </a:lnTo>
                  <a:lnTo>
                    <a:pt x="60" y="540660"/>
                  </a:lnTo>
                  <a:lnTo>
                    <a:pt x="59" y="539210"/>
                  </a:lnTo>
                  <a:lnTo>
                    <a:pt x="57" y="537761"/>
                  </a:lnTo>
                  <a:lnTo>
                    <a:pt x="56" y="536311"/>
                  </a:lnTo>
                  <a:lnTo>
                    <a:pt x="55" y="534862"/>
                  </a:lnTo>
                  <a:lnTo>
                    <a:pt x="53" y="533412"/>
                  </a:lnTo>
                  <a:lnTo>
                    <a:pt x="52" y="531963"/>
                  </a:lnTo>
                  <a:lnTo>
                    <a:pt x="51" y="530513"/>
                  </a:lnTo>
                  <a:lnTo>
                    <a:pt x="49" y="529064"/>
                  </a:lnTo>
                  <a:lnTo>
                    <a:pt x="48" y="527614"/>
                  </a:lnTo>
                  <a:lnTo>
                    <a:pt x="47" y="526165"/>
                  </a:lnTo>
                  <a:lnTo>
                    <a:pt x="46" y="524715"/>
                  </a:lnTo>
                  <a:lnTo>
                    <a:pt x="45" y="523266"/>
                  </a:lnTo>
                  <a:lnTo>
                    <a:pt x="43" y="521816"/>
                  </a:lnTo>
                  <a:lnTo>
                    <a:pt x="42" y="520367"/>
                  </a:lnTo>
                  <a:lnTo>
                    <a:pt x="41" y="518917"/>
                  </a:lnTo>
                  <a:lnTo>
                    <a:pt x="40" y="517468"/>
                  </a:lnTo>
                  <a:lnTo>
                    <a:pt x="39" y="516018"/>
                  </a:lnTo>
                  <a:lnTo>
                    <a:pt x="38" y="514569"/>
                  </a:lnTo>
                  <a:lnTo>
                    <a:pt x="37" y="513119"/>
                  </a:lnTo>
                  <a:lnTo>
                    <a:pt x="36" y="511670"/>
                  </a:lnTo>
                  <a:lnTo>
                    <a:pt x="36" y="510220"/>
                  </a:lnTo>
                  <a:lnTo>
                    <a:pt x="35" y="508771"/>
                  </a:lnTo>
                  <a:lnTo>
                    <a:pt x="34" y="507321"/>
                  </a:lnTo>
                  <a:lnTo>
                    <a:pt x="33" y="505872"/>
                  </a:lnTo>
                  <a:lnTo>
                    <a:pt x="32" y="504422"/>
                  </a:lnTo>
                  <a:lnTo>
                    <a:pt x="32" y="502973"/>
                  </a:lnTo>
                  <a:lnTo>
                    <a:pt x="31" y="501523"/>
                  </a:lnTo>
                  <a:lnTo>
                    <a:pt x="30" y="500074"/>
                  </a:lnTo>
                  <a:lnTo>
                    <a:pt x="30" y="498624"/>
                  </a:lnTo>
                  <a:lnTo>
                    <a:pt x="29" y="497175"/>
                  </a:lnTo>
                  <a:lnTo>
                    <a:pt x="28" y="495725"/>
                  </a:lnTo>
                  <a:lnTo>
                    <a:pt x="28" y="494276"/>
                  </a:lnTo>
                  <a:lnTo>
                    <a:pt x="27" y="492826"/>
                  </a:lnTo>
                  <a:lnTo>
                    <a:pt x="27" y="491377"/>
                  </a:lnTo>
                  <a:lnTo>
                    <a:pt x="26" y="489927"/>
                  </a:lnTo>
                  <a:lnTo>
                    <a:pt x="26" y="488478"/>
                  </a:lnTo>
                  <a:lnTo>
                    <a:pt x="26" y="487028"/>
                  </a:lnTo>
                  <a:lnTo>
                    <a:pt x="25" y="485579"/>
                  </a:lnTo>
                  <a:lnTo>
                    <a:pt x="25" y="484129"/>
                  </a:lnTo>
                  <a:lnTo>
                    <a:pt x="25" y="482680"/>
                  </a:lnTo>
                  <a:lnTo>
                    <a:pt x="24" y="481230"/>
                  </a:lnTo>
                  <a:lnTo>
                    <a:pt x="24" y="479781"/>
                  </a:lnTo>
                  <a:lnTo>
                    <a:pt x="24" y="478332"/>
                  </a:lnTo>
                  <a:lnTo>
                    <a:pt x="24" y="476882"/>
                  </a:lnTo>
                  <a:lnTo>
                    <a:pt x="24" y="475433"/>
                  </a:lnTo>
                  <a:lnTo>
                    <a:pt x="23" y="473983"/>
                  </a:lnTo>
                  <a:lnTo>
                    <a:pt x="23" y="472534"/>
                  </a:lnTo>
                  <a:lnTo>
                    <a:pt x="23" y="471084"/>
                  </a:lnTo>
                  <a:lnTo>
                    <a:pt x="23" y="469635"/>
                  </a:lnTo>
                  <a:lnTo>
                    <a:pt x="23" y="468185"/>
                  </a:lnTo>
                  <a:lnTo>
                    <a:pt x="23" y="466736"/>
                  </a:lnTo>
                  <a:lnTo>
                    <a:pt x="23" y="465286"/>
                  </a:lnTo>
                  <a:lnTo>
                    <a:pt x="23" y="463837"/>
                  </a:lnTo>
                  <a:lnTo>
                    <a:pt x="23" y="462387"/>
                  </a:lnTo>
                  <a:lnTo>
                    <a:pt x="23" y="460938"/>
                  </a:lnTo>
                  <a:lnTo>
                    <a:pt x="23" y="459488"/>
                  </a:lnTo>
                  <a:lnTo>
                    <a:pt x="23" y="458039"/>
                  </a:lnTo>
                  <a:lnTo>
                    <a:pt x="24" y="456589"/>
                  </a:lnTo>
                  <a:lnTo>
                    <a:pt x="24" y="455140"/>
                  </a:lnTo>
                  <a:lnTo>
                    <a:pt x="24" y="453690"/>
                  </a:lnTo>
                  <a:lnTo>
                    <a:pt x="24" y="452241"/>
                  </a:lnTo>
                  <a:lnTo>
                    <a:pt x="24" y="450791"/>
                  </a:lnTo>
                  <a:lnTo>
                    <a:pt x="24" y="449342"/>
                  </a:lnTo>
                  <a:lnTo>
                    <a:pt x="25" y="447892"/>
                  </a:lnTo>
                  <a:lnTo>
                    <a:pt x="25" y="446443"/>
                  </a:lnTo>
                  <a:lnTo>
                    <a:pt x="25" y="444993"/>
                  </a:lnTo>
                  <a:lnTo>
                    <a:pt x="25" y="443544"/>
                  </a:lnTo>
                  <a:lnTo>
                    <a:pt x="25" y="442094"/>
                  </a:lnTo>
                  <a:lnTo>
                    <a:pt x="26" y="440645"/>
                  </a:lnTo>
                  <a:lnTo>
                    <a:pt x="26" y="439195"/>
                  </a:lnTo>
                  <a:lnTo>
                    <a:pt x="26" y="437746"/>
                  </a:lnTo>
                  <a:lnTo>
                    <a:pt x="26" y="436296"/>
                  </a:lnTo>
                  <a:lnTo>
                    <a:pt x="27" y="434847"/>
                  </a:lnTo>
                  <a:lnTo>
                    <a:pt x="27" y="433397"/>
                  </a:lnTo>
                  <a:lnTo>
                    <a:pt x="27" y="431948"/>
                  </a:lnTo>
                  <a:lnTo>
                    <a:pt x="27" y="430498"/>
                  </a:lnTo>
                  <a:lnTo>
                    <a:pt x="27" y="429049"/>
                  </a:lnTo>
                  <a:lnTo>
                    <a:pt x="28" y="427599"/>
                  </a:lnTo>
                  <a:lnTo>
                    <a:pt x="28" y="426150"/>
                  </a:lnTo>
                  <a:lnTo>
                    <a:pt x="28" y="424700"/>
                  </a:lnTo>
                  <a:lnTo>
                    <a:pt x="28" y="423251"/>
                  </a:lnTo>
                  <a:lnTo>
                    <a:pt x="28" y="421801"/>
                  </a:lnTo>
                  <a:lnTo>
                    <a:pt x="29" y="420352"/>
                  </a:lnTo>
                  <a:lnTo>
                    <a:pt x="29" y="418902"/>
                  </a:lnTo>
                  <a:lnTo>
                    <a:pt x="29" y="417453"/>
                  </a:lnTo>
                  <a:lnTo>
                    <a:pt x="29" y="416003"/>
                  </a:lnTo>
                  <a:lnTo>
                    <a:pt x="29" y="414554"/>
                  </a:lnTo>
                  <a:lnTo>
                    <a:pt x="29" y="413104"/>
                  </a:lnTo>
                  <a:lnTo>
                    <a:pt x="29" y="411655"/>
                  </a:lnTo>
                  <a:lnTo>
                    <a:pt x="30" y="410205"/>
                  </a:lnTo>
                  <a:lnTo>
                    <a:pt x="30" y="408756"/>
                  </a:lnTo>
                  <a:lnTo>
                    <a:pt x="30" y="407306"/>
                  </a:lnTo>
                  <a:lnTo>
                    <a:pt x="30" y="405857"/>
                  </a:lnTo>
                  <a:lnTo>
                    <a:pt x="30" y="404407"/>
                  </a:lnTo>
                  <a:lnTo>
                    <a:pt x="30" y="402958"/>
                  </a:lnTo>
                  <a:lnTo>
                    <a:pt x="30" y="401508"/>
                  </a:lnTo>
                  <a:lnTo>
                    <a:pt x="30" y="400059"/>
                  </a:lnTo>
                  <a:lnTo>
                    <a:pt x="30" y="398610"/>
                  </a:lnTo>
                  <a:lnTo>
                    <a:pt x="30" y="397160"/>
                  </a:lnTo>
                  <a:lnTo>
                    <a:pt x="30" y="395711"/>
                  </a:lnTo>
                  <a:lnTo>
                    <a:pt x="30" y="394261"/>
                  </a:lnTo>
                  <a:lnTo>
                    <a:pt x="30" y="392812"/>
                  </a:lnTo>
                  <a:lnTo>
                    <a:pt x="29" y="391362"/>
                  </a:lnTo>
                  <a:lnTo>
                    <a:pt x="29" y="389913"/>
                  </a:lnTo>
                  <a:lnTo>
                    <a:pt x="29" y="388463"/>
                  </a:lnTo>
                  <a:lnTo>
                    <a:pt x="29" y="387014"/>
                  </a:lnTo>
                  <a:lnTo>
                    <a:pt x="29" y="385564"/>
                  </a:lnTo>
                  <a:lnTo>
                    <a:pt x="29" y="384115"/>
                  </a:lnTo>
                  <a:lnTo>
                    <a:pt x="28" y="382665"/>
                  </a:lnTo>
                  <a:lnTo>
                    <a:pt x="28" y="381216"/>
                  </a:lnTo>
                  <a:lnTo>
                    <a:pt x="28" y="379766"/>
                  </a:lnTo>
                  <a:lnTo>
                    <a:pt x="28" y="378317"/>
                  </a:lnTo>
                  <a:lnTo>
                    <a:pt x="27" y="376867"/>
                  </a:lnTo>
                  <a:lnTo>
                    <a:pt x="27" y="375418"/>
                  </a:lnTo>
                  <a:lnTo>
                    <a:pt x="27" y="373968"/>
                  </a:lnTo>
                  <a:lnTo>
                    <a:pt x="26" y="372519"/>
                  </a:lnTo>
                  <a:lnTo>
                    <a:pt x="26" y="371069"/>
                  </a:lnTo>
                  <a:lnTo>
                    <a:pt x="25" y="369620"/>
                  </a:lnTo>
                  <a:lnTo>
                    <a:pt x="25" y="368170"/>
                  </a:lnTo>
                  <a:lnTo>
                    <a:pt x="25" y="366721"/>
                  </a:lnTo>
                  <a:lnTo>
                    <a:pt x="24" y="365271"/>
                  </a:lnTo>
                  <a:lnTo>
                    <a:pt x="24" y="363822"/>
                  </a:lnTo>
                  <a:lnTo>
                    <a:pt x="23" y="362372"/>
                  </a:lnTo>
                  <a:lnTo>
                    <a:pt x="23" y="360923"/>
                  </a:lnTo>
                  <a:lnTo>
                    <a:pt x="22" y="359473"/>
                  </a:lnTo>
                  <a:lnTo>
                    <a:pt x="22" y="358024"/>
                  </a:lnTo>
                  <a:lnTo>
                    <a:pt x="21" y="356574"/>
                  </a:lnTo>
                  <a:lnTo>
                    <a:pt x="21" y="355125"/>
                  </a:lnTo>
                  <a:lnTo>
                    <a:pt x="20" y="353675"/>
                  </a:lnTo>
                  <a:lnTo>
                    <a:pt x="20" y="352226"/>
                  </a:lnTo>
                  <a:lnTo>
                    <a:pt x="19" y="350776"/>
                  </a:lnTo>
                  <a:lnTo>
                    <a:pt x="19" y="349327"/>
                  </a:lnTo>
                  <a:lnTo>
                    <a:pt x="18" y="347877"/>
                  </a:lnTo>
                  <a:lnTo>
                    <a:pt x="17" y="346428"/>
                  </a:lnTo>
                  <a:lnTo>
                    <a:pt x="17" y="344978"/>
                  </a:lnTo>
                  <a:lnTo>
                    <a:pt x="16" y="343529"/>
                  </a:lnTo>
                  <a:lnTo>
                    <a:pt x="16" y="342079"/>
                  </a:lnTo>
                  <a:lnTo>
                    <a:pt x="15" y="340630"/>
                  </a:lnTo>
                  <a:lnTo>
                    <a:pt x="14" y="339180"/>
                  </a:lnTo>
                  <a:lnTo>
                    <a:pt x="14" y="337731"/>
                  </a:lnTo>
                  <a:lnTo>
                    <a:pt x="13" y="336281"/>
                  </a:lnTo>
                  <a:lnTo>
                    <a:pt x="13" y="334832"/>
                  </a:lnTo>
                  <a:lnTo>
                    <a:pt x="12" y="333382"/>
                  </a:lnTo>
                  <a:lnTo>
                    <a:pt x="11" y="331933"/>
                  </a:lnTo>
                  <a:lnTo>
                    <a:pt x="11" y="330483"/>
                  </a:lnTo>
                  <a:lnTo>
                    <a:pt x="10" y="329034"/>
                  </a:lnTo>
                  <a:lnTo>
                    <a:pt x="10" y="327584"/>
                  </a:lnTo>
                  <a:lnTo>
                    <a:pt x="9" y="326135"/>
                  </a:lnTo>
                  <a:lnTo>
                    <a:pt x="9" y="324685"/>
                  </a:lnTo>
                  <a:lnTo>
                    <a:pt x="8" y="323236"/>
                  </a:lnTo>
                  <a:lnTo>
                    <a:pt x="7" y="321786"/>
                  </a:lnTo>
                  <a:lnTo>
                    <a:pt x="7" y="320337"/>
                  </a:lnTo>
                  <a:lnTo>
                    <a:pt x="6" y="318888"/>
                  </a:lnTo>
                  <a:lnTo>
                    <a:pt x="6" y="317438"/>
                  </a:lnTo>
                  <a:lnTo>
                    <a:pt x="5" y="315989"/>
                  </a:lnTo>
                  <a:lnTo>
                    <a:pt x="5" y="314539"/>
                  </a:lnTo>
                  <a:lnTo>
                    <a:pt x="4" y="313090"/>
                  </a:lnTo>
                  <a:lnTo>
                    <a:pt x="4" y="311640"/>
                  </a:lnTo>
                  <a:lnTo>
                    <a:pt x="4" y="310191"/>
                  </a:lnTo>
                  <a:lnTo>
                    <a:pt x="3" y="308741"/>
                  </a:lnTo>
                  <a:lnTo>
                    <a:pt x="3" y="307292"/>
                  </a:lnTo>
                  <a:lnTo>
                    <a:pt x="2" y="305842"/>
                  </a:lnTo>
                  <a:lnTo>
                    <a:pt x="2" y="304393"/>
                  </a:lnTo>
                  <a:lnTo>
                    <a:pt x="2" y="302943"/>
                  </a:lnTo>
                  <a:lnTo>
                    <a:pt x="1" y="301494"/>
                  </a:lnTo>
                  <a:lnTo>
                    <a:pt x="1" y="300044"/>
                  </a:lnTo>
                  <a:lnTo>
                    <a:pt x="1" y="298595"/>
                  </a:lnTo>
                  <a:lnTo>
                    <a:pt x="1" y="297145"/>
                  </a:lnTo>
                  <a:lnTo>
                    <a:pt x="0" y="295696"/>
                  </a:lnTo>
                  <a:lnTo>
                    <a:pt x="0" y="294246"/>
                  </a:lnTo>
                  <a:lnTo>
                    <a:pt x="0" y="292797"/>
                  </a:lnTo>
                  <a:lnTo>
                    <a:pt x="0" y="291347"/>
                  </a:lnTo>
                  <a:lnTo>
                    <a:pt x="0" y="289898"/>
                  </a:lnTo>
                  <a:lnTo>
                    <a:pt x="0" y="288448"/>
                  </a:lnTo>
                  <a:lnTo>
                    <a:pt x="0" y="286999"/>
                  </a:lnTo>
                  <a:lnTo>
                    <a:pt x="0" y="285549"/>
                  </a:lnTo>
                  <a:lnTo>
                    <a:pt x="0" y="284100"/>
                  </a:lnTo>
                  <a:lnTo>
                    <a:pt x="0" y="282650"/>
                  </a:lnTo>
                  <a:lnTo>
                    <a:pt x="0" y="281201"/>
                  </a:lnTo>
                  <a:lnTo>
                    <a:pt x="0" y="279751"/>
                  </a:lnTo>
                  <a:lnTo>
                    <a:pt x="0" y="278302"/>
                  </a:lnTo>
                  <a:lnTo>
                    <a:pt x="0" y="276852"/>
                  </a:lnTo>
                  <a:lnTo>
                    <a:pt x="0" y="275403"/>
                  </a:lnTo>
                  <a:lnTo>
                    <a:pt x="0" y="273953"/>
                  </a:lnTo>
                  <a:lnTo>
                    <a:pt x="1" y="272504"/>
                  </a:lnTo>
                  <a:lnTo>
                    <a:pt x="1" y="271054"/>
                  </a:lnTo>
                  <a:lnTo>
                    <a:pt x="1" y="269605"/>
                  </a:lnTo>
                  <a:lnTo>
                    <a:pt x="2" y="268155"/>
                  </a:lnTo>
                  <a:lnTo>
                    <a:pt x="2" y="266706"/>
                  </a:lnTo>
                  <a:lnTo>
                    <a:pt x="3" y="265256"/>
                  </a:lnTo>
                  <a:lnTo>
                    <a:pt x="3" y="263807"/>
                  </a:lnTo>
                  <a:lnTo>
                    <a:pt x="4" y="262357"/>
                  </a:lnTo>
                  <a:lnTo>
                    <a:pt x="4" y="260908"/>
                  </a:lnTo>
                  <a:lnTo>
                    <a:pt x="5" y="259458"/>
                  </a:lnTo>
                  <a:lnTo>
                    <a:pt x="5" y="258009"/>
                  </a:lnTo>
                  <a:lnTo>
                    <a:pt x="6" y="256559"/>
                  </a:lnTo>
                  <a:lnTo>
                    <a:pt x="7" y="255110"/>
                  </a:lnTo>
                  <a:lnTo>
                    <a:pt x="8" y="253660"/>
                  </a:lnTo>
                  <a:lnTo>
                    <a:pt x="8" y="252211"/>
                  </a:lnTo>
                  <a:lnTo>
                    <a:pt x="9" y="250761"/>
                  </a:lnTo>
                  <a:lnTo>
                    <a:pt x="10" y="249312"/>
                  </a:lnTo>
                  <a:lnTo>
                    <a:pt x="11" y="247862"/>
                  </a:lnTo>
                  <a:lnTo>
                    <a:pt x="12" y="246413"/>
                  </a:lnTo>
                  <a:lnTo>
                    <a:pt x="13" y="244963"/>
                  </a:lnTo>
                  <a:lnTo>
                    <a:pt x="14" y="243514"/>
                  </a:lnTo>
                  <a:lnTo>
                    <a:pt x="15" y="242064"/>
                  </a:lnTo>
                  <a:lnTo>
                    <a:pt x="16" y="240615"/>
                  </a:lnTo>
                  <a:lnTo>
                    <a:pt x="17" y="239166"/>
                  </a:lnTo>
                  <a:lnTo>
                    <a:pt x="18" y="237716"/>
                  </a:lnTo>
                  <a:lnTo>
                    <a:pt x="19" y="236267"/>
                  </a:lnTo>
                  <a:lnTo>
                    <a:pt x="20" y="234817"/>
                  </a:lnTo>
                  <a:lnTo>
                    <a:pt x="22" y="233368"/>
                  </a:lnTo>
                  <a:lnTo>
                    <a:pt x="23" y="231918"/>
                  </a:lnTo>
                  <a:lnTo>
                    <a:pt x="24" y="230469"/>
                  </a:lnTo>
                  <a:lnTo>
                    <a:pt x="25" y="229019"/>
                  </a:lnTo>
                  <a:lnTo>
                    <a:pt x="27" y="227570"/>
                  </a:lnTo>
                  <a:lnTo>
                    <a:pt x="28" y="226120"/>
                  </a:lnTo>
                  <a:lnTo>
                    <a:pt x="29" y="224671"/>
                  </a:lnTo>
                  <a:lnTo>
                    <a:pt x="31" y="223221"/>
                  </a:lnTo>
                  <a:lnTo>
                    <a:pt x="32" y="221772"/>
                  </a:lnTo>
                  <a:lnTo>
                    <a:pt x="34" y="220322"/>
                  </a:lnTo>
                  <a:lnTo>
                    <a:pt x="35" y="218873"/>
                  </a:lnTo>
                  <a:lnTo>
                    <a:pt x="37" y="217423"/>
                  </a:lnTo>
                  <a:lnTo>
                    <a:pt x="38" y="215974"/>
                  </a:lnTo>
                  <a:lnTo>
                    <a:pt x="40" y="214524"/>
                  </a:lnTo>
                  <a:lnTo>
                    <a:pt x="41" y="213075"/>
                  </a:lnTo>
                  <a:lnTo>
                    <a:pt x="43" y="211625"/>
                  </a:lnTo>
                  <a:lnTo>
                    <a:pt x="45" y="210176"/>
                  </a:lnTo>
                  <a:lnTo>
                    <a:pt x="46" y="208726"/>
                  </a:lnTo>
                  <a:lnTo>
                    <a:pt x="48" y="207277"/>
                  </a:lnTo>
                  <a:lnTo>
                    <a:pt x="50" y="205827"/>
                  </a:lnTo>
                  <a:lnTo>
                    <a:pt x="51" y="204378"/>
                  </a:lnTo>
                  <a:lnTo>
                    <a:pt x="53" y="202928"/>
                  </a:lnTo>
                  <a:lnTo>
                    <a:pt x="55" y="201479"/>
                  </a:lnTo>
                  <a:lnTo>
                    <a:pt x="56" y="200029"/>
                  </a:lnTo>
                  <a:lnTo>
                    <a:pt x="58" y="198580"/>
                  </a:lnTo>
                  <a:lnTo>
                    <a:pt x="60" y="197130"/>
                  </a:lnTo>
                  <a:lnTo>
                    <a:pt x="62" y="195681"/>
                  </a:lnTo>
                  <a:lnTo>
                    <a:pt x="63" y="194231"/>
                  </a:lnTo>
                  <a:lnTo>
                    <a:pt x="65" y="192782"/>
                  </a:lnTo>
                  <a:lnTo>
                    <a:pt x="67" y="191332"/>
                  </a:lnTo>
                  <a:lnTo>
                    <a:pt x="69" y="189883"/>
                  </a:lnTo>
                  <a:lnTo>
                    <a:pt x="70" y="188433"/>
                  </a:lnTo>
                  <a:lnTo>
                    <a:pt x="72" y="186984"/>
                  </a:lnTo>
                  <a:lnTo>
                    <a:pt x="74" y="185534"/>
                  </a:lnTo>
                  <a:lnTo>
                    <a:pt x="76" y="184085"/>
                  </a:lnTo>
                  <a:lnTo>
                    <a:pt x="78" y="182635"/>
                  </a:lnTo>
                  <a:lnTo>
                    <a:pt x="79" y="181186"/>
                  </a:lnTo>
                  <a:lnTo>
                    <a:pt x="81" y="179736"/>
                  </a:lnTo>
                  <a:lnTo>
                    <a:pt x="83" y="178287"/>
                  </a:lnTo>
                  <a:lnTo>
                    <a:pt x="85" y="176837"/>
                  </a:lnTo>
                  <a:lnTo>
                    <a:pt x="87" y="175388"/>
                  </a:lnTo>
                  <a:lnTo>
                    <a:pt x="88" y="173938"/>
                  </a:lnTo>
                  <a:lnTo>
                    <a:pt x="90" y="172489"/>
                  </a:lnTo>
                  <a:lnTo>
                    <a:pt x="92" y="171039"/>
                  </a:lnTo>
                  <a:lnTo>
                    <a:pt x="94" y="169590"/>
                  </a:lnTo>
                  <a:lnTo>
                    <a:pt x="95" y="168140"/>
                  </a:lnTo>
                  <a:lnTo>
                    <a:pt x="97" y="166691"/>
                  </a:lnTo>
                  <a:lnTo>
                    <a:pt x="99" y="165241"/>
                  </a:lnTo>
                  <a:lnTo>
                    <a:pt x="100" y="163792"/>
                  </a:lnTo>
                  <a:lnTo>
                    <a:pt x="102" y="162342"/>
                  </a:lnTo>
                  <a:lnTo>
                    <a:pt x="104" y="160893"/>
                  </a:lnTo>
                  <a:lnTo>
                    <a:pt x="106" y="159444"/>
                  </a:lnTo>
                  <a:lnTo>
                    <a:pt x="107" y="157994"/>
                  </a:lnTo>
                  <a:lnTo>
                    <a:pt x="109" y="156545"/>
                  </a:lnTo>
                  <a:lnTo>
                    <a:pt x="110" y="155095"/>
                  </a:lnTo>
                  <a:lnTo>
                    <a:pt x="112" y="153646"/>
                  </a:lnTo>
                  <a:lnTo>
                    <a:pt x="114" y="152196"/>
                  </a:lnTo>
                  <a:lnTo>
                    <a:pt x="115" y="150747"/>
                  </a:lnTo>
                  <a:lnTo>
                    <a:pt x="117" y="149297"/>
                  </a:lnTo>
                  <a:lnTo>
                    <a:pt x="118" y="147848"/>
                  </a:lnTo>
                  <a:lnTo>
                    <a:pt x="120" y="146398"/>
                  </a:lnTo>
                  <a:lnTo>
                    <a:pt x="121" y="144949"/>
                  </a:lnTo>
                  <a:lnTo>
                    <a:pt x="123" y="143499"/>
                  </a:lnTo>
                  <a:lnTo>
                    <a:pt x="124" y="142050"/>
                  </a:lnTo>
                  <a:lnTo>
                    <a:pt x="126" y="140600"/>
                  </a:lnTo>
                  <a:lnTo>
                    <a:pt x="127" y="139151"/>
                  </a:lnTo>
                  <a:lnTo>
                    <a:pt x="129" y="137701"/>
                  </a:lnTo>
                  <a:lnTo>
                    <a:pt x="130" y="136252"/>
                  </a:lnTo>
                  <a:lnTo>
                    <a:pt x="132" y="134802"/>
                  </a:lnTo>
                  <a:lnTo>
                    <a:pt x="133" y="133353"/>
                  </a:lnTo>
                  <a:lnTo>
                    <a:pt x="134" y="131903"/>
                  </a:lnTo>
                  <a:lnTo>
                    <a:pt x="136" y="130454"/>
                  </a:lnTo>
                  <a:lnTo>
                    <a:pt x="137" y="129004"/>
                  </a:lnTo>
                  <a:lnTo>
                    <a:pt x="138" y="127555"/>
                  </a:lnTo>
                  <a:lnTo>
                    <a:pt x="139" y="126105"/>
                  </a:lnTo>
                  <a:lnTo>
                    <a:pt x="141" y="124656"/>
                  </a:lnTo>
                  <a:lnTo>
                    <a:pt x="142" y="123206"/>
                  </a:lnTo>
                  <a:lnTo>
                    <a:pt x="143" y="121757"/>
                  </a:lnTo>
                  <a:lnTo>
                    <a:pt x="144" y="120307"/>
                  </a:lnTo>
                  <a:lnTo>
                    <a:pt x="145" y="118858"/>
                  </a:lnTo>
                  <a:lnTo>
                    <a:pt x="146" y="117408"/>
                  </a:lnTo>
                  <a:lnTo>
                    <a:pt x="147" y="115959"/>
                  </a:lnTo>
                  <a:lnTo>
                    <a:pt x="149" y="114509"/>
                  </a:lnTo>
                  <a:lnTo>
                    <a:pt x="150" y="113060"/>
                  </a:lnTo>
                  <a:lnTo>
                    <a:pt x="151" y="111610"/>
                  </a:lnTo>
                  <a:lnTo>
                    <a:pt x="152" y="110161"/>
                  </a:lnTo>
                  <a:lnTo>
                    <a:pt x="153" y="108711"/>
                  </a:lnTo>
                  <a:lnTo>
                    <a:pt x="154" y="107262"/>
                  </a:lnTo>
                  <a:lnTo>
                    <a:pt x="155" y="105812"/>
                  </a:lnTo>
                  <a:lnTo>
                    <a:pt x="155" y="104363"/>
                  </a:lnTo>
                  <a:lnTo>
                    <a:pt x="156" y="102913"/>
                  </a:lnTo>
                  <a:lnTo>
                    <a:pt x="157" y="101464"/>
                  </a:lnTo>
                  <a:lnTo>
                    <a:pt x="158" y="100014"/>
                  </a:lnTo>
                  <a:lnTo>
                    <a:pt x="159" y="98565"/>
                  </a:lnTo>
                  <a:lnTo>
                    <a:pt x="160" y="97115"/>
                  </a:lnTo>
                  <a:lnTo>
                    <a:pt x="160" y="95666"/>
                  </a:lnTo>
                  <a:lnTo>
                    <a:pt x="161" y="94216"/>
                  </a:lnTo>
                  <a:lnTo>
                    <a:pt x="162" y="92767"/>
                  </a:lnTo>
                  <a:lnTo>
                    <a:pt x="163" y="91317"/>
                  </a:lnTo>
                  <a:lnTo>
                    <a:pt x="163" y="89868"/>
                  </a:lnTo>
                  <a:lnTo>
                    <a:pt x="164" y="88418"/>
                  </a:lnTo>
                  <a:lnTo>
                    <a:pt x="165" y="86969"/>
                  </a:lnTo>
                  <a:lnTo>
                    <a:pt x="165" y="85519"/>
                  </a:lnTo>
                  <a:lnTo>
                    <a:pt x="166" y="84070"/>
                  </a:lnTo>
                  <a:lnTo>
                    <a:pt x="167" y="82620"/>
                  </a:lnTo>
                  <a:lnTo>
                    <a:pt x="167" y="81171"/>
                  </a:lnTo>
                  <a:lnTo>
                    <a:pt x="168" y="79722"/>
                  </a:lnTo>
                  <a:lnTo>
                    <a:pt x="168" y="78272"/>
                  </a:lnTo>
                  <a:lnTo>
                    <a:pt x="169" y="76823"/>
                  </a:lnTo>
                  <a:lnTo>
                    <a:pt x="170" y="75373"/>
                  </a:lnTo>
                  <a:lnTo>
                    <a:pt x="170" y="73924"/>
                  </a:lnTo>
                  <a:lnTo>
                    <a:pt x="171" y="72474"/>
                  </a:lnTo>
                  <a:lnTo>
                    <a:pt x="171" y="71025"/>
                  </a:lnTo>
                  <a:lnTo>
                    <a:pt x="171" y="69575"/>
                  </a:lnTo>
                  <a:lnTo>
                    <a:pt x="172" y="68126"/>
                  </a:lnTo>
                  <a:lnTo>
                    <a:pt x="172" y="66676"/>
                  </a:lnTo>
                  <a:lnTo>
                    <a:pt x="173" y="65227"/>
                  </a:lnTo>
                  <a:lnTo>
                    <a:pt x="173" y="63777"/>
                  </a:lnTo>
                  <a:lnTo>
                    <a:pt x="174" y="62328"/>
                  </a:lnTo>
                  <a:lnTo>
                    <a:pt x="174" y="60878"/>
                  </a:lnTo>
                  <a:lnTo>
                    <a:pt x="174" y="59429"/>
                  </a:lnTo>
                  <a:lnTo>
                    <a:pt x="175" y="57979"/>
                  </a:lnTo>
                  <a:lnTo>
                    <a:pt x="175" y="56530"/>
                  </a:lnTo>
                  <a:lnTo>
                    <a:pt x="175" y="55080"/>
                  </a:lnTo>
                  <a:lnTo>
                    <a:pt x="176" y="53631"/>
                  </a:lnTo>
                  <a:lnTo>
                    <a:pt x="176" y="52181"/>
                  </a:lnTo>
                  <a:lnTo>
                    <a:pt x="176" y="50732"/>
                  </a:lnTo>
                  <a:lnTo>
                    <a:pt x="177" y="49282"/>
                  </a:lnTo>
                  <a:lnTo>
                    <a:pt x="177" y="47833"/>
                  </a:lnTo>
                  <a:lnTo>
                    <a:pt x="177" y="46383"/>
                  </a:lnTo>
                  <a:lnTo>
                    <a:pt x="177" y="44934"/>
                  </a:lnTo>
                  <a:lnTo>
                    <a:pt x="178" y="43484"/>
                  </a:lnTo>
                  <a:lnTo>
                    <a:pt x="178" y="42035"/>
                  </a:lnTo>
                  <a:lnTo>
                    <a:pt x="178" y="40585"/>
                  </a:lnTo>
                  <a:lnTo>
                    <a:pt x="178" y="39136"/>
                  </a:lnTo>
                  <a:lnTo>
                    <a:pt x="178" y="37686"/>
                  </a:lnTo>
                  <a:lnTo>
                    <a:pt x="179" y="36237"/>
                  </a:lnTo>
                  <a:lnTo>
                    <a:pt x="179" y="34787"/>
                  </a:lnTo>
                  <a:lnTo>
                    <a:pt x="179" y="33338"/>
                  </a:lnTo>
                  <a:lnTo>
                    <a:pt x="179" y="31888"/>
                  </a:lnTo>
                  <a:lnTo>
                    <a:pt x="179" y="30439"/>
                  </a:lnTo>
                  <a:lnTo>
                    <a:pt x="180" y="28989"/>
                  </a:lnTo>
                  <a:lnTo>
                    <a:pt x="180" y="27540"/>
                  </a:lnTo>
                  <a:lnTo>
                    <a:pt x="180" y="26090"/>
                  </a:lnTo>
                  <a:lnTo>
                    <a:pt x="180" y="24641"/>
                  </a:lnTo>
                  <a:lnTo>
                    <a:pt x="180" y="23191"/>
                  </a:lnTo>
                  <a:lnTo>
                    <a:pt x="180" y="21742"/>
                  </a:lnTo>
                  <a:lnTo>
                    <a:pt x="180" y="20292"/>
                  </a:lnTo>
                  <a:lnTo>
                    <a:pt x="180" y="18843"/>
                  </a:lnTo>
                  <a:lnTo>
                    <a:pt x="181" y="17393"/>
                  </a:lnTo>
                  <a:lnTo>
                    <a:pt x="181" y="15944"/>
                  </a:lnTo>
                  <a:lnTo>
                    <a:pt x="181" y="14494"/>
                  </a:lnTo>
                  <a:lnTo>
                    <a:pt x="181" y="13045"/>
                  </a:lnTo>
                  <a:lnTo>
                    <a:pt x="181" y="11595"/>
                  </a:lnTo>
                  <a:lnTo>
                    <a:pt x="181" y="10146"/>
                  </a:lnTo>
                  <a:lnTo>
                    <a:pt x="181" y="8696"/>
                  </a:lnTo>
                  <a:lnTo>
                    <a:pt x="181" y="7247"/>
                  </a:lnTo>
                  <a:lnTo>
                    <a:pt x="181" y="5797"/>
                  </a:lnTo>
                  <a:lnTo>
                    <a:pt x="181" y="4348"/>
                  </a:lnTo>
                  <a:lnTo>
                    <a:pt x="181" y="2898"/>
                  </a:lnTo>
                  <a:lnTo>
                    <a:pt x="182" y="1449"/>
                  </a:lnTo>
                  <a:lnTo>
                    <a:pt x="182" y="0"/>
                  </a:lnTo>
                  <a:lnTo>
                    <a:pt x="183" y="0"/>
                  </a:lnTo>
                  <a:lnTo>
                    <a:pt x="183" y="740689"/>
                  </a:lnTo>
                  <a:lnTo>
                    <a:pt x="183" y="740689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57" name="pl39"/>
            <p:cNvSpPr/>
            <p:nvPr/>
          </p:nvSpPr>
          <p:spPr>
            <a:xfrm>
              <a:off x="5254763" y="3546390"/>
              <a:ext cx="355" cy="362824"/>
            </a:xfrm>
            <a:custGeom>
              <a:avLst/>
              <a:gdLst/>
              <a:ahLst/>
              <a:cxnLst/>
              <a:rect l="0" t="0" r="0" b="0"/>
              <a:pathLst>
                <a:path w="355" h="362824">
                  <a:moveTo>
                    <a:pt x="0" y="0"/>
                  </a:moveTo>
                  <a:lnTo>
                    <a:pt x="1" y="0"/>
                  </a:lnTo>
                  <a:lnTo>
                    <a:pt x="2" y="710"/>
                  </a:lnTo>
                  <a:lnTo>
                    <a:pt x="2" y="1420"/>
                  </a:lnTo>
                  <a:lnTo>
                    <a:pt x="2" y="2130"/>
                  </a:lnTo>
                  <a:lnTo>
                    <a:pt x="2" y="2840"/>
                  </a:lnTo>
                  <a:lnTo>
                    <a:pt x="2" y="3550"/>
                  </a:lnTo>
                  <a:lnTo>
                    <a:pt x="2" y="4260"/>
                  </a:lnTo>
                  <a:lnTo>
                    <a:pt x="2" y="4970"/>
                  </a:lnTo>
                  <a:lnTo>
                    <a:pt x="3" y="5680"/>
                  </a:lnTo>
                  <a:lnTo>
                    <a:pt x="3" y="6390"/>
                  </a:lnTo>
                  <a:lnTo>
                    <a:pt x="3" y="7100"/>
                  </a:lnTo>
                  <a:lnTo>
                    <a:pt x="3" y="7810"/>
                  </a:lnTo>
                  <a:lnTo>
                    <a:pt x="3" y="8520"/>
                  </a:lnTo>
                  <a:lnTo>
                    <a:pt x="3" y="9230"/>
                  </a:lnTo>
                  <a:lnTo>
                    <a:pt x="4" y="9940"/>
                  </a:lnTo>
                  <a:lnTo>
                    <a:pt x="4" y="10650"/>
                  </a:lnTo>
                  <a:lnTo>
                    <a:pt x="4" y="11360"/>
                  </a:lnTo>
                  <a:lnTo>
                    <a:pt x="4" y="12070"/>
                  </a:lnTo>
                  <a:lnTo>
                    <a:pt x="5" y="12780"/>
                  </a:lnTo>
                  <a:lnTo>
                    <a:pt x="5" y="13490"/>
                  </a:lnTo>
                  <a:lnTo>
                    <a:pt x="5" y="14200"/>
                  </a:lnTo>
                  <a:lnTo>
                    <a:pt x="5" y="14910"/>
                  </a:lnTo>
                  <a:lnTo>
                    <a:pt x="6" y="15620"/>
                  </a:lnTo>
                  <a:lnTo>
                    <a:pt x="6" y="16330"/>
                  </a:lnTo>
                  <a:lnTo>
                    <a:pt x="6" y="17040"/>
                  </a:lnTo>
                  <a:lnTo>
                    <a:pt x="7" y="17750"/>
                  </a:lnTo>
                  <a:lnTo>
                    <a:pt x="7" y="18460"/>
                  </a:lnTo>
                  <a:lnTo>
                    <a:pt x="7" y="19170"/>
                  </a:lnTo>
                  <a:lnTo>
                    <a:pt x="8" y="19880"/>
                  </a:lnTo>
                  <a:lnTo>
                    <a:pt x="8" y="20590"/>
                  </a:lnTo>
                  <a:lnTo>
                    <a:pt x="9" y="21300"/>
                  </a:lnTo>
                  <a:lnTo>
                    <a:pt x="9" y="22010"/>
                  </a:lnTo>
                  <a:lnTo>
                    <a:pt x="10" y="22720"/>
                  </a:lnTo>
                  <a:lnTo>
                    <a:pt x="10" y="23430"/>
                  </a:lnTo>
                  <a:lnTo>
                    <a:pt x="11" y="24140"/>
                  </a:lnTo>
                  <a:lnTo>
                    <a:pt x="11" y="24851"/>
                  </a:lnTo>
                  <a:lnTo>
                    <a:pt x="12" y="25561"/>
                  </a:lnTo>
                  <a:lnTo>
                    <a:pt x="12" y="26271"/>
                  </a:lnTo>
                  <a:lnTo>
                    <a:pt x="13" y="26981"/>
                  </a:lnTo>
                  <a:lnTo>
                    <a:pt x="13" y="27691"/>
                  </a:lnTo>
                  <a:lnTo>
                    <a:pt x="14" y="28401"/>
                  </a:lnTo>
                  <a:lnTo>
                    <a:pt x="15" y="29111"/>
                  </a:lnTo>
                  <a:lnTo>
                    <a:pt x="15" y="29821"/>
                  </a:lnTo>
                  <a:lnTo>
                    <a:pt x="16" y="30531"/>
                  </a:lnTo>
                  <a:lnTo>
                    <a:pt x="17" y="31241"/>
                  </a:lnTo>
                  <a:lnTo>
                    <a:pt x="17" y="31951"/>
                  </a:lnTo>
                  <a:lnTo>
                    <a:pt x="18" y="32661"/>
                  </a:lnTo>
                  <a:lnTo>
                    <a:pt x="19" y="33371"/>
                  </a:lnTo>
                  <a:lnTo>
                    <a:pt x="20" y="34081"/>
                  </a:lnTo>
                  <a:lnTo>
                    <a:pt x="21" y="34791"/>
                  </a:lnTo>
                  <a:lnTo>
                    <a:pt x="21" y="35501"/>
                  </a:lnTo>
                  <a:lnTo>
                    <a:pt x="22" y="36211"/>
                  </a:lnTo>
                  <a:lnTo>
                    <a:pt x="23" y="36921"/>
                  </a:lnTo>
                  <a:lnTo>
                    <a:pt x="24" y="37631"/>
                  </a:lnTo>
                  <a:lnTo>
                    <a:pt x="25" y="38341"/>
                  </a:lnTo>
                  <a:lnTo>
                    <a:pt x="26" y="39051"/>
                  </a:lnTo>
                  <a:lnTo>
                    <a:pt x="27" y="39761"/>
                  </a:lnTo>
                  <a:lnTo>
                    <a:pt x="28" y="40471"/>
                  </a:lnTo>
                  <a:lnTo>
                    <a:pt x="30" y="41181"/>
                  </a:lnTo>
                  <a:lnTo>
                    <a:pt x="31" y="41891"/>
                  </a:lnTo>
                  <a:lnTo>
                    <a:pt x="32" y="42601"/>
                  </a:lnTo>
                  <a:lnTo>
                    <a:pt x="33" y="43311"/>
                  </a:lnTo>
                  <a:lnTo>
                    <a:pt x="34" y="44021"/>
                  </a:lnTo>
                  <a:lnTo>
                    <a:pt x="36" y="44731"/>
                  </a:lnTo>
                  <a:lnTo>
                    <a:pt x="37" y="45441"/>
                  </a:lnTo>
                  <a:lnTo>
                    <a:pt x="38" y="46151"/>
                  </a:lnTo>
                  <a:lnTo>
                    <a:pt x="40" y="46861"/>
                  </a:lnTo>
                  <a:lnTo>
                    <a:pt x="41" y="47571"/>
                  </a:lnTo>
                  <a:lnTo>
                    <a:pt x="43" y="48281"/>
                  </a:lnTo>
                  <a:lnTo>
                    <a:pt x="44" y="48991"/>
                  </a:lnTo>
                  <a:lnTo>
                    <a:pt x="46" y="49702"/>
                  </a:lnTo>
                  <a:lnTo>
                    <a:pt x="47" y="50412"/>
                  </a:lnTo>
                  <a:lnTo>
                    <a:pt x="49" y="51122"/>
                  </a:lnTo>
                  <a:lnTo>
                    <a:pt x="51" y="51832"/>
                  </a:lnTo>
                  <a:lnTo>
                    <a:pt x="52" y="52542"/>
                  </a:lnTo>
                  <a:lnTo>
                    <a:pt x="54" y="53252"/>
                  </a:lnTo>
                  <a:lnTo>
                    <a:pt x="56" y="53962"/>
                  </a:lnTo>
                  <a:lnTo>
                    <a:pt x="58" y="54672"/>
                  </a:lnTo>
                  <a:lnTo>
                    <a:pt x="60" y="55382"/>
                  </a:lnTo>
                  <a:lnTo>
                    <a:pt x="61" y="56092"/>
                  </a:lnTo>
                  <a:lnTo>
                    <a:pt x="63" y="56802"/>
                  </a:lnTo>
                  <a:lnTo>
                    <a:pt x="65" y="57512"/>
                  </a:lnTo>
                  <a:lnTo>
                    <a:pt x="67" y="58222"/>
                  </a:lnTo>
                  <a:lnTo>
                    <a:pt x="70" y="58932"/>
                  </a:lnTo>
                  <a:lnTo>
                    <a:pt x="72" y="59642"/>
                  </a:lnTo>
                  <a:lnTo>
                    <a:pt x="74" y="60352"/>
                  </a:lnTo>
                  <a:lnTo>
                    <a:pt x="76" y="61062"/>
                  </a:lnTo>
                  <a:lnTo>
                    <a:pt x="78" y="61772"/>
                  </a:lnTo>
                  <a:lnTo>
                    <a:pt x="81" y="62482"/>
                  </a:lnTo>
                  <a:lnTo>
                    <a:pt x="83" y="63192"/>
                  </a:lnTo>
                  <a:lnTo>
                    <a:pt x="85" y="63902"/>
                  </a:lnTo>
                  <a:lnTo>
                    <a:pt x="88" y="64612"/>
                  </a:lnTo>
                  <a:lnTo>
                    <a:pt x="90" y="65322"/>
                  </a:lnTo>
                  <a:lnTo>
                    <a:pt x="93" y="66032"/>
                  </a:lnTo>
                  <a:lnTo>
                    <a:pt x="95" y="66742"/>
                  </a:lnTo>
                  <a:lnTo>
                    <a:pt x="98" y="67452"/>
                  </a:lnTo>
                  <a:lnTo>
                    <a:pt x="100" y="68162"/>
                  </a:lnTo>
                  <a:lnTo>
                    <a:pt x="103" y="68872"/>
                  </a:lnTo>
                  <a:lnTo>
                    <a:pt x="106" y="69582"/>
                  </a:lnTo>
                  <a:lnTo>
                    <a:pt x="108" y="70292"/>
                  </a:lnTo>
                  <a:lnTo>
                    <a:pt x="111" y="71002"/>
                  </a:lnTo>
                  <a:lnTo>
                    <a:pt x="114" y="71712"/>
                  </a:lnTo>
                  <a:lnTo>
                    <a:pt x="117" y="72422"/>
                  </a:lnTo>
                  <a:lnTo>
                    <a:pt x="120" y="73132"/>
                  </a:lnTo>
                  <a:lnTo>
                    <a:pt x="122" y="73842"/>
                  </a:lnTo>
                  <a:lnTo>
                    <a:pt x="125" y="74553"/>
                  </a:lnTo>
                  <a:lnTo>
                    <a:pt x="128" y="75263"/>
                  </a:lnTo>
                  <a:lnTo>
                    <a:pt x="131" y="75973"/>
                  </a:lnTo>
                  <a:lnTo>
                    <a:pt x="134" y="76683"/>
                  </a:lnTo>
                  <a:lnTo>
                    <a:pt x="137" y="77393"/>
                  </a:lnTo>
                  <a:lnTo>
                    <a:pt x="140" y="78103"/>
                  </a:lnTo>
                  <a:lnTo>
                    <a:pt x="143" y="78813"/>
                  </a:lnTo>
                  <a:lnTo>
                    <a:pt x="147" y="79523"/>
                  </a:lnTo>
                  <a:lnTo>
                    <a:pt x="150" y="80233"/>
                  </a:lnTo>
                  <a:lnTo>
                    <a:pt x="153" y="80943"/>
                  </a:lnTo>
                  <a:lnTo>
                    <a:pt x="156" y="81653"/>
                  </a:lnTo>
                  <a:lnTo>
                    <a:pt x="159" y="82363"/>
                  </a:lnTo>
                  <a:lnTo>
                    <a:pt x="162" y="83073"/>
                  </a:lnTo>
                  <a:lnTo>
                    <a:pt x="166" y="83783"/>
                  </a:lnTo>
                  <a:lnTo>
                    <a:pt x="169" y="84493"/>
                  </a:lnTo>
                  <a:lnTo>
                    <a:pt x="172" y="85203"/>
                  </a:lnTo>
                  <a:lnTo>
                    <a:pt x="175" y="85913"/>
                  </a:lnTo>
                  <a:lnTo>
                    <a:pt x="179" y="86623"/>
                  </a:lnTo>
                  <a:lnTo>
                    <a:pt x="182" y="87333"/>
                  </a:lnTo>
                  <a:lnTo>
                    <a:pt x="185" y="88043"/>
                  </a:lnTo>
                  <a:lnTo>
                    <a:pt x="189" y="88753"/>
                  </a:lnTo>
                  <a:lnTo>
                    <a:pt x="192" y="89463"/>
                  </a:lnTo>
                  <a:lnTo>
                    <a:pt x="195" y="90173"/>
                  </a:lnTo>
                  <a:lnTo>
                    <a:pt x="199" y="90883"/>
                  </a:lnTo>
                  <a:lnTo>
                    <a:pt x="202" y="91593"/>
                  </a:lnTo>
                  <a:lnTo>
                    <a:pt x="205" y="92303"/>
                  </a:lnTo>
                  <a:lnTo>
                    <a:pt x="208" y="93013"/>
                  </a:lnTo>
                  <a:lnTo>
                    <a:pt x="212" y="93723"/>
                  </a:lnTo>
                  <a:lnTo>
                    <a:pt x="215" y="94433"/>
                  </a:lnTo>
                  <a:lnTo>
                    <a:pt x="218" y="95143"/>
                  </a:lnTo>
                  <a:lnTo>
                    <a:pt x="222" y="95853"/>
                  </a:lnTo>
                  <a:lnTo>
                    <a:pt x="225" y="96563"/>
                  </a:lnTo>
                  <a:lnTo>
                    <a:pt x="228" y="97273"/>
                  </a:lnTo>
                  <a:lnTo>
                    <a:pt x="231" y="97983"/>
                  </a:lnTo>
                  <a:lnTo>
                    <a:pt x="234" y="98693"/>
                  </a:lnTo>
                  <a:lnTo>
                    <a:pt x="238" y="99404"/>
                  </a:lnTo>
                  <a:lnTo>
                    <a:pt x="241" y="100114"/>
                  </a:lnTo>
                  <a:lnTo>
                    <a:pt x="244" y="100824"/>
                  </a:lnTo>
                  <a:lnTo>
                    <a:pt x="247" y="101534"/>
                  </a:lnTo>
                  <a:lnTo>
                    <a:pt x="250" y="102244"/>
                  </a:lnTo>
                  <a:lnTo>
                    <a:pt x="253" y="102954"/>
                  </a:lnTo>
                  <a:lnTo>
                    <a:pt x="256" y="103664"/>
                  </a:lnTo>
                  <a:lnTo>
                    <a:pt x="259" y="104374"/>
                  </a:lnTo>
                  <a:lnTo>
                    <a:pt x="262" y="105084"/>
                  </a:lnTo>
                  <a:lnTo>
                    <a:pt x="265" y="105794"/>
                  </a:lnTo>
                  <a:lnTo>
                    <a:pt x="268" y="106504"/>
                  </a:lnTo>
                  <a:lnTo>
                    <a:pt x="271" y="107214"/>
                  </a:lnTo>
                  <a:lnTo>
                    <a:pt x="273" y="107924"/>
                  </a:lnTo>
                  <a:lnTo>
                    <a:pt x="276" y="108634"/>
                  </a:lnTo>
                  <a:lnTo>
                    <a:pt x="279" y="109344"/>
                  </a:lnTo>
                  <a:lnTo>
                    <a:pt x="281" y="110054"/>
                  </a:lnTo>
                  <a:lnTo>
                    <a:pt x="284" y="110764"/>
                  </a:lnTo>
                  <a:lnTo>
                    <a:pt x="287" y="111474"/>
                  </a:lnTo>
                  <a:lnTo>
                    <a:pt x="289" y="112184"/>
                  </a:lnTo>
                  <a:lnTo>
                    <a:pt x="292" y="112894"/>
                  </a:lnTo>
                  <a:lnTo>
                    <a:pt x="294" y="113604"/>
                  </a:lnTo>
                  <a:lnTo>
                    <a:pt x="296" y="114314"/>
                  </a:lnTo>
                  <a:lnTo>
                    <a:pt x="299" y="115024"/>
                  </a:lnTo>
                  <a:lnTo>
                    <a:pt x="301" y="115734"/>
                  </a:lnTo>
                  <a:lnTo>
                    <a:pt x="303" y="116444"/>
                  </a:lnTo>
                  <a:lnTo>
                    <a:pt x="305" y="117154"/>
                  </a:lnTo>
                  <a:lnTo>
                    <a:pt x="307" y="117864"/>
                  </a:lnTo>
                  <a:lnTo>
                    <a:pt x="309" y="118574"/>
                  </a:lnTo>
                  <a:lnTo>
                    <a:pt x="311" y="119284"/>
                  </a:lnTo>
                  <a:lnTo>
                    <a:pt x="313" y="119994"/>
                  </a:lnTo>
                  <a:lnTo>
                    <a:pt x="315" y="120704"/>
                  </a:lnTo>
                  <a:lnTo>
                    <a:pt x="317" y="121414"/>
                  </a:lnTo>
                  <a:lnTo>
                    <a:pt x="319" y="122124"/>
                  </a:lnTo>
                  <a:lnTo>
                    <a:pt x="320" y="122834"/>
                  </a:lnTo>
                  <a:lnTo>
                    <a:pt x="322" y="123544"/>
                  </a:lnTo>
                  <a:lnTo>
                    <a:pt x="324" y="124255"/>
                  </a:lnTo>
                  <a:lnTo>
                    <a:pt x="325" y="124965"/>
                  </a:lnTo>
                  <a:lnTo>
                    <a:pt x="327" y="125675"/>
                  </a:lnTo>
                  <a:lnTo>
                    <a:pt x="328" y="126385"/>
                  </a:lnTo>
                  <a:lnTo>
                    <a:pt x="329" y="127095"/>
                  </a:lnTo>
                  <a:lnTo>
                    <a:pt x="331" y="127805"/>
                  </a:lnTo>
                  <a:lnTo>
                    <a:pt x="332" y="128515"/>
                  </a:lnTo>
                  <a:lnTo>
                    <a:pt x="333" y="129225"/>
                  </a:lnTo>
                  <a:lnTo>
                    <a:pt x="334" y="129935"/>
                  </a:lnTo>
                  <a:lnTo>
                    <a:pt x="335" y="130645"/>
                  </a:lnTo>
                  <a:lnTo>
                    <a:pt x="336" y="131355"/>
                  </a:lnTo>
                  <a:lnTo>
                    <a:pt x="337" y="132065"/>
                  </a:lnTo>
                  <a:lnTo>
                    <a:pt x="338" y="132775"/>
                  </a:lnTo>
                  <a:lnTo>
                    <a:pt x="339" y="133485"/>
                  </a:lnTo>
                  <a:lnTo>
                    <a:pt x="339" y="134195"/>
                  </a:lnTo>
                  <a:lnTo>
                    <a:pt x="340" y="134905"/>
                  </a:lnTo>
                  <a:lnTo>
                    <a:pt x="341" y="135615"/>
                  </a:lnTo>
                  <a:lnTo>
                    <a:pt x="341" y="136325"/>
                  </a:lnTo>
                  <a:lnTo>
                    <a:pt x="342" y="137035"/>
                  </a:lnTo>
                  <a:lnTo>
                    <a:pt x="342" y="137745"/>
                  </a:lnTo>
                  <a:lnTo>
                    <a:pt x="343" y="138455"/>
                  </a:lnTo>
                  <a:lnTo>
                    <a:pt x="343" y="139165"/>
                  </a:lnTo>
                  <a:lnTo>
                    <a:pt x="343" y="139875"/>
                  </a:lnTo>
                  <a:lnTo>
                    <a:pt x="344" y="140585"/>
                  </a:lnTo>
                  <a:lnTo>
                    <a:pt x="344" y="141295"/>
                  </a:lnTo>
                  <a:lnTo>
                    <a:pt x="344" y="142005"/>
                  </a:lnTo>
                  <a:lnTo>
                    <a:pt x="344" y="142715"/>
                  </a:lnTo>
                  <a:lnTo>
                    <a:pt x="344" y="143425"/>
                  </a:lnTo>
                  <a:lnTo>
                    <a:pt x="344" y="144135"/>
                  </a:lnTo>
                  <a:lnTo>
                    <a:pt x="344" y="144845"/>
                  </a:lnTo>
                  <a:lnTo>
                    <a:pt x="344" y="145555"/>
                  </a:lnTo>
                  <a:lnTo>
                    <a:pt x="344" y="146265"/>
                  </a:lnTo>
                  <a:lnTo>
                    <a:pt x="344" y="146975"/>
                  </a:lnTo>
                  <a:lnTo>
                    <a:pt x="344" y="147685"/>
                  </a:lnTo>
                  <a:lnTo>
                    <a:pt x="344" y="148395"/>
                  </a:lnTo>
                  <a:lnTo>
                    <a:pt x="344" y="149106"/>
                  </a:lnTo>
                  <a:lnTo>
                    <a:pt x="344" y="149816"/>
                  </a:lnTo>
                  <a:lnTo>
                    <a:pt x="343" y="150526"/>
                  </a:lnTo>
                  <a:lnTo>
                    <a:pt x="343" y="151236"/>
                  </a:lnTo>
                  <a:lnTo>
                    <a:pt x="343" y="151946"/>
                  </a:lnTo>
                  <a:lnTo>
                    <a:pt x="343" y="152656"/>
                  </a:lnTo>
                  <a:lnTo>
                    <a:pt x="342" y="153366"/>
                  </a:lnTo>
                  <a:lnTo>
                    <a:pt x="342" y="154076"/>
                  </a:lnTo>
                  <a:lnTo>
                    <a:pt x="341" y="154786"/>
                  </a:lnTo>
                  <a:lnTo>
                    <a:pt x="341" y="155496"/>
                  </a:lnTo>
                  <a:lnTo>
                    <a:pt x="341" y="156206"/>
                  </a:lnTo>
                  <a:lnTo>
                    <a:pt x="340" y="156916"/>
                  </a:lnTo>
                  <a:lnTo>
                    <a:pt x="340" y="157626"/>
                  </a:lnTo>
                  <a:lnTo>
                    <a:pt x="339" y="158336"/>
                  </a:lnTo>
                  <a:lnTo>
                    <a:pt x="339" y="159046"/>
                  </a:lnTo>
                  <a:lnTo>
                    <a:pt x="339" y="159756"/>
                  </a:lnTo>
                  <a:lnTo>
                    <a:pt x="338" y="160466"/>
                  </a:lnTo>
                  <a:lnTo>
                    <a:pt x="338" y="161176"/>
                  </a:lnTo>
                  <a:lnTo>
                    <a:pt x="337" y="161886"/>
                  </a:lnTo>
                  <a:lnTo>
                    <a:pt x="337" y="162596"/>
                  </a:lnTo>
                  <a:lnTo>
                    <a:pt x="336" y="163306"/>
                  </a:lnTo>
                  <a:lnTo>
                    <a:pt x="336" y="164016"/>
                  </a:lnTo>
                  <a:lnTo>
                    <a:pt x="335" y="164726"/>
                  </a:lnTo>
                  <a:lnTo>
                    <a:pt x="335" y="165436"/>
                  </a:lnTo>
                  <a:lnTo>
                    <a:pt x="335" y="166146"/>
                  </a:lnTo>
                  <a:lnTo>
                    <a:pt x="334" y="166856"/>
                  </a:lnTo>
                  <a:lnTo>
                    <a:pt x="334" y="167566"/>
                  </a:lnTo>
                  <a:lnTo>
                    <a:pt x="333" y="168276"/>
                  </a:lnTo>
                  <a:lnTo>
                    <a:pt x="333" y="168986"/>
                  </a:lnTo>
                  <a:lnTo>
                    <a:pt x="333" y="169696"/>
                  </a:lnTo>
                  <a:lnTo>
                    <a:pt x="332" y="170406"/>
                  </a:lnTo>
                  <a:lnTo>
                    <a:pt x="332" y="171116"/>
                  </a:lnTo>
                  <a:lnTo>
                    <a:pt x="332" y="171826"/>
                  </a:lnTo>
                  <a:lnTo>
                    <a:pt x="331" y="172536"/>
                  </a:lnTo>
                  <a:lnTo>
                    <a:pt x="331" y="173246"/>
                  </a:lnTo>
                  <a:lnTo>
                    <a:pt x="331" y="173957"/>
                  </a:lnTo>
                  <a:lnTo>
                    <a:pt x="330" y="174667"/>
                  </a:lnTo>
                  <a:lnTo>
                    <a:pt x="330" y="175377"/>
                  </a:lnTo>
                  <a:lnTo>
                    <a:pt x="330" y="176087"/>
                  </a:lnTo>
                  <a:lnTo>
                    <a:pt x="330" y="176797"/>
                  </a:lnTo>
                  <a:lnTo>
                    <a:pt x="330" y="177507"/>
                  </a:lnTo>
                  <a:lnTo>
                    <a:pt x="329" y="178217"/>
                  </a:lnTo>
                  <a:lnTo>
                    <a:pt x="329" y="178927"/>
                  </a:lnTo>
                  <a:lnTo>
                    <a:pt x="329" y="179637"/>
                  </a:lnTo>
                  <a:lnTo>
                    <a:pt x="329" y="180347"/>
                  </a:lnTo>
                  <a:lnTo>
                    <a:pt x="329" y="181057"/>
                  </a:lnTo>
                  <a:lnTo>
                    <a:pt x="329" y="181767"/>
                  </a:lnTo>
                  <a:lnTo>
                    <a:pt x="329" y="182477"/>
                  </a:lnTo>
                  <a:lnTo>
                    <a:pt x="329" y="183187"/>
                  </a:lnTo>
                  <a:lnTo>
                    <a:pt x="329" y="183897"/>
                  </a:lnTo>
                  <a:lnTo>
                    <a:pt x="329" y="184607"/>
                  </a:lnTo>
                  <a:lnTo>
                    <a:pt x="329" y="185317"/>
                  </a:lnTo>
                  <a:lnTo>
                    <a:pt x="329" y="186027"/>
                  </a:lnTo>
                  <a:lnTo>
                    <a:pt x="330" y="186737"/>
                  </a:lnTo>
                  <a:lnTo>
                    <a:pt x="330" y="187447"/>
                  </a:lnTo>
                  <a:lnTo>
                    <a:pt x="330" y="188157"/>
                  </a:lnTo>
                  <a:lnTo>
                    <a:pt x="330" y="188867"/>
                  </a:lnTo>
                  <a:lnTo>
                    <a:pt x="330" y="189577"/>
                  </a:lnTo>
                  <a:lnTo>
                    <a:pt x="331" y="190287"/>
                  </a:lnTo>
                  <a:lnTo>
                    <a:pt x="331" y="190997"/>
                  </a:lnTo>
                  <a:lnTo>
                    <a:pt x="331" y="191707"/>
                  </a:lnTo>
                  <a:lnTo>
                    <a:pt x="332" y="192417"/>
                  </a:lnTo>
                  <a:lnTo>
                    <a:pt x="332" y="193127"/>
                  </a:lnTo>
                  <a:lnTo>
                    <a:pt x="332" y="193837"/>
                  </a:lnTo>
                  <a:lnTo>
                    <a:pt x="333" y="194547"/>
                  </a:lnTo>
                  <a:lnTo>
                    <a:pt x="333" y="195257"/>
                  </a:lnTo>
                  <a:lnTo>
                    <a:pt x="334" y="195967"/>
                  </a:lnTo>
                  <a:lnTo>
                    <a:pt x="334" y="196677"/>
                  </a:lnTo>
                  <a:lnTo>
                    <a:pt x="335" y="197387"/>
                  </a:lnTo>
                  <a:lnTo>
                    <a:pt x="335" y="198097"/>
                  </a:lnTo>
                  <a:lnTo>
                    <a:pt x="336" y="198808"/>
                  </a:lnTo>
                  <a:lnTo>
                    <a:pt x="336" y="199518"/>
                  </a:lnTo>
                  <a:lnTo>
                    <a:pt x="337" y="200228"/>
                  </a:lnTo>
                  <a:lnTo>
                    <a:pt x="338" y="200938"/>
                  </a:lnTo>
                  <a:lnTo>
                    <a:pt x="338" y="201648"/>
                  </a:lnTo>
                  <a:lnTo>
                    <a:pt x="339" y="202358"/>
                  </a:lnTo>
                  <a:lnTo>
                    <a:pt x="339" y="203068"/>
                  </a:lnTo>
                  <a:lnTo>
                    <a:pt x="340" y="203778"/>
                  </a:lnTo>
                  <a:lnTo>
                    <a:pt x="341" y="204488"/>
                  </a:lnTo>
                  <a:lnTo>
                    <a:pt x="341" y="205198"/>
                  </a:lnTo>
                  <a:lnTo>
                    <a:pt x="342" y="205908"/>
                  </a:lnTo>
                  <a:lnTo>
                    <a:pt x="343" y="206618"/>
                  </a:lnTo>
                  <a:lnTo>
                    <a:pt x="343" y="207328"/>
                  </a:lnTo>
                  <a:lnTo>
                    <a:pt x="344" y="208038"/>
                  </a:lnTo>
                  <a:lnTo>
                    <a:pt x="345" y="208748"/>
                  </a:lnTo>
                  <a:lnTo>
                    <a:pt x="345" y="209458"/>
                  </a:lnTo>
                  <a:lnTo>
                    <a:pt x="346" y="210168"/>
                  </a:lnTo>
                  <a:lnTo>
                    <a:pt x="346" y="210878"/>
                  </a:lnTo>
                  <a:lnTo>
                    <a:pt x="347" y="211588"/>
                  </a:lnTo>
                  <a:lnTo>
                    <a:pt x="348" y="212298"/>
                  </a:lnTo>
                  <a:lnTo>
                    <a:pt x="348" y="213008"/>
                  </a:lnTo>
                  <a:lnTo>
                    <a:pt x="349" y="213718"/>
                  </a:lnTo>
                  <a:lnTo>
                    <a:pt x="349" y="214428"/>
                  </a:lnTo>
                  <a:lnTo>
                    <a:pt x="350" y="215138"/>
                  </a:lnTo>
                  <a:lnTo>
                    <a:pt x="351" y="215848"/>
                  </a:lnTo>
                  <a:lnTo>
                    <a:pt x="351" y="216558"/>
                  </a:lnTo>
                  <a:lnTo>
                    <a:pt x="352" y="217268"/>
                  </a:lnTo>
                  <a:lnTo>
                    <a:pt x="352" y="217978"/>
                  </a:lnTo>
                  <a:lnTo>
                    <a:pt x="352" y="218688"/>
                  </a:lnTo>
                  <a:lnTo>
                    <a:pt x="353" y="219398"/>
                  </a:lnTo>
                  <a:lnTo>
                    <a:pt x="353" y="220108"/>
                  </a:lnTo>
                  <a:lnTo>
                    <a:pt x="354" y="220818"/>
                  </a:lnTo>
                  <a:lnTo>
                    <a:pt x="354" y="221528"/>
                  </a:lnTo>
                  <a:lnTo>
                    <a:pt x="354" y="222238"/>
                  </a:lnTo>
                  <a:lnTo>
                    <a:pt x="355" y="222948"/>
                  </a:lnTo>
                  <a:lnTo>
                    <a:pt x="355" y="223659"/>
                  </a:lnTo>
                  <a:lnTo>
                    <a:pt x="355" y="224369"/>
                  </a:lnTo>
                  <a:lnTo>
                    <a:pt x="355" y="225079"/>
                  </a:lnTo>
                  <a:lnTo>
                    <a:pt x="355" y="225789"/>
                  </a:lnTo>
                  <a:lnTo>
                    <a:pt x="355" y="226499"/>
                  </a:lnTo>
                  <a:lnTo>
                    <a:pt x="355" y="227209"/>
                  </a:lnTo>
                  <a:lnTo>
                    <a:pt x="355" y="227919"/>
                  </a:lnTo>
                  <a:lnTo>
                    <a:pt x="355" y="228629"/>
                  </a:lnTo>
                  <a:lnTo>
                    <a:pt x="355" y="229339"/>
                  </a:lnTo>
                  <a:lnTo>
                    <a:pt x="355" y="230049"/>
                  </a:lnTo>
                  <a:lnTo>
                    <a:pt x="354" y="230759"/>
                  </a:lnTo>
                  <a:lnTo>
                    <a:pt x="354" y="231469"/>
                  </a:lnTo>
                  <a:lnTo>
                    <a:pt x="354" y="232179"/>
                  </a:lnTo>
                  <a:lnTo>
                    <a:pt x="353" y="232889"/>
                  </a:lnTo>
                  <a:lnTo>
                    <a:pt x="353" y="233599"/>
                  </a:lnTo>
                  <a:lnTo>
                    <a:pt x="352" y="234309"/>
                  </a:lnTo>
                  <a:lnTo>
                    <a:pt x="352" y="235019"/>
                  </a:lnTo>
                  <a:lnTo>
                    <a:pt x="351" y="235729"/>
                  </a:lnTo>
                  <a:lnTo>
                    <a:pt x="350" y="236439"/>
                  </a:lnTo>
                  <a:lnTo>
                    <a:pt x="350" y="237149"/>
                  </a:lnTo>
                  <a:lnTo>
                    <a:pt x="349" y="237859"/>
                  </a:lnTo>
                  <a:lnTo>
                    <a:pt x="348" y="238569"/>
                  </a:lnTo>
                  <a:lnTo>
                    <a:pt x="347" y="239279"/>
                  </a:lnTo>
                  <a:lnTo>
                    <a:pt x="346" y="239989"/>
                  </a:lnTo>
                  <a:lnTo>
                    <a:pt x="345" y="240699"/>
                  </a:lnTo>
                  <a:lnTo>
                    <a:pt x="343" y="241409"/>
                  </a:lnTo>
                  <a:lnTo>
                    <a:pt x="342" y="242119"/>
                  </a:lnTo>
                  <a:lnTo>
                    <a:pt x="341" y="242829"/>
                  </a:lnTo>
                  <a:lnTo>
                    <a:pt x="340" y="243539"/>
                  </a:lnTo>
                  <a:lnTo>
                    <a:pt x="338" y="244249"/>
                  </a:lnTo>
                  <a:lnTo>
                    <a:pt x="337" y="244959"/>
                  </a:lnTo>
                  <a:lnTo>
                    <a:pt x="335" y="245669"/>
                  </a:lnTo>
                  <a:lnTo>
                    <a:pt x="333" y="246379"/>
                  </a:lnTo>
                  <a:lnTo>
                    <a:pt x="332" y="247089"/>
                  </a:lnTo>
                  <a:lnTo>
                    <a:pt x="330" y="247799"/>
                  </a:lnTo>
                  <a:lnTo>
                    <a:pt x="328" y="248510"/>
                  </a:lnTo>
                  <a:lnTo>
                    <a:pt x="326" y="249220"/>
                  </a:lnTo>
                  <a:lnTo>
                    <a:pt x="324" y="249930"/>
                  </a:lnTo>
                  <a:lnTo>
                    <a:pt x="322" y="250640"/>
                  </a:lnTo>
                  <a:lnTo>
                    <a:pt x="320" y="251350"/>
                  </a:lnTo>
                  <a:lnTo>
                    <a:pt x="318" y="252060"/>
                  </a:lnTo>
                  <a:lnTo>
                    <a:pt x="316" y="252770"/>
                  </a:lnTo>
                  <a:lnTo>
                    <a:pt x="313" y="253480"/>
                  </a:lnTo>
                  <a:lnTo>
                    <a:pt x="311" y="254190"/>
                  </a:lnTo>
                  <a:lnTo>
                    <a:pt x="308" y="254900"/>
                  </a:lnTo>
                  <a:lnTo>
                    <a:pt x="306" y="255610"/>
                  </a:lnTo>
                  <a:lnTo>
                    <a:pt x="303" y="256320"/>
                  </a:lnTo>
                  <a:lnTo>
                    <a:pt x="301" y="257030"/>
                  </a:lnTo>
                  <a:lnTo>
                    <a:pt x="298" y="257740"/>
                  </a:lnTo>
                  <a:lnTo>
                    <a:pt x="295" y="258450"/>
                  </a:lnTo>
                  <a:lnTo>
                    <a:pt x="293" y="259160"/>
                  </a:lnTo>
                  <a:lnTo>
                    <a:pt x="290" y="259870"/>
                  </a:lnTo>
                  <a:lnTo>
                    <a:pt x="287" y="260580"/>
                  </a:lnTo>
                  <a:lnTo>
                    <a:pt x="284" y="261290"/>
                  </a:lnTo>
                  <a:lnTo>
                    <a:pt x="281" y="262000"/>
                  </a:lnTo>
                  <a:lnTo>
                    <a:pt x="278" y="262710"/>
                  </a:lnTo>
                  <a:lnTo>
                    <a:pt x="275" y="263420"/>
                  </a:lnTo>
                  <a:lnTo>
                    <a:pt x="272" y="264130"/>
                  </a:lnTo>
                  <a:lnTo>
                    <a:pt x="269" y="264840"/>
                  </a:lnTo>
                  <a:lnTo>
                    <a:pt x="266" y="265550"/>
                  </a:lnTo>
                  <a:lnTo>
                    <a:pt x="263" y="266260"/>
                  </a:lnTo>
                  <a:lnTo>
                    <a:pt x="259" y="266970"/>
                  </a:lnTo>
                  <a:lnTo>
                    <a:pt x="256" y="267680"/>
                  </a:lnTo>
                  <a:lnTo>
                    <a:pt x="253" y="268390"/>
                  </a:lnTo>
                  <a:lnTo>
                    <a:pt x="249" y="269100"/>
                  </a:lnTo>
                  <a:lnTo>
                    <a:pt x="246" y="269810"/>
                  </a:lnTo>
                  <a:lnTo>
                    <a:pt x="243" y="270520"/>
                  </a:lnTo>
                  <a:lnTo>
                    <a:pt x="239" y="271230"/>
                  </a:lnTo>
                  <a:lnTo>
                    <a:pt x="236" y="271940"/>
                  </a:lnTo>
                  <a:lnTo>
                    <a:pt x="232" y="272650"/>
                  </a:lnTo>
                  <a:lnTo>
                    <a:pt x="229" y="273361"/>
                  </a:lnTo>
                  <a:lnTo>
                    <a:pt x="225" y="274071"/>
                  </a:lnTo>
                  <a:lnTo>
                    <a:pt x="222" y="274781"/>
                  </a:lnTo>
                  <a:lnTo>
                    <a:pt x="218" y="275491"/>
                  </a:lnTo>
                  <a:lnTo>
                    <a:pt x="215" y="276201"/>
                  </a:lnTo>
                  <a:lnTo>
                    <a:pt x="211" y="276911"/>
                  </a:lnTo>
                  <a:lnTo>
                    <a:pt x="208" y="277621"/>
                  </a:lnTo>
                  <a:lnTo>
                    <a:pt x="204" y="278331"/>
                  </a:lnTo>
                  <a:lnTo>
                    <a:pt x="201" y="279041"/>
                  </a:lnTo>
                  <a:lnTo>
                    <a:pt x="197" y="279751"/>
                  </a:lnTo>
                  <a:lnTo>
                    <a:pt x="194" y="280461"/>
                  </a:lnTo>
                  <a:lnTo>
                    <a:pt x="190" y="281171"/>
                  </a:lnTo>
                  <a:lnTo>
                    <a:pt x="187" y="281881"/>
                  </a:lnTo>
                  <a:lnTo>
                    <a:pt x="183" y="282591"/>
                  </a:lnTo>
                  <a:lnTo>
                    <a:pt x="180" y="283301"/>
                  </a:lnTo>
                  <a:lnTo>
                    <a:pt x="176" y="284011"/>
                  </a:lnTo>
                  <a:lnTo>
                    <a:pt x="173" y="284721"/>
                  </a:lnTo>
                  <a:lnTo>
                    <a:pt x="169" y="285431"/>
                  </a:lnTo>
                  <a:lnTo>
                    <a:pt x="166" y="286141"/>
                  </a:lnTo>
                  <a:lnTo>
                    <a:pt x="163" y="286851"/>
                  </a:lnTo>
                  <a:lnTo>
                    <a:pt x="159" y="287561"/>
                  </a:lnTo>
                  <a:lnTo>
                    <a:pt x="156" y="288271"/>
                  </a:lnTo>
                  <a:lnTo>
                    <a:pt x="152" y="288981"/>
                  </a:lnTo>
                  <a:lnTo>
                    <a:pt x="149" y="289691"/>
                  </a:lnTo>
                  <a:lnTo>
                    <a:pt x="146" y="290401"/>
                  </a:lnTo>
                  <a:lnTo>
                    <a:pt x="143" y="291111"/>
                  </a:lnTo>
                  <a:lnTo>
                    <a:pt x="139" y="291821"/>
                  </a:lnTo>
                  <a:lnTo>
                    <a:pt x="136" y="292531"/>
                  </a:lnTo>
                  <a:lnTo>
                    <a:pt x="133" y="293241"/>
                  </a:lnTo>
                  <a:lnTo>
                    <a:pt x="130" y="293951"/>
                  </a:lnTo>
                  <a:lnTo>
                    <a:pt x="127" y="294661"/>
                  </a:lnTo>
                  <a:lnTo>
                    <a:pt x="124" y="295371"/>
                  </a:lnTo>
                  <a:lnTo>
                    <a:pt x="121" y="296081"/>
                  </a:lnTo>
                  <a:lnTo>
                    <a:pt x="118" y="296791"/>
                  </a:lnTo>
                  <a:lnTo>
                    <a:pt x="115" y="297501"/>
                  </a:lnTo>
                  <a:lnTo>
                    <a:pt x="112" y="298212"/>
                  </a:lnTo>
                  <a:lnTo>
                    <a:pt x="109" y="298922"/>
                  </a:lnTo>
                  <a:lnTo>
                    <a:pt x="106" y="299632"/>
                  </a:lnTo>
                  <a:lnTo>
                    <a:pt x="103" y="300342"/>
                  </a:lnTo>
                  <a:lnTo>
                    <a:pt x="100" y="301052"/>
                  </a:lnTo>
                  <a:lnTo>
                    <a:pt x="98" y="301762"/>
                  </a:lnTo>
                  <a:lnTo>
                    <a:pt x="95" y="302472"/>
                  </a:lnTo>
                  <a:lnTo>
                    <a:pt x="92" y="303182"/>
                  </a:lnTo>
                  <a:lnTo>
                    <a:pt x="90" y="303892"/>
                  </a:lnTo>
                  <a:lnTo>
                    <a:pt x="87" y="304602"/>
                  </a:lnTo>
                  <a:lnTo>
                    <a:pt x="85" y="305312"/>
                  </a:lnTo>
                  <a:lnTo>
                    <a:pt x="82" y="306022"/>
                  </a:lnTo>
                  <a:lnTo>
                    <a:pt x="80" y="306732"/>
                  </a:lnTo>
                  <a:lnTo>
                    <a:pt x="78" y="307442"/>
                  </a:lnTo>
                  <a:lnTo>
                    <a:pt x="75" y="308152"/>
                  </a:lnTo>
                  <a:lnTo>
                    <a:pt x="73" y="308862"/>
                  </a:lnTo>
                  <a:lnTo>
                    <a:pt x="71" y="309572"/>
                  </a:lnTo>
                  <a:lnTo>
                    <a:pt x="69" y="310282"/>
                  </a:lnTo>
                  <a:lnTo>
                    <a:pt x="66" y="310992"/>
                  </a:lnTo>
                  <a:lnTo>
                    <a:pt x="64" y="311702"/>
                  </a:lnTo>
                  <a:lnTo>
                    <a:pt x="62" y="312412"/>
                  </a:lnTo>
                  <a:lnTo>
                    <a:pt x="60" y="313122"/>
                  </a:lnTo>
                  <a:lnTo>
                    <a:pt x="58" y="313832"/>
                  </a:lnTo>
                  <a:lnTo>
                    <a:pt x="56" y="314542"/>
                  </a:lnTo>
                  <a:lnTo>
                    <a:pt x="55" y="315252"/>
                  </a:lnTo>
                  <a:lnTo>
                    <a:pt x="53" y="315962"/>
                  </a:lnTo>
                  <a:lnTo>
                    <a:pt x="51" y="316672"/>
                  </a:lnTo>
                  <a:lnTo>
                    <a:pt x="49" y="317382"/>
                  </a:lnTo>
                  <a:lnTo>
                    <a:pt x="47" y="318092"/>
                  </a:lnTo>
                  <a:lnTo>
                    <a:pt x="46" y="318802"/>
                  </a:lnTo>
                  <a:lnTo>
                    <a:pt x="44" y="319512"/>
                  </a:lnTo>
                  <a:lnTo>
                    <a:pt x="43" y="320222"/>
                  </a:lnTo>
                  <a:lnTo>
                    <a:pt x="41" y="320932"/>
                  </a:lnTo>
                  <a:lnTo>
                    <a:pt x="40" y="321642"/>
                  </a:lnTo>
                  <a:lnTo>
                    <a:pt x="38" y="322352"/>
                  </a:lnTo>
                  <a:lnTo>
                    <a:pt x="37" y="323063"/>
                  </a:lnTo>
                  <a:lnTo>
                    <a:pt x="35" y="323773"/>
                  </a:lnTo>
                  <a:lnTo>
                    <a:pt x="34" y="324483"/>
                  </a:lnTo>
                  <a:lnTo>
                    <a:pt x="33" y="325193"/>
                  </a:lnTo>
                  <a:lnTo>
                    <a:pt x="32" y="325903"/>
                  </a:lnTo>
                  <a:lnTo>
                    <a:pt x="30" y="326613"/>
                  </a:lnTo>
                  <a:lnTo>
                    <a:pt x="29" y="327323"/>
                  </a:lnTo>
                  <a:lnTo>
                    <a:pt x="28" y="328033"/>
                  </a:lnTo>
                  <a:lnTo>
                    <a:pt x="27" y="328743"/>
                  </a:lnTo>
                  <a:lnTo>
                    <a:pt x="26" y="329453"/>
                  </a:lnTo>
                  <a:lnTo>
                    <a:pt x="25" y="330163"/>
                  </a:lnTo>
                  <a:lnTo>
                    <a:pt x="24" y="330873"/>
                  </a:lnTo>
                  <a:lnTo>
                    <a:pt x="23" y="331583"/>
                  </a:lnTo>
                  <a:lnTo>
                    <a:pt x="22" y="332293"/>
                  </a:lnTo>
                  <a:lnTo>
                    <a:pt x="21" y="333003"/>
                  </a:lnTo>
                  <a:lnTo>
                    <a:pt x="20" y="333713"/>
                  </a:lnTo>
                  <a:lnTo>
                    <a:pt x="19" y="334423"/>
                  </a:lnTo>
                  <a:lnTo>
                    <a:pt x="18" y="335133"/>
                  </a:lnTo>
                  <a:lnTo>
                    <a:pt x="18" y="335843"/>
                  </a:lnTo>
                  <a:lnTo>
                    <a:pt x="17" y="336553"/>
                  </a:lnTo>
                  <a:lnTo>
                    <a:pt x="16" y="337263"/>
                  </a:lnTo>
                  <a:lnTo>
                    <a:pt x="15" y="337973"/>
                  </a:lnTo>
                  <a:lnTo>
                    <a:pt x="15" y="338683"/>
                  </a:lnTo>
                  <a:lnTo>
                    <a:pt x="14" y="339393"/>
                  </a:lnTo>
                  <a:lnTo>
                    <a:pt x="13" y="340103"/>
                  </a:lnTo>
                  <a:lnTo>
                    <a:pt x="13" y="340813"/>
                  </a:lnTo>
                  <a:lnTo>
                    <a:pt x="12" y="341523"/>
                  </a:lnTo>
                  <a:lnTo>
                    <a:pt x="12" y="342233"/>
                  </a:lnTo>
                  <a:lnTo>
                    <a:pt x="11" y="342943"/>
                  </a:lnTo>
                  <a:lnTo>
                    <a:pt x="11" y="343653"/>
                  </a:lnTo>
                  <a:lnTo>
                    <a:pt x="10" y="344363"/>
                  </a:lnTo>
                  <a:lnTo>
                    <a:pt x="10" y="345073"/>
                  </a:lnTo>
                  <a:lnTo>
                    <a:pt x="9" y="345783"/>
                  </a:lnTo>
                  <a:lnTo>
                    <a:pt x="9" y="346493"/>
                  </a:lnTo>
                  <a:lnTo>
                    <a:pt x="8" y="347203"/>
                  </a:lnTo>
                  <a:lnTo>
                    <a:pt x="8" y="347914"/>
                  </a:lnTo>
                  <a:lnTo>
                    <a:pt x="7" y="348624"/>
                  </a:lnTo>
                  <a:lnTo>
                    <a:pt x="7" y="349334"/>
                  </a:lnTo>
                  <a:lnTo>
                    <a:pt x="7" y="350044"/>
                  </a:lnTo>
                  <a:lnTo>
                    <a:pt x="6" y="350754"/>
                  </a:lnTo>
                  <a:lnTo>
                    <a:pt x="6" y="351464"/>
                  </a:lnTo>
                  <a:lnTo>
                    <a:pt x="6" y="352174"/>
                  </a:lnTo>
                  <a:lnTo>
                    <a:pt x="5" y="352884"/>
                  </a:lnTo>
                  <a:lnTo>
                    <a:pt x="5" y="353594"/>
                  </a:lnTo>
                  <a:lnTo>
                    <a:pt x="5" y="354304"/>
                  </a:lnTo>
                  <a:lnTo>
                    <a:pt x="5" y="355014"/>
                  </a:lnTo>
                  <a:lnTo>
                    <a:pt x="4" y="355724"/>
                  </a:lnTo>
                  <a:lnTo>
                    <a:pt x="4" y="356434"/>
                  </a:lnTo>
                  <a:lnTo>
                    <a:pt x="4" y="357144"/>
                  </a:lnTo>
                  <a:lnTo>
                    <a:pt x="4" y="357854"/>
                  </a:lnTo>
                  <a:lnTo>
                    <a:pt x="3" y="358564"/>
                  </a:lnTo>
                  <a:lnTo>
                    <a:pt x="3" y="359274"/>
                  </a:lnTo>
                  <a:lnTo>
                    <a:pt x="3" y="359984"/>
                  </a:lnTo>
                  <a:lnTo>
                    <a:pt x="3" y="360694"/>
                  </a:lnTo>
                  <a:lnTo>
                    <a:pt x="3" y="361404"/>
                  </a:lnTo>
                  <a:lnTo>
                    <a:pt x="2" y="362114"/>
                  </a:lnTo>
                  <a:lnTo>
                    <a:pt x="2" y="362824"/>
                  </a:lnTo>
                  <a:lnTo>
                    <a:pt x="0" y="362824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58" name="pl40"/>
            <p:cNvSpPr/>
            <p:nvPr/>
          </p:nvSpPr>
          <p:spPr>
            <a:xfrm>
              <a:off x="5525846" y="1861307"/>
              <a:ext cx="126" cy="1324733"/>
            </a:xfrm>
            <a:custGeom>
              <a:avLst/>
              <a:gdLst/>
              <a:ahLst/>
              <a:cxnLst/>
              <a:rect l="0" t="0" r="0" b="0"/>
              <a:pathLst>
                <a:path w="126" h="1324733">
                  <a:moveTo>
                    <a:pt x="126" y="1324733"/>
                  </a:moveTo>
                  <a:lnTo>
                    <a:pt x="125" y="1324733"/>
                  </a:lnTo>
                  <a:lnTo>
                    <a:pt x="125" y="1322140"/>
                  </a:lnTo>
                  <a:lnTo>
                    <a:pt x="125" y="1319548"/>
                  </a:lnTo>
                  <a:lnTo>
                    <a:pt x="125" y="1316955"/>
                  </a:lnTo>
                  <a:lnTo>
                    <a:pt x="125" y="1314363"/>
                  </a:lnTo>
                  <a:lnTo>
                    <a:pt x="125" y="1311771"/>
                  </a:lnTo>
                  <a:lnTo>
                    <a:pt x="125" y="1309178"/>
                  </a:lnTo>
                  <a:lnTo>
                    <a:pt x="125" y="1306586"/>
                  </a:lnTo>
                  <a:lnTo>
                    <a:pt x="125" y="1303993"/>
                  </a:lnTo>
                  <a:lnTo>
                    <a:pt x="125" y="1301401"/>
                  </a:lnTo>
                  <a:lnTo>
                    <a:pt x="125" y="1298808"/>
                  </a:lnTo>
                  <a:lnTo>
                    <a:pt x="125" y="1296216"/>
                  </a:lnTo>
                  <a:lnTo>
                    <a:pt x="125" y="1293624"/>
                  </a:lnTo>
                  <a:lnTo>
                    <a:pt x="125" y="1291031"/>
                  </a:lnTo>
                  <a:lnTo>
                    <a:pt x="125" y="1288439"/>
                  </a:lnTo>
                  <a:lnTo>
                    <a:pt x="125" y="1285846"/>
                  </a:lnTo>
                  <a:lnTo>
                    <a:pt x="125" y="1283254"/>
                  </a:lnTo>
                  <a:lnTo>
                    <a:pt x="125" y="1280661"/>
                  </a:lnTo>
                  <a:lnTo>
                    <a:pt x="124" y="1278069"/>
                  </a:lnTo>
                  <a:lnTo>
                    <a:pt x="124" y="1275476"/>
                  </a:lnTo>
                  <a:lnTo>
                    <a:pt x="124" y="1272884"/>
                  </a:lnTo>
                  <a:lnTo>
                    <a:pt x="124" y="1270292"/>
                  </a:lnTo>
                  <a:lnTo>
                    <a:pt x="124" y="1267699"/>
                  </a:lnTo>
                  <a:lnTo>
                    <a:pt x="124" y="1265107"/>
                  </a:lnTo>
                  <a:lnTo>
                    <a:pt x="124" y="1262514"/>
                  </a:lnTo>
                  <a:lnTo>
                    <a:pt x="124" y="1259922"/>
                  </a:lnTo>
                  <a:lnTo>
                    <a:pt x="124" y="1257329"/>
                  </a:lnTo>
                  <a:lnTo>
                    <a:pt x="123" y="1254737"/>
                  </a:lnTo>
                  <a:lnTo>
                    <a:pt x="123" y="1252145"/>
                  </a:lnTo>
                  <a:lnTo>
                    <a:pt x="123" y="1249552"/>
                  </a:lnTo>
                  <a:lnTo>
                    <a:pt x="123" y="1246960"/>
                  </a:lnTo>
                  <a:lnTo>
                    <a:pt x="123" y="1244367"/>
                  </a:lnTo>
                  <a:lnTo>
                    <a:pt x="123" y="1241775"/>
                  </a:lnTo>
                  <a:lnTo>
                    <a:pt x="123" y="1239182"/>
                  </a:lnTo>
                  <a:lnTo>
                    <a:pt x="122" y="1236590"/>
                  </a:lnTo>
                  <a:lnTo>
                    <a:pt x="122" y="1233998"/>
                  </a:lnTo>
                  <a:lnTo>
                    <a:pt x="122" y="1231405"/>
                  </a:lnTo>
                  <a:lnTo>
                    <a:pt x="122" y="1228813"/>
                  </a:lnTo>
                  <a:lnTo>
                    <a:pt x="122" y="1226220"/>
                  </a:lnTo>
                  <a:lnTo>
                    <a:pt x="121" y="1223628"/>
                  </a:lnTo>
                  <a:lnTo>
                    <a:pt x="121" y="1221035"/>
                  </a:lnTo>
                  <a:lnTo>
                    <a:pt x="121" y="1218443"/>
                  </a:lnTo>
                  <a:lnTo>
                    <a:pt x="121" y="1215851"/>
                  </a:lnTo>
                  <a:lnTo>
                    <a:pt x="120" y="1213258"/>
                  </a:lnTo>
                  <a:lnTo>
                    <a:pt x="120" y="1210666"/>
                  </a:lnTo>
                  <a:lnTo>
                    <a:pt x="120" y="1208073"/>
                  </a:lnTo>
                  <a:lnTo>
                    <a:pt x="120" y="1205481"/>
                  </a:lnTo>
                  <a:lnTo>
                    <a:pt x="119" y="1202888"/>
                  </a:lnTo>
                  <a:lnTo>
                    <a:pt x="119" y="1200296"/>
                  </a:lnTo>
                  <a:lnTo>
                    <a:pt x="119" y="1197703"/>
                  </a:lnTo>
                  <a:lnTo>
                    <a:pt x="119" y="1195111"/>
                  </a:lnTo>
                  <a:lnTo>
                    <a:pt x="118" y="1192519"/>
                  </a:lnTo>
                  <a:lnTo>
                    <a:pt x="118" y="1189926"/>
                  </a:lnTo>
                  <a:lnTo>
                    <a:pt x="118" y="1187334"/>
                  </a:lnTo>
                  <a:lnTo>
                    <a:pt x="117" y="1184741"/>
                  </a:lnTo>
                  <a:lnTo>
                    <a:pt x="117" y="1182149"/>
                  </a:lnTo>
                  <a:lnTo>
                    <a:pt x="117" y="1179556"/>
                  </a:lnTo>
                  <a:lnTo>
                    <a:pt x="116" y="1176964"/>
                  </a:lnTo>
                  <a:lnTo>
                    <a:pt x="116" y="1174372"/>
                  </a:lnTo>
                  <a:lnTo>
                    <a:pt x="115" y="1171779"/>
                  </a:lnTo>
                  <a:lnTo>
                    <a:pt x="115" y="1169187"/>
                  </a:lnTo>
                  <a:lnTo>
                    <a:pt x="115" y="1166594"/>
                  </a:lnTo>
                  <a:lnTo>
                    <a:pt x="114" y="1164002"/>
                  </a:lnTo>
                  <a:lnTo>
                    <a:pt x="114" y="1161409"/>
                  </a:lnTo>
                  <a:lnTo>
                    <a:pt x="113" y="1158817"/>
                  </a:lnTo>
                  <a:lnTo>
                    <a:pt x="113" y="1156225"/>
                  </a:lnTo>
                  <a:lnTo>
                    <a:pt x="112" y="1153632"/>
                  </a:lnTo>
                  <a:lnTo>
                    <a:pt x="112" y="1151040"/>
                  </a:lnTo>
                  <a:lnTo>
                    <a:pt x="111" y="1148447"/>
                  </a:lnTo>
                  <a:lnTo>
                    <a:pt x="111" y="1145855"/>
                  </a:lnTo>
                  <a:lnTo>
                    <a:pt x="110" y="1143262"/>
                  </a:lnTo>
                  <a:lnTo>
                    <a:pt x="110" y="1140670"/>
                  </a:lnTo>
                  <a:lnTo>
                    <a:pt x="109" y="1138078"/>
                  </a:lnTo>
                  <a:lnTo>
                    <a:pt x="109" y="1135485"/>
                  </a:lnTo>
                  <a:lnTo>
                    <a:pt x="108" y="1132893"/>
                  </a:lnTo>
                  <a:lnTo>
                    <a:pt x="108" y="1130300"/>
                  </a:lnTo>
                  <a:lnTo>
                    <a:pt x="107" y="1127708"/>
                  </a:lnTo>
                  <a:lnTo>
                    <a:pt x="107" y="1125115"/>
                  </a:lnTo>
                  <a:lnTo>
                    <a:pt x="106" y="1122523"/>
                  </a:lnTo>
                  <a:lnTo>
                    <a:pt x="106" y="1119931"/>
                  </a:lnTo>
                  <a:lnTo>
                    <a:pt x="105" y="1117338"/>
                  </a:lnTo>
                  <a:lnTo>
                    <a:pt x="104" y="1114746"/>
                  </a:lnTo>
                  <a:lnTo>
                    <a:pt x="104" y="1112153"/>
                  </a:lnTo>
                  <a:lnTo>
                    <a:pt x="103" y="1109561"/>
                  </a:lnTo>
                  <a:lnTo>
                    <a:pt x="103" y="1106968"/>
                  </a:lnTo>
                  <a:lnTo>
                    <a:pt x="102" y="1104376"/>
                  </a:lnTo>
                  <a:lnTo>
                    <a:pt x="101" y="1101783"/>
                  </a:lnTo>
                  <a:lnTo>
                    <a:pt x="101" y="1099191"/>
                  </a:lnTo>
                  <a:lnTo>
                    <a:pt x="100" y="1096599"/>
                  </a:lnTo>
                  <a:lnTo>
                    <a:pt x="99" y="1094006"/>
                  </a:lnTo>
                  <a:lnTo>
                    <a:pt x="99" y="1091414"/>
                  </a:lnTo>
                  <a:lnTo>
                    <a:pt x="98" y="1088821"/>
                  </a:lnTo>
                  <a:lnTo>
                    <a:pt x="97" y="1086229"/>
                  </a:lnTo>
                  <a:lnTo>
                    <a:pt x="97" y="1083636"/>
                  </a:lnTo>
                  <a:lnTo>
                    <a:pt x="96" y="1081044"/>
                  </a:lnTo>
                  <a:lnTo>
                    <a:pt x="96" y="1078452"/>
                  </a:lnTo>
                  <a:lnTo>
                    <a:pt x="95" y="1075859"/>
                  </a:lnTo>
                  <a:lnTo>
                    <a:pt x="94" y="1073267"/>
                  </a:lnTo>
                  <a:lnTo>
                    <a:pt x="94" y="1070674"/>
                  </a:lnTo>
                  <a:lnTo>
                    <a:pt x="93" y="1068082"/>
                  </a:lnTo>
                  <a:lnTo>
                    <a:pt x="92" y="1065489"/>
                  </a:lnTo>
                  <a:lnTo>
                    <a:pt x="92" y="1062897"/>
                  </a:lnTo>
                  <a:lnTo>
                    <a:pt x="91" y="1060305"/>
                  </a:lnTo>
                  <a:lnTo>
                    <a:pt x="90" y="1057712"/>
                  </a:lnTo>
                  <a:lnTo>
                    <a:pt x="90" y="1055120"/>
                  </a:lnTo>
                  <a:lnTo>
                    <a:pt x="89" y="1052527"/>
                  </a:lnTo>
                  <a:lnTo>
                    <a:pt x="88" y="1049935"/>
                  </a:lnTo>
                  <a:lnTo>
                    <a:pt x="88" y="1047342"/>
                  </a:lnTo>
                  <a:lnTo>
                    <a:pt x="87" y="1044750"/>
                  </a:lnTo>
                  <a:lnTo>
                    <a:pt x="86" y="1042158"/>
                  </a:lnTo>
                  <a:lnTo>
                    <a:pt x="86" y="1039565"/>
                  </a:lnTo>
                  <a:lnTo>
                    <a:pt x="85" y="1036973"/>
                  </a:lnTo>
                  <a:lnTo>
                    <a:pt x="85" y="1034380"/>
                  </a:lnTo>
                  <a:lnTo>
                    <a:pt x="84" y="1031788"/>
                  </a:lnTo>
                  <a:lnTo>
                    <a:pt x="83" y="1029195"/>
                  </a:lnTo>
                  <a:lnTo>
                    <a:pt x="83" y="1026603"/>
                  </a:lnTo>
                  <a:lnTo>
                    <a:pt x="82" y="1024010"/>
                  </a:lnTo>
                  <a:lnTo>
                    <a:pt x="82" y="1021418"/>
                  </a:lnTo>
                  <a:lnTo>
                    <a:pt x="81" y="1018826"/>
                  </a:lnTo>
                  <a:lnTo>
                    <a:pt x="81" y="1016233"/>
                  </a:lnTo>
                  <a:lnTo>
                    <a:pt x="80" y="1013641"/>
                  </a:lnTo>
                  <a:lnTo>
                    <a:pt x="79" y="1011048"/>
                  </a:lnTo>
                  <a:lnTo>
                    <a:pt x="79" y="1008456"/>
                  </a:lnTo>
                  <a:lnTo>
                    <a:pt x="78" y="1005863"/>
                  </a:lnTo>
                  <a:lnTo>
                    <a:pt x="78" y="1003271"/>
                  </a:lnTo>
                  <a:lnTo>
                    <a:pt x="77" y="1000679"/>
                  </a:lnTo>
                  <a:lnTo>
                    <a:pt x="77" y="998086"/>
                  </a:lnTo>
                  <a:lnTo>
                    <a:pt x="77" y="995494"/>
                  </a:lnTo>
                  <a:lnTo>
                    <a:pt x="76" y="992901"/>
                  </a:lnTo>
                  <a:lnTo>
                    <a:pt x="76" y="990309"/>
                  </a:lnTo>
                  <a:lnTo>
                    <a:pt x="75" y="987716"/>
                  </a:lnTo>
                  <a:lnTo>
                    <a:pt x="75" y="985124"/>
                  </a:lnTo>
                  <a:lnTo>
                    <a:pt x="74" y="982532"/>
                  </a:lnTo>
                  <a:lnTo>
                    <a:pt x="74" y="979939"/>
                  </a:lnTo>
                  <a:lnTo>
                    <a:pt x="74" y="977347"/>
                  </a:lnTo>
                  <a:lnTo>
                    <a:pt x="73" y="974754"/>
                  </a:lnTo>
                  <a:lnTo>
                    <a:pt x="73" y="972162"/>
                  </a:lnTo>
                  <a:lnTo>
                    <a:pt x="73" y="969569"/>
                  </a:lnTo>
                  <a:lnTo>
                    <a:pt x="72" y="966977"/>
                  </a:lnTo>
                  <a:lnTo>
                    <a:pt x="72" y="964385"/>
                  </a:lnTo>
                  <a:lnTo>
                    <a:pt x="72" y="961792"/>
                  </a:lnTo>
                  <a:lnTo>
                    <a:pt x="71" y="959200"/>
                  </a:lnTo>
                  <a:lnTo>
                    <a:pt x="71" y="956607"/>
                  </a:lnTo>
                  <a:lnTo>
                    <a:pt x="71" y="954015"/>
                  </a:lnTo>
                  <a:lnTo>
                    <a:pt x="70" y="951422"/>
                  </a:lnTo>
                  <a:lnTo>
                    <a:pt x="70" y="948830"/>
                  </a:lnTo>
                  <a:lnTo>
                    <a:pt x="70" y="946237"/>
                  </a:lnTo>
                  <a:lnTo>
                    <a:pt x="70" y="943645"/>
                  </a:lnTo>
                  <a:lnTo>
                    <a:pt x="70" y="941053"/>
                  </a:lnTo>
                  <a:lnTo>
                    <a:pt x="69" y="938460"/>
                  </a:lnTo>
                  <a:lnTo>
                    <a:pt x="69" y="935868"/>
                  </a:lnTo>
                  <a:lnTo>
                    <a:pt x="69" y="933275"/>
                  </a:lnTo>
                  <a:lnTo>
                    <a:pt x="69" y="930683"/>
                  </a:lnTo>
                  <a:lnTo>
                    <a:pt x="69" y="928090"/>
                  </a:lnTo>
                  <a:lnTo>
                    <a:pt x="68" y="925498"/>
                  </a:lnTo>
                  <a:lnTo>
                    <a:pt x="68" y="922906"/>
                  </a:lnTo>
                  <a:lnTo>
                    <a:pt x="68" y="920313"/>
                  </a:lnTo>
                  <a:lnTo>
                    <a:pt x="68" y="917721"/>
                  </a:lnTo>
                  <a:lnTo>
                    <a:pt x="68" y="915128"/>
                  </a:lnTo>
                  <a:lnTo>
                    <a:pt x="68" y="912536"/>
                  </a:lnTo>
                  <a:lnTo>
                    <a:pt x="68" y="909943"/>
                  </a:lnTo>
                  <a:lnTo>
                    <a:pt x="67" y="907351"/>
                  </a:lnTo>
                  <a:lnTo>
                    <a:pt x="67" y="904759"/>
                  </a:lnTo>
                  <a:lnTo>
                    <a:pt x="67" y="902166"/>
                  </a:lnTo>
                  <a:lnTo>
                    <a:pt x="67" y="899574"/>
                  </a:lnTo>
                  <a:lnTo>
                    <a:pt x="67" y="896981"/>
                  </a:lnTo>
                  <a:lnTo>
                    <a:pt x="67" y="894389"/>
                  </a:lnTo>
                  <a:lnTo>
                    <a:pt x="67" y="891796"/>
                  </a:lnTo>
                  <a:lnTo>
                    <a:pt x="67" y="889204"/>
                  </a:lnTo>
                  <a:lnTo>
                    <a:pt x="67" y="886612"/>
                  </a:lnTo>
                  <a:lnTo>
                    <a:pt x="67" y="884019"/>
                  </a:lnTo>
                  <a:lnTo>
                    <a:pt x="67" y="881427"/>
                  </a:lnTo>
                  <a:lnTo>
                    <a:pt x="67" y="878834"/>
                  </a:lnTo>
                  <a:lnTo>
                    <a:pt x="66" y="876242"/>
                  </a:lnTo>
                  <a:lnTo>
                    <a:pt x="66" y="873649"/>
                  </a:lnTo>
                  <a:lnTo>
                    <a:pt x="66" y="871057"/>
                  </a:lnTo>
                  <a:lnTo>
                    <a:pt x="66" y="868465"/>
                  </a:lnTo>
                  <a:lnTo>
                    <a:pt x="66" y="865872"/>
                  </a:lnTo>
                  <a:lnTo>
                    <a:pt x="66" y="863280"/>
                  </a:lnTo>
                  <a:lnTo>
                    <a:pt x="66" y="860687"/>
                  </a:lnTo>
                  <a:lnTo>
                    <a:pt x="66" y="858095"/>
                  </a:lnTo>
                  <a:lnTo>
                    <a:pt x="66" y="855502"/>
                  </a:lnTo>
                  <a:lnTo>
                    <a:pt x="66" y="852910"/>
                  </a:lnTo>
                  <a:lnTo>
                    <a:pt x="66" y="850317"/>
                  </a:lnTo>
                  <a:lnTo>
                    <a:pt x="66" y="847725"/>
                  </a:lnTo>
                  <a:lnTo>
                    <a:pt x="66" y="845133"/>
                  </a:lnTo>
                  <a:lnTo>
                    <a:pt x="66" y="842540"/>
                  </a:lnTo>
                  <a:lnTo>
                    <a:pt x="65" y="839948"/>
                  </a:lnTo>
                  <a:lnTo>
                    <a:pt x="65" y="837355"/>
                  </a:lnTo>
                  <a:lnTo>
                    <a:pt x="65" y="834763"/>
                  </a:lnTo>
                  <a:lnTo>
                    <a:pt x="65" y="832170"/>
                  </a:lnTo>
                  <a:lnTo>
                    <a:pt x="65" y="829578"/>
                  </a:lnTo>
                  <a:lnTo>
                    <a:pt x="65" y="826986"/>
                  </a:lnTo>
                  <a:lnTo>
                    <a:pt x="65" y="824393"/>
                  </a:lnTo>
                  <a:lnTo>
                    <a:pt x="65" y="821801"/>
                  </a:lnTo>
                  <a:lnTo>
                    <a:pt x="65" y="819208"/>
                  </a:lnTo>
                  <a:lnTo>
                    <a:pt x="65" y="816616"/>
                  </a:lnTo>
                  <a:lnTo>
                    <a:pt x="64" y="814023"/>
                  </a:lnTo>
                  <a:lnTo>
                    <a:pt x="64" y="811431"/>
                  </a:lnTo>
                  <a:lnTo>
                    <a:pt x="64" y="808839"/>
                  </a:lnTo>
                  <a:lnTo>
                    <a:pt x="64" y="806246"/>
                  </a:lnTo>
                  <a:lnTo>
                    <a:pt x="64" y="803654"/>
                  </a:lnTo>
                  <a:lnTo>
                    <a:pt x="64" y="801061"/>
                  </a:lnTo>
                  <a:lnTo>
                    <a:pt x="64" y="798469"/>
                  </a:lnTo>
                  <a:lnTo>
                    <a:pt x="63" y="795876"/>
                  </a:lnTo>
                  <a:lnTo>
                    <a:pt x="63" y="793284"/>
                  </a:lnTo>
                  <a:lnTo>
                    <a:pt x="63" y="790692"/>
                  </a:lnTo>
                  <a:lnTo>
                    <a:pt x="63" y="788099"/>
                  </a:lnTo>
                  <a:lnTo>
                    <a:pt x="63" y="785507"/>
                  </a:lnTo>
                  <a:lnTo>
                    <a:pt x="63" y="782914"/>
                  </a:lnTo>
                  <a:lnTo>
                    <a:pt x="62" y="780322"/>
                  </a:lnTo>
                  <a:lnTo>
                    <a:pt x="62" y="777729"/>
                  </a:lnTo>
                  <a:lnTo>
                    <a:pt x="62" y="775137"/>
                  </a:lnTo>
                  <a:lnTo>
                    <a:pt x="62" y="772544"/>
                  </a:lnTo>
                  <a:lnTo>
                    <a:pt x="62" y="769952"/>
                  </a:lnTo>
                  <a:lnTo>
                    <a:pt x="62" y="767360"/>
                  </a:lnTo>
                  <a:lnTo>
                    <a:pt x="61" y="764767"/>
                  </a:lnTo>
                  <a:lnTo>
                    <a:pt x="61" y="762175"/>
                  </a:lnTo>
                  <a:lnTo>
                    <a:pt x="61" y="759582"/>
                  </a:lnTo>
                  <a:lnTo>
                    <a:pt x="61" y="756990"/>
                  </a:lnTo>
                  <a:lnTo>
                    <a:pt x="61" y="754397"/>
                  </a:lnTo>
                  <a:lnTo>
                    <a:pt x="60" y="751805"/>
                  </a:lnTo>
                  <a:lnTo>
                    <a:pt x="60" y="749213"/>
                  </a:lnTo>
                  <a:lnTo>
                    <a:pt x="60" y="746620"/>
                  </a:lnTo>
                  <a:lnTo>
                    <a:pt x="60" y="744028"/>
                  </a:lnTo>
                  <a:lnTo>
                    <a:pt x="59" y="741435"/>
                  </a:lnTo>
                  <a:lnTo>
                    <a:pt x="59" y="738843"/>
                  </a:lnTo>
                  <a:lnTo>
                    <a:pt x="59" y="736250"/>
                  </a:lnTo>
                  <a:lnTo>
                    <a:pt x="59" y="733658"/>
                  </a:lnTo>
                  <a:lnTo>
                    <a:pt x="58" y="731066"/>
                  </a:lnTo>
                  <a:lnTo>
                    <a:pt x="58" y="728473"/>
                  </a:lnTo>
                  <a:lnTo>
                    <a:pt x="58" y="725881"/>
                  </a:lnTo>
                  <a:lnTo>
                    <a:pt x="57" y="723288"/>
                  </a:lnTo>
                  <a:lnTo>
                    <a:pt x="57" y="720696"/>
                  </a:lnTo>
                  <a:lnTo>
                    <a:pt x="57" y="718103"/>
                  </a:lnTo>
                  <a:lnTo>
                    <a:pt x="56" y="715511"/>
                  </a:lnTo>
                  <a:lnTo>
                    <a:pt x="56" y="712919"/>
                  </a:lnTo>
                  <a:lnTo>
                    <a:pt x="56" y="710326"/>
                  </a:lnTo>
                  <a:lnTo>
                    <a:pt x="55" y="707734"/>
                  </a:lnTo>
                  <a:lnTo>
                    <a:pt x="55" y="705141"/>
                  </a:lnTo>
                  <a:lnTo>
                    <a:pt x="55" y="702549"/>
                  </a:lnTo>
                  <a:lnTo>
                    <a:pt x="54" y="699956"/>
                  </a:lnTo>
                  <a:lnTo>
                    <a:pt x="54" y="697364"/>
                  </a:lnTo>
                  <a:lnTo>
                    <a:pt x="54" y="694772"/>
                  </a:lnTo>
                  <a:lnTo>
                    <a:pt x="53" y="692179"/>
                  </a:lnTo>
                  <a:lnTo>
                    <a:pt x="53" y="689587"/>
                  </a:lnTo>
                  <a:lnTo>
                    <a:pt x="52" y="686994"/>
                  </a:lnTo>
                  <a:lnTo>
                    <a:pt x="52" y="684402"/>
                  </a:lnTo>
                  <a:lnTo>
                    <a:pt x="51" y="681809"/>
                  </a:lnTo>
                  <a:lnTo>
                    <a:pt x="51" y="679217"/>
                  </a:lnTo>
                  <a:lnTo>
                    <a:pt x="51" y="676624"/>
                  </a:lnTo>
                  <a:lnTo>
                    <a:pt x="50" y="674032"/>
                  </a:lnTo>
                  <a:lnTo>
                    <a:pt x="50" y="671440"/>
                  </a:lnTo>
                  <a:lnTo>
                    <a:pt x="49" y="668847"/>
                  </a:lnTo>
                  <a:lnTo>
                    <a:pt x="48" y="666255"/>
                  </a:lnTo>
                  <a:lnTo>
                    <a:pt x="48" y="663662"/>
                  </a:lnTo>
                  <a:lnTo>
                    <a:pt x="47" y="661070"/>
                  </a:lnTo>
                  <a:lnTo>
                    <a:pt x="47" y="658477"/>
                  </a:lnTo>
                  <a:lnTo>
                    <a:pt x="46" y="655885"/>
                  </a:lnTo>
                  <a:lnTo>
                    <a:pt x="46" y="653293"/>
                  </a:lnTo>
                  <a:lnTo>
                    <a:pt x="45" y="650700"/>
                  </a:lnTo>
                  <a:lnTo>
                    <a:pt x="44" y="648108"/>
                  </a:lnTo>
                  <a:lnTo>
                    <a:pt x="44" y="645515"/>
                  </a:lnTo>
                  <a:lnTo>
                    <a:pt x="43" y="642923"/>
                  </a:lnTo>
                  <a:lnTo>
                    <a:pt x="42" y="640330"/>
                  </a:lnTo>
                  <a:lnTo>
                    <a:pt x="42" y="637738"/>
                  </a:lnTo>
                  <a:lnTo>
                    <a:pt x="41" y="635146"/>
                  </a:lnTo>
                  <a:lnTo>
                    <a:pt x="40" y="632553"/>
                  </a:lnTo>
                  <a:lnTo>
                    <a:pt x="40" y="629961"/>
                  </a:lnTo>
                  <a:lnTo>
                    <a:pt x="39" y="627368"/>
                  </a:lnTo>
                  <a:lnTo>
                    <a:pt x="38" y="624776"/>
                  </a:lnTo>
                  <a:lnTo>
                    <a:pt x="37" y="622183"/>
                  </a:lnTo>
                  <a:lnTo>
                    <a:pt x="37" y="619591"/>
                  </a:lnTo>
                  <a:lnTo>
                    <a:pt x="36" y="616999"/>
                  </a:lnTo>
                  <a:lnTo>
                    <a:pt x="35" y="614406"/>
                  </a:lnTo>
                  <a:lnTo>
                    <a:pt x="34" y="611814"/>
                  </a:lnTo>
                  <a:lnTo>
                    <a:pt x="34" y="609221"/>
                  </a:lnTo>
                  <a:lnTo>
                    <a:pt x="33" y="606629"/>
                  </a:lnTo>
                  <a:lnTo>
                    <a:pt x="32" y="604036"/>
                  </a:lnTo>
                  <a:lnTo>
                    <a:pt x="31" y="601444"/>
                  </a:lnTo>
                  <a:lnTo>
                    <a:pt x="30" y="598851"/>
                  </a:lnTo>
                  <a:lnTo>
                    <a:pt x="29" y="596259"/>
                  </a:lnTo>
                  <a:lnTo>
                    <a:pt x="29" y="593667"/>
                  </a:lnTo>
                  <a:lnTo>
                    <a:pt x="28" y="591074"/>
                  </a:lnTo>
                  <a:lnTo>
                    <a:pt x="27" y="588482"/>
                  </a:lnTo>
                  <a:lnTo>
                    <a:pt x="26" y="585889"/>
                  </a:lnTo>
                  <a:lnTo>
                    <a:pt x="25" y="583297"/>
                  </a:lnTo>
                  <a:lnTo>
                    <a:pt x="24" y="580704"/>
                  </a:lnTo>
                  <a:lnTo>
                    <a:pt x="23" y="578112"/>
                  </a:lnTo>
                  <a:lnTo>
                    <a:pt x="22" y="575520"/>
                  </a:lnTo>
                  <a:lnTo>
                    <a:pt x="22" y="572927"/>
                  </a:lnTo>
                  <a:lnTo>
                    <a:pt x="21" y="570335"/>
                  </a:lnTo>
                  <a:lnTo>
                    <a:pt x="20" y="567742"/>
                  </a:lnTo>
                  <a:lnTo>
                    <a:pt x="19" y="565150"/>
                  </a:lnTo>
                  <a:lnTo>
                    <a:pt x="18" y="562557"/>
                  </a:lnTo>
                  <a:lnTo>
                    <a:pt x="17" y="559965"/>
                  </a:lnTo>
                  <a:lnTo>
                    <a:pt x="16" y="557373"/>
                  </a:lnTo>
                  <a:lnTo>
                    <a:pt x="16" y="554780"/>
                  </a:lnTo>
                  <a:lnTo>
                    <a:pt x="15" y="552188"/>
                  </a:lnTo>
                  <a:lnTo>
                    <a:pt x="14" y="549595"/>
                  </a:lnTo>
                  <a:lnTo>
                    <a:pt x="13" y="547003"/>
                  </a:lnTo>
                  <a:lnTo>
                    <a:pt x="12" y="544410"/>
                  </a:lnTo>
                  <a:lnTo>
                    <a:pt x="12" y="541818"/>
                  </a:lnTo>
                  <a:lnTo>
                    <a:pt x="11" y="539226"/>
                  </a:lnTo>
                  <a:lnTo>
                    <a:pt x="10" y="536633"/>
                  </a:lnTo>
                  <a:lnTo>
                    <a:pt x="9" y="534041"/>
                  </a:lnTo>
                  <a:lnTo>
                    <a:pt x="9" y="531448"/>
                  </a:lnTo>
                  <a:lnTo>
                    <a:pt x="8" y="528856"/>
                  </a:lnTo>
                  <a:lnTo>
                    <a:pt x="7" y="526263"/>
                  </a:lnTo>
                  <a:lnTo>
                    <a:pt x="7" y="523671"/>
                  </a:lnTo>
                  <a:lnTo>
                    <a:pt x="6" y="521079"/>
                  </a:lnTo>
                  <a:lnTo>
                    <a:pt x="6" y="518486"/>
                  </a:lnTo>
                  <a:lnTo>
                    <a:pt x="5" y="515894"/>
                  </a:lnTo>
                  <a:lnTo>
                    <a:pt x="4" y="513301"/>
                  </a:lnTo>
                  <a:lnTo>
                    <a:pt x="4" y="510709"/>
                  </a:lnTo>
                  <a:lnTo>
                    <a:pt x="3" y="508116"/>
                  </a:lnTo>
                  <a:lnTo>
                    <a:pt x="3" y="505524"/>
                  </a:lnTo>
                  <a:lnTo>
                    <a:pt x="2" y="502931"/>
                  </a:lnTo>
                  <a:lnTo>
                    <a:pt x="2" y="500339"/>
                  </a:lnTo>
                  <a:lnTo>
                    <a:pt x="2" y="497747"/>
                  </a:lnTo>
                  <a:lnTo>
                    <a:pt x="1" y="495154"/>
                  </a:lnTo>
                  <a:lnTo>
                    <a:pt x="1" y="492562"/>
                  </a:lnTo>
                  <a:lnTo>
                    <a:pt x="1" y="489969"/>
                  </a:lnTo>
                  <a:lnTo>
                    <a:pt x="0" y="487377"/>
                  </a:lnTo>
                  <a:lnTo>
                    <a:pt x="0" y="484784"/>
                  </a:lnTo>
                  <a:lnTo>
                    <a:pt x="0" y="482192"/>
                  </a:lnTo>
                  <a:lnTo>
                    <a:pt x="0" y="479600"/>
                  </a:lnTo>
                  <a:lnTo>
                    <a:pt x="0" y="477007"/>
                  </a:lnTo>
                  <a:lnTo>
                    <a:pt x="0" y="474415"/>
                  </a:lnTo>
                  <a:lnTo>
                    <a:pt x="0" y="471822"/>
                  </a:lnTo>
                  <a:lnTo>
                    <a:pt x="0" y="469230"/>
                  </a:lnTo>
                  <a:lnTo>
                    <a:pt x="0" y="466637"/>
                  </a:lnTo>
                  <a:lnTo>
                    <a:pt x="0" y="464045"/>
                  </a:lnTo>
                  <a:lnTo>
                    <a:pt x="0" y="461453"/>
                  </a:lnTo>
                  <a:lnTo>
                    <a:pt x="0" y="458860"/>
                  </a:lnTo>
                  <a:lnTo>
                    <a:pt x="0" y="456268"/>
                  </a:lnTo>
                  <a:lnTo>
                    <a:pt x="0" y="453675"/>
                  </a:lnTo>
                  <a:lnTo>
                    <a:pt x="0" y="451083"/>
                  </a:lnTo>
                  <a:lnTo>
                    <a:pt x="1" y="448490"/>
                  </a:lnTo>
                  <a:lnTo>
                    <a:pt x="1" y="445898"/>
                  </a:lnTo>
                  <a:lnTo>
                    <a:pt x="1" y="443306"/>
                  </a:lnTo>
                  <a:lnTo>
                    <a:pt x="2" y="440713"/>
                  </a:lnTo>
                  <a:lnTo>
                    <a:pt x="2" y="438121"/>
                  </a:lnTo>
                  <a:lnTo>
                    <a:pt x="2" y="435528"/>
                  </a:lnTo>
                  <a:lnTo>
                    <a:pt x="3" y="432936"/>
                  </a:lnTo>
                  <a:lnTo>
                    <a:pt x="3" y="430343"/>
                  </a:lnTo>
                  <a:lnTo>
                    <a:pt x="4" y="427751"/>
                  </a:lnTo>
                  <a:lnTo>
                    <a:pt x="5" y="425158"/>
                  </a:lnTo>
                  <a:lnTo>
                    <a:pt x="5" y="422566"/>
                  </a:lnTo>
                  <a:lnTo>
                    <a:pt x="6" y="419974"/>
                  </a:lnTo>
                  <a:lnTo>
                    <a:pt x="7" y="417381"/>
                  </a:lnTo>
                  <a:lnTo>
                    <a:pt x="7" y="414789"/>
                  </a:lnTo>
                  <a:lnTo>
                    <a:pt x="8" y="412196"/>
                  </a:lnTo>
                  <a:lnTo>
                    <a:pt x="9" y="409604"/>
                  </a:lnTo>
                  <a:lnTo>
                    <a:pt x="10" y="407011"/>
                  </a:lnTo>
                  <a:lnTo>
                    <a:pt x="10" y="404419"/>
                  </a:lnTo>
                  <a:lnTo>
                    <a:pt x="11" y="401827"/>
                  </a:lnTo>
                  <a:lnTo>
                    <a:pt x="12" y="399234"/>
                  </a:lnTo>
                  <a:lnTo>
                    <a:pt x="13" y="396642"/>
                  </a:lnTo>
                  <a:lnTo>
                    <a:pt x="14" y="394049"/>
                  </a:lnTo>
                  <a:lnTo>
                    <a:pt x="15" y="391457"/>
                  </a:lnTo>
                  <a:lnTo>
                    <a:pt x="16" y="388864"/>
                  </a:lnTo>
                  <a:lnTo>
                    <a:pt x="17" y="386272"/>
                  </a:lnTo>
                  <a:lnTo>
                    <a:pt x="18" y="383680"/>
                  </a:lnTo>
                  <a:lnTo>
                    <a:pt x="19" y="381087"/>
                  </a:lnTo>
                  <a:lnTo>
                    <a:pt x="20" y="378495"/>
                  </a:lnTo>
                  <a:lnTo>
                    <a:pt x="21" y="375902"/>
                  </a:lnTo>
                  <a:lnTo>
                    <a:pt x="23" y="373310"/>
                  </a:lnTo>
                  <a:lnTo>
                    <a:pt x="24" y="370717"/>
                  </a:lnTo>
                  <a:lnTo>
                    <a:pt x="25" y="368125"/>
                  </a:lnTo>
                  <a:lnTo>
                    <a:pt x="26" y="365533"/>
                  </a:lnTo>
                  <a:lnTo>
                    <a:pt x="27" y="362940"/>
                  </a:lnTo>
                  <a:lnTo>
                    <a:pt x="28" y="360348"/>
                  </a:lnTo>
                  <a:lnTo>
                    <a:pt x="30" y="357755"/>
                  </a:lnTo>
                  <a:lnTo>
                    <a:pt x="31" y="355163"/>
                  </a:lnTo>
                  <a:lnTo>
                    <a:pt x="32" y="352570"/>
                  </a:lnTo>
                  <a:lnTo>
                    <a:pt x="34" y="349978"/>
                  </a:lnTo>
                  <a:lnTo>
                    <a:pt x="35" y="347386"/>
                  </a:lnTo>
                  <a:lnTo>
                    <a:pt x="36" y="344793"/>
                  </a:lnTo>
                  <a:lnTo>
                    <a:pt x="37" y="342201"/>
                  </a:lnTo>
                  <a:lnTo>
                    <a:pt x="39" y="339608"/>
                  </a:lnTo>
                  <a:lnTo>
                    <a:pt x="40" y="337016"/>
                  </a:lnTo>
                  <a:lnTo>
                    <a:pt x="41" y="334423"/>
                  </a:lnTo>
                  <a:lnTo>
                    <a:pt x="43" y="331831"/>
                  </a:lnTo>
                  <a:lnTo>
                    <a:pt x="44" y="329238"/>
                  </a:lnTo>
                  <a:lnTo>
                    <a:pt x="45" y="326646"/>
                  </a:lnTo>
                  <a:lnTo>
                    <a:pt x="47" y="324054"/>
                  </a:lnTo>
                  <a:lnTo>
                    <a:pt x="48" y="321461"/>
                  </a:lnTo>
                  <a:lnTo>
                    <a:pt x="49" y="318869"/>
                  </a:lnTo>
                  <a:lnTo>
                    <a:pt x="51" y="316276"/>
                  </a:lnTo>
                  <a:lnTo>
                    <a:pt x="52" y="313684"/>
                  </a:lnTo>
                  <a:lnTo>
                    <a:pt x="53" y="311091"/>
                  </a:lnTo>
                  <a:lnTo>
                    <a:pt x="55" y="308499"/>
                  </a:lnTo>
                  <a:lnTo>
                    <a:pt x="56" y="305907"/>
                  </a:lnTo>
                  <a:lnTo>
                    <a:pt x="58" y="303314"/>
                  </a:lnTo>
                  <a:lnTo>
                    <a:pt x="59" y="300722"/>
                  </a:lnTo>
                  <a:lnTo>
                    <a:pt x="60" y="298129"/>
                  </a:lnTo>
                  <a:lnTo>
                    <a:pt x="62" y="295537"/>
                  </a:lnTo>
                  <a:lnTo>
                    <a:pt x="63" y="292944"/>
                  </a:lnTo>
                  <a:lnTo>
                    <a:pt x="64" y="290352"/>
                  </a:lnTo>
                  <a:lnTo>
                    <a:pt x="65" y="287760"/>
                  </a:lnTo>
                  <a:lnTo>
                    <a:pt x="67" y="285167"/>
                  </a:lnTo>
                  <a:lnTo>
                    <a:pt x="68" y="282575"/>
                  </a:lnTo>
                  <a:lnTo>
                    <a:pt x="69" y="279982"/>
                  </a:lnTo>
                  <a:lnTo>
                    <a:pt x="71" y="277390"/>
                  </a:lnTo>
                  <a:lnTo>
                    <a:pt x="72" y="274797"/>
                  </a:lnTo>
                  <a:lnTo>
                    <a:pt x="73" y="272205"/>
                  </a:lnTo>
                  <a:lnTo>
                    <a:pt x="74" y="269613"/>
                  </a:lnTo>
                  <a:lnTo>
                    <a:pt x="76" y="267020"/>
                  </a:lnTo>
                  <a:lnTo>
                    <a:pt x="77" y="264428"/>
                  </a:lnTo>
                  <a:lnTo>
                    <a:pt x="78" y="261835"/>
                  </a:lnTo>
                  <a:lnTo>
                    <a:pt x="79" y="259243"/>
                  </a:lnTo>
                  <a:lnTo>
                    <a:pt x="80" y="256650"/>
                  </a:lnTo>
                  <a:lnTo>
                    <a:pt x="82" y="254058"/>
                  </a:lnTo>
                  <a:lnTo>
                    <a:pt x="83" y="251465"/>
                  </a:lnTo>
                  <a:lnTo>
                    <a:pt x="84" y="248873"/>
                  </a:lnTo>
                  <a:lnTo>
                    <a:pt x="85" y="246281"/>
                  </a:lnTo>
                  <a:lnTo>
                    <a:pt x="86" y="243688"/>
                  </a:lnTo>
                  <a:lnTo>
                    <a:pt x="87" y="241096"/>
                  </a:lnTo>
                  <a:lnTo>
                    <a:pt x="88" y="238503"/>
                  </a:lnTo>
                  <a:lnTo>
                    <a:pt x="89" y="235911"/>
                  </a:lnTo>
                  <a:lnTo>
                    <a:pt x="90" y="233318"/>
                  </a:lnTo>
                  <a:lnTo>
                    <a:pt x="91" y="230726"/>
                  </a:lnTo>
                  <a:lnTo>
                    <a:pt x="92" y="228134"/>
                  </a:lnTo>
                  <a:lnTo>
                    <a:pt x="93" y="225541"/>
                  </a:lnTo>
                  <a:lnTo>
                    <a:pt x="94" y="222949"/>
                  </a:lnTo>
                  <a:lnTo>
                    <a:pt x="95" y="220356"/>
                  </a:lnTo>
                  <a:lnTo>
                    <a:pt x="96" y="217764"/>
                  </a:lnTo>
                  <a:lnTo>
                    <a:pt x="97" y="215171"/>
                  </a:lnTo>
                  <a:lnTo>
                    <a:pt x="98" y="212579"/>
                  </a:lnTo>
                  <a:lnTo>
                    <a:pt x="99" y="209987"/>
                  </a:lnTo>
                  <a:lnTo>
                    <a:pt x="100" y="207394"/>
                  </a:lnTo>
                  <a:lnTo>
                    <a:pt x="101" y="204802"/>
                  </a:lnTo>
                  <a:lnTo>
                    <a:pt x="101" y="202209"/>
                  </a:lnTo>
                  <a:lnTo>
                    <a:pt x="102" y="199617"/>
                  </a:lnTo>
                  <a:lnTo>
                    <a:pt x="103" y="197024"/>
                  </a:lnTo>
                  <a:lnTo>
                    <a:pt x="104" y="194432"/>
                  </a:lnTo>
                  <a:lnTo>
                    <a:pt x="104" y="191840"/>
                  </a:lnTo>
                  <a:lnTo>
                    <a:pt x="105" y="189247"/>
                  </a:lnTo>
                  <a:lnTo>
                    <a:pt x="106" y="186655"/>
                  </a:lnTo>
                  <a:lnTo>
                    <a:pt x="107" y="184062"/>
                  </a:lnTo>
                  <a:lnTo>
                    <a:pt x="107" y="181470"/>
                  </a:lnTo>
                  <a:lnTo>
                    <a:pt x="108" y="178877"/>
                  </a:lnTo>
                  <a:lnTo>
                    <a:pt x="109" y="176285"/>
                  </a:lnTo>
                  <a:lnTo>
                    <a:pt x="109" y="173693"/>
                  </a:lnTo>
                  <a:lnTo>
                    <a:pt x="110" y="171100"/>
                  </a:lnTo>
                  <a:lnTo>
                    <a:pt x="110" y="168508"/>
                  </a:lnTo>
                  <a:lnTo>
                    <a:pt x="111" y="165915"/>
                  </a:lnTo>
                  <a:lnTo>
                    <a:pt x="112" y="163323"/>
                  </a:lnTo>
                  <a:lnTo>
                    <a:pt x="112" y="160730"/>
                  </a:lnTo>
                  <a:lnTo>
                    <a:pt x="113" y="158138"/>
                  </a:lnTo>
                  <a:lnTo>
                    <a:pt x="113" y="155545"/>
                  </a:lnTo>
                  <a:lnTo>
                    <a:pt x="114" y="152953"/>
                  </a:lnTo>
                  <a:lnTo>
                    <a:pt x="114" y="150361"/>
                  </a:lnTo>
                  <a:lnTo>
                    <a:pt x="115" y="147768"/>
                  </a:lnTo>
                  <a:lnTo>
                    <a:pt x="115" y="145176"/>
                  </a:lnTo>
                  <a:lnTo>
                    <a:pt x="116" y="142583"/>
                  </a:lnTo>
                  <a:lnTo>
                    <a:pt x="116" y="139991"/>
                  </a:lnTo>
                  <a:lnTo>
                    <a:pt x="116" y="137398"/>
                  </a:lnTo>
                  <a:lnTo>
                    <a:pt x="117" y="134806"/>
                  </a:lnTo>
                  <a:lnTo>
                    <a:pt x="117" y="132214"/>
                  </a:lnTo>
                  <a:lnTo>
                    <a:pt x="118" y="129621"/>
                  </a:lnTo>
                  <a:lnTo>
                    <a:pt x="118" y="127029"/>
                  </a:lnTo>
                  <a:lnTo>
                    <a:pt x="118" y="124436"/>
                  </a:lnTo>
                  <a:lnTo>
                    <a:pt x="119" y="121844"/>
                  </a:lnTo>
                  <a:lnTo>
                    <a:pt x="119" y="119251"/>
                  </a:lnTo>
                  <a:lnTo>
                    <a:pt x="119" y="116659"/>
                  </a:lnTo>
                  <a:lnTo>
                    <a:pt x="120" y="114067"/>
                  </a:lnTo>
                  <a:lnTo>
                    <a:pt x="120" y="111474"/>
                  </a:lnTo>
                  <a:lnTo>
                    <a:pt x="120" y="108882"/>
                  </a:lnTo>
                  <a:lnTo>
                    <a:pt x="120" y="106289"/>
                  </a:lnTo>
                  <a:lnTo>
                    <a:pt x="121" y="103697"/>
                  </a:lnTo>
                  <a:lnTo>
                    <a:pt x="121" y="101104"/>
                  </a:lnTo>
                  <a:lnTo>
                    <a:pt x="121" y="98512"/>
                  </a:lnTo>
                  <a:lnTo>
                    <a:pt x="121" y="95920"/>
                  </a:lnTo>
                  <a:lnTo>
                    <a:pt x="122" y="93327"/>
                  </a:lnTo>
                  <a:lnTo>
                    <a:pt x="122" y="90735"/>
                  </a:lnTo>
                  <a:lnTo>
                    <a:pt x="122" y="88142"/>
                  </a:lnTo>
                  <a:lnTo>
                    <a:pt x="122" y="85550"/>
                  </a:lnTo>
                  <a:lnTo>
                    <a:pt x="122" y="82957"/>
                  </a:lnTo>
                  <a:lnTo>
                    <a:pt x="123" y="80365"/>
                  </a:lnTo>
                  <a:lnTo>
                    <a:pt x="123" y="77772"/>
                  </a:lnTo>
                  <a:lnTo>
                    <a:pt x="123" y="75180"/>
                  </a:lnTo>
                  <a:lnTo>
                    <a:pt x="123" y="72588"/>
                  </a:lnTo>
                  <a:lnTo>
                    <a:pt x="123" y="69995"/>
                  </a:lnTo>
                  <a:lnTo>
                    <a:pt x="123" y="67403"/>
                  </a:lnTo>
                  <a:lnTo>
                    <a:pt x="124" y="64810"/>
                  </a:lnTo>
                  <a:lnTo>
                    <a:pt x="124" y="62218"/>
                  </a:lnTo>
                  <a:lnTo>
                    <a:pt x="124" y="59625"/>
                  </a:lnTo>
                  <a:lnTo>
                    <a:pt x="124" y="57033"/>
                  </a:lnTo>
                  <a:lnTo>
                    <a:pt x="124" y="54441"/>
                  </a:lnTo>
                  <a:lnTo>
                    <a:pt x="124" y="51848"/>
                  </a:lnTo>
                  <a:lnTo>
                    <a:pt x="124" y="49256"/>
                  </a:lnTo>
                  <a:lnTo>
                    <a:pt x="124" y="46663"/>
                  </a:lnTo>
                  <a:lnTo>
                    <a:pt x="124" y="44071"/>
                  </a:lnTo>
                  <a:lnTo>
                    <a:pt x="125" y="41478"/>
                  </a:lnTo>
                  <a:lnTo>
                    <a:pt x="125" y="38886"/>
                  </a:lnTo>
                  <a:lnTo>
                    <a:pt x="125" y="36294"/>
                  </a:lnTo>
                  <a:lnTo>
                    <a:pt x="125" y="33701"/>
                  </a:lnTo>
                  <a:lnTo>
                    <a:pt x="125" y="31109"/>
                  </a:lnTo>
                  <a:lnTo>
                    <a:pt x="125" y="28516"/>
                  </a:lnTo>
                  <a:lnTo>
                    <a:pt x="125" y="25924"/>
                  </a:lnTo>
                  <a:lnTo>
                    <a:pt x="125" y="23331"/>
                  </a:lnTo>
                  <a:lnTo>
                    <a:pt x="125" y="20739"/>
                  </a:lnTo>
                  <a:lnTo>
                    <a:pt x="125" y="18147"/>
                  </a:lnTo>
                  <a:lnTo>
                    <a:pt x="125" y="15554"/>
                  </a:lnTo>
                  <a:lnTo>
                    <a:pt x="125" y="12962"/>
                  </a:lnTo>
                  <a:lnTo>
                    <a:pt x="125" y="10369"/>
                  </a:lnTo>
                  <a:lnTo>
                    <a:pt x="125" y="7777"/>
                  </a:lnTo>
                  <a:lnTo>
                    <a:pt x="125" y="5184"/>
                  </a:lnTo>
                  <a:lnTo>
                    <a:pt x="125" y="2592"/>
                  </a:lnTo>
                  <a:lnTo>
                    <a:pt x="125" y="0"/>
                  </a:lnTo>
                  <a:lnTo>
                    <a:pt x="126" y="0"/>
                  </a:lnTo>
                  <a:lnTo>
                    <a:pt x="126" y="1324733"/>
                  </a:lnTo>
                  <a:lnTo>
                    <a:pt x="126" y="1324733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59" name="pl41"/>
            <p:cNvSpPr/>
            <p:nvPr/>
          </p:nvSpPr>
          <p:spPr>
            <a:xfrm>
              <a:off x="5525973" y="2716765"/>
              <a:ext cx="151" cy="1033775"/>
            </a:xfrm>
            <a:custGeom>
              <a:avLst/>
              <a:gdLst/>
              <a:ahLst/>
              <a:cxnLst/>
              <a:rect l="0" t="0" r="0" b="0"/>
              <a:pathLst>
                <a:path w="151" h="1033775">
                  <a:moveTo>
                    <a:pt x="0" y="0"/>
                  </a:moveTo>
                  <a:lnTo>
                    <a:pt x="0" y="0"/>
                  </a:lnTo>
                  <a:lnTo>
                    <a:pt x="0" y="2023"/>
                  </a:lnTo>
                  <a:lnTo>
                    <a:pt x="0" y="4046"/>
                  </a:lnTo>
                  <a:lnTo>
                    <a:pt x="0" y="6069"/>
                  </a:lnTo>
                  <a:lnTo>
                    <a:pt x="0" y="8092"/>
                  </a:lnTo>
                  <a:lnTo>
                    <a:pt x="0" y="10115"/>
                  </a:lnTo>
                  <a:lnTo>
                    <a:pt x="0" y="12138"/>
                  </a:lnTo>
                  <a:lnTo>
                    <a:pt x="0" y="14161"/>
                  </a:lnTo>
                  <a:lnTo>
                    <a:pt x="0" y="16184"/>
                  </a:lnTo>
                  <a:lnTo>
                    <a:pt x="0" y="18207"/>
                  </a:lnTo>
                  <a:lnTo>
                    <a:pt x="1" y="20230"/>
                  </a:lnTo>
                  <a:lnTo>
                    <a:pt x="1" y="22253"/>
                  </a:lnTo>
                  <a:lnTo>
                    <a:pt x="1" y="24276"/>
                  </a:lnTo>
                  <a:lnTo>
                    <a:pt x="1" y="26299"/>
                  </a:lnTo>
                  <a:lnTo>
                    <a:pt x="1" y="28322"/>
                  </a:lnTo>
                  <a:lnTo>
                    <a:pt x="1" y="30345"/>
                  </a:lnTo>
                  <a:lnTo>
                    <a:pt x="1" y="32368"/>
                  </a:lnTo>
                  <a:lnTo>
                    <a:pt x="1" y="34391"/>
                  </a:lnTo>
                  <a:lnTo>
                    <a:pt x="1" y="36414"/>
                  </a:lnTo>
                  <a:lnTo>
                    <a:pt x="1" y="38437"/>
                  </a:lnTo>
                  <a:lnTo>
                    <a:pt x="1" y="40460"/>
                  </a:lnTo>
                  <a:lnTo>
                    <a:pt x="1" y="42483"/>
                  </a:lnTo>
                  <a:lnTo>
                    <a:pt x="1" y="44506"/>
                  </a:lnTo>
                  <a:lnTo>
                    <a:pt x="1" y="46530"/>
                  </a:lnTo>
                  <a:lnTo>
                    <a:pt x="2" y="48553"/>
                  </a:lnTo>
                  <a:lnTo>
                    <a:pt x="2" y="50576"/>
                  </a:lnTo>
                  <a:lnTo>
                    <a:pt x="2" y="52599"/>
                  </a:lnTo>
                  <a:lnTo>
                    <a:pt x="2" y="54622"/>
                  </a:lnTo>
                  <a:lnTo>
                    <a:pt x="2" y="56645"/>
                  </a:lnTo>
                  <a:lnTo>
                    <a:pt x="2" y="58668"/>
                  </a:lnTo>
                  <a:lnTo>
                    <a:pt x="2" y="60691"/>
                  </a:lnTo>
                  <a:lnTo>
                    <a:pt x="2" y="62714"/>
                  </a:lnTo>
                  <a:lnTo>
                    <a:pt x="3" y="64737"/>
                  </a:lnTo>
                  <a:lnTo>
                    <a:pt x="3" y="66760"/>
                  </a:lnTo>
                  <a:lnTo>
                    <a:pt x="3" y="68783"/>
                  </a:lnTo>
                  <a:lnTo>
                    <a:pt x="3" y="70806"/>
                  </a:lnTo>
                  <a:lnTo>
                    <a:pt x="3" y="72829"/>
                  </a:lnTo>
                  <a:lnTo>
                    <a:pt x="3" y="74852"/>
                  </a:lnTo>
                  <a:lnTo>
                    <a:pt x="3" y="76875"/>
                  </a:lnTo>
                  <a:lnTo>
                    <a:pt x="4" y="78898"/>
                  </a:lnTo>
                  <a:lnTo>
                    <a:pt x="4" y="80921"/>
                  </a:lnTo>
                  <a:lnTo>
                    <a:pt x="4" y="82944"/>
                  </a:lnTo>
                  <a:lnTo>
                    <a:pt x="4" y="84967"/>
                  </a:lnTo>
                  <a:lnTo>
                    <a:pt x="4" y="86990"/>
                  </a:lnTo>
                  <a:lnTo>
                    <a:pt x="5" y="89013"/>
                  </a:lnTo>
                  <a:lnTo>
                    <a:pt x="5" y="91037"/>
                  </a:lnTo>
                  <a:lnTo>
                    <a:pt x="5" y="93060"/>
                  </a:lnTo>
                  <a:lnTo>
                    <a:pt x="5" y="95083"/>
                  </a:lnTo>
                  <a:lnTo>
                    <a:pt x="5" y="97106"/>
                  </a:lnTo>
                  <a:lnTo>
                    <a:pt x="6" y="99129"/>
                  </a:lnTo>
                  <a:lnTo>
                    <a:pt x="6" y="101152"/>
                  </a:lnTo>
                  <a:lnTo>
                    <a:pt x="6" y="103175"/>
                  </a:lnTo>
                  <a:lnTo>
                    <a:pt x="6" y="105198"/>
                  </a:lnTo>
                  <a:lnTo>
                    <a:pt x="7" y="107221"/>
                  </a:lnTo>
                  <a:lnTo>
                    <a:pt x="7" y="109244"/>
                  </a:lnTo>
                  <a:lnTo>
                    <a:pt x="7" y="111267"/>
                  </a:lnTo>
                  <a:lnTo>
                    <a:pt x="8" y="113290"/>
                  </a:lnTo>
                  <a:lnTo>
                    <a:pt x="8" y="115313"/>
                  </a:lnTo>
                  <a:lnTo>
                    <a:pt x="8" y="117336"/>
                  </a:lnTo>
                  <a:lnTo>
                    <a:pt x="9" y="119359"/>
                  </a:lnTo>
                  <a:lnTo>
                    <a:pt x="9" y="121382"/>
                  </a:lnTo>
                  <a:lnTo>
                    <a:pt x="9" y="123405"/>
                  </a:lnTo>
                  <a:lnTo>
                    <a:pt x="10" y="125428"/>
                  </a:lnTo>
                  <a:lnTo>
                    <a:pt x="10" y="127451"/>
                  </a:lnTo>
                  <a:lnTo>
                    <a:pt x="10" y="129474"/>
                  </a:lnTo>
                  <a:lnTo>
                    <a:pt x="11" y="131497"/>
                  </a:lnTo>
                  <a:lnTo>
                    <a:pt x="11" y="133520"/>
                  </a:lnTo>
                  <a:lnTo>
                    <a:pt x="11" y="135544"/>
                  </a:lnTo>
                  <a:lnTo>
                    <a:pt x="12" y="137567"/>
                  </a:lnTo>
                  <a:lnTo>
                    <a:pt x="12" y="139590"/>
                  </a:lnTo>
                  <a:lnTo>
                    <a:pt x="13" y="141613"/>
                  </a:lnTo>
                  <a:lnTo>
                    <a:pt x="13" y="143636"/>
                  </a:lnTo>
                  <a:lnTo>
                    <a:pt x="13" y="145659"/>
                  </a:lnTo>
                  <a:lnTo>
                    <a:pt x="14" y="147682"/>
                  </a:lnTo>
                  <a:lnTo>
                    <a:pt x="14" y="149705"/>
                  </a:lnTo>
                  <a:lnTo>
                    <a:pt x="15" y="151728"/>
                  </a:lnTo>
                  <a:lnTo>
                    <a:pt x="15" y="153751"/>
                  </a:lnTo>
                  <a:lnTo>
                    <a:pt x="16" y="155774"/>
                  </a:lnTo>
                  <a:lnTo>
                    <a:pt x="16" y="157797"/>
                  </a:lnTo>
                  <a:lnTo>
                    <a:pt x="17" y="159820"/>
                  </a:lnTo>
                  <a:lnTo>
                    <a:pt x="17" y="161843"/>
                  </a:lnTo>
                  <a:lnTo>
                    <a:pt x="18" y="163866"/>
                  </a:lnTo>
                  <a:lnTo>
                    <a:pt x="18" y="165889"/>
                  </a:lnTo>
                  <a:lnTo>
                    <a:pt x="19" y="167912"/>
                  </a:lnTo>
                  <a:lnTo>
                    <a:pt x="19" y="169935"/>
                  </a:lnTo>
                  <a:lnTo>
                    <a:pt x="20" y="171958"/>
                  </a:lnTo>
                  <a:lnTo>
                    <a:pt x="21" y="173981"/>
                  </a:lnTo>
                  <a:lnTo>
                    <a:pt x="21" y="176004"/>
                  </a:lnTo>
                  <a:lnTo>
                    <a:pt x="22" y="178027"/>
                  </a:lnTo>
                  <a:lnTo>
                    <a:pt x="22" y="180051"/>
                  </a:lnTo>
                  <a:lnTo>
                    <a:pt x="23" y="182074"/>
                  </a:lnTo>
                  <a:lnTo>
                    <a:pt x="24" y="184097"/>
                  </a:lnTo>
                  <a:lnTo>
                    <a:pt x="24" y="186120"/>
                  </a:lnTo>
                  <a:lnTo>
                    <a:pt x="25" y="188143"/>
                  </a:lnTo>
                  <a:lnTo>
                    <a:pt x="25" y="190166"/>
                  </a:lnTo>
                  <a:lnTo>
                    <a:pt x="26" y="192189"/>
                  </a:lnTo>
                  <a:lnTo>
                    <a:pt x="27" y="194212"/>
                  </a:lnTo>
                  <a:lnTo>
                    <a:pt x="27" y="196235"/>
                  </a:lnTo>
                  <a:lnTo>
                    <a:pt x="28" y="198258"/>
                  </a:lnTo>
                  <a:lnTo>
                    <a:pt x="29" y="200281"/>
                  </a:lnTo>
                  <a:lnTo>
                    <a:pt x="29" y="202304"/>
                  </a:lnTo>
                  <a:lnTo>
                    <a:pt x="30" y="204327"/>
                  </a:lnTo>
                  <a:lnTo>
                    <a:pt x="31" y="206350"/>
                  </a:lnTo>
                  <a:lnTo>
                    <a:pt x="31" y="208373"/>
                  </a:lnTo>
                  <a:lnTo>
                    <a:pt x="32" y="210396"/>
                  </a:lnTo>
                  <a:lnTo>
                    <a:pt x="33" y="212419"/>
                  </a:lnTo>
                  <a:lnTo>
                    <a:pt x="33" y="214442"/>
                  </a:lnTo>
                  <a:lnTo>
                    <a:pt x="34" y="216465"/>
                  </a:lnTo>
                  <a:lnTo>
                    <a:pt x="35" y="218488"/>
                  </a:lnTo>
                  <a:lnTo>
                    <a:pt x="36" y="220511"/>
                  </a:lnTo>
                  <a:lnTo>
                    <a:pt x="36" y="222534"/>
                  </a:lnTo>
                  <a:lnTo>
                    <a:pt x="37" y="224557"/>
                  </a:lnTo>
                  <a:lnTo>
                    <a:pt x="38" y="226581"/>
                  </a:lnTo>
                  <a:lnTo>
                    <a:pt x="39" y="228604"/>
                  </a:lnTo>
                  <a:lnTo>
                    <a:pt x="39" y="230627"/>
                  </a:lnTo>
                  <a:lnTo>
                    <a:pt x="40" y="232650"/>
                  </a:lnTo>
                  <a:lnTo>
                    <a:pt x="41" y="234673"/>
                  </a:lnTo>
                  <a:lnTo>
                    <a:pt x="41" y="236696"/>
                  </a:lnTo>
                  <a:lnTo>
                    <a:pt x="42" y="238719"/>
                  </a:lnTo>
                  <a:lnTo>
                    <a:pt x="43" y="240742"/>
                  </a:lnTo>
                  <a:lnTo>
                    <a:pt x="44" y="242765"/>
                  </a:lnTo>
                  <a:lnTo>
                    <a:pt x="44" y="244788"/>
                  </a:lnTo>
                  <a:lnTo>
                    <a:pt x="45" y="246811"/>
                  </a:lnTo>
                  <a:lnTo>
                    <a:pt x="46" y="248834"/>
                  </a:lnTo>
                  <a:lnTo>
                    <a:pt x="47" y="250857"/>
                  </a:lnTo>
                  <a:lnTo>
                    <a:pt x="47" y="252880"/>
                  </a:lnTo>
                  <a:lnTo>
                    <a:pt x="48" y="254903"/>
                  </a:lnTo>
                  <a:lnTo>
                    <a:pt x="49" y="256926"/>
                  </a:lnTo>
                  <a:lnTo>
                    <a:pt x="50" y="258949"/>
                  </a:lnTo>
                  <a:lnTo>
                    <a:pt x="50" y="260972"/>
                  </a:lnTo>
                  <a:lnTo>
                    <a:pt x="51" y="262995"/>
                  </a:lnTo>
                  <a:lnTo>
                    <a:pt x="52" y="265018"/>
                  </a:lnTo>
                  <a:lnTo>
                    <a:pt x="52" y="267041"/>
                  </a:lnTo>
                  <a:lnTo>
                    <a:pt x="53" y="269064"/>
                  </a:lnTo>
                  <a:lnTo>
                    <a:pt x="54" y="271088"/>
                  </a:lnTo>
                  <a:lnTo>
                    <a:pt x="55" y="273111"/>
                  </a:lnTo>
                  <a:lnTo>
                    <a:pt x="55" y="275134"/>
                  </a:lnTo>
                  <a:lnTo>
                    <a:pt x="56" y="277157"/>
                  </a:lnTo>
                  <a:lnTo>
                    <a:pt x="57" y="279180"/>
                  </a:lnTo>
                  <a:lnTo>
                    <a:pt x="57" y="281203"/>
                  </a:lnTo>
                  <a:lnTo>
                    <a:pt x="58" y="283226"/>
                  </a:lnTo>
                  <a:lnTo>
                    <a:pt x="59" y="285249"/>
                  </a:lnTo>
                  <a:lnTo>
                    <a:pt x="59" y="287272"/>
                  </a:lnTo>
                  <a:lnTo>
                    <a:pt x="60" y="289295"/>
                  </a:lnTo>
                  <a:lnTo>
                    <a:pt x="61" y="291318"/>
                  </a:lnTo>
                  <a:lnTo>
                    <a:pt x="62" y="293341"/>
                  </a:lnTo>
                  <a:lnTo>
                    <a:pt x="62" y="295364"/>
                  </a:lnTo>
                  <a:lnTo>
                    <a:pt x="63" y="297387"/>
                  </a:lnTo>
                  <a:lnTo>
                    <a:pt x="63" y="299410"/>
                  </a:lnTo>
                  <a:lnTo>
                    <a:pt x="64" y="301433"/>
                  </a:lnTo>
                  <a:lnTo>
                    <a:pt x="65" y="303456"/>
                  </a:lnTo>
                  <a:lnTo>
                    <a:pt x="65" y="305479"/>
                  </a:lnTo>
                  <a:lnTo>
                    <a:pt x="66" y="307502"/>
                  </a:lnTo>
                  <a:lnTo>
                    <a:pt x="67" y="309525"/>
                  </a:lnTo>
                  <a:lnTo>
                    <a:pt x="67" y="311548"/>
                  </a:lnTo>
                  <a:lnTo>
                    <a:pt x="68" y="313571"/>
                  </a:lnTo>
                  <a:lnTo>
                    <a:pt x="68" y="315595"/>
                  </a:lnTo>
                  <a:lnTo>
                    <a:pt x="69" y="317618"/>
                  </a:lnTo>
                  <a:lnTo>
                    <a:pt x="70" y="319641"/>
                  </a:lnTo>
                  <a:lnTo>
                    <a:pt x="70" y="321664"/>
                  </a:lnTo>
                  <a:lnTo>
                    <a:pt x="71" y="323687"/>
                  </a:lnTo>
                  <a:lnTo>
                    <a:pt x="71" y="325710"/>
                  </a:lnTo>
                  <a:lnTo>
                    <a:pt x="72" y="327733"/>
                  </a:lnTo>
                  <a:lnTo>
                    <a:pt x="72" y="329756"/>
                  </a:lnTo>
                  <a:lnTo>
                    <a:pt x="73" y="331779"/>
                  </a:lnTo>
                  <a:lnTo>
                    <a:pt x="74" y="333802"/>
                  </a:lnTo>
                  <a:lnTo>
                    <a:pt x="74" y="335825"/>
                  </a:lnTo>
                  <a:lnTo>
                    <a:pt x="75" y="337848"/>
                  </a:lnTo>
                  <a:lnTo>
                    <a:pt x="75" y="339871"/>
                  </a:lnTo>
                  <a:lnTo>
                    <a:pt x="76" y="341894"/>
                  </a:lnTo>
                  <a:lnTo>
                    <a:pt x="76" y="343917"/>
                  </a:lnTo>
                  <a:lnTo>
                    <a:pt x="77" y="345940"/>
                  </a:lnTo>
                  <a:lnTo>
                    <a:pt x="77" y="347963"/>
                  </a:lnTo>
                  <a:lnTo>
                    <a:pt x="78" y="349986"/>
                  </a:lnTo>
                  <a:lnTo>
                    <a:pt x="78" y="352009"/>
                  </a:lnTo>
                  <a:lnTo>
                    <a:pt x="79" y="354032"/>
                  </a:lnTo>
                  <a:lnTo>
                    <a:pt x="79" y="356055"/>
                  </a:lnTo>
                  <a:lnTo>
                    <a:pt x="80" y="358078"/>
                  </a:lnTo>
                  <a:lnTo>
                    <a:pt x="80" y="360102"/>
                  </a:lnTo>
                  <a:lnTo>
                    <a:pt x="81" y="362125"/>
                  </a:lnTo>
                  <a:lnTo>
                    <a:pt x="81" y="364148"/>
                  </a:lnTo>
                  <a:lnTo>
                    <a:pt x="82" y="366171"/>
                  </a:lnTo>
                  <a:lnTo>
                    <a:pt x="82" y="368194"/>
                  </a:lnTo>
                  <a:lnTo>
                    <a:pt x="83" y="370217"/>
                  </a:lnTo>
                  <a:lnTo>
                    <a:pt x="83" y="372240"/>
                  </a:lnTo>
                  <a:lnTo>
                    <a:pt x="84" y="374263"/>
                  </a:lnTo>
                  <a:lnTo>
                    <a:pt x="84" y="376286"/>
                  </a:lnTo>
                  <a:lnTo>
                    <a:pt x="84" y="378309"/>
                  </a:lnTo>
                  <a:lnTo>
                    <a:pt x="85" y="380332"/>
                  </a:lnTo>
                  <a:lnTo>
                    <a:pt x="85" y="382355"/>
                  </a:lnTo>
                  <a:lnTo>
                    <a:pt x="86" y="384378"/>
                  </a:lnTo>
                  <a:lnTo>
                    <a:pt x="86" y="386401"/>
                  </a:lnTo>
                  <a:lnTo>
                    <a:pt x="87" y="388424"/>
                  </a:lnTo>
                  <a:lnTo>
                    <a:pt x="87" y="390447"/>
                  </a:lnTo>
                  <a:lnTo>
                    <a:pt x="88" y="392470"/>
                  </a:lnTo>
                  <a:lnTo>
                    <a:pt x="88" y="394493"/>
                  </a:lnTo>
                  <a:lnTo>
                    <a:pt x="89" y="396516"/>
                  </a:lnTo>
                  <a:lnTo>
                    <a:pt x="89" y="398539"/>
                  </a:lnTo>
                  <a:lnTo>
                    <a:pt x="90" y="400562"/>
                  </a:lnTo>
                  <a:lnTo>
                    <a:pt x="90" y="402585"/>
                  </a:lnTo>
                  <a:lnTo>
                    <a:pt x="91" y="404609"/>
                  </a:lnTo>
                  <a:lnTo>
                    <a:pt x="91" y="406632"/>
                  </a:lnTo>
                  <a:lnTo>
                    <a:pt x="91" y="408655"/>
                  </a:lnTo>
                  <a:lnTo>
                    <a:pt x="92" y="410678"/>
                  </a:lnTo>
                  <a:lnTo>
                    <a:pt x="92" y="412701"/>
                  </a:lnTo>
                  <a:lnTo>
                    <a:pt x="93" y="414724"/>
                  </a:lnTo>
                  <a:lnTo>
                    <a:pt x="93" y="416747"/>
                  </a:lnTo>
                  <a:lnTo>
                    <a:pt x="94" y="418770"/>
                  </a:lnTo>
                  <a:lnTo>
                    <a:pt x="94" y="420793"/>
                  </a:lnTo>
                  <a:lnTo>
                    <a:pt x="95" y="422816"/>
                  </a:lnTo>
                  <a:lnTo>
                    <a:pt x="95" y="424839"/>
                  </a:lnTo>
                  <a:lnTo>
                    <a:pt x="96" y="426862"/>
                  </a:lnTo>
                  <a:lnTo>
                    <a:pt x="96" y="428885"/>
                  </a:lnTo>
                  <a:lnTo>
                    <a:pt x="97" y="430908"/>
                  </a:lnTo>
                  <a:lnTo>
                    <a:pt x="97" y="432931"/>
                  </a:lnTo>
                  <a:lnTo>
                    <a:pt x="98" y="434954"/>
                  </a:lnTo>
                  <a:lnTo>
                    <a:pt x="98" y="436977"/>
                  </a:lnTo>
                  <a:lnTo>
                    <a:pt x="99" y="439000"/>
                  </a:lnTo>
                  <a:lnTo>
                    <a:pt x="99" y="441023"/>
                  </a:lnTo>
                  <a:lnTo>
                    <a:pt x="100" y="443046"/>
                  </a:lnTo>
                  <a:lnTo>
                    <a:pt x="100" y="445069"/>
                  </a:lnTo>
                  <a:lnTo>
                    <a:pt x="101" y="447092"/>
                  </a:lnTo>
                  <a:lnTo>
                    <a:pt x="101" y="449115"/>
                  </a:lnTo>
                  <a:lnTo>
                    <a:pt x="102" y="451139"/>
                  </a:lnTo>
                  <a:lnTo>
                    <a:pt x="102" y="453162"/>
                  </a:lnTo>
                  <a:lnTo>
                    <a:pt x="103" y="455185"/>
                  </a:lnTo>
                  <a:lnTo>
                    <a:pt x="104" y="457208"/>
                  </a:lnTo>
                  <a:lnTo>
                    <a:pt x="104" y="459231"/>
                  </a:lnTo>
                  <a:lnTo>
                    <a:pt x="105" y="461254"/>
                  </a:lnTo>
                  <a:lnTo>
                    <a:pt x="105" y="463277"/>
                  </a:lnTo>
                  <a:lnTo>
                    <a:pt x="106" y="465300"/>
                  </a:lnTo>
                  <a:lnTo>
                    <a:pt x="106" y="467323"/>
                  </a:lnTo>
                  <a:lnTo>
                    <a:pt x="107" y="469346"/>
                  </a:lnTo>
                  <a:lnTo>
                    <a:pt x="108" y="471369"/>
                  </a:lnTo>
                  <a:lnTo>
                    <a:pt x="108" y="473392"/>
                  </a:lnTo>
                  <a:lnTo>
                    <a:pt x="109" y="475415"/>
                  </a:lnTo>
                  <a:lnTo>
                    <a:pt x="109" y="477438"/>
                  </a:lnTo>
                  <a:lnTo>
                    <a:pt x="110" y="479461"/>
                  </a:lnTo>
                  <a:lnTo>
                    <a:pt x="110" y="481484"/>
                  </a:lnTo>
                  <a:lnTo>
                    <a:pt x="111" y="483507"/>
                  </a:lnTo>
                  <a:lnTo>
                    <a:pt x="112" y="485530"/>
                  </a:lnTo>
                  <a:lnTo>
                    <a:pt x="112" y="487553"/>
                  </a:lnTo>
                  <a:lnTo>
                    <a:pt x="113" y="489576"/>
                  </a:lnTo>
                  <a:lnTo>
                    <a:pt x="113" y="491599"/>
                  </a:lnTo>
                  <a:lnTo>
                    <a:pt x="114" y="493622"/>
                  </a:lnTo>
                  <a:lnTo>
                    <a:pt x="115" y="495646"/>
                  </a:lnTo>
                  <a:lnTo>
                    <a:pt x="115" y="497669"/>
                  </a:lnTo>
                  <a:lnTo>
                    <a:pt x="116" y="499692"/>
                  </a:lnTo>
                  <a:lnTo>
                    <a:pt x="117" y="501715"/>
                  </a:lnTo>
                  <a:lnTo>
                    <a:pt x="117" y="503738"/>
                  </a:lnTo>
                  <a:lnTo>
                    <a:pt x="118" y="505761"/>
                  </a:lnTo>
                  <a:lnTo>
                    <a:pt x="118" y="507784"/>
                  </a:lnTo>
                  <a:lnTo>
                    <a:pt x="119" y="509807"/>
                  </a:lnTo>
                  <a:lnTo>
                    <a:pt x="120" y="511830"/>
                  </a:lnTo>
                  <a:lnTo>
                    <a:pt x="120" y="513853"/>
                  </a:lnTo>
                  <a:lnTo>
                    <a:pt x="121" y="515876"/>
                  </a:lnTo>
                  <a:lnTo>
                    <a:pt x="122" y="517899"/>
                  </a:lnTo>
                  <a:lnTo>
                    <a:pt x="122" y="519922"/>
                  </a:lnTo>
                  <a:lnTo>
                    <a:pt x="123" y="521945"/>
                  </a:lnTo>
                  <a:lnTo>
                    <a:pt x="123" y="523968"/>
                  </a:lnTo>
                  <a:lnTo>
                    <a:pt x="124" y="525991"/>
                  </a:lnTo>
                  <a:lnTo>
                    <a:pt x="125" y="528014"/>
                  </a:lnTo>
                  <a:lnTo>
                    <a:pt x="125" y="530037"/>
                  </a:lnTo>
                  <a:lnTo>
                    <a:pt x="126" y="532060"/>
                  </a:lnTo>
                  <a:lnTo>
                    <a:pt x="127" y="534083"/>
                  </a:lnTo>
                  <a:lnTo>
                    <a:pt x="127" y="536106"/>
                  </a:lnTo>
                  <a:lnTo>
                    <a:pt x="128" y="538129"/>
                  </a:lnTo>
                  <a:lnTo>
                    <a:pt x="129" y="540153"/>
                  </a:lnTo>
                  <a:lnTo>
                    <a:pt x="129" y="542176"/>
                  </a:lnTo>
                  <a:lnTo>
                    <a:pt x="130" y="544199"/>
                  </a:lnTo>
                  <a:lnTo>
                    <a:pt x="130" y="546222"/>
                  </a:lnTo>
                  <a:lnTo>
                    <a:pt x="131" y="548245"/>
                  </a:lnTo>
                  <a:lnTo>
                    <a:pt x="132" y="550268"/>
                  </a:lnTo>
                  <a:lnTo>
                    <a:pt x="132" y="552291"/>
                  </a:lnTo>
                  <a:lnTo>
                    <a:pt x="133" y="554314"/>
                  </a:lnTo>
                  <a:lnTo>
                    <a:pt x="134" y="556337"/>
                  </a:lnTo>
                  <a:lnTo>
                    <a:pt x="134" y="558360"/>
                  </a:lnTo>
                  <a:lnTo>
                    <a:pt x="135" y="560383"/>
                  </a:lnTo>
                  <a:lnTo>
                    <a:pt x="135" y="562406"/>
                  </a:lnTo>
                  <a:lnTo>
                    <a:pt x="136" y="564429"/>
                  </a:lnTo>
                  <a:lnTo>
                    <a:pt x="137" y="566452"/>
                  </a:lnTo>
                  <a:lnTo>
                    <a:pt x="137" y="568475"/>
                  </a:lnTo>
                  <a:lnTo>
                    <a:pt x="138" y="570498"/>
                  </a:lnTo>
                  <a:lnTo>
                    <a:pt x="138" y="572521"/>
                  </a:lnTo>
                  <a:lnTo>
                    <a:pt x="139" y="574544"/>
                  </a:lnTo>
                  <a:lnTo>
                    <a:pt x="140" y="576567"/>
                  </a:lnTo>
                  <a:lnTo>
                    <a:pt x="140" y="578590"/>
                  </a:lnTo>
                  <a:lnTo>
                    <a:pt x="141" y="580613"/>
                  </a:lnTo>
                  <a:lnTo>
                    <a:pt x="141" y="582636"/>
                  </a:lnTo>
                  <a:lnTo>
                    <a:pt x="142" y="584660"/>
                  </a:lnTo>
                  <a:lnTo>
                    <a:pt x="142" y="586683"/>
                  </a:lnTo>
                  <a:lnTo>
                    <a:pt x="143" y="588706"/>
                  </a:lnTo>
                  <a:lnTo>
                    <a:pt x="143" y="590729"/>
                  </a:lnTo>
                  <a:lnTo>
                    <a:pt x="144" y="592752"/>
                  </a:lnTo>
                  <a:lnTo>
                    <a:pt x="144" y="594775"/>
                  </a:lnTo>
                  <a:lnTo>
                    <a:pt x="145" y="596798"/>
                  </a:lnTo>
                  <a:lnTo>
                    <a:pt x="145" y="598821"/>
                  </a:lnTo>
                  <a:lnTo>
                    <a:pt x="146" y="600844"/>
                  </a:lnTo>
                  <a:lnTo>
                    <a:pt x="146" y="602867"/>
                  </a:lnTo>
                  <a:lnTo>
                    <a:pt x="146" y="604890"/>
                  </a:lnTo>
                  <a:lnTo>
                    <a:pt x="147" y="606913"/>
                  </a:lnTo>
                  <a:lnTo>
                    <a:pt x="147" y="608936"/>
                  </a:lnTo>
                  <a:lnTo>
                    <a:pt x="148" y="610959"/>
                  </a:lnTo>
                  <a:lnTo>
                    <a:pt x="148" y="612982"/>
                  </a:lnTo>
                  <a:lnTo>
                    <a:pt x="148" y="615005"/>
                  </a:lnTo>
                  <a:lnTo>
                    <a:pt x="149" y="617028"/>
                  </a:lnTo>
                  <a:lnTo>
                    <a:pt x="149" y="619051"/>
                  </a:lnTo>
                  <a:lnTo>
                    <a:pt x="149" y="621074"/>
                  </a:lnTo>
                  <a:lnTo>
                    <a:pt x="150" y="623097"/>
                  </a:lnTo>
                  <a:lnTo>
                    <a:pt x="150" y="625120"/>
                  </a:lnTo>
                  <a:lnTo>
                    <a:pt x="150" y="627143"/>
                  </a:lnTo>
                  <a:lnTo>
                    <a:pt x="150" y="629166"/>
                  </a:lnTo>
                  <a:lnTo>
                    <a:pt x="150" y="631190"/>
                  </a:lnTo>
                  <a:lnTo>
                    <a:pt x="151" y="633213"/>
                  </a:lnTo>
                  <a:lnTo>
                    <a:pt x="151" y="635236"/>
                  </a:lnTo>
                  <a:lnTo>
                    <a:pt x="151" y="637259"/>
                  </a:lnTo>
                  <a:lnTo>
                    <a:pt x="151" y="639282"/>
                  </a:lnTo>
                  <a:lnTo>
                    <a:pt x="151" y="641305"/>
                  </a:lnTo>
                  <a:lnTo>
                    <a:pt x="151" y="643328"/>
                  </a:lnTo>
                  <a:lnTo>
                    <a:pt x="151" y="645351"/>
                  </a:lnTo>
                  <a:lnTo>
                    <a:pt x="151" y="647374"/>
                  </a:lnTo>
                  <a:lnTo>
                    <a:pt x="151" y="649397"/>
                  </a:lnTo>
                  <a:lnTo>
                    <a:pt x="151" y="651420"/>
                  </a:lnTo>
                  <a:lnTo>
                    <a:pt x="151" y="653443"/>
                  </a:lnTo>
                  <a:lnTo>
                    <a:pt x="151" y="655466"/>
                  </a:lnTo>
                  <a:lnTo>
                    <a:pt x="151" y="657489"/>
                  </a:lnTo>
                  <a:lnTo>
                    <a:pt x="151" y="659512"/>
                  </a:lnTo>
                  <a:lnTo>
                    <a:pt x="151" y="661535"/>
                  </a:lnTo>
                  <a:lnTo>
                    <a:pt x="151" y="663558"/>
                  </a:lnTo>
                  <a:lnTo>
                    <a:pt x="150" y="665581"/>
                  </a:lnTo>
                  <a:lnTo>
                    <a:pt x="150" y="667604"/>
                  </a:lnTo>
                  <a:lnTo>
                    <a:pt x="150" y="669627"/>
                  </a:lnTo>
                  <a:lnTo>
                    <a:pt x="150" y="671650"/>
                  </a:lnTo>
                  <a:lnTo>
                    <a:pt x="149" y="673673"/>
                  </a:lnTo>
                  <a:lnTo>
                    <a:pt x="149" y="675697"/>
                  </a:lnTo>
                  <a:lnTo>
                    <a:pt x="149" y="677720"/>
                  </a:lnTo>
                  <a:lnTo>
                    <a:pt x="148" y="679743"/>
                  </a:lnTo>
                  <a:lnTo>
                    <a:pt x="148" y="681766"/>
                  </a:lnTo>
                  <a:lnTo>
                    <a:pt x="147" y="683789"/>
                  </a:lnTo>
                  <a:lnTo>
                    <a:pt x="147" y="685812"/>
                  </a:lnTo>
                  <a:lnTo>
                    <a:pt x="146" y="687835"/>
                  </a:lnTo>
                  <a:lnTo>
                    <a:pt x="146" y="689858"/>
                  </a:lnTo>
                  <a:lnTo>
                    <a:pt x="145" y="691881"/>
                  </a:lnTo>
                  <a:lnTo>
                    <a:pt x="145" y="693904"/>
                  </a:lnTo>
                  <a:lnTo>
                    <a:pt x="144" y="695927"/>
                  </a:lnTo>
                  <a:lnTo>
                    <a:pt x="143" y="697950"/>
                  </a:lnTo>
                  <a:lnTo>
                    <a:pt x="143" y="699973"/>
                  </a:lnTo>
                  <a:lnTo>
                    <a:pt x="142" y="701996"/>
                  </a:lnTo>
                  <a:lnTo>
                    <a:pt x="141" y="704019"/>
                  </a:lnTo>
                  <a:lnTo>
                    <a:pt x="141" y="706042"/>
                  </a:lnTo>
                  <a:lnTo>
                    <a:pt x="140" y="708065"/>
                  </a:lnTo>
                  <a:lnTo>
                    <a:pt x="139" y="710088"/>
                  </a:lnTo>
                  <a:lnTo>
                    <a:pt x="138" y="712111"/>
                  </a:lnTo>
                  <a:lnTo>
                    <a:pt x="137" y="714134"/>
                  </a:lnTo>
                  <a:lnTo>
                    <a:pt x="136" y="716157"/>
                  </a:lnTo>
                  <a:lnTo>
                    <a:pt x="135" y="718180"/>
                  </a:lnTo>
                  <a:lnTo>
                    <a:pt x="134" y="720204"/>
                  </a:lnTo>
                  <a:lnTo>
                    <a:pt x="133" y="722227"/>
                  </a:lnTo>
                  <a:lnTo>
                    <a:pt x="132" y="724250"/>
                  </a:lnTo>
                  <a:lnTo>
                    <a:pt x="131" y="726273"/>
                  </a:lnTo>
                  <a:lnTo>
                    <a:pt x="130" y="728296"/>
                  </a:lnTo>
                  <a:lnTo>
                    <a:pt x="129" y="730319"/>
                  </a:lnTo>
                  <a:lnTo>
                    <a:pt x="128" y="732342"/>
                  </a:lnTo>
                  <a:lnTo>
                    <a:pt x="127" y="734365"/>
                  </a:lnTo>
                  <a:lnTo>
                    <a:pt x="126" y="736388"/>
                  </a:lnTo>
                  <a:lnTo>
                    <a:pt x="125" y="738411"/>
                  </a:lnTo>
                  <a:lnTo>
                    <a:pt x="124" y="740434"/>
                  </a:lnTo>
                  <a:lnTo>
                    <a:pt x="122" y="742457"/>
                  </a:lnTo>
                  <a:lnTo>
                    <a:pt x="121" y="744480"/>
                  </a:lnTo>
                  <a:lnTo>
                    <a:pt x="120" y="746503"/>
                  </a:lnTo>
                  <a:lnTo>
                    <a:pt x="119" y="748526"/>
                  </a:lnTo>
                  <a:lnTo>
                    <a:pt x="117" y="750549"/>
                  </a:lnTo>
                  <a:lnTo>
                    <a:pt x="116" y="752572"/>
                  </a:lnTo>
                  <a:lnTo>
                    <a:pt x="115" y="754595"/>
                  </a:lnTo>
                  <a:lnTo>
                    <a:pt x="113" y="756618"/>
                  </a:lnTo>
                  <a:lnTo>
                    <a:pt x="112" y="758641"/>
                  </a:lnTo>
                  <a:lnTo>
                    <a:pt x="110" y="760664"/>
                  </a:lnTo>
                  <a:lnTo>
                    <a:pt x="109" y="762687"/>
                  </a:lnTo>
                  <a:lnTo>
                    <a:pt x="108" y="764711"/>
                  </a:lnTo>
                  <a:lnTo>
                    <a:pt x="106" y="766734"/>
                  </a:lnTo>
                  <a:lnTo>
                    <a:pt x="105" y="768757"/>
                  </a:lnTo>
                  <a:lnTo>
                    <a:pt x="103" y="770780"/>
                  </a:lnTo>
                  <a:lnTo>
                    <a:pt x="102" y="772803"/>
                  </a:lnTo>
                  <a:lnTo>
                    <a:pt x="100" y="774826"/>
                  </a:lnTo>
                  <a:lnTo>
                    <a:pt x="99" y="776849"/>
                  </a:lnTo>
                  <a:lnTo>
                    <a:pt x="98" y="778872"/>
                  </a:lnTo>
                  <a:lnTo>
                    <a:pt x="96" y="780895"/>
                  </a:lnTo>
                  <a:lnTo>
                    <a:pt x="95" y="782918"/>
                  </a:lnTo>
                  <a:lnTo>
                    <a:pt x="93" y="784941"/>
                  </a:lnTo>
                  <a:lnTo>
                    <a:pt x="92" y="786964"/>
                  </a:lnTo>
                  <a:lnTo>
                    <a:pt x="90" y="788987"/>
                  </a:lnTo>
                  <a:lnTo>
                    <a:pt x="89" y="791010"/>
                  </a:lnTo>
                  <a:lnTo>
                    <a:pt x="87" y="793033"/>
                  </a:lnTo>
                  <a:lnTo>
                    <a:pt x="86" y="795056"/>
                  </a:lnTo>
                  <a:lnTo>
                    <a:pt x="84" y="797079"/>
                  </a:lnTo>
                  <a:lnTo>
                    <a:pt x="83" y="799102"/>
                  </a:lnTo>
                  <a:lnTo>
                    <a:pt x="81" y="801125"/>
                  </a:lnTo>
                  <a:lnTo>
                    <a:pt x="80" y="803148"/>
                  </a:lnTo>
                  <a:lnTo>
                    <a:pt x="78" y="805171"/>
                  </a:lnTo>
                  <a:lnTo>
                    <a:pt x="77" y="807194"/>
                  </a:lnTo>
                  <a:lnTo>
                    <a:pt x="75" y="809218"/>
                  </a:lnTo>
                  <a:lnTo>
                    <a:pt x="74" y="811241"/>
                  </a:lnTo>
                  <a:lnTo>
                    <a:pt x="72" y="813264"/>
                  </a:lnTo>
                  <a:lnTo>
                    <a:pt x="71" y="815287"/>
                  </a:lnTo>
                  <a:lnTo>
                    <a:pt x="69" y="817310"/>
                  </a:lnTo>
                  <a:lnTo>
                    <a:pt x="68" y="819333"/>
                  </a:lnTo>
                  <a:lnTo>
                    <a:pt x="66" y="821356"/>
                  </a:lnTo>
                  <a:lnTo>
                    <a:pt x="65" y="823379"/>
                  </a:lnTo>
                  <a:lnTo>
                    <a:pt x="64" y="825402"/>
                  </a:lnTo>
                  <a:lnTo>
                    <a:pt x="62" y="827425"/>
                  </a:lnTo>
                  <a:lnTo>
                    <a:pt x="61" y="829448"/>
                  </a:lnTo>
                  <a:lnTo>
                    <a:pt x="59" y="831471"/>
                  </a:lnTo>
                  <a:lnTo>
                    <a:pt x="58" y="833494"/>
                  </a:lnTo>
                  <a:lnTo>
                    <a:pt x="57" y="835517"/>
                  </a:lnTo>
                  <a:lnTo>
                    <a:pt x="55" y="837540"/>
                  </a:lnTo>
                  <a:lnTo>
                    <a:pt x="54" y="839563"/>
                  </a:lnTo>
                  <a:lnTo>
                    <a:pt x="53" y="841586"/>
                  </a:lnTo>
                  <a:lnTo>
                    <a:pt x="51" y="843609"/>
                  </a:lnTo>
                  <a:lnTo>
                    <a:pt x="50" y="845632"/>
                  </a:lnTo>
                  <a:lnTo>
                    <a:pt x="49" y="847655"/>
                  </a:lnTo>
                  <a:lnTo>
                    <a:pt x="47" y="849678"/>
                  </a:lnTo>
                  <a:lnTo>
                    <a:pt x="46" y="851701"/>
                  </a:lnTo>
                  <a:lnTo>
                    <a:pt x="45" y="853724"/>
                  </a:lnTo>
                  <a:lnTo>
                    <a:pt x="44" y="855748"/>
                  </a:lnTo>
                  <a:lnTo>
                    <a:pt x="43" y="857771"/>
                  </a:lnTo>
                  <a:lnTo>
                    <a:pt x="41" y="859794"/>
                  </a:lnTo>
                  <a:lnTo>
                    <a:pt x="40" y="861817"/>
                  </a:lnTo>
                  <a:lnTo>
                    <a:pt x="39" y="863840"/>
                  </a:lnTo>
                  <a:lnTo>
                    <a:pt x="38" y="865863"/>
                  </a:lnTo>
                  <a:lnTo>
                    <a:pt x="37" y="867886"/>
                  </a:lnTo>
                  <a:lnTo>
                    <a:pt x="36" y="869909"/>
                  </a:lnTo>
                  <a:lnTo>
                    <a:pt x="35" y="871932"/>
                  </a:lnTo>
                  <a:lnTo>
                    <a:pt x="34" y="873955"/>
                  </a:lnTo>
                  <a:lnTo>
                    <a:pt x="33" y="875978"/>
                  </a:lnTo>
                  <a:lnTo>
                    <a:pt x="32" y="878001"/>
                  </a:lnTo>
                  <a:lnTo>
                    <a:pt x="31" y="880024"/>
                  </a:lnTo>
                  <a:lnTo>
                    <a:pt x="30" y="882047"/>
                  </a:lnTo>
                  <a:lnTo>
                    <a:pt x="29" y="884070"/>
                  </a:lnTo>
                  <a:lnTo>
                    <a:pt x="28" y="886093"/>
                  </a:lnTo>
                  <a:lnTo>
                    <a:pt x="27" y="888116"/>
                  </a:lnTo>
                  <a:lnTo>
                    <a:pt x="26" y="890139"/>
                  </a:lnTo>
                  <a:lnTo>
                    <a:pt x="25" y="892162"/>
                  </a:lnTo>
                  <a:lnTo>
                    <a:pt x="25" y="894185"/>
                  </a:lnTo>
                  <a:lnTo>
                    <a:pt x="24" y="896208"/>
                  </a:lnTo>
                  <a:lnTo>
                    <a:pt x="23" y="898231"/>
                  </a:lnTo>
                  <a:lnTo>
                    <a:pt x="22" y="900255"/>
                  </a:lnTo>
                  <a:lnTo>
                    <a:pt x="21" y="902278"/>
                  </a:lnTo>
                  <a:lnTo>
                    <a:pt x="21" y="904301"/>
                  </a:lnTo>
                  <a:lnTo>
                    <a:pt x="20" y="906324"/>
                  </a:lnTo>
                  <a:lnTo>
                    <a:pt x="19" y="908347"/>
                  </a:lnTo>
                  <a:lnTo>
                    <a:pt x="18" y="910370"/>
                  </a:lnTo>
                  <a:lnTo>
                    <a:pt x="18" y="912393"/>
                  </a:lnTo>
                  <a:lnTo>
                    <a:pt x="17" y="914416"/>
                  </a:lnTo>
                  <a:lnTo>
                    <a:pt x="17" y="916439"/>
                  </a:lnTo>
                  <a:lnTo>
                    <a:pt x="16" y="918462"/>
                  </a:lnTo>
                  <a:lnTo>
                    <a:pt x="15" y="920485"/>
                  </a:lnTo>
                  <a:lnTo>
                    <a:pt x="15" y="922508"/>
                  </a:lnTo>
                  <a:lnTo>
                    <a:pt x="14" y="924531"/>
                  </a:lnTo>
                  <a:lnTo>
                    <a:pt x="14" y="926554"/>
                  </a:lnTo>
                  <a:lnTo>
                    <a:pt x="13" y="928577"/>
                  </a:lnTo>
                  <a:lnTo>
                    <a:pt x="13" y="930600"/>
                  </a:lnTo>
                  <a:lnTo>
                    <a:pt x="12" y="932623"/>
                  </a:lnTo>
                  <a:lnTo>
                    <a:pt x="12" y="934646"/>
                  </a:lnTo>
                  <a:lnTo>
                    <a:pt x="11" y="936669"/>
                  </a:lnTo>
                  <a:lnTo>
                    <a:pt x="11" y="938692"/>
                  </a:lnTo>
                  <a:lnTo>
                    <a:pt x="10" y="940715"/>
                  </a:lnTo>
                  <a:lnTo>
                    <a:pt x="10" y="942738"/>
                  </a:lnTo>
                  <a:lnTo>
                    <a:pt x="9" y="944762"/>
                  </a:lnTo>
                  <a:lnTo>
                    <a:pt x="9" y="946785"/>
                  </a:lnTo>
                  <a:lnTo>
                    <a:pt x="9" y="948808"/>
                  </a:lnTo>
                  <a:lnTo>
                    <a:pt x="8" y="950831"/>
                  </a:lnTo>
                  <a:lnTo>
                    <a:pt x="8" y="952854"/>
                  </a:lnTo>
                  <a:lnTo>
                    <a:pt x="7" y="954877"/>
                  </a:lnTo>
                  <a:lnTo>
                    <a:pt x="7" y="956900"/>
                  </a:lnTo>
                  <a:lnTo>
                    <a:pt x="7" y="958923"/>
                  </a:lnTo>
                  <a:lnTo>
                    <a:pt x="6" y="960946"/>
                  </a:lnTo>
                  <a:lnTo>
                    <a:pt x="6" y="962969"/>
                  </a:lnTo>
                  <a:lnTo>
                    <a:pt x="6" y="964992"/>
                  </a:lnTo>
                  <a:lnTo>
                    <a:pt x="6" y="967015"/>
                  </a:lnTo>
                  <a:lnTo>
                    <a:pt x="5" y="969038"/>
                  </a:lnTo>
                  <a:lnTo>
                    <a:pt x="5" y="971061"/>
                  </a:lnTo>
                  <a:lnTo>
                    <a:pt x="5" y="973084"/>
                  </a:lnTo>
                  <a:lnTo>
                    <a:pt x="5" y="975107"/>
                  </a:lnTo>
                  <a:lnTo>
                    <a:pt x="4" y="977130"/>
                  </a:lnTo>
                  <a:lnTo>
                    <a:pt x="4" y="979153"/>
                  </a:lnTo>
                  <a:lnTo>
                    <a:pt x="4" y="981176"/>
                  </a:lnTo>
                  <a:lnTo>
                    <a:pt x="4" y="983199"/>
                  </a:lnTo>
                  <a:lnTo>
                    <a:pt x="3" y="985222"/>
                  </a:lnTo>
                  <a:lnTo>
                    <a:pt x="3" y="987245"/>
                  </a:lnTo>
                  <a:lnTo>
                    <a:pt x="3" y="989269"/>
                  </a:lnTo>
                  <a:lnTo>
                    <a:pt x="3" y="991292"/>
                  </a:lnTo>
                  <a:lnTo>
                    <a:pt x="3" y="993315"/>
                  </a:lnTo>
                  <a:lnTo>
                    <a:pt x="3" y="995338"/>
                  </a:lnTo>
                  <a:lnTo>
                    <a:pt x="2" y="997361"/>
                  </a:lnTo>
                  <a:lnTo>
                    <a:pt x="2" y="999384"/>
                  </a:lnTo>
                  <a:lnTo>
                    <a:pt x="2" y="1001407"/>
                  </a:lnTo>
                  <a:lnTo>
                    <a:pt x="2" y="1003430"/>
                  </a:lnTo>
                  <a:lnTo>
                    <a:pt x="2" y="1005453"/>
                  </a:lnTo>
                  <a:lnTo>
                    <a:pt x="2" y="1007476"/>
                  </a:lnTo>
                  <a:lnTo>
                    <a:pt x="2" y="1009499"/>
                  </a:lnTo>
                  <a:lnTo>
                    <a:pt x="2" y="1011522"/>
                  </a:lnTo>
                  <a:lnTo>
                    <a:pt x="1" y="1013545"/>
                  </a:lnTo>
                  <a:lnTo>
                    <a:pt x="1" y="1015568"/>
                  </a:lnTo>
                  <a:lnTo>
                    <a:pt x="1" y="1017591"/>
                  </a:lnTo>
                  <a:lnTo>
                    <a:pt x="1" y="1019614"/>
                  </a:lnTo>
                  <a:lnTo>
                    <a:pt x="1" y="1021637"/>
                  </a:lnTo>
                  <a:lnTo>
                    <a:pt x="1" y="1023660"/>
                  </a:lnTo>
                  <a:lnTo>
                    <a:pt x="1" y="1025683"/>
                  </a:lnTo>
                  <a:lnTo>
                    <a:pt x="1" y="1027706"/>
                  </a:lnTo>
                  <a:lnTo>
                    <a:pt x="1" y="1029729"/>
                  </a:lnTo>
                  <a:lnTo>
                    <a:pt x="1" y="1031752"/>
                  </a:lnTo>
                  <a:lnTo>
                    <a:pt x="1" y="1033775"/>
                  </a:lnTo>
                  <a:lnTo>
                    <a:pt x="0" y="1033775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60" name="pl42"/>
            <p:cNvSpPr/>
            <p:nvPr/>
          </p:nvSpPr>
          <p:spPr>
            <a:xfrm>
              <a:off x="5797067" y="2305442"/>
              <a:ext cx="114" cy="1954562"/>
            </a:xfrm>
            <a:custGeom>
              <a:avLst/>
              <a:gdLst/>
              <a:ahLst/>
              <a:cxnLst/>
              <a:rect l="0" t="0" r="0" b="0"/>
              <a:pathLst>
                <a:path w="114" h="1954562">
                  <a:moveTo>
                    <a:pt x="114" y="1954562"/>
                  </a:moveTo>
                  <a:lnTo>
                    <a:pt x="113" y="1954562"/>
                  </a:lnTo>
                  <a:lnTo>
                    <a:pt x="113" y="1950737"/>
                  </a:lnTo>
                  <a:lnTo>
                    <a:pt x="113" y="1946912"/>
                  </a:lnTo>
                  <a:lnTo>
                    <a:pt x="113" y="1943087"/>
                  </a:lnTo>
                  <a:lnTo>
                    <a:pt x="112" y="1939262"/>
                  </a:lnTo>
                  <a:lnTo>
                    <a:pt x="112" y="1935437"/>
                  </a:lnTo>
                  <a:lnTo>
                    <a:pt x="112" y="1931612"/>
                  </a:lnTo>
                  <a:lnTo>
                    <a:pt x="112" y="1927787"/>
                  </a:lnTo>
                  <a:lnTo>
                    <a:pt x="112" y="1923962"/>
                  </a:lnTo>
                  <a:lnTo>
                    <a:pt x="112" y="1920137"/>
                  </a:lnTo>
                  <a:lnTo>
                    <a:pt x="112" y="1916312"/>
                  </a:lnTo>
                  <a:lnTo>
                    <a:pt x="111" y="1912487"/>
                  </a:lnTo>
                  <a:lnTo>
                    <a:pt x="111" y="1908662"/>
                  </a:lnTo>
                  <a:lnTo>
                    <a:pt x="111" y="1904837"/>
                  </a:lnTo>
                  <a:lnTo>
                    <a:pt x="111" y="1901012"/>
                  </a:lnTo>
                  <a:lnTo>
                    <a:pt x="111" y="1897187"/>
                  </a:lnTo>
                  <a:lnTo>
                    <a:pt x="110" y="1893362"/>
                  </a:lnTo>
                  <a:lnTo>
                    <a:pt x="110" y="1889537"/>
                  </a:lnTo>
                  <a:lnTo>
                    <a:pt x="110" y="1885712"/>
                  </a:lnTo>
                  <a:lnTo>
                    <a:pt x="110" y="1881887"/>
                  </a:lnTo>
                  <a:lnTo>
                    <a:pt x="109" y="1878062"/>
                  </a:lnTo>
                  <a:lnTo>
                    <a:pt x="109" y="1874237"/>
                  </a:lnTo>
                  <a:lnTo>
                    <a:pt x="109" y="1870412"/>
                  </a:lnTo>
                  <a:lnTo>
                    <a:pt x="108" y="1866587"/>
                  </a:lnTo>
                  <a:lnTo>
                    <a:pt x="108" y="1862762"/>
                  </a:lnTo>
                  <a:lnTo>
                    <a:pt x="108" y="1858937"/>
                  </a:lnTo>
                  <a:lnTo>
                    <a:pt x="107" y="1855112"/>
                  </a:lnTo>
                  <a:lnTo>
                    <a:pt x="107" y="1851287"/>
                  </a:lnTo>
                  <a:lnTo>
                    <a:pt x="106" y="1847462"/>
                  </a:lnTo>
                  <a:lnTo>
                    <a:pt x="106" y="1843637"/>
                  </a:lnTo>
                  <a:lnTo>
                    <a:pt x="105" y="1839812"/>
                  </a:lnTo>
                  <a:lnTo>
                    <a:pt x="105" y="1835987"/>
                  </a:lnTo>
                  <a:lnTo>
                    <a:pt x="104" y="1832162"/>
                  </a:lnTo>
                  <a:lnTo>
                    <a:pt x="104" y="1828337"/>
                  </a:lnTo>
                  <a:lnTo>
                    <a:pt x="103" y="1824512"/>
                  </a:lnTo>
                  <a:lnTo>
                    <a:pt x="103" y="1820687"/>
                  </a:lnTo>
                  <a:lnTo>
                    <a:pt x="102" y="1816862"/>
                  </a:lnTo>
                  <a:lnTo>
                    <a:pt x="101" y="1813037"/>
                  </a:lnTo>
                  <a:lnTo>
                    <a:pt x="101" y="1809213"/>
                  </a:lnTo>
                  <a:lnTo>
                    <a:pt x="100" y="1805388"/>
                  </a:lnTo>
                  <a:lnTo>
                    <a:pt x="99" y="1801563"/>
                  </a:lnTo>
                  <a:lnTo>
                    <a:pt x="98" y="1797738"/>
                  </a:lnTo>
                  <a:lnTo>
                    <a:pt x="98" y="1793913"/>
                  </a:lnTo>
                  <a:lnTo>
                    <a:pt x="97" y="1790088"/>
                  </a:lnTo>
                  <a:lnTo>
                    <a:pt x="96" y="1786263"/>
                  </a:lnTo>
                  <a:lnTo>
                    <a:pt x="95" y="1782438"/>
                  </a:lnTo>
                  <a:lnTo>
                    <a:pt x="94" y="1778613"/>
                  </a:lnTo>
                  <a:lnTo>
                    <a:pt x="93" y="1774788"/>
                  </a:lnTo>
                  <a:lnTo>
                    <a:pt x="92" y="1770963"/>
                  </a:lnTo>
                  <a:lnTo>
                    <a:pt x="91" y="1767138"/>
                  </a:lnTo>
                  <a:lnTo>
                    <a:pt x="90" y="1763313"/>
                  </a:lnTo>
                  <a:lnTo>
                    <a:pt x="89" y="1759488"/>
                  </a:lnTo>
                  <a:lnTo>
                    <a:pt x="88" y="1755663"/>
                  </a:lnTo>
                  <a:lnTo>
                    <a:pt x="87" y="1751838"/>
                  </a:lnTo>
                  <a:lnTo>
                    <a:pt x="86" y="1748013"/>
                  </a:lnTo>
                  <a:lnTo>
                    <a:pt x="85" y="1744188"/>
                  </a:lnTo>
                  <a:lnTo>
                    <a:pt x="84" y="1740363"/>
                  </a:lnTo>
                  <a:lnTo>
                    <a:pt x="82" y="1736538"/>
                  </a:lnTo>
                  <a:lnTo>
                    <a:pt x="81" y="1732713"/>
                  </a:lnTo>
                  <a:lnTo>
                    <a:pt x="80" y="1728888"/>
                  </a:lnTo>
                  <a:lnTo>
                    <a:pt x="79" y="1725063"/>
                  </a:lnTo>
                  <a:lnTo>
                    <a:pt x="77" y="1721238"/>
                  </a:lnTo>
                  <a:lnTo>
                    <a:pt x="76" y="1717413"/>
                  </a:lnTo>
                  <a:lnTo>
                    <a:pt x="74" y="1713588"/>
                  </a:lnTo>
                  <a:lnTo>
                    <a:pt x="73" y="1709763"/>
                  </a:lnTo>
                  <a:lnTo>
                    <a:pt x="72" y="1705938"/>
                  </a:lnTo>
                  <a:lnTo>
                    <a:pt x="70" y="1702113"/>
                  </a:lnTo>
                  <a:lnTo>
                    <a:pt x="69" y="1698288"/>
                  </a:lnTo>
                  <a:lnTo>
                    <a:pt x="67" y="1694463"/>
                  </a:lnTo>
                  <a:lnTo>
                    <a:pt x="66" y="1690638"/>
                  </a:lnTo>
                  <a:lnTo>
                    <a:pt x="64" y="1686813"/>
                  </a:lnTo>
                  <a:lnTo>
                    <a:pt x="62" y="1682988"/>
                  </a:lnTo>
                  <a:lnTo>
                    <a:pt x="61" y="1679163"/>
                  </a:lnTo>
                  <a:lnTo>
                    <a:pt x="59" y="1675338"/>
                  </a:lnTo>
                  <a:lnTo>
                    <a:pt x="58" y="1671513"/>
                  </a:lnTo>
                  <a:lnTo>
                    <a:pt x="56" y="1667688"/>
                  </a:lnTo>
                  <a:lnTo>
                    <a:pt x="54" y="1663863"/>
                  </a:lnTo>
                  <a:lnTo>
                    <a:pt x="53" y="1660038"/>
                  </a:lnTo>
                  <a:lnTo>
                    <a:pt x="51" y="1656214"/>
                  </a:lnTo>
                  <a:lnTo>
                    <a:pt x="49" y="1652389"/>
                  </a:lnTo>
                  <a:lnTo>
                    <a:pt x="48" y="1648564"/>
                  </a:lnTo>
                  <a:lnTo>
                    <a:pt x="46" y="1644739"/>
                  </a:lnTo>
                  <a:lnTo>
                    <a:pt x="44" y="1640914"/>
                  </a:lnTo>
                  <a:lnTo>
                    <a:pt x="42" y="1637089"/>
                  </a:lnTo>
                  <a:lnTo>
                    <a:pt x="41" y="1633264"/>
                  </a:lnTo>
                  <a:lnTo>
                    <a:pt x="39" y="1629439"/>
                  </a:lnTo>
                  <a:lnTo>
                    <a:pt x="37" y="1625614"/>
                  </a:lnTo>
                  <a:lnTo>
                    <a:pt x="36" y="1621789"/>
                  </a:lnTo>
                  <a:lnTo>
                    <a:pt x="34" y="1617964"/>
                  </a:lnTo>
                  <a:lnTo>
                    <a:pt x="33" y="1614139"/>
                  </a:lnTo>
                  <a:lnTo>
                    <a:pt x="31" y="1610314"/>
                  </a:lnTo>
                  <a:lnTo>
                    <a:pt x="29" y="1606489"/>
                  </a:lnTo>
                  <a:lnTo>
                    <a:pt x="28" y="1602664"/>
                  </a:lnTo>
                  <a:lnTo>
                    <a:pt x="26" y="1598839"/>
                  </a:lnTo>
                  <a:lnTo>
                    <a:pt x="25" y="1595014"/>
                  </a:lnTo>
                  <a:lnTo>
                    <a:pt x="23" y="1591189"/>
                  </a:lnTo>
                  <a:lnTo>
                    <a:pt x="22" y="1587364"/>
                  </a:lnTo>
                  <a:lnTo>
                    <a:pt x="20" y="1583539"/>
                  </a:lnTo>
                  <a:lnTo>
                    <a:pt x="19" y="1579714"/>
                  </a:lnTo>
                  <a:lnTo>
                    <a:pt x="18" y="1575889"/>
                  </a:lnTo>
                  <a:lnTo>
                    <a:pt x="16" y="1572064"/>
                  </a:lnTo>
                  <a:lnTo>
                    <a:pt x="15" y="1568239"/>
                  </a:lnTo>
                  <a:lnTo>
                    <a:pt x="14" y="1564414"/>
                  </a:lnTo>
                  <a:lnTo>
                    <a:pt x="13" y="1560589"/>
                  </a:lnTo>
                  <a:lnTo>
                    <a:pt x="11" y="1556764"/>
                  </a:lnTo>
                  <a:lnTo>
                    <a:pt x="10" y="1552939"/>
                  </a:lnTo>
                  <a:lnTo>
                    <a:pt x="9" y="1549114"/>
                  </a:lnTo>
                  <a:lnTo>
                    <a:pt x="8" y="1545289"/>
                  </a:lnTo>
                  <a:lnTo>
                    <a:pt x="7" y="1541464"/>
                  </a:lnTo>
                  <a:lnTo>
                    <a:pt x="6" y="1537639"/>
                  </a:lnTo>
                  <a:lnTo>
                    <a:pt x="5" y="1533814"/>
                  </a:lnTo>
                  <a:lnTo>
                    <a:pt x="5" y="1529989"/>
                  </a:lnTo>
                  <a:lnTo>
                    <a:pt x="4" y="1526164"/>
                  </a:lnTo>
                  <a:lnTo>
                    <a:pt x="3" y="1522339"/>
                  </a:lnTo>
                  <a:lnTo>
                    <a:pt x="3" y="1518514"/>
                  </a:lnTo>
                  <a:lnTo>
                    <a:pt x="2" y="1514689"/>
                  </a:lnTo>
                  <a:lnTo>
                    <a:pt x="1" y="1510864"/>
                  </a:lnTo>
                  <a:lnTo>
                    <a:pt x="1" y="1507040"/>
                  </a:lnTo>
                  <a:lnTo>
                    <a:pt x="1" y="1503215"/>
                  </a:lnTo>
                  <a:lnTo>
                    <a:pt x="0" y="1499390"/>
                  </a:lnTo>
                  <a:lnTo>
                    <a:pt x="0" y="1495565"/>
                  </a:lnTo>
                  <a:lnTo>
                    <a:pt x="0" y="1491740"/>
                  </a:lnTo>
                  <a:lnTo>
                    <a:pt x="0" y="1487915"/>
                  </a:lnTo>
                  <a:lnTo>
                    <a:pt x="0" y="1484090"/>
                  </a:lnTo>
                  <a:lnTo>
                    <a:pt x="0" y="1480265"/>
                  </a:lnTo>
                  <a:lnTo>
                    <a:pt x="0" y="1476440"/>
                  </a:lnTo>
                  <a:lnTo>
                    <a:pt x="0" y="1472615"/>
                  </a:lnTo>
                  <a:lnTo>
                    <a:pt x="0" y="1468790"/>
                  </a:lnTo>
                  <a:lnTo>
                    <a:pt x="0" y="1464965"/>
                  </a:lnTo>
                  <a:lnTo>
                    <a:pt x="0" y="1461140"/>
                  </a:lnTo>
                  <a:lnTo>
                    <a:pt x="0" y="1457315"/>
                  </a:lnTo>
                  <a:lnTo>
                    <a:pt x="1" y="1453490"/>
                  </a:lnTo>
                  <a:lnTo>
                    <a:pt x="1" y="1449665"/>
                  </a:lnTo>
                  <a:lnTo>
                    <a:pt x="2" y="1445840"/>
                  </a:lnTo>
                  <a:lnTo>
                    <a:pt x="2" y="1442015"/>
                  </a:lnTo>
                  <a:lnTo>
                    <a:pt x="3" y="1438190"/>
                  </a:lnTo>
                  <a:lnTo>
                    <a:pt x="3" y="1434365"/>
                  </a:lnTo>
                  <a:lnTo>
                    <a:pt x="4" y="1430540"/>
                  </a:lnTo>
                  <a:lnTo>
                    <a:pt x="5" y="1426715"/>
                  </a:lnTo>
                  <a:lnTo>
                    <a:pt x="5" y="1422890"/>
                  </a:lnTo>
                  <a:lnTo>
                    <a:pt x="6" y="1419065"/>
                  </a:lnTo>
                  <a:lnTo>
                    <a:pt x="7" y="1415240"/>
                  </a:lnTo>
                  <a:lnTo>
                    <a:pt x="8" y="1411415"/>
                  </a:lnTo>
                  <a:lnTo>
                    <a:pt x="8" y="1407590"/>
                  </a:lnTo>
                  <a:lnTo>
                    <a:pt x="9" y="1403765"/>
                  </a:lnTo>
                  <a:lnTo>
                    <a:pt x="10" y="1399940"/>
                  </a:lnTo>
                  <a:lnTo>
                    <a:pt x="11" y="1396115"/>
                  </a:lnTo>
                  <a:lnTo>
                    <a:pt x="12" y="1392290"/>
                  </a:lnTo>
                  <a:lnTo>
                    <a:pt x="13" y="1388465"/>
                  </a:lnTo>
                  <a:lnTo>
                    <a:pt x="14" y="1384640"/>
                  </a:lnTo>
                  <a:lnTo>
                    <a:pt x="15" y="1380815"/>
                  </a:lnTo>
                  <a:lnTo>
                    <a:pt x="16" y="1376990"/>
                  </a:lnTo>
                  <a:lnTo>
                    <a:pt x="17" y="1373165"/>
                  </a:lnTo>
                  <a:lnTo>
                    <a:pt x="18" y="1369340"/>
                  </a:lnTo>
                  <a:lnTo>
                    <a:pt x="19" y="1365515"/>
                  </a:lnTo>
                  <a:lnTo>
                    <a:pt x="20" y="1361690"/>
                  </a:lnTo>
                  <a:lnTo>
                    <a:pt x="22" y="1357865"/>
                  </a:lnTo>
                  <a:lnTo>
                    <a:pt x="23" y="1354041"/>
                  </a:lnTo>
                  <a:lnTo>
                    <a:pt x="24" y="1350216"/>
                  </a:lnTo>
                  <a:lnTo>
                    <a:pt x="25" y="1346391"/>
                  </a:lnTo>
                  <a:lnTo>
                    <a:pt x="26" y="1342566"/>
                  </a:lnTo>
                  <a:lnTo>
                    <a:pt x="27" y="1338741"/>
                  </a:lnTo>
                  <a:lnTo>
                    <a:pt x="28" y="1334916"/>
                  </a:lnTo>
                  <a:lnTo>
                    <a:pt x="29" y="1331091"/>
                  </a:lnTo>
                  <a:lnTo>
                    <a:pt x="30" y="1327266"/>
                  </a:lnTo>
                  <a:lnTo>
                    <a:pt x="31" y="1323441"/>
                  </a:lnTo>
                  <a:lnTo>
                    <a:pt x="32" y="1319616"/>
                  </a:lnTo>
                  <a:lnTo>
                    <a:pt x="34" y="1315791"/>
                  </a:lnTo>
                  <a:lnTo>
                    <a:pt x="35" y="1311966"/>
                  </a:lnTo>
                  <a:lnTo>
                    <a:pt x="36" y="1308141"/>
                  </a:lnTo>
                  <a:lnTo>
                    <a:pt x="37" y="1304316"/>
                  </a:lnTo>
                  <a:lnTo>
                    <a:pt x="38" y="1300491"/>
                  </a:lnTo>
                  <a:lnTo>
                    <a:pt x="39" y="1296666"/>
                  </a:lnTo>
                  <a:lnTo>
                    <a:pt x="40" y="1292841"/>
                  </a:lnTo>
                  <a:lnTo>
                    <a:pt x="41" y="1289016"/>
                  </a:lnTo>
                  <a:lnTo>
                    <a:pt x="42" y="1285191"/>
                  </a:lnTo>
                  <a:lnTo>
                    <a:pt x="43" y="1281366"/>
                  </a:lnTo>
                  <a:lnTo>
                    <a:pt x="44" y="1277541"/>
                  </a:lnTo>
                  <a:lnTo>
                    <a:pt x="45" y="1273716"/>
                  </a:lnTo>
                  <a:lnTo>
                    <a:pt x="46" y="1269891"/>
                  </a:lnTo>
                  <a:lnTo>
                    <a:pt x="47" y="1266066"/>
                  </a:lnTo>
                  <a:lnTo>
                    <a:pt x="47" y="1262241"/>
                  </a:lnTo>
                  <a:lnTo>
                    <a:pt x="48" y="1258416"/>
                  </a:lnTo>
                  <a:lnTo>
                    <a:pt x="49" y="1254591"/>
                  </a:lnTo>
                  <a:lnTo>
                    <a:pt x="50" y="1250766"/>
                  </a:lnTo>
                  <a:lnTo>
                    <a:pt x="51" y="1246941"/>
                  </a:lnTo>
                  <a:lnTo>
                    <a:pt x="52" y="1243116"/>
                  </a:lnTo>
                  <a:lnTo>
                    <a:pt x="53" y="1239291"/>
                  </a:lnTo>
                  <a:lnTo>
                    <a:pt x="53" y="1235466"/>
                  </a:lnTo>
                  <a:lnTo>
                    <a:pt x="54" y="1231641"/>
                  </a:lnTo>
                  <a:lnTo>
                    <a:pt x="55" y="1227816"/>
                  </a:lnTo>
                  <a:lnTo>
                    <a:pt x="56" y="1223991"/>
                  </a:lnTo>
                  <a:lnTo>
                    <a:pt x="56" y="1220166"/>
                  </a:lnTo>
                  <a:lnTo>
                    <a:pt x="57" y="1216341"/>
                  </a:lnTo>
                  <a:lnTo>
                    <a:pt x="58" y="1212516"/>
                  </a:lnTo>
                  <a:lnTo>
                    <a:pt x="59" y="1208691"/>
                  </a:lnTo>
                  <a:lnTo>
                    <a:pt x="59" y="1204867"/>
                  </a:lnTo>
                  <a:lnTo>
                    <a:pt x="60" y="1201042"/>
                  </a:lnTo>
                  <a:lnTo>
                    <a:pt x="61" y="1197217"/>
                  </a:lnTo>
                  <a:lnTo>
                    <a:pt x="62" y="1193392"/>
                  </a:lnTo>
                  <a:lnTo>
                    <a:pt x="62" y="1189567"/>
                  </a:lnTo>
                  <a:lnTo>
                    <a:pt x="63" y="1185742"/>
                  </a:lnTo>
                  <a:lnTo>
                    <a:pt x="64" y="1181917"/>
                  </a:lnTo>
                  <a:lnTo>
                    <a:pt x="64" y="1178092"/>
                  </a:lnTo>
                  <a:lnTo>
                    <a:pt x="65" y="1174267"/>
                  </a:lnTo>
                  <a:lnTo>
                    <a:pt x="66" y="1170442"/>
                  </a:lnTo>
                  <a:lnTo>
                    <a:pt x="66" y="1166617"/>
                  </a:lnTo>
                  <a:lnTo>
                    <a:pt x="67" y="1162792"/>
                  </a:lnTo>
                  <a:lnTo>
                    <a:pt x="68" y="1158967"/>
                  </a:lnTo>
                  <a:lnTo>
                    <a:pt x="68" y="1155142"/>
                  </a:lnTo>
                  <a:lnTo>
                    <a:pt x="69" y="1151317"/>
                  </a:lnTo>
                  <a:lnTo>
                    <a:pt x="70" y="1147492"/>
                  </a:lnTo>
                  <a:lnTo>
                    <a:pt x="70" y="1143667"/>
                  </a:lnTo>
                  <a:lnTo>
                    <a:pt x="71" y="1139842"/>
                  </a:lnTo>
                  <a:lnTo>
                    <a:pt x="72" y="1136017"/>
                  </a:lnTo>
                  <a:lnTo>
                    <a:pt x="72" y="1132192"/>
                  </a:lnTo>
                  <a:lnTo>
                    <a:pt x="73" y="1128367"/>
                  </a:lnTo>
                  <a:lnTo>
                    <a:pt x="74" y="1124542"/>
                  </a:lnTo>
                  <a:lnTo>
                    <a:pt x="74" y="1120717"/>
                  </a:lnTo>
                  <a:lnTo>
                    <a:pt x="75" y="1116892"/>
                  </a:lnTo>
                  <a:lnTo>
                    <a:pt x="76" y="1113067"/>
                  </a:lnTo>
                  <a:lnTo>
                    <a:pt x="76" y="1109242"/>
                  </a:lnTo>
                  <a:lnTo>
                    <a:pt x="77" y="1105417"/>
                  </a:lnTo>
                  <a:lnTo>
                    <a:pt x="78" y="1101592"/>
                  </a:lnTo>
                  <a:lnTo>
                    <a:pt x="78" y="1097767"/>
                  </a:lnTo>
                  <a:lnTo>
                    <a:pt x="79" y="1093942"/>
                  </a:lnTo>
                  <a:lnTo>
                    <a:pt x="80" y="1090117"/>
                  </a:lnTo>
                  <a:lnTo>
                    <a:pt x="80" y="1086292"/>
                  </a:lnTo>
                  <a:lnTo>
                    <a:pt x="81" y="1082467"/>
                  </a:lnTo>
                  <a:lnTo>
                    <a:pt x="82" y="1078642"/>
                  </a:lnTo>
                  <a:lnTo>
                    <a:pt x="82" y="1074817"/>
                  </a:lnTo>
                  <a:lnTo>
                    <a:pt x="83" y="1070992"/>
                  </a:lnTo>
                  <a:lnTo>
                    <a:pt x="84" y="1067167"/>
                  </a:lnTo>
                  <a:lnTo>
                    <a:pt x="84" y="1063342"/>
                  </a:lnTo>
                  <a:lnTo>
                    <a:pt x="85" y="1059517"/>
                  </a:lnTo>
                  <a:lnTo>
                    <a:pt x="86" y="1055693"/>
                  </a:lnTo>
                  <a:lnTo>
                    <a:pt x="86" y="1051868"/>
                  </a:lnTo>
                  <a:lnTo>
                    <a:pt x="87" y="1048043"/>
                  </a:lnTo>
                  <a:lnTo>
                    <a:pt x="88" y="1044218"/>
                  </a:lnTo>
                  <a:lnTo>
                    <a:pt x="88" y="1040393"/>
                  </a:lnTo>
                  <a:lnTo>
                    <a:pt x="89" y="1036568"/>
                  </a:lnTo>
                  <a:lnTo>
                    <a:pt x="90" y="1032743"/>
                  </a:lnTo>
                  <a:lnTo>
                    <a:pt x="90" y="1028918"/>
                  </a:lnTo>
                  <a:lnTo>
                    <a:pt x="91" y="1025093"/>
                  </a:lnTo>
                  <a:lnTo>
                    <a:pt x="92" y="1021268"/>
                  </a:lnTo>
                  <a:lnTo>
                    <a:pt x="92" y="1017443"/>
                  </a:lnTo>
                  <a:lnTo>
                    <a:pt x="93" y="1013618"/>
                  </a:lnTo>
                  <a:lnTo>
                    <a:pt x="93" y="1009793"/>
                  </a:lnTo>
                  <a:lnTo>
                    <a:pt x="94" y="1005968"/>
                  </a:lnTo>
                  <a:lnTo>
                    <a:pt x="95" y="1002143"/>
                  </a:lnTo>
                  <a:lnTo>
                    <a:pt x="95" y="998318"/>
                  </a:lnTo>
                  <a:lnTo>
                    <a:pt x="96" y="994493"/>
                  </a:lnTo>
                  <a:lnTo>
                    <a:pt x="96" y="990668"/>
                  </a:lnTo>
                  <a:lnTo>
                    <a:pt x="97" y="986843"/>
                  </a:lnTo>
                  <a:lnTo>
                    <a:pt x="97" y="983018"/>
                  </a:lnTo>
                  <a:lnTo>
                    <a:pt x="98" y="979193"/>
                  </a:lnTo>
                  <a:lnTo>
                    <a:pt x="98" y="975368"/>
                  </a:lnTo>
                  <a:lnTo>
                    <a:pt x="99" y="971543"/>
                  </a:lnTo>
                  <a:lnTo>
                    <a:pt x="99" y="967718"/>
                  </a:lnTo>
                  <a:lnTo>
                    <a:pt x="100" y="963893"/>
                  </a:lnTo>
                  <a:lnTo>
                    <a:pt x="100" y="960068"/>
                  </a:lnTo>
                  <a:lnTo>
                    <a:pt x="101" y="956243"/>
                  </a:lnTo>
                  <a:lnTo>
                    <a:pt x="101" y="952418"/>
                  </a:lnTo>
                  <a:lnTo>
                    <a:pt x="102" y="948593"/>
                  </a:lnTo>
                  <a:lnTo>
                    <a:pt x="102" y="944768"/>
                  </a:lnTo>
                  <a:lnTo>
                    <a:pt x="103" y="940943"/>
                  </a:lnTo>
                  <a:lnTo>
                    <a:pt x="103" y="937118"/>
                  </a:lnTo>
                  <a:lnTo>
                    <a:pt x="103" y="933293"/>
                  </a:lnTo>
                  <a:lnTo>
                    <a:pt x="104" y="929468"/>
                  </a:lnTo>
                  <a:lnTo>
                    <a:pt x="104" y="925643"/>
                  </a:lnTo>
                  <a:lnTo>
                    <a:pt x="105" y="921818"/>
                  </a:lnTo>
                  <a:lnTo>
                    <a:pt x="105" y="917993"/>
                  </a:lnTo>
                  <a:lnTo>
                    <a:pt x="105" y="914168"/>
                  </a:lnTo>
                  <a:lnTo>
                    <a:pt x="106" y="910343"/>
                  </a:lnTo>
                  <a:lnTo>
                    <a:pt x="106" y="906518"/>
                  </a:lnTo>
                  <a:lnTo>
                    <a:pt x="106" y="902694"/>
                  </a:lnTo>
                  <a:lnTo>
                    <a:pt x="106" y="898869"/>
                  </a:lnTo>
                  <a:lnTo>
                    <a:pt x="107" y="895044"/>
                  </a:lnTo>
                  <a:lnTo>
                    <a:pt x="107" y="891219"/>
                  </a:lnTo>
                  <a:lnTo>
                    <a:pt x="107" y="887394"/>
                  </a:lnTo>
                  <a:lnTo>
                    <a:pt x="107" y="883569"/>
                  </a:lnTo>
                  <a:lnTo>
                    <a:pt x="108" y="879744"/>
                  </a:lnTo>
                  <a:lnTo>
                    <a:pt x="108" y="875919"/>
                  </a:lnTo>
                  <a:lnTo>
                    <a:pt x="108" y="872094"/>
                  </a:lnTo>
                  <a:lnTo>
                    <a:pt x="108" y="868269"/>
                  </a:lnTo>
                  <a:lnTo>
                    <a:pt x="108" y="864444"/>
                  </a:lnTo>
                  <a:lnTo>
                    <a:pt x="109" y="860619"/>
                  </a:lnTo>
                  <a:lnTo>
                    <a:pt x="109" y="856794"/>
                  </a:lnTo>
                  <a:lnTo>
                    <a:pt x="109" y="852969"/>
                  </a:lnTo>
                  <a:lnTo>
                    <a:pt x="109" y="849144"/>
                  </a:lnTo>
                  <a:lnTo>
                    <a:pt x="109" y="845319"/>
                  </a:lnTo>
                  <a:lnTo>
                    <a:pt x="109" y="841494"/>
                  </a:lnTo>
                  <a:lnTo>
                    <a:pt x="109" y="837669"/>
                  </a:lnTo>
                  <a:lnTo>
                    <a:pt x="109" y="833844"/>
                  </a:lnTo>
                  <a:lnTo>
                    <a:pt x="109" y="830019"/>
                  </a:lnTo>
                  <a:lnTo>
                    <a:pt x="109" y="826194"/>
                  </a:lnTo>
                  <a:lnTo>
                    <a:pt x="109" y="822369"/>
                  </a:lnTo>
                  <a:lnTo>
                    <a:pt x="109" y="818544"/>
                  </a:lnTo>
                  <a:lnTo>
                    <a:pt x="109" y="814719"/>
                  </a:lnTo>
                  <a:lnTo>
                    <a:pt x="109" y="810894"/>
                  </a:lnTo>
                  <a:lnTo>
                    <a:pt x="109" y="807069"/>
                  </a:lnTo>
                  <a:lnTo>
                    <a:pt x="109" y="803244"/>
                  </a:lnTo>
                  <a:lnTo>
                    <a:pt x="109" y="799419"/>
                  </a:lnTo>
                  <a:lnTo>
                    <a:pt x="109" y="795594"/>
                  </a:lnTo>
                  <a:lnTo>
                    <a:pt x="109" y="791769"/>
                  </a:lnTo>
                  <a:lnTo>
                    <a:pt x="109" y="787944"/>
                  </a:lnTo>
                  <a:lnTo>
                    <a:pt x="109" y="784119"/>
                  </a:lnTo>
                  <a:lnTo>
                    <a:pt x="109" y="780294"/>
                  </a:lnTo>
                  <a:lnTo>
                    <a:pt x="108" y="776469"/>
                  </a:lnTo>
                  <a:lnTo>
                    <a:pt x="108" y="772644"/>
                  </a:lnTo>
                  <a:lnTo>
                    <a:pt x="108" y="768819"/>
                  </a:lnTo>
                  <a:lnTo>
                    <a:pt x="108" y="764994"/>
                  </a:lnTo>
                  <a:lnTo>
                    <a:pt x="108" y="761169"/>
                  </a:lnTo>
                  <a:lnTo>
                    <a:pt x="108" y="757344"/>
                  </a:lnTo>
                  <a:lnTo>
                    <a:pt x="107" y="753520"/>
                  </a:lnTo>
                  <a:lnTo>
                    <a:pt x="107" y="749695"/>
                  </a:lnTo>
                  <a:lnTo>
                    <a:pt x="107" y="745870"/>
                  </a:lnTo>
                  <a:lnTo>
                    <a:pt x="107" y="742045"/>
                  </a:lnTo>
                  <a:lnTo>
                    <a:pt x="106" y="738220"/>
                  </a:lnTo>
                  <a:lnTo>
                    <a:pt x="106" y="734395"/>
                  </a:lnTo>
                  <a:lnTo>
                    <a:pt x="106" y="730570"/>
                  </a:lnTo>
                  <a:lnTo>
                    <a:pt x="105" y="726745"/>
                  </a:lnTo>
                  <a:lnTo>
                    <a:pt x="105" y="722920"/>
                  </a:lnTo>
                  <a:lnTo>
                    <a:pt x="105" y="719095"/>
                  </a:lnTo>
                  <a:lnTo>
                    <a:pt x="104" y="715270"/>
                  </a:lnTo>
                  <a:lnTo>
                    <a:pt x="104" y="711445"/>
                  </a:lnTo>
                  <a:lnTo>
                    <a:pt x="104" y="707620"/>
                  </a:lnTo>
                  <a:lnTo>
                    <a:pt x="103" y="703795"/>
                  </a:lnTo>
                  <a:lnTo>
                    <a:pt x="103" y="699970"/>
                  </a:lnTo>
                  <a:lnTo>
                    <a:pt x="103" y="696145"/>
                  </a:lnTo>
                  <a:lnTo>
                    <a:pt x="102" y="692320"/>
                  </a:lnTo>
                  <a:lnTo>
                    <a:pt x="102" y="688495"/>
                  </a:lnTo>
                  <a:lnTo>
                    <a:pt x="101" y="684670"/>
                  </a:lnTo>
                  <a:lnTo>
                    <a:pt x="101" y="680845"/>
                  </a:lnTo>
                  <a:lnTo>
                    <a:pt x="100" y="677020"/>
                  </a:lnTo>
                  <a:lnTo>
                    <a:pt x="100" y="673195"/>
                  </a:lnTo>
                  <a:lnTo>
                    <a:pt x="99" y="669370"/>
                  </a:lnTo>
                  <a:lnTo>
                    <a:pt x="99" y="665545"/>
                  </a:lnTo>
                  <a:lnTo>
                    <a:pt x="98" y="661720"/>
                  </a:lnTo>
                  <a:lnTo>
                    <a:pt x="98" y="657895"/>
                  </a:lnTo>
                  <a:lnTo>
                    <a:pt x="97" y="654070"/>
                  </a:lnTo>
                  <a:lnTo>
                    <a:pt x="97" y="650245"/>
                  </a:lnTo>
                  <a:lnTo>
                    <a:pt x="96" y="646420"/>
                  </a:lnTo>
                  <a:lnTo>
                    <a:pt x="96" y="642595"/>
                  </a:lnTo>
                  <a:lnTo>
                    <a:pt x="95" y="638770"/>
                  </a:lnTo>
                  <a:lnTo>
                    <a:pt x="95" y="634945"/>
                  </a:lnTo>
                  <a:lnTo>
                    <a:pt x="94" y="631120"/>
                  </a:lnTo>
                  <a:lnTo>
                    <a:pt x="94" y="627295"/>
                  </a:lnTo>
                  <a:lnTo>
                    <a:pt x="93" y="623470"/>
                  </a:lnTo>
                  <a:lnTo>
                    <a:pt x="93" y="619645"/>
                  </a:lnTo>
                  <a:lnTo>
                    <a:pt x="92" y="615820"/>
                  </a:lnTo>
                  <a:lnTo>
                    <a:pt x="92" y="611995"/>
                  </a:lnTo>
                  <a:lnTo>
                    <a:pt x="91" y="608170"/>
                  </a:lnTo>
                  <a:lnTo>
                    <a:pt x="90" y="604345"/>
                  </a:lnTo>
                  <a:lnTo>
                    <a:pt x="90" y="600521"/>
                  </a:lnTo>
                  <a:lnTo>
                    <a:pt x="89" y="596696"/>
                  </a:lnTo>
                  <a:lnTo>
                    <a:pt x="89" y="592871"/>
                  </a:lnTo>
                  <a:lnTo>
                    <a:pt x="88" y="589046"/>
                  </a:lnTo>
                  <a:lnTo>
                    <a:pt x="88" y="585221"/>
                  </a:lnTo>
                  <a:lnTo>
                    <a:pt x="87" y="581396"/>
                  </a:lnTo>
                  <a:lnTo>
                    <a:pt x="87" y="577571"/>
                  </a:lnTo>
                  <a:lnTo>
                    <a:pt x="86" y="573746"/>
                  </a:lnTo>
                  <a:lnTo>
                    <a:pt x="86" y="569921"/>
                  </a:lnTo>
                  <a:lnTo>
                    <a:pt x="85" y="566096"/>
                  </a:lnTo>
                  <a:lnTo>
                    <a:pt x="85" y="562271"/>
                  </a:lnTo>
                  <a:lnTo>
                    <a:pt x="84" y="558446"/>
                  </a:lnTo>
                  <a:lnTo>
                    <a:pt x="84" y="554621"/>
                  </a:lnTo>
                  <a:lnTo>
                    <a:pt x="83" y="550796"/>
                  </a:lnTo>
                  <a:lnTo>
                    <a:pt x="83" y="546971"/>
                  </a:lnTo>
                  <a:lnTo>
                    <a:pt x="82" y="543146"/>
                  </a:lnTo>
                  <a:lnTo>
                    <a:pt x="82" y="539321"/>
                  </a:lnTo>
                  <a:lnTo>
                    <a:pt x="82" y="535496"/>
                  </a:lnTo>
                  <a:lnTo>
                    <a:pt x="81" y="531671"/>
                  </a:lnTo>
                  <a:lnTo>
                    <a:pt x="81" y="527846"/>
                  </a:lnTo>
                  <a:lnTo>
                    <a:pt x="81" y="524021"/>
                  </a:lnTo>
                  <a:lnTo>
                    <a:pt x="80" y="520196"/>
                  </a:lnTo>
                  <a:lnTo>
                    <a:pt x="80" y="516371"/>
                  </a:lnTo>
                  <a:lnTo>
                    <a:pt x="80" y="512546"/>
                  </a:lnTo>
                  <a:lnTo>
                    <a:pt x="79" y="508721"/>
                  </a:lnTo>
                  <a:lnTo>
                    <a:pt x="79" y="504896"/>
                  </a:lnTo>
                  <a:lnTo>
                    <a:pt x="79" y="501071"/>
                  </a:lnTo>
                  <a:lnTo>
                    <a:pt x="79" y="497246"/>
                  </a:lnTo>
                  <a:lnTo>
                    <a:pt x="78" y="493421"/>
                  </a:lnTo>
                  <a:lnTo>
                    <a:pt x="78" y="489596"/>
                  </a:lnTo>
                  <a:lnTo>
                    <a:pt x="78" y="485771"/>
                  </a:lnTo>
                  <a:lnTo>
                    <a:pt x="78" y="481946"/>
                  </a:lnTo>
                  <a:lnTo>
                    <a:pt x="78" y="478121"/>
                  </a:lnTo>
                  <a:lnTo>
                    <a:pt x="78" y="474296"/>
                  </a:lnTo>
                  <a:lnTo>
                    <a:pt x="78" y="470471"/>
                  </a:lnTo>
                  <a:lnTo>
                    <a:pt x="78" y="466646"/>
                  </a:lnTo>
                  <a:lnTo>
                    <a:pt x="78" y="462821"/>
                  </a:lnTo>
                  <a:lnTo>
                    <a:pt x="78" y="458996"/>
                  </a:lnTo>
                  <a:lnTo>
                    <a:pt x="78" y="455171"/>
                  </a:lnTo>
                  <a:lnTo>
                    <a:pt x="78" y="451347"/>
                  </a:lnTo>
                  <a:lnTo>
                    <a:pt x="78" y="447522"/>
                  </a:lnTo>
                  <a:lnTo>
                    <a:pt x="78" y="443697"/>
                  </a:lnTo>
                  <a:lnTo>
                    <a:pt x="78" y="439872"/>
                  </a:lnTo>
                  <a:lnTo>
                    <a:pt x="78" y="436047"/>
                  </a:lnTo>
                  <a:lnTo>
                    <a:pt x="78" y="432222"/>
                  </a:lnTo>
                  <a:lnTo>
                    <a:pt x="78" y="428397"/>
                  </a:lnTo>
                  <a:lnTo>
                    <a:pt x="78" y="424572"/>
                  </a:lnTo>
                  <a:lnTo>
                    <a:pt x="79" y="420747"/>
                  </a:lnTo>
                  <a:lnTo>
                    <a:pt x="79" y="416922"/>
                  </a:lnTo>
                  <a:lnTo>
                    <a:pt x="79" y="413097"/>
                  </a:lnTo>
                  <a:lnTo>
                    <a:pt x="79" y="409272"/>
                  </a:lnTo>
                  <a:lnTo>
                    <a:pt x="80" y="405447"/>
                  </a:lnTo>
                  <a:lnTo>
                    <a:pt x="80" y="401622"/>
                  </a:lnTo>
                  <a:lnTo>
                    <a:pt x="80" y="397797"/>
                  </a:lnTo>
                  <a:lnTo>
                    <a:pt x="81" y="393972"/>
                  </a:lnTo>
                  <a:lnTo>
                    <a:pt x="81" y="390147"/>
                  </a:lnTo>
                  <a:lnTo>
                    <a:pt x="82" y="386322"/>
                  </a:lnTo>
                  <a:lnTo>
                    <a:pt x="82" y="382497"/>
                  </a:lnTo>
                  <a:lnTo>
                    <a:pt x="82" y="378672"/>
                  </a:lnTo>
                  <a:lnTo>
                    <a:pt x="83" y="374847"/>
                  </a:lnTo>
                  <a:lnTo>
                    <a:pt x="83" y="371022"/>
                  </a:lnTo>
                  <a:lnTo>
                    <a:pt x="84" y="367197"/>
                  </a:lnTo>
                  <a:lnTo>
                    <a:pt x="84" y="363372"/>
                  </a:lnTo>
                  <a:lnTo>
                    <a:pt x="85" y="359547"/>
                  </a:lnTo>
                  <a:lnTo>
                    <a:pt x="85" y="355722"/>
                  </a:lnTo>
                  <a:lnTo>
                    <a:pt x="86" y="351897"/>
                  </a:lnTo>
                  <a:lnTo>
                    <a:pt x="86" y="348072"/>
                  </a:lnTo>
                  <a:lnTo>
                    <a:pt x="87" y="344247"/>
                  </a:lnTo>
                  <a:lnTo>
                    <a:pt x="87" y="340422"/>
                  </a:lnTo>
                  <a:lnTo>
                    <a:pt x="88" y="336597"/>
                  </a:lnTo>
                  <a:lnTo>
                    <a:pt x="88" y="332772"/>
                  </a:lnTo>
                  <a:lnTo>
                    <a:pt x="89" y="328947"/>
                  </a:lnTo>
                  <a:lnTo>
                    <a:pt x="89" y="325122"/>
                  </a:lnTo>
                  <a:lnTo>
                    <a:pt x="90" y="321297"/>
                  </a:lnTo>
                  <a:lnTo>
                    <a:pt x="90" y="317472"/>
                  </a:lnTo>
                  <a:lnTo>
                    <a:pt x="91" y="313647"/>
                  </a:lnTo>
                  <a:lnTo>
                    <a:pt x="91" y="309822"/>
                  </a:lnTo>
                  <a:lnTo>
                    <a:pt x="92" y="305997"/>
                  </a:lnTo>
                  <a:lnTo>
                    <a:pt x="93" y="302172"/>
                  </a:lnTo>
                  <a:lnTo>
                    <a:pt x="93" y="298348"/>
                  </a:lnTo>
                  <a:lnTo>
                    <a:pt x="94" y="294523"/>
                  </a:lnTo>
                  <a:lnTo>
                    <a:pt x="94" y="290698"/>
                  </a:lnTo>
                  <a:lnTo>
                    <a:pt x="95" y="286873"/>
                  </a:lnTo>
                  <a:lnTo>
                    <a:pt x="95" y="283048"/>
                  </a:lnTo>
                  <a:lnTo>
                    <a:pt x="96" y="279223"/>
                  </a:lnTo>
                  <a:lnTo>
                    <a:pt x="96" y="275398"/>
                  </a:lnTo>
                  <a:lnTo>
                    <a:pt x="97" y="271573"/>
                  </a:lnTo>
                  <a:lnTo>
                    <a:pt x="97" y="267748"/>
                  </a:lnTo>
                  <a:lnTo>
                    <a:pt x="98" y="263923"/>
                  </a:lnTo>
                  <a:lnTo>
                    <a:pt x="98" y="260098"/>
                  </a:lnTo>
                  <a:lnTo>
                    <a:pt x="99" y="256273"/>
                  </a:lnTo>
                  <a:lnTo>
                    <a:pt x="99" y="252448"/>
                  </a:lnTo>
                  <a:lnTo>
                    <a:pt x="100" y="248623"/>
                  </a:lnTo>
                  <a:lnTo>
                    <a:pt x="100" y="244798"/>
                  </a:lnTo>
                  <a:lnTo>
                    <a:pt x="101" y="240973"/>
                  </a:lnTo>
                  <a:lnTo>
                    <a:pt x="101" y="237148"/>
                  </a:lnTo>
                  <a:lnTo>
                    <a:pt x="102" y="233323"/>
                  </a:lnTo>
                  <a:lnTo>
                    <a:pt x="102" y="229498"/>
                  </a:lnTo>
                  <a:lnTo>
                    <a:pt x="103" y="225673"/>
                  </a:lnTo>
                  <a:lnTo>
                    <a:pt x="103" y="221848"/>
                  </a:lnTo>
                  <a:lnTo>
                    <a:pt x="104" y="218023"/>
                  </a:lnTo>
                  <a:lnTo>
                    <a:pt x="104" y="214198"/>
                  </a:lnTo>
                  <a:lnTo>
                    <a:pt x="104" y="210373"/>
                  </a:lnTo>
                  <a:lnTo>
                    <a:pt x="105" y="206548"/>
                  </a:lnTo>
                  <a:lnTo>
                    <a:pt x="105" y="202723"/>
                  </a:lnTo>
                  <a:lnTo>
                    <a:pt x="105" y="198898"/>
                  </a:lnTo>
                  <a:lnTo>
                    <a:pt x="106" y="195073"/>
                  </a:lnTo>
                  <a:lnTo>
                    <a:pt x="106" y="191248"/>
                  </a:lnTo>
                  <a:lnTo>
                    <a:pt x="107" y="187423"/>
                  </a:lnTo>
                  <a:lnTo>
                    <a:pt x="107" y="183598"/>
                  </a:lnTo>
                  <a:lnTo>
                    <a:pt x="107" y="179773"/>
                  </a:lnTo>
                  <a:lnTo>
                    <a:pt x="107" y="175948"/>
                  </a:lnTo>
                  <a:lnTo>
                    <a:pt x="108" y="172123"/>
                  </a:lnTo>
                  <a:lnTo>
                    <a:pt x="108" y="168298"/>
                  </a:lnTo>
                  <a:lnTo>
                    <a:pt x="108" y="164473"/>
                  </a:lnTo>
                  <a:lnTo>
                    <a:pt x="109" y="160648"/>
                  </a:lnTo>
                  <a:lnTo>
                    <a:pt x="109" y="156823"/>
                  </a:lnTo>
                  <a:lnTo>
                    <a:pt x="109" y="152998"/>
                  </a:lnTo>
                  <a:lnTo>
                    <a:pt x="109" y="149174"/>
                  </a:lnTo>
                  <a:lnTo>
                    <a:pt x="110" y="145349"/>
                  </a:lnTo>
                  <a:lnTo>
                    <a:pt x="110" y="141524"/>
                  </a:lnTo>
                  <a:lnTo>
                    <a:pt x="110" y="137699"/>
                  </a:lnTo>
                  <a:lnTo>
                    <a:pt x="110" y="133874"/>
                  </a:lnTo>
                  <a:lnTo>
                    <a:pt x="110" y="130049"/>
                  </a:lnTo>
                  <a:lnTo>
                    <a:pt x="111" y="126224"/>
                  </a:lnTo>
                  <a:lnTo>
                    <a:pt x="111" y="122399"/>
                  </a:lnTo>
                  <a:lnTo>
                    <a:pt x="111" y="118574"/>
                  </a:lnTo>
                  <a:lnTo>
                    <a:pt x="111" y="114749"/>
                  </a:lnTo>
                  <a:lnTo>
                    <a:pt x="111" y="110924"/>
                  </a:lnTo>
                  <a:lnTo>
                    <a:pt x="111" y="107099"/>
                  </a:lnTo>
                  <a:lnTo>
                    <a:pt x="112" y="103274"/>
                  </a:lnTo>
                  <a:lnTo>
                    <a:pt x="112" y="99449"/>
                  </a:lnTo>
                  <a:lnTo>
                    <a:pt x="112" y="95624"/>
                  </a:lnTo>
                  <a:lnTo>
                    <a:pt x="112" y="91799"/>
                  </a:lnTo>
                  <a:lnTo>
                    <a:pt x="112" y="87974"/>
                  </a:lnTo>
                  <a:lnTo>
                    <a:pt x="112" y="84149"/>
                  </a:lnTo>
                  <a:lnTo>
                    <a:pt x="112" y="80324"/>
                  </a:lnTo>
                  <a:lnTo>
                    <a:pt x="112" y="76499"/>
                  </a:lnTo>
                  <a:lnTo>
                    <a:pt x="113" y="72674"/>
                  </a:lnTo>
                  <a:lnTo>
                    <a:pt x="113" y="68849"/>
                  </a:lnTo>
                  <a:lnTo>
                    <a:pt x="113" y="65024"/>
                  </a:lnTo>
                  <a:lnTo>
                    <a:pt x="113" y="61199"/>
                  </a:lnTo>
                  <a:lnTo>
                    <a:pt x="113" y="57374"/>
                  </a:lnTo>
                  <a:lnTo>
                    <a:pt x="113" y="53549"/>
                  </a:lnTo>
                  <a:lnTo>
                    <a:pt x="113" y="49724"/>
                  </a:lnTo>
                  <a:lnTo>
                    <a:pt x="113" y="45899"/>
                  </a:lnTo>
                  <a:lnTo>
                    <a:pt x="113" y="42074"/>
                  </a:lnTo>
                  <a:lnTo>
                    <a:pt x="113" y="38249"/>
                  </a:lnTo>
                  <a:lnTo>
                    <a:pt x="113" y="34424"/>
                  </a:lnTo>
                  <a:lnTo>
                    <a:pt x="113" y="30599"/>
                  </a:lnTo>
                  <a:lnTo>
                    <a:pt x="113" y="26774"/>
                  </a:lnTo>
                  <a:lnTo>
                    <a:pt x="113" y="22949"/>
                  </a:lnTo>
                  <a:lnTo>
                    <a:pt x="113" y="19124"/>
                  </a:lnTo>
                  <a:lnTo>
                    <a:pt x="114" y="15299"/>
                  </a:lnTo>
                  <a:lnTo>
                    <a:pt x="114" y="11474"/>
                  </a:lnTo>
                  <a:lnTo>
                    <a:pt x="114" y="7649"/>
                  </a:lnTo>
                  <a:lnTo>
                    <a:pt x="114" y="3824"/>
                  </a:lnTo>
                  <a:lnTo>
                    <a:pt x="114" y="0"/>
                  </a:lnTo>
                  <a:lnTo>
                    <a:pt x="114" y="0"/>
                  </a:lnTo>
                  <a:lnTo>
                    <a:pt x="114" y="1954562"/>
                  </a:lnTo>
                  <a:lnTo>
                    <a:pt x="114" y="1954562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61" name="pl43"/>
            <p:cNvSpPr/>
            <p:nvPr/>
          </p:nvSpPr>
          <p:spPr>
            <a:xfrm>
              <a:off x="5797182" y="3259807"/>
              <a:ext cx="372" cy="681642"/>
            </a:xfrm>
            <a:custGeom>
              <a:avLst/>
              <a:gdLst/>
              <a:ahLst/>
              <a:cxnLst/>
              <a:rect l="0" t="0" r="0" b="0"/>
              <a:pathLst>
                <a:path w="372" h="681642">
                  <a:moveTo>
                    <a:pt x="0" y="0"/>
                  </a:moveTo>
                  <a:lnTo>
                    <a:pt x="1" y="0"/>
                  </a:lnTo>
                  <a:lnTo>
                    <a:pt x="1" y="1333"/>
                  </a:lnTo>
                  <a:lnTo>
                    <a:pt x="1" y="2667"/>
                  </a:lnTo>
                  <a:lnTo>
                    <a:pt x="1" y="4001"/>
                  </a:lnTo>
                  <a:lnTo>
                    <a:pt x="1" y="5335"/>
                  </a:lnTo>
                  <a:lnTo>
                    <a:pt x="2" y="6669"/>
                  </a:lnTo>
                  <a:lnTo>
                    <a:pt x="2" y="8003"/>
                  </a:lnTo>
                  <a:lnTo>
                    <a:pt x="2" y="9337"/>
                  </a:lnTo>
                  <a:lnTo>
                    <a:pt x="2" y="10671"/>
                  </a:lnTo>
                  <a:lnTo>
                    <a:pt x="2" y="12005"/>
                  </a:lnTo>
                  <a:lnTo>
                    <a:pt x="2" y="13339"/>
                  </a:lnTo>
                  <a:lnTo>
                    <a:pt x="3" y="14673"/>
                  </a:lnTo>
                  <a:lnTo>
                    <a:pt x="3" y="16007"/>
                  </a:lnTo>
                  <a:lnTo>
                    <a:pt x="3" y="17341"/>
                  </a:lnTo>
                  <a:lnTo>
                    <a:pt x="4" y="18675"/>
                  </a:lnTo>
                  <a:lnTo>
                    <a:pt x="4" y="20009"/>
                  </a:lnTo>
                  <a:lnTo>
                    <a:pt x="4" y="21343"/>
                  </a:lnTo>
                  <a:lnTo>
                    <a:pt x="5" y="22676"/>
                  </a:lnTo>
                  <a:lnTo>
                    <a:pt x="5" y="24010"/>
                  </a:lnTo>
                  <a:lnTo>
                    <a:pt x="5" y="25344"/>
                  </a:lnTo>
                  <a:lnTo>
                    <a:pt x="6" y="26678"/>
                  </a:lnTo>
                  <a:lnTo>
                    <a:pt x="6" y="28012"/>
                  </a:lnTo>
                  <a:lnTo>
                    <a:pt x="7" y="29346"/>
                  </a:lnTo>
                  <a:lnTo>
                    <a:pt x="7" y="30680"/>
                  </a:lnTo>
                  <a:lnTo>
                    <a:pt x="8" y="32014"/>
                  </a:lnTo>
                  <a:lnTo>
                    <a:pt x="8" y="33348"/>
                  </a:lnTo>
                  <a:lnTo>
                    <a:pt x="9" y="34682"/>
                  </a:lnTo>
                  <a:lnTo>
                    <a:pt x="9" y="36016"/>
                  </a:lnTo>
                  <a:lnTo>
                    <a:pt x="10" y="37350"/>
                  </a:lnTo>
                  <a:lnTo>
                    <a:pt x="11" y="38684"/>
                  </a:lnTo>
                  <a:lnTo>
                    <a:pt x="11" y="40018"/>
                  </a:lnTo>
                  <a:lnTo>
                    <a:pt x="12" y="41352"/>
                  </a:lnTo>
                  <a:lnTo>
                    <a:pt x="13" y="42686"/>
                  </a:lnTo>
                  <a:lnTo>
                    <a:pt x="14" y="44019"/>
                  </a:lnTo>
                  <a:lnTo>
                    <a:pt x="14" y="45353"/>
                  </a:lnTo>
                  <a:lnTo>
                    <a:pt x="15" y="46687"/>
                  </a:lnTo>
                  <a:lnTo>
                    <a:pt x="16" y="48021"/>
                  </a:lnTo>
                  <a:lnTo>
                    <a:pt x="17" y="49355"/>
                  </a:lnTo>
                  <a:lnTo>
                    <a:pt x="18" y="50689"/>
                  </a:lnTo>
                  <a:lnTo>
                    <a:pt x="19" y="52023"/>
                  </a:lnTo>
                  <a:lnTo>
                    <a:pt x="20" y="53357"/>
                  </a:lnTo>
                  <a:lnTo>
                    <a:pt x="21" y="54691"/>
                  </a:lnTo>
                  <a:lnTo>
                    <a:pt x="23" y="56025"/>
                  </a:lnTo>
                  <a:lnTo>
                    <a:pt x="24" y="57359"/>
                  </a:lnTo>
                  <a:lnTo>
                    <a:pt x="25" y="58693"/>
                  </a:lnTo>
                  <a:lnTo>
                    <a:pt x="26" y="60027"/>
                  </a:lnTo>
                  <a:lnTo>
                    <a:pt x="28" y="61361"/>
                  </a:lnTo>
                  <a:lnTo>
                    <a:pt x="29" y="62695"/>
                  </a:lnTo>
                  <a:lnTo>
                    <a:pt x="30" y="64029"/>
                  </a:lnTo>
                  <a:lnTo>
                    <a:pt x="32" y="65362"/>
                  </a:lnTo>
                  <a:lnTo>
                    <a:pt x="33" y="66696"/>
                  </a:lnTo>
                  <a:lnTo>
                    <a:pt x="35" y="68030"/>
                  </a:lnTo>
                  <a:lnTo>
                    <a:pt x="36" y="69364"/>
                  </a:lnTo>
                  <a:lnTo>
                    <a:pt x="38" y="70698"/>
                  </a:lnTo>
                  <a:lnTo>
                    <a:pt x="40" y="72032"/>
                  </a:lnTo>
                  <a:lnTo>
                    <a:pt x="41" y="73366"/>
                  </a:lnTo>
                  <a:lnTo>
                    <a:pt x="43" y="74700"/>
                  </a:lnTo>
                  <a:lnTo>
                    <a:pt x="45" y="76034"/>
                  </a:lnTo>
                  <a:lnTo>
                    <a:pt x="47" y="77368"/>
                  </a:lnTo>
                  <a:lnTo>
                    <a:pt x="48" y="78702"/>
                  </a:lnTo>
                  <a:lnTo>
                    <a:pt x="50" y="80036"/>
                  </a:lnTo>
                  <a:lnTo>
                    <a:pt x="52" y="81370"/>
                  </a:lnTo>
                  <a:lnTo>
                    <a:pt x="54" y="82704"/>
                  </a:lnTo>
                  <a:lnTo>
                    <a:pt x="56" y="84038"/>
                  </a:lnTo>
                  <a:lnTo>
                    <a:pt x="58" y="85372"/>
                  </a:lnTo>
                  <a:lnTo>
                    <a:pt x="60" y="86705"/>
                  </a:lnTo>
                  <a:lnTo>
                    <a:pt x="62" y="88039"/>
                  </a:lnTo>
                  <a:lnTo>
                    <a:pt x="64" y="89373"/>
                  </a:lnTo>
                  <a:lnTo>
                    <a:pt x="66" y="90707"/>
                  </a:lnTo>
                  <a:lnTo>
                    <a:pt x="68" y="92041"/>
                  </a:lnTo>
                  <a:lnTo>
                    <a:pt x="70" y="93375"/>
                  </a:lnTo>
                  <a:lnTo>
                    <a:pt x="72" y="94709"/>
                  </a:lnTo>
                  <a:lnTo>
                    <a:pt x="74" y="96043"/>
                  </a:lnTo>
                  <a:lnTo>
                    <a:pt x="76" y="97377"/>
                  </a:lnTo>
                  <a:lnTo>
                    <a:pt x="78" y="98711"/>
                  </a:lnTo>
                  <a:lnTo>
                    <a:pt x="80" y="100045"/>
                  </a:lnTo>
                  <a:lnTo>
                    <a:pt x="82" y="101379"/>
                  </a:lnTo>
                  <a:lnTo>
                    <a:pt x="84" y="102713"/>
                  </a:lnTo>
                  <a:lnTo>
                    <a:pt x="86" y="104047"/>
                  </a:lnTo>
                  <a:lnTo>
                    <a:pt x="88" y="105381"/>
                  </a:lnTo>
                  <a:lnTo>
                    <a:pt x="90" y="106715"/>
                  </a:lnTo>
                  <a:lnTo>
                    <a:pt x="92" y="108048"/>
                  </a:lnTo>
                  <a:lnTo>
                    <a:pt x="94" y="109382"/>
                  </a:lnTo>
                  <a:lnTo>
                    <a:pt x="95" y="110716"/>
                  </a:lnTo>
                  <a:lnTo>
                    <a:pt x="97" y="112050"/>
                  </a:lnTo>
                  <a:lnTo>
                    <a:pt x="99" y="113384"/>
                  </a:lnTo>
                  <a:lnTo>
                    <a:pt x="100" y="114718"/>
                  </a:lnTo>
                  <a:lnTo>
                    <a:pt x="102" y="116052"/>
                  </a:lnTo>
                  <a:lnTo>
                    <a:pt x="104" y="117386"/>
                  </a:lnTo>
                  <a:lnTo>
                    <a:pt x="105" y="118720"/>
                  </a:lnTo>
                  <a:lnTo>
                    <a:pt x="106" y="120054"/>
                  </a:lnTo>
                  <a:lnTo>
                    <a:pt x="108" y="121388"/>
                  </a:lnTo>
                  <a:lnTo>
                    <a:pt x="109" y="122722"/>
                  </a:lnTo>
                  <a:lnTo>
                    <a:pt x="110" y="124056"/>
                  </a:lnTo>
                  <a:lnTo>
                    <a:pt x="111" y="125390"/>
                  </a:lnTo>
                  <a:lnTo>
                    <a:pt x="112" y="126724"/>
                  </a:lnTo>
                  <a:lnTo>
                    <a:pt x="113" y="128058"/>
                  </a:lnTo>
                  <a:lnTo>
                    <a:pt x="114" y="129391"/>
                  </a:lnTo>
                  <a:lnTo>
                    <a:pt x="115" y="130725"/>
                  </a:lnTo>
                  <a:lnTo>
                    <a:pt x="116" y="132059"/>
                  </a:lnTo>
                  <a:lnTo>
                    <a:pt x="116" y="133393"/>
                  </a:lnTo>
                  <a:lnTo>
                    <a:pt x="117" y="134727"/>
                  </a:lnTo>
                  <a:lnTo>
                    <a:pt x="117" y="136061"/>
                  </a:lnTo>
                  <a:lnTo>
                    <a:pt x="118" y="137395"/>
                  </a:lnTo>
                  <a:lnTo>
                    <a:pt x="118" y="138729"/>
                  </a:lnTo>
                  <a:lnTo>
                    <a:pt x="118" y="140063"/>
                  </a:lnTo>
                  <a:lnTo>
                    <a:pt x="118" y="141397"/>
                  </a:lnTo>
                  <a:lnTo>
                    <a:pt x="118" y="142731"/>
                  </a:lnTo>
                  <a:lnTo>
                    <a:pt x="118" y="144065"/>
                  </a:lnTo>
                  <a:lnTo>
                    <a:pt x="118" y="145399"/>
                  </a:lnTo>
                  <a:lnTo>
                    <a:pt x="118" y="146733"/>
                  </a:lnTo>
                  <a:lnTo>
                    <a:pt x="117" y="148067"/>
                  </a:lnTo>
                  <a:lnTo>
                    <a:pt x="117" y="149401"/>
                  </a:lnTo>
                  <a:lnTo>
                    <a:pt x="116" y="150735"/>
                  </a:lnTo>
                  <a:lnTo>
                    <a:pt x="115" y="152068"/>
                  </a:lnTo>
                  <a:lnTo>
                    <a:pt x="115" y="153402"/>
                  </a:lnTo>
                  <a:lnTo>
                    <a:pt x="114" y="154736"/>
                  </a:lnTo>
                  <a:lnTo>
                    <a:pt x="113" y="156070"/>
                  </a:lnTo>
                  <a:lnTo>
                    <a:pt x="112" y="157404"/>
                  </a:lnTo>
                  <a:lnTo>
                    <a:pt x="111" y="158738"/>
                  </a:lnTo>
                  <a:lnTo>
                    <a:pt x="110" y="160072"/>
                  </a:lnTo>
                  <a:lnTo>
                    <a:pt x="108" y="161406"/>
                  </a:lnTo>
                  <a:lnTo>
                    <a:pt x="107" y="162740"/>
                  </a:lnTo>
                  <a:lnTo>
                    <a:pt x="106" y="164074"/>
                  </a:lnTo>
                  <a:lnTo>
                    <a:pt x="104" y="165408"/>
                  </a:lnTo>
                  <a:lnTo>
                    <a:pt x="103" y="166742"/>
                  </a:lnTo>
                  <a:lnTo>
                    <a:pt x="101" y="168076"/>
                  </a:lnTo>
                  <a:lnTo>
                    <a:pt x="99" y="169410"/>
                  </a:lnTo>
                  <a:lnTo>
                    <a:pt x="98" y="170744"/>
                  </a:lnTo>
                  <a:lnTo>
                    <a:pt x="96" y="172078"/>
                  </a:lnTo>
                  <a:lnTo>
                    <a:pt x="94" y="173411"/>
                  </a:lnTo>
                  <a:lnTo>
                    <a:pt x="93" y="174745"/>
                  </a:lnTo>
                  <a:lnTo>
                    <a:pt x="91" y="176079"/>
                  </a:lnTo>
                  <a:lnTo>
                    <a:pt x="89" y="177413"/>
                  </a:lnTo>
                  <a:lnTo>
                    <a:pt x="87" y="178747"/>
                  </a:lnTo>
                  <a:lnTo>
                    <a:pt x="85" y="180081"/>
                  </a:lnTo>
                  <a:lnTo>
                    <a:pt x="83" y="181415"/>
                  </a:lnTo>
                  <a:lnTo>
                    <a:pt x="81" y="182749"/>
                  </a:lnTo>
                  <a:lnTo>
                    <a:pt x="79" y="184083"/>
                  </a:lnTo>
                  <a:lnTo>
                    <a:pt x="77" y="185417"/>
                  </a:lnTo>
                  <a:lnTo>
                    <a:pt x="75" y="186751"/>
                  </a:lnTo>
                  <a:lnTo>
                    <a:pt x="73" y="188085"/>
                  </a:lnTo>
                  <a:lnTo>
                    <a:pt x="71" y="189419"/>
                  </a:lnTo>
                  <a:lnTo>
                    <a:pt x="69" y="190753"/>
                  </a:lnTo>
                  <a:lnTo>
                    <a:pt x="67" y="192087"/>
                  </a:lnTo>
                  <a:lnTo>
                    <a:pt x="65" y="193421"/>
                  </a:lnTo>
                  <a:lnTo>
                    <a:pt x="63" y="194754"/>
                  </a:lnTo>
                  <a:lnTo>
                    <a:pt x="61" y="196088"/>
                  </a:lnTo>
                  <a:lnTo>
                    <a:pt x="59" y="197422"/>
                  </a:lnTo>
                  <a:lnTo>
                    <a:pt x="57" y="198756"/>
                  </a:lnTo>
                  <a:lnTo>
                    <a:pt x="55" y="200090"/>
                  </a:lnTo>
                  <a:lnTo>
                    <a:pt x="53" y="201424"/>
                  </a:lnTo>
                  <a:lnTo>
                    <a:pt x="51" y="202758"/>
                  </a:lnTo>
                  <a:lnTo>
                    <a:pt x="49" y="204092"/>
                  </a:lnTo>
                  <a:lnTo>
                    <a:pt x="47" y="205426"/>
                  </a:lnTo>
                  <a:lnTo>
                    <a:pt x="46" y="206760"/>
                  </a:lnTo>
                  <a:lnTo>
                    <a:pt x="44" y="208094"/>
                  </a:lnTo>
                  <a:lnTo>
                    <a:pt x="42" y="209428"/>
                  </a:lnTo>
                  <a:lnTo>
                    <a:pt x="40" y="210762"/>
                  </a:lnTo>
                  <a:lnTo>
                    <a:pt x="39" y="212096"/>
                  </a:lnTo>
                  <a:lnTo>
                    <a:pt x="37" y="213430"/>
                  </a:lnTo>
                  <a:lnTo>
                    <a:pt x="35" y="214764"/>
                  </a:lnTo>
                  <a:lnTo>
                    <a:pt x="34" y="216097"/>
                  </a:lnTo>
                  <a:lnTo>
                    <a:pt x="32" y="217431"/>
                  </a:lnTo>
                  <a:lnTo>
                    <a:pt x="31" y="218765"/>
                  </a:lnTo>
                  <a:lnTo>
                    <a:pt x="30" y="220099"/>
                  </a:lnTo>
                  <a:lnTo>
                    <a:pt x="28" y="221433"/>
                  </a:lnTo>
                  <a:lnTo>
                    <a:pt x="27" y="222767"/>
                  </a:lnTo>
                  <a:lnTo>
                    <a:pt x="26" y="224101"/>
                  </a:lnTo>
                  <a:lnTo>
                    <a:pt x="24" y="225435"/>
                  </a:lnTo>
                  <a:lnTo>
                    <a:pt x="23" y="226769"/>
                  </a:lnTo>
                  <a:lnTo>
                    <a:pt x="22" y="228103"/>
                  </a:lnTo>
                  <a:lnTo>
                    <a:pt x="21" y="229437"/>
                  </a:lnTo>
                  <a:lnTo>
                    <a:pt x="20" y="230771"/>
                  </a:lnTo>
                  <a:lnTo>
                    <a:pt x="19" y="232105"/>
                  </a:lnTo>
                  <a:lnTo>
                    <a:pt x="18" y="233439"/>
                  </a:lnTo>
                  <a:lnTo>
                    <a:pt x="17" y="234773"/>
                  </a:lnTo>
                  <a:lnTo>
                    <a:pt x="16" y="236107"/>
                  </a:lnTo>
                  <a:lnTo>
                    <a:pt x="15" y="237440"/>
                  </a:lnTo>
                  <a:lnTo>
                    <a:pt x="14" y="238774"/>
                  </a:lnTo>
                  <a:lnTo>
                    <a:pt x="13" y="240108"/>
                  </a:lnTo>
                  <a:lnTo>
                    <a:pt x="12" y="241442"/>
                  </a:lnTo>
                  <a:lnTo>
                    <a:pt x="12" y="242776"/>
                  </a:lnTo>
                  <a:lnTo>
                    <a:pt x="11" y="244110"/>
                  </a:lnTo>
                  <a:lnTo>
                    <a:pt x="10" y="245444"/>
                  </a:lnTo>
                  <a:lnTo>
                    <a:pt x="10" y="246778"/>
                  </a:lnTo>
                  <a:lnTo>
                    <a:pt x="9" y="248112"/>
                  </a:lnTo>
                  <a:lnTo>
                    <a:pt x="8" y="249446"/>
                  </a:lnTo>
                  <a:lnTo>
                    <a:pt x="8" y="250780"/>
                  </a:lnTo>
                  <a:lnTo>
                    <a:pt x="7" y="252114"/>
                  </a:lnTo>
                  <a:lnTo>
                    <a:pt x="7" y="253448"/>
                  </a:lnTo>
                  <a:lnTo>
                    <a:pt x="6" y="254782"/>
                  </a:lnTo>
                  <a:lnTo>
                    <a:pt x="6" y="256116"/>
                  </a:lnTo>
                  <a:lnTo>
                    <a:pt x="5" y="257450"/>
                  </a:lnTo>
                  <a:lnTo>
                    <a:pt x="5" y="258783"/>
                  </a:lnTo>
                  <a:lnTo>
                    <a:pt x="5" y="260117"/>
                  </a:lnTo>
                  <a:lnTo>
                    <a:pt x="4" y="261451"/>
                  </a:lnTo>
                  <a:lnTo>
                    <a:pt x="4" y="262785"/>
                  </a:lnTo>
                  <a:lnTo>
                    <a:pt x="4" y="264119"/>
                  </a:lnTo>
                  <a:lnTo>
                    <a:pt x="3" y="265453"/>
                  </a:lnTo>
                  <a:lnTo>
                    <a:pt x="3" y="266787"/>
                  </a:lnTo>
                  <a:lnTo>
                    <a:pt x="3" y="268121"/>
                  </a:lnTo>
                  <a:lnTo>
                    <a:pt x="3" y="269455"/>
                  </a:lnTo>
                  <a:lnTo>
                    <a:pt x="3" y="270789"/>
                  </a:lnTo>
                  <a:lnTo>
                    <a:pt x="2" y="272123"/>
                  </a:lnTo>
                  <a:lnTo>
                    <a:pt x="2" y="273457"/>
                  </a:lnTo>
                  <a:lnTo>
                    <a:pt x="2" y="274791"/>
                  </a:lnTo>
                  <a:lnTo>
                    <a:pt x="2" y="276125"/>
                  </a:lnTo>
                  <a:lnTo>
                    <a:pt x="2" y="277459"/>
                  </a:lnTo>
                  <a:lnTo>
                    <a:pt x="2" y="278793"/>
                  </a:lnTo>
                  <a:lnTo>
                    <a:pt x="1" y="280126"/>
                  </a:lnTo>
                  <a:lnTo>
                    <a:pt x="1" y="281460"/>
                  </a:lnTo>
                  <a:lnTo>
                    <a:pt x="1" y="282794"/>
                  </a:lnTo>
                  <a:lnTo>
                    <a:pt x="1" y="284128"/>
                  </a:lnTo>
                  <a:lnTo>
                    <a:pt x="1" y="285462"/>
                  </a:lnTo>
                  <a:lnTo>
                    <a:pt x="1" y="286796"/>
                  </a:lnTo>
                  <a:lnTo>
                    <a:pt x="1" y="288130"/>
                  </a:lnTo>
                  <a:lnTo>
                    <a:pt x="1" y="289464"/>
                  </a:lnTo>
                  <a:lnTo>
                    <a:pt x="1" y="290798"/>
                  </a:lnTo>
                  <a:lnTo>
                    <a:pt x="1" y="292132"/>
                  </a:lnTo>
                  <a:lnTo>
                    <a:pt x="1" y="293466"/>
                  </a:lnTo>
                  <a:lnTo>
                    <a:pt x="1" y="294800"/>
                  </a:lnTo>
                  <a:lnTo>
                    <a:pt x="1" y="296134"/>
                  </a:lnTo>
                  <a:lnTo>
                    <a:pt x="1" y="297468"/>
                  </a:lnTo>
                  <a:lnTo>
                    <a:pt x="1" y="298802"/>
                  </a:lnTo>
                  <a:lnTo>
                    <a:pt x="1" y="300136"/>
                  </a:lnTo>
                  <a:lnTo>
                    <a:pt x="1" y="301470"/>
                  </a:lnTo>
                  <a:lnTo>
                    <a:pt x="1" y="302803"/>
                  </a:lnTo>
                  <a:lnTo>
                    <a:pt x="1" y="304137"/>
                  </a:lnTo>
                  <a:lnTo>
                    <a:pt x="2" y="305471"/>
                  </a:lnTo>
                  <a:lnTo>
                    <a:pt x="2" y="306805"/>
                  </a:lnTo>
                  <a:lnTo>
                    <a:pt x="2" y="308139"/>
                  </a:lnTo>
                  <a:lnTo>
                    <a:pt x="2" y="309473"/>
                  </a:lnTo>
                  <a:lnTo>
                    <a:pt x="2" y="310807"/>
                  </a:lnTo>
                  <a:lnTo>
                    <a:pt x="2" y="312141"/>
                  </a:lnTo>
                  <a:lnTo>
                    <a:pt x="2" y="313475"/>
                  </a:lnTo>
                  <a:lnTo>
                    <a:pt x="3" y="314809"/>
                  </a:lnTo>
                  <a:lnTo>
                    <a:pt x="3" y="316143"/>
                  </a:lnTo>
                  <a:lnTo>
                    <a:pt x="3" y="317477"/>
                  </a:lnTo>
                  <a:lnTo>
                    <a:pt x="3" y="318811"/>
                  </a:lnTo>
                  <a:lnTo>
                    <a:pt x="4" y="320145"/>
                  </a:lnTo>
                  <a:lnTo>
                    <a:pt x="4" y="321479"/>
                  </a:lnTo>
                  <a:lnTo>
                    <a:pt x="4" y="322813"/>
                  </a:lnTo>
                  <a:lnTo>
                    <a:pt x="5" y="324146"/>
                  </a:lnTo>
                  <a:lnTo>
                    <a:pt x="5" y="325480"/>
                  </a:lnTo>
                  <a:lnTo>
                    <a:pt x="5" y="326814"/>
                  </a:lnTo>
                  <a:lnTo>
                    <a:pt x="6" y="328148"/>
                  </a:lnTo>
                  <a:lnTo>
                    <a:pt x="6" y="329482"/>
                  </a:lnTo>
                  <a:lnTo>
                    <a:pt x="7" y="330816"/>
                  </a:lnTo>
                  <a:lnTo>
                    <a:pt x="7" y="332150"/>
                  </a:lnTo>
                  <a:lnTo>
                    <a:pt x="8" y="333484"/>
                  </a:lnTo>
                  <a:lnTo>
                    <a:pt x="8" y="334818"/>
                  </a:lnTo>
                  <a:lnTo>
                    <a:pt x="9" y="336152"/>
                  </a:lnTo>
                  <a:lnTo>
                    <a:pt x="9" y="337486"/>
                  </a:lnTo>
                  <a:lnTo>
                    <a:pt x="10" y="338820"/>
                  </a:lnTo>
                  <a:lnTo>
                    <a:pt x="11" y="340154"/>
                  </a:lnTo>
                  <a:lnTo>
                    <a:pt x="11" y="341488"/>
                  </a:lnTo>
                  <a:lnTo>
                    <a:pt x="12" y="342822"/>
                  </a:lnTo>
                  <a:lnTo>
                    <a:pt x="13" y="344156"/>
                  </a:lnTo>
                  <a:lnTo>
                    <a:pt x="14" y="345489"/>
                  </a:lnTo>
                  <a:lnTo>
                    <a:pt x="15" y="346823"/>
                  </a:lnTo>
                  <a:lnTo>
                    <a:pt x="16" y="348157"/>
                  </a:lnTo>
                  <a:lnTo>
                    <a:pt x="16" y="349491"/>
                  </a:lnTo>
                  <a:lnTo>
                    <a:pt x="17" y="350825"/>
                  </a:lnTo>
                  <a:lnTo>
                    <a:pt x="18" y="352159"/>
                  </a:lnTo>
                  <a:lnTo>
                    <a:pt x="20" y="353493"/>
                  </a:lnTo>
                  <a:lnTo>
                    <a:pt x="21" y="354827"/>
                  </a:lnTo>
                  <a:lnTo>
                    <a:pt x="22" y="356161"/>
                  </a:lnTo>
                  <a:lnTo>
                    <a:pt x="23" y="357495"/>
                  </a:lnTo>
                  <a:lnTo>
                    <a:pt x="24" y="358829"/>
                  </a:lnTo>
                  <a:lnTo>
                    <a:pt x="25" y="360163"/>
                  </a:lnTo>
                  <a:lnTo>
                    <a:pt x="27" y="361497"/>
                  </a:lnTo>
                  <a:lnTo>
                    <a:pt x="28" y="362831"/>
                  </a:lnTo>
                  <a:lnTo>
                    <a:pt x="30" y="364165"/>
                  </a:lnTo>
                  <a:lnTo>
                    <a:pt x="31" y="365499"/>
                  </a:lnTo>
                  <a:lnTo>
                    <a:pt x="32" y="366832"/>
                  </a:lnTo>
                  <a:lnTo>
                    <a:pt x="34" y="368166"/>
                  </a:lnTo>
                  <a:lnTo>
                    <a:pt x="36" y="369500"/>
                  </a:lnTo>
                  <a:lnTo>
                    <a:pt x="37" y="370834"/>
                  </a:lnTo>
                  <a:lnTo>
                    <a:pt x="39" y="372168"/>
                  </a:lnTo>
                  <a:lnTo>
                    <a:pt x="41" y="373502"/>
                  </a:lnTo>
                  <a:lnTo>
                    <a:pt x="42" y="374836"/>
                  </a:lnTo>
                  <a:lnTo>
                    <a:pt x="44" y="376170"/>
                  </a:lnTo>
                  <a:lnTo>
                    <a:pt x="46" y="377504"/>
                  </a:lnTo>
                  <a:lnTo>
                    <a:pt x="48" y="378838"/>
                  </a:lnTo>
                  <a:lnTo>
                    <a:pt x="50" y="380172"/>
                  </a:lnTo>
                  <a:lnTo>
                    <a:pt x="52" y="381506"/>
                  </a:lnTo>
                  <a:lnTo>
                    <a:pt x="54" y="382840"/>
                  </a:lnTo>
                  <a:lnTo>
                    <a:pt x="56" y="384174"/>
                  </a:lnTo>
                  <a:lnTo>
                    <a:pt x="58" y="385508"/>
                  </a:lnTo>
                  <a:lnTo>
                    <a:pt x="60" y="386842"/>
                  </a:lnTo>
                  <a:lnTo>
                    <a:pt x="62" y="388175"/>
                  </a:lnTo>
                  <a:lnTo>
                    <a:pt x="65" y="389509"/>
                  </a:lnTo>
                  <a:lnTo>
                    <a:pt x="67" y="390843"/>
                  </a:lnTo>
                  <a:lnTo>
                    <a:pt x="69" y="392177"/>
                  </a:lnTo>
                  <a:lnTo>
                    <a:pt x="71" y="393511"/>
                  </a:lnTo>
                  <a:lnTo>
                    <a:pt x="74" y="394845"/>
                  </a:lnTo>
                  <a:lnTo>
                    <a:pt x="76" y="396179"/>
                  </a:lnTo>
                  <a:lnTo>
                    <a:pt x="78" y="397513"/>
                  </a:lnTo>
                  <a:lnTo>
                    <a:pt x="81" y="398847"/>
                  </a:lnTo>
                  <a:lnTo>
                    <a:pt x="83" y="400181"/>
                  </a:lnTo>
                  <a:lnTo>
                    <a:pt x="85" y="401515"/>
                  </a:lnTo>
                  <a:lnTo>
                    <a:pt x="88" y="402849"/>
                  </a:lnTo>
                  <a:lnTo>
                    <a:pt x="90" y="404183"/>
                  </a:lnTo>
                  <a:lnTo>
                    <a:pt x="93" y="405517"/>
                  </a:lnTo>
                  <a:lnTo>
                    <a:pt x="95" y="406851"/>
                  </a:lnTo>
                  <a:lnTo>
                    <a:pt x="98" y="408185"/>
                  </a:lnTo>
                  <a:lnTo>
                    <a:pt x="100" y="409518"/>
                  </a:lnTo>
                  <a:lnTo>
                    <a:pt x="102" y="410852"/>
                  </a:lnTo>
                  <a:lnTo>
                    <a:pt x="105" y="412186"/>
                  </a:lnTo>
                  <a:lnTo>
                    <a:pt x="107" y="413520"/>
                  </a:lnTo>
                  <a:lnTo>
                    <a:pt x="110" y="414854"/>
                  </a:lnTo>
                  <a:lnTo>
                    <a:pt x="112" y="416188"/>
                  </a:lnTo>
                  <a:lnTo>
                    <a:pt x="115" y="417522"/>
                  </a:lnTo>
                  <a:lnTo>
                    <a:pt x="117" y="418856"/>
                  </a:lnTo>
                  <a:lnTo>
                    <a:pt x="120" y="420190"/>
                  </a:lnTo>
                  <a:lnTo>
                    <a:pt x="122" y="421524"/>
                  </a:lnTo>
                  <a:lnTo>
                    <a:pt x="125" y="422858"/>
                  </a:lnTo>
                  <a:lnTo>
                    <a:pt x="127" y="424192"/>
                  </a:lnTo>
                  <a:lnTo>
                    <a:pt x="130" y="425526"/>
                  </a:lnTo>
                  <a:lnTo>
                    <a:pt x="132" y="426860"/>
                  </a:lnTo>
                  <a:lnTo>
                    <a:pt x="134" y="428194"/>
                  </a:lnTo>
                  <a:lnTo>
                    <a:pt x="137" y="429528"/>
                  </a:lnTo>
                  <a:lnTo>
                    <a:pt x="139" y="430861"/>
                  </a:lnTo>
                  <a:lnTo>
                    <a:pt x="142" y="432195"/>
                  </a:lnTo>
                  <a:lnTo>
                    <a:pt x="144" y="433529"/>
                  </a:lnTo>
                  <a:lnTo>
                    <a:pt x="147" y="434863"/>
                  </a:lnTo>
                  <a:lnTo>
                    <a:pt x="149" y="436197"/>
                  </a:lnTo>
                  <a:lnTo>
                    <a:pt x="152" y="437531"/>
                  </a:lnTo>
                  <a:lnTo>
                    <a:pt x="154" y="438865"/>
                  </a:lnTo>
                  <a:lnTo>
                    <a:pt x="157" y="440199"/>
                  </a:lnTo>
                  <a:lnTo>
                    <a:pt x="159" y="441533"/>
                  </a:lnTo>
                  <a:lnTo>
                    <a:pt x="162" y="442867"/>
                  </a:lnTo>
                  <a:lnTo>
                    <a:pt x="164" y="444201"/>
                  </a:lnTo>
                  <a:lnTo>
                    <a:pt x="167" y="445535"/>
                  </a:lnTo>
                  <a:lnTo>
                    <a:pt x="169" y="446869"/>
                  </a:lnTo>
                  <a:lnTo>
                    <a:pt x="172" y="448203"/>
                  </a:lnTo>
                  <a:lnTo>
                    <a:pt x="174" y="449537"/>
                  </a:lnTo>
                  <a:lnTo>
                    <a:pt x="177" y="450871"/>
                  </a:lnTo>
                  <a:lnTo>
                    <a:pt x="180" y="452205"/>
                  </a:lnTo>
                  <a:lnTo>
                    <a:pt x="183" y="453538"/>
                  </a:lnTo>
                  <a:lnTo>
                    <a:pt x="185" y="454872"/>
                  </a:lnTo>
                  <a:lnTo>
                    <a:pt x="188" y="456206"/>
                  </a:lnTo>
                  <a:lnTo>
                    <a:pt x="191" y="457540"/>
                  </a:lnTo>
                  <a:lnTo>
                    <a:pt x="194" y="458874"/>
                  </a:lnTo>
                  <a:lnTo>
                    <a:pt x="197" y="460208"/>
                  </a:lnTo>
                  <a:lnTo>
                    <a:pt x="200" y="461542"/>
                  </a:lnTo>
                  <a:lnTo>
                    <a:pt x="203" y="462876"/>
                  </a:lnTo>
                  <a:lnTo>
                    <a:pt x="206" y="464210"/>
                  </a:lnTo>
                  <a:lnTo>
                    <a:pt x="209" y="465544"/>
                  </a:lnTo>
                  <a:lnTo>
                    <a:pt x="212" y="466878"/>
                  </a:lnTo>
                  <a:lnTo>
                    <a:pt x="215" y="468212"/>
                  </a:lnTo>
                  <a:lnTo>
                    <a:pt x="219" y="469546"/>
                  </a:lnTo>
                  <a:lnTo>
                    <a:pt x="222" y="470880"/>
                  </a:lnTo>
                  <a:lnTo>
                    <a:pt x="225" y="472214"/>
                  </a:lnTo>
                  <a:lnTo>
                    <a:pt x="229" y="473548"/>
                  </a:lnTo>
                  <a:lnTo>
                    <a:pt x="232" y="474881"/>
                  </a:lnTo>
                  <a:lnTo>
                    <a:pt x="236" y="476215"/>
                  </a:lnTo>
                  <a:lnTo>
                    <a:pt x="240" y="477549"/>
                  </a:lnTo>
                  <a:lnTo>
                    <a:pt x="243" y="478883"/>
                  </a:lnTo>
                  <a:lnTo>
                    <a:pt x="247" y="480217"/>
                  </a:lnTo>
                  <a:lnTo>
                    <a:pt x="251" y="481551"/>
                  </a:lnTo>
                  <a:lnTo>
                    <a:pt x="255" y="482885"/>
                  </a:lnTo>
                  <a:lnTo>
                    <a:pt x="259" y="484219"/>
                  </a:lnTo>
                  <a:lnTo>
                    <a:pt x="263" y="485553"/>
                  </a:lnTo>
                  <a:lnTo>
                    <a:pt x="267" y="486887"/>
                  </a:lnTo>
                  <a:lnTo>
                    <a:pt x="271" y="488221"/>
                  </a:lnTo>
                  <a:lnTo>
                    <a:pt x="275" y="489555"/>
                  </a:lnTo>
                  <a:lnTo>
                    <a:pt x="279" y="490889"/>
                  </a:lnTo>
                  <a:lnTo>
                    <a:pt x="283" y="492223"/>
                  </a:lnTo>
                  <a:lnTo>
                    <a:pt x="287" y="493557"/>
                  </a:lnTo>
                  <a:lnTo>
                    <a:pt x="291" y="494891"/>
                  </a:lnTo>
                  <a:lnTo>
                    <a:pt x="295" y="496224"/>
                  </a:lnTo>
                  <a:lnTo>
                    <a:pt x="299" y="497558"/>
                  </a:lnTo>
                  <a:lnTo>
                    <a:pt x="303" y="498892"/>
                  </a:lnTo>
                  <a:lnTo>
                    <a:pt x="307" y="500226"/>
                  </a:lnTo>
                  <a:lnTo>
                    <a:pt x="311" y="501560"/>
                  </a:lnTo>
                  <a:lnTo>
                    <a:pt x="315" y="502894"/>
                  </a:lnTo>
                  <a:lnTo>
                    <a:pt x="319" y="504228"/>
                  </a:lnTo>
                  <a:lnTo>
                    <a:pt x="323" y="505562"/>
                  </a:lnTo>
                  <a:lnTo>
                    <a:pt x="326" y="506896"/>
                  </a:lnTo>
                  <a:lnTo>
                    <a:pt x="330" y="508230"/>
                  </a:lnTo>
                  <a:lnTo>
                    <a:pt x="333" y="509564"/>
                  </a:lnTo>
                  <a:lnTo>
                    <a:pt x="337" y="510898"/>
                  </a:lnTo>
                  <a:lnTo>
                    <a:pt x="340" y="512232"/>
                  </a:lnTo>
                  <a:lnTo>
                    <a:pt x="343" y="513566"/>
                  </a:lnTo>
                  <a:lnTo>
                    <a:pt x="347" y="514900"/>
                  </a:lnTo>
                  <a:lnTo>
                    <a:pt x="349" y="516234"/>
                  </a:lnTo>
                  <a:lnTo>
                    <a:pt x="352" y="517567"/>
                  </a:lnTo>
                  <a:lnTo>
                    <a:pt x="355" y="518901"/>
                  </a:lnTo>
                  <a:lnTo>
                    <a:pt x="357" y="520235"/>
                  </a:lnTo>
                  <a:lnTo>
                    <a:pt x="360" y="521569"/>
                  </a:lnTo>
                  <a:lnTo>
                    <a:pt x="362" y="522903"/>
                  </a:lnTo>
                  <a:lnTo>
                    <a:pt x="364" y="524237"/>
                  </a:lnTo>
                  <a:lnTo>
                    <a:pt x="365" y="525571"/>
                  </a:lnTo>
                  <a:lnTo>
                    <a:pt x="367" y="526905"/>
                  </a:lnTo>
                  <a:lnTo>
                    <a:pt x="368" y="528239"/>
                  </a:lnTo>
                  <a:lnTo>
                    <a:pt x="369" y="529573"/>
                  </a:lnTo>
                  <a:lnTo>
                    <a:pt x="370" y="530907"/>
                  </a:lnTo>
                  <a:lnTo>
                    <a:pt x="371" y="532241"/>
                  </a:lnTo>
                  <a:lnTo>
                    <a:pt x="371" y="533575"/>
                  </a:lnTo>
                  <a:lnTo>
                    <a:pt x="372" y="534909"/>
                  </a:lnTo>
                  <a:lnTo>
                    <a:pt x="372" y="536243"/>
                  </a:lnTo>
                  <a:lnTo>
                    <a:pt x="371" y="537577"/>
                  </a:lnTo>
                  <a:lnTo>
                    <a:pt x="371" y="538910"/>
                  </a:lnTo>
                  <a:lnTo>
                    <a:pt x="370" y="540244"/>
                  </a:lnTo>
                  <a:lnTo>
                    <a:pt x="369" y="541578"/>
                  </a:lnTo>
                  <a:lnTo>
                    <a:pt x="368" y="542912"/>
                  </a:lnTo>
                  <a:lnTo>
                    <a:pt x="366" y="544246"/>
                  </a:lnTo>
                  <a:lnTo>
                    <a:pt x="364" y="545580"/>
                  </a:lnTo>
                  <a:lnTo>
                    <a:pt x="362" y="546914"/>
                  </a:lnTo>
                  <a:lnTo>
                    <a:pt x="360" y="548248"/>
                  </a:lnTo>
                  <a:lnTo>
                    <a:pt x="358" y="549582"/>
                  </a:lnTo>
                  <a:lnTo>
                    <a:pt x="355" y="550916"/>
                  </a:lnTo>
                  <a:lnTo>
                    <a:pt x="352" y="552250"/>
                  </a:lnTo>
                  <a:lnTo>
                    <a:pt x="349" y="553584"/>
                  </a:lnTo>
                  <a:lnTo>
                    <a:pt x="345" y="554918"/>
                  </a:lnTo>
                  <a:lnTo>
                    <a:pt x="342" y="556252"/>
                  </a:lnTo>
                  <a:lnTo>
                    <a:pt x="338" y="557586"/>
                  </a:lnTo>
                  <a:lnTo>
                    <a:pt x="334" y="558920"/>
                  </a:lnTo>
                  <a:lnTo>
                    <a:pt x="330" y="560253"/>
                  </a:lnTo>
                  <a:lnTo>
                    <a:pt x="325" y="561587"/>
                  </a:lnTo>
                  <a:lnTo>
                    <a:pt x="321" y="562921"/>
                  </a:lnTo>
                  <a:lnTo>
                    <a:pt x="316" y="564255"/>
                  </a:lnTo>
                  <a:lnTo>
                    <a:pt x="311" y="565589"/>
                  </a:lnTo>
                  <a:lnTo>
                    <a:pt x="306" y="566923"/>
                  </a:lnTo>
                  <a:lnTo>
                    <a:pt x="301" y="568257"/>
                  </a:lnTo>
                  <a:lnTo>
                    <a:pt x="295" y="569591"/>
                  </a:lnTo>
                  <a:lnTo>
                    <a:pt x="290" y="570925"/>
                  </a:lnTo>
                  <a:lnTo>
                    <a:pt x="284" y="572259"/>
                  </a:lnTo>
                  <a:lnTo>
                    <a:pt x="279" y="573593"/>
                  </a:lnTo>
                  <a:lnTo>
                    <a:pt x="273" y="574927"/>
                  </a:lnTo>
                  <a:lnTo>
                    <a:pt x="267" y="576261"/>
                  </a:lnTo>
                  <a:lnTo>
                    <a:pt x="261" y="577595"/>
                  </a:lnTo>
                  <a:lnTo>
                    <a:pt x="255" y="578929"/>
                  </a:lnTo>
                  <a:lnTo>
                    <a:pt x="249" y="580263"/>
                  </a:lnTo>
                  <a:lnTo>
                    <a:pt x="243" y="581597"/>
                  </a:lnTo>
                  <a:lnTo>
                    <a:pt x="237" y="582930"/>
                  </a:lnTo>
                  <a:lnTo>
                    <a:pt x="230" y="584264"/>
                  </a:lnTo>
                  <a:lnTo>
                    <a:pt x="224" y="585598"/>
                  </a:lnTo>
                  <a:lnTo>
                    <a:pt x="218" y="586932"/>
                  </a:lnTo>
                  <a:lnTo>
                    <a:pt x="212" y="588266"/>
                  </a:lnTo>
                  <a:lnTo>
                    <a:pt x="206" y="589600"/>
                  </a:lnTo>
                  <a:lnTo>
                    <a:pt x="199" y="590934"/>
                  </a:lnTo>
                  <a:lnTo>
                    <a:pt x="193" y="592268"/>
                  </a:lnTo>
                  <a:lnTo>
                    <a:pt x="187" y="593602"/>
                  </a:lnTo>
                  <a:lnTo>
                    <a:pt x="181" y="594936"/>
                  </a:lnTo>
                  <a:lnTo>
                    <a:pt x="175" y="596270"/>
                  </a:lnTo>
                  <a:lnTo>
                    <a:pt x="169" y="597604"/>
                  </a:lnTo>
                  <a:lnTo>
                    <a:pt x="163" y="598938"/>
                  </a:lnTo>
                  <a:lnTo>
                    <a:pt x="158" y="600272"/>
                  </a:lnTo>
                  <a:lnTo>
                    <a:pt x="152" y="601606"/>
                  </a:lnTo>
                  <a:lnTo>
                    <a:pt x="146" y="602940"/>
                  </a:lnTo>
                  <a:lnTo>
                    <a:pt x="141" y="604273"/>
                  </a:lnTo>
                  <a:lnTo>
                    <a:pt x="136" y="605607"/>
                  </a:lnTo>
                  <a:lnTo>
                    <a:pt x="130" y="606941"/>
                  </a:lnTo>
                  <a:lnTo>
                    <a:pt x="125" y="608275"/>
                  </a:lnTo>
                  <a:lnTo>
                    <a:pt x="120" y="609609"/>
                  </a:lnTo>
                  <a:lnTo>
                    <a:pt x="115" y="610943"/>
                  </a:lnTo>
                  <a:lnTo>
                    <a:pt x="110" y="612277"/>
                  </a:lnTo>
                  <a:lnTo>
                    <a:pt x="105" y="613611"/>
                  </a:lnTo>
                  <a:lnTo>
                    <a:pt x="101" y="614945"/>
                  </a:lnTo>
                  <a:lnTo>
                    <a:pt x="96" y="616279"/>
                  </a:lnTo>
                  <a:lnTo>
                    <a:pt x="92" y="617613"/>
                  </a:lnTo>
                  <a:lnTo>
                    <a:pt x="88" y="618947"/>
                  </a:lnTo>
                  <a:lnTo>
                    <a:pt x="84" y="620281"/>
                  </a:lnTo>
                  <a:lnTo>
                    <a:pt x="80" y="621615"/>
                  </a:lnTo>
                  <a:lnTo>
                    <a:pt x="76" y="622949"/>
                  </a:lnTo>
                  <a:lnTo>
                    <a:pt x="72" y="624283"/>
                  </a:lnTo>
                  <a:lnTo>
                    <a:pt x="69" y="625616"/>
                  </a:lnTo>
                  <a:lnTo>
                    <a:pt x="65" y="626950"/>
                  </a:lnTo>
                  <a:lnTo>
                    <a:pt x="62" y="628284"/>
                  </a:lnTo>
                  <a:lnTo>
                    <a:pt x="58" y="629618"/>
                  </a:lnTo>
                  <a:lnTo>
                    <a:pt x="55" y="630952"/>
                  </a:lnTo>
                  <a:lnTo>
                    <a:pt x="52" y="632286"/>
                  </a:lnTo>
                  <a:lnTo>
                    <a:pt x="50" y="633620"/>
                  </a:lnTo>
                  <a:lnTo>
                    <a:pt x="47" y="634954"/>
                  </a:lnTo>
                  <a:lnTo>
                    <a:pt x="44" y="636288"/>
                  </a:lnTo>
                  <a:lnTo>
                    <a:pt x="42" y="637622"/>
                  </a:lnTo>
                  <a:lnTo>
                    <a:pt x="39" y="638956"/>
                  </a:lnTo>
                  <a:lnTo>
                    <a:pt x="37" y="640290"/>
                  </a:lnTo>
                  <a:lnTo>
                    <a:pt x="35" y="641624"/>
                  </a:lnTo>
                  <a:lnTo>
                    <a:pt x="33" y="642958"/>
                  </a:lnTo>
                  <a:lnTo>
                    <a:pt x="31" y="644292"/>
                  </a:lnTo>
                  <a:lnTo>
                    <a:pt x="29" y="645626"/>
                  </a:lnTo>
                  <a:lnTo>
                    <a:pt x="27" y="646959"/>
                  </a:lnTo>
                  <a:lnTo>
                    <a:pt x="25" y="648293"/>
                  </a:lnTo>
                  <a:lnTo>
                    <a:pt x="24" y="649627"/>
                  </a:lnTo>
                  <a:lnTo>
                    <a:pt x="22" y="650961"/>
                  </a:lnTo>
                  <a:lnTo>
                    <a:pt x="21" y="652295"/>
                  </a:lnTo>
                  <a:lnTo>
                    <a:pt x="19" y="653629"/>
                  </a:lnTo>
                  <a:lnTo>
                    <a:pt x="18" y="654963"/>
                  </a:lnTo>
                  <a:lnTo>
                    <a:pt x="17" y="656297"/>
                  </a:lnTo>
                  <a:lnTo>
                    <a:pt x="16" y="657631"/>
                  </a:lnTo>
                  <a:lnTo>
                    <a:pt x="14" y="658965"/>
                  </a:lnTo>
                  <a:lnTo>
                    <a:pt x="13" y="660299"/>
                  </a:lnTo>
                  <a:lnTo>
                    <a:pt x="12" y="661633"/>
                  </a:lnTo>
                  <a:lnTo>
                    <a:pt x="12" y="662967"/>
                  </a:lnTo>
                  <a:lnTo>
                    <a:pt x="11" y="664301"/>
                  </a:lnTo>
                  <a:lnTo>
                    <a:pt x="10" y="665635"/>
                  </a:lnTo>
                  <a:lnTo>
                    <a:pt x="9" y="666969"/>
                  </a:lnTo>
                  <a:lnTo>
                    <a:pt x="8" y="668302"/>
                  </a:lnTo>
                  <a:lnTo>
                    <a:pt x="8" y="669636"/>
                  </a:lnTo>
                  <a:lnTo>
                    <a:pt x="7" y="670970"/>
                  </a:lnTo>
                  <a:lnTo>
                    <a:pt x="7" y="672304"/>
                  </a:lnTo>
                  <a:lnTo>
                    <a:pt x="6" y="673638"/>
                  </a:lnTo>
                  <a:lnTo>
                    <a:pt x="6" y="674972"/>
                  </a:lnTo>
                  <a:lnTo>
                    <a:pt x="5" y="676306"/>
                  </a:lnTo>
                  <a:lnTo>
                    <a:pt x="5" y="677640"/>
                  </a:lnTo>
                  <a:lnTo>
                    <a:pt x="4" y="678974"/>
                  </a:lnTo>
                  <a:lnTo>
                    <a:pt x="4" y="680308"/>
                  </a:lnTo>
                  <a:lnTo>
                    <a:pt x="3" y="681642"/>
                  </a:lnTo>
                  <a:lnTo>
                    <a:pt x="0" y="681642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62" name="pl44"/>
            <p:cNvSpPr/>
            <p:nvPr/>
          </p:nvSpPr>
          <p:spPr>
            <a:xfrm>
              <a:off x="6068171" y="3346800"/>
              <a:ext cx="219" cy="663268"/>
            </a:xfrm>
            <a:custGeom>
              <a:avLst/>
              <a:gdLst/>
              <a:ahLst/>
              <a:cxnLst/>
              <a:rect l="0" t="0" r="0" b="0"/>
              <a:pathLst>
                <a:path w="219" h="663268">
                  <a:moveTo>
                    <a:pt x="219" y="663268"/>
                  </a:moveTo>
                  <a:lnTo>
                    <a:pt x="218" y="663268"/>
                  </a:lnTo>
                  <a:lnTo>
                    <a:pt x="218" y="661970"/>
                  </a:lnTo>
                  <a:lnTo>
                    <a:pt x="218" y="660672"/>
                  </a:lnTo>
                  <a:lnTo>
                    <a:pt x="218" y="659374"/>
                  </a:lnTo>
                  <a:lnTo>
                    <a:pt x="218" y="658076"/>
                  </a:lnTo>
                  <a:lnTo>
                    <a:pt x="218" y="656778"/>
                  </a:lnTo>
                  <a:lnTo>
                    <a:pt x="218" y="655480"/>
                  </a:lnTo>
                  <a:lnTo>
                    <a:pt x="218" y="654182"/>
                  </a:lnTo>
                  <a:lnTo>
                    <a:pt x="218" y="652884"/>
                  </a:lnTo>
                  <a:lnTo>
                    <a:pt x="217" y="651586"/>
                  </a:lnTo>
                  <a:lnTo>
                    <a:pt x="217" y="650288"/>
                  </a:lnTo>
                  <a:lnTo>
                    <a:pt x="217" y="648990"/>
                  </a:lnTo>
                  <a:lnTo>
                    <a:pt x="217" y="647692"/>
                  </a:lnTo>
                  <a:lnTo>
                    <a:pt x="217" y="646394"/>
                  </a:lnTo>
                  <a:lnTo>
                    <a:pt x="217" y="645096"/>
                  </a:lnTo>
                  <a:lnTo>
                    <a:pt x="217" y="643798"/>
                  </a:lnTo>
                  <a:lnTo>
                    <a:pt x="217" y="642500"/>
                  </a:lnTo>
                  <a:lnTo>
                    <a:pt x="217" y="641202"/>
                  </a:lnTo>
                  <a:lnTo>
                    <a:pt x="216" y="639904"/>
                  </a:lnTo>
                  <a:lnTo>
                    <a:pt x="216" y="638606"/>
                  </a:lnTo>
                  <a:lnTo>
                    <a:pt x="216" y="637308"/>
                  </a:lnTo>
                  <a:lnTo>
                    <a:pt x="216" y="636010"/>
                  </a:lnTo>
                  <a:lnTo>
                    <a:pt x="216" y="634712"/>
                  </a:lnTo>
                  <a:lnTo>
                    <a:pt x="216" y="633414"/>
                  </a:lnTo>
                  <a:lnTo>
                    <a:pt x="215" y="632116"/>
                  </a:lnTo>
                  <a:lnTo>
                    <a:pt x="215" y="630818"/>
                  </a:lnTo>
                  <a:lnTo>
                    <a:pt x="215" y="629520"/>
                  </a:lnTo>
                  <a:lnTo>
                    <a:pt x="215" y="628222"/>
                  </a:lnTo>
                  <a:lnTo>
                    <a:pt x="215" y="626924"/>
                  </a:lnTo>
                  <a:lnTo>
                    <a:pt x="214" y="625626"/>
                  </a:lnTo>
                  <a:lnTo>
                    <a:pt x="214" y="624328"/>
                  </a:lnTo>
                  <a:lnTo>
                    <a:pt x="214" y="623030"/>
                  </a:lnTo>
                  <a:lnTo>
                    <a:pt x="214" y="621732"/>
                  </a:lnTo>
                  <a:lnTo>
                    <a:pt x="213" y="620434"/>
                  </a:lnTo>
                  <a:lnTo>
                    <a:pt x="213" y="619136"/>
                  </a:lnTo>
                  <a:lnTo>
                    <a:pt x="213" y="617838"/>
                  </a:lnTo>
                  <a:lnTo>
                    <a:pt x="212" y="616540"/>
                  </a:lnTo>
                  <a:lnTo>
                    <a:pt x="212" y="615242"/>
                  </a:lnTo>
                  <a:lnTo>
                    <a:pt x="212" y="613944"/>
                  </a:lnTo>
                  <a:lnTo>
                    <a:pt x="211" y="612646"/>
                  </a:lnTo>
                  <a:lnTo>
                    <a:pt x="211" y="611348"/>
                  </a:lnTo>
                  <a:lnTo>
                    <a:pt x="211" y="610050"/>
                  </a:lnTo>
                  <a:lnTo>
                    <a:pt x="210" y="608752"/>
                  </a:lnTo>
                  <a:lnTo>
                    <a:pt x="210" y="607454"/>
                  </a:lnTo>
                  <a:lnTo>
                    <a:pt x="210" y="606157"/>
                  </a:lnTo>
                  <a:lnTo>
                    <a:pt x="209" y="604859"/>
                  </a:lnTo>
                  <a:lnTo>
                    <a:pt x="209" y="603561"/>
                  </a:lnTo>
                  <a:lnTo>
                    <a:pt x="208" y="602263"/>
                  </a:lnTo>
                  <a:lnTo>
                    <a:pt x="208" y="600965"/>
                  </a:lnTo>
                  <a:lnTo>
                    <a:pt x="207" y="599667"/>
                  </a:lnTo>
                  <a:lnTo>
                    <a:pt x="207" y="598369"/>
                  </a:lnTo>
                  <a:lnTo>
                    <a:pt x="206" y="597071"/>
                  </a:lnTo>
                  <a:lnTo>
                    <a:pt x="206" y="595773"/>
                  </a:lnTo>
                  <a:lnTo>
                    <a:pt x="205" y="594475"/>
                  </a:lnTo>
                  <a:lnTo>
                    <a:pt x="205" y="593177"/>
                  </a:lnTo>
                  <a:lnTo>
                    <a:pt x="204" y="591879"/>
                  </a:lnTo>
                  <a:lnTo>
                    <a:pt x="203" y="590581"/>
                  </a:lnTo>
                  <a:lnTo>
                    <a:pt x="203" y="589283"/>
                  </a:lnTo>
                  <a:lnTo>
                    <a:pt x="202" y="587985"/>
                  </a:lnTo>
                  <a:lnTo>
                    <a:pt x="201" y="586687"/>
                  </a:lnTo>
                  <a:lnTo>
                    <a:pt x="201" y="585389"/>
                  </a:lnTo>
                  <a:lnTo>
                    <a:pt x="200" y="584091"/>
                  </a:lnTo>
                  <a:lnTo>
                    <a:pt x="199" y="582793"/>
                  </a:lnTo>
                  <a:lnTo>
                    <a:pt x="198" y="581495"/>
                  </a:lnTo>
                  <a:lnTo>
                    <a:pt x="198" y="580197"/>
                  </a:lnTo>
                  <a:lnTo>
                    <a:pt x="197" y="578899"/>
                  </a:lnTo>
                  <a:lnTo>
                    <a:pt x="196" y="577601"/>
                  </a:lnTo>
                  <a:lnTo>
                    <a:pt x="195" y="576303"/>
                  </a:lnTo>
                  <a:lnTo>
                    <a:pt x="194" y="575005"/>
                  </a:lnTo>
                  <a:lnTo>
                    <a:pt x="193" y="573707"/>
                  </a:lnTo>
                  <a:lnTo>
                    <a:pt x="193" y="572409"/>
                  </a:lnTo>
                  <a:lnTo>
                    <a:pt x="192" y="571111"/>
                  </a:lnTo>
                  <a:lnTo>
                    <a:pt x="191" y="569813"/>
                  </a:lnTo>
                  <a:lnTo>
                    <a:pt x="190" y="568515"/>
                  </a:lnTo>
                  <a:lnTo>
                    <a:pt x="189" y="567217"/>
                  </a:lnTo>
                  <a:lnTo>
                    <a:pt x="188" y="565919"/>
                  </a:lnTo>
                  <a:lnTo>
                    <a:pt x="186" y="564621"/>
                  </a:lnTo>
                  <a:lnTo>
                    <a:pt x="185" y="563323"/>
                  </a:lnTo>
                  <a:lnTo>
                    <a:pt x="184" y="562025"/>
                  </a:lnTo>
                  <a:lnTo>
                    <a:pt x="183" y="560727"/>
                  </a:lnTo>
                  <a:lnTo>
                    <a:pt x="182" y="559429"/>
                  </a:lnTo>
                  <a:lnTo>
                    <a:pt x="181" y="558131"/>
                  </a:lnTo>
                  <a:lnTo>
                    <a:pt x="179" y="556833"/>
                  </a:lnTo>
                  <a:lnTo>
                    <a:pt x="178" y="555535"/>
                  </a:lnTo>
                  <a:lnTo>
                    <a:pt x="177" y="554237"/>
                  </a:lnTo>
                  <a:lnTo>
                    <a:pt x="176" y="552939"/>
                  </a:lnTo>
                  <a:lnTo>
                    <a:pt x="174" y="551641"/>
                  </a:lnTo>
                  <a:lnTo>
                    <a:pt x="173" y="550343"/>
                  </a:lnTo>
                  <a:lnTo>
                    <a:pt x="172" y="549045"/>
                  </a:lnTo>
                  <a:lnTo>
                    <a:pt x="170" y="547747"/>
                  </a:lnTo>
                  <a:lnTo>
                    <a:pt x="169" y="546449"/>
                  </a:lnTo>
                  <a:lnTo>
                    <a:pt x="167" y="545151"/>
                  </a:lnTo>
                  <a:lnTo>
                    <a:pt x="166" y="543853"/>
                  </a:lnTo>
                  <a:lnTo>
                    <a:pt x="164" y="542555"/>
                  </a:lnTo>
                  <a:lnTo>
                    <a:pt x="163" y="541257"/>
                  </a:lnTo>
                  <a:lnTo>
                    <a:pt x="161" y="539959"/>
                  </a:lnTo>
                  <a:lnTo>
                    <a:pt x="159" y="538662"/>
                  </a:lnTo>
                  <a:lnTo>
                    <a:pt x="158" y="537364"/>
                  </a:lnTo>
                  <a:lnTo>
                    <a:pt x="156" y="536066"/>
                  </a:lnTo>
                  <a:lnTo>
                    <a:pt x="155" y="534768"/>
                  </a:lnTo>
                  <a:lnTo>
                    <a:pt x="153" y="533470"/>
                  </a:lnTo>
                  <a:lnTo>
                    <a:pt x="151" y="532172"/>
                  </a:lnTo>
                  <a:lnTo>
                    <a:pt x="149" y="530874"/>
                  </a:lnTo>
                  <a:lnTo>
                    <a:pt x="148" y="529576"/>
                  </a:lnTo>
                  <a:lnTo>
                    <a:pt x="146" y="528278"/>
                  </a:lnTo>
                  <a:lnTo>
                    <a:pt x="144" y="526980"/>
                  </a:lnTo>
                  <a:lnTo>
                    <a:pt x="142" y="525682"/>
                  </a:lnTo>
                  <a:lnTo>
                    <a:pt x="140" y="524384"/>
                  </a:lnTo>
                  <a:lnTo>
                    <a:pt x="138" y="523086"/>
                  </a:lnTo>
                  <a:lnTo>
                    <a:pt x="136" y="521788"/>
                  </a:lnTo>
                  <a:lnTo>
                    <a:pt x="134" y="520490"/>
                  </a:lnTo>
                  <a:lnTo>
                    <a:pt x="133" y="519192"/>
                  </a:lnTo>
                  <a:lnTo>
                    <a:pt x="131" y="517894"/>
                  </a:lnTo>
                  <a:lnTo>
                    <a:pt x="129" y="516596"/>
                  </a:lnTo>
                  <a:lnTo>
                    <a:pt x="127" y="515298"/>
                  </a:lnTo>
                  <a:lnTo>
                    <a:pt x="125" y="514000"/>
                  </a:lnTo>
                  <a:lnTo>
                    <a:pt x="123" y="512702"/>
                  </a:lnTo>
                  <a:lnTo>
                    <a:pt x="120" y="511404"/>
                  </a:lnTo>
                  <a:lnTo>
                    <a:pt x="118" y="510106"/>
                  </a:lnTo>
                  <a:lnTo>
                    <a:pt x="116" y="508808"/>
                  </a:lnTo>
                  <a:lnTo>
                    <a:pt x="114" y="507510"/>
                  </a:lnTo>
                  <a:lnTo>
                    <a:pt x="112" y="506212"/>
                  </a:lnTo>
                  <a:lnTo>
                    <a:pt x="110" y="504914"/>
                  </a:lnTo>
                  <a:lnTo>
                    <a:pt x="108" y="503616"/>
                  </a:lnTo>
                  <a:lnTo>
                    <a:pt x="106" y="502318"/>
                  </a:lnTo>
                  <a:lnTo>
                    <a:pt x="104" y="501020"/>
                  </a:lnTo>
                  <a:lnTo>
                    <a:pt x="101" y="499722"/>
                  </a:lnTo>
                  <a:lnTo>
                    <a:pt x="99" y="498424"/>
                  </a:lnTo>
                  <a:lnTo>
                    <a:pt x="97" y="497126"/>
                  </a:lnTo>
                  <a:lnTo>
                    <a:pt x="95" y="495828"/>
                  </a:lnTo>
                  <a:lnTo>
                    <a:pt x="93" y="494530"/>
                  </a:lnTo>
                  <a:lnTo>
                    <a:pt x="91" y="493232"/>
                  </a:lnTo>
                  <a:lnTo>
                    <a:pt x="88" y="491934"/>
                  </a:lnTo>
                  <a:lnTo>
                    <a:pt x="86" y="490636"/>
                  </a:lnTo>
                  <a:lnTo>
                    <a:pt x="84" y="489338"/>
                  </a:lnTo>
                  <a:lnTo>
                    <a:pt x="82" y="488040"/>
                  </a:lnTo>
                  <a:lnTo>
                    <a:pt x="80" y="486742"/>
                  </a:lnTo>
                  <a:lnTo>
                    <a:pt x="78" y="485444"/>
                  </a:lnTo>
                  <a:lnTo>
                    <a:pt x="75" y="484146"/>
                  </a:lnTo>
                  <a:lnTo>
                    <a:pt x="73" y="482848"/>
                  </a:lnTo>
                  <a:lnTo>
                    <a:pt x="71" y="481550"/>
                  </a:lnTo>
                  <a:lnTo>
                    <a:pt x="69" y="480252"/>
                  </a:lnTo>
                  <a:lnTo>
                    <a:pt x="67" y="478954"/>
                  </a:lnTo>
                  <a:lnTo>
                    <a:pt x="65" y="477656"/>
                  </a:lnTo>
                  <a:lnTo>
                    <a:pt x="63" y="476358"/>
                  </a:lnTo>
                  <a:lnTo>
                    <a:pt x="61" y="475060"/>
                  </a:lnTo>
                  <a:lnTo>
                    <a:pt x="59" y="473762"/>
                  </a:lnTo>
                  <a:lnTo>
                    <a:pt x="57" y="472464"/>
                  </a:lnTo>
                  <a:lnTo>
                    <a:pt x="55" y="471167"/>
                  </a:lnTo>
                  <a:lnTo>
                    <a:pt x="53" y="469869"/>
                  </a:lnTo>
                  <a:lnTo>
                    <a:pt x="51" y="468571"/>
                  </a:lnTo>
                  <a:lnTo>
                    <a:pt x="49" y="467273"/>
                  </a:lnTo>
                  <a:lnTo>
                    <a:pt x="47" y="465975"/>
                  </a:lnTo>
                  <a:lnTo>
                    <a:pt x="45" y="464677"/>
                  </a:lnTo>
                  <a:lnTo>
                    <a:pt x="43" y="463379"/>
                  </a:lnTo>
                  <a:lnTo>
                    <a:pt x="41" y="462081"/>
                  </a:lnTo>
                  <a:lnTo>
                    <a:pt x="39" y="460783"/>
                  </a:lnTo>
                  <a:lnTo>
                    <a:pt x="37" y="459485"/>
                  </a:lnTo>
                  <a:lnTo>
                    <a:pt x="36" y="458187"/>
                  </a:lnTo>
                  <a:lnTo>
                    <a:pt x="34" y="456889"/>
                  </a:lnTo>
                  <a:lnTo>
                    <a:pt x="32" y="455591"/>
                  </a:lnTo>
                  <a:lnTo>
                    <a:pt x="31" y="454293"/>
                  </a:lnTo>
                  <a:lnTo>
                    <a:pt x="29" y="452995"/>
                  </a:lnTo>
                  <a:lnTo>
                    <a:pt x="27" y="451697"/>
                  </a:lnTo>
                  <a:lnTo>
                    <a:pt x="26" y="450399"/>
                  </a:lnTo>
                  <a:lnTo>
                    <a:pt x="24" y="449101"/>
                  </a:lnTo>
                  <a:lnTo>
                    <a:pt x="23" y="447803"/>
                  </a:lnTo>
                  <a:lnTo>
                    <a:pt x="21" y="446505"/>
                  </a:lnTo>
                  <a:lnTo>
                    <a:pt x="20" y="445207"/>
                  </a:lnTo>
                  <a:lnTo>
                    <a:pt x="19" y="443909"/>
                  </a:lnTo>
                  <a:lnTo>
                    <a:pt x="17" y="442611"/>
                  </a:lnTo>
                  <a:lnTo>
                    <a:pt x="16" y="441313"/>
                  </a:lnTo>
                  <a:lnTo>
                    <a:pt x="15" y="440015"/>
                  </a:lnTo>
                  <a:lnTo>
                    <a:pt x="14" y="438717"/>
                  </a:lnTo>
                  <a:lnTo>
                    <a:pt x="13" y="437419"/>
                  </a:lnTo>
                  <a:lnTo>
                    <a:pt x="11" y="436121"/>
                  </a:lnTo>
                  <a:lnTo>
                    <a:pt x="10" y="434823"/>
                  </a:lnTo>
                  <a:lnTo>
                    <a:pt x="9" y="433525"/>
                  </a:lnTo>
                  <a:lnTo>
                    <a:pt x="9" y="432227"/>
                  </a:lnTo>
                  <a:lnTo>
                    <a:pt x="8" y="430929"/>
                  </a:lnTo>
                  <a:lnTo>
                    <a:pt x="7" y="429631"/>
                  </a:lnTo>
                  <a:lnTo>
                    <a:pt x="6" y="428333"/>
                  </a:lnTo>
                  <a:lnTo>
                    <a:pt x="5" y="427035"/>
                  </a:lnTo>
                  <a:lnTo>
                    <a:pt x="4" y="425737"/>
                  </a:lnTo>
                  <a:lnTo>
                    <a:pt x="4" y="424439"/>
                  </a:lnTo>
                  <a:lnTo>
                    <a:pt x="3" y="423141"/>
                  </a:lnTo>
                  <a:lnTo>
                    <a:pt x="3" y="421843"/>
                  </a:lnTo>
                  <a:lnTo>
                    <a:pt x="2" y="420545"/>
                  </a:lnTo>
                  <a:lnTo>
                    <a:pt x="2" y="419247"/>
                  </a:lnTo>
                  <a:lnTo>
                    <a:pt x="1" y="417949"/>
                  </a:lnTo>
                  <a:lnTo>
                    <a:pt x="1" y="416651"/>
                  </a:lnTo>
                  <a:lnTo>
                    <a:pt x="0" y="415353"/>
                  </a:lnTo>
                  <a:lnTo>
                    <a:pt x="0" y="414055"/>
                  </a:lnTo>
                  <a:lnTo>
                    <a:pt x="0" y="412757"/>
                  </a:lnTo>
                  <a:lnTo>
                    <a:pt x="0" y="411459"/>
                  </a:lnTo>
                  <a:lnTo>
                    <a:pt x="0" y="410161"/>
                  </a:lnTo>
                  <a:lnTo>
                    <a:pt x="0" y="408863"/>
                  </a:lnTo>
                  <a:lnTo>
                    <a:pt x="0" y="407565"/>
                  </a:lnTo>
                  <a:lnTo>
                    <a:pt x="0" y="406267"/>
                  </a:lnTo>
                  <a:lnTo>
                    <a:pt x="0" y="404969"/>
                  </a:lnTo>
                  <a:lnTo>
                    <a:pt x="0" y="403672"/>
                  </a:lnTo>
                  <a:lnTo>
                    <a:pt x="0" y="402374"/>
                  </a:lnTo>
                  <a:lnTo>
                    <a:pt x="0" y="401076"/>
                  </a:lnTo>
                  <a:lnTo>
                    <a:pt x="0" y="399778"/>
                  </a:lnTo>
                  <a:lnTo>
                    <a:pt x="0" y="398480"/>
                  </a:lnTo>
                  <a:lnTo>
                    <a:pt x="1" y="397182"/>
                  </a:lnTo>
                  <a:lnTo>
                    <a:pt x="1" y="395884"/>
                  </a:lnTo>
                  <a:lnTo>
                    <a:pt x="1" y="394586"/>
                  </a:lnTo>
                  <a:lnTo>
                    <a:pt x="2" y="393288"/>
                  </a:lnTo>
                  <a:lnTo>
                    <a:pt x="2" y="391990"/>
                  </a:lnTo>
                  <a:lnTo>
                    <a:pt x="3" y="390692"/>
                  </a:lnTo>
                  <a:lnTo>
                    <a:pt x="3" y="389394"/>
                  </a:lnTo>
                  <a:lnTo>
                    <a:pt x="4" y="388096"/>
                  </a:lnTo>
                  <a:lnTo>
                    <a:pt x="4" y="386798"/>
                  </a:lnTo>
                  <a:lnTo>
                    <a:pt x="5" y="385500"/>
                  </a:lnTo>
                  <a:lnTo>
                    <a:pt x="6" y="384202"/>
                  </a:lnTo>
                  <a:lnTo>
                    <a:pt x="6" y="382904"/>
                  </a:lnTo>
                  <a:lnTo>
                    <a:pt x="7" y="381606"/>
                  </a:lnTo>
                  <a:lnTo>
                    <a:pt x="8" y="380308"/>
                  </a:lnTo>
                  <a:lnTo>
                    <a:pt x="9" y="379010"/>
                  </a:lnTo>
                  <a:lnTo>
                    <a:pt x="9" y="377712"/>
                  </a:lnTo>
                  <a:lnTo>
                    <a:pt x="10" y="376414"/>
                  </a:lnTo>
                  <a:lnTo>
                    <a:pt x="11" y="375116"/>
                  </a:lnTo>
                  <a:lnTo>
                    <a:pt x="12" y="373818"/>
                  </a:lnTo>
                  <a:lnTo>
                    <a:pt x="13" y="372520"/>
                  </a:lnTo>
                  <a:lnTo>
                    <a:pt x="14" y="371222"/>
                  </a:lnTo>
                  <a:lnTo>
                    <a:pt x="14" y="369924"/>
                  </a:lnTo>
                  <a:lnTo>
                    <a:pt x="15" y="368626"/>
                  </a:lnTo>
                  <a:lnTo>
                    <a:pt x="16" y="367328"/>
                  </a:lnTo>
                  <a:lnTo>
                    <a:pt x="17" y="366030"/>
                  </a:lnTo>
                  <a:lnTo>
                    <a:pt x="18" y="364732"/>
                  </a:lnTo>
                  <a:lnTo>
                    <a:pt x="19" y="363434"/>
                  </a:lnTo>
                  <a:lnTo>
                    <a:pt x="20" y="362136"/>
                  </a:lnTo>
                  <a:lnTo>
                    <a:pt x="21" y="360838"/>
                  </a:lnTo>
                  <a:lnTo>
                    <a:pt x="22" y="359540"/>
                  </a:lnTo>
                  <a:lnTo>
                    <a:pt x="23" y="358242"/>
                  </a:lnTo>
                  <a:lnTo>
                    <a:pt x="24" y="356944"/>
                  </a:lnTo>
                  <a:lnTo>
                    <a:pt x="25" y="355646"/>
                  </a:lnTo>
                  <a:lnTo>
                    <a:pt x="26" y="354348"/>
                  </a:lnTo>
                  <a:lnTo>
                    <a:pt x="27" y="353050"/>
                  </a:lnTo>
                  <a:lnTo>
                    <a:pt x="28" y="351752"/>
                  </a:lnTo>
                  <a:lnTo>
                    <a:pt x="29" y="350454"/>
                  </a:lnTo>
                  <a:lnTo>
                    <a:pt x="30" y="349156"/>
                  </a:lnTo>
                  <a:lnTo>
                    <a:pt x="31" y="347858"/>
                  </a:lnTo>
                  <a:lnTo>
                    <a:pt x="32" y="346560"/>
                  </a:lnTo>
                  <a:lnTo>
                    <a:pt x="32" y="345262"/>
                  </a:lnTo>
                  <a:lnTo>
                    <a:pt x="33" y="343964"/>
                  </a:lnTo>
                  <a:lnTo>
                    <a:pt x="34" y="342666"/>
                  </a:lnTo>
                  <a:lnTo>
                    <a:pt x="35" y="341368"/>
                  </a:lnTo>
                  <a:lnTo>
                    <a:pt x="36" y="340070"/>
                  </a:lnTo>
                  <a:lnTo>
                    <a:pt x="37" y="338772"/>
                  </a:lnTo>
                  <a:lnTo>
                    <a:pt x="38" y="337474"/>
                  </a:lnTo>
                  <a:lnTo>
                    <a:pt x="39" y="336177"/>
                  </a:lnTo>
                  <a:lnTo>
                    <a:pt x="39" y="334879"/>
                  </a:lnTo>
                  <a:lnTo>
                    <a:pt x="40" y="333581"/>
                  </a:lnTo>
                  <a:lnTo>
                    <a:pt x="41" y="332283"/>
                  </a:lnTo>
                  <a:lnTo>
                    <a:pt x="42" y="330985"/>
                  </a:lnTo>
                  <a:lnTo>
                    <a:pt x="42" y="329687"/>
                  </a:lnTo>
                  <a:lnTo>
                    <a:pt x="43" y="328389"/>
                  </a:lnTo>
                  <a:lnTo>
                    <a:pt x="44" y="327091"/>
                  </a:lnTo>
                  <a:lnTo>
                    <a:pt x="44" y="325793"/>
                  </a:lnTo>
                  <a:lnTo>
                    <a:pt x="45" y="324495"/>
                  </a:lnTo>
                  <a:lnTo>
                    <a:pt x="45" y="323197"/>
                  </a:lnTo>
                  <a:lnTo>
                    <a:pt x="46" y="321899"/>
                  </a:lnTo>
                  <a:lnTo>
                    <a:pt x="47" y="320601"/>
                  </a:lnTo>
                  <a:lnTo>
                    <a:pt x="47" y="319303"/>
                  </a:lnTo>
                  <a:lnTo>
                    <a:pt x="48" y="318005"/>
                  </a:lnTo>
                  <a:lnTo>
                    <a:pt x="48" y="316707"/>
                  </a:lnTo>
                  <a:lnTo>
                    <a:pt x="48" y="315409"/>
                  </a:lnTo>
                  <a:lnTo>
                    <a:pt x="49" y="314111"/>
                  </a:lnTo>
                  <a:lnTo>
                    <a:pt x="49" y="312813"/>
                  </a:lnTo>
                  <a:lnTo>
                    <a:pt x="50" y="311515"/>
                  </a:lnTo>
                  <a:lnTo>
                    <a:pt x="50" y="310217"/>
                  </a:lnTo>
                  <a:lnTo>
                    <a:pt x="50" y="308919"/>
                  </a:lnTo>
                  <a:lnTo>
                    <a:pt x="50" y="307621"/>
                  </a:lnTo>
                  <a:lnTo>
                    <a:pt x="51" y="306323"/>
                  </a:lnTo>
                  <a:lnTo>
                    <a:pt x="51" y="305025"/>
                  </a:lnTo>
                  <a:lnTo>
                    <a:pt x="51" y="303727"/>
                  </a:lnTo>
                  <a:lnTo>
                    <a:pt x="51" y="302429"/>
                  </a:lnTo>
                  <a:lnTo>
                    <a:pt x="51" y="301131"/>
                  </a:lnTo>
                  <a:lnTo>
                    <a:pt x="52" y="299833"/>
                  </a:lnTo>
                  <a:lnTo>
                    <a:pt x="52" y="298535"/>
                  </a:lnTo>
                  <a:lnTo>
                    <a:pt x="52" y="297237"/>
                  </a:lnTo>
                  <a:lnTo>
                    <a:pt x="52" y="295939"/>
                  </a:lnTo>
                  <a:lnTo>
                    <a:pt x="52" y="294641"/>
                  </a:lnTo>
                  <a:lnTo>
                    <a:pt x="52" y="293343"/>
                  </a:lnTo>
                  <a:lnTo>
                    <a:pt x="52" y="292045"/>
                  </a:lnTo>
                  <a:lnTo>
                    <a:pt x="52" y="290747"/>
                  </a:lnTo>
                  <a:lnTo>
                    <a:pt x="52" y="289449"/>
                  </a:lnTo>
                  <a:lnTo>
                    <a:pt x="52" y="288151"/>
                  </a:lnTo>
                  <a:lnTo>
                    <a:pt x="52" y="286853"/>
                  </a:lnTo>
                  <a:lnTo>
                    <a:pt x="51" y="285555"/>
                  </a:lnTo>
                  <a:lnTo>
                    <a:pt x="51" y="284257"/>
                  </a:lnTo>
                  <a:lnTo>
                    <a:pt x="51" y="282959"/>
                  </a:lnTo>
                  <a:lnTo>
                    <a:pt x="51" y="281661"/>
                  </a:lnTo>
                  <a:lnTo>
                    <a:pt x="51" y="280363"/>
                  </a:lnTo>
                  <a:lnTo>
                    <a:pt x="51" y="279065"/>
                  </a:lnTo>
                  <a:lnTo>
                    <a:pt x="51" y="277767"/>
                  </a:lnTo>
                  <a:lnTo>
                    <a:pt x="50" y="276469"/>
                  </a:lnTo>
                  <a:lnTo>
                    <a:pt x="50" y="275171"/>
                  </a:lnTo>
                  <a:lnTo>
                    <a:pt x="50" y="273873"/>
                  </a:lnTo>
                  <a:lnTo>
                    <a:pt x="50" y="272575"/>
                  </a:lnTo>
                  <a:lnTo>
                    <a:pt x="50" y="271277"/>
                  </a:lnTo>
                  <a:lnTo>
                    <a:pt x="49" y="269979"/>
                  </a:lnTo>
                  <a:lnTo>
                    <a:pt x="49" y="268682"/>
                  </a:lnTo>
                  <a:lnTo>
                    <a:pt x="49" y="267384"/>
                  </a:lnTo>
                  <a:lnTo>
                    <a:pt x="49" y="266086"/>
                  </a:lnTo>
                  <a:lnTo>
                    <a:pt x="49" y="264788"/>
                  </a:lnTo>
                  <a:lnTo>
                    <a:pt x="48" y="263490"/>
                  </a:lnTo>
                  <a:lnTo>
                    <a:pt x="48" y="262192"/>
                  </a:lnTo>
                  <a:lnTo>
                    <a:pt x="48" y="260894"/>
                  </a:lnTo>
                  <a:lnTo>
                    <a:pt x="48" y="259596"/>
                  </a:lnTo>
                  <a:lnTo>
                    <a:pt x="48" y="258298"/>
                  </a:lnTo>
                  <a:lnTo>
                    <a:pt x="48" y="257000"/>
                  </a:lnTo>
                  <a:lnTo>
                    <a:pt x="47" y="255702"/>
                  </a:lnTo>
                  <a:lnTo>
                    <a:pt x="47" y="254404"/>
                  </a:lnTo>
                  <a:lnTo>
                    <a:pt x="47" y="253106"/>
                  </a:lnTo>
                  <a:lnTo>
                    <a:pt x="47" y="251808"/>
                  </a:lnTo>
                  <a:lnTo>
                    <a:pt x="47" y="250510"/>
                  </a:lnTo>
                  <a:lnTo>
                    <a:pt x="47" y="249212"/>
                  </a:lnTo>
                  <a:lnTo>
                    <a:pt x="47" y="247914"/>
                  </a:lnTo>
                  <a:lnTo>
                    <a:pt x="47" y="246616"/>
                  </a:lnTo>
                  <a:lnTo>
                    <a:pt x="47" y="245318"/>
                  </a:lnTo>
                  <a:lnTo>
                    <a:pt x="47" y="244020"/>
                  </a:lnTo>
                  <a:lnTo>
                    <a:pt x="47" y="242722"/>
                  </a:lnTo>
                  <a:lnTo>
                    <a:pt x="47" y="241424"/>
                  </a:lnTo>
                  <a:lnTo>
                    <a:pt x="47" y="240126"/>
                  </a:lnTo>
                  <a:lnTo>
                    <a:pt x="47" y="238828"/>
                  </a:lnTo>
                  <a:lnTo>
                    <a:pt x="48" y="237530"/>
                  </a:lnTo>
                  <a:lnTo>
                    <a:pt x="48" y="236232"/>
                  </a:lnTo>
                  <a:lnTo>
                    <a:pt x="48" y="234934"/>
                  </a:lnTo>
                  <a:lnTo>
                    <a:pt x="48" y="233636"/>
                  </a:lnTo>
                  <a:lnTo>
                    <a:pt x="49" y="232338"/>
                  </a:lnTo>
                  <a:lnTo>
                    <a:pt x="49" y="231040"/>
                  </a:lnTo>
                  <a:lnTo>
                    <a:pt x="49" y="229742"/>
                  </a:lnTo>
                  <a:lnTo>
                    <a:pt x="50" y="228444"/>
                  </a:lnTo>
                  <a:lnTo>
                    <a:pt x="50" y="227146"/>
                  </a:lnTo>
                  <a:lnTo>
                    <a:pt x="50" y="225848"/>
                  </a:lnTo>
                  <a:lnTo>
                    <a:pt x="51" y="224550"/>
                  </a:lnTo>
                  <a:lnTo>
                    <a:pt x="51" y="223252"/>
                  </a:lnTo>
                  <a:lnTo>
                    <a:pt x="52" y="221954"/>
                  </a:lnTo>
                  <a:lnTo>
                    <a:pt x="53" y="220656"/>
                  </a:lnTo>
                  <a:lnTo>
                    <a:pt x="53" y="219358"/>
                  </a:lnTo>
                  <a:lnTo>
                    <a:pt x="54" y="218060"/>
                  </a:lnTo>
                  <a:lnTo>
                    <a:pt x="55" y="216762"/>
                  </a:lnTo>
                  <a:lnTo>
                    <a:pt x="55" y="215464"/>
                  </a:lnTo>
                  <a:lnTo>
                    <a:pt x="56" y="214166"/>
                  </a:lnTo>
                  <a:lnTo>
                    <a:pt x="57" y="212868"/>
                  </a:lnTo>
                  <a:lnTo>
                    <a:pt x="58" y="211570"/>
                  </a:lnTo>
                  <a:lnTo>
                    <a:pt x="59" y="210272"/>
                  </a:lnTo>
                  <a:lnTo>
                    <a:pt x="60" y="208974"/>
                  </a:lnTo>
                  <a:lnTo>
                    <a:pt x="61" y="207676"/>
                  </a:lnTo>
                  <a:lnTo>
                    <a:pt x="62" y="206378"/>
                  </a:lnTo>
                  <a:lnTo>
                    <a:pt x="63" y="205080"/>
                  </a:lnTo>
                  <a:lnTo>
                    <a:pt x="64" y="203782"/>
                  </a:lnTo>
                  <a:lnTo>
                    <a:pt x="65" y="202484"/>
                  </a:lnTo>
                  <a:lnTo>
                    <a:pt x="66" y="201187"/>
                  </a:lnTo>
                  <a:lnTo>
                    <a:pt x="67" y="199889"/>
                  </a:lnTo>
                  <a:lnTo>
                    <a:pt x="68" y="198591"/>
                  </a:lnTo>
                  <a:lnTo>
                    <a:pt x="69" y="197293"/>
                  </a:lnTo>
                  <a:lnTo>
                    <a:pt x="71" y="195995"/>
                  </a:lnTo>
                  <a:lnTo>
                    <a:pt x="72" y="194697"/>
                  </a:lnTo>
                  <a:lnTo>
                    <a:pt x="73" y="193399"/>
                  </a:lnTo>
                  <a:lnTo>
                    <a:pt x="75" y="192101"/>
                  </a:lnTo>
                  <a:lnTo>
                    <a:pt x="76" y="190803"/>
                  </a:lnTo>
                  <a:lnTo>
                    <a:pt x="77" y="189505"/>
                  </a:lnTo>
                  <a:lnTo>
                    <a:pt x="79" y="188207"/>
                  </a:lnTo>
                  <a:lnTo>
                    <a:pt x="80" y="186909"/>
                  </a:lnTo>
                  <a:lnTo>
                    <a:pt x="82" y="185611"/>
                  </a:lnTo>
                  <a:lnTo>
                    <a:pt x="83" y="184313"/>
                  </a:lnTo>
                  <a:lnTo>
                    <a:pt x="85" y="183015"/>
                  </a:lnTo>
                  <a:lnTo>
                    <a:pt x="86" y="181717"/>
                  </a:lnTo>
                  <a:lnTo>
                    <a:pt x="88" y="180419"/>
                  </a:lnTo>
                  <a:lnTo>
                    <a:pt x="89" y="179121"/>
                  </a:lnTo>
                  <a:lnTo>
                    <a:pt x="91" y="177823"/>
                  </a:lnTo>
                  <a:lnTo>
                    <a:pt x="93" y="176525"/>
                  </a:lnTo>
                  <a:lnTo>
                    <a:pt x="94" y="175227"/>
                  </a:lnTo>
                  <a:lnTo>
                    <a:pt x="96" y="173929"/>
                  </a:lnTo>
                  <a:lnTo>
                    <a:pt x="98" y="172631"/>
                  </a:lnTo>
                  <a:lnTo>
                    <a:pt x="99" y="171333"/>
                  </a:lnTo>
                  <a:lnTo>
                    <a:pt x="101" y="170035"/>
                  </a:lnTo>
                  <a:lnTo>
                    <a:pt x="103" y="168737"/>
                  </a:lnTo>
                  <a:lnTo>
                    <a:pt x="105" y="167439"/>
                  </a:lnTo>
                  <a:lnTo>
                    <a:pt x="106" y="166141"/>
                  </a:lnTo>
                  <a:lnTo>
                    <a:pt x="108" y="164843"/>
                  </a:lnTo>
                  <a:lnTo>
                    <a:pt x="110" y="163545"/>
                  </a:lnTo>
                  <a:lnTo>
                    <a:pt x="111" y="162247"/>
                  </a:lnTo>
                  <a:lnTo>
                    <a:pt x="113" y="160949"/>
                  </a:lnTo>
                  <a:lnTo>
                    <a:pt x="115" y="159651"/>
                  </a:lnTo>
                  <a:lnTo>
                    <a:pt x="117" y="158353"/>
                  </a:lnTo>
                  <a:lnTo>
                    <a:pt x="119" y="157055"/>
                  </a:lnTo>
                  <a:lnTo>
                    <a:pt x="120" y="155757"/>
                  </a:lnTo>
                  <a:lnTo>
                    <a:pt x="122" y="154459"/>
                  </a:lnTo>
                  <a:lnTo>
                    <a:pt x="124" y="153161"/>
                  </a:lnTo>
                  <a:lnTo>
                    <a:pt x="126" y="151863"/>
                  </a:lnTo>
                  <a:lnTo>
                    <a:pt x="127" y="150565"/>
                  </a:lnTo>
                  <a:lnTo>
                    <a:pt x="129" y="149267"/>
                  </a:lnTo>
                  <a:lnTo>
                    <a:pt x="131" y="147969"/>
                  </a:lnTo>
                  <a:lnTo>
                    <a:pt x="133" y="146671"/>
                  </a:lnTo>
                  <a:lnTo>
                    <a:pt x="134" y="145373"/>
                  </a:lnTo>
                  <a:lnTo>
                    <a:pt x="136" y="144075"/>
                  </a:lnTo>
                  <a:lnTo>
                    <a:pt x="138" y="142777"/>
                  </a:lnTo>
                  <a:lnTo>
                    <a:pt x="139" y="141479"/>
                  </a:lnTo>
                  <a:lnTo>
                    <a:pt x="141" y="140181"/>
                  </a:lnTo>
                  <a:lnTo>
                    <a:pt x="143" y="138883"/>
                  </a:lnTo>
                  <a:lnTo>
                    <a:pt x="144" y="137585"/>
                  </a:lnTo>
                  <a:lnTo>
                    <a:pt x="146" y="136287"/>
                  </a:lnTo>
                  <a:lnTo>
                    <a:pt x="148" y="134989"/>
                  </a:lnTo>
                  <a:lnTo>
                    <a:pt x="149" y="133692"/>
                  </a:lnTo>
                  <a:lnTo>
                    <a:pt x="151" y="132394"/>
                  </a:lnTo>
                  <a:lnTo>
                    <a:pt x="153" y="131096"/>
                  </a:lnTo>
                  <a:lnTo>
                    <a:pt x="154" y="129798"/>
                  </a:lnTo>
                  <a:lnTo>
                    <a:pt x="156" y="128500"/>
                  </a:lnTo>
                  <a:lnTo>
                    <a:pt x="157" y="127202"/>
                  </a:lnTo>
                  <a:lnTo>
                    <a:pt x="159" y="125904"/>
                  </a:lnTo>
                  <a:lnTo>
                    <a:pt x="160" y="124606"/>
                  </a:lnTo>
                  <a:lnTo>
                    <a:pt x="162" y="123308"/>
                  </a:lnTo>
                  <a:lnTo>
                    <a:pt x="163" y="122010"/>
                  </a:lnTo>
                  <a:lnTo>
                    <a:pt x="165" y="120712"/>
                  </a:lnTo>
                  <a:lnTo>
                    <a:pt x="166" y="119414"/>
                  </a:lnTo>
                  <a:lnTo>
                    <a:pt x="168" y="118116"/>
                  </a:lnTo>
                  <a:lnTo>
                    <a:pt x="169" y="116818"/>
                  </a:lnTo>
                  <a:lnTo>
                    <a:pt x="170" y="115520"/>
                  </a:lnTo>
                  <a:lnTo>
                    <a:pt x="172" y="114222"/>
                  </a:lnTo>
                  <a:lnTo>
                    <a:pt x="173" y="112924"/>
                  </a:lnTo>
                  <a:lnTo>
                    <a:pt x="174" y="111626"/>
                  </a:lnTo>
                  <a:lnTo>
                    <a:pt x="176" y="110328"/>
                  </a:lnTo>
                  <a:lnTo>
                    <a:pt x="177" y="109030"/>
                  </a:lnTo>
                  <a:lnTo>
                    <a:pt x="178" y="107732"/>
                  </a:lnTo>
                  <a:lnTo>
                    <a:pt x="179" y="106434"/>
                  </a:lnTo>
                  <a:lnTo>
                    <a:pt x="180" y="105136"/>
                  </a:lnTo>
                  <a:lnTo>
                    <a:pt x="182" y="103838"/>
                  </a:lnTo>
                  <a:lnTo>
                    <a:pt x="183" y="102540"/>
                  </a:lnTo>
                  <a:lnTo>
                    <a:pt x="184" y="101242"/>
                  </a:lnTo>
                  <a:lnTo>
                    <a:pt x="185" y="99944"/>
                  </a:lnTo>
                  <a:lnTo>
                    <a:pt x="186" y="98646"/>
                  </a:lnTo>
                  <a:lnTo>
                    <a:pt x="187" y="97348"/>
                  </a:lnTo>
                  <a:lnTo>
                    <a:pt x="188" y="96050"/>
                  </a:lnTo>
                  <a:lnTo>
                    <a:pt x="189" y="94752"/>
                  </a:lnTo>
                  <a:lnTo>
                    <a:pt x="190" y="93454"/>
                  </a:lnTo>
                  <a:lnTo>
                    <a:pt x="191" y="92156"/>
                  </a:lnTo>
                  <a:lnTo>
                    <a:pt x="192" y="90858"/>
                  </a:lnTo>
                  <a:lnTo>
                    <a:pt x="193" y="89560"/>
                  </a:lnTo>
                  <a:lnTo>
                    <a:pt x="194" y="88262"/>
                  </a:lnTo>
                  <a:lnTo>
                    <a:pt x="195" y="86964"/>
                  </a:lnTo>
                  <a:lnTo>
                    <a:pt x="196" y="85666"/>
                  </a:lnTo>
                  <a:lnTo>
                    <a:pt x="196" y="84368"/>
                  </a:lnTo>
                  <a:lnTo>
                    <a:pt x="197" y="83070"/>
                  </a:lnTo>
                  <a:lnTo>
                    <a:pt x="198" y="81772"/>
                  </a:lnTo>
                  <a:lnTo>
                    <a:pt x="199" y="80474"/>
                  </a:lnTo>
                  <a:lnTo>
                    <a:pt x="199" y="79176"/>
                  </a:lnTo>
                  <a:lnTo>
                    <a:pt x="200" y="77878"/>
                  </a:lnTo>
                  <a:lnTo>
                    <a:pt x="201" y="76580"/>
                  </a:lnTo>
                  <a:lnTo>
                    <a:pt x="202" y="75282"/>
                  </a:lnTo>
                  <a:lnTo>
                    <a:pt x="202" y="73984"/>
                  </a:lnTo>
                  <a:lnTo>
                    <a:pt x="203" y="72686"/>
                  </a:lnTo>
                  <a:lnTo>
                    <a:pt x="203" y="71388"/>
                  </a:lnTo>
                  <a:lnTo>
                    <a:pt x="204" y="70090"/>
                  </a:lnTo>
                  <a:lnTo>
                    <a:pt x="205" y="68792"/>
                  </a:lnTo>
                  <a:lnTo>
                    <a:pt x="205" y="67494"/>
                  </a:lnTo>
                  <a:lnTo>
                    <a:pt x="206" y="66197"/>
                  </a:lnTo>
                  <a:lnTo>
                    <a:pt x="206" y="64899"/>
                  </a:lnTo>
                  <a:lnTo>
                    <a:pt x="207" y="63601"/>
                  </a:lnTo>
                  <a:lnTo>
                    <a:pt x="207" y="62303"/>
                  </a:lnTo>
                  <a:lnTo>
                    <a:pt x="208" y="61005"/>
                  </a:lnTo>
                  <a:lnTo>
                    <a:pt x="208" y="59707"/>
                  </a:lnTo>
                  <a:lnTo>
                    <a:pt x="209" y="58409"/>
                  </a:lnTo>
                  <a:lnTo>
                    <a:pt x="209" y="57111"/>
                  </a:lnTo>
                  <a:lnTo>
                    <a:pt x="210" y="55813"/>
                  </a:lnTo>
                  <a:lnTo>
                    <a:pt x="210" y="54515"/>
                  </a:lnTo>
                  <a:lnTo>
                    <a:pt x="210" y="53217"/>
                  </a:lnTo>
                  <a:lnTo>
                    <a:pt x="211" y="51919"/>
                  </a:lnTo>
                  <a:lnTo>
                    <a:pt x="211" y="50621"/>
                  </a:lnTo>
                  <a:lnTo>
                    <a:pt x="211" y="49323"/>
                  </a:lnTo>
                  <a:lnTo>
                    <a:pt x="212" y="48025"/>
                  </a:lnTo>
                  <a:lnTo>
                    <a:pt x="212" y="46727"/>
                  </a:lnTo>
                  <a:lnTo>
                    <a:pt x="212" y="45429"/>
                  </a:lnTo>
                  <a:lnTo>
                    <a:pt x="213" y="44131"/>
                  </a:lnTo>
                  <a:lnTo>
                    <a:pt x="213" y="42833"/>
                  </a:lnTo>
                  <a:lnTo>
                    <a:pt x="213" y="41535"/>
                  </a:lnTo>
                  <a:lnTo>
                    <a:pt x="214" y="40237"/>
                  </a:lnTo>
                  <a:lnTo>
                    <a:pt x="214" y="38939"/>
                  </a:lnTo>
                  <a:lnTo>
                    <a:pt x="214" y="37641"/>
                  </a:lnTo>
                  <a:lnTo>
                    <a:pt x="214" y="36343"/>
                  </a:lnTo>
                  <a:lnTo>
                    <a:pt x="215" y="35045"/>
                  </a:lnTo>
                  <a:lnTo>
                    <a:pt x="215" y="33747"/>
                  </a:lnTo>
                  <a:lnTo>
                    <a:pt x="215" y="32449"/>
                  </a:lnTo>
                  <a:lnTo>
                    <a:pt x="215" y="31151"/>
                  </a:lnTo>
                  <a:lnTo>
                    <a:pt x="215" y="29853"/>
                  </a:lnTo>
                  <a:lnTo>
                    <a:pt x="216" y="28555"/>
                  </a:lnTo>
                  <a:lnTo>
                    <a:pt x="216" y="27257"/>
                  </a:lnTo>
                  <a:lnTo>
                    <a:pt x="216" y="25959"/>
                  </a:lnTo>
                  <a:lnTo>
                    <a:pt x="216" y="24661"/>
                  </a:lnTo>
                  <a:lnTo>
                    <a:pt x="216" y="23363"/>
                  </a:lnTo>
                  <a:lnTo>
                    <a:pt x="216" y="22065"/>
                  </a:lnTo>
                  <a:lnTo>
                    <a:pt x="217" y="20767"/>
                  </a:lnTo>
                  <a:lnTo>
                    <a:pt x="217" y="19469"/>
                  </a:lnTo>
                  <a:lnTo>
                    <a:pt x="217" y="18171"/>
                  </a:lnTo>
                  <a:lnTo>
                    <a:pt x="217" y="16873"/>
                  </a:lnTo>
                  <a:lnTo>
                    <a:pt x="217" y="15575"/>
                  </a:lnTo>
                  <a:lnTo>
                    <a:pt x="217" y="14277"/>
                  </a:lnTo>
                  <a:lnTo>
                    <a:pt x="217" y="12979"/>
                  </a:lnTo>
                  <a:lnTo>
                    <a:pt x="217" y="11681"/>
                  </a:lnTo>
                  <a:lnTo>
                    <a:pt x="217" y="10383"/>
                  </a:lnTo>
                  <a:lnTo>
                    <a:pt x="218" y="9085"/>
                  </a:lnTo>
                  <a:lnTo>
                    <a:pt x="218" y="7787"/>
                  </a:lnTo>
                  <a:lnTo>
                    <a:pt x="218" y="6489"/>
                  </a:lnTo>
                  <a:lnTo>
                    <a:pt x="218" y="5191"/>
                  </a:lnTo>
                  <a:lnTo>
                    <a:pt x="218" y="3893"/>
                  </a:lnTo>
                  <a:lnTo>
                    <a:pt x="218" y="2595"/>
                  </a:lnTo>
                  <a:lnTo>
                    <a:pt x="218" y="1297"/>
                  </a:lnTo>
                  <a:lnTo>
                    <a:pt x="218" y="0"/>
                  </a:lnTo>
                  <a:lnTo>
                    <a:pt x="219" y="0"/>
                  </a:lnTo>
                  <a:lnTo>
                    <a:pt x="219" y="663268"/>
                  </a:lnTo>
                  <a:lnTo>
                    <a:pt x="219" y="663268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63" name="pl45"/>
            <p:cNvSpPr/>
            <p:nvPr/>
          </p:nvSpPr>
          <p:spPr>
            <a:xfrm>
              <a:off x="6068391" y="3620111"/>
              <a:ext cx="604" cy="258583"/>
            </a:xfrm>
            <a:custGeom>
              <a:avLst/>
              <a:gdLst/>
              <a:ahLst/>
              <a:cxnLst/>
              <a:rect l="0" t="0" r="0" b="0"/>
              <a:pathLst>
                <a:path w="604" h="258583">
                  <a:moveTo>
                    <a:pt x="0" y="0"/>
                  </a:moveTo>
                  <a:lnTo>
                    <a:pt x="2" y="0"/>
                  </a:lnTo>
                  <a:lnTo>
                    <a:pt x="2" y="506"/>
                  </a:lnTo>
                  <a:lnTo>
                    <a:pt x="2" y="1012"/>
                  </a:lnTo>
                  <a:lnTo>
                    <a:pt x="2" y="1518"/>
                  </a:lnTo>
                  <a:lnTo>
                    <a:pt x="3" y="2024"/>
                  </a:lnTo>
                  <a:lnTo>
                    <a:pt x="3" y="2530"/>
                  </a:lnTo>
                  <a:lnTo>
                    <a:pt x="3" y="3036"/>
                  </a:lnTo>
                  <a:lnTo>
                    <a:pt x="3" y="3542"/>
                  </a:lnTo>
                  <a:lnTo>
                    <a:pt x="3" y="4048"/>
                  </a:lnTo>
                  <a:lnTo>
                    <a:pt x="3" y="4554"/>
                  </a:lnTo>
                  <a:lnTo>
                    <a:pt x="4" y="5060"/>
                  </a:lnTo>
                  <a:lnTo>
                    <a:pt x="4" y="5566"/>
                  </a:lnTo>
                  <a:lnTo>
                    <a:pt x="4" y="6072"/>
                  </a:lnTo>
                  <a:lnTo>
                    <a:pt x="4" y="6578"/>
                  </a:lnTo>
                  <a:lnTo>
                    <a:pt x="5" y="7084"/>
                  </a:lnTo>
                  <a:lnTo>
                    <a:pt x="5" y="7590"/>
                  </a:lnTo>
                  <a:lnTo>
                    <a:pt x="5" y="8096"/>
                  </a:lnTo>
                  <a:lnTo>
                    <a:pt x="6" y="8602"/>
                  </a:lnTo>
                  <a:lnTo>
                    <a:pt x="6" y="9108"/>
                  </a:lnTo>
                  <a:lnTo>
                    <a:pt x="6" y="9614"/>
                  </a:lnTo>
                  <a:lnTo>
                    <a:pt x="7" y="10120"/>
                  </a:lnTo>
                  <a:lnTo>
                    <a:pt x="7" y="10626"/>
                  </a:lnTo>
                  <a:lnTo>
                    <a:pt x="7" y="11132"/>
                  </a:lnTo>
                  <a:lnTo>
                    <a:pt x="8" y="11638"/>
                  </a:lnTo>
                  <a:lnTo>
                    <a:pt x="8" y="12144"/>
                  </a:lnTo>
                  <a:lnTo>
                    <a:pt x="9" y="12650"/>
                  </a:lnTo>
                  <a:lnTo>
                    <a:pt x="9" y="13156"/>
                  </a:lnTo>
                  <a:lnTo>
                    <a:pt x="10" y="13662"/>
                  </a:lnTo>
                  <a:lnTo>
                    <a:pt x="10" y="14168"/>
                  </a:lnTo>
                  <a:lnTo>
                    <a:pt x="11" y="14675"/>
                  </a:lnTo>
                  <a:lnTo>
                    <a:pt x="11" y="15181"/>
                  </a:lnTo>
                  <a:lnTo>
                    <a:pt x="12" y="15687"/>
                  </a:lnTo>
                  <a:lnTo>
                    <a:pt x="12" y="16193"/>
                  </a:lnTo>
                  <a:lnTo>
                    <a:pt x="13" y="16699"/>
                  </a:lnTo>
                  <a:lnTo>
                    <a:pt x="13" y="17205"/>
                  </a:lnTo>
                  <a:lnTo>
                    <a:pt x="14" y="17711"/>
                  </a:lnTo>
                  <a:lnTo>
                    <a:pt x="15" y="18217"/>
                  </a:lnTo>
                  <a:lnTo>
                    <a:pt x="15" y="18723"/>
                  </a:lnTo>
                  <a:lnTo>
                    <a:pt x="16" y="19229"/>
                  </a:lnTo>
                  <a:lnTo>
                    <a:pt x="17" y="19735"/>
                  </a:lnTo>
                  <a:lnTo>
                    <a:pt x="18" y="20241"/>
                  </a:lnTo>
                  <a:lnTo>
                    <a:pt x="18" y="20747"/>
                  </a:lnTo>
                  <a:lnTo>
                    <a:pt x="19" y="21253"/>
                  </a:lnTo>
                  <a:lnTo>
                    <a:pt x="20" y="21759"/>
                  </a:lnTo>
                  <a:lnTo>
                    <a:pt x="21" y="22265"/>
                  </a:lnTo>
                  <a:lnTo>
                    <a:pt x="22" y="22771"/>
                  </a:lnTo>
                  <a:lnTo>
                    <a:pt x="23" y="23277"/>
                  </a:lnTo>
                  <a:lnTo>
                    <a:pt x="24" y="23783"/>
                  </a:lnTo>
                  <a:lnTo>
                    <a:pt x="25" y="24289"/>
                  </a:lnTo>
                  <a:lnTo>
                    <a:pt x="26" y="24795"/>
                  </a:lnTo>
                  <a:lnTo>
                    <a:pt x="27" y="25301"/>
                  </a:lnTo>
                  <a:lnTo>
                    <a:pt x="28" y="25807"/>
                  </a:lnTo>
                  <a:lnTo>
                    <a:pt x="29" y="26313"/>
                  </a:lnTo>
                  <a:lnTo>
                    <a:pt x="31" y="26819"/>
                  </a:lnTo>
                  <a:lnTo>
                    <a:pt x="32" y="27325"/>
                  </a:lnTo>
                  <a:lnTo>
                    <a:pt x="33" y="27831"/>
                  </a:lnTo>
                  <a:lnTo>
                    <a:pt x="34" y="28337"/>
                  </a:lnTo>
                  <a:lnTo>
                    <a:pt x="36" y="28843"/>
                  </a:lnTo>
                  <a:lnTo>
                    <a:pt x="37" y="29350"/>
                  </a:lnTo>
                  <a:lnTo>
                    <a:pt x="38" y="29856"/>
                  </a:lnTo>
                  <a:lnTo>
                    <a:pt x="40" y="30362"/>
                  </a:lnTo>
                  <a:lnTo>
                    <a:pt x="41" y="30868"/>
                  </a:lnTo>
                  <a:lnTo>
                    <a:pt x="43" y="31374"/>
                  </a:lnTo>
                  <a:lnTo>
                    <a:pt x="44" y="31880"/>
                  </a:lnTo>
                  <a:lnTo>
                    <a:pt x="46" y="32386"/>
                  </a:lnTo>
                  <a:lnTo>
                    <a:pt x="48" y="32892"/>
                  </a:lnTo>
                  <a:lnTo>
                    <a:pt x="49" y="33398"/>
                  </a:lnTo>
                  <a:lnTo>
                    <a:pt x="51" y="33904"/>
                  </a:lnTo>
                  <a:lnTo>
                    <a:pt x="53" y="34410"/>
                  </a:lnTo>
                  <a:lnTo>
                    <a:pt x="55" y="34916"/>
                  </a:lnTo>
                  <a:lnTo>
                    <a:pt x="56" y="35422"/>
                  </a:lnTo>
                  <a:lnTo>
                    <a:pt x="58" y="35928"/>
                  </a:lnTo>
                  <a:lnTo>
                    <a:pt x="60" y="36434"/>
                  </a:lnTo>
                  <a:lnTo>
                    <a:pt x="62" y="36940"/>
                  </a:lnTo>
                  <a:lnTo>
                    <a:pt x="64" y="37446"/>
                  </a:lnTo>
                  <a:lnTo>
                    <a:pt x="66" y="37952"/>
                  </a:lnTo>
                  <a:lnTo>
                    <a:pt x="68" y="38458"/>
                  </a:lnTo>
                  <a:lnTo>
                    <a:pt x="71" y="38964"/>
                  </a:lnTo>
                  <a:lnTo>
                    <a:pt x="73" y="39470"/>
                  </a:lnTo>
                  <a:lnTo>
                    <a:pt x="75" y="39976"/>
                  </a:lnTo>
                  <a:lnTo>
                    <a:pt x="77" y="40482"/>
                  </a:lnTo>
                  <a:lnTo>
                    <a:pt x="80" y="40988"/>
                  </a:lnTo>
                  <a:lnTo>
                    <a:pt x="82" y="41494"/>
                  </a:lnTo>
                  <a:lnTo>
                    <a:pt x="84" y="42000"/>
                  </a:lnTo>
                  <a:lnTo>
                    <a:pt x="87" y="42506"/>
                  </a:lnTo>
                  <a:lnTo>
                    <a:pt x="89" y="43012"/>
                  </a:lnTo>
                  <a:lnTo>
                    <a:pt x="92" y="43518"/>
                  </a:lnTo>
                  <a:lnTo>
                    <a:pt x="94" y="44025"/>
                  </a:lnTo>
                  <a:lnTo>
                    <a:pt x="97" y="44531"/>
                  </a:lnTo>
                  <a:lnTo>
                    <a:pt x="100" y="45037"/>
                  </a:lnTo>
                  <a:lnTo>
                    <a:pt x="102" y="45543"/>
                  </a:lnTo>
                  <a:lnTo>
                    <a:pt x="105" y="46049"/>
                  </a:lnTo>
                  <a:lnTo>
                    <a:pt x="108" y="46555"/>
                  </a:lnTo>
                  <a:lnTo>
                    <a:pt x="111" y="47061"/>
                  </a:lnTo>
                  <a:lnTo>
                    <a:pt x="113" y="47567"/>
                  </a:lnTo>
                  <a:lnTo>
                    <a:pt x="116" y="48073"/>
                  </a:lnTo>
                  <a:lnTo>
                    <a:pt x="119" y="48579"/>
                  </a:lnTo>
                  <a:lnTo>
                    <a:pt x="122" y="49085"/>
                  </a:lnTo>
                  <a:lnTo>
                    <a:pt x="125" y="49591"/>
                  </a:lnTo>
                  <a:lnTo>
                    <a:pt x="128" y="50097"/>
                  </a:lnTo>
                  <a:lnTo>
                    <a:pt x="131" y="50603"/>
                  </a:lnTo>
                  <a:lnTo>
                    <a:pt x="134" y="51109"/>
                  </a:lnTo>
                  <a:lnTo>
                    <a:pt x="137" y="51615"/>
                  </a:lnTo>
                  <a:lnTo>
                    <a:pt x="140" y="52121"/>
                  </a:lnTo>
                  <a:lnTo>
                    <a:pt x="143" y="52627"/>
                  </a:lnTo>
                  <a:lnTo>
                    <a:pt x="146" y="53133"/>
                  </a:lnTo>
                  <a:lnTo>
                    <a:pt x="150" y="53639"/>
                  </a:lnTo>
                  <a:lnTo>
                    <a:pt x="153" y="54145"/>
                  </a:lnTo>
                  <a:lnTo>
                    <a:pt x="156" y="54651"/>
                  </a:lnTo>
                  <a:lnTo>
                    <a:pt x="159" y="55157"/>
                  </a:lnTo>
                  <a:lnTo>
                    <a:pt x="163" y="55663"/>
                  </a:lnTo>
                  <a:lnTo>
                    <a:pt x="166" y="56169"/>
                  </a:lnTo>
                  <a:lnTo>
                    <a:pt x="169" y="56675"/>
                  </a:lnTo>
                  <a:lnTo>
                    <a:pt x="172" y="57181"/>
                  </a:lnTo>
                  <a:lnTo>
                    <a:pt x="176" y="57687"/>
                  </a:lnTo>
                  <a:lnTo>
                    <a:pt x="179" y="58194"/>
                  </a:lnTo>
                  <a:lnTo>
                    <a:pt x="182" y="58700"/>
                  </a:lnTo>
                  <a:lnTo>
                    <a:pt x="186" y="59206"/>
                  </a:lnTo>
                  <a:lnTo>
                    <a:pt x="189" y="59712"/>
                  </a:lnTo>
                  <a:lnTo>
                    <a:pt x="192" y="60218"/>
                  </a:lnTo>
                  <a:lnTo>
                    <a:pt x="196" y="60724"/>
                  </a:lnTo>
                  <a:lnTo>
                    <a:pt x="199" y="61230"/>
                  </a:lnTo>
                  <a:lnTo>
                    <a:pt x="202" y="61736"/>
                  </a:lnTo>
                  <a:lnTo>
                    <a:pt x="206" y="62242"/>
                  </a:lnTo>
                  <a:lnTo>
                    <a:pt x="209" y="62748"/>
                  </a:lnTo>
                  <a:lnTo>
                    <a:pt x="213" y="63254"/>
                  </a:lnTo>
                  <a:lnTo>
                    <a:pt x="216" y="63760"/>
                  </a:lnTo>
                  <a:lnTo>
                    <a:pt x="219" y="64266"/>
                  </a:lnTo>
                  <a:lnTo>
                    <a:pt x="223" y="64772"/>
                  </a:lnTo>
                  <a:lnTo>
                    <a:pt x="226" y="65278"/>
                  </a:lnTo>
                  <a:lnTo>
                    <a:pt x="229" y="65784"/>
                  </a:lnTo>
                  <a:lnTo>
                    <a:pt x="233" y="66290"/>
                  </a:lnTo>
                  <a:lnTo>
                    <a:pt x="236" y="66796"/>
                  </a:lnTo>
                  <a:lnTo>
                    <a:pt x="239" y="67302"/>
                  </a:lnTo>
                  <a:lnTo>
                    <a:pt x="242" y="67808"/>
                  </a:lnTo>
                  <a:lnTo>
                    <a:pt x="246" y="68314"/>
                  </a:lnTo>
                  <a:lnTo>
                    <a:pt x="249" y="68820"/>
                  </a:lnTo>
                  <a:lnTo>
                    <a:pt x="252" y="69326"/>
                  </a:lnTo>
                  <a:lnTo>
                    <a:pt x="255" y="69832"/>
                  </a:lnTo>
                  <a:lnTo>
                    <a:pt x="258" y="70338"/>
                  </a:lnTo>
                  <a:lnTo>
                    <a:pt x="262" y="70844"/>
                  </a:lnTo>
                  <a:lnTo>
                    <a:pt x="265" y="71350"/>
                  </a:lnTo>
                  <a:lnTo>
                    <a:pt x="268" y="71856"/>
                  </a:lnTo>
                  <a:lnTo>
                    <a:pt x="271" y="72362"/>
                  </a:lnTo>
                  <a:lnTo>
                    <a:pt x="274" y="72869"/>
                  </a:lnTo>
                  <a:lnTo>
                    <a:pt x="277" y="73375"/>
                  </a:lnTo>
                  <a:lnTo>
                    <a:pt x="280" y="73881"/>
                  </a:lnTo>
                  <a:lnTo>
                    <a:pt x="283" y="74387"/>
                  </a:lnTo>
                  <a:lnTo>
                    <a:pt x="286" y="74893"/>
                  </a:lnTo>
                  <a:lnTo>
                    <a:pt x="289" y="75399"/>
                  </a:lnTo>
                  <a:lnTo>
                    <a:pt x="292" y="75905"/>
                  </a:lnTo>
                  <a:lnTo>
                    <a:pt x="294" y="76411"/>
                  </a:lnTo>
                  <a:lnTo>
                    <a:pt x="297" y="76917"/>
                  </a:lnTo>
                  <a:lnTo>
                    <a:pt x="300" y="77423"/>
                  </a:lnTo>
                  <a:lnTo>
                    <a:pt x="303" y="77929"/>
                  </a:lnTo>
                  <a:lnTo>
                    <a:pt x="305" y="78435"/>
                  </a:lnTo>
                  <a:lnTo>
                    <a:pt x="308" y="78941"/>
                  </a:lnTo>
                  <a:lnTo>
                    <a:pt x="311" y="79447"/>
                  </a:lnTo>
                  <a:lnTo>
                    <a:pt x="313" y="79953"/>
                  </a:lnTo>
                  <a:lnTo>
                    <a:pt x="316" y="80459"/>
                  </a:lnTo>
                  <a:lnTo>
                    <a:pt x="318" y="80965"/>
                  </a:lnTo>
                  <a:lnTo>
                    <a:pt x="321" y="81471"/>
                  </a:lnTo>
                  <a:lnTo>
                    <a:pt x="323" y="81977"/>
                  </a:lnTo>
                  <a:lnTo>
                    <a:pt x="326" y="82483"/>
                  </a:lnTo>
                  <a:lnTo>
                    <a:pt x="328" y="82989"/>
                  </a:lnTo>
                  <a:lnTo>
                    <a:pt x="331" y="83495"/>
                  </a:lnTo>
                  <a:lnTo>
                    <a:pt x="333" y="84001"/>
                  </a:lnTo>
                  <a:lnTo>
                    <a:pt x="335" y="84507"/>
                  </a:lnTo>
                  <a:lnTo>
                    <a:pt x="337" y="85013"/>
                  </a:lnTo>
                  <a:lnTo>
                    <a:pt x="340" y="85519"/>
                  </a:lnTo>
                  <a:lnTo>
                    <a:pt x="342" y="86025"/>
                  </a:lnTo>
                  <a:lnTo>
                    <a:pt x="344" y="86531"/>
                  </a:lnTo>
                  <a:lnTo>
                    <a:pt x="346" y="87037"/>
                  </a:lnTo>
                  <a:lnTo>
                    <a:pt x="348" y="87544"/>
                  </a:lnTo>
                  <a:lnTo>
                    <a:pt x="350" y="88050"/>
                  </a:lnTo>
                  <a:lnTo>
                    <a:pt x="352" y="88556"/>
                  </a:lnTo>
                  <a:lnTo>
                    <a:pt x="354" y="89062"/>
                  </a:lnTo>
                  <a:lnTo>
                    <a:pt x="356" y="89568"/>
                  </a:lnTo>
                  <a:lnTo>
                    <a:pt x="358" y="90074"/>
                  </a:lnTo>
                  <a:lnTo>
                    <a:pt x="360" y="90580"/>
                  </a:lnTo>
                  <a:lnTo>
                    <a:pt x="362" y="91086"/>
                  </a:lnTo>
                  <a:lnTo>
                    <a:pt x="364" y="91592"/>
                  </a:lnTo>
                  <a:lnTo>
                    <a:pt x="365" y="92098"/>
                  </a:lnTo>
                  <a:lnTo>
                    <a:pt x="367" y="92604"/>
                  </a:lnTo>
                  <a:lnTo>
                    <a:pt x="369" y="93110"/>
                  </a:lnTo>
                  <a:lnTo>
                    <a:pt x="371" y="93616"/>
                  </a:lnTo>
                  <a:lnTo>
                    <a:pt x="372" y="94122"/>
                  </a:lnTo>
                  <a:lnTo>
                    <a:pt x="374" y="94628"/>
                  </a:lnTo>
                  <a:lnTo>
                    <a:pt x="376" y="95134"/>
                  </a:lnTo>
                  <a:lnTo>
                    <a:pt x="377" y="95640"/>
                  </a:lnTo>
                  <a:lnTo>
                    <a:pt x="379" y="96146"/>
                  </a:lnTo>
                  <a:lnTo>
                    <a:pt x="380" y="96652"/>
                  </a:lnTo>
                  <a:lnTo>
                    <a:pt x="382" y="97158"/>
                  </a:lnTo>
                  <a:lnTo>
                    <a:pt x="384" y="97664"/>
                  </a:lnTo>
                  <a:lnTo>
                    <a:pt x="385" y="98170"/>
                  </a:lnTo>
                  <a:lnTo>
                    <a:pt x="387" y="98676"/>
                  </a:lnTo>
                  <a:lnTo>
                    <a:pt x="388" y="99182"/>
                  </a:lnTo>
                  <a:lnTo>
                    <a:pt x="390" y="99688"/>
                  </a:lnTo>
                  <a:lnTo>
                    <a:pt x="391" y="100194"/>
                  </a:lnTo>
                  <a:lnTo>
                    <a:pt x="393" y="100700"/>
                  </a:lnTo>
                  <a:lnTo>
                    <a:pt x="394" y="101206"/>
                  </a:lnTo>
                  <a:lnTo>
                    <a:pt x="395" y="101713"/>
                  </a:lnTo>
                  <a:lnTo>
                    <a:pt x="397" y="102219"/>
                  </a:lnTo>
                  <a:lnTo>
                    <a:pt x="398" y="102725"/>
                  </a:lnTo>
                  <a:lnTo>
                    <a:pt x="400" y="103231"/>
                  </a:lnTo>
                  <a:lnTo>
                    <a:pt x="401" y="103737"/>
                  </a:lnTo>
                  <a:lnTo>
                    <a:pt x="403" y="104243"/>
                  </a:lnTo>
                  <a:lnTo>
                    <a:pt x="404" y="104749"/>
                  </a:lnTo>
                  <a:lnTo>
                    <a:pt x="405" y="105255"/>
                  </a:lnTo>
                  <a:lnTo>
                    <a:pt x="407" y="105761"/>
                  </a:lnTo>
                  <a:lnTo>
                    <a:pt x="408" y="106267"/>
                  </a:lnTo>
                  <a:lnTo>
                    <a:pt x="410" y="106773"/>
                  </a:lnTo>
                  <a:lnTo>
                    <a:pt x="411" y="107279"/>
                  </a:lnTo>
                  <a:lnTo>
                    <a:pt x="412" y="107785"/>
                  </a:lnTo>
                  <a:lnTo>
                    <a:pt x="414" y="108291"/>
                  </a:lnTo>
                  <a:lnTo>
                    <a:pt x="415" y="108797"/>
                  </a:lnTo>
                  <a:lnTo>
                    <a:pt x="417" y="109303"/>
                  </a:lnTo>
                  <a:lnTo>
                    <a:pt x="418" y="109809"/>
                  </a:lnTo>
                  <a:lnTo>
                    <a:pt x="420" y="110315"/>
                  </a:lnTo>
                  <a:lnTo>
                    <a:pt x="421" y="110821"/>
                  </a:lnTo>
                  <a:lnTo>
                    <a:pt x="422" y="111327"/>
                  </a:lnTo>
                  <a:lnTo>
                    <a:pt x="424" y="111833"/>
                  </a:lnTo>
                  <a:lnTo>
                    <a:pt x="425" y="112339"/>
                  </a:lnTo>
                  <a:lnTo>
                    <a:pt x="427" y="112845"/>
                  </a:lnTo>
                  <a:lnTo>
                    <a:pt x="428" y="113351"/>
                  </a:lnTo>
                  <a:lnTo>
                    <a:pt x="430" y="113857"/>
                  </a:lnTo>
                  <a:lnTo>
                    <a:pt x="432" y="114363"/>
                  </a:lnTo>
                  <a:lnTo>
                    <a:pt x="433" y="114869"/>
                  </a:lnTo>
                  <a:lnTo>
                    <a:pt x="435" y="115375"/>
                  </a:lnTo>
                  <a:lnTo>
                    <a:pt x="436" y="115881"/>
                  </a:lnTo>
                  <a:lnTo>
                    <a:pt x="438" y="116388"/>
                  </a:lnTo>
                  <a:lnTo>
                    <a:pt x="440" y="116894"/>
                  </a:lnTo>
                  <a:lnTo>
                    <a:pt x="441" y="117400"/>
                  </a:lnTo>
                  <a:lnTo>
                    <a:pt x="443" y="117906"/>
                  </a:lnTo>
                  <a:lnTo>
                    <a:pt x="445" y="118412"/>
                  </a:lnTo>
                  <a:lnTo>
                    <a:pt x="447" y="118918"/>
                  </a:lnTo>
                  <a:lnTo>
                    <a:pt x="448" y="119424"/>
                  </a:lnTo>
                  <a:lnTo>
                    <a:pt x="450" y="119930"/>
                  </a:lnTo>
                  <a:lnTo>
                    <a:pt x="452" y="120436"/>
                  </a:lnTo>
                  <a:lnTo>
                    <a:pt x="454" y="120942"/>
                  </a:lnTo>
                  <a:lnTo>
                    <a:pt x="456" y="121448"/>
                  </a:lnTo>
                  <a:lnTo>
                    <a:pt x="458" y="121954"/>
                  </a:lnTo>
                  <a:lnTo>
                    <a:pt x="459" y="122460"/>
                  </a:lnTo>
                  <a:lnTo>
                    <a:pt x="461" y="122966"/>
                  </a:lnTo>
                  <a:lnTo>
                    <a:pt x="463" y="123472"/>
                  </a:lnTo>
                  <a:lnTo>
                    <a:pt x="465" y="123978"/>
                  </a:lnTo>
                  <a:lnTo>
                    <a:pt x="467" y="124484"/>
                  </a:lnTo>
                  <a:lnTo>
                    <a:pt x="469" y="124990"/>
                  </a:lnTo>
                  <a:lnTo>
                    <a:pt x="472" y="125496"/>
                  </a:lnTo>
                  <a:lnTo>
                    <a:pt x="474" y="126002"/>
                  </a:lnTo>
                  <a:lnTo>
                    <a:pt x="476" y="126508"/>
                  </a:lnTo>
                  <a:lnTo>
                    <a:pt x="478" y="127014"/>
                  </a:lnTo>
                  <a:lnTo>
                    <a:pt x="480" y="127520"/>
                  </a:lnTo>
                  <a:lnTo>
                    <a:pt x="482" y="128026"/>
                  </a:lnTo>
                  <a:lnTo>
                    <a:pt x="485" y="128532"/>
                  </a:lnTo>
                  <a:lnTo>
                    <a:pt x="487" y="129038"/>
                  </a:lnTo>
                  <a:lnTo>
                    <a:pt x="489" y="129544"/>
                  </a:lnTo>
                  <a:lnTo>
                    <a:pt x="491" y="130050"/>
                  </a:lnTo>
                  <a:lnTo>
                    <a:pt x="494" y="130556"/>
                  </a:lnTo>
                  <a:lnTo>
                    <a:pt x="496" y="131063"/>
                  </a:lnTo>
                  <a:lnTo>
                    <a:pt x="498" y="131569"/>
                  </a:lnTo>
                  <a:lnTo>
                    <a:pt x="501" y="132075"/>
                  </a:lnTo>
                  <a:lnTo>
                    <a:pt x="503" y="132581"/>
                  </a:lnTo>
                  <a:lnTo>
                    <a:pt x="505" y="133087"/>
                  </a:lnTo>
                  <a:lnTo>
                    <a:pt x="508" y="133593"/>
                  </a:lnTo>
                  <a:lnTo>
                    <a:pt x="510" y="134099"/>
                  </a:lnTo>
                  <a:lnTo>
                    <a:pt x="513" y="134605"/>
                  </a:lnTo>
                  <a:lnTo>
                    <a:pt x="515" y="135111"/>
                  </a:lnTo>
                  <a:lnTo>
                    <a:pt x="518" y="135617"/>
                  </a:lnTo>
                  <a:lnTo>
                    <a:pt x="520" y="136123"/>
                  </a:lnTo>
                  <a:lnTo>
                    <a:pt x="523" y="136629"/>
                  </a:lnTo>
                  <a:lnTo>
                    <a:pt x="525" y="137135"/>
                  </a:lnTo>
                  <a:lnTo>
                    <a:pt x="528" y="137641"/>
                  </a:lnTo>
                  <a:lnTo>
                    <a:pt x="530" y="138147"/>
                  </a:lnTo>
                  <a:lnTo>
                    <a:pt x="533" y="138653"/>
                  </a:lnTo>
                  <a:lnTo>
                    <a:pt x="535" y="139159"/>
                  </a:lnTo>
                  <a:lnTo>
                    <a:pt x="537" y="139665"/>
                  </a:lnTo>
                  <a:lnTo>
                    <a:pt x="540" y="140171"/>
                  </a:lnTo>
                  <a:lnTo>
                    <a:pt x="542" y="140677"/>
                  </a:lnTo>
                  <a:lnTo>
                    <a:pt x="545" y="141183"/>
                  </a:lnTo>
                  <a:lnTo>
                    <a:pt x="547" y="141689"/>
                  </a:lnTo>
                  <a:lnTo>
                    <a:pt x="550" y="142195"/>
                  </a:lnTo>
                  <a:lnTo>
                    <a:pt x="552" y="142701"/>
                  </a:lnTo>
                  <a:lnTo>
                    <a:pt x="554" y="143207"/>
                  </a:lnTo>
                  <a:lnTo>
                    <a:pt x="557" y="143713"/>
                  </a:lnTo>
                  <a:lnTo>
                    <a:pt x="559" y="144219"/>
                  </a:lnTo>
                  <a:lnTo>
                    <a:pt x="561" y="144725"/>
                  </a:lnTo>
                  <a:lnTo>
                    <a:pt x="564" y="145231"/>
                  </a:lnTo>
                  <a:lnTo>
                    <a:pt x="566" y="145738"/>
                  </a:lnTo>
                  <a:lnTo>
                    <a:pt x="568" y="146244"/>
                  </a:lnTo>
                  <a:lnTo>
                    <a:pt x="570" y="146750"/>
                  </a:lnTo>
                  <a:lnTo>
                    <a:pt x="572" y="147256"/>
                  </a:lnTo>
                  <a:lnTo>
                    <a:pt x="574" y="147762"/>
                  </a:lnTo>
                  <a:lnTo>
                    <a:pt x="576" y="148268"/>
                  </a:lnTo>
                  <a:lnTo>
                    <a:pt x="578" y="148774"/>
                  </a:lnTo>
                  <a:lnTo>
                    <a:pt x="580" y="149280"/>
                  </a:lnTo>
                  <a:lnTo>
                    <a:pt x="582" y="149786"/>
                  </a:lnTo>
                  <a:lnTo>
                    <a:pt x="584" y="150292"/>
                  </a:lnTo>
                  <a:lnTo>
                    <a:pt x="586" y="150798"/>
                  </a:lnTo>
                  <a:lnTo>
                    <a:pt x="587" y="151304"/>
                  </a:lnTo>
                  <a:lnTo>
                    <a:pt x="589" y="151810"/>
                  </a:lnTo>
                  <a:lnTo>
                    <a:pt x="590" y="152316"/>
                  </a:lnTo>
                  <a:lnTo>
                    <a:pt x="592" y="152822"/>
                  </a:lnTo>
                  <a:lnTo>
                    <a:pt x="593" y="153328"/>
                  </a:lnTo>
                  <a:lnTo>
                    <a:pt x="595" y="153834"/>
                  </a:lnTo>
                  <a:lnTo>
                    <a:pt x="596" y="154340"/>
                  </a:lnTo>
                  <a:lnTo>
                    <a:pt x="597" y="154846"/>
                  </a:lnTo>
                  <a:lnTo>
                    <a:pt x="598" y="155352"/>
                  </a:lnTo>
                  <a:lnTo>
                    <a:pt x="599" y="155858"/>
                  </a:lnTo>
                  <a:lnTo>
                    <a:pt x="600" y="156364"/>
                  </a:lnTo>
                  <a:lnTo>
                    <a:pt x="601" y="156870"/>
                  </a:lnTo>
                  <a:lnTo>
                    <a:pt x="601" y="157376"/>
                  </a:lnTo>
                  <a:lnTo>
                    <a:pt x="602" y="157882"/>
                  </a:lnTo>
                  <a:lnTo>
                    <a:pt x="603" y="158388"/>
                  </a:lnTo>
                  <a:lnTo>
                    <a:pt x="603" y="158894"/>
                  </a:lnTo>
                  <a:lnTo>
                    <a:pt x="603" y="159400"/>
                  </a:lnTo>
                  <a:lnTo>
                    <a:pt x="603" y="159907"/>
                  </a:lnTo>
                  <a:lnTo>
                    <a:pt x="604" y="160413"/>
                  </a:lnTo>
                  <a:lnTo>
                    <a:pt x="604" y="160919"/>
                  </a:lnTo>
                  <a:lnTo>
                    <a:pt x="603" y="161425"/>
                  </a:lnTo>
                  <a:lnTo>
                    <a:pt x="603" y="161931"/>
                  </a:lnTo>
                  <a:lnTo>
                    <a:pt x="603" y="162437"/>
                  </a:lnTo>
                  <a:lnTo>
                    <a:pt x="602" y="162943"/>
                  </a:lnTo>
                  <a:lnTo>
                    <a:pt x="602" y="163449"/>
                  </a:lnTo>
                  <a:lnTo>
                    <a:pt x="601" y="163955"/>
                  </a:lnTo>
                  <a:lnTo>
                    <a:pt x="600" y="164461"/>
                  </a:lnTo>
                  <a:lnTo>
                    <a:pt x="599" y="164967"/>
                  </a:lnTo>
                  <a:lnTo>
                    <a:pt x="598" y="165473"/>
                  </a:lnTo>
                  <a:lnTo>
                    <a:pt x="597" y="165979"/>
                  </a:lnTo>
                  <a:lnTo>
                    <a:pt x="596" y="166485"/>
                  </a:lnTo>
                  <a:lnTo>
                    <a:pt x="594" y="166991"/>
                  </a:lnTo>
                  <a:lnTo>
                    <a:pt x="593" y="167497"/>
                  </a:lnTo>
                  <a:lnTo>
                    <a:pt x="591" y="168003"/>
                  </a:lnTo>
                  <a:lnTo>
                    <a:pt x="589" y="168509"/>
                  </a:lnTo>
                  <a:lnTo>
                    <a:pt x="587" y="169015"/>
                  </a:lnTo>
                  <a:lnTo>
                    <a:pt x="585" y="169521"/>
                  </a:lnTo>
                  <a:lnTo>
                    <a:pt x="583" y="170027"/>
                  </a:lnTo>
                  <a:lnTo>
                    <a:pt x="580" y="170533"/>
                  </a:lnTo>
                  <a:lnTo>
                    <a:pt x="578" y="171039"/>
                  </a:lnTo>
                  <a:lnTo>
                    <a:pt x="575" y="171545"/>
                  </a:lnTo>
                  <a:lnTo>
                    <a:pt x="573" y="172051"/>
                  </a:lnTo>
                  <a:lnTo>
                    <a:pt x="570" y="172557"/>
                  </a:lnTo>
                  <a:lnTo>
                    <a:pt x="567" y="173063"/>
                  </a:lnTo>
                  <a:lnTo>
                    <a:pt x="564" y="173569"/>
                  </a:lnTo>
                  <a:lnTo>
                    <a:pt x="561" y="174075"/>
                  </a:lnTo>
                  <a:lnTo>
                    <a:pt x="557" y="174582"/>
                  </a:lnTo>
                  <a:lnTo>
                    <a:pt x="554" y="175088"/>
                  </a:lnTo>
                  <a:lnTo>
                    <a:pt x="550" y="175594"/>
                  </a:lnTo>
                  <a:lnTo>
                    <a:pt x="547" y="176100"/>
                  </a:lnTo>
                  <a:lnTo>
                    <a:pt x="543" y="176606"/>
                  </a:lnTo>
                  <a:lnTo>
                    <a:pt x="539" y="177112"/>
                  </a:lnTo>
                  <a:lnTo>
                    <a:pt x="535" y="177618"/>
                  </a:lnTo>
                  <a:lnTo>
                    <a:pt x="531" y="178124"/>
                  </a:lnTo>
                  <a:lnTo>
                    <a:pt x="527" y="178630"/>
                  </a:lnTo>
                  <a:lnTo>
                    <a:pt x="522" y="179136"/>
                  </a:lnTo>
                  <a:lnTo>
                    <a:pt x="518" y="179642"/>
                  </a:lnTo>
                  <a:lnTo>
                    <a:pt x="513" y="180148"/>
                  </a:lnTo>
                  <a:lnTo>
                    <a:pt x="509" y="180654"/>
                  </a:lnTo>
                  <a:lnTo>
                    <a:pt x="504" y="181160"/>
                  </a:lnTo>
                  <a:lnTo>
                    <a:pt x="499" y="181666"/>
                  </a:lnTo>
                  <a:lnTo>
                    <a:pt x="494" y="182172"/>
                  </a:lnTo>
                  <a:lnTo>
                    <a:pt x="489" y="182678"/>
                  </a:lnTo>
                  <a:lnTo>
                    <a:pt x="484" y="183184"/>
                  </a:lnTo>
                  <a:lnTo>
                    <a:pt x="479" y="183690"/>
                  </a:lnTo>
                  <a:lnTo>
                    <a:pt x="474" y="184196"/>
                  </a:lnTo>
                  <a:lnTo>
                    <a:pt x="469" y="184702"/>
                  </a:lnTo>
                  <a:lnTo>
                    <a:pt x="463" y="185208"/>
                  </a:lnTo>
                  <a:lnTo>
                    <a:pt x="458" y="185714"/>
                  </a:lnTo>
                  <a:lnTo>
                    <a:pt x="452" y="186220"/>
                  </a:lnTo>
                  <a:lnTo>
                    <a:pt x="447" y="186726"/>
                  </a:lnTo>
                  <a:lnTo>
                    <a:pt x="441" y="187232"/>
                  </a:lnTo>
                  <a:lnTo>
                    <a:pt x="436" y="187738"/>
                  </a:lnTo>
                  <a:lnTo>
                    <a:pt x="430" y="188244"/>
                  </a:lnTo>
                  <a:lnTo>
                    <a:pt x="424" y="188750"/>
                  </a:lnTo>
                  <a:lnTo>
                    <a:pt x="418" y="189257"/>
                  </a:lnTo>
                  <a:lnTo>
                    <a:pt x="412" y="189763"/>
                  </a:lnTo>
                  <a:lnTo>
                    <a:pt x="407" y="190269"/>
                  </a:lnTo>
                  <a:lnTo>
                    <a:pt x="401" y="190775"/>
                  </a:lnTo>
                  <a:lnTo>
                    <a:pt x="395" y="191281"/>
                  </a:lnTo>
                  <a:lnTo>
                    <a:pt x="389" y="191787"/>
                  </a:lnTo>
                  <a:lnTo>
                    <a:pt x="383" y="192293"/>
                  </a:lnTo>
                  <a:lnTo>
                    <a:pt x="377" y="192799"/>
                  </a:lnTo>
                  <a:lnTo>
                    <a:pt x="371" y="193305"/>
                  </a:lnTo>
                  <a:lnTo>
                    <a:pt x="365" y="193811"/>
                  </a:lnTo>
                  <a:lnTo>
                    <a:pt x="358" y="194317"/>
                  </a:lnTo>
                  <a:lnTo>
                    <a:pt x="352" y="194823"/>
                  </a:lnTo>
                  <a:lnTo>
                    <a:pt x="346" y="195329"/>
                  </a:lnTo>
                  <a:lnTo>
                    <a:pt x="340" y="195835"/>
                  </a:lnTo>
                  <a:lnTo>
                    <a:pt x="334" y="196341"/>
                  </a:lnTo>
                  <a:lnTo>
                    <a:pt x="328" y="196847"/>
                  </a:lnTo>
                  <a:lnTo>
                    <a:pt x="322" y="197353"/>
                  </a:lnTo>
                  <a:lnTo>
                    <a:pt x="316" y="197859"/>
                  </a:lnTo>
                  <a:lnTo>
                    <a:pt x="310" y="198365"/>
                  </a:lnTo>
                  <a:lnTo>
                    <a:pt x="304" y="198871"/>
                  </a:lnTo>
                  <a:lnTo>
                    <a:pt x="298" y="199377"/>
                  </a:lnTo>
                  <a:lnTo>
                    <a:pt x="292" y="199883"/>
                  </a:lnTo>
                  <a:lnTo>
                    <a:pt x="286" y="200389"/>
                  </a:lnTo>
                  <a:lnTo>
                    <a:pt x="280" y="200895"/>
                  </a:lnTo>
                  <a:lnTo>
                    <a:pt x="275" y="201401"/>
                  </a:lnTo>
                  <a:lnTo>
                    <a:pt x="269" y="201907"/>
                  </a:lnTo>
                  <a:lnTo>
                    <a:pt x="263" y="202413"/>
                  </a:lnTo>
                  <a:lnTo>
                    <a:pt x="257" y="202919"/>
                  </a:lnTo>
                  <a:lnTo>
                    <a:pt x="252" y="203426"/>
                  </a:lnTo>
                  <a:lnTo>
                    <a:pt x="246" y="203932"/>
                  </a:lnTo>
                  <a:lnTo>
                    <a:pt x="240" y="204438"/>
                  </a:lnTo>
                  <a:lnTo>
                    <a:pt x="235" y="204944"/>
                  </a:lnTo>
                  <a:lnTo>
                    <a:pt x="229" y="205450"/>
                  </a:lnTo>
                  <a:lnTo>
                    <a:pt x="224" y="205956"/>
                  </a:lnTo>
                  <a:lnTo>
                    <a:pt x="219" y="206462"/>
                  </a:lnTo>
                  <a:lnTo>
                    <a:pt x="213" y="206968"/>
                  </a:lnTo>
                  <a:lnTo>
                    <a:pt x="208" y="207474"/>
                  </a:lnTo>
                  <a:lnTo>
                    <a:pt x="203" y="207980"/>
                  </a:lnTo>
                  <a:lnTo>
                    <a:pt x="198" y="208486"/>
                  </a:lnTo>
                  <a:lnTo>
                    <a:pt x="193" y="208992"/>
                  </a:lnTo>
                  <a:lnTo>
                    <a:pt x="188" y="209498"/>
                  </a:lnTo>
                  <a:lnTo>
                    <a:pt x="183" y="210004"/>
                  </a:lnTo>
                  <a:lnTo>
                    <a:pt x="178" y="210510"/>
                  </a:lnTo>
                  <a:lnTo>
                    <a:pt x="173" y="211016"/>
                  </a:lnTo>
                  <a:lnTo>
                    <a:pt x="168" y="211522"/>
                  </a:lnTo>
                  <a:lnTo>
                    <a:pt x="164" y="212028"/>
                  </a:lnTo>
                  <a:lnTo>
                    <a:pt x="159" y="212534"/>
                  </a:lnTo>
                  <a:lnTo>
                    <a:pt x="155" y="213040"/>
                  </a:lnTo>
                  <a:lnTo>
                    <a:pt x="150" y="213546"/>
                  </a:lnTo>
                  <a:lnTo>
                    <a:pt x="146" y="214052"/>
                  </a:lnTo>
                  <a:lnTo>
                    <a:pt x="142" y="214558"/>
                  </a:lnTo>
                  <a:lnTo>
                    <a:pt x="138" y="215064"/>
                  </a:lnTo>
                  <a:lnTo>
                    <a:pt x="134" y="215570"/>
                  </a:lnTo>
                  <a:lnTo>
                    <a:pt x="130" y="216076"/>
                  </a:lnTo>
                  <a:lnTo>
                    <a:pt x="126" y="216582"/>
                  </a:lnTo>
                  <a:lnTo>
                    <a:pt x="122" y="217088"/>
                  </a:lnTo>
                  <a:lnTo>
                    <a:pt x="118" y="217594"/>
                  </a:lnTo>
                  <a:lnTo>
                    <a:pt x="114" y="218101"/>
                  </a:lnTo>
                  <a:lnTo>
                    <a:pt x="111" y="218607"/>
                  </a:lnTo>
                  <a:lnTo>
                    <a:pt x="107" y="219113"/>
                  </a:lnTo>
                  <a:lnTo>
                    <a:pt x="104" y="219619"/>
                  </a:lnTo>
                  <a:lnTo>
                    <a:pt x="100" y="220125"/>
                  </a:lnTo>
                  <a:lnTo>
                    <a:pt x="97" y="220631"/>
                  </a:lnTo>
                  <a:lnTo>
                    <a:pt x="94" y="221137"/>
                  </a:lnTo>
                  <a:lnTo>
                    <a:pt x="91" y="221643"/>
                  </a:lnTo>
                  <a:lnTo>
                    <a:pt x="88" y="222149"/>
                  </a:lnTo>
                  <a:lnTo>
                    <a:pt x="85" y="222655"/>
                  </a:lnTo>
                  <a:lnTo>
                    <a:pt x="82" y="223161"/>
                  </a:lnTo>
                  <a:lnTo>
                    <a:pt x="79" y="223667"/>
                  </a:lnTo>
                  <a:lnTo>
                    <a:pt x="76" y="224173"/>
                  </a:lnTo>
                  <a:lnTo>
                    <a:pt x="73" y="224679"/>
                  </a:lnTo>
                  <a:lnTo>
                    <a:pt x="71" y="225185"/>
                  </a:lnTo>
                  <a:lnTo>
                    <a:pt x="68" y="225691"/>
                  </a:lnTo>
                  <a:lnTo>
                    <a:pt x="66" y="226197"/>
                  </a:lnTo>
                  <a:lnTo>
                    <a:pt x="63" y="226703"/>
                  </a:lnTo>
                  <a:lnTo>
                    <a:pt x="61" y="227209"/>
                  </a:lnTo>
                  <a:lnTo>
                    <a:pt x="58" y="227715"/>
                  </a:lnTo>
                  <a:lnTo>
                    <a:pt x="56" y="228221"/>
                  </a:lnTo>
                  <a:lnTo>
                    <a:pt x="54" y="228727"/>
                  </a:lnTo>
                  <a:lnTo>
                    <a:pt x="52" y="229233"/>
                  </a:lnTo>
                  <a:lnTo>
                    <a:pt x="50" y="229739"/>
                  </a:lnTo>
                  <a:lnTo>
                    <a:pt x="48" y="230245"/>
                  </a:lnTo>
                  <a:lnTo>
                    <a:pt x="46" y="230751"/>
                  </a:lnTo>
                  <a:lnTo>
                    <a:pt x="44" y="231257"/>
                  </a:lnTo>
                  <a:lnTo>
                    <a:pt x="42" y="231763"/>
                  </a:lnTo>
                  <a:lnTo>
                    <a:pt x="41" y="232269"/>
                  </a:lnTo>
                  <a:lnTo>
                    <a:pt x="39" y="232776"/>
                  </a:lnTo>
                  <a:lnTo>
                    <a:pt x="37" y="233282"/>
                  </a:lnTo>
                  <a:lnTo>
                    <a:pt x="36" y="233788"/>
                  </a:lnTo>
                  <a:lnTo>
                    <a:pt x="34" y="234294"/>
                  </a:lnTo>
                  <a:lnTo>
                    <a:pt x="33" y="234800"/>
                  </a:lnTo>
                  <a:lnTo>
                    <a:pt x="31" y="235306"/>
                  </a:lnTo>
                  <a:lnTo>
                    <a:pt x="30" y="235812"/>
                  </a:lnTo>
                  <a:lnTo>
                    <a:pt x="29" y="236318"/>
                  </a:lnTo>
                  <a:lnTo>
                    <a:pt x="28" y="236824"/>
                  </a:lnTo>
                  <a:lnTo>
                    <a:pt x="26" y="237330"/>
                  </a:lnTo>
                  <a:lnTo>
                    <a:pt x="25" y="237836"/>
                  </a:lnTo>
                  <a:lnTo>
                    <a:pt x="24" y="238342"/>
                  </a:lnTo>
                  <a:lnTo>
                    <a:pt x="23" y="238848"/>
                  </a:lnTo>
                  <a:lnTo>
                    <a:pt x="22" y="239354"/>
                  </a:lnTo>
                  <a:lnTo>
                    <a:pt x="21" y="239860"/>
                  </a:lnTo>
                  <a:lnTo>
                    <a:pt x="20" y="240366"/>
                  </a:lnTo>
                  <a:lnTo>
                    <a:pt x="19" y="240872"/>
                  </a:lnTo>
                  <a:lnTo>
                    <a:pt x="18" y="241378"/>
                  </a:lnTo>
                  <a:lnTo>
                    <a:pt x="17" y="241884"/>
                  </a:lnTo>
                  <a:lnTo>
                    <a:pt x="16" y="242390"/>
                  </a:lnTo>
                  <a:lnTo>
                    <a:pt x="16" y="242896"/>
                  </a:lnTo>
                  <a:lnTo>
                    <a:pt x="15" y="243402"/>
                  </a:lnTo>
                  <a:lnTo>
                    <a:pt x="14" y="243908"/>
                  </a:lnTo>
                  <a:lnTo>
                    <a:pt x="13" y="244414"/>
                  </a:lnTo>
                  <a:lnTo>
                    <a:pt x="13" y="244920"/>
                  </a:lnTo>
                  <a:lnTo>
                    <a:pt x="12" y="245426"/>
                  </a:lnTo>
                  <a:lnTo>
                    <a:pt x="11" y="245932"/>
                  </a:lnTo>
                  <a:lnTo>
                    <a:pt x="11" y="246438"/>
                  </a:lnTo>
                  <a:lnTo>
                    <a:pt x="10" y="246945"/>
                  </a:lnTo>
                  <a:lnTo>
                    <a:pt x="10" y="247451"/>
                  </a:lnTo>
                  <a:lnTo>
                    <a:pt x="9" y="247957"/>
                  </a:lnTo>
                  <a:lnTo>
                    <a:pt x="9" y="248463"/>
                  </a:lnTo>
                  <a:lnTo>
                    <a:pt x="8" y="248969"/>
                  </a:lnTo>
                  <a:lnTo>
                    <a:pt x="8" y="249475"/>
                  </a:lnTo>
                  <a:lnTo>
                    <a:pt x="7" y="249981"/>
                  </a:lnTo>
                  <a:lnTo>
                    <a:pt x="7" y="250487"/>
                  </a:lnTo>
                  <a:lnTo>
                    <a:pt x="7" y="250993"/>
                  </a:lnTo>
                  <a:lnTo>
                    <a:pt x="6" y="251499"/>
                  </a:lnTo>
                  <a:lnTo>
                    <a:pt x="6" y="252005"/>
                  </a:lnTo>
                  <a:lnTo>
                    <a:pt x="5" y="252511"/>
                  </a:lnTo>
                  <a:lnTo>
                    <a:pt x="5" y="253017"/>
                  </a:lnTo>
                  <a:lnTo>
                    <a:pt x="5" y="253523"/>
                  </a:lnTo>
                  <a:lnTo>
                    <a:pt x="5" y="254029"/>
                  </a:lnTo>
                  <a:lnTo>
                    <a:pt x="4" y="254535"/>
                  </a:lnTo>
                  <a:lnTo>
                    <a:pt x="4" y="255041"/>
                  </a:lnTo>
                  <a:lnTo>
                    <a:pt x="4" y="255547"/>
                  </a:lnTo>
                  <a:lnTo>
                    <a:pt x="4" y="256053"/>
                  </a:lnTo>
                  <a:lnTo>
                    <a:pt x="3" y="256559"/>
                  </a:lnTo>
                  <a:lnTo>
                    <a:pt x="3" y="257065"/>
                  </a:lnTo>
                  <a:lnTo>
                    <a:pt x="3" y="257571"/>
                  </a:lnTo>
                  <a:lnTo>
                    <a:pt x="3" y="258077"/>
                  </a:lnTo>
                  <a:lnTo>
                    <a:pt x="3" y="258583"/>
                  </a:lnTo>
                  <a:lnTo>
                    <a:pt x="0" y="258583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64" name="pl46"/>
            <p:cNvSpPr/>
            <p:nvPr/>
          </p:nvSpPr>
          <p:spPr>
            <a:xfrm>
              <a:off x="6339264" y="3134127"/>
              <a:ext cx="336" cy="729025"/>
            </a:xfrm>
            <a:custGeom>
              <a:avLst/>
              <a:gdLst/>
              <a:ahLst/>
              <a:cxnLst/>
              <a:rect l="0" t="0" r="0" b="0"/>
              <a:pathLst>
                <a:path w="336" h="729025">
                  <a:moveTo>
                    <a:pt x="336" y="729025"/>
                  </a:moveTo>
                  <a:lnTo>
                    <a:pt x="334" y="729025"/>
                  </a:lnTo>
                  <a:lnTo>
                    <a:pt x="334" y="727598"/>
                  </a:lnTo>
                  <a:lnTo>
                    <a:pt x="334" y="726172"/>
                  </a:lnTo>
                  <a:lnTo>
                    <a:pt x="333" y="724745"/>
                  </a:lnTo>
                  <a:lnTo>
                    <a:pt x="333" y="723318"/>
                  </a:lnTo>
                  <a:lnTo>
                    <a:pt x="333" y="721892"/>
                  </a:lnTo>
                  <a:lnTo>
                    <a:pt x="332" y="720465"/>
                  </a:lnTo>
                  <a:lnTo>
                    <a:pt x="332" y="719038"/>
                  </a:lnTo>
                  <a:lnTo>
                    <a:pt x="331" y="717612"/>
                  </a:lnTo>
                  <a:lnTo>
                    <a:pt x="331" y="716185"/>
                  </a:lnTo>
                  <a:lnTo>
                    <a:pt x="331" y="714758"/>
                  </a:lnTo>
                  <a:lnTo>
                    <a:pt x="330" y="713332"/>
                  </a:lnTo>
                  <a:lnTo>
                    <a:pt x="329" y="711905"/>
                  </a:lnTo>
                  <a:lnTo>
                    <a:pt x="329" y="710478"/>
                  </a:lnTo>
                  <a:lnTo>
                    <a:pt x="328" y="709052"/>
                  </a:lnTo>
                  <a:lnTo>
                    <a:pt x="327" y="707625"/>
                  </a:lnTo>
                  <a:lnTo>
                    <a:pt x="326" y="706198"/>
                  </a:lnTo>
                  <a:lnTo>
                    <a:pt x="325" y="704772"/>
                  </a:lnTo>
                  <a:lnTo>
                    <a:pt x="324" y="703345"/>
                  </a:lnTo>
                  <a:lnTo>
                    <a:pt x="323" y="701918"/>
                  </a:lnTo>
                  <a:lnTo>
                    <a:pt x="322" y="700492"/>
                  </a:lnTo>
                  <a:lnTo>
                    <a:pt x="321" y="699065"/>
                  </a:lnTo>
                  <a:lnTo>
                    <a:pt x="320" y="697638"/>
                  </a:lnTo>
                  <a:lnTo>
                    <a:pt x="318" y="696212"/>
                  </a:lnTo>
                  <a:lnTo>
                    <a:pt x="317" y="694785"/>
                  </a:lnTo>
                  <a:lnTo>
                    <a:pt x="315" y="693358"/>
                  </a:lnTo>
                  <a:lnTo>
                    <a:pt x="314" y="691932"/>
                  </a:lnTo>
                  <a:lnTo>
                    <a:pt x="312" y="690505"/>
                  </a:lnTo>
                  <a:lnTo>
                    <a:pt x="310" y="689078"/>
                  </a:lnTo>
                  <a:lnTo>
                    <a:pt x="308" y="687652"/>
                  </a:lnTo>
                  <a:lnTo>
                    <a:pt x="306" y="686225"/>
                  </a:lnTo>
                  <a:lnTo>
                    <a:pt x="304" y="684798"/>
                  </a:lnTo>
                  <a:lnTo>
                    <a:pt x="302" y="683372"/>
                  </a:lnTo>
                  <a:lnTo>
                    <a:pt x="299" y="681945"/>
                  </a:lnTo>
                  <a:lnTo>
                    <a:pt x="297" y="680518"/>
                  </a:lnTo>
                  <a:lnTo>
                    <a:pt x="294" y="679092"/>
                  </a:lnTo>
                  <a:lnTo>
                    <a:pt x="291" y="677665"/>
                  </a:lnTo>
                  <a:lnTo>
                    <a:pt x="289" y="676238"/>
                  </a:lnTo>
                  <a:lnTo>
                    <a:pt x="286" y="674812"/>
                  </a:lnTo>
                  <a:lnTo>
                    <a:pt x="283" y="673385"/>
                  </a:lnTo>
                  <a:lnTo>
                    <a:pt x="280" y="671958"/>
                  </a:lnTo>
                  <a:lnTo>
                    <a:pt x="277" y="670532"/>
                  </a:lnTo>
                  <a:lnTo>
                    <a:pt x="273" y="669105"/>
                  </a:lnTo>
                  <a:lnTo>
                    <a:pt x="270" y="667678"/>
                  </a:lnTo>
                  <a:lnTo>
                    <a:pt x="266" y="666252"/>
                  </a:lnTo>
                  <a:lnTo>
                    <a:pt x="263" y="664825"/>
                  </a:lnTo>
                  <a:lnTo>
                    <a:pt x="259" y="663398"/>
                  </a:lnTo>
                  <a:lnTo>
                    <a:pt x="256" y="661972"/>
                  </a:lnTo>
                  <a:lnTo>
                    <a:pt x="252" y="660545"/>
                  </a:lnTo>
                  <a:lnTo>
                    <a:pt x="249" y="659118"/>
                  </a:lnTo>
                  <a:lnTo>
                    <a:pt x="245" y="657692"/>
                  </a:lnTo>
                  <a:lnTo>
                    <a:pt x="241" y="656265"/>
                  </a:lnTo>
                  <a:lnTo>
                    <a:pt x="237" y="654839"/>
                  </a:lnTo>
                  <a:lnTo>
                    <a:pt x="234" y="653412"/>
                  </a:lnTo>
                  <a:lnTo>
                    <a:pt x="230" y="651985"/>
                  </a:lnTo>
                  <a:lnTo>
                    <a:pt x="226" y="650559"/>
                  </a:lnTo>
                  <a:lnTo>
                    <a:pt x="223" y="649132"/>
                  </a:lnTo>
                  <a:lnTo>
                    <a:pt x="219" y="647705"/>
                  </a:lnTo>
                  <a:lnTo>
                    <a:pt x="216" y="646279"/>
                  </a:lnTo>
                  <a:lnTo>
                    <a:pt x="212" y="644852"/>
                  </a:lnTo>
                  <a:lnTo>
                    <a:pt x="209" y="643425"/>
                  </a:lnTo>
                  <a:lnTo>
                    <a:pt x="206" y="641999"/>
                  </a:lnTo>
                  <a:lnTo>
                    <a:pt x="203" y="640572"/>
                  </a:lnTo>
                  <a:lnTo>
                    <a:pt x="200" y="639145"/>
                  </a:lnTo>
                  <a:lnTo>
                    <a:pt x="197" y="637719"/>
                  </a:lnTo>
                  <a:lnTo>
                    <a:pt x="194" y="636292"/>
                  </a:lnTo>
                  <a:lnTo>
                    <a:pt x="192" y="634865"/>
                  </a:lnTo>
                  <a:lnTo>
                    <a:pt x="189" y="633439"/>
                  </a:lnTo>
                  <a:lnTo>
                    <a:pt x="187" y="632012"/>
                  </a:lnTo>
                  <a:lnTo>
                    <a:pt x="185" y="630585"/>
                  </a:lnTo>
                  <a:lnTo>
                    <a:pt x="183" y="629159"/>
                  </a:lnTo>
                  <a:lnTo>
                    <a:pt x="181" y="627732"/>
                  </a:lnTo>
                  <a:lnTo>
                    <a:pt x="180" y="626305"/>
                  </a:lnTo>
                  <a:lnTo>
                    <a:pt x="179" y="624879"/>
                  </a:lnTo>
                  <a:lnTo>
                    <a:pt x="178" y="623452"/>
                  </a:lnTo>
                  <a:lnTo>
                    <a:pt x="177" y="622025"/>
                  </a:lnTo>
                  <a:lnTo>
                    <a:pt x="176" y="620599"/>
                  </a:lnTo>
                  <a:lnTo>
                    <a:pt x="176" y="619172"/>
                  </a:lnTo>
                  <a:lnTo>
                    <a:pt x="175" y="617745"/>
                  </a:lnTo>
                  <a:lnTo>
                    <a:pt x="175" y="616319"/>
                  </a:lnTo>
                  <a:lnTo>
                    <a:pt x="175" y="614892"/>
                  </a:lnTo>
                  <a:lnTo>
                    <a:pt x="175" y="613465"/>
                  </a:lnTo>
                  <a:lnTo>
                    <a:pt x="176" y="612039"/>
                  </a:lnTo>
                  <a:lnTo>
                    <a:pt x="176" y="610612"/>
                  </a:lnTo>
                  <a:lnTo>
                    <a:pt x="177" y="609185"/>
                  </a:lnTo>
                  <a:lnTo>
                    <a:pt x="178" y="607759"/>
                  </a:lnTo>
                  <a:lnTo>
                    <a:pt x="179" y="606332"/>
                  </a:lnTo>
                  <a:lnTo>
                    <a:pt x="180" y="604905"/>
                  </a:lnTo>
                  <a:lnTo>
                    <a:pt x="181" y="603479"/>
                  </a:lnTo>
                  <a:lnTo>
                    <a:pt x="182" y="602052"/>
                  </a:lnTo>
                  <a:lnTo>
                    <a:pt x="183" y="600625"/>
                  </a:lnTo>
                  <a:lnTo>
                    <a:pt x="185" y="599199"/>
                  </a:lnTo>
                  <a:lnTo>
                    <a:pt x="186" y="597772"/>
                  </a:lnTo>
                  <a:lnTo>
                    <a:pt x="187" y="596345"/>
                  </a:lnTo>
                  <a:lnTo>
                    <a:pt x="189" y="594919"/>
                  </a:lnTo>
                  <a:lnTo>
                    <a:pt x="190" y="593492"/>
                  </a:lnTo>
                  <a:lnTo>
                    <a:pt x="191" y="592065"/>
                  </a:lnTo>
                  <a:lnTo>
                    <a:pt x="193" y="590639"/>
                  </a:lnTo>
                  <a:lnTo>
                    <a:pt x="194" y="589212"/>
                  </a:lnTo>
                  <a:lnTo>
                    <a:pt x="195" y="587785"/>
                  </a:lnTo>
                  <a:lnTo>
                    <a:pt x="196" y="586359"/>
                  </a:lnTo>
                  <a:lnTo>
                    <a:pt x="197" y="584932"/>
                  </a:lnTo>
                  <a:lnTo>
                    <a:pt x="198" y="583505"/>
                  </a:lnTo>
                  <a:lnTo>
                    <a:pt x="199" y="582079"/>
                  </a:lnTo>
                  <a:lnTo>
                    <a:pt x="200" y="580652"/>
                  </a:lnTo>
                  <a:lnTo>
                    <a:pt x="200" y="579225"/>
                  </a:lnTo>
                  <a:lnTo>
                    <a:pt x="200" y="577799"/>
                  </a:lnTo>
                  <a:lnTo>
                    <a:pt x="201" y="576372"/>
                  </a:lnTo>
                  <a:lnTo>
                    <a:pt x="201" y="574945"/>
                  </a:lnTo>
                  <a:lnTo>
                    <a:pt x="201" y="573519"/>
                  </a:lnTo>
                  <a:lnTo>
                    <a:pt x="200" y="572092"/>
                  </a:lnTo>
                  <a:lnTo>
                    <a:pt x="200" y="570665"/>
                  </a:lnTo>
                  <a:lnTo>
                    <a:pt x="199" y="569239"/>
                  </a:lnTo>
                  <a:lnTo>
                    <a:pt x="198" y="567812"/>
                  </a:lnTo>
                  <a:lnTo>
                    <a:pt x="197" y="566385"/>
                  </a:lnTo>
                  <a:lnTo>
                    <a:pt x="196" y="564959"/>
                  </a:lnTo>
                  <a:lnTo>
                    <a:pt x="195" y="563532"/>
                  </a:lnTo>
                  <a:lnTo>
                    <a:pt x="194" y="562105"/>
                  </a:lnTo>
                  <a:lnTo>
                    <a:pt x="192" y="560679"/>
                  </a:lnTo>
                  <a:lnTo>
                    <a:pt x="190" y="559252"/>
                  </a:lnTo>
                  <a:lnTo>
                    <a:pt x="188" y="557825"/>
                  </a:lnTo>
                  <a:lnTo>
                    <a:pt x="186" y="556399"/>
                  </a:lnTo>
                  <a:lnTo>
                    <a:pt x="184" y="554972"/>
                  </a:lnTo>
                  <a:lnTo>
                    <a:pt x="182" y="553545"/>
                  </a:lnTo>
                  <a:lnTo>
                    <a:pt x="179" y="552119"/>
                  </a:lnTo>
                  <a:lnTo>
                    <a:pt x="177" y="550692"/>
                  </a:lnTo>
                  <a:lnTo>
                    <a:pt x="174" y="549265"/>
                  </a:lnTo>
                  <a:lnTo>
                    <a:pt x="171" y="547839"/>
                  </a:lnTo>
                  <a:lnTo>
                    <a:pt x="169" y="546412"/>
                  </a:lnTo>
                  <a:lnTo>
                    <a:pt x="166" y="544985"/>
                  </a:lnTo>
                  <a:lnTo>
                    <a:pt x="163" y="543559"/>
                  </a:lnTo>
                  <a:lnTo>
                    <a:pt x="160" y="542132"/>
                  </a:lnTo>
                  <a:lnTo>
                    <a:pt x="157" y="540705"/>
                  </a:lnTo>
                  <a:lnTo>
                    <a:pt x="154" y="539279"/>
                  </a:lnTo>
                  <a:lnTo>
                    <a:pt x="150" y="537852"/>
                  </a:lnTo>
                  <a:lnTo>
                    <a:pt x="147" y="536425"/>
                  </a:lnTo>
                  <a:lnTo>
                    <a:pt x="144" y="534999"/>
                  </a:lnTo>
                  <a:lnTo>
                    <a:pt x="141" y="533572"/>
                  </a:lnTo>
                  <a:lnTo>
                    <a:pt x="138" y="532145"/>
                  </a:lnTo>
                  <a:lnTo>
                    <a:pt x="134" y="530719"/>
                  </a:lnTo>
                  <a:lnTo>
                    <a:pt x="131" y="529292"/>
                  </a:lnTo>
                  <a:lnTo>
                    <a:pt x="128" y="527865"/>
                  </a:lnTo>
                  <a:lnTo>
                    <a:pt x="124" y="526439"/>
                  </a:lnTo>
                  <a:lnTo>
                    <a:pt x="121" y="525012"/>
                  </a:lnTo>
                  <a:lnTo>
                    <a:pt x="118" y="523585"/>
                  </a:lnTo>
                  <a:lnTo>
                    <a:pt x="115" y="522159"/>
                  </a:lnTo>
                  <a:lnTo>
                    <a:pt x="111" y="520732"/>
                  </a:lnTo>
                  <a:lnTo>
                    <a:pt x="108" y="519305"/>
                  </a:lnTo>
                  <a:lnTo>
                    <a:pt x="105" y="517879"/>
                  </a:lnTo>
                  <a:lnTo>
                    <a:pt x="101" y="516452"/>
                  </a:lnTo>
                  <a:lnTo>
                    <a:pt x="98" y="515025"/>
                  </a:lnTo>
                  <a:lnTo>
                    <a:pt x="94" y="513599"/>
                  </a:lnTo>
                  <a:lnTo>
                    <a:pt x="91" y="512172"/>
                  </a:lnTo>
                  <a:lnTo>
                    <a:pt x="88" y="510745"/>
                  </a:lnTo>
                  <a:lnTo>
                    <a:pt x="84" y="509319"/>
                  </a:lnTo>
                  <a:lnTo>
                    <a:pt x="81" y="507892"/>
                  </a:lnTo>
                  <a:lnTo>
                    <a:pt x="77" y="506465"/>
                  </a:lnTo>
                  <a:lnTo>
                    <a:pt x="74" y="505039"/>
                  </a:lnTo>
                  <a:lnTo>
                    <a:pt x="70" y="503612"/>
                  </a:lnTo>
                  <a:lnTo>
                    <a:pt x="67" y="502185"/>
                  </a:lnTo>
                  <a:lnTo>
                    <a:pt x="63" y="500759"/>
                  </a:lnTo>
                  <a:lnTo>
                    <a:pt x="60" y="499332"/>
                  </a:lnTo>
                  <a:lnTo>
                    <a:pt x="56" y="497905"/>
                  </a:lnTo>
                  <a:lnTo>
                    <a:pt x="52" y="496479"/>
                  </a:lnTo>
                  <a:lnTo>
                    <a:pt x="49" y="495052"/>
                  </a:lnTo>
                  <a:lnTo>
                    <a:pt x="45" y="493625"/>
                  </a:lnTo>
                  <a:lnTo>
                    <a:pt x="42" y="492199"/>
                  </a:lnTo>
                  <a:lnTo>
                    <a:pt x="38" y="490772"/>
                  </a:lnTo>
                  <a:lnTo>
                    <a:pt x="35" y="489345"/>
                  </a:lnTo>
                  <a:lnTo>
                    <a:pt x="32" y="487919"/>
                  </a:lnTo>
                  <a:lnTo>
                    <a:pt x="28" y="486492"/>
                  </a:lnTo>
                  <a:lnTo>
                    <a:pt x="25" y="485065"/>
                  </a:lnTo>
                  <a:lnTo>
                    <a:pt x="22" y="483639"/>
                  </a:lnTo>
                  <a:lnTo>
                    <a:pt x="19" y="482212"/>
                  </a:lnTo>
                  <a:lnTo>
                    <a:pt x="16" y="480785"/>
                  </a:lnTo>
                  <a:lnTo>
                    <a:pt x="14" y="479359"/>
                  </a:lnTo>
                  <a:lnTo>
                    <a:pt x="11" y="477932"/>
                  </a:lnTo>
                  <a:lnTo>
                    <a:pt x="9" y="476505"/>
                  </a:lnTo>
                  <a:lnTo>
                    <a:pt x="7" y="475079"/>
                  </a:lnTo>
                  <a:lnTo>
                    <a:pt x="5" y="473652"/>
                  </a:lnTo>
                  <a:lnTo>
                    <a:pt x="4" y="472225"/>
                  </a:lnTo>
                  <a:lnTo>
                    <a:pt x="2" y="470799"/>
                  </a:lnTo>
                  <a:lnTo>
                    <a:pt x="1" y="469372"/>
                  </a:lnTo>
                  <a:lnTo>
                    <a:pt x="0" y="467945"/>
                  </a:lnTo>
                  <a:lnTo>
                    <a:pt x="0" y="466519"/>
                  </a:lnTo>
                  <a:lnTo>
                    <a:pt x="0" y="465092"/>
                  </a:lnTo>
                  <a:lnTo>
                    <a:pt x="0" y="463665"/>
                  </a:lnTo>
                  <a:lnTo>
                    <a:pt x="0" y="462239"/>
                  </a:lnTo>
                  <a:lnTo>
                    <a:pt x="1" y="460812"/>
                  </a:lnTo>
                  <a:lnTo>
                    <a:pt x="2" y="459385"/>
                  </a:lnTo>
                  <a:lnTo>
                    <a:pt x="3" y="457959"/>
                  </a:lnTo>
                  <a:lnTo>
                    <a:pt x="5" y="456532"/>
                  </a:lnTo>
                  <a:lnTo>
                    <a:pt x="7" y="455105"/>
                  </a:lnTo>
                  <a:lnTo>
                    <a:pt x="10" y="453679"/>
                  </a:lnTo>
                  <a:lnTo>
                    <a:pt x="13" y="452252"/>
                  </a:lnTo>
                  <a:lnTo>
                    <a:pt x="16" y="450825"/>
                  </a:lnTo>
                  <a:lnTo>
                    <a:pt x="20" y="449399"/>
                  </a:lnTo>
                  <a:lnTo>
                    <a:pt x="24" y="447972"/>
                  </a:lnTo>
                  <a:lnTo>
                    <a:pt x="28" y="446545"/>
                  </a:lnTo>
                  <a:lnTo>
                    <a:pt x="33" y="445119"/>
                  </a:lnTo>
                  <a:lnTo>
                    <a:pt x="38" y="443692"/>
                  </a:lnTo>
                  <a:lnTo>
                    <a:pt x="43" y="442265"/>
                  </a:lnTo>
                  <a:lnTo>
                    <a:pt x="48" y="440839"/>
                  </a:lnTo>
                  <a:lnTo>
                    <a:pt x="54" y="439412"/>
                  </a:lnTo>
                  <a:lnTo>
                    <a:pt x="60" y="437985"/>
                  </a:lnTo>
                  <a:lnTo>
                    <a:pt x="66" y="436559"/>
                  </a:lnTo>
                  <a:lnTo>
                    <a:pt x="73" y="435132"/>
                  </a:lnTo>
                  <a:lnTo>
                    <a:pt x="79" y="433706"/>
                  </a:lnTo>
                  <a:lnTo>
                    <a:pt x="86" y="432279"/>
                  </a:lnTo>
                  <a:lnTo>
                    <a:pt x="93" y="430852"/>
                  </a:lnTo>
                  <a:lnTo>
                    <a:pt x="100" y="429426"/>
                  </a:lnTo>
                  <a:lnTo>
                    <a:pt x="108" y="427999"/>
                  </a:lnTo>
                  <a:lnTo>
                    <a:pt x="115" y="426572"/>
                  </a:lnTo>
                  <a:lnTo>
                    <a:pt x="122" y="425146"/>
                  </a:lnTo>
                  <a:lnTo>
                    <a:pt x="130" y="423719"/>
                  </a:lnTo>
                  <a:lnTo>
                    <a:pt x="137" y="422292"/>
                  </a:lnTo>
                  <a:lnTo>
                    <a:pt x="145" y="420866"/>
                  </a:lnTo>
                  <a:lnTo>
                    <a:pt x="152" y="419439"/>
                  </a:lnTo>
                  <a:lnTo>
                    <a:pt x="159" y="418012"/>
                  </a:lnTo>
                  <a:lnTo>
                    <a:pt x="167" y="416586"/>
                  </a:lnTo>
                  <a:lnTo>
                    <a:pt x="174" y="415159"/>
                  </a:lnTo>
                  <a:lnTo>
                    <a:pt x="181" y="413732"/>
                  </a:lnTo>
                  <a:lnTo>
                    <a:pt x="188" y="412306"/>
                  </a:lnTo>
                  <a:lnTo>
                    <a:pt x="195" y="410879"/>
                  </a:lnTo>
                  <a:lnTo>
                    <a:pt x="202" y="409452"/>
                  </a:lnTo>
                  <a:lnTo>
                    <a:pt x="209" y="408026"/>
                  </a:lnTo>
                  <a:lnTo>
                    <a:pt x="215" y="406599"/>
                  </a:lnTo>
                  <a:lnTo>
                    <a:pt x="222" y="405172"/>
                  </a:lnTo>
                  <a:lnTo>
                    <a:pt x="228" y="403746"/>
                  </a:lnTo>
                  <a:lnTo>
                    <a:pt x="234" y="402319"/>
                  </a:lnTo>
                  <a:lnTo>
                    <a:pt x="240" y="400892"/>
                  </a:lnTo>
                  <a:lnTo>
                    <a:pt x="245" y="399466"/>
                  </a:lnTo>
                  <a:lnTo>
                    <a:pt x="251" y="398039"/>
                  </a:lnTo>
                  <a:lnTo>
                    <a:pt x="256" y="396612"/>
                  </a:lnTo>
                  <a:lnTo>
                    <a:pt x="261" y="395186"/>
                  </a:lnTo>
                  <a:lnTo>
                    <a:pt x="266" y="393759"/>
                  </a:lnTo>
                  <a:lnTo>
                    <a:pt x="270" y="392332"/>
                  </a:lnTo>
                  <a:lnTo>
                    <a:pt x="275" y="390906"/>
                  </a:lnTo>
                  <a:lnTo>
                    <a:pt x="279" y="389479"/>
                  </a:lnTo>
                  <a:lnTo>
                    <a:pt x="283" y="388052"/>
                  </a:lnTo>
                  <a:lnTo>
                    <a:pt x="287" y="386626"/>
                  </a:lnTo>
                  <a:lnTo>
                    <a:pt x="290" y="385199"/>
                  </a:lnTo>
                  <a:lnTo>
                    <a:pt x="293" y="383772"/>
                  </a:lnTo>
                  <a:lnTo>
                    <a:pt x="297" y="382346"/>
                  </a:lnTo>
                  <a:lnTo>
                    <a:pt x="300" y="380919"/>
                  </a:lnTo>
                  <a:lnTo>
                    <a:pt x="302" y="379492"/>
                  </a:lnTo>
                  <a:lnTo>
                    <a:pt x="305" y="378066"/>
                  </a:lnTo>
                  <a:lnTo>
                    <a:pt x="308" y="376639"/>
                  </a:lnTo>
                  <a:lnTo>
                    <a:pt x="310" y="375212"/>
                  </a:lnTo>
                  <a:lnTo>
                    <a:pt x="312" y="373786"/>
                  </a:lnTo>
                  <a:lnTo>
                    <a:pt x="314" y="372359"/>
                  </a:lnTo>
                  <a:lnTo>
                    <a:pt x="316" y="370932"/>
                  </a:lnTo>
                  <a:lnTo>
                    <a:pt x="318" y="369506"/>
                  </a:lnTo>
                  <a:lnTo>
                    <a:pt x="319" y="368079"/>
                  </a:lnTo>
                  <a:lnTo>
                    <a:pt x="321" y="366652"/>
                  </a:lnTo>
                  <a:lnTo>
                    <a:pt x="322" y="365226"/>
                  </a:lnTo>
                  <a:lnTo>
                    <a:pt x="323" y="363799"/>
                  </a:lnTo>
                  <a:lnTo>
                    <a:pt x="325" y="362372"/>
                  </a:lnTo>
                  <a:lnTo>
                    <a:pt x="326" y="360946"/>
                  </a:lnTo>
                  <a:lnTo>
                    <a:pt x="327" y="359519"/>
                  </a:lnTo>
                  <a:lnTo>
                    <a:pt x="327" y="358092"/>
                  </a:lnTo>
                  <a:lnTo>
                    <a:pt x="328" y="356666"/>
                  </a:lnTo>
                  <a:lnTo>
                    <a:pt x="329" y="355239"/>
                  </a:lnTo>
                  <a:lnTo>
                    <a:pt x="330" y="353812"/>
                  </a:lnTo>
                  <a:lnTo>
                    <a:pt x="330" y="352386"/>
                  </a:lnTo>
                  <a:lnTo>
                    <a:pt x="331" y="350959"/>
                  </a:lnTo>
                  <a:lnTo>
                    <a:pt x="331" y="349532"/>
                  </a:lnTo>
                  <a:lnTo>
                    <a:pt x="332" y="348106"/>
                  </a:lnTo>
                  <a:lnTo>
                    <a:pt x="332" y="346679"/>
                  </a:lnTo>
                  <a:lnTo>
                    <a:pt x="333" y="345252"/>
                  </a:lnTo>
                  <a:lnTo>
                    <a:pt x="333" y="343826"/>
                  </a:lnTo>
                  <a:lnTo>
                    <a:pt x="333" y="342399"/>
                  </a:lnTo>
                  <a:lnTo>
                    <a:pt x="334" y="340972"/>
                  </a:lnTo>
                  <a:lnTo>
                    <a:pt x="334" y="339546"/>
                  </a:lnTo>
                  <a:lnTo>
                    <a:pt x="334" y="338119"/>
                  </a:lnTo>
                  <a:lnTo>
                    <a:pt x="334" y="336692"/>
                  </a:lnTo>
                  <a:lnTo>
                    <a:pt x="334" y="335266"/>
                  </a:lnTo>
                  <a:lnTo>
                    <a:pt x="335" y="333839"/>
                  </a:lnTo>
                  <a:lnTo>
                    <a:pt x="335" y="332412"/>
                  </a:lnTo>
                  <a:lnTo>
                    <a:pt x="335" y="330986"/>
                  </a:lnTo>
                  <a:lnTo>
                    <a:pt x="335" y="329559"/>
                  </a:lnTo>
                  <a:lnTo>
                    <a:pt x="335" y="328132"/>
                  </a:lnTo>
                  <a:lnTo>
                    <a:pt x="335" y="326706"/>
                  </a:lnTo>
                  <a:lnTo>
                    <a:pt x="335" y="325279"/>
                  </a:lnTo>
                  <a:lnTo>
                    <a:pt x="335" y="323852"/>
                  </a:lnTo>
                  <a:lnTo>
                    <a:pt x="335" y="322426"/>
                  </a:lnTo>
                  <a:lnTo>
                    <a:pt x="335" y="320999"/>
                  </a:lnTo>
                  <a:lnTo>
                    <a:pt x="335" y="319572"/>
                  </a:lnTo>
                  <a:lnTo>
                    <a:pt x="335" y="318146"/>
                  </a:lnTo>
                  <a:lnTo>
                    <a:pt x="336" y="316719"/>
                  </a:lnTo>
                  <a:lnTo>
                    <a:pt x="336" y="315292"/>
                  </a:lnTo>
                  <a:lnTo>
                    <a:pt x="336" y="313866"/>
                  </a:lnTo>
                  <a:lnTo>
                    <a:pt x="336" y="312439"/>
                  </a:lnTo>
                  <a:lnTo>
                    <a:pt x="336" y="311012"/>
                  </a:lnTo>
                  <a:lnTo>
                    <a:pt x="336" y="309586"/>
                  </a:lnTo>
                  <a:lnTo>
                    <a:pt x="336" y="308159"/>
                  </a:lnTo>
                  <a:lnTo>
                    <a:pt x="336" y="306732"/>
                  </a:lnTo>
                  <a:lnTo>
                    <a:pt x="336" y="305306"/>
                  </a:lnTo>
                  <a:lnTo>
                    <a:pt x="336" y="303879"/>
                  </a:lnTo>
                  <a:lnTo>
                    <a:pt x="336" y="302452"/>
                  </a:lnTo>
                  <a:lnTo>
                    <a:pt x="336" y="301026"/>
                  </a:lnTo>
                  <a:lnTo>
                    <a:pt x="336" y="299599"/>
                  </a:lnTo>
                  <a:lnTo>
                    <a:pt x="336" y="298172"/>
                  </a:lnTo>
                  <a:lnTo>
                    <a:pt x="336" y="296746"/>
                  </a:lnTo>
                  <a:lnTo>
                    <a:pt x="336" y="295319"/>
                  </a:lnTo>
                  <a:lnTo>
                    <a:pt x="336" y="293892"/>
                  </a:lnTo>
                  <a:lnTo>
                    <a:pt x="336" y="292466"/>
                  </a:lnTo>
                  <a:lnTo>
                    <a:pt x="336" y="291039"/>
                  </a:lnTo>
                  <a:lnTo>
                    <a:pt x="336" y="289612"/>
                  </a:lnTo>
                  <a:lnTo>
                    <a:pt x="336" y="288186"/>
                  </a:lnTo>
                  <a:lnTo>
                    <a:pt x="336" y="286759"/>
                  </a:lnTo>
                  <a:lnTo>
                    <a:pt x="336" y="285332"/>
                  </a:lnTo>
                  <a:lnTo>
                    <a:pt x="336" y="283906"/>
                  </a:lnTo>
                  <a:lnTo>
                    <a:pt x="336" y="282479"/>
                  </a:lnTo>
                  <a:lnTo>
                    <a:pt x="336" y="281052"/>
                  </a:lnTo>
                  <a:lnTo>
                    <a:pt x="336" y="279626"/>
                  </a:lnTo>
                  <a:lnTo>
                    <a:pt x="336" y="278199"/>
                  </a:lnTo>
                  <a:lnTo>
                    <a:pt x="336" y="276772"/>
                  </a:lnTo>
                  <a:lnTo>
                    <a:pt x="336" y="275346"/>
                  </a:lnTo>
                  <a:lnTo>
                    <a:pt x="336" y="273919"/>
                  </a:lnTo>
                  <a:lnTo>
                    <a:pt x="336" y="272492"/>
                  </a:lnTo>
                  <a:lnTo>
                    <a:pt x="336" y="271066"/>
                  </a:lnTo>
                  <a:lnTo>
                    <a:pt x="336" y="269639"/>
                  </a:lnTo>
                  <a:lnTo>
                    <a:pt x="336" y="268212"/>
                  </a:lnTo>
                  <a:lnTo>
                    <a:pt x="336" y="266786"/>
                  </a:lnTo>
                  <a:lnTo>
                    <a:pt x="336" y="265359"/>
                  </a:lnTo>
                  <a:lnTo>
                    <a:pt x="336" y="263932"/>
                  </a:lnTo>
                  <a:lnTo>
                    <a:pt x="336" y="262506"/>
                  </a:lnTo>
                  <a:lnTo>
                    <a:pt x="336" y="261079"/>
                  </a:lnTo>
                  <a:lnTo>
                    <a:pt x="336" y="259652"/>
                  </a:lnTo>
                  <a:lnTo>
                    <a:pt x="336" y="258226"/>
                  </a:lnTo>
                  <a:lnTo>
                    <a:pt x="336" y="256799"/>
                  </a:lnTo>
                  <a:lnTo>
                    <a:pt x="336" y="255372"/>
                  </a:lnTo>
                  <a:lnTo>
                    <a:pt x="336" y="253946"/>
                  </a:lnTo>
                  <a:lnTo>
                    <a:pt x="336" y="252519"/>
                  </a:lnTo>
                  <a:lnTo>
                    <a:pt x="336" y="251092"/>
                  </a:lnTo>
                  <a:lnTo>
                    <a:pt x="336" y="249666"/>
                  </a:lnTo>
                  <a:lnTo>
                    <a:pt x="336" y="248239"/>
                  </a:lnTo>
                  <a:lnTo>
                    <a:pt x="336" y="246812"/>
                  </a:lnTo>
                  <a:lnTo>
                    <a:pt x="336" y="245386"/>
                  </a:lnTo>
                  <a:lnTo>
                    <a:pt x="336" y="243959"/>
                  </a:lnTo>
                  <a:lnTo>
                    <a:pt x="336" y="242532"/>
                  </a:lnTo>
                  <a:lnTo>
                    <a:pt x="336" y="241106"/>
                  </a:lnTo>
                  <a:lnTo>
                    <a:pt x="335" y="239679"/>
                  </a:lnTo>
                  <a:lnTo>
                    <a:pt x="335" y="238252"/>
                  </a:lnTo>
                  <a:lnTo>
                    <a:pt x="335" y="236826"/>
                  </a:lnTo>
                  <a:lnTo>
                    <a:pt x="335" y="235399"/>
                  </a:lnTo>
                  <a:lnTo>
                    <a:pt x="335" y="233972"/>
                  </a:lnTo>
                  <a:lnTo>
                    <a:pt x="335" y="232546"/>
                  </a:lnTo>
                  <a:lnTo>
                    <a:pt x="335" y="231119"/>
                  </a:lnTo>
                  <a:lnTo>
                    <a:pt x="335" y="229692"/>
                  </a:lnTo>
                  <a:lnTo>
                    <a:pt x="335" y="228266"/>
                  </a:lnTo>
                  <a:lnTo>
                    <a:pt x="335" y="226839"/>
                  </a:lnTo>
                  <a:lnTo>
                    <a:pt x="335" y="225412"/>
                  </a:lnTo>
                  <a:lnTo>
                    <a:pt x="335" y="223986"/>
                  </a:lnTo>
                  <a:lnTo>
                    <a:pt x="335" y="222559"/>
                  </a:lnTo>
                  <a:lnTo>
                    <a:pt x="334" y="221132"/>
                  </a:lnTo>
                  <a:lnTo>
                    <a:pt x="334" y="219706"/>
                  </a:lnTo>
                  <a:lnTo>
                    <a:pt x="334" y="218279"/>
                  </a:lnTo>
                  <a:lnTo>
                    <a:pt x="334" y="216853"/>
                  </a:lnTo>
                  <a:lnTo>
                    <a:pt x="334" y="215426"/>
                  </a:lnTo>
                  <a:lnTo>
                    <a:pt x="333" y="213999"/>
                  </a:lnTo>
                  <a:lnTo>
                    <a:pt x="333" y="212573"/>
                  </a:lnTo>
                  <a:lnTo>
                    <a:pt x="333" y="211146"/>
                  </a:lnTo>
                  <a:lnTo>
                    <a:pt x="332" y="209719"/>
                  </a:lnTo>
                  <a:lnTo>
                    <a:pt x="332" y="208293"/>
                  </a:lnTo>
                  <a:lnTo>
                    <a:pt x="332" y="206866"/>
                  </a:lnTo>
                  <a:lnTo>
                    <a:pt x="331" y="205439"/>
                  </a:lnTo>
                  <a:lnTo>
                    <a:pt x="331" y="204013"/>
                  </a:lnTo>
                  <a:lnTo>
                    <a:pt x="330" y="202586"/>
                  </a:lnTo>
                  <a:lnTo>
                    <a:pt x="330" y="201159"/>
                  </a:lnTo>
                  <a:lnTo>
                    <a:pt x="329" y="199733"/>
                  </a:lnTo>
                  <a:lnTo>
                    <a:pt x="328" y="198306"/>
                  </a:lnTo>
                  <a:lnTo>
                    <a:pt x="327" y="196879"/>
                  </a:lnTo>
                  <a:lnTo>
                    <a:pt x="327" y="195453"/>
                  </a:lnTo>
                  <a:lnTo>
                    <a:pt x="326" y="194026"/>
                  </a:lnTo>
                  <a:lnTo>
                    <a:pt x="325" y="192599"/>
                  </a:lnTo>
                  <a:lnTo>
                    <a:pt x="324" y="191173"/>
                  </a:lnTo>
                  <a:lnTo>
                    <a:pt x="323" y="189746"/>
                  </a:lnTo>
                  <a:lnTo>
                    <a:pt x="322" y="188319"/>
                  </a:lnTo>
                  <a:lnTo>
                    <a:pt x="320" y="186893"/>
                  </a:lnTo>
                  <a:lnTo>
                    <a:pt x="319" y="185466"/>
                  </a:lnTo>
                  <a:lnTo>
                    <a:pt x="318" y="184039"/>
                  </a:lnTo>
                  <a:lnTo>
                    <a:pt x="316" y="182613"/>
                  </a:lnTo>
                  <a:lnTo>
                    <a:pt x="314" y="181186"/>
                  </a:lnTo>
                  <a:lnTo>
                    <a:pt x="313" y="179759"/>
                  </a:lnTo>
                  <a:lnTo>
                    <a:pt x="311" y="178333"/>
                  </a:lnTo>
                  <a:lnTo>
                    <a:pt x="309" y="176906"/>
                  </a:lnTo>
                  <a:lnTo>
                    <a:pt x="307" y="175479"/>
                  </a:lnTo>
                  <a:lnTo>
                    <a:pt x="305" y="174053"/>
                  </a:lnTo>
                  <a:lnTo>
                    <a:pt x="303" y="172626"/>
                  </a:lnTo>
                  <a:lnTo>
                    <a:pt x="300" y="171199"/>
                  </a:lnTo>
                  <a:lnTo>
                    <a:pt x="298" y="169773"/>
                  </a:lnTo>
                  <a:lnTo>
                    <a:pt x="295" y="168346"/>
                  </a:lnTo>
                  <a:lnTo>
                    <a:pt x="293" y="166919"/>
                  </a:lnTo>
                  <a:lnTo>
                    <a:pt x="290" y="165493"/>
                  </a:lnTo>
                  <a:lnTo>
                    <a:pt x="287" y="164066"/>
                  </a:lnTo>
                  <a:lnTo>
                    <a:pt x="284" y="162639"/>
                  </a:lnTo>
                  <a:lnTo>
                    <a:pt x="281" y="161213"/>
                  </a:lnTo>
                  <a:lnTo>
                    <a:pt x="278" y="159786"/>
                  </a:lnTo>
                  <a:lnTo>
                    <a:pt x="275" y="158359"/>
                  </a:lnTo>
                  <a:lnTo>
                    <a:pt x="271" y="156933"/>
                  </a:lnTo>
                  <a:lnTo>
                    <a:pt x="268" y="155506"/>
                  </a:lnTo>
                  <a:lnTo>
                    <a:pt x="264" y="154079"/>
                  </a:lnTo>
                  <a:lnTo>
                    <a:pt x="261" y="152653"/>
                  </a:lnTo>
                  <a:lnTo>
                    <a:pt x="257" y="151226"/>
                  </a:lnTo>
                  <a:lnTo>
                    <a:pt x="254" y="149799"/>
                  </a:lnTo>
                  <a:lnTo>
                    <a:pt x="250" y="148373"/>
                  </a:lnTo>
                  <a:lnTo>
                    <a:pt x="246" y="146946"/>
                  </a:lnTo>
                  <a:lnTo>
                    <a:pt x="243" y="145519"/>
                  </a:lnTo>
                  <a:lnTo>
                    <a:pt x="239" y="144093"/>
                  </a:lnTo>
                  <a:lnTo>
                    <a:pt x="235" y="142666"/>
                  </a:lnTo>
                  <a:lnTo>
                    <a:pt x="232" y="141239"/>
                  </a:lnTo>
                  <a:lnTo>
                    <a:pt x="228" y="139813"/>
                  </a:lnTo>
                  <a:lnTo>
                    <a:pt x="225" y="138386"/>
                  </a:lnTo>
                  <a:lnTo>
                    <a:pt x="221" y="136959"/>
                  </a:lnTo>
                  <a:lnTo>
                    <a:pt x="218" y="135533"/>
                  </a:lnTo>
                  <a:lnTo>
                    <a:pt x="214" y="134106"/>
                  </a:lnTo>
                  <a:lnTo>
                    <a:pt x="211" y="132679"/>
                  </a:lnTo>
                  <a:lnTo>
                    <a:pt x="208" y="131253"/>
                  </a:lnTo>
                  <a:lnTo>
                    <a:pt x="205" y="129826"/>
                  </a:lnTo>
                  <a:lnTo>
                    <a:pt x="202" y="128399"/>
                  </a:lnTo>
                  <a:lnTo>
                    <a:pt x="199" y="126973"/>
                  </a:lnTo>
                  <a:lnTo>
                    <a:pt x="197" y="125546"/>
                  </a:lnTo>
                  <a:lnTo>
                    <a:pt x="194" y="124119"/>
                  </a:lnTo>
                  <a:lnTo>
                    <a:pt x="192" y="122693"/>
                  </a:lnTo>
                  <a:lnTo>
                    <a:pt x="190" y="121266"/>
                  </a:lnTo>
                  <a:lnTo>
                    <a:pt x="188" y="119839"/>
                  </a:lnTo>
                  <a:lnTo>
                    <a:pt x="186" y="118413"/>
                  </a:lnTo>
                  <a:lnTo>
                    <a:pt x="185" y="116986"/>
                  </a:lnTo>
                  <a:lnTo>
                    <a:pt x="184" y="115559"/>
                  </a:lnTo>
                  <a:lnTo>
                    <a:pt x="183" y="114133"/>
                  </a:lnTo>
                  <a:lnTo>
                    <a:pt x="182" y="112706"/>
                  </a:lnTo>
                  <a:lnTo>
                    <a:pt x="182" y="111279"/>
                  </a:lnTo>
                  <a:lnTo>
                    <a:pt x="181" y="109853"/>
                  </a:lnTo>
                  <a:lnTo>
                    <a:pt x="181" y="108426"/>
                  </a:lnTo>
                  <a:lnTo>
                    <a:pt x="181" y="106999"/>
                  </a:lnTo>
                  <a:lnTo>
                    <a:pt x="182" y="105573"/>
                  </a:lnTo>
                  <a:lnTo>
                    <a:pt x="182" y="104146"/>
                  </a:lnTo>
                  <a:lnTo>
                    <a:pt x="183" y="102719"/>
                  </a:lnTo>
                  <a:lnTo>
                    <a:pt x="185" y="101293"/>
                  </a:lnTo>
                  <a:lnTo>
                    <a:pt x="186" y="99866"/>
                  </a:lnTo>
                  <a:lnTo>
                    <a:pt x="187" y="98439"/>
                  </a:lnTo>
                  <a:lnTo>
                    <a:pt x="189" y="97013"/>
                  </a:lnTo>
                  <a:lnTo>
                    <a:pt x="191" y="95586"/>
                  </a:lnTo>
                  <a:lnTo>
                    <a:pt x="193" y="94159"/>
                  </a:lnTo>
                  <a:lnTo>
                    <a:pt x="196" y="92733"/>
                  </a:lnTo>
                  <a:lnTo>
                    <a:pt x="198" y="91306"/>
                  </a:lnTo>
                  <a:lnTo>
                    <a:pt x="201" y="89879"/>
                  </a:lnTo>
                  <a:lnTo>
                    <a:pt x="204" y="88453"/>
                  </a:lnTo>
                  <a:lnTo>
                    <a:pt x="207" y="87026"/>
                  </a:lnTo>
                  <a:lnTo>
                    <a:pt x="210" y="85599"/>
                  </a:lnTo>
                  <a:lnTo>
                    <a:pt x="213" y="84173"/>
                  </a:lnTo>
                  <a:lnTo>
                    <a:pt x="216" y="82746"/>
                  </a:lnTo>
                  <a:lnTo>
                    <a:pt x="220" y="81319"/>
                  </a:lnTo>
                  <a:lnTo>
                    <a:pt x="223" y="79893"/>
                  </a:lnTo>
                  <a:lnTo>
                    <a:pt x="227" y="78466"/>
                  </a:lnTo>
                  <a:lnTo>
                    <a:pt x="230" y="77039"/>
                  </a:lnTo>
                  <a:lnTo>
                    <a:pt x="234" y="75613"/>
                  </a:lnTo>
                  <a:lnTo>
                    <a:pt x="238" y="74186"/>
                  </a:lnTo>
                  <a:lnTo>
                    <a:pt x="241" y="72759"/>
                  </a:lnTo>
                  <a:lnTo>
                    <a:pt x="245" y="71333"/>
                  </a:lnTo>
                  <a:lnTo>
                    <a:pt x="249" y="69906"/>
                  </a:lnTo>
                  <a:lnTo>
                    <a:pt x="252" y="68479"/>
                  </a:lnTo>
                  <a:lnTo>
                    <a:pt x="256" y="67053"/>
                  </a:lnTo>
                  <a:lnTo>
                    <a:pt x="260" y="65626"/>
                  </a:lnTo>
                  <a:lnTo>
                    <a:pt x="263" y="64199"/>
                  </a:lnTo>
                  <a:lnTo>
                    <a:pt x="267" y="62773"/>
                  </a:lnTo>
                  <a:lnTo>
                    <a:pt x="270" y="61346"/>
                  </a:lnTo>
                  <a:lnTo>
                    <a:pt x="273" y="59919"/>
                  </a:lnTo>
                  <a:lnTo>
                    <a:pt x="277" y="58493"/>
                  </a:lnTo>
                  <a:lnTo>
                    <a:pt x="280" y="57066"/>
                  </a:lnTo>
                  <a:lnTo>
                    <a:pt x="283" y="55639"/>
                  </a:lnTo>
                  <a:lnTo>
                    <a:pt x="286" y="54213"/>
                  </a:lnTo>
                  <a:lnTo>
                    <a:pt x="289" y="52786"/>
                  </a:lnTo>
                  <a:lnTo>
                    <a:pt x="292" y="51359"/>
                  </a:lnTo>
                  <a:lnTo>
                    <a:pt x="294" y="49933"/>
                  </a:lnTo>
                  <a:lnTo>
                    <a:pt x="297" y="48506"/>
                  </a:lnTo>
                  <a:lnTo>
                    <a:pt x="299" y="47079"/>
                  </a:lnTo>
                  <a:lnTo>
                    <a:pt x="302" y="45653"/>
                  </a:lnTo>
                  <a:lnTo>
                    <a:pt x="304" y="44226"/>
                  </a:lnTo>
                  <a:lnTo>
                    <a:pt x="306" y="42799"/>
                  </a:lnTo>
                  <a:lnTo>
                    <a:pt x="308" y="41373"/>
                  </a:lnTo>
                  <a:lnTo>
                    <a:pt x="310" y="39946"/>
                  </a:lnTo>
                  <a:lnTo>
                    <a:pt x="312" y="38519"/>
                  </a:lnTo>
                  <a:lnTo>
                    <a:pt x="314" y="37093"/>
                  </a:lnTo>
                  <a:lnTo>
                    <a:pt x="315" y="35666"/>
                  </a:lnTo>
                  <a:lnTo>
                    <a:pt x="317" y="34239"/>
                  </a:lnTo>
                  <a:lnTo>
                    <a:pt x="318" y="32813"/>
                  </a:lnTo>
                  <a:lnTo>
                    <a:pt x="320" y="31386"/>
                  </a:lnTo>
                  <a:lnTo>
                    <a:pt x="321" y="29959"/>
                  </a:lnTo>
                  <a:lnTo>
                    <a:pt x="322" y="28533"/>
                  </a:lnTo>
                  <a:lnTo>
                    <a:pt x="323" y="27106"/>
                  </a:lnTo>
                  <a:lnTo>
                    <a:pt x="324" y="25679"/>
                  </a:lnTo>
                  <a:lnTo>
                    <a:pt x="325" y="24253"/>
                  </a:lnTo>
                  <a:lnTo>
                    <a:pt x="326" y="22826"/>
                  </a:lnTo>
                  <a:lnTo>
                    <a:pt x="327" y="21399"/>
                  </a:lnTo>
                  <a:lnTo>
                    <a:pt x="328" y="19973"/>
                  </a:lnTo>
                  <a:lnTo>
                    <a:pt x="329" y="18546"/>
                  </a:lnTo>
                  <a:lnTo>
                    <a:pt x="329" y="17119"/>
                  </a:lnTo>
                  <a:lnTo>
                    <a:pt x="330" y="15693"/>
                  </a:lnTo>
                  <a:lnTo>
                    <a:pt x="331" y="14266"/>
                  </a:lnTo>
                  <a:lnTo>
                    <a:pt x="331" y="12839"/>
                  </a:lnTo>
                  <a:lnTo>
                    <a:pt x="331" y="11413"/>
                  </a:lnTo>
                  <a:lnTo>
                    <a:pt x="332" y="9986"/>
                  </a:lnTo>
                  <a:lnTo>
                    <a:pt x="332" y="8559"/>
                  </a:lnTo>
                  <a:lnTo>
                    <a:pt x="333" y="7133"/>
                  </a:lnTo>
                  <a:lnTo>
                    <a:pt x="333" y="5706"/>
                  </a:lnTo>
                  <a:lnTo>
                    <a:pt x="333" y="4279"/>
                  </a:lnTo>
                  <a:lnTo>
                    <a:pt x="334" y="2853"/>
                  </a:lnTo>
                  <a:lnTo>
                    <a:pt x="334" y="1426"/>
                  </a:lnTo>
                  <a:lnTo>
                    <a:pt x="334" y="0"/>
                  </a:lnTo>
                  <a:lnTo>
                    <a:pt x="336" y="0"/>
                  </a:lnTo>
                  <a:lnTo>
                    <a:pt x="336" y="729025"/>
                  </a:lnTo>
                  <a:lnTo>
                    <a:pt x="336" y="729025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65" name="pl47"/>
            <p:cNvSpPr/>
            <p:nvPr/>
          </p:nvSpPr>
          <p:spPr>
            <a:xfrm>
              <a:off x="6339600" y="3573697"/>
              <a:ext cx="3153" cy="213852"/>
            </a:xfrm>
            <a:custGeom>
              <a:avLst/>
              <a:gdLst/>
              <a:ahLst/>
              <a:cxnLst/>
              <a:rect l="0" t="0" r="0" b="0"/>
              <a:pathLst>
                <a:path w="3153" h="213852">
                  <a:moveTo>
                    <a:pt x="0" y="0"/>
                  </a:moveTo>
                  <a:lnTo>
                    <a:pt x="16" y="0"/>
                  </a:lnTo>
                  <a:lnTo>
                    <a:pt x="22" y="418"/>
                  </a:lnTo>
                  <a:lnTo>
                    <a:pt x="30" y="836"/>
                  </a:lnTo>
                  <a:lnTo>
                    <a:pt x="41" y="1255"/>
                  </a:lnTo>
                  <a:lnTo>
                    <a:pt x="54" y="1673"/>
                  </a:lnTo>
                  <a:lnTo>
                    <a:pt x="71" y="2092"/>
                  </a:lnTo>
                  <a:lnTo>
                    <a:pt x="92" y="2510"/>
                  </a:lnTo>
                  <a:lnTo>
                    <a:pt x="118" y="2929"/>
                  </a:lnTo>
                  <a:lnTo>
                    <a:pt x="150" y="3347"/>
                  </a:lnTo>
                  <a:lnTo>
                    <a:pt x="187" y="3766"/>
                  </a:lnTo>
                  <a:lnTo>
                    <a:pt x="231" y="4184"/>
                  </a:lnTo>
                  <a:lnTo>
                    <a:pt x="282" y="4603"/>
                  </a:lnTo>
                  <a:lnTo>
                    <a:pt x="341" y="5021"/>
                  </a:lnTo>
                  <a:lnTo>
                    <a:pt x="407" y="5440"/>
                  </a:lnTo>
                  <a:lnTo>
                    <a:pt x="481" y="5858"/>
                  </a:lnTo>
                  <a:lnTo>
                    <a:pt x="560" y="6277"/>
                  </a:lnTo>
                  <a:lnTo>
                    <a:pt x="646" y="6695"/>
                  </a:lnTo>
                  <a:lnTo>
                    <a:pt x="736" y="7114"/>
                  </a:lnTo>
                  <a:lnTo>
                    <a:pt x="829" y="7532"/>
                  </a:lnTo>
                  <a:lnTo>
                    <a:pt x="923" y="7951"/>
                  </a:lnTo>
                  <a:lnTo>
                    <a:pt x="1016" y="8369"/>
                  </a:lnTo>
                  <a:lnTo>
                    <a:pt x="1105" y="8788"/>
                  </a:lnTo>
                  <a:lnTo>
                    <a:pt x="1188" y="9206"/>
                  </a:lnTo>
                  <a:lnTo>
                    <a:pt x="1263" y="9625"/>
                  </a:lnTo>
                  <a:lnTo>
                    <a:pt x="1327" y="10043"/>
                  </a:lnTo>
                  <a:lnTo>
                    <a:pt x="1379" y="10462"/>
                  </a:lnTo>
                  <a:lnTo>
                    <a:pt x="1417" y="10880"/>
                  </a:lnTo>
                  <a:lnTo>
                    <a:pt x="1438" y="11299"/>
                  </a:lnTo>
                  <a:lnTo>
                    <a:pt x="1442" y="11717"/>
                  </a:lnTo>
                  <a:lnTo>
                    <a:pt x="1430" y="12136"/>
                  </a:lnTo>
                  <a:lnTo>
                    <a:pt x="1401" y="12554"/>
                  </a:lnTo>
                  <a:lnTo>
                    <a:pt x="1358" y="12973"/>
                  </a:lnTo>
                  <a:lnTo>
                    <a:pt x="1301" y="13391"/>
                  </a:lnTo>
                  <a:lnTo>
                    <a:pt x="1233" y="13810"/>
                  </a:lnTo>
                  <a:lnTo>
                    <a:pt x="1154" y="14228"/>
                  </a:lnTo>
                  <a:lnTo>
                    <a:pt x="1068" y="14647"/>
                  </a:lnTo>
                  <a:lnTo>
                    <a:pt x="977" y="15065"/>
                  </a:lnTo>
                  <a:lnTo>
                    <a:pt x="883" y="15484"/>
                  </a:lnTo>
                  <a:lnTo>
                    <a:pt x="789" y="15902"/>
                  </a:lnTo>
                  <a:lnTo>
                    <a:pt x="697" y="16321"/>
                  </a:lnTo>
                  <a:lnTo>
                    <a:pt x="609" y="16739"/>
                  </a:lnTo>
                  <a:lnTo>
                    <a:pt x="525" y="17158"/>
                  </a:lnTo>
                  <a:lnTo>
                    <a:pt x="448" y="17576"/>
                  </a:lnTo>
                  <a:lnTo>
                    <a:pt x="378" y="17995"/>
                  </a:lnTo>
                  <a:lnTo>
                    <a:pt x="315" y="18413"/>
                  </a:lnTo>
                  <a:lnTo>
                    <a:pt x="260" y="18832"/>
                  </a:lnTo>
                  <a:lnTo>
                    <a:pt x="212" y="19250"/>
                  </a:lnTo>
                  <a:lnTo>
                    <a:pt x="171" y="19669"/>
                  </a:lnTo>
                  <a:lnTo>
                    <a:pt x="136" y="20087"/>
                  </a:lnTo>
                  <a:lnTo>
                    <a:pt x="106" y="20506"/>
                  </a:lnTo>
                  <a:lnTo>
                    <a:pt x="82" y="20924"/>
                  </a:lnTo>
                  <a:lnTo>
                    <a:pt x="63" y="21343"/>
                  </a:lnTo>
                  <a:lnTo>
                    <a:pt x="48" y="21761"/>
                  </a:lnTo>
                  <a:lnTo>
                    <a:pt x="36" y="22180"/>
                  </a:lnTo>
                  <a:lnTo>
                    <a:pt x="27" y="22598"/>
                  </a:lnTo>
                  <a:lnTo>
                    <a:pt x="20" y="23017"/>
                  </a:lnTo>
                  <a:lnTo>
                    <a:pt x="14" y="23435"/>
                  </a:lnTo>
                  <a:lnTo>
                    <a:pt x="10" y="23854"/>
                  </a:lnTo>
                  <a:lnTo>
                    <a:pt x="7" y="24272"/>
                  </a:lnTo>
                  <a:lnTo>
                    <a:pt x="5" y="24691"/>
                  </a:lnTo>
                  <a:lnTo>
                    <a:pt x="3" y="25109"/>
                  </a:lnTo>
                  <a:lnTo>
                    <a:pt x="2" y="25528"/>
                  </a:lnTo>
                  <a:lnTo>
                    <a:pt x="1" y="25946"/>
                  </a:lnTo>
                  <a:lnTo>
                    <a:pt x="1" y="26365"/>
                  </a:lnTo>
                  <a:lnTo>
                    <a:pt x="0" y="26783"/>
                  </a:lnTo>
                  <a:lnTo>
                    <a:pt x="0" y="27202"/>
                  </a:lnTo>
                  <a:lnTo>
                    <a:pt x="0" y="27620"/>
                  </a:lnTo>
                  <a:lnTo>
                    <a:pt x="0" y="28039"/>
                  </a:lnTo>
                  <a:lnTo>
                    <a:pt x="0" y="28457"/>
                  </a:lnTo>
                  <a:lnTo>
                    <a:pt x="0" y="28876"/>
                  </a:lnTo>
                  <a:lnTo>
                    <a:pt x="0" y="29294"/>
                  </a:lnTo>
                  <a:lnTo>
                    <a:pt x="0" y="29713"/>
                  </a:lnTo>
                  <a:lnTo>
                    <a:pt x="0" y="30131"/>
                  </a:lnTo>
                  <a:lnTo>
                    <a:pt x="0" y="30550"/>
                  </a:lnTo>
                  <a:lnTo>
                    <a:pt x="0" y="30968"/>
                  </a:lnTo>
                  <a:lnTo>
                    <a:pt x="0" y="31387"/>
                  </a:lnTo>
                  <a:lnTo>
                    <a:pt x="0" y="31805"/>
                  </a:lnTo>
                  <a:lnTo>
                    <a:pt x="0" y="32224"/>
                  </a:lnTo>
                  <a:lnTo>
                    <a:pt x="0" y="32642"/>
                  </a:lnTo>
                  <a:lnTo>
                    <a:pt x="0" y="33061"/>
                  </a:lnTo>
                  <a:lnTo>
                    <a:pt x="0" y="33479"/>
                  </a:lnTo>
                  <a:lnTo>
                    <a:pt x="0" y="33898"/>
                  </a:lnTo>
                  <a:lnTo>
                    <a:pt x="0" y="34316"/>
                  </a:lnTo>
                  <a:lnTo>
                    <a:pt x="0" y="34735"/>
                  </a:lnTo>
                  <a:lnTo>
                    <a:pt x="0" y="35153"/>
                  </a:lnTo>
                  <a:lnTo>
                    <a:pt x="0" y="35572"/>
                  </a:lnTo>
                  <a:lnTo>
                    <a:pt x="0" y="35990"/>
                  </a:lnTo>
                  <a:lnTo>
                    <a:pt x="0" y="36409"/>
                  </a:lnTo>
                  <a:lnTo>
                    <a:pt x="0" y="36827"/>
                  </a:lnTo>
                  <a:lnTo>
                    <a:pt x="0" y="37246"/>
                  </a:lnTo>
                  <a:lnTo>
                    <a:pt x="0" y="37664"/>
                  </a:lnTo>
                  <a:lnTo>
                    <a:pt x="0" y="38083"/>
                  </a:lnTo>
                  <a:lnTo>
                    <a:pt x="0" y="38501"/>
                  </a:lnTo>
                  <a:lnTo>
                    <a:pt x="0" y="38920"/>
                  </a:lnTo>
                  <a:lnTo>
                    <a:pt x="0" y="39338"/>
                  </a:lnTo>
                  <a:lnTo>
                    <a:pt x="0" y="39757"/>
                  </a:lnTo>
                  <a:lnTo>
                    <a:pt x="0" y="40175"/>
                  </a:lnTo>
                  <a:lnTo>
                    <a:pt x="0" y="40594"/>
                  </a:lnTo>
                  <a:lnTo>
                    <a:pt x="0" y="41012"/>
                  </a:lnTo>
                  <a:lnTo>
                    <a:pt x="0" y="41431"/>
                  </a:lnTo>
                  <a:lnTo>
                    <a:pt x="0" y="41849"/>
                  </a:lnTo>
                  <a:lnTo>
                    <a:pt x="0" y="42268"/>
                  </a:lnTo>
                  <a:lnTo>
                    <a:pt x="0" y="42686"/>
                  </a:lnTo>
                  <a:lnTo>
                    <a:pt x="0" y="43105"/>
                  </a:lnTo>
                  <a:lnTo>
                    <a:pt x="0" y="43523"/>
                  </a:lnTo>
                  <a:lnTo>
                    <a:pt x="0" y="43942"/>
                  </a:lnTo>
                  <a:lnTo>
                    <a:pt x="0" y="44360"/>
                  </a:lnTo>
                  <a:lnTo>
                    <a:pt x="0" y="44779"/>
                  </a:lnTo>
                  <a:lnTo>
                    <a:pt x="0" y="45197"/>
                  </a:lnTo>
                  <a:lnTo>
                    <a:pt x="0" y="45616"/>
                  </a:lnTo>
                  <a:lnTo>
                    <a:pt x="0" y="46034"/>
                  </a:lnTo>
                  <a:lnTo>
                    <a:pt x="0" y="46453"/>
                  </a:lnTo>
                  <a:lnTo>
                    <a:pt x="0" y="46871"/>
                  </a:lnTo>
                  <a:lnTo>
                    <a:pt x="0" y="47290"/>
                  </a:lnTo>
                  <a:lnTo>
                    <a:pt x="0" y="47708"/>
                  </a:lnTo>
                  <a:lnTo>
                    <a:pt x="0" y="48127"/>
                  </a:lnTo>
                  <a:lnTo>
                    <a:pt x="0" y="48545"/>
                  </a:lnTo>
                  <a:lnTo>
                    <a:pt x="0" y="48964"/>
                  </a:lnTo>
                  <a:lnTo>
                    <a:pt x="0" y="49382"/>
                  </a:lnTo>
                  <a:lnTo>
                    <a:pt x="0" y="49801"/>
                  </a:lnTo>
                  <a:lnTo>
                    <a:pt x="0" y="50219"/>
                  </a:lnTo>
                  <a:lnTo>
                    <a:pt x="0" y="50638"/>
                  </a:lnTo>
                  <a:lnTo>
                    <a:pt x="0" y="51056"/>
                  </a:lnTo>
                  <a:lnTo>
                    <a:pt x="0" y="51475"/>
                  </a:lnTo>
                  <a:lnTo>
                    <a:pt x="0" y="51893"/>
                  </a:lnTo>
                  <a:lnTo>
                    <a:pt x="0" y="52312"/>
                  </a:lnTo>
                  <a:lnTo>
                    <a:pt x="0" y="52730"/>
                  </a:lnTo>
                  <a:lnTo>
                    <a:pt x="0" y="53149"/>
                  </a:lnTo>
                  <a:lnTo>
                    <a:pt x="0" y="53567"/>
                  </a:lnTo>
                  <a:lnTo>
                    <a:pt x="0" y="53986"/>
                  </a:lnTo>
                  <a:lnTo>
                    <a:pt x="0" y="54404"/>
                  </a:lnTo>
                  <a:lnTo>
                    <a:pt x="0" y="54823"/>
                  </a:lnTo>
                  <a:lnTo>
                    <a:pt x="0" y="55241"/>
                  </a:lnTo>
                  <a:lnTo>
                    <a:pt x="0" y="55660"/>
                  </a:lnTo>
                  <a:lnTo>
                    <a:pt x="0" y="56078"/>
                  </a:lnTo>
                  <a:lnTo>
                    <a:pt x="0" y="56497"/>
                  </a:lnTo>
                  <a:lnTo>
                    <a:pt x="0" y="56915"/>
                  </a:lnTo>
                  <a:lnTo>
                    <a:pt x="0" y="57334"/>
                  </a:lnTo>
                  <a:lnTo>
                    <a:pt x="0" y="57752"/>
                  </a:lnTo>
                  <a:lnTo>
                    <a:pt x="0" y="58171"/>
                  </a:lnTo>
                  <a:lnTo>
                    <a:pt x="0" y="58589"/>
                  </a:lnTo>
                  <a:lnTo>
                    <a:pt x="0" y="59008"/>
                  </a:lnTo>
                  <a:lnTo>
                    <a:pt x="0" y="59426"/>
                  </a:lnTo>
                  <a:lnTo>
                    <a:pt x="0" y="59845"/>
                  </a:lnTo>
                  <a:lnTo>
                    <a:pt x="0" y="60263"/>
                  </a:lnTo>
                  <a:lnTo>
                    <a:pt x="0" y="60682"/>
                  </a:lnTo>
                  <a:lnTo>
                    <a:pt x="0" y="61100"/>
                  </a:lnTo>
                  <a:lnTo>
                    <a:pt x="0" y="61519"/>
                  </a:lnTo>
                  <a:lnTo>
                    <a:pt x="0" y="61937"/>
                  </a:lnTo>
                  <a:lnTo>
                    <a:pt x="0" y="62356"/>
                  </a:lnTo>
                  <a:lnTo>
                    <a:pt x="0" y="62774"/>
                  </a:lnTo>
                  <a:lnTo>
                    <a:pt x="0" y="63193"/>
                  </a:lnTo>
                  <a:lnTo>
                    <a:pt x="0" y="63611"/>
                  </a:lnTo>
                  <a:lnTo>
                    <a:pt x="0" y="64030"/>
                  </a:lnTo>
                  <a:lnTo>
                    <a:pt x="0" y="64448"/>
                  </a:lnTo>
                  <a:lnTo>
                    <a:pt x="0" y="64867"/>
                  </a:lnTo>
                  <a:lnTo>
                    <a:pt x="0" y="65285"/>
                  </a:lnTo>
                  <a:lnTo>
                    <a:pt x="0" y="65704"/>
                  </a:lnTo>
                  <a:lnTo>
                    <a:pt x="0" y="66122"/>
                  </a:lnTo>
                  <a:lnTo>
                    <a:pt x="0" y="66541"/>
                  </a:lnTo>
                  <a:lnTo>
                    <a:pt x="0" y="66959"/>
                  </a:lnTo>
                  <a:lnTo>
                    <a:pt x="0" y="67378"/>
                  </a:lnTo>
                  <a:lnTo>
                    <a:pt x="0" y="67796"/>
                  </a:lnTo>
                  <a:lnTo>
                    <a:pt x="0" y="68215"/>
                  </a:lnTo>
                  <a:lnTo>
                    <a:pt x="0" y="68633"/>
                  </a:lnTo>
                  <a:lnTo>
                    <a:pt x="0" y="69052"/>
                  </a:lnTo>
                  <a:lnTo>
                    <a:pt x="0" y="69470"/>
                  </a:lnTo>
                  <a:lnTo>
                    <a:pt x="0" y="69889"/>
                  </a:lnTo>
                  <a:lnTo>
                    <a:pt x="0" y="70307"/>
                  </a:lnTo>
                  <a:lnTo>
                    <a:pt x="0" y="70726"/>
                  </a:lnTo>
                  <a:lnTo>
                    <a:pt x="0" y="71144"/>
                  </a:lnTo>
                  <a:lnTo>
                    <a:pt x="0" y="71563"/>
                  </a:lnTo>
                  <a:lnTo>
                    <a:pt x="0" y="71981"/>
                  </a:lnTo>
                  <a:lnTo>
                    <a:pt x="0" y="72400"/>
                  </a:lnTo>
                  <a:lnTo>
                    <a:pt x="0" y="72818"/>
                  </a:lnTo>
                  <a:lnTo>
                    <a:pt x="0" y="73237"/>
                  </a:lnTo>
                  <a:lnTo>
                    <a:pt x="0" y="73655"/>
                  </a:lnTo>
                  <a:lnTo>
                    <a:pt x="0" y="74074"/>
                  </a:lnTo>
                  <a:lnTo>
                    <a:pt x="0" y="74492"/>
                  </a:lnTo>
                  <a:lnTo>
                    <a:pt x="0" y="74911"/>
                  </a:lnTo>
                  <a:lnTo>
                    <a:pt x="0" y="75329"/>
                  </a:lnTo>
                  <a:lnTo>
                    <a:pt x="0" y="75748"/>
                  </a:lnTo>
                  <a:lnTo>
                    <a:pt x="0" y="76166"/>
                  </a:lnTo>
                  <a:lnTo>
                    <a:pt x="0" y="76585"/>
                  </a:lnTo>
                  <a:lnTo>
                    <a:pt x="0" y="77003"/>
                  </a:lnTo>
                  <a:lnTo>
                    <a:pt x="0" y="77422"/>
                  </a:lnTo>
                  <a:lnTo>
                    <a:pt x="0" y="77840"/>
                  </a:lnTo>
                  <a:lnTo>
                    <a:pt x="0" y="78259"/>
                  </a:lnTo>
                  <a:lnTo>
                    <a:pt x="0" y="78677"/>
                  </a:lnTo>
                  <a:lnTo>
                    <a:pt x="0" y="79096"/>
                  </a:lnTo>
                  <a:lnTo>
                    <a:pt x="0" y="79514"/>
                  </a:lnTo>
                  <a:lnTo>
                    <a:pt x="0" y="79933"/>
                  </a:lnTo>
                  <a:lnTo>
                    <a:pt x="0" y="80351"/>
                  </a:lnTo>
                  <a:lnTo>
                    <a:pt x="0" y="80770"/>
                  </a:lnTo>
                  <a:lnTo>
                    <a:pt x="0" y="81188"/>
                  </a:lnTo>
                  <a:lnTo>
                    <a:pt x="0" y="81607"/>
                  </a:lnTo>
                  <a:lnTo>
                    <a:pt x="0" y="82025"/>
                  </a:lnTo>
                  <a:lnTo>
                    <a:pt x="0" y="82444"/>
                  </a:lnTo>
                  <a:lnTo>
                    <a:pt x="0" y="82862"/>
                  </a:lnTo>
                  <a:lnTo>
                    <a:pt x="0" y="83281"/>
                  </a:lnTo>
                  <a:lnTo>
                    <a:pt x="0" y="83699"/>
                  </a:lnTo>
                  <a:lnTo>
                    <a:pt x="0" y="84118"/>
                  </a:lnTo>
                  <a:lnTo>
                    <a:pt x="0" y="84536"/>
                  </a:lnTo>
                  <a:lnTo>
                    <a:pt x="0" y="84955"/>
                  </a:lnTo>
                  <a:lnTo>
                    <a:pt x="0" y="85373"/>
                  </a:lnTo>
                  <a:lnTo>
                    <a:pt x="0" y="85792"/>
                  </a:lnTo>
                  <a:lnTo>
                    <a:pt x="0" y="86210"/>
                  </a:lnTo>
                  <a:lnTo>
                    <a:pt x="0" y="86629"/>
                  </a:lnTo>
                  <a:lnTo>
                    <a:pt x="0" y="87047"/>
                  </a:lnTo>
                  <a:lnTo>
                    <a:pt x="0" y="87466"/>
                  </a:lnTo>
                  <a:lnTo>
                    <a:pt x="0" y="87884"/>
                  </a:lnTo>
                  <a:lnTo>
                    <a:pt x="0" y="88303"/>
                  </a:lnTo>
                  <a:lnTo>
                    <a:pt x="0" y="88721"/>
                  </a:lnTo>
                  <a:lnTo>
                    <a:pt x="0" y="89140"/>
                  </a:lnTo>
                  <a:lnTo>
                    <a:pt x="0" y="89558"/>
                  </a:lnTo>
                  <a:lnTo>
                    <a:pt x="0" y="89977"/>
                  </a:lnTo>
                  <a:lnTo>
                    <a:pt x="0" y="90395"/>
                  </a:lnTo>
                  <a:lnTo>
                    <a:pt x="0" y="90814"/>
                  </a:lnTo>
                  <a:lnTo>
                    <a:pt x="0" y="91232"/>
                  </a:lnTo>
                  <a:lnTo>
                    <a:pt x="0" y="91651"/>
                  </a:lnTo>
                  <a:lnTo>
                    <a:pt x="0" y="92069"/>
                  </a:lnTo>
                  <a:lnTo>
                    <a:pt x="0" y="92488"/>
                  </a:lnTo>
                  <a:lnTo>
                    <a:pt x="0" y="92906"/>
                  </a:lnTo>
                  <a:lnTo>
                    <a:pt x="0" y="93325"/>
                  </a:lnTo>
                  <a:lnTo>
                    <a:pt x="0" y="93743"/>
                  </a:lnTo>
                  <a:lnTo>
                    <a:pt x="0" y="94162"/>
                  </a:lnTo>
                  <a:lnTo>
                    <a:pt x="0" y="94580"/>
                  </a:lnTo>
                  <a:lnTo>
                    <a:pt x="0" y="94999"/>
                  </a:lnTo>
                  <a:lnTo>
                    <a:pt x="0" y="95417"/>
                  </a:lnTo>
                  <a:lnTo>
                    <a:pt x="0" y="95836"/>
                  </a:lnTo>
                  <a:lnTo>
                    <a:pt x="0" y="96254"/>
                  </a:lnTo>
                  <a:lnTo>
                    <a:pt x="0" y="96673"/>
                  </a:lnTo>
                  <a:lnTo>
                    <a:pt x="0" y="97091"/>
                  </a:lnTo>
                  <a:lnTo>
                    <a:pt x="0" y="97510"/>
                  </a:lnTo>
                  <a:lnTo>
                    <a:pt x="0" y="97928"/>
                  </a:lnTo>
                  <a:lnTo>
                    <a:pt x="0" y="98347"/>
                  </a:lnTo>
                  <a:lnTo>
                    <a:pt x="0" y="98765"/>
                  </a:lnTo>
                  <a:lnTo>
                    <a:pt x="0" y="99184"/>
                  </a:lnTo>
                  <a:lnTo>
                    <a:pt x="0" y="99602"/>
                  </a:lnTo>
                  <a:lnTo>
                    <a:pt x="0" y="100021"/>
                  </a:lnTo>
                  <a:lnTo>
                    <a:pt x="0" y="100439"/>
                  </a:lnTo>
                  <a:lnTo>
                    <a:pt x="0" y="100858"/>
                  </a:lnTo>
                  <a:lnTo>
                    <a:pt x="0" y="101276"/>
                  </a:lnTo>
                  <a:lnTo>
                    <a:pt x="0" y="101695"/>
                  </a:lnTo>
                  <a:lnTo>
                    <a:pt x="0" y="102113"/>
                  </a:lnTo>
                  <a:lnTo>
                    <a:pt x="0" y="102532"/>
                  </a:lnTo>
                  <a:lnTo>
                    <a:pt x="0" y="102950"/>
                  </a:lnTo>
                  <a:lnTo>
                    <a:pt x="0" y="103369"/>
                  </a:lnTo>
                  <a:lnTo>
                    <a:pt x="0" y="103787"/>
                  </a:lnTo>
                  <a:lnTo>
                    <a:pt x="0" y="104206"/>
                  </a:lnTo>
                  <a:lnTo>
                    <a:pt x="0" y="104624"/>
                  </a:lnTo>
                  <a:lnTo>
                    <a:pt x="0" y="105043"/>
                  </a:lnTo>
                  <a:lnTo>
                    <a:pt x="0" y="105461"/>
                  </a:lnTo>
                  <a:lnTo>
                    <a:pt x="0" y="105880"/>
                  </a:lnTo>
                  <a:lnTo>
                    <a:pt x="0" y="106298"/>
                  </a:lnTo>
                  <a:lnTo>
                    <a:pt x="0" y="106717"/>
                  </a:lnTo>
                  <a:lnTo>
                    <a:pt x="0" y="107135"/>
                  </a:lnTo>
                  <a:lnTo>
                    <a:pt x="0" y="107554"/>
                  </a:lnTo>
                  <a:lnTo>
                    <a:pt x="0" y="107972"/>
                  </a:lnTo>
                  <a:lnTo>
                    <a:pt x="0" y="108391"/>
                  </a:lnTo>
                  <a:lnTo>
                    <a:pt x="0" y="108809"/>
                  </a:lnTo>
                  <a:lnTo>
                    <a:pt x="0" y="109228"/>
                  </a:lnTo>
                  <a:lnTo>
                    <a:pt x="0" y="109646"/>
                  </a:lnTo>
                  <a:lnTo>
                    <a:pt x="0" y="110065"/>
                  </a:lnTo>
                  <a:lnTo>
                    <a:pt x="0" y="110483"/>
                  </a:lnTo>
                  <a:lnTo>
                    <a:pt x="0" y="110902"/>
                  </a:lnTo>
                  <a:lnTo>
                    <a:pt x="0" y="111320"/>
                  </a:lnTo>
                  <a:lnTo>
                    <a:pt x="0" y="111739"/>
                  </a:lnTo>
                  <a:lnTo>
                    <a:pt x="0" y="112157"/>
                  </a:lnTo>
                  <a:lnTo>
                    <a:pt x="0" y="112576"/>
                  </a:lnTo>
                  <a:lnTo>
                    <a:pt x="0" y="112994"/>
                  </a:lnTo>
                  <a:lnTo>
                    <a:pt x="0" y="113413"/>
                  </a:lnTo>
                  <a:lnTo>
                    <a:pt x="0" y="113831"/>
                  </a:lnTo>
                  <a:lnTo>
                    <a:pt x="0" y="114250"/>
                  </a:lnTo>
                  <a:lnTo>
                    <a:pt x="0" y="114668"/>
                  </a:lnTo>
                  <a:lnTo>
                    <a:pt x="0" y="115087"/>
                  </a:lnTo>
                  <a:lnTo>
                    <a:pt x="0" y="115505"/>
                  </a:lnTo>
                  <a:lnTo>
                    <a:pt x="0" y="115924"/>
                  </a:lnTo>
                  <a:lnTo>
                    <a:pt x="0" y="116342"/>
                  </a:lnTo>
                  <a:lnTo>
                    <a:pt x="0" y="116761"/>
                  </a:lnTo>
                  <a:lnTo>
                    <a:pt x="0" y="117179"/>
                  </a:lnTo>
                  <a:lnTo>
                    <a:pt x="0" y="117598"/>
                  </a:lnTo>
                  <a:lnTo>
                    <a:pt x="0" y="118016"/>
                  </a:lnTo>
                  <a:lnTo>
                    <a:pt x="0" y="118435"/>
                  </a:lnTo>
                  <a:lnTo>
                    <a:pt x="0" y="118853"/>
                  </a:lnTo>
                  <a:lnTo>
                    <a:pt x="0" y="119272"/>
                  </a:lnTo>
                  <a:lnTo>
                    <a:pt x="0" y="119690"/>
                  </a:lnTo>
                  <a:lnTo>
                    <a:pt x="0" y="120109"/>
                  </a:lnTo>
                  <a:lnTo>
                    <a:pt x="0" y="120527"/>
                  </a:lnTo>
                  <a:lnTo>
                    <a:pt x="0" y="120946"/>
                  </a:lnTo>
                  <a:lnTo>
                    <a:pt x="0" y="121364"/>
                  </a:lnTo>
                  <a:lnTo>
                    <a:pt x="0" y="121783"/>
                  </a:lnTo>
                  <a:lnTo>
                    <a:pt x="0" y="122201"/>
                  </a:lnTo>
                  <a:lnTo>
                    <a:pt x="0" y="122620"/>
                  </a:lnTo>
                  <a:lnTo>
                    <a:pt x="0" y="123038"/>
                  </a:lnTo>
                  <a:lnTo>
                    <a:pt x="0" y="123457"/>
                  </a:lnTo>
                  <a:lnTo>
                    <a:pt x="0" y="123875"/>
                  </a:lnTo>
                  <a:lnTo>
                    <a:pt x="0" y="124294"/>
                  </a:lnTo>
                  <a:lnTo>
                    <a:pt x="0" y="124712"/>
                  </a:lnTo>
                  <a:lnTo>
                    <a:pt x="0" y="125131"/>
                  </a:lnTo>
                  <a:lnTo>
                    <a:pt x="0" y="125549"/>
                  </a:lnTo>
                  <a:lnTo>
                    <a:pt x="0" y="125968"/>
                  </a:lnTo>
                  <a:lnTo>
                    <a:pt x="0" y="126386"/>
                  </a:lnTo>
                  <a:lnTo>
                    <a:pt x="0" y="126805"/>
                  </a:lnTo>
                  <a:lnTo>
                    <a:pt x="0" y="127223"/>
                  </a:lnTo>
                  <a:lnTo>
                    <a:pt x="0" y="127642"/>
                  </a:lnTo>
                  <a:lnTo>
                    <a:pt x="0" y="128060"/>
                  </a:lnTo>
                  <a:lnTo>
                    <a:pt x="0" y="128479"/>
                  </a:lnTo>
                  <a:lnTo>
                    <a:pt x="0" y="128897"/>
                  </a:lnTo>
                  <a:lnTo>
                    <a:pt x="0" y="129316"/>
                  </a:lnTo>
                  <a:lnTo>
                    <a:pt x="0" y="129734"/>
                  </a:lnTo>
                  <a:lnTo>
                    <a:pt x="0" y="130153"/>
                  </a:lnTo>
                  <a:lnTo>
                    <a:pt x="0" y="130571"/>
                  </a:lnTo>
                  <a:lnTo>
                    <a:pt x="0" y="130990"/>
                  </a:lnTo>
                  <a:lnTo>
                    <a:pt x="0" y="131408"/>
                  </a:lnTo>
                  <a:lnTo>
                    <a:pt x="0" y="131827"/>
                  </a:lnTo>
                  <a:lnTo>
                    <a:pt x="0" y="132245"/>
                  </a:lnTo>
                  <a:lnTo>
                    <a:pt x="0" y="132663"/>
                  </a:lnTo>
                  <a:lnTo>
                    <a:pt x="0" y="133082"/>
                  </a:lnTo>
                  <a:lnTo>
                    <a:pt x="0" y="133500"/>
                  </a:lnTo>
                  <a:lnTo>
                    <a:pt x="0" y="133919"/>
                  </a:lnTo>
                  <a:lnTo>
                    <a:pt x="0" y="134337"/>
                  </a:lnTo>
                  <a:lnTo>
                    <a:pt x="0" y="134756"/>
                  </a:lnTo>
                  <a:lnTo>
                    <a:pt x="0" y="135174"/>
                  </a:lnTo>
                  <a:lnTo>
                    <a:pt x="0" y="135593"/>
                  </a:lnTo>
                  <a:lnTo>
                    <a:pt x="0" y="136011"/>
                  </a:lnTo>
                  <a:lnTo>
                    <a:pt x="0" y="136430"/>
                  </a:lnTo>
                  <a:lnTo>
                    <a:pt x="0" y="136848"/>
                  </a:lnTo>
                  <a:lnTo>
                    <a:pt x="0" y="137267"/>
                  </a:lnTo>
                  <a:lnTo>
                    <a:pt x="0" y="137685"/>
                  </a:lnTo>
                  <a:lnTo>
                    <a:pt x="0" y="138104"/>
                  </a:lnTo>
                  <a:lnTo>
                    <a:pt x="0" y="138522"/>
                  </a:lnTo>
                  <a:lnTo>
                    <a:pt x="0" y="138941"/>
                  </a:lnTo>
                  <a:lnTo>
                    <a:pt x="0" y="139359"/>
                  </a:lnTo>
                  <a:lnTo>
                    <a:pt x="0" y="139778"/>
                  </a:lnTo>
                  <a:lnTo>
                    <a:pt x="0" y="140196"/>
                  </a:lnTo>
                  <a:lnTo>
                    <a:pt x="0" y="140615"/>
                  </a:lnTo>
                  <a:lnTo>
                    <a:pt x="0" y="141033"/>
                  </a:lnTo>
                  <a:lnTo>
                    <a:pt x="0" y="141452"/>
                  </a:lnTo>
                  <a:lnTo>
                    <a:pt x="0" y="141870"/>
                  </a:lnTo>
                  <a:lnTo>
                    <a:pt x="0" y="142289"/>
                  </a:lnTo>
                  <a:lnTo>
                    <a:pt x="0" y="142707"/>
                  </a:lnTo>
                  <a:lnTo>
                    <a:pt x="0" y="143126"/>
                  </a:lnTo>
                  <a:lnTo>
                    <a:pt x="0" y="143544"/>
                  </a:lnTo>
                  <a:lnTo>
                    <a:pt x="0" y="143963"/>
                  </a:lnTo>
                  <a:lnTo>
                    <a:pt x="0" y="144381"/>
                  </a:lnTo>
                  <a:lnTo>
                    <a:pt x="0" y="144800"/>
                  </a:lnTo>
                  <a:lnTo>
                    <a:pt x="1" y="145218"/>
                  </a:lnTo>
                  <a:lnTo>
                    <a:pt x="1" y="145637"/>
                  </a:lnTo>
                  <a:lnTo>
                    <a:pt x="2" y="146055"/>
                  </a:lnTo>
                  <a:lnTo>
                    <a:pt x="3" y="146474"/>
                  </a:lnTo>
                  <a:lnTo>
                    <a:pt x="4" y="146892"/>
                  </a:lnTo>
                  <a:lnTo>
                    <a:pt x="7" y="147311"/>
                  </a:lnTo>
                  <a:lnTo>
                    <a:pt x="10" y="147729"/>
                  </a:lnTo>
                  <a:lnTo>
                    <a:pt x="14" y="148148"/>
                  </a:lnTo>
                  <a:lnTo>
                    <a:pt x="19" y="148566"/>
                  </a:lnTo>
                  <a:lnTo>
                    <a:pt x="27" y="148985"/>
                  </a:lnTo>
                  <a:lnTo>
                    <a:pt x="36" y="149403"/>
                  </a:lnTo>
                  <a:lnTo>
                    <a:pt x="49" y="149822"/>
                  </a:lnTo>
                  <a:lnTo>
                    <a:pt x="65" y="150240"/>
                  </a:lnTo>
                  <a:lnTo>
                    <a:pt x="86" y="150659"/>
                  </a:lnTo>
                  <a:lnTo>
                    <a:pt x="113" y="151077"/>
                  </a:lnTo>
                  <a:lnTo>
                    <a:pt x="145" y="151496"/>
                  </a:lnTo>
                  <a:lnTo>
                    <a:pt x="185" y="151914"/>
                  </a:lnTo>
                  <a:lnTo>
                    <a:pt x="233" y="152333"/>
                  </a:lnTo>
                  <a:lnTo>
                    <a:pt x="290" y="152751"/>
                  </a:lnTo>
                  <a:lnTo>
                    <a:pt x="357" y="153170"/>
                  </a:lnTo>
                  <a:lnTo>
                    <a:pt x="437" y="153588"/>
                  </a:lnTo>
                  <a:lnTo>
                    <a:pt x="529" y="154007"/>
                  </a:lnTo>
                  <a:lnTo>
                    <a:pt x="633" y="154425"/>
                  </a:lnTo>
                  <a:lnTo>
                    <a:pt x="750" y="154844"/>
                  </a:lnTo>
                  <a:lnTo>
                    <a:pt x="878" y="155262"/>
                  </a:lnTo>
                  <a:lnTo>
                    <a:pt x="1017" y="155681"/>
                  </a:lnTo>
                  <a:lnTo>
                    <a:pt x="1168" y="156099"/>
                  </a:lnTo>
                  <a:lnTo>
                    <a:pt x="1327" y="156518"/>
                  </a:lnTo>
                  <a:lnTo>
                    <a:pt x="1495" y="156936"/>
                  </a:lnTo>
                  <a:lnTo>
                    <a:pt x="1667" y="157355"/>
                  </a:lnTo>
                  <a:lnTo>
                    <a:pt x="1841" y="157773"/>
                  </a:lnTo>
                  <a:lnTo>
                    <a:pt x="2014" y="158192"/>
                  </a:lnTo>
                  <a:lnTo>
                    <a:pt x="2184" y="158610"/>
                  </a:lnTo>
                  <a:lnTo>
                    <a:pt x="2347" y="159029"/>
                  </a:lnTo>
                  <a:lnTo>
                    <a:pt x="2501" y="159447"/>
                  </a:lnTo>
                  <a:lnTo>
                    <a:pt x="2644" y="159866"/>
                  </a:lnTo>
                  <a:lnTo>
                    <a:pt x="2770" y="160284"/>
                  </a:lnTo>
                  <a:lnTo>
                    <a:pt x="2879" y="160703"/>
                  </a:lnTo>
                  <a:lnTo>
                    <a:pt x="2971" y="161121"/>
                  </a:lnTo>
                  <a:lnTo>
                    <a:pt x="3045" y="161540"/>
                  </a:lnTo>
                  <a:lnTo>
                    <a:pt x="3099" y="161958"/>
                  </a:lnTo>
                  <a:lnTo>
                    <a:pt x="3135" y="162377"/>
                  </a:lnTo>
                  <a:lnTo>
                    <a:pt x="3153" y="162795"/>
                  </a:lnTo>
                  <a:lnTo>
                    <a:pt x="3152" y="163214"/>
                  </a:lnTo>
                  <a:lnTo>
                    <a:pt x="3133" y="163632"/>
                  </a:lnTo>
                  <a:lnTo>
                    <a:pt x="3100" y="164051"/>
                  </a:lnTo>
                  <a:lnTo>
                    <a:pt x="3052" y="164469"/>
                  </a:lnTo>
                  <a:lnTo>
                    <a:pt x="2993" y="164888"/>
                  </a:lnTo>
                  <a:lnTo>
                    <a:pt x="2922" y="165306"/>
                  </a:lnTo>
                  <a:lnTo>
                    <a:pt x="2841" y="165725"/>
                  </a:lnTo>
                  <a:lnTo>
                    <a:pt x="2751" y="166143"/>
                  </a:lnTo>
                  <a:lnTo>
                    <a:pt x="2653" y="166562"/>
                  </a:lnTo>
                  <a:lnTo>
                    <a:pt x="2546" y="166980"/>
                  </a:lnTo>
                  <a:lnTo>
                    <a:pt x="2432" y="167399"/>
                  </a:lnTo>
                  <a:lnTo>
                    <a:pt x="2312" y="167817"/>
                  </a:lnTo>
                  <a:lnTo>
                    <a:pt x="2186" y="168236"/>
                  </a:lnTo>
                  <a:lnTo>
                    <a:pt x="2056" y="168654"/>
                  </a:lnTo>
                  <a:lnTo>
                    <a:pt x="1921" y="169073"/>
                  </a:lnTo>
                  <a:lnTo>
                    <a:pt x="1784" y="169491"/>
                  </a:lnTo>
                  <a:lnTo>
                    <a:pt x="1644" y="169910"/>
                  </a:lnTo>
                  <a:lnTo>
                    <a:pt x="1505" y="170328"/>
                  </a:lnTo>
                  <a:lnTo>
                    <a:pt x="1366" y="170747"/>
                  </a:lnTo>
                  <a:lnTo>
                    <a:pt x="1230" y="171165"/>
                  </a:lnTo>
                  <a:lnTo>
                    <a:pt x="1099" y="171584"/>
                  </a:lnTo>
                  <a:lnTo>
                    <a:pt x="972" y="172002"/>
                  </a:lnTo>
                  <a:lnTo>
                    <a:pt x="852" y="172421"/>
                  </a:lnTo>
                  <a:lnTo>
                    <a:pt x="739" y="172839"/>
                  </a:lnTo>
                  <a:lnTo>
                    <a:pt x="635" y="173258"/>
                  </a:lnTo>
                  <a:lnTo>
                    <a:pt x="541" y="173676"/>
                  </a:lnTo>
                  <a:lnTo>
                    <a:pt x="457" y="174095"/>
                  </a:lnTo>
                  <a:lnTo>
                    <a:pt x="381" y="174513"/>
                  </a:lnTo>
                  <a:lnTo>
                    <a:pt x="314" y="174932"/>
                  </a:lnTo>
                  <a:lnTo>
                    <a:pt x="256" y="175350"/>
                  </a:lnTo>
                  <a:lnTo>
                    <a:pt x="207" y="175769"/>
                  </a:lnTo>
                  <a:lnTo>
                    <a:pt x="165" y="176187"/>
                  </a:lnTo>
                  <a:lnTo>
                    <a:pt x="130" y="176606"/>
                  </a:lnTo>
                  <a:lnTo>
                    <a:pt x="102" y="177024"/>
                  </a:lnTo>
                  <a:lnTo>
                    <a:pt x="79" y="177443"/>
                  </a:lnTo>
                  <a:lnTo>
                    <a:pt x="60" y="177861"/>
                  </a:lnTo>
                  <a:lnTo>
                    <a:pt x="45" y="178280"/>
                  </a:lnTo>
                  <a:lnTo>
                    <a:pt x="34" y="178698"/>
                  </a:lnTo>
                  <a:lnTo>
                    <a:pt x="25" y="179117"/>
                  </a:lnTo>
                  <a:lnTo>
                    <a:pt x="18" y="179535"/>
                  </a:lnTo>
                  <a:lnTo>
                    <a:pt x="13" y="179954"/>
                  </a:lnTo>
                  <a:lnTo>
                    <a:pt x="9" y="180372"/>
                  </a:lnTo>
                  <a:lnTo>
                    <a:pt x="6" y="180791"/>
                  </a:lnTo>
                  <a:lnTo>
                    <a:pt x="4" y="181209"/>
                  </a:lnTo>
                  <a:lnTo>
                    <a:pt x="3" y="181628"/>
                  </a:lnTo>
                  <a:lnTo>
                    <a:pt x="2" y="182046"/>
                  </a:lnTo>
                  <a:lnTo>
                    <a:pt x="1" y="182465"/>
                  </a:lnTo>
                  <a:lnTo>
                    <a:pt x="0" y="182883"/>
                  </a:lnTo>
                  <a:lnTo>
                    <a:pt x="0" y="183302"/>
                  </a:lnTo>
                  <a:lnTo>
                    <a:pt x="0" y="183720"/>
                  </a:lnTo>
                  <a:lnTo>
                    <a:pt x="0" y="184139"/>
                  </a:lnTo>
                  <a:lnTo>
                    <a:pt x="0" y="184557"/>
                  </a:lnTo>
                  <a:lnTo>
                    <a:pt x="0" y="184976"/>
                  </a:lnTo>
                  <a:lnTo>
                    <a:pt x="0" y="185394"/>
                  </a:lnTo>
                  <a:lnTo>
                    <a:pt x="0" y="185813"/>
                  </a:lnTo>
                  <a:lnTo>
                    <a:pt x="0" y="186231"/>
                  </a:lnTo>
                  <a:lnTo>
                    <a:pt x="0" y="186650"/>
                  </a:lnTo>
                  <a:lnTo>
                    <a:pt x="0" y="187068"/>
                  </a:lnTo>
                  <a:lnTo>
                    <a:pt x="1" y="187487"/>
                  </a:lnTo>
                  <a:lnTo>
                    <a:pt x="1" y="187905"/>
                  </a:lnTo>
                  <a:lnTo>
                    <a:pt x="2" y="188324"/>
                  </a:lnTo>
                  <a:lnTo>
                    <a:pt x="3" y="188742"/>
                  </a:lnTo>
                  <a:lnTo>
                    <a:pt x="5" y="189161"/>
                  </a:lnTo>
                  <a:lnTo>
                    <a:pt x="7" y="189579"/>
                  </a:lnTo>
                  <a:lnTo>
                    <a:pt x="10" y="189998"/>
                  </a:lnTo>
                  <a:lnTo>
                    <a:pt x="14" y="190416"/>
                  </a:lnTo>
                  <a:lnTo>
                    <a:pt x="20" y="190835"/>
                  </a:lnTo>
                  <a:lnTo>
                    <a:pt x="27" y="191253"/>
                  </a:lnTo>
                  <a:lnTo>
                    <a:pt x="36" y="191672"/>
                  </a:lnTo>
                  <a:lnTo>
                    <a:pt x="48" y="192090"/>
                  </a:lnTo>
                  <a:lnTo>
                    <a:pt x="63" y="192509"/>
                  </a:lnTo>
                  <a:lnTo>
                    <a:pt x="82" y="192927"/>
                  </a:lnTo>
                  <a:lnTo>
                    <a:pt x="106" y="193346"/>
                  </a:lnTo>
                  <a:lnTo>
                    <a:pt x="136" y="193764"/>
                  </a:lnTo>
                  <a:lnTo>
                    <a:pt x="171" y="194183"/>
                  </a:lnTo>
                  <a:lnTo>
                    <a:pt x="212" y="194601"/>
                  </a:lnTo>
                  <a:lnTo>
                    <a:pt x="260" y="195020"/>
                  </a:lnTo>
                  <a:lnTo>
                    <a:pt x="315" y="195438"/>
                  </a:lnTo>
                  <a:lnTo>
                    <a:pt x="378" y="195857"/>
                  </a:lnTo>
                  <a:lnTo>
                    <a:pt x="448" y="196275"/>
                  </a:lnTo>
                  <a:lnTo>
                    <a:pt x="525" y="196694"/>
                  </a:lnTo>
                  <a:lnTo>
                    <a:pt x="609" y="197112"/>
                  </a:lnTo>
                  <a:lnTo>
                    <a:pt x="697" y="197531"/>
                  </a:lnTo>
                  <a:lnTo>
                    <a:pt x="789" y="197949"/>
                  </a:lnTo>
                  <a:lnTo>
                    <a:pt x="883" y="198368"/>
                  </a:lnTo>
                  <a:lnTo>
                    <a:pt x="977" y="198786"/>
                  </a:lnTo>
                  <a:lnTo>
                    <a:pt x="1068" y="199205"/>
                  </a:lnTo>
                  <a:lnTo>
                    <a:pt x="1154" y="199623"/>
                  </a:lnTo>
                  <a:lnTo>
                    <a:pt x="1233" y="200042"/>
                  </a:lnTo>
                  <a:lnTo>
                    <a:pt x="1301" y="200460"/>
                  </a:lnTo>
                  <a:lnTo>
                    <a:pt x="1358" y="200879"/>
                  </a:lnTo>
                  <a:lnTo>
                    <a:pt x="1401" y="201297"/>
                  </a:lnTo>
                  <a:lnTo>
                    <a:pt x="1430" y="201716"/>
                  </a:lnTo>
                  <a:lnTo>
                    <a:pt x="1442" y="202134"/>
                  </a:lnTo>
                  <a:lnTo>
                    <a:pt x="1438" y="202553"/>
                  </a:lnTo>
                  <a:lnTo>
                    <a:pt x="1417" y="202971"/>
                  </a:lnTo>
                  <a:lnTo>
                    <a:pt x="1379" y="203390"/>
                  </a:lnTo>
                  <a:lnTo>
                    <a:pt x="1327" y="203808"/>
                  </a:lnTo>
                  <a:lnTo>
                    <a:pt x="1263" y="204227"/>
                  </a:lnTo>
                  <a:lnTo>
                    <a:pt x="1188" y="204645"/>
                  </a:lnTo>
                  <a:lnTo>
                    <a:pt x="1105" y="205064"/>
                  </a:lnTo>
                  <a:lnTo>
                    <a:pt x="1016" y="205482"/>
                  </a:lnTo>
                  <a:lnTo>
                    <a:pt x="923" y="205901"/>
                  </a:lnTo>
                  <a:lnTo>
                    <a:pt x="829" y="206319"/>
                  </a:lnTo>
                  <a:lnTo>
                    <a:pt x="736" y="206738"/>
                  </a:lnTo>
                  <a:lnTo>
                    <a:pt x="646" y="207156"/>
                  </a:lnTo>
                  <a:lnTo>
                    <a:pt x="560" y="207575"/>
                  </a:lnTo>
                  <a:lnTo>
                    <a:pt x="481" y="207993"/>
                  </a:lnTo>
                  <a:lnTo>
                    <a:pt x="407" y="208412"/>
                  </a:lnTo>
                  <a:lnTo>
                    <a:pt x="341" y="208830"/>
                  </a:lnTo>
                  <a:lnTo>
                    <a:pt x="282" y="209249"/>
                  </a:lnTo>
                  <a:lnTo>
                    <a:pt x="231" y="209667"/>
                  </a:lnTo>
                  <a:lnTo>
                    <a:pt x="187" y="210086"/>
                  </a:lnTo>
                  <a:lnTo>
                    <a:pt x="150" y="210504"/>
                  </a:lnTo>
                  <a:lnTo>
                    <a:pt x="118" y="210923"/>
                  </a:lnTo>
                  <a:lnTo>
                    <a:pt x="92" y="211341"/>
                  </a:lnTo>
                  <a:lnTo>
                    <a:pt x="71" y="211760"/>
                  </a:lnTo>
                  <a:lnTo>
                    <a:pt x="54" y="212178"/>
                  </a:lnTo>
                  <a:lnTo>
                    <a:pt x="41" y="212597"/>
                  </a:lnTo>
                  <a:lnTo>
                    <a:pt x="30" y="213015"/>
                  </a:lnTo>
                  <a:lnTo>
                    <a:pt x="22" y="213434"/>
                  </a:lnTo>
                  <a:lnTo>
                    <a:pt x="16" y="213852"/>
                  </a:lnTo>
                  <a:lnTo>
                    <a:pt x="0" y="213852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66" name="pl48"/>
            <p:cNvSpPr/>
            <p:nvPr/>
          </p:nvSpPr>
          <p:spPr>
            <a:xfrm>
              <a:off x="6577114" y="3795478"/>
              <a:ext cx="33695" cy="6281"/>
            </a:xfrm>
            <a:custGeom>
              <a:avLst/>
              <a:gdLst/>
              <a:ahLst/>
              <a:cxnLst/>
              <a:rect l="0" t="0" r="0" b="0"/>
              <a:pathLst>
                <a:path w="33695" h="6281">
                  <a:moveTo>
                    <a:pt x="33695" y="6281"/>
                  </a:moveTo>
                  <a:lnTo>
                    <a:pt x="33316" y="6281"/>
                  </a:lnTo>
                  <a:lnTo>
                    <a:pt x="33295" y="6269"/>
                  </a:lnTo>
                  <a:lnTo>
                    <a:pt x="33272" y="6257"/>
                  </a:lnTo>
                  <a:lnTo>
                    <a:pt x="33249" y="6245"/>
                  </a:lnTo>
                  <a:lnTo>
                    <a:pt x="33224" y="6232"/>
                  </a:lnTo>
                  <a:lnTo>
                    <a:pt x="33199" y="6220"/>
                  </a:lnTo>
                  <a:lnTo>
                    <a:pt x="33171" y="6208"/>
                  </a:lnTo>
                  <a:lnTo>
                    <a:pt x="33143" y="6195"/>
                  </a:lnTo>
                  <a:lnTo>
                    <a:pt x="33113" y="6183"/>
                  </a:lnTo>
                  <a:lnTo>
                    <a:pt x="33082" y="6171"/>
                  </a:lnTo>
                  <a:lnTo>
                    <a:pt x="33049" y="6159"/>
                  </a:lnTo>
                  <a:lnTo>
                    <a:pt x="33015" y="6146"/>
                  </a:lnTo>
                  <a:lnTo>
                    <a:pt x="32979" y="6134"/>
                  </a:lnTo>
                  <a:lnTo>
                    <a:pt x="32941" y="6122"/>
                  </a:lnTo>
                  <a:lnTo>
                    <a:pt x="32902" y="6109"/>
                  </a:lnTo>
                  <a:lnTo>
                    <a:pt x="32861" y="6097"/>
                  </a:lnTo>
                  <a:lnTo>
                    <a:pt x="32819" y="6085"/>
                  </a:lnTo>
                  <a:lnTo>
                    <a:pt x="32774" y="6072"/>
                  </a:lnTo>
                  <a:lnTo>
                    <a:pt x="32728" y="6060"/>
                  </a:lnTo>
                  <a:lnTo>
                    <a:pt x="32679" y="6048"/>
                  </a:lnTo>
                  <a:lnTo>
                    <a:pt x="32629" y="6036"/>
                  </a:lnTo>
                  <a:lnTo>
                    <a:pt x="32576" y="6023"/>
                  </a:lnTo>
                  <a:lnTo>
                    <a:pt x="32521" y="6011"/>
                  </a:lnTo>
                  <a:lnTo>
                    <a:pt x="32464" y="5999"/>
                  </a:lnTo>
                  <a:lnTo>
                    <a:pt x="32404" y="5986"/>
                  </a:lnTo>
                  <a:lnTo>
                    <a:pt x="32342" y="5974"/>
                  </a:lnTo>
                  <a:lnTo>
                    <a:pt x="32278" y="5962"/>
                  </a:lnTo>
                  <a:lnTo>
                    <a:pt x="32211" y="5950"/>
                  </a:lnTo>
                  <a:lnTo>
                    <a:pt x="32141" y="5937"/>
                  </a:lnTo>
                  <a:lnTo>
                    <a:pt x="32070" y="5925"/>
                  </a:lnTo>
                  <a:lnTo>
                    <a:pt x="31993" y="5913"/>
                  </a:lnTo>
                  <a:lnTo>
                    <a:pt x="31916" y="5900"/>
                  </a:lnTo>
                  <a:lnTo>
                    <a:pt x="31834" y="5888"/>
                  </a:lnTo>
                  <a:lnTo>
                    <a:pt x="31751" y="5876"/>
                  </a:lnTo>
                  <a:lnTo>
                    <a:pt x="31663" y="5863"/>
                  </a:lnTo>
                  <a:lnTo>
                    <a:pt x="31573" y="5851"/>
                  </a:lnTo>
                  <a:lnTo>
                    <a:pt x="31480" y="5839"/>
                  </a:lnTo>
                  <a:lnTo>
                    <a:pt x="31383" y="5827"/>
                  </a:lnTo>
                  <a:lnTo>
                    <a:pt x="31283" y="5814"/>
                  </a:lnTo>
                  <a:lnTo>
                    <a:pt x="31178" y="5802"/>
                  </a:lnTo>
                  <a:lnTo>
                    <a:pt x="31072" y="5790"/>
                  </a:lnTo>
                  <a:lnTo>
                    <a:pt x="30960" y="5777"/>
                  </a:lnTo>
                  <a:lnTo>
                    <a:pt x="30847" y="5765"/>
                  </a:lnTo>
                  <a:lnTo>
                    <a:pt x="30726" y="5753"/>
                  </a:lnTo>
                  <a:lnTo>
                    <a:pt x="30605" y="5741"/>
                  </a:lnTo>
                  <a:lnTo>
                    <a:pt x="30477" y="5728"/>
                  </a:lnTo>
                  <a:lnTo>
                    <a:pt x="30348" y="5716"/>
                  </a:lnTo>
                  <a:lnTo>
                    <a:pt x="30213" y="5704"/>
                  </a:lnTo>
                  <a:lnTo>
                    <a:pt x="30074" y="5691"/>
                  </a:lnTo>
                  <a:lnTo>
                    <a:pt x="29931" y="5679"/>
                  </a:lnTo>
                  <a:lnTo>
                    <a:pt x="29783" y="5667"/>
                  </a:lnTo>
                  <a:lnTo>
                    <a:pt x="29632" y="5654"/>
                  </a:lnTo>
                  <a:lnTo>
                    <a:pt x="29475" y="5642"/>
                  </a:lnTo>
                  <a:lnTo>
                    <a:pt x="29316" y="5630"/>
                  </a:lnTo>
                  <a:lnTo>
                    <a:pt x="29149" y="5618"/>
                  </a:lnTo>
                  <a:lnTo>
                    <a:pt x="28981" y="5605"/>
                  </a:lnTo>
                  <a:lnTo>
                    <a:pt x="28804" y="5593"/>
                  </a:lnTo>
                  <a:lnTo>
                    <a:pt x="28626" y="5581"/>
                  </a:lnTo>
                  <a:lnTo>
                    <a:pt x="28441" y="5568"/>
                  </a:lnTo>
                  <a:lnTo>
                    <a:pt x="28252" y="5556"/>
                  </a:lnTo>
                  <a:lnTo>
                    <a:pt x="28058" y="5544"/>
                  </a:lnTo>
                  <a:lnTo>
                    <a:pt x="27859" y="5532"/>
                  </a:lnTo>
                  <a:lnTo>
                    <a:pt x="27656" y="5519"/>
                  </a:lnTo>
                  <a:lnTo>
                    <a:pt x="27446" y="5507"/>
                  </a:lnTo>
                  <a:lnTo>
                    <a:pt x="27234" y="5495"/>
                  </a:lnTo>
                  <a:lnTo>
                    <a:pt x="27014" y="5482"/>
                  </a:lnTo>
                  <a:lnTo>
                    <a:pt x="26792" y="5470"/>
                  </a:lnTo>
                  <a:lnTo>
                    <a:pt x="26561" y="5458"/>
                  </a:lnTo>
                  <a:lnTo>
                    <a:pt x="26328" y="5446"/>
                  </a:lnTo>
                  <a:lnTo>
                    <a:pt x="26087" y="5433"/>
                  </a:lnTo>
                  <a:lnTo>
                    <a:pt x="25844" y="5421"/>
                  </a:lnTo>
                  <a:lnTo>
                    <a:pt x="25594" y="5409"/>
                  </a:lnTo>
                  <a:lnTo>
                    <a:pt x="25339" y="5396"/>
                  </a:lnTo>
                  <a:lnTo>
                    <a:pt x="25080" y="5384"/>
                  </a:lnTo>
                  <a:lnTo>
                    <a:pt x="24815" y="5372"/>
                  </a:lnTo>
                  <a:lnTo>
                    <a:pt x="24546" y="5359"/>
                  </a:lnTo>
                  <a:lnTo>
                    <a:pt x="24270" y="5347"/>
                  </a:lnTo>
                  <a:lnTo>
                    <a:pt x="23992" y="5335"/>
                  </a:lnTo>
                  <a:lnTo>
                    <a:pt x="23706" y="5323"/>
                  </a:lnTo>
                  <a:lnTo>
                    <a:pt x="23419" y="5310"/>
                  </a:lnTo>
                  <a:lnTo>
                    <a:pt x="23123" y="5298"/>
                  </a:lnTo>
                  <a:lnTo>
                    <a:pt x="22825" y="5286"/>
                  </a:lnTo>
                  <a:lnTo>
                    <a:pt x="22520" y="5273"/>
                  </a:lnTo>
                  <a:lnTo>
                    <a:pt x="22213" y="5261"/>
                  </a:lnTo>
                  <a:lnTo>
                    <a:pt x="21900" y="5249"/>
                  </a:lnTo>
                  <a:lnTo>
                    <a:pt x="21583" y="5237"/>
                  </a:lnTo>
                  <a:lnTo>
                    <a:pt x="21262" y="5224"/>
                  </a:lnTo>
                  <a:lnTo>
                    <a:pt x="20936" y="5212"/>
                  </a:lnTo>
                  <a:lnTo>
                    <a:pt x="20607" y="5200"/>
                  </a:lnTo>
                  <a:lnTo>
                    <a:pt x="20273" y="5187"/>
                  </a:lnTo>
                  <a:lnTo>
                    <a:pt x="19937" y="5175"/>
                  </a:lnTo>
                  <a:lnTo>
                    <a:pt x="19594" y="5163"/>
                  </a:lnTo>
                  <a:lnTo>
                    <a:pt x="19251" y="5150"/>
                  </a:lnTo>
                  <a:lnTo>
                    <a:pt x="18902" y="5138"/>
                  </a:lnTo>
                  <a:lnTo>
                    <a:pt x="18551" y="5126"/>
                  </a:lnTo>
                  <a:lnTo>
                    <a:pt x="18196" y="5114"/>
                  </a:lnTo>
                  <a:lnTo>
                    <a:pt x="17839" y="5101"/>
                  </a:lnTo>
                  <a:lnTo>
                    <a:pt x="17479" y="5089"/>
                  </a:lnTo>
                  <a:lnTo>
                    <a:pt x="17117" y="5077"/>
                  </a:lnTo>
                  <a:lnTo>
                    <a:pt x="16752" y="5064"/>
                  </a:lnTo>
                  <a:lnTo>
                    <a:pt x="16385" y="5052"/>
                  </a:lnTo>
                  <a:lnTo>
                    <a:pt x="16016" y="5040"/>
                  </a:lnTo>
                  <a:lnTo>
                    <a:pt x="15645" y="5028"/>
                  </a:lnTo>
                  <a:lnTo>
                    <a:pt x="15274" y="5015"/>
                  </a:lnTo>
                  <a:lnTo>
                    <a:pt x="14900" y="5003"/>
                  </a:lnTo>
                  <a:lnTo>
                    <a:pt x="14525" y="4991"/>
                  </a:lnTo>
                  <a:lnTo>
                    <a:pt x="14150" y="4978"/>
                  </a:lnTo>
                  <a:lnTo>
                    <a:pt x="13774" y="4966"/>
                  </a:lnTo>
                  <a:lnTo>
                    <a:pt x="13398" y="4954"/>
                  </a:lnTo>
                  <a:lnTo>
                    <a:pt x="13021" y="4941"/>
                  </a:lnTo>
                  <a:lnTo>
                    <a:pt x="12645" y="4929"/>
                  </a:lnTo>
                  <a:lnTo>
                    <a:pt x="12269" y="4917"/>
                  </a:lnTo>
                  <a:lnTo>
                    <a:pt x="11894" y="4905"/>
                  </a:lnTo>
                  <a:lnTo>
                    <a:pt x="11520" y="4892"/>
                  </a:lnTo>
                  <a:lnTo>
                    <a:pt x="11147" y="4880"/>
                  </a:lnTo>
                  <a:lnTo>
                    <a:pt x="10776" y="4868"/>
                  </a:lnTo>
                  <a:lnTo>
                    <a:pt x="10406" y="4855"/>
                  </a:lnTo>
                  <a:lnTo>
                    <a:pt x="10039" y="4843"/>
                  </a:lnTo>
                  <a:lnTo>
                    <a:pt x="9673" y="4831"/>
                  </a:lnTo>
                  <a:lnTo>
                    <a:pt x="9311" y="4819"/>
                  </a:lnTo>
                  <a:lnTo>
                    <a:pt x="8951" y="4806"/>
                  </a:lnTo>
                  <a:lnTo>
                    <a:pt x="8595" y="4794"/>
                  </a:lnTo>
                  <a:lnTo>
                    <a:pt x="8242" y="4782"/>
                  </a:lnTo>
                  <a:lnTo>
                    <a:pt x="7893" y="4769"/>
                  </a:lnTo>
                  <a:lnTo>
                    <a:pt x="7548" y="4757"/>
                  </a:lnTo>
                  <a:lnTo>
                    <a:pt x="7207" y="4745"/>
                  </a:lnTo>
                  <a:lnTo>
                    <a:pt x="6872" y="4732"/>
                  </a:lnTo>
                  <a:lnTo>
                    <a:pt x="6539" y="4720"/>
                  </a:lnTo>
                  <a:lnTo>
                    <a:pt x="6215" y="4708"/>
                  </a:lnTo>
                  <a:lnTo>
                    <a:pt x="5893" y="4696"/>
                  </a:lnTo>
                  <a:lnTo>
                    <a:pt x="5581" y="4683"/>
                  </a:lnTo>
                  <a:lnTo>
                    <a:pt x="5271" y="4671"/>
                  </a:lnTo>
                  <a:lnTo>
                    <a:pt x="4970" y="4659"/>
                  </a:lnTo>
                  <a:lnTo>
                    <a:pt x="4674" y="4646"/>
                  </a:lnTo>
                  <a:lnTo>
                    <a:pt x="4386" y="4634"/>
                  </a:lnTo>
                  <a:lnTo>
                    <a:pt x="4105" y="4622"/>
                  </a:lnTo>
                  <a:lnTo>
                    <a:pt x="3830" y="4610"/>
                  </a:lnTo>
                  <a:lnTo>
                    <a:pt x="3565" y="4597"/>
                  </a:lnTo>
                  <a:lnTo>
                    <a:pt x="3305" y="4585"/>
                  </a:lnTo>
                  <a:lnTo>
                    <a:pt x="3057" y="4573"/>
                  </a:lnTo>
                  <a:lnTo>
                    <a:pt x="2812" y="4560"/>
                  </a:lnTo>
                  <a:lnTo>
                    <a:pt x="2583" y="4548"/>
                  </a:lnTo>
                  <a:lnTo>
                    <a:pt x="2356" y="4536"/>
                  </a:lnTo>
                  <a:lnTo>
                    <a:pt x="2143" y="4523"/>
                  </a:lnTo>
                  <a:lnTo>
                    <a:pt x="1936" y="4511"/>
                  </a:lnTo>
                  <a:lnTo>
                    <a:pt x="1741" y="4499"/>
                  </a:lnTo>
                  <a:lnTo>
                    <a:pt x="1554" y="4487"/>
                  </a:lnTo>
                  <a:lnTo>
                    <a:pt x="1377" y="4474"/>
                  </a:lnTo>
                  <a:lnTo>
                    <a:pt x="1211" y="4462"/>
                  </a:lnTo>
                  <a:lnTo>
                    <a:pt x="1053" y="4450"/>
                  </a:lnTo>
                  <a:lnTo>
                    <a:pt x="909" y="4437"/>
                  </a:lnTo>
                  <a:lnTo>
                    <a:pt x="769" y="4425"/>
                  </a:lnTo>
                  <a:lnTo>
                    <a:pt x="648" y="4413"/>
                  </a:lnTo>
                  <a:lnTo>
                    <a:pt x="530" y="4401"/>
                  </a:lnTo>
                  <a:lnTo>
                    <a:pt x="430" y="4388"/>
                  </a:lnTo>
                  <a:lnTo>
                    <a:pt x="335" y="4376"/>
                  </a:lnTo>
                  <a:lnTo>
                    <a:pt x="256" y="4364"/>
                  </a:lnTo>
                  <a:lnTo>
                    <a:pt x="185" y="4351"/>
                  </a:lnTo>
                  <a:lnTo>
                    <a:pt x="126" y="4339"/>
                  </a:lnTo>
                  <a:lnTo>
                    <a:pt x="78" y="4327"/>
                  </a:lnTo>
                  <a:lnTo>
                    <a:pt x="40" y="4315"/>
                  </a:lnTo>
                  <a:lnTo>
                    <a:pt x="17" y="4302"/>
                  </a:lnTo>
                  <a:lnTo>
                    <a:pt x="0" y="4290"/>
                  </a:lnTo>
                  <a:lnTo>
                    <a:pt x="0" y="4278"/>
                  </a:lnTo>
                  <a:lnTo>
                    <a:pt x="4" y="4265"/>
                  </a:lnTo>
                  <a:lnTo>
                    <a:pt x="29" y="4253"/>
                  </a:lnTo>
                  <a:lnTo>
                    <a:pt x="57" y="4241"/>
                  </a:lnTo>
                  <a:lnTo>
                    <a:pt x="103" y="4228"/>
                  </a:lnTo>
                  <a:lnTo>
                    <a:pt x="154" y="4216"/>
                  </a:lnTo>
                  <a:lnTo>
                    <a:pt x="221" y="4204"/>
                  </a:lnTo>
                  <a:lnTo>
                    <a:pt x="296" y="4192"/>
                  </a:lnTo>
                  <a:lnTo>
                    <a:pt x="383" y="4179"/>
                  </a:lnTo>
                  <a:lnTo>
                    <a:pt x="482" y="4167"/>
                  </a:lnTo>
                  <a:lnTo>
                    <a:pt x="589" y="4155"/>
                  </a:lnTo>
                  <a:lnTo>
                    <a:pt x="710" y="4142"/>
                  </a:lnTo>
                  <a:lnTo>
                    <a:pt x="837" y="4130"/>
                  </a:lnTo>
                  <a:lnTo>
                    <a:pt x="981" y="4118"/>
                  </a:lnTo>
                  <a:lnTo>
                    <a:pt x="1127" y="4106"/>
                  </a:lnTo>
                  <a:lnTo>
                    <a:pt x="1292" y="4093"/>
                  </a:lnTo>
                  <a:lnTo>
                    <a:pt x="1460" y="4081"/>
                  </a:lnTo>
                  <a:lnTo>
                    <a:pt x="1642" y="4069"/>
                  </a:lnTo>
                  <a:lnTo>
                    <a:pt x="1831" y="4056"/>
                  </a:lnTo>
                  <a:lnTo>
                    <a:pt x="2031" y="4044"/>
                  </a:lnTo>
                  <a:lnTo>
                    <a:pt x="2239" y="4032"/>
                  </a:lnTo>
                  <a:lnTo>
                    <a:pt x="2455" y="4019"/>
                  </a:lnTo>
                  <a:lnTo>
                    <a:pt x="2683" y="4007"/>
                  </a:lnTo>
                  <a:lnTo>
                    <a:pt x="2915" y="3995"/>
                  </a:lnTo>
                  <a:lnTo>
                    <a:pt x="3160" y="3983"/>
                  </a:lnTo>
                  <a:lnTo>
                    <a:pt x="3407" y="3970"/>
                  </a:lnTo>
                  <a:lnTo>
                    <a:pt x="3669" y="3958"/>
                  </a:lnTo>
                  <a:lnTo>
                    <a:pt x="3932" y="3946"/>
                  </a:lnTo>
                  <a:lnTo>
                    <a:pt x="4207" y="3933"/>
                  </a:lnTo>
                  <a:lnTo>
                    <a:pt x="4486" y="3921"/>
                  </a:lnTo>
                  <a:lnTo>
                    <a:pt x="4773" y="3909"/>
                  </a:lnTo>
                  <a:lnTo>
                    <a:pt x="5066" y="3897"/>
                  </a:lnTo>
                  <a:lnTo>
                    <a:pt x="5365" y="3884"/>
                  </a:lnTo>
                  <a:lnTo>
                    <a:pt x="5670" y="3872"/>
                  </a:lnTo>
                  <a:lnTo>
                    <a:pt x="5979" y="3860"/>
                  </a:lnTo>
                  <a:lnTo>
                    <a:pt x="6296" y="3847"/>
                  </a:lnTo>
                  <a:lnTo>
                    <a:pt x="6615" y="3835"/>
                  </a:lnTo>
                  <a:lnTo>
                    <a:pt x="6941" y="3823"/>
                  </a:lnTo>
                  <a:lnTo>
                    <a:pt x="7269" y="3810"/>
                  </a:lnTo>
                  <a:lnTo>
                    <a:pt x="7603" y="3798"/>
                  </a:lnTo>
                  <a:lnTo>
                    <a:pt x="7939" y="3786"/>
                  </a:lnTo>
                  <a:lnTo>
                    <a:pt x="8281" y="3774"/>
                  </a:lnTo>
                  <a:lnTo>
                    <a:pt x="8623" y="3761"/>
                  </a:lnTo>
                  <a:lnTo>
                    <a:pt x="8970" y="3749"/>
                  </a:lnTo>
                  <a:lnTo>
                    <a:pt x="9318" y="3737"/>
                  </a:lnTo>
                  <a:lnTo>
                    <a:pt x="9669" y="3724"/>
                  </a:lnTo>
                  <a:lnTo>
                    <a:pt x="10022" y="3712"/>
                  </a:lnTo>
                  <a:lnTo>
                    <a:pt x="10376" y="3700"/>
                  </a:lnTo>
                  <a:lnTo>
                    <a:pt x="10731" y="3688"/>
                  </a:lnTo>
                  <a:lnTo>
                    <a:pt x="11087" y="3675"/>
                  </a:lnTo>
                  <a:lnTo>
                    <a:pt x="11445" y="3663"/>
                  </a:lnTo>
                  <a:lnTo>
                    <a:pt x="11802" y="3651"/>
                  </a:lnTo>
                  <a:lnTo>
                    <a:pt x="12159" y="3638"/>
                  </a:lnTo>
                  <a:lnTo>
                    <a:pt x="12516" y="3626"/>
                  </a:lnTo>
                  <a:lnTo>
                    <a:pt x="12873" y="3614"/>
                  </a:lnTo>
                  <a:lnTo>
                    <a:pt x="13229" y="3601"/>
                  </a:lnTo>
                  <a:lnTo>
                    <a:pt x="13584" y="3589"/>
                  </a:lnTo>
                  <a:lnTo>
                    <a:pt x="13937" y="3577"/>
                  </a:lnTo>
                  <a:lnTo>
                    <a:pt x="14289" y="3565"/>
                  </a:lnTo>
                  <a:lnTo>
                    <a:pt x="14639" y="3552"/>
                  </a:lnTo>
                  <a:lnTo>
                    <a:pt x="14988" y="3540"/>
                  </a:lnTo>
                  <a:lnTo>
                    <a:pt x="15333" y="3528"/>
                  </a:lnTo>
                  <a:lnTo>
                    <a:pt x="15677" y="3515"/>
                  </a:lnTo>
                  <a:lnTo>
                    <a:pt x="16016" y="3503"/>
                  </a:lnTo>
                  <a:lnTo>
                    <a:pt x="16355" y="3491"/>
                  </a:lnTo>
                  <a:lnTo>
                    <a:pt x="16688" y="3479"/>
                  </a:lnTo>
                  <a:lnTo>
                    <a:pt x="17019" y="3466"/>
                  </a:lnTo>
                  <a:lnTo>
                    <a:pt x="17345" y="3454"/>
                  </a:lnTo>
                  <a:lnTo>
                    <a:pt x="17669" y="3442"/>
                  </a:lnTo>
                  <a:lnTo>
                    <a:pt x="17988" y="3429"/>
                  </a:lnTo>
                  <a:lnTo>
                    <a:pt x="18302" y="3417"/>
                  </a:lnTo>
                  <a:lnTo>
                    <a:pt x="18613" y="3405"/>
                  </a:lnTo>
                  <a:lnTo>
                    <a:pt x="18918" y="3392"/>
                  </a:lnTo>
                  <a:lnTo>
                    <a:pt x="19221" y="3380"/>
                  </a:lnTo>
                  <a:lnTo>
                    <a:pt x="19515" y="3368"/>
                  </a:lnTo>
                  <a:lnTo>
                    <a:pt x="19808" y="3356"/>
                  </a:lnTo>
                  <a:lnTo>
                    <a:pt x="20092" y="3343"/>
                  </a:lnTo>
                  <a:lnTo>
                    <a:pt x="20374" y="3331"/>
                  </a:lnTo>
                  <a:lnTo>
                    <a:pt x="20648" y="3319"/>
                  </a:lnTo>
                  <a:lnTo>
                    <a:pt x="20918" y="3306"/>
                  </a:lnTo>
                  <a:lnTo>
                    <a:pt x="21182" y="3294"/>
                  </a:lnTo>
                  <a:lnTo>
                    <a:pt x="21440" y="3282"/>
                  </a:lnTo>
                  <a:lnTo>
                    <a:pt x="21693" y="3270"/>
                  </a:lnTo>
                  <a:lnTo>
                    <a:pt x="21939" y="3257"/>
                  </a:lnTo>
                  <a:lnTo>
                    <a:pt x="22180" y="3245"/>
                  </a:lnTo>
                  <a:lnTo>
                    <a:pt x="22413" y="3233"/>
                  </a:lnTo>
                  <a:lnTo>
                    <a:pt x="22644" y="3220"/>
                  </a:lnTo>
                  <a:lnTo>
                    <a:pt x="22863" y="3208"/>
                  </a:lnTo>
                  <a:lnTo>
                    <a:pt x="23081" y="3196"/>
                  </a:lnTo>
                  <a:lnTo>
                    <a:pt x="23288" y="3184"/>
                  </a:lnTo>
                  <a:lnTo>
                    <a:pt x="23493" y="3171"/>
                  </a:lnTo>
                  <a:lnTo>
                    <a:pt x="23689" y="3159"/>
                  </a:lnTo>
                  <a:lnTo>
                    <a:pt x="23879" y="3147"/>
                  </a:lnTo>
                  <a:lnTo>
                    <a:pt x="24063" y="3134"/>
                  </a:lnTo>
                  <a:lnTo>
                    <a:pt x="24241" y="3122"/>
                  </a:lnTo>
                  <a:lnTo>
                    <a:pt x="24413" y="3110"/>
                  </a:lnTo>
                  <a:lnTo>
                    <a:pt x="24577" y="3097"/>
                  </a:lnTo>
                  <a:lnTo>
                    <a:pt x="24737" y="3085"/>
                  </a:lnTo>
                  <a:lnTo>
                    <a:pt x="24887" y="3073"/>
                  </a:lnTo>
                  <a:lnTo>
                    <a:pt x="25036" y="3061"/>
                  </a:lnTo>
                  <a:lnTo>
                    <a:pt x="25173" y="3048"/>
                  </a:lnTo>
                  <a:lnTo>
                    <a:pt x="25308" y="3036"/>
                  </a:lnTo>
                  <a:lnTo>
                    <a:pt x="25434" y="3024"/>
                  </a:lnTo>
                  <a:lnTo>
                    <a:pt x="25556" y="3011"/>
                  </a:lnTo>
                  <a:lnTo>
                    <a:pt x="25670" y="2999"/>
                  </a:lnTo>
                  <a:lnTo>
                    <a:pt x="25779" y="2987"/>
                  </a:lnTo>
                  <a:lnTo>
                    <a:pt x="25883" y="2975"/>
                  </a:lnTo>
                  <a:lnTo>
                    <a:pt x="25979" y="2962"/>
                  </a:lnTo>
                  <a:lnTo>
                    <a:pt x="26072" y="2950"/>
                  </a:lnTo>
                  <a:lnTo>
                    <a:pt x="26156" y="2938"/>
                  </a:lnTo>
                  <a:lnTo>
                    <a:pt x="26239" y="2925"/>
                  </a:lnTo>
                  <a:lnTo>
                    <a:pt x="26311" y="2913"/>
                  </a:lnTo>
                  <a:lnTo>
                    <a:pt x="26382" y="2901"/>
                  </a:lnTo>
                  <a:lnTo>
                    <a:pt x="26444" y="2888"/>
                  </a:lnTo>
                  <a:lnTo>
                    <a:pt x="26504" y="2876"/>
                  </a:lnTo>
                  <a:lnTo>
                    <a:pt x="26556" y="2864"/>
                  </a:lnTo>
                  <a:lnTo>
                    <a:pt x="26605" y="2852"/>
                  </a:lnTo>
                  <a:lnTo>
                    <a:pt x="26648" y="2839"/>
                  </a:lnTo>
                  <a:lnTo>
                    <a:pt x="26686" y="2827"/>
                  </a:lnTo>
                  <a:lnTo>
                    <a:pt x="26721" y="2815"/>
                  </a:lnTo>
                  <a:lnTo>
                    <a:pt x="26749" y="2802"/>
                  </a:lnTo>
                  <a:lnTo>
                    <a:pt x="26775" y="2790"/>
                  </a:lnTo>
                  <a:lnTo>
                    <a:pt x="26794" y="2778"/>
                  </a:lnTo>
                  <a:lnTo>
                    <a:pt x="26812" y="2766"/>
                  </a:lnTo>
                  <a:lnTo>
                    <a:pt x="26823" y="2753"/>
                  </a:lnTo>
                  <a:lnTo>
                    <a:pt x="26832" y="2741"/>
                  </a:lnTo>
                  <a:lnTo>
                    <a:pt x="26836" y="2729"/>
                  </a:lnTo>
                  <a:lnTo>
                    <a:pt x="26837" y="2716"/>
                  </a:lnTo>
                  <a:lnTo>
                    <a:pt x="26834" y="2704"/>
                  </a:lnTo>
                  <a:lnTo>
                    <a:pt x="26828" y="2692"/>
                  </a:lnTo>
                  <a:lnTo>
                    <a:pt x="26819" y="2679"/>
                  </a:lnTo>
                  <a:lnTo>
                    <a:pt x="26806" y="2667"/>
                  </a:lnTo>
                  <a:lnTo>
                    <a:pt x="26791" y="2655"/>
                  </a:lnTo>
                  <a:lnTo>
                    <a:pt x="26772" y="2643"/>
                  </a:lnTo>
                  <a:lnTo>
                    <a:pt x="26752" y="2630"/>
                  </a:lnTo>
                  <a:lnTo>
                    <a:pt x="26728" y="2618"/>
                  </a:lnTo>
                  <a:lnTo>
                    <a:pt x="26703" y="2606"/>
                  </a:lnTo>
                  <a:lnTo>
                    <a:pt x="26674" y="2593"/>
                  </a:lnTo>
                  <a:lnTo>
                    <a:pt x="26644" y="2581"/>
                  </a:lnTo>
                  <a:lnTo>
                    <a:pt x="26611" y="2569"/>
                  </a:lnTo>
                  <a:lnTo>
                    <a:pt x="26577" y="2557"/>
                  </a:lnTo>
                  <a:lnTo>
                    <a:pt x="26541" y="2544"/>
                  </a:lnTo>
                  <a:lnTo>
                    <a:pt x="26504" y="2532"/>
                  </a:lnTo>
                  <a:lnTo>
                    <a:pt x="26466" y="2520"/>
                  </a:lnTo>
                  <a:lnTo>
                    <a:pt x="26425" y="2507"/>
                  </a:lnTo>
                  <a:lnTo>
                    <a:pt x="26384" y="2495"/>
                  </a:lnTo>
                  <a:lnTo>
                    <a:pt x="26342" y="2483"/>
                  </a:lnTo>
                  <a:lnTo>
                    <a:pt x="26299" y="2470"/>
                  </a:lnTo>
                  <a:lnTo>
                    <a:pt x="26256" y="2458"/>
                  </a:lnTo>
                  <a:lnTo>
                    <a:pt x="26211" y="2446"/>
                  </a:lnTo>
                  <a:lnTo>
                    <a:pt x="26167" y="2434"/>
                  </a:lnTo>
                  <a:lnTo>
                    <a:pt x="26122" y="2421"/>
                  </a:lnTo>
                  <a:lnTo>
                    <a:pt x="26077" y="2409"/>
                  </a:lnTo>
                  <a:lnTo>
                    <a:pt x="26031" y="2397"/>
                  </a:lnTo>
                  <a:lnTo>
                    <a:pt x="25986" y="2384"/>
                  </a:lnTo>
                  <a:lnTo>
                    <a:pt x="25941" y="2372"/>
                  </a:lnTo>
                  <a:lnTo>
                    <a:pt x="25896" y="2360"/>
                  </a:lnTo>
                  <a:lnTo>
                    <a:pt x="25852" y="2348"/>
                  </a:lnTo>
                  <a:lnTo>
                    <a:pt x="25808" y="2335"/>
                  </a:lnTo>
                  <a:lnTo>
                    <a:pt x="25766" y="2323"/>
                  </a:lnTo>
                  <a:lnTo>
                    <a:pt x="25723" y="2311"/>
                  </a:lnTo>
                  <a:lnTo>
                    <a:pt x="25682" y="2298"/>
                  </a:lnTo>
                  <a:lnTo>
                    <a:pt x="25641" y="2286"/>
                  </a:lnTo>
                  <a:lnTo>
                    <a:pt x="25602" y="2274"/>
                  </a:lnTo>
                  <a:lnTo>
                    <a:pt x="25564" y="2261"/>
                  </a:lnTo>
                  <a:lnTo>
                    <a:pt x="25527" y="2249"/>
                  </a:lnTo>
                  <a:lnTo>
                    <a:pt x="25492" y="2237"/>
                  </a:lnTo>
                  <a:lnTo>
                    <a:pt x="25458" y="2225"/>
                  </a:lnTo>
                  <a:lnTo>
                    <a:pt x="25425" y="2212"/>
                  </a:lnTo>
                  <a:lnTo>
                    <a:pt x="25394" y="2200"/>
                  </a:lnTo>
                  <a:lnTo>
                    <a:pt x="25366" y="2188"/>
                  </a:lnTo>
                  <a:lnTo>
                    <a:pt x="25338" y="2175"/>
                  </a:lnTo>
                  <a:lnTo>
                    <a:pt x="25313" y="2163"/>
                  </a:lnTo>
                  <a:lnTo>
                    <a:pt x="25289" y="2151"/>
                  </a:lnTo>
                  <a:lnTo>
                    <a:pt x="25268" y="2139"/>
                  </a:lnTo>
                  <a:lnTo>
                    <a:pt x="25248" y="2126"/>
                  </a:lnTo>
                  <a:lnTo>
                    <a:pt x="25231" y="2114"/>
                  </a:lnTo>
                  <a:lnTo>
                    <a:pt x="25216" y="2102"/>
                  </a:lnTo>
                  <a:lnTo>
                    <a:pt x="25203" y="2089"/>
                  </a:lnTo>
                  <a:lnTo>
                    <a:pt x="25192" y="2077"/>
                  </a:lnTo>
                  <a:lnTo>
                    <a:pt x="25184" y="2065"/>
                  </a:lnTo>
                  <a:lnTo>
                    <a:pt x="25178" y="2053"/>
                  </a:lnTo>
                  <a:lnTo>
                    <a:pt x="25174" y="2040"/>
                  </a:lnTo>
                  <a:lnTo>
                    <a:pt x="25174" y="2028"/>
                  </a:lnTo>
                  <a:lnTo>
                    <a:pt x="25174" y="2016"/>
                  </a:lnTo>
                  <a:lnTo>
                    <a:pt x="25179" y="2003"/>
                  </a:lnTo>
                  <a:lnTo>
                    <a:pt x="25184" y="1991"/>
                  </a:lnTo>
                  <a:lnTo>
                    <a:pt x="25194" y="1979"/>
                  </a:lnTo>
                  <a:lnTo>
                    <a:pt x="25205" y="1966"/>
                  </a:lnTo>
                  <a:lnTo>
                    <a:pt x="25219" y="1954"/>
                  </a:lnTo>
                  <a:lnTo>
                    <a:pt x="25235" y="1942"/>
                  </a:lnTo>
                  <a:lnTo>
                    <a:pt x="25254" y="1930"/>
                  </a:lnTo>
                  <a:lnTo>
                    <a:pt x="25276" y="1917"/>
                  </a:lnTo>
                  <a:lnTo>
                    <a:pt x="25300" y="1905"/>
                  </a:lnTo>
                  <a:lnTo>
                    <a:pt x="25327" y="1893"/>
                  </a:lnTo>
                  <a:lnTo>
                    <a:pt x="25355" y="1880"/>
                  </a:lnTo>
                  <a:lnTo>
                    <a:pt x="25388" y="1868"/>
                  </a:lnTo>
                  <a:lnTo>
                    <a:pt x="25421" y="1856"/>
                  </a:lnTo>
                  <a:lnTo>
                    <a:pt x="25459" y="1844"/>
                  </a:lnTo>
                  <a:lnTo>
                    <a:pt x="25497" y="1831"/>
                  </a:lnTo>
                  <a:lnTo>
                    <a:pt x="25539" y="1819"/>
                  </a:lnTo>
                  <a:lnTo>
                    <a:pt x="25583" y="1807"/>
                  </a:lnTo>
                  <a:lnTo>
                    <a:pt x="25629" y="1794"/>
                  </a:lnTo>
                  <a:lnTo>
                    <a:pt x="25678" y="1782"/>
                  </a:lnTo>
                  <a:lnTo>
                    <a:pt x="25729" y="1770"/>
                  </a:lnTo>
                  <a:lnTo>
                    <a:pt x="25782" y="1757"/>
                  </a:lnTo>
                  <a:lnTo>
                    <a:pt x="25837" y="1745"/>
                  </a:lnTo>
                  <a:lnTo>
                    <a:pt x="25895" y="1733"/>
                  </a:lnTo>
                  <a:lnTo>
                    <a:pt x="25954" y="1721"/>
                  </a:lnTo>
                  <a:lnTo>
                    <a:pt x="26017" y="1708"/>
                  </a:lnTo>
                  <a:lnTo>
                    <a:pt x="26080" y="1696"/>
                  </a:lnTo>
                  <a:lnTo>
                    <a:pt x="26146" y="1684"/>
                  </a:lnTo>
                  <a:lnTo>
                    <a:pt x="26214" y="1671"/>
                  </a:lnTo>
                  <a:lnTo>
                    <a:pt x="26283" y="1659"/>
                  </a:lnTo>
                  <a:lnTo>
                    <a:pt x="26354" y="1647"/>
                  </a:lnTo>
                  <a:lnTo>
                    <a:pt x="26427" y="1635"/>
                  </a:lnTo>
                  <a:lnTo>
                    <a:pt x="26502" y="1622"/>
                  </a:lnTo>
                  <a:lnTo>
                    <a:pt x="26578" y="1610"/>
                  </a:lnTo>
                  <a:lnTo>
                    <a:pt x="26656" y="1598"/>
                  </a:lnTo>
                  <a:lnTo>
                    <a:pt x="26735" y="1585"/>
                  </a:lnTo>
                  <a:lnTo>
                    <a:pt x="26816" y="1573"/>
                  </a:lnTo>
                  <a:lnTo>
                    <a:pt x="26898" y="1561"/>
                  </a:lnTo>
                  <a:lnTo>
                    <a:pt x="26982" y="1548"/>
                  </a:lnTo>
                  <a:lnTo>
                    <a:pt x="27066" y="1536"/>
                  </a:lnTo>
                  <a:lnTo>
                    <a:pt x="27152" y="1524"/>
                  </a:lnTo>
                  <a:lnTo>
                    <a:pt x="27238" y="1512"/>
                  </a:lnTo>
                  <a:lnTo>
                    <a:pt x="27326" y="1499"/>
                  </a:lnTo>
                  <a:lnTo>
                    <a:pt x="27415" y="1487"/>
                  </a:lnTo>
                  <a:lnTo>
                    <a:pt x="27504" y="1475"/>
                  </a:lnTo>
                  <a:lnTo>
                    <a:pt x="27594" y="1462"/>
                  </a:lnTo>
                  <a:lnTo>
                    <a:pt x="27685" y="1450"/>
                  </a:lnTo>
                  <a:lnTo>
                    <a:pt x="27777" y="1438"/>
                  </a:lnTo>
                  <a:lnTo>
                    <a:pt x="27869" y="1426"/>
                  </a:lnTo>
                  <a:lnTo>
                    <a:pt x="27962" y="1413"/>
                  </a:lnTo>
                  <a:lnTo>
                    <a:pt x="28055" y="1401"/>
                  </a:lnTo>
                  <a:lnTo>
                    <a:pt x="28148" y="1389"/>
                  </a:lnTo>
                  <a:lnTo>
                    <a:pt x="28242" y="1376"/>
                  </a:lnTo>
                  <a:lnTo>
                    <a:pt x="28336" y="1364"/>
                  </a:lnTo>
                  <a:lnTo>
                    <a:pt x="28430" y="1352"/>
                  </a:lnTo>
                  <a:lnTo>
                    <a:pt x="28524" y="1339"/>
                  </a:lnTo>
                  <a:lnTo>
                    <a:pt x="28619" y="1327"/>
                  </a:lnTo>
                  <a:lnTo>
                    <a:pt x="28713" y="1315"/>
                  </a:lnTo>
                  <a:lnTo>
                    <a:pt x="28807" y="1303"/>
                  </a:lnTo>
                  <a:lnTo>
                    <a:pt x="28901" y="1290"/>
                  </a:lnTo>
                  <a:lnTo>
                    <a:pt x="28995" y="1278"/>
                  </a:lnTo>
                  <a:lnTo>
                    <a:pt x="29088" y="1266"/>
                  </a:lnTo>
                  <a:lnTo>
                    <a:pt x="29181" y="1253"/>
                  </a:lnTo>
                  <a:lnTo>
                    <a:pt x="29274" y="1241"/>
                  </a:lnTo>
                  <a:lnTo>
                    <a:pt x="29366" y="1229"/>
                  </a:lnTo>
                  <a:lnTo>
                    <a:pt x="29458" y="1217"/>
                  </a:lnTo>
                  <a:lnTo>
                    <a:pt x="29549" y="1204"/>
                  </a:lnTo>
                  <a:lnTo>
                    <a:pt x="29640" y="1192"/>
                  </a:lnTo>
                  <a:lnTo>
                    <a:pt x="29730" y="1180"/>
                  </a:lnTo>
                  <a:lnTo>
                    <a:pt x="29819" y="1167"/>
                  </a:lnTo>
                  <a:lnTo>
                    <a:pt x="29908" y="1155"/>
                  </a:lnTo>
                  <a:lnTo>
                    <a:pt x="29996" y="1143"/>
                  </a:lnTo>
                  <a:lnTo>
                    <a:pt x="30083" y="1130"/>
                  </a:lnTo>
                  <a:lnTo>
                    <a:pt x="30169" y="1118"/>
                  </a:lnTo>
                  <a:lnTo>
                    <a:pt x="30255" y="1106"/>
                  </a:lnTo>
                  <a:lnTo>
                    <a:pt x="30339" y="1094"/>
                  </a:lnTo>
                  <a:lnTo>
                    <a:pt x="30422" y="1081"/>
                  </a:lnTo>
                  <a:lnTo>
                    <a:pt x="30505" y="1069"/>
                  </a:lnTo>
                  <a:lnTo>
                    <a:pt x="30586" y="1057"/>
                  </a:lnTo>
                  <a:lnTo>
                    <a:pt x="30666" y="1044"/>
                  </a:lnTo>
                  <a:lnTo>
                    <a:pt x="30746" y="1032"/>
                  </a:lnTo>
                  <a:lnTo>
                    <a:pt x="30824" y="1020"/>
                  </a:lnTo>
                  <a:lnTo>
                    <a:pt x="30901" y="1008"/>
                  </a:lnTo>
                  <a:lnTo>
                    <a:pt x="30977" y="995"/>
                  </a:lnTo>
                  <a:lnTo>
                    <a:pt x="31051" y="983"/>
                  </a:lnTo>
                  <a:lnTo>
                    <a:pt x="31125" y="971"/>
                  </a:lnTo>
                  <a:lnTo>
                    <a:pt x="31197" y="958"/>
                  </a:lnTo>
                  <a:lnTo>
                    <a:pt x="31269" y="946"/>
                  </a:lnTo>
                  <a:lnTo>
                    <a:pt x="31338" y="934"/>
                  </a:lnTo>
                  <a:lnTo>
                    <a:pt x="31407" y="922"/>
                  </a:lnTo>
                  <a:lnTo>
                    <a:pt x="31475" y="909"/>
                  </a:lnTo>
                  <a:lnTo>
                    <a:pt x="31541" y="897"/>
                  </a:lnTo>
                  <a:lnTo>
                    <a:pt x="31606" y="885"/>
                  </a:lnTo>
                  <a:lnTo>
                    <a:pt x="31669" y="872"/>
                  </a:lnTo>
                  <a:lnTo>
                    <a:pt x="31732" y="860"/>
                  </a:lnTo>
                  <a:lnTo>
                    <a:pt x="31793" y="848"/>
                  </a:lnTo>
                  <a:lnTo>
                    <a:pt x="31853" y="835"/>
                  </a:lnTo>
                  <a:lnTo>
                    <a:pt x="31911" y="823"/>
                  </a:lnTo>
                  <a:lnTo>
                    <a:pt x="31969" y="811"/>
                  </a:lnTo>
                  <a:lnTo>
                    <a:pt x="32024" y="799"/>
                  </a:lnTo>
                  <a:lnTo>
                    <a:pt x="32079" y="786"/>
                  </a:lnTo>
                  <a:lnTo>
                    <a:pt x="32132" y="774"/>
                  </a:lnTo>
                  <a:lnTo>
                    <a:pt x="32185" y="762"/>
                  </a:lnTo>
                  <a:lnTo>
                    <a:pt x="32236" y="749"/>
                  </a:lnTo>
                  <a:lnTo>
                    <a:pt x="32285" y="737"/>
                  </a:lnTo>
                  <a:lnTo>
                    <a:pt x="32334" y="725"/>
                  </a:lnTo>
                  <a:lnTo>
                    <a:pt x="32381" y="713"/>
                  </a:lnTo>
                  <a:lnTo>
                    <a:pt x="32427" y="700"/>
                  </a:lnTo>
                  <a:lnTo>
                    <a:pt x="32472" y="688"/>
                  </a:lnTo>
                  <a:lnTo>
                    <a:pt x="32516" y="676"/>
                  </a:lnTo>
                  <a:lnTo>
                    <a:pt x="32558" y="663"/>
                  </a:lnTo>
                  <a:lnTo>
                    <a:pt x="32600" y="651"/>
                  </a:lnTo>
                  <a:lnTo>
                    <a:pt x="32640" y="639"/>
                  </a:lnTo>
                  <a:lnTo>
                    <a:pt x="32679" y="626"/>
                  </a:lnTo>
                  <a:lnTo>
                    <a:pt x="32717" y="614"/>
                  </a:lnTo>
                  <a:lnTo>
                    <a:pt x="32754" y="602"/>
                  </a:lnTo>
                  <a:lnTo>
                    <a:pt x="32789" y="590"/>
                  </a:lnTo>
                  <a:lnTo>
                    <a:pt x="32824" y="577"/>
                  </a:lnTo>
                  <a:lnTo>
                    <a:pt x="32858" y="565"/>
                  </a:lnTo>
                  <a:lnTo>
                    <a:pt x="32890" y="553"/>
                  </a:lnTo>
                  <a:lnTo>
                    <a:pt x="32922" y="540"/>
                  </a:lnTo>
                  <a:lnTo>
                    <a:pt x="32952" y="528"/>
                  </a:lnTo>
                  <a:lnTo>
                    <a:pt x="32983" y="516"/>
                  </a:lnTo>
                  <a:lnTo>
                    <a:pt x="33011" y="504"/>
                  </a:lnTo>
                  <a:lnTo>
                    <a:pt x="33039" y="491"/>
                  </a:lnTo>
                  <a:lnTo>
                    <a:pt x="33065" y="479"/>
                  </a:lnTo>
                  <a:lnTo>
                    <a:pt x="33092" y="467"/>
                  </a:lnTo>
                  <a:lnTo>
                    <a:pt x="33117" y="454"/>
                  </a:lnTo>
                  <a:lnTo>
                    <a:pt x="33141" y="442"/>
                  </a:lnTo>
                  <a:lnTo>
                    <a:pt x="33164" y="430"/>
                  </a:lnTo>
                  <a:lnTo>
                    <a:pt x="33187" y="417"/>
                  </a:lnTo>
                  <a:lnTo>
                    <a:pt x="33209" y="405"/>
                  </a:lnTo>
                  <a:lnTo>
                    <a:pt x="33229" y="393"/>
                  </a:lnTo>
                  <a:lnTo>
                    <a:pt x="33250" y="381"/>
                  </a:lnTo>
                  <a:lnTo>
                    <a:pt x="33269" y="368"/>
                  </a:lnTo>
                  <a:lnTo>
                    <a:pt x="33288" y="356"/>
                  </a:lnTo>
                  <a:lnTo>
                    <a:pt x="33306" y="344"/>
                  </a:lnTo>
                  <a:lnTo>
                    <a:pt x="33324" y="331"/>
                  </a:lnTo>
                  <a:lnTo>
                    <a:pt x="33340" y="319"/>
                  </a:lnTo>
                  <a:lnTo>
                    <a:pt x="33357" y="307"/>
                  </a:lnTo>
                  <a:lnTo>
                    <a:pt x="33372" y="295"/>
                  </a:lnTo>
                  <a:lnTo>
                    <a:pt x="33387" y="282"/>
                  </a:lnTo>
                  <a:lnTo>
                    <a:pt x="33401" y="270"/>
                  </a:lnTo>
                  <a:lnTo>
                    <a:pt x="33415" y="258"/>
                  </a:lnTo>
                  <a:lnTo>
                    <a:pt x="33428" y="245"/>
                  </a:lnTo>
                  <a:lnTo>
                    <a:pt x="33441" y="233"/>
                  </a:lnTo>
                  <a:lnTo>
                    <a:pt x="33453" y="221"/>
                  </a:lnTo>
                  <a:lnTo>
                    <a:pt x="33464" y="208"/>
                  </a:lnTo>
                  <a:lnTo>
                    <a:pt x="33476" y="196"/>
                  </a:lnTo>
                  <a:lnTo>
                    <a:pt x="33486" y="184"/>
                  </a:lnTo>
                  <a:lnTo>
                    <a:pt x="33496" y="172"/>
                  </a:lnTo>
                  <a:lnTo>
                    <a:pt x="33506" y="159"/>
                  </a:lnTo>
                  <a:lnTo>
                    <a:pt x="33516" y="147"/>
                  </a:lnTo>
                  <a:lnTo>
                    <a:pt x="33525" y="135"/>
                  </a:lnTo>
                  <a:lnTo>
                    <a:pt x="33533" y="122"/>
                  </a:lnTo>
                  <a:lnTo>
                    <a:pt x="33541" y="110"/>
                  </a:lnTo>
                  <a:lnTo>
                    <a:pt x="33549" y="98"/>
                  </a:lnTo>
                  <a:lnTo>
                    <a:pt x="33557" y="86"/>
                  </a:lnTo>
                  <a:lnTo>
                    <a:pt x="33564" y="73"/>
                  </a:lnTo>
                  <a:lnTo>
                    <a:pt x="33571" y="61"/>
                  </a:lnTo>
                  <a:lnTo>
                    <a:pt x="33577" y="49"/>
                  </a:lnTo>
                  <a:lnTo>
                    <a:pt x="33583" y="36"/>
                  </a:lnTo>
                  <a:lnTo>
                    <a:pt x="33589" y="24"/>
                  </a:lnTo>
                  <a:lnTo>
                    <a:pt x="33595" y="12"/>
                  </a:lnTo>
                  <a:lnTo>
                    <a:pt x="33600" y="0"/>
                  </a:lnTo>
                  <a:lnTo>
                    <a:pt x="33695" y="0"/>
                  </a:lnTo>
                  <a:lnTo>
                    <a:pt x="33695" y="6281"/>
                  </a:lnTo>
                  <a:lnTo>
                    <a:pt x="33695" y="6281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67" name="pl49"/>
            <p:cNvSpPr/>
            <p:nvPr/>
          </p:nvSpPr>
          <p:spPr>
            <a:xfrm>
              <a:off x="6610809" y="3798430"/>
              <a:ext cx="108483" cy="1951"/>
            </a:xfrm>
            <a:custGeom>
              <a:avLst/>
              <a:gdLst/>
              <a:ahLst/>
              <a:cxnLst/>
              <a:rect l="0" t="0" r="0" b="0"/>
              <a:pathLst>
                <a:path w="108483" h="1951">
                  <a:moveTo>
                    <a:pt x="0" y="0"/>
                  </a:moveTo>
                  <a:lnTo>
                    <a:pt x="304" y="0"/>
                  </a:lnTo>
                  <a:lnTo>
                    <a:pt x="321" y="3"/>
                  </a:lnTo>
                  <a:lnTo>
                    <a:pt x="339" y="7"/>
                  </a:lnTo>
                  <a:lnTo>
                    <a:pt x="358" y="11"/>
                  </a:lnTo>
                  <a:lnTo>
                    <a:pt x="378" y="15"/>
                  </a:lnTo>
                  <a:lnTo>
                    <a:pt x="399" y="19"/>
                  </a:lnTo>
                  <a:lnTo>
                    <a:pt x="421" y="22"/>
                  </a:lnTo>
                  <a:lnTo>
                    <a:pt x="443" y="26"/>
                  </a:lnTo>
                  <a:lnTo>
                    <a:pt x="468" y="30"/>
                  </a:lnTo>
                  <a:lnTo>
                    <a:pt x="493" y="34"/>
                  </a:lnTo>
                  <a:lnTo>
                    <a:pt x="519" y="38"/>
                  </a:lnTo>
                  <a:lnTo>
                    <a:pt x="547" y="42"/>
                  </a:lnTo>
                  <a:lnTo>
                    <a:pt x="576" y="45"/>
                  </a:lnTo>
                  <a:lnTo>
                    <a:pt x="606" y="49"/>
                  </a:lnTo>
                  <a:lnTo>
                    <a:pt x="637" y="53"/>
                  </a:lnTo>
                  <a:lnTo>
                    <a:pt x="670" y="57"/>
                  </a:lnTo>
                  <a:lnTo>
                    <a:pt x="704" y="61"/>
                  </a:lnTo>
                  <a:lnTo>
                    <a:pt x="740" y="64"/>
                  </a:lnTo>
                  <a:lnTo>
                    <a:pt x="777" y="68"/>
                  </a:lnTo>
                  <a:lnTo>
                    <a:pt x="817" y="72"/>
                  </a:lnTo>
                  <a:lnTo>
                    <a:pt x="857" y="76"/>
                  </a:lnTo>
                  <a:lnTo>
                    <a:pt x="900" y="80"/>
                  </a:lnTo>
                  <a:lnTo>
                    <a:pt x="944" y="84"/>
                  </a:lnTo>
                  <a:lnTo>
                    <a:pt x="990" y="87"/>
                  </a:lnTo>
                  <a:lnTo>
                    <a:pt x="1038" y="91"/>
                  </a:lnTo>
                  <a:lnTo>
                    <a:pt x="1088" y="95"/>
                  </a:lnTo>
                  <a:lnTo>
                    <a:pt x="1140" y="99"/>
                  </a:lnTo>
                  <a:lnTo>
                    <a:pt x="1193" y="103"/>
                  </a:lnTo>
                  <a:lnTo>
                    <a:pt x="1250" y="106"/>
                  </a:lnTo>
                  <a:lnTo>
                    <a:pt x="1307" y="110"/>
                  </a:lnTo>
                  <a:lnTo>
                    <a:pt x="1369" y="114"/>
                  </a:lnTo>
                  <a:lnTo>
                    <a:pt x="1431" y="118"/>
                  </a:lnTo>
                  <a:lnTo>
                    <a:pt x="1497" y="122"/>
                  </a:lnTo>
                  <a:lnTo>
                    <a:pt x="1564" y="126"/>
                  </a:lnTo>
                  <a:lnTo>
                    <a:pt x="1634" y="129"/>
                  </a:lnTo>
                  <a:lnTo>
                    <a:pt x="1707" y="133"/>
                  </a:lnTo>
                  <a:lnTo>
                    <a:pt x="1782" y="137"/>
                  </a:lnTo>
                  <a:lnTo>
                    <a:pt x="1860" y="141"/>
                  </a:lnTo>
                  <a:lnTo>
                    <a:pt x="1941" y="145"/>
                  </a:lnTo>
                  <a:lnTo>
                    <a:pt x="2025" y="148"/>
                  </a:lnTo>
                  <a:lnTo>
                    <a:pt x="2110" y="152"/>
                  </a:lnTo>
                  <a:lnTo>
                    <a:pt x="2201" y="156"/>
                  </a:lnTo>
                  <a:lnTo>
                    <a:pt x="2292" y="160"/>
                  </a:lnTo>
                  <a:lnTo>
                    <a:pt x="2389" y="164"/>
                  </a:lnTo>
                  <a:lnTo>
                    <a:pt x="2486" y="168"/>
                  </a:lnTo>
                  <a:lnTo>
                    <a:pt x="2589" y="171"/>
                  </a:lnTo>
                  <a:lnTo>
                    <a:pt x="2693" y="175"/>
                  </a:lnTo>
                  <a:lnTo>
                    <a:pt x="2802" y="179"/>
                  </a:lnTo>
                  <a:lnTo>
                    <a:pt x="2914" y="183"/>
                  </a:lnTo>
                  <a:lnTo>
                    <a:pt x="3029" y="187"/>
                  </a:lnTo>
                  <a:lnTo>
                    <a:pt x="3148" y="190"/>
                  </a:lnTo>
                  <a:lnTo>
                    <a:pt x="3269" y="194"/>
                  </a:lnTo>
                  <a:lnTo>
                    <a:pt x="3396" y="198"/>
                  </a:lnTo>
                  <a:lnTo>
                    <a:pt x="3524" y="202"/>
                  </a:lnTo>
                  <a:lnTo>
                    <a:pt x="3658" y="206"/>
                  </a:lnTo>
                  <a:lnTo>
                    <a:pt x="3794" y="210"/>
                  </a:lnTo>
                  <a:lnTo>
                    <a:pt x="3936" y="213"/>
                  </a:lnTo>
                  <a:lnTo>
                    <a:pt x="4079" y="217"/>
                  </a:lnTo>
                  <a:lnTo>
                    <a:pt x="4228" y="221"/>
                  </a:lnTo>
                  <a:lnTo>
                    <a:pt x="4380" y="225"/>
                  </a:lnTo>
                  <a:lnTo>
                    <a:pt x="4536" y="229"/>
                  </a:lnTo>
                  <a:lnTo>
                    <a:pt x="4696" y="232"/>
                  </a:lnTo>
                  <a:lnTo>
                    <a:pt x="4860" y="236"/>
                  </a:lnTo>
                  <a:lnTo>
                    <a:pt x="5029" y="240"/>
                  </a:lnTo>
                  <a:lnTo>
                    <a:pt x="5200" y="244"/>
                  </a:lnTo>
                  <a:lnTo>
                    <a:pt x="5377" y="248"/>
                  </a:lnTo>
                  <a:lnTo>
                    <a:pt x="5556" y="252"/>
                  </a:lnTo>
                  <a:lnTo>
                    <a:pt x="5742" y="255"/>
                  </a:lnTo>
                  <a:lnTo>
                    <a:pt x="5929" y="259"/>
                  </a:lnTo>
                  <a:lnTo>
                    <a:pt x="6123" y="263"/>
                  </a:lnTo>
                  <a:lnTo>
                    <a:pt x="6319" y="267"/>
                  </a:lnTo>
                  <a:lnTo>
                    <a:pt x="6520" y="271"/>
                  </a:lnTo>
                  <a:lnTo>
                    <a:pt x="6725" y="274"/>
                  </a:lnTo>
                  <a:lnTo>
                    <a:pt x="6934" y="278"/>
                  </a:lnTo>
                  <a:lnTo>
                    <a:pt x="7147" y="282"/>
                  </a:lnTo>
                  <a:lnTo>
                    <a:pt x="7363" y="286"/>
                  </a:lnTo>
                  <a:lnTo>
                    <a:pt x="7585" y="290"/>
                  </a:lnTo>
                  <a:lnTo>
                    <a:pt x="7809" y="294"/>
                  </a:lnTo>
                  <a:lnTo>
                    <a:pt x="8039" y="297"/>
                  </a:lnTo>
                  <a:lnTo>
                    <a:pt x="8271" y="301"/>
                  </a:lnTo>
                  <a:lnTo>
                    <a:pt x="8509" y="305"/>
                  </a:lnTo>
                  <a:lnTo>
                    <a:pt x="8749" y="309"/>
                  </a:lnTo>
                  <a:lnTo>
                    <a:pt x="8994" y="313"/>
                  </a:lnTo>
                  <a:lnTo>
                    <a:pt x="9242" y="316"/>
                  </a:lnTo>
                  <a:lnTo>
                    <a:pt x="9494" y="320"/>
                  </a:lnTo>
                  <a:lnTo>
                    <a:pt x="9749" y="324"/>
                  </a:lnTo>
                  <a:lnTo>
                    <a:pt x="10007" y="328"/>
                  </a:lnTo>
                  <a:lnTo>
                    <a:pt x="10270" y="332"/>
                  </a:lnTo>
                  <a:lnTo>
                    <a:pt x="10534" y="336"/>
                  </a:lnTo>
                  <a:lnTo>
                    <a:pt x="10804" y="339"/>
                  </a:lnTo>
                  <a:lnTo>
                    <a:pt x="11074" y="343"/>
                  </a:lnTo>
                  <a:lnTo>
                    <a:pt x="11350" y="347"/>
                  </a:lnTo>
                  <a:lnTo>
                    <a:pt x="11627" y="351"/>
                  </a:lnTo>
                  <a:lnTo>
                    <a:pt x="11908" y="355"/>
                  </a:lnTo>
                  <a:lnTo>
                    <a:pt x="12190" y="358"/>
                  </a:lnTo>
                  <a:lnTo>
                    <a:pt x="12476" y="362"/>
                  </a:lnTo>
                  <a:lnTo>
                    <a:pt x="12763" y="366"/>
                  </a:lnTo>
                  <a:lnTo>
                    <a:pt x="13053" y="370"/>
                  </a:lnTo>
                  <a:lnTo>
                    <a:pt x="13345" y="374"/>
                  </a:lnTo>
                  <a:lnTo>
                    <a:pt x="13639" y="378"/>
                  </a:lnTo>
                  <a:lnTo>
                    <a:pt x="13935" y="381"/>
                  </a:lnTo>
                  <a:lnTo>
                    <a:pt x="14232" y="385"/>
                  </a:lnTo>
                  <a:lnTo>
                    <a:pt x="14531" y="389"/>
                  </a:lnTo>
                  <a:lnTo>
                    <a:pt x="14830" y="393"/>
                  </a:lnTo>
                  <a:lnTo>
                    <a:pt x="15131" y="397"/>
                  </a:lnTo>
                  <a:lnTo>
                    <a:pt x="15433" y="400"/>
                  </a:lnTo>
                  <a:lnTo>
                    <a:pt x="15736" y="404"/>
                  </a:lnTo>
                  <a:lnTo>
                    <a:pt x="16039" y="408"/>
                  </a:lnTo>
                  <a:lnTo>
                    <a:pt x="16342" y="412"/>
                  </a:lnTo>
                  <a:lnTo>
                    <a:pt x="16645" y="416"/>
                  </a:lnTo>
                  <a:lnTo>
                    <a:pt x="16949" y="420"/>
                  </a:lnTo>
                  <a:lnTo>
                    <a:pt x="17252" y="423"/>
                  </a:lnTo>
                  <a:lnTo>
                    <a:pt x="17554" y="427"/>
                  </a:lnTo>
                  <a:lnTo>
                    <a:pt x="17856" y="431"/>
                  </a:lnTo>
                  <a:lnTo>
                    <a:pt x="18157" y="435"/>
                  </a:lnTo>
                  <a:lnTo>
                    <a:pt x="18456" y="439"/>
                  </a:lnTo>
                  <a:lnTo>
                    <a:pt x="18755" y="442"/>
                  </a:lnTo>
                  <a:lnTo>
                    <a:pt x="19051" y="446"/>
                  </a:lnTo>
                  <a:lnTo>
                    <a:pt x="19347" y="450"/>
                  </a:lnTo>
                  <a:lnTo>
                    <a:pt x="19639" y="454"/>
                  </a:lnTo>
                  <a:lnTo>
                    <a:pt x="19930" y="458"/>
                  </a:lnTo>
                  <a:lnTo>
                    <a:pt x="20218" y="462"/>
                  </a:lnTo>
                  <a:lnTo>
                    <a:pt x="20503" y="465"/>
                  </a:lnTo>
                  <a:lnTo>
                    <a:pt x="20786" y="469"/>
                  </a:lnTo>
                  <a:lnTo>
                    <a:pt x="21064" y="473"/>
                  </a:lnTo>
                  <a:lnTo>
                    <a:pt x="21341" y="477"/>
                  </a:lnTo>
                  <a:lnTo>
                    <a:pt x="21612" y="481"/>
                  </a:lnTo>
                  <a:lnTo>
                    <a:pt x="21882" y="484"/>
                  </a:lnTo>
                  <a:lnTo>
                    <a:pt x="22144" y="488"/>
                  </a:lnTo>
                  <a:lnTo>
                    <a:pt x="22405" y="492"/>
                  </a:lnTo>
                  <a:lnTo>
                    <a:pt x="22659" y="496"/>
                  </a:lnTo>
                  <a:lnTo>
                    <a:pt x="22911" y="500"/>
                  </a:lnTo>
                  <a:lnTo>
                    <a:pt x="23156" y="504"/>
                  </a:lnTo>
                  <a:lnTo>
                    <a:pt x="23396" y="507"/>
                  </a:lnTo>
                  <a:lnTo>
                    <a:pt x="23631" y="511"/>
                  </a:lnTo>
                  <a:lnTo>
                    <a:pt x="23860" y="515"/>
                  </a:lnTo>
                  <a:lnTo>
                    <a:pt x="24085" y="519"/>
                  </a:lnTo>
                  <a:lnTo>
                    <a:pt x="24302" y="523"/>
                  </a:lnTo>
                  <a:lnTo>
                    <a:pt x="24515" y="526"/>
                  </a:lnTo>
                  <a:lnTo>
                    <a:pt x="24719" y="530"/>
                  </a:lnTo>
                  <a:lnTo>
                    <a:pt x="24920" y="534"/>
                  </a:lnTo>
                  <a:lnTo>
                    <a:pt x="25110" y="538"/>
                  </a:lnTo>
                  <a:lnTo>
                    <a:pt x="25297" y="542"/>
                  </a:lnTo>
                  <a:lnTo>
                    <a:pt x="25474" y="546"/>
                  </a:lnTo>
                  <a:lnTo>
                    <a:pt x="25646" y="549"/>
                  </a:lnTo>
                  <a:lnTo>
                    <a:pt x="25809" y="553"/>
                  </a:lnTo>
                  <a:lnTo>
                    <a:pt x="25966" y="557"/>
                  </a:lnTo>
                  <a:lnTo>
                    <a:pt x="26116" y="561"/>
                  </a:lnTo>
                  <a:lnTo>
                    <a:pt x="26256" y="565"/>
                  </a:lnTo>
                  <a:lnTo>
                    <a:pt x="26392" y="568"/>
                  </a:lnTo>
                  <a:lnTo>
                    <a:pt x="26516" y="572"/>
                  </a:lnTo>
                  <a:lnTo>
                    <a:pt x="26637" y="576"/>
                  </a:lnTo>
                  <a:lnTo>
                    <a:pt x="26744" y="580"/>
                  </a:lnTo>
                  <a:lnTo>
                    <a:pt x="26849" y="584"/>
                  </a:lnTo>
                  <a:lnTo>
                    <a:pt x="26940" y="588"/>
                  </a:lnTo>
                  <a:lnTo>
                    <a:pt x="27027" y="591"/>
                  </a:lnTo>
                  <a:lnTo>
                    <a:pt x="27104" y="595"/>
                  </a:lnTo>
                  <a:lnTo>
                    <a:pt x="27174" y="599"/>
                  </a:lnTo>
                  <a:lnTo>
                    <a:pt x="27235" y="603"/>
                  </a:lnTo>
                  <a:lnTo>
                    <a:pt x="27287" y="607"/>
                  </a:lnTo>
                  <a:lnTo>
                    <a:pt x="27333" y="610"/>
                  </a:lnTo>
                  <a:lnTo>
                    <a:pt x="27368" y="614"/>
                  </a:lnTo>
                  <a:lnTo>
                    <a:pt x="27399" y="618"/>
                  </a:lnTo>
                  <a:lnTo>
                    <a:pt x="27417" y="622"/>
                  </a:lnTo>
                  <a:lnTo>
                    <a:pt x="27432" y="626"/>
                  </a:lnTo>
                  <a:lnTo>
                    <a:pt x="27433" y="630"/>
                  </a:lnTo>
                  <a:lnTo>
                    <a:pt x="27432" y="633"/>
                  </a:lnTo>
                  <a:lnTo>
                    <a:pt x="27418" y="637"/>
                  </a:lnTo>
                  <a:lnTo>
                    <a:pt x="27400" y="641"/>
                  </a:lnTo>
                  <a:lnTo>
                    <a:pt x="27373" y="645"/>
                  </a:lnTo>
                  <a:lnTo>
                    <a:pt x="27339" y="649"/>
                  </a:lnTo>
                  <a:lnTo>
                    <a:pt x="27297" y="652"/>
                  </a:lnTo>
                  <a:lnTo>
                    <a:pt x="27248" y="656"/>
                  </a:lnTo>
                  <a:lnTo>
                    <a:pt x="27194" y="660"/>
                  </a:lnTo>
                  <a:lnTo>
                    <a:pt x="27130" y="664"/>
                  </a:lnTo>
                  <a:lnTo>
                    <a:pt x="27062" y="668"/>
                  </a:lnTo>
                  <a:lnTo>
                    <a:pt x="26985" y="672"/>
                  </a:lnTo>
                  <a:lnTo>
                    <a:pt x="26905" y="675"/>
                  </a:lnTo>
                  <a:lnTo>
                    <a:pt x="26815" y="679"/>
                  </a:lnTo>
                  <a:lnTo>
                    <a:pt x="26723" y="683"/>
                  </a:lnTo>
                  <a:lnTo>
                    <a:pt x="26622" y="687"/>
                  </a:lnTo>
                  <a:lnTo>
                    <a:pt x="26519" y="691"/>
                  </a:lnTo>
                  <a:lnTo>
                    <a:pt x="26409" y="694"/>
                  </a:lnTo>
                  <a:lnTo>
                    <a:pt x="26295" y="698"/>
                  </a:lnTo>
                  <a:lnTo>
                    <a:pt x="26176" y="702"/>
                  </a:lnTo>
                  <a:lnTo>
                    <a:pt x="26053" y="706"/>
                  </a:lnTo>
                  <a:lnTo>
                    <a:pt x="25927" y="710"/>
                  </a:lnTo>
                  <a:lnTo>
                    <a:pt x="25796" y="714"/>
                  </a:lnTo>
                  <a:lnTo>
                    <a:pt x="25664" y="717"/>
                  </a:lnTo>
                  <a:lnTo>
                    <a:pt x="25527" y="721"/>
                  </a:lnTo>
                  <a:lnTo>
                    <a:pt x="25389" y="725"/>
                  </a:lnTo>
                  <a:lnTo>
                    <a:pt x="25248" y="729"/>
                  </a:lnTo>
                  <a:lnTo>
                    <a:pt x="25106" y="733"/>
                  </a:lnTo>
                  <a:lnTo>
                    <a:pt x="24962" y="736"/>
                  </a:lnTo>
                  <a:lnTo>
                    <a:pt x="24817" y="740"/>
                  </a:lnTo>
                  <a:lnTo>
                    <a:pt x="24672" y="744"/>
                  </a:lnTo>
                  <a:lnTo>
                    <a:pt x="24526" y="748"/>
                  </a:lnTo>
                  <a:lnTo>
                    <a:pt x="24381" y="752"/>
                  </a:lnTo>
                  <a:lnTo>
                    <a:pt x="24236" y="756"/>
                  </a:lnTo>
                  <a:lnTo>
                    <a:pt x="24092" y="759"/>
                  </a:lnTo>
                  <a:lnTo>
                    <a:pt x="23950" y="763"/>
                  </a:lnTo>
                  <a:lnTo>
                    <a:pt x="23808" y="767"/>
                  </a:lnTo>
                  <a:lnTo>
                    <a:pt x="23671" y="771"/>
                  </a:lnTo>
                  <a:lnTo>
                    <a:pt x="23535" y="775"/>
                  </a:lnTo>
                  <a:lnTo>
                    <a:pt x="23403" y="778"/>
                  </a:lnTo>
                  <a:lnTo>
                    <a:pt x="23274" y="782"/>
                  </a:lnTo>
                  <a:lnTo>
                    <a:pt x="23149" y="786"/>
                  </a:lnTo>
                  <a:lnTo>
                    <a:pt x="23029" y="790"/>
                  </a:lnTo>
                  <a:lnTo>
                    <a:pt x="22914" y="794"/>
                  </a:lnTo>
                  <a:lnTo>
                    <a:pt x="22805" y="798"/>
                  </a:lnTo>
                  <a:lnTo>
                    <a:pt x="22699" y="801"/>
                  </a:lnTo>
                  <a:lnTo>
                    <a:pt x="22603" y="805"/>
                  </a:lnTo>
                  <a:lnTo>
                    <a:pt x="22510" y="809"/>
                  </a:lnTo>
                  <a:lnTo>
                    <a:pt x="22429" y="813"/>
                  </a:lnTo>
                  <a:lnTo>
                    <a:pt x="22351" y="817"/>
                  </a:lnTo>
                  <a:lnTo>
                    <a:pt x="22286" y="820"/>
                  </a:lnTo>
                  <a:lnTo>
                    <a:pt x="22225" y="824"/>
                  </a:lnTo>
                  <a:lnTo>
                    <a:pt x="22177" y="828"/>
                  </a:lnTo>
                  <a:lnTo>
                    <a:pt x="22136" y="832"/>
                  </a:lnTo>
                  <a:lnTo>
                    <a:pt x="22106" y="836"/>
                  </a:lnTo>
                  <a:lnTo>
                    <a:pt x="22087" y="840"/>
                  </a:lnTo>
                  <a:lnTo>
                    <a:pt x="22077" y="843"/>
                  </a:lnTo>
                  <a:lnTo>
                    <a:pt x="22082" y="847"/>
                  </a:lnTo>
                  <a:lnTo>
                    <a:pt x="22093" y="851"/>
                  </a:lnTo>
                  <a:lnTo>
                    <a:pt x="22123" y="855"/>
                  </a:lnTo>
                  <a:lnTo>
                    <a:pt x="22157" y="859"/>
                  </a:lnTo>
                  <a:lnTo>
                    <a:pt x="22215" y="862"/>
                  </a:lnTo>
                  <a:lnTo>
                    <a:pt x="22277" y="866"/>
                  </a:lnTo>
                  <a:lnTo>
                    <a:pt x="22361" y="870"/>
                  </a:lnTo>
                  <a:lnTo>
                    <a:pt x="22452" y="874"/>
                  </a:lnTo>
                  <a:lnTo>
                    <a:pt x="22563" y="878"/>
                  </a:lnTo>
                  <a:lnTo>
                    <a:pt x="22687" y="882"/>
                  </a:lnTo>
                  <a:lnTo>
                    <a:pt x="22826" y="885"/>
                  </a:lnTo>
                  <a:lnTo>
                    <a:pt x="22983" y="889"/>
                  </a:lnTo>
                  <a:lnTo>
                    <a:pt x="23151" y="893"/>
                  </a:lnTo>
                  <a:lnTo>
                    <a:pt x="23343" y="897"/>
                  </a:lnTo>
                  <a:lnTo>
                    <a:pt x="23543" y="901"/>
                  </a:lnTo>
                  <a:lnTo>
                    <a:pt x="23771" y="904"/>
                  </a:lnTo>
                  <a:lnTo>
                    <a:pt x="24005" y="908"/>
                  </a:lnTo>
                  <a:lnTo>
                    <a:pt x="24269" y="912"/>
                  </a:lnTo>
                  <a:lnTo>
                    <a:pt x="24540" y="916"/>
                  </a:lnTo>
                  <a:lnTo>
                    <a:pt x="24839" y="920"/>
                  </a:lnTo>
                  <a:lnTo>
                    <a:pt x="25150" y="924"/>
                  </a:lnTo>
                  <a:lnTo>
                    <a:pt x="25483" y="927"/>
                  </a:lnTo>
                  <a:lnTo>
                    <a:pt x="25834" y="931"/>
                  </a:lnTo>
                  <a:lnTo>
                    <a:pt x="26203" y="935"/>
                  </a:lnTo>
                  <a:lnTo>
                    <a:pt x="26595" y="939"/>
                  </a:lnTo>
                  <a:lnTo>
                    <a:pt x="27000" y="943"/>
                  </a:lnTo>
                  <a:lnTo>
                    <a:pt x="27435" y="946"/>
                  </a:lnTo>
                  <a:lnTo>
                    <a:pt x="27877" y="950"/>
                  </a:lnTo>
                  <a:lnTo>
                    <a:pt x="28355" y="954"/>
                  </a:lnTo>
                  <a:lnTo>
                    <a:pt x="28839" y="958"/>
                  </a:lnTo>
                  <a:lnTo>
                    <a:pt x="29355" y="962"/>
                  </a:lnTo>
                  <a:lnTo>
                    <a:pt x="29882" y="966"/>
                  </a:lnTo>
                  <a:lnTo>
                    <a:pt x="30437" y="969"/>
                  </a:lnTo>
                  <a:lnTo>
                    <a:pt x="31008" y="973"/>
                  </a:lnTo>
                  <a:lnTo>
                    <a:pt x="31600" y="977"/>
                  </a:lnTo>
                  <a:lnTo>
                    <a:pt x="32214" y="981"/>
                  </a:lnTo>
                  <a:lnTo>
                    <a:pt x="32845" y="985"/>
                  </a:lnTo>
                  <a:lnTo>
                    <a:pt x="33503" y="988"/>
                  </a:lnTo>
                  <a:lnTo>
                    <a:pt x="34171" y="992"/>
                  </a:lnTo>
                  <a:lnTo>
                    <a:pt x="34872" y="996"/>
                  </a:lnTo>
                  <a:lnTo>
                    <a:pt x="35578" y="1000"/>
                  </a:lnTo>
                  <a:lnTo>
                    <a:pt x="36321" y="1004"/>
                  </a:lnTo>
                  <a:lnTo>
                    <a:pt x="37070" y="1008"/>
                  </a:lnTo>
                  <a:lnTo>
                    <a:pt x="37849" y="1011"/>
                  </a:lnTo>
                  <a:lnTo>
                    <a:pt x="38639" y="1015"/>
                  </a:lnTo>
                  <a:lnTo>
                    <a:pt x="39453" y="1019"/>
                  </a:lnTo>
                  <a:lnTo>
                    <a:pt x="40284" y="1023"/>
                  </a:lnTo>
                  <a:lnTo>
                    <a:pt x="41133" y="1027"/>
                  </a:lnTo>
                  <a:lnTo>
                    <a:pt x="42003" y="1030"/>
                  </a:lnTo>
                  <a:lnTo>
                    <a:pt x="42885" y="1034"/>
                  </a:lnTo>
                  <a:lnTo>
                    <a:pt x="43793" y="1038"/>
                  </a:lnTo>
                  <a:lnTo>
                    <a:pt x="44707" y="1042"/>
                  </a:lnTo>
                  <a:lnTo>
                    <a:pt x="45651" y="1046"/>
                  </a:lnTo>
                  <a:lnTo>
                    <a:pt x="46598" y="1050"/>
                  </a:lnTo>
                  <a:lnTo>
                    <a:pt x="47573" y="1053"/>
                  </a:lnTo>
                  <a:lnTo>
                    <a:pt x="48554" y="1057"/>
                  </a:lnTo>
                  <a:lnTo>
                    <a:pt x="49556" y="1061"/>
                  </a:lnTo>
                  <a:lnTo>
                    <a:pt x="50568" y="1065"/>
                  </a:lnTo>
                  <a:lnTo>
                    <a:pt x="51596" y="1069"/>
                  </a:lnTo>
                  <a:lnTo>
                    <a:pt x="52637" y="1072"/>
                  </a:lnTo>
                  <a:lnTo>
                    <a:pt x="53688" y="1076"/>
                  </a:lnTo>
                  <a:lnTo>
                    <a:pt x="54754" y="1080"/>
                  </a:lnTo>
                  <a:lnTo>
                    <a:pt x="55827" y="1084"/>
                  </a:lnTo>
                  <a:lnTo>
                    <a:pt x="56916" y="1088"/>
                  </a:lnTo>
                  <a:lnTo>
                    <a:pt x="58008" y="1092"/>
                  </a:lnTo>
                  <a:lnTo>
                    <a:pt x="59116" y="1095"/>
                  </a:lnTo>
                  <a:lnTo>
                    <a:pt x="60227" y="1099"/>
                  </a:lnTo>
                  <a:lnTo>
                    <a:pt x="61350" y="1103"/>
                  </a:lnTo>
                  <a:lnTo>
                    <a:pt x="62476" y="1107"/>
                  </a:lnTo>
                  <a:lnTo>
                    <a:pt x="63610" y="1111"/>
                  </a:lnTo>
                  <a:lnTo>
                    <a:pt x="64748" y="1114"/>
                  </a:lnTo>
                  <a:lnTo>
                    <a:pt x="65890" y="1118"/>
                  </a:lnTo>
                  <a:lnTo>
                    <a:pt x="67036" y="1122"/>
                  </a:lnTo>
                  <a:lnTo>
                    <a:pt x="68184" y="1126"/>
                  </a:lnTo>
                  <a:lnTo>
                    <a:pt x="69334" y="1130"/>
                  </a:lnTo>
                  <a:lnTo>
                    <a:pt x="70485" y="1134"/>
                  </a:lnTo>
                  <a:lnTo>
                    <a:pt x="71635" y="1137"/>
                  </a:lnTo>
                  <a:lnTo>
                    <a:pt x="72785" y="1141"/>
                  </a:lnTo>
                  <a:lnTo>
                    <a:pt x="73931" y="1145"/>
                  </a:lnTo>
                  <a:lnTo>
                    <a:pt x="75076" y="1149"/>
                  </a:lnTo>
                  <a:lnTo>
                    <a:pt x="76216" y="1153"/>
                  </a:lnTo>
                  <a:lnTo>
                    <a:pt x="77351" y="1156"/>
                  </a:lnTo>
                  <a:lnTo>
                    <a:pt x="78480" y="1160"/>
                  </a:lnTo>
                  <a:lnTo>
                    <a:pt x="79602" y="1164"/>
                  </a:lnTo>
                  <a:lnTo>
                    <a:pt x="80718" y="1168"/>
                  </a:lnTo>
                  <a:lnTo>
                    <a:pt x="81822" y="1172"/>
                  </a:lnTo>
                  <a:lnTo>
                    <a:pt x="82920" y="1176"/>
                  </a:lnTo>
                  <a:lnTo>
                    <a:pt x="84002" y="1179"/>
                  </a:lnTo>
                  <a:lnTo>
                    <a:pt x="85079" y="1183"/>
                  </a:lnTo>
                  <a:lnTo>
                    <a:pt x="86134" y="1187"/>
                  </a:lnTo>
                  <a:lnTo>
                    <a:pt x="87185" y="1191"/>
                  </a:lnTo>
                  <a:lnTo>
                    <a:pt x="88212" y="1195"/>
                  </a:lnTo>
                  <a:lnTo>
                    <a:pt x="89231" y="1198"/>
                  </a:lnTo>
                  <a:lnTo>
                    <a:pt x="90227" y="1202"/>
                  </a:lnTo>
                  <a:lnTo>
                    <a:pt x="91210" y="1206"/>
                  </a:lnTo>
                  <a:lnTo>
                    <a:pt x="92172" y="1210"/>
                  </a:lnTo>
                  <a:lnTo>
                    <a:pt x="93114" y="1214"/>
                  </a:lnTo>
                  <a:lnTo>
                    <a:pt x="94040" y="1218"/>
                  </a:lnTo>
                  <a:lnTo>
                    <a:pt x="94936" y="1221"/>
                  </a:lnTo>
                  <a:lnTo>
                    <a:pt x="95822" y="1225"/>
                  </a:lnTo>
                  <a:lnTo>
                    <a:pt x="96670" y="1229"/>
                  </a:lnTo>
                  <a:lnTo>
                    <a:pt x="97512" y="1233"/>
                  </a:lnTo>
                  <a:lnTo>
                    <a:pt x="98309" y="1237"/>
                  </a:lnTo>
                  <a:lnTo>
                    <a:pt x="99097" y="1240"/>
                  </a:lnTo>
                  <a:lnTo>
                    <a:pt x="99845" y="1244"/>
                  </a:lnTo>
                  <a:lnTo>
                    <a:pt x="100576" y="1248"/>
                  </a:lnTo>
                  <a:lnTo>
                    <a:pt x="101273" y="1252"/>
                  </a:lnTo>
                  <a:lnTo>
                    <a:pt x="101944" y="1256"/>
                  </a:lnTo>
                  <a:lnTo>
                    <a:pt x="102587" y="1260"/>
                  </a:lnTo>
                  <a:lnTo>
                    <a:pt x="103195" y="1263"/>
                  </a:lnTo>
                  <a:lnTo>
                    <a:pt x="103782" y="1267"/>
                  </a:lnTo>
                  <a:lnTo>
                    <a:pt x="104323" y="1271"/>
                  </a:lnTo>
                  <a:lnTo>
                    <a:pt x="104852" y="1275"/>
                  </a:lnTo>
                  <a:lnTo>
                    <a:pt x="105324" y="1279"/>
                  </a:lnTo>
                  <a:lnTo>
                    <a:pt x="105788" y="1282"/>
                  </a:lnTo>
                  <a:lnTo>
                    <a:pt x="106195" y="1286"/>
                  </a:lnTo>
                  <a:lnTo>
                    <a:pt x="106586" y="1290"/>
                  </a:lnTo>
                  <a:lnTo>
                    <a:pt x="106930" y="1294"/>
                  </a:lnTo>
                  <a:lnTo>
                    <a:pt x="107248" y="1298"/>
                  </a:lnTo>
                  <a:lnTo>
                    <a:pt x="107528" y="1302"/>
                  </a:lnTo>
                  <a:lnTo>
                    <a:pt x="107771" y="1305"/>
                  </a:lnTo>
                  <a:lnTo>
                    <a:pt x="107984" y="1309"/>
                  </a:lnTo>
                  <a:lnTo>
                    <a:pt x="108151" y="1313"/>
                  </a:lnTo>
                  <a:lnTo>
                    <a:pt x="108298" y="1317"/>
                  </a:lnTo>
                  <a:lnTo>
                    <a:pt x="108388" y="1321"/>
                  </a:lnTo>
                  <a:lnTo>
                    <a:pt x="108468" y="1324"/>
                  </a:lnTo>
                  <a:lnTo>
                    <a:pt x="108481" y="1328"/>
                  </a:lnTo>
                  <a:lnTo>
                    <a:pt x="108483" y="1332"/>
                  </a:lnTo>
                  <a:lnTo>
                    <a:pt x="108428" y="1336"/>
                  </a:lnTo>
                  <a:lnTo>
                    <a:pt x="108353" y="1340"/>
                  </a:lnTo>
                  <a:lnTo>
                    <a:pt x="108230" y="1344"/>
                  </a:lnTo>
                  <a:lnTo>
                    <a:pt x="108077" y="1347"/>
                  </a:lnTo>
                  <a:lnTo>
                    <a:pt x="107888" y="1351"/>
                  </a:lnTo>
                  <a:lnTo>
                    <a:pt x="107658" y="1355"/>
                  </a:lnTo>
                  <a:lnTo>
                    <a:pt x="107402" y="1359"/>
                  </a:lnTo>
                  <a:lnTo>
                    <a:pt x="107096" y="1363"/>
                  </a:lnTo>
                  <a:lnTo>
                    <a:pt x="106775" y="1366"/>
                  </a:lnTo>
                  <a:lnTo>
                    <a:pt x="106394" y="1370"/>
                  </a:lnTo>
                  <a:lnTo>
                    <a:pt x="106005" y="1374"/>
                  </a:lnTo>
                  <a:lnTo>
                    <a:pt x="105555" y="1378"/>
                  </a:lnTo>
                  <a:lnTo>
                    <a:pt x="105093" y="1382"/>
                  </a:lnTo>
                  <a:lnTo>
                    <a:pt x="104582" y="1386"/>
                  </a:lnTo>
                  <a:lnTo>
                    <a:pt x="104049" y="1389"/>
                  </a:lnTo>
                  <a:lnTo>
                    <a:pt x="103478" y="1393"/>
                  </a:lnTo>
                  <a:lnTo>
                    <a:pt x="102877" y="1397"/>
                  </a:lnTo>
                  <a:lnTo>
                    <a:pt x="102247" y="1401"/>
                  </a:lnTo>
                  <a:lnTo>
                    <a:pt x="101581" y="1405"/>
                  </a:lnTo>
                  <a:lnTo>
                    <a:pt x="100895" y="1408"/>
                  </a:lnTo>
                  <a:lnTo>
                    <a:pt x="100166" y="1412"/>
                  </a:lnTo>
                  <a:lnTo>
                    <a:pt x="99427" y="1416"/>
                  </a:lnTo>
                  <a:lnTo>
                    <a:pt x="98638" y="1420"/>
                  </a:lnTo>
                  <a:lnTo>
                    <a:pt x="97842" y="1424"/>
                  </a:lnTo>
                  <a:lnTo>
                    <a:pt x="97002" y="1428"/>
                  </a:lnTo>
                  <a:lnTo>
                    <a:pt x="96151" y="1431"/>
                  </a:lnTo>
                  <a:lnTo>
                    <a:pt x="95265" y="1435"/>
                  </a:lnTo>
                  <a:lnTo>
                    <a:pt x="94361" y="1439"/>
                  </a:lnTo>
                  <a:lnTo>
                    <a:pt x="93432" y="1443"/>
                  </a:lnTo>
                  <a:lnTo>
                    <a:pt x="92480" y="1447"/>
                  </a:lnTo>
                  <a:lnTo>
                    <a:pt x="91511" y="1450"/>
                  </a:lnTo>
                  <a:lnTo>
                    <a:pt x="90515" y="1454"/>
                  </a:lnTo>
                  <a:lnTo>
                    <a:pt x="89508" y="1458"/>
                  </a:lnTo>
                  <a:lnTo>
                    <a:pt x="88471" y="1462"/>
                  </a:lnTo>
                  <a:lnTo>
                    <a:pt x="87429" y="1466"/>
                  </a:lnTo>
                  <a:lnTo>
                    <a:pt x="86357" y="1470"/>
                  </a:lnTo>
                  <a:lnTo>
                    <a:pt x="85280" y="1473"/>
                  </a:lnTo>
                  <a:lnTo>
                    <a:pt x="84179" y="1477"/>
                  </a:lnTo>
                  <a:lnTo>
                    <a:pt x="83071" y="1481"/>
                  </a:lnTo>
                  <a:lnTo>
                    <a:pt x="81945" y="1485"/>
                  </a:lnTo>
                  <a:lnTo>
                    <a:pt x="80810" y="1489"/>
                  </a:lnTo>
                  <a:lnTo>
                    <a:pt x="79663" y="1492"/>
                  </a:lnTo>
                  <a:lnTo>
                    <a:pt x="78504" y="1496"/>
                  </a:lnTo>
                  <a:lnTo>
                    <a:pt x="77338" y="1500"/>
                  </a:lnTo>
                  <a:lnTo>
                    <a:pt x="76161" y="1504"/>
                  </a:lnTo>
                  <a:lnTo>
                    <a:pt x="74980" y="1508"/>
                  </a:lnTo>
                  <a:lnTo>
                    <a:pt x="73788" y="1512"/>
                  </a:lnTo>
                  <a:lnTo>
                    <a:pt x="72594" y="1515"/>
                  </a:lnTo>
                  <a:lnTo>
                    <a:pt x="71392" y="1519"/>
                  </a:lnTo>
                  <a:lnTo>
                    <a:pt x="70188" y="1523"/>
                  </a:lnTo>
                  <a:lnTo>
                    <a:pt x="68980" y="1527"/>
                  </a:lnTo>
                  <a:lnTo>
                    <a:pt x="67770" y="1531"/>
                  </a:lnTo>
                  <a:lnTo>
                    <a:pt x="66559" y="1534"/>
                  </a:lnTo>
                  <a:lnTo>
                    <a:pt x="65347" y="1538"/>
                  </a:lnTo>
                  <a:lnTo>
                    <a:pt x="64135" y="1542"/>
                  </a:lnTo>
                  <a:lnTo>
                    <a:pt x="62925" y="1546"/>
                  </a:lnTo>
                  <a:lnTo>
                    <a:pt x="61716" y="1550"/>
                  </a:lnTo>
                  <a:lnTo>
                    <a:pt x="60511" y="1554"/>
                  </a:lnTo>
                  <a:lnTo>
                    <a:pt x="59307" y="1557"/>
                  </a:lnTo>
                  <a:lnTo>
                    <a:pt x="58111" y="1561"/>
                  </a:lnTo>
                  <a:lnTo>
                    <a:pt x="56916" y="1565"/>
                  </a:lnTo>
                  <a:lnTo>
                    <a:pt x="55729" y="1569"/>
                  </a:lnTo>
                  <a:lnTo>
                    <a:pt x="54547" y="1573"/>
                  </a:lnTo>
                  <a:lnTo>
                    <a:pt x="53373" y="1576"/>
                  </a:lnTo>
                  <a:lnTo>
                    <a:pt x="52206" y="1580"/>
                  </a:lnTo>
                  <a:lnTo>
                    <a:pt x="51046" y="1584"/>
                  </a:lnTo>
                  <a:lnTo>
                    <a:pt x="49897" y="1588"/>
                  </a:lnTo>
                  <a:lnTo>
                    <a:pt x="48755" y="1592"/>
                  </a:lnTo>
                  <a:lnTo>
                    <a:pt x="47626" y="1596"/>
                  </a:lnTo>
                  <a:lnTo>
                    <a:pt x="46502" y="1599"/>
                  </a:lnTo>
                  <a:lnTo>
                    <a:pt x="45396" y="1603"/>
                  </a:lnTo>
                  <a:lnTo>
                    <a:pt x="44294" y="1607"/>
                  </a:lnTo>
                  <a:lnTo>
                    <a:pt x="43212" y="1611"/>
                  </a:lnTo>
                  <a:lnTo>
                    <a:pt x="42135" y="1615"/>
                  </a:lnTo>
                  <a:lnTo>
                    <a:pt x="41077" y="1618"/>
                  </a:lnTo>
                  <a:lnTo>
                    <a:pt x="40027" y="1622"/>
                  </a:lnTo>
                  <a:lnTo>
                    <a:pt x="38994" y="1626"/>
                  </a:lnTo>
                  <a:lnTo>
                    <a:pt x="37973" y="1630"/>
                  </a:lnTo>
                  <a:lnTo>
                    <a:pt x="36966" y="1634"/>
                  </a:lnTo>
                  <a:lnTo>
                    <a:pt x="35976" y="1638"/>
                  </a:lnTo>
                  <a:lnTo>
                    <a:pt x="34995" y="1641"/>
                  </a:lnTo>
                  <a:lnTo>
                    <a:pt x="34036" y="1645"/>
                  </a:lnTo>
                  <a:lnTo>
                    <a:pt x="33083" y="1649"/>
                  </a:lnTo>
                  <a:lnTo>
                    <a:pt x="32158" y="1653"/>
                  </a:lnTo>
                  <a:lnTo>
                    <a:pt x="31237" y="1657"/>
                  </a:lnTo>
                  <a:lnTo>
                    <a:pt x="30341" y="1660"/>
                  </a:lnTo>
                  <a:lnTo>
                    <a:pt x="29454" y="1664"/>
                  </a:lnTo>
                  <a:lnTo>
                    <a:pt x="28588" y="1668"/>
                  </a:lnTo>
                  <a:lnTo>
                    <a:pt x="27735" y="1672"/>
                  </a:lnTo>
                  <a:lnTo>
                    <a:pt x="26899" y="1676"/>
                  </a:lnTo>
                  <a:lnTo>
                    <a:pt x="26081" y="1680"/>
                  </a:lnTo>
                  <a:lnTo>
                    <a:pt x="25275" y="1683"/>
                  </a:lnTo>
                  <a:lnTo>
                    <a:pt x="24492" y="1687"/>
                  </a:lnTo>
                  <a:lnTo>
                    <a:pt x="23717" y="1691"/>
                  </a:lnTo>
                  <a:lnTo>
                    <a:pt x="22968" y="1695"/>
                  </a:lnTo>
                  <a:lnTo>
                    <a:pt x="22224" y="1699"/>
                  </a:lnTo>
                  <a:lnTo>
                    <a:pt x="21509" y="1702"/>
                  </a:lnTo>
                  <a:lnTo>
                    <a:pt x="20800" y="1706"/>
                  </a:lnTo>
                  <a:lnTo>
                    <a:pt x="20116" y="1710"/>
                  </a:lnTo>
                  <a:lnTo>
                    <a:pt x="19441" y="1714"/>
                  </a:lnTo>
                  <a:lnTo>
                    <a:pt x="18786" y="1718"/>
                  </a:lnTo>
                  <a:lnTo>
                    <a:pt x="18146" y="1722"/>
                  </a:lnTo>
                  <a:lnTo>
                    <a:pt x="17521" y="1725"/>
                  </a:lnTo>
                  <a:lnTo>
                    <a:pt x="16914" y="1729"/>
                  </a:lnTo>
                  <a:lnTo>
                    <a:pt x="16318" y="1733"/>
                  </a:lnTo>
                  <a:lnTo>
                    <a:pt x="15744" y="1737"/>
                  </a:lnTo>
                  <a:lnTo>
                    <a:pt x="15176" y="1741"/>
                  </a:lnTo>
                  <a:lnTo>
                    <a:pt x="14634" y="1744"/>
                  </a:lnTo>
                  <a:lnTo>
                    <a:pt x="14097" y="1748"/>
                  </a:lnTo>
                  <a:lnTo>
                    <a:pt x="13584" y="1752"/>
                  </a:lnTo>
                  <a:lnTo>
                    <a:pt x="13078" y="1756"/>
                  </a:lnTo>
                  <a:lnTo>
                    <a:pt x="12592" y="1760"/>
                  </a:lnTo>
                  <a:lnTo>
                    <a:pt x="12116" y="1764"/>
                  </a:lnTo>
                  <a:lnTo>
                    <a:pt x="11656" y="1767"/>
                  </a:lnTo>
                  <a:lnTo>
                    <a:pt x="11210" y="1771"/>
                  </a:lnTo>
                  <a:lnTo>
                    <a:pt x="10775" y="1775"/>
                  </a:lnTo>
                  <a:lnTo>
                    <a:pt x="10357" y="1779"/>
                  </a:lnTo>
                  <a:lnTo>
                    <a:pt x="9947" y="1783"/>
                  </a:lnTo>
                  <a:lnTo>
                    <a:pt x="9556" y="1786"/>
                  </a:lnTo>
                  <a:lnTo>
                    <a:pt x="9169" y="1790"/>
                  </a:lnTo>
                  <a:lnTo>
                    <a:pt x="8804" y="1794"/>
                  </a:lnTo>
                  <a:lnTo>
                    <a:pt x="8443" y="1798"/>
                  </a:lnTo>
                  <a:lnTo>
                    <a:pt x="8101" y="1802"/>
                  </a:lnTo>
                  <a:lnTo>
                    <a:pt x="7764" y="1806"/>
                  </a:lnTo>
                  <a:lnTo>
                    <a:pt x="7443" y="1809"/>
                  </a:lnTo>
                  <a:lnTo>
                    <a:pt x="7130" y="1813"/>
                  </a:lnTo>
                  <a:lnTo>
                    <a:pt x="6829" y="1817"/>
                  </a:lnTo>
                  <a:lnTo>
                    <a:pt x="6539" y="1821"/>
                  </a:lnTo>
                  <a:lnTo>
                    <a:pt x="6257" y="1825"/>
                  </a:lnTo>
                  <a:lnTo>
                    <a:pt x="5988" y="1828"/>
                  </a:lnTo>
                  <a:lnTo>
                    <a:pt x="5724" y="1832"/>
                  </a:lnTo>
                  <a:lnTo>
                    <a:pt x="5476" y="1836"/>
                  </a:lnTo>
                  <a:lnTo>
                    <a:pt x="5231" y="1840"/>
                  </a:lnTo>
                  <a:lnTo>
                    <a:pt x="5001" y="1844"/>
                  </a:lnTo>
                  <a:lnTo>
                    <a:pt x="4775" y="1848"/>
                  </a:lnTo>
                  <a:lnTo>
                    <a:pt x="4561" y="1851"/>
                  </a:lnTo>
                  <a:lnTo>
                    <a:pt x="4352" y="1855"/>
                  </a:lnTo>
                  <a:lnTo>
                    <a:pt x="4154" y="1859"/>
                  </a:lnTo>
                  <a:lnTo>
                    <a:pt x="3962" y="1863"/>
                  </a:lnTo>
                  <a:lnTo>
                    <a:pt x="3777" y="1867"/>
                  </a:lnTo>
                  <a:lnTo>
                    <a:pt x="3601" y="1870"/>
                  </a:lnTo>
                  <a:lnTo>
                    <a:pt x="3430" y="1874"/>
                  </a:lnTo>
                  <a:lnTo>
                    <a:pt x="3269" y="1878"/>
                  </a:lnTo>
                  <a:lnTo>
                    <a:pt x="3111" y="1882"/>
                  </a:lnTo>
                  <a:lnTo>
                    <a:pt x="2963" y="1886"/>
                  </a:lnTo>
                  <a:lnTo>
                    <a:pt x="2818" y="1890"/>
                  </a:lnTo>
                  <a:lnTo>
                    <a:pt x="2682" y="1893"/>
                  </a:lnTo>
                  <a:lnTo>
                    <a:pt x="2550" y="1897"/>
                  </a:lnTo>
                  <a:lnTo>
                    <a:pt x="2425" y="1901"/>
                  </a:lnTo>
                  <a:lnTo>
                    <a:pt x="2304" y="1905"/>
                  </a:lnTo>
                  <a:lnTo>
                    <a:pt x="2189" y="1909"/>
                  </a:lnTo>
                  <a:lnTo>
                    <a:pt x="2079" y="1912"/>
                  </a:lnTo>
                  <a:lnTo>
                    <a:pt x="1973" y="1916"/>
                  </a:lnTo>
                  <a:lnTo>
                    <a:pt x="1873" y="1920"/>
                  </a:lnTo>
                  <a:lnTo>
                    <a:pt x="1775" y="1924"/>
                  </a:lnTo>
                  <a:lnTo>
                    <a:pt x="1685" y="1928"/>
                  </a:lnTo>
                  <a:lnTo>
                    <a:pt x="1596" y="1932"/>
                  </a:lnTo>
                  <a:lnTo>
                    <a:pt x="1514" y="1935"/>
                  </a:lnTo>
                  <a:lnTo>
                    <a:pt x="1433" y="1939"/>
                  </a:lnTo>
                  <a:lnTo>
                    <a:pt x="1358" y="1943"/>
                  </a:lnTo>
                  <a:lnTo>
                    <a:pt x="1285" y="1947"/>
                  </a:lnTo>
                  <a:lnTo>
                    <a:pt x="1217" y="1951"/>
                  </a:lnTo>
                  <a:lnTo>
                    <a:pt x="0" y="1951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68" name="pl50"/>
            <p:cNvSpPr/>
            <p:nvPr/>
          </p:nvSpPr>
          <p:spPr>
            <a:xfrm>
              <a:off x="6881462" y="3612999"/>
              <a:ext cx="556" cy="254135"/>
            </a:xfrm>
            <a:custGeom>
              <a:avLst/>
              <a:gdLst/>
              <a:ahLst/>
              <a:cxnLst/>
              <a:rect l="0" t="0" r="0" b="0"/>
              <a:pathLst>
                <a:path w="556" h="254135">
                  <a:moveTo>
                    <a:pt x="556" y="254135"/>
                  </a:moveTo>
                  <a:lnTo>
                    <a:pt x="553" y="254135"/>
                  </a:lnTo>
                  <a:lnTo>
                    <a:pt x="553" y="253637"/>
                  </a:lnTo>
                  <a:lnTo>
                    <a:pt x="553" y="253140"/>
                  </a:lnTo>
                  <a:lnTo>
                    <a:pt x="552" y="252643"/>
                  </a:lnTo>
                  <a:lnTo>
                    <a:pt x="552" y="252145"/>
                  </a:lnTo>
                  <a:lnTo>
                    <a:pt x="552" y="251648"/>
                  </a:lnTo>
                  <a:lnTo>
                    <a:pt x="552" y="251151"/>
                  </a:lnTo>
                  <a:lnTo>
                    <a:pt x="552" y="250653"/>
                  </a:lnTo>
                  <a:lnTo>
                    <a:pt x="551" y="250156"/>
                  </a:lnTo>
                  <a:lnTo>
                    <a:pt x="551" y="249659"/>
                  </a:lnTo>
                  <a:lnTo>
                    <a:pt x="551" y="249161"/>
                  </a:lnTo>
                  <a:lnTo>
                    <a:pt x="550" y="248664"/>
                  </a:lnTo>
                  <a:lnTo>
                    <a:pt x="550" y="248167"/>
                  </a:lnTo>
                  <a:lnTo>
                    <a:pt x="550" y="247669"/>
                  </a:lnTo>
                  <a:lnTo>
                    <a:pt x="549" y="247172"/>
                  </a:lnTo>
                  <a:lnTo>
                    <a:pt x="549" y="246675"/>
                  </a:lnTo>
                  <a:lnTo>
                    <a:pt x="548" y="246177"/>
                  </a:lnTo>
                  <a:lnTo>
                    <a:pt x="548" y="245680"/>
                  </a:lnTo>
                  <a:lnTo>
                    <a:pt x="548" y="245183"/>
                  </a:lnTo>
                  <a:lnTo>
                    <a:pt x="547" y="244685"/>
                  </a:lnTo>
                  <a:lnTo>
                    <a:pt x="547" y="244188"/>
                  </a:lnTo>
                  <a:lnTo>
                    <a:pt x="546" y="243691"/>
                  </a:lnTo>
                  <a:lnTo>
                    <a:pt x="546" y="243193"/>
                  </a:lnTo>
                  <a:lnTo>
                    <a:pt x="545" y="242696"/>
                  </a:lnTo>
                  <a:lnTo>
                    <a:pt x="544" y="242199"/>
                  </a:lnTo>
                  <a:lnTo>
                    <a:pt x="544" y="241701"/>
                  </a:lnTo>
                  <a:lnTo>
                    <a:pt x="543" y="241204"/>
                  </a:lnTo>
                  <a:lnTo>
                    <a:pt x="542" y="240707"/>
                  </a:lnTo>
                  <a:lnTo>
                    <a:pt x="542" y="240209"/>
                  </a:lnTo>
                  <a:lnTo>
                    <a:pt x="541" y="239712"/>
                  </a:lnTo>
                  <a:lnTo>
                    <a:pt x="540" y="239215"/>
                  </a:lnTo>
                  <a:lnTo>
                    <a:pt x="539" y="238717"/>
                  </a:lnTo>
                  <a:lnTo>
                    <a:pt x="538" y="238220"/>
                  </a:lnTo>
                  <a:lnTo>
                    <a:pt x="538" y="237723"/>
                  </a:lnTo>
                  <a:lnTo>
                    <a:pt x="537" y="237225"/>
                  </a:lnTo>
                  <a:lnTo>
                    <a:pt x="536" y="236728"/>
                  </a:lnTo>
                  <a:lnTo>
                    <a:pt x="535" y="236231"/>
                  </a:lnTo>
                  <a:lnTo>
                    <a:pt x="534" y="235733"/>
                  </a:lnTo>
                  <a:lnTo>
                    <a:pt x="533" y="235236"/>
                  </a:lnTo>
                  <a:lnTo>
                    <a:pt x="531" y="234739"/>
                  </a:lnTo>
                  <a:lnTo>
                    <a:pt x="530" y="234241"/>
                  </a:lnTo>
                  <a:lnTo>
                    <a:pt x="529" y="233744"/>
                  </a:lnTo>
                  <a:lnTo>
                    <a:pt x="528" y="233247"/>
                  </a:lnTo>
                  <a:lnTo>
                    <a:pt x="527" y="232749"/>
                  </a:lnTo>
                  <a:lnTo>
                    <a:pt x="525" y="232252"/>
                  </a:lnTo>
                  <a:lnTo>
                    <a:pt x="524" y="231755"/>
                  </a:lnTo>
                  <a:lnTo>
                    <a:pt x="522" y="231257"/>
                  </a:lnTo>
                  <a:lnTo>
                    <a:pt x="521" y="230760"/>
                  </a:lnTo>
                  <a:lnTo>
                    <a:pt x="519" y="230263"/>
                  </a:lnTo>
                  <a:lnTo>
                    <a:pt x="518" y="229765"/>
                  </a:lnTo>
                  <a:lnTo>
                    <a:pt x="516" y="229268"/>
                  </a:lnTo>
                  <a:lnTo>
                    <a:pt x="515" y="228771"/>
                  </a:lnTo>
                  <a:lnTo>
                    <a:pt x="513" y="228273"/>
                  </a:lnTo>
                  <a:lnTo>
                    <a:pt x="511" y="227776"/>
                  </a:lnTo>
                  <a:lnTo>
                    <a:pt x="509" y="227279"/>
                  </a:lnTo>
                  <a:lnTo>
                    <a:pt x="507" y="226782"/>
                  </a:lnTo>
                  <a:lnTo>
                    <a:pt x="505" y="226284"/>
                  </a:lnTo>
                  <a:lnTo>
                    <a:pt x="503" y="225787"/>
                  </a:lnTo>
                  <a:lnTo>
                    <a:pt x="501" y="225290"/>
                  </a:lnTo>
                  <a:lnTo>
                    <a:pt x="499" y="224792"/>
                  </a:lnTo>
                  <a:lnTo>
                    <a:pt x="497" y="224295"/>
                  </a:lnTo>
                  <a:lnTo>
                    <a:pt x="495" y="223798"/>
                  </a:lnTo>
                  <a:lnTo>
                    <a:pt x="493" y="223300"/>
                  </a:lnTo>
                  <a:lnTo>
                    <a:pt x="490" y="222803"/>
                  </a:lnTo>
                  <a:lnTo>
                    <a:pt x="488" y="222306"/>
                  </a:lnTo>
                  <a:lnTo>
                    <a:pt x="485" y="221808"/>
                  </a:lnTo>
                  <a:lnTo>
                    <a:pt x="483" y="221311"/>
                  </a:lnTo>
                  <a:lnTo>
                    <a:pt x="480" y="220814"/>
                  </a:lnTo>
                  <a:lnTo>
                    <a:pt x="478" y="220316"/>
                  </a:lnTo>
                  <a:lnTo>
                    <a:pt x="475" y="219819"/>
                  </a:lnTo>
                  <a:lnTo>
                    <a:pt x="472" y="219322"/>
                  </a:lnTo>
                  <a:lnTo>
                    <a:pt x="470" y="218824"/>
                  </a:lnTo>
                  <a:lnTo>
                    <a:pt x="467" y="218327"/>
                  </a:lnTo>
                  <a:lnTo>
                    <a:pt x="464" y="217830"/>
                  </a:lnTo>
                  <a:lnTo>
                    <a:pt x="461" y="217332"/>
                  </a:lnTo>
                  <a:lnTo>
                    <a:pt x="458" y="216835"/>
                  </a:lnTo>
                  <a:lnTo>
                    <a:pt x="455" y="216338"/>
                  </a:lnTo>
                  <a:lnTo>
                    <a:pt x="452" y="215840"/>
                  </a:lnTo>
                  <a:lnTo>
                    <a:pt x="449" y="215343"/>
                  </a:lnTo>
                  <a:lnTo>
                    <a:pt x="446" y="214846"/>
                  </a:lnTo>
                  <a:lnTo>
                    <a:pt x="443" y="214348"/>
                  </a:lnTo>
                  <a:lnTo>
                    <a:pt x="439" y="213851"/>
                  </a:lnTo>
                  <a:lnTo>
                    <a:pt x="436" y="213354"/>
                  </a:lnTo>
                  <a:lnTo>
                    <a:pt x="433" y="212856"/>
                  </a:lnTo>
                  <a:lnTo>
                    <a:pt x="430" y="212359"/>
                  </a:lnTo>
                  <a:lnTo>
                    <a:pt x="426" y="211862"/>
                  </a:lnTo>
                  <a:lnTo>
                    <a:pt x="423" y="211364"/>
                  </a:lnTo>
                  <a:lnTo>
                    <a:pt x="419" y="210867"/>
                  </a:lnTo>
                  <a:lnTo>
                    <a:pt x="416" y="210370"/>
                  </a:lnTo>
                  <a:lnTo>
                    <a:pt x="412" y="209872"/>
                  </a:lnTo>
                  <a:lnTo>
                    <a:pt x="409" y="209375"/>
                  </a:lnTo>
                  <a:lnTo>
                    <a:pt x="405" y="208878"/>
                  </a:lnTo>
                  <a:lnTo>
                    <a:pt x="402" y="208380"/>
                  </a:lnTo>
                  <a:lnTo>
                    <a:pt x="398" y="207883"/>
                  </a:lnTo>
                  <a:lnTo>
                    <a:pt x="395" y="207386"/>
                  </a:lnTo>
                  <a:lnTo>
                    <a:pt x="391" y="206888"/>
                  </a:lnTo>
                  <a:lnTo>
                    <a:pt x="387" y="206391"/>
                  </a:lnTo>
                  <a:lnTo>
                    <a:pt x="384" y="205894"/>
                  </a:lnTo>
                  <a:lnTo>
                    <a:pt x="380" y="205396"/>
                  </a:lnTo>
                  <a:lnTo>
                    <a:pt x="376" y="204899"/>
                  </a:lnTo>
                  <a:lnTo>
                    <a:pt x="373" y="204402"/>
                  </a:lnTo>
                  <a:lnTo>
                    <a:pt x="369" y="203904"/>
                  </a:lnTo>
                  <a:lnTo>
                    <a:pt x="365" y="203407"/>
                  </a:lnTo>
                  <a:lnTo>
                    <a:pt x="362" y="202910"/>
                  </a:lnTo>
                  <a:lnTo>
                    <a:pt x="358" y="202412"/>
                  </a:lnTo>
                  <a:lnTo>
                    <a:pt x="354" y="201915"/>
                  </a:lnTo>
                  <a:lnTo>
                    <a:pt x="351" y="201418"/>
                  </a:lnTo>
                  <a:lnTo>
                    <a:pt x="347" y="200920"/>
                  </a:lnTo>
                  <a:lnTo>
                    <a:pt x="343" y="200423"/>
                  </a:lnTo>
                  <a:lnTo>
                    <a:pt x="340" y="199926"/>
                  </a:lnTo>
                  <a:lnTo>
                    <a:pt x="336" y="199428"/>
                  </a:lnTo>
                  <a:lnTo>
                    <a:pt x="333" y="198931"/>
                  </a:lnTo>
                  <a:lnTo>
                    <a:pt x="329" y="198434"/>
                  </a:lnTo>
                  <a:lnTo>
                    <a:pt x="326" y="197936"/>
                  </a:lnTo>
                  <a:lnTo>
                    <a:pt x="322" y="197439"/>
                  </a:lnTo>
                  <a:lnTo>
                    <a:pt x="319" y="196942"/>
                  </a:lnTo>
                  <a:lnTo>
                    <a:pt x="315" y="196444"/>
                  </a:lnTo>
                  <a:lnTo>
                    <a:pt x="312" y="195947"/>
                  </a:lnTo>
                  <a:lnTo>
                    <a:pt x="308" y="195450"/>
                  </a:lnTo>
                  <a:lnTo>
                    <a:pt x="305" y="194952"/>
                  </a:lnTo>
                  <a:lnTo>
                    <a:pt x="302" y="194455"/>
                  </a:lnTo>
                  <a:lnTo>
                    <a:pt x="298" y="193958"/>
                  </a:lnTo>
                  <a:lnTo>
                    <a:pt x="295" y="193460"/>
                  </a:lnTo>
                  <a:lnTo>
                    <a:pt x="292" y="192963"/>
                  </a:lnTo>
                  <a:lnTo>
                    <a:pt x="289" y="192466"/>
                  </a:lnTo>
                  <a:lnTo>
                    <a:pt x="285" y="191968"/>
                  </a:lnTo>
                  <a:lnTo>
                    <a:pt x="282" y="191471"/>
                  </a:lnTo>
                  <a:lnTo>
                    <a:pt x="279" y="190974"/>
                  </a:lnTo>
                  <a:lnTo>
                    <a:pt x="276" y="190476"/>
                  </a:lnTo>
                  <a:lnTo>
                    <a:pt x="273" y="189979"/>
                  </a:lnTo>
                  <a:lnTo>
                    <a:pt x="270" y="189482"/>
                  </a:lnTo>
                  <a:lnTo>
                    <a:pt x="267" y="188985"/>
                  </a:lnTo>
                  <a:lnTo>
                    <a:pt x="264" y="188487"/>
                  </a:lnTo>
                  <a:lnTo>
                    <a:pt x="261" y="187990"/>
                  </a:lnTo>
                  <a:lnTo>
                    <a:pt x="259" y="187493"/>
                  </a:lnTo>
                  <a:lnTo>
                    <a:pt x="256" y="186995"/>
                  </a:lnTo>
                  <a:lnTo>
                    <a:pt x="253" y="186498"/>
                  </a:lnTo>
                  <a:lnTo>
                    <a:pt x="250" y="186001"/>
                  </a:lnTo>
                  <a:lnTo>
                    <a:pt x="248" y="185503"/>
                  </a:lnTo>
                  <a:lnTo>
                    <a:pt x="245" y="185006"/>
                  </a:lnTo>
                  <a:lnTo>
                    <a:pt x="242" y="184509"/>
                  </a:lnTo>
                  <a:lnTo>
                    <a:pt x="240" y="184011"/>
                  </a:lnTo>
                  <a:lnTo>
                    <a:pt x="237" y="183514"/>
                  </a:lnTo>
                  <a:lnTo>
                    <a:pt x="235" y="183017"/>
                  </a:lnTo>
                  <a:lnTo>
                    <a:pt x="232" y="182519"/>
                  </a:lnTo>
                  <a:lnTo>
                    <a:pt x="230" y="182022"/>
                  </a:lnTo>
                  <a:lnTo>
                    <a:pt x="227" y="181525"/>
                  </a:lnTo>
                  <a:lnTo>
                    <a:pt x="225" y="181027"/>
                  </a:lnTo>
                  <a:lnTo>
                    <a:pt x="222" y="180530"/>
                  </a:lnTo>
                  <a:lnTo>
                    <a:pt x="220" y="180033"/>
                  </a:lnTo>
                  <a:lnTo>
                    <a:pt x="217" y="179535"/>
                  </a:lnTo>
                  <a:lnTo>
                    <a:pt x="215" y="179038"/>
                  </a:lnTo>
                  <a:lnTo>
                    <a:pt x="213" y="178541"/>
                  </a:lnTo>
                  <a:lnTo>
                    <a:pt x="210" y="178043"/>
                  </a:lnTo>
                  <a:lnTo>
                    <a:pt x="208" y="177546"/>
                  </a:lnTo>
                  <a:lnTo>
                    <a:pt x="205" y="177049"/>
                  </a:lnTo>
                  <a:lnTo>
                    <a:pt x="203" y="176551"/>
                  </a:lnTo>
                  <a:lnTo>
                    <a:pt x="201" y="176054"/>
                  </a:lnTo>
                  <a:lnTo>
                    <a:pt x="198" y="175557"/>
                  </a:lnTo>
                  <a:lnTo>
                    <a:pt x="196" y="175059"/>
                  </a:lnTo>
                  <a:lnTo>
                    <a:pt x="193" y="174562"/>
                  </a:lnTo>
                  <a:lnTo>
                    <a:pt x="191" y="174065"/>
                  </a:lnTo>
                  <a:lnTo>
                    <a:pt x="188" y="173567"/>
                  </a:lnTo>
                  <a:lnTo>
                    <a:pt x="186" y="173070"/>
                  </a:lnTo>
                  <a:lnTo>
                    <a:pt x="184" y="172573"/>
                  </a:lnTo>
                  <a:lnTo>
                    <a:pt x="181" y="172075"/>
                  </a:lnTo>
                  <a:lnTo>
                    <a:pt x="179" y="171578"/>
                  </a:lnTo>
                  <a:lnTo>
                    <a:pt x="176" y="171081"/>
                  </a:lnTo>
                  <a:lnTo>
                    <a:pt x="174" y="170583"/>
                  </a:lnTo>
                  <a:lnTo>
                    <a:pt x="171" y="170086"/>
                  </a:lnTo>
                  <a:lnTo>
                    <a:pt x="168" y="169589"/>
                  </a:lnTo>
                  <a:lnTo>
                    <a:pt x="166" y="169091"/>
                  </a:lnTo>
                  <a:lnTo>
                    <a:pt x="163" y="168594"/>
                  </a:lnTo>
                  <a:lnTo>
                    <a:pt x="160" y="168097"/>
                  </a:lnTo>
                  <a:lnTo>
                    <a:pt x="158" y="167599"/>
                  </a:lnTo>
                  <a:lnTo>
                    <a:pt x="155" y="167102"/>
                  </a:lnTo>
                  <a:lnTo>
                    <a:pt x="152" y="166605"/>
                  </a:lnTo>
                  <a:lnTo>
                    <a:pt x="150" y="166107"/>
                  </a:lnTo>
                  <a:lnTo>
                    <a:pt x="147" y="165610"/>
                  </a:lnTo>
                  <a:lnTo>
                    <a:pt x="144" y="165113"/>
                  </a:lnTo>
                  <a:lnTo>
                    <a:pt x="141" y="164615"/>
                  </a:lnTo>
                  <a:lnTo>
                    <a:pt x="138" y="164118"/>
                  </a:lnTo>
                  <a:lnTo>
                    <a:pt x="135" y="163621"/>
                  </a:lnTo>
                  <a:lnTo>
                    <a:pt x="132" y="163123"/>
                  </a:lnTo>
                  <a:lnTo>
                    <a:pt x="129" y="162626"/>
                  </a:lnTo>
                  <a:lnTo>
                    <a:pt x="126" y="162129"/>
                  </a:lnTo>
                  <a:lnTo>
                    <a:pt x="123" y="161631"/>
                  </a:lnTo>
                  <a:lnTo>
                    <a:pt x="120" y="161134"/>
                  </a:lnTo>
                  <a:lnTo>
                    <a:pt x="117" y="160637"/>
                  </a:lnTo>
                  <a:lnTo>
                    <a:pt x="114" y="160139"/>
                  </a:lnTo>
                  <a:lnTo>
                    <a:pt x="111" y="159642"/>
                  </a:lnTo>
                  <a:lnTo>
                    <a:pt x="108" y="159145"/>
                  </a:lnTo>
                  <a:lnTo>
                    <a:pt x="105" y="158647"/>
                  </a:lnTo>
                  <a:lnTo>
                    <a:pt x="102" y="158150"/>
                  </a:lnTo>
                  <a:lnTo>
                    <a:pt x="99" y="157653"/>
                  </a:lnTo>
                  <a:lnTo>
                    <a:pt x="96" y="157155"/>
                  </a:lnTo>
                  <a:lnTo>
                    <a:pt x="93" y="156658"/>
                  </a:lnTo>
                  <a:lnTo>
                    <a:pt x="89" y="156161"/>
                  </a:lnTo>
                  <a:lnTo>
                    <a:pt x="86" y="155663"/>
                  </a:lnTo>
                  <a:lnTo>
                    <a:pt x="83" y="155166"/>
                  </a:lnTo>
                  <a:lnTo>
                    <a:pt x="80" y="154669"/>
                  </a:lnTo>
                  <a:lnTo>
                    <a:pt x="77" y="154171"/>
                  </a:lnTo>
                  <a:lnTo>
                    <a:pt x="74" y="153674"/>
                  </a:lnTo>
                  <a:lnTo>
                    <a:pt x="71" y="153177"/>
                  </a:lnTo>
                  <a:lnTo>
                    <a:pt x="68" y="152679"/>
                  </a:lnTo>
                  <a:lnTo>
                    <a:pt x="65" y="152182"/>
                  </a:lnTo>
                  <a:lnTo>
                    <a:pt x="62" y="151685"/>
                  </a:lnTo>
                  <a:lnTo>
                    <a:pt x="59" y="151188"/>
                  </a:lnTo>
                  <a:lnTo>
                    <a:pt x="56" y="150690"/>
                  </a:lnTo>
                  <a:lnTo>
                    <a:pt x="53" y="150193"/>
                  </a:lnTo>
                  <a:lnTo>
                    <a:pt x="50" y="149696"/>
                  </a:lnTo>
                  <a:lnTo>
                    <a:pt x="48" y="149198"/>
                  </a:lnTo>
                  <a:lnTo>
                    <a:pt x="45" y="148701"/>
                  </a:lnTo>
                  <a:lnTo>
                    <a:pt x="42" y="148204"/>
                  </a:lnTo>
                  <a:lnTo>
                    <a:pt x="40" y="147706"/>
                  </a:lnTo>
                  <a:lnTo>
                    <a:pt x="37" y="147209"/>
                  </a:lnTo>
                  <a:lnTo>
                    <a:pt x="35" y="146712"/>
                  </a:lnTo>
                  <a:lnTo>
                    <a:pt x="32" y="146214"/>
                  </a:lnTo>
                  <a:lnTo>
                    <a:pt x="30" y="145717"/>
                  </a:lnTo>
                  <a:lnTo>
                    <a:pt x="28" y="145220"/>
                  </a:lnTo>
                  <a:lnTo>
                    <a:pt x="25" y="144722"/>
                  </a:lnTo>
                  <a:lnTo>
                    <a:pt x="23" y="144225"/>
                  </a:lnTo>
                  <a:lnTo>
                    <a:pt x="21" y="143728"/>
                  </a:lnTo>
                  <a:lnTo>
                    <a:pt x="19" y="143230"/>
                  </a:lnTo>
                  <a:lnTo>
                    <a:pt x="17" y="142733"/>
                  </a:lnTo>
                  <a:lnTo>
                    <a:pt x="16" y="142236"/>
                  </a:lnTo>
                  <a:lnTo>
                    <a:pt x="14" y="141738"/>
                  </a:lnTo>
                  <a:lnTo>
                    <a:pt x="12" y="141241"/>
                  </a:lnTo>
                  <a:lnTo>
                    <a:pt x="11" y="140744"/>
                  </a:lnTo>
                  <a:lnTo>
                    <a:pt x="9" y="140246"/>
                  </a:lnTo>
                  <a:lnTo>
                    <a:pt x="8" y="139749"/>
                  </a:lnTo>
                  <a:lnTo>
                    <a:pt x="7" y="139252"/>
                  </a:lnTo>
                  <a:lnTo>
                    <a:pt x="6" y="138754"/>
                  </a:lnTo>
                  <a:lnTo>
                    <a:pt x="5" y="138257"/>
                  </a:lnTo>
                  <a:lnTo>
                    <a:pt x="4" y="137760"/>
                  </a:lnTo>
                  <a:lnTo>
                    <a:pt x="3" y="137262"/>
                  </a:lnTo>
                  <a:lnTo>
                    <a:pt x="2" y="136765"/>
                  </a:lnTo>
                  <a:lnTo>
                    <a:pt x="1" y="136268"/>
                  </a:lnTo>
                  <a:lnTo>
                    <a:pt x="1" y="135770"/>
                  </a:lnTo>
                  <a:lnTo>
                    <a:pt x="0" y="135273"/>
                  </a:lnTo>
                  <a:lnTo>
                    <a:pt x="0" y="134776"/>
                  </a:lnTo>
                  <a:lnTo>
                    <a:pt x="0" y="134278"/>
                  </a:lnTo>
                  <a:lnTo>
                    <a:pt x="0" y="133781"/>
                  </a:lnTo>
                  <a:lnTo>
                    <a:pt x="0" y="133284"/>
                  </a:lnTo>
                  <a:lnTo>
                    <a:pt x="0" y="132786"/>
                  </a:lnTo>
                  <a:lnTo>
                    <a:pt x="0" y="132289"/>
                  </a:lnTo>
                  <a:lnTo>
                    <a:pt x="0" y="131792"/>
                  </a:lnTo>
                  <a:lnTo>
                    <a:pt x="0" y="131294"/>
                  </a:lnTo>
                  <a:lnTo>
                    <a:pt x="0" y="130797"/>
                  </a:lnTo>
                  <a:lnTo>
                    <a:pt x="1" y="130300"/>
                  </a:lnTo>
                  <a:lnTo>
                    <a:pt x="1" y="129802"/>
                  </a:lnTo>
                  <a:lnTo>
                    <a:pt x="2" y="129305"/>
                  </a:lnTo>
                  <a:lnTo>
                    <a:pt x="3" y="128808"/>
                  </a:lnTo>
                  <a:lnTo>
                    <a:pt x="4" y="128310"/>
                  </a:lnTo>
                  <a:lnTo>
                    <a:pt x="4" y="127813"/>
                  </a:lnTo>
                  <a:lnTo>
                    <a:pt x="5" y="127316"/>
                  </a:lnTo>
                  <a:lnTo>
                    <a:pt x="6" y="126818"/>
                  </a:lnTo>
                  <a:lnTo>
                    <a:pt x="7" y="126321"/>
                  </a:lnTo>
                  <a:lnTo>
                    <a:pt x="8" y="125824"/>
                  </a:lnTo>
                  <a:lnTo>
                    <a:pt x="10" y="125326"/>
                  </a:lnTo>
                  <a:lnTo>
                    <a:pt x="11" y="124829"/>
                  </a:lnTo>
                  <a:lnTo>
                    <a:pt x="12" y="124332"/>
                  </a:lnTo>
                  <a:lnTo>
                    <a:pt x="13" y="123834"/>
                  </a:lnTo>
                  <a:lnTo>
                    <a:pt x="15" y="123337"/>
                  </a:lnTo>
                  <a:lnTo>
                    <a:pt x="16" y="122840"/>
                  </a:lnTo>
                  <a:lnTo>
                    <a:pt x="17" y="122342"/>
                  </a:lnTo>
                  <a:lnTo>
                    <a:pt x="19" y="121845"/>
                  </a:lnTo>
                  <a:lnTo>
                    <a:pt x="20" y="121348"/>
                  </a:lnTo>
                  <a:lnTo>
                    <a:pt x="22" y="120850"/>
                  </a:lnTo>
                  <a:lnTo>
                    <a:pt x="23" y="120353"/>
                  </a:lnTo>
                  <a:lnTo>
                    <a:pt x="25" y="119856"/>
                  </a:lnTo>
                  <a:lnTo>
                    <a:pt x="27" y="119358"/>
                  </a:lnTo>
                  <a:lnTo>
                    <a:pt x="28" y="118861"/>
                  </a:lnTo>
                  <a:lnTo>
                    <a:pt x="30" y="118364"/>
                  </a:lnTo>
                  <a:lnTo>
                    <a:pt x="31" y="117866"/>
                  </a:lnTo>
                  <a:lnTo>
                    <a:pt x="33" y="117369"/>
                  </a:lnTo>
                  <a:lnTo>
                    <a:pt x="35" y="116872"/>
                  </a:lnTo>
                  <a:lnTo>
                    <a:pt x="36" y="116374"/>
                  </a:lnTo>
                  <a:lnTo>
                    <a:pt x="38" y="115877"/>
                  </a:lnTo>
                  <a:lnTo>
                    <a:pt x="40" y="115380"/>
                  </a:lnTo>
                  <a:lnTo>
                    <a:pt x="41" y="114882"/>
                  </a:lnTo>
                  <a:lnTo>
                    <a:pt x="43" y="114385"/>
                  </a:lnTo>
                  <a:lnTo>
                    <a:pt x="44" y="113888"/>
                  </a:lnTo>
                  <a:lnTo>
                    <a:pt x="46" y="113391"/>
                  </a:lnTo>
                  <a:lnTo>
                    <a:pt x="48" y="112893"/>
                  </a:lnTo>
                  <a:lnTo>
                    <a:pt x="49" y="112396"/>
                  </a:lnTo>
                  <a:lnTo>
                    <a:pt x="51" y="111899"/>
                  </a:lnTo>
                  <a:lnTo>
                    <a:pt x="52" y="111401"/>
                  </a:lnTo>
                  <a:lnTo>
                    <a:pt x="54" y="110904"/>
                  </a:lnTo>
                  <a:lnTo>
                    <a:pt x="55" y="110407"/>
                  </a:lnTo>
                  <a:lnTo>
                    <a:pt x="57" y="109909"/>
                  </a:lnTo>
                  <a:lnTo>
                    <a:pt x="58" y="109412"/>
                  </a:lnTo>
                  <a:lnTo>
                    <a:pt x="59" y="108915"/>
                  </a:lnTo>
                  <a:lnTo>
                    <a:pt x="61" y="108417"/>
                  </a:lnTo>
                  <a:lnTo>
                    <a:pt x="62" y="107920"/>
                  </a:lnTo>
                  <a:lnTo>
                    <a:pt x="64" y="107423"/>
                  </a:lnTo>
                  <a:lnTo>
                    <a:pt x="65" y="106925"/>
                  </a:lnTo>
                  <a:lnTo>
                    <a:pt x="66" y="106428"/>
                  </a:lnTo>
                  <a:lnTo>
                    <a:pt x="67" y="105931"/>
                  </a:lnTo>
                  <a:lnTo>
                    <a:pt x="69" y="105433"/>
                  </a:lnTo>
                  <a:lnTo>
                    <a:pt x="70" y="104936"/>
                  </a:lnTo>
                  <a:lnTo>
                    <a:pt x="71" y="104439"/>
                  </a:lnTo>
                  <a:lnTo>
                    <a:pt x="72" y="103941"/>
                  </a:lnTo>
                  <a:lnTo>
                    <a:pt x="73" y="103444"/>
                  </a:lnTo>
                  <a:lnTo>
                    <a:pt x="74" y="102947"/>
                  </a:lnTo>
                  <a:lnTo>
                    <a:pt x="75" y="102449"/>
                  </a:lnTo>
                  <a:lnTo>
                    <a:pt x="76" y="101952"/>
                  </a:lnTo>
                  <a:lnTo>
                    <a:pt x="77" y="101455"/>
                  </a:lnTo>
                  <a:lnTo>
                    <a:pt x="79" y="100957"/>
                  </a:lnTo>
                  <a:lnTo>
                    <a:pt x="80" y="100460"/>
                  </a:lnTo>
                  <a:lnTo>
                    <a:pt x="80" y="99963"/>
                  </a:lnTo>
                  <a:lnTo>
                    <a:pt x="81" y="99465"/>
                  </a:lnTo>
                  <a:lnTo>
                    <a:pt x="82" y="98968"/>
                  </a:lnTo>
                  <a:lnTo>
                    <a:pt x="83" y="98471"/>
                  </a:lnTo>
                  <a:lnTo>
                    <a:pt x="84" y="97973"/>
                  </a:lnTo>
                  <a:lnTo>
                    <a:pt x="85" y="97476"/>
                  </a:lnTo>
                  <a:lnTo>
                    <a:pt x="86" y="96979"/>
                  </a:lnTo>
                  <a:lnTo>
                    <a:pt x="87" y="96481"/>
                  </a:lnTo>
                  <a:lnTo>
                    <a:pt x="88" y="95984"/>
                  </a:lnTo>
                  <a:lnTo>
                    <a:pt x="89" y="95487"/>
                  </a:lnTo>
                  <a:lnTo>
                    <a:pt x="90" y="94989"/>
                  </a:lnTo>
                  <a:lnTo>
                    <a:pt x="91" y="94492"/>
                  </a:lnTo>
                  <a:lnTo>
                    <a:pt x="92" y="93995"/>
                  </a:lnTo>
                  <a:lnTo>
                    <a:pt x="92" y="93497"/>
                  </a:lnTo>
                  <a:lnTo>
                    <a:pt x="93" y="93000"/>
                  </a:lnTo>
                  <a:lnTo>
                    <a:pt x="94" y="92503"/>
                  </a:lnTo>
                  <a:lnTo>
                    <a:pt x="95" y="92005"/>
                  </a:lnTo>
                  <a:lnTo>
                    <a:pt x="96" y="91508"/>
                  </a:lnTo>
                  <a:lnTo>
                    <a:pt x="97" y="91011"/>
                  </a:lnTo>
                  <a:lnTo>
                    <a:pt x="98" y="90513"/>
                  </a:lnTo>
                  <a:lnTo>
                    <a:pt x="99" y="90016"/>
                  </a:lnTo>
                  <a:lnTo>
                    <a:pt x="100" y="89519"/>
                  </a:lnTo>
                  <a:lnTo>
                    <a:pt x="101" y="89021"/>
                  </a:lnTo>
                  <a:lnTo>
                    <a:pt x="103" y="88524"/>
                  </a:lnTo>
                  <a:lnTo>
                    <a:pt x="104" y="88027"/>
                  </a:lnTo>
                  <a:lnTo>
                    <a:pt x="105" y="87529"/>
                  </a:lnTo>
                  <a:lnTo>
                    <a:pt x="106" y="87032"/>
                  </a:lnTo>
                  <a:lnTo>
                    <a:pt x="107" y="86535"/>
                  </a:lnTo>
                  <a:lnTo>
                    <a:pt x="109" y="86037"/>
                  </a:lnTo>
                  <a:lnTo>
                    <a:pt x="110" y="85540"/>
                  </a:lnTo>
                  <a:lnTo>
                    <a:pt x="111" y="85043"/>
                  </a:lnTo>
                  <a:lnTo>
                    <a:pt x="113" y="84545"/>
                  </a:lnTo>
                  <a:lnTo>
                    <a:pt x="114" y="84048"/>
                  </a:lnTo>
                  <a:lnTo>
                    <a:pt x="116" y="83551"/>
                  </a:lnTo>
                  <a:lnTo>
                    <a:pt x="118" y="83053"/>
                  </a:lnTo>
                  <a:lnTo>
                    <a:pt x="119" y="82556"/>
                  </a:lnTo>
                  <a:lnTo>
                    <a:pt x="121" y="82059"/>
                  </a:lnTo>
                  <a:lnTo>
                    <a:pt x="123" y="81561"/>
                  </a:lnTo>
                  <a:lnTo>
                    <a:pt x="124" y="81064"/>
                  </a:lnTo>
                  <a:lnTo>
                    <a:pt x="126" y="80567"/>
                  </a:lnTo>
                  <a:lnTo>
                    <a:pt x="128" y="80069"/>
                  </a:lnTo>
                  <a:lnTo>
                    <a:pt x="130" y="79572"/>
                  </a:lnTo>
                  <a:lnTo>
                    <a:pt x="132" y="79075"/>
                  </a:lnTo>
                  <a:lnTo>
                    <a:pt x="134" y="78577"/>
                  </a:lnTo>
                  <a:lnTo>
                    <a:pt x="137" y="78080"/>
                  </a:lnTo>
                  <a:lnTo>
                    <a:pt x="139" y="77583"/>
                  </a:lnTo>
                  <a:lnTo>
                    <a:pt x="141" y="77085"/>
                  </a:lnTo>
                  <a:lnTo>
                    <a:pt x="144" y="76588"/>
                  </a:lnTo>
                  <a:lnTo>
                    <a:pt x="146" y="76091"/>
                  </a:lnTo>
                  <a:lnTo>
                    <a:pt x="149" y="75594"/>
                  </a:lnTo>
                  <a:lnTo>
                    <a:pt x="151" y="75096"/>
                  </a:lnTo>
                  <a:lnTo>
                    <a:pt x="154" y="74599"/>
                  </a:lnTo>
                  <a:lnTo>
                    <a:pt x="156" y="74102"/>
                  </a:lnTo>
                  <a:lnTo>
                    <a:pt x="159" y="73604"/>
                  </a:lnTo>
                  <a:lnTo>
                    <a:pt x="162" y="73107"/>
                  </a:lnTo>
                  <a:lnTo>
                    <a:pt x="165" y="72610"/>
                  </a:lnTo>
                  <a:lnTo>
                    <a:pt x="168" y="72112"/>
                  </a:lnTo>
                  <a:lnTo>
                    <a:pt x="171" y="71615"/>
                  </a:lnTo>
                  <a:lnTo>
                    <a:pt x="174" y="71118"/>
                  </a:lnTo>
                  <a:lnTo>
                    <a:pt x="177" y="70620"/>
                  </a:lnTo>
                  <a:lnTo>
                    <a:pt x="181" y="70123"/>
                  </a:lnTo>
                  <a:lnTo>
                    <a:pt x="184" y="69626"/>
                  </a:lnTo>
                  <a:lnTo>
                    <a:pt x="187" y="69128"/>
                  </a:lnTo>
                  <a:lnTo>
                    <a:pt x="191" y="68631"/>
                  </a:lnTo>
                  <a:lnTo>
                    <a:pt x="194" y="68134"/>
                  </a:lnTo>
                  <a:lnTo>
                    <a:pt x="198" y="67636"/>
                  </a:lnTo>
                  <a:lnTo>
                    <a:pt x="202" y="67139"/>
                  </a:lnTo>
                  <a:lnTo>
                    <a:pt x="205" y="66642"/>
                  </a:lnTo>
                  <a:lnTo>
                    <a:pt x="209" y="66144"/>
                  </a:lnTo>
                  <a:lnTo>
                    <a:pt x="213" y="65647"/>
                  </a:lnTo>
                  <a:lnTo>
                    <a:pt x="217" y="65150"/>
                  </a:lnTo>
                  <a:lnTo>
                    <a:pt x="221" y="64652"/>
                  </a:lnTo>
                  <a:lnTo>
                    <a:pt x="225" y="64155"/>
                  </a:lnTo>
                  <a:lnTo>
                    <a:pt x="229" y="63658"/>
                  </a:lnTo>
                  <a:lnTo>
                    <a:pt x="233" y="63160"/>
                  </a:lnTo>
                  <a:lnTo>
                    <a:pt x="237" y="62663"/>
                  </a:lnTo>
                  <a:lnTo>
                    <a:pt x="241" y="62166"/>
                  </a:lnTo>
                  <a:lnTo>
                    <a:pt x="245" y="61668"/>
                  </a:lnTo>
                  <a:lnTo>
                    <a:pt x="250" y="61171"/>
                  </a:lnTo>
                  <a:lnTo>
                    <a:pt x="254" y="60674"/>
                  </a:lnTo>
                  <a:lnTo>
                    <a:pt x="258" y="60176"/>
                  </a:lnTo>
                  <a:lnTo>
                    <a:pt x="263" y="59679"/>
                  </a:lnTo>
                  <a:lnTo>
                    <a:pt x="267" y="59182"/>
                  </a:lnTo>
                  <a:lnTo>
                    <a:pt x="271" y="58684"/>
                  </a:lnTo>
                  <a:lnTo>
                    <a:pt x="276" y="58187"/>
                  </a:lnTo>
                  <a:lnTo>
                    <a:pt x="280" y="57690"/>
                  </a:lnTo>
                  <a:lnTo>
                    <a:pt x="285" y="57192"/>
                  </a:lnTo>
                  <a:lnTo>
                    <a:pt x="289" y="56695"/>
                  </a:lnTo>
                  <a:lnTo>
                    <a:pt x="294" y="56198"/>
                  </a:lnTo>
                  <a:lnTo>
                    <a:pt x="298" y="55700"/>
                  </a:lnTo>
                  <a:lnTo>
                    <a:pt x="303" y="55203"/>
                  </a:lnTo>
                  <a:lnTo>
                    <a:pt x="307" y="54706"/>
                  </a:lnTo>
                  <a:lnTo>
                    <a:pt x="312" y="54208"/>
                  </a:lnTo>
                  <a:lnTo>
                    <a:pt x="317" y="53711"/>
                  </a:lnTo>
                  <a:lnTo>
                    <a:pt x="321" y="53214"/>
                  </a:lnTo>
                  <a:lnTo>
                    <a:pt x="326" y="52716"/>
                  </a:lnTo>
                  <a:lnTo>
                    <a:pt x="330" y="52219"/>
                  </a:lnTo>
                  <a:lnTo>
                    <a:pt x="335" y="51722"/>
                  </a:lnTo>
                  <a:lnTo>
                    <a:pt x="339" y="51224"/>
                  </a:lnTo>
                  <a:lnTo>
                    <a:pt x="344" y="50727"/>
                  </a:lnTo>
                  <a:lnTo>
                    <a:pt x="348" y="50230"/>
                  </a:lnTo>
                  <a:lnTo>
                    <a:pt x="353" y="49732"/>
                  </a:lnTo>
                  <a:lnTo>
                    <a:pt x="357" y="49235"/>
                  </a:lnTo>
                  <a:lnTo>
                    <a:pt x="361" y="48738"/>
                  </a:lnTo>
                  <a:lnTo>
                    <a:pt x="366" y="48240"/>
                  </a:lnTo>
                  <a:lnTo>
                    <a:pt x="370" y="47743"/>
                  </a:lnTo>
                  <a:lnTo>
                    <a:pt x="375" y="47246"/>
                  </a:lnTo>
                  <a:lnTo>
                    <a:pt x="379" y="46748"/>
                  </a:lnTo>
                  <a:lnTo>
                    <a:pt x="383" y="46251"/>
                  </a:lnTo>
                  <a:lnTo>
                    <a:pt x="387" y="45754"/>
                  </a:lnTo>
                  <a:lnTo>
                    <a:pt x="392" y="45256"/>
                  </a:lnTo>
                  <a:lnTo>
                    <a:pt x="396" y="44759"/>
                  </a:lnTo>
                  <a:lnTo>
                    <a:pt x="400" y="44262"/>
                  </a:lnTo>
                  <a:lnTo>
                    <a:pt x="404" y="43764"/>
                  </a:lnTo>
                  <a:lnTo>
                    <a:pt x="408" y="43267"/>
                  </a:lnTo>
                  <a:lnTo>
                    <a:pt x="412" y="42770"/>
                  </a:lnTo>
                  <a:lnTo>
                    <a:pt x="416" y="42272"/>
                  </a:lnTo>
                  <a:lnTo>
                    <a:pt x="420" y="41775"/>
                  </a:lnTo>
                  <a:lnTo>
                    <a:pt x="423" y="41278"/>
                  </a:lnTo>
                  <a:lnTo>
                    <a:pt x="427" y="40780"/>
                  </a:lnTo>
                  <a:lnTo>
                    <a:pt x="431" y="40283"/>
                  </a:lnTo>
                  <a:lnTo>
                    <a:pt x="434" y="39786"/>
                  </a:lnTo>
                  <a:lnTo>
                    <a:pt x="438" y="39288"/>
                  </a:lnTo>
                  <a:lnTo>
                    <a:pt x="442" y="38791"/>
                  </a:lnTo>
                  <a:lnTo>
                    <a:pt x="445" y="38294"/>
                  </a:lnTo>
                  <a:lnTo>
                    <a:pt x="448" y="37797"/>
                  </a:lnTo>
                  <a:lnTo>
                    <a:pt x="452" y="37299"/>
                  </a:lnTo>
                  <a:lnTo>
                    <a:pt x="455" y="36802"/>
                  </a:lnTo>
                  <a:lnTo>
                    <a:pt x="458" y="36305"/>
                  </a:lnTo>
                  <a:lnTo>
                    <a:pt x="461" y="35807"/>
                  </a:lnTo>
                  <a:lnTo>
                    <a:pt x="465" y="35310"/>
                  </a:lnTo>
                  <a:lnTo>
                    <a:pt x="468" y="34813"/>
                  </a:lnTo>
                  <a:lnTo>
                    <a:pt x="471" y="34315"/>
                  </a:lnTo>
                  <a:lnTo>
                    <a:pt x="473" y="33818"/>
                  </a:lnTo>
                  <a:lnTo>
                    <a:pt x="476" y="33321"/>
                  </a:lnTo>
                  <a:lnTo>
                    <a:pt x="479" y="32823"/>
                  </a:lnTo>
                  <a:lnTo>
                    <a:pt x="482" y="32326"/>
                  </a:lnTo>
                  <a:lnTo>
                    <a:pt x="484" y="31829"/>
                  </a:lnTo>
                  <a:lnTo>
                    <a:pt x="487" y="31331"/>
                  </a:lnTo>
                  <a:lnTo>
                    <a:pt x="489" y="30834"/>
                  </a:lnTo>
                  <a:lnTo>
                    <a:pt x="492" y="30337"/>
                  </a:lnTo>
                  <a:lnTo>
                    <a:pt x="494" y="29839"/>
                  </a:lnTo>
                  <a:lnTo>
                    <a:pt x="497" y="29342"/>
                  </a:lnTo>
                  <a:lnTo>
                    <a:pt x="499" y="28845"/>
                  </a:lnTo>
                  <a:lnTo>
                    <a:pt x="501" y="28347"/>
                  </a:lnTo>
                  <a:lnTo>
                    <a:pt x="503" y="27850"/>
                  </a:lnTo>
                  <a:lnTo>
                    <a:pt x="505" y="27353"/>
                  </a:lnTo>
                  <a:lnTo>
                    <a:pt x="507" y="26855"/>
                  </a:lnTo>
                  <a:lnTo>
                    <a:pt x="509" y="26358"/>
                  </a:lnTo>
                  <a:lnTo>
                    <a:pt x="511" y="25861"/>
                  </a:lnTo>
                  <a:lnTo>
                    <a:pt x="513" y="25363"/>
                  </a:lnTo>
                  <a:lnTo>
                    <a:pt x="515" y="24866"/>
                  </a:lnTo>
                  <a:lnTo>
                    <a:pt x="516" y="24369"/>
                  </a:lnTo>
                  <a:lnTo>
                    <a:pt x="518" y="23871"/>
                  </a:lnTo>
                  <a:lnTo>
                    <a:pt x="520" y="23374"/>
                  </a:lnTo>
                  <a:lnTo>
                    <a:pt x="521" y="22877"/>
                  </a:lnTo>
                  <a:lnTo>
                    <a:pt x="523" y="22379"/>
                  </a:lnTo>
                  <a:lnTo>
                    <a:pt x="524" y="21882"/>
                  </a:lnTo>
                  <a:lnTo>
                    <a:pt x="526" y="21385"/>
                  </a:lnTo>
                  <a:lnTo>
                    <a:pt x="527" y="20887"/>
                  </a:lnTo>
                  <a:lnTo>
                    <a:pt x="528" y="20390"/>
                  </a:lnTo>
                  <a:lnTo>
                    <a:pt x="530" y="19893"/>
                  </a:lnTo>
                  <a:lnTo>
                    <a:pt x="531" y="19395"/>
                  </a:lnTo>
                  <a:lnTo>
                    <a:pt x="532" y="18898"/>
                  </a:lnTo>
                  <a:lnTo>
                    <a:pt x="533" y="18401"/>
                  </a:lnTo>
                  <a:lnTo>
                    <a:pt x="534" y="17903"/>
                  </a:lnTo>
                  <a:lnTo>
                    <a:pt x="535" y="17406"/>
                  </a:lnTo>
                  <a:lnTo>
                    <a:pt x="536" y="16909"/>
                  </a:lnTo>
                  <a:lnTo>
                    <a:pt x="537" y="16411"/>
                  </a:lnTo>
                  <a:lnTo>
                    <a:pt x="538" y="15914"/>
                  </a:lnTo>
                  <a:lnTo>
                    <a:pt x="539" y="15417"/>
                  </a:lnTo>
                  <a:lnTo>
                    <a:pt x="540" y="14919"/>
                  </a:lnTo>
                  <a:lnTo>
                    <a:pt x="541" y="14422"/>
                  </a:lnTo>
                  <a:lnTo>
                    <a:pt x="541" y="13925"/>
                  </a:lnTo>
                  <a:lnTo>
                    <a:pt x="542" y="13427"/>
                  </a:lnTo>
                  <a:lnTo>
                    <a:pt x="543" y="12930"/>
                  </a:lnTo>
                  <a:lnTo>
                    <a:pt x="544" y="12433"/>
                  </a:lnTo>
                  <a:lnTo>
                    <a:pt x="544" y="11935"/>
                  </a:lnTo>
                  <a:lnTo>
                    <a:pt x="545" y="11438"/>
                  </a:lnTo>
                  <a:lnTo>
                    <a:pt x="545" y="10941"/>
                  </a:lnTo>
                  <a:lnTo>
                    <a:pt x="546" y="10443"/>
                  </a:lnTo>
                  <a:lnTo>
                    <a:pt x="546" y="9946"/>
                  </a:lnTo>
                  <a:lnTo>
                    <a:pt x="547" y="9449"/>
                  </a:lnTo>
                  <a:lnTo>
                    <a:pt x="547" y="8951"/>
                  </a:lnTo>
                  <a:lnTo>
                    <a:pt x="548" y="8454"/>
                  </a:lnTo>
                  <a:lnTo>
                    <a:pt x="548" y="7957"/>
                  </a:lnTo>
                  <a:lnTo>
                    <a:pt x="549" y="7459"/>
                  </a:lnTo>
                  <a:lnTo>
                    <a:pt x="549" y="6962"/>
                  </a:lnTo>
                  <a:lnTo>
                    <a:pt x="550" y="6465"/>
                  </a:lnTo>
                  <a:lnTo>
                    <a:pt x="550" y="5967"/>
                  </a:lnTo>
                  <a:lnTo>
                    <a:pt x="550" y="5470"/>
                  </a:lnTo>
                  <a:lnTo>
                    <a:pt x="551" y="4973"/>
                  </a:lnTo>
                  <a:lnTo>
                    <a:pt x="551" y="4475"/>
                  </a:lnTo>
                  <a:lnTo>
                    <a:pt x="551" y="3978"/>
                  </a:lnTo>
                  <a:lnTo>
                    <a:pt x="551" y="3481"/>
                  </a:lnTo>
                  <a:lnTo>
                    <a:pt x="552" y="2983"/>
                  </a:lnTo>
                  <a:lnTo>
                    <a:pt x="552" y="2486"/>
                  </a:lnTo>
                  <a:lnTo>
                    <a:pt x="552" y="1989"/>
                  </a:lnTo>
                  <a:lnTo>
                    <a:pt x="552" y="1491"/>
                  </a:lnTo>
                  <a:lnTo>
                    <a:pt x="553" y="994"/>
                  </a:lnTo>
                  <a:lnTo>
                    <a:pt x="553" y="497"/>
                  </a:lnTo>
                  <a:lnTo>
                    <a:pt x="553" y="0"/>
                  </a:lnTo>
                  <a:lnTo>
                    <a:pt x="556" y="0"/>
                  </a:lnTo>
                  <a:lnTo>
                    <a:pt x="556" y="254135"/>
                  </a:lnTo>
                  <a:lnTo>
                    <a:pt x="556" y="254135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69" name="pl51"/>
            <p:cNvSpPr/>
            <p:nvPr/>
          </p:nvSpPr>
          <p:spPr>
            <a:xfrm>
              <a:off x="6882018" y="3712698"/>
              <a:ext cx="1507" cy="111820"/>
            </a:xfrm>
            <a:custGeom>
              <a:avLst/>
              <a:gdLst/>
              <a:ahLst/>
              <a:cxnLst/>
              <a:rect l="0" t="0" r="0" b="0"/>
              <a:pathLst>
                <a:path w="1507" h="111820">
                  <a:moveTo>
                    <a:pt x="0" y="0"/>
                  </a:moveTo>
                  <a:lnTo>
                    <a:pt x="7" y="0"/>
                  </a:lnTo>
                  <a:lnTo>
                    <a:pt x="8" y="218"/>
                  </a:lnTo>
                  <a:lnTo>
                    <a:pt x="8" y="437"/>
                  </a:lnTo>
                  <a:lnTo>
                    <a:pt x="9" y="656"/>
                  </a:lnTo>
                  <a:lnTo>
                    <a:pt x="10" y="875"/>
                  </a:lnTo>
                  <a:lnTo>
                    <a:pt x="10" y="1094"/>
                  </a:lnTo>
                  <a:lnTo>
                    <a:pt x="11" y="1312"/>
                  </a:lnTo>
                  <a:lnTo>
                    <a:pt x="12" y="1531"/>
                  </a:lnTo>
                  <a:lnTo>
                    <a:pt x="13" y="1750"/>
                  </a:lnTo>
                  <a:lnTo>
                    <a:pt x="14" y="1969"/>
                  </a:lnTo>
                  <a:lnTo>
                    <a:pt x="15" y="2188"/>
                  </a:lnTo>
                  <a:lnTo>
                    <a:pt x="17" y="2407"/>
                  </a:lnTo>
                  <a:lnTo>
                    <a:pt x="18" y="2625"/>
                  </a:lnTo>
                  <a:lnTo>
                    <a:pt x="19" y="2844"/>
                  </a:lnTo>
                  <a:lnTo>
                    <a:pt x="20" y="3063"/>
                  </a:lnTo>
                  <a:lnTo>
                    <a:pt x="22" y="3282"/>
                  </a:lnTo>
                  <a:lnTo>
                    <a:pt x="24" y="3501"/>
                  </a:lnTo>
                  <a:lnTo>
                    <a:pt x="25" y="3720"/>
                  </a:lnTo>
                  <a:lnTo>
                    <a:pt x="27" y="3938"/>
                  </a:lnTo>
                  <a:lnTo>
                    <a:pt x="29" y="4157"/>
                  </a:lnTo>
                  <a:lnTo>
                    <a:pt x="31" y="4376"/>
                  </a:lnTo>
                  <a:lnTo>
                    <a:pt x="33" y="4595"/>
                  </a:lnTo>
                  <a:lnTo>
                    <a:pt x="35" y="4814"/>
                  </a:lnTo>
                  <a:lnTo>
                    <a:pt x="37" y="5033"/>
                  </a:lnTo>
                  <a:lnTo>
                    <a:pt x="40" y="5251"/>
                  </a:lnTo>
                  <a:lnTo>
                    <a:pt x="42" y="5470"/>
                  </a:lnTo>
                  <a:lnTo>
                    <a:pt x="45" y="5689"/>
                  </a:lnTo>
                  <a:lnTo>
                    <a:pt x="48" y="5908"/>
                  </a:lnTo>
                  <a:lnTo>
                    <a:pt x="51" y="6127"/>
                  </a:lnTo>
                  <a:lnTo>
                    <a:pt x="54" y="6345"/>
                  </a:lnTo>
                  <a:lnTo>
                    <a:pt x="57" y="6564"/>
                  </a:lnTo>
                  <a:lnTo>
                    <a:pt x="60" y="6783"/>
                  </a:lnTo>
                  <a:lnTo>
                    <a:pt x="64" y="7002"/>
                  </a:lnTo>
                  <a:lnTo>
                    <a:pt x="68" y="7221"/>
                  </a:lnTo>
                  <a:lnTo>
                    <a:pt x="72" y="7440"/>
                  </a:lnTo>
                  <a:lnTo>
                    <a:pt x="76" y="7658"/>
                  </a:lnTo>
                  <a:lnTo>
                    <a:pt x="80" y="7877"/>
                  </a:lnTo>
                  <a:lnTo>
                    <a:pt x="84" y="8096"/>
                  </a:lnTo>
                  <a:lnTo>
                    <a:pt x="89" y="8315"/>
                  </a:lnTo>
                  <a:lnTo>
                    <a:pt x="94" y="8534"/>
                  </a:lnTo>
                  <a:lnTo>
                    <a:pt x="99" y="8753"/>
                  </a:lnTo>
                  <a:lnTo>
                    <a:pt x="104" y="8971"/>
                  </a:lnTo>
                  <a:lnTo>
                    <a:pt x="109" y="9190"/>
                  </a:lnTo>
                  <a:lnTo>
                    <a:pt x="115" y="9409"/>
                  </a:lnTo>
                  <a:lnTo>
                    <a:pt x="120" y="9628"/>
                  </a:lnTo>
                  <a:lnTo>
                    <a:pt x="126" y="9847"/>
                  </a:lnTo>
                  <a:lnTo>
                    <a:pt x="132" y="10066"/>
                  </a:lnTo>
                  <a:lnTo>
                    <a:pt x="139" y="10284"/>
                  </a:lnTo>
                  <a:lnTo>
                    <a:pt x="145" y="10503"/>
                  </a:lnTo>
                  <a:lnTo>
                    <a:pt x="152" y="10722"/>
                  </a:lnTo>
                  <a:lnTo>
                    <a:pt x="159" y="10941"/>
                  </a:lnTo>
                  <a:lnTo>
                    <a:pt x="166" y="11160"/>
                  </a:lnTo>
                  <a:lnTo>
                    <a:pt x="173" y="11378"/>
                  </a:lnTo>
                  <a:lnTo>
                    <a:pt x="181" y="11597"/>
                  </a:lnTo>
                  <a:lnTo>
                    <a:pt x="188" y="11816"/>
                  </a:lnTo>
                  <a:lnTo>
                    <a:pt x="196" y="12035"/>
                  </a:lnTo>
                  <a:lnTo>
                    <a:pt x="205" y="12254"/>
                  </a:lnTo>
                  <a:lnTo>
                    <a:pt x="213" y="12473"/>
                  </a:lnTo>
                  <a:lnTo>
                    <a:pt x="221" y="12691"/>
                  </a:lnTo>
                  <a:lnTo>
                    <a:pt x="230" y="12910"/>
                  </a:lnTo>
                  <a:lnTo>
                    <a:pt x="239" y="13129"/>
                  </a:lnTo>
                  <a:lnTo>
                    <a:pt x="248" y="13348"/>
                  </a:lnTo>
                  <a:lnTo>
                    <a:pt x="257" y="13567"/>
                  </a:lnTo>
                  <a:lnTo>
                    <a:pt x="266" y="13786"/>
                  </a:lnTo>
                  <a:lnTo>
                    <a:pt x="276" y="14004"/>
                  </a:lnTo>
                  <a:lnTo>
                    <a:pt x="286" y="14223"/>
                  </a:lnTo>
                  <a:lnTo>
                    <a:pt x="295" y="14442"/>
                  </a:lnTo>
                  <a:lnTo>
                    <a:pt x="305" y="14661"/>
                  </a:lnTo>
                  <a:lnTo>
                    <a:pt x="315" y="14880"/>
                  </a:lnTo>
                  <a:lnTo>
                    <a:pt x="325" y="15099"/>
                  </a:lnTo>
                  <a:lnTo>
                    <a:pt x="336" y="15317"/>
                  </a:lnTo>
                  <a:lnTo>
                    <a:pt x="346" y="15536"/>
                  </a:lnTo>
                  <a:lnTo>
                    <a:pt x="356" y="15755"/>
                  </a:lnTo>
                  <a:lnTo>
                    <a:pt x="367" y="15974"/>
                  </a:lnTo>
                  <a:lnTo>
                    <a:pt x="377" y="16193"/>
                  </a:lnTo>
                  <a:lnTo>
                    <a:pt x="388" y="16411"/>
                  </a:lnTo>
                  <a:lnTo>
                    <a:pt x="398" y="16630"/>
                  </a:lnTo>
                  <a:lnTo>
                    <a:pt x="409" y="16849"/>
                  </a:lnTo>
                  <a:lnTo>
                    <a:pt x="419" y="17068"/>
                  </a:lnTo>
                  <a:lnTo>
                    <a:pt x="430" y="17287"/>
                  </a:lnTo>
                  <a:lnTo>
                    <a:pt x="440" y="17506"/>
                  </a:lnTo>
                  <a:lnTo>
                    <a:pt x="451" y="17724"/>
                  </a:lnTo>
                  <a:lnTo>
                    <a:pt x="461" y="17943"/>
                  </a:lnTo>
                  <a:lnTo>
                    <a:pt x="472" y="18162"/>
                  </a:lnTo>
                  <a:lnTo>
                    <a:pt x="482" y="18381"/>
                  </a:lnTo>
                  <a:lnTo>
                    <a:pt x="492" y="18600"/>
                  </a:lnTo>
                  <a:lnTo>
                    <a:pt x="502" y="18819"/>
                  </a:lnTo>
                  <a:lnTo>
                    <a:pt x="512" y="19037"/>
                  </a:lnTo>
                  <a:lnTo>
                    <a:pt x="521" y="19256"/>
                  </a:lnTo>
                  <a:lnTo>
                    <a:pt x="531" y="19475"/>
                  </a:lnTo>
                  <a:lnTo>
                    <a:pt x="540" y="19694"/>
                  </a:lnTo>
                  <a:lnTo>
                    <a:pt x="549" y="19913"/>
                  </a:lnTo>
                  <a:lnTo>
                    <a:pt x="558" y="20132"/>
                  </a:lnTo>
                  <a:lnTo>
                    <a:pt x="567" y="20350"/>
                  </a:lnTo>
                  <a:lnTo>
                    <a:pt x="575" y="20569"/>
                  </a:lnTo>
                  <a:lnTo>
                    <a:pt x="583" y="20788"/>
                  </a:lnTo>
                  <a:lnTo>
                    <a:pt x="591" y="21007"/>
                  </a:lnTo>
                  <a:lnTo>
                    <a:pt x="599" y="21226"/>
                  </a:lnTo>
                  <a:lnTo>
                    <a:pt x="606" y="21444"/>
                  </a:lnTo>
                  <a:lnTo>
                    <a:pt x="613" y="21663"/>
                  </a:lnTo>
                  <a:lnTo>
                    <a:pt x="619" y="21882"/>
                  </a:lnTo>
                  <a:lnTo>
                    <a:pt x="626" y="22101"/>
                  </a:lnTo>
                  <a:lnTo>
                    <a:pt x="632" y="22320"/>
                  </a:lnTo>
                  <a:lnTo>
                    <a:pt x="637" y="22539"/>
                  </a:lnTo>
                  <a:lnTo>
                    <a:pt x="642" y="22757"/>
                  </a:lnTo>
                  <a:lnTo>
                    <a:pt x="647" y="22976"/>
                  </a:lnTo>
                  <a:lnTo>
                    <a:pt x="651" y="23195"/>
                  </a:lnTo>
                  <a:lnTo>
                    <a:pt x="655" y="23414"/>
                  </a:lnTo>
                  <a:lnTo>
                    <a:pt x="659" y="23633"/>
                  </a:lnTo>
                  <a:lnTo>
                    <a:pt x="662" y="23852"/>
                  </a:lnTo>
                  <a:lnTo>
                    <a:pt x="664" y="24070"/>
                  </a:lnTo>
                  <a:lnTo>
                    <a:pt x="667" y="24289"/>
                  </a:lnTo>
                  <a:lnTo>
                    <a:pt x="668" y="24508"/>
                  </a:lnTo>
                  <a:lnTo>
                    <a:pt x="670" y="24727"/>
                  </a:lnTo>
                  <a:lnTo>
                    <a:pt x="671" y="24946"/>
                  </a:lnTo>
                  <a:lnTo>
                    <a:pt x="671" y="25165"/>
                  </a:lnTo>
                  <a:lnTo>
                    <a:pt x="671" y="25383"/>
                  </a:lnTo>
                  <a:lnTo>
                    <a:pt x="671" y="25602"/>
                  </a:lnTo>
                  <a:lnTo>
                    <a:pt x="670" y="25821"/>
                  </a:lnTo>
                  <a:lnTo>
                    <a:pt x="669" y="26040"/>
                  </a:lnTo>
                  <a:lnTo>
                    <a:pt x="667" y="26259"/>
                  </a:lnTo>
                  <a:lnTo>
                    <a:pt x="665" y="26477"/>
                  </a:lnTo>
                  <a:lnTo>
                    <a:pt x="663" y="26696"/>
                  </a:lnTo>
                  <a:lnTo>
                    <a:pt x="660" y="26915"/>
                  </a:lnTo>
                  <a:lnTo>
                    <a:pt x="657" y="27134"/>
                  </a:lnTo>
                  <a:lnTo>
                    <a:pt x="653" y="27353"/>
                  </a:lnTo>
                  <a:lnTo>
                    <a:pt x="649" y="27572"/>
                  </a:lnTo>
                  <a:lnTo>
                    <a:pt x="645" y="27790"/>
                  </a:lnTo>
                  <a:lnTo>
                    <a:pt x="640" y="28009"/>
                  </a:lnTo>
                  <a:lnTo>
                    <a:pt x="635" y="28228"/>
                  </a:lnTo>
                  <a:lnTo>
                    <a:pt x="630" y="28447"/>
                  </a:lnTo>
                  <a:lnTo>
                    <a:pt x="624" y="28666"/>
                  </a:lnTo>
                  <a:lnTo>
                    <a:pt x="618" y="28885"/>
                  </a:lnTo>
                  <a:lnTo>
                    <a:pt x="612" y="29103"/>
                  </a:lnTo>
                  <a:lnTo>
                    <a:pt x="606" y="29322"/>
                  </a:lnTo>
                  <a:lnTo>
                    <a:pt x="599" y="29541"/>
                  </a:lnTo>
                  <a:lnTo>
                    <a:pt x="592" y="29760"/>
                  </a:lnTo>
                  <a:lnTo>
                    <a:pt x="585" y="29979"/>
                  </a:lnTo>
                  <a:lnTo>
                    <a:pt x="578" y="30198"/>
                  </a:lnTo>
                  <a:lnTo>
                    <a:pt x="570" y="30416"/>
                  </a:lnTo>
                  <a:lnTo>
                    <a:pt x="563" y="30635"/>
                  </a:lnTo>
                  <a:lnTo>
                    <a:pt x="555" y="30854"/>
                  </a:lnTo>
                  <a:lnTo>
                    <a:pt x="547" y="31073"/>
                  </a:lnTo>
                  <a:lnTo>
                    <a:pt x="539" y="31292"/>
                  </a:lnTo>
                  <a:lnTo>
                    <a:pt x="531" y="31510"/>
                  </a:lnTo>
                  <a:lnTo>
                    <a:pt x="523" y="31729"/>
                  </a:lnTo>
                  <a:lnTo>
                    <a:pt x="515" y="31948"/>
                  </a:lnTo>
                  <a:lnTo>
                    <a:pt x="507" y="32167"/>
                  </a:lnTo>
                  <a:lnTo>
                    <a:pt x="499" y="32386"/>
                  </a:lnTo>
                  <a:lnTo>
                    <a:pt x="491" y="32605"/>
                  </a:lnTo>
                  <a:lnTo>
                    <a:pt x="483" y="32823"/>
                  </a:lnTo>
                  <a:lnTo>
                    <a:pt x="476" y="33042"/>
                  </a:lnTo>
                  <a:lnTo>
                    <a:pt x="468" y="33261"/>
                  </a:lnTo>
                  <a:lnTo>
                    <a:pt x="460" y="33480"/>
                  </a:lnTo>
                  <a:lnTo>
                    <a:pt x="453" y="33699"/>
                  </a:lnTo>
                  <a:lnTo>
                    <a:pt x="446" y="33918"/>
                  </a:lnTo>
                  <a:lnTo>
                    <a:pt x="438" y="34136"/>
                  </a:lnTo>
                  <a:lnTo>
                    <a:pt x="431" y="34355"/>
                  </a:lnTo>
                  <a:lnTo>
                    <a:pt x="425" y="34574"/>
                  </a:lnTo>
                  <a:lnTo>
                    <a:pt x="418" y="34793"/>
                  </a:lnTo>
                  <a:lnTo>
                    <a:pt x="412" y="35012"/>
                  </a:lnTo>
                  <a:lnTo>
                    <a:pt x="406" y="35231"/>
                  </a:lnTo>
                  <a:lnTo>
                    <a:pt x="400" y="35449"/>
                  </a:lnTo>
                  <a:lnTo>
                    <a:pt x="395" y="35668"/>
                  </a:lnTo>
                  <a:lnTo>
                    <a:pt x="390" y="35887"/>
                  </a:lnTo>
                  <a:lnTo>
                    <a:pt x="385" y="36106"/>
                  </a:lnTo>
                  <a:lnTo>
                    <a:pt x="380" y="36325"/>
                  </a:lnTo>
                  <a:lnTo>
                    <a:pt x="376" y="36543"/>
                  </a:lnTo>
                  <a:lnTo>
                    <a:pt x="372" y="36762"/>
                  </a:lnTo>
                  <a:lnTo>
                    <a:pt x="369" y="36981"/>
                  </a:lnTo>
                  <a:lnTo>
                    <a:pt x="366" y="37200"/>
                  </a:lnTo>
                  <a:lnTo>
                    <a:pt x="363" y="37419"/>
                  </a:lnTo>
                  <a:lnTo>
                    <a:pt x="361" y="37638"/>
                  </a:lnTo>
                  <a:lnTo>
                    <a:pt x="359" y="37856"/>
                  </a:lnTo>
                  <a:lnTo>
                    <a:pt x="358" y="38075"/>
                  </a:lnTo>
                  <a:lnTo>
                    <a:pt x="356" y="38294"/>
                  </a:lnTo>
                  <a:lnTo>
                    <a:pt x="356" y="38513"/>
                  </a:lnTo>
                  <a:lnTo>
                    <a:pt x="356" y="38732"/>
                  </a:lnTo>
                  <a:lnTo>
                    <a:pt x="356" y="38951"/>
                  </a:lnTo>
                  <a:lnTo>
                    <a:pt x="356" y="39169"/>
                  </a:lnTo>
                  <a:lnTo>
                    <a:pt x="357" y="39388"/>
                  </a:lnTo>
                  <a:lnTo>
                    <a:pt x="358" y="39607"/>
                  </a:lnTo>
                  <a:lnTo>
                    <a:pt x="360" y="39826"/>
                  </a:lnTo>
                  <a:lnTo>
                    <a:pt x="362" y="40045"/>
                  </a:lnTo>
                  <a:lnTo>
                    <a:pt x="365" y="40264"/>
                  </a:lnTo>
                  <a:lnTo>
                    <a:pt x="368" y="40482"/>
                  </a:lnTo>
                  <a:lnTo>
                    <a:pt x="371" y="40701"/>
                  </a:lnTo>
                  <a:lnTo>
                    <a:pt x="375" y="40920"/>
                  </a:lnTo>
                  <a:lnTo>
                    <a:pt x="379" y="41139"/>
                  </a:lnTo>
                  <a:lnTo>
                    <a:pt x="384" y="41358"/>
                  </a:lnTo>
                  <a:lnTo>
                    <a:pt x="389" y="41577"/>
                  </a:lnTo>
                  <a:lnTo>
                    <a:pt x="394" y="41795"/>
                  </a:lnTo>
                  <a:lnTo>
                    <a:pt x="400" y="42014"/>
                  </a:lnTo>
                  <a:lnTo>
                    <a:pt x="406" y="42233"/>
                  </a:lnTo>
                  <a:lnTo>
                    <a:pt x="412" y="42452"/>
                  </a:lnTo>
                  <a:lnTo>
                    <a:pt x="419" y="42671"/>
                  </a:lnTo>
                  <a:lnTo>
                    <a:pt x="425" y="42889"/>
                  </a:lnTo>
                  <a:lnTo>
                    <a:pt x="433" y="43108"/>
                  </a:lnTo>
                  <a:lnTo>
                    <a:pt x="440" y="43327"/>
                  </a:lnTo>
                  <a:lnTo>
                    <a:pt x="448" y="43546"/>
                  </a:lnTo>
                  <a:lnTo>
                    <a:pt x="456" y="43765"/>
                  </a:lnTo>
                  <a:lnTo>
                    <a:pt x="464" y="43984"/>
                  </a:lnTo>
                  <a:lnTo>
                    <a:pt x="473" y="44202"/>
                  </a:lnTo>
                  <a:lnTo>
                    <a:pt x="482" y="44421"/>
                  </a:lnTo>
                  <a:lnTo>
                    <a:pt x="490" y="44640"/>
                  </a:lnTo>
                  <a:lnTo>
                    <a:pt x="500" y="44859"/>
                  </a:lnTo>
                  <a:lnTo>
                    <a:pt x="509" y="45078"/>
                  </a:lnTo>
                  <a:lnTo>
                    <a:pt x="518" y="45297"/>
                  </a:lnTo>
                  <a:lnTo>
                    <a:pt x="528" y="45515"/>
                  </a:lnTo>
                  <a:lnTo>
                    <a:pt x="538" y="45734"/>
                  </a:lnTo>
                  <a:lnTo>
                    <a:pt x="547" y="45953"/>
                  </a:lnTo>
                  <a:lnTo>
                    <a:pt x="557" y="46172"/>
                  </a:lnTo>
                  <a:lnTo>
                    <a:pt x="567" y="46391"/>
                  </a:lnTo>
                  <a:lnTo>
                    <a:pt x="578" y="46610"/>
                  </a:lnTo>
                  <a:lnTo>
                    <a:pt x="588" y="46828"/>
                  </a:lnTo>
                  <a:lnTo>
                    <a:pt x="598" y="47047"/>
                  </a:lnTo>
                  <a:lnTo>
                    <a:pt x="608" y="47266"/>
                  </a:lnTo>
                  <a:lnTo>
                    <a:pt x="618" y="47485"/>
                  </a:lnTo>
                  <a:lnTo>
                    <a:pt x="629" y="47704"/>
                  </a:lnTo>
                  <a:lnTo>
                    <a:pt x="639" y="47922"/>
                  </a:lnTo>
                  <a:lnTo>
                    <a:pt x="649" y="48141"/>
                  </a:lnTo>
                  <a:lnTo>
                    <a:pt x="660" y="48360"/>
                  </a:lnTo>
                  <a:lnTo>
                    <a:pt x="670" y="48579"/>
                  </a:lnTo>
                  <a:lnTo>
                    <a:pt x="680" y="48798"/>
                  </a:lnTo>
                  <a:lnTo>
                    <a:pt x="690" y="49017"/>
                  </a:lnTo>
                  <a:lnTo>
                    <a:pt x="700" y="49235"/>
                  </a:lnTo>
                  <a:lnTo>
                    <a:pt x="710" y="49454"/>
                  </a:lnTo>
                  <a:lnTo>
                    <a:pt x="720" y="49673"/>
                  </a:lnTo>
                  <a:lnTo>
                    <a:pt x="730" y="49892"/>
                  </a:lnTo>
                  <a:lnTo>
                    <a:pt x="740" y="50111"/>
                  </a:lnTo>
                  <a:lnTo>
                    <a:pt x="749" y="50330"/>
                  </a:lnTo>
                  <a:lnTo>
                    <a:pt x="759" y="50548"/>
                  </a:lnTo>
                  <a:lnTo>
                    <a:pt x="768" y="50767"/>
                  </a:lnTo>
                  <a:lnTo>
                    <a:pt x="778" y="50986"/>
                  </a:lnTo>
                  <a:lnTo>
                    <a:pt x="787" y="51205"/>
                  </a:lnTo>
                  <a:lnTo>
                    <a:pt x="796" y="51424"/>
                  </a:lnTo>
                  <a:lnTo>
                    <a:pt x="805" y="51643"/>
                  </a:lnTo>
                  <a:lnTo>
                    <a:pt x="814" y="51861"/>
                  </a:lnTo>
                  <a:lnTo>
                    <a:pt x="823" y="52080"/>
                  </a:lnTo>
                  <a:lnTo>
                    <a:pt x="832" y="52299"/>
                  </a:lnTo>
                  <a:lnTo>
                    <a:pt x="841" y="52518"/>
                  </a:lnTo>
                  <a:lnTo>
                    <a:pt x="850" y="52737"/>
                  </a:lnTo>
                  <a:lnTo>
                    <a:pt x="858" y="52955"/>
                  </a:lnTo>
                  <a:lnTo>
                    <a:pt x="867" y="53174"/>
                  </a:lnTo>
                  <a:lnTo>
                    <a:pt x="876" y="53393"/>
                  </a:lnTo>
                  <a:lnTo>
                    <a:pt x="884" y="53612"/>
                  </a:lnTo>
                  <a:lnTo>
                    <a:pt x="893" y="53831"/>
                  </a:lnTo>
                  <a:lnTo>
                    <a:pt x="901" y="54050"/>
                  </a:lnTo>
                  <a:lnTo>
                    <a:pt x="910" y="54268"/>
                  </a:lnTo>
                  <a:lnTo>
                    <a:pt x="918" y="54487"/>
                  </a:lnTo>
                  <a:lnTo>
                    <a:pt x="926" y="54706"/>
                  </a:lnTo>
                  <a:lnTo>
                    <a:pt x="935" y="54925"/>
                  </a:lnTo>
                  <a:lnTo>
                    <a:pt x="943" y="55144"/>
                  </a:lnTo>
                  <a:lnTo>
                    <a:pt x="952" y="55363"/>
                  </a:lnTo>
                  <a:lnTo>
                    <a:pt x="960" y="55581"/>
                  </a:lnTo>
                  <a:lnTo>
                    <a:pt x="969" y="55800"/>
                  </a:lnTo>
                  <a:lnTo>
                    <a:pt x="978" y="56019"/>
                  </a:lnTo>
                  <a:lnTo>
                    <a:pt x="986" y="56238"/>
                  </a:lnTo>
                  <a:lnTo>
                    <a:pt x="995" y="56457"/>
                  </a:lnTo>
                  <a:lnTo>
                    <a:pt x="1004" y="56676"/>
                  </a:lnTo>
                  <a:lnTo>
                    <a:pt x="1013" y="56894"/>
                  </a:lnTo>
                  <a:lnTo>
                    <a:pt x="1022" y="57113"/>
                  </a:lnTo>
                  <a:lnTo>
                    <a:pt x="1031" y="57332"/>
                  </a:lnTo>
                  <a:lnTo>
                    <a:pt x="1040" y="57551"/>
                  </a:lnTo>
                  <a:lnTo>
                    <a:pt x="1050" y="57770"/>
                  </a:lnTo>
                  <a:lnTo>
                    <a:pt x="1059" y="57988"/>
                  </a:lnTo>
                  <a:lnTo>
                    <a:pt x="1069" y="58207"/>
                  </a:lnTo>
                  <a:lnTo>
                    <a:pt x="1078" y="58426"/>
                  </a:lnTo>
                  <a:lnTo>
                    <a:pt x="1088" y="58645"/>
                  </a:lnTo>
                  <a:lnTo>
                    <a:pt x="1098" y="58864"/>
                  </a:lnTo>
                  <a:lnTo>
                    <a:pt x="1108" y="59083"/>
                  </a:lnTo>
                  <a:lnTo>
                    <a:pt x="1118" y="59301"/>
                  </a:lnTo>
                  <a:lnTo>
                    <a:pt x="1129" y="59520"/>
                  </a:lnTo>
                  <a:lnTo>
                    <a:pt x="1139" y="59739"/>
                  </a:lnTo>
                  <a:lnTo>
                    <a:pt x="1150" y="59958"/>
                  </a:lnTo>
                  <a:lnTo>
                    <a:pt x="1160" y="60177"/>
                  </a:lnTo>
                  <a:lnTo>
                    <a:pt x="1171" y="60396"/>
                  </a:lnTo>
                  <a:lnTo>
                    <a:pt x="1182" y="60614"/>
                  </a:lnTo>
                  <a:lnTo>
                    <a:pt x="1193" y="60833"/>
                  </a:lnTo>
                  <a:lnTo>
                    <a:pt x="1204" y="61052"/>
                  </a:lnTo>
                  <a:lnTo>
                    <a:pt x="1215" y="61271"/>
                  </a:lnTo>
                  <a:lnTo>
                    <a:pt x="1226" y="61490"/>
                  </a:lnTo>
                  <a:lnTo>
                    <a:pt x="1237" y="61709"/>
                  </a:lnTo>
                  <a:lnTo>
                    <a:pt x="1249" y="61927"/>
                  </a:lnTo>
                  <a:lnTo>
                    <a:pt x="1260" y="62146"/>
                  </a:lnTo>
                  <a:lnTo>
                    <a:pt x="1271" y="62365"/>
                  </a:lnTo>
                  <a:lnTo>
                    <a:pt x="1282" y="62584"/>
                  </a:lnTo>
                  <a:lnTo>
                    <a:pt x="1293" y="62803"/>
                  </a:lnTo>
                  <a:lnTo>
                    <a:pt x="1304" y="63021"/>
                  </a:lnTo>
                  <a:lnTo>
                    <a:pt x="1315" y="63240"/>
                  </a:lnTo>
                  <a:lnTo>
                    <a:pt x="1326" y="63459"/>
                  </a:lnTo>
                  <a:lnTo>
                    <a:pt x="1337" y="63678"/>
                  </a:lnTo>
                  <a:lnTo>
                    <a:pt x="1347" y="63897"/>
                  </a:lnTo>
                  <a:lnTo>
                    <a:pt x="1358" y="64116"/>
                  </a:lnTo>
                  <a:lnTo>
                    <a:pt x="1368" y="64334"/>
                  </a:lnTo>
                  <a:lnTo>
                    <a:pt x="1378" y="64553"/>
                  </a:lnTo>
                  <a:lnTo>
                    <a:pt x="1388" y="64772"/>
                  </a:lnTo>
                  <a:lnTo>
                    <a:pt x="1397" y="64991"/>
                  </a:lnTo>
                  <a:lnTo>
                    <a:pt x="1407" y="65210"/>
                  </a:lnTo>
                  <a:lnTo>
                    <a:pt x="1416" y="65429"/>
                  </a:lnTo>
                  <a:lnTo>
                    <a:pt x="1424" y="65647"/>
                  </a:lnTo>
                  <a:lnTo>
                    <a:pt x="1433" y="65866"/>
                  </a:lnTo>
                  <a:lnTo>
                    <a:pt x="1441" y="66085"/>
                  </a:lnTo>
                  <a:lnTo>
                    <a:pt x="1448" y="66304"/>
                  </a:lnTo>
                  <a:lnTo>
                    <a:pt x="1455" y="66523"/>
                  </a:lnTo>
                  <a:lnTo>
                    <a:pt x="1462" y="66742"/>
                  </a:lnTo>
                  <a:lnTo>
                    <a:pt x="1469" y="66960"/>
                  </a:lnTo>
                  <a:lnTo>
                    <a:pt x="1474" y="67179"/>
                  </a:lnTo>
                  <a:lnTo>
                    <a:pt x="1480" y="67398"/>
                  </a:lnTo>
                  <a:lnTo>
                    <a:pt x="1485" y="67617"/>
                  </a:lnTo>
                  <a:lnTo>
                    <a:pt x="1489" y="67836"/>
                  </a:lnTo>
                  <a:lnTo>
                    <a:pt x="1493" y="68054"/>
                  </a:lnTo>
                  <a:lnTo>
                    <a:pt x="1497" y="68273"/>
                  </a:lnTo>
                  <a:lnTo>
                    <a:pt x="1500" y="68492"/>
                  </a:lnTo>
                  <a:lnTo>
                    <a:pt x="1502" y="68711"/>
                  </a:lnTo>
                  <a:lnTo>
                    <a:pt x="1504" y="68930"/>
                  </a:lnTo>
                  <a:lnTo>
                    <a:pt x="1506" y="69149"/>
                  </a:lnTo>
                  <a:lnTo>
                    <a:pt x="1506" y="69367"/>
                  </a:lnTo>
                  <a:lnTo>
                    <a:pt x="1507" y="69586"/>
                  </a:lnTo>
                  <a:lnTo>
                    <a:pt x="1506" y="69805"/>
                  </a:lnTo>
                  <a:lnTo>
                    <a:pt x="1506" y="70024"/>
                  </a:lnTo>
                  <a:lnTo>
                    <a:pt x="1504" y="70243"/>
                  </a:lnTo>
                  <a:lnTo>
                    <a:pt x="1502" y="70462"/>
                  </a:lnTo>
                  <a:lnTo>
                    <a:pt x="1500" y="70680"/>
                  </a:lnTo>
                  <a:lnTo>
                    <a:pt x="1497" y="70899"/>
                  </a:lnTo>
                  <a:lnTo>
                    <a:pt x="1494" y="71118"/>
                  </a:lnTo>
                  <a:lnTo>
                    <a:pt x="1489" y="71337"/>
                  </a:lnTo>
                  <a:lnTo>
                    <a:pt x="1485" y="71556"/>
                  </a:lnTo>
                  <a:lnTo>
                    <a:pt x="1480" y="71775"/>
                  </a:lnTo>
                  <a:lnTo>
                    <a:pt x="1475" y="71993"/>
                  </a:lnTo>
                  <a:lnTo>
                    <a:pt x="1469" y="72212"/>
                  </a:lnTo>
                  <a:lnTo>
                    <a:pt x="1462" y="72431"/>
                  </a:lnTo>
                  <a:lnTo>
                    <a:pt x="1456" y="72650"/>
                  </a:lnTo>
                  <a:lnTo>
                    <a:pt x="1448" y="72869"/>
                  </a:lnTo>
                  <a:lnTo>
                    <a:pt x="1441" y="73087"/>
                  </a:lnTo>
                  <a:lnTo>
                    <a:pt x="1433" y="73306"/>
                  </a:lnTo>
                  <a:lnTo>
                    <a:pt x="1424" y="73525"/>
                  </a:lnTo>
                  <a:lnTo>
                    <a:pt x="1416" y="73744"/>
                  </a:lnTo>
                  <a:lnTo>
                    <a:pt x="1407" y="73963"/>
                  </a:lnTo>
                  <a:lnTo>
                    <a:pt x="1398" y="74182"/>
                  </a:lnTo>
                  <a:lnTo>
                    <a:pt x="1388" y="74400"/>
                  </a:lnTo>
                  <a:lnTo>
                    <a:pt x="1378" y="74619"/>
                  </a:lnTo>
                  <a:lnTo>
                    <a:pt x="1368" y="74838"/>
                  </a:lnTo>
                  <a:lnTo>
                    <a:pt x="1358" y="75057"/>
                  </a:lnTo>
                  <a:lnTo>
                    <a:pt x="1347" y="75276"/>
                  </a:lnTo>
                  <a:lnTo>
                    <a:pt x="1337" y="75495"/>
                  </a:lnTo>
                  <a:lnTo>
                    <a:pt x="1326" y="75713"/>
                  </a:lnTo>
                  <a:lnTo>
                    <a:pt x="1315" y="75932"/>
                  </a:lnTo>
                  <a:lnTo>
                    <a:pt x="1304" y="76151"/>
                  </a:lnTo>
                  <a:lnTo>
                    <a:pt x="1293" y="76370"/>
                  </a:lnTo>
                  <a:lnTo>
                    <a:pt x="1282" y="76589"/>
                  </a:lnTo>
                  <a:lnTo>
                    <a:pt x="1271" y="76808"/>
                  </a:lnTo>
                  <a:lnTo>
                    <a:pt x="1260" y="77026"/>
                  </a:lnTo>
                  <a:lnTo>
                    <a:pt x="1249" y="77245"/>
                  </a:lnTo>
                  <a:lnTo>
                    <a:pt x="1237" y="77464"/>
                  </a:lnTo>
                  <a:lnTo>
                    <a:pt x="1226" y="77683"/>
                  </a:lnTo>
                  <a:lnTo>
                    <a:pt x="1215" y="77902"/>
                  </a:lnTo>
                  <a:lnTo>
                    <a:pt x="1204" y="78120"/>
                  </a:lnTo>
                  <a:lnTo>
                    <a:pt x="1193" y="78339"/>
                  </a:lnTo>
                  <a:lnTo>
                    <a:pt x="1182" y="78558"/>
                  </a:lnTo>
                  <a:lnTo>
                    <a:pt x="1171" y="78777"/>
                  </a:lnTo>
                  <a:lnTo>
                    <a:pt x="1160" y="78996"/>
                  </a:lnTo>
                  <a:lnTo>
                    <a:pt x="1150" y="79215"/>
                  </a:lnTo>
                  <a:lnTo>
                    <a:pt x="1139" y="79433"/>
                  </a:lnTo>
                  <a:lnTo>
                    <a:pt x="1129" y="79652"/>
                  </a:lnTo>
                  <a:lnTo>
                    <a:pt x="1118" y="79871"/>
                  </a:lnTo>
                  <a:lnTo>
                    <a:pt x="1108" y="80090"/>
                  </a:lnTo>
                  <a:lnTo>
                    <a:pt x="1098" y="80309"/>
                  </a:lnTo>
                  <a:lnTo>
                    <a:pt x="1088" y="80528"/>
                  </a:lnTo>
                  <a:lnTo>
                    <a:pt x="1078" y="80746"/>
                  </a:lnTo>
                  <a:lnTo>
                    <a:pt x="1068" y="80965"/>
                  </a:lnTo>
                  <a:lnTo>
                    <a:pt x="1059" y="81184"/>
                  </a:lnTo>
                  <a:lnTo>
                    <a:pt x="1049" y="81403"/>
                  </a:lnTo>
                  <a:lnTo>
                    <a:pt x="1040" y="81622"/>
                  </a:lnTo>
                  <a:lnTo>
                    <a:pt x="1031" y="81841"/>
                  </a:lnTo>
                  <a:lnTo>
                    <a:pt x="1021" y="82059"/>
                  </a:lnTo>
                  <a:lnTo>
                    <a:pt x="1012" y="82278"/>
                  </a:lnTo>
                  <a:lnTo>
                    <a:pt x="1003" y="82497"/>
                  </a:lnTo>
                  <a:lnTo>
                    <a:pt x="994" y="82716"/>
                  </a:lnTo>
                  <a:lnTo>
                    <a:pt x="986" y="82935"/>
                  </a:lnTo>
                  <a:lnTo>
                    <a:pt x="977" y="83154"/>
                  </a:lnTo>
                  <a:lnTo>
                    <a:pt x="968" y="83372"/>
                  </a:lnTo>
                  <a:lnTo>
                    <a:pt x="960" y="83591"/>
                  </a:lnTo>
                  <a:lnTo>
                    <a:pt x="951" y="83810"/>
                  </a:lnTo>
                  <a:lnTo>
                    <a:pt x="942" y="84029"/>
                  </a:lnTo>
                  <a:lnTo>
                    <a:pt x="934" y="84248"/>
                  </a:lnTo>
                  <a:lnTo>
                    <a:pt x="925" y="84466"/>
                  </a:lnTo>
                  <a:lnTo>
                    <a:pt x="917" y="84685"/>
                  </a:lnTo>
                  <a:lnTo>
                    <a:pt x="908" y="84904"/>
                  </a:lnTo>
                  <a:lnTo>
                    <a:pt x="900" y="85123"/>
                  </a:lnTo>
                  <a:lnTo>
                    <a:pt x="891" y="85342"/>
                  </a:lnTo>
                  <a:lnTo>
                    <a:pt x="882" y="85561"/>
                  </a:lnTo>
                  <a:lnTo>
                    <a:pt x="874" y="85779"/>
                  </a:lnTo>
                  <a:lnTo>
                    <a:pt x="865" y="85998"/>
                  </a:lnTo>
                  <a:lnTo>
                    <a:pt x="856" y="86217"/>
                  </a:lnTo>
                  <a:lnTo>
                    <a:pt x="847" y="86436"/>
                  </a:lnTo>
                  <a:lnTo>
                    <a:pt x="838" y="86655"/>
                  </a:lnTo>
                  <a:lnTo>
                    <a:pt x="829" y="86874"/>
                  </a:lnTo>
                  <a:lnTo>
                    <a:pt x="820" y="87092"/>
                  </a:lnTo>
                  <a:lnTo>
                    <a:pt x="811" y="87311"/>
                  </a:lnTo>
                  <a:lnTo>
                    <a:pt x="801" y="87530"/>
                  </a:lnTo>
                  <a:lnTo>
                    <a:pt x="792" y="87749"/>
                  </a:lnTo>
                  <a:lnTo>
                    <a:pt x="782" y="87968"/>
                  </a:lnTo>
                  <a:lnTo>
                    <a:pt x="772" y="88187"/>
                  </a:lnTo>
                  <a:lnTo>
                    <a:pt x="763" y="88405"/>
                  </a:lnTo>
                  <a:lnTo>
                    <a:pt x="753" y="88624"/>
                  </a:lnTo>
                  <a:lnTo>
                    <a:pt x="742" y="88843"/>
                  </a:lnTo>
                  <a:lnTo>
                    <a:pt x="732" y="89062"/>
                  </a:lnTo>
                  <a:lnTo>
                    <a:pt x="722" y="89281"/>
                  </a:lnTo>
                  <a:lnTo>
                    <a:pt x="711" y="89499"/>
                  </a:lnTo>
                  <a:lnTo>
                    <a:pt x="701" y="89718"/>
                  </a:lnTo>
                  <a:lnTo>
                    <a:pt x="690" y="89937"/>
                  </a:lnTo>
                  <a:lnTo>
                    <a:pt x="679" y="90156"/>
                  </a:lnTo>
                  <a:lnTo>
                    <a:pt x="668" y="90375"/>
                  </a:lnTo>
                  <a:lnTo>
                    <a:pt x="657" y="90594"/>
                  </a:lnTo>
                  <a:lnTo>
                    <a:pt x="646" y="90812"/>
                  </a:lnTo>
                  <a:lnTo>
                    <a:pt x="635" y="91031"/>
                  </a:lnTo>
                  <a:lnTo>
                    <a:pt x="623" y="91250"/>
                  </a:lnTo>
                  <a:lnTo>
                    <a:pt x="612" y="91469"/>
                  </a:lnTo>
                  <a:lnTo>
                    <a:pt x="600" y="91688"/>
                  </a:lnTo>
                  <a:lnTo>
                    <a:pt x="588" y="91907"/>
                  </a:lnTo>
                  <a:lnTo>
                    <a:pt x="577" y="92125"/>
                  </a:lnTo>
                  <a:lnTo>
                    <a:pt x="565" y="92344"/>
                  </a:lnTo>
                  <a:lnTo>
                    <a:pt x="553" y="92563"/>
                  </a:lnTo>
                  <a:lnTo>
                    <a:pt x="541" y="92782"/>
                  </a:lnTo>
                  <a:lnTo>
                    <a:pt x="529" y="93001"/>
                  </a:lnTo>
                  <a:lnTo>
                    <a:pt x="517" y="93220"/>
                  </a:lnTo>
                  <a:lnTo>
                    <a:pt x="506" y="93438"/>
                  </a:lnTo>
                  <a:lnTo>
                    <a:pt x="494" y="93657"/>
                  </a:lnTo>
                  <a:lnTo>
                    <a:pt x="482" y="93876"/>
                  </a:lnTo>
                  <a:lnTo>
                    <a:pt x="470" y="94095"/>
                  </a:lnTo>
                  <a:lnTo>
                    <a:pt x="458" y="94314"/>
                  </a:lnTo>
                  <a:lnTo>
                    <a:pt x="446" y="94532"/>
                  </a:lnTo>
                  <a:lnTo>
                    <a:pt x="434" y="94751"/>
                  </a:lnTo>
                  <a:lnTo>
                    <a:pt x="423" y="94970"/>
                  </a:lnTo>
                  <a:lnTo>
                    <a:pt x="411" y="95189"/>
                  </a:lnTo>
                  <a:lnTo>
                    <a:pt x="400" y="95408"/>
                  </a:lnTo>
                  <a:lnTo>
                    <a:pt x="388" y="95627"/>
                  </a:lnTo>
                  <a:lnTo>
                    <a:pt x="377" y="95845"/>
                  </a:lnTo>
                  <a:lnTo>
                    <a:pt x="366" y="96064"/>
                  </a:lnTo>
                  <a:lnTo>
                    <a:pt x="354" y="96283"/>
                  </a:lnTo>
                  <a:lnTo>
                    <a:pt x="343" y="96502"/>
                  </a:lnTo>
                  <a:lnTo>
                    <a:pt x="333" y="96721"/>
                  </a:lnTo>
                  <a:lnTo>
                    <a:pt x="322" y="96940"/>
                  </a:lnTo>
                  <a:lnTo>
                    <a:pt x="311" y="97158"/>
                  </a:lnTo>
                  <a:lnTo>
                    <a:pt x="301" y="97377"/>
                  </a:lnTo>
                  <a:lnTo>
                    <a:pt x="291" y="97596"/>
                  </a:lnTo>
                  <a:lnTo>
                    <a:pt x="281" y="97815"/>
                  </a:lnTo>
                  <a:lnTo>
                    <a:pt x="271" y="98034"/>
                  </a:lnTo>
                  <a:lnTo>
                    <a:pt x="261" y="98253"/>
                  </a:lnTo>
                  <a:lnTo>
                    <a:pt x="251" y="98471"/>
                  </a:lnTo>
                  <a:lnTo>
                    <a:pt x="242" y="98690"/>
                  </a:lnTo>
                  <a:lnTo>
                    <a:pt x="233" y="98909"/>
                  </a:lnTo>
                  <a:lnTo>
                    <a:pt x="224" y="99128"/>
                  </a:lnTo>
                  <a:lnTo>
                    <a:pt x="215" y="99347"/>
                  </a:lnTo>
                  <a:lnTo>
                    <a:pt x="207" y="99565"/>
                  </a:lnTo>
                  <a:lnTo>
                    <a:pt x="198" y="99784"/>
                  </a:lnTo>
                  <a:lnTo>
                    <a:pt x="190" y="100003"/>
                  </a:lnTo>
                  <a:lnTo>
                    <a:pt x="182" y="100222"/>
                  </a:lnTo>
                  <a:lnTo>
                    <a:pt x="175" y="100441"/>
                  </a:lnTo>
                  <a:lnTo>
                    <a:pt x="167" y="100660"/>
                  </a:lnTo>
                  <a:lnTo>
                    <a:pt x="160" y="100878"/>
                  </a:lnTo>
                  <a:lnTo>
                    <a:pt x="153" y="101097"/>
                  </a:lnTo>
                  <a:lnTo>
                    <a:pt x="146" y="101316"/>
                  </a:lnTo>
                  <a:lnTo>
                    <a:pt x="140" y="101535"/>
                  </a:lnTo>
                  <a:lnTo>
                    <a:pt x="133" y="101754"/>
                  </a:lnTo>
                  <a:lnTo>
                    <a:pt x="127" y="101973"/>
                  </a:lnTo>
                  <a:lnTo>
                    <a:pt x="121" y="102191"/>
                  </a:lnTo>
                  <a:lnTo>
                    <a:pt x="115" y="102410"/>
                  </a:lnTo>
                  <a:lnTo>
                    <a:pt x="110" y="102629"/>
                  </a:lnTo>
                  <a:lnTo>
                    <a:pt x="104" y="102848"/>
                  </a:lnTo>
                  <a:lnTo>
                    <a:pt x="99" y="103067"/>
                  </a:lnTo>
                  <a:lnTo>
                    <a:pt x="94" y="103286"/>
                  </a:lnTo>
                  <a:lnTo>
                    <a:pt x="89" y="103504"/>
                  </a:lnTo>
                  <a:lnTo>
                    <a:pt x="85" y="103723"/>
                  </a:lnTo>
                  <a:lnTo>
                    <a:pt x="80" y="103942"/>
                  </a:lnTo>
                  <a:lnTo>
                    <a:pt x="76" y="104161"/>
                  </a:lnTo>
                  <a:lnTo>
                    <a:pt x="72" y="104380"/>
                  </a:lnTo>
                  <a:lnTo>
                    <a:pt x="68" y="104598"/>
                  </a:lnTo>
                  <a:lnTo>
                    <a:pt x="64" y="104817"/>
                  </a:lnTo>
                  <a:lnTo>
                    <a:pt x="61" y="105036"/>
                  </a:lnTo>
                  <a:lnTo>
                    <a:pt x="57" y="105255"/>
                  </a:lnTo>
                  <a:lnTo>
                    <a:pt x="54" y="105474"/>
                  </a:lnTo>
                  <a:lnTo>
                    <a:pt x="51" y="105693"/>
                  </a:lnTo>
                  <a:lnTo>
                    <a:pt x="48" y="105911"/>
                  </a:lnTo>
                  <a:lnTo>
                    <a:pt x="45" y="106130"/>
                  </a:lnTo>
                  <a:lnTo>
                    <a:pt x="42" y="106349"/>
                  </a:lnTo>
                  <a:lnTo>
                    <a:pt x="40" y="106568"/>
                  </a:lnTo>
                  <a:lnTo>
                    <a:pt x="37" y="106787"/>
                  </a:lnTo>
                  <a:lnTo>
                    <a:pt x="35" y="107006"/>
                  </a:lnTo>
                  <a:lnTo>
                    <a:pt x="33" y="107224"/>
                  </a:lnTo>
                  <a:lnTo>
                    <a:pt x="31" y="107443"/>
                  </a:lnTo>
                  <a:lnTo>
                    <a:pt x="29" y="107662"/>
                  </a:lnTo>
                  <a:lnTo>
                    <a:pt x="27" y="107881"/>
                  </a:lnTo>
                  <a:lnTo>
                    <a:pt x="25" y="108100"/>
                  </a:lnTo>
                  <a:lnTo>
                    <a:pt x="24" y="108319"/>
                  </a:lnTo>
                  <a:lnTo>
                    <a:pt x="22" y="108537"/>
                  </a:lnTo>
                  <a:lnTo>
                    <a:pt x="20" y="108756"/>
                  </a:lnTo>
                  <a:lnTo>
                    <a:pt x="19" y="108975"/>
                  </a:lnTo>
                  <a:lnTo>
                    <a:pt x="18" y="109194"/>
                  </a:lnTo>
                  <a:lnTo>
                    <a:pt x="17" y="109413"/>
                  </a:lnTo>
                  <a:lnTo>
                    <a:pt x="15" y="109631"/>
                  </a:lnTo>
                  <a:lnTo>
                    <a:pt x="14" y="109850"/>
                  </a:lnTo>
                  <a:lnTo>
                    <a:pt x="13" y="110069"/>
                  </a:lnTo>
                  <a:lnTo>
                    <a:pt x="12" y="110288"/>
                  </a:lnTo>
                  <a:lnTo>
                    <a:pt x="11" y="110507"/>
                  </a:lnTo>
                  <a:lnTo>
                    <a:pt x="11" y="110726"/>
                  </a:lnTo>
                  <a:lnTo>
                    <a:pt x="10" y="110944"/>
                  </a:lnTo>
                  <a:lnTo>
                    <a:pt x="9" y="111163"/>
                  </a:lnTo>
                  <a:lnTo>
                    <a:pt x="8" y="111382"/>
                  </a:lnTo>
                  <a:lnTo>
                    <a:pt x="8" y="111601"/>
                  </a:lnTo>
                  <a:lnTo>
                    <a:pt x="7" y="111820"/>
                  </a:lnTo>
                  <a:lnTo>
                    <a:pt x="0" y="111820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370" name="pl52"/>
            <p:cNvSpPr/>
            <p:nvPr/>
          </p:nvSpPr>
          <p:spPr>
            <a:xfrm>
              <a:off x="1973132" y="3716459"/>
              <a:ext cx="0" cy="47153"/>
            </a:xfrm>
            <a:custGeom>
              <a:avLst/>
              <a:gdLst/>
              <a:ahLst/>
              <a:cxnLst/>
              <a:rect l="0" t="0" r="0" b="0"/>
              <a:pathLst>
                <a:path h="47153">
                  <a:moveTo>
                    <a:pt x="0" y="47153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1" name="pl53"/>
            <p:cNvSpPr/>
            <p:nvPr/>
          </p:nvSpPr>
          <p:spPr>
            <a:xfrm>
              <a:off x="1973132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2" name="pg54"/>
            <p:cNvSpPr/>
            <p:nvPr/>
          </p:nvSpPr>
          <p:spPr>
            <a:xfrm>
              <a:off x="1952792" y="3763613"/>
              <a:ext cx="40681" cy="36148"/>
            </a:xfrm>
            <a:custGeom>
              <a:avLst/>
              <a:gdLst/>
              <a:ahLst/>
              <a:cxnLst/>
              <a:rect l="0" t="0" r="0" b="0"/>
              <a:pathLst>
                <a:path w="40681" h="36148">
                  <a:moveTo>
                    <a:pt x="0" y="0"/>
                  </a:moveTo>
                  <a:lnTo>
                    <a:pt x="0" y="36148"/>
                  </a:lnTo>
                  <a:lnTo>
                    <a:pt x="40681" y="36148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3" name="pl55"/>
            <p:cNvSpPr/>
            <p:nvPr/>
          </p:nvSpPr>
          <p:spPr>
            <a:xfrm>
              <a:off x="1952792" y="379976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4" name="pl56"/>
            <p:cNvSpPr/>
            <p:nvPr/>
          </p:nvSpPr>
          <p:spPr>
            <a:xfrm>
              <a:off x="2027374" y="3765186"/>
              <a:ext cx="0" cy="15622"/>
            </a:xfrm>
            <a:custGeom>
              <a:avLst/>
              <a:gdLst/>
              <a:ahLst/>
              <a:cxnLst/>
              <a:rect l="0" t="0" r="0" b="0"/>
              <a:pathLst>
                <a:path h="15622">
                  <a:moveTo>
                    <a:pt x="0" y="15622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5" name="pl57"/>
            <p:cNvSpPr/>
            <p:nvPr/>
          </p:nvSpPr>
          <p:spPr>
            <a:xfrm>
              <a:off x="2027374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pg58"/>
            <p:cNvSpPr/>
            <p:nvPr/>
          </p:nvSpPr>
          <p:spPr>
            <a:xfrm>
              <a:off x="2007033" y="3780808"/>
              <a:ext cx="40681" cy="18952"/>
            </a:xfrm>
            <a:custGeom>
              <a:avLst/>
              <a:gdLst/>
              <a:ahLst/>
              <a:cxnLst/>
              <a:rect l="0" t="0" r="0" b="0"/>
              <a:pathLst>
                <a:path w="40681" h="18952">
                  <a:moveTo>
                    <a:pt x="0" y="0"/>
                  </a:moveTo>
                  <a:lnTo>
                    <a:pt x="0" y="18952"/>
                  </a:lnTo>
                  <a:lnTo>
                    <a:pt x="40681" y="18952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7" name="pl59"/>
            <p:cNvSpPr/>
            <p:nvPr/>
          </p:nvSpPr>
          <p:spPr>
            <a:xfrm>
              <a:off x="2007033" y="379976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pl60"/>
            <p:cNvSpPr/>
            <p:nvPr/>
          </p:nvSpPr>
          <p:spPr>
            <a:xfrm>
              <a:off x="2244341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9" name="pl61"/>
            <p:cNvSpPr/>
            <p:nvPr/>
          </p:nvSpPr>
          <p:spPr>
            <a:xfrm>
              <a:off x="2244341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0" name="pg62"/>
            <p:cNvSpPr/>
            <p:nvPr/>
          </p:nvSpPr>
          <p:spPr>
            <a:xfrm>
              <a:off x="2224001" y="379976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1" name="pl63"/>
            <p:cNvSpPr/>
            <p:nvPr/>
          </p:nvSpPr>
          <p:spPr>
            <a:xfrm>
              <a:off x="2224001" y="379976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2" name="pl64"/>
            <p:cNvSpPr/>
            <p:nvPr/>
          </p:nvSpPr>
          <p:spPr>
            <a:xfrm>
              <a:off x="2298583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3" name="pl65"/>
            <p:cNvSpPr/>
            <p:nvPr/>
          </p:nvSpPr>
          <p:spPr>
            <a:xfrm>
              <a:off x="2298583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4" name="pg66"/>
            <p:cNvSpPr/>
            <p:nvPr/>
          </p:nvSpPr>
          <p:spPr>
            <a:xfrm>
              <a:off x="2278243" y="379976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5" name="pl67"/>
            <p:cNvSpPr/>
            <p:nvPr/>
          </p:nvSpPr>
          <p:spPr>
            <a:xfrm>
              <a:off x="2278243" y="379976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6" name="pl68"/>
            <p:cNvSpPr/>
            <p:nvPr/>
          </p:nvSpPr>
          <p:spPr>
            <a:xfrm>
              <a:off x="2515551" y="3606575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7" name="pl69"/>
            <p:cNvSpPr/>
            <p:nvPr/>
          </p:nvSpPr>
          <p:spPr>
            <a:xfrm>
              <a:off x="2515551" y="3755737"/>
              <a:ext cx="0" cy="11252"/>
            </a:xfrm>
            <a:custGeom>
              <a:avLst/>
              <a:gdLst/>
              <a:ahLst/>
              <a:cxnLst/>
              <a:rect l="0" t="0" r="0" b="0"/>
              <a:pathLst>
                <a:path h="11252">
                  <a:moveTo>
                    <a:pt x="0" y="0"/>
                  </a:moveTo>
                  <a:lnTo>
                    <a:pt x="0" y="11252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8" name="pg70"/>
            <p:cNvSpPr/>
            <p:nvPr/>
          </p:nvSpPr>
          <p:spPr>
            <a:xfrm>
              <a:off x="2495210" y="3606575"/>
              <a:ext cx="40681" cy="149162"/>
            </a:xfrm>
            <a:custGeom>
              <a:avLst/>
              <a:gdLst/>
              <a:ahLst/>
              <a:cxnLst/>
              <a:rect l="0" t="0" r="0" b="0"/>
              <a:pathLst>
                <a:path w="40681" h="149162">
                  <a:moveTo>
                    <a:pt x="0" y="0"/>
                  </a:moveTo>
                  <a:lnTo>
                    <a:pt x="0" y="149162"/>
                  </a:lnTo>
                  <a:lnTo>
                    <a:pt x="40681" y="149162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9" name="pl71"/>
            <p:cNvSpPr/>
            <p:nvPr/>
          </p:nvSpPr>
          <p:spPr>
            <a:xfrm>
              <a:off x="2495210" y="3661184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0" name="pl72"/>
            <p:cNvSpPr/>
            <p:nvPr/>
          </p:nvSpPr>
          <p:spPr>
            <a:xfrm>
              <a:off x="2569792" y="3739757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1" name="pl73"/>
            <p:cNvSpPr/>
            <p:nvPr/>
          </p:nvSpPr>
          <p:spPr>
            <a:xfrm>
              <a:off x="2569792" y="3781488"/>
              <a:ext cx="0" cy="8183"/>
            </a:xfrm>
            <a:custGeom>
              <a:avLst/>
              <a:gdLst/>
              <a:ahLst/>
              <a:cxnLst/>
              <a:rect l="0" t="0" r="0" b="0"/>
              <a:pathLst>
                <a:path h="8183">
                  <a:moveTo>
                    <a:pt x="0" y="0"/>
                  </a:moveTo>
                  <a:lnTo>
                    <a:pt x="0" y="8183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2" name="pg74"/>
            <p:cNvSpPr/>
            <p:nvPr/>
          </p:nvSpPr>
          <p:spPr>
            <a:xfrm>
              <a:off x="2549452" y="3739757"/>
              <a:ext cx="40681" cy="41731"/>
            </a:xfrm>
            <a:custGeom>
              <a:avLst/>
              <a:gdLst/>
              <a:ahLst/>
              <a:cxnLst/>
              <a:rect l="0" t="0" r="0" b="0"/>
              <a:pathLst>
                <a:path w="40681" h="41731">
                  <a:moveTo>
                    <a:pt x="0" y="0"/>
                  </a:moveTo>
                  <a:lnTo>
                    <a:pt x="0" y="41731"/>
                  </a:lnTo>
                  <a:lnTo>
                    <a:pt x="40681" y="41731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3" name="pl75"/>
            <p:cNvSpPr/>
            <p:nvPr/>
          </p:nvSpPr>
          <p:spPr>
            <a:xfrm>
              <a:off x="2549452" y="3746389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4" name="pl76"/>
            <p:cNvSpPr/>
            <p:nvPr/>
          </p:nvSpPr>
          <p:spPr>
            <a:xfrm>
              <a:off x="2786760" y="3366654"/>
              <a:ext cx="0" cy="221189"/>
            </a:xfrm>
            <a:custGeom>
              <a:avLst/>
              <a:gdLst/>
              <a:ahLst/>
              <a:cxnLst/>
              <a:rect l="0" t="0" r="0" b="0"/>
              <a:pathLst>
                <a:path h="221189">
                  <a:moveTo>
                    <a:pt x="0" y="221189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5" name="pl77"/>
            <p:cNvSpPr/>
            <p:nvPr/>
          </p:nvSpPr>
          <p:spPr>
            <a:xfrm>
              <a:off x="2786760" y="3758923"/>
              <a:ext cx="0" cy="40837"/>
            </a:xfrm>
            <a:custGeom>
              <a:avLst/>
              <a:gdLst/>
              <a:ahLst/>
              <a:cxnLst/>
              <a:rect l="0" t="0" r="0" b="0"/>
              <a:pathLst>
                <a:path h="40837">
                  <a:moveTo>
                    <a:pt x="0" y="0"/>
                  </a:moveTo>
                  <a:lnTo>
                    <a:pt x="0" y="40837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6" name="pg78"/>
            <p:cNvSpPr/>
            <p:nvPr/>
          </p:nvSpPr>
          <p:spPr>
            <a:xfrm>
              <a:off x="2766419" y="3587844"/>
              <a:ext cx="40681" cy="171079"/>
            </a:xfrm>
            <a:custGeom>
              <a:avLst/>
              <a:gdLst/>
              <a:ahLst/>
              <a:cxnLst/>
              <a:rect l="0" t="0" r="0" b="0"/>
              <a:pathLst>
                <a:path w="40681" h="171079">
                  <a:moveTo>
                    <a:pt x="0" y="0"/>
                  </a:moveTo>
                  <a:lnTo>
                    <a:pt x="0" y="171079"/>
                  </a:lnTo>
                  <a:lnTo>
                    <a:pt x="40681" y="171079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7" name="pl79"/>
            <p:cNvSpPr/>
            <p:nvPr/>
          </p:nvSpPr>
          <p:spPr>
            <a:xfrm>
              <a:off x="2766419" y="3745628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8" name="pl80"/>
            <p:cNvSpPr/>
            <p:nvPr/>
          </p:nvSpPr>
          <p:spPr>
            <a:xfrm>
              <a:off x="2841002" y="3733939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9" name="pl81"/>
            <p:cNvSpPr/>
            <p:nvPr/>
          </p:nvSpPr>
          <p:spPr>
            <a:xfrm>
              <a:off x="2841002" y="3778912"/>
              <a:ext cx="0" cy="20848"/>
            </a:xfrm>
            <a:custGeom>
              <a:avLst/>
              <a:gdLst/>
              <a:ahLst/>
              <a:cxnLst/>
              <a:rect l="0" t="0" r="0" b="0"/>
              <a:pathLst>
                <a:path h="20848">
                  <a:moveTo>
                    <a:pt x="0" y="0"/>
                  </a:moveTo>
                  <a:lnTo>
                    <a:pt x="0" y="20848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0" name="pg82"/>
            <p:cNvSpPr/>
            <p:nvPr/>
          </p:nvSpPr>
          <p:spPr>
            <a:xfrm>
              <a:off x="2820661" y="3733939"/>
              <a:ext cx="40681" cy="44972"/>
            </a:xfrm>
            <a:custGeom>
              <a:avLst/>
              <a:gdLst/>
              <a:ahLst/>
              <a:cxnLst/>
              <a:rect l="0" t="0" r="0" b="0"/>
              <a:pathLst>
                <a:path w="40681" h="44972">
                  <a:moveTo>
                    <a:pt x="0" y="0"/>
                  </a:moveTo>
                  <a:lnTo>
                    <a:pt x="0" y="44972"/>
                  </a:lnTo>
                  <a:lnTo>
                    <a:pt x="40681" y="44972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1" name="pl83"/>
            <p:cNvSpPr/>
            <p:nvPr/>
          </p:nvSpPr>
          <p:spPr>
            <a:xfrm>
              <a:off x="2820661" y="3778349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2" name="pl84"/>
            <p:cNvSpPr/>
            <p:nvPr/>
          </p:nvSpPr>
          <p:spPr>
            <a:xfrm>
              <a:off x="3057969" y="3067730"/>
              <a:ext cx="0" cy="38388"/>
            </a:xfrm>
            <a:custGeom>
              <a:avLst/>
              <a:gdLst/>
              <a:ahLst/>
              <a:cxnLst/>
              <a:rect l="0" t="0" r="0" b="0"/>
              <a:pathLst>
                <a:path h="38388">
                  <a:moveTo>
                    <a:pt x="0" y="38388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3" name="pl85"/>
            <p:cNvSpPr/>
            <p:nvPr/>
          </p:nvSpPr>
          <p:spPr>
            <a:xfrm>
              <a:off x="3057969" y="3397576"/>
              <a:ext cx="0" cy="13174"/>
            </a:xfrm>
            <a:custGeom>
              <a:avLst/>
              <a:gdLst/>
              <a:ahLst/>
              <a:cxnLst/>
              <a:rect l="0" t="0" r="0" b="0"/>
              <a:pathLst>
                <a:path h="13174">
                  <a:moveTo>
                    <a:pt x="0" y="0"/>
                  </a:moveTo>
                  <a:lnTo>
                    <a:pt x="0" y="13174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4" name="pg86"/>
            <p:cNvSpPr/>
            <p:nvPr/>
          </p:nvSpPr>
          <p:spPr>
            <a:xfrm>
              <a:off x="3037628" y="3106118"/>
              <a:ext cx="40681" cy="291457"/>
            </a:xfrm>
            <a:custGeom>
              <a:avLst/>
              <a:gdLst/>
              <a:ahLst/>
              <a:cxnLst/>
              <a:rect l="0" t="0" r="0" b="0"/>
              <a:pathLst>
                <a:path w="40681" h="291457">
                  <a:moveTo>
                    <a:pt x="0" y="0"/>
                  </a:moveTo>
                  <a:lnTo>
                    <a:pt x="0" y="291457"/>
                  </a:lnTo>
                  <a:lnTo>
                    <a:pt x="40681" y="291457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5" name="pl87"/>
            <p:cNvSpPr/>
            <p:nvPr/>
          </p:nvSpPr>
          <p:spPr>
            <a:xfrm>
              <a:off x="3037628" y="3247268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6" name="pl88"/>
            <p:cNvSpPr/>
            <p:nvPr/>
          </p:nvSpPr>
          <p:spPr>
            <a:xfrm>
              <a:off x="3112211" y="3586218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7" name="pl89"/>
            <p:cNvSpPr/>
            <p:nvPr/>
          </p:nvSpPr>
          <p:spPr>
            <a:xfrm>
              <a:off x="3112211" y="3628157"/>
              <a:ext cx="0" cy="16706"/>
            </a:xfrm>
            <a:custGeom>
              <a:avLst/>
              <a:gdLst/>
              <a:ahLst/>
              <a:cxnLst/>
              <a:rect l="0" t="0" r="0" b="0"/>
              <a:pathLst>
                <a:path h="16706">
                  <a:moveTo>
                    <a:pt x="0" y="0"/>
                  </a:moveTo>
                  <a:lnTo>
                    <a:pt x="0" y="16706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8" name="pg90"/>
            <p:cNvSpPr/>
            <p:nvPr/>
          </p:nvSpPr>
          <p:spPr>
            <a:xfrm>
              <a:off x="3091870" y="3586218"/>
              <a:ext cx="40681" cy="41938"/>
            </a:xfrm>
            <a:custGeom>
              <a:avLst/>
              <a:gdLst/>
              <a:ahLst/>
              <a:cxnLst/>
              <a:rect l="0" t="0" r="0" b="0"/>
              <a:pathLst>
                <a:path w="40681" h="41938">
                  <a:moveTo>
                    <a:pt x="0" y="0"/>
                  </a:moveTo>
                  <a:lnTo>
                    <a:pt x="0" y="41938"/>
                  </a:lnTo>
                  <a:lnTo>
                    <a:pt x="40681" y="41938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9" name="pl91"/>
            <p:cNvSpPr/>
            <p:nvPr/>
          </p:nvSpPr>
          <p:spPr>
            <a:xfrm>
              <a:off x="3091870" y="3595800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0" name="pl92"/>
            <p:cNvSpPr/>
            <p:nvPr/>
          </p:nvSpPr>
          <p:spPr>
            <a:xfrm>
              <a:off x="3329178" y="3669776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1" name="pl93"/>
            <p:cNvSpPr/>
            <p:nvPr/>
          </p:nvSpPr>
          <p:spPr>
            <a:xfrm>
              <a:off x="3329178" y="3782017"/>
              <a:ext cx="0" cy="17743"/>
            </a:xfrm>
            <a:custGeom>
              <a:avLst/>
              <a:gdLst/>
              <a:ahLst/>
              <a:cxnLst/>
              <a:rect l="0" t="0" r="0" b="0"/>
              <a:pathLst>
                <a:path h="17743">
                  <a:moveTo>
                    <a:pt x="0" y="0"/>
                  </a:moveTo>
                  <a:lnTo>
                    <a:pt x="0" y="17743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2" name="pg94"/>
            <p:cNvSpPr/>
            <p:nvPr/>
          </p:nvSpPr>
          <p:spPr>
            <a:xfrm>
              <a:off x="3308837" y="3669776"/>
              <a:ext cx="40681" cy="112240"/>
            </a:xfrm>
            <a:custGeom>
              <a:avLst/>
              <a:gdLst/>
              <a:ahLst/>
              <a:cxnLst/>
              <a:rect l="0" t="0" r="0" b="0"/>
              <a:pathLst>
                <a:path w="40681" h="112240">
                  <a:moveTo>
                    <a:pt x="0" y="0"/>
                  </a:moveTo>
                  <a:lnTo>
                    <a:pt x="0" y="112240"/>
                  </a:lnTo>
                  <a:lnTo>
                    <a:pt x="40681" y="112240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3" name="pl95"/>
            <p:cNvSpPr/>
            <p:nvPr/>
          </p:nvSpPr>
          <p:spPr>
            <a:xfrm>
              <a:off x="3308837" y="373757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4" name="pl96"/>
            <p:cNvSpPr/>
            <p:nvPr/>
          </p:nvSpPr>
          <p:spPr>
            <a:xfrm>
              <a:off x="3383420" y="3667057"/>
              <a:ext cx="0" cy="64552"/>
            </a:xfrm>
            <a:custGeom>
              <a:avLst/>
              <a:gdLst/>
              <a:ahLst/>
              <a:cxnLst/>
              <a:rect l="0" t="0" r="0" b="0"/>
              <a:pathLst>
                <a:path h="64552">
                  <a:moveTo>
                    <a:pt x="0" y="64552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5" name="pl97"/>
            <p:cNvSpPr/>
            <p:nvPr/>
          </p:nvSpPr>
          <p:spPr>
            <a:xfrm>
              <a:off x="3383420" y="3794298"/>
              <a:ext cx="0" cy="5462"/>
            </a:xfrm>
            <a:custGeom>
              <a:avLst/>
              <a:gdLst/>
              <a:ahLst/>
              <a:cxnLst/>
              <a:rect l="0" t="0" r="0" b="0"/>
              <a:pathLst>
                <a:path h="5462">
                  <a:moveTo>
                    <a:pt x="0" y="0"/>
                  </a:moveTo>
                  <a:lnTo>
                    <a:pt x="0" y="5462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6" name="pg98"/>
            <p:cNvSpPr/>
            <p:nvPr/>
          </p:nvSpPr>
          <p:spPr>
            <a:xfrm>
              <a:off x="3363079" y="3731609"/>
              <a:ext cx="40681" cy="62689"/>
            </a:xfrm>
            <a:custGeom>
              <a:avLst/>
              <a:gdLst/>
              <a:ahLst/>
              <a:cxnLst/>
              <a:rect l="0" t="0" r="0" b="0"/>
              <a:pathLst>
                <a:path w="40681" h="62689">
                  <a:moveTo>
                    <a:pt x="0" y="0"/>
                  </a:moveTo>
                  <a:lnTo>
                    <a:pt x="0" y="62689"/>
                  </a:lnTo>
                  <a:lnTo>
                    <a:pt x="40681" y="62689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7" name="pl99"/>
            <p:cNvSpPr/>
            <p:nvPr/>
          </p:nvSpPr>
          <p:spPr>
            <a:xfrm>
              <a:off x="3363079" y="3780445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8" name="pl100"/>
            <p:cNvSpPr/>
            <p:nvPr/>
          </p:nvSpPr>
          <p:spPr>
            <a:xfrm>
              <a:off x="3600387" y="3428022"/>
              <a:ext cx="0" cy="48925"/>
            </a:xfrm>
            <a:custGeom>
              <a:avLst/>
              <a:gdLst/>
              <a:ahLst/>
              <a:cxnLst/>
              <a:rect l="0" t="0" r="0" b="0"/>
              <a:pathLst>
                <a:path h="48925">
                  <a:moveTo>
                    <a:pt x="0" y="48925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9" name="pl101"/>
            <p:cNvSpPr/>
            <p:nvPr/>
          </p:nvSpPr>
          <p:spPr>
            <a:xfrm>
              <a:off x="3600387" y="3567942"/>
              <a:ext cx="0" cy="50065"/>
            </a:xfrm>
            <a:custGeom>
              <a:avLst/>
              <a:gdLst/>
              <a:ahLst/>
              <a:cxnLst/>
              <a:rect l="0" t="0" r="0" b="0"/>
              <a:pathLst>
                <a:path h="50065">
                  <a:moveTo>
                    <a:pt x="0" y="0"/>
                  </a:moveTo>
                  <a:lnTo>
                    <a:pt x="0" y="50065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0" name="pg102"/>
            <p:cNvSpPr/>
            <p:nvPr/>
          </p:nvSpPr>
          <p:spPr>
            <a:xfrm>
              <a:off x="3580047" y="3476947"/>
              <a:ext cx="40681" cy="90994"/>
            </a:xfrm>
            <a:custGeom>
              <a:avLst/>
              <a:gdLst/>
              <a:ahLst/>
              <a:cxnLst/>
              <a:rect l="0" t="0" r="0" b="0"/>
              <a:pathLst>
                <a:path w="40681" h="90994">
                  <a:moveTo>
                    <a:pt x="0" y="0"/>
                  </a:moveTo>
                  <a:lnTo>
                    <a:pt x="0" y="90994"/>
                  </a:lnTo>
                  <a:lnTo>
                    <a:pt x="40681" y="90994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1" name="pl103"/>
            <p:cNvSpPr/>
            <p:nvPr/>
          </p:nvSpPr>
          <p:spPr>
            <a:xfrm>
              <a:off x="3580047" y="3564758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2" name="pl104"/>
            <p:cNvSpPr/>
            <p:nvPr/>
          </p:nvSpPr>
          <p:spPr>
            <a:xfrm>
              <a:off x="3654629" y="3665774"/>
              <a:ext cx="0" cy="19544"/>
            </a:xfrm>
            <a:custGeom>
              <a:avLst/>
              <a:gdLst/>
              <a:ahLst/>
              <a:cxnLst/>
              <a:rect l="0" t="0" r="0" b="0"/>
              <a:pathLst>
                <a:path h="19544">
                  <a:moveTo>
                    <a:pt x="0" y="1954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3" name="pl105"/>
            <p:cNvSpPr/>
            <p:nvPr/>
          </p:nvSpPr>
          <p:spPr>
            <a:xfrm>
              <a:off x="3654629" y="3709252"/>
              <a:ext cx="0" cy="18506"/>
            </a:xfrm>
            <a:custGeom>
              <a:avLst/>
              <a:gdLst/>
              <a:ahLst/>
              <a:cxnLst/>
              <a:rect l="0" t="0" r="0" b="0"/>
              <a:pathLst>
                <a:path h="18506">
                  <a:moveTo>
                    <a:pt x="0" y="0"/>
                  </a:moveTo>
                  <a:lnTo>
                    <a:pt x="0" y="18506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4" name="pg106"/>
            <p:cNvSpPr/>
            <p:nvPr/>
          </p:nvSpPr>
          <p:spPr>
            <a:xfrm>
              <a:off x="3634288" y="3685318"/>
              <a:ext cx="40681" cy="23933"/>
            </a:xfrm>
            <a:custGeom>
              <a:avLst/>
              <a:gdLst/>
              <a:ahLst/>
              <a:cxnLst/>
              <a:rect l="0" t="0" r="0" b="0"/>
              <a:pathLst>
                <a:path w="40681" h="23933">
                  <a:moveTo>
                    <a:pt x="0" y="0"/>
                  </a:moveTo>
                  <a:lnTo>
                    <a:pt x="0" y="23933"/>
                  </a:lnTo>
                  <a:lnTo>
                    <a:pt x="40681" y="23933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5" name="pl107"/>
            <p:cNvSpPr/>
            <p:nvPr/>
          </p:nvSpPr>
          <p:spPr>
            <a:xfrm>
              <a:off x="3634288" y="3704466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6" name="pl108"/>
            <p:cNvSpPr/>
            <p:nvPr/>
          </p:nvSpPr>
          <p:spPr>
            <a:xfrm>
              <a:off x="3871597" y="3659023"/>
              <a:ext cx="0" cy="342"/>
            </a:xfrm>
            <a:custGeom>
              <a:avLst/>
              <a:gdLst/>
              <a:ahLst/>
              <a:cxnLst/>
              <a:rect l="0" t="0" r="0" b="0"/>
              <a:pathLst>
                <a:path h="342">
                  <a:moveTo>
                    <a:pt x="0" y="342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7" name="pl109"/>
            <p:cNvSpPr/>
            <p:nvPr/>
          </p:nvSpPr>
          <p:spPr>
            <a:xfrm>
              <a:off x="3871597" y="3759246"/>
              <a:ext cx="0" cy="2081"/>
            </a:xfrm>
            <a:custGeom>
              <a:avLst/>
              <a:gdLst/>
              <a:ahLst/>
              <a:cxnLst/>
              <a:rect l="0" t="0" r="0" b="0"/>
              <a:pathLst>
                <a:path h="2081">
                  <a:moveTo>
                    <a:pt x="0" y="0"/>
                  </a:moveTo>
                  <a:lnTo>
                    <a:pt x="0" y="2081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8" name="pg110"/>
            <p:cNvSpPr/>
            <p:nvPr/>
          </p:nvSpPr>
          <p:spPr>
            <a:xfrm>
              <a:off x="3851256" y="3659365"/>
              <a:ext cx="40681" cy="99880"/>
            </a:xfrm>
            <a:custGeom>
              <a:avLst/>
              <a:gdLst/>
              <a:ahLst/>
              <a:cxnLst/>
              <a:rect l="0" t="0" r="0" b="0"/>
              <a:pathLst>
                <a:path w="40681" h="99880">
                  <a:moveTo>
                    <a:pt x="0" y="0"/>
                  </a:moveTo>
                  <a:lnTo>
                    <a:pt x="0" y="99880"/>
                  </a:lnTo>
                  <a:lnTo>
                    <a:pt x="40681" y="99880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9" name="pl111"/>
            <p:cNvSpPr/>
            <p:nvPr/>
          </p:nvSpPr>
          <p:spPr>
            <a:xfrm>
              <a:off x="3851256" y="3710650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0" name="pl112"/>
            <p:cNvSpPr/>
            <p:nvPr/>
          </p:nvSpPr>
          <p:spPr>
            <a:xfrm>
              <a:off x="3925838" y="3745557"/>
              <a:ext cx="0" cy="19894"/>
            </a:xfrm>
            <a:custGeom>
              <a:avLst/>
              <a:gdLst/>
              <a:ahLst/>
              <a:cxnLst/>
              <a:rect l="0" t="0" r="0" b="0"/>
              <a:pathLst>
                <a:path h="19894">
                  <a:moveTo>
                    <a:pt x="0" y="198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1" name="pl113"/>
            <p:cNvSpPr/>
            <p:nvPr/>
          </p:nvSpPr>
          <p:spPr>
            <a:xfrm>
              <a:off x="3925838" y="3784191"/>
              <a:ext cx="0" cy="3738"/>
            </a:xfrm>
            <a:custGeom>
              <a:avLst/>
              <a:gdLst/>
              <a:ahLst/>
              <a:cxnLst/>
              <a:rect l="0" t="0" r="0" b="0"/>
              <a:pathLst>
                <a:path h="3738">
                  <a:moveTo>
                    <a:pt x="0" y="0"/>
                  </a:moveTo>
                  <a:lnTo>
                    <a:pt x="0" y="3738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2" name="pg114"/>
            <p:cNvSpPr/>
            <p:nvPr/>
          </p:nvSpPr>
          <p:spPr>
            <a:xfrm>
              <a:off x="3905498" y="3765452"/>
              <a:ext cx="40681" cy="18739"/>
            </a:xfrm>
            <a:custGeom>
              <a:avLst/>
              <a:gdLst/>
              <a:ahLst/>
              <a:cxnLst/>
              <a:rect l="0" t="0" r="0" b="0"/>
              <a:pathLst>
                <a:path w="40681" h="18739">
                  <a:moveTo>
                    <a:pt x="0" y="0"/>
                  </a:moveTo>
                  <a:lnTo>
                    <a:pt x="0" y="18739"/>
                  </a:lnTo>
                  <a:lnTo>
                    <a:pt x="40681" y="18739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3" name="pl115"/>
            <p:cNvSpPr/>
            <p:nvPr/>
          </p:nvSpPr>
          <p:spPr>
            <a:xfrm>
              <a:off x="3905498" y="3777514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4" name="pl116"/>
            <p:cNvSpPr/>
            <p:nvPr/>
          </p:nvSpPr>
          <p:spPr>
            <a:xfrm>
              <a:off x="4142806" y="3637727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5" name="pl117"/>
            <p:cNvSpPr/>
            <p:nvPr/>
          </p:nvSpPr>
          <p:spPr>
            <a:xfrm>
              <a:off x="4142806" y="3654828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6" name="pg118"/>
            <p:cNvSpPr/>
            <p:nvPr/>
          </p:nvSpPr>
          <p:spPr>
            <a:xfrm>
              <a:off x="4122465" y="3637727"/>
              <a:ext cx="40681" cy="17100"/>
            </a:xfrm>
            <a:custGeom>
              <a:avLst/>
              <a:gdLst/>
              <a:ahLst/>
              <a:cxnLst/>
              <a:rect l="0" t="0" r="0" b="0"/>
              <a:pathLst>
                <a:path w="40681" h="17100">
                  <a:moveTo>
                    <a:pt x="0" y="0"/>
                  </a:moveTo>
                  <a:lnTo>
                    <a:pt x="0" y="17100"/>
                  </a:lnTo>
                  <a:lnTo>
                    <a:pt x="40681" y="17100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7" name="pl119"/>
            <p:cNvSpPr/>
            <p:nvPr/>
          </p:nvSpPr>
          <p:spPr>
            <a:xfrm>
              <a:off x="4122465" y="3639486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8" name="pl120"/>
            <p:cNvSpPr/>
            <p:nvPr/>
          </p:nvSpPr>
          <p:spPr>
            <a:xfrm>
              <a:off x="4197048" y="3695229"/>
              <a:ext cx="0" cy="19576"/>
            </a:xfrm>
            <a:custGeom>
              <a:avLst/>
              <a:gdLst/>
              <a:ahLst/>
              <a:cxnLst/>
              <a:rect l="0" t="0" r="0" b="0"/>
              <a:pathLst>
                <a:path h="19576">
                  <a:moveTo>
                    <a:pt x="0" y="19576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9" name="pl121"/>
            <p:cNvSpPr/>
            <p:nvPr/>
          </p:nvSpPr>
          <p:spPr>
            <a:xfrm>
              <a:off x="4197048" y="3750419"/>
              <a:ext cx="0" cy="49341"/>
            </a:xfrm>
            <a:custGeom>
              <a:avLst/>
              <a:gdLst/>
              <a:ahLst/>
              <a:cxnLst/>
              <a:rect l="0" t="0" r="0" b="0"/>
              <a:pathLst>
                <a:path h="49341">
                  <a:moveTo>
                    <a:pt x="0" y="0"/>
                  </a:moveTo>
                  <a:lnTo>
                    <a:pt x="0" y="49341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0" name="pg122"/>
            <p:cNvSpPr/>
            <p:nvPr/>
          </p:nvSpPr>
          <p:spPr>
            <a:xfrm>
              <a:off x="4176707" y="3714805"/>
              <a:ext cx="40681" cy="35613"/>
            </a:xfrm>
            <a:custGeom>
              <a:avLst/>
              <a:gdLst/>
              <a:ahLst/>
              <a:cxnLst/>
              <a:rect l="0" t="0" r="0" b="0"/>
              <a:pathLst>
                <a:path w="40681" h="35613">
                  <a:moveTo>
                    <a:pt x="0" y="0"/>
                  </a:moveTo>
                  <a:lnTo>
                    <a:pt x="0" y="35613"/>
                  </a:lnTo>
                  <a:lnTo>
                    <a:pt x="40681" y="35613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1" name="pl123"/>
            <p:cNvSpPr/>
            <p:nvPr/>
          </p:nvSpPr>
          <p:spPr>
            <a:xfrm>
              <a:off x="4176707" y="3739605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2" name="pl124"/>
            <p:cNvSpPr/>
            <p:nvPr/>
          </p:nvSpPr>
          <p:spPr>
            <a:xfrm>
              <a:off x="4414015" y="3724323"/>
              <a:ext cx="0" cy="38929"/>
            </a:xfrm>
            <a:custGeom>
              <a:avLst/>
              <a:gdLst/>
              <a:ahLst/>
              <a:cxnLst/>
              <a:rect l="0" t="0" r="0" b="0"/>
              <a:pathLst>
                <a:path h="38929">
                  <a:moveTo>
                    <a:pt x="0" y="38929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3" name="pl125"/>
            <p:cNvSpPr/>
            <p:nvPr/>
          </p:nvSpPr>
          <p:spPr>
            <a:xfrm>
              <a:off x="4414015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4" name="pg126"/>
            <p:cNvSpPr/>
            <p:nvPr/>
          </p:nvSpPr>
          <p:spPr>
            <a:xfrm>
              <a:off x="4393674" y="3763253"/>
              <a:ext cx="40681" cy="36507"/>
            </a:xfrm>
            <a:custGeom>
              <a:avLst/>
              <a:gdLst/>
              <a:ahLst/>
              <a:cxnLst/>
              <a:rect l="0" t="0" r="0" b="0"/>
              <a:pathLst>
                <a:path w="40681" h="36507">
                  <a:moveTo>
                    <a:pt x="0" y="0"/>
                  </a:moveTo>
                  <a:lnTo>
                    <a:pt x="0" y="36507"/>
                  </a:lnTo>
                  <a:lnTo>
                    <a:pt x="40681" y="36507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5" name="pl127"/>
            <p:cNvSpPr/>
            <p:nvPr/>
          </p:nvSpPr>
          <p:spPr>
            <a:xfrm>
              <a:off x="4393674" y="3764856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6" name="pl128"/>
            <p:cNvSpPr/>
            <p:nvPr/>
          </p:nvSpPr>
          <p:spPr>
            <a:xfrm>
              <a:off x="4468257" y="3776537"/>
              <a:ext cx="0" cy="8736"/>
            </a:xfrm>
            <a:custGeom>
              <a:avLst/>
              <a:gdLst/>
              <a:ahLst/>
              <a:cxnLst/>
              <a:rect l="0" t="0" r="0" b="0"/>
              <a:pathLst>
                <a:path h="8736">
                  <a:moveTo>
                    <a:pt x="0" y="8736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7" name="pl129"/>
            <p:cNvSpPr/>
            <p:nvPr/>
          </p:nvSpPr>
          <p:spPr>
            <a:xfrm>
              <a:off x="4468257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8" name="pg130"/>
            <p:cNvSpPr/>
            <p:nvPr/>
          </p:nvSpPr>
          <p:spPr>
            <a:xfrm>
              <a:off x="4447916" y="3785273"/>
              <a:ext cx="40681" cy="14487"/>
            </a:xfrm>
            <a:custGeom>
              <a:avLst/>
              <a:gdLst/>
              <a:ahLst/>
              <a:cxnLst/>
              <a:rect l="0" t="0" r="0" b="0"/>
              <a:pathLst>
                <a:path w="40681" h="14487">
                  <a:moveTo>
                    <a:pt x="0" y="0"/>
                  </a:moveTo>
                  <a:lnTo>
                    <a:pt x="0" y="14487"/>
                  </a:lnTo>
                  <a:lnTo>
                    <a:pt x="40681" y="14487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9" name="pl131"/>
            <p:cNvSpPr/>
            <p:nvPr/>
          </p:nvSpPr>
          <p:spPr>
            <a:xfrm>
              <a:off x="4447916" y="3785700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0" name="pl132"/>
            <p:cNvSpPr/>
            <p:nvPr/>
          </p:nvSpPr>
          <p:spPr>
            <a:xfrm>
              <a:off x="4685224" y="3540394"/>
              <a:ext cx="0" cy="122918"/>
            </a:xfrm>
            <a:custGeom>
              <a:avLst/>
              <a:gdLst/>
              <a:ahLst/>
              <a:cxnLst/>
              <a:rect l="0" t="0" r="0" b="0"/>
              <a:pathLst>
                <a:path h="122918">
                  <a:moveTo>
                    <a:pt x="0" y="122918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1" name="pl133"/>
            <p:cNvSpPr/>
            <p:nvPr/>
          </p:nvSpPr>
          <p:spPr>
            <a:xfrm>
              <a:off x="4685224" y="3770682"/>
              <a:ext cx="0" cy="29078"/>
            </a:xfrm>
            <a:custGeom>
              <a:avLst/>
              <a:gdLst/>
              <a:ahLst/>
              <a:cxnLst/>
              <a:rect l="0" t="0" r="0" b="0"/>
              <a:pathLst>
                <a:path h="29078">
                  <a:moveTo>
                    <a:pt x="0" y="0"/>
                  </a:moveTo>
                  <a:lnTo>
                    <a:pt x="0" y="29078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2" name="pg134"/>
            <p:cNvSpPr/>
            <p:nvPr/>
          </p:nvSpPr>
          <p:spPr>
            <a:xfrm>
              <a:off x="4664883" y="3663312"/>
              <a:ext cx="40681" cy="107369"/>
            </a:xfrm>
            <a:custGeom>
              <a:avLst/>
              <a:gdLst/>
              <a:ahLst/>
              <a:cxnLst/>
              <a:rect l="0" t="0" r="0" b="0"/>
              <a:pathLst>
                <a:path w="40681" h="107369">
                  <a:moveTo>
                    <a:pt x="0" y="0"/>
                  </a:moveTo>
                  <a:lnTo>
                    <a:pt x="0" y="107369"/>
                  </a:lnTo>
                  <a:lnTo>
                    <a:pt x="40681" y="107369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3" name="pl135"/>
            <p:cNvSpPr/>
            <p:nvPr/>
          </p:nvSpPr>
          <p:spPr>
            <a:xfrm>
              <a:off x="4664883" y="3676883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4" name="pl136"/>
            <p:cNvSpPr/>
            <p:nvPr/>
          </p:nvSpPr>
          <p:spPr>
            <a:xfrm>
              <a:off x="4739466" y="3719913"/>
              <a:ext cx="0" cy="27295"/>
            </a:xfrm>
            <a:custGeom>
              <a:avLst/>
              <a:gdLst/>
              <a:ahLst/>
              <a:cxnLst/>
              <a:rect l="0" t="0" r="0" b="0"/>
              <a:pathLst>
                <a:path h="27295">
                  <a:moveTo>
                    <a:pt x="0" y="27295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5" name="pl137"/>
            <p:cNvSpPr/>
            <p:nvPr/>
          </p:nvSpPr>
          <p:spPr>
            <a:xfrm>
              <a:off x="4739466" y="3787691"/>
              <a:ext cx="0" cy="12069"/>
            </a:xfrm>
            <a:custGeom>
              <a:avLst/>
              <a:gdLst/>
              <a:ahLst/>
              <a:cxnLst/>
              <a:rect l="0" t="0" r="0" b="0"/>
              <a:pathLst>
                <a:path h="12069">
                  <a:moveTo>
                    <a:pt x="0" y="0"/>
                  </a:moveTo>
                  <a:lnTo>
                    <a:pt x="0" y="12069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6" name="pg138"/>
            <p:cNvSpPr/>
            <p:nvPr/>
          </p:nvSpPr>
          <p:spPr>
            <a:xfrm>
              <a:off x="4719125" y="3747209"/>
              <a:ext cx="40681" cy="40482"/>
            </a:xfrm>
            <a:custGeom>
              <a:avLst/>
              <a:gdLst/>
              <a:ahLst/>
              <a:cxnLst/>
              <a:rect l="0" t="0" r="0" b="0"/>
              <a:pathLst>
                <a:path w="40681" h="40482">
                  <a:moveTo>
                    <a:pt x="0" y="0"/>
                  </a:moveTo>
                  <a:lnTo>
                    <a:pt x="0" y="40482"/>
                  </a:lnTo>
                  <a:lnTo>
                    <a:pt x="40681" y="40482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7" name="pl139"/>
            <p:cNvSpPr/>
            <p:nvPr/>
          </p:nvSpPr>
          <p:spPr>
            <a:xfrm>
              <a:off x="4719125" y="3761595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8" name="pl140"/>
            <p:cNvSpPr/>
            <p:nvPr/>
          </p:nvSpPr>
          <p:spPr>
            <a:xfrm>
              <a:off x="4956433" y="2820534"/>
              <a:ext cx="0" cy="214568"/>
            </a:xfrm>
            <a:custGeom>
              <a:avLst/>
              <a:gdLst/>
              <a:ahLst/>
              <a:cxnLst/>
              <a:rect l="0" t="0" r="0" b="0"/>
              <a:pathLst>
                <a:path h="214568">
                  <a:moveTo>
                    <a:pt x="0" y="214568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9" name="pl141"/>
            <p:cNvSpPr/>
            <p:nvPr/>
          </p:nvSpPr>
          <p:spPr>
            <a:xfrm>
              <a:off x="4956433" y="3745432"/>
              <a:ext cx="0" cy="54328"/>
            </a:xfrm>
            <a:custGeom>
              <a:avLst/>
              <a:gdLst/>
              <a:ahLst/>
              <a:cxnLst/>
              <a:rect l="0" t="0" r="0" b="0"/>
              <a:pathLst>
                <a:path h="54328">
                  <a:moveTo>
                    <a:pt x="0" y="0"/>
                  </a:moveTo>
                  <a:lnTo>
                    <a:pt x="0" y="54328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0" name="pg142"/>
            <p:cNvSpPr/>
            <p:nvPr/>
          </p:nvSpPr>
          <p:spPr>
            <a:xfrm>
              <a:off x="4936093" y="3035103"/>
              <a:ext cx="40681" cy="710328"/>
            </a:xfrm>
            <a:custGeom>
              <a:avLst/>
              <a:gdLst/>
              <a:ahLst/>
              <a:cxnLst/>
              <a:rect l="0" t="0" r="0" b="0"/>
              <a:pathLst>
                <a:path w="40681" h="710328">
                  <a:moveTo>
                    <a:pt x="0" y="0"/>
                  </a:moveTo>
                  <a:lnTo>
                    <a:pt x="0" y="710328"/>
                  </a:lnTo>
                  <a:lnTo>
                    <a:pt x="40681" y="710328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1" name="pl143"/>
            <p:cNvSpPr/>
            <p:nvPr/>
          </p:nvSpPr>
          <p:spPr>
            <a:xfrm>
              <a:off x="4936093" y="3127113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2" name="pl144"/>
            <p:cNvSpPr/>
            <p:nvPr/>
          </p:nvSpPr>
          <p:spPr>
            <a:xfrm>
              <a:off x="5010675" y="3286345"/>
              <a:ext cx="0" cy="278010"/>
            </a:xfrm>
            <a:custGeom>
              <a:avLst/>
              <a:gdLst/>
              <a:ahLst/>
              <a:cxnLst/>
              <a:rect l="0" t="0" r="0" b="0"/>
              <a:pathLst>
                <a:path h="278010">
                  <a:moveTo>
                    <a:pt x="0" y="27801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3" name="pl145"/>
            <p:cNvSpPr/>
            <p:nvPr/>
          </p:nvSpPr>
          <p:spPr>
            <a:xfrm>
              <a:off x="5010675" y="3777211"/>
              <a:ext cx="0" cy="22549"/>
            </a:xfrm>
            <a:custGeom>
              <a:avLst/>
              <a:gdLst/>
              <a:ahLst/>
              <a:cxnLst/>
              <a:rect l="0" t="0" r="0" b="0"/>
              <a:pathLst>
                <a:path h="22549">
                  <a:moveTo>
                    <a:pt x="0" y="0"/>
                  </a:moveTo>
                  <a:lnTo>
                    <a:pt x="0" y="22549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4" name="pg146"/>
            <p:cNvSpPr/>
            <p:nvPr/>
          </p:nvSpPr>
          <p:spPr>
            <a:xfrm>
              <a:off x="4990334" y="3564356"/>
              <a:ext cx="40681" cy="212855"/>
            </a:xfrm>
            <a:custGeom>
              <a:avLst/>
              <a:gdLst/>
              <a:ahLst/>
              <a:cxnLst/>
              <a:rect l="0" t="0" r="0" b="0"/>
              <a:pathLst>
                <a:path w="40681" h="212855">
                  <a:moveTo>
                    <a:pt x="0" y="0"/>
                  </a:moveTo>
                  <a:lnTo>
                    <a:pt x="0" y="212855"/>
                  </a:lnTo>
                  <a:lnTo>
                    <a:pt x="40681" y="212855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5" name="pl147"/>
            <p:cNvSpPr/>
            <p:nvPr/>
          </p:nvSpPr>
          <p:spPr>
            <a:xfrm>
              <a:off x="4990334" y="3590837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6" name="pl148"/>
            <p:cNvSpPr/>
            <p:nvPr/>
          </p:nvSpPr>
          <p:spPr>
            <a:xfrm>
              <a:off x="5227642" y="3515150"/>
              <a:ext cx="0" cy="23550"/>
            </a:xfrm>
            <a:custGeom>
              <a:avLst/>
              <a:gdLst/>
              <a:ahLst/>
              <a:cxnLst/>
              <a:rect l="0" t="0" r="0" b="0"/>
              <a:pathLst>
                <a:path h="23550">
                  <a:moveTo>
                    <a:pt x="0" y="2355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7" name="pl149"/>
            <p:cNvSpPr/>
            <p:nvPr/>
          </p:nvSpPr>
          <p:spPr>
            <a:xfrm>
              <a:off x="5227642" y="3763022"/>
              <a:ext cx="0" cy="13869"/>
            </a:xfrm>
            <a:custGeom>
              <a:avLst/>
              <a:gdLst/>
              <a:ahLst/>
              <a:cxnLst/>
              <a:rect l="0" t="0" r="0" b="0"/>
              <a:pathLst>
                <a:path h="13869">
                  <a:moveTo>
                    <a:pt x="0" y="0"/>
                  </a:moveTo>
                  <a:lnTo>
                    <a:pt x="0" y="13869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8" name="pg150"/>
            <p:cNvSpPr/>
            <p:nvPr/>
          </p:nvSpPr>
          <p:spPr>
            <a:xfrm>
              <a:off x="5207302" y="3538701"/>
              <a:ext cx="40681" cy="224321"/>
            </a:xfrm>
            <a:custGeom>
              <a:avLst/>
              <a:gdLst/>
              <a:ahLst/>
              <a:cxnLst/>
              <a:rect l="0" t="0" r="0" b="0"/>
              <a:pathLst>
                <a:path w="40681" h="224321">
                  <a:moveTo>
                    <a:pt x="0" y="0"/>
                  </a:moveTo>
                  <a:lnTo>
                    <a:pt x="0" y="224321"/>
                  </a:lnTo>
                  <a:lnTo>
                    <a:pt x="40681" y="224321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9" name="pl151"/>
            <p:cNvSpPr/>
            <p:nvPr/>
          </p:nvSpPr>
          <p:spPr>
            <a:xfrm>
              <a:off x="5207302" y="3624364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0" name="pl152"/>
            <p:cNvSpPr/>
            <p:nvPr/>
          </p:nvSpPr>
          <p:spPr>
            <a:xfrm>
              <a:off x="5281884" y="3662885"/>
              <a:ext cx="0" cy="18745"/>
            </a:xfrm>
            <a:custGeom>
              <a:avLst/>
              <a:gdLst/>
              <a:ahLst/>
              <a:cxnLst/>
              <a:rect l="0" t="0" r="0" b="0"/>
              <a:pathLst>
                <a:path h="18745">
                  <a:moveTo>
                    <a:pt x="0" y="18745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1" name="pl153"/>
            <p:cNvSpPr/>
            <p:nvPr/>
          </p:nvSpPr>
          <p:spPr>
            <a:xfrm>
              <a:off x="5281884" y="3788350"/>
              <a:ext cx="0" cy="4370"/>
            </a:xfrm>
            <a:custGeom>
              <a:avLst/>
              <a:gdLst/>
              <a:ahLst/>
              <a:cxnLst/>
              <a:rect l="0" t="0" r="0" b="0"/>
              <a:pathLst>
                <a:path h="4370">
                  <a:moveTo>
                    <a:pt x="0" y="0"/>
                  </a:moveTo>
                  <a:lnTo>
                    <a:pt x="0" y="437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2" name="pg154"/>
            <p:cNvSpPr/>
            <p:nvPr/>
          </p:nvSpPr>
          <p:spPr>
            <a:xfrm>
              <a:off x="5261544" y="3681630"/>
              <a:ext cx="40681" cy="106719"/>
            </a:xfrm>
            <a:custGeom>
              <a:avLst/>
              <a:gdLst/>
              <a:ahLst/>
              <a:cxnLst/>
              <a:rect l="0" t="0" r="0" b="0"/>
              <a:pathLst>
                <a:path w="40681" h="106719">
                  <a:moveTo>
                    <a:pt x="0" y="0"/>
                  </a:moveTo>
                  <a:lnTo>
                    <a:pt x="0" y="106719"/>
                  </a:lnTo>
                  <a:lnTo>
                    <a:pt x="40681" y="106719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3" name="pl155"/>
            <p:cNvSpPr/>
            <p:nvPr/>
          </p:nvSpPr>
          <p:spPr>
            <a:xfrm>
              <a:off x="5261544" y="3732208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4" name="pl156"/>
            <p:cNvSpPr/>
            <p:nvPr/>
          </p:nvSpPr>
          <p:spPr>
            <a:xfrm>
              <a:off x="5498852" y="2222072"/>
              <a:ext cx="0" cy="125730"/>
            </a:xfrm>
            <a:custGeom>
              <a:avLst/>
              <a:gdLst/>
              <a:ahLst/>
              <a:cxnLst/>
              <a:rect l="0" t="0" r="0" b="0"/>
              <a:pathLst>
                <a:path h="125730">
                  <a:moveTo>
                    <a:pt x="0" y="12573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5" name="pl157"/>
            <p:cNvSpPr/>
            <p:nvPr/>
          </p:nvSpPr>
          <p:spPr>
            <a:xfrm>
              <a:off x="5498852" y="2594838"/>
              <a:ext cx="0" cy="230436"/>
            </a:xfrm>
            <a:custGeom>
              <a:avLst/>
              <a:gdLst/>
              <a:ahLst/>
              <a:cxnLst/>
              <a:rect l="0" t="0" r="0" b="0"/>
              <a:pathLst>
                <a:path h="230436">
                  <a:moveTo>
                    <a:pt x="0" y="0"/>
                  </a:moveTo>
                  <a:lnTo>
                    <a:pt x="0" y="230436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6" name="pg158"/>
            <p:cNvSpPr/>
            <p:nvPr/>
          </p:nvSpPr>
          <p:spPr>
            <a:xfrm>
              <a:off x="5478511" y="2347803"/>
              <a:ext cx="40681" cy="247035"/>
            </a:xfrm>
            <a:custGeom>
              <a:avLst/>
              <a:gdLst/>
              <a:ahLst/>
              <a:cxnLst/>
              <a:rect l="0" t="0" r="0" b="0"/>
              <a:pathLst>
                <a:path w="40681" h="247035">
                  <a:moveTo>
                    <a:pt x="0" y="0"/>
                  </a:moveTo>
                  <a:lnTo>
                    <a:pt x="0" y="247035"/>
                  </a:lnTo>
                  <a:lnTo>
                    <a:pt x="40681" y="247035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7" name="pl159"/>
            <p:cNvSpPr/>
            <p:nvPr/>
          </p:nvSpPr>
          <p:spPr>
            <a:xfrm>
              <a:off x="5478511" y="2362504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8" name="pl160"/>
            <p:cNvSpPr/>
            <p:nvPr/>
          </p:nvSpPr>
          <p:spPr>
            <a:xfrm>
              <a:off x="5553093" y="3038488"/>
              <a:ext cx="0" cy="164725"/>
            </a:xfrm>
            <a:custGeom>
              <a:avLst/>
              <a:gdLst/>
              <a:ahLst/>
              <a:cxnLst/>
              <a:rect l="0" t="0" r="0" b="0"/>
              <a:pathLst>
                <a:path h="164725">
                  <a:moveTo>
                    <a:pt x="0" y="164725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9" name="pl161"/>
            <p:cNvSpPr/>
            <p:nvPr/>
          </p:nvSpPr>
          <p:spPr>
            <a:xfrm>
              <a:off x="5553093" y="3424447"/>
              <a:ext cx="0" cy="4370"/>
            </a:xfrm>
            <a:custGeom>
              <a:avLst/>
              <a:gdLst/>
              <a:ahLst/>
              <a:cxnLst/>
              <a:rect l="0" t="0" r="0" b="0"/>
              <a:pathLst>
                <a:path h="4370">
                  <a:moveTo>
                    <a:pt x="0" y="0"/>
                  </a:moveTo>
                  <a:lnTo>
                    <a:pt x="0" y="437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0" name="pg162"/>
            <p:cNvSpPr/>
            <p:nvPr/>
          </p:nvSpPr>
          <p:spPr>
            <a:xfrm>
              <a:off x="5532753" y="3203213"/>
              <a:ext cx="40681" cy="221233"/>
            </a:xfrm>
            <a:custGeom>
              <a:avLst/>
              <a:gdLst/>
              <a:ahLst/>
              <a:cxnLst/>
              <a:rect l="0" t="0" r="0" b="0"/>
              <a:pathLst>
                <a:path w="40681" h="221233">
                  <a:moveTo>
                    <a:pt x="0" y="0"/>
                  </a:moveTo>
                  <a:lnTo>
                    <a:pt x="0" y="221233"/>
                  </a:lnTo>
                  <a:lnTo>
                    <a:pt x="40681" y="221233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1" name="pl163"/>
            <p:cNvSpPr/>
            <p:nvPr/>
          </p:nvSpPr>
          <p:spPr>
            <a:xfrm>
              <a:off x="5532753" y="330973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2" name="pl164"/>
            <p:cNvSpPr/>
            <p:nvPr/>
          </p:nvSpPr>
          <p:spPr>
            <a:xfrm>
              <a:off x="5770061" y="3484607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3" name="pl165"/>
            <p:cNvSpPr/>
            <p:nvPr/>
          </p:nvSpPr>
          <p:spPr>
            <a:xfrm>
              <a:off x="5770061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4" name="pg166"/>
            <p:cNvSpPr/>
            <p:nvPr/>
          </p:nvSpPr>
          <p:spPr>
            <a:xfrm>
              <a:off x="5749720" y="3484607"/>
              <a:ext cx="40681" cy="315153"/>
            </a:xfrm>
            <a:custGeom>
              <a:avLst/>
              <a:gdLst/>
              <a:ahLst/>
              <a:cxnLst/>
              <a:rect l="0" t="0" r="0" b="0"/>
              <a:pathLst>
                <a:path w="40681" h="315153">
                  <a:moveTo>
                    <a:pt x="0" y="0"/>
                  </a:moveTo>
                  <a:lnTo>
                    <a:pt x="0" y="315153"/>
                  </a:lnTo>
                  <a:lnTo>
                    <a:pt x="40681" y="315153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5" name="pl167"/>
            <p:cNvSpPr/>
            <p:nvPr/>
          </p:nvSpPr>
          <p:spPr>
            <a:xfrm>
              <a:off x="5749720" y="3799347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6" name="pl168"/>
            <p:cNvSpPr/>
            <p:nvPr/>
          </p:nvSpPr>
          <p:spPr>
            <a:xfrm>
              <a:off x="5824303" y="3702739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7" name="pl169"/>
            <p:cNvSpPr/>
            <p:nvPr/>
          </p:nvSpPr>
          <p:spPr>
            <a:xfrm>
              <a:off x="5824303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8" name="pg170"/>
            <p:cNvSpPr/>
            <p:nvPr/>
          </p:nvSpPr>
          <p:spPr>
            <a:xfrm>
              <a:off x="5803962" y="3702739"/>
              <a:ext cx="40681" cy="97022"/>
            </a:xfrm>
            <a:custGeom>
              <a:avLst/>
              <a:gdLst/>
              <a:ahLst/>
              <a:cxnLst/>
              <a:rect l="0" t="0" r="0" b="0"/>
              <a:pathLst>
                <a:path w="40681" h="97022">
                  <a:moveTo>
                    <a:pt x="0" y="0"/>
                  </a:moveTo>
                  <a:lnTo>
                    <a:pt x="0" y="97022"/>
                  </a:lnTo>
                  <a:lnTo>
                    <a:pt x="40681" y="97022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9" name="pl171"/>
            <p:cNvSpPr/>
            <p:nvPr/>
          </p:nvSpPr>
          <p:spPr>
            <a:xfrm>
              <a:off x="5803962" y="3799632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0" name="pl172"/>
            <p:cNvSpPr/>
            <p:nvPr/>
          </p:nvSpPr>
          <p:spPr>
            <a:xfrm>
              <a:off x="6041270" y="3557108"/>
              <a:ext cx="0" cy="29716"/>
            </a:xfrm>
            <a:custGeom>
              <a:avLst/>
              <a:gdLst/>
              <a:ahLst/>
              <a:cxnLst/>
              <a:rect l="0" t="0" r="0" b="0"/>
              <a:pathLst>
                <a:path h="29716">
                  <a:moveTo>
                    <a:pt x="0" y="29716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1" name="pl173"/>
            <p:cNvSpPr/>
            <p:nvPr/>
          </p:nvSpPr>
          <p:spPr>
            <a:xfrm>
              <a:off x="6041270" y="3762725"/>
              <a:ext cx="0" cy="37036"/>
            </a:xfrm>
            <a:custGeom>
              <a:avLst/>
              <a:gdLst/>
              <a:ahLst/>
              <a:cxnLst/>
              <a:rect l="0" t="0" r="0" b="0"/>
              <a:pathLst>
                <a:path h="37036">
                  <a:moveTo>
                    <a:pt x="0" y="0"/>
                  </a:moveTo>
                  <a:lnTo>
                    <a:pt x="0" y="37036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2" name="pg174"/>
            <p:cNvSpPr/>
            <p:nvPr/>
          </p:nvSpPr>
          <p:spPr>
            <a:xfrm>
              <a:off x="6020929" y="3586824"/>
              <a:ext cx="40681" cy="175900"/>
            </a:xfrm>
            <a:custGeom>
              <a:avLst/>
              <a:gdLst/>
              <a:ahLst/>
              <a:cxnLst/>
              <a:rect l="0" t="0" r="0" b="0"/>
              <a:pathLst>
                <a:path w="40681" h="175900">
                  <a:moveTo>
                    <a:pt x="0" y="0"/>
                  </a:moveTo>
                  <a:lnTo>
                    <a:pt x="0" y="175900"/>
                  </a:lnTo>
                  <a:lnTo>
                    <a:pt x="40681" y="175900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3" name="pl175"/>
            <p:cNvSpPr/>
            <p:nvPr/>
          </p:nvSpPr>
          <p:spPr>
            <a:xfrm>
              <a:off x="6020929" y="371652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4" name="pl176"/>
            <p:cNvSpPr/>
            <p:nvPr/>
          </p:nvSpPr>
          <p:spPr>
            <a:xfrm>
              <a:off x="6095512" y="3699045"/>
              <a:ext cx="0" cy="35161"/>
            </a:xfrm>
            <a:custGeom>
              <a:avLst/>
              <a:gdLst/>
              <a:ahLst/>
              <a:cxnLst/>
              <a:rect l="0" t="0" r="0" b="0"/>
              <a:pathLst>
                <a:path h="35161">
                  <a:moveTo>
                    <a:pt x="0" y="35161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5" name="pl177"/>
            <p:cNvSpPr/>
            <p:nvPr/>
          </p:nvSpPr>
          <p:spPr>
            <a:xfrm>
              <a:off x="6095512" y="3788257"/>
              <a:ext cx="0" cy="11503"/>
            </a:xfrm>
            <a:custGeom>
              <a:avLst/>
              <a:gdLst/>
              <a:ahLst/>
              <a:cxnLst/>
              <a:rect l="0" t="0" r="0" b="0"/>
              <a:pathLst>
                <a:path h="11503">
                  <a:moveTo>
                    <a:pt x="0" y="0"/>
                  </a:moveTo>
                  <a:lnTo>
                    <a:pt x="0" y="11503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6" name="pg178"/>
            <p:cNvSpPr/>
            <p:nvPr/>
          </p:nvSpPr>
          <p:spPr>
            <a:xfrm>
              <a:off x="6075171" y="3734207"/>
              <a:ext cx="40681" cy="54050"/>
            </a:xfrm>
            <a:custGeom>
              <a:avLst/>
              <a:gdLst/>
              <a:ahLst/>
              <a:cxnLst/>
              <a:rect l="0" t="0" r="0" b="0"/>
              <a:pathLst>
                <a:path w="40681" h="54050">
                  <a:moveTo>
                    <a:pt x="0" y="0"/>
                  </a:moveTo>
                  <a:lnTo>
                    <a:pt x="0" y="54050"/>
                  </a:lnTo>
                  <a:lnTo>
                    <a:pt x="40681" y="54050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7" name="pl179"/>
            <p:cNvSpPr/>
            <p:nvPr/>
          </p:nvSpPr>
          <p:spPr>
            <a:xfrm>
              <a:off x="6075171" y="3767702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8" name="pl180"/>
            <p:cNvSpPr/>
            <p:nvPr/>
          </p:nvSpPr>
          <p:spPr>
            <a:xfrm>
              <a:off x="6312479" y="3585427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9" name="pl181"/>
            <p:cNvSpPr/>
            <p:nvPr/>
          </p:nvSpPr>
          <p:spPr>
            <a:xfrm>
              <a:off x="6312479" y="3659971"/>
              <a:ext cx="0" cy="94318"/>
            </a:xfrm>
            <a:custGeom>
              <a:avLst/>
              <a:gdLst/>
              <a:ahLst/>
              <a:cxnLst/>
              <a:rect l="0" t="0" r="0" b="0"/>
              <a:pathLst>
                <a:path h="94318">
                  <a:moveTo>
                    <a:pt x="0" y="0"/>
                  </a:moveTo>
                  <a:lnTo>
                    <a:pt x="0" y="94318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0" name="pg182"/>
            <p:cNvSpPr/>
            <p:nvPr/>
          </p:nvSpPr>
          <p:spPr>
            <a:xfrm>
              <a:off x="6292138" y="3585427"/>
              <a:ext cx="40681" cy="74544"/>
            </a:xfrm>
            <a:custGeom>
              <a:avLst/>
              <a:gdLst/>
              <a:ahLst/>
              <a:cxnLst/>
              <a:rect l="0" t="0" r="0" b="0"/>
              <a:pathLst>
                <a:path w="40681" h="74544">
                  <a:moveTo>
                    <a:pt x="0" y="0"/>
                  </a:moveTo>
                  <a:lnTo>
                    <a:pt x="0" y="74544"/>
                  </a:lnTo>
                  <a:lnTo>
                    <a:pt x="40681" y="74544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1" name="pl183"/>
            <p:cNvSpPr/>
            <p:nvPr/>
          </p:nvSpPr>
          <p:spPr>
            <a:xfrm>
              <a:off x="6292138" y="3596709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2" name="pl184"/>
            <p:cNvSpPr/>
            <p:nvPr/>
          </p:nvSpPr>
          <p:spPr>
            <a:xfrm>
              <a:off x="6366721" y="3733777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3" name="pl185"/>
            <p:cNvSpPr/>
            <p:nvPr/>
          </p:nvSpPr>
          <p:spPr>
            <a:xfrm>
              <a:off x="6366721" y="3741740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4" name="pg186"/>
            <p:cNvSpPr/>
            <p:nvPr/>
          </p:nvSpPr>
          <p:spPr>
            <a:xfrm>
              <a:off x="6346380" y="3733777"/>
              <a:ext cx="40681" cy="7963"/>
            </a:xfrm>
            <a:custGeom>
              <a:avLst/>
              <a:gdLst/>
              <a:ahLst/>
              <a:cxnLst/>
              <a:rect l="0" t="0" r="0" b="0"/>
              <a:pathLst>
                <a:path w="40681" h="7963">
                  <a:moveTo>
                    <a:pt x="0" y="0"/>
                  </a:moveTo>
                  <a:lnTo>
                    <a:pt x="0" y="7963"/>
                  </a:lnTo>
                  <a:lnTo>
                    <a:pt x="40681" y="7963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5" name="pl187"/>
            <p:cNvSpPr/>
            <p:nvPr/>
          </p:nvSpPr>
          <p:spPr>
            <a:xfrm>
              <a:off x="6346380" y="3736693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6" name="pl188"/>
            <p:cNvSpPr/>
            <p:nvPr/>
          </p:nvSpPr>
          <p:spPr>
            <a:xfrm>
              <a:off x="6583688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7" name="pl189"/>
            <p:cNvSpPr/>
            <p:nvPr/>
          </p:nvSpPr>
          <p:spPr>
            <a:xfrm>
              <a:off x="6583688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8" name="pg190"/>
            <p:cNvSpPr/>
            <p:nvPr/>
          </p:nvSpPr>
          <p:spPr>
            <a:xfrm>
              <a:off x="6563348" y="379976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9" name="pl191"/>
            <p:cNvSpPr/>
            <p:nvPr/>
          </p:nvSpPr>
          <p:spPr>
            <a:xfrm>
              <a:off x="6563348" y="379976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10" name="pl192"/>
            <p:cNvSpPr/>
            <p:nvPr/>
          </p:nvSpPr>
          <p:spPr>
            <a:xfrm>
              <a:off x="6637930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11" name="pl193"/>
            <p:cNvSpPr/>
            <p:nvPr/>
          </p:nvSpPr>
          <p:spPr>
            <a:xfrm>
              <a:off x="6637930" y="3799761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12" name="pg194"/>
            <p:cNvSpPr/>
            <p:nvPr/>
          </p:nvSpPr>
          <p:spPr>
            <a:xfrm>
              <a:off x="6617589" y="379976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13" name="pl195"/>
            <p:cNvSpPr/>
            <p:nvPr/>
          </p:nvSpPr>
          <p:spPr>
            <a:xfrm>
              <a:off x="6617589" y="3799761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14" name="pl196"/>
            <p:cNvSpPr/>
            <p:nvPr/>
          </p:nvSpPr>
          <p:spPr>
            <a:xfrm>
              <a:off x="6854898" y="3681715"/>
              <a:ext cx="0" cy="28436"/>
            </a:xfrm>
            <a:custGeom>
              <a:avLst/>
              <a:gdLst/>
              <a:ahLst/>
              <a:cxnLst/>
              <a:rect l="0" t="0" r="0" b="0"/>
              <a:pathLst>
                <a:path h="28436">
                  <a:moveTo>
                    <a:pt x="0" y="28436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15" name="pl197"/>
            <p:cNvSpPr/>
            <p:nvPr/>
          </p:nvSpPr>
          <p:spPr>
            <a:xfrm>
              <a:off x="6854898" y="3757205"/>
              <a:ext cx="0" cy="41211"/>
            </a:xfrm>
            <a:custGeom>
              <a:avLst/>
              <a:gdLst/>
              <a:ahLst/>
              <a:cxnLst/>
              <a:rect l="0" t="0" r="0" b="0"/>
              <a:pathLst>
                <a:path h="41211">
                  <a:moveTo>
                    <a:pt x="0" y="0"/>
                  </a:moveTo>
                  <a:lnTo>
                    <a:pt x="0" y="41211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16" name="pg198"/>
            <p:cNvSpPr/>
            <p:nvPr/>
          </p:nvSpPr>
          <p:spPr>
            <a:xfrm>
              <a:off x="6834557" y="3710151"/>
              <a:ext cx="40681" cy="47054"/>
            </a:xfrm>
            <a:custGeom>
              <a:avLst/>
              <a:gdLst/>
              <a:ahLst/>
              <a:cxnLst/>
              <a:rect l="0" t="0" r="0" b="0"/>
              <a:pathLst>
                <a:path w="40681" h="47054">
                  <a:moveTo>
                    <a:pt x="0" y="0"/>
                  </a:moveTo>
                  <a:lnTo>
                    <a:pt x="0" y="47054"/>
                  </a:lnTo>
                  <a:lnTo>
                    <a:pt x="40681" y="47054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17" name="pl199"/>
            <p:cNvSpPr/>
            <p:nvPr/>
          </p:nvSpPr>
          <p:spPr>
            <a:xfrm>
              <a:off x="6834557" y="3744138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18" name="pl200"/>
            <p:cNvSpPr/>
            <p:nvPr/>
          </p:nvSpPr>
          <p:spPr>
            <a:xfrm>
              <a:off x="6909139" y="3765249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19" name="pl201"/>
            <p:cNvSpPr/>
            <p:nvPr/>
          </p:nvSpPr>
          <p:spPr>
            <a:xfrm>
              <a:off x="6909139" y="3782484"/>
              <a:ext cx="0" cy="16862"/>
            </a:xfrm>
            <a:custGeom>
              <a:avLst/>
              <a:gdLst/>
              <a:ahLst/>
              <a:cxnLst/>
              <a:rect l="0" t="0" r="0" b="0"/>
              <a:pathLst>
                <a:path h="16862">
                  <a:moveTo>
                    <a:pt x="0" y="0"/>
                  </a:moveTo>
                  <a:lnTo>
                    <a:pt x="0" y="16862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20" name="pg202"/>
            <p:cNvSpPr/>
            <p:nvPr/>
          </p:nvSpPr>
          <p:spPr>
            <a:xfrm>
              <a:off x="6888799" y="3765249"/>
              <a:ext cx="40681" cy="17235"/>
            </a:xfrm>
            <a:custGeom>
              <a:avLst/>
              <a:gdLst/>
              <a:ahLst/>
              <a:cxnLst/>
              <a:rect l="0" t="0" r="0" b="0"/>
              <a:pathLst>
                <a:path w="40681" h="17235">
                  <a:moveTo>
                    <a:pt x="0" y="0"/>
                  </a:moveTo>
                  <a:lnTo>
                    <a:pt x="0" y="17235"/>
                  </a:lnTo>
                  <a:lnTo>
                    <a:pt x="40681" y="17235"/>
                  </a:lnTo>
                  <a:lnTo>
                    <a:pt x="40681" y="0"/>
                  </a:lnTo>
                  <a:close/>
                </a:path>
              </a:pathLst>
            </a:cu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21" name="pl203"/>
            <p:cNvSpPr/>
            <p:nvPr/>
          </p:nvSpPr>
          <p:spPr>
            <a:xfrm>
              <a:off x="6888799" y="3782098"/>
              <a:ext cx="40681" cy="0"/>
            </a:xfrm>
            <a:custGeom>
              <a:avLst/>
              <a:gdLst/>
              <a:ahLst/>
              <a:cxnLst/>
              <a:rect l="0" t="0" r="0" b="0"/>
              <a:pathLst>
                <a:path w="40681">
                  <a:moveTo>
                    <a:pt x="0" y="0"/>
                  </a:moveTo>
                  <a:lnTo>
                    <a:pt x="40681" y="0"/>
                  </a:lnTo>
                </a:path>
              </a:pathLst>
            </a:custGeom>
            <a:ln w="1910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22" name="pt204"/>
            <p:cNvSpPr/>
            <p:nvPr/>
          </p:nvSpPr>
          <p:spPr>
            <a:xfrm>
              <a:off x="1955082" y="3757820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23" name="pt205"/>
            <p:cNvSpPr/>
            <p:nvPr/>
          </p:nvSpPr>
          <p:spPr>
            <a:xfrm>
              <a:off x="2226291" y="3716019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24" name="pt206"/>
            <p:cNvSpPr/>
            <p:nvPr/>
          </p:nvSpPr>
          <p:spPr>
            <a:xfrm>
              <a:off x="2497500" y="3610059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25" name="pt207"/>
            <p:cNvSpPr/>
            <p:nvPr/>
          </p:nvSpPr>
          <p:spPr>
            <a:xfrm>
              <a:off x="2768709" y="3633711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26" name="pt208"/>
            <p:cNvSpPr/>
            <p:nvPr/>
          </p:nvSpPr>
          <p:spPr>
            <a:xfrm>
              <a:off x="3039918" y="3227838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27" name="pt209"/>
            <p:cNvSpPr/>
            <p:nvPr/>
          </p:nvSpPr>
          <p:spPr>
            <a:xfrm>
              <a:off x="3311128" y="3675782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28" name="pt210"/>
            <p:cNvSpPr/>
            <p:nvPr/>
          </p:nvSpPr>
          <p:spPr>
            <a:xfrm>
              <a:off x="3582337" y="3513085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29" name="pt211"/>
            <p:cNvSpPr/>
            <p:nvPr/>
          </p:nvSpPr>
          <p:spPr>
            <a:xfrm>
              <a:off x="3853546" y="3691872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30" name="pt212"/>
            <p:cNvSpPr/>
            <p:nvPr/>
          </p:nvSpPr>
          <p:spPr>
            <a:xfrm>
              <a:off x="4124755" y="3620952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31" name="pt213"/>
            <p:cNvSpPr/>
            <p:nvPr/>
          </p:nvSpPr>
          <p:spPr>
            <a:xfrm>
              <a:off x="4395964" y="3752340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32" name="pt214"/>
            <p:cNvSpPr/>
            <p:nvPr/>
          </p:nvSpPr>
          <p:spPr>
            <a:xfrm>
              <a:off x="4667173" y="3672156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33" name="pt215"/>
            <p:cNvSpPr/>
            <p:nvPr/>
          </p:nvSpPr>
          <p:spPr>
            <a:xfrm>
              <a:off x="4938383" y="3287538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34" name="pt216"/>
            <p:cNvSpPr/>
            <p:nvPr/>
          </p:nvSpPr>
          <p:spPr>
            <a:xfrm>
              <a:off x="5209592" y="3625575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35" name="pt217"/>
            <p:cNvSpPr/>
            <p:nvPr/>
          </p:nvSpPr>
          <p:spPr>
            <a:xfrm>
              <a:off x="5480801" y="2452448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36" name="pt218"/>
            <p:cNvSpPr/>
            <p:nvPr/>
          </p:nvSpPr>
          <p:spPr>
            <a:xfrm>
              <a:off x="5752010" y="3511781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37" name="pt219"/>
            <p:cNvSpPr/>
            <p:nvPr/>
          </p:nvSpPr>
          <p:spPr>
            <a:xfrm>
              <a:off x="6023219" y="3666537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38" name="pt220"/>
            <p:cNvSpPr/>
            <p:nvPr/>
          </p:nvSpPr>
          <p:spPr>
            <a:xfrm>
              <a:off x="6294429" y="3549827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39" name="pt221"/>
            <p:cNvSpPr/>
            <p:nvPr/>
          </p:nvSpPr>
          <p:spPr>
            <a:xfrm>
              <a:off x="6565638" y="3781253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40" name="pt222"/>
            <p:cNvSpPr/>
            <p:nvPr/>
          </p:nvSpPr>
          <p:spPr>
            <a:xfrm>
              <a:off x="6836847" y="3720275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41" name="pt223"/>
            <p:cNvSpPr/>
            <p:nvPr/>
          </p:nvSpPr>
          <p:spPr>
            <a:xfrm>
              <a:off x="2009323" y="3771005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42" name="pt224"/>
            <p:cNvSpPr/>
            <p:nvPr/>
          </p:nvSpPr>
          <p:spPr>
            <a:xfrm>
              <a:off x="2280533" y="3756410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43" name="pt225"/>
            <p:cNvSpPr/>
            <p:nvPr/>
          </p:nvSpPr>
          <p:spPr>
            <a:xfrm>
              <a:off x="2551742" y="3706207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44" name="pt226"/>
            <p:cNvSpPr/>
            <p:nvPr/>
          </p:nvSpPr>
          <p:spPr>
            <a:xfrm>
              <a:off x="2822951" y="3724141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45" name="pt227"/>
            <p:cNvSpPr/>
            <p:nvPr/>
          </p:nvSpPr>
          <p:spPr>
            <a:xfrm>
              <a:off x="3094160" y="3572142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46" name="pt228"/>
            <p:cNvSpPr/>
            <p:nvPr/>
          </p:nvSpPr>
          <p:spPr>
            <a:xfrm>
              <a:off x="3365369" y="3736583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47" name="pt229"/>
            <p:cNvSpPr/>
            <p:nvPr/>
          </p:nvSpPr>
          <p:spPr>
            <a:xfrm>
              <a:off x="3636579" y="3680463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48" name="pt230"/>
            <p:cNvSpPr/>
            <p:nvPr/>
          </p:nvSpPr>
          <p:spPr>
            <a:xfrm>
              <a:off x="3907788" y="3754078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49" name="pt231"/>
            <p:cNvSpPr/>
            <p:nvPr/>
          </p:nvSpPr>
          <p:spPr>
            <a:xfrm>
              <a:off x="4178997" y="3721913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50" name="pt232"/>
            <p:cNvSpPr/>
            <p:nvPr/>
          </p:nvSpPr>
          <p:spPr>
            <a:xfrm>
              <a:off x="4450206" y="3771356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51" name="pt233"/>
            <p:cNvSpPr/>
            <p:nvPr/>
          </p:nvSpPr>
          <p:spPr>
            <a:xfrm>
              <a:off x="4721415" y="3745183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52" name="pt234"/>
            <p:cNvSpPr/>
            <p:nvPr/>
          </p:nvSpPr>
          <p:spPr>
            <a:xfrm>
              <a:off x="4992624" y="3585651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53" name="pt235"/>
            <p:cNvSpPr/>
            <p:nvPr/>
          </p:nvSpPr>
          <p:spPr>
            <a:xfrm>
              <a:off x="5263834" y="3713508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54" name="pt236"/>
            <p:cNvSpPr/>
            <p:nvPr/>
          </p:nvSpPr>
          <p:spPr>
            <a:xfrm>
              <a:off x="5535043" y="3262889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55" name="pt237"/>
            <p:cNvSpPr/>
            <p:nvPr/>
          </p:nvSpPr>
          <p:spPr>
            <a:xfrm>
              <a:off x="5806252" y="3682627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56" name="pt238"/>
            <p:cNvSpPr/>
            <p:nvPr/>
          </p:nvSpPr>
          <p:spPr>
            <a:xfrm>
              <a:off x="6077461" y="3739744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57" name="pt239"/>
            <p:cNvSpPr/>
            <p:nvPr/>
          </p:nvSpPr>
          <p:spPr>
            <a:xfrm>
              <a:off x="6348670" y="3696640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58" name="pt240"/>
            <p:cNvSpPr/>
            <p:nvPr/>
          </p:nvSpPr>
          <p:spPr>
            <a:xfrm>
              <a:off x="6619880" y="3781568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59" name="pt241"/>
            <p:cNvSpPr/>
            <p:nvPr/>
          </p:nvSpPr>
          <p:spPr>
            <a:xfrm>
              <a:off x="6891089" y="3755359"/>
              <a:ext cx="36101" cy="36101"/>
            </a:xfrm>
            <a:prstGeom prst="ellipse">
              <a:avLst/>
            </a:prstGeom>
            <a:solidFill>
              <a:srgbClr val="FFFFFF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60" name="tx242"/>
            <p:cNvSpPr/>
            <p:nvPr/>
          </p:nvSpPr>
          <p:spPr>
            <a:xfrm>
              <a:off x="1960181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61" name="tx243"/>
            <p:cNvSpPr/>
            <p:nvPr/>
          </p:nvSpPr>
          <p:spPr>
            <a:xfrm>
              <a:off x="2231390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62" name="tx244"/>
            <p:cNvSpPr/>
            <p:nvPr/>
          </p:nvSpPr>
          <p:spPr>
            <a:xfrm>
              <a:off x="2502599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63" name="tx245"/>
            <p:cNvSpPr/>
            <p:nvPr/>
          </p:nvSpPr>
          <p:spPr>
            <a:xfrm>
              <a:off x="2773808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64" name="tx246"/>
            <p:cNvSpPr/>
            <p:nvPr/>
          </p:nvSpPr>
          <p:spPr>
            <a:xfrm>
              <a:off x="3055559" y="1809316"/>
              <a:ext cx="59061" cy="2312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**</a:t>
              </a:r>
            </a:p>
          </p:txBody>
        </p:sp>
        <p:sp>
          <p:nvSpPr>
            <p:cNvPr id="565" name="tx247"/>
            <p:cNvSpPr/>
            <p:nvPr/>
          </p:nvSpPr>
          <p:spPr>
            <a:xfrm>
              <a:off x="3316227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66" name="tx248"/>
            <p:cNvSpPr/>
            <p:nvPr/>
          </p:nvSpPr>
          <p:spPr>
            <a:xfrm>
              <a:off x="3597977" y="1809316"/>
              <a:ext cx="59061" cy="2312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**</a:t>
              </a:r>
            </a:p>
          </p:txBody>
        </p:sp>
        <p:sp>
          <p:nvSpPr>
            <p:cNvPr id="568" name="tx250"/>
            <p:cNvSpPr/>
            <p:nvPr/>
          </p:nvSpPr>
          <p:spPr>
            <a:xfrm>
              <a:off x="4129854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69" name="tx251"/>
            <p:cNvSpPr/>
            <p:nvPr/>
          </p:nvSpPr>
          <p:spPr>
            <a:xfrm>
              <a:off x="4401064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70" name="tx252"/>
            <p:cNvSpPr/>
            <p:nvPr/>
          </p:nvSpPr>
          <p:spPr>
            <a:xfrm>
              <a:off x="4672273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71" name="tx253"/>
            <p:cNvSpPr/>
            <p:nvPr/>
          </p:nvSpPr>
          <p:spPr>
            <a:xfrm>
              <a:off x="4943482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72" name="tx254"/>
            <p:cNvSpPr/>
            <p:nvPr/>
          </p:nvSpPr>
          <p:spPr>
            <a:xfrm>
              <a:off x="5214691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73" name="tx255"/>
            <p:cNvSpPr/>
            <p:nvPr/>
          </p:nvSpPr>
          <p:spPr>
            <a:xfrm>
              <a:off x="5496442" y="1809316"/>
              <a:ext cx="59061" cy="2312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**</a:t>
              </a:r>
            </a:p>
          </p:txBody>
        </p:sp>
        <p:sp>
          <p:nvSpPr>
            <p:cNvPr id="574" name="tx256"/>
            <p:cNvSpPr/>
            <p:nvPr/>
          </p:nvSpPr>
          <p:spPr>
            <a:xfrm>
              <a:off x="5757109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75" name="tx257"/>
            <p:cNvSpPr/>
            <p:nvPr/>
          </p:nvSpPr>
          <p:spPr>
            <a:xfrm>
              <a:off x="6028319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76" name="tx258"/>
            <p:cNvSpPr/>
            <p:nvPr/>
          </p:nvSpPr>
          <p:spPr>
            <a:xfrm>
              <a:off x="6299528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77" name="tx259"/>
            <p:cNvSpPr/>
            <p:nvPr/>
          </p:nvSpPr>
          <p:spPr>
            <a:xfrm>
              <a:off x="6570737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78" name="tx260"/>
            <p:cNvSpPr/>
            <p:nvPr/>
          </p:nvSpPr>
          <p:spPr>
            <a:xfrm>
              <a:off x="6841946" y="1764149"/>
              <a:ext cx="80144" cy="4112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97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9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s</a:t>
              </a:r>
            </a:p>
          </p:txBody>
        </p:sp>
        <p:sp>
          <p:nvSpPr>
            <p:cNvPr id="579" name="rc261"/>
            <p:cNvSpPr/>
            <p:nvPr/>
          </p:nvSpPr>
          <p:spPr>
            <a:xfrm>
              <a:off x="1837528" y="1662403"/>
              <a:ext cx="5207216" cy="3143249"/>
            </a:xfrm>
            <a:prstGeom prst="rect">
              <a:avLst/>
            </a:prstGeom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0" name="pl262"/>
            <p:cNvSpPr/>
            <p:nvPr/>
          </p:nvSpPr>
          <p:spPr>
            <a:xfrm>
              <a:off x="1837528" y="4805652"/>
              <a:ext cx="5207216" cy="0"/>
            </a:xfrm>
            <a:custGeom>
              <a:avLst/>
              <a:gdLst/>
              <a:ahLst/>
              <a:cxnLst/>
              <a:rect l="0" t="0" r="0" b="0"/>
              <a:pathLst>
                <a:path w="5207216">
                  <a:moveTo>
                    <a:pt x="0" y="0"/>
                  </a:moveTo>
                  <a:lnTo>
                    <a:pt x="5207216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1" name="pl263"/>
            <p:cNvSpPr/>
            <p:nvPr/>
          </p:nvSpPr>
          <p:spPr>
            <a:xfrm>
              <a:off x="2000253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2" name="pl264"/>
            <p:cNvSpPr/>
            <p:nvPr/>
          </p:nvSpPr>
          <p:spPr>
            <a:xfrm>
              <a:off x="2271462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3" name="pl265"/>
            <p:cNvSpPr/>
            <p:nvPr/>
          </p:nvSpPr>
          <p:spPr>
            <a:xfrm>
              <a:off x="2542672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4" name="pl266"/>
            <p:cNvSpPr/>
            <p:nvPr/>
          </p:nvSpPr>
          <p:spPr>
            <a:xfrm>
              <a:off x="2813881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5" name="pl267"/>
            <p:cNvSpPr/>
            <p:nvPr/>
          </p:nvSpPr>
          <p:spPr>
            <a:xfrm>
              <a:off x="3085090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6" name="pl268"/>
            <p:cNvSpPr/>
            <p:nvPr/>
          </p:nvSpPr>
          <p:spPr>
            <a:xfrm>
              <a:off x="3356299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7" name="pl269"/>
            <p:cNvSpPr/>
            <p:nvPr/>
          </p:nvSpPr>
          <p:spPr>
            <a:xfrm>
              <a:off x="3627508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8" name="pl270"/>
            <p:cNvSpPr/>
            <p:nvPr/>
          </p:nvSpPr>
          <p:spPr>
            <a:xfrm>
              <a:off x="3898717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9" name="pl271"/>
            <p:cNvSpPr/>
            <p:nvPr/>
          </p:nvSpPr>
          <p:spPr>
            <a:xfrm>
              <a:off x="4169927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0" name="pl272"/>
            <p:cNvSpPr/>
            <p:nvPr/>
          </p:nvSpPr>
          <p:spPr>
            <a:xfrm>
              <a:off x="4441136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1" name="pl273"/>
            <p:cNvSpPr/>
            <p:nvPr/>
          </p:nvSpPr>
          <p:spPr>
            <a:xfrm>
              <a:off x="4712345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2" name="pl274"/>
            <p:cNvSpPr/>
            <p:nvPr/>
          </p:nvSpPr>
          <p:spPr>
            <a:xfrm>
              <a:off x="4983554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3" name="pl275"/>
            <p:cNvSpPr/>
            <p:nvPr/>
          </p:nvSpPr>
          <p:spPr>
            <a:xfrm>
              <a:off x="5254763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4" name="pl276"/>
            <p:cNvSpPr/>
            <p:nvPr/>
          </p:nvSpPr>
          <p:spPr>
            <a:xfrm>
              <a:off x="5525973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5" name="pl277"/>
            <p:cNvSpPr/>
            <p:nvPr/>
          </p:nvSpPr>
          <p:spPr>
            <a:xfrm>
              <a:off x="5797182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6" name="pl278"/>
            <p:cNvSpPr/>
            <p:nvPr/>
          </p:nvSpPr>
          <p:spPr>
            <a:xfrm>
              <a:off x="6068391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7" name="pl279"/>
            <p:cNvSpPr/>
            <p:nvPr/>
          </p:nvSpPr>
          <p:spPr>
            <a:xfrm>
              <a:off x="6339600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8" name="pl280"/>
            <p:cNvSpPr/>
            <p:nvPr/>
          </p:nvSpPr>
          <p:spPr>
            <a:xfrm>
              <a:off x="6610809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9" name="pl281"/>
            <p:cNvSpPr/>
            <p:nvPr/>
          </p:nvSpPr>
          <p:spPr>
            <a:xfrm>
              <a:off x="6882018" y="480565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9553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00" name="tx282"/>
            <p:cNvSpPr/>
            <p:nvPr/>
          </p:nvSpPr>
          <p:spPr>
            <a:xfrm rot="-900000">
              <a:off x="1619953" y="4917122"/>
              <a:ext cx="393910" cy="5577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 cell naïve</a:t>
              </a:r>
            </a:p>
          </p:txBody>
        </p:sp>
        <p:sp>
          <p:nvSpPr>
            <p:cNvPr id="601" name="tx283"/>
            <p:cNvSpPr/>
            <p:nvPr/>
          </p:nvSpPr>
          <p:spPr>
            <a:xfrm rot="-900000">
              <a:off x="1801983" y="4914054"/>
              <a:ext cx="482686" cy="7058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 cell memory</a:t>
              </a:r>
            </a:p>
          </p:txBody>
        </p:sp>
        <p:sp>
          <p:nvSpPr>
            <p:cNvPr id="602" name="tx284"/>
            <p:cNvSpPr/>
            <p:nvPr/>
          </p:nvSpPr>
          <p:spPr>
            <a:xfrm rot="-900000">
              <a:off x="2102346" y="4911109"/>
              <a:ext cx="453144" cy="6968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 cell plasma</a:t>
              </a:r>
            </a:p>
          </p:txBody>
        </p:sp>
        <p:sp>
          <p:nvSpPr>
            <p:cNvPr id="603" name="tx285"/>
            <p:cNvSpPr/>
            <p:nvPr/>
          </p:nvSpPr>
          <p:spPr>
            <a:xfrm rot="20700000">
              <a:off x="2427355" y="4917309"/>
              <a:ext cx="400161" cy="564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 cell CD8+</a:t>
              </a:r>
            </a:p>
          </p:txBody>
        </p:sp>
        <p:sp>
          <p:nvSpPr>
            <p:cNvPr id="604" name="tx286"/>
            <p:cNvSpPr/>
            <p:nvPr/>
          </p:nvSpPr>
          <p:spPr>
            <a:xfrm rot="-900000">
              <a:off x="2159679" y="4973148"/>
              <a:ext cx="946398" cy="715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 cell CD4+ memory resting</a:t>
              </a:r>
            </a:p>
          </p:txBody>
        </p:sp>
        <p:sp>
          <p:nvSpPr>
            <p:cNvPr id="605" name="tx287"/>
            <p:cNvSpPr/>
            <p:nvPr/>
          </p:nvSpPr>
          <p:spPr>
            <a:xfrm rot="-900000">
              <a:off x="2355913" y="4983019"/>
              <a:ext cx="1022672" cy="715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 cell CD4+ memory activated</a:t>
              </a:r>
            </a:p>
          </p:txBody>
        </p:sp>
        <p:sp>
          <p:nvSpPr>
            <p:cNvPr id="606" name="tx288"/>
            <p:cNvSpPr/>
            <p:nvPr/>
          </p:nvSpPr>
          <p:spPr>
            <a:xfrm rot="-900000">
              <a:off x="2928966" y="4944173"/>
              <a:ext cx="715714" cy="706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 cell follicular helper</a:t>
              </a:r>
            </a:p>
          </p:txBody>
        </p:sp>
        <p:sp>
          <p:nvSpPr>
            <p:cNvPr id="607" name="tx289"/>
            <p:cNvSpPr/>
            <p:nvPr/>
          </p:nvSpPr>
          <p:spPr>
            <a:xfrm rot="-900000">
              <a:off x="3108590" y="4955338"/>
              <a:ext cx="808769" cy="715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 cell regulatory (</a:t>
              </a:r>
              <a:r>
                <a:rPr sz="600" dirty="0" err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regs</a:t>
              </a:r>
              <a:r>
                <a:rPr sz="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608" name="tx290"/>
            <p:cNvSpPr/>
            <p:nvPr/>
          </p:nvSpPr>
          <p:spPr>
            <a:xfrm rot="20700000">
              <a:off x="3692035" y="4915161"/>
              <a:ext cx="491244" cy="7058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K cell resting</a:t>
              </a:r>
            </a:p>
          </p:txBody>
        </p:sp>
        <p:sp>
          <p:nvSpPr>
            <p:cNvPr id="609" name="tx291"/>
            <p:cNvSpPr/>
            <p:nvPr/>
          </p:nvSpPr>
          <p:spPr>
            <a:xfrm rot="-900000">
              <a:off x="3890229" y="4939917"/>
              <a:ext cx="567518" cy="5543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K cell activated</a:t>
              </a:r>
            </a:p>
          </p:txBody>
        </p:sp>
        <p:sp>
          <p:nvSpPr>
            <p:cNvPr id="610" name="tx292"/>
            <p:cNvSpPr/>
            <p:nvPr/>
          </p:nvSpPr>
          <p:spPr>
            <a:xfrm rot="20700000">
              <a:off x="4392596" y="4894342"/>
              <a:ext cx="330361" cy="7058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onocyte</a:t>
              </a:r>
            </a:p>
          </p:txBody>
        </p:sp>
        <p:sp>
          <p:nvSpPr>
            <p:cNvPr id="611" name="tx293"/>
            <p:cNvSpPr/>
            <p:nvPr/>
          </p:nvSpPr>
          <p:spPr>
            <a:xfrm rot="-900000">
              <a:off x="4447263" y="4922627"/>
              <a:ext cx="550626" cy="708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acrophage M0</a:t>
              </a:r>
            </a:p>
          </p:txBody>
        </p:sp>
        <p:sp>
          <p:nvSpPr>
            <p:cNvPr id="612" name="tx294"/>
            <p:cNvSpPr/>
            <p:nvPr/>
          </p:nvSpPr>
          <p:spPr>
            <a:xfrm rot="-900000">
              <a:off x="4718472" y="4922627"/>
              <a:ext cx="550626" cy="708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acrophage M1</a:t>
              </a:r>
            </a:p>
          </p:txBody>
        </p:sp>
        <p:sp>
          <p:nvSpPr>
            <p:cNvPr id="613" name="tx295"/>
            <p:cNvSpPr/>
            <p:nvPr/>
          </p:nvSpPr>
          <p:spPr>
            <a:xfrm rot="20700000">
              <a:off x="4989681" y="4922627"/>
              <a:ext cx="550626" cy="708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acrophage M2</a:t>
              </a:r>
            </a:p>
          </p:txBody>
        </p:sp>
        <p:sp>
          <p:nvSpPr>
            <p:cNvPr id="614" name="tx296"/>
            <p:cNvSpPr/>
            <p:nvPr/>
          </p:nvSpPr>
          <p:spPr>
            <a:xfrm rot="-900000">
              <a:off x="4861321" y="4975454"/>
              <a:ext cx="957150" cy="7058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yeloid dendritic cell resting</a:t>
              </a:r>
            </a:p>
          </p:txBody>
        </p:sp>
        <p:sp>
          <p:nvSpPr>
            <p:cNvPr id="615" name="tx297"/>
            <p:cNvSpPr/>
            <p:nvPr/>
          </p:nvSpPr>
          <p:spPr>
            <a:xfrm rot="-900000">
              <a:off x="5057556" y="4985325"/>
              <a:ext cx="1033425" cy="7058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yeloid dendritic cell activated</a:t>
              </a:r>
            </a:p>
          </p:txBody>
        </p:sp>
        <p:sp>
          <p:nvSpPr>
            <p:cNvPr id="616" name="tx298"/>
            <p:cNvSpPr/>
            <p:nvPr/>
          </p:nvSpPr>
          <p:spPr>
            <a:xfrm rot="20700000">
              <a:off x="5730432" y="4947588"/>
              <a:ext cx="626789" cy="5543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ast cell activated</a:t>
              </a:r>
            </a:p>
          </p:txBody>
        </p:sp>
        <p:sp>
          <p:nvSpPr>
            <p:cNvPr id="617" name="tx299"/>
            <p:cNvSpPr/>
            <p:nvPr/>
          </p:nvSpPr>
          <p:spPr>
            <a:xfrm rot="20700000">
              <a:off x="6270292" y="4897969"/>
              <a:ext cx="351606" cy="6968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osinophil</a:t>
              </a:r>
            </a:p>
          </p:txBody>
        </p:sp>
        <p:sp>
          <p:nvSpPr>
            <p:cNvPr id="618" name="tx300"/>
            <p:cNvSpPr/>
            <p:nvPr/>
          </p:nvSpPr>
          <p:spPr>
            <a:xfrm rot="-900000">
              <a:off x="6545707" y="4897415"/>
              <a:ext cx="347327" cy="6968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eutrophil</a:t>
              </a:r>
            </a:p>
          </p:txBody>
        </p:sp>
        <p:sp>
          <p:nvSpPr>
            <p:cNvPr id="619" name="rc301"/>
            <p:cNvSpPr/>
            <p:nvPr/>
          </p:nvSpPr>
          <p:spPr>
            <a:xfrm>
              <a:off x="7075922" y="3005765"/>
              <a:ext cx="89999" cy="90000"/>
            </a:xfrm>
            <a:prstGeom prst="rect">
              <a:avLst/>
            </a:prstGeom>
          </p:spPr>
          <p:txBody>
            <a:bodyPr/>
            <a:lstStyle/>
            <a:p>
              <a:endParaRPr/>
            </a:p>
          </p:txBody>
        </p:sp>
        <p:sp>
          <p:nvSpPr>
            <p:cNvPr id="620" name="pl302"/>
            <p:cNvSpPr/>
            <p:nvPr/>
          </p:nvSpPr>
          <p:spPr>
            <a:xfrm>
              <a:off x="7120922" y="3073265"/>
              <a:ext cx="0" cy="13500"/>
            </a:xfrm>
            <a:custGeom>
              <a:avLst/>
              <a:gdLst/>
              <a:ahLst/>
              <a:cxnLst/>
              <a:rect l="0" t="0" r="0" b="0"/>
              <a:pathLst>
                <a:path h="13500">
                  <a:moveTo>
                    <a:pt x="0" y="13500"/>
                  </a:moveTo>
                  <a:lnTo>
                    <a:pt x="0" y="0"/>
                  </a:lnTo>
                </a:path>
              </a:pathLst>
            </a:custGeom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1" name="pl303"/>
            <p:cNvSpPr/>
            <p:nvPr/>
          </p:nvSpPr>
          <p:spPr>
            <a:xfrm>
              <a:off x="7120922" y="3014765"/>
              <a:ext cx="0" cy="13499"/>
            </a:xfrm>
            <a:custGeom>
              <a:avLst/>
              <a:gdLst/>
              <a:ahLst/>
              <a:cxnLst/>
              <a:rect l="0" t="0" r="0" b="0"/>
              <a:pathLst>
                <a:path h="13499">
                  <a:moveTo>
                    <a:pt x="0" y="13499"/>
                  </a:moveTo>
                  <a:lnTo>
                    <a:pt x="0" y="0"/>
                  </a:lnTo>
                </a:path>
              </a:pathLst>
            </a:custGeom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2" name="rc304"/>
            <p:cNvSpPr/>
            <p:nvPr/>
          </p:nvSpPr>
          <p:spPr>
            <a:xfrm>
              <a:off x="7087172" y="3028265"/>
              <a:ext cx="67500" cy="44999"/>
            </a:xfrm>
            <a:prstGeom prst="rect">
              <a:avLst/>
            </a:prstGeom>
            <a:solidFill>
              <a:srgbClr val="4DBBD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3" name="pl305"/>
            <p:cNvSpPr/>
            <p:nvPr/>
          </p:nvSpPr>
          <p:spPr>
            <a:xfrm>
              <a:off x="7087172" y="3050765"/>
              <a:ext cx="67499" cy="0"/>
            </a:xfrm>
            <a:custGeom>
              <a:avLst/>
              <a:gdLst/>
              <a:ahLst/>
              <a:cxnLst/>
              <a:rect l="0" t="0" r="0" b="0"/>
              <a:pathLst>
                <a:path w="67499">
                  <a:moveTo>
                    <a:pt x="0" y="0"/>
                  </a:moveTo>
                  <a:lnTo>
                    <a:pt x="67499" y="0"/>
                  </a:lnTo>
                </a:path>
              </a:pathLst>
            </a:custGeom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4" name="rc306"/>
            <p:cNvSpPr/>
            <p:nvPr/>
          </p:nvSpPr>
          <p:spPr>
            <a:xfrm>
              <a:off x="7075922" y="3095765"/>
              <a:ext cx="89999" cy="89999"/>
            </a:xfrm>
            <a:prstGeom prst="rect">
              <a:avLst/>
            </a:prstGeom>
          </p:spPr>
          <p:txBody>
            <a:bodyPr/>
            <a:lstStyle/>
            <a:p>
              <a:endParaRPr/>
            </a:p>
          </p:txBody>
        </p:sp>
        <p:sp>
          <p:nvSpPr>
            <p:cNvPr id="625" name="pl307"/>
            <p:cNvSpPr/>
            <p:nvPr/>
          </p:nvSpPr>
          <p:spPr>
            <a:xfrm>
              <a:off x="7120922" y="3163265"/>
              <a:ext cx="0" cy="13500"/>
            </a:xfrm>
            <a:custGeom>
              <a:avLst/>
              <a:gdLst/>
              <a:ahLst/>
              <a:cxnLst/>
              <a:rect l="0" t="0" r="0" b="0"/>
              <a:pathLst>
                <a:path h="13500">
                  <a:moveTo>
                    <a:pt x="0" y="13500"/>
                  </a:moveTo>
                  <a:lnTo>
                    <a:pt x="0" y="0"/>
                  </a:lnTo>
                </a:path>
              </a:pathLst>
            </a:custGeom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6" name="pl308"/>
            <p:cNvSpPr/>
            <p:nvPr/>
          </p:nvSpPr>
          <p:spPr>
            <a:xfrm>
              <a:off x="7120922" y="3104765"/>
              <a:ext cx="0" cy="13499"/>
            </a:xfrm>
            <a:custGeom>
              <a:avLst/>
              <a:gdLst/>
              <a:ahLst/>
              <a:cxnLst/>
              <a:rect l="0" t="0" r="0" b="0"/>
              <a:pathLst>
                <a:path h="13499">
                  <a:moveTo>
                    <a:pt x="0" y="13499"/>
                  </a:moveTo>
                  <a:lnTo>
                    <a:pt x="0" y="0"/>
                  </a:lnTo>
                </a:path>
              </a:pathLst>
            </a:custGeom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7" name="rc309"/>
            <p:cNvSpPr/>
            <p:nvPr/>
          </p:nvSpPr>
          <p:spPr>
            <a:xfrm>
              <a:off x="7087172" y="3118265"/>
              <a:ext cx="67500" cy="44999"/>
            </a:xfrm>
            <a:prstGeom prst="rect">
              <a:avLst/>
            </a:prstGeom>
            <a:solidFill>
              <a:srgbClr val="E64B35">
                <a:alpha val="100000"/>
              </a:srgbClr>
            </a:solidFill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8" name="pl310"/>
            <p:cNvSpPr/>
            <p:nvPr/>
          </p:nvSpPr>
          <p:spPr>
            <a:xfrm>
              <a:off x="7087172" y="3140765"/>
              <a:ext cx="67499" cy="0"/>
            </a:xfrm>
            <a:custGeom>
              <a:avLst/>
              <a:gdLst/>
              <a:ahLst/>
              <a:cxnLst/>
              <a:rect l="0" t="0" r="0" b="0"/>
              <a:pathLst>
                <a:path w="67499">
                  <a:moveTo>
                    <a:pt x="0" y="0"/>
                  </a:moveTo>
                  <a:lnTo>
                    <a:pt x="67499" y="0"/>
                  </a:lnTo>
                </a:path>
              </a:pathLst>
            </a:custGeom>
            <a:ln w="9553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9" name="tx311"/>
            <p:cNvSpPr/>
            <p:nvPr/>
          </p:nvSpPr>
          <p:spPr>
            <a:xfrm>
              <a:off x="7201922" y="3026487"/>
              <a:ext cx="257596" cy="470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ibersort</a:t>
              </a:r>
            </a:p>
          </p:txBody>
        </p:sp>
        <p:sp>
          <p:nvSpPr>
            <p:cNvPr id="630" name="tx312"/>
            <p:cNvSpPr/>
            <p:nvPr/>
          </p:nvSpPr>
          <p:spPr>
            <a:xfrm>
              <a:off x="7201922" y="3116487"/>
              <a:ext cx="405804" cy="4700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5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500" dirty="0" err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ibersort</a:t>
              </a:r>
              <a:r>
                <a:rPr sz="5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ABS</a:t>
              </a:r>
            </a:p>
          </p:txBody>
        </p:sp>
      </p:grpSp>
      <p:sp>
        <p:nvSpPr>
          <p:cNvPr id="317" name="文本框 316"/>
          <p:cNvSpPr txBox="1"/>
          <p:nvPr/>
        </p:nvSpPr>
        <p:spPr>
          <a:xfrm>
            <a:off x="6610253" y="5896734"/>
            <a:ext cx="57150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. 1 The infiltrating features and proportion </a:t>
            </a:r>
            <a:r>
              <a:rPr lang="en-US" altLang="zh-CN" b="1" dirty="0" smtClean="0"/>
              <a:t>of</a:t>
            </a:r>
          </a:p>
          <a:p>
            <a:r>
              <a:rPr lang="en-US" altLang="zh-CN" b="1" dirty="0" smtClean="0"/>
              <a:t> </a:t>
            </a:r>
            <a:r>
              <a:rPr lang="en-US" altLang="zh-CN" b="1" dirty="0"/>
              <a:t>each lymphocyte in CRC TCGA tissue samples. 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40564746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C:\Users\ACER\Desktop\infitration CRC\estimation_plot2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6434" y="718343"/>
            <a:ext cx="5274310" cy="405701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图片 3" descr="C:\Users\ACER\Desktop\infitration CRC\estimation_plot1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282" y="718343"/>
            <a:ext cx="6602152" cy="4992861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文本框 7"/>
          <p:cNvSpPr txBox="1"/>
          <p:nvPr/>
        </p:nvSpPr>
        <p:spPr>
          <a:xfrm>
            <a:off x="249382" y="277091"/>
            <a:ext cx="6927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784127" y="281715"/>
            <a:ext cx="6927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49382" y="6064255"/>
            <a:ext cx="10453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. 1 The infiltrating features and proportion of each lymphocyte in CRC TCGA tissue samples. 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38427000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3094" y="262526"/>
            <a:ext cx="3589468" cy="2873809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904" y="262526"/>
            <a:ext cx="3589467" cy="2873809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904" y="3394144"/>
            <a:ext cx="3414184" cy="2733473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82031" y="3394143"/>
            <a:ext cx="3301629" cy="2643358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1569971" y="191868"/>
            <a:ext cx="464583" cy="45725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600" b="1" kern="120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sz="120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349917" y="203361"/>
            <a:ext cx="464583" cy="45725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600" b="1" kern="1200" dirty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507037" y="3299215"/>
            <a:ext cx="464042" cy="45725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600" b="1" kern="120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endParaRPr lang="zh-CN" sz="120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283050" y="3340016"/>
            <a:ext cx="464042" cy="45725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600" b="1" kern="120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D</a:t>
            </a:r>
            <a:endParaRPr lang="zh-CN" sz="120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1507037" y="6266482"/>
            <a:ext cx="9583073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altLang="zh-CN" b="1" dirty="0"/>
              <a:t>Figure 2  The infiltration level of major-lineage immune cells in CRC GSE </a:t>
            </a:r>
            <a:r>
              <a:rPr lang="en-US" altLang="zh-CN" b="1" dirty="0" err="1"/>
              <a:t>sc-seq</a:t>
            </a:r>
            <a:r>
              <a:rPr lang="en-US" altLang="zh-CN" b="1" dirty="0"/>
              <a:t> samples. </a:t>
            </a:r>
          </a:p>
        </p:txBody>
      </p:sp>
    </p:spTree>
    <p:extLst>
      <p:ext uri="{BB962C8B-B14F-4D97-AF65-F5344CB8AC3E}">
        <p14:creationId xmlns:p14="http://schemas.microsoft.com/office/powerpoint/2010/main" val="18499312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文本框 59"/>
          <p:cNvSpPr txBox="1"/>
          <p:nvPr/>
        </p:nvSpPr>
        <p:spPr>
          <a:xfrm>
            <a:off x="1496889" y="11361"/>
            <a:ext cx="655612" cy="6002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kern="1200" dirty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26" name="文本框 60"/>
          <p:cNvSpPr txBox="1"/>
          <p:nvPr/>
        </p:nvSpPr>
        <p:spPr>
          <a:xfrm>
            <a:off x="2810168" y="107529"/>
            <a:ext cx="1539489" cy="498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COAD-APC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27" name="文本框 61"/>
          <p:cNvSpPr txBox="1"/>
          <p:nvPr/>
        </p:nvSpPr>
        <p:spPr>
          <a:xfrm>
            <a:off x="7434571" y="94092"/>
            <a:ext cx="1539489" cy="498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COAD-TP53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28" name="文本框 62"/>
          <p:cNvSpPr txBox="1"/>
          <p:nvPr/>
        </p:nvSpPr>
        <p:spPr>
          <a:xfrm>
            <a:off x="2810169" y="2121624"/>
            <a:ext cx="1539489" cy="498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COAD-TTN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30" name="文本框 64"/>
          <p:cNvSpPr txBox="1"/>
          <p:nvPr/>
        </p:nvSpPr>
        <p:spPr>
          <a:xfrm>
            <a:off x="3159065" y="2519192"/>
            <a:ext cx="1539489" cy="498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READ-APC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33" name="文本框 67"/>
          <p:cNvSpPr txBox="1"/>
          <p:nvPr/>
        </p:nvSpPr>
        <p:spPr>
          <a:xfrm>
            <a:off x="7555397" y="2192233"/>
            <a:ext cx="1539489" cy="498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kern="1200" dirty="0" smtClean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READ-APC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34" name="文本框 68"/>
          <p:cNvSpPr txBox="1"/>
          <p:nvPr/>
        </p:nvSpPr>
        <p:spPr>
          <a:xfrm>
            <a:off x="2811110" y="4307225"/>
            <a:ext cx="1538547" cy="498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kern="1200" dirty="0" smtClean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READ-TP53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37" name="文本框 71"/>
          <p:cNvSpPr txBox="1"/>
          <p:nvPr/>
        </p:nvSpPr>
        <p:spPr>
          <a:xfrm>
            <a:off x="7643319" y="4288628"/>
            <a:ext cx="1539489" cy="498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kern="1200" dirty="0" smtClean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READ-KRAS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6374" y="310638"/>
            <a:ext cx="4279820" cy="1860791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5233" y="310638"/>
            <a:ext cx="4279819" cy="1860791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6889" y="2367457"/>
            <a:ext cx="4461466" cy="1939768"/>
          </a:xfrm>
          <a:prstGeom prst="rect">
            <a:avLst/>
          </a:prstGeom>
        </p:spPr>
      </p:pic>
      <p:sp>
        <p:nvSpPr>
          <p:cNvPr id="45" name="文本框 59"/>
          <p:cNvSpPr txBox="1"/>
          <p:nvPr/>
        </p:nvSpPr>
        <p:spPr>
          <a:xfrm>
            <a:off x="6138347" y="10533"/>
            <a:ext cx="655612" cy="6002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kern="1200" dirty="0" smtClean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46" name="文本框 59"/>
          <p:cNvSpPr txBox="1"/>
          <p:nvPr/>
        </p:nvSpPr>
        <p:spPr>
          <a:xfrm>
            <a:off x="1508616" y="2090183"/>
            <a:ext cx="655612" cy="6002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altLang="zh-CN" sz="1400" b="1" dirty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47" name="文本框 59"/>
          <p:cNvSpPr txBox="1"/>
          <p:nvPr/>
        </p:nvSpPr>
        <p:spPr>
          <a:xfrm>
            <a:off x="6142152" y="2171429"/>
            <a:ext cx="655612" cy="6002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altLang="zh-CN" sz="1400" b="1" dirty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D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48" name="图片 4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5233" y="2519191"/>
            <a:ext cx="4279819" cy="1860791"/>
          </a:xfrm>
          <a:prstGeom prst="rect">
            <a:avLst/>
          </a:prstGeom>
        </p:spPr>
      </p:pic>
      <p:pic>
        <p:nvPicPr>
          <p:cNvPr id="49" name="图片 4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6889" y="4550524"/>
            <a:ext cx="4467296" cy="1942302"/>
          </a:xfrm>
          <a:prstGeom prst="rect">
            <a:avLst/>
          </a:prstGeom>
        </p:spPr>
      </p:pic>
      <p:sp>
        <p:nvSpPr>
          <p:cNvPr id="50" name="文本框 59"/>
          <p:cNvSpPr txBox="1"/>
          <p:nvPr/>
        </p:nvSpPr>
        <p:spPr>
          <a:xfrm>
            <a:off x="1511551" y="4229612"/>
            <a:ext cx="655612" cy="62661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altLang="zh-CN" sz="1400" b="1" dirty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E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51" name="图片 5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5233" y="4550524"/>
            <a:ext cx="4356744" cy="1894237"/>
          </a:xfrm>
          <a:prstGeom prst="rect">
            <a:avLst/>
          </a:prstGeom>
        </p:spPr>
      </p:pic>
      <p:sp>
        <p:nvSpPr>
          <p:cNvPr id="54" name="文本框 59"/>
          <p:cNvSpPr txBox="1"/>
          <p:nvPr/>
        </p:nvSpPr>
        <p:spPr>
          <a:xfrm>
            <a:off x="6148140" y="4250419"/>
            <a:ext cx="655612" cy="6002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altLang="zh-CN" sz="1400" b="1" dirty="0">
                <a:latin typeface="等线" panose="02010600030101010101" pitchFamily="2" charset="-122"/>
                <a:ea typeface="等线" panose="02010600030101010101" pitchFamily="2" charset="-122"/>
                <a:cs typeface="宋体" panose="02010600030101010101" pitchFamily="2" charset="-122"/>
              </a:rPr>
              <a:t>F</a:t>
            </a:r>
            <a:endParaRPr lang="zh-CN" sz="1400" b="1" dirty="0">
              <a:effectLst/>
              <a:latin typeface="等线" panose="02010600030101010101" pitchFamily="2" charset="-122"/>
              <a:ea typeface="等线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22" name="Rectangle 2"/>
          <p:cNvSpPr>
            <a:spLocks noChangeArrowheads="1"/>
          </p:cNvSpPr>
          <p:nvPr/>
        </p:nvSpPr>
        <p:spPr bwMode="auto">
          <a:xfrm>
            <a:off x="290720" y="6408102"/>
            <a:ext cx="9908482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/>
              <a:t>Figure 3  The </a:t>
            </a:r>
            <a:r>
              <a:rPr lang="en-US" altLang="zh-CN" b="1" dirty="0"/>
              <a:t>distributions of immune infiltration levels under different gene mutation </a:t>
            </a:r>
            <a:r>
              <a:rPr lang="en-US" altLang="zh-CN" b="1" dirty="0" smtClean="0"/>
              <a:t>status.</a:t>
            </a:r>
            <a:endParaRPr lang="zh-CN" altLang="zh-CN" b="1" dirty="0"/>
          </a:p>
        </p:txBody>
      </p:sp>
    </p:spTree>
    <p:extLst>
      <p:ext uri="{BB962C8B-B14F-4D97-AF65-F5344CB8AC3E}">
        <p14:creationId xmlns:p14="http://schemas.microsoft.com/office/powerpoint/2010/main" val="36874078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40"/>
          <p:cNvSpPr txBox="1"/>
          <p:nvPr/>
        </p:nvSpPr>
        <p:spPr>
          <a:xfrm>
            <a:off x="5909289" y="180806"/>
            <a:ext cx="1375185" cy="35664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b="1" dirty="0" smtClean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              </a:t>
            </a:r>
            <a:r>
              <a:rPr lang="en-US" sz="1000" b="1" kern="1200" dirty="0" smtClean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APC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9" name="文本框 43"/>
          <p:cNvSpPr txBox="1"/>
          <p:nvPr/>
        </p:nvSpPr>
        <p:spPr>
          <a:xfrm>
            <a:off x="1698890" y="5627826"/>
            <a:ext cx="1375185" cy="35637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b="1" dirty="0" smtClean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           TP53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25" name="文本框 59"/>
          <p:cNvSpPr txBox="1"/>
          <p:nvPr/>
        </p:nvSpPr>
        <p:spPr>
          <a:xfrm>
            <a:off x="5191652" y="80801"/>
            <a:ext cx="655612" cy="6002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altLang="zh-CN" sz="1400" b="1" dirty="0" smtClean="0">
                <a:effectLst/>
                <a:latin typeface="等线" panose="02010600030101010101" pitchFamily="2" charset="-122"/>
                <a:ea typeface="等线" panose="02010600030101010101" pitchFamily="2" charset="-122"/>
                <a:cs typeface="宋体" panose="02010600030101010101" pitchFamily="2" charset="-122"/>
              </a:rPr>
              <a:t>B</a:t>
            </a:r>
            <a:endParaRPr lang="zh-CN" sz="1400" b="1" dirty="0">
              <a:effectLst/>
              <a:latin typeface="等线" panose="02010600030101010101" pitchFamily="2" charset="-122"/>
              <a:ea typeface="等线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1653" y="382868"/>
            <a:ext cx="3820464" cy="2467383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840" y="3335908"/>
            <a:ext cx="4023109" cy="2598258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1652" y="3382906"/>
            <a:ext cx="4027810" cy="2601294"/>
          </a:xfrm>
          <a:prstGeom prst="rect">
            <a:avLst/>
          </a:prstGeom>
        </p:spPr>
      </p:pic>
      <p:sp>
        <p:nvSpPr>
          <p:cNvPr id="41" name="文本框 59"/>
          <p:cNvSpPr txBox="1"/>
          <p:nvPr/>
        </p:nvSpPr>
        <p:spPr>
          <a:xfrm>
            <a:off x="122635" y="3069353"/>
            <a:ext cx="655612" cy="6002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altLang="zh-CN" sz="1400" b="1" dirty="0" smtClean="0">
                <a:effectLst/>
                <a:latin typeface="等线" panose="02010600030101010101" pitchFamily="2" charset="-122"/>
                <a:ea typeface="等线" panose="02010600030101010101" pitchFamily="2" charset="-122"/>
                <a:cs typeface="宋体" panose="02010600030101010101" pitchFamily="2" charset="-122"/>
              </a:rPr>
              <a:t>C</a:t>
            </a:r>
            <a:endParaRPr lang="zh-CN" sz="1400" b="1" dirty="0">
              <a:effectLst/>
              <a:latin typeface="等线" panose="02010600030101010101" pitchFamily="2" charset="-122"/>
              <a:ea typeface="等线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43" name="文本框 59"/>
          <p:cNvSpPr txBox="1"/>
          <p:nvPr/>
        </p:nvSpPr>
        <p:spPr>
          <a:xfrm>
            <a:off x="5120927" y="3069353"/>
            <a:ext cx="655612" cy="6002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altLang="zh-CN" sz="1400" b="1" dirty="0" smtClean="0">
                <a:effectLst/>
                <a:latin typeface="等线" panose="02010600030101010101" pitchFamily="2" charset="-122"/>
                <a:ea typeface="等线" panose="02010600030101010101" pitchFamily="2" charset="-122"/>
                <a:cs typeface="宋体" panose="02010600030101010101" pitchFamily="2" charset="-122"/>
              </a:rPr>
              <a:t>D</a:t>
            </a:r>
            <a:endParaRPr lang="zh-CN" sz="1400" b="1" dirty="0">
              <a:effectLst/>
              <a:latin typeface="等线" panose="02010600030101010101" pitchFamily="2" charset="-122"/>
              <a:ea typeface="等线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44" name="文本框 40"/>
          <p:cNvSpPr txBox="1"/>
          <p:nvPr/>
        </p:nvSpPr>
        <p:spPr>
          <a:xfrm>
            <a:off x="6000977" y="3113028"/>
            <a:ext cx="1375185" cy="35664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b="1" dirty="0" smtClean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              KRAS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46" name="文本框 59"/>
          <p:cNvSpPr txBox="1"/>
          <p:nvPr/>
        </p:nvSpPr>
        <p:spPr>
          <a:xfrm>
            <a:off x="225831" y="-62755"/>
            <a:ext cx="655612" cy="6002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altLang="zh-CN" sz="1400" b="1" dirty="0" smtClean="0">
                <a:effectLst/>
                <a:latin typeface="等线" panose="02010600030101010101" pitchFamily="2" charset="-122"/>
                <a:ea typeface="等线" panose="02010600030101010101" pitchFamily="2" charset="-122"/>
                <a:cs typeface="宋体" panose="02010600030101010101" pitchFamily="2" charset="-122"/>
              </a:rPr>
              <a:t>A</a:t>
            </a:r>
            <a:endParaRPr lang="zh-CN" sz="1400" b="1" dirty="0">
              <a:effectLst/>
              <a:latin typeface="等线" panose="02010600030101010101" pitchFamily="2" charset="-122"/>
              <a:ea typeface="等线" panose="02010600030101010101" pitchFamily="2" charset="-122"/>
              <a:cs typeface="宋体" panose="02010600030101010101" pitchFamily="2" charset="-122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341747" y="251655"/>
            <a:ext cx="3482907" cy="2720146"/>
            <a:chOff x="341747" y="251654"/>
            <a:chExt cx="3764261" cy="3646395"/>
          </a:xfrm>
        </p:grpSpPr>
        <p:pic>
          <p:nvPicPr>
            <p:cNvPr id="45" name="图片 44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116" y="1465586"/>
              <a:ext cx="3752892" cy="1261908"/>
            </a:xfrm>
            <a:prstGeom prst="rect">
              <a:avLst/>
            </a:prstGeom>
          </p:spPr>
        </p:pic>
        <p:pic>
          <p:nvPicPr>
            <p:cNvPr id="48" name="图片 47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116" y="251654"/>
              <a:ext cx="3752892" cy="1261908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1747" y="2639566"/>
              <a:ext cx="3742706" cy="1258483"/>
            </a:xfrm>
            <a:prstGeom prst="rect">
              <a:avLst/>
            </a:prstGeom>
          </p:spPr>
        </p:pic>
      </p:grpSp>
      <p:sp>
        <p:nvSpPr>
          <p:cNvPr id="17" name="文本框 40"/>
          <p:cNvSpPr txBox="1"/>
          <p:nvPr/>
        </p:nvSpPr>
        <p:spPr>
          <a:xfrm>
            <a:off x="1224912" y="3078083"/>
            <a:ext cx="1375185" cy="41558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b="1" dirty="0" smtClean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              </a:t>
            </a:r>
            <a:r>
              <a:rPr lang="en-US" sz="1000" b="1" dirty="0" smtClean="0">
                <a:solidFill>
                  <a:srgbClr val="000000"/>
                </a:solidFill>
                <a:latin typeface="等线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TP53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0" name="Rectangle 2"/>
          <p:cNvSpPr>
            <a:spLocks noChangeArrowheads="1"/>
          </p:cNvSpPr>
          <p:nvPr/>
        </p:nvSpPr>
        <p:spPr bwMode="auto">
          <a:xfrm>
            <a:off x="553637" y="6057905"/>
            <a:ext cx="11271739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b="1" dirty="0"/>
              <a:t>Figure 4 The comparison of tumor infiltration levels among tumors with different somatic copy </a:t>
            </a:r>
            <a:r>
              <a:rPr lang="en-US" altLang="zh-CN" b="1" dirty="0" smtClean="0"/>
              <a:t>number alterations </a:t>
            </a:r>
            <a:r>
              <a:rPr lang="en-US" altLang="zh-CN" b="1" dirty="0"/>
              <a:t>for genes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effectLst/>
                <a:latin typeface="+mn-ea"/>
                <a:cs typeface="Times New Roman" panose="02020603050405020304" pitchFamily="18" charset="0"/>
              </a:rPr>
              <a:t>.</a:t>
            </a:r>
            <a:endParaRPr kumimoji="0" lang="en-US" altLang="zh-CN" sz="3600" b="0" i="0" u="none" strike="noStrike" cap="none" normalizeH="0" baseline="0" dirty="0" smtClean="0">
              <a:ln>
                <a:noFill/>
              </a:ln>
              <a:effectLst/>
              <a:latin typeface="+mn-ea"/>
            </a:endParaRPr>
          </a:p>
        </p:txBody>
      </p:sp>
      <p:sp>
        <p:nvSpPr>
          <p:cNvPr id="11" name="Rectangle 3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en-US" altLang="zh-CN" sz="900" b="1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</a:t>
            </a:r>
            <a:r>
              <a:rPr kumimoji="0" lang="en-US" altLang="zh-CN" sz="900" b="1" i="0" u="none" strike="noStrike" cap="none" normalizeH="0" baseline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</a:t>
            </a:r>
            <a:r>
              <a:rPr kumimoji="0" lang="en-US" altLang="zh-CN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he comparison of tumor infiltration levels among tumors with different somatic copy number alterations for genes.</a:t>
            </a:r>
            <a:r>
              <a:rPr kumimoji="0" lang="en-US" altLang="zh-CN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zh-CN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76667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993" y="102772"/>
            <a:ext cx="9891346" cy="3171574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993" y="3274346"/>
            <a:ext cx="9887734" cy="3170416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51692" y="0"/>
            <a:ext cx="35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 smtClean="0"/>
              <a:t>A</a:t>
            </a:r>
            <a:endParaRPr lang="zh-CN" altLang="en-US" sz="1100" b="1" dirty="0"/>
          </a:p>
        </p:txBody>
      </p:sp>
      <p:sp>
        <p:nvSpPr>
          <p:cNvPr id="7" name="文本框 6"/>
          <p:cNvSpPr txBox="1"/>
          <p:nvPr/>
        </p:nvSpPr>
        <p:spPr>
          <a:xfrm>
            <a:off x="351692" y="3115508"/>
            <a:ext cx="35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 smtClean="0"/>
              <a:t>B</a:t>
            </a:r>
            <a:endParaRPr lang="zh-CN" altLang="en-US" sz="1100" b="1" dirty="0"/>
          </a:p>
        </p:txBody>
      </p:sp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527538" y="6418934"/>
            <a:ext cx="11271739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/>
              <a:t>Figure </a:t>
            </a:r>
            <a:r>
              <a:rPr lang="en-US" altLang="zh-CN" b="1" dirty="0" smtClean="0"/>
              <a:t>5 </a:t>
            </a:r>
            <a:r>
              <a:rPr lang="en-US" altLang="zh-CN" b="1" dirty="0"/>
              <a:t>The survival difference of CRC TILs of each subset.</a:t>
            </a:r>
            <a:r>
              <a:rPr lang="en-US" altLang="zh-CN" dirty="0"/>
              <a:t> </a:t>
            </a:r>
            <a:endParaRPr kumimoji="0" lang="en-US" altLang="zh-CN" sz="3600" b="0" i="0" u="none" strike="noStrike" cap="none" normalizeH="0" baseline="0" dirty="0" smtClean="0">
              <a:ln>
                <a:noFill/>
              </a:ln>
              <a:effectLst/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23845021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527538" y="6418934"/>
            <a:ext cx="11271739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 smtClean="0"/>
              <a:t>Figure </a:t>
            </a:r>
            <a:r>
              <a:rPr lang="en-US" altLang="zh-CN" b="1" dirty="0"/>
              <a:t>6. Increasing age associated with better ICB responses..</a:t>
            </a:r>
            <a:r>
              <a:rPr lang="en-US" altLang="zh-CN" dirty="0" smtClean="0"/>
              <a:t> </a:t>
            </a:r>
            <a:endParaRPr kumimoji="0" lang="en-US" altLang="zh-CN" sz="3600" b="0" i="0" u="none" strike="noStrike" cap="none" normalizeH="0" baseline="0" dirty="0" smtClean="0">
              <a:ln>
                <a:noFill/>
              </a:ln>
              <a:effectLst/>
              <a:latin typeface="+mn-ea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25935" y="3545128"/>
            <a:ext cx="4667472" cy="2611214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7254247" y="3206574"/>
            <a:ext cx="485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F</a:t>
            </a:r>
            <a:endParaRPr lang="zh-CN" altLang="en-US" sz="1600" b="1" dirty="0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503" y="764375"/>
            <a:ext cx="4375903" cy="2187952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427503" y="339374"/>
            <a:ext cx="485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A</a:t>
            </a:r>
            <a:endParaRPr lang="zh-CN" altLang="en-US" sz="1600" b="1" dirty="0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718" y="717722"/>
            <a:ext cx="2450841" cy="2450841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4803406" y="341842"/>
            <a:ext cx="485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B</a:t>
            </a:r>
            <a:endParaRPr lang="zh-CN" altLang="en-US" sz="1600" b="1" dirty="0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54247" y="717722"/>
            <a:ext cx="2466391" cy="2466391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7325935" y="341842"/>
            <a:ext cx="485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C</a:t>
            </a:r>
            <a:endParaRPr lang="zh-CN" altLang="en-US" sz="1600" b="1" dirty="0"/>
          </a:p>
        </p:txBody>
      </p:sp>
      <p:sp>
        <p:nvSpPr>
          <p:cNvPr id="17" name="文本框 16"/>
          <p:cNvSpPr txBox="1"/>
          <p:nvPr/>
        </p:nvSpPr>
        <p:spPr>
          <a:xfrm>
            <a:off x="9736191" y="341842"/>
            <a:ext cx="485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D</a:t>
            </a:r>
            <a:endParaRPr lang="zh-CN" altLang="en-US" sz="1600" b="1" dirty="0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36191" y="717722"/>
            <a:ext cx="2455809" cy="2455809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511479" y="3120064"/>
            <a:ext cx="485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E</a:t>
            </a:r>
            <a:endParaRPr lang="zh-CN" altLang="en-US" sz="1600" b="1" dirty="0"/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503" y="3545128"/>
            <a:ext cx="6755837" cy="25570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14294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内容占位符 6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1871" y="784223"/>
            <a:ext cx="5989941" cy="4992322"/>
          </a:xfrm>
        </p:spPr>
      </p:pic>
      <p:sp>
        <p:nvSpPr>
          <p:cNvPr id="5" name="内容占位符 2"/>
          <p:cNvSpPr txBox="1">
            <a:spLocks/>
          </p:cNvSpPr>
          <p:nvPr/>
        </p:nvSpPr>
        <p:spPr>
          <a:xfrm>
            <a:off x="64477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2069390" y="716706"/>
            <a:ext cx="13461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Fig 1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1052145" y="5987859"/>
            <a:ext cx="1100796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kern="100" dirty="0">
                <a:latin typeface="Times New Roman" panose="02020603050405020304" pitchFamily="18" charset="0"/>
              </a:rPr>
              <a:t>Supplementary Figure 1--The </a:t>
            </a:r>
            <a:r>
              <a:rPr lang="en-US" altLang="zh-CN" b="1" kern="100" dirty="0" err="1">
                <a:latin typeface="Times New Roman" panose="02020603050405020304" pitchFamily="18" charset="0"/>
              </a:rPr>
              <a:t>correplot</a:t>
            </a:r>
            <a:r>
              <a:rPr lang="en-US" altLang="zh-CN" b="1" kern="100" dirty="0">
                <a:latin typeface="Times New Roman" panose="02020603050405020304" pitchFamily="18" charset="0"/>
              </a:rPr>
              <a:t> of the proportion of each immune cell in CRC samples presented the statistically significant differences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62503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98</TotalTime>
  <Words>283</Words>
  <Application>Microsoft Office PowerPoint</Application>
  <PresentationFormat>宽屏</PresentationFormat>
  <Paragraphs>94</Paragraphs>
  <Slides>8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4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CER</dc:creator>
  <cp:lastModifiedBy>ACER</cp:lastModifiedBy>
  <cp:revision>57</cp:revision>
  <dcterms:created xsi:type="dcterms:W3CDTF">2021-09-28T09:01:50Z</dcterms:created>
  <dcterms:modified xsi:type="dcterms:W3CDTF">2022-08-03T07:00:26Z</dcterms:modified>
</cp:coreProperties>
</file>